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ink/ink1.xml" ContentType="application/inkml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66" r:id="rId2"/>
    <p:sldMasterId id="2147483682" r:id="rId3"/>
  </p:sldMasterIdLst>
  <p:notesMasterIdLst>
    <p:notesMasterId r:id="rId7"/>
  </p:notesMasterIdLst>
  <p:sldIdLst>
    <p:sldId id="297" r:id="rId4"/>
    <p:sldId id="293" r:id="rId5"/>
    <p:sldId id="298" r:id="rId6"/>
  </p:sldIdLst>
  <p:sldSz cx="9144000" cy="5143500" type="screen16x9"/>
  <p:notesSz cx="6858000" cy="9144000"/>
  <p:defaultTextStyle>
    <a:defPPr>
      <a:defRPr lang="en-US"/>
    </a:defPPr>
    <a:lvl1pPr marL="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1pPr>
    <a:lvl2pPr marL="3429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2pPr>
    <a:lvl3pPr marL="6858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3pPr>
    <a:lvl4pPr marL="10287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4pPr>
    <a:lvl5pPr marL="13716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5pPr>
    <a:lvl6pPr marL="17145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6pPr>
    <a:lvl7pPr marL="20574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7pPr>
    <a:lvl8pPr marL="24003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8pPr>
    <a:lvl9pPr marL="2743200" algn="l" defTabSz="685800" rtl="0" eaLnBrk="1" latinLnBrk="0" hangingPunct="1">
      <a:defRPr sz="135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  <a:srgbClr val="CC0066"/>
    <a:srgbClr val="0033CC"/>
    <a:srgbClr val="990033"/>
    <a:srgbClr val="3333CC"/>
    <a:srgbClr val="3366FF"/>
    <a:srgbClr val="3333FF"/>
    <a:srgbClr val="33CCFF"/>
    <a:srgbClr val="00FFFF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13" autoAdjust="0"/>
    <p:restoredTop sz="96357" autoAdjust="0"/>
  </p:normalViewPr>
  <p:slideViewPr>
    <p:cSldViewPr snapToGrid="0">
      <p:cViewPr varScale="1">
        <p:scale>
          <a:sx n="84" d="100"/>
          <a:sy n="84" d="100"/>
        </p:scale>
        <p:origin x="724" y="64"/>
      </p:cViewPr>
      <p:guideLst>
        <p:guide orient="horz" pos="162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bleStyles" Target="tableStyles.xml"/><Relationship Id="rId5" Type="http://schemas.openxmlformats.org/officeDocument/2006/relationships/slide" Target="slides/slide2.xml"/><Relationship Id="rId10" Type="http://schemas.openxmlformats.org/officeDocument/2006/relationships/theme" Target="theme/theme1.xml"/><Relationship Id="rId4" Type="http://schemas.openxmlformats.org/officeDocument/2006/relationships/slide" Target="slides/slide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nasweeta Angane" userId="05da2731-9352-4b35-b713-60351f56afbd" providerId="ADAL" clId="{35B67B36-9BAF-4026-8F45-5C8D0D30CF73}"/>
    <pc:docChg chg="undo custSel addSld delSld modSld sldOrd">
      <pc:chgData name="Manasweeta Angane" userId="05da2731-9352-4b35-b713-60351f56afbd" providerId="ADAL" clId="{35B67B36-9BAF-4026-8F45-5C8D0D30CF73}" dt="2022-11-01T01:45:33.018" v="335" actId="20577"/>
      <pc:docMkLst>
        <pc:docMk/>
      </pc:docMkLst>
      <pc:sldChg chg="addSp delSp modSp add mod">
        <pc:chgData name="Manasweeta Angane" userId="05da2731-9352-4b35-b713-60351f56afbd" providerId="ADAL" clId="{35B67B36-9BAF-4026-8F45-5C8D0D30CF73}" dt="2022-10-31T12:50:54.838" v="271" actId="1036"/>
        <pc:sldMkLst>
          <pc:docMk/>
          <pc:sldMk cId="1254738402" sldId="256"/>
        </pc:sldMkLst>
        <pc:spChg chg="add del mod">
          <ac:chgData name="Manasweeta Angane" userId="05da2731-9352-4b35-b713-60351f56afbd" providerId="ADAL" clId="{35B67B36-9BAF-4026-8F45-5C8D0D30CF73}" dt="2022-10-14T05:01:54.476" v="39" actId="478"/>
          <ac:spMkLst>
            <pc:docMk/>
            <pc:sldMk cId="1254738402" sldId="256"/>
            <ac:spMk id="2" creationId="{FE30E602-AE61-7DA0-434C-B0D9130CB5F9}"/>
          </ac:spMkLst>
        </pc:spChg>
        <pc:spChg chg="add mod">
          <ac:chgData name="Manasweeta Angane" userId="05da2731-9352-4b35-b713-60351f56afbd" providerId="ADAL" clId="{35B67B36-9BAF-4026-8F45-5C8D0D30CF73}" dt="2022-10-14T05:09:10.071" v="125" actId="14100"/>
          <ac:spMkLst>
            <pc:docMk/>
            <pc:sldMk cId="1254738402" sldId="256"/>
            <ac:spMk id="4" creationId="{FACC440F-5C61-A6E9-7482-2FD6985CBEE2}"/>
          </ac:spMkLst>
        </pc:spChg>
        <pc:spChg chg="mod">
          <ac:chgData name="Manasweeta Angane" userId="05da2731-9352-4b35-b713-60351f56afbd" providerId="ADAL" clId="{35B67B36-9BAF-4026-8F45-5C8D0D30CF73}" dt="2022-10-31T12:50:54.838" v="271" actId="1036"/>
          <ac:spMkLst>
            <pc:docMk/>
            <pc:sldMk cId="1254738402" sldId="256"/>
            <ac:spMk id="5" creationId="{04338863-F357-402B-809B-491B184C2878}"/>
          </ac:spMkLst>
        </pc:spChg>
        <pc:spChg chg="mod">
          <ac:chgData name="Manasweeta Angane" userId="05da2731-9352-4b35-b713-60351f56afbd" providerId="ADAL" clId="{35B67B36-9BAF-4026-8F45-5C8D0D30CF73}" dt="2022-10-14T05:00:26.749" v="20" actId="20577"/>
          <ac:spMkLst>
            <pc:docMk/>
            <pc:sldMk cId="1254738402" sldId="256"/>
            <ac:spMk id="9" creationId="{B6B751D4-5C79-7747-9D65-B4263B4C6DDA}"/>
          </ac:spMkLst>
        </pc:spChg>
        <pc:spChg chg="mod">
          <ac:chgData name="Manasweeta Angane" userId="05da2731-9352-4b35-b713-60351f56afbd" providerId="ADAL" clId="{35B67B36-9BAF-4026-8F45-5C8D0D30CF73}" dt="2022-10-14T05:01:11.904" v="37" actId="20577"/>
          <ac:spMkLst>
            <pc:docMk/>
            <pc:sldMk cId="1254738402" sldId="256"/>
            <ac:spMk id="10" creationId="{F8523BA8-19CA-6241-B709-C6E421C28427}"/>
          </ac:spMkLst>
        </pc:spChg>
        <pc:picChg chg="add mod ord">
          <ac:chgData name="Manasweeta Angane" userId="05da2731-9352-4b35-b713-60351f56afbd" providerId="ADAL" clId="{35B67B36-9BAF-4026-8F45-5C8D0D30CF73}" dt="2022-10-14T05:05:21.516" v="101" actId="1076"/>
          <ac:picMkLst>
            <pc:docMk/>
            <pc:sldMk cId="1254738402" sldId="256"/>
            <ac:picMk id="3" creationId="{A83B1F6E-8D05-E12F-3D75-0F6812B0FF96}"/>
          </ac:picMkLst>
        </pc:picChg>
        <pc:picChg chg="add del mod">
          <ac:chgData name="Manasweeta Angane" userId="05da2731-9352-4b35-b713-60351f56afbd" providerId="ADAL" clId="{35B67B36-9BAF-4026-8F45-5C8D0D30CF73}" dt="2022-10-14T05:04:57.664" v="96" actId="478"/>
          <ac:picMkLst>
            <pc:docMk/>
            <pc:sldMk cId="1254738402" sldId="256"/>
            <ac:picMk id="5" creationId="{D800A0E4-E16A-1065-3970-33C958A01CB3}"/>
          </ac:picMkLst>
        </pc:picChg>
      </pc:sldChg>
      <pc:sldChg chg="add ord">
        <pc:chgData name="Manasweeta Angane" userId="05da2731-9352-4b35-b713-60351f56afbd" providerId="ADAL" clId="{35B67B36-9BAF-4026-8F45-5C8D0D30CF73}" dt="2022-10-14T05:00:04.997" v="11"/>
        <pc:sldMkLst>
          <pc:docMk/>
          <pc:sldMk cId="592248708" sldId="260"/>
        </pc:sldMkLst>
      </pc:sldChg>
      <pc:sldChg chg="addSp modSp mod ord">
        <pc:chgData name="Manasweeta Angane" userId="05da2731-9352-4b35-b713-60351f56afbd" providerId="ADAL" clId="{35B67B36-9BAF-4026-8F45-5C8D0D30CF73}" dt="2022-10-25T08:54:41.532" v="186" actId="20577"/>
        <pc:sldMkLst>
          <pc:docMk/>
          <pc:sldMk cId="2988400537" sldId="284"/>
        </pc:sldMkLst>
        <pc:spChg chg="add mod">
          <ac:chgData name="Manasweeta Angane" userId="05da2731-9352-4b35-b713-60351f56afbd" providerId="ADAL" clId="{35B67B36-9BAF-4026-8F45-5C8D0D30CF73}" dt="2022-10-25T08:54:38.066" v="185" actId="20577"/>
          <ac:spMkLst>
            <pc:docMk/>
            <pc:sldMk cId="2988400537" sldId="284"/>
            <ac:spMk id="2" creationId="{B96C4202-BBB4-88B7-DA08-B67B649D50BC}"/>
          </ac:spMkLst>
        </pc:spChg>
        <pc:spChg chg="mod">
          <ac:chgData name="Manasweeta Angane" userId="05da2731-9352-4b35-b713-60351f56afbd" providerId="ADAL" clId="{35B67B36-9BAF-4026-8F45-5C8D0D30CF73}" dt="2022-10-25T08:54:41.532" v="186" actId="20577"/>
          <ac:spMkLst>
            <pc:docMk/>
            <pc:sldMk cId="2988400537" sldId="284"/>
            <ac:spMk id="117" creationId="{555CACB8-2D2D-4E3F-AF81-93D16C21748B}"/>
          </ac:spMkLst>
        </pc:spChg>
      </pc:sldChg>
      <pc:sldChg chg="addSp modSp mod">
        <pc:chgData name="Manasweeta Angane" userId="05da2731-9352-4b35-b713-60351f56afbd" providerId="ADAL" clId="{35B67B36-9BAF-4026-8F45-5C8D0D30CF73}" dt="2022-11-01T01:45:33.018" v="335" actId="20577"/>
        <pc:sldMkLst>
          <pc:docMk/>
          <pc:sldMk cId="1046971931" sldId="293"/>
        </pc:sldMkLst>
        <pc:spChg chg="add mod">
          <ac:chgData name="Manasweeta Angane" userId="05da2731-9352-4b35-b713-60351f56afbd" providerId="ADAL" clId="{35B67B36-9BAF-4026-8F45-5C8D0D30CF73}" dt="2022-11-01T01:44:49.446" v="327" actId="20577"/>
          <ac:spMkLst>
            <pc:docMk/>
            <pc:sldMk cId="1046971931" sldId="293"/>
            <ac:spMk id="3" creationId="{3301C9F2-50F5-0A61-696D-1A66819DE51A}"/>
          </ac:spMkLst>
        </pc:spChg>
        <pc:spChg chg="mod">
          <ac:chgData name="Manasweeta Angane" userId="05da2731-9352-4b35-b713-60351f56afbd" providerId="ADAL" clId="{35B67B36-9BAF-4026-8F45-5C8D0D30CF73}" dt="2022-11-01T01:44:12.360" v="284" actId="20577"/>
          <ac:spMkLst>
            <pc:docMk/>
            <pc:sldMk cId="1046971931" sldId="293"/>
            <ac:spMk id="11" creationId="{7D80F4E0-502C-4D49-85AC-4E84CA18DCC7}"/>
          </ac:spMkLst>
        </pc:spChg>
        <pc:spChg chg="mod">
          <ac:chgData name="Manasweeta Angane" userId="05da2731-9352-4b35-b713-60351f56afbd" providerId="ADAL" clId="{35B67B36-9BAF-4026-8F45-5C8D0D30CF73}" dt="2022-11-01T01:45:01.004" v="329" actId="20577"/>
          <ac:spMkLst>
            <pc:docMk/>
            <pc:sldMk cId="1046971931" sldId="293"/>
            <ac:spMk id="24" creationId="{B69BCE85-BD7B-4E48-A163-58B643F99E35}"/>
          </ac:spMkLst>
        </pc:spChg>
        <pc:spChg chg="mod">
          <ac:chgData name="Manasweeta Angane" userId="05da2731-9352-4b35-b713-60351f56afbd" providerId="ADAL" clId="{35B67B36-9BAF-4026-8F45-5C8D0D30CF73}" dt="2022-11-01T01:45:07.078" v="330" actId="20577"/>
          <ac:spMkLst>
            <pc:docMk/>
            <pc:sldMk cId="1046971931" sldId="293"/>
            <ac:spMk id="25" creationId="{5BFD7D79-2525-4D46-9923-247D6D654495}"/>
          </ac:spMkLst>
        </pc:spChg>
        <pc:spChg chg="mod">
          <ac:chgData name="Manasweeta Angane" userId="05da2731-9352-4b35-b713-60351f56afbd" providerId="ADAL" clId="{35B67B36-9BAF-4026-8F45-5C8D0D30CF73}" dt="2022-11-01T01:45:33.018" v="335" actId="20577"/>
          <ac:spMkLst>
            <pc:docMk/>
            <pc:sldMk cId="1046971931" sldId="293"/>
            <ac:spMk id="26" creationId="{EF3E1FB5-A979-4AC9-940B-BAF4B16EA53F}"/>
          </ac:spMkLst>
        </pc:spChg>
      </pc:sldChg>
      <pc:sldChg chg="modSp mod">
        <pc:chgData name="Manasweeta Angane" userId="05da2731-9352-4b35-b713-60351f56afbd" providerId="ADAL" clId="{35B67B36-9BAF-4026-8F45-5C8D0D30CF73}" dt="2022-10-29T06:59:44.355" v="240" actId="13926"/>
        <pc:sldMkLst>
          <pc:docMk/>
          <pc:sldMk cId="72074382" sldId="294"/>
        </pc:sldMkLst>
        <pc:graphicFrameChg chg="modGraphic">
          <ac:chgData name="Manasweeta Angane" userId="05da2731-9352-4b35-b713-60351f56afbd" providerId="ADAL" clId="{35B67B36-9BAF-4026-8F45-5C8D0D30CF73}" dt="2022-10-29T06:59:44.355" v="240" actId="13926"/>
          <ac:graphicFrameMkLst>
            <pc:docMk/>
            <pc:sldMk cId="72074382" sldId="294"/>
            <ac:graphicFrameMk id="14" creationId="{AF1C1A4D-6DE2-4344-B335-B83D1CAF92C3}"/>
          </ac:graphicFrameMkLst>
        </pc:graphicFrameChg>
      </pc:sldChg>
      <pc:sldChg chg="modSp add mod ord">
        <pc:chgData name="Manasweeta Angane" userId="05da2731-9352-4b35-b713-60351f56afbd" providerId="ADAL" clId="{35B67B36-9BAF-4026-8F45-5C8D0D30CF73}" dt="2022-10-29T06:51:29.416" v="239"/>
        <pc:sldMkLst>
          <pc:docMk/>
          <pc:sldMk cId="2867490092" sldId="307"/>
        </pc:sldMkLst>
        <pc:spChg chg="mod">
          <ac:chgData name="Manasweeta Angane" userId="05da2731-9352-4b35-b713-60351f56afbd" providerId="ADAL" clId="{35B67B36-9BAF-4026-8F45-5C8D0D30CF73}" dt="2022-10-14T05:08:44.372" v="120" actId="14100"/>
          <ac:spMkLst>
            <pc:docMk/>
            <pc:sldMk cId="2867490092" sldId="307"/>
            <ac:spMk id="4" creationId="{FACC440F-5C61-A6E9-7482-2FD6985CBEE2}"/>
          </ac:spMkLst>
        </pc:spChg>
        <pc:spChg chg="mod">
          <ac:chgData name="Manasweeta Angane" userId="05da2731-9352-4b35-b713-60351f56afbd" providerId="ADAL" clId="{35B67B36-9BAF-4026-8F45-5C8D0D30CF73}" dt="2022-10-14T05:06:27.748" v="117" actId="20577"/>
          <ac:spMkLst>
            <pc:docMk/>
            <pc:sldMk cId="2867490092" sldId="307"/>
            <ac:spMk id="9" creationId="{B6B751D4-5C79-7747-9D65-B4263B4C6DDA}"/>
          </ac:spMkLst>
        </pc:spChg>
        <pc:spChg chg="mod">
          <ac:chgData name="Manasweeta Angane" userId="05da2731-9352-4b35-b713-60351f56afbd" providerId="ADAL" clId="{35B67B36-9BAF-4026-8F45-5C8D0D30CF73}" dt="2022-10-14T05:08:16.175" v="118" actId="6549"/>
          <ac:spMkLst>
            <pc:docMk/>
            <pc:sldMk cId="2867490092" sldId="307"/>
            <ac:spMk id="10" creationId="{F8523BA8-19CA-6241-B709-C6E421C28427}"/>
          </ac:spMkLst>
        </pc:spChg>
      </pc:sldChg>
      <pc:sldChg chg="new del">
        <pc:chgData name="Manasweeta Angane" userId="05da2731-9352-4b35-b713-60351f56afbd" providerId="ADAL" clId="{35B67B36-9BAF-4026-8F45-5C8D0D30CF73}" dt="2022-10-14T05:00:18.981" v="13" actId="2696"/>
        <pc:sldMkLst>
          <pc:docMk/>
          <pc:sldMk cId="3557316419" sldId="307"/>
        </pc:sldMkLst>
      </pc:sldChg>
      <pc:sldChg chg="add del">
        <pc:chgData name="Manasweeta Angane" userId="05da2731-9352-4b35-b713-60351f56afbd" providerId="ADAL" clId="{35B67B36-9BAF-4026-8F45-5C8D0D30CF73}" dt="2022-10-14T05:00:13.995" v="12" actId="2696"/>
        <pc:sldMkLst>
          <pc:docMk/>
          <pc:sldMk cId="2837249999" sldId="308"/>
        </pc:sldMkLst>
      </pc:sldChg>
      <pc:sldChg chg="modSp mod">
        <pc:chgData name="Manasweeta Angane" userId="05da2731-9352-4b35-b713-60351f56afbd" providerId="ADAL" clId="{35B67B36-9BAF-4026-8F45-5C8D0D30CF73}" dt="2022-10-25T09:19:50.699" v="237" actId="1036"/>
        <pc:sldMkLst>
          <pc:docMk/>
          <pc:sldMk cId="2034698016" sldId="310"/>
        </pc:sldMkLst>
        <pc:spChg chg="mod">
          <ac:chgData name="Manasweeta Angane" userId="05da2731-9352-4b35-b713-60351f56afbd" providerId="ADAL" clId="{35B67B36-9BAF-4026-8F45-5C8D0D30CF73}" dt="2022-10-25T09:19:50.699" v="237" actId="1036"/>
          <ac:spMkLst>
            <pc:docMk/>
            <pc:sldMk cId="2034698016" sldId="310"/>
            <ac:spMk id="78" creationId="{A4233CF2-CF4E-40DB-952B-F71388A2FBA8}"/>
          </ac:spMkLst>
        </pc:spChg>
      </pc:sldChg>
    </pc:docChg>
  </pc:docChgLst>
  <pc:docChgLst>
    <pc:chgData name="Manasweeta Angane" userId="05da2731-9352-4b35-b713-60351f56afbd" providerId="ADAL" clId="{ABBA02FC-26DE-4604-AAA3-9EC983C9D2DC}"/>
    <pc:docChg chg="modSld">
      <pc:chgData name="Manasweeta Angane" userId="05da2731-9352-4b35-b713-60351f56afbd" providerId="ADAL" clId="{ABBA02FC-26DE-4604-AAA3-9EC983C9D2DC}" dt="2023-06-11T14:20:41.780" v="26" actId="20577"/>
      <pc:docMkLst>
        <pc:docMk/>
      </pc:docMkLst>
      <pc:sldChg chg="modSp mod">
        <pc:chgData name="Manasweeta Angane" userId="05da2731-9352-4b35-b713-60351f56afbd" providerId="ADAL" clId="{ABBA02FC-26DE-4604-AAA3-9EC983C9D2DC}" dt="2023-06-11T14:20:22.671" v="17" actId="20577"/>
        <pc:sldMkLst>
          <pc:docMk/>
          <pc:sldMk cId="1046971931" sldId="293"/>
        </pc:sldMkLst>
        <pc:spChg chg="mod">
          <ac:chgData name="Manasweeta Angane" userId="05da2731-9352-4b35-b713-60351f56afbd" providerId="ADAL" clId="{ABBA02FC-26DE-4604-AAA3-9EC983C9D2DC}" dt="2023-06-11T14:20:22.671" v="17" actId="20577"/>
          <ac:spMkLst>
            <pc:docMk/>
            <pc:sldMk cId="1046971931" sldId="293"/>
            <ac:spMk id="11" creationId="{7D80F4E0-502C-4D49-85AC-4E84CA18DCC7}"/>
          </ac:spMkLst>
        </pc:spChg>
      </pc:sldChg>
      <pc:sldChg chg="modSp mod">
        <pc:chgData name="Manasweeta Angane" userId="05da2731-9352-4b35-b713-60351f56afbd" providerId="ADAL" clId="{ABBA02FC-26DE-4604-AAA3-9EC983C9D2DC}" dt="2023-06-11T14:20:04.263" v="8" actId="20577"/>
        <pc:sldMkLst>
          <pc:docMk/>
          <pc:sldMk cId="3975102812" sldId="297"/>
        </pc:sldMkLst>
        <pc:spChg chg="mod">
          <ac:chgData name="Manasweeta Angane" userId="05da2731-9352-4b35-b713-60351f56afbd" providerId="ADAL" clId="{ABBA02FC-26DE-4604-AAA3-9EC983C9D2DC}" dt="2023-06-11T14:20:04.263" v="8" actId="20577"/>
          <ac:spMkLst>
            <pc:docMk/>
            <pc:sldMk cId="3975102812" sldId="297"/>
            <ac:spMk id="18" creationId="{45F2BEED-A6BE-45AE-BED7-62E52E5E5868}"/>
          </ac:spMkLst>
        </pc:spChg>
      </pc:sldChg>
      <pc:sldChg chg="modSp mod">
        <pc:chgData name="Manasweeta Angane" userId="05da2731-9352-4b35-b713-60351f56afbd" providerId="ADAL" clId="{ABBA02FC-26DE-4604-AAA3-9EC983C9D2DC}" dt="2023-06-11T14:20:41.780" v="26" actId="20577"/>
        <pc:sldMkLst>
          <pc:docMk/>
          <pc:sldMk cId="1417210217" sldId="298"/>
        </pc:sldMkLst>
        <pc:spChg chg="mod">
          <ac:chgData name="Manasweeta Angane" userId="05da2731-9352-4b35-b713-60351f56afbd" providerId="ADAL" clId="{ABBA02FC-26DE-4604-AAA3-9EC983C9D2DC}" dt="2023-06-11T14:20:41.780" v="26" actId="20577"/>
          <ac:spMkLst>
            <pc:docMk/>
            <pc:sldMk cId="1417210217" sldId="298"/>
            <ac:spMk id="11" creationId="{7D80F4E0-502C-4D49-85AC-4E84CA18DCC7}"/>
          </ac:spMkLst>
        </pc:spChg>
      </pc:sldChg>
    </pc:docChg>
  </pc:docChgLst>
  <pc:docChgLst>
    <pc:chgData name="Manasweeta Angane" userId="05da2731-9352-4b35-b713-60351f56afbd" providerId="ADAL" clId="{8F87C93B-F36F-43D9-94B9-D7D1F8A0B471}"/>
    <pc:docChg chg="modSld">
      <pc:chgData name="Manasweeta Angane" userId="05da2731-9352-4b35-b713-60351f56afbd" providerId="ADAL" clId="{8F87C93B-F36F-43D9-94B9-D7D1F8A0B471}" dt="2020-11-08T01:54:24.860" v="1" actId="1076"/>
      <pc:docMkLst>
        <pc:docMk/>
      </pc:docMkLst>
      <pc:sldChg chg="addSp modSp">
        <pc:chgData name="Manasweeta Angane" userId="05da2731-9352-4b35-b713-60351f56afbd" providerId="ADAL" clId="{8F87C93B-F36F-43D9-94B9-D7D1F8A0B471}" dt="2020-11-08T01:54:24.860" v="1" actId="1076"/>
        <pc:sldMkLst>
          <pc:docMk/>
          <pc:sldMk cId="2764835349" sldId="259"/>
        </pc:sldMkLst>
        <pc:grpChg chg="add mod">
          <ac:chgData name="Manasweeta Angane" userId="05da2731-9352-4b35-b713-60351f56afbd" providerId="ADAL" clId="{8F87C93B-F36F-43D9-94B9-D7D1F8A0B471}" dt="2020-11-08T01:54:24.860" v="1" actId="1076"/>
          <ac:grpSpMkLst>
            <pc:docMk/>
            <pc:sldMk cId="2764835349" sldId="259"/>
            <ac:grpSpMk id="4" creationId="{A5E145EA-B2A8-4549-8D43-B60DCB1CC13E}"/>
          </ac:grpSpMkLst>
        </pc:grpChg>
      </pc:sldChg>
    </pc:docChg>
  </pc:docChgLst>
  <pc:docChgLst>
    <pc:chgData name="Manasweeta Angane" userId="05da2731-9352-4b35-b713-60351f56afbd" providerId="ADAL" clId="{EAC5F388-D890-4547-BC12-64905966776F}"/>
    <pc:docChg chg="undo custSel addSld modSld">
      <pc:chgData name="Manasweeta Angane" userId="05da2731-9352-4b35-b713-60351f56afbd" providerId="ADAL" clId="{EAC5F388-D890-4547-BC12-64905966776F}" dt="2021-06-14T10:16:32.584" v="9" actId="680"/>
      <pc:docMkLst>
        <pc:docMk/>
      </pc:docMkLst>
      <pc:sldChg chg="modSp mod">
        <pc:chgData name="Manasweeta Angane" userId="05da2731-9352-4b35-b713-60351f56afbd" providerId="ADAL" clId="{EAC5F388-D890-4547-BC12-64905966776F}" dt="2021-05-23T21:07:43.589" v="8" actId="20577"/>
        <pc:sldMkLst>
          <pc:docMk/>
          <pc:sldMk cId="4248096269" sldId="267"/>
        </pc:sldMkLst>
        <pc:spChg chg="mod">
          <ac:chgData name="Manasweeta Angane" userId="05da2731-9352-4b35-b713-60351f56afbd" providerId="ADAL" clId="{EAC5F388-D890-4547-BC12-64905966776F}" dt="2021-05-23T21:07:43.589" v="8" actId="20577"/>
          <ac:spMkLst>
            <pc:docMk/>
            <pc:sldMk cId="4248096269" sldId="267"/>
            <ac:spMk id="10" creationId="{F754395B-DA89-41A0-AD45-85B4C0268995}"/>
          </ac:spMkLst>
        </pc:spChg>
      </pc:sldChg>
      <pc:sldChg chg="new">
        <pc:chgData name="Manasweeta Angane" userId="05da2731-9352-4b35-b713-60351f56afbd" providerId="ADAL" clId="{EAC5F388-D890-4547-BC12-64905966776F}" dt="2021-06-14T10:16:32.584" v="9" actId="680"/>
        <pc:sldMkLst>
          <pc:docMk/>
          <pc:sldMk cId="2942563435" sldId="269"/>
        </pc:sldMkLst>
      </pc:sldChg>
    </pc:docChg>
  </pc:docChgLst>
  <pc:docChgLst>
    <pc:chgData name="Manasweeta Angane" userId="05da2731-9352-4b35-b713-60351f56afbd" providerId="ADAL" clId="{9DB0C637-5A51-4AF8-848B-0A876275EF09}"/>
    <pc:docChg chg="undo redo custSel addSld modSld">
      <pc:chgData name="Manasweeta Angane" userId="05da2731-9352-4b35-b713-60351f56afbd" providerId="ADAL" clId="{9DB0C637-5A51-4AF8-848B-0A876275EF09}" dt="2022-06-16T10:28:39.105" v="3464" actId="1037"/>
      <pc:docMkLst>
        <pc:docMk/>
      </pc:docMkLst>
      <pc:sldChg chg="addSp delSp modSp mod setBg">
        <pc:chgData name="Manasweeta Angane" userId="05da2731-9352-4b35-b713-60351f56afbd" providerId="ADAL" clId="{9DB0C637-5A51-4AF8-848B-0A876275EF09}" dt="2022-06-12T06:53:58.825" v="2441" actId="478"/>
        <pc:sldMkLst>
          <pc:docMk/>
          <pc:sldMk cId="2942563435" sldId="269"/>
        </pc:sldMkLst>
        <pc:spChg chg="add del mod">
          <ac:chgData name="Manasweeta Angane" userId="05da2731-9352-4b35-b713-60351f56afbd" providerId="ADAL" clId="{9DB0C637-5A51-4AF8-848B-0A876275EF09}" dt="2022-06-12T02:41:21.513" v="392" actId="478"/>
          <ac:spMkLst>
            <pc:docMk/>
            <pc:sldMk cId="2942563435" sldId="269"/>
            <ac:spMk id="3" creationId="{9461E6A0-F8A6-4182-8469-A25A6774F0D8}"/>
          </ac:spMkLst>
        </pc:spChg>
        <pc:spChg chg="add del mod">
          <ac:chgData name="Manasweeta Angane" userId="05da2731-9352-4b35-b713-60351f56afbd" providerId="ADAL" clId="{9DB0C637-5A51-4AF8-848B-0A876275EF09}" dt="2022-06-12T03:05:12.265" v="446" actId="478"/>
          <ac:spMkLst>
            <pc:docMk/>
            <pc:sldMk cId="2942563435" sldId="269"/>
            <ac:spMk id="5" creationId="{7A88EE25-160D-4861-A751-AB7E77FDF614}"/>
          </ac:spMkLst>
        </pc:spChg>
        <pc:spChg chg="add mod">
          <ac:chgData name="Manasweeta Angane" userId="05da2731-9352-4b35-b713-60351f56afbd" providerId="ADAL" clId="{9DB0C637-5A51-4AF8-848B-0A876275EF09}" dt="2022-06-12T03:36:48.927" v="772" actId="164"/>
          <ac:spMkLst>
            <pc:docMk/>
            <pc:sldMk cId="2942563435" sldId="269"/>
            <ac:spMk id="7" creationId="{ACF66282-DA63-4AA5-A67E-16B2F01D29BA}"/>
          </ac:spMkLst>
        </pc:spChg>
        <pc:spChg chg="add del">
          <ac:chgData name="Manasweeta Angane" userId="05da2731-9352-4b35-b713-60351f56afbd" providerId="ADAL" clId="{9DB0C637-5A51-4AF8-848B-0A876275EF09}" dt="2022-06-12T03:04:52.632" v="445" actId="478"/>
          <ac:spMkLst>
            <pc:docMk/>
            <pc:sldMk cId="2942563435" sldId="269"/>
            <ac:spMk id="8" creationId="{D9C70876-F297-4EB8-8382-FC868F618EF3}"/>
          </ac:spMkLst>
        </pc:spChg>
        <pc:spChg chg="mod">
          <ac:chgData name="Manasweeta Angane" userId="05da2731-9352-4b35-b713-60351f56afbd" providerId="ADAL" clId="{9DB0C637-5A51-4AF8-848B-0A876275EF09}" dt="2022-06-07T12:16:14.367" v="181"/>
          <ac:spMkLst>
            <pc:docMk/>
            <pc:sldMk cId="2942563435" sldId="269"/>
            <ac:spMk id="15" creationId="{B9F7D265-B06F-4E93-9234-D655656BD410}"/>
          </ac:spMkLst>
        </pc:spChg>
        <pc:spChg chg="add del mod">
          <ac:chgData name="Manasweeta Angane" userId="05da2731-9352-4b35-b713-60351f56afbd" providerId="ADAL" clId="{9DB0C637-5A51-4AF8-848B-0A876275EF09}" dt="2022-06-12T03:35:44.526" v="702" actId="478"/>
          <ac:spMkLst>
            <pc:docMk/>
            <pc:sldMk cId="2942563435" sldId="269"/>
            <ac:spMk id="17" creationId="{84DF76F2-CC89-4F57-8185-96CB495150BA}"/>
          </ac:spMkLst>
        </pc:spChg>
        <pc:spChg chg="mod">
          <ac:chgData name="Manasweeta Angane" userId="05da2731-9352-4b35-b713-60351f56afbd" providerId="ADAL" clId="{9DB0C637-5A51-4AF8-848B-0A876275EF09}" dt="2022-06-12T04:38:41.458" v="1135" actId="1076"/>
          <ac:spMkLst>
            <pc:docMk/>
            <pc:sldMk cId="2942563435" sldId="269"/>
            <ac:spMk id="29" creationId="{FC37E74B-D05E-4271-8B96-93BE34C68A1B}"/>
          </ac:spMkLst>
        </pc:spChg>
        <pc:spChg chg="mod">
          <ac:chgData name="Manasweeta Angane" userId="05da2731-9352-4b35-b713-60351f56afbd" providerId="ADAL" clId="{9DB0C637-5A51-4AF8-848B-0A876275EF09}" dt="2022-06-12T04:38:41.458" v="1135" actId="1076"/>
          <ac:spMkLst>
            <pc:docMk/>
            <pc:sldMk cId="2942563435" sldId="269"/>
            <ac:spMk id="30" creationId="{9C72C34F-D9A7-4C0D-8D0C-BD3B5ADC61FC}"/>
          </ac:spMkLst>
        </pc:spChg>
        <pc:spChg chg="add del mod topLvl">
          <ac:chgData name="Manasweeta Angane" userId="05da2731-9352-4b35-b713-60351f56afbd" providerId="ADAL" clId="{9DB0C637-5A51-4AF8-848B-0A876275EF09}" dt="2022-06-12T04:15:33.127" v="826" actId="164"/>
          <ac:spMkLst>
            <pc:docMk/>
            <pc:sldMk cId="2942563435" sldId="269"/>
            <ac:spMk id="32" creationId="{B3037B9B-68A8-40A3-8575-CBF15D6ADA0A}"/>
          </ac:spMkLst>
        </pc:spChg>
        <pc:spChg chg="add del mod topLvl">
          <ac:chgData name="Manasweeta Angane" userId="05da2731-9352-4b35-b713-60351f56afbd" providerId="ADAL" clId="{9DB0C637-5A51-4AF8-848B-0A876275EF09}" dt="2022-06-12T04:15:33.127" v="826" actId="164"/>
          <ac:spMkLst>
            <pc:docMk/>
            <pc:sldMk cId="2942563435" sldId="269"/>
            <ac:spMk id="34" creationId="{2C3F89CA-E735-4DEA-B063-50FFEF367FE5}"/>
          </ac:spMkLst>
        </pc:spChg>
        <pc:spChg chg="add del mod topLvl">
          <ac:chgData name="Manasweeta Angane" userId="05da2731-9352-4b35-b713-60351f56afbd" providerId="ADAL" clId="{9DB0C637-5A51-4AF8-848B-0A876275EF09}" dt="2022-06-12T04:15:33.127" v="826" actId="164"/>
          <ac:spMkLst>
            <pc:docMk/>
            <pc:sldMk cId="2942563435" sldId="269"/>
            <ac:spMk id="35" creationId="{121E2171-1CE3-4AC5-9130-B6A4079BD6F3}"/>
          </ac:spMkLst>
        </pc:spChg>
        <pc:spChg chg="mod">
          <ac:chgData name="Manasweeta Angane" userId="05da2731-9352-4b35-b713-60351f56afbd" providerId="ADAL" clId="{9DB0C637-5A51-4AF8-848B-0A876275EF09}" dt="2022-06-12T04:13:45.550" v="815" actId="165"/>
          <ac:spMkLst>
            <pc:docMk/>
            <pc:sldMk cId="2942563435" sldId="269"/>
            <ac:spMk id="37" creationId="{053E81BD-7A28-4857-A372-DD82E6718F9E}"/>
          </ac:spMkLst>
        </pc:spChg>
        <pc:spChg chg="mod">
          <ac:chgData name="Manasweeta Angane" userId="05da2731-9352-4b35-b713-60351f56afbd" providerId="ADAL" clId="{9DB0C637-5A51-4AF8-848B-0A876275EF09}" dt="2022-06-12T04:13:45.550" v="815" actId="165"/>
          <ac:spMkLst>
            <pc:docMk/>
            <pc:sldMk cId="2942563435" sldId="269"/>
            <ac:spMk id="38" creationId="{2C48063F-BCB6-4E22-A188-7B12802D1007}"/>
          </ac:spMkLst>
        </pc:spChg>
        <pc:spChg chg="mod topLvl">
          <ac:chgData name="Manasweeta Angane" userId="05da2731-9352-4b35-b713-60351f56afbd" providerId="ADAL" clId="{9DB0C637-5A51-4AF8-848B-0A876275EF09}" dt="2022-06-12T06:53:37.252" v="2438" actId="165"/>
          <ac:spMkLst>
            <pc:docMk/>
            <pc:sldMk cId="2942563435" sldId="269"/>
            <ac:spMk id="42" creationId="{9125F188-D551-44C3-8206-96EAA55D240D}"/>
          </ac:spMkLst>
        </pc:spChg>
        <pc:spChg chg="add del mod ord topLvl">
          <ac:chgData name="Manasweeta Angane" userId="05da2731-9352-4b35-b713-60351f56afbd" providerId="ADAL" clId="{9DB0C637-5A51-4AF8-848B-0A876275EF09}" dt="2022-06-12T06:53:37.252" v="2438" actId="165"/>
          <ac:spMkLst>
            <pc:docMk/>
            <pc:sldMk cId="2942563435" sldId="269"/>
            <ac:spMk id="44" creationId="{2808E333-5AF5-4EF5-A21A-DE4B9D01D2DA}"/>
          </ac:spMkLst>
        </pc:spChg>
        <pc:spChg chg="add del mod topLvl">
          <ac:chgData name="Manasweeta Angane" userId="05da2731-9352-4b35-b713-60351f56afbd" providerId="ADAL" clId="{9DB0C637-5A51-4AF8-848B-0A876275EF09}" dt="2022-06-12T05:47:33.503" v="1378" actId="478"/>
          <ac:spMkLst>
            <pc:docMk/>
            <pc:sldMk cId="2942563435" sldId="269"/>
            <ac:spMk id="45" creationId="{BF189ED8-92B8-42B3-A5F6-D79E0D4DA744}"/>
          </ac:spMkLst>
        </pc:spChg>
        <pc:spChg chg="mod">
          <ac:chgData name="Manasweeta Angane" userId="05da2731-9352-4b35-b713-60351f56afbd" providerId="ADAL" clId="{9DB0C637-5A51-4AF8-848B-0A876275EF09}" dt="2022-06-12T04:30:48.812" v="1074"/>
          <ac:spMkLst>
            <pc:docMk/>
            <pc:sldMk cId="2942563435" sldId="269"/>
            <ac:spMk id="47" creationId="{DB5DD4B4-9DBB-4702-9C90-3475F492E385}"/>
          </ac:spMkLst>
        </pc:spChg>
        <pc:spChg chg="mod">
          <ac:chgData name="Manasweeta Angane" userId="05da2731-9352-4b35-b713-60351f56afbd" providerId="ADAL" clId="{9DB0C637-5A51-4AF8-848B-0A876275EF09}" dt="2022-06-12T04:30:48.812" v="1074"/>
          <ac:spMkLst>
            <pc:docMk/>
            <pc:sldMk cId="2942563435" sldId="269"/>
            <ac:spMk id="49" creationId="{24A3C2A0-135D-4000-9A78-294BCE7C7B45}"/>
          </ac:spMkLst>
        </pc:spChg>
        <pc:spChg chg="mod">
          <ac:chgData name="Manasweeta Angane" userId="05da2731-9352-4b35-b713-60351f56afbd" providerId="ADAL" clId="{9DB0C637-5A51-4AF8-848B-0A876275EF09}" dt="2022-06-12T04:30:48.812" v="1074"/>
          <ac:spMkLst>
            <pc:docMk/>
            <pc:sldMk cId="2942563435" sldId="269"/>
            <ac:spMk id="50" creationId="{934359A4-EC80-4495-A62D-EC23A70D6B6A}"/>
          </ac:spMkLst>
        </pc:spChg>
        <pc:spChg chg="add del mod ord">
          <ac:chgData name="Manasweeta Angane" userId="05da2731-9352-4b35-b713-60351f56afbd" providerId="ADAL" clId="{9DB0C637-5A51-4AF8-848B-0A876275EF09}" dt="2022-06-12T04:39:37.194" v="1252"/>
          <ac:spMkLst>
            <pc:docMk/>
            <pc:sldMk cId="2942563435" sldId="269"/>
            <ac:spMk id="52" creationId="{AE9CCC24-AC92-418D-8205-1624F309DEF4}"/>
          </ac:spMkLst>
        </pc:spChg>
        <pc:spChg chg="mod">
          <ac:chgData name="Manasweeta Angane" userId="05da2731-9352-4b35-b713-60351f56afbd" providerId="ADAL" clId="{9DB0C637-5A51-4AF8-848B-0A876275EF09}" dt="2022-06-12T05:48:53.329" v="1442" actId="571"/>
          <ac:spMkLst>
            <pc:docMk/>
            <pc:sldMk cId="2942563435" sldId="269"/>
            <ac:spMk id="55" creationId="{B4D250C4-39F2-4BBC-A7DF-959562121F80}"/>
          </ac:spMkLst>
        </pc:spChg>
        <pc:spChg chg="mod">
          <ac:chgData name="Manasweeta Angane" userId="05da2731-9352-4b35-b713-60351f56afbd" providerId="ADAL" clId="{9DB0C637-5A51-4AF8-848B-0A876275EF09}" dt="2022-06-12T05:48:53.329" v="1442" actId="571"/>
          <ac:spMkLst>
            <pc:docMk/>
            <pc:sldMk cId="2942563435" sldId="269"/>
            <ac:spMk id="56" creationId="{B3EE0955-EFFE-4BF5-BB34-B9AE5F99F99E}"/>
          </ac:spMkLst>
        </pc:spChg>
        <pc:spChg chg="mod">
          <ac:chgData name="Manasweeta Angane" userId="05da2731-9352-4b35-b713-60351f56afbd" providerId="ADAL" clId="{9DB0C637-5A51-4AF8-848B-0A876275EF09}" dt="2022-06-12T06:53:37.252" v="2438" actId="165"/>
          <ac:spMkLst>
            <pc:docMk/>
            <pc:sldMk cId="2942563435" sldId="269"/>
            <ac:spMk id="62" creationId="{CC4DB37D-41C5-49E8-BE9A-1789FD39844A}"/>
          </ac:spMkLst>
        </pc:spChg>
        <pc:spChg chg="mod">
          <ac:chgData name="Manasweeta Angane" userId="05da2731-9352-4b35-b713-60351f56afbd" providerId="ADAL" clId="{9DB0C637-5A51-4AF8-848B-0A876275EF09}" dt="2022-06-12T06:53:37.252" v="2438" actId="165"/>
          <ac:spMkLst>
            <pc:docMk/>
            <pc:sldMk cId="2942563435" sldId="269"/>
            <ac:spMk id="63" creationId="{787BF382-F5CC-426B-9B0F-ED3285F21904}"/>
          </ac:spMkLst>
        </pc:spChg>
        <pc:spChg chg="mod">
          <ac:chgData name="Manasweeta Angane" userId="05da2731-9352-4b35-b713-60351f56afbd" providerId="ADAL" clId="{9DB0C637-5A51-4AF8-848B-0A876275EF09}" dt="2022-06-12T06:53:37.252" v="2438" actId="165"/>
          <ac:spMkLst>
            <pc:docMk/>
            <pc:sldMk cId="2942563435" sldId="269"/>
            <ac:spMk id="66" creationId="{36ABE25F-63DC-4DEB-AEC3-5DD8D0B3ABAC}"/>
          </ac:spMkLst>
        </pc:spChg>
        <pc:spChg chg="mod">
          <ac:chgData name="Manasweeta Angane" userId="05da2731-9352-4b35-b713-60351f56afbd" providerId="ADAL" clId="{9DB0C637-5A51-4AF8-848B-0A876275EF09}" dt="2022-06-12T06:53:37.252" v="2438" actId="165"/>
          <ac:spMkLst>
            <pc:docMk/>
            <pc:sldMk cId="2942563435" sldId="269"/>
            <ac:spMk id="72" creationId="{E3CE3B61-07D3-46BF-AC1F-F835E9EBA77F}"/>
          </ac:spMkLst>
        </pc:spChg>
        <pc:spChg chg="mod">
          <ac:chgData name="Manasweeta Angane" userId="05da2731-9352-4b35-b713-60351f56afbd" providerId="ADAL" clId="{9DB0C637-5A51-4AF8-848B-0A876275EF09}" dt="2022-06-12T06:53:37.252" v="2438" actId="165"/>
          <ac:spMkLst>
            <pc:docMk/>
            <pc:sldMk cId="2942563435" sldId="269"/>
            <ac:spMk id="73" creationId="{57A9B6BC-EDAF-4BB1-A62E-7BC9DA1337B7}"/>
          </ac:spMkLst>
        </pc:spChg>
        <pc:spChg chg="mod">
          <ac:chgData name="Manasweeta Angane" userId="05da2731-9352-4b35-b713-60351f56afbd" providerId="ADAL" clId="{9DB0C637-5A51-4AF8-848B-0A876275EF09}" dt="2022-06-12T06:31:36.123" v="2098" actId="165"/>
          <ac:spMkLst>
            <pc:docMk/>
            <pc:sldMk cId="2942563435" sldId="269"/>
            <ac:spMk id="102" creationId="{3733501F-E387-4E4C-8148-E6FC3B3BFB6D}"/>
          </ac:spMkLst>
        </pc:spChg>
        <pc:spChg chg="mod ord">
          <ac:chgData name="Manasweeta Angane" userId="05da2731-9352-4b35-b713-60351f56afbd" providerId="ADAL" clId="{9DB0C637-5A51-4AF8-848B-0A876275EF09}" dt="2022-06-12T06:53:37.252" v="2438" actId="165"/>
          <ac:spMkLst>
            <pc:docMk/>
            <pc:sldMk cId="2942563435" sldId="269"/>
            <ac:spMk id="104" creationId="{1FB1D634-1144-4112-B438-0A6D2439306A}"/>
          </ac:spMkLst>
        </pc:spChg>
        <pc:spChg chg="mod">
          <ac:chgData name="Manasweeta Angane" userId="05da2731-9352-4b35-b713-60351f56afbd" providerId="ADAL" clId="{9DB0C637-5A51-4AF8-848B-0A876275EF09}" dt="2022-06-12T06:53:37.252" v="2438" actId="165"/>
          <ac:spMkLst>
            <pc:docMk/>
            <pc:sldMk cId="2942563435" sldId="269"/>
            <ac:spMk id="105" creationId="{FDDEE1E4-BA17-4F63-A349-F65D3605C5C6}"/>
          </ac:spMkLst>
        </pc:spChg>
        <pc:grpChg chg="add mod">
          <ac:chgData name="Manasweeta Angane" userId="05da2731-9352-4b35-b713-60351f56afbd" providerId="ADAL" clId="{9DB0C637-5A51-4AF8-848B-0A876275EF09}" dt="2022-06-07T12:32:18.968" v="381" actId="14100"/>
          <ac:grpSpMkLst>
            <pc:docMk/>
            <pc:sldMk cId="2942563435" sldId="269"/>
            <ac:grpSpMk id="8" creationId="{B49938D0-205B-408A-B870-7A56930DD9E8}"/>
          </ac:grpSpMkLst>
        </pc:grpChg>
        <pc:grpChg chg="add del mod">
          <ac:chgData name="Manasweeta Angane" userId="05da2731-9352-4b35-b713-60351f56afbd" providerId="ADAL" clId="{9DB0C637-5A51-4AF8-848B-0A876275EF09}" dt="2022-06-07T12:16:16.461" v="182"/>
          <ac:grpSpMkLst>
            <pc:docMk/>
            <pc:sldMk cId="2942563435" sldId="269"/>
            <ac:grpSpMk id="13" creationId="{A3FAD09D-8D63-4318-AFA5-49AF28FCFD21}"/>
          </ac:grpSpMkLst>
        </pc:grpChg>
        <pc:grpChg chg="add del mod">
          <ac:chgData name="Manasweeta Angane" userId="05da2731-9352-4b35-b713-60351f56afbd" providerId="ADAL" clId="{9DB0C637-5A51-4AF8-848B-0A876275EF09}" dt="2022-06-12T05:49:26.911" v="1447" actId="478"/>
          <ac:grpSpMkLst>
            <pc:docMk/>
            <pc:sldMk cId="2942563435" sldId="269"/>
            <ac:grpSpMk id="18" creationId="{519A12B2-8EA0-4463-A4B1-1260B51FF929}"/>
          </ac:grpSpMkLst>
        </pc:grpChg>
        <pc:grpChg chg="add del mod">
          <ac:chgData name="Manasweeta Angane" userId="05da2731-9352-4b35-b713-60351f56afbd" providerId="ADAL" clId="{9DB0C637-5A51-4AF8-848B-0A876275EF09}" dt="2022-06-12T04:27:06.202" v="1045" actId="21"/>
          <ac:grpSpMkLst>
            <pc:docMk/>
            <pc:sldMk cId="2942563435" sldId="269"/>
            <ac:grpSpMk id="19" creationId="{C831DB5B-C1E3-4738-BC49-C4592133A817}"/>
          </ac:grpSpMkLst>
        </pc:grpChg>
        <pc:grpChg chg="add mod">
          <ac:chgData name="Manasweeta Angane" userId="05da2731-9352-4b35-b713-60351f56afbd" providerId="ADAL" clId="{9DB0C637-5A51-4AF8-848B-0A876275EF09}" dt="2022-06-12T06:53:37.252" v="2438" actId="165"/>
          <ac:grpSpMkLst>
            <pc:docMk/>
            <pc:sldMk cId="2942563435" sldId="269"/>
            <ac:grpSpMk id="21" creationId="{6F06EEB4-0750-4778-A118-4BEA82BD6E74}"/>
          </ac:grpSpMkLst>
        </pc:grpChg>
        <pc:grpChg chg="add mod topLvl">
          <ac:chgData name="Manasweeta Angane" userId="05da2731-9352-4b35-b713-60351f56afbd" providerId="ADAL" clId="{9DB0C637-5A51-4AF8-848B-0A876275EF09}" dt="2022-06-12T06:53:37.252" v="2438" actId="165"/>
          <ac:grpSpMkLst>
            <pc:docMk/>
            <pc:sldMk cId="2942563435" sldId="269"/>
            <ac:grpSpMk id="22" creationId="{069D0259-AB1B-42AB-B24D-48F1914D1FBA}"/>
          </ac:grpSpMkLst>
        </pc:grpChg>
        <pc:grpChg chg="add mod">
          <ac:chgData name="Manasweeta Angane" userId="05da2731-9352-4b35-b713-60351f56afbd" providerId="ADAL" clId="{9DB0C637-5A51-4AF8-848B-0A876275EF09}" dt="2022-06-12T06:00:54.723" v="1662" actId="164"/>
          <ac:grpSpMkLst>
            <pc:docMk/>
            <pc:sldMk cId="2942563435" sldId="269"/>
            <ac:grpSpMk id="24" creationId="{D163A13F-E590-4763-BA8F-B7A785FD91E1}"/>
          </ac:grpSpMkLst>
        </pc:grpChg>
        <pc:grpChg chg="add del mod">
          <ac:chgData name="Manasweeta Angane" userId="05da2731-9352-4b35-b713-60351f56afbd" providerId="ADAL" clId="{9DB0C637-5A51-4AF8-848B-0A876275EF09}" dt="2022-06-12T05:49:25.967" v="1446" actId="478"/>
          <ac:grpSpMkLst>
            <pc:docMk/>
            <pc:sldMk cId="2942563435" sldId="269"/>
            <ac:grpSpMk id="25" creationId="{8C467016-0770-4F99-89AD-82B6A7E61CDF}"/>
          </ac:grpSpMkLst>
        </pc:grpChg>
        <pc:grpChg chg="add del mod">
          <ac:chgData name="Manasweeta Angane" userId="05da2731-9352-4b35-b713-60351f56afbd" providerId="ADAL" clId="{9DB0C637-5A51-4AF8-848B-0A876275EF09}" dt="2022-06-12T04:13:45.550" v="815" actId="165"/>
          <ac:grpSpMkLst>
            <pc:docMk/>
            <pc:sldMk cId="2942563435" sldId="269"/>
            <ac:grpSpMk id="31" creationId="{4D4F6601-84DF-410B-91BD-8C192CC212B8}"/>
          </ac:grpSpMkLst>
        </pc:grpChg>
        <pc:grpChg chg="add del mod topLvl">
          <ac:chgData name="Manasweeta Angane" userId="05da2731-9352-4b35-b713-60351f56afbd" providerId="ADAL" clId="{9DB0C637-5A51-4AF8-848B-0A876275EF09}" dt="2022-06-12T04:13:58.357" v="819" actId="478"/>
          <ac:grpSpMkLst>
            <pc:docMk/>
            <pc:sldMk cId="2942563435" sldId="269"/>
            <ac:grpSpMk id="36" creationId="{DB81CC1C-229D-4EBA-97AD-2F40B614F448}"/>
          </ac:grpSpMkLst>
        </pc:grpChg>
        <pc:grpChg chg="add del mod topLvl">
          <ac:chgData name="Manasweeta Angane" userId="05da2731-9352-4b35-b713-60351f56afbd" providerId="ADAL" clId="{9DB0C637-5A51-4AF8-848B-0A876275EF09}" dt="2022-06-12T06:08:07.792" v="1823" actId="165"/>
          <ac:grpSpMkLst>
            <pc:docMk/>
            <pc:sldMk cId="2942563435" sldId="269"/>
            <ac:grpSpMk id="39" creationId="{B13F1BFC-9169-44AD-9478-B78705D766AA}"/>
          </ac:grpSpMkLst>
        </pc:grpChg>
        <pc:grpChg chg="add del mod">
          <ac:chgData name="Manasweeta Angane" userId="05da2731-9352-4b35-b713-60351f56afbd" providerId="ADAL" clId="{9DB0C637-5A51-4AF8-848B-0A876275EF09}" dt="2022-06-12T06:06:41.550" v="1806" actId="165"/>
          <ac:grpSpMkLst>
            <pc:docMk/>
            <pc:sldMk cId="2942563435" sldId="269"/>
            <ac:grpSpMk id="40" creationId="{F57A5585-0506-4A35-98DA-E2EAC72DD97D}"/>
          </ac:grpSpMkLst>
        </pc:grpChg>
        <pc:grpChg chg="add del mod ord">
          <ac:chgData name="Manasweeta Angane" userId="05da2731-9352-4b35-b713-60351f56afbd" providerId="ADAL" clId="{9DB0C637-5A51-4AF8-848B-0A876275EF09}" dt="2022-06-12T05:47:49.873" v="1380" actId="165"/>
          <ac:grpSpMkLst>
            <pc:docMk/>
            <pc:sldMk cId="2942563435" sldId="269"/>
            <ac:grpSpMk id="41" creationId="{E15B7DC1-6199-4986-AC25-E4433C49A7FB}"/>
          </ac:grpSpMkLst>
        </pc:grpChg>
        <pc:grpChg chg="add del mod">
          <ac:chgData name="Manasweeta Angane" userId="05da2731-9352-4b35-b713-60351f56afbd" providerId="ADAL" clId="{9DB0C637-5A51-4AF8-848B-0A876275EF09}" dt="2022-06-12T05:47:33.503" v="1378" actId="478"/>
          <ac:grpSpMkLst>
            <pc:docMk/>
            <pc:sldMk cId="2942563435" sldId="269"/>
            <ac:grpSpMk id="43" creationId="{1ECEC16E-4181-475D-B4A5-F3182D498D1A}"/>
          </ac:grpSpMkLst>
        </pc:grpChg>
        <pc:grpChg chg="add del mod">
          <ac:chgData name="Manasweeta Angane" userId="05da2731-9352-4b35-b713-60351f56afbd" providerId="ADAL" clId="{9DB0C637-5A51-4AF8-848B-0A876275EF09}" dt="2022-06-12T05:49:30.975" v="1451" actId="478"/>
          <ac:grpSpMkLst>
            <pc:docMk/>
            <pc:sldMk cId="2942563435" sldId="269"/>
            <ac:grpSpMk id="46" creationId="{8413E7FE-8B3C-47A2-B1E0-B3985699AE45}"/>
          </ac:grpSpMkLst>
        </pc:grpChg>
        <pc:grpChg chg="mod">
          <ac:chgData name="Manasweeta Angane" userId="05da2731-9352-4b35-b713-60351f56afbd" providerId="ADAL" clId="{9DB0C637-5A51-4AF8-848B-0A876275EF09}" dt="2022-06-12T04:30:48.812" v="1074"/>
          <ac:grpSpMkLst>
            <pc:docMk/>
            <pc:sldMk cId="2942563435" sldId="269"/>
            <ac:grpSpMk id="48" creationId="{CD764A61-8590-45FC-AF3F-3FDE1B19C462}"/>
          </ac:grpSpMkLst>
        </pc:grpChg>
        <pc:grpChg chg="add del mod">
          <ac:chgData name="Manasweeta Angane" userId="05da2731-9352-4b35-b713-60351f56afbd" providerId="ADAL" clId="{9DB0C637-5A51-4AF8-848B-0A876275EF09}" dt="2022-06-12T06:09:34.272" v="1834" actId="165"/>
          <ac:grpSpMkLst>
            <pc:docMk/>
            <pc:sldMk cId="2942563435" sldId="269"/>
            <ac:grpSpMk id="53" creationId="{C1A6B43B-6114-4593-8CA5-1E74F61D9FB9}"/>
          </ac:grpSpMkLst>
        </pc:grpChg>
        <pc:grpChg chg="add mod">
          <ac:chgData name="Manasweeta Angane" userId="05da2731-9352-4b35-b713-60351f56afbd" providerId="ADAL" clId="{9DB0C637-5A51-4AF8-848B-0A876275EF09}" dt="2022-06-12T05:48:53.329" v="1442" actId="571"/>
          <ac:grpSpMkLst>
            <pc:docMk/>
            <pc:sldMk cId="2942563435" sldId="269"/>
            <ac:grpSpMk id="54" creationId="{1CE2B3D9-E0B1-43BB-8289-F68B0AE74907}"/>
          </ac:grpSpMkLst>
        </pc:grpChg>
        <pc:grpChg chg="add mod topLvl">
          <ac:chgData name="Manasweeta Angane" userId="05da2731-9352-4b35-b713-60351f56afbd" providerId="ADAL" clId="{9DB0C637-5A51-4AF8-848B-0A876275EF09}" dt="2022-06-12T06:53:37.252" v="2438" actId="165"/>
          <ac:grpSpMkLst>
            <pc:docMk/>
            <pc:sldMk cId="2942563435" sldId="269"/>
            <ac:grpSpMk id="57" creationId="{32A7EF28-B540-461A-9F18-D608DD509516}"/>
          </ac:grpSpMkLst>
        </pc:grpChg>
        <pc:grpChg chg="add del mod">
          <ac:chgData name="Manasweeta Angane" userId="05da2731-9352-4b35-b713-60351f56afbd" providerId="ADAL" clId="{9DB0C637-5A51-4AF8-848B-0A876275EF09}" dt="2022-06-12T05:55:21.199" v="1643" actId="478"/>
          <ac:grpSpMkLst>
            <pc:docMk/>
            <pc:sldMk cId="2942563435" sldId="269"/>
            <ac:grpSpMk id="58" creationId="{447CC2D7-698D-4CED-86CB-31F8711DD95F}"/>
          </ac:grpSpMkLst>
        </pc:grpChg>
        <pc:grpChg chg="mod topLvl">
          <ac:chgData name="Manasweeta Angane" userId="05da2731-9352-4b35-b713-60351f56afbd" providerId="ADAL" clId="{9DB0C637-5A51-4AF8-848B-0A876275EF09}" dt="2022-06-12T06:53:37.252" v="2438" actId="165"/>
          <ac:grpSpMkLst>
            <pc:docMk/>
            <pc:sldMk cId="2942563435" sldId="269"/>
            <ac:grpSpMk id="59" creationId="{355C1A43-B73B-4884-8F67-F53CB2C386C8}"/>
          </ac:grpSpMkLst>
        </pc:grpChg>
        <pc:grpChg chg="add mod topLvl">
          <ac:chgData name="Manasweeta Angane" userId="05da2731-9352-4b35-b713-60351f56afbd" providerId="ADAL" clId="{9DB0C637-5A51-4AF8-848B-0A876275EF09}" dt="2022-06-12T06:53:37.252" v="2438" actId="165"/>
          <ac:grpSpMkLst>
            <pc:docMk/>
            <pc:sldMk cId="2942563435" sldId="269"/>
            <ac:grpSpMk id="64" creationId="{EBB26CE0-CE52-4D74-9F78-DD11B8461C82}"/>
          </ac:grpSpMkLst>
        </pc:grpChg>
        <pc:grpChg chg="add mod topLvl">
          <ac:chgData name="Manasweeta Angane" userId="05da2731-9352-4b35-b713-60351f56afbd" providerId="ADAL" clId="{9DB0C637-5A51-4AF8-848B-0A876275EF09}" dt="2022-06-12T06:53:37.252" v="2438" actId="165"/>
          <ac:grpSpMkLst>
            <pc:docMk/>
            <pc:sldMk cId="2942563435" sldId="269"/>
            <ac:grpSpMk id="68" creationId="{F3A67821-5F44-4655-AD18-B7FA09299227}"/>
          </ac:grpSpMkLst>
        </pc:grpChg>
        <pc:grpChg chg="add del mod">
          <ac:chgData name="Manasweeta Angane" userId="05da2731-9352-4b35-b713-60351f56afbd" providerId="ADAL" clId="{9DB0C637-5A51-4AF8-848B-0A876275EF09}" dt="2022-06-12T06:26:16.799" v="2030" actId="165"/>
          <ac:grpSpMkLst>
            <pc:docMk/>
            <pc:sldMk cId="2942563435" sldId="269"/>
            <ac:grpSpMk id="74" creationId="{79D6B3A0-401D-4C1D-86C0-9C66DE623F50}"/>
          </ac:grpSpMkLst>
        </pc:grpChg>
        <pc:grpChg chg="add mod ord">
          <ac:chgData name="Manasweeta Angane" userId="05da2731-9352-4b35-b713-60351f56afbd" providerId="ADAL" clId="{9DB0C637-5A51-4AF8-848B-0A876275EF09}" dt="2022-06-12T06:53:37.252" v="2438" actId="165"/>
          <ac:grpSpMkLst>
            <pc:docMk/>
            <pc:sldMk cId="2942563435" sldId="269"/>
            <ac:grpSpMk id="88" creationId="{D4F8A790-9FD6-49D1-B885-3C73094F80A6}"/>
          </ac:grpSpMkLst>
        </pc:grpChg>
        <pc:grpChg chg="add mod">
          <ac:chgData name="Manasweeta Angane" userId="05da2731-9352-4b35-b713-60351f56afbd" providerId="ADAL" clId="{9DB0C637-5A51-4AF8-848B-0A876275EF09}" dt="2022-06-12T06:42:15.398" v="2264" actId="338"/>
          <ac:grpSpMkLst>
            <pc:docMk/>
            <pc:sldMk cId="2942563435" sldId="269"/>
            <ac:grpSpMk id="89" creationId="{91F7E34D-70AC-44E5-8A77-1662E5EB8985}"/>
          </ac:grpSpMkLst>
        </pc:grpChg>
        <pc:grpChg chg="add mod topLvl">
          <ac:chgData name="Manasweeta Angane" userId="05da2731-9352-4b35-b713-60351f56afbd" providerId="ADAL" clId="{9DB0C637-5A51-4AF8-848B-0A876275EF09}" dt="2022-06-12T06:53:37.252" v="2438" actId="165"/>
          <ac:grpSpMkLst>
            <pc:docMk/>
            <pc:sldMk cId="2942563435" sldId="269"/>
            <ac:grpSpMk id="90" creationId="{2B057F1E-4E5F-4D1D-B0D6-7787B0EFC9DD}"/>
          </ac:grpSpMkLst>
        </pc:grpChg>
        <pc:grpChg chg="add del mod">
          <ac:chgData name="Manasweeta Angane" userId="05da2731-9352-4b35-b713-60351f56afbd" providerId="ADAL" clId="{9DB0C637-5A51-4AF8-848B-0A876275EF09}" dt="2022-06-12T06:53:37.252" v="2438" actId="165"/>
          <ac:grpSpMkLst>
            <pc:docMk/>
            <pc:sldMk cId="2942563435" sldId="269"/>
            <ac:grpSpMk id="92" creationId="{FDA0F0C9-D173-4B8C-A970-942BDF219E46}"/>
          </ac:grpSpMkLst>
        </pc:grpChg>
        <pc:grpChg chg="add del mod">
          <ac:chgData name="Manasweeta Angane" userId="05da2731-9352-4b35-b713-60351f56afbd" providerId="ADAL" clId="{9DB0C637-5A51-4AF8-848B-0A876275EF09}" dt="2022-06-12T06:31:36.123" v="2098" actId="165"/>
          <ac:grpSpMkLst>
            <pc:docMk/>
            <pc:sldMk cId="2942563435" sldId="269"/>
            <ac:grpSpMk id="95" creationId="{E891EC14-1C9C-4A66-8A50-86752C1BF668}"/>
          </ac:grpSpMkLst>
        </pc:grpChg>
        <pc:grpChg chg="mod topLvl">
          <ac:chgData name="Manasweeta Angane" userId="05da2731-9352-4b35-b713-60351f56afbd" providerId="ADAL" clId="{9DB0C637-5A51-4AF8-848B-0A876275EF09}" dt="2022-06-12T06:53:37.252" v="2438" actId="165"/>
          <ac:grpSpMkLst>
            <pc:docMk/>
            <pc:sldMk cId="2942563435" sldId="269"/>
            <ac:grpSpMk id="96" creationId="{09DB888B-5911-4D60-915B-3FB925B87A46}"/>
          </ac:grpSpMkLst>
        </pc:grpChg>
        <pc:grpChg chg="del mod topLvl">
          <ac:chgData name="Manasweeta Angane" userId="05da2731-9352-4b35-b713-60351f56afbd" providerId="ADAL" clId="{9DB0C637-5A51-4AF8-848B-0A876275EF09}" dt="2022-06-12T06:31:39.769" v="2099" actId="478"/>
          <ac:grpSpMkLst>
            <pc:docMk/>
            <pc:sldMk cId="2942563435" sldId="269"/>
            <ac:grpSpMk id="97" creationId="{F9182395-BE6B-4F6B-BD0C-18826CF235BC}"/>
          </ac:grpSpMkLst>
        </pc:grpChg>
        <pc:graphicFrameChg chg="add del mod modGraphic">
          <ac:chgData name="Manasweeta Angane" userId="05da2731-9352-4b35-b713-60351f56afbd" providerId="ADAL" clId="{9DB0C637-5A51-4AF8-848B-0A876275EF09}" dt="2022-06-12T02:51:15.344" v="396" actId="478"/>
          <ac:graphicFrameMkLst>
            <pc:docMk/>
            <pc:sldMk cId="2942563435" sldId="269"/>
            <ac:graphicFrameMk id="2" creationId="{1343E550-F5B1-417D-938B-C8EE27CEAED0}"/>
          </ac:graphicFrameMkLst>
        </pc:graphicFrameChg>
        <pc:graphicFrameChg chg="add mod modGraphic">
          <ac:chgData name="Manasweeta Angane" userId="05da2731-9352-4b35-b713-60351f56afbd" providerId="ADAL" clId="{9DB0C637-5A51-4AF8-848B-0A876275EF09}" dt="2022-06-12T03:36:48.927" v="772" actId="164"/>
          <ac:graphicFrameMkLst>
            <pc:docMk/>
            <pc:sldMk cId="2942563435" sldId="269"/>
            <ac:graphicFrameMk id="9" creationId="{37FE6962-AFEC-4665-A02F-AF37CD0998BD}"/>
          </ac:graphicFrameMkLst>
        </pc:graphicFrameChg>
        <pc:graphicFrameChg chg="add del mod modGraphic">
          <ac:chgData name="Manasweeta Angane" userId="05da2731-9352-4b35-b713-60351f56afbd" providerId="ADAL" clId="{9DB0C637-5A51-4AF8-848B-0A876275EF09}" dt="2022-06-12T03:35:45.518" v="703" actId="478"/>
          <ac:graphicFrameMkLst>
            <pc:docMk/>
            <pc:sldMk cId="2942563435" sldId="269"/>
            <ac:graphicFrameMk id="10" creationId="{013B1272-A15E-4D0B-8146-8D5CDE476A80}"/>
          </ac:graphicFrameMkLst>
        </pc:graphicFrameChg>
        <pc:graphicFrameChg chg="add del mod">
          <ac:chgData name="Manasweeta Angane" userId="05da2731-9352-4b35-b713-60351f56afbd" providerId="ADAL" clId="{9DB0C637-5A51-4AF8-848B-0A876275EF09}" dt="2022-06-12T03:07:13.225" v="458" actId="478"/>
          <ac:graphicFrameMkLst>
            <pc:docMk/>
            <pc:sldMk cId="2942563435" sldId="269"/>
            <ac:graphicFrameMk id="14" creationId="{DB57A617-7896-4667-9511-1B00D4147643}"/>
          </ac:graphicFrameMkLst>
        </pc:graphicFrameChg>
        <pc:graphicFrameChg chg="add del mod">
          <ac:chgData name="Manasweeta Angane" userId="05da2731-9352-4b35-b713-60351f56afbd" providerId="ADAL" clId="{9DB0C637-5A51-4AF8-848B-0A876275EF09}" dt="2022-06-12T03:35:50.253" v="705" actId="478"/>
          <ac:graphicFrameMkLst>
            <pc:docMk/>
            <pc:sldMk cId="2942563435" sldId="269"/>
            <ac:graphicFrameMk id="15" creationId="{A66F6140-DFE4-4FD6-9A77-6C6D1954A254}"/>
          </ac:graphicFrameMkLst>
        </pc:graphicFrameChg>
        <pc:graphicFrameChg chg="add del mod">
          <ac:chgData name="Manasweeta Angane" userId="05da2731-9352-4b35-b713-60351f56afbd" providerId="ADAL" clId="{9DB0C637-5A51-4AF8-848B-0A876275EF09}" dt="2022-06-12T03:09:06.090" v="467" actId="478"/>
          <ac:graphicFrameMkLst>
            <pc:docMk/>
            <pc:sldMk cId="2942563435" sldId="269"/>
            <ac:graphicFrameMk id="16" creationId="{C983646F-94AF-411A-AE8E-4DDBD942468A}"/>
          </ac:graphicFrameMkLst>
        </pc:graphicFrameChg>
        <pc:graphicFrameChg chg="add del mod modGraphic">
          <ac:chgData name="Manasweeta Angane" userId="05da2731-9352-4b35-b713-60351f56afbd" providerId="ADAL" clId="{9DB0C637-5A51-4AF8-848B-0A876275EF09}" dt="2022-06-12T04:27:01.159" v="1044" actId="478"/>
          <ac:graphicFrameMkLst>
            <pc:docMk/>
            <pc:sldMk cId="2942563435" sldId="269"/>
            <ac:graphicFrameMk id="20" creationId="{4D136612-C6A5-4B83-BBC1-D734EB8C928D}"/>
          </ac:graphicFrameMkLst>
        </pc:graphicFrameChg>
        <pc:graphicFrameChg chg="mod">
          <ac:chgData name="Manasweeta Angane" userId="05da2731-9352-4b35-b713-60351f56afbd" providerId="ADAL" clId="{9DB0C637-5A51-4AF8-848B-0A876275EF09}" dt="2022-06-12T06:53:37.252" v="2438" actId="165"/>
          <ac:graphicFrameMkLst>
            <pc:docMk/>
            <pc:sldMk cId="2942563435" sldId="269"/>
            <ac:graphicFrameMk id="67" creationId="{53640C11-6B8C-4EA4-958B-65E47B72EEBD}"/>
          </ac:graphicFrameMkLst>
        </pc:graphicFrameChg>
        <pc:graphicFrameChg chg="add mod">
          <ac:chgData name="Manasweeta Angane" userId="05da2731-9352-4b35-b713-60351f56afbd" providerId="ADAL" clId="{9DB0C637-5A51-4AF8-848B-0A876275EF09}" dt="2022-06-12T06:48:31.942" v="2331" actId="1076"/>
          <ac:graphicFrameMkLst>
            <pc:docMk/>
            <pc:sldMk cId="2942563435" sldId="269"/>
            <ac:graphicFrameMk id="91" creationId="{692223E4-6AA9-47F4-8738-CF0F1ABCA849}"/>
          </ac:graphicFrameMkLst>
        </pc:graphicFrameChg>
        <pc:graphicFrameChg chg="mod">
          <ac:chgData name="Manasweeta Angane" userId="05da2731-9352-4b35-b713-60351f56afbd" providerId="ADAL" clId="{9DB0C637-5A51-4AF8-848B-0A876275EF09}" dt="2022-06-12T06:31:36.123" v="2098" actId="165"/>
          <ac:graphicFrameMkLst>
            <pc:docMk/>
            <pc:sldMk cId="2942563435" sldId="269"/>
            <ac:graphicFrameMk id="103" creationId="{D8C24FA6-DC94-4E0C-A057-05A51210780B}"/>
          </ac:graphicFrameMkLst>
        </pc:graphicFrameChg>
        <pc:picChg chg="del">
          <ac:chgData name="Manasweeta Angane" userId="05da2731-9352-4b35-b713-60351f56afbd" providerId="ADAL" clId="{9DB0C637-5A51-4AF8-848B-0A876275EF09}" dt="2022-06-07T12:18:28.689" v="197" actId="478"/>
          <ac:picMkLst>
            <pc:docMk/>
            <pc:sldMk cId="2942563435" sldId="269"/>
            <ac:picMk id="2" creationId="{EE50FD0A-DAFD-42F7-AFFB-C0C9B49C08DE}"/>
          </ac:picMkLst>
        </pc:picChg>
        <pc:picChg chg="del mod">
          <ac:chgData name="Manasweeta Angane" userId="05da2731-9352-4b35-b713-60351f56afbd" providerId="ADAL" clId="{9DB0C637-5A51-4AF8-848B-0A876275EF09}" dt="2022-06-07T12:18:30.823" v="199" actId="478"/>
          <ac:picMkLst>
            <pc:docMk/>
            <pc:sldMk cId="2942563435" sldId="269"/>
            <ac:picMk id="3" creationId="{510FBE95-2CDD-4E1B-951A-DFA3ED6C0FD1}"/>
          </ac:picMkLst>
        </pc:picChg>
        <pc:picChg chg="add del mod">
          <ac:chgData name="Manasweeta Angane" userId="05da2731-9352-4b35-b713-60351f56afbd" providerId="ADAL" clId="{9DB0C637-5A51-4AF8-848B-0A876275EF09}" dt="2022-06-12T03:35:42.829" v="701" actId="478"/>
          <ac:picMkLst>
            <pc:docMk/>
            <pc:sldMk cId="2942563435" sldId="269"/>
            <ac:picMk id="4" creationId="{A38FE211-A961-4CF8-9EF3-7F75C63CFBA4}"/>
          </ac:picMkLst>
        </pc:picChg>
        <pc:picChg chg="del mod">
          <ac:chgData name="Manasweeta Angane" userId="05da2731-9352-4b35-b713-60351f56afbd" providerId="ADAL" clId="{9DB0C637-5A51-4AF8-848B-0A876275EF09}" dt="2022-06-07T12:18:29.661" v="198" actId="478"/>
          <ac:picMkLst>
            <pc:docMk/>
            <pc:sldMk cId="2942563435" sldId="269"/>
            <ac:picMk id="5" creationId="{116E5255-09DC-44EA-8C2C-BD33D8BAF1DF}"/>
          </ac:picMkLst>
        </pc:picChg>
        <pc:picChg chg="add mod">
          <ac:chgData name="Manasweeta Angane" userId="05da2731-9352-4b35-b713-60351f56afbd" providerId="ADAL" clId="{9DB0C637-5A51-4AF8-848B-0A876275EF09}" dt="2022-06-12T04:16:52.750" v="885" actId="1036"/>
          <ac:picMkLst>
            <pc:docMk/>
            <pc:sldMk cId="2942563435" sldId="269"/>
            <ac:picMk id="6" creationId="{874E6535-A81B-41C3-8618-5E72016A79BA}"/>
          </ac:picMkLst>
        </pc:picChg>
        <pc:picChg chg="del mod ord">
          <ac:chgData name="Manasweeta Angane" userId="05da2731-9352-4b35-b713-60351f56afbd" providerId="ADAL" clId="{9DB0C637-5A51-4AF8-848B-0A876275EF09}" dt="2022-06-12T05:49:29.375" v="1450" actId="478"/>
          <ac:picMkLst>
            <pc:docMk/>
            <pc:sldMk cId="2942563435" sldId="269"/>
            <ac:picMk id="11" creationId="{0F3DD18D-64CF-B728-1223-51DD88F6A088}"/>
          </ac:picMkLst>
        </pc:picChg>
        <pc:picChg chg="add del mod">
          <ac:chgData name="Manasweeta Angane" userId="05da2731-9352-4b35-b713-60351f56afbd" providerId="ADAL" clId="{9DB0C637-5A51-4AF8-848B-0A876275EF09}" dt="2022-06-07T12:18:27.556" v="196" actId="478"/>
          <ac:picMkLst>
            <pc:docMk/>
            <pc:sldMk cId="2942563435" sldId="269"/>
            <ac:picMk id="11" creationId="{B545896D-C959-4C03-BFE2-7DB3B0DEFC07}"/>
          </ac:picMkLst>
        </pc:picChg>
        <pc:picChg chg="del mod">
          <ac:chgData name="Manasweeta Angane" userId="05da2731-9352-4b35-b713-60351f56afbd" providerId="ADAL" clId="{9DB0C637-5A51-4AF8-848B-0A876275EF09}" dt="2022-06-12T05:49:28.623" v="1449" actId="478"/>
          <ac:picMkLst>
            <pc:docMk/>
            <pc:sldMk cId="2942563435" sldId="269"/>
            <ac:picMk id="12" creationId="{ED6AF8BF-9805-DAE4-F29A-E5886A3BA6F4}"/>
          </ac:picMkLst>
        </pc:picChg>
        <pc:picChg chg="del mod ord">
          <ac:chgData name="Manasweeta Angane" userId="05da2731-9352-4b35-b713-60351f56afbd" providerId="ADAL" clId="{9DB0C637-5A51-4AF8-848B-0A876275EF09}" dt="2022-06-12T05:49:27.983" v="1448" actId="478"/>
          <ac:picMkLst>
            <pc:docMk/>
            <pc:sldMk cId="2942563435" sldId="269"/>
            <ac:picMk id="13" creationId="{C8584449-B3DF-EB19-09EB-A1B5C2D3CECC}"/>
          </ac:picMkLst>
        </pc:picChg>
        <pc:picChg chg="mod">
          <ac:chgData name="Manasweeta Angane" userId="05da2731-9352-4b35-b713-60351f56afbd" providerId="ADAL" clId="{9DB0C637-5A51-4AF8-848B-0A876275EF09}" dt="2022-06-07T12:16:14.367" v="181"/>
          <ac:picMkLst>
            <pc:docMk/>
            <pc:sldMk cId="2942563435" sldId="269"/>
            <ac:picMk id="14" creationId="{ABE640EA-244E-4361-86F0-FD18A0ACF79B}"/>
          </ac:picMkLst>
        </pc:picChg>
        <pc:picChg chg="add del mod">
          <ac:chgData name="Manasweeta Angane" userId="05da2731-9352-4b35-b713-60351f56afbd" providerId="ADAL" clId="{9DB0C637-5A51-4AF8-848B-0A876275EF09}" dt="2022-06-12T03:35:48.926" v="704" actId="478"/>
          <ac:picMkLst>
            <pc:docMk/>
            <pc:sldMk cId="2942563435" sldId="269"/>
            <ac:picMk id="23" creationId="{22A303D1-D6A5-4F80-8F59-6FDDB720844D}"/>
          </ac:picMkLst>
        </pc:picChg>
        <pc:picChg chg="mod">
          <ac:chgData name="Manasweeta Angane" userId="05da2731-9352-4b35-b713-60351f56afbd" providerId="ADAL" clId="{9DB0C637-5A51-4AF8-848B-0A876275EF09}" dt="2022-06-12T04:38:41.458" v="1135" actId="1076"/>
          <ac:picMkLst>
            <pc:docMk/>
            <pc:sldMk cId="2942563435" sldId="269"/>
            <ac:picMk id="26" creationId="{9DB5B930-29CF-4AB3-90F3-59CF9D9EFD33}"/>
          </ac:picMkLst>
        </pc:picChg>
        <pc:picChg chg="mod">
          <ac:chgData name="Manasweeta Angane" userId="05da2731-9352-4b35-b713-60351f56afbd" providerId="ADAL" clId="{9DB0C637-5A51-4AF8-848B-0A876275EF09}" dt="2022-06-12T04:38:41.458" v="1135" actId="1076"/>
          <ac:picMkLst>
            <pc:docMk/>
            <pc:sldMk cId="2942563435" sldId="269"/>
            <ac:picMk id="27" creationId="{04F40808-E1E8-402F-A00F-C4FF92472716}"/>
          </ac:picMkLst>
        </pc:picChg>
        <pc:picChg chg="mod">
          <ac:chgData name="Manasweeta Angane" userId="05da2731-9352-4b35-b713-60351f56afbd" providerId="ADAL" clId="{9DB0C637-5A51-4AF8-848B-0A876275EF09}" dt="2022-06-12T04:38:41.458" v="1135" actId="1076"/>
          <ac:picMkLst>
            <pc:docMk/>
            <pc:sldMk cId="2942563435" sldId="269"/>
            <ac:picMk id="28" creationId="{34E81630-E536-4D16-87A1-2D6250075370}"/>
          </ac:picMkLst>
        </pc:picChg>
        <pc:picChg chg="add del mod topLvl">
          <ac:chgData name="Manasweeta Angane" userId="05da2731-9352-4b35-b713-60351f56afbd" providerId="ADAL" clId="{9DB0C637-5A51-4AF8-848B-0A876275EF09}" dt="2022-06-12T04:13:55.652" v="818" actId="478"/>
          <ac:picMkLst>
            <pc:docMk/>
            <pc:sldMk cId="2942563435" sldId="269"/>
            <ac:picMk id="33" creationId="{141DC3BB-99B3-4911-9C09-66EC385606A5}"/>
          </ac:picMkLst>
        </pc:picChg>
        <pc:picChg chg="add mod">
          <ac:chgData name="Manasweeta Angane" userId="05da2731-9352-4b35-b713-60351f56afbd" providerId="ADAL" clId="{9DB0C637-5A51-4AF8-848B-0A876275EF09}" dt="2022-06-12T06:53:37.252" v="2438" actId="165"/>
          <ac:picMkLst>
            <pc:docMk/>
            <pc:sldMk cId="2942563435" sldId="269"/>
            <ac:picMk id="51" creationId="{4263E31F-E179-4155-844D-3925ED8701A0}"/>
          </ac:picMkLst>
        </pc:picChg>
        <pc:picChg chg="del mod">
          <ac:chgData name="Manasweeta Angane" userId="05da2731-9352-4b35-b713-60351f56afbd" providerId="ADAL" clId="{9DB0C637-5A51-4AF8-848B-0A876275EF09}" dt="2022-06-12T05:53:01.955" v="1618" actId="478"/>
          <ac:picMkLst>
            <pc:docMk/>
            <pc:sldMk cId="2942563435" sldId="269"/>
            <ac:picMk id="60" creationId="{63D45281-9B97-4B83-A880-E2EA5B4B428D}"/>
          </ac:picMkLst>
        </pc:picChg>
        <pc:picChg chg="add del mod">
          <ac:chgData name="Manasweeta Angane" userId="05da2731-9352-4b35-b713-60351f56afbd" providerId="ADAL" clId="{9DB0C637-5A51-4AF8-848B-0A876275EF09}" dt="2022-06-12T05:55:21.199" v="1643" actId="478"/>
          <ac:picMkLst>
            <pc:docMk/>
            <pc:sldMk cId="2942563435" sldId="269"/>
            <ac:picMk id="61" creationId="{947C84DC-24DF-47D8-B90A-27BE9611618C}"/>
          </ac:picMkLst>
        </pc:picChg>
        <pc:picChg chg="mod">
          <ac:chgData name="Manasweeta Angane" userId="05da2731-9352-4b35-b713-60351f56afbd" providerId="ADAL" clId="{9DB0C637-5A51-4AF8-848B-0A876275EF09}" dt="2022-06-12T06:53:37.252" v="2438" actId="165"/>
          <ac:picMkLst>
            <pc:docMk/>
            <pc:sldMk cId="2942563435" sldId="269"/>
            <ac:picMk id="65" creationId="{CF58F6E4-A4F3-4DAF-896D-70DA30A9E6A7}"/>
          </ac:picMkLst>
        </pc:picChg>
        <pc:picChg chg="mod">
          <ac:chgData name="Manasweeta Angane" userId="05da2731-9352-4b35-b713-60351f56afbd" providerId="ADAL" clId="{9DB0C637-5A51-4AF8-848B-0A876275EF09}" dt="2022-06-12T06:53:37.252" v="2438" actId="165"/>
          <ac:picMkLst>
            <pc:docMk/>
            <pc:sldMk cId="2942563435" sldId="269"/>
            <ac:picMk id="69" creationId="{E30A9DA0-0574-4D53-BCC2-5A0DB16FABE3}"/>
          </ac:picMkLst>
        </pc:picChg>
        <pc:picChg chg="mod">
          <ac:chgData name="Manasweeta Angane" userId="05da2731-9352-4b35-b713-60351f56afbd" providerId="ADAL" clId="{9DB0C637-5A51-4AF8-848B-0A876275EF09}" dt="2022-06-12T06:53:37.252" v="2438" actId="165"/>
          <ac:picMkLst>
            <pc:docMk/>
            <pc:sldMk cId="2942563435" sldId="269"/>
            <ac:picMk id="70" creationId="{DDA8056A-655E-4819-98D0-A027A537A31D}"/>
          </ac:picMkLst>
        </pc:picChg>
        <pc:picChg chg="mod">
          <ac:chgData name="Manasweeta Angane" userId="05da2731-9352-4b35-b713-60351f56afbd" providerId="ADAL" clId="{9DB0C637-5A51-4AF8-848B-0A876275EF09}" dt="2022-06-12T06:53:37.252" v="2438" actId="165"/>
          <ac:picMkLst>
            <pc:docMk/>
            <pc:sldMk cId="2942563435" sldId="269"/>
            <ac:picMk id="71" creationId="{84690B64-1FE6-4BE7-B5F2-7604DAAAD836}"/>
          </ac:picMkLst>
        </pc:picChg>
        <pc:picChg chg="add del mod modCrop">
          <ac:chgData name="Manasweeta Angane" userId="05da2731-9352-4b35-b713-60351f56afbd" providerId="ADAL" clId="{9DB0C637-5A51-4AF8-848B-0A876275EF09}" dt="2022-06-12T06:21:34.775" v="2006" actId="478"/>
          <ac:picMkLst>
            <pc:docMk/>
            <pc:sldMk cId="2942563435" sldId="269"/>
            <ac:picMk id="76" creationId="{D787E2B9-E8FA-404A-88C4-AB5DA3258267}"/>
          </ac:picMkLst>
        </pc:picChg>
        <pc:picChg chg="add mod topLvl">
          <ac:chgData name="Manasweeta Angane" userId="05da2731-9352-4b35-b713-60351f56afbd" providerId="ADAL" clId="{9DB0C637-5A51-4AF8-848B-0A876275EF09}" dt="2022-06-12T06:53:37.252" v="2438" actId="165"/>
          <ac:picMkLst>
            <pc:docMk/>
            <pc:sldMk cId="2942563435" sldId="269"/>
            <ac:picMk id="77" creationId="{4B693F6C-4EFB-4904-9169-60EB952A3033}"/>
          </ac:picMkLst>
        </pc:picChg>
        <pc:picChg chg="add mod topLvl">
          <ac:chgData name="Manasweeta Angane" userId="05da2731-9352-4b35-b713-60351f56afbd" providerId="ADAL" clId="{9DB0C637-5A51-4AF8-848B-0A876275EF09}" dt="2022-06-12T06:53:37.252" v="2438" actId="165"/>
          <ac:picMkLst>
            <pc:docMk/>
            <pc:sldMk cId="2942563435" sldId="269"/>
            <ac:picMk id="78" creationId="{0331A042-666F-44FC-8ACF-7210DA11C303}"/>
          </ac:picMkLst>
        </pc:picChg>
        <pc:picChg chg="add mod topLvl">
          <ac:chgData name="Manasweeta Angane" userId="05da2731-9352-4b35-b713-60351f56afbd" providerId="ADAL" clId="{9DB0C637-5A51-4AF8-848B-0A876275EF09}" dt="2022-06-12T06:53:37.252" v="2438" actId="165"/>
          <ac:picMkLst>
            <pc:docMk/>
            <pc:sldMk cId="2942563435" sldId="269"/>
            <ac:picMk id="79" creationId="{2CFA76D1-EE3C-4080-A4B8-188405E52973}"/>
          </ac:picMkLst>
        </pc:picChg>
        <pc:picChg chg="add mod modCrop">
          <ac:chgData name="Manasweeta Angane" userId="05da2731-9352-4b35-b713-60351f56afbd" providerId="ADAL" clId="{9DB0C637-5A51-4AF8-848B-0A876275EF09}" dt="2022-06-12T06:53:37.252" v="2438" actId="165"/>
          <ac:picMkLst>
            <pc:docMk/>
            <pc:sldMk cId="2942563435" sldId="269"/>
            <ac:picMk id="81" creationId="{A5BDBDAB-6A01-42AA-A8FE-338FB3955417}"/>
          </ac:picMkLst>
        </pc:picChg>
        <pc:picChg chg="add del mod">
          <ac:chgData name="Manasweeta Angane" userId="05da2731-9352-4b35-b713-60351f56afbd" providerId="ADAL" clId="{9DB0C637-5A51-4AF8-848B-0A876275EF09}" dt="2022-06-12T06:24:08.360" v="2019" actId="478"/>
          <ac:picMkLst>
            <pc:docMk/>
            <pc:sldMk cId="2942563435" sldId="269"/>
            <ac:picMk id="83" creationId="{D1E4444F-BCDC-4F8A-967D-55AC00EB3E2E}"/>
          </ac:picMkLst>
        </pc:picChg>
        <pc:picChg chg="add del">
          <ac:chgData name="Manasweeta Angane" userId="05da2731-9352-4b35-b713-60351f56afbd" providerId="ADAL" clId="{9DB0C637-5A51-4AF8-848B-0A876275EF09}" dt="2022-06-12T06:24:45.801" v="2022" actId="478"/>
          <ac:picMkLst>
            <pc:docMk/>
            <pc:sldMk cId="2942563435" sldId="269"/>
            <ac:picMk id="85" creationId="{9668754A-E818-4DEC-841D-224D28C3E5BA}"/>
          </ac:picMkLst>
        </pc:picChg>
        <pc:picChg chg="add mod">
          <ac:chgData name="Manasweeta Angane" userId="05da2731-9352-4b35-b713-60351f56afbd" providerId="ADAL" clId="{9DB0C637-5A51-4AF8-848B-0A876275EF09}" dt="2022-06-12T06:53:37.252" v="2438" actId="165"/>
          <ac:picMkLst>
            <pc:docMk/>
            <pc:sldMk cId="2942563435" sldId="269"/>
            <ac:picMk id="87" creationId="{FFF0AC6F-26C5-4E72-954E-234422FB8D45}"/>
          </ac:picMkLst>
        </pc:picChg>
        <pc:picChg chg="add del mod">
          <ac:chgData name="Manasweeta Angane" userId="05da2731-9352-4b35-b713-60351f56afbd" providerId="ADAL" clId="{9DB0C637-5A51-4AF8-848B-0A876275EF09}" dt="2022-06-12T06:35:21.214" v="2134" actId="478"/>
          <ac:picMkLst>
            <pc:docMk/>
            <pc:sldMk cId="2942563435" sldId="269"/>
            <ac:picMk id="94" creationId="{51E37D7F-79E7-4CE6-AE21-2AF08F73F76A}"/>
          </ac:picMkLst>
        </pc:picChg>
        <pc:picChg chg="del mod topLvl">
          <ac:chgData name="Manasweeta Angane" userId="05da2731-9352-4b35-b713-60351f56afbd" providerId="ADAL" clId="{9DB0C637-5A51-4AF8-848B-0A876275EF09}" dt="2022-06-12T06:31:41.901" v="2101" actId="478"/>
          <ac:picMkLst>
            <pc:docMk/>
            <pc:sldMk cId="2942563435" sldId="269"/>
            <ac:picMk id="98" creationId="{AAF02B21-216D-41B6-9504-9DEFAA0BF343}"/>
          </ac:picMkLst>
        </pc:picChg>
        <pc:picChg chg="del mod topLvl">
          <ac:chgData name="Manasweeta Angane" userId="05da2731-9352-4b35-b713-60351f56afbd" providerId="ADAL" clId="{9DB0C637-5A51-4AF8-848B-0A876275EF09}" dt="2022-06-12T06:31:42.781" v="2102" actId="478"/>
          <ac:picMkLst>
            <pc:docMk/>
            <pc:sldMk cId="2942563435" sldId="269"/>
            <ac:picMk id="99" creationId="{C9EF8C21-7403-4078-8BB0-C9AA943533BA}"/>
          </ac:picMkLst>
        </pc:picChg>
        <pc:picChg chg="del mod topLvl">
          <ac:chgData name="Manasweeta Angane" userId="05da2731-9352-4b35-b713-60351f56afbd" providerId="ADAL" clId="{9DB0C637-5A51-4AF8-848B-0A876275EF09}" dt="2022-06-12T06:31:40.988" v="2100" actId="478"/>
          <ac:picMkLst>
            <pc:docMk/>
            <pc:sldMk cId="2942563435" sldId="269"/>
            <ac:picMk id="100" creationId="{17064E25-5BA4-4144-9CA2-98C9F7DCC46C}"/>
          </ac:picMkLst>
        </pc:picChg>
        <pc:picChg chg="mod">
          <ac:chgData name="Manasweeta Angane" userId="05da2731-9352-4b35-b713-60351f56afbd" providerId="ADAL" clId="{9DB0C637-5A51-4AF8-848B-0A876275EF09}" dt="2022-06-12T06:31:36.123" v="2098" actId="165"/>
          <ac:picMkLst>
            <pc:docMk/>
            <pc:sldMk cId="2942563435" sldId="269"/>
            <ac:picMk id="101" creationId="{2130484D-A4D9-4E9A-8AEE-5E4737E647A3}"/>
          </ac:picMkLst>
        </pc:picChg>
        <pc:picChg chg="add del mod">
          <ac:chgData name="Manasweeta Angane" userId="05da2731-9352-4b35-b713-60351f56afbd" providerId="ADAL" clId="{9DB0C637-5A51-4AF8-848B-0A876275EF09}" dt="2022-06-12T06:53:58.825" v="2441" actId="478"/>
          <ac:picMkLst>
            <pc:docMk/>
            <pc:sldMk cId="2942563435" sldId="269"/>
            <ac:picMk id="110" creationId="{6C1C1E56-1399-4BD8-B43C-08181604FC56}"/>
          </ac:picMkLst>
        </pc:picChg>
        <pc:picChg chg="add del mod">
          <ac:chgData name="Manasweeta Angane" userId="05da2731-9352-4b35-b713-60351f56afbd" providerId="ADAL" clId="{9DB0C637-5A51-4AF8-848B-0A876275EF09}" dt="2022-06-07T12:18:01.967" v="193" actId="478"/>
          <ac:picMkLst>
            <pc:docMk/>
            <pc:sldMk cId="2942563435" sldId="269"/>
            <ac:picMk id="1026" creationId="{20E97E50-9F96-4467-BF1B-415D82D28229}"/>
          </ac:picMkLst>
        </pc:picChg>
        <pc:picChg chg="add del mod">
          <ac:chgData name="Manasweeta Angane" userId="05da2731-9352-4b35-b713-60351f56afbd" providerId="ADAL" clId="{9DB0C637-5A51-4AF8-848B-0A876275EF09}" dt="2022-06-12T03:38:16.285" v="786" actId="478"/>
          <ac:picMkLst>
            <pc:docMk/>
            <pc:sldMk cId="2942563435" sldId="269"/>
            <ac:picMk id="1026" creationId="{3FAAB11B-7BAA-4286-BAD1-4B6E285A9C3F}"/>
          </ac:picMkLst>
        </pc:picChg>
        <pc:picChg chg="add del mod">
          <ac:chgData name="Manasweeta Angane" userId="05da2731-9352-4b35-b713-60351f56afbd" providerId="ADAL" clId="{9DB0C637-5A51-4AF8-848B-0A876275EF09}" dt="2022-06-12T03:35:54.845" v="707" actId="478"/>
          <ac:picMkLst>
            <pc:docMk/>
            <pc:sldMk cId="2942563435" sldId="269"/>
            <ac:picMk id="1028" creationId="{EFFAC93C-329D-4C38-BBE0-5A7455662851}"/>
          </ac:picMkLst>
        </pc:picChg>
        <pc:picChg chg="add del mod">
          <ac:chgData name="Manasweeta Angane" userId="05da2731-9352-4b35-b713-60351f56afbd" providerId="ADAL" clId="{9DB0C637-5A51-4AF8-848B-0A876275EF09}" dt="2022-06-07T12:25:23.604" v="229" actId="21"/>
          <ac:picMkLst>
            <pc:docMk/>
            <pc:sldMk cId="2942563435" sldId="269"/>
            <ac:picMk id="1030" creationId="{4792039F-2077-4D70-924E-26CAD3FFB313}"/>
          </ac:picMkLst>
        </pc:picChg>
        <pc:picChg chg="add del mod">
          <ac:chgData name="Manasweeta Angane" userId="05da2731-9352-4b35-b713-60351f56afbd" providerId="ADAL" clId="{9DB0C637-5A51-4AF8-848B-0A876275EF09}" dt="2022-06-12T03:35:54.077" v="706" actId="478"/>
          <ac:picMkLst>
            <pc:docMk/>
            <pc:sldMk cId="2942563435" sldId="269"/>
            <ac:picMk id="1032" creationId="{99474CAB-F966-436F-B692-4E5E730E7212}"/>
          </ac:picMkLst>
        </pc:picChg>
        <pc:picChg chg="add mod">
          <ac:chgData name="Manasweeta Angane" userId="05da2731-9352-4b35-b713-60351f56afbd" providerId="ADAL" clId="{9DB0C637-5A51-4AF8-848B-0A876275EF09}" dt="2022-06-07T12:25:59.522" v="233" actId="1076"/>
          <ac:picMkLst>
            <pc:docMk/>
            <pc:sldMk cId="2942563435" sldId="269"/>
            <ac:picMk id="1034" creationId="{3E6DF42D-CF2B-4856-8653-284239E14632}"/>
          </ac:picMkLst>
        </pc:picChg>
        <pc:picChg chg="add mod">
          <ac:chgData name="Manasweeta Angane" userId="05da2731-9352-4b35-b713-60351f56afbd" providerId="ADAL" clId="{9DB0C637-5A51-4AF8-848B-0A876275EF09}" dt="2022-06-12T06:53:37.252" v="2438" actId="165"/>
          <ac:picMkLst>
            <pc:docMk/>
            <pc:sldMk cId="2942563435" sldId="269"/>
            <ac:picMk id="1036" creationId="{1D8EE2AA-F50C-4A4C-8964-F14F928562B3}"/>
          </ac:picMkLst>
        </pc:picChg>
        <pc:picChg chg="add del mod">
          <ac:chgData name="Manasweeta Angane" userId="05da2731-9352-4b35-b713-60351f56afbd" providerId="ADAL" clId="{9DB0C637-5A51-4AF8-848B-0A876275EF09}" dt="2022-06-07T12:26:54.193" v="244"/>
          <ac:picMkLst>
            <pc:docMk/>
            <pc:sldMk cId="2942563435" sldId="269"/>
            <ac:picMk id="1038" creationId="{503A446B-73DF-4420-A876-63F8283E73A7}"/>
          </ac:picMkLst>
        </pc:picChg>
        <pc:picChg chg="add del mod">
          <ac:chgData name="Manasweeta Angane" userId="05da2731-9352-4b35-b713-60351f56afbd" providerId="ADAL" clId="{9DB0C637-5A51-4AF8-848B-0A876275EF09}" dt="2022-06-12T04:34:24.650" v="1111" actId="21"/>
          <ac:picMkLst>
            <pc:docMk/>
            <pc:sldMk cId="2942563435" sldId="269"/>
            <ac:picMk id="1040" creationId="{E07DEFC9-931C-4FD2-912E-6D069C6D6C48}"/>
          </ac:picMkLst>
        </pc:picChg>
      </pc:sldChg>
      <pc:sldChg chg="addSp delSp modSp new mod">
        <pc:chgData name="Manasweeta Angane" userId="05da2731-9352-4b35-b713-60351f56afbd" providerId="ADAL" clId="{9DB0C637-5A51-4AF8-848B-0A876275EF09}" dt="2022-06-12T04:26:40.784" v="1043" actId="167"/>
        <pc:sldMkLst>
          <pc:docMk/>
          <pc:sldMk cId="3166259601" sldId="272"/>
        </pc:sldMkLst>
        <pc:spChg chg="add del mod">
          <ac:chgData name="Manasweeta Angane" userId="05da2731-9352-4b35-b713-60351f56afbd" providerId="ADAL" clId="{9DB0C637-5A51-4AF8-848B-0A876275EF09}" dt="2022-06-12T03:01:16.022" v="424"/>
          <ac:spMkLst>
            <pc:docMk/>
            <pc:sldMk cId="3166259601" sldId="272"/>
            <ac:spMk id="2" creationId="{8EFED15F-E1A1-4C19-8249-AAFA6A2EA397}"/>
          </ac:spMkLst>
        </pc:spChg>
        <pc:spChg chg="add del mod ord">
          <ac:chgData name="Manasweeta Angane" userId="05da2731-9352-4b35-b713-60351f56afbd" providerId="ADAL" clId="{9DB0C637-5A51-4AF8-848B-0A876275EF09}" dt="2022-06-12T03:34:18.814" v="693" actId="478"/>
          <ac:spMkLst>
            <pc:docMk/>
            <pc:sldMk cId="3166259601" sldId="272"/>
            <ac:spMk id="3" creationId="{6F1C66BE-85FB-4A7F-8F97-A7D44ABC886F}"/>
          </ac:spMkLst>
        </pc:spChg>
        <pc:spChg chg="add del mod">
          <ac:chgData name="Manasweeta Angane" userId="05da2731-9352-4b35-b713-60351f56afbd" providerId="ADAL" clId="{9DB0C637-5A51-4AF8-848B-0A876275EF09}" dt="2022-06-12T03:34:18.814" v="693" actId="478"/>
          <ac:spMkLst>
            <pc:docMk/>
            <pc:sldMk cId="3166259601" sldId="272"/>
            <ac:spMk id="4" creationId="{36E5342B-1CF7-4E21-9E22-F7AE9CD5B6DF}"/>
          </ac:spMkLst>
        </pc:spChg>
        <pc:spChg chg="add mod topLvl">
          <ac:chgData name="Manasweeta Angane" userId="05da2731-9352-4b35-b713-60351f56afbd" providerId="ADAL" clId="{9DB0C637-5A51-4AF8-848B-0A876275EF09}" dt="2022-06-12T04:26:02.830" v="1037" actId="1076"/>
          <ac:spMkLst>
            <pc:docMk/>
            <pc:sldMk cId="3166259601" sldId="272"/>
            <ac:spMk id="5" creationId="{E86B19AE-1B3F-4A36-9161-DFEC126BADDE}"/>
          </ac:spMkLst>
        </pc:spChg>
        <pc:spChg chg="add del mod ord">
          <ac:chgData name="Manasweeta Angane" userId="05da2731-9352-4b35-b713-60351f56afbd" providerId="ADAL" clId="{9DB0C637-5A51-4AF8-848B-0A876275EF09}" dt="2022-06-12T03:30:00.765" v="625" actId="478"/>
          <ac:spMkLst>
            <pc:docMk/>
            <pc:sldMk cId="3166259601" sldId="272"/>
            <ac:spMk id="6" creationId="{E0286CF6-C5E2-4B3C-998E-FED9B829BBC7}"/>
          </ac:spMkLst>
        </pc:spChg>
        <pc:spChg chg="add mod topLvl">
          <ac:chgData name="Manasweeta Angane" userId="05da2731-9352-4b35-b713-60351f56afbd" providerId="ADAL" clId="{9DB0C637-5A51-4AF8-848B-0A876275EF09}" dt="2022-06-12T04:26:02.830" v="1037" actId="1076"/>
          <ac:spMkLst>
            <pc:docMk/>
            <pc:sldMk cId="3166259601" sldId="272"/>
            <ac:spMk id="11" creationId="{E245B3FD-DD24-4C97-A6A2-85C1FD6BA4F6}"/>
          </ac:spMkLst>
        </pc:spChg>
        <pc:spChg chg="add mod">
          <ac:chgData name="Manasweeta Angane" userId="05da2731-9352-4b35-b713-60351f56afbd" providerId="ADAL" clId="{9DB0C637-5A51-4AF8-848B-0A876275EF09}" dt="2022-06-12T04:23:52.424" v="952"/>
          <ac:spMkLst>
            <pc:docMk/>
            <pc:sldMk cId="3166259601" sldId="272"/>
            <ac:spMk id="15" creationId="{29E9A8EF-4DA1-4308-8A50-727164723146}"/>
          </ac:spMkLst>
        </pc:spChg>
        <pc:spChg chg="add mod">
          <ac:chgData name="Manasweeta Angane" userId="05da2731-9352-4b35-b713-60351f56afbd" providerId="ADAL" clId="{9DB0C637-5A51-4AF8-848B-0A876275EF09}" dt="2022-06-12T04:23:52.424" v="952"/>
          <ac:spMkLst>
            <pc:docMk/>
            <pc:sldMk cId="3166259601" sldId="272"/>
            <ac:spMk id="16" creationId="{12F04974-8A84-46F9-BF6D-D7F1EE3B83E2}"/>
          </ac:spMkLst>
        </pc:spChg>
        <pc:spChg chg="add mod">
          <ac:chgData name="Manasweeta Angane" userId="05da2731-9352-4b35-b713-60351f56afbd" providerId="ADAL" clId="{9DB0C637-5A51-4AF8-848B-0A876275EF09}" dt="2022-06-12T04:24:26.248" v="956" actId="164"/>
          <ac:spMkLst>
            <pc:docMk/>
            <pc:sldMk cId="3166259601" sldId="272"/>
            <ac:spMk id="17" creationId="{EFDCC705-3C65-474D-A8DA-379ABFEE4DFA}"/>
          </ac:spMkLst>
        </pc:spChg>
        <pc:spChg chg="add mod">
          <ac:chgData name="Manasweeta Angane" userId="05da2731-9352-4b35-b713-60351f56afbd" providerId="ADAL" clId="{9DB0C637-5A51-4AF8-848B-0A876275EF09}" dt="2022-06-12T04:24:11.469" v="953"/>
          <ac:spMkLst>
            <pc:docMk/>
            <pc:sldMk cId="3166259601" sldId="272"/>
            <ac:spMk id="19" creationId="{2383202C-7EF7-4135-83CF-98C3CC297CD9}"/>
          </ac:spMkLst>
        </pc:spChg>
        <pc:spChg chg="add mod">
          <ac:chgData name="Manasweeta Angane" userId="05da2731-9352-4b35-b713-60351f56afbd" providerId="ADAL" clId="{9DB0C637-5A51-4AF8-848B-0A876275EF09}" dt="2022-06-12T04:24:11.469" v="953"/>
          <ac:spMkLst>
            <pc:docMk/>
            <pc:sldMk cId="3166259601" sldId="272"/>
            <ac:spMk id="20" creationId="{84D3FF3E-DDAD-4814-AD9C-D2E64EF28CAF}"/>
          </ac:spMkLst>
        </pc:spChg>
        <pc:spChg chg="mod">
          <ac:chgData name="Manasweeta Angane" userId="05da2731-9352-4b35-b713-60351f56afbd" providerId="ADAL" clId="{9DB0C637-5A51-4AF8-848B-0A876275EF09}" dt="2022-06-12T04:24:39.851" v="957"/>
          <ac:spMkLst>
            <pc:docMk/>
            <pc:sldMk cId="3166259601" sldId="272"/>
            <ac:spMk id="23" creationId="{1FBBA1FB-3564-4482-BE80-D4C5D6B05CDB}"/>
          </ac:spMkLst>
        </pc:spChg>
        <pc:spChg chg="mod">
          <ac:chgData name="Manasweeta Angane" userId="05da2731-9352-4b35-b713-60351f56afbd" providerId="ADAL" clId="{9DB0C637-5A51-4AF8-848B-0A876275EF09}" dt="2022-06-12T04:24:39.851" v="957"/>
          <ac:spMkLst>
            <pc:docMk/>
            <pc:sldMk cId="3166259601" sldId="272"/>
            <ac:spMk id="25" creationId="{7CADB8B8-10CF-4B5A-944B-32970A1B0087}"/>
          </ac:spMkLst>
        </pc:spChg>
        <pc:spChg chg="mod">
          <ac:chgData name="Manasweeta Angane" userId="05da2731-9352-4b35-b713-60351f56afbd" providerId="ADAL" clId="{9DB0C637-5A51-4AF8-848B-0A876275EF09}" dt="2022-06-12T04:24:39.851" v="957"/>
          <ac:spMkLst>
            <pc:docMk/>
            <pc:sldMk cId="3166259601" sldId="272"/>
            <ac:spMk id="26" creationId="{FDFF1143-CE9E-4BBD-999B-3252F3D41A95}"/>
          </ac:spMkLst>
        </pc:spChg>
        <pc:spChg chg="add mod">
          <ac:chgData name="Manasweeta Angane" userId="05da2731-9352-4b35-b713-60351f56afbd" providerId="ADAL" clId="{9DB0C637-5A51-4AF8-848B-0A876275EF09}" dt="2022-06-12T04:25:21.735" v="963"/>
          <ac:spMkLst>
            <pc:docMk/>
            <pc:sldMk cId="3166259601" sldId="272"/>
            <ac:spMk id="29" creationId="{B1353B46-C6BD-4BD0-A7BE-6B77617F65C3}"/>
          </ac:spMkLst>
        </pc:spChg>
        <pc:spChg chg="add mod">
          <ac:chgData name="Manasweeta Angane" userId="05da2731-9352-4b35-b713-60351f56afbd" providerId="ADAL" clId="{9DB0C637-5A51-4AF8-848B-0A876275EF09}" dt="2022-06-12T04:25:21.735" v="963"/>
          <ac:spMkLst>
            <pc:docMk/>
            <pc:sldMk cId="3166259601" sldId="272"/>
            <ac:spMk id="30" creationId="{9F759D6F-3441-44E9-89B8-6869ACCB2012}"/>
          </ac:spMkLst>
        </pc:spChg>
        <pc:spChg chg="add mod">
          <ac:chgData name="Manasweeta Angane" userId="05da2731-9352-4b35-b713-60351f56afbd" providerId="ADAL" clId="{9DB0C637-5A51-4AF8-848B-0A876275EF09}" dt="2022-06-12T04:26:29.241" v="1041" actId="164"/>
          <ac:spMkLst>
            <pc:docMk/>
            <pc:sldMk cId="3166259601" sldId="272"/>
            <ac:spMk id="31" creationId="{A08403DF-07CD-4BE8-99B5-DEBB0104E9D9}"/>
          </ac:spMkLst>
        </pc:spChg>
        <pc:spChg chg="add mod">
          <ac:chgData name="Manasweeta Angane" userId="05da2731-9352-4b35-b713-60351f56afbd" providerId="ADAL" clId="{9DB0C637-5A51-4AF8-848B-0A876275EF09}" dt="2022-06-12T04:25:34.750" v="966"/>
          <ac:spMkLst>
            <pc:docMk/>
            <pc:sldMk cId="3166259601" sldId="272"/>
            <ac:spMk id="33" creationId="{AB42DC89-725E-495B-890A-172B65C37FD3}"/>
          </ac:spMkLst>
        </pc:spChg>
        <pc:spChg chg="add mod">
          <ac:chgData name="Manasweeta Angane" userId="05da2731-9352-4b35-b713-60351f56afbd" providerId="ADAL" clId="{9DB0C637-5A51-4AF8-848B-0A876275EF09}" dt="2022-06-12T04:25:34.750" v="966"/>
          <ac:spMkLst>
            <pc:docMk/>
            <pc:sldMk cId="3166259601" sldId="272"/>
            <ac:spMk id="34" creationId="{BE079476-3233-465B-8F66-383747A7F814}"/>
          </ac:spMkLst>
        </pc:spChg>
        <pc:grpChg chg="add del mod">
          <ac:chgData name="Manasweeta Angane" userId="05da2731-9352-4b35-b713-60351f56afbd" providerId="ADAL" clId="{9DB0C637-5A51-4AF8-848B-0A876275EF09}" dt="2022-06-12T03:37:38.623" v="778" actId="165"/>
          <ac:grpSpMkLst>
            <pc:docMk/>
            <pc:sldMk cId="3166259601" sldId="272"/>
            <ac:grpSpMk id="9" creationId="{4A5FABA2-E98D-4BF5-8E98-65F83917AA32}"/>
          </ac:grpSpMkLst>
        </pc:grpChg>
        <pc:grpChg chg="add mod">
          <ac:chgData name="Manasweeta Angane" userId="05da2731-9352-4b35-b713-60351f56afbd" providerId="ADAL" clId="{9DB0C637-5A51-4AF8-848B-0A876275EF09}" dt="2022-06-12T04:26:02.830" v="1037" actId="1076"/>
          <ac:grpSpMkLst>
            <pc:docMk/>
            <pc:sldMk cId="3166259601" sldId="272"/>
            <ac:grpSpMk id="10" creationId="{C8AF8E7C-CBA8-4727-8232-DD569239DDC0}"/>
          </ac:grpSpMkLst>
        </pc:grpChg>
        <pc:grpChg chg="add mod">
          <ac:chgData name="Manasweeta Angane" userId="05da2731-9352-4b35-b713-60351f56afbd" providerId="ADAL" clId="{9DB0C637-5A51-4AF8-848B-0A876275EF09}" dt="2022-06-12T04:25:48.791" v="1034" actId="1076"/>
          <ac:grpSpMkLst>
            <pc:docMk/>
            <pc:sldMk cId="3166259601" sldId="272"/>
            <ac:grpSpMk id="12" creationId="{F1E38553-5971-4020-885B-133D6B4CBB85}"/>
          </ac:grpSpMkLst>
        </pc:grpChg>
        <pc:grpChg chg="add mod ord">
          <ac:chgData name="Manasweeta Angane" userId="05da2731-9352-4b35-b713-60351f56afbd" providerId="ADAL" clId="{9DB0C637-5A51-4AF8-848B-0A876275EF09}" dt="2022-06-12T04:26:40.784" v="1043" actId="167"/>
          <ac:grpSpMkLst>
            <pc:docMk/>
            <pc:sldMk cId="3166259601" sldId="272"/>
            <ac:grpSpMk id="13" creationId="{20B897BC-7865-427B-B360-70BFA993D555}"/>
          </ac:grpSpMkLst>
        </pc:grpChg>
        <pc:grpChg chg="add mod">
          <ac:chgData name="Manasweeta Angane" userId="05da2731-9352-4b35-b713-60351f56afbd" providerId="ADAL" clId="{9DB0C637-5A51-4AF8-848B-0A876275EF09}" dt="2022-06-12T04:23:52.424" v="952"/>
          <ac:grpSpMkLst>
            <pc:docMk/>
            <pc:sldMk cId="3166259601" sldId="272"/>
            <ac:grpSpMk id="14" creationId="{B06CC452-7E63-4D3A-97F1-B955FFEE3E3A}"/>
          </ac:grpSpMkLst>
        </pc:grpChg>
        <pc:grpChg chg="add mod">
          <ac:chgData name="Manasweeta Angane" userId="05da2731-9352-4b35-b713-60351f56afbd" providerId="ADAL" clId="{9DB0C637-5A51-4AF8-848B-0A876275EF09}" dt="2022-06-12T04:24:26.248" v="956" actId="164"/>
          <ac:grpSpMkLst>
            <pc:docMk/>
            <pc:sldMk cId="3166259601" sldId="272"/>
            <ac:grpSpMk id="18" creationId="{E43756ED-ABF4-44A9-8CB7-383BB3DCA0A6}"/>
          </ac:grpSpMkLst>
        </pc:grpChg>
        <pc:grpChg chg="add mod ord">
          <ac:chgData name="Manasweeta Angane" userId="05da2731-9352-4b35-b713-60351f56afbd" providerId="ADAL" clId="{9DB0C637-5A51-4AF8-848B-0A876275EF09}" dt="2022-06-12T04:25:57.728" v="1036" actId="167"/>
          <ac:grpSpMkLst>
            <pc:docMk/>
            <pc:sldMk cId="3166259601" sldId="272"/>
            <ac:grpSpMk id="22" creationId="{15866070-FC73-4768-97B1-A0F656EA2279}"/>
          </ac:grpSpMkLst>
        </pc:grpChg>
        <pc:grpChg chg="mod">
          <ac:chgData name="Manasweeta Angane" userId="05da2731-9352-4b35-b713-60351f56afbd" providerId="ADAL" clId="{9DB0C637-5A51-4AF8-848B-0A876275EF09}" dt="2022-06-12T04:24:39.851" v="957"/>
          <ac:grpSpMkLst>
            <pc:docMk/>
            <pc:sldMk cId="3166259601" sldId="272"/>
            <ac:grpSpMk id="24" creationId="{A056554F-5FC1-4159-8B9A-839C4093D1D9}"/>
          </ac:grpSpMkLst>
        </pc:grpChg>
        <pc:grpChg chg="add mod">
          <ac:chgData name="Manasweeta Angane" userId="05da2731-9352-4b35-b713-60351f56afbd" providerId="ADAL" clId="{9DB0C637-5A51-4AF8-848B-0A876275EF09}" dt="2022-06-12T04:25:21.735" v="963"/>
          <ac:grpSpMkLst>
            <pc:docMk/>
            <pc:sldMk cId="3166259601" sldId="272"/>
            <ac:grpSpMk id="28" creationId="{872DED2E-C11C-4CFE-B98F-ABE4FE4544D5}"/>
          </ac:grpSpMkLst>
        </pc:grpChg>
        <pc:grpChg chg="add mod">
          <ac:chgData name="Manasweeta Angane" userId="05da2731-9352-4b35-b713-60351f56afbd" providerId="ADAL" clId="{9DB0C637-5A51-4AF8-848B-0A876275EF09}" dt="2022-06-12T04:26:29.241" v="1041" actId="164"/>
          <ac:grpSpMkLst>
            <pc:docMk/>
            <pc:sldMk cId="3166259601" sldId="272"/>
            <ac:grpSpMk id="32" creationId="{B04870F5-6F7B-4AC1-B7CF-3D000EEE3089}"/>
          </ac:grpSpMkLst>
        </pc:grpChg>
        <pc:graphicFrameChg chg="add del mod">
          <ac:chgData name="Manasweeta Angane" userId="05da2731-9352-4b35-b713-60351f56afbd" providerId="ADAL" clId="{9DB0C637-5A51-4AF8-848B-0A876275EF09}" dt="2022-06-12T04:25:24.888" v="964"/>
          <ac:graphicFrameMkLst>
            <pc:docMk/>
            <pc:sldMk cId="3166259601" sldId="272"/>
            <ac:graphicFrameMk id="27" creationId="{577AE599-1504-49A3-9907-447739C9A2C1}"/>
          </ac:graphicFrameMkLst>
        </pc:graphicFrameChg>
        <pc:picChg chg="add mod topLvl">
          <ac:chgData name="Manasweeta Angane" userId="05da2731-9352-4b35-b713-60351f56afbd" providerId="ADAL" clId="{9DB0C637-5A51-4AF8-848B-0A876275EF09}" dt="2022-06-12T04:26:02.830" v="1037" actId="1076"/>
          <ac:picMkLst>
            <pc:docMk/>
            <pc:sldMk cId="3166259601" sldId="272"/>
            <ac:picMk id="7" creationId="{B81BF43F-DCE3-4686-8D6F-64025B546144}"/>
          </ac:picMkLst>
        </pc:picChg>
        <pc:picChg chg="add mod topLvl">
          <ac:chgData name="Manasweeta Angane" userId="05da2731-9352-4b35-b713-60351f56afbd" providerId="ADAL" clId="{9DB0C637-5A51-4AF8-848B-0A876275EF09}" dt="2022-06-12T04:26:02.830" v="1037" actId="1076"/>
          <ac:picMkLst>
            <pc:docMk/>
            <pc:sldMk cId="3166259601" sldId="272"/>
            <ac:picMk id="8" creationId="{70DAF1FB-F7CD-414D-AC19-CD01B7651439}"/>
          </ac:picMkLst>
        </pc:picChg>
        <pc:picChg chg="add del mod">
          <ac:chgData name="Manasweeta Angane" userId="05da2731-9352-4b35-b713-60351f56afbd" providerId="ADAL" clId="{9DB0C637-5A51-4AF8-848B-0A876275EF09}" dt="2022-06-12T04:26:21.909" v="1040" actId="478"/>
          <ac:picMkLst>
            <pc:docMk/>
            <pc:sldMk cId="3166259601" sldId="272"/>
            <ac:picMk id="2050" creationId="{27E292AB-A058-4131-9A1A-C38338314C88}"/>
          </ac:picMkLst>
        </pc:picChg>
        <pc:picChg chg="add mod topLvl">
          <ac:chgData name="Manasweeta Angane" userId="05da2731-9352-4b35-b713-60351f56afbd" providerId="ADAL" clId="{9DB0C637-5A51-4AF8-848B-0A876275EF09}" dt="2022-06-12T04:26:02.830" v="1037" actId="1076"/>
          <ac:picMkLst>
            <pc:docMk/>
            <pc:sldMk cId="3166259601" sldId="272"/>
            <ac:picMk id="2052" creationId="{23594197-22D0-48A1-9759-9557B8D9B0FB}"/>
          </ac:picMkLst>
        </pc:picChg>
      </pc:sldChg>
      <pc:sldChg chg="addSp modSp add">
        <pc:chgData name="Manasweeta Angane" userId="05da2731-9352-4b35-b713-60351f56afbd" providerId="ADAL" clId="{9DB0C637-5A51-4AF8-848B-0A876275EF09}" dt="2022-06-12T04:34:28.542" v="1112"/>
        <pc:sldMkLst>
          <pc:docMk/>
          <pc:sldMk cId="1115324438" sldId="273"/>
        </pc:sldMkLst>
        <pc:picChg chg="add mod">
          <ac:chgData name="Manasweeta Angane" userId="05da2731-9352-4b35-b713-60351f56afbd" providerId="ADAL" clId="{9DB0C637-5A51-4AF8-848B-0A876275EF09}" dt="2022-06-07T12:25:26.421" v="230"/>
          <ac:picMkLst>
            <pc:docMk/>
            <pc:sldMk cId="1115324438" sldId="273"/>
            <ac:picMk id="10" creationId="{0425E1B5-6271-4131-B6E9-31D9887827B2}"/>
          </ac:picMkLst>
        </pc:picChg>
        <pc:picChg chg="add mod">
          <ac:chgData name="Manasweeta Angane" userId="05da2731-9352-4b35-b713-60351f56afbd" providerId="ADAL" clId="{9DB0C637-5A51-4AF8-848B-0A876275EF09}" dt="2022-06-12T04:34:28.542" v="1112"/>
          <ac:picMkLst>
            <pc:docMk/>
            <pc:sldMk cId="1115324438" sldId="273"/>
            <ac:picMk id="14" creationId="{1B48F5AB-299E-438F-BAF0-61C1AFA0B255}"/>
          </ac:picMkLst>
        </pc:picChg>
      </pc:sldChg>
      <pc:sldChg chg="add">
        <pc:chgData name="Manasweeta Angane" userId="05da2731-9352-4b35-b713-60351f56afbd" providerId="ADAL" clId="{9DB0C637-5A51-4AF8-848B-0A876275EF09}" dt="2022-06-12T03:35:32.466" v="700" actId="2890"/>
        <pc:sldMkLst>
          <pc:docMk/>
          <pc:sldMk cId="1520954764" sldId="274"/>
        </pc:sldMkLst>
      </pc:sldChg>
      <pc:sldChg chg="addSp delSp modSp new mod">
        <pc:chgData name="Manasweeta Angane" userId="05da2731-9352-4b35-b713-60351f56afbd" providerId="ADAL" clId="{9DB0C637-5A51-4AF8-848B-0A876275EF09}" dt="2022-06-12T05:49:08.881" v="1444"/>
        <pc:sldMkLst>
          <pc:docMk/>
          <pc:sldMk cId="1754629027" sldId="275"/>
        </pc:sldMkLst>
        <pc:spChg chg="mod">
          <ac:chgData name="Manasweeta Angane" userId="05da2731-9352-4b35-b713-60351f56afbd" providerId="ADAL" clId="{9DB0C637-5A51-4AF8-848B-0A876275EF09}" dt="2022-06-12T04:27:16.092" v="1047"/>
          <ac:spMkLst>
            <pc:docMk/>
            <pc:sldMk cId="1754629027" sldId="275"/>
            <ac:spMk id="3" creationId="{E1028034-5566-4CEF-A2AB-7033BD4FB036}"/>
          </ac:spMkLst>
        </pc:spChg>
        <pc:spChg chg="mod">
          <ac:chgData name="Manasweeta Angane" userId="05da2731-9352-4b35-b713-60351f56afbd" providerId="ADAL" clId="{9DB0C637-5A51-4AF8-848B-0A876275EF09}" dt="2022-06-12T04:27:16.092" v="1047"/>
          <ac:spMkLst>
            <pc:docMk/>
            <pc:sldMk cId="1754629027" sldId="275"/>
            <ac:spMk id="4" creationId="{7D4F30D8-A485-4880-98C2-ED544146B6EE}"/>
          </ac:spMkLst>
        </pc:spChg>
        <pc:spChg chg="mod">
          <ac:chgData name="Manasweeta Angane" userId="05da2731-9352-4b35-b713-60351f56afbd" providerId="ADAL" clId="{9DB0C637-5A51-4AF8-848B-0A876275EF09}" dt="2022-06-12T04:27:16.092" v="1047"/>
          <ac:spMkLst>
            <pc:docMk/>
            <pc:sldMk cId="1754629027" sldId="275"/>
            <ac:spMk id="5" creationId="{C3CD9651-773D-43C6-B90C-FE5F4BC7FF44}"/>
          </ac:spMkLst>
        </pc:spChg>
        <pc:spChg chg="mod">
          <ac:chgData name="Manasweeta Angane" userId="05da2731-9352-4b35-b713-60351f56afbd" providerId="ADAL" clId="{9DB0C637-5A51-4AF8-848B-0A876275EF09}" dt="2022-06-12T04:27:21.741" v="1049"/>
          <ac:spMkLst>
            <pc:docMk/>
            <pc:sldMk cId="1754629027" sldId="275"/>
            <ac:spMk id="7" creationId="{A79A1C92-20E5-4201-A663-801741815CC0}"/>
          </ac:spMkLst>
        </pc:spChg>
        <pc:spChg chg="mod">
          <ac:chgData name="Manasweeta Angane" userId="05da2731-9352-4b35-b713-60351f56afbd" providerId="ADAL" clId="{9DB0C637-5A51-4AF8-848B-0A876275EF09}" dt="2022-06-12T04:27:21.741" v="1049"/>
          <ac:spMkLst>
            <pc:docMk/>
            <pc:sldMk cId="1754629027" sldId="275"/>
            <ac:spMk id="8" creationId="{B81BFA94-932D-4F4A-9497-74B1D9FAAF7D}"/>
          </ac:spMkLst>
        </pc:spChg>
        <pc:spChg chg="mod">
          <ac:chgData name="Manasweeta Angane" userId="05da2731-9352-4b35-b713-60351f56afbd" providerId="ADAL" clId="{9DB0C637-5A51-4AF8-848B-0A876275EF09}" dt="2022-06-12T04:27:21.741" v="1049"/>
          <ac:spMkLst>
            <pc:docMk/>
            <pc:sldMk cId="1754629027" sldId="275"/>
            <ac:spMk id="9" creationId="{5E95CC75-4133-4CA6-98B7-1C81C24CAA67}"/>
          </ac:spMkLst>
        </pc:spChg>
        <pc:spChg chg="mod">
          <ac:chgData name="Manasweeta Angane" userId="05da2731-9352-4b35-b713-60351f56afbd" providerId="ADAL" clId="{9DB0C637-5A51-4AF8-848B-0A876275EF09}" dt="2022-06-12T04:27:56.972" v="1050"/>
          <ac:spMkLst>
            <pc:docMk/>
            <pc:sldMk cId="1754629027" sldId="275"/>
            <ac:spMk id="11" creationId="{1A21F91A-4D3B-49E0-984B-3CFFEE05FDC2}"/>
          </ac:spMkLst>
        </pc:spChg>
        <pc:spChg chg="mod">
          <ac:chgData name="Manasweeta Angane" userId="05da2731-9352-4b35-b713-60351f56afbd" providerId="ADAL" clId="{9DB0C637-5A51-4AF8-848B-0A876275EF09}" dt="2022-06-12T04:27:56.972" v="1050"/>
          <ac:spMkLst>
            <pc:docMk/>
            <pc:sldMk cId="1754629027" sldId="275"/>
            <ac:spMk id="13" creationId="{41CCA50F-2191-43CE-A886-64143E729898}"/>
          </ac:spMkLst>
        </pc:spChg>
        <pc:spChg chg="mod">
          <ac:chgData name="Manasweeta Angane" userId="05da2731-9352-4b35-b713-60351f56afbd" providerId="ADAL" clId="{9DB0C637-5A51-4AF8-848B-0A876275EF09}" dt="2022-06-12T04:27:56.972" v="1050"/>
          <ac:spMkLst>
            <pc:docMk/>
            <pc:sldMk cId="1754629027" sldId="275"/>
            <ac:spMk id="14" creationId="{686612DB-A05C-4DD3-BE2B-F8ADBE0C7FF7}"/>
          </ac:spMkLst>
        </pc:spChg>
        <pc:spChg chg="mod">
          <ac:chgData name="Manasweeta Angane" userId="05da2731-9352-4b35-b713-60351f56afbd" providerId="ADAL" clId="{9DB0C637-5A51-4AF8-848B-0A876275EF09}" dt="2022-06-12T04:29:54.057" v="1066" actId="208"/>
          <ac:spMkLst>
            <pc:docMk/>
            <pc:sldMk cId="1754629027" sldId="275"/>
            <ac:spMk id="16" creationId="{DB50141D-84E1-45FE-8437-3CB22EC08C3A}"/>
          </ac:spMkLst>
        </pc:spChg>
        <pc:spChg chg="mod">
          <ac:chgData name="Manasweeta Angane" userId="05da2731-9352-4b35-b713-60351f56afbd" providerId="ADAL" clId="{9DB0C637-5A51-4AF8-848B-0A876275EF09}" dt="2022-06-12T04:29:54.057" v="1066" actId="208"/>
          <ac:spMkLst>
            <pc:docMk/>
            <pc:sldMk cId="1754629027" sldId="275"/>
            <ac:spMk id="18" creationId="{B46277B2-877D-4FF4-AF3A-313D420DA51C}"/>
          </ac:spMkLst>
        </pc:spChg>
        <pc:spChg chg="mod">
          <ac:chgData name="Manasweeta Angane" userId="05da2731-9352-4b35-b713-60351f56afbd" providerId="ADAL" clId="{9DB0C637-5A51-4AF8-848B-0A876275EF09}" dt="2022-06-12T04:29:54.057" v="1066" actId="208"/>
          <ac:spMkLst>
            <pc:docMk/>
            <pc:sldMk cId="1754629027" sldId="275"/>
            <ac:spMk id="19" creationId="{34122F8F-C0FE-4998-A61B-39601CA2C379}"/>
          </ac:spMkLst>
        </pc:spChg>
        <pc:spChg chg="add del mod">
          <ac:chgData name="Manasweeta Angane" userId="05da2731-9352-4b35-b713-60351f56afbd" providerId="ADAL" clId="{9DB0C637-5A51-4AF8-848B-0A876275EF09}" dt="2022-06-12T05:49:08.881" v="1444"/>
          <ac:spMkLst>
            <pc:docMk/>
            <pc:sldMk cId="1754629027" sldId="275"/>
            <ac:spMk id="20" creationId="{29F27606-1713-463A-8692-051CF5760853}"/>
          </ac:spMkLst>
        </pc:spChg>
        <pc:grpChg chg="add del mod">
          <ac:chgData name="Manasweeta Angane" userId="05da2731-9352-4b35-b713-60351f56afbd" providerId="ADAL" clId="{9DB0C637-5A51-4AF8-848B-0A876275EF09}" dt="2022-06-12T04:27:19.144" v="1048"/>
          <ac:grpSpMkLst>
            <pc:docMk/>
            <pc:sldMk cId="1754629027" sldId="275"/>
            <ac:grpSpMk id="2" creationId="{1870B330-7715-4E6D-902D-4CDF60ADCBA5}"/>
          </ac:grpSpMkLst>
        </pc:grpChg>
        <pc:grpChg chg="add del mod">
          <ac:chgData name="Manasweeta Angane" userId="05da2731-9352-4b35-b713-60351f56afbd" providerId="ADAL" clId="{9DB0C637-5A51-4AF8-848B-0A876275EF09}" dt="2022-06-12T05:48:40.879" v="1440" actId="478"/>
          <ac:grpSpMkLst>
            <pc:docMk/>
            <pc:sldMk cId="1754629027" sldId="275"/>
            <ac:grpSpMk id="6" creationId="{336B6C9E-851A-441A-8321-726EE2AC51D9}"/>
          </ac:grpSpMkLst>
        </pc:grpChg>
        <pc:grpChg chg="add del mod">
          <ac:chgData name="Manasweeta Angane" userId="05da2731-9352-4b35-b713-60351f56afbd" providerId="ADAL" clId="{9DB0C637-5A51-4AF8-848B-0A876275EF09}" dt="2022-06-12T05:48:39.007" v="1439" actId="478"/>
          <ac:grpSpMkLst>
            <pc:docMk/>
            <pc:sldMk cId="1754629027" sldId="275"/>
            <ac:grpSpMk id="10" creationId="{6370D65B-C3B5-4168-BA35-752EBE8B069F}"/>
          </ac:grpSpMkLst>
        </pc:grpChg>
        <pc:grpChg chg="mod">
          <ac:chgData name="Manasweeta Angane" userId="05da2731-9352-4b35-b713-60351f56afbd" providerId="ADAL" clId="{9DB0C637-5A51-4AF8-848B-0A876275EF09}" dt="2022-06-12T04:27:56.972" v="1050"/>
          <ac:grpSpMkLst>
            <pc:docMk/>
            <pc:sldMk cId="1754629027" sldId="275"/>
            <ac:grpSpMk id="12" creationId="{180969FB-C0AD-4E05-8FED-1954BC0C8552}"/>
          </ac:grpSpMkLst>
        </pc:grpChg>
        <pc:grpChg chg="add del mod ord">
          <ac:chgData name="Manasweeta Angane" userId="05da2731-9352-4b35-b713-60351f56afbd" providerId="ADAL" clId="{9DB0C637-5A51-4AF8-848B-0A876275EF09}" dt="2022-06-12T05:48:37.920" v="1438" actId="478"/>
          <ac:grpSpMkLst>
            <pc:docMk/>
            <pc:sldMk cId="1754629027" sldId="275"/>
            <ac:grpSpMk id="15" creationId="{4D0DEBEB-08B3-4B23-8E82-E0A66017013A}"/>
          </ac:grpSpMkLst>
        </pc:grpChg>
        <pc:grpChg chg="mod">
          <ac:chgData name="Manasweeta Angane" userId="05da2731-9352-4b35-b713-60351f56afbd" providerId="ADAL" clId="{9DB0C637-5A51-4AF8-848B-0A876275EF09}" dt="2022-06-12T04:28:22.507" v="1055"/>
          <ac:grpSpMkLst>
            <pc:docMk/>
            <pc:sldMk cId="1754629027" sldId="275"/>
            <ac:grpSpMk id="17" creationId="{142E30E6-23A9-4A38-816D-ABEA7E0EE792}"/>
          </ac:grpSpMkLst>
        </pc:grpChg>
      </pc:sldChg>
      <pc:sldChg chg="modSp add mod">
        <pc:chgData name="Manasweeta Angane" userId="05da2731-9352-4b35-b713-60351f56afbd" providerId="ADAL" clId="{9DB0C637-5A51-4AF8-848B-0A876275EF09}" dt="2022-06-12T05:55:17.550" v="1641" actId="1076"/>
        <pc:sldMkLst>
          <pc:docMk/>
          <pc:sldMk cId="560320406" sldId="276"/>
        </pc:sldMkLst>
        <pc:spChg chg="mod">
          <ac:chgData name="Manasweeta Angane" userId="05da2731-9352-4b35-b713-60351f56afbd" providerId="ADAL" clId="{9DB0C637-5A51-4AF8-848B-0A876275EF09}" dt="2022-06-12T05:55:17.550" v="1641" actId="1076"/>
          <ac:spMkLst>
            <pc:docMk/>
            <pc:sldMk cId="560320406" sldId="276"/>
            <ac:spMk id="29" creationId="{FC37E74B-D05E-4271-8B96-93BE34C68A1B}"/>
          </ac:spMkLst>
        </pc:spChg>
        <pc:spChg chg="mod">
          <ac:chgData name="Manasweeta Angane" userId="05da2731-9352-4b35-b713-60351f56afbd" providerId="ADAL" clId="{9DB0C637-5A51-4AF8-848B-0A876275EF09}" dt="2022-06-12T05:55:17.550" v="1641" actId="1076"/>
          <ac:spMkLst>
            <pc:docMk/>
            <pc:sldMk cId="560320406" sldId="276"/>
            <ac:spMk id="30" creationId="{9C72C34F-D9A7-4C0D-8D0C-BD3B5ADC61FC}"/>
          </ac:spMkLst>
        </pc:spChg>
        <pc:spChg chg="ord">
          <ac:chgData name="Manasweeta Angane" userId="05da2731-9352-4b35-b713-60351f56afbd" providerId="ADAL" clId="{9DB0C637-5A51-4AF8-848B-0A876275EF09}" dt="2022-06-12T05:55:08.950" v="1634" actId="166"/>
          <ac:spMkLst>
            <pc:docMk/>
            <pc:sldMk cId="560320406" sldId="276"/>
            <ac:spMk id="42" creationId="{9125F188-D551-44C3-8206-96EAA55D240D}"/>
          </ac:spMkLst>
        </pc:spChg>
        <pc:grpChg chg="mod">
          <ac:chgData name="Manasweeta Angane" userId="05da2731-9352-4b35-b713-60351f56afbd" providerId="ADAL" clId="{9DB0C637-5A51-4AF8-848B-0A876275EF09}" dt="2022-06-12T05:54:28.653" v="1628" actId="14100"/>
          <ac:grpSpMkLst>
            <pc:docMk/>
            <pc:sldMk cId="560320406" sldId="276"/>
            <ac:grpSpMk id="21" creationId="{6F06EEB4-0750-4778-A118-4BEA82BD6E74}"/>
          </ac:grpSpMkLst>
        </pc:grpChg>
        <pc:grpChg chg="mod">
          <ac:chgData name="Manasweeta Angane" userId="05da2731-9352-4b35-b713-60351f56afbd" providerId="ADAL" clId="{9DB0C637-5A51-4AF8-848B-0A876275EF09}" dt="2022-06-12T05:55:17.550" v="1641" actId="1076"/>
          <ac:grpSpMkLst>
            <pc:docMk/>
            <pc:sldMk cId="560320406" sldId="276"/>
            <ac:grpSpMk id="25" creationId="{8C467016-0770-4F99-89AD-82B6A7E61CDF}"/>
          </ac:grpSpMkLst>
        </pc:grpChg>
        <pc:picChg chg="mod">
          <ac:chgData name="Manasweeta Angane" userId="05da2731-9352-4b35-b713-60351f56afbd" providerId="ADAL" clId="{9DB0C637-5A51-4AF8-848B-0A876275EF09}" dt="2022-06-12T05:55:17.550" v="1641" actId="1076"/>
          <ac:picMkLst>
            <pc:docMk/>
            <pc:sldMk cId="560320406" sldId="276"/>
            <ac:picMk id="26" creationId="{9DB5B930-29CF-4AB3-90F3-59CF9D9EFD33}"/>
          </ac:picMkLst>
        </pc:picChg>
        <pc:picChg chg="mod">
          <ac:chgData name="Manasweeta Angane" userId="05da2731-9352-4b35-b713-60351f56afbd" providerId="ADAL" clId="{9DB0C637-5A51-4AF8-848B-0A876275EF09}" dt="2022-06-12T05:55:17.550" v="1641" actId="1076"/>
          <ac:picMkLst>
            <pc:docMk/>
            <pc:sldMk cId="560320406" sldId="276"/>
            <ac:picMk id="27" creationId="{04F40808-E1E8-402F-A00F-C4FF92472716}"/>
          </ac:picMkLst>
        </pc:picChg>
        <pc:picChg chg="mod">
          <ac:chgData name="Manasweeta Angane" userId="05da2731-9352-4b35-b713-60351f56afbd" providerId="ADAL" clId="{9DB0C637-5A51-4AF8-848B-0A876275EF09}" dt="2022-06-12T05:55:17.550" v="1641" actId="1076"/>
          <ac:picMkLst>
            <pc:docMk/>
            <pc:sldMk cId="560320406" sldId="276"/>
            <ac:picMk id="28" creationId="{34E81630-E536-4D16-87A1-2D6250075370}"/>
          </ac:picMkLst>
        </pc:picChg>
      </pc:sldChg>
      <pc:sldChg chg="addSp delSp modSp add mod">
        <pc:chgData name="Manasweeta Angane" userId="05da2731-9352-4b35-b713-60351f56afbd" providerId="ADAL" clId="{9DB0C637-5A51-4AF8-848B-0A876275EF09}" dt="2022-06-16T10:28:39.105" v="3464" actId="1037"/>
        <pc:sldMkLst>
          <pc:docMk/>
          <pc:sldMk cId="2478566023" sldId="277"/>
        </pc:sldMkLst>
        <pc:spChg chg="add del mod">
          <ac:chgData name="Manasweeta Angane" userId="05da2731-9352-4b35-b713-60351f56afbd" providerId="ADAL" clId="{9DB0C637-5A51-4AF8-848B-0A876275EF09}" dt="2022-06-15T14:49:25.548" v="2983" actId="33987"/>
          <ac:spMkLst>
            <pc:docMk/>
            <pc:sldMk cId="2478566023" sldId="277"/>
            <ac:spMk id="6" creationId="{265C8985-8B06-4474-990E-CA06890AFCFA}"/>
          </ac:spMkLst>
        </pc:spChg>
        <pc:spChg chg="add del mod">
          <ac:chgData name="Manasweeta Angane" userId="05da2731-9352-4b35-b713-60351f56afbd" providerId="ADAL" clId="{9DB0C637-5A51-4AF8-848B-0A876275EF09}" dt="2022-06-15T15:03:34.968" v="3155" actId="478"/>
          <ac:spMkLst>
            <pc:docMk/>
            <pc:sldMk cId="2478566023" sldId="277"/>
            <ac:spMk id="7" creationId="{99E9E977-C5B3-4558-A254-1B9A4958A8BB}"/>
          </ac:spMkLst>
        </pc:spChg>
        <pc:spChg chg="mod">
          <ac:chgData name="Manasweeta Angane" userId="05da2731-9352-4b35-b713-60351f56afbd" providerId="ADAL" clId="{9DB0C637-5A51-4AF8-848B-0A876275EF09}" dt="2022-06-15T15:08:02.074" v="3413" actId="1076"/>
          <ac:spMkLst>
            <pc:docMk/>
            <pc:sldMk cId="2478566023" sldId="277"/>
            <ac:spMk id="38" creationId="{6B7FAA91-0C2A-45F3-844F-817FB4BABA04}"/>
          </ac:spMkLst>
        </pc:spChg>
        <pc:spChg chg="mod">
          <ac:chgData name="Manasweeta Angane" userId="05da2731-9352-4b35-b713-60351f56afbd" providerId="ADAL" clId="{9DB0C637-5A51-4AF8-848B-0A876275EF09}" dt="2022-06-15T15:08:02.074" v="3413" actId="1076"/>
          <ac:spMkLst>
            <pc:docMk/>
            <pc:sldMk cId="2478566023" sldId="277"/>
            <ac:spMk id="39" creationId="{B569BABC-EC9A-4EDF-A442-AE37B8117945}"/>
          </ac:spMkLst>
        </pc:spChg>
        <pc:spChg chg="mod">
          <ac:chgData name="Manasweeta Angane" userId="05da2731-9352-4b35-b713-60351f56afbd" providerId="ADAL" clId="{9DB0C637-5A51-4AF8-848B-0A876275EF09}" dt="2022-06-15T14:30:11.760" v="2596" actId="165"/>
          <ac:spMkLst>
            <pc:docMk/>
            <pc:sldMk cId="2478566023" sldId="277"/>
            <ac:spMk id="40" creationId="{FBF7B8CD-F45C-43F7-8F5E-1B5BC914F564}"/>
          </ac:spMkLst>
        </pc:spChg>
        <pc:spChg chg="del mod topLvl">
          <ac:chgData name="Manasweeta Angane" userId="05da2731-9352-4b35-b713-60351f56afbd" providerId="ADAL" clId="{9DB0C637-5A51-4AF8-848B-0A876275EF09}" dt="2022-06-15T14:29:34.290" v="2593" actId="478"/>
          <ac:spMkLst>
            <pc:docMk/>
            <pc:sldMk cId="2478566023" sldId="277"/>
            <ac:spMk id="42" creationId="{9125F188-D551-44C3-8206-96EAA55D240D}"/>
          </ac:spMkLst>
        </pc:spChg>
        <pc:spChg chg="mod">
          <ac:chgData name="Manasweeta Angane" userId="05da2731-9352-4b35-b713-60351f56afbd" providerId="ADAL" clId="{9DB0C637-5A51-4AF8-848B-0A876275EF09}" dt="2022-06-15T14:30:33.935" v="2599" actId="688"/>
          <ac:spMkLst>
            <pc:docMk/>
            <pc:sldMk cId="2478566023" sldId="277"/>
            <ac:spMk id="43" creationId="{CEA894C7-4C0E-4758-9505-C3B827119160}"/>
          </ac:spMkLst>
        </pc:spChg>
        <pc:spChg chg="del mod topLvl">
          <ac:chgData name="Manasweeta Angane" userId="05da2731-9352-4b35-b713-60351f56afbd" providerId="ADAL" clId="{9DB0C637-5A51-4AF8-848B-0A876275EF09}" dt="2022-06-15T14:29:29.898" v="2592" actId="478"/>
          <ac:spMkLst>
            <pc:docMk/>
            <pc:sldMk cId="2478566023" sldId="277"/>
            <ac:spMk id="44" creationId="{2808E333-5AF5-4EF5-A21A-DE4B9D01D2DA}"/>
          </ac:spMkLst>
        </pc:spChg>
        <pc:spChg chg="mod">
          <ac:chgData name="Manasweeta Angane" userId="05da2731-9352-4b35-b713-60351f56afbd" providerId="ADAL" clId="{9DB0C637-5A51-4AF8-848B-0A876275EF09}" dt="2022-06-15T14:30:11.760" v="2596" actId="165"/>
          <ac:spMkLst>
            <pc:docMk/>
            <pc:sldMk cId="2478566023" sldId="277"/>
            <ac:spMk id="45" creationId="{FD685721-769F-48C5-B266-1057D8F4E846}"/>
          </ac:spMkLst>
        </pc:spChg>
        <pc:spChg chg="add mod">
          <ac:chgData name="Manasweeta Angane" userId="05da2731-9352-4b35-b713-60351f56afbd" providerId="ADAL" clId="{9DB0C637-5A51-4AF8-848B-0A876275EF09}" dt="2022-06-15T15:11:32.396" v="3426" actId="14838"/>
          <ac:spMkLst>
            <pc:docMk/>
            <pc:sldMk cId="2478566023" sldId="277"/>
            <ac:spMk id="46" creationId="{DE116AA8-3BBD-44C1-A8F3-4756110D0286}"/>
          </ac:spMkLst>
        </pc:spChg>
        <pc:spChg chg="mod">
          <ac:chgData name="Manasweeta Angane" userId="05da2731-9352-4b35-b713-60351f56afbd" providerId="ADAL" clId="{9DB0C637-5A51-4AF8-848B-0A876275EF09}" dt="2022-06-15T14:33:54.232" v="2622" actId="571"/>
          <ac:spMkLst>
            <pc:docMk/>
            <pc:sldMk cId="2478566023" sldId="277"/>
            <ac:spMk id="48" creationId="{90303EC3-AD86-42B5-9AC7-0E45AF158D69}"/>
          </ac:spMkLst>
        </pc:spChg>
        <pc:spChg chg="mod">
          <ac:chgData name="Manasweeta Angane" userId="05da2731-9352-4b35-b713-60351f56afbd" providerId="ADAL" clId="{9DB0C637-5A51-4AF8-848B-0A876275EF09}" dt="2022-06-15T14:33:54.232" v="2622" actId="571"/>
          <ac:spMkLst>
            <pc:docMk/>
            <pc:sldMk cId="2478566023" sldId="277"/>
            <ac:spMk id="49" creationId="{8A7DA1B5-D0DC-4C87-A382-73EA15B9169C}"/>
          </ac:spMkLst>
        </pc:spChg>
        <pc:spChg chg="mod">
          <ac:chgData name="Manasweeta Angane" userId="05da2731-9352-4b35-b713-60351f56afbd" providerId="ADAL" clId="{9DB0C637-5A51-4AF8-848B-0A876275EF09}" dt="2022-06-15T14:33:54.232" v="2622" actId="571"/>
          <ac:spMkLst>
            <pc:docMk/>
            <pc:sldMk cId="2478566023" sldId="277"/>
            <ac:spMk id="53" creationId="{6A91A281-FAC2-4788-952F-8F24193967F5}"/>
          </ac:spMkLst>
        </pc:spChg>
        <pc:spChg chg="mod">
          <ac:chgData name="Manasweeta Angane" userId="05da2731-9352-4b35-b713-60351f56afbd" providerId="ADAL" clId="{9DB0C637-5A51-4AF8-848B-0A876275EF09}" dt="2022-06-12T06:54:26.395" v="2444" actId="165"/>
          <ac:spMkLst>
            <pc:docMk/>
            <pc:sldMk cId="2478566023" sldId="277"/>
            <ac:spMk id="62" creationId="{CC4DB37D-41C5-49E8-BE9A-1789FD39844A}"/>
          </ac:spMkLst>
        </pc:spChg>
        <pc:spChg chg="mod">
          <ac:chgData name="Manasweeta Angane" userId="05da2731-9352-4b35-b713-60351f56afbd" providerId="ADAL" clId="{9DB0C637-5A51-4AF8-848B-0A876275EF09}" dt="2022-06-12T06:54:26.395" v="2444" actId="165"/>
          <ac:spMkLst>
            <pc:docMk/>
            <pc:sldMk cId="2478566023" sldId="277"/>
            <ac:spMk id="63" creationId="{787BF382-F5CC-426B-9B0F-ED3285F21904}"/>
          </ac:spMkLst>
        </pc:spChg>
        <pc:spChg chg="mod">
          <ac:chgData name="Manasweeta Angane" userId="05da2731-9352-4b35-b713-60351f56afbd" providerId="ADAL" clId="{9DB0C637-5A51-4AF8-848B-0A876275EF09}" dt="2022-06-12T06:54:26.395" v="2444" actId="165"/>
          <ac:spMkLst>
            <pc:docMk/>
            <pc:sldMk cId="2478566023" sldId="277"/>
            <ac:spMk id="66" creationId="{36ABE25F-63DC-4DEB-AEC3-5DD8D0B3ABAC}"/>
          </ac:spMkLst>
        </pc:spChg>
        <pc:spChg chg="del mod topLvl">
          <ac:chgData name="Manasweeta Angane" userId="05da2731-9352-4b35-b713-60351f56afbd" providerId="ADAL" clId="{9DB0C637-5A51-4AF8-848B-0A876275EF09}" dt="2022-06-12T06:51:07.016" v="2351" actId="478"/>
          <ac:spMkLst>
            <pc:docMk/>
            <pc:sldMk cId="2478566023" sldId="277"/>
            <ac:spMk id="72" creationId="{E3CE3B61-07D3-46BF-AC1F-F835E9EBA77F}"/>
          </ac:spMkLst>
        </pc:spChg>
        <pc:spChg chg="del mod topLvl">
          <ac:chgData name="Manasweeta Angane" userId="05da2731-9352-4b35-b713-60351f56afbd" providerId="ADAL" clId="{9DB0C637-5A51-4AF8-848B-0A876275EF09}" dt="2022-06-12T06:51:04.953" v="2349" actId="478"/>
          <ac:spMkLst>
            <pc:docMk/>
            <pc:sldMk cId="2478566023" sldId="277"/>
            <ac:spMk id="73" creationId="{57A9B6BC-EDAF-4BB1-A62E-7BC9DA1337B7}"/>
          </ac:spMkLst>
        </pc:spChg>
        <pc:spChg chg="mod">
          <ac:chgData name="Manasweeta Angane" userId="05da2731-9352-4b35-b713-60351f56afbd" providerId="ADAL" clId="{9DB0C637-5A51-4AF8-848B-0A876275EF09}" dt="2022-06-15T14:44:01.138" v="2957"/>
          <ac:spMkLst>
            <pc:docMk/>
            <pc:sldMk cId="2478566023" sldId="277"/>
            <ac:spMk id="76" creationId="{2B4C5E36-3474-4D28-8AA6-B6F315EC16A2}"/>
          </ac:spMkLst>
        </pc:spChg>
        <pc:spChg chg="mod">
          <ac:chgData name="Manasweeta Angane" userId="05da2731-9352-4b35-b713-60351f56afbd" providerId="ADAL" clId="{9DB0C637-5A51-4AF8-848B-0A876275EF09}" dt="2022-06-15T14:44:01.138" v="2957"/>
          <ac:spMkLst>
            <pc:docMk/>
            <pc:sldMk cId="2478566023" sldId="277"/>
            <ac:spMk id="80" creationId="{30605EA9-2DEC-4D21-AC2A-D2479E75B8C8}"/>
          </ac:spMkLst>
        </pc:spChg>
        <pc:spChg chg="mod">
          <ac:chgData name="Manasweeta Angane" userId="05da2731-9352-4b35-b713-60351f56afbd" providerId="ADAL" clId="{9DB0C637-5A51-4AF8-848B-0A876275EF09}" dt="2022-06-15T14:44:01.138" v="2957"/>
          <ac:spMkLst>
            <pc:docMk/>
            <pc:sldMk cId="2478566023" sldId="277"/>
            <ac:spMk id="82" creationId="{4EAE4B8E-4A7C-4DEC-8339-612981F1B468}"/>
          </ac:spMkLst>
        </pc:spChg>
        <pc:spChg chg="mod">
          <ac:chgData name="Manasweeta Angane" userId="05da2731-9352-4b35-b713-60351f56afbd" providerId="ADAL" clId="{9DB0C637-5A51-4AF8-848B-0A876275EF09}" dt="2022-06-15T14:44:01.138" v="2957"/>
          <ac:spMkLst>
            <pc:docMk/>
            <pc:sldMk cId="2478566023" sldId="277"/>
            <ac:spMk id="83" creationId="{184B9206-5B57-437A-8046-51111DA2F5D6}"/>
          </ac:spMkLst>
        </pc:spChg>
        <pc:spChg chg="add mod">
          <ac:chgData name="Manasweeta Angane" userId="05da2731-9352-4b35-b713-60351f56afbd" providerId="ADAL" clId="{9DB0C637-5A51-4AF8-848B-0A876275EF09}" dt="2022-06-15T15:10:16.318" v="3420" actId="339"/>
          <ac:spMkLst>
            <pc:docMk/>
            <pc:sldMk cId="2478566023" sldId="277"/>
            <ac:spMk id="84" creationId="{AFE50ABB-E90E-440F-915C-C14E3CC56EBC}"/>
          </ac:spMkLst>
        </pc:spChg>
        <pc:spChg chg="add mod">
          <ac:chgData name="Manasweeta Angane" userId="05da2731-9352-4b35-b713-60351f56afbd" providerId="ADAL" clId="{9DB0C637-5A51-4AF8-848B-0A876275EF09}" dt="2022-06-15T15:10:25.079" v="3421" actId="339"/>
          <ac:spMkLst>
            <pc:docMk/>
            <pc:sldMk cId="2478566023" sldId="277"/>
            <ac:spMk id="85" creationId="{1541D077-5551-469C-B41A-A8E7A52D04BF}"/>
          </ac:spMkLst>
        </pc:spChg>
        <pc:spChg chg="del mod topLvl">
          <ac:chgData name="Manasweeta Angane" userId="05da2731-9352-4b35-b713-60351f56afbd" providerId="ADAL" clId="{9DB0C637-5A51-4AF8-848B-0A876275EF09}" dt="2022-06-12T06:50:36.632" v="2343" actId="478"/>
          <ac:spMkLst>
            <pc:docMk/>
            <pc:sldMk cId="2478566023" sldId="277"/>
            <ac:spMk id="104" creationId="{1FB1D634-1144-4112-B438-0A6D2439306A}"/>
          </ac:spMkLst>
        </pc:spChg>
        <pc:spChg chg="del mod topLvl">
          <ac:chgData name="Manasweeta Angane" userId="05da2731-9352-4b35-b713-60351f56afbd" providerId="ADAL" clId="{9DB0C637-5A51-4AF8-848B-0A876275EF09}" dt="2022-06-12T06:50:38.232" v="2344" actId="478"/>
          <ac:spMkLst>
            <pc:docMk/>
            <pc:sldMk cId="2478566023" sldId="277"/>
            <ac:spMk id="105" creationId="{FDDEE1E4-BA17-4F63-A349-F65D3605C5C6}"/>
          </ac:spMkLst>
        </pc:spChg>
        <pc:grpChg chg="add mod">
          <ac:chgData name="Manasweeta Angane" userId="05da2731-9352-4b35-b713-60351f56afbd" providerId="ADAL" clId="{9DB0C637-5A51-4AF8-848B-0A876275EF09}" dt="2022-06-15T14:51:25.062" v="2999" actId="12788"/>
          <ac:grpSpMkLst>
            <pc:docMk/>
            <pc:sldMk cId="2478566023" sldId="277"/>
            <ac:grpSpMk id="2" creationId="{35183592-6E65-4E18-94C6-EAE969932278}"/>
          </ac:grpSpMkLst>
        </pc:grpChg>
        <pc:grpChg chg="add del mod ord">
          <ac:chgData name="Manasweeta Angane" userId="05da2731-9352-4b35-b713-60351f56afbd" providerId="ADAL" clId="{9DB0C637-5A51-4AF8-848B-0A876275EF09}" dt="2022-06-14T10:59:26.474" v="2461" actId="165"/>
          <ac:grpSpMkLst>
            <pc:docMk/>
            <pc:sldMk cId="2478566023" sldId="277"/>
            <ac:grpSpMk id="2" creationId="{6728C37F-D9B8-4717-B8A9-CE2CBC07DD82}"/>
          </ac:grpSpMkLst>
        </pc:grpChg>
        <pc:grpChg chg="add del mod">
          <ac:chgData name="Manasweeta Angane" userId="05da2731-9352-4b35-b713-60351f56afbd" providerId="ADAL" clId="{9DB0C637-5A51-4AF8-848B-0A876275EF09}" dt="2022-06-12T06:54:26.395" v="2444" actId="165"/>
          <ac:grpSpMkLst>
            <pc:docMk/>
            <pc:sldMk cId="2478566023" sldId="277"/>
            <ac:grpSpMk id="3" creationId="{C18D1518-05C5-4DAF-876B-6BA97C227920}"/>
          </ac:grpSpMkLst>
        </pc:grpChg>
        <pc:grpChg chg="add del mod">
          <ac:chgData name="Manasweeta Angane" userId="05da2731-9352-4b35-b713-60351f56afbd" providerId="ADAL" clId="{9DB0C637-5A51-4AF8-848B-0A876275EF09}" dt="2022-06-15T15:07:52.719" v="3412" actId="1076"/>
          <ac:grpSpMkLst>
            <pc:docMk/>
            <pc:sldMk cId="2478566023" sldId="277"/>
            <ac:grpSpMk id="5" creationId="{75DBE16C-6983-4D00-9E2C-6514D346DB0E}"/>
          </ac:grpSpMkLst>
        </pc:grpChg>
        <pc:grpChg chg="del mod topLvl">
          <ac:chgData name="Manasweeta Angane" userId="05da2731-9352-4b35-b713-60351f56afbd" providerId="ADAL" clId="{9DB0C637-5A51-4AF8-848B-0A876275EF09}" dt="2022-06-15T14:29:07.946" v="2589" actId="165"/>
          <ac:grpSpMkLst>
            <pc:docMk/>
            <pc:sldMk cId="2478566023" sldId="277"/>
            <ac:grpSpMk id="21" creationId="{6F06EEB4-0750-4778-A118-4BEA82BD6E74}"/>
          </ac:grpSpMkLst>
        </pc:grpChg>
        <pc:grpChg chg="del mod topLvl">
          <ac:chgData name="Manasweeta Angane" userId="05da2731-9352-4b35-b713-60351f56afbd" providerId="ADAL" clId="{9DB0C637-5A51-4AF8-848B-0A876275EF09}" dt="2022-06-15T14:28:53.365" v="2585" actId="165"/>
          <ac:grpSpMkLst>
            <pc:docMk/>
            <pc:sldMk cId="2478566023" sldId="277"/>
            <ac:grpSpMk id="22" creationId="{069D0259-AB1B-42AB-B24D-48F1914D1FBA}"/>
          </ac:grpSpMkLst>
        </pc:grpChg>
        <pc:grpChg chg="add del mod">
          <ac:chgData name="Manasweeta Angane" userId="05da2731-9352-4b35-b713-60351f56afbd" providerId="ADAL" clId="{9DB0C637-5A51-4AF8-848B-0A876275EF09}" dt="2022-06-15T14:30:11.760" v="2596" actId="165"/>
          <ac:grpSpMkLst>
            <pc:docMk/>
            <pc:sldMk cId="2478566023" sldId="277"/>
            <ac:grpSpMk id="27" creationId="{3E1B6734-0488-4994-A507-9904D2429105}"/>
          </ac:grpSpMkLst>
        </pc:grpChg>
        <pc:grpChg chg="mod topLvl">
          <ac:chgData name="Manasweeta Angane" userId="05da2731-9352-4b35-b713-60351f56afbd" providerId="ADAL" clId="{9DB0C637-5A51-4AF8-848B-0A876275EF09}" dt="2022-06-15T14:34:15.367" v="2623" actId="164"/>
          <ac:grpSpMkLst>
            <pc:docMk/>
            <pc:sldMk cId="2478566023" sldId="277"/>
            <ac:grpSpMk id="28" creationId="{7EF6F77A-A294-4C40-809D-E434A236BE6C}"/>
          </ac:grpSpMkLst>
        </pc:grpChg>
        <pc:grpChg chg="mod topLvl">
          <ac:chgData name="Manasweeta Angane" userId="05da2731-9352-4b35-b713-60351f56afbd" providerId="ADAL" clId="{9DB0C637-5A51-4AF8-848B-0A876275EF09}" dt="2022-06-15T14:33:32.654" v="2601" actId="14100"/>
          <ac:grpSpMkLst>
            <pc:docMk/>
            <pc:sldMk cId="2478566023" sldId="277"/>
            <ac:grpSpMk id="29" creationId="{54D5CA74-7A75-4B9F-BE44-EBA3C23972E8}"/>
          </ac:grpSpMkLst>
        </pc:grpChg>
        <pc:grpChg chg="add mod">
          <ac:chgData name="Manasweeta Angane" userId="05da2731-9352-4b35-b713-60351f56afbd" providerId="ADAL" clId="{9DB0C637-5A51-4AF8-848B-0A876275EF09}" dt="2022-06-15T15:08:02.074" v="3413" actId="1076"/>
          <ac:grpSpMkLst>
            <pc:docMk/>
            <pc:sldMk cId="2478566023" sldId="277"/>
            <ac:grpSpMk id="34" creationId="{9CD79BA0-39D0-45FE-974E-489C03303ABB}"/>
          </ac:grpSpMkLst>
        </pc:grpChg>
        <pc:grpChg chg="add mod">
          <ac:chgData name="Manasweeta Angane" userId="05da2731-9352-4b35-b713-60351f56afbd" providerId="ADAL" clId="{9DB0C637-5A51-4AF8-848B-0A876275EF09}" dt="2022-06-15T14:34:15.367" v="2623" actId="164"/>
          <ac:grpSpMkLst>
            <pc:docMk/>
            <pc:sldMk cId="2478566023" sldId="277"/>
            <ac:grpSpMk id="47" creationId="{1D4C3B56-6928-4FFD-91A4-3F57E0082E85}"/>
          </ac:grpSpMkLst>
        </pc:grpChg>
        <pc:grpChg chg="add mod">
          <ac:chgData name="Manasweeta Angane" userId="05da2731-9352-4b35-b713-60351f56afbd" providerId="ADAL" clId="{9DB0C637-5A51-4AF8-848B-0A876275EF09}" dt="2022-06-15T14:34:15.367" v="2623" actId="164"/>
          <ac:grpSpMkLst>
            <pc:docMk/>
            <pc:sldMk cId="2478566023" sldId="277"/>
            <ac:grpSpMk id="50" creationId="{AB717946-1A9F-4C82-98BE-588661375716}"/>
          </ac:grpSpMkLst>
        </pc:grpChg>
        <pc:grpChg chg="del mod topLvl">
          <ac:chgData name="Manasweeta Angane" userId="05da2731-9352-4b35-b713-60351f56afbd" providerId="ADAL" clId="{9DB0C637-5A51-4AF8-848B-0A876275EF09}" dt="2022-06-15T14:24:41.665" v="2557" actId="21"/>
          <ac:grpSpMkLst>
            <pc:docMk/>
            <pc:sldMk cId="2478566023" sldId="277"/>
            <ac:grpSpMk id="57" creationId="{32A7EF28-B540-461A-9F18-D608DD509516}"/>
          </ac:grpSpMkLst>
        </pc:grpChg>
        <pc:grpChg chg="mod">
          <ac:chgData name="Manasweeta Angane" userId="05da2731-9352-4b35-b713-60351f56afbd" providerId="ADAL" clId="{9DB0C637-5A51-4AF8-848B-0A876275EF09}" dt="2022-06-12T06:54:26.395" v="2444" actId="165"/>
          <ac:grpSpMkLst>
            <pc:docMk/>
            <pc:sldMk cId="2478566023" sldId="277"/>
            <ac:grpSpMk id="59" creationId="{355C1A43-B73B-4884-8F67-F53CB2C386C8}"/>
          </ac:grpSpMkLst>
        </pc:grpChg>
        <pc:grpChg chg="add del mod">
          <ac:chgData name="Manasweeta Angane" userId="05da2731-9352-4b35-b713-60351f56afbd" providerId="ADAL" clId="{9DB0C637-5A51-4AF8-848B-0A876275EF09}" dt="2022-06-15T14:44:36.499" v="2958" actId="478"/>
          <ac:grpSpMkLst>
            <pc:docMk/>
            <pc:sldMk cId="2478566023" sldId="277"/>
            <ac:grpSpMk id="61" creationId="{D6A93FA7-9656-4F4E-AA38-C569DA724D74}"/>
          </ac:grpSpMkLst>
        </pc:grpChg>
        <pc:grpChg chg="mod">
          <ac:chgData name="Manasweeta Angane" userId="05da2731-9352-4b35-b713-60351f56afbd" providerId="ADAL" clId="{9DB0C637-5A51-4AF8-848B-0A876275EF09}" dt="2022-06-12T06:54:26.395" v="2444" actId="165"/>
          <ac:grpSpMkLst>
            <pc:docMk/>
            <pc:sldMk cId="2478566023" sldId="277"/>
            <ac:grpSpMk id="64" creationId="{EBB26CE0-CE52-4D74-9F78-DD11B8461C82}"/>
          </ac:grpSpMkLst>
        </pc:grpChg>
        <pc:grpChg chg="mod">
          <ac:chgData name="Manasweeta Angane" userId="05da2731-9352-4b35-b713-60351f56afbd" providerId="ADAL" clId="{9DB0C637-5A51-4AF8-848B-0A876275EF09}" dt="2022-06-15T14:44:01.138" v="2957"/>
          <ac:grpSpMkLst>
            <pc:docMk/>
            <pc:sldMk cId="2478566023" sldId="277"/>
            <ac:grpSpMk id="68" creationId="{6FBD4F72-EBB6-4A5B-84E2-6F198E27D83D}"/>
          </ac:grpSpMkLst>
        </pc:grpChg>
        <pc:grpChg chg="del mod topLvl">
          <ac:chgData name="Manasweeta Angane" userId="05da2731-9352-4b35-b713-60351f56afbd" providerId="ADAL" clId="{9DB0C637-5A51-4AF8-848B-0A876275EF09}" dt="2022-06-12T06:50:26.602" v="2339" actId="165"/>
          <ac:grpSpMkLst>
            <pc:docMk/>
            <pc:sldMk cId="2478566023" sldId="277"/>
            <ac:grpSpMk id="68" creationId="{F3A67821-5F44-4655-AD18-B7FA09299227}"/>
          </ac:grpSpMkLst>
        </pc:grpChg>
        <pc:grpChg chg="mod">
          <ac:chgData name="Manasweeta Angane" userId="05da2731-9352-4b35-b713-60351f56afbd" providerId="ADAL" clId="{9DB0C637-5A51-4AF8-848B-0A876275EF09}" dt="2022-06-15T14:44:01.138" v="2957"/>
          <ac:grpSpMkLst>
            <pc:docMk/>
            <pc:sldMk cId="2478566023" sldId="277"/>
            <ac:grpSpMk id="69" creationId="{1510F919-70B6-48BD-B2D7-CA88CF95FBAB}"/>
          </ac:grpSpMkLst>
        </pc:grpChg>
        <pc:grpChg chg="mod">
          <ac:chgData name="Manasweeta Angane" userId="05da2731-9352-4b35-b713-60351f56afbd" providerId="ADAL" clId="{9DB0C637-5A51-4AF8-848B-0A876275EF09}" dt="2022-06-15T14:44:01.138" v="2957"/>
          <ac:grpSpMkLst>
            <pc:docMk/>
            <pc:sldMk cId="2478566023" sldId="277"/>
            <ac:grpSpMk id="70" creationId="{D1134D53-81F3-4F48-ABEE-0033AB7E630B}"/>
          </ac:grpSpMkLst>
        </pc:grpChg>
        <pc:grpChg chg="del mod topLvl">
          <ac:chgData name="Manasweeta Angane" userId="05da2731-9352-4b35-b713-60351f56afbd" providerId="ADAL" clId="{9DB0C637-5A51-4AF8-848B-0A876275EF09}" dt="2022-06-12T06:50:26.602" v="2339" actId="165"/>
          <ac:grpSpMkLst>
            <pc:docMk/>
            <pc:sldMk cId="2478566023" sldId="277"/>
            <ac:grpSpMk id="88" creationId="{D4F8A790-9FD6-49D1-B885-3C73094F80A6}"/>
          </ac:grpSpMkLst>
        </pc:grpChg>
        <pc:grpChg chg="del mod topLvl">
          <ac:chgData name="Manasweeta Angane" userId="05da2731-9352-4b35-b713-60351f56afbd" providerId="ADAL" clId="{9DB0C637-5A51-4AF8-848B-0A876275EF09}" dt="2022-06-12T06:50:14.211" v="2335" actId="165"/>
          <ac:grpSpMkLst>
            <pc:docMk/>
            <pc:sldMk cId="2478566023" sldId="277"/>
            <ac:grpSpMk id="90" creationId="{2B057F1E-4E5F-4D1D-B0D6-7787B0EFC9DD}"/>
          </ac:grpSpMkLst>
        </pc:grpChg>
        <pc:grpChg chg="del">
          <ac:chgData name="Manasweeta Angane" userId="05da2731-9352-4b35-b713-60351f56afbd" providerId="ADAL" clId="{9DB0C637-5A51-4AF8-848B-0A876275EF09}" dt="2022-06-12T06:49:51.329" v="2333" actId="165"/>
          <ac:grpSpMkLst>
            <pc:docMk/>
            <pc:sldMk cId="2478566023" sldId="277"/>
            <ac:grpSpMk id="92" creationId="{FDA0F0C9-D173-4B8C-A970-942BDF219E46}"/>
          </ac:grpSpMkLst>
        </pc:grpChg>
        <pc:grpChg chg="del mod topLvl">
          <ac:chgData name="Manasweeta Angane" userId="05da2731-9352-4b35-b713-60351f56afbd" providerId="ADAL" clId="{9DB0C637-5A51-4AF8-848B-0A876275EF09}" dt="2022-06-12T06:50:26.602" v="2339" actId="165"/>
          <ac:grpSpMkLst>
            <pc:docMk/>
            <pc:sldMk cId="2478566023" sldId="277"/>
            <ac:grpSpMk id="96" creationId="{09DB888B-5911-4D60-915B-3FB925B87A46}"/>
          </ac:grpSpMkLst>
        </pc:grpChg>
        <pc:graphicFrameChg chg="add del mod modGraphic">
          <ac:chgData name="Manasweeta Angane" userId="05da2731-9352-4b35-b713-60351f56afbd" providerId="ADAL" clId="{9DB0C637-5A51-4AF8-848B-0A876275EF09}" dt="2022-06-14T10:30:45.698" v="2460" actId="478"/>
          <ac:graphicFrameMkLst>
            <pc:docMk/>
            <pc:sldMk cId="2478566023" sldId="277"/>
            <ac:graphicFrameMk id="4" creationId="{25D89DBA-AB13-4A4E-AD37-D682BFA2914E}"/>
          </ac:graphicFrameMkLst>
        </pc:graphicFrameChg>
        <pc:graphicFrameChg chg="add del mod">
          <ac:chgData name="Manasweeta Angane" userId="05da2731-9352-4b35-b713-60351f56afbd" providerId="ADAL" clId="{9DB0C637-5A51-4AF8-848B-0A876275EF09}" dt="2022-06-15T14:38:31.939" v="2945" actId="12084"/>
          <ac:graphicFrameMkLst>
            <pc:docMk/>
            <pc:sldMk cId="2478566023" sldId="277"/>
            <ac:graphicFrameMk id="4" creationId="{84640BAB-B6BE-46B3-8019-404B2AD17C5B}"/>
          </ac:graphicFrameMkLst>
        </pc:graphicFrameChg>
        <pc:graphicFrameChg chg="mod">
          <ac:chgData name="Manasweeta Angane" userId="05da2731-9352-4b35-b713-60351f56afbd" providerId="ADAL" clId="{9DB0C637-5A51-4AF8-848B-0A876275EF09}" dt="2022-06-15T14:30:11.760" v="2596" actId="165"/>
          <ac:graphicFrameMkLst>
            <pc:docMk/>
            <pc:sldMk cId="2478566023" sldId="277"/>
            <ac:graphicFrameMk id="41" creationId="{6F19C738-A72E-4149-8FB4-751F6E4FD3CD}"/>
          </ac:graphicFrameMkLst>
        </pc:graphicFrameChg>
        <pc:graphicFrameChg chg="mod">
          <ac:chgData name="Manasweeta Angane" userId="05da2731-9352-4b35-b713-60351f56afbd" providerId="ADAL" clId="{9DB0C637-5A51-4AF8-848B-0A876275EF09}" dt="2022-06-16T10:28:39.105" v="3464" actId="1037"/>
          <ac:graphicFrameMkLst>
            <pc:docMk/>
            <pc:sldMk cId="2478566023" sldId="277"/>
            <ac:graphicFrameMk id="54" creationId="{EFE8D310-F98E-436C-9E2A-DE86F1128AEB}"/>
          </ac:graphicFrameMkLst>
        </pc:graphicFrameChg>
        <pc:graphicFrameChg chg="add del mod">
          <ac:chgData name="Manasweeta Angane" userId="05da2731-9352-4b35-b713-60351f56afbd" providerId="ADAL" clId="{9DB0C637-5A51-4AF8-848B-0A876275EF09}" dt="2022-06-15T14:37:01.547" v="2813" actId="478"/>
          <ac:graphicFrameMkLst>
            <pc:docMk/>
            <pc:sldMk cId="2478566023" sldId="277"/>
            <ac:graphicFrameMk id="60" creationId="{DFC6BA1B-2EC0-4BB3-9E19-950D5C01F8F5}"/>
          </ac:graphicFrameMkLst>
        </pc:graphicFrameChg>
        <pc:graphicFrameChg chg="mod ord">
          <ac:chgData name="Manasweeta Angane" userId="05da2731-9352-4b35-b713-60351f56afbd" providerId="ADAL" clId="{9DB0C637-5A51-4AF8-848B-0A876275EF09}" dt="2022-06-15T14:23:34.590" v="2469" actId="1037"/>
          <ac:graphicFrameMkLst>
            <pc:docMk/>
            <pc:sldMk cId="2478566023" sldId="277"/>
            <ac:graphicFrameMk id="67" creationId="{53640C11-6B8C-4EA4-958B-65E47B72EEBD}"/>
          </ac:graphicFrameMkLst>
        </pc:graphicFrameChg>
        <pc:graphicFrameChg chg="add del mod">
          <ac:chgData name="Manasweeta Angane" userId="05da2731-9352-4b35-b713-60351f56afbd" providerId="ADAL" clId="{9DB0C637-5A51-4AF8-848B-0A876275EF09}" dt="2022-06-15T15:14:34.208" v="3430" actId="478"/>
          <ac:graphicFrameMkLst>
            <pc:docMk/>
            <pc:sldMk cId="2478566023" sldId="277"/>
            <ac:graphicFrameMk id="86" creationId="{A9F91DB1-ED29-411E-9F76-9E56963EA791}"/>
          </ac:graphicFrameMkLst>
        </pc:graphicFrameChg>
        <pc:graphicFrameChg chg="add del mod">
          <ac:chgData name="Manasweeta Angane" userId="05da2731-9352-4b35-b713-60351f56afbd" providerId="ADAL" clId="{9DB0C637-5A51-4AF8-848B-0A876275EF09}" dt="2022-06-15T15:28:21.996" v="3462" actId="2085"/>
          <ac:graphicFrameMkLst>
            <pc:docMk/>
            <pc:sldMk cId="2478566023" sldId="277"/>
            <ac:graphicFrameMk id="88" creationId="{00000000-0008-0000-0400-000004000000}"/>
          </ac:graphicFrameMkLst>
        </pc:graphicFrameChg>
        <pc:graphicFrameChg chg="add del mod">
          <ac:chgData name="Manasweeta Angane" userId="05da2731-9352-4b35-b713-60351f56afbd" providerId="ADAL" clId="{9DB0C637-5A51-4AF8-848B-0A876275EF09}" dt="2022-06-15T15:22:31.889" v="3461" actId="478"/>
          <ac:graphicFrameMkLst>
            <pc:docMk/>
            <pc:sldMk cId="2478566023" sldId="277"/>
            <ac:graphicFrameMk id="89" creationId="{C9EE23F6-C42D-46E7-9136-04BC8F627C4E}"/>
          </ac:graphicFrameMkLst>
        </pc:graphicFrameChg>
        <pc:graphicFrameChg chg="del">
          <ac:chgData name="Manasweeta Angane" userId="05da2731-9352-4b35-b713-60351f56afbd" providerId="ADAL" clId="{9DB0C637-5A51-4AF8-848B-0A876275EF09}" dt="2022-06-12T06:49:55.352" v="2334" actId="478"/>
          <ac:graphicFrameMkLst>
            <pc:docMk/>
            <pc:sldMk cId="2478566023" sldId="277"/>
            <ac:graphicFrameMk id="91" creationId="{692223E4-6AA9-47F4-8738-CF0F1ABCA849}"/>
          </ac:graphicFrameMkLst>
        </pc:graphicFrameChg>
        <pc:picChg chg="add del mod">
          <ac:chgData name="Manasweeta Angane" userId="05da2731-9352-4b35-b713-60351f56afbd" providerId="ADAL" clId="{9DB0C637-5A51-4AF8-848B-0A876275EF09}" dt="2022-06-15T15:21:06.906" v="3453" actId="478"/>
          <ac:picMkLst>
            <pc:docMk/>
            <pc:sldMk cId="2478566023" sldId="277"/>
            <ac:picMk id="3" creationId="{7326DEB1-BDFF-481F-B89C-4ED00E41E246}"/>
          </ac:picMkLst>
        </pc:picChg>
        <pc:picChg chg="add del mod">
          <ac:chgData name="Manasweeta Angane" userId="05da2731-9352-4b35-b713-60351f56afbd" providerId="ADAL" clId="{9DB0C637-5A51-4AF8-848B-0A876275EF09}" dt="2022-06-15T15:19:33.481" v="3448" actId="478"/>
          <ac:picMkLst>
            <pc:docMk/>
            <pc:sldMk cId="2478566023" sldId="277"/>
            <ac:picMk id="8" creationId="{9E712C26-B291-45C8-9024-B7785247D6AF}"/>
          </ac:picMkLst>
        </pc:picChg>
        <pc:picChg chg="mod topLvl">
          <ac:chgData name="Manasweeta Angane" userId="05da2731-9352-4b35-b713-60351f56afbd" providerId="ADAL" clId="{9DB0C637-5A51-4AF8-848B-0A876275EF09}" dt="2022-06-15T14:30:11.760" v="2596" actId="165"/>
          <ac:picMkLst>
            <pc:docMk/>
            <pc:sldMk cId="2478566023" sldId="277"/>
            <ac:picMk id="30" creationId="{CFC5AEC8-D678-4DBB-95E5-78C200643EEA}"/>
          </ac:picMkLst>
        </pc:picChg>
        <pc:picChg chg="mod topLvl">
          <ac:chgData name="Manasweeta Angane" userId="05da2731-9352-4b35-b713-60351f56afbd" providerId="ADAL" clId="{9DB0C637-5A51-4AF8-848B-0A876275EF09}" dt="2022-06-15T14:33:32.654" v="2601" actId="14100"/>
          <ac:picMkLst>
            <pc:docMk/>
            <pc:sldMk cId="2478566023" sldId="277"/>
            <ac:picMk id="31" creationId="{9F87B7BC-E90B-48D9-8C6C-8B983727CD0B}"/>
          </ac:picMkLst>
        </pc:picChg>
        <pc:picChg chg="mod topLvl">
          <ac:chgData name="Manasweeta Angane" userId="05da2731-9352-4b35-b713-60351f56afbd" providerId="ADAL" clId="{9DB0C637-5A51-4AF8-848B-0A876275EF09}" dt="2022-06-15T14:33:32.654" v="2601" actId="14100"/>
          <ac:picMkLst>
            <pc:docMk/>
            <pc:sldMk cId="2478566023" sldId="277"/>
            <ac:picMk id="32" creationId="{46D177A0-AFC7-4040-8663-580651AC5958}"/>
          </ac:picMkLst>
        </pc:picChg>
        <pc:picChg chg="mod">
          <ac:chgData name="Manasweeta Angane" userId="05da2731-9352-4b35-b713-60351f56afbd" providerId="ADAL" clId="{9DB0C637-5A51-4AF8-848B-0A876275EF09}" dt="2022-06-15T14:30:11.760" v="2596" actId="165"/>
          <ac:picMkLst>
            <pc:docMk/>
            <pc:sldMk cId="2478566023" sldId="277"/>
            <ac:picMk id="33" creationId="{8908C865-9005-4919-80F9-74805F80E1C0}"/>
          </ac:picMkLst>
        </pc:picChg>
        <pc:picChg chg="mod">
          <ac:chgData name="Manasweeta Angane" userId="05da2731-9352-4b35-b713-60351f56afbd" providerId="ADAL" clId="{9DB0C637-5A51-4AF8-848B-0A876275EF09}" dt="2022-06-15T15:08:02.074" v="3413" actId="1076"/>
          <ac:picMkLst>
            <pc:docMk/>
            <pc:sldMk cId="2478566023" sldId="277"/>
            <ac:picMk id="35" creationId="{E4A854CB-5BBA-403C-93A4-ECA1286C1F40}"/>
          </ac:picMkLst>
        </pc:picChg>
        <pc:picChg chg="mod">
          <ac:chgData name="Manasweeta Angane" userId="05da2731-9352-4b35-b713-60351f56afbd" providerId="ADAL" clId="{9DB0C637-5A51-4AF8-848B-0A876275EF09}" dt="2022-06-15T15:08:02.074" v="3413" actId="1076"/>
          <ac:picMkLst>
            <pc:docMk/>
            <pc:sldMk cId="2478566023" sldId="277"/>
            <ac:picMk id="36" creationId="{BFB09B2F-53FE-4D3D-BEBA-94774DA3459C}"/>
          </ac:picMkLst>
        </pc:picChg>
        <pc:picChg chg="mod">
          <ac:chgData name="Manasweeta Angane" userId="05da2731-9352-4b35-b713-60351f56afbd" providerId="ADAL" clId="{9DB0C637-5A51-4AF8-848B-0A876275EF09}" dt="2022-06-15T15:08:02.074" v="3413" actId="1076"/>
          <ac:picMkLst>
            <pc:docMk/>
            <pc:sldMk cId="2478566023" sldId="277"/>
            <ac:picMk id="37" creationId="{62A9F9C5-7705-4FE3-B8B5-E0CA387A318B}"/>
          </ac:picMkLst>
        </pc:picChg>
        <pc:picChg chg="mod topLvl">
          <ac:chgData name="Manasweeta Angane" userId="05da2731-9352-4b35-b713-60351f56afbd" providerId="ADAL" clId="{9DB0C637-5A51-4AF8-848B-0A876275EF09}" dt="2022-06-15T14:52:44.779" v="3063" actId="1076"/>
          <ac:picMkLst>
            <pc:docMk/>
            <pc:sldMk cId="2478566023" sldId="277"/>
            <ac:picMk id="51" creationId="{4263E31F-E179-4155-844D-3925ED8701A0}"/>
          </ac:picMkLst>
        </pc:picChg>
        <pc:picChg chg="mod">
          <ac:chgData name="Manasweeta Angane" userId="05da2731-9352-4b35-b713-60351f56afbd" providerId="ADAL" clId="{9DB0C637-5A51-4AF8-848B-0A876275EF09}" dt="2022-06-15T14:33:54.232" v="2622" actId="571"/>
          <ac:picMkLst>
            <pc:docMk/>
            <pc:sldMk cId="2478566023" sldId="277"/>
            <ac:picMk id="52" creationId="{300AE812-47A1-4D8D-8CE8-B044427F52D5}"/>
          </ac:picMkLst>
        </pc:picChg>
        <pc:picChg chg="add mod">
          <ac:chgData name="Manasweeta Angane" userId="05da2731-9352-4b35-b713-60351f56afbd" providerId="ADAL" clId="{9DB0C637-5A51-4AF8-848B-0A876275EF09}" dt="2022-06-15T14:34:15.367" v="2623" actId="164"/>
          <ac:picMkLst>
            <pc:docMk/>
            <pc:sldMk cId="2478566023" sldId="277"/>
            <ac:picMk id="55" creationId="{8AB90C67-13E3-423A-899E-2B06E318E965}"/>
          </ac:picMkLst>
        </pc:picChg>
        <pc:picChg chg="add mod">
          <ac:chgData name="Manasweeta Angane" userId="05da2731-9352-4b35-b713-60351f56afbd" providerId="ADAL" clId="{9DB0C637-5A51-4AF8-848B-0A876275EF09}" dt="2022-06-15T14:34:15.367" v="2623" actId="164"/>
          <ac:picMkLst>
            <pc:docMk/>
            <pc:sldMk cId="2478566023" sldId="277"/>
            <ac:picMk id="56" creationId="{FE048E57-1F96-4798-AF8F-8730964C6A5E}"/>
          </ac:picMkLst>
        </pc:picChg>
        <pc:picChg chg="add mod">
          <ac:chgData name="Manasweeta Angane" userId="05da2731-9352-4b35-b713-60351f56afbd" providerId="ADAL" clId="{9DB0C637-5A51-4AF8-848B-0A876275EF09}" dt="2022-06-15T14:34:15.367" v="2623" actId="164"/>
          <ac:picMkLst>
            <pc:docMk/>
            <pc:sldMk cId="2478566023" sldId="277"/>
            <ac:picMk id="58" creationId="{B9C0153F-E44B-4FCF-9622-582228F55E56}"/>
          </ac:picMkLst>
        </pc:picChg>
        <pc:picChg chg="mod">
          <ac:chgData name="Manasweeta Angane" userId="05da2731-9352-4b35-b713-60351f56afbd" providerId="ADAL" clId="{9DB0C637-5A51-4AF8-848B-0A876275EF09}" dt="2022-06-12T06:54:26.395" v="2444" actId="165"/>
          <ac:picMkLst>
            <pc:docMk/>
            <pc:sldMk cId="2478566023" sldId="277"/>
            <ac:picMk id="65" creationId="{CF58F6E4-A4F3-4DAF-896D-70DA30A9E6A7}"/>
          </ac:picMkLst>
        </pc:picChg>
        <pc:picChg chg="del mod topLvl">
          <ac:chgData name="Manasweeta Angane" userId="05da2731-9352-4b35-b713-60351f56afbd" providerId="ADAL" clId="{9DB0C637-5A51-4AF8-848B-0A876275EF09}" dt="2022-06-12T06:51:02.423" v="2347" actId="478"/>
          <ac:picMkLst>
            <pc:docMk/>
            <pc:sldMk cId="2478566023" sldId="277"/>
            <ac:picMk id="69" creationId="{E30A9DA0-0574-4D53-BCC2-5A0DB16FABE3}"/>
          </ac:picMkLst>
        </pc:picChg>
        <pc:picChg chg="del mod topLvl">
          <ac:chgData name="Manasweeta Angane" userId="05da2731-9352-4b35-b713-60351f56afbd" providerId="ADAL" clId="{9DB0C637-5A51-4AF8-848B-0A876275EF09}" dt="2022-06-12T06:51:07.912" v="2352" actId="478"/>
          <ac:picMkLst>
            <pc:docMk/>
            <pc:sldMk cId="2478566023" sldId="277"/>
            <ac:picMk id="70" creationId="{DDA8056A-655E-4819-98D0-A027A537A31D}"/>
          </ac:picMkLst>
        </pc:picChg>
        <pc:picChg chg="mod">
          <ac:chgData name="Manasweeta Angane" userId="05da2731-9352-4b35-b713-60351f56afbd" providerId="ADAL" clId="{9DB0C637-5A51-4AF8-848B-0A876275EF09}" dt="2022-06-15T14:44:01.138" v="2957"/>
          <ac:picMkLst>
            <pc:docMk/>
            <pc:sldMk cId="2478566023" sldId="277"/>
            <ac:picMk id="71" creationId="{016179B6-43BE-4A6D-B36C-CCF153BB80B4}"/>
          </ac:picMkLst>
        </pc:picChg>
        <pc:picChg chg="del mod topLvl">
          <ac:chgData name="Manasweeta Angane" userId="05da2731-9352-4b35-b713-60351f56afbd" providerId="ADAL" clId="{9DB0C637-5A51-4AF8-848B-0A876275EF09}" dt="2022-06-12T06:51:04.216" v="2348" actId="478"/>
          <ac:picMkLst>
            <pc:docMk/>
            <pc:sldMk cId="2478566023" sldId="277"/>
            <ac:picMk id="71" creationId="{84690B64-1FE6-4BE7-B5F2-7604DAAAD836}"/>
          </ac:picMkLst>
        </pc:picChg>
        <pc:picChg chg="mod">
          <ac:chgData name="Manasweeta Angane" userId="05da2731-9352-4b35-b713-60351f56afbd" providerId="ADAL" clId="{9DB0C637-5A51-4AF8-848B-0A876275EF09}" dt="2022-06-15T14:44:01.138" v="2957"/>
          <ac:picMkLst>
            <pc:docMk/>
            <pc:sldMk cId="2478566023" sldId="277"/>
            <ac:picMk id="72" creationId="{F8B5D1A1-E41A-4E2C-A103-C1DF161D97C1}"/>
          </ac:picMkLst>
        </pc:picChg>
        <pc:picChg chg="mod">
          <ac:chgData name="Manasweeta Angane" userId="05da2731-9352-4b35-b713-60351f56afbd" providerId="ADAL" clId="{9DB0C637-5A51-4AF8-848B-0A876275EF09}" dt="2022-06-15T14:44:01.138" v="2957"/>
          <ac:picMkLst>
            <pc:docMk/>
            <pc:sldMk cId="2478566023" sldId="277"/>
            <ac:picMk id="73" creationId="{947C88CC-DA85-48FC-9ED8-1315DEFA5154}"/>
          </ac:picMkLst>
        </pc:picChg>
        <pc:picChg chg="mod">
          <ac:chgData name="Manasweeta Angane" userId="05da2731-9352-4b35-b713-60351f56afbd" providerId="ADAL" clId="{9DB0C637-5A51-4AF8-848B-0A876275EF09}" dt="2022-06-15T14:44:01.138" v="2957"/>
          <ac:picMkLst>
            <pc:docMk/>
            <pc:sldMk cId="2478566023" sldId="277"/>
            <ac:picMk id="74" creationId="{836C6C89-A826-48AB-A680-9CF567066E7B}"/>
          </ac:picMkLst>
        </pc:picChg>
        <pc:picChg chg="mod">
          <ac:chgData name="Manasweeta Angane" userId="05da2731-9352-4b35-b713-60351f56afbd" providerId="ADAL" clId="{9DB0C637-5A51-4AF8-848B-0A876275EF09}" dt="2022-06-15T14:44:01.138" v="2957"/>
          <ac:picMkLst>
            <pc:docMk/>
            <pc:sldMk cId="2478566023" sldId="277"/>
            <ac:picMk id="75" creationId="{30768B66-D101-4BA2-94AA-188AF63FC5BC}"/>
          </ac:picMkLst>
        </pc:picChg>
        <pc:picChg chg="mod">
          <ac:chgData name="Manasweeta Angane" userId="05da2731-9352-4b35-b713-60351f56afbd" providerId="ADAL" clId="{9DB0C637-5A51-4AF8-848B-0A876275EF09}" dt="2022-06-12T06:54:26.395" v="2444" actId="165"/>
          <ac:picMkLst>
            <pc:docMk/>
            <pc:sldMk cId="2478566023" sldId="277"/>
            <ac:picMk id="77" creationId="{4B693F6C-4EFB-4904-9169-60EB952A3033}"/>
          </ac:picMkLst>
        </pc:picChg>
        <pc:picChg chg="mod">
          <ac:chgData name="Manasweeta Angane" userId="05da2731-9352-4b35-b713-60351f56afbd" providerId="ADAL" clId="{9DB0C637-5A51-4AF8-848B-0A876275EF09}" dt="2022-06-12T06:54:26.395" v="2444" actId="165"/>
          <ac:picMkLst>
            <pc:docMk/>
            <pc:sldMk cId="2478566023" sldId="277"/>
            <ac:picMk id="78" creationId="{0331A042-666F-44FC-8ACF-7210DA11C303}"/>
          </ac:picMkLst>
        </pc:picChg>
        <pc:picChg chg="mod">
          <ac:chgData name="Manasweeta Angane" userId="05da2731-9352-4b35-b713-60351f56afbd" providerId="ADAL" clId="{9DB0C637-5A51-4AF8-848B-0A876275EF09}" dt="2022-06-12T06:54:26.395" v="2444" actId="165"/>
          <ac:picMkLst>
            <pc:docMk/>
            <pc:sldMk cId="2478566023" sldId="277"/>
            <ac:picMk id="79" creationId="{2CFA76D1-EE3C-4080-A4B8-188405E52973}"/>
          </ac:picMkLst>
        </pc:picChg>
        <pc:picChg chg="mod topLvl">
          <ac:chgData name="Manasweeta Angane" userId="05da2731-9352-4b35-b713-60351f56afbd" providerId="ADAL" clId="{9DB0C637-5A51-4AF8-848B-0A876275EF09}" dt="2022-06-15T14:43:24.195" v="2956" actId="1440"/>
          <ac:picMkLst>
            <pc:docMk/>
            <pc:sldMk cId="2478566023" sldId="277"/>
            <ac:picMk id="81" creationId="{A5BDBDAB-6A01-42AA-A8FE-338FB3955417}"/>
          </ac:picMkLst>
        </pc:picChg>
        <pc:picChg chg="mod topLvl">
          <ac:chgData name="Manasweeta Angane" userId="05da2731-9352-4b35-b713-60351f56afbd" providerId="ADAL" clId="{9DB0C637-5A51-4AF8-848B-0A876275EF09}" dt="2022-06-15T14:43:24.195" v="2956" actId="1440"/>
          <ac:picMkLst>
            <pc:docMk/>
            <pc:sldMk cId="2478566023" sldId="277"/>
            <ac:picMk id="87" creationId="{FFF0AC6F-26C5-4E72-954E-234422FB8D45}"/>
          </ac:picMkLst>
        </pc:picChg>
        <pc:picChg chg="mod topLvl">
          <ac:chgData name="Manasweeta Angane" userId="05da2731-9352-4b35-b713-60351f56afbd" providerId="ADAL" clId="{9DB0C637-5A51-4AF8-848B-0A876275EF09}" dt="2022-06-15T14:53:01.220" v="3064" actId="1076"/>
          <ac:picMkLst>
            <pc:docMk/>
            <pc:sldMk cId="2478566023" sldId="277"/>
            <ac:picMk id="1036" creationId="{1D8EE2AA-F50C-4A4C-8964-F14F928562B3}"/>
          </ac:picMkLst>
        </pc:picChg>
      </pc:sldChg>
    </pc:docChg>
  </pc:docChgLst>
  <pc:docChgLst>
    <pc:chgData name="Manasweeta Angane" userId="05da2731-9352-4b35-b713-60351f56afbd" providerId="ADAL" clId="{9F8E7246-803F-4AD4-AD02-5ADAFDA400F2}"/>
    <pc:docChg chg="undo redo custSel addSld modSld sldOrd">
      <pc:chgData name="Manasweeta Angane" userId="05da2731-9352-4b35-b713-60351f56afbd" providerId="ADAL" clId="{9F8E7246-803F-4AD4-AD02-5ADAFDA400F2}" dt="2021-05-23T00:20:53.560" v="4694" actId="1076"/>
      <pc:docMkLst>
        <pc:docMk/>
      </pc:docMkLst>
      <pc:sldChg chg="addSp delSp modSp mod">
        <pc:chgData name="Manasweeta Angane" userId="05da2731-9352-4b35-b713-60351f56afbd" providerId="ADAL" clId="{9F8E7246-803F-4AD4-AD02-5ADAFDA400F2}" dt="2021-05-10T11:33:40.748" v="449" actId="166"/>
        <pc:sldMkLst>
          <pc:docMk/>
          <pc:sldMk cId="2764835349" sldId="259"/>
        </pc:sldMkLst>
        <pc:spChg chg="mod">
          <ac:chgData name="Manasweeta Angane" userId="05da2731-9352-4b35-b713-60351f56afbd" providerId="ADAL" clId="{9F8E7246-803F-4AD4-AD02-5ADAFDA400F2}" dt="2021-04-03T03:38:26.807" v="0"/>
          <ac:spMkLst>
            <pc:docMk/>
            <pc:sldMk cId="2764835349" sldId="259"/>
            <ac:spMk id="19" creationId="{D62E7651-5122-4CA4-9103-884B7B2A1FA4}"/>
          </ac:spMkLst>
        </pc:spChg>
        <pc:grpChg chg="add mod">
          <ac:chgData name="Manasweeta Angane" userId="05da2731-9352-4b35-b713-60351f56afbd" providerId="ADAL" clId="{9F8E7246-803F-4AD4-AD02-5ADAFDA400F2}" dt="2021-04-03T03:38:36.765" v="53" actId="1037"/>
          <ac:grpSpMkLst>
            <pc:docMk/>
            <pc:sldMk cId="2764835349" sldId="259"/>
            <ac:grpSpMk id="17" creationId="{725AAB17-22B0-40CC-AB71-822FC7F9F2A9}"/>
          </ac:grpSpMkLst>
        </pc:grpChg>
        <pc:picChg chg="mod">
          <ac:chgData name="Manasweeta Angane" userId="05da2731-9352-4b35-b713-60351f56afbd" providerId="ADAL" clId="{9F8E7246-803F-4AD4-AD02-5ADAFDA400F2}" dt="2021-05-10T10:02:43.192" v="245"/>
          <ac:picMkLst>
            <pc:docMk/>
            <pc:sldMk cId="2764835349" sldId="259"/>
            <ac:picMk id="16" creationId="{0C632A22-601E-4654-98A4-B752DAB0A5BB}"/>
          </ac:picMkLst>
        </pc:picChg>
        <pc:picChg chg="add mod">
          <ac:chgData name="Manasweeta Angane" userId="05da2731-9352-4b35-b713-60351f56afbd" providerId="ADAL" clId="{9F8E7246-803F-4AD4-AD02-5ADAFDA400F2}" dt="2021-05-10T11:28:09.081" v="406"/>
          <ac:picMkLst>
            <pc:docMk/>
            <pc:sldMk cId="2764835349" sldId="259"/>
            <ac:picMk id="17" creationId="{38F0623C-1AF6-479B-B595-A800114A58E6}"/>
          </ac:picMkLst>
        </pc:picChg>
        <pc:picChg chg="add mod">
          <ac:chgData name="Manasweeta Angane" userId="05da2731-9352-4b35-b713-60351f56afbd" providerId="ADAL" clId="{9F8E7246-803F-4AD4-AD02-5ADAFDA400F2}" dt="2021-05-09T04:41:59.983" v="105"/>
          <ac:picMkLst>
            <pc:docMk/>
            <pc:sldMk cId="2764835349" sldId="259"/>
            <ac:picMk id="18" creationId="{693716A8-F217-4C3C-9390-BF8D34EA63BC}"/>
          </ac:picMkLst>
        </pc:picChg>
        <pc:picChg chg="mod">
          <ac:chgData name="Manasweeta Angane" userId="05da2731-9352-4b35-b713-60351f56afbd" providerId="ADAL" clId="{9F8E7246-803F-4AD4-AD02-5ADAFDA400F2}" dt="2021-04-03T03:38:26.807" v="0"/>
          <ac:picMkLst>
            <pc:docMk/>
            <pc:sldMk cId="2764835349" sldId="259"/>
            <ac:picMk id="18" creationId="{FCC5A82E-52DA-4921-A1DA-D81C062E9D17}"/>
          </ac:picMkLst>
        </pc:picChg>
        <pc:picChg chg="add mod">
          <ac:chgData name="Manasweeta Angane" userId="05da2731-9352-4b35-b713-60351f56afbd" providerId="ADAL" clId="{9F8E7246-803F-4AD4-AD02-5ADAFDA400F2}" dt="2021-05-09T04:42:22.070" v="111" actId="1076"/>
          <ac:picMkLst>
            <pc:docMk/>
            <pc:sldMk cId="2764835349" sldId="259"/>
            <ac:picMk id="19" creationId="{B7587D7F-18C7-4E38-B82C-D76225ECF0AD}"/>
          </ac:picMkLst>
        </pc:picChg>
        <pc:picChg chg="add mod">
          <ac:chgData name="Manasweeta Angane" userId="05da2731-9352-4b35-b713-60351f56afbd" providerId="ADAL" clId="{9F8E7246-803F-4AD4-AD02-5ADAFDA400F2}" dt="2021-05-10T11:19:54.193" v="398"/>
          <ac:picMkLst>
            <pc:docMk/>
            <pc:sldMk cId="2764835349" sldId="259"/>
            <ac:picMk id="20" creationId="{50B70FDF-93B1-4D04-AD61-1C03C186CA64}"/>
          </ac:picMkLst>
        </pc:picChg>
        <pc:picChg chg="add mod">
          <ac:chgData name="Manasweeta Angane" userId="05da2731-9352-4b35-b713-60351f56afbd" providerId="ADAL" clId="{9F8E7246-803F-4AD4-AD02-5ADAFDA400F2}" dt="2021-05-10T11:20:00.277" v="399"/>
          <ac:picMkLst>
            <pc:docMk/>
            <pc:sldMk cId="2764835349" sldId="259"/>
            <ac:picMk id="26" creationId="{17767071-EEEB-47A6-9C9F-EC579458EAD2}"/>
          </ac:picMkLst>
        </pc:picChg>
        <pc:picChg chg="mod">
          <ac:chgData name="Manasweeta Angane" userId="05da2731-9352-4b35-b713-60351f56afbd" providerId="ADAL" clId="{9F8E7246-803F-4AD4-AD02-5ADAFDA400F2}" dt="2021-05-10T11:08:05.076" v="380" actId="1076"/>
          <ac:picMkLst>
            <pc:docMk/>
            <pc:sldMk cId="2764835349" sldId="259"/>
            <ac:picMk id="27" creationId="{AD90960C-5D7B-42B1-BCEA-05C5E386F7E8}"/>
          </ac:picMkLst>
        </pc:picChg>
        <pc:picChg chg="add mod">
          <ac:chgData name="Manasweeta Angane" userId="05da2731-9352-4b35-b713-60351f56afbd" providerId="ADAL" clId="{9F8E7246-803F-4AD4-AD02-5ADAFDA400F2}" dt="2021-05-10T11:25:38.589" v="403"/>
          <ac:picMkLst>
            <pc:docMk/>
            <pc:sldMk cId="2764835349" sldId="259"/>
            <ac:picMk id="28" creationId="{14464A21-7546-4B1B-8F2D-8446CE74DBFF}"/>
          </ac:picMkLst>
        </pc:picChg>
        <pc:picChg chg="add mod">
          <ac:chgData name="Manasweeta Angane" userId="05da2731-9352-4b35-b713-60351f56afbd" providerId="ADAL" clId="{9F8E7246-803F-4AD4-AD02-5ADAFDA400F2}" dt="2021-05-10T10:07:29.218" v="273" actId="1076"/>
          <ac:picMkLst>
            <pc:docMk/>
            <pc:sldMk cId="2764835349" sldId="259"/>
            <ac:picMk id="29" creationId="{02A73C63-BECD-47DA-830F-3177CAE5D067}"/>
          </ac:picMkLst>
        </pc:picChg>
        <pc:picChg chg="add mod">
          <ac:chgData name="Manasweeta Angane" userId="05da2731-9352-4b35-b713-60351f56afbd" providerId="ADAL" clId="{9F8E7246-803F-4AD4-AD02-5ADAFDA400F2}" dt="2021-05-10T10:07:33.498" v="274" actId="1076"/>
          <ac:picMkLst>
            <pc:docMk/>
            <pc:sldMk cId="2764835349" sldId="259"/>
            <ac:picMk id="30" creationId="{D0C48259-0540-4F71-A869-2FD8D071695D}"/>
          </ac:picMkLst>
        </pc:picChg>
        <pc:picChg chg="add mod">
          <ac:chgData name="Manasweeta Angane" userId="05da2731-9352-4b35-b713-60351f56afbd" providerId="ADAL" clId="{9F8E7246-803F-4AD4-AD02-5ADAFDA400F2}" dt="2021-05-10T11:26:07.073" v="405" actId="1076"/>
          <ac:picMkLst>
            <pc:docMk/>
            <pc:sldMk cId="2764835349" sldId="259"/>
            <ac:picMk id="31" creationId="{318D01EE-B552-46A9-8EA2-F37ECF766573}"/>
          </ac:picMkLst>
        </pc:picChg>
        <pc:picChg chg="add mod">
          <ac:chgData name="Manasweeta Angane" userId="05da2731-9352-4b35-b713-60351f56afbd" providerId="ADAL" clId="{9F8E7246-803F-4AD4-AD02-5ADAFDA400F2}" dt="2021-05-10T11:30:13.915" v="425" actId="1076"/>
          <ac:picMkLst>
            <pc:docMk/>
            <pc:sldMk cId="2764835349" sldId="259"/>
            <ac:picMk id="32" creationId="{78F641C7-DEC6-4A2C-B4F1-78C77B3E6CC9}"/>
          </ac:picMkLst>
        </pc:picChg>
        <pc:picChg chg="add mod">
          <ac:chgData name="Manasweeta Angane" userId="05da2731-9352-4b35-b713-60351f56afbd" providerId="ADAL" clId="{9F8E7246-803F-4AD4-AD02-5ADAFDA400F2}" dt="2021-05-10T10:02:30.191" v="244"/>
          <ac:picMkLst>
            <pc:docMk/>
            <pc:sldMk cId="2764835349" sldId="259"/>
            <ac:picMk id="33" creationId="{83E4B70F-3591-48E4-90F3-916C383129BF}"/>
          </ac:picMkLst>
        </pc:picChg>
        <pc:picChg chg="add mod">
          <ac:chgData name="Manasweeta Angane" userId="05da2731-9352-4b35-b713-60351f56afbd" providerId="ADAL" clId="{9F8E7246-803F-4AD4-AD02-5ADAFDA400F2}" dt="2021-05-10T09:59:19.848" v="232" actId="1076"/>
          <ac:picMkLst>
            <pc:docMk/>
            <pc:sldMk cId="2764835349" sldId="259"/>
            <ac:picMk id="34" creationId="{11CC7DF1-B1F0-4AE6-93EC-0529CD492466}"/>
          </ac:picMkLst>
        </pc:picChg>
        <pc:picChg chg="add mod">
          <ac:chgData name="Manasweeta Angane" userId="05da2731-9352-4b35-b713-60351f56afbd" providerId="ADAL" clId="{9F8E7246-803F-4AD4-AD02-5ADAFDA400F2}" dt="2021-05-10T10:18:34.421" v="348" actId="1076"/>
          <ac:picMkLst>
            <pc:docMk/>
            <pc:sldMk cId="2764835349" sldId="259"/>
            <ac:picMk id="35" creationId="{93F7C139-363C-45B3-B7AE-EF89DF394249}"/>
          </ac:picMkLst>
        </pc:picChg>
        <pc:picChg chg="add mod">
          <ac:chgData name="Manasweeta Angane" userId="05da2731-9352-4b35-b713-60351f56afbd" providerId="ADAL" clId="{9F8E7246-803F-4AD4-AD02-5ADAFDA400F2}" dt="2021-05-10T10:07:10.210" v="271" actId="167"/>
          <ac:picMkLst>
            <pc:docMk/>
            <pc:sldMk cId="2764835349" sldId="259"/>
            <ac:picMk id="36" creationId="{2EB6F462-D2BE-4641-AED0-6114EDD0E4A0}"/>
          </ac:picMkLst>
        </pc:picChg>
        <pc:picChg chg="add mod">
          <ac:chgData name="Manasweeta Angane" userId="05da2731-9352-4b35-b713-60351f56afbd" providerId="ADAL" clId="{9F8E7246-803F-4AD4-AD02-5ADAFDA400F2}" dt="2021-05-10T11:25:19.112" v="401"/>
          <ac:picMkLst>
            <pc:docMk/>
            <pc:sldMk cId="2764835349" sldId="259"/>
            <ac:picMk id="37" creationId="{2F85DFBD-A06B-4761-85DF-C4E7EEBA173B}"/>
          </ac:picMkLst>
        </pc:picChg>
        <pc:picChg chg="add mod">
          <ac:chgData name="Manasweeta Angane" userId="05da2731-9352-4b35-b713-60351f56afbd" providerId="ADAL" clId="{9F8E7246-803F-4AD4-AD02-5ADAFDA400F2}" dt="2021-05-10T10:29:20.217" v="359" actId="1076"/>
          <ac:picMkLst>
            <pc:docMk/>
            <pc:sldMk cId="2764835349" sldId="259"/>
            <ac:picMk id="38" creationId="{2BFF88E3-46CC-42FF-B795-6F79E5DE7560}"/>
          </ac:picMkLst>
        </pc:picChg>
        <pc:picChg chg="add mod">
          <ac:chgData name="Manasweeta Angane" userId="05da2731-9352-4b35-b713-60351f56afbd" providerId="ADAL" clId="{9F8E7246-803F-4AD4-AD02-5ADAFDA400F2}" dt="2021-05-10T10:29:17.874" v="358" actId="1076"/>
          <ac:picMkLst>
            <pc:docMk/>
            <pc:sldMk cId="2764835349" sldId="259"/>
            <ac:picMk id="39" creationId="{242F7324-EDB9-4D37-8751-21991421DF37}"/>
          </ac:picMkLst>
        </pc:picChg>
        <pc:picChg chg="add mod">
          <ac:chgData name="Manasweeta Angane" userId="05da2731-9352-4b35-b713-60351f56afbd" providerId="ADAL" clId="{9F8E7246-803F-4AD4-AD02-5ADAFDA400F2}" dt="2021-05-10T11:08:21.002" v="386" actId="1076"/>
          <ac:picMkLst>
            <pc:docMk/>
            <pc:sldMk cId="2764835349" sldId="259"/>
            <ac:picMk id="40" creationId="{D8B5B8F6-095A-4C97-9813-4C593D708C71}"/>
          </ac:picMkLst>
        </pc:picChg>
        <pc:picChg chg="add del mod">
          <ac:chgData name="Manasweeta Angane" userId="05da2731-9352-4b35-b713-60351f56afbd" providerId="ADAL" clId="{9F8E7246-803F-4AD4-AD02-5ADAFDA400F2}" dt="2021-05-10T11:16:39.927" v="388"/>
          <ac:picMkLst>
            <pc:docMk/>
            <pc:sldMk cId="2764835349" sldId="259"/>
            <ac:picMk id="41" creationId="{CC4B473E-C3DF-4EF3-8CEF-BCDF3CBA88D7}"/>
          </ac:picMkLst>
        </pc:picChg>
        <pc:picChg chg="add del mod">
          <ac:chgData name="Manasweeta Angane" userId="05da2731-9352-4b35-b713-60351f56afbd" providerId="ADAL" clId="{9F8E7246-803F-4AD4-AD02-5ADAFDA400F2}" dt="2021-05-10T11:20:07.209" v="400" actId="478"/>
          <ac:picMkLst>
            <pc:docMk/>
            <pc:sldMk cId="2764835349" sldId="259"/>
            <ac:picMk id="42" creationId="{189D5629-825B-49D8-86BD-43ACBFA3CBB7}"/>
          </ac:picMkLst>
        </pc:picChg>
        <pc:picChg chg="add mod">
          <ac:chgData name="Manasweeta Angane" userId="05da2731-9352-4b35-b713-60351f56afbd" providerId="ADAL" clId="{9F8E7246-803F-4AD4-AD02-5ADAFDA400F2}" dt="2021-05-10T11:17:45.101" v="397" actId="1076"/>
          <ac:picMkLst>
            <pc:docMk/>
            <pc:sldMk cId="2764835349" sldId="259"/>
            <ac:picMk id="43" creationId="{8E9A5AD6-8D1B-4D83-8357-0F87E97A9A19}"/>
          </ac:picMkLst>
        </pc:picChg>
        <pc:picChg chg="add mod">
          <ac:chgData name="Manasweeta Angane" userId="05da2731-9352-4b35-b713-60351f56afbd" providerId="ADAL" clId="{9F8E7246-803F-4AD4-AD02-5ADAFDA400F2}" dt="2021-05-10T11:29:53.274" v="422" actId="1076"/>
          <ac:picMkLst>
            <pc:docMk/>
            <pc:sldMk cId="2764835349" sldId="259"/>
            <ac:picMk id="44" creationId="{E3CEDA3F-C0A9-44D3-8BFC-576CB5CE9915}"/>
          </ac:picMkLst>
        </pc:picChg>
        <pc:picChg chg="add mod">
          <ac:chgData name="Manasweeta Angane" userId="05da2731-9352-4b35-b713-60351f56afbd" providerId="ADAL" clId="{9F8E7246-803F-4AD4-AD02-5ADAFDA400F2}" dt="2021-05-10T11:28:38.041" v="411" actId="1076"/>
          <ac:picMkLst>
            <pc:docMk/>
            <pc:sldMk cId="2764835349" sldId="259"/>
            <ac:picMk id="45" creationId="{DCDD893A-A216-4D98-AEC9-7705132EAC57}"/>
          </ac:picMkLst>
        </pc:picChg>
        <pc:picChg chg="add mod">
          <ac:chgData name="Manasweeta Angane" userId="05da2731-9352-4b35-b713-60351f56afbd" providerId="ADAL" clId="{9F8E7246-803F-4AD4-AD02-5ADAFDA400F2}" dt="2021-05-10T11:28:50.512" v="412"/>
          <ac:picMkLst>
            <pc:docMk/>
            <pc:sldMk cId="2764835349" sldId="259"/>
            <ac:picMk id="46" creationId="{6D7250C2-0218-49F5-A51E-3AC98D7D08C1}"/>
          </ac:picMkLst>
        </pc:picChg>
        <pc:picChg chg="add mod">
          <ac:chgData name="Manasweeta Angane" userId="05da2731-9352-4b35-b713-60351f56afbd" providerId="ADAL" clId="{9F8E7246-803F-4AD4-AD02-5ADAFDA400F2}" dt="2021-05-10T11:30:36.634" v="427" actId="1076"/>
          <ac:picMkLst>
            <pc:docMk/>
            <pc:sldMk cId="2764835349" sldId="259"/>
            <ac:picMk id="47" creationId="{2150154C-339B-4C71-933B-329D5CAE9346}"/>
          </ac:picMkLst>
        </pc:picChg>
        <pc:picChg chg="mod">
          <ac:chgData name="Manasweeta Angane" userId="05da2731-9352-4b35-b713-60351f56afbd" providerId="ADAL" clId="{9F8E7246-803F-4AD4-AD02-5ADAFDA400F2}" dt="2021-05-09T04:40:21.184" v="87"/>
          <ac:picMkLst>
            <pc:docMk/>
            <pc:sldMk cId="2764835349" sldId="259"/>
            <ac:picMk id="49" creationId="{E0A7E8B5-4176-42F5-B3C5-5431802FABE7}"/>
          </ac:picMkLst>
        </pc:picChg>
        <pc:picChg chg="mod">
          <ac:chgData name="Manasweeta Angane" userId="05da2731-9352-4b35-b713-60351f56afbd" providerId="ADAL" clId="{9F8E7246-803F-4AD4-AD02-5ADAFDA400F2}" dt="2021-05-09T05:05:00.015" v="169"/>
          <ac:picMkLst>
            <pc:docMk/>
            <pc:sldMk cId="2764835349" sldId="259"/>
            <ac:picMk id="50" creationId="{10681031-75A0-4A0B-9DC7-88249CDB6B3A}"/>
          </ac:picMkLst>
        </pc:picChg>
        <pc:picChg chg="mod">
          <ac:chgData name="Manasweeta Angane" userId="05da2731-9352-4b35-b713-60351f56afbd" providerId="ADAL" clId="{9F8E7246-803F-4AD4-AD02-5ADAFDA400F2}" dt="2021-05-10T11:07:08.105" v="372"/>
          <ac:picMkLst>
            <pc:docMk/>
            <pc:sldMk cId="2764835349" sldId="259"/>
            <ac:picMk id="51" creationId="{510C70A0-8345-4C2D-BAE4-A57622817052}"/>
          </ac:picMkLst>
        </pc:picChg>
        <pc:picChg chg="mod">
          <ac:chgData name="Manasweeta Angane" userId="05da2731-9352-4b35-b713-60351f56afbd" providerId="ADAL" clId="{9F8E7246-803F-4AD4-AD02-5ADAFDA400F2}" dt="2021-05-10T10:05:03.151" v="259"/>
          <ac:picMkLst>
            <pc:docMk/>
            <pc:sldMk cId="2764835349" sldId="259"/>
            <ac:picMk id="52" creationId="{2A9CE1E7-B2B0-4DAB-BA6D-D2442DB2F362}"/>
          </ac:picMkLst>
        </pc:picChg>
        <pc:picChg chg="mod">
          <ac:chgData name="Manasweeta Angane" userId="05da2731-9352-4b35-b713-60351f56afbd" providerId="ADAL" clId="{9F8E7246-803F-4AD4-AD02-5ADAFDA400F2}" dt="2021-05-10T10:04:58.762" v="258"/>
          <ac:picMkLst>
            <pc:docMk/>
            <pc:sldMk cId="2764835349" sldId="259"/>
            <ac:picMk id="53" creationId="{D0520211-CAE7-46EC-922C-DBD66A6DDE5C}"/>
          </ac:picMkLst>
        </pc:picChg>
        <pc:picChg chg="mod">
          <ac:chgData name="Manasweeta Angane" userId="05da2731-9352-4b35-b713-60351f56afbd" providerId="ADAL" clId="{9F8E7246-803F-4AD4-AD02-5ADAFDA400F2}" dt="2021-05-09T05:04:18.558" v="167" actId="1076"/>
          <ac:picMkLst>
            <pc:docMk/>
            <pc:sldMk cId="2764835349" sldId="259"/>
            <ac:picMk id="54" creationId="{F44A9757-E37A-498E-B7F6-B63EF6220C2E}"/>
          </ac:picMkLst>
        </pc:picChg>
        <pc:picChg chg="add mod">
          <ac:chgData name="Manasweeta Angane" userId="05da2731-9352-4b35-b713-60351f56afbd" providerId="ADAL" clId="{9F8E7246-803F-4AD4-AD02-5ADAFDA400F2}" dt="2021-05-10T11:31:52.298" v="432"/>
          <ac:picMkLst>
            <pc:docMk/>
            <pc:sldMk cId="2764835349" sldId="259"/>
            <ac:picMk id="55" creationId="{76AC46E1-1529-441A-B7C7-5BF677A619E6}"/>
          </ac:picMkLst>
        </pc:picChg>
        <pc:picChg chg="add mod">
          <ac:chgData name="Manasweeta Angane" userId="05da2731-9352-4b35-b713-60351f56afbd" providerId="ADAL" clId="{9F8E7246-803F-4AD4-AD02-5ADAFDA400F2}" dt="2021-05-10T11:33:40.748" v="449" actId="166"/>
          <ac:picMkLst>
            <pc:docMk/>
            <pc:sldMk cId="2764835349" sldId="259"/>
            <ac:picMk id="56" creationId="{62AA8308-46F3-4043-9755-F0611BDFC493}"/>
          </ac:picMkLst>
        </pc:picChg>
        <pc:picChg chg="add mod">
          <ac:chgData name="Manasweeta Angane" userId="05da2731-9352-4b35-b713-60351f56afbd" providerId="ADAL" clId="{9F8E7246-803F-4AD4-AD02-5ADAFDA400F2}" dt="2021-05-10T11:33:28.508" v="448" actId="167"/>
          <ac:picMkLst>
            <pc:docMk/>
            <pc:sldMk cId="2764835349" sldId="259"/>
            <ac:picMk id="57" creationId="{5C5CA2EF-6EB2-4FDF-9ADE-9E4D42D8ACEE}"/>
          </ac:picMkLst>
        </pc:picChg>
        <pc:picChg chg="mod">
          <ac:chgData name="Manasweeta Angane" userId="05da2731-9352-4b35-b713-60351f56afbd" providerId="ADAL" clId="{9F8E7246-803F-4AD4-AD02-5ADAFDA400F2}" dt="2021-05-10T10:17:39.077" v="344" actId="1076"/>
          <ac:picMkLst>
            <pc:docMk/>
            <pc:sldMk cId="2764835349" sldId="259"/>
            <ac:picMk id="1026" creationId="{137C4FFD-2974-4454-B897-C812188AA1E5}"/>
          </ac:picMkLst>
        </pc:picChg>
      </pc:sldChg>
      <pc:sldChg chg="add">
        <pc:chgData name="Manasweeta Angane" userId="05da2731-9352-4b35-b713-60351f56afbd" providerId="ADAL" clId="{9F8E7246-803F-4AD4-AD02-5ADAFDA400F2}" dt="2021-05-01T11:17:25.233" v="54"/>
        <pc:sldMkLst>
          <pc:docMk/>
          <pc:sldMk cId="1300633407" sldId="261"/>
        </pc:sldMkLst>
      </pc:sldChg>
      <pc:sldChg chg="addSp delSp modSp mod ord">
        <pc:chgData name="Manasweeta Angane" userId="05da2731-9352-4b35-b713-60351f56afbd" providerId="ADAL" clId="{9F8E7246-803F-4AD4-AD02-5ADAFDA400F2}" dt="2021-05-23T00:20:53.560" v="4694" actId="1076"/>
        <pc:sldMkLst>
          <pc:docMk/>
          <pc:sldMk cId="3145637976" sldId="268"/>
        </pc:sldMkLst>
        <pc:spChg chg="add del mod ord">
          <ac:chgData name="Manasweeta Angane" userId="05da2731-9352-4b35-b713-60351f56afbd" providerId="ADAL" clId="{9F8E7246-803F-4AD4-AD02-5ADAFDA400F2}" dt="2021-05-22T20:59:35.749" v="3603" actId="166"/>
          <ac:spMkLst>
            <pc:docMk/>
            <pc:sldMk cId="3145637976" sldId="268"/>
            <ac:spMk id="3" creationId="{AE116250-06D3-4487-927B-6ABD4B0174E0}"/>
          </ac:spMkLst>
        </pc:spChg>
        <pc:spChg chg="mod ord">
          <ac:chgData name="Manasweeta Angane" userId="05da2731-9352-4b35-b713-60351f56afbd" providerId="ADAL" clId="{9F8E7246-803F-4AD4-AD02-5ADAFDA400F2}" dt="2021-05-22T09:44:52.794" v="1333" actId="167"/>
          <ac:spMkLst>
            <pc:docMk/>
            <pc:sldMk cId="3145637976" sldId="268"/>
            <ac:spMk id="4" creationId="{4AE5A754-CBD5-4B6D-92E4-E0E9DC5E10E3}"/>
          </ac:spMkLst>
        </pc:spChg>
        <pc:spChg chg="mod ord">
          <ac:chgData name="Manasweeta Angane" userId="05da2731-9352-4b35-b713-60351f56afbd" providerId="ADAL" clId="{9F8E7246-803F-4AD4-AD02-5ADAFDA400F2}" dt="2021-05-22T20:59:19.746" v="3599" actId="166"/>
          <ac:spMkLst>
            <pc:docMk/>
            <pc:sldMk cId="3145637976" sldId="268"/>
            <ac:spMk id="8" creationId="{9578BF0C-3884-4FD5-9C26-852AC96763B9}"/>
          </ac:spMkLst>
        </pc:spChg>
        <pc:spChg chg="add del mod">
          <ac:chgData name="Manasweeta Angane" userId="05da2731-9352-4b35-b713-60351f56afbd" providerId="ADAL" clId="{9F8E7246-803F-4AD4-AD02-5ADAFDA400F2}" dt="2021-05-22T09:32:57.368" v="1231" actId="478"/>
          <ac:spMkLst>
            <pc:docMk/>
            <pc:sldMk cId="3145637976" sldId="268"/>
            <ac:spMk id="9" creationId="{B9E4776F-FC6B-4503-882B-080C8817392F}"/>
          </ac:spMkLst>
        </pc:spChg>
        <pc:spChg chg="add mod">
          <ac:chgData name="Manasweeta Angane" userId="05da2731-9352-4b35-b713-60351f56afbd" providerId="ADAL" clId="{9F8E7246-803F-4AD4-AD02-5ADAFDA400F2}" dt="2021-05-22T09:43:50.248" v="1332" actId="122"/>
          <ac:spMkLst>
            <pc:docMk/>
            <pc:sldMk cId="3145637976" sldId="268"/>
            <ac:spMk id="13" creationId="{4E903B95-E5BD-4DEC-B559-9D2FB529FE27}"/>
          </ac:spMkLst>
        </pc:spChg>
        <pc:spChg chg="mod">
          <ac:chgData name="Manasweeta Angane" userId="05da2731-9352-4b35-b713-60351f56afbd" providerId="ADAL" clId="{9F8E7246-803F-4AD4-AD02-5ADAFDA400F2}" dt="2021-05-22T10:51:50.458" v="2573" actId="12789"/>
          <ac:spMkLst>
            <pc:docMk/>
            <pc:sldMk cId="3145637976" sldId="268"/>
            <ac:spMk id="111" creationId="{3130C39E-4D71-4B0B-AD10-2660F8CDB2E7}"/>
          </ac:spMkLst>
        </pc:spChg>
        <pc:spChg chg="mod ord">
          <ac:chgData name="Manasweeta Angane" userId="05da2731-9352-4b35-b713-60351f56afbd" providerId="ADAL" clId="{9F8E7246-803F-4AD4-AD02-5ADAFDA400F2}" dt="2021-05-22T11:23:30.690" v="3248" actId="167"/>
          <ac:spMkLst>
            <pc:docMk/>
            <pc:sldMk cId="3145637976" sldId="268"/>
            <ac:spMk id="112" creationId="{A8532107-6208-4D80-8926-B447E0FCCA7F}"/>
          </ac:spMkLst>
        </pc:spChg>
        <pc:spChg chg="mod ord">
          <ac:chgData name="Manasweeta Angane" userId="05da2731-9352-4b35-b713-60351f56afbd" providerId="ADAL" clId="{9F8E7246-803F-4AD4-AD02-5ADAFDA400F2}" dt="2021-05-22T10:11:44.677" v="2245" actId="166"/>
          <ac:spMkLst>
            <pc:docMk/>
            <pc:sldMk cId="3145637976" sldId="268"/>
            <ac:spMk id="113" creationId="{3B01C123-C096-40D9-ACDE-6BDAF936C1F5}"/>
          </ac:spMkLst>
        </pc:spChg>
        <pc:spChg chg="mod ord">
          <ac:chgData name="Manasweeta Angane" userId="05da2731-9352-4b35-b713-60351f56afbd" providerId="ADAL" clId="{9F8E7246-803F-4AD4-AD02-5ADAFDA400F2}" dt="2021-05-22T09:56:59.498" v="1843" actId="166"/>
          <ac:spMkLst>
            <pc:docMk/>
            <pc:sldMk cId="3145637976" sldId="268"/>
            <ac:spMk id="114" creationId="{EF234447-80A7-40F9-9DBD-254FE22BABF3}"/>
          </ac:spMkLst>
        </pc:spChg>
        <pc:spChg chg="add mod">
          <ac:chgData name="Manasweeta Angane" userId="05da2731-9352-4b35-b713-60351f56afbd" providerId="ADAL" clId="{9F8E7246-803F-4AD4-AD02-5ADAFDA400F2}" dt="2021-05-22T11:06:34.741" v="3176" actId="20577"/>
          <ac:spMkLst>
            <pc:docMk/>
            <pc:sldMk cId="3145637976" sldId="268"/>
            <ac:spMk id="206" creationId="{856263D8-599B-4A11-A3F3-815C0358F37C}"/>
          </ac:spMkLst>
        </pc:spChg>
        <pc:spChg chg="add mod">
          <ac:chgData name="Manasweeta Angane" userId="05da2731-9352-4b35-b713-60351f56afbd" providerId="ADAL" clId="{9F8E7246-803F-4AD4-AD02-5ADAFDA400F2}" dt="2021-05-22T11:06:31.910" v="3174" actId="20577"/>
          <ac:spMkLst>
            <pc:docMk/>
            <pc:sldMk cId="3145637976" sldId="268"/>
            <ac:spMk id="231" creationId="{091255D1-3CB3-4641-9A48-614240CC5035}"/>
          </ac:spMkLst>
        </pc:spChg>
        <pc:spChg chg="add mod">
          <ac:chgData name="Manasweeta Angane" userId="05da2731-9352-4b35-b713-60351f56afbd" providerId="ADAL" clId="{9F8E7246-803F-4AD4-AD02-5ADAFDA400F2}" dt="2021-05-22T10:55:40.580" v="2739" actId="20577"/>
          <ac:spMkLst>
            <pc:docMk/>
            <pc:sldMk cId="3145637976" sldId="268"/>
            <ac:spMk id="232" creationId="{A1880B3E-1806-4D70-A6B2-45A405D66349}"/>
          </ac:spMkLst>
        </pc:spChg>
        <pc:grpChg chg="add mod topLvl">
          <ac:chgData name="Manasweeta Angane" userId="05da2731-9352-4b35-b713-60351f56afbd" providerId="ADAL" clId="{9F8E7246-803F-4AD4-AD02-5ADAFDA400F2}" dt="2021-05-22T21:00:45.684" v="3607" actId="165"/>
          <ac:grpSpMkLst>
            <pc:docMk/>
            <pc:sldMk cId="3145637976" sldId="268"/>
            <ac:grpSpMk id="2" creationId="{CDDECE0C-A6EE-4B64-B730-F15394E60E37}"/>
          </ac:grpSpMkLst>
        </pc:grpChg>
        <pc:grpChg chg="add mod topLvl">
          <ac:chgData name="Manasweeta Angane" userId="05da2731-9352-4b35-b713-60351f56afbd" providerId="ADAL" clId="{9F8E7246-803F-4AD4-AD02-5ADAFDA400F2}" dt="2021-05-22T21:00:45.684" v="3607" actId="165"/>
          <ac:grpSpMkLst>
            <pc:docMk/>
            <pc:sldMk cId="3145637976" sldId="268"/>
            <ac:grpSpMk id="5" creationId="{76A86ECE-F864-4D73-8DD9-07C841466624}"/>
          </ac:grpSpMkLst>
        </pc:grpChg>
        <pc:grpChg chg="add del mod topLvl">
          <ac:chgData name="Manasweeta Angane" userId="05da2731-9352-4b35-b713-60351f56afbd" providerId="ADAL" clId="{9F8E7246-803F-4AD4-AD02-5ADAFDA400F2}" dt="2021-05-22T21:15:31.437" v="3659" actId="165"/>
          <ac:grpSpMkLst>
            <pc:docMk/>
            <pc:sldMk cId="3145637976" sldId="268"/>
            <ac:grpSpMk id="6" creationId="{4FC23FD0-2729-42FB-ABE0-8319312BA463}"/>
          </ac:grpSpMkLst>
        </pc:grpChg>
        <pc:grpChg chg="add mod topLvl">
          <ac:chgData name="Manasweeta Angane" userId="05da2731-9352-4b35-b713-60351f56afbd" providerId="ADAL" clId="{9F8E7246-803F-4AD4-AD02-5ADAFDA400F2}" dt="2021-05-23T00:13:57.745" v="4647"/>
          <ac:grpSpMkLst>
            <pc:docMk/>
            <pc:sldMk cId="3145637976" sldId="268"/>
            <ac:grpSpMk id="7" creationId="{E1C68698-1206-4D21-83CA-777640CE06F2}"/>
          </ac:grpSpMkLst>
        </pc:grpChg>
        <pc:grpChg chg="add del mod topLvl">
          <ac:chgData name="Manasweeta Angane" userId="05da2731-9352-4b35-b713-60351f56afbd" providerId="ADAL" clId="{9F8E7246-803F-4AD4-AD02-5ADAFDA400F2}" dt="2021-05-22T22:55:16.623" v="4573" actId="165"/>
          <ac:grpSpMkLst>
            <pc:docMk/>
            <pc:sldMk cId="3145637976" sldId="268"/>
            <ac:grpSpMk id="9" creationId="{849B9688-768C-4292-927C-E323C4AE8531}"/>
          </ac:grpSpMkLst>
        </pc:grpChg>
        <pc:grpChg chg="add del mod topLvl">
          <ac:chgData name="Manasweeta Angane" userId="05da2731-9352-4b35-b713-60351f56afbd" providerId="ADAL" clId="{9F8E7246-803F-4AD4-AD02-5ADAFDA400F2}" dt="2021-05-22T22:18:11.325" v="3975" actId="478"/>
          <ac:grpSpMkLst>
            <pc:docMk/>
            <pc:sldMk cId="3145637976" sldId="268"/>
            <ac:grpSpMk id="10" creationId="{4949A3B9-5A40-482A-BBCD-B1EA5B4F2526}"/>
          </ac:grpSpMkLst>
        </pc:grpChg>
        <pc:grpChg chg="del mod topLvl">
          <ac:chgData name="Manasweeta Angane" userId="05da2731-9352-4b35-b713-60351f56afbd" providerId="ADAL" clId="{9F8E7246-803F-4AD4-AD02-5ADAFDA400F2}" dt="2021-05-22T09:53:41.037" v="1506" actId="165"/>
          <ac:grpSpMkLst>
            <pc:docMk/>
            <pc:sldMk cId="3145637976" sldId="268"/>
            <ac:grpSpMk id="10" creationId="{55D4762B-384F-4E4A-A433-57756592495B}"/>
          </ac:grpSpMkLst>
        </pc:grpChg>
        <pc:grpChg chg="del mod topLvl">
          <ac:chgData name="Manasweeta Angane" userId="05da2731-9352-4b35-b713-60351f56afbd" providerId="ADAL" clId="{9F8E7246-803F-4AD4-AD02-5ADAFDA400F2}" dt="2021-05-22T09:53:55.990" v="1507" actId="165"/>
          <ac:grpSpMkLst>
            <pc:docMk/>
            <pc:sldMk cId="3145637976" sldId="268"/>
            <ac:grpSpMk id="11" creationId="{3446A069-2D41-4239-9B2E-A6B31AEE84C9}"/>
          </ac:grpSpMkLst>
        </pc:grpChg>
        <pc:grpChg chg="add del mod">
          <ac:chgData name="Manasweeta Angane" userId="05da2731-9352-4b35-b713-60351f56afbd" providerId="ADAL" clId="{9F8E7246-803F-4AD4-AD02-5ADAFDA400F2}" dt="2021-05-22T21:00:45.684" v="3607" actId="165"/>
          <ac:grpSpMkLst>
            <pc:docMk/>
            <pc:sldMk cId="3145637976" sldId="268"/>
            <ac:grpSpMk id="11" creationId="{EAFB5EED-CC02-41E4-A30D-0CAE13C280AE}"/>
          </ac:grpSpMkLst>
        </pc:grpChg>
        <pc:grpChg chg="del mod">
          <ac:chgData name="Manasweeta Angane" userId="05da2731-9352-4b35-b713-60351f56afbd" providerId="ADAL" clId="{9F8E7246-803F-4AD4-AD02-5ADAFDA400F2}" dt="2021-05-22T09:17:40.061" v="759" actId="165"/>
          <ac:grpSpMkLst>
            <pc:docMk/>
            <pc:sldMk cId="3145637976" sldId="268"/>
            <ac:grpSpMk id="12" creationId="{80C288FA-EC2A-44F4-84C2-93F7B86E1639}"/>
          </ac:grpSpMkLst>
        </pc:grpChg>
        <pc:grpChg chg="add mod">
          <ac:chgData name="Manasweeta Angane" userId="05da2731-9352-4b35-b713-60351f56afbd" providerId="ADAL" clId="{9F8E7246-803F-4AD4-AD02-5ADAFDA400F2}" dt="2021-05-22T21:02:58.325" v="3620" actId="164"/>
          <ac:grpSpMkLst>
            <pc:docMk/>
            <pc:sldMk cId="3145637976" sldId="268"/>
            <ac:grpSpMk id="12" creationId="{EA165AC7-3A73-44A9-B853-4B4878882853}"/>
          </ac:grpSpMkLst>
        </pc:grpChg>
        <pc:grpChg chg="add del mod">
          <ac:chgData name="Manasweeta Angane" userId="05da2731-9352-4b35-b713-60351f56afbd" providerId="ADAL" clId="{9F8E7246-803F-4AD4-AD02-5ADAFDA400F2}" dt="2021-05-22T21:02:31.793" v="3618" actId="165"/>
          <ac:grpSpMkLst>
            <pc:docMk/>
            <pc:sldMk cId="3145637976" sldId="268"/>
            <ac:grpSpMk id="14" creationId="{7A82B0D8-158B-4A6F-8E3F-F15040FA73E7}"/>
          </ac:grpSpMkLst>
        </pc:grpChg>
        <pc:grpChg chg="add mod ord">
          <ac:chgData name="Manasweeta Angane" userId="05da2731-9352-4b35-b713-60351f56afbd" providerId="ADAL" clId="{9F8E7246-803F-4AD4-AD02-5ADAFDA400F2}" dt="2021-05-22T22:57:55" v="4587" actId="166"/>
          <ac:grpSpMkLst>
            <pc:docMk/>
            <pc:sldMk cId="3145637976" sldId="268"/>
            <ac:grpSpMk id="15" creationId="{06450F43-4BDE-4F0B-89B3-854446C85461}"/>
          </ac:grpSpMkLst>
        </pc:grpChg>
        <pc:grpChg chg="add del mod">
          <ac:chgData name="Manasweeta Angane" userId="05da2731-9352-4b35-b713-60351f56afbd" providerId="ADAL" clId="{9F8E7246-803F-4AD4-AD02-5ADAFDA400F2}" dt="2021-05-22T21:04:02.450" v="3626" actId="165"/>
          <ac:grpSpMkLst>
            <pc:docMk/>
            <pc:sldMk cId="3145637976" sldId="268"/>
            <ac:grpSpMk id="16" creationId="{4F43018A-F010-49B5-B6FD-78DCCE9CDC04}"/>
          </ac:grpSpMkLst>
        </pc:grpChg>
        <pc:grpChg chg="add mod">
          <ac:chgData name="Manasweeta Angane" userId="05da2731-9352-4b35-b713-60351f56afbd" providerId="ADAL" clId="{9F8E7246-803F-4AD4-AD02-5ADAFDA400F2}" dt="2021-05-22T10:58:53.452" v="2755" actId="164"/>
          <ac:grpSpMkLst>
            <pc:docMk/>
            <pc:sldMk cId="3145637976" sldId="268"/>
            <ac:grpSpMk id="16" creationId="{86C0E1E5-CCD7-4D5D-ABA6-27FBAE1271F3}"/>
          </ac:grpSpMkLst>
        </pc:grpChg>
        <pc:grpChg chg="add del mod">
          <ac:chgData name="Manasweeta Angane" userId="05da2731-9352-4b35-b713-60351f56afbd" providerId="ADAL" clId="{9F8E7246-803F-4AD4-AD02-5ADAFDA400F2}" dt="2021-05-22T11:18:04.824" v="3191" actId="165"/>
          <ac:grpSpMkLst>
            <pc:docMk/>
            <pc:sldMk cId="3145637976" sldId="268"/>
            <ac:grpSpMk id="17" creationId="{4459FE30-89D5-43E0-8D62-84AA0361AC89}"/>
          </ac:grpSpMkLst>
        </pc:grpChg>
        <pc:grpChg chg="add mod">
          <ac:chgData name="Manasweeta Angane" userId="05da2731-9352-4b35-b713-60351f56afbd" providerId="ADAL" clId="{9F8E7246-803F-4AD4-AD02-5ADAFDA400F2}" dt="2021-05-22T21:03:57.138" v="3625" actId="1076"/>
          <ac:grpSpMkLst>
            <pc:docMk/>
            <pc:sldMk cId="3145637976" sldId="268"/>
            <ac:grpSpMk id="17" creationId="{ED8C76E9-ED5B-465C-9F4A-5783A95EFB1E}"/>
          </ac:grpSpMkLst>
        </pc:grpChg>
        <pc:grpChg chg="add mod topLvl">
          <ac:chgData name="Manasweeta Angane" userId="05da2731-9352-4b35-b713-60351f56afbd" providerId="ADAL" clId="{9F8E7246-803F-4AD4-AD02-5ADAFDA400F2}" dt="2021-05-22T21:00:45.684" v="3607" actId="165"/>
          <ac:grpSpMkLst>
            <pc:docMk/>
            <pc:sldMk cId="3145637976" sldId="268"/>
            <ac:grpSpMk id="18" creationId="{3C65095A-C8DF-4380-A319-15843A6451B5}"/>
          </ac:grpSpMkLst>
        </pc:grpChg>
        <pc:grpChg chg="add mod">
          <ac:chgData name="Manasweeta Angane" userId="05da2731-9352-4b35-b713-60351f56afbd" providerId="ADAL" clId="{9F8E7246-803F-4AD4-AD02-5ADAFDA400F2}" dt="2021-05-22T21:03:19.435" v="3623" actId="164"/>
          <ac:grpSpMkLst>
            <pc:docMk/>
            <pc:sldMk cId="3145637976" sldId="268"/>
            <ac:grpSpMk id="19" creationId="{67F0C5FD-E448-4E43-A3BF-BAD63295F8A3}"/>
          </ac:grpSpMkLst>
        </pc:grpChg>
        <pc:grpChg chg="add del mod">
          <ac:chgData name="Manasweeta Angane" userId="05da2731-9352-4b35-b713-60351f56afbd" providerId="ADAL" clId="{9F8E7246-803F-4AD4-AD02-5ADAFDA400F2}" dt="2021-05-22T11:03:01.587" v="3147" actId="478"/>
          <ac:grpSpMkLst>
            <pc:docMk/>
            <pc:sldMk cId="3145637976" sldId="268"/>
            <ac:grpSpMk id="19" creationId="{739108C8-0C63-4B96-ACB5-44AE4AA95751}"/>
          </ac:grpSpMkLst>
        </pc:grpChg>
        <pc:grpChg chg="add mod topLvl">
          <ac:chgData name="Manasweeta Angane" userId="05da2731-9352-4b35-b713-60351f56afbd" providerId="ADAL" clId="{9F8E7246-803F-4AD4-AD02-5ADAFDA400F2}" dt="2021-05-22T22:34:44.593" v="4168" actId="1076"/>
          <ac:grpSpMkLst>
            <pc:docMk/>
            <pc:sldMk cId="3145637976" sldId="268"/>
            <ac:grpSpMk id="20" creationId="{EA024967-F98A-49CB-84CC-14F8ED39020B}"/>
          </ac:grpSpMkLst>
        </pc:grpChg>
        <pc:grpChg chg="add mod topLvl">
          <ac:chgData name="Manasweeta Angane" userId="05da2731-9352-4b35-b713-60351f56afbd" providerId="ADAL" clId="{9F8E7246-803F-4AD4-AD02-5ADAFDA400F2}" dt="2021-05-22T21:00:45.684" v="3607" actId="165"/>
          <ac:grpSpMkLst>
            <pc:docMk/>
            <pc:sldMk cId="3145637976" sldId="268"/>
            <ac:grpSpMk id="21" creationId="{23678D48-FA37-4B70-B7FF-DC66B62C1674}"/>
          </ac:grpSpMkLst>
        </pc:grpChg>
        <pc:grpChg chg="add mod">
          <ac:chgData name="Manasweeta Angane" userId="05da2731-9352-4b35-b713-60351f56afbd" providerId="ADAL" clId="{9F8E7246-803F-4AD4-AD02-5ADAFDA400F2}" dt="2021-05-22T21:06:09.232" v="3647" actId="164"/>
          <ac:grpSpMkLst>
            <pc:docMk/>
            <pc:sldMk cId="3145637976" sldId="268"/>
            <ac:grpSpMk id="22" creationId="{E23C544C-51E1-4ADD-AA9F-1A86A41E6897}"/>
          </ac:grpSpMkLst>
        </pc:grpChg>
        <pc:grpChg chg="add mod">
          <ac:chgData name="Manasweeta Angane" userId="05da2731-9352-4b35-b713-60351f56afbd" providerId="ADAL" clId="{9F8E7246-803F-4AD4-AD02-5ADAFDA400F2}" dt="2021-05-22T21:06:31.763" v="3650" actId="164"/>
          <ac:grpSpMkLst>
            <pc:docMk/>
            <pc:sldMk cId="3145637976" sldId="268"/>
            <ac:grpSpMk id="23" creationId="{94491B58-4083-4F7E-A921-6140228B202C}"/>
          </ac:grpSpMkLst>
        </pc:grpChg>
        <pc:grpChg chg="add mod">
          <ac:chgData name="Manasweeta Angane" userId="05da2731-9352-4b35-b713-60351f56afbd" providerId="ADAL" clId="{9F8E7246-803F-4AD4-AD02-5ADAFDA400F2}" dt="2021-05-23T00:12:37.822" v="4643"/>
          <ac:grpSpMkLst>
            <pc:docMk/>
            <pc:sldMk cId="3145637976" sldId="268"/>
            <ac:grpSpMk id="24" creationId="{6047A8A4-E1D6-42FC-9555-BAF4A27222FD}"/>
          </ac:grpSpMkLst>
        </pc:grpChg>
        <pc:grpChg chg="add del mod">
          <ac:chgData name="Manasweeta Angane" userId="05da2731-9352-4b35-b713-60351f56afbd" providerId="ADAL" clId="{9F8E7246-803F-4AD4-AD02-5ADAFDA400F2}" dt="2021-05-22T21:23:54.719" v="3669" actId="165"/>
          <ac:grpSpMkLst>
            <pc:docMk/>
            <pc:sldMk cId="3145637976" sldId="268"/>
            <ac:grpSpMk id="25" creationId="{A0B02E8B-BD07-4B2A-BBF4-94B35B5DD13D}"/>
          </ac:grpSpMkLst>
        </pc:grpChg>
        <pc:grpChg chg="add del mod">
          <ac:chgData name="Manasweeta Angane" userId="05da2731-9352-4b35-b713-60351f56afbd" providerId="ADAL" clId="{9F8E7246-803F-4AD4-AD02-5ADAFDA400F2}" dt="2021-05-22T22:21:55.301" v="4047" actId="1076"/>
          <ac:grpSpMkLst>
            <pc:docMk/>
            <pc:sldMk cId="3145637976" sldId="268"/>
            <ac:grpSpMk id="26" creationId="{CB67E6E1-6425-4F3D-BC25-7EF74174481B}"/>
          </ac:grpSpMkLst>
        </pc:grpChg>
        <pc:grpChg chg="add del mod">
          <ac:chgData name="Manasweeta Angane" userId="05da2731-9352-4b35-b713-60351f56afbd" providerId="ADAL" clId="{9F8E7246-803F-4AD4-AD02-5ADAFDA400F2}" dt="2021-05-22T22:14:48.779" v="3932" actId="165"/>
          <ac:grpSpMkLst>
            <pc:docMk/>
            <pc:sldMk cId="3145637976" sldId="268"/>
            <ac:grpSpMk id="27" creationId="{CCD85DE9-3C1A-4EBD-A3CD-BB8CEC66A8B9}"/>
          </ac:grpSpMkLst>
        </pc:grpChg>
        <pc:grpChg chg="add mod">
          <ac:chgData name="Manasweeta Angane" userId="05da2731-9352-4b35-b713-60351f56afbd" providerId="ADAL" clId="{9F8E7246-803F-4AD4-AD02-5ADAFDA400F2}" dt="2021-05-22T22:56:34.921" v="4579" actId="1076"/>
          <ac:grpSpMkLst>
            <pc:docMk/>
            <pc:sldMk cId="3145637976" sldId="268"/>
            <ac:grpSpMk id="28" creationId="{F01C0DCC-14AA-4E8D-8B79-496F9D8770E5}"/>
          </ac:grpSpMkLst>
        </pc:grpChg>
        <pc:grpChg chg="add mod">
          <ac:chgData name="Manasweeta Angane" userId="05da2731-9352-4b35-b713-60351f56afbd" providerId="ADAL" clId="{9F8E7246-803F-4AD4-AD02-5ADAFDA400F2}" dt="2021-05-22T22:37:32.704" v="4414" actId="164"/>
          <ac:grpSpMkLst>
            <pc:docMk/>
            <pc:sldMk cId="3145637976" sldId="268"/>
            <ac:grpSpMk id="29" creationId="{A47F7386-FF2A-4490-ABF0-71BDB6934FC5}"/>
          </ac:grpSpMkLst>
        </pc:grpChg>
        <pc:grpChg chg="add del mod">
          <ac:chgData name="Manasweeta Angane" userId="05da2731-9352-4b35-b713-60351f56afbd" providerId="ADAL" clId="{9F8E7246-803F-4AD4-AD02-5ADAFDA400F2}" dt="2021-05-22T22:47:36.102" v="4482" actId="165"/>
          <ac:grpSpMkLst>
            <pc:docMk/>
            <pc:sldMk cId="3145637976" sldId="268"/>
            <ac:grpSpMk id="30" creationId="{199DB252-6080-4622-9C88-1D06C40B6394}"/>
          </ac:grpSpMkLst>
        </pc:grpChg>
        <pc:grpChg chg="add del mod">
          <ac:chgData name="Manasweeta Angane" userId="05da2731-9352-4b35-b713-60351f56afbd" providerId="ADAL" clId="{9F8E7246-803F-4AD4-AD02-5ADAFDA400F2}" dt="2021-05-22T22:53:45.028" v="4566" actId="165"/>
          <ac:grpSpMkLst>
            <pc:docMk/>
            <pc:sldMk cId="3145637976" sldId="268"/>
            <ac:grpSpMk id="31" creationId="{71DEDBED-943B-49EA-B96A-B3F5793E1A22}"/>
          </ac:grpSpMkLst>
        </pc:grpChg>
        <pc:grpChg chg="add mod">
          <ac:chgData name="Manasweeta Angane" userId="05da2731-9352-4b35-b713-60351f56afbd" providerId="ADAL" clId="{9F8E7246-803F-4AD4-AD02-5ADAFDA400F2}" dt="2021-05-22T23:04:08.270" v="4623" actId="1076"/>
          <ac:grpSpMkLst>
            <pc:docMk/>
            <pc:sldMk cId="3145637976" sldId="268"/>
            <ac:grpSpMk id="32" creationId="{D74AC426-9BA9-42BE-B3AA-E716B16A570F}"/>
          </ac:grpSpMkLst>
        </pc:grpChg>
        <pc:grpChg chg="add del mod">
          <ac:chgData name="Manasweeta Angane" userId="05da2731-9352-4b35-b713-60351f56afbd" providerId="ADAL" clId="{9F8E7246-803F-4AD4-AD02-5ADAFDA400F2}" dt="2021-05-22T09:53:27.436" v="1505" actId="478"/>
          <ac:grpSpMkLst>
            <pc:docMk/>
            <pc:sldMk cId="3145637976" sldId="268"/>
            <ac:grpSpMk id="81" creationId="{6EA38062-F8B1-48C6-A839-CC1CAAA6789B}"/>
          </ac:grpSpMkLst>
        </pc:grpChg>
        <pc:grpChg chg="add del mod">
          <ac:chgData name="Manasweeta Angane" userId="05da2731-9352-4b35-b713-60351f56afbd" providerId="ADAL" clId="{9F8E7246-803F-4AD4-AD02-5ADAFDA400F2}" dt="2021-05-22T09:54:53.222" v="1645" actId="478"/>
          <ac:grpSpMkLst>
            <pc:docMk/>
            <pc:sldMk cId="3145637976" sldId="268"/>
            <ac:grpSpMk id="88" creationId="{422302D5-2CE8-43C6-B028-04967B48A7C4}"/>
          </ac:grpSpMkLst>
        </pc:grpChg>
        <pc:grpChg chg="mod">
          <ac:chgData name="Manasweeta Angane" userId="05da2731-9352-4b35-b713-60351f56afbd" providerId="ADAL" clId="{9F8E7246-803F-4AD4-AD02-5ADAFDA400F2}" dt="2021-05-22T10:51:50.458" v="2573" actId="12789"/>
          <ac:grpSpMkLst>
            <pc:docMk/>
            <pc:sldMk cId="3145637976" sldId="268"/>
            <ac:grpSpMk id="109" creationId="{67E5F1E1-32EE-4A88-9488-CFC3EF076927}"/>
          </ac:grpSpMkLst>
        </pc:grpChg>
        <pc:grpChg chg="del mod topLvl">
          <ac:chgData name="Manasweeta Angane" userId="05da2731-9352-4b35-b713-60351f56afbd" providerId="ADAL" clId="{9F8E7246-803F-4AD4-AD02-5ADAFDA400F2}" dt="2021-05-22T09:41:15.368" v="1292" actId="165"/>
          <ac:grpSpMkLst>
            <pc:docMk/>
            <pc:sldMk cId="3145637976" sldId="268"/>
            <ac:grpSpMk id="118" creationId="{A0782B21-5323-4FD2-B719-58E1F0497BB2}"/>
          </ac:grpSpMkLst>
        </pc:grpChg>
        <pc:grpChg chg="add del mod">
          <ac:chgData name="Manasweeta Angane" userId="05da2731-9352-4b35-b713-60351f56afbd" providerId="ADAL" clId="{9F8E7246-803F-4AD4-AD02-5ADAFDA400F2}" dt="2021-05-22T21:00:35.543" v="3606" actId="165"/>
          <ac:grpSpMkLst>
            <pc:docMk/>
            <pc:sldMk cId="3145637976" sldId="268"/>
            <ac:grpSpMk id="133" creationId="{8B861F86-3A95-47FE-B9B2-007A9F51DD80}"/>
          </ac:grpSpMkLst>
        </pc:grpChg>
        <pc:grpChg chg="del">
          <ac:chgData name="Manasweeta Angane" userId="05da2731-9352-4b35-b713-60351f56afbd" providerId="ADAL" clId="{9F8E7246-803F-4AD4-AD02-5ADAFDA400F2}" dt="2021-05-22T09:33:01.448" v="1232" actId="478"/>
          <ac:grpSpMkLst>
            <pc:docMk/>
            <pc:sldMk cId="3145637976" sldId="268"/>
            <ac:grpSpMk id="133" creationId="{B3114FD7-986A-4987-B7B2-665717B3A15E}"/>
          </ac:grpSpMkLst>
        </pc:grpChg>
        <pc:grpChg chg="del mod ord topLvl">
          <ac:chgData name="Manasweeta Angane" userId="05da2731-9352-4b35-b713-60351f56afbd" providerId="ADAL" clId="{9F8E7246-803F-4AD4-AD02-5ADAFDA400F2}" dt="2021-05-22T22:36:12.125" v="4337" actId="165"/>
          <ac:grpSpMkLst>
            <pc:docMk/>
            <pc:sldMk cId="3145637976" sldId="268"/>
            <ac:grpSpMk id="135" creationId="{9D3CB42A-FC25-43F7-8E68-C853AE423988}"/>
          </ac:grpSpMkLst>
        </pc:grpChg>
        <pc:grpChg chg="del mod topLvl">
          <ac:chgData name="Manasweeta Angane" userId="05da2731-9352-4b35-b713-60351f56afbd" providerId="ADAL" clId="{9F8E7246-803F-4AD4-AD02-5ADAFDA400F2}" dt="2021-05-22T22:06:43.117" v="3791" actId="165"/>
          <ac:grpSpMkLst>
            <pc:docMk/>
            <pc:sldMk cId="3145637976" sldId="268"/>
            <ac:grpSpMk id="136" creationId="{8199E2BF-8232-4684-8728-27E91C5EBFAA}"/>
          </ac:grpSpMkLst>
        </pc:grpChg>
        <pc:grpChg chg="add del mod topLvl">
          <ac:chgData name="Manasweeta Angane" userId="05da2731-9352-4b35-b713-60351f56afbd" providerId="ADAL" clId="{9F8E7246-803F-4AD4-AD02-5ADAFDA400F2}" dt="2021-05-22T22:39:28.330" v="4428" actId="165"/>
          <ac:grpSpMkLst>
            <pc:docMk/>
            <pc:sldMk cId="3145637976" sldId="268"/>
            <ac:grpSpMk id="141" creationId="{C2149EEB-2635-4753-AECD-AC5E7DA52607}"/>
          </ac:grpSpMkLst>
        </pc:grpChg>
        <pc:grpChg chg="mod topLvl">
          <ac:chgData name="Manasweeta Angane" userId="05da2731-9352-4b35-b713-60351f56afbd" providerId="ADAL" clId="{9F8E7246-803F-4AD4-AD02-5ADAFDA400F2}" dt="2021-05-22T21:00:35.543" v="3606" actId="165"/>
          <ac:grpSpMkLst>
            <pc:docMk/>
            <pc:sldMk cId="3145637976" sldId="268"/>
            <ac:grpSpMk id="142" creationId="{67FA6706-8D46-4264-90A6-DA2FD3112F69}"/>
          </ac:grpSpMkLst>
        </pc:grpChg>
        <pc:grpChg chg="del mod topLvl">
          <ac:chgData name="Manasweeta Angane" userId="05da2731-9352-4b35-b713-60351f56afbd" providerId="ADAL" clId="{9F8E7246-803F-4AD4-AD02-5ADAFDA400F2}" dt="2021-05-22T22:33:35.139" v="4051" actId="478"/>
          <ac:grpSpMkLst>
            <pc:docMk/>
            <pc:sldMk cId="3145637976" sldId="268"/>
            <ac:grpSpMk id="143" creationId="{6B16CB6E-1FB4-4E30-8342-DA3A29EAE937}"/>
          </ac:grpSpMkLst>
        </pc:grpChg>
        <pc:grpChg chg="mod topLvl">
          <ac:chgData name="Manasweeta Angane" userId="05da2731-9352-4b35-b713-60351f56afbd" providerId="ADAL" clId="{9F8E7246-803F-4AD4-AD02-5ADAFDA400F2}" dt="2021-05-23T00:13:46.948" v="4646"/>
          <ac:grpSpMkLst>
            <pc:docMk/>
            <pc:sldMk cId="3145637976" sldId="268"/>
            <ac:grpSpMk id="144" creationId="{D273DF9F-D457-467C-9D1B-7967F8993640}"/>
          </ac:grpSpMkLst>
        </pc:grpChg>
        <pc:grpChg chg="mod topLvl">
          <ac:chgData name="Manasweeta Angane" userId="05da2731-9352-4b35-b713-60351f56afbd" providerId="ADAL" clId="{9F8E7246-803F-4AD4-AD02-5ADAFDA400F2}" dt="2021-05-22T21:00:35.543" v="3606" actId="165"/>
          <ac:grpSpMkLst>
            <pc:docMk/>
            <pc:sldMk cId="3145637976" sldId="268"/>
            <ac:grpSpMk id="145" creationId="{1CB57B06-FA75-48C9-A6BC-A4E6F430710C}"/>
          </ac:grpSpMkLst>
        </pc:grpChg>
        <pc:grpChg chg="del mod topLvl">
          <ac:chgData name="Manasweeta Angane" userId="05da2731-9352-4b35-b713-60351f56afbd" providerId="ADAL" clId="{9F8E7246-803F-4AD4-AD02-5ADAFDA400F2}" dt="2021-05-22T22:16:01.593" v="3968" actId="478"/>
          <ac:grpSpMkLst>
            <pc:docMk/>
            <pc:sldMk cId="3145637976" sldId="268"/>
            <ac:grpSpMk id="146" creationId="{9C55AA04-0638-4C2E-9C8C-635A1F320381}"/>
          </ac:grpSpMkLst>
        </pc:grpChg>
        <pc:grpChg chg="del mod topLvl">
          <ac:chgData name="Manasweeta Angane" userId="05da2731-9352-4b35-b713-60351f56afbd" providerId="ADAL" clId="{9F8E7246-803F-4AD4-AD02-5ADAFDA400F2}" dt="2021-05-22T22:10:43.735" v="3899" actId="478"/>
          <ac:grpSpMkLst>
            <pc:docMk/>
            <pc:sldMk cId="3145637976" sldId="268"/>
            <ac:grpSpMk id="147" creationId="{36353230-EF40-4898-8348-FE1704E7A825}"/>
          </ac:grpSpMkLst>
        </pc:grpChg>
        <pc:grpChg chg="del mod topLvl">
          <ac:chgData name="Manasweeta Angane" userId="05da2731-9352-4b35-b713-60351f56afbd" providerId="ADAL" clId="{9F8E7246-803F-4AD4-AD02-5ADAFDA400F2}" dt="2021-05-22T21:17:01.921" v="3664" actId="165"/>
          <ac:grpSpMkLst>
            <pc:docMk/>
            <pc:sldMk cId="3145637976" sldId="268"/>
            <ac:grpSpMk id="148" creationId="{5BBDC609-AF69-4CDF-BCDB-7C4C4AD97462}"/>
          </ac:grpSpMkLst>
        </pc:grpChg>
        <pc:grpChg chg="del mod topLvl">
          <ac:chgData name="Manasweeta Angane" userId="05da2731-9352-4b35-b713-60351f56afbd" providerId="ADAL" clId="{9F8E7246-803F-4AD4-AD02-5ADAFDA400F2}" dt="2021-05-22T22:05:30.258" v="3786" actId="165"/>
          <ac:grpSpMkLst>
            <pc:docMk/>
            <pc:sldMk cId="3145637976" sldId="268"/>
            <ac:grpSpMk id="150" creationId="{0FC7E3AC-8939-413B-9960-C0B87BE792FC}"/>
          </ac:grpSpMkLst>
        </pc:grpChg>
        <pc:grpChg chg="add del mod">
          <ac:chgData name="Manasweeta Angane" userId="05da2731-9352-4b35-b713-60351f56afbd" providerId="ADAL" clId="{9F8E7246-803F-4AD4-AD02-5ADAFDA400F2}" dt="2021-05-22T09:55:25.914" v="1704" actId="165"/>
          <ac:grpSpMkLst>
            <pc:docMk/>
            <pc:sldMk cId="3145637976" sldId="268"/>
            <ac:grpSpMk id="155" creationId="{9E413BCB-7703-4EE7-9192-E77831D84231}"/>
          </ac:grpSpMkLst>
        </pc:grpChg>
        <pc:grpChg chg="add mod">
          <ac:chgData name="Manasweeta Angane" userId="05da2731-9352-4b35-b713-60351f56afbd" providerId="ADAL" clId="{9F8E7246-803F-4AD4-AD02-5ADAFDA400F2}" dt="2021-05-23T00:15:48.996" v="4650" actId="1076"/>
          <ac:grpSpMkLst>
            <pc:docMk/>
            <pc:sldMk cId="3145637976" sldId="268"/>
            <ac:grpSpMk id="176" creationId="{C9642CF7-6595-4725-9BF2-DD6421CFE129}"/>
          </ac:grpSpMkLst>
        </pc:grpChg>
        <pc:grpChg chg="add del mod">
          <ac:chgData name="Manasweeta Angane" userId="05da2731-9352-4b35-b713-60351f56afbd" providerId="ADAL" clId="{9F8E7246-803F-4AD4-AD02-5ADAFDA400F2}" dt="2021-05-22T09:59:11.139" v="1933" actId="165"/>
          <ac:grpSpMkLst>
            <pc:docMk/>
            <pc:sldMk cId="3145637976" sldId="268"/>
            <ac:grpSpMk id="179" creationId="{18931E6D-D431-419A-96E3-8F31AFE50248}"/>
          </ac:grpSpMkLst>
        </pc:grpChg>
        <pc:grpChg chg="add mod">
          <ac:chgData name="Manasweeta Angane" userId="05da2731-9352-4b35-b713-60351f56afbd" providerId="ADAL" clId="{9F8E7246-803F-4AD4-AD02-5ADAFDA400F2}" dt="2021-05-23T00:19:32.447" v="4692" actId="1076"/>
          <ac:grpSpMkLst>
            <pc:docMk/>
            <pc:sldMk cId="3145637976" sldId="268"/>
            <ac:grpSpMk id="208" creationId="{B75B7045-1669-4FBD-A936-5786C3B7F362}"/>
          </ac:grpSpMkLst>
        </pc:grpChg>
        <pc:grpChg chg="add mod">
          <ac:chgData name="Manasweeta Angane" userId="05da2731-9352-4b35-b713-60351f56afbd" providerId="ADAL" clId="{9F8E7246-803F-4AD4-AD02-5ADAFDA400F2}" dt="2021-05-22T10:58:53.452" v="2755" actId="164"/>
          <ac:grpSpMkLst>
            <pc:docMk/>
            <pc:sldMk cId="3145637976" sldId="268"/>
            <ac:grpSpMk id="218" creationId="{E8FE01DD-AF9F-4D29-A96F-C003B13B8E03}"/>
          </ac:grpSpMkLst>
        </pc:grpChg>
        <pc:grpChg chg="add mod">
          <ac:chgData name="Manasweeta Angane" userId="05da2731-9352-4b35-b713-60351f56afbd" providerId="ADAL" clId="{9F8E7246-803F-4AD4-AD02-5ADAFDA400F2}" dt="2021-05-22T22:51:33.933" v="4513" actId="1076"/>
          <ac:grpSpMkLst>
            <pc:docMk/>
            <pc:sldMk cId="3145637976" sldId="268"/>
            <ac:grpSpMk id="233" creationId="{1035494A-358A-4909-9B5E-9796833D5D3C}"/>
          </ac:grpSpMkLst>
        </pc:grpChg>
        <pc:grpChg chg="add del mod">
          <ac:chgData name="Manasweeta Angane" userId="05da2731-9352-4b35-b713-60351f56afbd" providerId="ADAL" clId="{9F8E7246-803F-4AD4-AD02-5ADAFDA400F2}" dt="2021-05-22T11:03:57.496" v="3156" actId="165"/>
          <ac:grpSpMkLst>
            <pc:docMk/>
            <pc:sldMk cId="3145637976" sldId="268"/>
            <ac:grpSpMk id="233" creationId="{D1A377F3-BAA5-4B52-BB07-086BE89523F9}"/>
          </ac:grpSpMkLst>
        </pc:grpChg>
        <pc:grpChg chg="mod topLvl">
          <ac:chgData name="Manasweeta Angane" userId="05da2731-9352-4b35-b713-60351f56afbd" providerId="ADAL" clId="{9F8E7246-803F-4AD4-AD02-5ADAFDA400F2}" dt="2021-05-22T23:07:27.256" v="4635" actId="1076"/>
          <ac:grpSpMkLst>
            <pc:docMk/>
            <pc:sldMk cId="3145637976" sldId="268"/>
            <ac:grpSpMk id="256" creationId="{75BFB4DD-2211-47C7-AAB7-B36931CC0A5E}"/>
          </ac:grpSpMkLst>
        </pc:grpChg>
        <pc:grpChg chg="mod topLvl">
          <ac:chgData name="Manasweeta Angane" userId="05da2731-9352-4b35-b713-60351f56afbd" providerId="ADAL" clId="{9F8E7246-803F-4AD4-AD02-5ADAFDA400F2}" dt="2021-05-22T11:23:45.143" v="3250" actId="167"/>
          <ac:grpSpMkLst>
            <pc:docMk/>
            <pc:sldMk cId="3145637976" sldId="268"/>
            <ac:grpSpMk id="257" creationId="{DA0E798D-C357-4386-9C33-285E34E9393D}"/>
          </ac:grpSpMkLst>
        </pc:grpChg>
        <pc:grpChg chg="add mod">
          <ac:chgData name="Manasweeta Angane" userId="05da2731-9352-4b35-b713-60351f56afbd" providerId="ADAL" clId="{9F8E7246-803F-4AD4-AD02-5ADAFDA400F2}" dt="2021-05-22T23:05:08.770" v="4625" actId="1076"/>
          <ac:grpSpMkLst>
            <pc:docMk/>
            <pc:sldMk cId="3145637976" sldId="268"/>
            <ac:grpSpMk id="264" creationId="{2BB4502F-12F3-4087-BED9-EF35A1B16A06}"/>
          </ac:grpSpMkLst>
        </pc:grpChg>
        <pc:grpChg chg="add mod ord topLvl">
          <ac:chgData name="Manasweeta Angane" userId="05da2731-9352-4b35-b713-60351f56afbd" providerId="ADAL" clId="{9F8E7246-803F-4AD4-AD02-5ADAFDA400F2}" dt="2021-05-22T21:01:37.872" v="3614" actId="167"/>
          <ac:grpSpMkLst>
            <pc:docMk/>
            <pc:sldMk cId="3145637976" sldId="268"/>
            <ac:grpSpMk id="266" creationId="{30884ABD-770E-4F90-8DCD-DD0DBCFA01B5}"/>
          </ac:grpSpMkLst>
        </pc:grpChg>
        <pc:grpChg chg="add mod topLvl">
          <ac:chgData name="Manasweeta Angane" userId="05da2731-9352-4b35-b713-60351f56afbd" providerId="ADAL" clId="{9F8E7246-803F-4AD4-AD02-5ADAFDA400F2}" dt="2021-05-22T21:00:45.684" v="3607" actId="165"/>
          <ac:grpSpMkLst>
            <pc:docMk/>
            <pc:sldMk cId="3145637976" sldId="268"/>
            <ac:grpSpMk id="290" creationId="{76940501-C6B1-4261-BB57-13E2A4A9A29F}"/>
          </ac:grpSpMkLst>
        </pc:grpChg>
        <pc:graphicFrameChg chg="add del mod">
          <ac:chgData name="Manasweeta Angane" userId="05da2731-9352-4b35-b713-60351f56afbd" providerId="ADAL" clId="{9F8E7246-803F-4AD4-AD02-5ADAFDA400F2}" dt="2021-05-22T09:30:42.689" v="1222" actId="478"/>
          <ac:graphicFrameMkLst>
            <pc:docMk/>
            <pc:sldMk cId="3145637976" sldId="268"/>
            <ac:graphicFrameMk id="2" creationId="{A853B395-9715-491C-883C-7406DAB7E52E}"/>
          </ac:graphicFrameMkLst>
        </pc:graphicFrameChg>
        <pc:graphicFrameChg chg="add del mod">
          <ac:chgData name="Manasweeta Angane" userId="05da2731-9352-4b35-b713-60351f56afbd" providerId="ADAL" clId="{9F8E7246-803F-4AD4-AD02-5ADAFDA400F2}" dt="2021-05-22T09:30:41.955" v="1221" actId="478"/>
          <ac:graphicFrameMkLst>
            <pc:docMk/>
            <pc:sldMk cId="3145637976" sldId="268"/>
            <ac:graphicFrameMk id="5" creationId="{B487165B-7793-44C9-85B5-D10116EEA84E}"/>
          </ac:graphicFrameMkLst>
        </pc:graphicFrameChg>
        <pc:graphicFrameChg chg="add del mod">
          <ac:chgData name="Manasweeta Angane" userId="05da2731-9352-4b35-b713-60351f56afbd" providerId="ADAL" clId="{9F8E7246-803F-4AD4-AD02-5ADAFDA400F2}" dt="2021-05-22T09:30:39.305" v="1220" actId="478"/>
          <ac:graphicFrameMkLst>
            <pc:docMk/>
            <pc:sldMk cId="3145637976" sldId="268"/>
            <ac:graphicFrameMk id="6" creationId="{AB96BDA2-EC19-461D-9042-7B2011EE1F78}"/>
          </ac:graphicFrameMkLst>
        </pc:graphicFrameChg>
        <pc:graphicFrameChg chg="add del mod">
          <ac:chgData name="Manasweeta Angane" userId="05da2731-9352-4b35-b713-60351f56afbd" providerId="ADAL" clId="{9F8E7246-803F-4AD4-AD02-5ADAFDA400F2}" dt="2021-05-22T09:31:50.938" v="1224" actId="478"/>
          <ac:graphicFrameMkLst>
            <pc:docMk/>
            <pc:sldMk cId="3145637976" sldId="268"/>
            <ac:graphicFrameMk id="7" creationId="{AFC024AA-6971-4D5E-B490-6AD17B41F3AB}"/>
          </ac:graphicFrameMkLst>
        </pc:graphicFrameChg>
        <pc:picChg chg="mod topLvl">
          <ac:chgData name="Manasweeta Angane" userId="05da2731-9352-4b35-b713-60351f56afbd" providerId="ADAL" clId="{9F8E7246-803F-4AD4-AD02-5ADAFDA400F2}" dt="2021-05-22T21:07:35.467" v="3658" actId="29295"/>
          <ac:picMkLst>
            <pc:docMk/>
            <pc:sldMk cId="3145637976" sldId="268"/>
            <ac:picMk id="63" creationId="{FFD12E96-C47E-4680-A42F-BE0666A83820}"/>
          </ac:picMkLst>
        </pc:picChg>
        <pc:picChg chg="mod topLvl">
          <ac:chgData name="Manasweeta Angane" userId="05da2731-9352-4b35-b713-60351f56afbd" providerId="ADAL" clId="{9F8E7246-803F-4AD4-AD02-5ADAFDA400F2}" dt="2021-05-22T21:02:31.793" v="3618" actId="165"/>
          <ac:picMkLst>
            <pc:docMk/>
            <pc:sldMk cId="3145637976" sldId="268"/>
            <ac:picMk id="69" creationId="{268A7AD0-ED0E-4F7B-BF30-7C92EAE07824}"/>
          </ac:picMkLst>
        </pc:picChg>
        <pc:picChg chg="mod topLvl">
          <ac:chgData name="Manasweeta Angane" userId="05da2731-9352-4b35-b713-60351f56afbd" providerId="ADAL" clId="{9F8E7246-803F-4AD4-AD02-5ADAFDA400F2}" dt="2021-05-22T21:02:31.793" v="3618" actId="165"/>
          <ac:picMkLst>
            <pc:docMk/>
            <pc:sldMk cId="3145637976" sldId="268"/>
            <ac:picMk id="70" creationId="{A1F40D6A-62A0-4AB5-A38C-5F8C48038D5F}"/>
          </ac:picMkLst>
        </pc:picChg>
        <pc:picChg chg="add mod topLvl">
          <ac:chgData name="Manasweeta Angane" userId="05da2731-9352-4b35-b713-60351f56afbd" providerId="ADAL" clId="{9F8E7246-803F-4AD4-AD02-5ADAFDA400F2}" dt="2021-05-22T23:04:03.848" v="4622" actId="164"/>
          <ac:picMkLst>
            <pc:docMk/>
            <pc:sldMk cId="3145637976" sldId="268"/>
            <ac:picMk id="71" creationId="{2B60A1E2-6435-4118-B1D5-E931089C2D6A}"/>
          </ac:picMkLst>
        </pc:picChg>
        <pc:picChg chg="add mod topLvl">
          <ac:chgData name="Manasweeta Angane" userId="05da2731-9352-4b35-b713-60351f56afbd" providerId="ADAL" clId="{9F8E7246-803F-4AD4-AD02-5ADAFDA400F2}" dt="2021-05-22T21:02:31.793" v="3618" actId="165"/>
          <ac:picMkLst>
            <pc:docMk/>
            <pc:sldMk cId="3145637976" sldId="268"/>
            <ac:picMk id="72" creationId="{2BCC4350-1E5A-4493-8AE6-B6D367DEA6CA}"/>
          </ac:picMkLst>
        </pc:picChg>
        <pc:picChg chg="mod topLvl">
          <ac:chgData name="Manasweeta Angane" userId="05da2731-9352-4b35-b713-60351f56afbd" providerId="ADAL" clId="{9F8E7246-803F-4AD4-AD02-5ADAFDA400F2}" dt="2021-05-22T21:03:08.075" v="3622" actId="164"/>
          <ac:picMkLst>
            <pc:docMk/>
            <pc:sldMk cId="3145637976" sldId="268"/>
            <ac:picMk id="73" creationId="{F1DC4C44-9167-47C8-8408-EBD03807B7C5}"/>
          </ac:picMkLst>
        </pc:picChg>
        <pc:picChg chg="add mod topLvl">
          <ac:chgData name="Manasweeta Angane" userId="05da2731-9352-4b35-b713-60351f56afbd" providerId="ADAL" clId="{9F8E7246-803F-4AD4-AD02-5ADAFDA400F2}" dt="2021-05-22T21:06:09.232" v="3647" actId="164"/>
          <ac:picMkLst>
            <pc:docMk/>
            <pc:sldMk cId="3145637976" sldId="268"/>
            <ac:picMk id="74" creationId="{9E8E0083-012C-4B77-AE6E-899FCAB72D28}"/>
          </ac:picMkLst>
        </pc:picChg>
        <pc:picChg chg="add mod ord topLvl">
          <ac:chgData name="Manasweeta Angane" userId="05da2731-9352-4b35-b713-60351f56afbd" providerId="ADAL" clId="{9F8E7246-803F-4AD4-AD02-5ADAFDA400F2}" dt="2021-05-22T21:06:31.763" v="3650" actId="164"/>
          <ac:picMkLst>
            <pc:docMk/>
            <pc:sldMk cId="3145637976" sldId="268"/>
            <ac:picMk id="75" creationId="{3A63C3A8-9AB7-4CB1-97D6-2FE113DF2048}"/>
          </ac:picMkLst>
        </pc:picChg>
        <pc:picChg chg="add mod topLvl">
          <ac:chgData name="Manasweeta Angane" userId="05da2731-9352-4b35-b713-60351f56afbd" providerId="ADAL" clId="{9F8E7246-803F-4AD4-AD02-5ADAFDA400F2}" dt="2021-05-22T21:06:31.763" v="3650" actId="164"/>
          <ac:picMkLst>
            <pc:docMk/>
            <pc:sldMk cId="3145637976" sldId="268"/>
            <ac:picMk id="76" creationId="{1D8F8A38-DB9E-4E37-9265-933CEF2E1432}"/>
          </ac:picMkLst>
        </pc:picChg>
        <pc:picChg chg="add mod topLvl">
          <ac:chgData name="Manasweeta Angane" userId="05da2731-9352-4b35-b713-60351f56afbd" providerId="ADAL" clId="{9F8E7246-803F-4AD4-AD02-5ADAFDA400F2}" dt="2021-05-22T21:02:31.793" v="3618" actId="165"/>
          <ac:picMkLst>
            <pc:docMk/>
            <pc:sldMk cId="3145637976" sldId="268"/>
            <ac:picMk id="77" creationId="{4779BC41-8D4B-4FB2-9398-15C115C9E715}"/>
          </ac:picMkLst>
        </pc:picChg>
        <pc:picChg chg="add mod topLvl">
          <ac:chgData name="Manasweeta Angane" userId="05da2731-9352-4b35-b713-60351f56afbd" providerId="ADAL" clId="{9F8E7246-803F-4AD4-AD02-5ADAFDA400F2}" dt="2021-05-22T21:02:31.793" v="3618" actId="165"/>
          <ac:picMkLst>
            <pc:docMk/>
            <pc:sldMk cId="3145637976" sldId="268"/>
            <ac:picMk id="78" creationId="{5DF0BCBC-AA1A-428F-BF1D-EE5CECD40EA9}"/>
          </ac:picMkLst>
        </pc:picChg>
        <pc:picChg chg="add del mod">
          <ac:chgData name="Manasweeta Angane" userId="05da2731-9352-4b35-b713-60351f56afbd" providerId="ADAL" clId="{9F8E7246-803F-4AD4-AD02-5ADAFDA400F2}" dt="2021-05-22T10:37:03.377" v="2507" actId="478"/>
          <ac:picMkLst>
            <pc:docMk/>
            <pc:sldMk cId="3145637976" sldId="268"/>
            <ac:picMk id="79" creationId="{11062767-A8B3-4474-866F-826FC3573CF5}"/>
          </ac:picMkLst>
        </pc:picChg>
        <pc:picChg chg="add del mod">
          <ac:chgData name="Manasweeta Angane" userId="05da2731-9352-4b35-b713-60351f56afbd" providerId="ADAL" clId="{9F8E7246-803F-4AD4-AD02-5ADAFDA400F2}" dt="2021-05-22T10:37:06.702" v="2512" actId="478"/>
          <ac:picMkLst>
            <pc:docMk/>
            <pc:sldMk cId="3145637976" sldId="268"/>
            <ac:picMk id="80" creationId="{0DC8B91A-8F1D-42AD-90B6-7056DC4C5A8C}"/>
          </ac:picMkLst>
        </pc:picChg>
        <pc:picChg chg="mod">
          <ac:chgData name="Manasweeta Angane" userId="05da2731-9352-4b35-b713-60351f56afbd" providerId="ADAL" clId="{9F8E7246-803F-4AD4-AD02-5ADAFDA400F2}" dt="2021-05-22T09:53:19.875" v="1417"/>
          <ac:picMkLst>
            <pc:docMk/>
            <pc:sldMk cId="3145637976" sldId="268"/>
            <ac:picMk id="82" creationId="{47CF0E08-C7F3-415C-9438-347C7C085D20}"/>
          </ac:picMkLst>
        </pc:picChg>
        <pc:picChg chg="mod">
          <ac:chgData name="Manasweeta Angane" userId="05da2731-9352-4b35-b713-60351f56afbd" providerId="ADAL" clId="{9F8E7246-803F-4AD4-AD02-5ADAFDA400F2}" dt="2021-05-22T09:53:19.875" v="1417"/>
          <ac:picMkLst>
            <pc:docMk/>
            <pc:sldMk cId="3145637976" sldId="268"/>
            <ac:picMk id="83" creationId="{E0206917-A576-45D5-AF45-B96C23D40C8C}"/>
          </ac:picMkLst>
        </pc:picChg>
        <pc:picChg chg="mod">
          <ac:chgData name="Manasweeta Angane" userId="05da2731-9352-4b35-b713-60351f56afbd" providerId="ADAL" clId="{9F8E7246-803F-4AD4-AD02-5ADAFDA400F2}" dt="2021-05-22T09:53:19.875" v="1417"/>
          <ac:picMkLst>
            <pc:docMk/>
            <pc:sldMk cId="3145637976" sldId="268"/>
            <ac:picMk id="84" creationId="{916DF51C-3737-4CC8-BE65-3758A0AEA836}"/>
          </ac:picMkLst>
        </pc:picChg>
        <pc:picChg chg="mod">
          <ac:chgData name="Manasweeta Angane" userId="05da2731-9352-4b35-b713-60351f56afbd" providerId="ADAL" clId="{9F8E7246-803F-4AD4-AD02-5ADAFDA400F2}" dt="2021-05-22T09:53:19.875" v="1417"/>
          <ac:picMkLst>
            <pc:docMk/>
            <pc:sldMk cId="3145637976" sldId="268"/>
            <ac:picMk id="85" creationId="{58D6095C-55DB-47AE-B28C-2F3A024ACCA2}"/>
          </ac:picMkLst>
        </pc:picChg>
        <pc:picChg chg="mod">
          <ac:chgData name="Manasweeta Angane" userId="05da2731-9352-4b35-b713-60351f56afbd" providerId="ADAL" clId="{9F8E7246-803F-4AD4-AD02-5ADAFDA400F2}" dt="2021-05-22T09:53:19.875" v="1417"/>
          <ac:picMkLst>
            <pc:docMk/>
            <pc:sldMk cId="3145637976" sldId="268"/>
            <ac:picMk id="86" creationId="{848DF507-838D-49C1-944E-08960562217A}"/>
          </ac:picMkLst>
        </pc:picChg>
        <pc:picChg chg="mod">
          <ac:chgData name="Manasweeta Angane" userId="05da2731-9352-4b35-b713-60351f56afbd" providerId="ADAL" clId="{9F8E7246-803F-4AD4-AD02-5ADAFDA400F2}" dt="2021-05-22T09:53:19.875" v="1417"/>
          <ac:picMkLst>
            <pc:docMk/>
            <pc:sldMk cId="3145637976" sldId="268"/>
            <ac:picMk id="87" creationId="{61D32853-3AA0-4617-B5D5-AED44608FB79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89" creationId="{DB2660CF-8D64-49CA-88CC-E8165DC5AB3B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90" creationId="{C85951D7-94DE-4625-8455-A8F50B509C7C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91" creationId="{1BC1D2DF-6EF5-4C1C-BF18-F05639C1591C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92" creationId="{991ACEA8-4CE7-4A69-81FA-7695B077066F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93" creationId="{324E966C-61D5-4BE6-8E82-70CD00A1D39C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94" creationId="{A915DD73-685C-4F63-AEE5-E974D67C56CD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95" creationId="{5AA577DE-210B-472A-B295-5E02D8A5B405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96" creationId="{2588372D-3F46-47A7-8C5F-65716BC75AD1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97" creationId="{106A895C-3576-4AF4-929A-207C7C3DA2CD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98" creationId="{A0C278ED-5AD5-44E7-841F-6BCCE83DF7DA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99" creationId="{3FF2336B-2AD2-4B47-B74E-2D5A668A72BC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100" creationId="{B4B85B21-1810-4047-9AE0-8B4C2BD7D2C2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101" creationId="{FF9B0334-78AE-47DF-9453-A03492F9A707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102" creationId="{FE17F90D-E5CC-47F6-ACCF-82A769FD8FB8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103" creationId="{E205BD35-2FAE-431A-A4FE-E2DC782EC583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104" creationId="{58EC96F0-D73D-4611-B15D-9038A4A4B326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105" creationId="{9F381FCB-3EB7-4D57-B243-BA6343AFA17C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106" creationId="{99D0A586-F231-4822-973B-11290D27ED72}"/>
          </ac:picMkLst>
        </pc:picChg>
        <pc:picChg chg="mod">
          <ac:chgData name="Manasweeta Angane" userId="05da2731-9352-4b35-b713-60351f56afbd" providerId="ADAL" clId="{9F8E7246-803F-4AD4-AD02-5ADAFDA400F2}" dt="2021-05-22T10:52:28.234" v="2580" actId="14100"/>
          <ac:picMkLst>
            <pc:docMk/>
            <pc:sldMk cId="3145637976" sldId="268"/>
            <ac:picMk id="107" creationId="{5C0B13FE-23D3-4408-B63D-2E63CEF1FC6D}"/>
          </ac:picMkLst>
        </pc:picChg>
        <pc:picChg chg="mod">
          <ac:chgData name="Manasweeta Angane" userId="05da2731-9352-4b35-b713-60351f56afbd" providerId="ADAL" clId="{9F8E7246-803F-4AD4-AD02-5ADAFDA400F2}" dt="2021-05-22T10:52:18.379" v="2578" actId="1076"/>
          <ac:picMkLst>
            <pc:docMk/>
            <pc:sldMk cId="3145637976" sldId="268"/>
            <ac:picMk id="108" creationId="{7F6EFE52-17E3-49DF-B205-17E2CACD5EA8}"/>
          </ac:picMkLst>
        </pc:picChg>
        <pc:picChg chg="mod">
          <ac:chgData name="Manasweeta Angane" userId="05da2731-9352-4b35-b713-60351f56afbd" providerId="ADAL" clId="{9F8E7246-803F-4AD4-AD02-5ADAFDA400F2}" dt="2021-05-22T10:52:22.803" v="2579" actId="14100"/>
          <ac:picMkLst>
            <pc:docMk/>
            <pc:sldMk cId="3145637976" sldId="268"/>
            <ac:picMk id="110" creationId="{8A7FEBF2-7B4F-43AC-AED8-2AE6ABEAB31F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115" creationId="{54D4DF85-70E7-407C-8146-5D155158139A}"/>
          </ac:picMkLst>
        </pc:picChg>
        <pc:picChg chg="mod topLvl">
          <ac:chgData name="Manasweeta Angane" userId="05da2731-9352-4b35-b713-60351f56afbd" providerId="ADAL" clId="{9F8E7246-803F-4AD4-AD02-5ADAFDA400F2}" dt="2021-05-22T21:06:09.232" v="3647" actId="164"/>
          <ac:picMkLst>
            <pc:docMk/>
            <pc:sldMk cId="3145637976" sldId="268"/>
            <ac:picMk id="116" creationId="{EE901BD3-59B1-4F2A-9522-2595EEF17AB9}"/>
          </ac:picMkLst>
        </pc:picChg>
        <pc:picChg chg="mod topLvl">
          <ac:chgData name="Manasweeta Angane" userId="05da2731-9352-4b35-b713-60351f56afbd" providerId="ADAL" clId="{9F8E7246-803F-4AD4-AD02-5ADAFDA400F2}" dt="2021-05-22T21:03:08.075" v="3622" actId="164"/>
          <ac:picMkLst>
            <pc:docMk/>
            <pc:sldMk cId="3145637976" sldId="268"/>
            <ac:picMk id="117" creationId="{E3DE838B-D6D1-4AB6-ADE7-C6D29C994B00}"/>
          </ac:picMkLst>
        </pc:picChg>
        <pc:picChg chg="mod ord topLvl">
          <ac:chgData name="Manasweeta Angane" userId="05da2731-9352-4b35-b713-60351f56afbd" providerId="ADAL" clId="{9F8E7246-803F-4AD4-AD02-5ADAFDA400F2}" dt="2021-05-22T23:07:52.241" v="4636" actId="167"/>
          <ac:picMkLst>
            <pc:docMk/>
            <pc:sldMk cId="3145637976" sldId="268"/>
            <ac:picMk id="119" creationId="{8266D51C-5B54-453C-9811-ECCC4E2CB7E9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120" creationId="{D73DDC4B-DA43-4A74-AB9C-354F6B03E519}"/>
          </ac:picMkLst>
        </pc:picChg>
        <pc:picChg chg="mod ord topLvl">
          <ac:chgData name="Manasweeta Angane" userId="05da2731-9352-4b35-b713-60351f56afbd" providerId="ADAL" clId="{9F8E7246-803F-4AD4-AD02-5ADAFDA400F2}" dt="2021-05-22T21:02:31.793" v="3618" actId="165"/>
          <ac:picMkLst>
            <pc:docMk/>
            <pc:sldMk cId="3145637976" sldId="268"/>
            <ac:picMk id="121" creationId="{A699C752-50E6-4562-8EDA-0EBA9EBD69E6}"/>
          </ac:picMkLst>
        </pc:picChg>
        <pc:picChg chg="mod topLvl">
          <ac:chgData name="Manasweeta Angane" userId="05da2731-9352-4b35-b713-60351f56afbd" providerId="ADAL" clId="{9F8E7246-803F-4AD4-AD02-5ADAFDA400F2}" dt="2021-05-22T21:02:31.793" v="3618" actId="165"/>
          <ac:picMkLst>
            <pc:docMk/>
            <pc:sldMk cId="3145637976" sldId="268"/>
            <ac:picMk id="122" creationId="{AA92527F-8035-4404-84E0-045D401AC189}"/>
          </ac:picMkLst>
        </pc:picChg>
        <pc:picChg chg="mod ord topLvl">
          <ac:chgData name="Manasweeta Angane" userId="05da2731-9352-4b35-b713-60351f56afbd" providerId="ADAL" clId="{9F8E7246-803F-4AD4-AD02-5ADAFDA400F2}" dt="2021-05-22T21:02:31.793" v="3618" actId="165"/>
          <ac:picMkLst>
            <pc:docMk/>
            <pc:sldMk cId="3145637976" sldId="268"/>
            <ac:picMk id="123" creationId="{C987DDFD-24DA-47A5-9660-AF7B1759AFD5}"/>
          </ac:picMkLst>
        </pc:picChg>
        <pc:picChg chg="add del mod topLvl">
          <ac:chgData name="Manasweeta Angane" userId="05da2731-9352-4b35-b713-60351f56afbd" providerId="ADAL" clId="{9F8E7246-803F-4AD4-AD02-5ADAFDA400F2}" dt="2021-05-22T21:02:31.793" v="3618" actId="165"/>
          <ac:picMkLst>
            <pc:docMk/>
            <pc:sldMk cId="3145637976" sldId="268"/>
            <ac:picMk id="124" creationId="{48E1E8CB-8408-49CE-96CB-394C698E5CE0}"/>
          </ac:picMkLst>
        </pc:picChg>
        <pc:picChg chg="mod topLvl">
          <ac:chgData name="Manasweeta Angane" userId="05da2731-9352-4b35-b713-60351f56afbd" providerId="ADAL" clId="{9F8E7246-803F-4AD4-AD02-5ADAFDA400F2}" dt="2021-05-22T21:05:50.930" v="3646" actId="1076"/>
          <ac:picMkLst>
            <pc:docMk/>
            <pc:sldMk cId="3145637976" sldId="268"/>
            <ac:picMk id="125" creationId="{9B17EEF0-E6EF-4DA2-A876-AAB9102F32DA}"/>
          </ac:picMkLst>
        </pc:picChg>
        <pc:picChg chg="mod topLvl">
          <ac:chgData name="Manasweeta Angane" userId="05da2731-9352-4b35-b713-60351f56afbd" providerId="ADAL" clId="{9F8E7246-803F-4AD4-AD02-5ADAFDA400F2}" dt="2021-05-22T21:03:19.435" v="3623" actId="164"/>
          <ac:picMkLst>
            <pc:docMk/>
            <pc:sldMk cId="3145637976" sldId="268"/>
            <ac:picMk id="126" creationId="{1D9453B5-ACFA-41B6-AD30-7C67EBBFAA8D}"/>
          </ac:picMkLst>
        </pc:picChg>
        <pc:picChg chg="mod topLvl">
          <ac:chgData name="Manasweeta Angane" userId="05da2731-9352-4b35-b713-60351f56afbd" providerId="ADAL" clId="{9F8E7246-803F-4AD4-AD02-5ADAFDA400F2}" dt="2021-05-22T21:03:19.435" v="3623" actId="164"/>
          <ac:picMkLst>
            <pc:docMk/>
            <pc:sldMk cId="3145637976" sldId="268"/>
            <ac:picMk id="127" creationId="{D57632DB-9A15-4173-971E-D8569C8DECF1}"/>
          </ac:picMkLst>
        </pc:picChg>
        <pc:picChg chg="del">
          <ac:chgData name="Manasweeta Angane" userId="05da2731-9352-4b35-b713-60351f56afbd" providerId="ADAL" clId="{9F8E7246-803F-4AD4-AD02-5ADAFDA400F2}" dt="2021-05-22T09:14:46.611" v="452" actId="478"/>
          <ac:picMkLst>
            <pc:docMk/>
            <pc:sldMk cId="3145637976" sldId="268"/>
            <ac:picMk id="128" creationId="{1F09F4B5-BE47-4D8B-A8A9-38F04D8F33A0}"/>
          </ac:picMkLst>
        </pc:picChg>
        <pc:picChg chg="add mod">
          <ac:chgData name="Manasweeta Angane" userId="05da2731-9352-4b35-b713-60351f56afbd" providerId="ADAL" clId="{9F8E7246-803F-4AD4-AD02-5ADAFDA400F2}" dt="2021-05-22T20:55:10.340" v="3490" actId="571"/>
          <ac:picMkLst>
            <pc:docMk/>
            <pc:sldMk cId="3145637976" sldId="268"/>
            <ac:picMk id="128" creationId="{CEE8E494-86EB-4517-8D02-131EC0FA5082}"/>
          </ac:picMkLst>
        </pc:picChg>
        <pc:picChg chg="del mod topLvl">
          <ac:chgData name="Manasweeta Angane" userId="05da2731-9352-4b35-b713-60351f56afbd" providerId="ADAL" clId="{9F8E7246-803F-4AD4-AD02-5ADAFDA400F2}" dt="2021-05-22T09:23:52.402" v="790" actId="21"/>
          <ac:picMkLst>
            <pc:docMk/>
            <pc:sldMk cId="3145637976" sldId="268"/>
            <ac:picMk id="129" creationId="{6110A799-576F-4B76-B552-AEE3F142F0C7}"/>
          </ac:picMkLst>
        </pc:picChg>
        <pc:picChg chg="add mod">
          <ac:chgData name="Manasweeta Angane" userId="05da2731-9352-4b35-b713-60351f56afbd" providerId="ADAL" clId="{9F8E7246-803F-4AD4-AD02-5ADAFDA400F2}" dt="2021-05-22T20:55:49.356" v="3495" actId="571"/>
          <ac:picMkLst>
            <pc:docMk/>
            <pc:sldMk cId="3145637976" sldId="268"/>
            <ac:picMk id="129" creationId="{68A56CD5-3CCC-4517-8D52-6637A9B16FCE}"/>
          </ac:picMkLst>
        </pc:picChg>
        <pc:picChg chg="mod topLvl">
          <ac:chgData name="Manasweeta Angane" userId="05da2731-9352-4b35-b713-60351f56afbd" providerId="ADAL" clId="{9F8E7246-803F-4AD4-AD02-5ADAFDA400F2}" dt="2021-05-22T21:06:09.232" v="3647" actId="164"/>
          <ac:picMkLst>
            <pc:docMk/>
            <pc:sldMk cId="3145637976" sldId="268"/>
            <ac:picMk id="130" creationId="{89ADDBA9-E143-4048-8131-22EE00C0C031}"/>
          </ac:picMkLst>
        </pc:picChg>
        <pc:picChg chg="mod topLvl">
          <ac:chgData name="Manasweeta Angane" userId="05da2731-9352-4b35-b713-60351f56afbd" providerId="ADAL" clId="{9F8E7246-803F-4AD4-AD02-5ADAFDA400F2}" dt="2021-05-22T21:05:04.670" v="3641" actId="1076"/>
          <ac:picMkLst>
            <pc:docMk/>
            <pc:sldMk cId="3145637976" sldId="268"/>
            <ac:picMk id="131" creationId="{DBE65334-0AF4-44BE-84C1-2F1B7E2B7E11}"/>
          </ac:picMkLst>
        </pc:picChg>
        <pc:picChg chg="add mod">
          <ac:chgData name="Manasweeta Angane" userId="05da2731-9352-4b35-b713-60351f56afbd" providerId="ADAL" clId="{9F8E7246-803F-4AD4-AD02-5ADAFDA400F2}" dt="2021-05-22T20:55:49.356" v="3495" actId="571"/>
          <ac:picMkLst>
            <pc:docMk/>
            <pc:sldMk cId="3145637976" sldId="268"/>
            <ac:picMk id="132" creationId="{0205547A-CFD0-439A-A7E5-0A9C3DA264C5}"/>
          </ac:picMkLst>
        </pc:picChg>
        <pc:picChg chg="del mod topLvl">
          <ac:chgData name="Manasweeta Angane" userId="05da2731-9352-4b35-b713-60351f56afbd" providerId="ADAL" clId="{9F8E7246-803F-4AD4-AD02-5ADAFDA400F2}" dt="2021-05-22T09:23:52.402" v="790" actId="21"/>
          <ac:picMkLst>
            <pc:docMk/>
            <pc:sldMk cId="3145637976" sldId="268"/>
            <ac:picMk id="132" creationId="{E3155331-5D9B-4813-A963-2CA6AC52C304}"/>
          </ac:picMkLst>
        </pc:picChg>
        <pc:picChg chg="mod topLvl">
          <ac:chgData name="Manasweeta Angane" userId="05da2731-9352-4b35-b713-60351f56afbd" providerId="ADAL" clId="{9F8E7246-803F-4AD4-AD02-5ADAFDA400F2}" dt="2021-05-22T21:01:16.090" v="3611" actId="167"/>
          <ac:picMkLst>
            <pc:docMk/>
            <pc:sldMk cId="3145637976" sldId="268"/>
            <ac:picMk id="134" creationId="{1AAE73B2-3CC1-4E46-88BF-98C2BA5DFDDA}"/>
          </ac:picMkLst>
        </pc:picChg>
        <pc:picChg chg="add del mod topLvl">
          <ac:chgData name="Manasweeta Angane" userId="05da2731-9352-4b35-b713-60351f56afbd" providerId="ADAL" clId="{9F8E7246-803F-4AD4-AD02-5ADAFDA400F2}" dt="2021-05-22T22:13:42.138" v="3929" actId="478"/>
          <ac:picMkLst>
            <pc:docMk/>
            <pc:sldMk cId="3145637976" sldId="268"/>
            <ac:picMk id="137" creationId="{93AFF0EE-8F50-4C03-A1BC-47199BAF3265}"/>
          </ac:picMkLst>
        </pc:picChg>
        <pc:picChg chg="mod topLvl">
          <ac:chgData name="Manasweeta Angane" userId="05da2731-9352-4b35-b713-60351f56afbd" providerId="ADAL" clId="{9F8E7246-803F-4AD4-AD02-5ADAFDA400F2}" dt="2021-05-22T21:01:30.935" v="3613" actId="1076"/>
          <ac:picMkLst>
            <pc:docMk/>
            <pc:sldMk cId="3145637976" sldId="268"/>
            <ac:picMk id="138" creationId="{14B5D621-3D3E-4E90-9782-A09FA99034BB}"/>
          </ac:picMkLst>
        </pc:picChg>
        <pc:picChg chg="mod topLvl">
          <ac:chgData name="Manasweeta Angane" userId="05da2731-9352-4b35-b713-60351f56afbd" providerId="ADAL" clId="{9F8E7246-803F-4AD4-AD02-5ADAFDA400F2}" dt="2021-05-22T21:00:35.543" v="3606" actId="165"/>
          <ac:picMkLst>
            <pc:docMk/>
            <pc:sldMk cId="3145637976" sldId="268"/>
            <ac:picMk id="139" creationId="{867668E3-DD1B-41B2-8157-E2F31B222C8F}"/>
          </ac:picMkLst>
        </pc:picChg>
        <pc:picChg chg="mod topLvl">
          <ac:chgData name="Manasweeta Angane" userId="05da2731-9352-4b35-b713-60351f56afbd" providerId="ADAL" clId="{9F8E7246-803F-4AD4-AD02-5ADAFDA400F2}" dt="2021-05-22T21:01:55.918" v="3617" actId="167"/>
          <ac:picMkLst>
            <pc:docMk/>
            <pc:sldMk cId="3145637976" sldId="268"/>
            <ac:picMk id="140" creationId="{20731E7F-4B41-4D4B-A9BF-D16138E35581}"/>
          </ac:picMkLst>
        </pc:picChg>
        <pc:picChg chg="mod topLvl">
          <ac:chgData name="Manasweeta Angane" userId="05da2731-9352-4b35-b713-60351f56afbd" providerId="ADAL" clId="{9F8E7246-803F-4AD4-AD02-5ADAFDA400F2}" dt="2021-05-22T22:15:22.311" v="3961" actId="1076"/>
          <ac:picMkLst>
            <pc:docMk/>
            <pc:sldMk cId="3145637976" sldId="268"/>
            <ac:picMk id="149" creationId="{9B8ECC95-3A15-4925-B66F-72742253F7E8}"/>
          </ac:picMkLst>
        </pc:picChg>
        <pc:picChg chg="mod topLvl">
          <ac:chgData name="Manasweeta Angane" userId="05da2731-9352-4b35-b713-60351f56afbd" providerId="ADAL" clId="{9F8E7246-803F-4AD4-AD02-5ADAFDA400F2}" dt="2021-05-22T22:08:04.602" v="3803" actId="1076"/>
          <ac:picMkLst>
            <pc:docMk/>
            <pc:sldMk cId="3145637976" sldId="268"/>
            <ac:picMk id="151" creationId="{36C210C2-0906-4B4C-8D1C-0E57AFE79DF5}"/>
          </ac:picMkLst>
        </pc:picChg>
        <pc:picChg chg="del mod topLvl">
          <ac:chgData name="Manasweeta Angane" userId="05da2731-9352-4b35-b713-60351f56afbd" providerId="ADAL" clId="{9F8E7246-803F-4AD4-AD02-5ADAFDA400F2}" dt="2021-05-22T22:05:36.907" v="3787" actId="478"/>
          <ac:picMkLst>
            <pc:docMk/>
            <pc:sldMk cId="3145637976" sldId="268"/>
            <ac:picMk id="152" creationId="{DEAA9A95-D80E-45D5-A9E2-FF101AA5F1EE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152" creationId="{F2CC1352-8A10-4258-8C94-967E928A6E65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153" creationId="{A7A186F6-3659-4E14-9C8F-5463EB31C3BF}"/>
          </ac:picMkLst>
        </pc:picChg>
        <pc:picChg chg="del mod topLvl">
          <ac:chgData name="Manasweeta Angane" userId="05da2731-9352-4b35-b713-60351f56afbd" providerId="ADAL" clId="{9F8E7246-803F-4AD4-AD02-5ADAFDA400F2}" dt="2021-05-22T21:24:00.328" v="3670" actId="478"/>
          <ac:picMkLst>
            <pc:docMk/>
            <pc:sldMk cId="3145637976" sldId="268"/>
            <ac:picMk id="153" creationId="{BCFC7E45-4A91-4866-9452-94FE22CE4A04}"/>
          </ac:picMkLst>
        </pc:picChg>
        <pc:picChg chg="mod">
          <ac:chgData name="Manasweeta Angane" userId="05da2731-9352-4b35-b713-60351f56afbd" providerId="ADAL" clId="{9F8E7246-803F-4AD4-AD02-5ADAFDA400F2}" dt="2021-05-22T09:54:28.982" v="1509"/>
          <ac:picMkLst>
            <pc:docMk/>
            <pc:sldMk cId="3145637976" sldId="268"/>
            <ac:picMk id="154" creationId="{0F8F8BC6-AA75-4F5F-B3DD-EB7DE4F577E8}"/>
          </ac:picMkLst>
        </pc:picChg>
        <pc:picChg chg="del mod topLvl">
          <ac:chgData name="Manasweeta Angane" userId="05da2731-9352-4b35-b713-60351f56afbd" providerId="ADAL" clId="{9F8E7246-803F-4AD4-AD02-5ADAFDA400F2}" dt="2021-05-22T22:08:38.509" v="3807" actId="478"/>
          <ac:picMkLst>
            <pc:docMk/>
            <pc:sldMk cId="3145637976" sldId="268"/>
            <ac:picMk id="154" creationId="{BE99FABE-DDC5-42D5-A2DD-2714119F2887}"/>
          </ac:picMkLst>
        </pc:picChg>
        <pc:picChg chg="del mod topLvl">
          <ac:chgData name="Manasweeta Angane" userId="05da2731-9352-4b35-b713-60351f56afbd" providerId="ADAL" clId="{9F8E7246-803F-4AD4-AD02-5ADAFDA400F2}" dt="2021-05-22T22:08:37.352" v="3806" actId="478"/>
          <ac:picMkLst>
            <pc:docMk/>
            <pc:sldMk cId="3145637976" sldId="268"/>
            <ac:picMk id="155" creationId="{A62741ED-341F-414A-860E-F81C11C9E18D}"/>
          </ac:picMkLst>
        </pc:picChg>
        <pc:picChg chg="del mod topLvl">
          <ac:chgData name="Manasweeta Angane" userId="05da2731-9352-4b35-b713-60351f56afbd" providerId="ADAL" clId="{9F8E7246-803F-4AD4-AD02-5ADAFDA400F2}" dt="2021-05-22T22:08:35.831" v="3805" actId="478"/>
          <ac:picMkLst>
            <pc:docMk/>
            <pc:sldMk cId="3145637976" sldId="268"/>
            <ac:picMk id="156" creationId="{165420CF-685A-4BAA-8A0C-AE7CC9DB80E9}"/>
          </ac:picMkLst>
        </pc:picChg>
        <pc:picChg chg="del mod topLvl">
          <ac:chgData name="Manasweeta Angane" userId="05da2731-9352-4b35-b713-60351f56afbd" providerId="ADAL" clId="{9F8E7246-803F-4AD4-AD02-5ADAFDA400F2}" dt="2021-05-22T10:37:11.504" v="2518" actId="478"/>
          <ac:picMkLst>
            <pc:docMk/>
            <pc:sldMk cId="3145637976" sldId="268"/>
            <ac:picMk id="156" creationId="{9117A1CB-8A51-4515-A87E-1B311F1E8D47}"/>
          </ac:picMkLst>
        </pc:picChg>
        <pc:picChg chg="del mod topLvl">
          <ac:chgData name="Manasweeta Angane" userId="05da2731-9352-4b35-b713-60351f56afbd" providerId="ADAL" clId="{9F8E7246-803F-4AD4-AD02-5ADAFDA400F2}" dt="2021-05-22T10:37:08.033" v="2514" actId="478"/>
          <ac:picMkLst>
            <pc:docMk/>
            <pc:sldMk cId="3145637976" sldId="268"/>
            <ac:picMk id="157" creationId="{9F529FEF-F4FE-45DD-8A0B-2EC58FFD5A84}"/>
          </ac:picMkLst>
        </pc:picChg>
        <pc:picChg chg="mod">
          <ac:chgData name="Manasweeta Angane" userId="05da2731-9352-4b35-b713-60351f56afbd" providerId="ADAL" clId="{9F8E7246-803F-4AD4-AD02-5ADAFDA400F2}" dt="2021-05-22T21:00:35.543" v="3606" actId="165"/>
          <ac:picMkLst>
            <pc:docMk/>
            <pc:sldMk cId="3145637976" sldId="268"/>
            <ac:picMk id="157" creationId="{F28D5753-5D44-4EE6-B61C-4760110B46FA}"/>
          </ac:picMkLst>
        </pc:picChg>
        <pc:picChg chg="mod">
          <ac:chgData name="Manasweeta Angane" userId="05da2731-9352-4b35-b713-60351f56afbd" providerId="ADAL" clId="{9F8E7246-803F-4AD4-AD02-5ADAFDA400F2}" dt="2021-05-22T21:00:35.543" v="3606" actId="165"/>
          <ac:picMkLst>
            <pc:docMk/>
            <pc:sldMk cId="3145637976" sldId="268"/>
            <ac:picMk id="158" creationId="{BD79D81C-A251-4EF4-8B90-54F533D40291}"/>
          </ac:picMkLst>
        </pc:picChg>
        <pc:picChg chg="del mod topLvl">
          <ac:chgData name="Manasweeta Angane" userId="05da2731-9352-4b35-b713-60351f56afbd" providerId="ADAL" clId="{9F8E7246-803F-4AD4-AD02-5ADAFDA400F2}" dt="2021-05-22T10:37:10.432" v="2517" actId="478"/>
          <ac:picMkLst>
            <pc:docMk/>
            <pc:sldMk cId="3145637976" sldId="268"/>
            <ac:picMk id="158" creationId="{D3E8E70C-0229-4360-BAB1-D1A494EB2747}"/>
          </ac:picMkLst>
        </pc:picChg>
        <pc:picChg chg="del mod topLvl">
          <ac:chgData name="Manasweeta Angane" userId="05da2731-9352-4b35-b713-60351f56afbd" providerId="ADAL" clId="{9F8E7246-803F-4AD4-AD02-5ADAFDA400F2}" dt="2021-05-22T10:36:57.488" v="2502" actId="478"/>
          <ac:picMkLst>
            <pc:docMk/>
            <pc:sldMk cId="3145637976" sldId="268"/>
            <ac:picMk id="159" creationId="{2846CF18-96E2-45E1-8291-5D68550E897D}"/>
          </ac:picMkLst>
        </pc:picChg>
        <pc:picChg chg="mod">
          <ac:chgData name="Manasweeta Angane" userId="05da2731-9352-4b35-b713-60351f56afbd" providerId="ADAL" clId="{9F8E7246-803F-4AD4-AD02-5ADAFDA400F2}" dt="2021-05-22T21:00:35.543" v="3606" actId="165"/>
          <ac:picMkLst>
            <pc:docMk/>
            <pc:sldMk cId="3145637976" sldId="268"/>
            <ac:picMk id="159" creationId="{B92ED3B7-1582-4584-8A3A-11C967AF132D}"/>
          </ac:picMkLst>
        </pc:picChg>
        <pc:picChg chg="mod">
          <ac:chgData name="Manasweeta Angane" userId="05da2731-9352-4b35-b713-60351f56afbd" providerId="ADAL" clId="{9F8E7246-803F-4AD4-AD02-5ADAFDA400F2}" dt="2021-05-22T21:00:35.543" v="3606" actId="165"/>
          <ac:picMkLst>
            <pc:docMk/>
            <pc:sldMk cId="3145637976" sldId="268"/>
            <ac:picMk id="160" creationId="{866BC359-6408-45E7-9100-20EE5DF5FFD2}"/>
          </ac:picMkLst>
        </pc:picChg>
        <pc:picChg chg="del mod topLvl">
          <ac:chgData name="Manasweeta Angane" userId="05da2731-9352-4b35-b713-60351f56afbd" providerId="ADAL" clId="{9F8E7246-803F-4AD4-AD02-5ADAFDA400F2}" dt="2021-05-22T10:36:53.824" v="2497" actId="478"/>
          <ac:picMkLst>
            <pc:docMk/>
            <pc:sldMk cId="3145637976" sldId="268"/>
            <ac:picMk id="160" creationId="{939D4AB8-958A-447E-A9F7-3AD74F638400}"/>
          </ac:picMkLst>
        </pc:picChg>
        <pc:picChg chg="del mod topLvl">
          <ac:chgData name="Manasweeta Angane" userId="05da2731-9352-4b35-b713-60351f56afbd" providerId="ADAL" clId="{9F8E7246-803F-4AD4-AD02-5ADAFDA400F2}" dt="2021-05-22T10:36:55.247" v="2499" actId="478"/>
          <ac:picMkLst>
            <pc:docMk/>
            <pc:sldMk cId="3145637976" sldId="268"/>
            <ac:picMk id="161" creationId="{A43C25FF-F950-49C5-A185-7A051762F1EA}"/>
          </ac:picMkLst>
        </pc:picChg>
        <pc:picChg chg="mod">
          <ac:chgData name="Manasweeta Angane" userId="05da2731-9352-4b35-b713-60351f56afbd" providerId="ADAL" clId="{9F8E7246-803F-4AD4-AD02-5ADAFDA400F2}" dt="2021-05-22T21:00:35.543" v="3606" actId="165"/>
          <ac:picMkLst>
            <pc:docMk/>
            <pc:sldMk cId="3145637976" sldId="268"/>
            <ac:picMk id="161" creationId="{EBBDE1F7-FA15-454F-AAE5-5DC1CCA0E1B0}"/>
          </ac:picMkLst>
        </pc:picChg>
        <pc:picChg chg="mod">
          <ac:chgData name="Manasweeta Angane" userId="05da2731-9352-4b35-b713-60351f56afbd" providerId="ADAL" clId="{9F8E7246-803F-4AD4-AD02-5ADAFDA400F2}" dt="2021-05-22T21:00:35.543" v="3606" actId="165"/>
          <ac:picMkLst>
            <pc:docMk/>
            <pc:sldMk cId="3145637976" sldId="268"/>
            <ac:picMk id="162" creationId="{933E170F-117D-4B47-882D-89E4FE8CB021}"/>
          </ac:picMkLst>
        </pc:picChg>
        <pc:picChg chg="del mod topLvl">
          <ac:chgData name="Manasweeta Angane" userId="05da2731-9352-4b35-b713-60351f56afbd" providerId="ADAL" clId="{9F8E7246-803F-4AD4-AD02-5ADAFDA400F2}" dt="2021-05-22T10:37:07.344" v="2513" actId="478"/>
          <ac:picMkLst>
            <pc:docMk/>
            <pc:sldMk cId="3145637976" sldId="268"/>
            <ac:picMk id="162" creationId="{9BD3547B-349B-45A6-A274-7129D448F9B0}"/>
          </ac:picMkLst>
        </pc:picChg>
        <pc:picChg chg="del mod topLvl">
          <ac:chgData name="Manasweeta Angane" userId="05da2731-9352-4b35-b713-60351f56afbd" providerId="ADAL" clId="{9F8E7246-803F-4AD4-AD02-5ADAFDA400F2}" dt="2021-05-22T10:37:09.649" v="2516" actId="478"/>
          <ac:picMkLst>
            <pc:docMk/>
            <pc:sldMk cId="3145637976" sldId="268"/>
            <ac:picMk id="163" creationId="{6F39D2EF-40BE-4B40-97BD-63844ED45186}"/>
          </ac:picMkLst>
        </pc:picChg>
        <pc:picChg chg="mod">
          <ac:chgData name="Manasweeta Angane" userId="05da2731-9352-4b35-b713-60351f56afbd" providerId="ADAL" clId="{9F8E7246-803F-4AD4-AD02-5ADAFDA400F2}" dt="2021-05-22T21:00:35.543" v="3606" actId="165"/>
          <ac:picMkLst>
            <pc:docMk/>
            <pc:sldMk cId="3145637976" sldId="268"/>
            <ac:picMk id="163" creationId="{9B7252B1-3E02-41B8-80B8-A333E3BA8493}"/>
          </ac:picMkLst>
        </pc:picChg>
        <pc:picChg chg="del mod topLvl">
          <ac:chgData name="Manasweeta Angane" userId="05da2731-9352-4b35-b713-60351f56afbd" providerId="ADAL" clId="{9F8E7246-803F-4AD4-AD02-5ADAFDA400F2}" dt="2021-05-22T10:36:58.560" v="2503" actId="478"/>
          <ac:picMkLst>
            <pc:docMk/>
            <pc:sldMk cId="3145637976" sldId="268"/>
            <ac:picMk id="164" creationId="{0C386201-06B1-4877-B01E-8CD318C44867}"/>
          </ac:picMkLst>
        </pc:picChg>
        <pc:picChg chg="mod">
          <ac:chgData name="Manasweeta Angane" userId="05da2731-9352-4b35-b713-60351f56afbd" providerId="ADAL" clId="{9F8E7246-803F-4AD4-AD02-5ADAFDA400F2}" dt="2021-05-22T21:00:35.543" v="3606" actId="165"/>
          <ac:picMkLst>
            <pc:docMk/>
            <pc:sldMk cId="3145637976" sldId="268"/>
            <ac:picMk id="164" creationId="{31441B51-883B-46EC-BD2B-6A92E1CC1934}"/>
          </ac:picMkLst>
        </pc:picChg>
        <pc:picChg chg="mod">
          <ac:chgData name="Manasweeta Angane" userId="05da2731-9352-4b35-b713-60351f56afbd" providerId="ADAL" clId="{9F8E7246-803F-4AD4-AD02-5ADAFDA400F2}" dt="2021-05-22T21:00:35.543" v="3606" actId="165"/>
          <ac:picMkLst>
            <pc:docMk/>
            <pc:sldMk cId="3145637976" sldId="268"/>
            <ac:picMk id="165" creationId="{A4DF4002-EA63-4D5A-9CBF-E7E741678694}"/>
          </ac:picMkLst>
        </pc:picChg>
        <pc:picChg chg="del mod topLvl">
          <ac:chgData name="Manasweeta Angane" userId="05da2731-9352-4b35-b713-60351f56afbd" providerId="ADAL" clId="{9F8E7246-803F-4AD4-AD02-5ADAFDA400F2}" dt="2021-05-22T10:37:01.088" v="2504" actId="478"/>
          <ac:picMkLst>
            <pc:docMk/>
            <pc:sldMk cId="3145637976" sldId="268"/>
            <ac:picMk id="165" creationId="{A54CD195-49CD-41D3-AA2E-3AE7C3DEFEFB}"/>
          </ac:picMkLst>
        </pc:picChg>
        <pc:picChg chg="mod">
          <ac:chgData name="Manasweeta Angane" userId="05da2731-9352-4b35-b713-60351f56afbd" providerId="ADAL" clId="{9F8E7246-803F-4AD4-AD02-5ADAFDA400F2}" dt="2021-05-22T21:00:35.543" v="3606" actId="165"/>
          <ac:picMkLst>
            <pc:docMk/>
            <pc:sldMk cId="3145637976" sldId="268"/>
            <ac:picMk id="166" creationId="{019F6DA1-F997-4950-99CD-DF9FB088B055}"/>
          </ac:picMkLst>
        </pc:picChg>
        <pc:picChg chg="del mod topLvl">
          <ac:chgData name="Manasweeta Angane" userId="05da2731-9352-4b35-b713-60351f56afbd" providerId="ADAL" clId="{9F8E7246-803F-4AD4-AD02-5ADAFDA400F2}" dt="2021-05-22T10:37:05.376" v="2510" actId="478"/>
          <ac:picMkLst>
            <pc:docMk/>
            <pc:sldMk cId="3145637976" sldId="268"/>
            <ac:picMk id="166" creationId="{83FAB14E-3ADA-49C5-97B3-0C9D9E0C27D5}"/>
          </ac:picMkLst>
        </pc:picChg>
        <pc:picChg chg="del mod topLvl">
          <ac:chgData name="Manasweeta Angane" userId="05da2731-9352-4b35-b713-60351f56afbd" providerId="ADAL" clId="{9F8E7246-803F-4AD4-AD02-5ADAFDA400F2}" dt="2021-05-22T10:37:06.032" v="2511" actId="478"/>
          <ac:picMkLst>
            <pc:docMk/>
            <pc:sldMk cId="3145637976" sldId="268"/>
            <ac:picMk id="167" creationId="{AABC43EC-9764-4701-8A95-FB19F49C4F6F}"/>
          </ac:picMkLst>
        </pc:picChg>
        <pc:picChg chg="mod">
          <ac:chgData name="Manasweeta Angane" userId="05da2731-9352-4b35-b713-60351f56afbd" providerId="ADAL" clId="{9F8E7246-803F-4AD4-AD02-5ADAFDA400F2}" dt="2021-05-22T21:00:35.543" v="3606" actId="165"/>
          <ac:picMkLst>
            <pc:docMk/>
            <pc:sldMk cId="3145637976" sldId="268"/>
            <ac:picMk id="167" creationId="{B65055B5-7B73-4FBA-8C3F-028292F75AA6}"/>
          </ac:picMkLst>
        </pc:picChg>
        <pc:picChg chg="del mod topLvl">
          <ac:chgData name="Manasweeta Angane" userId="05da2731-9352-4b35-b713-60351f56afbd" providerId="ADAL" clId="{9F8E7246-803F-4AD4-AD02-5ADAFDA400F2}" dt="2021-05-22T10:36:52.016" v="2495" actId="478"/>
          <ac:picMkLst>
            <pc:docMk/>
            <pc:sldMk cId="3145637976" sldId="268"/>
            <ac:picMk id="168" creationId="{99800EA6-331B-4B9D-9315-89441409187D}"/>
          </ac:picMkLst>
        </pc:picChg>
        <pc:picChg chg="mod">
          <ac:chgData name="Manasweeta Angane" userId="05da2731-9352-4b35-b713-60351f56afbd" providerId="ADAL" clId="{9F8E7246-803F-4AD4-AD02-5ADAFDA400F2}" dt="2021-05-22T21:00:35.543" v="3606" actId="165"/>
          <ac:picMkLst>
            <pc:docMk/>
            <pc:sldMk cId="3145637976" sldId="268"/>
            <ac:picMk id="168" creationId="{A9149B0A-21F9-468D-A383-340791143051}"/>
          </ac:picMkLst>
        </pc:picChg>
        <pc:picChg chg="mod">
          <ac:chgData name="Manasweeta Angane" userId="05da2731-9352-4b35-b713-60351f56afbd" providerId="ADAL" clId="{9F8E7246-803F-4AD4-AD02-5ADAFDA400F2}" dt="2021-05-22T22:33:33.061" v="4050" actId="1076"/>
          <ac:picMkLst>
            <pc:docMk/>
            <pc:sldMk cId="3145637976" sldId="268"/>
            <ac:picMk id="169" creationId="{400FD4FE-FFBB-480C-A012-75CB5A104CF9}"/>
          </ac:picMkLst>
        </pc:picChg>
        <pc:picChg chg="del mod topLvl">
          <ac:chgData name="Manasweeta Angane" userId="05da2731-9352-4b35-b713-60351f56afbd" providerId="ADAL" clId="{9F8E7246-803F-4AD4-AD02-5ADAFDA400F2}" dt="2021-05-22T10:36:52.849" v="2496" actId="478"/>
          <ac:picMkLst>
            <pc:docMk/>
            <pc:sldMk cId="3145637976" sldId="268"/>
            <ac:picMk id="169" creationId="{EAC5839A-C3B6-45C6-975B-B35EB6063FF2}"/>
          </ac:picMkLst>
        </pc:picChg>
        <pc:picChg chg="mod">
          <ac:chgData name="Manasweeta Angane" userId="05da2731-9352-4b35-b713-60351f56afbd" providerId="ADAL" clId="{9F8E7246-803F-4AD4-AD02-5ADAFDA400F2}" dt="2021-05-22T22:33:33.061" v="4050" actId="1076"/>
          <ac:picMkLst>
            <pc:docMk/>
            <pc:sldMk cId="3145637976" sldId="268"/>
            <ac:picMk id="170" creationId="{B4785251-590A-4901-8351-BEB26D791023}"/>
          </ac:picMkLst>
        </pc:picChg>
        <pc:picChg chg="del mod topLvl">
          <ac:chgData name="Manasweeta Angane" userId="05da2731-9352-4b35-b713-60351f56afbd" providerId="ADAL" clId="{9F8E7246-803F-4AD4-AD02-5ADAFDA400F2}" dt="2021-05-22T10:36:56.896" v="2501" actId="478"/>
          <ac:picMkLst>
            <pc:docMk/>
            <pc:sldMk cId="3145637976" sldId="268"/>
            <ac:picMk id="170" creationId="{BEB95D9D-2F8A-48AF-BA1A-E649E743CE90}"/>
          </ac:picMkLst>
        </pc:picChg>
        <pc:picChg chg="del mod topLvl">
          <ac:chgData name="Manasweeta Angane" userId="05da2731-9352-4b35-b713-60351f56afbd" providerId="ADAL" clId="{9F8E7246-803F-4AD4-AD02-5ADAFDA400F2}" dt="2021-05-22T10:36:55.824" v="2500" actId="478"/>
          <ac:picMkLst>
            <pc:docMk/>
            <pc:sldMk cId="3145637976" sldId="268"/>
            <ac:picMk id="171" creationId="{0FC6986E-59B6-4A03-B9F2-B1719D1AB7E5}"/>
          </ac:picMkLst>
        </pc:picChg>
        <pc:picChg chg="mod">
          <ac:chgData name="Manasweeta Angane" userId="05da2731-9352-4b35-b713-60351f56afbd" providerId="ADAL" clId="{9F8E7246-803F-4AD4-AD02-5ADAFDA400F2}" dt="2021-05-22T21:00:35.543" v="3606" actId="165"/>
          <ac:picMkLst>
            <pc:docMk/>
            <pc:sldMk cId="3145637976" sldId="268"/>
            <ac:picMk id="171" creationId="{5DF7D849-F92D-4309-8267-F7AFF0A1D99B}"/>
          </ac:picMkLst>
        </pc:picChg>
        <pc:picChg chg="mod">
          <ac:chgData name="Manasweeta Angane" userId="05da2731-9352-4b35-b713-60351f56afbd" providerId="ADAL" clId="{9F8E7246-803F-4AD4-AD02-5ADAFDA400F2}" dt="2021-05-22T21:00:35.543" v="3606" actId="165"/>
          <ac:picMkLst>
            <pc:docMk/>
            <pc:sldMk cId="3145637976" sldId="268"/>
            <ac:picMk id="172" creationId="{8FCD60A7-63A2-433A-ABFD-039A5392E67E}"/>
          </ac:picMkLst>
        </pc:picChg>
        <pc:picChg chg="del mod topLvl">
          <ac:chgData name="Manasweeta Angane" userId="05da2731-9352-4b35-b713-60351f56afbd" providerId="ADAL" clId="{9F8E7246-803F-4AD4-AD02-5ADAFDA400F2}" dt="2021-05-22T10:37:12.112" v="2519" actId="478"/>
          <ac:picMkLst>
            <pc:docMk/>
            <pc:sldMk cId="3145637976" sldId="268"/>
            <ac:picMk id="172" creationId="{E108D435-C16C-4B57-951C-FCC09FFCFEDA}"/>
          </ac:picMkLst>
        </pc:picChg>
        <pc:picChg chg="del mod topLvl">
          <ac:chgData name="Manasweeta Angane" userId="05da2731-9352-4b35-b713-60351f56afbd" providerId="ADAL" clId="{9F8E7246-803F-4AD4-AD02-5ADAFDA400F2}" dt="2021-05-22T22:39:33.174" v="4429" actId="478"/>
          <ac:picMkLst>
            <pc:docMk/>
            <pc:sldMk cId="3145637976" sldId="268"/>
            <ac:picMk id="173" creationId="{931BE2B1-6790-4EFE-B9F3-ED94DAB9FA61}"/>
          </ac:picMkLst>
        </pc:picChg>
        <pc:picChg chg="del mod topLvl">
          <ac:chgData name="Manasweeta Angane" userId="05da2731-9352-4b35-b713-60351f56afbd" providerId="ADAL" clId="{9F8E7246-803F-4AD4-AD02-5ADAFDA400F2}" dt="2021-05-22T10:37:08.896" v="2515" actId="478"/>
          <ac:picMkLst>
            <pc:docMk/>
            <pc:sldMk cId="3145637976" sldId="268"/>
            <ac:picMk id="173" creationId="{F410D700-A251-4D69-A60B-F474C3133527}"/>
          </ac:picMkLst>
        </pc:picChg>
        <pc:picChg chg="mod topLvl">
          <ac:chgData name="Manasweeta Angane" userId="05da2731-9352-4b35-b713-60351f56afbd" providerId="ADAL" clId="{9F8E7246-803F-4AD4-AD02-5ADAFDA400F2}" dt="2021-05-22T22:39:28.330" v="4428" actId="165"/>
          <ac:picMkLst>
            <pc:docMk/>
            <pc:sldMk cId="3145637976" sldId="268"/>
            <ac:picMk id="174" creationId="{D7F30796-E66E-460A-8569-276C54760AEC}"/>
          </ac:picMkLst>
        </pc:picChg>
        <pc:picChg chg="del mod topLvl">
          <ac:chgData name="Manasweeta Angane" userId="05da2731-9352-4b35-b713-60351f56afbd" providerId="ADAL" clId="{9F8E7246-803F-4AD4-AD02-5ADAFDA400F2}" dt="2021-05-22T10:36:54.591" v="2498" actId="478"/>
          <ac:picMkLst>
            <pc:docMk/>
            <pc:sldMk cId="3145637976" sldId="268"/>
            <ac:picMk id="174" creationId="{DB5ABF44-6132-4493-9946-B8194BEC5EA2}"/>
          </ac:picMkLst>
        </pc:picChg>
        <pc:picChg chg="del mod topLvl">
          <ac:chgData name="Manasweeta Angane" userId="05da2731-9352-4b35-b713-60351f56afbd" providerId="ADAL" clId="{9F8E7246-803F-4AD4-AD02-5ADAFDA400F2}" dt="2021-05-22T22:11:10.543" v="3905" actId="478"/>
          <ac:picMkLst>
            <pc:docMk/>
            <pc:sldMk cId="3145637976" sldId="268"/>
            <ac:picMk id="175" creationId="{9A82FC16-42EA-4C5E-9181-B8D7997FBC3C}"/>
          </ac:picMkLst>
        </pc:picChg>
        <pc:picChg chg="del mod topLvl">
          <ac:chgData name="Manasweeta Angane" userId="05da2731-9352-4b35-b713-60351f56afbd" providerId="ADAL" clId="{9F8E7246-803F-4AD4-AD02-5ADAFDA400F2}" dt="2021-05-22T10:37:02.751" v="2506" actId="478"/>
          <ac:picMkLst>
            <pc:docMk/>
            <pc:sldMk cId="3145637976" sldId="268"/>
            <ac:picMk id="175" creationId="{CCB61636-6B38-40F4-B681-4AD63495D6F5}"/>
          </ac:picMkLst>
        </pc:picChg>
        <pc:picChg chg="del mod topLvl">
          <ac:chgData name="Manasweeta Angane" userId="05da2731-9352-4b35-b713-60351f56afbd" providerId="ADAL" clId="{9F8E7246-803F-4AD4-AD02-5ADAFDA400F2}" dt="2021-05-22T22:06:54.524" v="3792" actId="478"/>
          <ac:picMkLst>
            <pc:docMk/>
            <pc:sldMk cId="3145637976" sldId="268"/>
            <ac:picMk id="176" creationId="{41E203CC-8657-4C64-A0FB-E62732E111F2}"/>
          </ac:picMkLst>
        </pc:picChg>
        <pc:picChg chg="del mod topLvl">
          <ac:chgData name="Manasweeta Angane" userId="05da2731-9352-4b35-b713-60351f56afbd" providerId="ADAL" clId="{9F8E7246-803F-4AD4-AD02-5ADAFDA400F2}" dt="2021-05-22T10:37:01.935" v="2505" actId="478"/>
          <ac:picMkLst>
            <pc:docMk/>
            <pc:sldMk cId="3145637976" sldId="268"/>
            <ac:picMk id="176" creationId="{AE049FA2-8C33-4E28-8A78-16E3BCB8AA80}"/>
          </ac:picMkLst>
        </pc:picChg>
        <pc:picChg chg="mod topLvl">
          <ac:chgData name="Manasweeta Angane" userId="05da2731-9352-4b35-b713-60351f56afbd" providerId="ADAL" clId="{9F8E7246-803F-4AD4-AD02-5ADAFDA400F2}" dt="2021-05-22T22:37:32.704" v="4414" actId="164"/>
          <ac:picMkLst>
            <pc:docMk/>
            <pc:sldMk cId="3145637976" sldId="268"/>
            <ac:picMk id="177" creationId="{AAE49543-4A74-4E44-8F05-601DB4A675C3}"/>
          </ac:picMkLst>
        </pc:picChg>
        <pc:picChg chg="del mod topLvl">
          <ac:chgData name="Manasweeta Angane" userId="05da2731-9352-4b35-b713-60351f56afbd" providerId="ADAL" clId="{9F8E7246-803F-4AD4-AD02-5ADAFDA400F2}" dt="2021-05-22T10:37:04.160" v="2508" actId="478"/>
          <ac:picMkLst>
            <pc:docMk/>
            <pc:sldMk cId="3145637976" sldId="268"/>
            <ac:picMk id="177" creationId="{BCEA495C-9239-4760-99FB-863E1320E843}"/>
          </ac:picMkLst>
        </pc:picChg>
        <pc:picChg chg="del mod topLvl">
          <ac:chgData name="Manasweeta Angane" userId="05da2731-9352-4b35-b713-60351f56afbd" providerId="ADAL" clId="{9F8E7246-803F-4AD4-AD02-5ADAFDA400F2}" dt="2021-05-22T22:36:17.110" v="4338" actId="478"/>
          <ac:picMkLst>
            <pc:docMk/>
            <pc:sldMk cId="3145637976" sldId="268"/>
            <ac:picMk id="178" creationId="{503C8BA0-947F-4DB1-90DD-AB23DF1F2494}"/>
          </ac:picMkLst>
        </pc:picChg>
        <pc:picChg chg="del mod topLvl">
          <ac:chgData name="Manasweeta Angane" userId="05da2731-9352-4b35-b713-60351f56afbd" providerId="ADAL" clId="{9F8E7246-803F-4AD4-AD02-5ADAFDA400F2}" dt="2021-05-22T10:37:04.832" v="2509" actId="478"/>
          <ac:picMkLst>
            <pc:docMk/>
            <pc:sldMk cId="3145637976" sldId="268"/>
            <ac:picMk id="178" creationId="{A5D1FBE6-9963-4F3E-8D02-01302B3CD8F2}"/>
          </ac:picMkLst>
        </pc:picChg>
        <pc:picChg chg="mod">
          <ac:chgData name="Manasweeta Angane" userId="05da2731-9352-4b35-b713-60351f56afbd" providerId="ADAL" clId="{9F8E7246-803F-4AD4-AD02-5ADAFDA400F2}" dt="2021-05-23T00:15:43.418" v="4649"/>
          <ac:picMkLst>
            <pc:docMk/>
            <pc:sldMk cId="3145637976" sldId="268"/>
            <ac:picMk id="178" creationId="{CFBF0894-9E05-4350-BB4E-EDCE6F1E73F1}"/>
          </ac:picMkLst>
        </pc:picChg>
        <pc:picChg chg="mod">
          <ac:chgData name="Manasweeta Angane" userId="05da2731-9352-4b35-b713-60351f56afbd" providerId="ADAL" clId="{9F8E7246-803F-4AD4-AD02-5ADAFDA400F2}" dt="2021-05-23T00:15:43.418" v="4649"/>
          <ac:picMkLst>
            <pc:docMk/>
            <pc:sldMk cId="3145637976" sldId="268"/>
            <ac:picMk id="179" creationId="{A8A3E3B2-831B-425D-A909-4A463AB58262}"/>
          </ac:picMkLst>
        </pc:picChg>
        <pc:picChg chg="mod topLvl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180" creationId="{08D31902-A643-473B-96D3-168590F797B5}"/>
          </ac:picMkLst>
        </pc:picChg>
        <pc:picChg chg="add mod">
          <ac:chgData name="Manasweeta Angane" userId="05da2731-9352-4b35-b713-60351f56afbd" providerId="ADAL" clId="{9F8E7246-803F-4AD4-AD02-5ADAFDA400F2}" dt="2021-05-22T21:05:46.404" v="3644" actId="571"/>
          <ac:picMkLst>
            <pc:docMk/>
            <pc:sldMk cId="3145637976" sldId="268"/>
            <ac:picMk id="180" creationId="{39823B8A-5E8B-43D1-B7BA-54F8F0B3CE6D}"/>
          </ac:picMkLst>
        </pc:picChg>
        <pc:picChg chg="mod">
          <ac:chgData name="Manasweeta Angane" userId="05da2731-9352-4b35-b713-60351f56afbd" providerId="ADAL" clId="{9F8E7246-803F-4AD4-AD02-5ADAFDA400F2}" dt="2021-05-23T00:15:43.418" v="4649"/>
          <ac:picMkLst>
            <pc:docMk/>
            <pc:sldMk cId="3145637976" sldId="268"/>
            <ac:picMk id="180" creationId="{556996FF-854B-4000-B477-71EBEF5EFFE7}"/>
          </ac:picMkLst>
        </pc:picChg>
        <pc:picChg chg="add mod">
          <ac:chgData name="Manasweeta Angane" userId="05da2731-9352-4b35-b713-60351f56afbd" providerId="ADAL" clId="{9F8E7246-803F-4AD4-AD02-5ADAFDA400F2}" dt="2021-05-23T00:16:22.074" v="4654" actId="167"/>
          <ac:picMkLst>
            <pc:docMk/>
            <pc:sldMk cId="3145637976" sldId="268"/>
            <ac:picMk id="181" creationId="{A37EA6FC-3453-4A17-A71D-FF8AEB09B7EA}"/>
          </ac:picMkLst>
        </pc:picChg>
        <pc:picChg chg="mod topLvl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181" creationId="{BC8654D9-2748-43ED-A86A-D8C7E27B5BE4}"/>
          </ac:picMkLst>
        </pc:picChg>
        <pc:picChg chg="del mod ord topLvl">
          <ac:chgData name="Manasweeta Angane" userId="05da2731-9352-4b35-b713-60351f56afbd" providerId="ADAL" clId="{9F8E7246-803F-4AD4-AD02-5ADAFDA400F2}" dt="2021-05-22T10:28:24.142" v="2277" actId="478"/>
          <ac:picMkLst>
            <pc:docMk/>
            <pc:sldMk cId="3145637976" sldId="268"/>
            <ac:picMk id="182" creationId="{05A6CB0D-CBF0-4A25-BF7D-2782E18FE4AD}"/>
          </ac:picMkLst>
        </pc:picChg>
        <pc:picChg chg="add mod">
          <ac:chgData name="Manasweeta Angane" userId="05da2731-9352-4b35-b713-60351f56afbd" providerId="ADAL" clId="{9F8E7246-803F-4AD4-AD02-5ADAFDA400F2}" dt="2021-05-22T21:06:31.763" v="3650" actId="164"/>
          <ac:picMkLst>
            <pc:docMk/>
            <pc:sldMk cId="3145637976" sldId="268"/>
            <ac:picMk id="182" creationId="{86B25B73-EEC2-4CEE-AB08-CEDEA60985A1}"/>
          </ac:picMkLst>
        </pc:picChg>
        <pc:picChg chg="mod topLvl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183" creationId="{12B58023-7988-43EF-93E9-E88B32DF631A}"/>
          </ac:picMkLst>
        </pc:picChg>
        <pc:picChg chg="add del mod">
          <ac:chgData name="Manasweeta Angane" userId="05da2731-9352-4b35-b713-60351f56afbd" providerId="ADAL" clId="{9F8E7246-803F-4AD4-AD02-5ADAFDA400F2}" dt="2021-05-23T00:17:11.590" v="4657" actId="478"/>
          <ac:picMkLst>
            <pc:docMk/>
            <pc:sldMk cId="3145637976" sldId="268"/>
            <ac:picMk id="183" creationId="{40098E77-7C20-4771-B11C-DE5485416DE1}"/>
          </ac:picMkLst>
        </pc:picChg>
        <pc:picChg chg="mod topLvl">
          <ac:chgData name="Manasweeta Angane" userId="05da2731-9352-4b35-b713-60351f56afbd" providerId="ADAL" clId="{9F8E7246-803F-4AD4-AD02-5ADAFDA400F2}" dt="2021-05-22T11:04:28.156" v="3163" actId="1076"/>
          <ac:picMkLst>
            <pc:docMk/>
            <pc:sldMk cId="3145637976" sldId="268"/>
            <ac:picMk id="184" creationId="{44CBA7AE-9683-4271-95D5-42146FD29FA3}"/>
          </ac:picMkLst>
        </pc:picChg>
        <pc:picChg chg="add del mod ord topLvl">
          <ac:chgData name="Manasweeta Angane" userId="05da2731-9352-4b35-b713-60351f56afbd" providerId="ADAL" clId="{9F8E7246-803F-4AD4-AD02-5ADAFDA400F2}" dt="2021-05-22T11:04:40.740" v="3167" actId="166"/>
          <ac:picMkLst>
            <pc:docMk/>
            <pc:sldMk cId="3145637976" sldId="268"/>
            <ac:picMk id="185" creationId="{16077B0F-A71E-4664-A47D-F7F0F96450B8}"/>
          </ac:picMkLst>
        </pc:picChg>
        <pc:picChg chg="mod topLvl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186" creationId="{C988176D-5CA6-47CA-BD6B-6EF34418EC2A}"/>
          </ac:picMkLst>
        </pc:picChg>
        <pc:picChg chg="add mod">
          <ac:chgData name="Manasweeta Angane" userId="05da2731-9352-4b35-b713-60351f56afbd" providerId="ADAL" clId="{9F8E7246-803F-4AD4-AD02-5ADAFDA400F2}" dt="2021-05-22T21:07:28.216" v="3657" actId="29295"/>
          <ac:picMkLst>
            <pc:docMk/>
            <pc:sldMk cId="3145637976" sldId="268"/>
            <ac:picMk id="186" creationId="{E60D3C60-3F19-4D03-B141-21F64ADBF9D9}"/>
          </ac:picMkLst>
        </pc:picChg>
        <pc:picChg chg="del mod topLvl">
          <ac:chgData name="Manasweeta Angane" userId="05da2731-9352-4b35-b713-60351f56afbd" providerId="ADAL" clId="{9F8E7246-803F-4AD4-AD02-5ADAFDA400F2}" dt="2021-05-22T10:27:09.263" v="2267" actId="478"/>
          <ac:picMkLst>
            <pc:docMk/>
            <pc:sldMk cId="3145637976" sldId="268"/>
            <ac:picMk id="187" creationId="{2BF87DE9-1F29-4F7F-8149-3918E6A81AFB}"/>
          </ac:picMkLst>
        </pc:picChg>
        <pc:picChg chg="add mod">
          <ac:chgData name="Manasweeta Angane" userId="05da2731-9352-4b35-b713-60351f56afbd" providerId="ADAL" clId="{9F8E7246-803F-4AD4-AD02-5ADAFDA400F2}" dt="2021-05-22T21:07:14.045" v="3656" actId="1076"/>
          <ac:picMkLst>
            <pc:docMk/>
            <pc:sldMk cId="3145637976" sldId="268"/>
            <ac:picMk id="187" creationId="{2DE3345E-9A1E-4E63-99FE-3BC353969FAB}"/>
          </ac:picMkLst>
        </pc:picChg>
        <pc:picChg chg="mod topLvl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188" creationId="{95E420DB-3710-4013-B916-DAA9371A7764}"/>
          </ac:picMkLst>
        </pc:picChg>
        <pc:picChg chg="add mod ord topLvl">
          <ac:chgData name="Manasweeta Angane" userId="05da2731-9352-4b35-b713-60351f56afbd" providerId="ADAL" clId="{9F8E7246-803F-4AD4-AD02-5ADAFDA400F2}" dt="2021-05-22T22:21:55.301" v="4047" actId="1076"/>
          <ac:picMkLst>
            <pc:docMk/>
            <pc:sldMk cId="3145637976" sldId="268"/>
            <ac:picMk id="188" creationId="{9A2DDEF8-D47E-45A3-9518-4462925F77AC}"/>
          </ac:picMkLst>
        </pc:picChg>
        <pc:picChg chg="mod topLvl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189" creationId="{382412B6-F5B4-44D2-8870-DA3DBB57E02C}"/>
          </ac:picMkLst>
        </pc:picChg>
        <pc:picChg chg="add del mod">
          <ac:chgData name="Manasweeta Angane" userId="05da2731-9352-4b35-b713-60351f56afbd" providerId="ADAL" clId="{9F8E7246-803F-4AD4-AD02-5ADAFDA400F2}" dt="2021-05-23T00:17:27.931" v="4659" actId="478"/>
          <ac:picMkLst>
            <pc:docMk/>
            <pc:sldMk cId="3145637976" sldId="268"/>
            <ac:picMk id="189" creationId="{546A446B-ED0A-4D42-B9A6-261739F815B6}"/>
          </ac:picMkLst>
        </pc:picChg>
        <pc:picChg chg="add del mod">
          <ac:chgData name="Manasweeta Angane" userId="05da2731-9352-4b35-b713-60351f56afbd" providerId="ADAL" clId="{9F8E7246-803F-4AD4-AD02-5ADAFDA400F2}" dt="2021-05-22T22:46:33.617" v="4475" actId="478"/>
          <ac:picMkLst>
            <pc:docMk/>
            <pc:sldMk cId="3145637976" sldId="268"/>
            <ac:picMk id="189" creationId="{A369AFDD-EE42-4A18-ABC8-0352D5469F45}"/>
          </ac:picMkLst>
        </pc:picChg>
        <pc:picChg chg="add del mod topLvl">
          <ac:chgData name="Manasweeta Angane" userId="05da2731-9352-4b35-b713-60351f56afbd" providerId="ADAL" clId="{9F8E7246-803F-4AD4-AD02-5ADAFDA400F2}" dt="2021-05-22T22:54:05.122" v="4567" actId="29295"/>
          <ac:picMkLst>
            <pc:docMk/>
            <pc:sldMk cId="3145637976" sldId="268"/>
            <ac:picMk id="190" creationId="{C2248900-FCCB-4DE3-A82E-1CAD0BD99706}"/>
          </ac:picMkLst>
        </pc:picChg>
        <pc:picChg chg="mod topLvl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190" creationId="{CF0B88C8-8FD7-4B40-B04E-811B54238B6C}"/>
          </ac:picMkLst>
        </pc:picChg>
        <pc:picChg chg="add mod">
          <ac:chgData name="Manasweeta Angane" userId="05da2731-9352-4b35-b713-60351f56afbd" providerId="ADAL" clId="{9F8E7246-803F-4AD4-AD02-5ADAFDA400F2}" dt="2021-05-22T22:51:33.933" v="4513" actId="1076"/>
          <ac:picMkLst>
            <pc:docMk/>
            <pc:sldMk cId="3145637976" sldId="268"/>
            <ac:picMk id="191" creationId="{909BDCE2-9C76-432E-9397-5F94DF34026B}"/>
          </ac:picMkLst>
        </pc:picChg>
        <pc:picChg chg="del mod topLvl">
          <ac:chgData name="Manasweeta Angane" userId="05da2731-9352-4b35-b713-60351f56afbd" providerId="ADAL" clId="{9F8E7246-803F-4AD4-AD02-5ADAFDA400F2}" dt="2021-05-22T10:29:52.655" v="2286" actId="478"/>
          <ac:picMkLst>
            <pc:docMk/>
            <pc:sldMk cId="3145637976" sldId="268"/>
            <ac:picMk id="191" creationId="{F241C0A2-B4D4-418C-AA5F-07FC59A5270E}"/>
          </ac:picMkLst>
        </pc:picChg>
        <pc:picChg chg="del mod topLvl">
          <ac:chgData name="Manasweeta Angane" userId="05da2731-9352-4b35-b713-60351f56afbd" providerId="ADAL" clId="{9F8E7246-803F-4AD4-AD02-5ADAFDA400F2}" dt="2021-05-22T10:09:32.253" v="2236" actId="478"/>
          <ac:picMkLst>
            <pc:docMk/>
            <pc:sldMk cId="3145637976" sldId="268"/>
            <ac:picMk id="192" creationId="{46AC9047-22B3-4728-A55D-9EF6DB32F0DF}"/>
          </ac:picMkLst>
        </pc:picChg>
        <pc:picChg chg="add mod">
          <ac:chgData name="Manasweeta Angane" userId="05da2731-9352-4b35-b713-60351f56afbd" providerId="ADAL" clId="{9F8E7246-803F-4AD4-AD02-5ADAFDA400F2}" dt="2021-05-22T22:51:33.933" v="4513" actId="1076"/>
          <ac:picMkLst>
            <pc:docMk/>
            <pc:sldMk cId="3145637976" sldId="268"/>
            <ac:picMk id="192" creationId="{F4CA7FB6-2246-4690-B2BA-568B684BE88B}"/>
          </ac:picMkLst>
        </pc:picChg>
        <pc:picChg chg="add mod">
          <ac:chgData name="Manasweeta Angane" userId="05da2731-9352-4b35-b713-60351f56afbd" providerId="ADAL" clId="{9F8E7246-803F-4AD4-AD02-5ADAFDA400F2}" dt="2021-05-22T22:13:54.060" v="3931" actId="167"/>
          <ac:picMkLst>
            <pc:docMk/>
            <pc:sldMk cId="3145637976" sldId="268"/>
            <ac:picMk id="193" creationId="{63E276F9-9C63-459B-A18A-04E1E4F154AA}"/>
          </ac:picMkLst>
        </pc:picChg>
        <pc:picChg chg="del mod topLvl">
          <ac:chgData name="Manasweeta Angane" userId="05da2731-9352-4b35-b713-60351f56afbd" providerId="ADAL" clId="{9F8E7246-803F-4AD4-AD02-5ADAFDA400F2}" dt="2021-05-22T10:05:50.995" v="2059" actId="478"/>
          <ac:picMkLst>
            <pc:docMk/>
            <pc:sldMk cId="3145637976" sldId="268"/>
            <ac:picMk id="193" creationId="{A45688CA-F8AE-484D-8D81-2032818C8826}"/>
          </ac:picMkLst>
        </pc:picChg>
        <pc:picChg chg="mod ord topLvl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194" creationId="{58167A30-5613-4B53-BE78-54BB078E2A09}"/>
          </ac:picMkLst>
        </pc:picChg>
        <pc:picChg chg="add mod">
          <ac:chgData name="Manasweeta Angane" userId="05da2731-9352-4b35-b713-60351f56afbd" providerId="ADAL" clId="{9F8E7246-803F-4AD4-AD02-5ADAFDA400F2}" dt="2021-05-23T00:20:53.560" v="4694" actId="1076"/>
          <ac:picMkLst>
            <pc:docMk/>
            <pc:sldMk cId="3145637976" sldId="268"/>
            <ac:picMk id="194" creationId="{B9971A82-52E5-4A82-8477-3C09C1DB41F6}"/>
          </ac:picMkLst>
        </pc:picChg>
        <pc:picChg chg="add mod topLvl">
          <ac:chgData name="Manasweeta Angane" userId="05da2731-9352-4b35-b713-60351f56afbd" providerId="ADAL" clId="{9F8E7246-803F-4AD4-AD02-5ADAFDA400F2}" dt="2021-05-22T22:21:55.301" v="4047" actId="1076"/>
          <ac:picMkLst>
            <pc:docMk/>
            <pc:sldMk cId="3145637976" sldId="268"/>
            <ac:picMk id="195" creationId="{8EBCA554-E2F9-43B0-94DD-3327893FC6D7}"/>
          </ac:picMkLst>
        </pc:picChg>
        <pc:picChg chg="del mod topLvl">
          <ac:chgData name="Manasweeta Angane" userId="05da2731-9352-4b35-b713-60351f56afbd" providerId="ADAL" clId="{9F8E7246-803F-4AD4-AD02-5ADAFDA400F2}" dt="2021-05-22T09:59:15.466" v="1934" actId="478"/>
          <ac:picMkLst>
            <pc:docMk/>
            <pc:sldMk cId="3145637976" sldId="268"/>
            <ac:picMk id="195" creationId="{916DB434-2246-463F-BC1E-721F23457A30}"/>
          </ac:picMkLst>
        </pc:picChg>
        <pc:picChg chg="add mod ord">
          <ac:chgData name="Manasweeta Angane" userId="05da2731-9352-4b35-b713-60351f56afbd" providerId="ADAL" clId="{9F8E7246-803F-4AD4-AD02-5ADAFDA400F2}" dt="2021-05-23T00:17:42.590" v="4662" actId="167"/>
          <ac:picMkLst>
            <pc:docMk/>
            <pc:sldMk cId="3145637976" sldId="268"/>
            <ac:picMk id="196" creationId="{2DE3EBCE-4FD8-418E-B139-C26C93951337}"/>
          </ac:picMkLst>
        </pc:picChg>
        <pc:picChg chg="mod topLvl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196" creationId="{E3C2E6FC-5791-418D-83AB-5936D1508846}"/>
          </ac:picMkLst>
        </pc:picChg>
        <pc:picChg chg="mod topLvl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197" creationId="{BE904371-FFE6-4E30-BEA5-519A41653D34}"/>
          </ac:picMkLst>
        </pc:picChg>
        <pc:picChg chg="add mod topLvl">
          <ac:chgData name="Manasweeta Angane" userId="05da2731-9352-4b35-b713-60351f56afbd" providerId="ADAL" clId="{9F8E7246-803F-4AD4-AD02-5ADAFDA400F2}" dt="2021-05-22T22:53:11.575" v="4563" actId="164"/>
          <ac:picMkLst>
            <pc:docMk/>
            <pc:sldMk cId="3145637976" sldId="268"/>
            <ac:picMk id="197" creationId="{F2F9B689-5190-43D3-AC61-E77108204A8B}"/>
          </ac:picMkLst>
        </pc:picChg>
        <pc:picChg chg="del mod topLvl">
          <ac:chgData name="Manasweeta Angane" userId="05da2731-9352-4b35-b713-60351f56afbd" providerId="ADAL" clId="{9F8E7246-803F-4AD4-AD02-5ADAFDA400F2}" dt="2021-05-22T10:06:56.729" v="2092" actId="478"/>
          <ac:picMkLst>
            <pc:docMk/>
            <pc:sldMk cId="3145637976" sldId="268"/>
            <ac:picMk id="198" creationId="{001A8939-D14F-47D4-939F-322D6F4F4325}"/>
          </ac:picMkLst>
        </pc:picChg>
        <pc:picChg chg="add del mod">
          <ac:chgData name="Manasweeta Angane" userId="05da2731-9352-4b35-b713-60351f56afbd" providerId="ADAL" clId="{9F8E7246-803F-4AD4-AD02-5ADAFDA400F2}" dt="2021-05-22T22:11:48.277" v="3908"/>
          <ac:picMkLst>
            <pc:docMk/>
            <pc:sldMk cId="3145637976" sldId="268"/>
            <ac:picMk id="198" creationId="{C492D5BC-A5EF-4CC1-A39D-CA62C8DB22E9}"/>
          </ac:picMkLst>
        </pc:picChg>
        <pc:picChg chg="mod ord topLvl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199" creationId="{0C97FECA-DF1B-4076-B343-C2B53F320527}"/>
          </ac:picMkLst>
        </pc:picChg>
        <pc:picChg chg="add mod topLvl">
          <ac:chgData name="Manasweeta Angane" userId="05da2731-9352-4b35-b713-60351f56afbd" providerId="ADAL" clId="{9F8E7246-803F-4AD4-AD02-5ADAFDA400F2}" dt="2021-05-22T22:53:11.575" v="4563" actId="164"/>
          <ac:picMkLst>
            <pc:docMk/>
            <pc:sldMk cId="3145637976" sldId="268"/>
            <ac:picMk id="199" creationId="{54B6A258-4902-4CC4-BEBF-A78C719D6181}"/>
          </ac:picMkLst>
        </pc:picChg>
        <pc:picChg chg="mod topLvl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200" creationId="{99BC761D-7CF7-4393-9369-C8BFE42E516F}"/>
          </ac:picMkLst>
        </pc:picChg>
        <pc:picChg chg="add del mod topLvl">
          <ac:chgData name="Manasweeta Angane" userId="05da2731-9352-4b35-b713-60351f56afbd" providerId="ADAL" clId="{9F8E7246-803F-4AD4-AD02-5ADAFDA400F2}" dt="2021-05-22T22:14:53.123" v="3933" actId="478"/>
          <ac:picMkLst>
            <pc:docMk/>
            <pc:sldMk cId="3145637976" sldId="268"/>
            <ac:picMk id="200" creationId="{B4647B46-C961-4444-874C-0D87D2F91917}"/>
          </ac:picMkLst>
        </pc:picChg>
        <pc:picChg chg="del mod topLvl">
          <ac:chgData name="Manasweeta Angane" userId="05da2731-9352-4b35-b713-60351f56afbd" providerId="ADAL" clId="{9F8E7246-803F-4AD4-AD02-5ADAFDA400F2}" dt="2021-05-22T10:19:27.101" v="2253" actId="478"/>
          <ac:picMkLst>
            <pc:docMk/>
            <pc:sldMk cId="3145637976" sldId="268"/>
            <ac:picMk id="201" creationId="{4F019B95-E981-4612-8B0E-B373541ED02B}"/>
          </ac:picMkLst>
        </pc:picChg>
        <pc:picChg chg="mod topLvl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202" creationId="{7E3BAB2B-42E5-4552-BCE3-8E2BBA511B12}"/>
          </ac:picMkLst>
        </pc:picChg>
        <pc:picChg chg="add del mod">
          <ac:chgData name="Manasweeta Angane" userId="05da2731-9352-4b35-b713-60351f56afbd" providerId="ADAL" clId="{9F8E7246-803F-4AD4-AD02-5ADAFDA400F2}" dt="2021-05-22T22:42:28.786" v="4457" actId="478"/>
          <ac:picMkLst>
            <pc:docMk/>
            <pc:sldMk cId="3145637976" sldId="268"/>
            <ac:picMk id="202" creationId="{F17CDE71-C119-4734-818F-C237FE687B64}"/>
          </ac:picMkLst>
        </pc:picChg>
        <pc:picChg chg="add del mod">
          <ac:chgData name="Manasweeta Angane" userId="05da2731-9352-4b35-b713-60351f56afbd" providerId="ADAL" clId="{9F8E7246-803F-4AD4-AD02-5ADAFDA400F2}" dt="2021-05-22T22:41:22.332" v="4439" actId="478"/>
          <ac:picMkLst>
            <pc:docMk/>
            <pc:sldMk cId="3145637976" sldId="268"/>
            <ac:picMk id="203" creationId="{D010AD78-BE65-4C0E-AA34-8324372FB8EC}"/>
          </ac:picMkLst>
        </pc:picChg>
        <pc:picChg chg="add mod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203" creationId="{EBB2E020-5AA5-46A8-B04D-849B694E8331}"/>
          </ac:picMkLst>
        </pc:picChg>
        <pc:picChg chg="add mod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204" creationId="{7C4BDED0-D31C-4B95-B0D3-30799FE23AB4}"/>
          </ac:picMkLst>
        </pc:picChg>
        <pc:picChg chg="add del mod">
          <ac:chgData name="Manasweeta Angane" userId="05da2731-9352-4b35-b713-60351f56afbd" providerId="ADAL" clId="{9F8E7246-803F-4AD4-AD02-5ADAFDA400F2}" dt="2021-05-22T22:41:10.613" v="4437" actId="478"/>
          <ac:picMkLst>
            <pc:docMk/>
            <pc:sldMk cId="3145637976" sldId="268"/>
            <ac:picMk id="204" creationId="{F4A188D8-906E-4F2B-9440-FEF2E714AA38}"/>
          </ac:picMkLst>
        </pc:picChg>
        <pc:picChg chg="add del mod">
          <ac:chgData name="Manasweeta Angane" userId="05da2731-9352-4b35-b713-60351f56afbd" providerId="ADAL" clId="{9F8E7246-803F-4AD4-AD02-5ADAFDA400F2}" dt="2021-05-22T10:30:58.814" v="2296" actId="478"/>
          <ac:picMkLst>
            <pc:docMk/>
            <pc:sldMk cId="3145637976" sldId="268"/>
            <ac:picMk id="205" creationId="{BB3C0D42-0EDF-4A98-BEF3-1E3EA7461C1B}"/>
          </ac:picMkLst>
        </pc:picChg>
        <pc:picChg chg="add mod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207" creationId="{57B947A0-4435-491E-8731-C6F5AFFE1149}"/>
          </ac:picMkLst>
        </pc:picChg>
        <pc:picChg chg="add del mod">
          <ac:chgData name="Manasweeta Angane" userId="05da2731-9352-4b35-b713-60351f56afbd" providerId="ADAL" clId="{9F8E7246-803F-4AD4-AD02-5ADAFDA400F2}" dt="2021-05-22T22:35:02.916" v="4299" actId="478"/>
          <ac:picMkLst>
            <pc:docMk/>
            <pc:sldMk cId="3145637976" sldId="268"/>
            <ac:picMk id="207" creationId="{68ADBE5E-4833-456F-9458-44F7BC94B5E8}"/>
          </ac:picMkLst>
        </pc:picChg>
        <pc:picChg chg="add mod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208" creationId="{B0F1972E-1165-4BD7-BE2B-B7C6DA3C46FE}"/>
          </ac:picMkLst>
        </pc:picChg>
        <pc:picChg chg="mod">
          <ac:chgData name="Manasweeta Angane" userId="05da2731-9352-4b35-b713-60351f56afbd" providerId="ADAL" clId="{9F8E7246-803F-4AD4-AD02-5ADAFDA400F2}" dt="2021-05-23T00:19:32.447" v="4692" actId="1076"/>
          <ac:picMkLst>
            <pc:docMk/>
            <pc:sldMk cId="3145637976" sldId="268"/>
            <ac:picMk id="209" creationId="{16686D8D-9705-4439-AA6F-C31F1020661D}"/>
          </ac:picMkLst>
        </pc:picChg>
        <pc:picChg chg="add mod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209" creationId="{81E3DD54-3EC5-4869-9888-76627B852A7B}"/>
          </ac:picMkLst>
        </pc:picChg>
        <pc:picChg chg="add mod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210" creationId="{A2AEF2B9-B703-404B-8DDA-05A8F294B5B5}"/>
          </ac:picMkLst>
        </pc:picChg>
        <pc:picChg chg="mod">
          <ac:chgData name="Manasweeta Angane" userId="05da2731-9352-4b35-b713-60351f56afbd" providerId="ADAL" clId="{9F8E7246-803F-4AD4-AD02-5ADAFDA400F2}" dt="2021-05-23T00:19:32.447" v="4692" actId="1076"/>
          <ac:picMkLst>
            <pc:docMk/>
            <pc:sldMk cId="3145637976" sldId="268"/>
            <ac:picMk id="210" creationId="{EE6389CB-90F2-457E-A303-01CC0B1D9FBC}"/>
          </ac:picMkLst>
        </pc:picChg>
        <pc:picChg chg="add mod ord">
          <ac:chgData name="Manasweeta Angane" userId="05da2731-9352-4b35-b713-60351f56afbd" providerId="ADAL" clId="{9F8E7246-803F-4AD4-AD02-5ADAFDA400F2}" dt="2021-05-22T22:37:32.704" v="4414" actId="164"/>
          <ac:picMkLst>
            <pc:docMk/>
            <pc:sldMk cId="3145637976" sldId="268"/>
            <ac:picMk id="211" creationId="{42634B97-9CB3-4F70-82CF-142A6B43094C}"/>
          </ac:picMkLst>
        </pc:picChg>
        <pc:picChg chg="add mod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211" creationId="{47B98A21-C351-44CC-8F32-70BCF8EC8BD2}"/>
          </ac:picMkLst>
        </pc:picChg>
        <pc:picChg chg="add mod">
          <ac:chgData name="Manasweeta Angane" userId="05da2731-9352-4b35-b713-60351f56afbd" providerId="ADAL" clId="{9F8E7246-803F-4AD4-AD02-5ADAFDA400F2}" dt="2021-05-22T23:01:30.674" v="4604" actId="1076"/>
          <ac:picMkLst>
            <pc:docMk/>
            <pc:sldMk cId="3145637976" sldId="268"/>
            <ac:picMk id="212" creationId="{12749F58-3DD6-4A5C-99B1-FC003D364485}"/>
          </ac:picMkLst>
        </pc:picChg>
        <pc:picChg chg="add mod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212" creationId="{EDE9536E-8195-4C71-9B9B-8AA88FD8F5C7}"/>
          </ac:picMkLst>
        </pc:picChg>
        <pc:picChg chg="add del mod">
          <ac:chgData name="Manasweeta Angane" userId="05da2731-9352-4b35-b713-60351f56afbd" providerId="ADAL" clId="{9F8E7246-803F-4AD4-AD02-5ADAFDA400F2}" dt="2021-05-22T23:01:18.877" v="4601" actId="478"/>
          <ac:picMkLst>
            <pc:docMk/>
            <pc:sldMk cId="3145637976" sldId="268"/>
            <ac:picMk id="213" creationId="{50046756-1BA4-4A80-9FEE-7AFAF07AF1E7}"/>
          </ac:picMkLst>
        </pc:picChg>
        <pc:picChg chg="add mod">
          <ac:chgData name="Manasweeta Angane" userId="05da2731-9352-4b35-b713-60351f56afbd" providerId="ADAL" clId="{9F8E7246-803F-4AD4-AD02-5ADAFDA400F2}" dt="2021-05-22T10:58:53.452" v="2755" actId="164"/>
          <ac:picMkLst>
            <pc:docMk/>
            <pc:sldMk cId="3145637976" sldId="268"/>
            <ac:picMk id="213" creationId="{FDFD312D-3958-43B4-B057-9A1F1500C583}"/>
          </ac:picMkLst>
        </pc:picChg>
        <pc:picChg chg="add del mod">
          <ac:chgData name="Manasweeta Angane" userId="05da2731-9352-4b35-b713-60351f56afbd" providerId="ADAL" clId="{9F8E7246-803F-4AD4-AD02-5ADAFDA400F2}" dt="2021-05-22T10:33:07.528" v="2317" actId="21"/>
          <ac:picMkLst>
            <pc:docMk/>
            <pc:sldMk cId="3145637976" sldId="268"/>
            <ac:picMk id="214" creationId="{11E68676-1974-4C86-A962-390F73450E77}"/>
          </ac:picMkLst>
        </pc:picChg>
        <pc:picChg chg="add del mod topLvl">
          <ac:chgData name="Manasweeta Angane" userId="05da2731-9352-4b35-b713-60351f56afbd" providerId="ADAL" clId="{9F8E7246-803F-4AD4-AD02-5ADAFDA400F2}" dt="2021-05-22T22:49:34.848" v="4497" actId="478"/>
          <ac:picMkLst>
            <pc:docMk/>
            <pc:sldMk cId="3145637976" sldId="268"/>
            <ac:picMk id="214" creationId="{2430B3EE-A96F-44C1-8525-3EEB9B13ECAC}"/>
          </ac:picMkLst>
        </pc:picChg>
        <pc:picChg chg="add mod">
          <ac:chgData name="Manasweeta Angane" userId="05da2731-9352-4b35-b713-60351f56afbd" providerId="ADAL" clId="{9F8E7246-803F-4AD4-AD02-5ADAFDA400F2}" dt="2021-05-22T10:35:29.839" v="2384" actId="1076"/>
          <ac:picMkLst>
            <pc:docMk/>
            <pc:sldMk cId="3145637976" sldId="268"/>
            <ac:picMk id="215" creationId="{F71E4AF5-6110-4161-A357-F395FE1F404D}"/>
          </ac:picMkLst>
        </pc:picChg>
        <pc:picChg chg="add del mod">
          <ac:chgData name="Manasweeta Angane" userId="05da2731-9352-4b35-b713-60351f56afbd" providerId="ADAL" clId="{9F8E7246-803F-4AD4-AD02-5ADAFDA400F2}" dt="2021-05-22T22:48:24.321" v="4492" actId="478"/>
          <ac:picMkLst>
            <pc:docMk/>
            <pc:sldMk cId="3145637976" sldId="268"/>
            <ac:picMk id="216" creationId="{20807AD8-BC46-4CEE-AABB-2A18CD768215}"/>
          </ac:picMkLst>
        </pc:picChg>
        <pc:picChg chg="add del mod">
          <ac:chgData name="Manasweeta Angane" userId="05da2731-9352-4b35-b713-60351f56afbd" providerId="ADAL" clId="{9F8E7246-803F-4AD4-AD02-5ADAFDA400F2}" dt="2021-05-22T10:34:25.984" v="2328" actId="478"/>
          <ac:picMkLst>
            <pc:docMk/>
            <pc:sldMk cId="3145637976" sldId="268"/>
            <ac:picMk id="216" creationId="{2B895A92-FDC9-41F4-A599-201A58C220ED}"/>
          </ac:picMkLst>
        </pc:picChg>
        <pc:picChg chg="add mod">
          <ac:chgData name="Manasweeta Angane" userId="05da2731-9352-4b35-b713-60351f56afbd" providerId="ADAL" clId="{9F8E7246-803F-4AD4-AD02-5ADAFDA400F2}" dt="2021-05-22T10:35:29.839" v="2384" actId="1076"/>
          <ac:picMkLst>
            <pc:docMk/>
            <pc:sldMk cId="3145637976" sldId="268"/>
            <ac:picMk id="217" creationId="{30765596-B6C3-4BBB-81DB-FD877056E5CA}"/>
          </ac:picMkLst>
        </pc:picChg>
        <pc:picChg chg="add mod topLvl">
          <ac:chgData name="Manasweeta Angane" userId="05da2731-9352-4b35-b713-60351f56afbd" providerId="ADAL" clId="{9F8E7246-803F-4AD4-AD02-5ADAFDA400F2}" dt="2021-05-22T22:53:45.028" v="4566" actId="165"/>
          <ac:picMkLst>
            <pc:docMk/>
            <pc:sldMk cId="3145637976" sldId="268"/>
            <ac:picMk id="217" creationId="{F9DC3CEB-2580-4994-A6F8-C559A027C2FE}"/>
          </ac:picMkLst>
        </pc:picChg>
        <pc:picChg chg="mod">
          <ac:chgData name="Manasweeta Angane" userId="05da2731-9352-4b35-b713-60351f56afbd" providerId="ADAL" clId="{9F8E7246-803F-4AD4-AD02-5ADAFDA400F2}" dt="2021-05-22T10:35:54.231" v="2491" actId="1076"/>
          <ac:picMkLst>
            <pc:docMk/>
            <pc:sldMk cId="3145637976" sldId="268"/>
            <ac:picMk id="219" creationId="{F5E1D94F-53AB-4DC0-9869-20E119378417}"/>
          </ac:picMkLst>
        </pc:picChg>
        <pc:picChg chg="mod">
          <ac:chgData name="Manasweeta Angane" userId="05da2731-9352-4b35-b713-60351f56afbd" providerId="ADAL" clId="{9F8E7246-803F-4AD4-AD02-5ADAFDA400F2}" dt="2021-05-22T10:35:54.231" v="2491" actId="1076"/>
          <ac:picMkLst>
            <pc:docMk/>
            <pc:sldMk cId="3145637976" sldId="268"/>
            <ac:picMk id="220" creationId="{AD8511DD-1067-42E4-B26B-0208CCE67AEE}"/>
          </ac:picMkLst>
        </pc:picChg>
        <pc:picChg chg="add del mod">
          <ac:chgData name="Manasweeta Angane" userId="05da2731-9352-4b35-b713-60351f56afbd" providerId="ADAL" clId="{9F8E7246-803F-4AD4-AD02-5ADAFDA400F2}" dt="2021-05-22T23:03:06.410" v="4617" actId="478"/>
          <ac:picMkLst>
            <pc:docMk/>
            <pc:sldMk cId="3145637976" sldId="268"/>
            <ac:picMk id="220" creationId="{F93F0A3B-0BFE-4694-B12C-B37E492982DE}"/>
          </ac:picMkLst>
        </pc:picChg>
        <pc:picChg chg="add mod topLvl">
          <ac:chgData name="Manasweeta Angane" userId="05da2731-9352-4b35-b713-60351f56afbd" providerId="ADAL" clId="{9F8E7246-803F-4AD4-AD02-5ADAFDA400F2}" dt="2021-05-22T22:54:47.951" v="4571" actId="1076"/>
          <ac:picMkLst>
            <pc:docMk/>
            <pc:sldMk cId="3145637976" sldId="268"/>
            <ac:picMk id="221" creationId="{31A98ABF-9560-45E8-91D7-5A68C504CDDD}"/>
          </ac:picMkLst>
        </pc:picChg>
        <pc:picChg chg="add 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22" creationId="{BF1088EE-93EE-4C45-86BA-FFA26CFD1689}"/>
          </ac:picMkLst>
        </pc:picChg>
        <pc:picChg chg="add mod">
          <ac:chgData name="Manasweeta Angane" userId="05da2731-9352-4b35-b713-60351f56afbd" providerId="ADAL" clId="{9F8E7246-803F-4AD4-AD02-5ADAFDA400F2}" dt="2021-05-22T10:56:54.531" v="2743" actId="1076"/>
          <ac:picMkLst>
            <pc:docMk/>
            <pc:sldMk cId="3145637976" sldId="268"/>
            <ac:picMk id="223" creationId="{B0FAFCE0-8C4D-40AC-8F91-8F4B698A810C}"/>
          </ac:picMkLst>
        </pc:picChg>
        <pc:picChg chg="add mod topLvl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24" creationId="{7AB5EBDC-9044-471F-A464-EF5F9558CFAC}"/>
          </ac:picMkLst>
        </pc:picChg>
        <pc:picChg chg="add mod topLvl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25" creationId="{81619C0F-11DF-497F-A57A-BDC8B2DADB86}"/>
          </ac:picMkLst>
        </pc:picChg>
        <pc:picChg chg="add mod topLvl">
          <ac:chgData name="Manasweeta Angane" userId="05da2731-9352-4b35-b713-60351f56afbd" providerId="ADAL" clId="{9F8E7246-803F-4AD4-AD02-5ADAFDA400F2}" dt="2021-05-22T21:01:03.480" v="3609" actId="167"/>
          <ac:picMkLst>
            <pc:docMk/>
            <pc:sldMk cId="3145637976" sldId="268"/>
            <ac:picMk id="226" creationId="{90B5B416-A754-46FC-B7D8-F35B2E7B21E6}"/>
          </ac:picMkLst>
        </pc:picChg>
        <pc:picChg chg="add del mod topLvl">
          <ac:chgData name="Manasweeta Angane" userId="05da2731-9352-4b35-b713-60351f56afbd" providerId="ADAL" clId="{9F8E7246-803F-4AD4-AD02-5ADAFDA400F2}" dt="2021-05-22T22:18:11.325" v="3975" actId="478"/>
          <ac:picMkLst>
            <pc:docMk/>
            <pc:sldMk cId="3145637976" sldId="268"/>
            <ac:picMk id="227" creationId="{DD960CC1-57E5-4A0F-8636-D9B54C4B6B68}"/>
          </ac:picMkLst>
        </pc:picChg>
        <pc:picChg chg="add mod topLvl">
          <ac:chgData name="Manasweeta Angane" userId="05da2731-9352-4b35-b713-60351f56afbd" providerId="ADAL" clId="{9F8E7246-803F-4AD4-AD02-5ADAFDA400F2}" dt="2021-05-22T22:22:51.614" v="4049" actId="167"/>
          <ac:picMkLst>
            <pc:docMk/>
            <pc:sldMk cId="3145637976" sldId="268"/>
            <ac:picMk id="228" creationId="{E14D988B-DD49-40A1-AB86-6237733AB56D}"/>
          </ac:picMkLst>
        </pc:picChg>
        <pc:picChg chg="add 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29" creationId="{A359B232-0D23-4C6F-A78D-F2BD8F034F51}"/>
          </ac:picMkLst>
        </pc:picChg>
        <pc:picChg chg="add 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30" creationId="{C0309CA0-63B6-4E26-8498-86A8D1F9E27B}"/>
          </ac:picMkLst>
        </pc:picChg>
        <pc:picChg chg="mod topLvl">
          <ac:chgData name="Manasweeta Angane" userId="05da2731-9352-4b35-b713-60351f56afbd" providerId="ADAL" clId="{9F8E7246-803F-4AD4-AD02-5ADAFDA400F2}" dt="2021-05-22T11:03:57.496" v="3156" actId="165"/>
          <ac:picMkLst>
            <pc:docMk/>
            <pc:sldMk cId="3145637976" sldId="268"/>
            <ac:picMk id="234" creationId="{7514EF54-E505-4B02-B2E8-878A7FE465B5}"/>
          </ac:picMkLst>
        </pc:picChg>
        <pc:picChg chg="mod ord topLvl">
          <ac:chgData name="Manasweeta Angane" userId="05da2731-9352-4b35-b713-60351f56afbd" providerId="ADAL" clId="{9F8E7246-803F-4AD4-AD02-5ADAFDA400F2}" dt="2021-05-22T11:23:40.817" v="3249" actId="167"/>
          <ac:picMkLst>
            <pc:docMk/>
            <pc:sldMk cId="3145637976" sldId="268"/>
            <ac:picMk id="235" creationId="{E885F960-C465-40F5-B6B0-67697EDEF8D8}"/>
          </ac:picMkLst>
        </pc:picChg>
        <pc:picChg chg="mod topLvl">
          <ac:chgData name="Manasweeta Angane" userId="05da2731-9352-4b35-b713-60351f56afbd" providerId="ADAL" clId="{9F8E7246-803F-4AD4-AD02-5ADAFDA400F2}" dt="2021-05-23T00:18:50.544" v="4689" actId="1076"/>
          <ac:picMkLst>
            <pc:docMk/>
            <pc:sldMk cId="3145637976" sldId="268"/>
            <ac:picMk id="236" creationId="{6ED2C0A5-922E-44F9-983E-2A18E576C3B1}"/>
          </ac:picMkLst>
        </pc:picChg>
        <pc:picChg chg="mod ord topLvl">
          <ac:chgData name="Manasweeta Angane" userId="05da2731-9352-4b35-b713-60351f56afbd" providerId="ADAL" clId="{9F8E7246-803F-4AD4-AD02-5ADAFDA400F2}" dt="2021-05-22T23:06:39.053" v="4630" actId="167"/>
          <ac:picMkLst>
            <pc:docMk/>
            <pc:sldMk cId="3145637976" sldId="268"/>
            <ac:picMk id="237" creationId="{619E0113-5715-4A52-9EFA-B2E43A687B9F}"/>
          </ac:picMkLst>
        </pc:picChg>
        <pc:picChg chg="mod topLvl">
          <ac:chgData name="Manasweeta Angane" userId="05da2731-9352-4b35-b713-60351f56afbd" providerId="ADAL" clId="{9F8E7246-803F-4AD4-AD02-5ADAFDA400F2}" dt="2021-05-23T00:18:56.419" v="4690" actId="1076"/>
          <ac:picMkLst>
            <pc:docMk/>
            <pc:sldMk cId="3145637976" sldId="268"/>
            <ac:picMk id="238" creationId="{4931CE14-871B-4E42-B99B-BE18636A194D}"/>
          </ac:picMkLst>
        </pc:picChg>
        <pc:picChg chg="mod topLvl">
          <ac:chgData name="Manasweeta Angane" userId="05da2731-9352-4b35-b713-60351f56afbd" providerId="ADAL" clId="{9F8E7246-803F-4AD4-AD02-5ADAFDA400F2}" dt="2021-05-22T11:03:57.496" v="3156" actId="165"/>
          <ac:picMkLst>
            <pc:docMk/>
            <pc:sldMk cId="3145637976" sldId="268"/>
            <ac:picMk id="239" creationId="{F4735D94-4974-42AD-9A10-D2A1F9342A23}"/>
          </ac:picMkLst>
        </pc:picChg>
        <pc:picChg chg="mod ord topLvl">
          <ac:chgData name="Manasweeta Angane" userId="05da2731-9352-4b35-b713-60351f56afbd" providerId="ADAL" clId="{9F8E7246-803F-4AD4-AD02-5ADAFDA400F2}" dt="2021-05-22T11:05:27.598" v="3172" actId="166"/>
          <ac:picMkLst>
            <pc:docMk/>
            <pc:sldMk cId="3145637976" sldId="268"/>
            <ac:picMk id="240" creationId="{55D28B78-090F-4C58-92D2-181CED2659DF}"/>
          </ac:picMkLst>
        </pc:picChg>
        <pc:picChg chg="mod topLvl">
          <ac:chgData name="Manasweeta Angane" userId="05da2731-9352-4b35-b713-60351f56afbd" providerId="ADAL" clId="{9F8E7246-803F-4AD4-AD02-5ADAFDA400F2}" dt="2021-05-22T11:03:57.496" v="3156" actId="165"/>
          <ac:picMkLst>
            <pc:docMk/>
            <pc:sldMk cId="3145637976" sldId="268"/>
            <ac:picMk id="241" creationId="{8BE1D218-A849-4EC1-B3FF-0D35A53739DB}"/>
          </ac:picMkLst>
        </pc:picChg>
        <pc:picChg chg="mod ord topLvl">
          <ac:chgData name="Manasweeta Angane" userId="05da2731-9352-4b35-b713-60351f56afbd" providerId="ADAL" clId="{9F8E7246-803F-4AD4-AD02-5ADAFDA400F2}" dt="2021-05-22T11:23:52.640" v="3251" actId="167"/>
          <ac:picMkLst>
            <pc:docMk/>
            <pc:sldMk cId="3145637976" sldId="268"/>
            <ac:picMk id="242" creationId="{46145A29-98CB-4528-9614-B3F879A428F6}"/>
          </ac:picMkLst>
        </pc:picChg>
        <pc:picChg chg="mod topLvl">
          <ac:chgData name="Manasweeta Angane" userId="05da2731-9352-4b35-b713-60351f56afbd" providerId="ADAL" clId="{9F8E7246-803F-4AD4-AD02-5ADAFDA400F2}" dt="2021-05-22T11:03:57.496" v="3156" actId="165"/>
          <ac:picMkLst>
            <pc:docMk/>
            <pc:sldMk cId="3145637976" sldId="268"/>
            <ac:picMk id="243" creationId="{F8BF0B79-51A1-4624-9BE1-65BB95FA05DD}"/>
          </ac:picMkLst>
        </pc:picChg>
        <pc:picChg chg="mod topLvl">
          <ac:chgData name="Manasweeta Angane" userId="05da2731-9352-4b35-b713-60351f56afbd" providerId="ADAL" clId="{9F8E7246-803F-4AD4-AD02-5ADAFDA400F2}" dt="2021-05-22T11:03:57.496" v="3156" actId="165"/>
          <ac:picMkLst>
            <pc:docMk/>
            <pc:sldMk cId="3145637976" sldId="268"/>
            <ac:picMk id="244" creationId="{4D475953-91C0-417B-B710-B45AF3089BB9}"/>
          </ac:picMkLst>
        </pc:picChg>
        <pc:picChg chg="mod topLvl">
          <ac:chgData name="Manasweeta Angane" userId="05da2731-9352-4b35-b713-60351f56afbd" providerId="ADAL" clId="{9F8E7246-803F-4AD4-AD02-5ADAFDA400F2}" dt="2021-05-22T22:46:49.211" v="4477" actId="1076"/>
          <ac:picMkLst>
            <pc:docMk/>
            <pc:sldMk cId="3145637976" sldId="268"/>
            <ac:picMk id="245" creationId="{3232672C-7472-4AD6-9224-FD79276F159F}"/>
          </ac:picMkLst>
        </pc:picChg>
        <pc:picChg chg="mod topLvl">
          <ac:chgData name="Manasweeta Angane" userId="05da2731-9352-4b35-b713-60351f56afbd" providerId="ADAL" clId="{9F8E7246-803F-4AD4-AD02-5ADAFDA400F2}" dt="2021-05-22T23:06:56.428" v="4632"/>
          <ac:picMkLst>
            <pc:docMk/>
            <pc:sldMk cId="3145637976" sldId="268"/>
            <ac:picMk id="246" creationId="{DE1BC34D-8EE0-4376-B575-6508EE40E2AE}"/>
          </ac:picMkLst>
        </pc:picChg>
        <pc:picChg chg="del mod topLvl">
          <ac:chgData name="Manasweeta Angane" userId="05da2731-9352-4b35-b713-60351f56afbd" providerId="ADAL" clId="{9F8E7246-803F-4AD4-AD02-5ADAFDA400F2}" dt="2021-05-22T23:06:07.816" v="4626" actId="478"/>
          <ac:picMkLst>
            <pc:docMk/>
            <pc:sldMk cId="3145637976" sldId="268"/>
            <ac:picMk id="247" creationId="{0F36A592-9F7E-46C5-8D94-4F5C5D036F89}"/>
          </ac:picMkLst>
        </pc:picChg>
        <pc:picChg chg="mod topLvl">
          <ac:chgData name="Manasweeta Angane" userId="05da2731-9352-4b35-b713-60351f56afbd" providerId="ADAL" clId="{9F8E7246-803F-4AD4-AD02-5ADAFDA400F2}" dt="2021-05-22T11:03:57.496" v="3156" actId="165"/>
          <ac:picMkLst>
            <pc:docMk/>
            <pc:sldMk cId="3145637976" sldId="268"/>
            <ac:picMk id="248" creationId="{07FA9B60-9B6A-4CFA-9168-DA489C1FE954}"/>
          </ac:picMkLst>
        </pc:picChg>
        <pc:picChg chg="mod topLvl">
          <ac:chgData name="Manasweeta Angane" userId="05da2731-9352-4b35-b713-60351f56afbd" providerId="ADAL" clId="{9F8E7246-803F-4AD4-AD02-5ADAFDA400F2}" dt="2021-05-22T11:03:57.496" v="3156" actId="165"/>
          <ac:picMkLst>
            <pc:docMk/>
            <pc:sldMk cId="3145637976" sldId="268"/>
            <ac:picMk id="249" creationId="{CDB6468B-E253-46DA-8D83-5352AC33FA69}"/>
          </ac:picMkLst>
        </pc:picChg>
        <pc:picChg chg="mod topLvl">
          <ac:chgData name="Manasweeta Angane" userId="05da2731-9352-4b35-b713-60351f56afbd" providerId="ADAL" clId="{9F8E7246-803F-4AD4-AD02-5ADAFDA400F2}" dt="2021-05-22T22:46:23.992" v="4473" actId="1076"/>
          <ac:picMkLst>
            <pc:docMk/>
            <pc:sldMk cId="3145637976" sldId="268"/>
            <ac:picMk id="250" creationId="{505C7445-6CFB-40B9-9A9B-DF259A7C9A47}"/>
          </ac:picMkLst>
        </pc:picChg>
        <pc:picChg chg="mod topLvl">
          <ac:chgData name="Manasweeta Angane" userId="05da2731-9352-4b35-b713-60351f56afbd" providerId="ADAL" clId="{9F8E7246-803F-4AD4-AD02-5ADAFDA400F2}" dt="2021-05-22T22:54:10.294" v="4568" actId="29295"/>
          <ac:picMkLst>
            <pc:docMk/>
            <pc:sldMk cId="3145637976" sldId="268"/>
            <ac:picMk id="251" creationId="{8290E1F9-C71A-4553-90C7-975F8F67B7E2}"/>
          </ac:picMkLst>
        </pc:picChg>
        <pc:picChg chg="mod topLvl">
          <ac:chgData name="Manasweeta Angane" userId="05da2731-9352-4b35-b713-60351f56afbd" providerId="ADAL" clId="{9F8E7246-803F-4AD4-AD02-5ADAFDA400F2}" dt="2021-05-23T00:18:33.903" v="4681" actId="1076"/>
          <ac:picMkLst>
            <pc:docMk/>
            <pc:sldMk cId="3145637976" sldId="268"/>
            <ac:picMk id="252" creationId="{2F3976E9-5ECC-49D2-BBC5-FF30611D0C94}"/>
          </ac:picMkLst>
        </pc:picChg>
        <pc:picChg chg="mod topLvl">
          <ac:chgData name="Manasweeta Angane" userId="05da2731-9352-4b35-b713-60351f56afbd" providerId="ADAL" clId="{9F8E7246-803F-4AD4-AD02-5ADAFDA400F2}" dt="2021-05-23T00:18:10.903" v="4668" actId="1076"/>
          <ac:picMkLst>
            <pc:docMk/>
            <pc:sldMk cId="3145637976" sldId="268"/>
            <ac:picMk id="253" creationId="{0631E0FC-CD44-44A3-B4EB-9C3B4EF43B32}"/>
          </ac:picMkLst>
        </pc:picChg>
        <pc:picChg chg="mod topLvl">
          <ac:chgData name="Manasweeta Angane" userId="05da2731-9352-4b35-b713-60351f56afbd" providerId="ADAL" clId="{9F8E7246-803F-4AD4-AD02-5ADAFDA400F2}" dt="2021-05-22T22:51:33.933" v="4513" actId="1076"/>
          <ac:picMkLst>
            <pc:docMk/>
            <pc:sldMk cId="3145637976" sldId="268"/>
            <ac:picMk id="254" creationId="{7B355144-93D4-48A6-94BC-FAA4BD577547}"/>
          </ac:picMkLst>
        </pc:picChg>
        <pc:picChg chg="mod topLvl">
          <ac:chgData name="Manasweeta Angane" userId="05da2731-9352-4b35-b713-60351f56afbd" providerId="ADAL" clId="{9F8E7246-803F-4AD4-AD02-5ADAFDA400F2}" dt="2021-05-22T11:03:57.496" v="3156" actId="165"/>
          <ac:picMkLst>
            <pc:docMk/>
            <pc:sldMk cId="3145637976" sldId="268"/>
            <ac:picMk id="255" creationId="{78BFD560-0935-4892-A304-740D83F2A423}"/>
          </ac:picMkLst>
        </pc:picChg>
        <pc:picChg chg="mod">
          <ac:chgData name="Manasweeta Angane" userId="05da2731-9352-4b35-b713-60351f56afbd" providerId="ADAL" clId="{9F8E7246-803F-4AD4-AD02-5ADAFDA400F2}" dt="2021-05-22T11:03:57.496" v="3156" actId="165"/>
          <ac:picMkLst>
            <pc:docMk/>
            <pc:sldMk cId="3145637976" sldId="268"/>
            <ac:picMk id="258" creationId="{25871D25-63D1-455B-888A-EEB0376D2BC3}"/>
          </ac:picMkLst>
        </pc:picChg>
        <pc:picChg chg="mod">
          <ac:chgData name="Manasweeta Angane" userId="05da2731-9352-4b35-b713-60351f56afbd" providerId="ADAL" clId="{9F8E7246-803F-4AD4-AD02-5ADAFDA400F2}" dt="2021-05-22T11:03:57.496" v="3156" actId="165"/>
          <ac:picMkLst>
            <pc:docMk/>
            <pc:sldMk cId="3145637976" sldId="268"/>
            <ac:picMk id="259" creationId="{88FDFFCF-A357-4E5D-9D00-2E4BC1030746}"/>
          </ac:picMkLst>
        </pc:picChg>
        <pc:picChg chg="mod">
          <ac:chgData name="Manasweeta Angane" userId="05da2731-9352-4b35-b713-60351f56afbd" providerId="ADAL" clId="{9F8E7246-803F-4AD4-AD02-5ADAFDA400F2}" dt="2021-05-22T23:07:27.256" v="4635" actId="1076"/>
          <ac:picMkLst>
            <pc:docMk/>
            <pc:sldMk cId="3145637976" sldId="268"/>
            <ac:picMk id="260" creationId="{943A5EAF-22AC-4658-A060-095C65E2C8E8}"/>
          </ac:picMkLst>
        </pc:picChg>
        <pc:picChg chg="mod">
          <ac:chgData name="Manasweeta Angane" userId="05da2731-9352-4b35-b713-60351f56afbd" providerId="ADAL" clId="{9F8E7246-803F-4AD4-AD02-5ADAFDA400F2}" dt="2021-05-22T23:07:27.256" v="4635" actId="1076"/>
          <ac:picMkLst>
            <pc:docMk/>
            <pc:sldMk cId="3145637976" sldId="268"/>
            <ac:picMk id="261" creationId="{F74193E3-88CE-46F3-AAF3-6E70108857E9}"/>
          </ac:picMkLst>
        </pc:picChg>
        <pc:picChg chg="add 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62" creationId="{7D6A6D59-2E76-4FAA-88FC-4F5CE5F6FB07}"/>
          </ac:picMkLst>
        </pc:picChg>
        <pc:picChg chg="add 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63" creationId="{04D7A89E-8A74-421C-9D58-F4358F24CD89}"/>
          </ac:picMkLst>
        </pc:picChg>
        <pc:picChg chg="add del mod">
          <ac:chgData name="Manasweeta Angane" userId="05da2731-9352-4b35-b713-60351f56afbd" providerId="ADAL" clId="{9F8E7246-803F-4AD4-AD02-5ADAFDA400F2}" dt="2021-05-22T11:25:30.838" v="3357" actId="478"/>
          <ac:picMkLst>
            <pc:docMk/>
            <pc:sldMk cId="3145637976" sldId="268"/>
            <ac:picMk id="264" creationId="{B90EDADF-37B8-46F1-A3CF-30AB82F6AB62}"/>
          </ac:picMkLst>
        </pc:picChg>
        <pc:picChg chg="add 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65" creationId="{A1A26873-88DF-45A8-A0CC-689EABC54E8E}"/>
          </ac:picMkLst>
        </pc:picChg>
        <pc:picChg chg="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67" creationId="{E85C2ED9-54F2-438F-9858-2B12ECCBC61D}"/>
          </ac:picMkLst>
        </pc:picChg>
        <pc:picChg chg="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68" creationId="{C5AD5D19-DF13-44E4-AA51-1AAC8773A374}"/>
          </ac:picMkLst>
        </pc:picChg>
        <pc:picChg chg="add del mod">
          <ac:chgData name="Manasweeta Angane" userId="05da2731-9352-4b35-b713-60351f56afbd" providerId="ADAL" clId="{9F8E7246-803F-4AD4-AD02-5ADAFDA400F2}" dt="2021-05-22T11:24:28.359" v="3340" actId="478"/>
          <ac:picMkLst>
            <pc:docMk/>
            <pc:sldMk cId="3145637976" sldId="268"/>
            <ac:picMk id="269" creationId="{1C26141B-E5CA-479D-A17F-FBF1A9F8ACEC}"/>
          </ac:picMkLst>
        </pc:picChg>
        <pc:picChg chg="add del mod">
          <ac:chgData name="Manasweeta Angane" userId="05da2731-9352-4b35-b713-60351f56afbd" providerId="ADAL" clId="{9F8E7246-803F-4AD4-AD02-5ADAFDA400F2}" dt="2021-05-23T00:15:23.828" v="4648" actId="478"/>
          <ac:picMkLst>
            <pc:docMk/>
            <pc:sldMk cId="3145637976" sldId="268"/>
            <ac:picMk id="269" creationId="{F5386E27-8342-4220-9456-9E5920D5CE44}"/>
          </ac:picMkLst>
        </pc:picChg>
        <pc:picChg chg="add del mod">
          <ac:chgData name="Manasweeta Angane" userId="05da2731-9352-4b35-b713-60351f56afbd" providerId="ADAL" clId="{9F8E7246-803F-4AD4-AD02-5ADAFDA400F2}" dt="2021-05-22T11:24:28.359" v="3340" actId="478"/>
          <ac:picMkLst>
            <pc:docMk/>
            <pc:sldMk cId="3145637976" sldId="268"/>
            <ac:picMk id="270" creationId="{2B3072E4-B302-4894-A4B4-9A065828FA7A}"/>
          </ac:picMkLst>
        </pc:picChg>
        <pc:picChg chg="add mod">
          <ac:chgData name="Manasweeta Angane" userId="05da2731-9352-4b35-b713-60351f56afbd" providerId="ADAL" clId="{9F8E7246-803F-4AD4-AD02-5ADAFDA400F2}" dt="2021-05-22T23:02:46.941" v="4616" actId="1076"/>
          <ac:picMkLst>
            <pc:docMk/>
            <pc:sldMk cId="3145637976" sldId="268"/>
            <ac:picMk id="270" creationId="{973936B9-0109-4590-924D-C4CDC29D6492}"/>
          </ac:picMkLst>
        </pc:picChg>
        <pc:picChg chg="add mod">
          <ac:chgData name="Manasweeta Angane" userId="05da2731-9352-4b35-b713-60351f56afbd" providerId="ADAL" clId="{9F8E7246-803F-4AD4-AD02-5ADAFDA400F2}" dt="2021-05-22T22:34:44.593" v="4168" actId="1076"/>
          <ac:picMkLst>
            <pc:docMk/>
            <pc:sldMk cId="3145637976" sldId="268"/>
            <ac:picMk id="271" creationId="{ECF28697-050D-4095-9DF5-29843C60E17B}"/>
          </ac:picMkLst>
        </pc:picChg>
        <pc:picChg chg="add mod">
          <ac:chgData name="Manasweeta Angane" userId="05da2731-9352-4b35-b713-60351f56afbd" providerId="ADAL" clId="{9F8E7246-803F-4AD4-AD02-5ADAFDA400F2}" dt="2021-05-22T22:34:44.593" v="4168" actId="1076"/>
          <ac:picMkLst>
            <pc:docMk/>
            <pc:sldMk cId="3145637976" sldId="268"/>
            <ac:picMk id="272" creationId="{545B610B-B3C8-4CCA-AD5C-3C535B8FDFC6}"/>
          </ac:picMkLst>
        </pc:picChg>
        <pc:picChg chg="add 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73" creationId="{D6340B7F-1D4E-4C1E-979A-0C916198FD84}"/>
          </ac:picMkLst>
        </pc:picChg>
        <pc:picChg chg="add 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74" creationId="{CC4B4AF3-240E-4F84-BD0B-77503E5E0E99}"/>
          </ac:picMkLst>
        </pc:picChg>
        <pc:picChg chg="add mod topLvl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75" creationId="{FE08B307-244F-44B3-BF15-991EC0B3D278}"/>
          </ac:picMkLst>
        </pc:picChg>
        <pc:picChg chg="add 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76" creationId="{D822BAC7-C329-4CA8-8AA6-E0DF9312B58E}"/>
          </ac:picMkLst>
        </pc:picChg>
        <pc:picChg chg="add mod">
          <ac:chgData name="Manasweeta Angane" userId="05da2731-9352-4b35-b713-60351f56afbd" providerId="ADAL" clId="{9F8E7246-803F-4AD4-AD02-5ADAFDA400F2}" dt="2021-05-22T23:04:03.848" v="4622" actId="164"/>
          <ac:picMkLst>
            <pc:docMk/>
            <pc:sldMk cId="3145637976" sldId="268"/>
            <ac:picMk id="277" creationId="{BF3CC4A0-C15E-4A16-9B71-9310A2E1D6E0}"/>
          </ac:picMkLst>
        </pc:picChg>
        <pc:picChg chg="add del mod">
          <ac:chgData name="Manasweeta Angane" userId="05da2731-9352-4b35-b713-60351f56afbd" providerId="ADAL" clId="{9F8E7246-803F-4AD4-AD02-5ADAFDA400F2}" dt="2021-05-22T11:28:32.214" v="3393" actId="478"/>
          <ac:picMkLst>
            <pc:docMk/>
            <pc:sldMk cId="3145637976" sldId="268"/>
            <ac:picMk id="277" creationId="{EA8A9463-5BED-4862-8650-D3E1504D0E98}"/>
          </ac:picMkLst>
        </pc:picChg>
        <pc:picChg chg="add 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78" creationId="{5BCAFCAC-D31D-428B-9190-7083D9648037}"/>
          </ac:picMkLst>
        </pc:picChg>
        <pc:picChg chg="add 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79" creationId="{5C82B6CA-4DF9-4893-86AA-EB687472FB82}"/>
          </ac:picMkLst>
        </pc:picChg>
        <pc:picChg chg="add 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80" creationId="{CB4BEAFB-1E45-4E7E-B521-EAFC4F3D5683}"/>
          </ac:picMkLst>
        </pc:picChg>
        <pc:picChg chg="add mod topLvl">
          <ac:chgData name="Manasweeta Angane" userId="05da2731-9352-4b35-b713-60351f56afbd" providerId="ADAL" clId="{9F8E7246-803F-4AD4-AD02-5ADAFDA400F2}" dt="2021-05-22T22:55:32.686" v="4575"/>
          <ac:picMkLst>
            <pc:docMk/>
            <pc:sldMk cId="3145637976" sldId="268"/>
            <ac:picMk id="281" creationId="{8E085FDD-E6E4-4B1E-919E-16B1C439F51A}"/>
          </ac:picMkLst>
        </pc:picChg>
        <pc:picChg chg="add mod topLvl">
          <ac:chgData name="Manasweeta Angane" userId="05da2731-9352-4b35-b713-60351f56afbd" providerId="ADAL" clId="{9F8E7246-803F-4AD4-AD02-5ADAFDA400F2}" dt="2021-05-22T22:55:26.467" v="4574"/>
          <ac:picMkLst>
            <pc:docMk/>
            <pc:sldMk cId="3145637976" sldId="268"/>
            <ac:picMk id="282" creationId="{840D2313-2C60-4D11-979A-51691A1DACB8}"/>
          </ac:picMkLst>
        </pc:picChg>
        <pc:picChg chg="add mod topLvl">
          <ac:chgData name="Manasweeta Angane" userId="05da2731-9352-4b35-b713-60351f56afbd" providerId="ADAL" clId="{9F8E7246-803F-4AD4-AD02-5ADAFDA400F2}" dt="2021-05-22T22:55:16.623" v="4573" actId="165"/>
          <ac:picMkLst>
            <pc:docMk/>
            <pc:sldMk cId="3145637976" sldId="268"/>
            <ac:picMk id="283" creationId="{D3BB7085-F3A0-4BB6-BAD9-C2F67AE51B20}"/>
          </ac:picMkLst>
        </pc:picChg>
        <pc:picChg chg="add mod topLvl">
          <ac:chgData name="Manasweeta Angane" userId="05da2731-9352-4b35-b713-60351f56afbd" providerId="ADAL" clId="{9F8E7246-803F-4AD4-AD02-5ADAFDA400F2}" dt="2021-05-22T21:16:52.562" v="3663" actId="164"/>
          <ac:picMkLst>
            <pc:docMk/>
            <pc:sldMk cId="3145637976" sldId="268"/>
            <ac:picMk id="284" creationId="{D2F295A0-AD69-4A04-A8CE-64D4835DA202}"/>
          </ac:picMkLst>
        </pc:picChg>
        <pc:picChg chg="add mod topLvl">
          <ac:chgData name="Manasweeta Angane" userId="05da2731-9352-4b35-b713-60351f56afbd" providerId="ADAL" clId="{9F8E7246-803F-4AD4-AD02-5ADAFDA400F2}" dt="2021-05-22T21:16:52.562" v="3663" actId="164"/>
          <ac:picMkLst>
            <pc:docMk/>
            <pc:sldMk cId="3145637976" sldId="268"/>
            <ac:picMk id="285" creationId="{BA1D07B4-733B-4911-AEF9-D5EE8A9CFB3C}"/>
          </ac:picMkLst>
        </pc:picChg>
        <pc:picChg chg="add mod topLvl">
          <ac:chgData name="Manasweeta Angane" userId="05da2731-9352-4b35-b713-60351f56afbd" providerId="ADAL" clId="{9F8E7246-803F-4AD4-AD02-5ADAFDA400F2}" dt="2021-05-22T21:16:52.562" v="3663" actId="164"/>
          <ac:picMkLst>
            <pc:docMk/>
            <pc:sldMk cId="3145637976" sldId="268"/>
            <ac:picMk id="286" creationId="{23B29AA8-C6C1-41FB-8519-6C4218177209}"/>
          </ac:picMkLst>
        </pc:picChg>
        <pc:picChg chg="add mod topLvl">
          <ac:chgData name="Manasweeta Angane" userId="05da2731-9352-4b35-b713-60351f56afbd" providerId="ADAL" clId="{9F8E7246-803F-4AD4-AD02-5ADAFDA400F2}" dt="2021-05-22T21:16:52.562" v="3663" actId="164"/>
          <ac:picMkLst>
            <pc:docMk/>
            <pc:sldMk cId="3145637976" sldId="268"/>
            <ac:picMk id="287" creationId="{133B6AE4-A70D-4AD5-9273-5BEE5C00032F}"/>
          </ac:picMkLst>
        </pc:picChg>
        <pc:picChg chg="add 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88" creationId="{93FB0006-E53A-4308-ADAC-A569DCC53EC4}"/>
          </ac:picMkLst>
        </pc:picChg>
        <pc:picChg chg="add mod topLvl">
          <ac:chgData name="Manasweeta Angane" userId="05da2731-9352-4b35-b713-60351f56afbd" providerId="ADAL" clId="{9F8E7246-803F-4AD4-AD02-5ADAFDA400F2}" dt="2021-05-22T21:01:43.387" v="3615" actId="167"/>
          <ac:picMkLst>
            <pc:docMk/>
            <pc:sldMk cId="3145637976" sldId="268"/>
            <ac:picMk id="289" creationId="{D7881C87-87DF-47C3-8AFA-CF3F121E72D7}"/>
          </ac:picMkLst>
        </pc:picChg>
        <pc:picChg chg="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91" creationId="{7B81DAB5-88C6-4220-AFE8-FC695EB6FA6E}"/>
          </ac:picMkLst>
        </pc:picChg>
        <pc:picChg chg="mod">
          <ac:chgData name="Manasweeta Angane" userId="05da2731-9352-4b35-b713-60351f56afbd" providerId="ADAL" clId="{9F8E7246-803F-4AD4-AD02-5ADAFDA400F2}" dt="2021-05-22T21:00:45.684" v="3607" actId="165"/>
          <ac:picMkLst>
            <pc:docMk/>
            <pc:sldMk cId="3145637976" sldId="268"/>
            <ac:picMk id="292" creationId="{371822F2-48C4-4484-A7AF-4B05732C63D1}"/>
          </ac:picMkLst>
        </pc:picChg>
        <pc:picChg chg="add del mod">
          <ac:chgData name="Manasweeta Angane" userId="05da2731-9352-4b35-b713-60351f56afbd" providerId="ADAL" clId="{9F8E7246-803F-4AD4-AD02-5ADAFDA400F2}" dt="2021-05-22T23:04:03.848" v="4622" actId="164"/>
          <ac:picMkLst>
            <pc:docMk/>
            <pc:sldMk cId="3145637976" sldId="268"/>
            <ac:picMk id="293" creationId="{FE98DEC7-0B8E-4668-9587-17129F9865C5}"/>
          </ac:picMkLst>
        </pc:picChg>
        <pc:picChg chg="add mod ord">
          <ac:chgData name="Manasweeta Angane" userId="05da2731-9352-4b35-b713-60351f56afbd" providerId="ADAL" clId="{9F8E7246-803F-4AD4-AD02-5ADAFDA400F2}" dt="2021-05-22T23:07:14.022" v="4634" actId="14100"/>
          <ac:picMkLst>
            <pc:docMk/>
            <pc:sldMk cId="3145637976" sldId="268"/>
            <ac:picMk id="294" creationId="{8AEE1CFA-1D64-4B8B-B9F6-62F63B5FE641}"/>
          </ac:picMkLst>
        </pc:picChg>
      </pc:sldChg>
      <pc:sldChg chg="addSp delSp modSp">
        <pc:chgData name="Manasweeta Angane" userId="05da2731-9352-4b35-b713-60351f56afbd" providerId="ADAL" clId="{9F8E7246-803F-4AD4-AD02-5ADAFDA400F2}" dt="2021-05-22T10:45:46.305" v="2534" actId="21"/>
        <pc:sldMkLst>
          <pc:docMk/>
          <pc:sldMk cId="1930498660" sldId="269"/>
        </pc:sldMkLst>
        <pc:picChg chg="add del mod">
          <ac:chgData name="Manasweeta Angane" userId="05da2731-9352-4b35-b713-60351f56afbd" providerId="ADAL" clId="{9F8E7246-803F-4AD4-AD02-5ADAFDA400F2}" dt="2021-05-22T10:45:46.305" v="2534" actId="21"/>
          <ac:picMkLst>
            <pc:docMk/>
            <pc:sldMk cId="1930498660" sldId="269"/>
            <ac:picMk id="18" creationId="{F983E446-1923-4E4F-9303-524E39D9641F}"/>
          </ac:picMkLst>
        </pc:picChg>
        <pc:picChg chg="mod">
          <ac:chgData name="Manasweeta Angane" userId="05da2731-9352-4b35-b713-60351f56afbd" providerId="ADAL" clId="{9F8E7246-803F-4AD4-AD02-5ADAFDA400F2}" dt="2021-05-22T09:36:15.117" v="1248" actId="1076"/>
          <ac:picMkLst>
            <pc:docMk/>
            <pc:sldMk cId="1930498660" sldId="269"/>
            <ac:picMk id="1030" creationId="{930D383E-B4E8-4A31-BFF7-771761F0FC2D}"/>
          </ac:picMkLst>
        </pc:picChg>
      </pc:sldChg>
      <pc:sldChg chg="addSp modSp add">
        <pc:chgData name="Manasweeta Angane" userId="05da2731-9352-4b35-b713-60351f56afbd" providerId="ADAL" clId="{9F8E7246-803F-4AD4-AD02-5ADAFDA400F2}" dt="2021-05-22T11:08:30.868" v="3178" actId="1076"/>
        <pc:sldMkLst>
          <pc:docMk/>
          <pc:sldMk cId="2362421498" sldId="275"/>
        </pc:sldMkLst>
        <pc:picChg chg="add mod">
          <ac:chgData name="Manasweeta Angane" userId="05da2731-9352-4b35-b713-60351f56afbd" providerId="ADAL" clId="{9F8E7246-803F-4AD4-AD02-5ADAFDA400F2}" dt="2021-05-22T11:08:30.868" v="3178" actId="1076"/>
          <ac:picMkLst>
            <pc:docMk/>
            <pc:sldMk cId="2362421498" sldId="275"/>
            <ac:picMk id="128" creationId="{44E2A13F-BD36-47CD-9DD8-5E06D51B6839}"/>
          </ac:picMkLst>
        </pc:picChg>
      </pc:sldChg>
    </pc:docChg>
  </pc:docChgLst>
  <pc:docChgLst>
    <pc:chgData name="Manasweeta Angane" userId="05da2731-9352-4b35-b713-60351f56afbd" providerId="ADAL" clId="{121B3E88-C8E7-4600-B4A4-3E65BB803D64}"/>
    <pc:docChg chg="undo redo custSel addSld modSld">
      <pc:chgData name="Manasweeta Angane" userId="05da2731-9352-4b35-b713-60351f56afbd" providerId="ADAL" clId="{121B3E88-C8E7-4600-B4A4-3E65BB803D64}" dt="2021-07-02T09:18:46.445" v="2455"/>
      <pc:docMkLst>
        <pc:docMk/>
      </pc:docMkLst>
      <pc:sldChg chg="addSp delSp modSp mod">
        <pc:chgData name="Manasweeta Angane" userId="05da2731-9352-4b35-b713-60351f56afbd" providerId="ADAL" clId="{121B3E88-C8E7-4600-B4A4-3E65BB803D64}" dt="2021-07-01T08:38:37.658" v="894"/>
        <pc:sldMkLst>
          <pc:docMk/>
          <pc:sldMk cId="2942563435" sldId="269"/>
        </pc:sldMkLst>
        <pc:picChg chg="add mod modCrop">
          <ac:chgData name="Manasweeta Angane" userId="05da2731-9352-4b35-b713-60351f56afbd" providerId="ADAL" clId="{121B3E88-C8E7-4600-B4A4-3E65BB803D64}" dt="2021-07-01T08:16:06.304" v="578" actId="732"/>
          <ac:picMkLst>
            <pc:docMk/>
            <pc:sldMk cId="2942563435" sldId="269"/>
            <ac:picMk id="2" creationId="{EE50FD0A-DAFD-42F7-AFFB-C0C9B49C08DE}"/>
          </ac:picMkLst>
        </pc:picChg>
        <pc:picChg chg="add mod">
          <ac:chgData name="Manasweeta Angane" userId="05da2731-9352-4b35-b713-60351f56afbd" providerId="ADAL" clId="{121B3E88-C8E7-4600-B4A4-3E65BB803D64}" dt="2021-07-01T08:15:31.520" v="572"/>
          <ac:picMkLst>
            <pc:docMk/>
            <pc:sldMk cId="2942563435" sldId="269"/>
            <ac:picMk id="3" creationId="{510FBE95-2CDD-4E1B-951A-DFA3ED6C0FD1}"/>
          </ac:picMkLst>
        </pc:picChg>
        <pc:picChg chg="add del">
          <ac:chgData name="Manasweeta Angane" userId="05da2731-9352-4b35-b713-60351f56afbd" providerId="ADAL" clId="{121B3E88-C8E7-4600-B4A4-3E65BB803D64}" dt="2021-07-01T08:34:38.931" v="722" actId="478"/>
          <ac:picMkLst>
            <pc:docMk/>
            <pc:sldMk cId="2942563435" sldId="269"/>
            <ac:picMk id="4" creationId="{4B650E6C-E34A-46B4-9D70-E8A7A2CC0C0C}"/>
          </ac:picMkLst>
        </pc:picChg>
        <pc:picChg chg="add mod modCrop">
          <ac:chgData name="Manasweeta Angane" userId="05da2731-9352-4b35-b713-60351f56afbd" providerId="ADAL" clId="{121B3E88-C8E7-4600-B4A4-3E65BB803D64}" dt="2021-07-01T08:37:22.572" v="800" actId="732"/>
          <ac:picMkLst>
            <pc:docMk/>
            <pc:sldMk cId="2942563435" sldId="269"/>
            <ac:picMk id="5" creationId="{116E5255-09DC-44EA-8C2C-BD33D8BAF1DF}"/>
          </ac:picMkLst>
        </pc:picChg>
        <pc:picChg chg="add del mod">
          <ac:chgData name="Manasweeta Angane" userId="05da2731-9352-4b35-b713-60351f56afbd" providerId="ADAL" clId="{121B3E88-C8E7-4600-B4A4-3E65BB803D64}" dt="2021-07-01T08:38:37.658" v="894"/>
          <ac:picMkLst>
            <pc:docMk/>
            <pc:sldMk cId="2942563435" sldId="269"/>
            <ac:picMk id="6" creationId="{C44C5632-DA80-4823-A5E7-95C195CC7494}"/>
          </ac:picMkLst>
        </pc:picChg>
      </pc:sldChg>
      <pc:sldChg chg="addSp delSp modSp add mod">
        <pc:chgData name="Manasweeta Angane" userId="05da2731-9352-4b35-b713-60351f56afbd" providerId="ADAL" clId="{121B3E88-C8E7-4600-B4A4-3E65BB803D64}" dt="2021-07-02T09:18:46.445" v="2455"/>
        <pc:sldMkLst>
          <pc:docMk/>
          <pc:sldMk cId="731297326" sldId="270"/>
        </pc:sldMkLst>
        <pc:spChg chg="ord">
          <ac:chgData name="Manasweeta Angane" userId="05da2731-9352-4b35-b713-60351f56afbd" providerId="ADAL" clId="{121B3E88-C8E7-4600-B4A4-3E65BB803D64}" dt="2021-07-01T08:09:24.641" v="561" actId="166"/>
          <ac:spMkLst>
            <pc:docMk/>
            <pc:sldMk cId="731297326" sldId="270"/>
            <ac:spMk id="3" creationId="{AE116250-06D3-4487-927B-6ABD4B0174E0}"/>
          </ac:spMkLst>
        </pc:spChg>
        <pc:spChg chg="mod ord">
          <ac:chgData name="Manasweeta Angane" userId="05da2731-9352-4b35-b713-60351f56afbd" providerId="ADAL" clId="{121B3E88-C8E7-4600-B4A4-3E65BB803D64}" dt="2021-07-02T03:49:56.294" v="2432" actId="1035"/>
          <ac:spMkLst>
            <pc:docMk/>
            <pc:sldMk cId="731297326" sldId="270"/>
            <ac:spMk id="8" creationId="{9578BF0C-3884-4FD5-9C26-852AC96763B9}"/>
          </ac:spMkLst>
        </pc:spChg>
        <pc:spChg chg="del ord">
          <ac:chgData name="Manasweeta Angane" userId="05da2731-9352-4b35-b713-60351f56afbd" providerId="ADAL" clId="{121B3E88-C8E7-4600-B4A4-3E65BB803D64}" dt="2021-07-01T08:29:55.765" v="603" actId="478"/>
          <ac:spMkLst>
            <pc:docMk/>
            <pc:sldMk cId="731297326" sldId="270"/>
            <ac:spMk id="113" creationId="{3B01C123-C096-40D9-ACDE-6BDAF936C1F5}"/>
          </ac:spMkLst>
        </pc:spChg>
        <pc:spChg chg="del ord">
          <ac:chgData name="Manasweeta Angane" userId="05da2731-9352-4b35-b713-60351f56afbd" providerId="ADAL" clId="{121B3E88-C8E7-4600-B4A4-3E65BB803D64}" dt="2021-07-01T08:29:58.984" v="604" actId="478"/>
          <ac:spMkLst>
            <pc:docMk/>
            <pc:sldMk cId="731297326" sldId="270"/>
            <ac:spMk id="114" creationId="{EF234447-80A7-40F9-9DBD-254FE22BABF3}"/>
          </ac:spMkLst>
        </pc:spChg>
        <pc:spChg chg="mod">
          <ac:chgData name="Manasweeta Angane" userId="05da2731-9352-4b35-b713-60351f56afbd" providerId="ADAL" clId="{121B3E88-C8E7-4600-B4A4-3E65BB803D64}" dt="2021-07-01T07:55:14.715" v="52" actId="164"/>
          <ac:spMkLst>
            <pc:docMk/>
            <pc:sldMk cId="731297326" sldId="270"/>
            <ac:spMk id="206" creationId="{856263D8-599B-4A11-A3F3-815C0358F37C}"/>
          </ac:spMkLst>
        </pc:spChg>
        <pc:spChg chg="add del mod">
          <ac:chgData name="Manasweeta Angane" userId="05da2731-9352-4b35-b713-60351f56afbd" providerId="ADAL" clId="{121B3E88-C8E7-4600-B4A4-3E65BB803D64}" dt="2021-07-01T07:57:50.492" v="172" actId="478"/>
          <ac:spMkLst>
            <pc:docMk/>
            <pc:sldMk cId="731297326" sldId="270"/>
            <ac:spMk id="207" creationId="{F1F73930-023C-438A-A246-0C303A0EDA77}"/>
          </ac:spMkLst>
        </pc:spChg>
        <pc:spChg chg="del">
          <ac:chgData name="Manasweeta Angane" userId="05da2731-9352-4b35-b713-60351f56afbd" providerId="ADAL" clId="{121B3E88-C8E7-4600-B4A4-3E65BB803D64}" dt="2021-07-01T08:30:19.543" v="624" actId="478"/>
          <ac:spMkLst>
            <pc:docMk/>
            <pc:sldMk cId="731297326" sldId="270"/>
            <ac:spMk id="231" creationId="{091255D1-3CB3-4641-9A48-614240CC5035}"/>
          </ac:spMkLst>
        </pc:spChg>
        <pc:spChg chg="del">
          <ac:chgData name="Manasweeta Angane" userId="05da2731-9352-4b35-b713-60351f56afbd" providerId="ADAL" clId="{121B3E88-C8E7-4600-B4A4-3E65BB803D64}" dt="2021-07-01T08:06:11.444" v="428" actId="478"/>
          <ac:spMkLst>
            <pc:docMk/>
            <pc:sldMk cId="731297326" sldId="270"/>
            <ac:spMk id="232" creationId="{A1880B3E-1806-4D70-A6B2-45A405D66349}"/>
          </ac:spMkLst>
        </pc:spChg>
        <pc:spChg chg="del mod">
          <ac:chgData name="Manasweeta Angane" userId="05da2731-9352-4b35-b713-60351f56afbd" providerId="ADAL" clId="{121B3E88-C8E7-4600-B4A4-3E65BB803D64}" dt="2021-07-01T08:01:12.825" v="348" actId="478"/>
          <ac:spMkLst>
            <pc:docMk/>
            <pc:sldMk cId="731297326" sldId="270"/>
            <ac:spMk id="327" creationId="{013DC9F0-28E4-4EA5-9D10-A06F7128D65D}"/>
          </ac:spMkLst>
        </pc:spChg>
        <pc:spChg chg="add mod">
          <ac:chgData name="Manasweeta Angane" userId="05da2731-9352-4b35-b713-60351f56afbd" providerId="ADAL" clId="{121B3E88-C8E7-4600-B4A4-3E65BB803D64}" dt="2021-07-01T10:48:47.714" v="1972" actId="1037"/>
          <ac:spMkLst>
            <pc:docMk/>
            <pc:sldMk cId="731297326" sldId="270"/>
            <ac:spMk id="464" creationId="{AE7BC747-BB05-4618-82ED-600F6CECDA4B}"/>
          </ac:spMkLst>
        </pc:spChg>
        <pc:grpChg chg="mod topLvl">
          <ac:chgData name="Manasweeta Angane" userId="05da2731-9352-4b35-b713-60351f56afbd" providerId="ADAL" clId="{121B3E88-C8E7-4600-B4A4-3E65BB803D64}" dt="2021-07-01T08:48:34.627" v="953" actId="1076"/>
          <ac:grpSpMkLst>
            <pc:docMk/>
            <pc:sldMk cId="731297326" sldId="270"/>
            <ac:grpSpMk id="2" creationId="{CDDECE0C-A6EE-4B64-B730-F15394E60E37}"/>
          </ac:grpSpMkLst>
        </pc:grpChg>
        <pc:grpChg chg="mod topLvl">
          <ac:chgData name="Manasweeta Angane" userId="05da2731-9352-4b35-b713-60351f56afbd" providerId="ADAL" clId="{121B3E88-C8E7-4600-B4A4-3E65BB803D64}" dt="2021-07-01T08:27:01.752" v="589" actId="478"/>
          <ac:grpSpMkLst>
            <pc:docMk/>
            <pc:sldMk cId="731297326" sldId="270"/>
            <ac:grpSpMk id="5" creationId="{76A86ECE-F864-4D73-8DD9-07C841466624}"/>
          </ac:grpSpMkLst>
        </pc:grpChg>
        <pc:grpChg chg="mod ord">
          <ac:chgData name="Manasweeta Angane" userId="05da2731-9352-4b35-b713-60351f56afbd" providerId="ADAL" clId="{121B3E88-C8E7-4600-B4A4-3E65BB803D64}" dt="2021-07-01T10:58:18.177" v="2041" actId="14100"/>
          <ac:grpSpMkLst>
            <pc:docMk/>
            <pc:sldMk cId="731297326" sldId="270"/>
            <ac:grpSpMk id="6" creationId="{75ECB785-9F03-47B9-9993-E033DA928C01}"/>
          </ac:grpSpMkLst>
        </pc:grpChg>
        <pc:grpChg chg="del mod topLvl">
          <ac:chgData name="Manasweeta Angane" userId="05da2731-9352-4b35-b713-60351f56afbd" providerId="ADAL" clId="{121B3E88-C8E7-4600-B4A4-3E65BB803D64}" dt="2021-07-02T04:00:57.176" v="2441" actId="165"/>
          <ac:grpSpMkLst>
            <pc:docMk/>
            <pc:sldMk cId="731297326" sldId="270"/>
            <ac:grpSpMk id="7" creationId="{E1C68698-1206-4D21-83CA-777640CE06F2}"/>
          </ac:grpSpMkLst>
        </pc:grpChg>
        <pc:grpChg chg="add mod">
          <ac:chgData name="Manasweeta Angane" userId="05da2731-9352-4b35-b713-60351f56afbd" providerId="ADAL" clId="{121B3E88-C8E7-4600-B4A4-3E65BB803D64}" dt="2021-07-02T04:00:39.484" v="2440" actId="164"/>
          <ac:grpSpMkLst>
            <pc:docMk/>
            <pc:sldMk cId="731297326" sldId="270"/>
            <ac:grpSpMk id="9" creationId="{7694C6C9-59AE-4B04-BB04-AE37381B96F4}"/>
          </ac:grpSpMkLst>
        </pc:grpChg>
        <pc:grpChg chg="add del mod">
          <ac:chgData name="Manasweeta Angane" userId="05da2731-9352-4b35-b713-60351f56afbd" providerId="ADAL" clId="{121B3E88-C8E7-4600-B4A4-3E65BB803D64}" dt="2021-07-01T08:01:38.750" v="390" actId="478"/>
          <ac:grpSpMkLst>
            <pc:docMk/>
            <pc:sldMk cId="731297326" sldId="270"/>
            <ac:grpSpMk id="9" creationId="{8CF09967-0BED-4E62-B138-57666F6E3ED3}"/>
          </ac:grpSpMkLst>
        </pc:grpChg>
        <pc:grpChg chg="add del mod">
          <ac:chgData name="Manasweeta Angane" userId="05da2731-9352-4b35-b713-60351f56afbd" providerId="ADAL" clId="{121B3E88-C8E7-4600-B4A4-3E65BB803D64}" dt="2021-07-01T08:26:44.009" v="587" actId="165"/>
          <ac:grpSpMkLst>
            <pc:docMk/>
            <pc:sldMk cId="731297326" sldId="270"/>
            <ac:grpSpMk id="10" creationId="{9DF7CDF2-C95E-46E5-B728-E003F630551D}"/>
          </ac:grpSpMkLst>
        </pc:grpChg>
        <pc:grpChg chg="add mod">
          <ac:chgData name="Manasweeta Angane" userId="05da2731-9352-4b35-b713-60351f56afbd" providerId="ADAL" clId="{121B3E88-C8E7-4600-B4A4-3E65BB803D64}" dt="2021-07-02T04:01:29.317" v="2443" actId="164"/>
          <ac:grpSpMkLst>
            <pc:docMk/>
            <pc:sldMk cId="731297326" sldId="270"/>
            <ac:grpSpMk id="10" creationId="{FB9F57DC-2408-4FC8-BA2E-C10DA5F5BB0A}"/>
          </ac:grpSpMkLst>
        </pc:grpChg>
        <pc:grpChg chg="add mod">
          <ac:chgData name="Manasweeta Angane" userId="05da2731-9352-4b35-b713-60351f56afbd" providerId="ADAL" clId="{121B3E88-C8E7-4600-B4A4-3E65BB803D64}" dt="2021-07-01T11:32:40.515" v="2277" actId="688"/>
          <ac:grpSpMkLst>
            <pc:docMk/>
            <pc:sldMk cId="731297326" sldId="270"/>
            <ac:grpSpMk id="11" creationId="{96EFB168-73B3-4389-96A0-20C79DA25869}"/>
          </ac:grpSpMkLst>
        </pc:grpChg>
        <pc:grpChg chg="add mod topLvl">
          <ac:chgData name="Manasweeta Angane" userId="05da2731-9352-4b35-b713-60351f56afbd" providerId="ADAL" clId="{121B3E88-C8E7-4600-B4A4-3E65BB803D64}" dt="2021-07-01T11:32:40.515" v="2277" actId="688"/>
          <ac:grpSpMkLst>
            <pc:docMk/>
            <pc:sldMk cId="731297326" sldId="270"/>
            <ac:grpSpMk id="12" creationId="{2A2E5B81-1D2A-43DB-986F-3B0511728A9A}"/>
          </ac:grpSpMkLst>
        </pc:grpChg>
        <pc:grpChg chg="add del mod">
          <ac:chgData name="Manasweeta Angane" userId="05da2731-9352-4b35-b713-60351f56afbd" providerId="ADAL" clId="{121B3E88-C8E7-4600-B4A4-3E65BB803D64}" dt="2021-07-01T10:27:55.212" v="1855" actId="478"/>
          <ac:grpSpMkLst>
            <pc:docMk/>
            <pc:sldMk cId="731297326" sldId="270"/>
            <ac:grpSpMk id="14" creationId="{97B25C15-88EE-4FB9-88EF-13F713AB7B74}"/>
          </ac:grpSpMkLst>
        </pc:grpChg>
        <pc:grpChg chg="add del mod">
          <ac:chgData name="Manasweeta Angane" userId="05da2731-9352-4b35-b713-60351f56afbd" providerId="ADAL" clId="{121B3E88-C8E7-4600-B4A4-3E65BB803D64}" dt="2021-07-01T10:40:33.839" v="1890" actId="478"/>
          <ac:grpSpMkLst>
            <pc:docMk/>
            <pc:sldMk cId="731297326" sldId="270"/>
            <ac:grpSpMk id="15" creationId="{169F2979-A625-4E8D-ADDE-499F8BCD94A3}"/>
          </ac:grpSpMkLst>
        </pc:grpChg>
        <pc:grpChg chg="add mod">
          <ac:chgData name="Manasweeta Angane" userId="05da2731-9352-4b35-b713-60351f56afbd" providerId="ADAL" clId="{121B3E88-C8E7-4600-B4A4-3E65BB803D64}" dt="2021-07-01T11:25:39.144" v="2247" actId="1076"/>
          <ac:grpSpMkLst>
            <pc:docMk/>
            <pc:sldMk cId="731297326" sldId="270"/>
            <ac:grpSpMk id="16" creationId="{19DE4891-A407-4917-BDEF-5C09D1E35A62}"/>
          </ac:grpSpMkLst>
        </pc:grpChg>
        <pc:grpChg chg="del">
          <ac:chgData name="Manasweeta Angane" userId="05da2731-9352-4b35-b713-60351f56afbd" providerId="ADAL" clId="{121B3E88-C8E7-4600-B4A4-3E65BB803D64}" dt="2021-07-01T07:53:26.540" v="9" actId="478"/>
          <ac:grpSpMkLst>
            <pc:docMk/>
            <pc:sldMk cId="731297326" sldId="270"/>
            <ac:grpSpMk id="17" creationId="{ED8C76E9-ED5B-465C-9F4A-5783A95EFB1E}"/>
          </ac:grpSpMkLst>
        </pc:grpChg>
        <pc:grpChg chg="mod topLvl">
          <ac:chgData name="Manasweeta Angane" userId="05da2731-9352-4b35-b713-60351f56afbd" providerId="ADAL" clId="{121B3E88-C8E7-4600-B4A4-3E65BB803D64}" dt="2021-07-01T08:26:44.009" v="587" actId="165"/>
          <ac:grpSpMkLst>
            <pc:docMk/>
            <pc:sldMk cId="731297326" sldId="270"/>
            <ac:grpSpMk id="18" creationId="{3C65095A-C8DF-4380-A319-15843A6451B5}"/>
          </ac:grpSpMkLst>
        </pc:grpChg>
        <pc:grpChg chg="del">
          <ac:chgData name="Manasweeta Angane" userId="05da2731-9352-4b35-b713-60351f56afbd" providerId="ADAL" clId="{121B3E88-C8E7-4600-B4A4-3E65BB803D64}" dt="2021-07-01T07:53:21.298" v="3" actId="478"/>
          <ac:grpSpMkLst>
            <pc:docMk/>
            <pc:sldMk cId="731297326" sldId="270"/>
            <ac:grpSpMk id="19" creationId="{67F0C5FD-E448-4E43-A3BF-BAD63295F8A3}"/>
          </ac:grpSpMkLst>
        </pc:grpChg>
        <pc:grpChg chg="del mod topLvl">
          <ac:chgData name="Manasweeta Angane" userId="05da2731-9352-4b35-b713-60351f56afbd" providerId="ADAL" clId="{121B3E88-C8E7-4600-B4A4-3E65BB803D64}" dt="2021-07-02T09:17:15.356" v="2445" actId="165"/>
          <ac:grpSpMkLst>
            <pc:docMk/>
            <pc:sldMk cId="731297326" sldId="270"/>
            <ac:grpSpMk id="20" creationId="{EA024967-F98A-49CB-84CC-14F8ED39020B}"/>
          </ac:grpSpMkLst>
        </pc:grpChg>
        <pc:grpChg chg="mod topLvl">
          <ac:chgData name="Manasweeta Angane" userId="05da2731-9352-4b35-b713-60351f56afbd" providerId="ADAL" clId="{121B3E88-C8E7-4600-B4A4-3E65BB803D64}" dt="2021-07-01T08:31:19.580" v="666" actId="478"/>
          <ac:grpSpMkLst>
            <pc:docMk/>
            <pc:sldMk cId="731297326" sldId="270"/>
            <ac:grpSpMk id="21" creationId="{23678D48-FA37-4B70-B7FF-DC66B62C1674}"/>
          </ac:grpSpMkLst>
        </pc:grpChg>
        <pc:grpChg chg="del">
          <ac:chgData name="Manasweeta Angane" userId="05da2731-9352-4b35-b713-60351f56afbd" providerId="ADAL" clId="{121B3E88-C8E7-4600-B4A4-3E65BB803D64}" dt="2021-07-01T07:53:19.548" v="1" actId="478"/>
          <ac:grpSpMkLst>
            <pc:docMk/>
            <pc:sldMk cId="731297326" sldId="270"/>
            <ac:grpSpMk id="22" creationId="{E23C544C-51E1-4ADD-AA9F-1A86A41E6897}"/>
          </ac:grpSpMkLst>
        </pc:grpChg>
        <pc:grpChg chg="del">
          <ac:chgData name="Manasweeta Angane" userId="05da2731-9352-4b35-b713-60351f56afbd" providerId="ADAL" clId="{121B3E88-C8E7-4600-B4A4-3E65BB803D64}" dt="2021-07-01T07:53:23.010" v="5" actId="478"/>
          <ac:grpSpMkLst>
            <pc:docMk/>
            <pc:sldMk cId="731297326" sldId="270"/>
            <ac:grpSpMk id="23" creationId="{94491B58-4083-4F7E-A921-6140228B202C}"/>
          </ac:grpSpMkLst>
        </pc:grpChg>
        <pc:grpChg chg="mod topLvl">
          <ac:chgData name="Manasweeta Angane" userId="05da2731-9352-4b35-b713-60351f56afbd" providerId="ADAL" clId="{121B3E88-C8E7-4600-B4A4-3E65BB803D64}" dt="2021-07-01T08:27:14.999" v="592" actId="1076"/>
          <ac:grpSpMkLst>
            <pc:docMk/>
            <pc:sldMk cId="731297326" sldId="270"/>
            <ac:grpSpMk id="24" creationId="{6047A8A4-E1D6-42FC-9555-BAF4A27222FD}"/>
          </ac:grpSpMkLst>
        </pc:grpChg>
        <pc:grpChg chg="add mod">
          <ac:chgData name="Manasweeta Angane" userId="05da2731-9352-4b35-b713-60351f56afbd" providerId="ADAL" clId="{121B3E88-C8E7-4600-B4A4-3E65BB803D64}" dt="2021-07-01T10:52:33.982" v="2007" actId="164"/>
          <ac:grpSpMkLst>
            <pc:docMk/>
            <pc:sldMk cId="731297326" sldId="270"/>
            <ac:grpSpMk id="25" creationId="{6E7BEBA2-FC8C-480F-95F6-2E987D481AA8}"/>
          </ac:grpSpMkLst>
        </pc:grpChg>
        <pc:grpChg chg="mod">
          <ac:chgData name="Manasweeta Angane" userId="05da2731-9352-4b35-b713-60351f56afbd" providerId="ADAL" clId="{121B3E88-C8E7-4600-B4A4-3E65BB803D64}" dt="2021-07-01T07:55:14.715" v="52" actId="164"/>
          <ac:grpSpMkLst>
            <pc:docMk/>
            <pc:sldMk cId="731297326" sldId="270"/>
            <ac:grpSpMk id="26" creationId="{CB67E6E1-6425-4F3D-BC25-7EF74174481B}"/>
          </ac:grpSpMkLst>
        </pc:grpChg>
        <pc:grpChg chg="add del mod">
          <ac:chgData name="Manasweeta Angane" userId="05da2731-9352-4b35-b713-60351f56afbd" providerId="ADAL" clId="{121B3E88-C8E7-4600-B4A4-3E65BB803D64}" dt="2021-07-01T11:01:14.232" v="2094" actId="165"/>
          <ac:grpSpMkLst>
            <pc:docMk/>
            <pc:sldMk cId="731297326" sldId="270"/>
            <ac:grpSpMk id="27" creationId="{FFB8406F-60E5-4040-96CE-D6F9351D3BED}"/>
          </ac:grpSpMkLst>
        </pc:grpChg>
        <pc:grpChg chg="mod">
          <ac:chgData name="Manasweeta Angane" userId="05da2731-9352-4b35-b713-60351f56afbd" providerId="ADAL" clId="{121B3E88-C8E7-4600-B4A4-3E65BB803D64}" dt="2021-07-01T07:55:14.715" v="52" actId="164"/>
          <ac:grpSpMkLst>
            <pc:docMk/>
            <pc:sldMk cId="731297326" sldId="270"/>
            <ac:grpSpMk id="28" creationId="{F01C0DCC-14AA-4E8D-8B79-496F9D8770E5}"/>
          </ac:grpSpMkLst>
        </pc:grpChg>
        <pc:grpChg chg="mod">
          <ac:chgData name="Manasweeta Angane" userId="05da2731-9352-4b35-b713-60351f56afbd" providerId="ADAL" clId="{121B3E88-C8E7-4600-B4A4-3E65BB803D64}" dt="2021-07-01T07:55:14.715" v="52" actId="164"/>
          <ac:grpSpMkLst>
            <pc:docMk/>
            <pc:sldMk cId="731297326" sldId="270"/>
            <ac:grpSpMk id="29" creationId="{A47F7386-FF2A-4490-ABF0-71BDB6934FC5}"/>
          </ac:grpSpMkLst>
        </pc:grpChg>
        <pc:grpChg chg="add del mod topLvl">
          <ac:chgData name="Manasweeta Angane" userId="05da2731-9352-4b35-b713-60351f56afbd" providerId="ADAL" clId="{121B3E88-C8E7-4600-B4A4-3E65BB803D64}" dt="2021-07-01T11:34:00.997" v="2283" actId="1076"/>
          <ac:grpSpMkLst>
            <pc:docMk/>
            <pc:sldMk cId="731297326" sldId="270"/>
            <ac:grpSpMk id="30" creationId="{89158FF9-56F5-42C8-918A-46A99E71D281}"/>
          </ac:grpSpMkLst>
        </pc:grpChg>
        <pc:grpChg chg="add del mod">
          <ac:chgData name="Manasweeta Angane" userId="05da2731-9352-4b35-b713-60351f56afbd" providerId="ADAL" clId="{121B3E88-C8E7-4600-B4A4-3E65BB803D64}" dt="2021-07-01T11:03:45.711" v="2148" actId="165"/>
          <ac:grpSpMkLst>
            <pc:docMk/>
            <pc:sldMk cId="731297326" sldId="270"/>
            <ac:grpSpMk id="31" creationId="{9E80CCC8-8542-45D3-9420-C34D31D53CA1}"/>
          </ac:grpSpMkLst>
        </pc:grpChg>
        <pc:grpChg chg="del">
          <ac:chgData name="Manasweeta Angane" userId="05da2731-9352-4b35-b713-60351f56afbd" providerId="ADAL" clId="{121B3E88-C8E7-4600-B4A4-3E65BB803D64}" dt="2021-07-01T07:53:33.017" v="17" actId="478"/>
          <ac:grpSpMkLst>
            <pc:docMk/>
            <pc:sldMk cId="731297326" sldId="270"/>
            <ac:grpSpMk id="32" creationId="{D74AC426-9BA9-42BE-B3AA-E716B16A570F}"/>
          </ac:grpSpMkLst>
        </pc:grpChg>
        <pc:grpChg chg="add del mod">
          <ac:chgData name="Manasweeta Angane" userId="05da2731-9352-4b35-b713-60351f56afbd" providerId="ADAL" clId="{121B3E88-C8E7-4600-B4A4-3E65BB803D64}" dt="2021-07-01T11:24:24.977" v="2203" actId="478"/>
          <ac:grpSpMkLst>
            <pc:docMk/>
            <pc:sldMk cId="731297326" sldId="270"/>
            <ac:grpSpMk id="33" creationId="{4CA5C5B2-5C04-4577-8586-291048CA64EB}"/>
          </ac:grpSpMkLst>
        </pc:grpChg>
        <pc:grpChg chg="add mod">
          <ac:chgData name="Manasweeta Angane" userId="05da2731-9352-4b35-b713-60351f56afbd" providerId="ADAL" clId="{121B3E88-C8E7-4600-B4A4-3E65BB803D64}" dt="2021-07-01T11:23:52.403" v="2197" actId="1076"/>
          <ac:grpSpMkLst>
            <pc:docMk/>
            <pc:sldMk cId="731297326" sldId="270"/>
            <ac:grpSpMk id="34" creationId="{5E478530-2C31-4D20-9DBC-346296D12578}"/>
          </ac:grpSpMkLst>
        </pc:grpChg>
        <pc:grpChg chg="add mod">
          <ac:chgData name="Manasweeta Angane" userId="05da2731-9352-4b35-b713-60351f56afbd" providerId="ADAL" clId="{121B3E88-C8E7-4600-B4A4-3E65BB803D64}" dt="2021-07-01T11:25:20.474" v="2243" actId="1038"/>
          <ac:grpSpMkLst>
            <pc:docMk/>
            <pc:sldMk cId="731297326" sldId="270"/>
            <ac:grpSpMk id="35" creationId="{F4CAC3CF-0DC4-4031-A80B-994CB03CA8F9}"/>
          </ac:grpSpMkLst>
        </pc:grpChg>
        <pc:grpChg chg="add mod">
          <ac:chgData name="Manasweeta Angane" userId="05da2731-9352-4b35-b713-60351f56afbd" providerId="ADAL" clId="{121B3E88-C8E7-4600-B4A4-3E65BB803D64}" dt="2021-07-01T11:26:33.402" v="2255" actId="1076"/>
          <ac:grpSpMkLst>
            <pc:docMk/>
            <pc:sldMk cId="731297326" sldId="270"/>
            <ac:grpSpMk id="36" creationId="{2F63E80D-3BF8-4AA5-8CC4-1D04E4C8976B}"/>
          </ac:grpSpMkLst>
        </pc:grpChg>
        <pc:grpChg chg="add mod">
          <ac:chgData name="Manasweeta Angane" userId="05da2731-9352-4b35-b713-60351f56afbd" providerId="ADAL" clId="{121B3E88-C8E7-4600-B4A4-3E65BB803D64}" dt="2021-07-01T11:32:12.196" v="2273" actId="164"/>
          <ac:grpSpMkLst>
            <pc:docMk/>
            <pc:sldMk cId="731297326" sldId="270"/>
            <ac:grpSpMk id="37" creationId="{BD877BEF-E9A6-464D-BCF6-492915FF22C4}"/>
          </ac:grpSpMkLst>
        </pc:grpChg>
        <pc:grpChg chg="mod">
          <ac:chgData name="Manasweeta Angane" userId="05da2731-9352-4b35-b713-60351f56afbd" providerId="ADAL" clId="{121B3E88-C8E7-4600-B4A4-3E65BB803D64}" dt="2021-07-01T07:55:14.715" v="52" actId="164"/>
          <ac:grpSpMkLst>
            <pc:docMk/>
            <pc:sldMk cId="731297326" sldId="270"/>
            <ac:grpSpMk id="142" creationId="{67FA6706-8D46-4264-90A6-DA2FD3112F69}"/>
          </ac:grpSpMkLst>
        </pc:grpChg>
        <pc:grpChg chg="mod">
          <ac:chgData name="Manasweeta Angane" userId="05da2731-9352-4b35-b713-60351f56afbd" providerId="ADAL" clId="{121B3E88-C8E7-4600-B4A4-3E65BB803D64}" dt="2021-07-01T07:55:14.715" v="52" actId="164"/>
          <ac:grpSpMkLst>
            <pc:docMk/>
            <pc:sldMk cId="731297326" sldId="270"/>
            <ac:grpSpMk id="144" creationId="{D273DF9F-D457-467C-9D1B-7967F8993640}"/>
          </ac:grpSpMkLst>
        </pc:grpChg>
        <pc:grpChg chg="mod">
          <ac:chgData name="Manasweeta Angane" userId="05da2731-9352-4b35-b713-60351f56afbd" providerId="ADAL" clId="{121B3E88-C8E7-4600-B4A4-3E65BB803D64}" dt="2021-07-01T07:55:14.715" v="52" actId="164"/>
          <ac:grpSpMkLst>
            <pc:docMk/>
            <pc:sldMk cId="731297326" sldId="270"/>
            <ac:grpSpMk id="145" creationId="{1CB57B06-FA75-48C9-A6BC-A4E6F430710C}"/>
          </ac:grpSpMkLst>
        </pc:grpChg>
        <pc:grpChg chg="mod">
          <ac:chgData name="Manasweeta Angane" userId="05da2731-9352-4b35-b713-60351f56afbd" providerId="ADAL" clId="{121B3E88-C8E7-4600-B4A4-3E65BB803D64}" dt="2021-07-01T07:55:14.715" v="52" actId="164"/>
          <ac:grpSpMkLst>
            <pc:docMk/>
            <pc:sldMk cId="731297326" sldId="270"/>
            <ac:grpSpMk id="176" creationId="{C9642CF7-6595-4725-9BF2-DD6421CFE129}"/>
          </ac:grpSpMkLst>
        </pc:grpChg>
        <pc:grpChg chg="add del mod">
          <ac:chgData name="Manasweeta Angane" userId="05da2731-9352-4b35-b713-60351f56afbd" providerId="ADAL" clId="{121B3E88-C8E7-4600-B4A4-3E65BB803D64}" dt="2021-07-01T08:26:29.972" v="584" actId="165"/>
          <ac:grpSpMkLst>
            <pc:docMk/>
            <pc:sldMk cId="731297326" sldId="270"/>
            <ac:grpSpMk id="183" creationId="{19180432-3C6B-42CB-AA40-850F634F7DDF}"/>
          </ac:grpSpMkLst>
        </pc:grpChg>
        <pc:grpChg chg="del mod topLvl">
          <ac:chgData name="Manasweeta Angane" userId="05da2731-9352-4b35-b713-60351f56afbd" providerId="ADAL" clId="{121B3E88-C8E7-4600-B4A4-3E65BB803D64}" dt="2021-07-01T08:27:52.387" v="601" actId="478"/>
          <ac:grpSpMkLst>
            <pc:docMk/>
            <pc:sldMk cId="731297326" sldId="270"/>
            <ac:grpSpMk id="205" creationId="{D6AD6903-A99C-4277-B625-C2274E62F65A}"/>
          </ac:grpSpMkLst>
        </pc:grpChg>
        <pc:grpChg chg="mod">
          <ac:chgData name="Manasweeta Angane" userId="05da2731-9352-4b35-b713-60351f56afbd" providerId="ADAL" clId="{121B3E88-C8E7-4600-B4A4-3E65BB803D64}" dt="2021-07-01T07:55:14.715" v="52" actId="164"/>
          <ac:grpSpMkLst>
            <pc:docMk/>
            <pc:sldMk cId="731297326" sldId="270"/>
            <ac:grpSpMk id="208" creationId="{B75B7045-1669-4FBD-A936-5786C3B7F362}"/>
          </ac:grpSpMkLst>
        </pc:grpChg>
        <pc:grpChg chg="del mod topLvl">
          <ac:chgData name="Manasweeta Angane" userId="05da2731-9352-4b35-b713-60351f56afbd" providerId="ADAL" clId="{121B3E88-C8E7-4600-B4A4-3E65BB803D64}" dt="2021-07-01T11:24:12.945" v="2201" actId="478"/>
          <ac:grpSpMkLst>
            <pc:docMk/>
            <pc:sldMk cId="731297326" sldId="270"/>
            <ac:grpSpMk id="216" creationId="{49FD83D7-3E67-4FB1-ADFD-3CC11E5A03BC}"/>
          </ac:grpSpMkLst>
        </pc:grpChg>
        <pc:grpChg chg="mod topLvl">
          <ac:chgData name="Manasweeta Angane" userId="05da2731-9352-4b35-b713-60351f56afbd" providerId="ADAL" clId="{121B3E88-C8E7-4600-B4A4-3E65BB803D64}" dt="2021-07-02T03:59:37.845" v="2438" actId="1076"/>
          <ac:grpSpMkLst>
            <pc:docMk/>
            <pc:sldMk cId="731297326" sldId="270"/>
            <ac:grpSpMk id="218" creationId="{B578E15F-6E9D-450A-BC10-4364FFDF4542}"/>
          </ac:grpSpMkLst>
        </pc:grpChg>
        <pc:grpChg chg="del mod topLvl">
          <ac:chgData name="Manasweeta Angane" userId="05da2731-9352-4b35-b713-60351f56afbd" providerId="ADAL" clId="{121B3E88-C8E7-4600-B4A4-3E65BB803D64}" dt="2021-07-01T11:01:23.981" v="2096" actId="165"/>
          <ac:grpSpMkLst>
            <pc:docMk/>
            <pc:sldMk cId="731297326" sldId="270"/>
            <ac:grpSpMk id="219" creationId="{B19A1699-17EF-48A6-9AF4-BFDE6DAFE61F}"/>
          </ac:grpSpMkLst>
        </pc:grpChg>
        <pc:grpChg chg="del">
          <ac:chgData name="Manasweeta Angane" userId="05da2731-9352-4b35-b713-60351f56afbd" providerId="ADAL" clId="{121B3E88-C8E7-4600-B4A4-3E65BB803D64}" dt="2021-07-01T07:53:47.675" v="30" actId="478"/>
          <ac:grpSpMkLst>
            <pc:docMk/>
            <pc:sldMk cId="731297326" sldId="270"/>
            <ac:grpSpMk id="233" creationId="{1035494A-358A-4909-9B5E-9796833D5D3C}"/>
          </ac:grpSpMkLst>
        </pc:grpChg>
        <pc:grpChg chg="del mod topLvl">
          <ac:chgData name="Manasweeta Angane" userId="05da2731-9352-4b35-b713-60351f56afbd" providerId="ADAL" clId="{121B3E88-C8E7-4600-B4A4-3E65BB803D64}" dt="2021-07-01T08:27:55.075" v="602" actId="478"/>
          <ac:grpSpMkLst>
            <pc:docMk/>
            <pc:sldMk cId="731297326" sldId="270"/>
            <ac:grpSpMk id="247" creationId="{E33AD4D0-5C0B-4BE4-8D64-21A5EF546920}"/>
          </ac:grpSpMkLst>
        </pc:grpChg>
        <pc:grpChg chg="del">
          <ac:chgData name="Manasweeta Angane" userId="05da2731-9352-4b35-b713-60351f56afbd" providerId="ADAL" clId="{121B3E88-C8E7-4600-B4A4-3E65BB803D64}" dt="2021-07-01T07:53:37.426" v="21" actId="478"/>
          <ac:grpSpMkLst>
            <pc:docMk/>
            <pc:sldMk cId="731297326" sldId="270"/>
            <ac:grpSpMk id="256" creationId="{75BFB4DD-2211-47C7-AAB7-B36931CC0A5E}"/>
          </ac:grpSpMkLst>
        </pc:grpChg>
        <pc:grpChg chg="del">
          <ac:chgData name="Manasweeta Angane" userId="05da2731-9352-4b35-b713-60351f56afbd" providerId="ADAL" clId="{121B3E88-C8E7-4600-B4A4-3E65BB803D64}" dt="2021-07-01T07:53:46.892" v="29" actId="478"/>
          <ac:grpSpMkLst>
            <pc:docMk/>
            <pc:sldMk cId="731297326" sldId="270"/>
            <ac:grpSpMk id="257" creationId="{DA0E798D-C357-4386-9C33-285E34E9393D}"/>
          </ac:grpSpMkLst>
        </pc:grpChg>
        <pc:grpChg chg="mod">
          <ac:chgData name="Manasweeta Angane" userId="05da2731-9352-4b35-b713-60351f56afbd" providerId="ADAL" clId="{121B3E88-C8E7-4600-B4A4-3E65BB803D64}" dt="2021-07-01T07:55:14.715" v="52" actId="164"/>
          <ac:grpSpMkLst>
            <pc:docMk/>
            <pc:sldMk cId="731297326" sldId="270"/>
            <ac:grpSpMk id="264" creationId="{2BB4502F-12F3-4087-BED9-EF35A1B16A06}"/>
          </ac:grpSpMkLst>
        </pc:grpChg>
        <pc:grpChg chg="mod topLvl">
          <ac:chgData name="Manasweeta Angane" userId="05da2731-9352-4b35-b713-60351f56afbd" providerId="ADAL" clId="{121B3E88-C8E7-4600-B4A4-3E65BB803D64}" dt="2021-07-01T08:26:44.009" v="587" actId="165"/>
          <ac:grpSpMkLst>
            <pc:docMk/>
            <pc:sldMk cId="731297326" sldId="270"/>
            <ac:grpSpMk id="266" creationId="{30884ABD-770E-4F90-8DCD-DD0DBCFA01B5}"/>
          </ac:grpSpMkLst>
        </pc:grpChg>
        <pc:grpChg chg="del mod topLvl">
          <ac:chgData name="Manasweeta Angane" userId="05da2731-9352-4b35-b713-60351f56afbd" providerId="ADAL" clId="{121B3E88-C8E7-4600-B4A4-3E65BB803D64}" dt="2021-07-01T08:27:45.523" v="598" actId="478"/>
          <ac:grpSpMkLst>
            <pc:docMk/>
            <pc:sldMk cId="731297326" sldId="270"/>
            <ac:grpSpMk id="269" creationId="{36B95C9A-B10E-41C5-B21B-7E40EB909412}"/>
          </ac:grpSpMkLst>
        </pc:grpChg>
        <pc:grpChg chg="mod topLvl">
          <ac:chgData name="Manasweeta Angane" userId="05da2731-9352-4b35-b713-60351f56afbd" providerId="ADAL" clId="{121B3E88-C8E7-4600-B4A4-3E65BB803D64}" dt="2021-07-01T08:26:44.009" v="587" actId="165"/>
          <ac:grpSpMkLst>
            <pc:docMk/>
            <pc:sldMk cId="731297326" sldId="270"/>
            <ac:grpSpMk id="290" creationId="{76940501-C6B1-4261-BB57-13E2A4A9A29F}"/>
          </ac:grpSpMkLst>
        </pc:grpChg>
        <pc:grpChg chg="del mod topLvl">
          <ac:chgData name="Manasweeta Angane" userId="05da2731-9352-4b35-b713-60351f56afbd" providerId="ADAL" clId="{121B3E88-C8E7-4600-B4A4-3E65BB803D64}" dt="2021-07-01T08:27:44.218" v="597" actId="478"/>
          <ac:grpSpMkLst>
            <pc:docMk/>
            <pc:sldMk cId="731297326" sldId="270"/>
            <ac:grpSpMk id="295" creationId="{FDE98F6F-D576-41C2-8066-04869A85090E}"/>
          </ac:grpSpMkLst>
        </pc:grpChg>
        <pc:grpChg chg="add del mod topLvl">
          <ac:chgData name="Manasweeta Angane" userId="05da2731-9352-4b35-b713-60351f56afbd" providerId="ADAL" clId="{121B3E88-C8E7-4600-B4A4-3E65BB803D64}" dt="2021-07-01T08:55:36.137" v="1294" actId="478"/>
          <ac:grpSpMkLst>
            <pc:docMk/>
            <pc:sldMk cId="731297326" sldId="270"/>
            <ac:grpSpMk id="296" creationId="{22F5739C-57C6-4556-BB91-92BB65790502}"/>
          </ac:grpSpMkLst>
        </pc:grpChg>
        <pc:grpChg chg="del mod topLvl">
          <ac:chgData name="Manasweeta Angane" userId="05da2731-9352-4b35-b713-60351f56afbd" providerId="ADAL" clId="{121B3E88-C8E7-4600-B4A4-3E65BB803D64}" dt="2021-07-01T11:20:00.094" v="2171" actId="478"/>
          <ac:grpSpMkLst>
            <pc:docMk/>
            <pc:sldMk cId="731297326" sldId="270"/>
            <ac:grpSpMk id="298" creationId="{0F6FF40E-C517-4A53-971B-6D0885C304A9}"/>
          </ac:grpSpMkLst>
        </pc:grpChg>
        <pc:grpChg chg="add del mod">
          <ac:chgData name="Manasweeta Angane" userId="05da2731-9352-4b35-b713-60351f56afbd" providerId="ADAL" clId="{121B3E88-C8E7-4600-B4A4-3E65BB803D64}" dt="2021-07-01T08:26:34.642" v="585" actId="165"/>
          <ac:grpSpMkLst>
            <pc:docMk/>
            <pc:sldMk cId="731297326" sldId="270"/>
            <ac:grpSpMk id="321" creationId="{6EE75CDE-E336-4F5F-9462-38F15F75E5C9}"/>
          </ac:grpSpMkLst>
        </pc:grpChg>
        <pc:grpChg chg="del mod topLvl">
          <ac:chgData name="Manasweeta Angane" userId="05da2731-9352-4b35-b713-60351f56afbd" providerId="ADAL" clId="{121B3E88-C8E7-4600-B4A4-3E65BB803D64}" dt="2021-07-01T08:27:35.089" v="594" actId="478"/>
          <ac:grpSpMkLst>
            <pc:docMk/>
            <pc:sldMk cId="731297326" sldId="270"/>
            <ac:grpSpMk id="326" creationId="{87509462-33DC-4CF5-A1EA-F8C83CB4E441}"/>
          </ac:grpSpMkLst>
        </pc:grpChg>
        <pc:grpChg chg="del mod topLvl">
          <ac:chgData name="Manasweeta Angane" userId="05da2731-9352-4b35-b713-60351f56afbd" providerId="ADAL" clId="{121B3E88-C8E7-4600-B4A4-3E65BB803D64}" dt="2021-07-01T10:25:58.426" v="1835" actId="478"/>
          <ac:grpSpMkLst>
            <pc:docMk/>
            <pc:sldMk cId="731297326" sldId="270"/>
            <ac:grpSpMk id="331" creationId="{E5ED13C4-6263-4D8D-AEE5-5DF2EBEF7C66}"/>
          </ac:grpSpMkLst>
        </pc:grpChg>
        <pc:grpChg chg="mod topLvl">
          <ac:chgData name="Manasweeta Angane" userId="05da2731-9352-4b35-b713-60351f56afbd" providerId="ADAL" clId="{121B3E88-C8E7-4600-B4A4-3E65BB803D64}" dt="2021-07-01T11:25:52.855" v="2249" actId="1076"/>
          <ac:grpSpMkLst>
            <pc:docMk/>
            <pc:sldMk cId="731297326" sldId="270"/>
            <ac:grpSpMk id="332" creationId="{185DDFD9-4BF4-4B77-862B-896EAACA3369}"/>
          </ac:grpSpMkLst>
        </pc:grpChg>
        <pc:grpChg chg="mod topLvl">
          <ac:chgData name="Manasweeta Angane" userId="05da2731-9352-4b35-b713-60351f56afbd" providerId="ADAL" clId="{121B3E88-C8E7-4600-B4A4-3E65BB803D64}" dt="2021-07-01T11:25:20.474" v="2243" actId="1038"/>
          <ac:grpSpMkLst>
            <pc:docMk/>
            <pc:sldMk cId="731297326" sldId="270"/>
            <ac:grpSpMk id="333" creationId="{8F2B6025-04C5-4E0A-80BF-FA7809312E08}"/>
          </ac:grpSpMkLst>
        </pc:grpChg>
        <pc:grpChg chg="del mod topLvl">
          <ac:chgData name="Manasweeta Angane" userId="05da2731-9352-4b35-b713-60351f56afbd" providerId="ADAL" clId="{121B3E88-C8E7-4600-B4A4-3E65BB803D64}" dt="2021-07-01T08:27:39.865" v="595" actId="478"/>
          <ac:grpSpMkLst>
            <pc:docMk/>
            <pc:sldMk cId="731297326" sldId="270"/>
            <ac:grpSpMk id="336" creationId="{DF4318C0-1749-4931-AE73-D5778AAD3D7A}"/>
          </ac:grpSpMkLst>
        </pc:grpChg>
        <pc:grpChg chg="del mod topLvl">
          <ac:chgData name="Manasweeta Angane" userId="05da2731-9352-4b35-b713-60351f56afbd" providerId="ADAL" clId="{121B3E88-C8E7-4600-B4A4-3E65BB803D64}" dt="2021-07-01T08:27:29.363" v="593" actId="478"/>
          <ac:grpSpMkLst>
            <pc:docMk/>
            <pc:sldMk cId="731297326" sldId="270"/>
            <ac:grpSpMk id="337" creationId="{E631D62B-90B4-4553-81AE-3B6BAA7A5B98}"/>
          </ac:grpSpMkLst>
        </pc:grpChg>
        <pc:grpChg chg="del mod topLvl">
          <ac:chgData name="Manasweeta Angane" userId="05da2731-9352-4b35-b713-60351f56afbd" providerId="ADAL" clId="{121B3E88-C8E7-4600-B4A4-3E65BB803D64}" dt="2021-07-01T08:27:41.580" v="596" actId="478"/>
          <ac:grpSpMkLst>
            <pc:docMk/>
            <pc:sldMk cId="731297326" sldId="270"/>
            <ac:grpSpMk id="338" creationId="{B8EB459D-D0ED-4908-BCA9-6F9AE12AB160}"/>
          </ac:grpSpMkLst>
        </pc:grpChg>
        <pc:grpChg chg="del mod topLvl">
          <ac:chgData name="Manasweeta Angane" userId="05da2731-9352-4b35-b713-60351f56afbd" providerId="ADAL" clId="{121B3E88-C8E7-4600-B4A4-3E65BB803D64}" dt="2021-07-01T10:42:19.433" v="1904" actId="478"/>
          <ac:grpSpMkLst>
            <pc:docMk/>
            <pc:sldMk cId="731297326" sldId="270"/>
            <ac:grpSpMk id="339" creationId="{4A3468FC-73BB-4148-828E-E32F9955B7FC}"/>
          </ac:grpSpMkLst>
        </pc:grpChg>
        <pc:grpChg chg="del mod topLvl">
          <ac:chgData name="Manasweeta Angane" userId="05da2731-9352-4b35-b713-60351f56afbd" providerId="ADAL" clId="{121B3E88-C8E7-4600-B4A4-3E65BB803D64}" dt="2021-07-02T04:00:31.431" v="2439" actId="165"/>
          <ac:grpSpMkLst>
            <pc:docMk/>
            <pc:sldMk cId="731297326" sldId="270"/>
            <ac:grpSpMk id="341" creationId="{A839F078-44A6-420C-A82F-CF59EF10D5F0}"/>
          </ac:grpSpMkLst>
        </pc:grpChg>
        <pc:grpChg chg="add del mod">
          <ac:chgData name="Manasweeta Angane" userId="05da2731-9352-4b35-b713-60351f56afbd" providerId="ADAL" clId="{121B3E88-C8E7-4600-B4A4-3E65BB803D64}" dt="2021-07-01T08:07:54.122" v="433"/>
          <ac:grpSpMkLst>
            <pc:docMk/>
            <pc:sldMk cId="731297326" sldId="270"/>
            <ac:grpSpMk id="368" creationId="{46E71F22-55C1-4F2F-BC55-396443FAFB52}"/>
          </ac:grpSpMkLst>
        </pc:grpChg>
        <pc:grpChg chg="mod">
          <ac:chgData name="Manasweeta Angane" userId="05da2731-9352-4b35-b713-60351f56afbd" providerId="ADAL" clId="{121B3E88-C8E7-4600-B4A4-3E65BB803D64}" dt="2021-07-01T08:07:37.413" v="432"/>
          <ac:grpSpMkLst>
            <pc:docMk/>
            <pc:sldMk cId="731297326" sldId="270"/>
            <ac:grpSpMk id="372" creationId="{8DEFE63B-9608-4597-8972-7B6D087201EE}"/>
          </ac:grpSpMkLst>
        </pc:grpChg>
        <pc:grpChg chg="mod">
          <ac:chgData name="Manasweeta Angane" userId="05da2731-9352-4b35-b713-60351f56afbd" providerId="ADAL" clId="{121B3E88-C8E7-4600-B4A4-3E65BB803D64}" dt="2021-07-01T08:07:37.413" v="432"/>
          <ac:grpSpMkLst>
            <pc:docMk/>
            <pc:sldMk cId="731297326" sldId="270"/>
            <ac:grpSpMk id="377" creationId="{D4ED26CF-2AE8-43A4-A9E8-ADD51314B121}"/>
          </ac:grpSpMkLst>
        </pc:grpChg>
        <pc:grpChg chg="mod">
          <ac:chgData name="Manasweeta Angane" userId="05da2731-9352-4b35-b713-60351f56afbd" providerId="ADAL" clId="{121B3E88-C8E7-4600-B4A4-3E65BB803D64}" dt="2021-07-01T08:07:37.413" v="432"/>
          <ac:grpSpMkLst>
            <pc:docMk/>
            <pc:sldMk cId="731297326" sldId="270"/>
            <ac:grpSpMk id="378" creationId="{98952F00-8AA5-465E-AB12-A607B884DFD8}"/>
          </ac:grpSpMkLst>
        </pc:grpChg>
        <pc:grpChg chg="mod">
          <ac:chgData name="Manasweeta Angane" userId="05da2731-9352-4b35-b713-60351f56afbd" providerId="ADAL" clId="{121B3E88-C8E7-4600-B4A4-3E65BB803D64}" dt="2021-07-01T08:07:37.413" v="432"/>
          <ac:grpSpMkLst>
            <pc:docMk/>
            <pc:sldMk cId="731297326" sldId="270"/>
            <ac:grpSpMk id="379" creationId="{F003ABBB-31BA-4F3B-BA71-8DC568D44717}"/>
          </ac:grpSpMkLst>
        </pc:grpChg>
        <pc:grpChg chg="mod">
          <ac:chgData name="Manasweeta Angane" userId="05da2731-9352-4b35-b713-60351f56afbd" providerId="ADAL" clId="{121B3E88-C8E7-4600-B4A4-3E65BB803D64}" dt="2021-07-01T08:07:37.413" v="432"/>
          <ac:grpSpMkLst>
            <pc:docMk/>
            <pc:sldMk cId="731297326" sldId="270"/>
            <ac:grpSpMk id="380" creationId="{DC86ECC4-F6E9-4DC2-9272-E5701F7E9E28}"/>
          </ac:grpSpMkLst>
        </pc:grpChg>
        <pc:grpChg chg="mod">
          <ac:chgData name="Manasweeta Angane" userId="05da2731-9352-4b35-b713-60351f56afbd" providerId="ADAL" clId="{121B3E88-C8E7-4600-B4A4-3E65BB803D64}" dt="2021-07-01T08:07:37.413" v="432"/>
          <ac:grpSpMkLst>
            <pc:docMk/>
            <pc:sldMk cId="731297326" sldId="270"/>
            <ac:grpSpMk id="381" creationId="{3D6EB105-52F3-4A0A-A9C0-4EB4532C9899}"/>
          </ac:grpSpMkLst>
        </pc:grpChg>
        <pc:grpChg chg="mod">
          <ac:chgData name="Manasweeta Angane" userId="05da2731-9352-4b35-b713-60351f56afbd" providerId="ADAL" clId="{121B3E88-C8E7-4600-B4A4-3E65BB803D64}" dt="2021-07-01T08:07:37.413" v="432"/>
          <ac:grpSpMkLst>
            <pc:docMk/>
            <pc:sldMk cId="731297326" sldId="270"/>
            <ac:grpSpMk id="382" creationId="{181D9963-107C-46F7-B400-13D1BB8378FF}"/>
          </ac:grpSpMkLst>
        </pc:grpChg>
        <pc:grpChg chg="mod">
          <ac:chgData name="Manasweeta Angane" userId="05da2731-9352-4b35-b713-60351f56afbd" providerId="ADAL" clId="{121B3E88-C8E7-4600-B4A4-3E65BB803D64}" dt="2021-07-01T08:07:37.413" v="432"/>
          <ac:grpSpMkLst>
            <pc:docMk/>
            <pc:sldMk cId="731297326" sldId="270"/>
            <ac:grpSpMk id="386" creationId="{9724BB39-74F3-4029-B38B-4EE47338F305}"/>
          </ac:grpSpMkLst>
        </pc:grpChg>
        <pc:grpChg chg="mod">
          <ac:chgData name="Manasweeta Angane" userId="05da2731-9352-4b35-b713-60351f56afbd" providerId="ADAL" clId="{121B3E88-C8E7-4600-B4A4-3E65BB803D64}" dt="2021-07-01T08:07:37.413" v="432"/>
          <ac:grpSpMkLst>
            <pc:docMk/>
            <pc:sldMk cId="731297326" sldId="270"/>
            <ac:grpSpMk id="388" creationId="{FCAD1B99-0B2B-4557-B497-A748A83D0A9A}"/>
          </ac:grpSpMkLst>
        </pc:grpChg>
        <pc:grpChg chg="add del mod">
          <ac:chgData name="Manasweeta Angane" userId="05da2731-9352-4b35-b713-60351f56afbd" providerId="ADAL" clId="{121B3E88-C8E7-4600-B4A4-3E65BB803D64}" dt="2021-07-01T08:26:38.676" v="586" actId="165"/>
          <ac:grpSpMkLst>
            <pc:docMk/>
            <pc:sldMk cId="731297326" sldId="270"/>
            <ac:grpSpMk id="412" creationId="{FA390A8B-901F-4DFB-B79E-7FF344E7F195}"/>
          </ac:grpSpMkLst>
        </pc:grpChg>
        <pc:grpChg chg="mod topLvl">
          <ac:chgData name="Manasweeta Angane" userId="05da2731-9352-4b35-b713-60351f56afbd" providerId="ADAL" clId="{121B3E88-C8E7-4600-B4A4-3E65BB803D64}" dt="2021-07-01T08:26:38.676" v="586" actId="165"/>
          <ac:grpSpMkLst>
            <pc:docMk/>
            <pc:sldMk cId="731297326" sldId="270"/>
            <ac:grpSpMk id="416" creationId="{EFEFEDFA-5C17-44DE-B624-6ABF10CC015D}"/>
          </ac:grpSpMkLst>
        </pc:grpChg>
        <pc:grpChg chg="mod topLvl">
          <ac:chgData name="Manasweeta Angane" userId="05da2731-9352-4b35-b713-60351f56afbd" providerId="ADAL" clId="{121B3E88-C8E7-4600-B4A4-3E65BB803D64}" dt="2021-07-01T08:26:38.676" v="586" actId="165"/>
          <ac:grpSpMkLst>
            <pc:docMk/>
            <pc:sldMk cId="731297326" sldId="270"/>
            <ac:grpSpMk id="421" creationId="{ED50245C-4182-4036-9C81-4E9F69267F68}"/>
          </ac:grpSpMkLst>
        </pc:grpChg>
        <pc:grpChg chg="mod topLvl">
          <ac:chgData name="Manasweeta Angane" userId="05da2731-9352-4b35-b713-60351f56afbd" providerId="ADAL" clId="{121B3E88-C8E7-4600-B4A4-3E65BB803D64}" dt="2021-07-01T11:24:05.991" v="2199" actId="1076"/>
          <ac:grpSpMkLst>
            <pc:docMk/>
            <pc:sldMk cId="731297326" sldId="270"/>
            <ac:grpSpMk id="422" creationId="{CD94E1D5-C5C8-4DDB-88A4-A6355C82402D}"/>
          </ac:grpSpMkLst>
        </pc:grpChg>
        <pc:grpChg chg="del mod topLvl">
          <ac:chgData name="Manasweeta Angane" userId="05da2731-9352-4b35-b713-60351f56afbd" providerId="ADAL" clId="{121B3E88-C8E7-4600-B4A4-3E65BB803D64}" dt="2021-07-02T09:17:23.913" v="2447" actId="165"/>
          <ac:grpSpMkLst>
            <pc:docMk/>
            <pc:sldMk cId="731297326" sldId="270"/>
            <ac:grpSpMk id="423" creationId="{31A86E20-5323-4D86-93CC-715C65EA7369}"/>
          </ac:grpSpMkLst>
        </pc:grpChg>
        <pc:grpChg chg="del mod topLvl">
          <ac:chgData name="Manasweeta Angane" userId="05da2731-9352-4b35-b713-60351f56afbd" providerId="ADAL" clId="{121B3E88-C8E7-4600-B4A4-3E65BB803D64}" dt="2021-07-01T09:14:16.523" v="1619" actId="478"/>
          <ac:grpSpMkLst>
            <pc:docMk/>
            <pc:sldMk cId="731297326" sldId="270"/>
            <ac:grpSpMk id="424" creationId="{F212C20F-9828-4A10-91ED-0A047F12107D}"/>
          </ac:grpSpMkLst>
        </pc:grpChg>
        <pc:grpChg chg="mod topLvl">
          <ac:chgData name="Manasweeta Angane" userId="05da2731-9352-4b35-b713-60351f56afbd" providerId="ADAL" clId="{121B3E88-C8E7-4600-B4A4-3E65BB803D64}" dt="2021-07-01T08:48:43.848" v="954" actId="478"/>
          <ac:grpSpMkLst>
            <pc:docMk/>
            <pc:sldMk cId="731297326" sldId="270"/>
            <ac:grpSpMk id="425" creationId="{3BA41A6C-461A-4E67-B0E3-B07DB9DBFED9}"/>
          </ac:grpSpMkLst>
        </pc:grpChg>
        <pc:grpChg chg="del mod topLvl">
          <ac:chgData name="Manasweeta Angane" userId="05da2731-9352-4b35-b713-60351f56afbd" providerId="ADAL" clId="{121B3E88-C8E7-4600-B4A4-3E65BB803D64}" dt="2021-07-01T09:13:26.322" v="1434" actId="478"/>
          <ac:grpSpMkLst>
            <pc:docMk/>
            <pc:sldMk cId="731297326" sldId="270"/>
            <ac:grpSpMk id="426" creationId="{44F4C0D2-72F1-431A-A723-445CC4D15A20}"/>
          </ac:grpSpMkLst>
        </pc:grpChg>
        <pc:grpChg chg="mod topLvl">
          <ac:chgData name="Manasweeta Angane" userId="05da2731-9352-4b35-b713-60351f56afbd" providerId="ADAL" clId="{121B3E88-C8E7-4600-B4A4-3E65BB803D64}" dt="2021-07-01T08:31:04.666" v="663" actId="478"/>
          <ac:grpSpMkLst>
            <pc:docMk/>
            <pc:sldMk cId="731297326" sldId="270"/>
            <ac:grpSpMk id="430" creationId="{D3E43E59-4164-4F64-92DF-8E280487542E}"/>
          </ac:grpSpMkLst>
        </pc:grpChg>
        <pc:grpChg chg="mod topLvl">
          <ac:chgData name="Manasweeta Angane" userId="05da2731-9352-4b35-b713-60351f56afbd" providerId="ADAL" clId="{121B3E88-C8E7-4600-B4A4-3E65BB803D64}" dt="2021-07-01T08:26:38.676" v="586" actId="165"/>
          <ac:grpSpMkLst>
            <pc:docMk/>
            <pc:sldMk cId="731297326" sldId="270"/>
            <ac:grpSpMk id="432" creationId="{EAF97BDC-67FA-4B42-86E1-DE7EB68FCC68}"/>
          </ac:grpSpMkLst>
        </pc:grpChg>
        <pc:grpChg chg="add mod ord">
          <ac:chgData name="Manasweeta Angane" userId="05da2731-9352-4b35-b713-60351f56afbd" providerId="ADAL" clId="{121B3E88-C8E7-4600-B4A4-3E65BB803D64}" dt="2021-07-01T10:15:37.783" v="1774" actId="1076"/>
          <ac:grpSpMkLst>
            <pc:docMk/>
            <pc:sldMk cId="731297326" sldId="270"/>
            <ac:grpSpMk id="461" creationId="{045AAB12-B6F8-418F-85E8-396F141E0BD4}"/>
          </ac:grpSpMkLst>
        </pc:grpChg>
        <pc:grpChg chg="add del mod ord">
          <ac:chgData name="Manasweeta Angane" userId="05da2731-9352-4b35-b713-60351f56afbd" providerId="ADAL" clId="{121B3E88-C8E7-4600-B4A4-3E65BB803D64}" dt="2021-07-01T10:15:44.067" v="1776" actId="478"/>
          <ac:grpSpMkLst>
            <pc:docMk/>
            <pc:sldMk cId="731297326" sldId="270"/>
            <ac:grpSpMk id="465" creationId="{36F29113-B253-439E-9C0E-2C0035D2AC74}"/>
          </ac:grpSpMkLst>
        </pc:grpChg>
        <pc:grpChg chg="add mod ord">
          <ac:chgData name="Manasweeta Angane" userId="05da2731-9352-4b35-b713-60351f56afbd" providerId="ADAL" clId="{121B3E88-C8E7-4600-B4A4-3E65BB803D64}" dt="2021-07-01T10:26:52.594" v="1850" actId="1076"/>
          <ac:grpSpMkLst>
            <pc:docMk/>
            <pc:sldMk cId="731297326" sldId="270"/>
            <ac:grpSpMk id="468" creationId="{0398E5EB-9386-4EA9-A3F0-2AAC9E33DFB1}"/>
          </ac:grpSpMkLst>
        </pc:grpChg>
        <pc:grpChg chg="add del mod ord">
          <ac:chgData name="Manasweeta Angane" userId="05da2731-9352-4b35-b713-60351f56afbd" providerId="ADAL" clId="{121B3E88-C8E7-4600-B4A4-3E65BB803D64}" dt="2021-07-01T10:45:35.456" v="1936" actId="478"/>
          <ac:grpSpMkLst>
            <pc:docMk/>
            <pc:sldMk cId="731297326" sldId="270"/>
            <ac:grpSpMk id="471" creationId="{D2C89A2D-A0F2-4166-8199-3CBF68FAEBC8}"/>
          </ac:grpSpMkLst>
        </pc:grpChg>
        <pc:grpChg chg="add mod ord">
          <ac:chgData name="Manasweeta Angane" userId="05da2731-9352-4b35-b713-60351f56afbd" providerId="ADAL" clId="{121B3E88-C8E7-4600-B4A4-3E65BB803D64}" dt="2021-07-01T20:05:37.626" v="2416" actId="1076"/>
          <ac:grpSpMkLst>
            <pc:docMk/>
            <pc:sldMk cId="731297326" sldId="270"/>
            <ac:grpSpMk id="474" creationId="{F639CF5E-C3BC-4BA8-A5DF-90FBE9CC83C0}"/>
          </ac:grpSpMkLst>
        </pc:grpChg>
        <pc:grpChg chg="add mod ord">
          <ac:chgData name="Manasweeta Angane" userId="05da2731-9352-4b35-b713-60351f56afbd" providerId="ADAL" clId="{121B3E88-C8E7-4600-B4A4-3E65BB803D64}" dt="2021-07-01T10:52:33.982" v="2007" actId="164"/>
          <ac:grpSpMkLst>
            <pc:docMk/>
            <pc:sldMk cId="731297326" sldId="270"/>
            <ac:grpSpMk id="477" creationId="{B4556DE6-24E4-4687-8CA2-AEF996396216}"/>
          </ac:grpSpMkLst>
        </pc:grpChg>
        <pc:grpChg chg="add mod">
          <ac:chgData name="Manasweeta Angane" userId="05da2731-9352-4b35-b713-60351f56afbd" providerId="ADAL" clId="{121B3E88-C8E7-4600-B4A4-3E65BB803D64}" dt="2021-07-01T11:23:59.852" v="2198" actId="1076"/>
          <ac:grpSpMkLst>
            <pc:docMk/>
            <pc:sldMk cId="731297326" sldId="270"/>
            <ac:grpSpMk id="480" creationId="{CE891513-D3C2-4AE7-BFC6-67ECD9176300}"/>
          </ac:grpSpMkLst>
        </pc:grpChg>
        <pc:grpChg chg="add mod">
          <ac:chgData name="Manasweeta Angane" userId="05da2731-9352-4b35-b713-60351f56afbd" providerId="ADAL" clId="{121B3E88-C8E7-4600-B4A4-3E65BB803D64}" dt="2021-07-01T09:13:34.224" v="1436" actId="1076"/>
          <ac:grpSpMkLst>
            <pc:docMk/>
            <pc:sldMk cId="731297326" sldId="270"/>
            <ac:grpSpMk id="483" creationId="{E563B09B-E8DC-462C-93CD-D8327771D4CE}"/>
          </ac:grpSpMkLst>
        </pc:grpChg>
        <pc:grpChg chg="add mod ord">
          <ac:chgData name="Manasweeta Angane" userId="05da2731-9352-4b35-b713-60351f56afbd" providerId="ADAL" clId="{121B3E88-C8E7-4600-B4A4-3E65BB803D64}" dt="2021-07-01T09:31:30.247" v="1667" actId="167"/>
          <ac:grpSpMkLst>
            <pc:docMk/>
            <pc:sldMk cId="731297326" sldId="270"/>
            <ac:grpSpMk id="489" creationId="{E92A1D04-C12D-4BBF-BBAF-A67EDFD1F432}"/>
          </ac:grpSpMkLst>
        </pc:grpChg>
        <pc:grpChg chg="add del mod ord">
          <ac:chgData name="Manasweeta Angane" userId="05da2731-9352-4b35-b713-60351f56afbd" providerId="ADAL" clId="{121B3E88-C8E7-4600-B4A4-3E65BB803D64}" dt="2021-07-01T10:52:56.683" v="2013" actId="478"/>
          <ac:grpSpMkLst>
            <pc:docMk/>
            <pc:sldMk cId="731297326" sldId="270"/>
            <ac:grpSpMk id="492" creationId="{F2C7DC6C-348C-45E6-A8AC-86617FD36615}"/>
          </ac:grpSpMkLst>
        </pc:grpChg>
        <pc:grpChg chg="add del mod ord">
          <ac:chgData name="Manasweeta Angane" userId="05da2731-9352-4b35-b713-60351f56afbd" providerId="ADAL" clId="{121B3E88-C8E7-4600-B4A4-3E65BB803D64}" dt="2021-07-01T10:46:41.481" v="1945" actId="478"/>
          <ac:grpSpMkLst>
            <pc:docMk/>
            <pc:sldMk cId="731297326" sldId="270"/>
            <ac:grpSpMk id="495" creationId="{5AC2C5F5-C54C-454D-A758-71571A01309A}"/>
          </ac:grpSpMkLst>
        </pc:grpChg>
        <pc:grpChg chg="add mod ord">
          <ac:chgData name="Manasweeta Angane" userId="05da2731-9352-4b35-b713-60351f56afbd" providerId="ADAL" clId="{121B3E88-C8E7-4600-B4A4-3E65BB803D64}" dt="2021-07-01T11:26:33.402" v="2255" actId="1076"/>
          <ac:grpSpMkLst>
            <pc:docMk/>
            <pc:sldMk cId="731297326" sldId="270"/>
            <ac:grpSpMk id="498" creationId="{08269ABB-6C60-4B0E-8F0F-632D57A08E4E}"/>
          </ac:grpSpMkLst>
        </pc:grpChg>
        <pc:grpChg chg="add del mod">
          <ac:chgData name="Manasweeta Angane" userId="05da2731-9352-4b35-b713-60351f56afbd" providerId="ADAL" clId="{121B3E88-C8E7-4600-B4A4-3E65BB803D64}" dt="2021-07-01T11:26:42.099" v="2258" actId="478"/>
          <ac:grpSpMkLst>
            <pc:docMk/>
            <pc:sldMk cId="731297326" sldId="270"/>
            <ac:grpSpMk id="501" creationId="{0B8D8149-3050-48B7-9D7E-8B499FC38F6C}"/>
          </ac:grpSpMkLst>
        </pc:grpChg>
        <pc:grpChg chg="add mod">
          <ac:chgData name="Manasweeta Angane" userId="05da2731-9352-4b35-b713-60351f56afbd" providerId="ADAL" clId="{121B3E88-C8E7-4600-B4A4-3E65BB803D64}" dt="2021-07-01T10:45:16.251" v="1930" actId="164"/>
          <ac:grpSpMkLst>
            <pc:docMk/>
            <pc:sldMk cId="731297326" sldId="270"/>
            <ac:grpSpMk id="505" creationId="{DC01A938-D61A-4578-B8DF-5D2FFC0F510F}"/>
          </ac:grpSpMkLst>
        </pc:grpChg>
        <pc:grpChg chg="add mod ord">
          <ac:chgData name="Manasweeta Angane" userId="05da2731-9352-4b35-b713-60351f56afbd" providerId="ADAL" clId="{121B3E88-C8E7-4600-B4A4-3E65BB803D64}" dt="2021-07-01T10:38:59.230" v="1881" actId="14100"/>
          <ac:grpSpMkLst>
            <pc:docMk/>
            <pc:sldMk cId="731297326" sldId="270"/>
            <ac:grpSpMk id="512" creationId="{8E9BF768-F483-48BD-95F6-EC479D734922}"/>
          </ac:grpSpMkLst>
        </pc:grpChg>
        <pc:grpChg chg="add mod ord">
          <ac:chgData name="Manasweeta Angane" userId="05da2731-9352-4b35-b713-60351f56afbd" providerId="ADAL" clId="{121B3E88-C8E7-4600-B4A4-3E65BB803D64}" dt="2021-07-01T10:46:05.750" v="1941" actId="1076"/>
          <ac:grpSpMkLst>
            <pc:docMk/>
            <pc:sldMk cId="731297326" sldId="270"/>
            <ac:grpSpMk id="515" creationId="{C72B5716-6B55-4193-B1C8-F26B508BE8F1}"/>
          </ac:grpSpMkLst>
        </pc:grpChg>
        <pc:grpChg chg="add mod">
          <ac:chgData name="Manasweeta Angane" userId="05da2731-9352-4b35-b713-60351f56afbd" providerId="ADAL" clId="{121B3E88-C8E7-4600-B4A4-3E65BB803D64}" dt="2021-07-01T11:26:33.402" v="2255" actId="1076"/>
          <ac:grpSpMkLst>
            <pc:docMk/>
            <pc:sldMk cId="731297326" sldId="270"/>
            <ac:grpSpMk id="518" creationId="{9988ED7B-46D8-4708-8ED6-68C3BF8A7AC7}"/>
          </ac:grpSpMkLst>
        </pc:grpChg>
        <pc:grpChg chg="add mod ord">
          <ac:chgData name="Manasweeta Angane" userId="05da2731-9352-4b35-b713-60351f56afbd" providerId="ADAL" clId="{121B3E88-C8E7-4600-B4A4-3E65BB803D64}" dt="2021-07-01T10:45:46.925" v="1940" actId="167"/>
          <ac:grpSpMkLst>
            <pc:docMk/>
            <pc:sldMk cId="731297326" sldId="270"/>
            <ac:grpSpMk id="522" creationId="{413888F3-470F-4C04-81A4-9DFA2D54CFFD}"/>
          </ac:grpSpMkLst>
        </pc:grpChg>
        <pc:grpChg chg="mod">
          <ac:chgData name="Manasweeta Angane" userId="05da2731-9352-4b35-b713-60351f56afbd" providerId="ADAL" clId="{121B3E88-C8E7-4600-B4A4-3E65BB803D64}" dt="2021-07-01T10:45:20.715" v="1931"/>
          <ac:grpSpMkLst>
            <pc:docMk/>
            <pc:sldMk cId="731297326" sldId="270"/>
            <ac:grpSpMk id="523" creationId="{9311F78B-1B5E-42FF-9F89-62509B12CBF8}"/>
          </ac:grpSpMkLst>
        </pc:grpChg>
        <pc:grpChg chg="add mod">
          <ac:chgData name="Manasweeta Angane" userId="05da2731-9352-4b35-b713-60351f56afbd" providerId="ADAL" clId="{121B3E88-C8E7-4600-B4A4-3E65BB803D64}" dt="2021-07-01T11:26:33.402" v="2255" actId="1076"/>
          <ac:grpSpMkLst>
            <pc:docMk/>
            <pc:sldMk cId="731297326" sldId="270"/>
            <ac:grpSpMk id="527" creationId="{FCB2B27E-AF52-4C3F-81B0-A9D6D5616F05}"/>
          </ac:grpSpMkLst>
        </pc:grpChg>
        <pc:grpChg chg="add mod">
          <ac:chgData name="Manasweeta Angane" userId="05da2731-9352-4b35-b713-60351f56afbd" providerId="ADAL" clId="{121B3E88-C8E7-4600-B4A4-3E65BB803D64}" dt="2021-07-01T10:53:25.325" v="2016" actId="1076"/>
          <ac:grpSpMkLst>
            <pc:docMk/>
            <pc:sldMk cId="731297326" sldId="270"/>
            <ac:grpSpMk id="530" creationId="{FB10A85E-2063-4725-B5C2-B7FCFB8C614C}"/>
          </ac:grpSpMkLst>
        </pc:grpChg>
        <pc:grpChg chg="mod">
          <ac:chgData name="Manasweeta Angane" userId="05da2731-9352-4b35-b713-60351f56afbd" providerId="ADAL" clId="{121B3E88-C8E7-4600-B4A4-3E65BB803D64}" dt="2021-07-01T10:52:37.245" v="2008"/>
          <ac:grpSpMkLst>
            <pc:docMk/>
            <pc:sldMk cId="731297326" sldId="270"/>
            <ac:grpSpMk id="531" creationId="{1118136E-2758-472D-82D1-50EECC208175}"/>
          </ac:grpSpMkLst>
        </pc:grpChg>
        <pc:grpChg chg="add mod">
          <ac:chgData name="Manasweeta Angane" userId="05da2731-9352-4b35-b713-60351f56afbd" providerId="ADAL" clId="{121B3E88-C8E7-4600-B4A4-3E65BB803D64}" dt="2021-07-01T10:54:12.245" v="2017"/>
          <ac:grpSpMkLst>
            <pc:docMk/>
            <pc:sldMk cId="731297326" sldId="270"/>
            <ac:grpSpMk id="535" creationId="{C1BF51FD-33DD-486B-96F2-4060E43C9B31}"/>
          </ac:grpSpMkLst>
        </pc:grpChg>
        <pc:grpChg chg="mod">
          <ac:chgData name="Manasweeta Angane" userId="05da2731-9352-4b35-b713-60351f56afbd" providerId="ADAL" clId="{121B3E88-C8E7-4600-B4A4-3E65BB803D64}" dt="2021-07-01T10:54:12.245" v="2017"/>
          <ac:grpSpMkLst>
            <pc:docMk/>
            <pc:sldMk cId="731297326" sldId="270"/>
            <ac:grpSpMk id="536" creationId="{480EFA45-FE8C-4C44-8BD3-E0CC07C7E260}"/>
          </ac:grpSpMkLst>
        </pc:grpChg>
        <pc:grpChg chg="add del mod topLvl">
          <ac:chgData name="Manasweeta Angane" userId="05da2731-9352-4b35-b713-60351f56afbd" providerId="ADAL" clId="{121B3E88-C8E7-4600-B4A4-3E65BB803D64}" dt="2021-07-01T11:33:33.665" v="2278" actId="478"/>
          <ac:grpSpMkLst>
            <pc:docMk/>
            <pc:sldMk cId="731297326" sldId="270"/>
            <ac:grpSpMk id="540" creationId="{B1441B86-889D-4096-BAD4-9268CDB00AB3}"/>
          </ac:grpSpMkLst>
        </pc:grpChg>
        <pc:grpChg chg="del mod">
          <ac:chgData name="Manasweeta Angane" userId="05da2731-9352-4b35-b713-60351f56afbd" providerId="ADAL" clId="{121B3E88-C8E7-4600-B4A4-3E65BB803D64}" dt="2021-07-01T11:33:39.535" v="2281" actId="478"/>
          <ac:grpSpMkLst>
            <pc:docMk/>
            <pc:sldMk cId="731297326" sldId="270"/>
            <ac:grpSpMk id="541" creationId="{B8F27B5B-09FB-4F00-B037-0B9A602D8CA2}"/>
          </ac:grpSpMkLst>
        </pc:grpChg>
        <pc:picChg chg="del">
          <ac:chgData name="Manasweeta Angane" userId="05da2731-9352-4b35-b713-60351f56afbd" providerId="ADAL" clId="{121B3E88-C8E7-4600-B4A4-3E65BB803D64}" dt="2021-07-01T07:53:25.570" v="8" actId="478"/>
          <ac:picMkLst>
            <pc:docMk/>
            <pc:sldMk cId="731297326" sldId="270"/>
            <ac:picMk id="63" creationId="{FFD12E96-C47E-4680-A42F-BE0666A83820}"/>
          </ac:picMkLst>
        </pc:picChg>
        <pc:picChg chg="del">
          <ac:chgData name="Manasweeta Angane" userId="05da2731-9352-4b35-b713-60351f56afbd" providerId="ADAL" clId="{121B3E88-C8E7-4600-B4A4-3E65BB803D64}" dt="2021-07-01T07:53:30.202" v="13" actId="478"/>
          <ac:picMkLst>
            <pc:docMk/>
            <pc:sldMk cId="731297326" sldId="270"/>
            <ac:picMk id="69" creationId="{268A7AD0-ED0E-4F7B-BF30-7C92EAE07824}"/>
          </ac:picMkLst>
        </pc:picChg>
        <pc:picChg chg="del">
          <ac:chgData name="Manasweeta Angane" userId="05da2731-9352-4b35-b713-60351f56afbd" providerId="ADAL" clId="{121B3E88-C8E7-4600-B4A4-3E65BB803D64}" dt="2021-07-01T07:53:29.228" v="12" actId="478"/>
          <ac:picMkLst>
            <pc:docMk/>
            <pc:sldMk cId="731297326" sldId="270"/>
            <ac:picMk id="70" creationId="{A1F40D6A-62A0-4AB5-A38C-5F8C48038D5F}"/>
          </ac:picMkLst>
        </pc:picChg>
        <pc:picChg chg="del">
          <ac:chgData name="Manasweeta Angane" userId="05da2731-9352-4b35-b713-60351f56afbd" providerId="ADAL" clId="{121B3E88-C8E7-4600-B4A4-3E65BB803D64}" dt="2021-07-01T07:53:32.254" v="16" actId="478"/>
          <ac:picMkLst>
            <pc:docMk/>
            <pc:sldMk cId="731297326" sldId="270"/>
            <ac:picMk id="72" creationId="{2BCC4350-1E5A-4493-8AE6-B6D367DEA6CA}"/>
          </ac:picMkLst>
        </pc:picChg>
        <pc:picChg chg="del">
          <ac:chgData name="Manasweeta Angane" userId="05da2731-9352-4b35-b713-60351f56afbd" providerId="ADAL" clId="{121B3E88-C8E7-4600-B4A4-3E65BB803D64}" dt="2021-07-01T07:53:27.756" v="10" actId="478"/>
          <ac:picMkLst>
            <pc:docMk/>
            <pc:sldMk cId="731297326" sldId="270"/>
            <ac:picMk id="77" creationId="{4779BC41-8D4B-4FB2-9398-15C115C9E715}"/>
          </ac:picMkLst>
        </pc:picChg>
        <pc:picChg chg="del">
          <ac:chgData name="Manasweeta Angane" userId="05da2731-9352-4b35-b713-60351f56afbd" providerId="ADAL" clId="{121B3E88-C8E7-4600-B4A4-3E65BB803D64}" dt="2021-07-01T07:53:28.369" v="11" actId="478"/>
          <ac:picMkLst>
            <pc:docMk/>
            <pc:sldMk cId="731297326" sldId="270"/>
            <ac:picMk id="78" creationId="{5DF0BCBC-AA1A-428F-BF1D-EE5CECD40EA9}"/>
          </ac:picMkLst>
        </pc:picChg>
        <pc:picChg chg="del">
          <ac:chgData name="Manasweeta Angane" userId="05da2731-9352-4b35-b713-60351f56afbd" providerId="ADAL" clId="{121B3E88-C8E7-4600-B4A4-3E65BB803D64}" dt="2021-07-01T07:53:35.212" v="20" actId="478"/>
          <ac:picMkLst>
            <pc:docMk/>
            <pc:sldMk cId="731297326" sldId="270"/>
            <ac:picMk id="119" creationId="{8266D51C-5B54-453C-9811-ECCC4E2CB7E9}"/>
          </ac:picMkLst>
        </pc:picChg>
        <pc:picChg chg="del">
          <ac:chgData name="Manasweeta Angane" userId="05da2731-9352-4b35-b713-60351f56afbd" providerId="ADAL" clId="{121B3E88-C8E7-4600-B4A4-3E65BB803D64}" dt="2021-07-01T07:53:31.498" v="15" actId="478"/>
          <ac:picMkLst>
            <pc:docMk/>
            <pc:sldMk cId="731297326" sldId="270"/>
            <ac:picMk id="121" creationId="{A699C752-50E6-4562-8EDA-0EBA9EBD69E6}"/>
          </ac:picMkLst>
        </pc:picChg>
        <pc:picChg chg="del">
          <ac:chgData name="Manasweeta Angane" userId="05da2731-9352-4b35-b713-60351f56afbd" providerId="ADAL" clId="{121B3E88-C8E7-4600-B4A4-3E65BB803D64}" dt="2021-07-01T07:53:30.865" v="14" actId="478"/>
          <ac:picMkLst>
            <pc:docMk/>
            <pc:sldMk cId="731297326" sldId="270"/>
            <ac:picMk id="122" creationId="{AA92527F-8035-4404-84E0-045D401AC189}"/>
          </ac:picMkLst>
        </pc:picChg>
        <pc:picChg chg="del">
          <ac:chgData name="Manasweeta Angane" userId="05da2731-9352-4b35-b713-60351f56afbd" providerId="ADAL" clId="{121B3E88-C8E7-4600-B4A4-3E65BB803D64}" dt="2021-07-01T07:53:34.499" v="19" actId="478"/>
          <ac:picMkLst>
            <pc:docMk/>
            <pc:sldMk cId="731297326" sldId="270"/>
            <ac:picMk id="123" creationId="{C987DDFD-24DA-47A5-9660-AF7B1759AFD5}"/>
          </ac:picMkLst>
        </pc:picChg>
        <pc:picChg chg="del">
          <ac:chgData name="Manasweeta Angane" userId="05da2731-9352-4b35-b713-60351f56afbd" providerId="ADAL" clId="{121B3E88-C8E7-4600-B4A4-3E65BB803D64}" dt="2021-07-01T07:53:33.777" v="18" actId="478"/>
          <ac:picMkLst>
            <pc:docMk/>
            <pc:sldMk cId="731297326" sldId="270"/>
            <ac:picMk id="124" creationId="{48E1E8CB-8408-49CE-96CB-394C698E5CE0}"/>
          </ac:picMkLst>
        </pc:picChg>
        <pc:picChg chg="del">
          <ac:chgData name="Manasweeta Angane" userId="05da2731-9352-4b35-b713-60351f56afbd" providerId="ADAL" clId="{121B3E88-C8E7-4600-B4A4-3E65BB803D64}" dt="2021-07-01T07:53:22.413" v="4" actId="478"/>
          <ac:picMkLst>
            <pc:docMk/>
            <pc:sldMk cId="731297326" sldId="270"/>
            <ac:picMk id="125" creationId="{9B17EEF0-E6EF-4DA2-A876-AAB9102F32DA}"/>
          </ac:picMkLst>
        </pc:picChg>
        <pc:picChg chg="del">
          <ac:chgData name="Manasweeta Angane" userId="05da2731-9352-4b35-b713-60351f56afbd" providerId="ADAL" clId="{121B3E88-C8E7-4600-B4A4-3E65BB803D64}" dt="2021-07-01T07:53:20.653" v="2" actId="478"/>
          <ac:picMkLst>
            <pc:docMk/>
            <pc:sldMk cId="731297326" sldId="270"/>
            <ac:picMk id="131" creationId="{DBE65334-0AF4-44BE-84C1-2F1B7E2B7E11}"/>
          </ac:picMkLst>
        </pc:picChg>
        <pc:picChg chg="mod">
          <ac:chgData name="Manasweeta Angane" userId="05da2731-9352-4b35-b713-60351f56afbd" providerId="ADAL" clId="{121B3E88-C8E7-4600-B4A4-3E65BB803D64}" dt="2021-07-01T07:55:14.715" v="52" actId="164"/>
          <ac:picMkLst>
            <pc:docMk/>
            <pc:sldMk cId="731297326" sldId="270"/>
            <ac:picMk id="134" creationId="{1AAE73B2-3CC1-4E46-88BF-98C2BA5DFDDA}"/>
          </ac:picMkLst>
        </pc:picChg>
        <pc:picChg chg="mod">
          <ac:chgData name="Manasweeta Angane" userId="05da2731-9352-4b35-b713-60351f56afbd" providerId="ADAL" clId="{121B3E88-C8E7-4600-B4A4-3E65BB803D64}" dt="2021-07-01T07:55:14.715" v="52" actId="164"/>
          <ac:picMkLst>
            <pc:docMk/>
            <pc:sldMk cId="731297326" sldId="270"/>
            <ac:picMk id="138" creationId="{14B5D621-3D3E-4E90-9782-A09FA99034BB}"/>
          </ac:picMkLst>
        </pc:picChg>
        <pc:picChg chg="mod">
          <ac:chgData name="Manasweeta Angane" userId="05da2731-9352-4b35-b713-60351f56afbd" providerId="ADAL" clId="{121B3E88-C8E7-4600-B4A4-3E65BB803D64}" dt="2021-07-01T07:55:14.715" v="52" actId="164"/>
          <ac:picMkLst>
            <pc:docMk/>
            <pc:sldMk cId="731297326" sldId="270"/>
            <ac:picMk id="139" creationId="{867668E3-DD1B-41B2-8157-E2F31B222C8F}"/>
          </ac:picMkLst>
        </pc:picChg>
        <pc:picChg chg="mod">
          <ac:chgData name="Manasweeta Angane" userId="05da2731-9352-4b35-b713-60351f56afbd" providerId="ADAL" clId="{121B3E88-C8E7-4600-B4A4-3E65BB803D64}" dt="2021-07-01T07:55:14.715" v="52" actId="164"/>
          <ac:picMkLst>
            <pc:docMk/>
            <pc:sldMk cId="731297326" sldId="270"/>
            <ac:picMk id="140" creationId="{20731E7F-4B41-4D4B-A9BF-D16138E35581}"/>
          </ac:picMkLst>
        </pc:picChg>
        <pc:picChg chg="mod">
          <ac:chgData name="Manasweeta Angane" userId="05da2731-9352-4b35-b713-60351f56afbd" providerId="ADAL" clId="{121B3E88-C8E7-4600-B4A4-3E65BB803D64}" dt="2021-07-01T07:55:14.715" v="52" actId="164"/>
          <ac:picMkLst>
            <pc:docMk/>
            <pc:sldMk cId="731297326" sldId="270"/>
            <ac:picMk id="149" creationId="{9B8ECC95-3A15-4925-B66F-72742253F7E8}"/>
          </ac:picMkLst>
        </pc:picChg>
        <pc:picChg chg="mod">
          <ac:chgData name="Manasweeta Angane" userId="05da2731-9352-4b35-b713-60351f56afbd" providerId="ADAL" clId="{121B3E88-C8E7-4600-B4A4-3E65BB803D64}" dt="2021-07-01T07:55:14.715" v="52" actId="164"/>
          <ac:picMkLst>
            <pc:docMk/>
            <pc:sldMk cId="731297326" sldId="270"/>
            <ac:picMk id="151" creationId="{36C210C2-0906-4B4C-8D1C-0E57AFE79DF5}"/>
          </ac:picMkLst>
        </pc:picChg>
        <pc:picChg chg="mod">
          <ac:chgData name="Manasweeta Angane" userId="05da2731-9352-4b35-b713-60351f56afbd" providerId="ADAL" clId="{121B3E88-C8E7-4600-B4A4-3E65BB803D64}" dt="2021-07-01T07:55:14.715" v="52" actId="164"/>
          <ac:picMkLst>
            <pc:docMk/>
            <pc:sldMk cId="731297326" sldId="270"/>
            <ac:picMk id="174" creationId="{D7F30796-E66E-460A-8569-276C54760AEC}"/>
          </ac:picMkLst>
        </pc:picChg>
        <pc:picChg chg="mod">
          <ac:chgData name="Manasweeta Angane" userId="05da2731-9352-4b35-b713-60351f56afbd" providerId="ADAL" clId="{121B3E88-C8E7-4600-B4A4-3E65BB803D64}" dt="2021-07-01T07:55:14.715" v="52" actId="164"/>
          <ac:picMkLst>
            <pc:docMk/>
            <pc:sldMk cId="731297326" sldId="270"/>
            <ac:picMk id="181" creationId="{A37EA6FC-3453-4A17-A71D-FF8AEB09B7EA}"/>
          </ac:picMkLst>
        </pc:picChg>
        <pc:picChg chg="del">
          <ac:chgData name="Manasweeta Angane" userId="05da2731-9352-4b35-b713-60351f56afbd" providerId="ADAL" clId="{121B3E88-C8E7-4600-B4A4-3E65BB803D64}" dt="2021-07-01T07:53:39.913" v="23" actId="478"/>
          <ac:picMkLst>
            <pc:docMk/>
            <pc:sldMk cId="731297326" sldId="270"/>
            <ac:picMk id="184" creationId="{44CBA7AE-9683-4271-95D5-42146FD29FA3}"/>
          </ac:picMkLst>
        </pc:picChg>
        <pc:picChg chg="del">
          <ac:chgData name="Manasweeta Angane" userId="05da2731-9352-4b35-b713-60351f56afbd" providerId="ADAL" clId="{121B3E88-C8E7-4600-B4A4-3E65BB803D64}" dt="2021-07-01T07:53:38.550" v="22" actId="478"/>
          <ac:picMkLst>
            <pc:docMk/>
            <pc:sldMk cId="731297326" sldId="270"/>
            <ac:picMk id="185" creationId="{16077B0F-A71E-4664-A47D-F7F0F96450B8}"/>
          </ac:picMkLst>
        </pc:picChg>
        <pc:picChg chg="del">
          <ac:chgData name="Manasweeta Angane" userId="05da2731-9352-4b35-b713-60351f56afbd" providerId="ADAL" clId="{121B3E88-C8E7-4600-B4A4-3E65BB803D64}" dt="2021-07-01T07:53:24.987" v="7" actId="478"/>
          <ac:picMkLst>
            <pc:docMk/>
            <pc:sldMk cId="731297326" sldId="270"/>
            <ac:picMk id="186" creationId="{E60D3C60-3F19-4D03-B141-21F64ADBF9D9}"/>
          </ac:picMkLst>
        </pc:picChg>
        <pc:picChg chg="del">
          <ac:chgData name="Manasweeta Angane" userId="05da2731-9352-4b35-b713-60351f56afbd" providerId="ADAL" clId="{121B3E88-C8E7-4600-B4A4-3E65BB803D64}" dt="2021-07-01T07:53:23.842" v="6" actId="478"/>
          <ac:picMkLst>
            <pc:docMk/>
            <pc:sldMk cId="731297326" sldId="270"/>
            <ac:picMk id="187" creationId="{2DE3345E-9A1E-4E63-99FE-3BC353969FAB}"/>
          </ac:picMkLst>
        </pc:picChg>
        <pc:picChg chg="mod topLvl">
          <ac:chgData name="Manasweeta Angane" userId="05da2731-9352-4b35-b713-60351f56afbd" providerId="ADAL" clId="{121B3E88-C8E7-4600-B4A4-3E65BB803D64}" dt="2021-07-01T11:32:12.196" v="2273" actId="164"/>
          <ac:picMkLst>
            <pc:docMk/>
            <pc:sldMk cId="731297326" sldId="270"/>
            <ac:picMk id="189" creationId="{B11C9A79-94DF-47BA-A5F0-92B982AEBF7A}"/>
          </ac:picMkLst>
        </pc:picChg>
        <pc:picChg chg="del">
          <ac:chgData name="Manasweeta Angane" userId="05da2731-9352-4b35-b713-60351f56afbd" providerId="ADAL" clId="{121B3E88-C8E7-4600-B4A4-3E65BB803D64}" dt="2021-07-01T07:53:56.963" v="41" actId="478"/>
          <ac:picMkLst>
            <pc:docMk/>
            <pc:sldMk cId="731297326" sldId="270"/>
            <ac:picMk id="190" creationId="{C2248900-FCCB-4DE3-A82E-1CAD0BD99706}"/>
          </ac:picMkLst>
        </pc:picChg>
        <pc:picChg chg="mod">
          <ac:chgData name="Manasweeta Angane" userId="05da2731-9352-4b35-b713-60351f56afbd" providerId="ADAL" clId="{121B3E88-C8E7-4600-B4A4-3E65BB803D64}" dt="2021-07-01T07:55:14.715" v="52" actId="164"/>
          <ac:picMkLst>
            <pc:docMk/>
            <pc:sldMk cId="731297326" sldId="270"/>
            <ac:picMk id="193" creationId="{63E276F9-9C63-459B-A18A-04E1E4F154AA}"/>
          </ac:picMkLst>
        </pc:picChg>
        <pc:picChg chg="add del">
          <ac:chgData name="Manasweeta Angane" userId="05da2731-9352-4b35-b713-60351f56afbd" providerId="ADAL" clId="{121B3E88-C8E7-4600-B4A4-3E65BB803D64}" dt="2021-07-01T08:05:57.467" v="427" actId="478"/>
          <ac:picMkLst>
            <pc:docMk/>
            <pc:sldMk cId="731297326" sldId="270"/>
            <ac:picMk id="194" creationId="{B9971A82-52E5-4A82-8477-3C09C1DB41F6}"/>
          </ac:picMkLst>
        </pc:picChg>
        <pc:picChg chg="del">
          <ac:chgData name="Manasweeta Angane" userId="05da2731-9352-4b35-b713-60351f56afbd" providerId="ADAL" clId="{121B3E88-C8E7-4600-B4A4-3E65BB803D64}" dt="2021-07-01T07:53:51.981" v="35" actId="478"/>
          <ac:picMkLst>
            <pc:docMk/>
            <pc:sldMk cId="731297326" sldId="270"/>
            <ac:picMk id="196" creationId="{2DE3EBCE-4FD8-418E-B139-C26C93951337}"/>
          </ac:picMkLst>
        </pc:picChg>
        <pc:picChg chg="mod topLvl">
          <ac:chgData name="Manasweeta Angane" userId="05da2731-9352-4b35-b713-60351f56afbd" providerId="ADAL" clId="{121B3E88-C8E7-4600-B4A4-3E65BB803D64}" dt="2021-07-01T10:15:37.783" v="1774" actId="1076"/>
          <ac:picMkLst>
            <pc:docMk/>
            <pc:sldMk cId="731297326" sldId="270"/>
            <ac:picMk id="198" creationId="{EB68730C-3C85-4D93-B6FD-2059DD55B14D}"/>
          </ac:picMkLst>
        </pc:picChg>
        <pc:picChg chg="mod topLvl">
          <ac:chgData name="Manasweeta Angane" userId="05da2731-9352-4b35-b713-60351f56afbd" providerId="ADAL" clId="{121B3E88-C8E7-4600-B4A4-3E65BB803D64}" dt="2021-07-02T09:18:39.931" v="2453"/>
          <ac:picMkLst>
            <pc:docMk/>
            <pc:sldMk cId="731297326" sldId="270"/>
            <ac:picMk id="200" creationId="{0B22D3E6-F673-438B-95D8-2F8190AABC41}"/>
          </ac:picMkLst>
        </pc:picChg>
        <pc:picChg chg="mod topLvl">
          <ac:chgData name="Manasweeta Angane" userId="05da2731-9352-4b35-b713-60351f56afbd" providerId="ADAL" clId="{121B3E88-C8E7-4600-B4A4-3E65BB803D64}" dt="2021-07-01T10:52:00.312" v="2006" actId="1076"/>
          <ac:picMkLst>
            <pc:docMk/>
            <pc:sldMk cId="731297326" sldId="270"/>
            <ac:picMk id="201" creationId="{53270373-300D-49B0-AF1A-48B4C3B3FF9E}"/>
          </ac:picMkLst>
        </pc:picChg>
        <pc:picChg chg="mod">
          <ac:chgData name="Manasweeta Angane" userId="05da2731-9352-4b35-b713-60351f56afbd" providerId="ADAL" clId="{121B3E88-C8E7-4600-B4A4-3E65BB803D64}" dt="2021-07-01T07:55:14.715" v="52" actId="164"/>
          <ac:picMkLst>
            <pc:docMk/>
            <pc:sldMk cId="731297326" sldId="270"/>
            <ac:picMk id="212" creationId="{12749F58-3DD6-4A5C-99B1-FC003D364485}"/>
          </ac:picMkLst>
        </pc:picChg>
        <pc:picChg chg="mod topLvl">
          <ac:chgData name="Manasweeta Angane" userId="05da2731-9352-4b35-b713-60351f56afbd" providerId="ADAL" clId="{121B3E88-C8E7-4600-B4A4-3E65BB803D64}" dt="2021-07-01T10:11:34.761" v="1722" actId="167"/>
          <ac:picMkLst>
            <pc:docMk/>
            <pc:sldMk cId="731297326" sldId="270"/>
            <ac:picMk id="213" creationId="{C840D78D-F425-4B86-8089-D1BD64C32B49}"/>
          </ac:picMkLst>
        </pc:picChg>
        <pc:picChg chg="mod topLvl">
          <ac:chgData name="Manasweeta Angane" userId="05da2731-9352-4b35-b713-60351f56afbd" providerId="ADAL" clId="{121B3E88-C8E7-4600-B4A4-3E65BB803D64}" dt="2021-07-01T08:26:29.972" v="584" actId="165"/>
          <ac:picMkLst>
            <pc:docMk/>
            <pc:sldMk cId="731297326" sldId="270"/>
            <ac:picMk id="214" creationId="{53AB74A0-8EAB-4C13-9943-B609B03FD94B}"/>
          </ac:picMkLst>
        </pc:picChg>
        <pc:picChg chg="mod topLvl">
          <ac:chgData name="Manasweeta Angane" userId="05da2731-9352-4b35-b713-60351f56afbd" providerId="ADAL" clId="{121B3E88-C8E7-4600-B4A4-3E65BB803D64}" dt="2021-07-01T08:26:29.972" v="584" actId="165"/>
          <ac:picMkLst>
            <pc:docMk/>
            <pc:sldMk cId="731297326" sldId="270"/>
            <ac:picMk id="215" creationId="{228EA555-CC1E-488E-9D93-309962FD983B}"/>
          </ac:picMkLst>
        </pc:picChg>
        <pc:picChg chg="del">
          <ac:chgData name="Manasweeta Angane" userId="05da2731-9352-4b35-b713-60351f56afbd" providerId="ADAL" clId="{121B3E88-C8E7-4600-B4A4-3E65BB803D64}" dt="2021-07-01T07:53:55.899" v="40" actId="478"/>
          <ac:picMkLst>
            <pc:docMk/>
            <pc:sldMk cId="731297326" sldId="270"/>
            <ac:picMk id="217" creationId="{F9DC3CEB-2580-4994-A6F8-C559A027C2FE}"/>
          </ac:picMkLst>
        </pc:picChg>
        <pc:picChg chg="del mod topLvl">
          <ac:chgData name="Manasweeta Angane" userId="05da2731-9352-4b35-b713-60351f56afbd" providerId="ADAL" clId="{121B3E88-C8E7-4600-B4A4-3E65BB803D64}" dt="2021-07-01T11:24:24.977" v="2203" actId="478"/>
          <ac:picMkLst>
            <pc:docMk/>
            <pc:sldMk cId="731297326" sldId="270"/>
            <ac:picMk id="220" creationId="{EF004D17-D2AB-4EE4-8CC3-5C77DF1D9581}"/>
          </ac:picMkLst>
        </pc:picChg>
        <pc:picChg chg="mod topLvl">
          <ac:chgData name="Manasweeta Angane" userId="05da2731-9352-4b35-b713-60351f56afbd" providerId="ADAL" clId="{121B3E88-C8E7-4600-B4A4-3E65BB803D64}" dt="2021-07-01T08:26:44.009" v="587" actId="165"/>
          <ac:picMkLst>
            <pc:docMk/>
            <pc:sldMk cId="731297326" sldId="270"/>
            <ac:picMk id="221" creationId="{31A98ABF-9560-45E8-91D7-5A68C504CDDD}"/>
          </ac:picMkLst>
        </pc:picChg>
        <pc:picChg chg="mod">
          <ac:chgData name="Manasweeta Angane" userId="05da2731-9352-4b35-b713-60351f56afbd" providerId="ADAL" clId="{121B3E88-C8E7-4600-B4A4-3E65BB803D64}" dt="2021-07-01T08:48:34.627" v="953" actId="1076"/>
          <ac:picMkLst>
            <pc:docMk/>
            <pc:sldMk cId="731297326" sldId="270"/>
            <ac:picMk id="222" creationId="{BF1088EE-93EE-4C45-86BA-FFA26CFD1689}"/>
          </ac:picMkLst>
        </pc:picChg>
        <pc:picChg chg="mod topLvl">
          <ac:chgData name="Manasweeta Angane" userId="05da2731-9352-4b35-b713-60351f56afbd" providerId="ADAL" clId="{121B3E88-C8E7-4600-B4A4-3E65BB803D64}" dt="2021-07-01T08:48:25.924" v="952" actId="1076"/>
          <ac:picMkLst>
            <pc:docMk/>
            <pc:sldMk cId="731297326" sldId="270"/>
            <ac:picMk id="223" creationId="{B0FAFCE0-8C4D-40AC-8F91-8F4B698A810C}"/>
          </ac:picMkLst>
        </pc:picChg>
        <pc:picChg chg="mod topLvl">
          <ac:chgData name="Manasweeta Angane" userId="05da2731-9352-4b35-b713-60351f56afbd" providerId="ADAL" clId="{121B3E88-C8E7-4600-B4A4-3E65BB803D64}" dt="2021-07-01T08:26:44.009" v="587" actId="165"/>
          <ac:picMkLst>
            <pc:docMk/>
            <pc:sldMk cId="731297326" sldId="270"/>
            <ac:picMk id="224" creationId="{7AB5EBDC-9044-471F-A464-EF5F9558CFAC}"/>
          </ac:picMkLst>
        </pc:picChg>
        <pc:picChg chg="mod topLvl">
          <ac:chgData name="Manasweeta Angane" userId="05da2731-9352-4b35-b713-60351f56afbd" providerId="ADAL" clId="{121B3E88-C8E7-4600-B4A4-3E65BB803D64}" dt="2021-07-01T08:26:44.009" v="587" actId="165"/>
          <ac:picMkLst>
            <pc:docMk/>
            <pc:sldMk cId="731297326" sldId="270"/>
            <ac:picMk id="225" creationId="{81619C0F-11DF-497F-A57A-BDC8B2DADB86}"/>
          </ac:picMkLst>
        </pc:picChg>
        <pc:picChg chg="del mod topLvl">
          <ac:chgData name="Manasweeta Angane" userId="05da2731-9352-4b35-b713-60351f56afbd" providerId="ADAL" clId="{121B3E88-C8E7-4600-B4A4-3E65BB803D64}" dt="2021-07-01T09:12:38.552" v="1430" actId="478"/>
          <ac:picMkLst>
            <pc:docMk/>
            <pc:sldMk cId="731297326" sldId="270"/>
            <ac:picMk id="226" creationId="{90B5B416-A754-46FC-B7D8-F35B2E7B21E6}"/>
          </ac:picMkLst>
        </pc:picChg>
        <pc:picChg chg="mod ord topLvl">
          <ac:chgData name="Manasweeta Angane" userId="05da2731-9352-4b35-b713-60351f56afbd" providerId="ADAL" clId="{121B3E88-C8E7-4600-B4A4-3E65BB803D64}" dt="2021-07-01T11:24:16.177" v="2202" actId="1076"/>
          <ac:picMkLst>
            <pc:docMk/>
            <pc:sldMk cId="731297326" sldId="270"/>
            <ac:picMk id="227" creationId="{158FE962-8BAB-4125-89DC-4B272109865F}"/>
          </ac:picMkLst>
        </pc:picChg>
        <pc:picChg chg="del mod topLvl">
          <ac:chgData name="Manasweeta Angane" userId="05da2731-9352-4b35-b713-60351f56afbd" providerId="ADAL" clId="{121B3E88-C8E7-4600-B4A4-3E65BB803D64}" dt="2021-07-01T08:48:18.145" v="950" actId="478"/>
          <ac:picMkLst>
            <pc:docMk/>
            <pc:sldMk cId="731297326" sldId="270"/>
            <ac:picMk id="228" creationId="{E14D988B-DD49-40A1-AB86-6237733AB56D}"/>
          </ac:picMkLst>
        </pc:picChg>
        <pc:picChg chg="mod">
          <ac:chgData name="Manasweeta Angane" userId="05da2731-9352-4b35-b713-60351f56afbd" providerId="ADAL" clId="{121B3E88-C8E7-4600-B4A4-3E65BB803D64}" dt="2021-07-01T08:26:44.009" v="587" actId="165"/>
          <ac:picMkLst>
            <pc:docMk/>
            <pc:sldMk cId="731297326" sldId="270"/>
            <ac:picMk id="229" creationId="{A359B232-0D23-4C6F-A78D-F2BD8F034F51}"/>
          </ac:picMkLst>
        </pc:picChg>
        <pc:picChg chg="mod">
          <ac:chgData name="Manasweeta Angane" userId="05da2731-9352-4b35-b713-60351f56afbd" providerId="ADAL" clId="{121B3E88-C8E7-4600-B4A4-3E65BB803D64}" dt="2021-07-01T08:26:44.009" v="587" actId="165"/>
          <ac:picMkLst>
            <pc:docMk/>
            <pc:sldMk cId="731297326" sldId="270"/>
            <ac:picMk id="230" creationId="{C0309CA0-63B6-4E26-8498-86A8D1F9E27B}"/>
          </ac:picMkLst>
        </pc:picChg>
        <pc:picChg chg="del">
          <ac:chgData name="Manasweeta Angane" userId="05da2731-9352-4b35-b713-60351f56afbd" providerId="ADAL" clId="{121B3E88-C8E7-4600-B4A4-3E65BB803D64}" dt="2021-07-01T07:53:45.086" v="27" actId="478"/>
          <ac:picMkLst>
            <pc:docMk/>
            <pc:sldMk cId="731297326" sldId="270"/>
            <ac:picMk id="234" creationId="{7514EF54-E505-4B02-B2E8-878A7FE465B5}"/>
          </ac:picMkLst>
        </pc:picChg>
        <pc:picChg chg="del">
          <ac:chgData name="Manasweeta Angane" userId="05da2731-9352-4b35-b713-60351f56afbd" providerId="ADAL" clId="{121B3E88-C8E7-4600-B4A4-3E65BB803D64}" dt="2021-07-01T07:53:46.161" v="28" actId="478"/>
          <ac:picMkLst>
            <pc:docMk/>
            <pc:sldMk cId="731297326" sldId="270"/>
            <ac:picMk id="235" creationId="{E885F960-C465-40F5-B6B0-67697EDEF8D8}"/>
          </ac:picMkLst>
        </pc:picChg>
        <pc:picChg chg="del">
          <ac:chgData name="Manasweeta Angane" userId="05da2731-9352-4b35-b713-60351f56afbd" providerId="ADAL" clId="{121B3E88-C8E7-4600-B4A4-3E65BB803D64}" dt="2021-07-01T07:53:51.169" v="34" actId="478"/>
          <ac:picMkLst>
            <pc:docMk/>
            <pc:sldMk cId="731297326" sldId="270"/>
            <ac:picMk id="236" creationId="{6ED2C0A5-922E-44F9-983E-2A18E576C3B1}"/>
          </ac:picMkLst>
        </pc:picChg>
        <pc:picChg chg="del">
          <ac:chgData name="Manasweeta Angane" userId="05da2731-9352-4b35-b713-60351f56afbd" providerId="ADAL" clId="{121B3E88-C8E7-4600-B4A4-3E65BB803D64}" dt="2021-07-01T07:53:52.861" v="36" actId="478"/>
          <ac:picMkLst>
            <pc:docMk/>
            <pc:sldMk cId="731297326" sldId="270"/>
            <ac:picMk id="237" creationId="{619E0113-5715-4A52-9EFA-B2E43A687B9F}"/>
          </ac:picMkLst>
        </pc:picChg>
        <pc:picChg chg="del">
          <ac:chgData name="Manasweeta Angane" userId="05da2731-9352-4b35-b713-60351f56afbd" providerId="ADAL" clId="{121B3E88-C8E7-4600-B4A4-3E65BB803D64}" dt="2021-07-01T07:53:50.489" v="33" actId="478"/>
          <ac:picMkLst>
            <pc:docMk/>
            <pc:sldMk cId="731297326" sldId="270"/>
            <ac:picMk id="238" creationId="{4931CE14-871B-4E42-B99B-BE18636A194D}"/>
          </ac:picMkLst>
        </pc:picChg>
        <pc:picChg chg="del">
          <ac:chgData name="Manasweeta Angane" userId="05da2731-9352-4b35-b713-60351f56afbd" providerId="ADAL" clId="{121B3E88-C8E7-4600-B4A4-3E65BB803D64}" dt="2021-07-01T07:54:04.188" v="46" actId="478"/>
          <ac:picMkLst>
            <pc:docMk/>
            <pc:sldMk cId="731297326" sldId="270"/>
            <ac:picMk id="239" creationId="{F4735D94-4974-42AD-9A10-D2A1F9342A23}"/>
          </ac:picMkLst>
        </pc:picChg>
        <pc:picChg chg="del">
          <ac:chgData name="Manasweeta Angane" userId="05da2731-9352-4b35-b713-60351f56afbd" providerId="ADAL" clId="{121B3E88-C8E7-4600-B4A4-3E65BB803D64}" dt="2021-07-01T07:54:04.947" v="47" actId="478"/>
          <ac:picMkLst>
            <pc:docMk/>
            <pc:sldMk cId="731297326" sldId="270"/>
            <ac:picMk id="240" creationId="{55D28B78-090F-4C58-92D2-181CED2659DF}"/>
          </ac:picMkLst>
        </pc:picChg>
        <pc:picChg chg="del">
          <ac:chgData name="Manasweeta Angane" userId="05da2731-9352-4b35-b713-60351f56afbd" providerId="ADAL" clId="{121B3E88-C8E7-4600-B4A4-3E65BB803D64}" dt="2021-07-01T07:53:54.443" v="38" actId="478"/>
          <ac:picMkLst>
            <pc:docMk/>
            <pc:sldMk cId="731297326" sldId="270"/>
            <ac:picMk id="241" creationId="{8BE1D218-A849-4EC1-B3FF-0D35A53739DB}"/>
          </ac:picMkLst>
        </pc:picChg>
        <pc:picChg chg="del">
          <ac:chgData name="Manasweeta Angane" userId="05da2731-9352-4b35-b713-60351f56afbd" providerId="ADAL" clId="{121B3E88-C8E7-4600-B4A4-3E65BB803D64}" dt="2021-07-01T07:53:49.029" v="31" actId="478"/>
          <ac:picMkLst>
            <pc:docMk/>
            <pc:sldMk cId="731297326" sldId="270"/>
            <ac:picMk id="242" creationId="{46145A29-98CB-4528-9614-B3F879A428F6}"/>
          </ac:picMkLst>
        </pc:picChg>
        <pc:picChg chg="del">
          <ac:chgData name="Manasweeta Angane" userId="05da2731-9352-4b35-b713-60351f56afbd" providerId="ADAL" clId="{121B3E88-C8E7-4600-B4A4-3E65BB803D64}" dt="2021-07-01T07:53:49.801" v="32" actId="478"/>
          <ac:picMkLst>
            <pc:docMk/>
            <pc:sldMk cId="731297326" sldId="270"/>
            <ac:picMk id="243" creationId="{F8BF0B79-51A1-4624-9BE1-65BB95FA05DD}"/>
          </ac:picMkLst>
        </pc:picChg>
        <pc:picChg chg="del">
          <ac:chgData name="Manasweeta Angane" userId="05da2731-9352-4b35-b713-60351f56afbd" providerId="ADAL" clId="{121B3E88-C8E7-4600-B4A4-3E65BB803D64}" dt="2021-07-01T07:53:59.876" v="44" actId="478"/>
          <ac:picMkLst>
            <pc:docMk/>
            <pc:sldMk cId="731297326" sldId="270"/>
            <ac:picMk id="244" creationId="{4D475953-91C0-417B-B710-B45AF3089BB9}"/>
          </ac:picMkLst>
        </pc:picChg>
        <pc:picChg chg="del">
          <ac:chgData name="Manasweeta Angane" userId="05da2731-9352-4b35-b713-60351f56afbd" providerId="ADAL" clId="{121B3E88-C8E7-4600-B4A4-3E65BB803D64}" dt="2021-07-01T07:53:55.186" v="39" actId="478"/>
          <ac:picMkLst>
            <pc:docMk/>
            <pc:sldMk cId="731297326" sldId="270"/>
            <ac:picMk id="245" creationId="{3232672C-7472-4AD6-9224-FD79276F159F}"/>
          </ac:picMkLst>
        </pc:picChg>
        <pc:picChg chg="del">
          <ac:chgData name="Manasweeta Angane" userId="05da2731-9352-4b35-b713-60351f56afbd" providerId="ADAL" clId="{121B3E88-C8E7-4600-B4A4-3E65BB803D64}" dt="2021-07-01T07:53:41.390" v="24" actId="478"/>
          <ac:picMkLst>
            <pc:docMk/>
            <pc:sldMk cId="731297326" sldId="270"/>
            <ac:picMk id="246" creationId="{DE1BC34D-8EE0-4376-B575-6508EE40E2AE}"/>
          </ac:picMkLst>
        </pc:picChg>
        <pc:picChg chg="del">
          <ac:chgData name="Manasweeta Angane" userId="05da2731-9352-4b35-b713-60351f56afbd" providerId="ADAL" clId="{121B3E88-C8E7-4600-B4A4-3E65BB803D64}" dt="2021-07-01T07:54:05.859" v="48" actId="478"/>
          <ac:picMkLst>
            <pc:docMk/>
            <pc:sldMk cId="731297326" sldId="270"/>
            <ac:picMk id="248" creationId="{07FA9B60-9B6A-4CFA-9168-DA489C1FE954}"/>
          </ac:picMkLst>
        </pc:picChg>
        <pc:picChg chg="del">
          <ac:chgData name="Manasweeta Angane" userId="05da2731-9352-4b35-b713-60351f56afbd" providerId="ADAL" clId="{121B3E88-C8E7-4600-B4A4-3E65BB803D64}" dt="2021-07-01T07:54:02.300" v="45" actId="478"/>
          <ac:picMkLst>
            <pc:docMk/>
            <pc:sldMk cId="731297326" sldId="270"/>
            <ac:picMk id="249" creationId="{CDB6468B-E253-46DA-8D83-5352AC33FA69}"/>
          </ac:picMkLst>
        </pc:picChg>
        <pc:picChg chg="del">
          <ac:chgData name="Manasweeta Angane" userId="05da2731-9352-4b35-b713-60351f56afbd" providerId="ADAL" clId="{121B3E88-C8E7-4600-B4A4-3E65BB803D64}" dt="2021-07-01T07:54:06.897" v="49" actId="478"/>
          <ac:picMkLst>
            <pc:docMk/>
            <pc:sldMk cId="731297326" sldId="270"/>
            <ac:picMk id="250" creationId="{505C7445-6CFB-40B9-9A9B-DF259A7C9A47}"/>
          </ac:picMkLst>
        </pc:picChg>
        <pc:picChg chg="del">
          <ac:chgData name="Manasweeta Angane" userId="05da2731-9352-4b35-b713-60351f56afbd" providerId="ADAL" clId="{121B3E88-C8E7-4600-B4A4-3E65BB803D64}" dt="2021-07-01T07:53:57.915" v="42" actId="478"/>
          <ac:picMkLst>
            <pc:docMk/>
            <pc:sldMk cId="731297326" sldId="270"/>
            <ac:picMk id="251" creationId="{8290E1F9-C71A-4553-90C7-975F8F67B7E2}"/>
          </ac:picMkLst>
        </pc:picChg>
        <pc:picChg chg="del">
          <ac:chgData name="Manasweeta Angane" userId="05da2731-9352-4b35-b713-60351f56afbd" providerId="ADAL" clId="{121B3E88-C8E7-4600-B4A4-3E65BB803D64}" dt="2021-07-01T07:53:44.164" v="26" actId="478"/>
          <ac:picMkLst>
            <pc:docMk/>
            <pc:sldMk cId="731297326" sldId="270"/>
            <ac:picMk id="252" creationId="{2F3976E9-5ECC-49D2-BBC5-FF30611D0C94}"/>
          </ac:picMkLst>
        </pc:picChg>
        <pc:picChg chg="del">
          <ac:chgData name="Manasweeta Angane" userId="05da2731-9352-4b35-b713-60351f56afbd" providerId="ADAL" clId="{121B3E88-C8E7-4600-B4A4-3E65BB803D64}" dt="2021-07-01T07:53:53.812" v="37" actId="478"/>
          <ac:picMkLst>
            <pc:docMk/>
            <pc:sldMk cId="731297326" sldId="270"/>
            <ac:picMk id="253" creationId="{0631E0FC-CD44-44A3-B4EB-9C3B4EF43B32}"/>
          </ac:picMkLst>
        </pc:picChg>
        <pc:picChg chg="del">
          <ac:chgData name="Manasweeta Angane" userId="05da2731-9352-4b35-b713-60351f56afbd" providerId="ADAL" clId="{121B3E88-C8E7-4600-B4A4-3E65BB803D64}" dt="2021-07-01T07:53:59.060" v="43" actId="478"/>
          <ac:picMkLst>
            <pc:docMk/>
            <pc:sldMk cId="731297326" sldId="270"/>
            <ac:picMk id="255" creationId="{78BFD560-0935-4892-A304-740D83F2A423}"/>
          </ac:picMkLst>
        </pc:picChg>
        <pc:picChg chg="mod">
          <ac:chgData name="Manasweeta Angane" userId="05da2731-9352-4b35-b713-60351f56afbd" providerId="ADAL" clId="{121B3E88-C8E7-4600-B4A4-3E65BB803D64}" dt="2021-07-01T08:27:01.752" v="589" actId="478"/>
          <ac:picMkLst>
            <pc:docMk/>
            <pc:sldMk cId="731297326" sldId="270"/>
            <ac:picMk id="262" creationId="{7D6A6D59-2E76-4FAA-88FC-4F5CE5F6FB07}"/>
          </ac:picMkLst>
        </pc:picChg>
        <pc:picChg chg="mod">
          <ac:chgData name="Manasweeta Angane" userId="05da2731-9352-4b35-b713-60351f56afbd" providerId="ADAL" clId="{121B3E88-C8E7-4600-B4A4-3E65BB803D64}" dt="2021-07-01T08:48:34.627" v="953" actId="1076"/>
          <ac:picMkLst>
            <pc:docMk/>
            <pc:sldMk cId="731297326" sldId="270"/>
            <ac:picMk id="263" creationId="{04D7A89E-8A74-421C-9D58-F4358F24CD89}"/>
          </ac:picMkLst>
        </pc:picChg>
        <pc:picChg chg="del mod">
          <ac:chgData name="Manasweeta Angane" userId="05da2731-9352-4b35-b713-60351f56afbd" providerId="ADAL" clId="{121B3E88-C8E7-4600-B4A4-3E65BB803D64}" dt="2021-07-01T08:32:29.628" v="697" actId="478"/>
          <ac:picMkLst>
            <pc:docMk/>
            <pc:sldMk cId="731297326" sldId="270"/>
            <ac:picMk id="265" creationId="{A1A26873-88DF-45A8-A0CC-689EABC54E8E}"/>
          </ac:picMkLst>
        </pc:picChg>
        <pc:picChg chg="mod">
          <ac:chgData name="Manasweeta Angane" userId="05da2731-9352-4b35-b713-60351f56afbd" providerId="ADAL" clId="{121B3E88-C8E7-4600-B4A4-3E65BB803D64}" dt="2021-07-01T08:26:44.009" v="587" actId="165"/>
          <ac:picMkLst>
            <pc:docMk/>
            <pc:sldMk cId="731297326" sldId="270"/>
            <ac:picMk id="267" creationId="{E85C2ED9-54F2-438F-9858-2B12ECCBC61D}"/>
          </ac:picMkLst>
        </pc:picChg>
        <pc:picChg chg="mod">
          <ac:chgData name="Manasweeta Angane" userId="05da2731-9352-4b35-b713-60351f56afbd" providerId="ADAL" clId="{121B3E88-C8E7-4600-B4A4-3E65BB803D64}" dt="2021-07-01T08:26:44.009" v="587" actId="165"/>
          <ac:picMkLst>
            <pc:docMk/>
            <pc:sldMk cId="731297326" sldId="270"/>
            <ac:picMk id="268" creationId="{C5AD5D19-DF13-44E4-AA51-1AAC8773A374}"/>
          </ac:picMkLst>
        </pc:picChg>
        <pc:picChg chg="add del">
          <ac:chgData name="Manasweeta Angane" userId="05da2731-9352-4b35-b713-60351f56afbd" providerId="ADAL" clId="{121B3E88-C8E7-4600-B4A4-3E65BB803D64}" dt="2021-07-01T08:05:56.403" v="426" actId="478"/>
          <ac:picMkLst>
            <pc:docMk/>
            <pc:sldMk cId="731297326" sldId="270"/>
            <ac:picMk id="270" creationId="{973936B9-0109-4590-924D-C4CDC29D6492}"/>
          </ac:picMkLst>
        </pc:picChg>
        <pc:picChg chg="del mod topLvl">
          <ac:chgData name="Manasweeta Angane" userId="05da2731-9352-4b35-b713-60351f56afbd" providerId="ADAL" clId="{121B3E88-C8E7-4600-B4A4-3E65BB803D64}" dt="2021-07-02T09:17:19.368" v="2446" actId="478"/>
          <ac:picMkLst>
            <pc:docMk/>
            <pc:sldMk cId="731297326" sldId="270"/>
            <ac:picMk id="271" creationId="{ECF28697-050D-4095-9DF5-29843C60E17B}"/>
          </ac:picMkLst>
        </pc:picChg>
        <pc:picChg chg="mod topLvl">
          <ac:chgData name="Manasweeta Angane" userId="05da2731-9352-4b35-b713-60351f56afbd" providerId="ADAL" clId="{121B3E88-C8E7-4600-B4A4-3E65BB803D64}" dt="2021-07-02T09:17:15.356" v="2445" actId="165"/>
          <ac:picMkLst>
            <pc:docMk/>
            <pc:sldMk cId="731297326" sldId="270"/>
            <ac:picMk id="272" creationId="{545B610B-B3C8-4CCA-AD5C-3C535B8FDFC6}"/>
          </ac:picMkLst>
        </pc:picChg>
        <pc:picChg chg="mod topLvl">
          <ac:chgData name="Manasweeta Angane" userId="05da2731-9352-4b35-b713-60351f56afbd" providerId="ADAL" clId="{121B3E88-C8E7-4600-B4A4-3E65BB803D64}" dt="2021-07-02T04:01:29.317" v="2443" actId="164"/>
          <ac:picMkLst>
            <pc:docMk/>
            <pc:sldMk cId="731297326" sldId="270"/>
            <ac:picMk id="273" creationId="{D6340B7F-1D4E-4C1E-979A-0C916198FD84}"/>
          </ac:picMkLst>
        </pc:picChg>
        <pc:picChg chg="mod topLvl">
          <ac:chgData name="Manasweeta Angane" userId="05da2731-9352-4b35-b713-60351f56afbd" providerId="ADAL" clId="{121B3E88-C8E7-4600-B4A4-3E65BB803D64}" dt="2021-07-02T04:01:29.317" v="2443" actId="164"/>
          <ac:picMkLst>
            <pc:docMk/>
            <pc:sldMk cId="731297326" sldId="270"/>
            <ac:picMk id="274" creationId="{CC4B4AF3-240E-4F84-BD0B-77503E5E0E99}"/>
          </ac:picMkLst>
        </pc:picChg>
        <pc:picChg chg="mod topLvl">
          <ac:chgData name="Manasweeta Angane" userId="05da2731-9352-4b35-b713-60351f56afbd" providerId="ADAL" clId="{121B3E88-C8E7-4600-B4A4-3E65BB803D64}" dt="2021-07-01T08:26:44.009" v="587" actId="165"/>
          <ac:picMkLst>
            <pc:docMk/>
            <pc:sldMk cId="731297326" sldId="270"/>
            <ac:picMk id="275" creationId="{FE08B307-244F-44B3-BF15-991EC0B3D278}"/>
          </ac:picMkLst>
        </pc:picChg>
        <pc:picChg chg="mod">
          <ac:chgData name="Manasweeta Angane" userId="05da2731-9352-4b35-b713-60351f56afbd" providerId="ADAL" clId="{121B3E88-C8E7-4600-B4A4-3E65BB803D64}" dt="2021-07-01T08:27:01.752" v="589" actId="478"/>
          <ac:picMkLst>
            <pc:docMk/>
            <pc:sldMk cId="731297326" sldId="270"/>
            <ac:picMk id="276" creationId="{D822BAC7-C329-4CA8-8AA6-E0DF9312B58E}"/>
          </ac:picMkLst>
        </pc:picChg>
        <pc:picChg chg="mod">
          <ac:chgData name="Manasweeta Angane" userId="05da2731-9352-4b35-b713-60351f56afbd" providerId="ADAL" clId="{121B3E88-C8E7-4600-B4A4-3E65BB803D64}" dt="2021-07-01T08:31:19.580" v="666" actId="478"/>
          <ac:picMkLst>
            <pc:docMk/>
            <pc:sldMk cId="731297326" sldId="270"/>
            <ac:picMk id="278" creationId="{5BCAFCAC-D31D-428B-9190-7083D9648037}"/>
          </ac:picMkLst>
        </pc:picChg>
        <pc:picChg chg="mod">
          <ac:chgData name="Manasweeta Angane" userId="05da2731-9352-4b35-b713-60351f56afbd" providerId="ADAL" clId="{121B3E88-C8E7-4600-B4A4-3E65BB803D64}" dt="2021-07-01T08:31:19.580" v="666" actId="478"/>
          <ac:picMkLst>
            <pc:docMk/>
            <pc:sldMk cId="731297326" sldId="270"/>
            <ac:picMk id="279" creationId="{5C82B6CA-4DF9-4893-86AA-EB687472FB82}"/>
          </ac:picMkLst>
        </pc:picChg>
        <pc:picChg chg="del mod">
          <ac:chgData name="Manasweeta Angane" userId="05da2731-9352-4b35-b713-60351f56afbd" providerId="ADAL" clId="{121B3E88-C8E7-4600-B4A4-3E65BB803D64}" dt="2021-07-01T08:31:19.580" v="666" actId="478"/>
          <ac:picMkLst>
            <pc:docMk/>
            <pc:sldMk cId="731297326" sldId="270"/>
            <ac:picMk id="280" creationId="{CB4BEAFB-1E45-4E7E-B521-EAFC4F3D5683}"/>
          </ac:picMkLst>
        </pc:picChg>
        <pc:picChg chg="del mod topLvl">
          <ac:chgData name="Manasweeta Angane" userId="05da2731-9352-4b35-b713-60351f56afbd" providerId="ADAL" clId="{121B3E88-C8E7-4600-B4A4-3E65BB803D64}" dt="2021-07-01T08:26:49.907" v="588" actId="478"/>
          <ac:picMkLst>
            <pc:docMk/>
            <pc:sldMk cId="731297326" sldId="270"/>
            <ac:picMk id="281" creationId="{8E085FDD-E6E4-4B1E-919E-16B1C439F51A}"/>
          </ac:picMkLst>
        </pc:picChg>
        <pc:picChg chg="mod topLvl">
          <ac:chgData name="Manasweeta Angane" userId="05da2731-9352-4b35-b713-60351f56afbd" providerId="ADAL" clId="{121B3E88-C8E7-4600-B4A4-3E65BB803D64}" dt="2021-07-01T08:26:44.009" v="587" actId="165"/>
          <ac:picMkLst>
            <pc:docMk/>
            <pc:sldMk cId="731297326" sldId="270"/>
            <ac:picMk id="282" creationId="{840D2313-2C60-4D11-979A-51691A1DACB8}"/>
          </ac:picMkLst>
        </pc:picChg>
        <pc:picChg chg="mod topLvl">
          <ac:chgData name="Manasweeta Angane" userId="05da2731-9352-4b35-b713-60351f56afbd" providerId="ADAL" clId="{121B3E88-C8E7-4600-B4A4-3E65BB803D64}" dt="2021-07-01T08:26:44.009" v="587" actId="165"/>
          <ac:picMkLst>
            <pc:docMk/>
            <pc:sldMk cId="731297326" sldId="270"/>
            <ac:picMk id="283" creationId="{D3BB7085-F3A0-4BB6-BAD9-C2F67AE51B20}"/>
          </ac:picMkLst>
        </pc:picChg>
        <pc:picChg chg="del mod">
          <ac:chgData name="Manasweeta Angane" userId="05da2731-9352-4b35-b713-60351f56afbd" providerId="ADAL" clId="{121B3E88-C8E7-4600-B4A4-3E65BB803D64}" dt="2021-07-01T08:27:09.516" v="590" actId="478"/>
          <ac:picMkLst>
            <pc:docMk/>
            <pc:sldMk cId="731297326" sldId="270"/>
            <ac:picMk id="284" creationId="{D2F295A0-AD69-4A04-A8CE-64D4835DA202}"/>
          </ac:picMkLst>
        </pc:picChg>
        <pc:picChg chg="del mod">
          <ac:chgData name="Manasweeta Angane" userId="05da2731-9352-4b35-b713-60351f56afbd" providerId="ADAL" clId="{121B3E88-C8E7-4600-B4A4-3E65BB803D64}" dt="2021-07-01T08:27:11.915" v="591" actId="478"/>
          <ac:picMkLst>
            <pc:docMk/>
            <pc:sldMk cId="731297326" sldId="270"/>
            <ac:picMk id="285" creationId="{BA1D07B4-733B-4911-AEF9-D5EE8A9CFB3C}"/>
          </ac:picMkLst>
        </pc:picChg>
        <pc:picChg chg="mod">
          <ac:chgData name="Manasweeta Angane" userId="05da2731-9352-4b35-b713-60351f56afbd" providerId="ADAL" clId="{121B3E88-C8E7-4600-B4A4-3E65BB803D64}" dt="2021-07-01T08:27:14.999" v="592" actId="1076"/>
          <ac:picMkLst>
            <pc:docMk/>
            <pc:sldMk cId="731297326" sldId="270"/>
            <ac:picMk id="286" creationId="{23B29AA8-C6C1-41FB-8519-6C4218177209}"/>
          </ac:picMkLst>
        </pc:picChg>
        <pc:picChg chg="mod">
          <ac:chgData name="Manasweeta Angane" userId="05da2731-9352-4b35-b713-60351f56afbd" providerId="ADAL" clId="{121B3E88-C8E7-4600-B4A4-3E65BB803D64}" dt="2021-07-01T08:27:14.999" v="592" actId="1076"/>
          <ac:picMkLst>
            <pc:docMk/>
            <pc:sldMk cId="731297326" sldId="270"/>
            <ac:picMk id="287" creationId="{133B6AE4-A70D-4AD5-9273-5BEE5C00032F}"/>
          </ac:picMkLst>
        </pc:picChg>
        <pc:picChg chg="del mod">
          <ac:chgData name="Manasweeta Angane" userId="05da2731-9352-4b35-b713-60351f56afbd" providerId="ADAL" clId="{121B3E88-C8E7-4600-B4A4-3E65BB803D64}" dt="2021-07-01T08:27:01.752" v="589" actId="478"/>
          <ac:picMkLst>
            <pc:docMk/>
            <pc:sldMk cId="731297326" sldId="270"/>
            <ac:picMk id="288" creationId="{93FB0006-E53A-4308-ADAC-A569DCC53EC4}"/>
          </ac:picMkLst>
        </pc:picChg>
        <pc:picChg chg="mod topLvl">
          <ac:chgData name="Manasweeta Angane" userId="05da2731-9352-4b35-b713-60351f56afbd" providerId="ADAL" clId="{121B3E88-C8E7-4600-B4A4-3E65BB803D64}" dt="2021-07-01T08:26:44.009" v="587" actId="165"/>
          <ac:picMkLst>
            <pc:docMk/>
            <pc:sldMk cId="731297326" sldId="270"/>
            <ac:picMk id="289" creationId="{D7881C87-87DF-47C3-8AFA-CF3F121E72D7}"/>
          </ac:picMkLst>
        </pc:picChg>
        <pc:picChg chg="mod">
          <ac:chgData name="Manasweeta Angane" userId="05da2731-9352-4b35-b713-60351f56afbd" providerId="ADAL" clId="{121B3E88-C8E7-4600-B4A4-3E65BB803D64}" dt="2021-07-01T08:26:44.009" v="587" actId="165"/>
          <ac:picMkLst>
            <pc:docMk/>
            <pc:sldMk cId="731297326" sldId="270"/>
            <ac:picMk id="291" creationId="{7B81DAB5-88C6-4220-AFE8-FC695EB6FA6E}"/>
          </ac:picMkLst>
        </pc:picChg>
        <pc:picChg chg="mod">
          <ac:chgData name="Manasweeta Angane" userId="05da2731-9352-4b35-b713-60351f56afbd" providerId="ADAL" clId="{121B3E88-C8E7-4600-B4A4-3E65BB803D64}" dt="2021-07-01T08:26:44.009" v="587" actId="165"/>
          <ac:picMkLst>
            <pc:docMk/>
            <pc:sldMk cId="731297326" sldId="270"/>
            <ac:picMk id="292" creationId="{371822F2-48C4-4484-A7AF-4B05732C63D1}"/>
          </ac:picMkLst>
        </pc:picChg>
        <pc:picChg chg="del">
          <ac:chgData name="Manasweeta Angane" userId="05da2731-9352-4b35-b713-60351f56afbd" providerId="ADAL" clId="{121B3E88-C8E7-4600-B4A4-3E65BB803D64}" dt="2021-07-01T07:53:42.299" v="25" actId="478"/>
          <ac:picMkLst>
            <pc:docMk/>
            <pc:sldMk cId="731297326" sldId="270"/>
            <ac:picMk id="294" creationId="{8AEE1CFA-1D64-4B8B-B9F6-62F63B5FE641}"/>
          </ac:picMkLst>
        </pc:picChg>
        <pc:picChg chg="del mod topLvl">
          <ac:chgData name="Manasweeta Angane" userId="05da2731-9352-4b35-b713-60351f56afbd" providerId="ADAL" clId="{121B3E88-C8E7-4600-B4A4-3E65BB803D64}" dt="2021-07-01T07:59:57.244" v="175" actId="478"/>
          <ac:picMkLst>
            <pc:docMk/>
            <pc:sldMk cId="731297326" sldId="270"/>
            <ac:picMk id="297" creationId="{ABB70CE4-1ABD-4F4E-A600-778C8578EA74}"/>
          </ac:picMkLst>
        </pc:picChg>
        <pc:picChg chg="mod">
          <ac:chgData name="Manasweeta Angane" userId="05da2731-9352-4b35-b713-60351f56afbd" providerId="ADAL" clId="{121B3E88-C8E7-4600-B4A4-3E65BB803D64}" dt="2021-07-01T08:26:29.972" v="584" actId="165"/>
          <ac:picMkLst>
            <pc:docMk/>
            <pc:sldMk cId="731297326" sldId="270"/>
            <ac:picMk id="299" creationId="{FDD26A16-A5F3-4AFA-8CD9-EE1FCEA21BE4}"/>
          </ac:picMkLst>
        </pc:picChg>
        <pc:picChg chg="mod">
          <ac:chgData name="Manasweeta Angane" userId="05da2731-9352-4b35-b713-60351f56afbd" providerId="ADAL" clId="{121B3E88-C8E7-4600-B4A4-3E65BB803D64}" dt="2021-07-01T08:26:29.972" v="584" actId="165"/>
          <ac:picMkLst>
            <pc:docMk/>
            <pc:sldMk cId="731297326" sldId="270"/>
            <ac:picMk id="300" creationId="{7B1B6F71-3BE4-45E4-BF20-1BED133331BA}"/>
          </ac:picMkLst>
        </pc:picChg>
        <pc:picChg chg="mod">
          <ac:chgData name="Manasweeta Angane" userId="05da2731-9352-4b35-b713-60351f56afbd" providerId="ADAL" clId="{121B3E88-C8E7-4600-B4A4-3E65BB803D64}" dt="2021-07-01T08:26:29.972" v="584" actId="165"/>
          <ac:picMkLst>
            <pc:docMk/>
            <pc:sldMk cId="731297326" sldId="270"/>
            <ac:picMk id="301" creationId="{24B9B533-F12C-4F19-8DC2-74E2C84D875E}"/>
          </ac:picMkLst>
        </pc:picChg>
        <pc:picChg chg="add del mod topLvl">
          <ac:chgData name="Manasweeta Angane" userId="05da2731-9352-4b35-b713-60351f56afbd" providerId="ADAL" clId="{121B3E88-C8E7-4600-B4A4-3E65BB803D64}" dt="2021-07-01T08:55:36.137" v="1294" actId="478"/>
          <ac:picMkLst>
            <pc:docMk/>
            <pc:sldMk cId="731297326" sldId="270"/>
            <ac:picMk id="302" creationId="{C8AF1B1E-5EA8-4457-9A64-90DC57851BFD}"/>
          </ac:picMkLst>
        </pc:picChg>
        <pc:picChg chg="add del mod topLvl">
          <ac:chgData name="Manasweeta Angane" userId="05da2731-9352-4b35-b713-60351f56afbd" providerId="ADAL" clId="{121B3E88-C8E7-4600-B4A4-3E65BB803D64}" dt="2021-07-01T10:45:34.454" v="1935" actId="478"/>
          <ac:picMkLst>
            <pc:docMk/>
            <pc:sldMk cId="731297326" sldId="270"/>
            <ac:picMk id="303" creationId="{B49DAB67-FD39-43B2-8DF5-488B225052DD}"/>
          </ac:picMkLst>
        </pc:picChg>
        <pc:picChg chg="mod">
          <ac:chgData name="Manasweeta Angane" userId="05da2731-9352-4b35-b713-60351f56afbd" providerId="ADAL" clId="{121B3E88-C8E7-4600-B4A4-3E65BB803D64}" dt="2021-07-01T08:26:29.972" v="584" actId="165"/>
          <ac:picMkLst>
            <pc:docMk/>
            <pc:sldMk cId="731297326" sldId="270"/>
            <ac:picMk id="304" creationId="{6E011A5A-AEF8-490C-8C2A-ABA8F731B001}"/>
          </ac:picMkLst>
        </pc:picChg>
        <pc:picChg chg="mod">
          <ac:chgData name="Manasweeta Angane" userId="05da2731-9352-4b35-b713-60351f56afbd" providerId="ADAL" clId="{121B3E88-C8E7-4600-B4A4-3E65BB803D64}" dt="2021-07-01T08:26:29.972" v="584" actId="165"/>
          <ac:picMkLst>
            <pc:docMk/>
            <pc:sldMk cId="731297326" sldId="270"/>
            <ac:picMk id="305" creationId="{6DE194B1-C605-4CA4-824F-E81CA72B621A}"/>
          </ac:picMkLst>
        </pc:picChg>
        <pc:picChg chg="mod">
          <ac:chgData name="Manasweeta Angane" userId="05da2731-9352-4b35-b713-60351f56afbd" providerId="ADAL" clId="{121B3E88-C8E7-4600-B4A4-3E65BB803D64}" dt="2021-07-01T08:26:29.972" v="584" actId="165"/>
          <ac:picMkLst>
            <pc:docMk/>
            <pc:sldMk cId="731297326" sldId="270"/>
            <ac:picMk id="306" creationId="{3AA64238-4B5E-48BE-8035-7D23ABCB3E43}"/>
          </ac:picMkLst>
        </pc:picChg>
        <pc:picChg chg="mod">
          <ac:chgData name="Manasweeta Angane" userId="05da2731-9352-4b35-b713-60351f56afbd" providerId="ADAL" clId="{121B3E88-C8E7-4600-B4A4-3E65BB803D64}" dt="2021-07-01T08:26:29.972" v="584" actId="165"/>
          <ac:picMkLst>
            <pc:docMk/>
            <pc:sldMk cId="731297326" sldId="270"/>
            <ac:picMk id="307" creationId="{E8DFBEC1-734D-4F9D-8300-AC5752E66F95}"/>
          </ac:picMkLst>
        </pc:picChg>
        <pc:picChg chg="mod">
          <ac:chgData name="Manasweeta Angane" userId="05da2731-9352-4b35-b713-60351f56afbd" providerId="ADAL" clId="{121B3E88-C8E7-4600-B4A4-3E65BB803D64}" dt="2021-07-01T08:26:29.972" v="584" actId="165"/>
          <ac:picMkLst>
            <pc:docMk/>
            <pc:sldMk cId="731297326" sldId="270"/>
            <ac:picMk id="308" creationId="{29250DE0-807A-4C46-A92A-2F13175A7E57}"/>
          </ac:picMkLst>
        </pc:picChg>
        <pc:picChg chg="mod topLvl">
          <ac:chgData name="Manasweeta Angane" userId="05da2731-9352-4b35-b713-60351f56afbd" providerId="ADAL" clId="{121B3E88-C8E7-4600-B4A4-3E65BB803D64}" dt="2021-07-01T20:05:26.508" v="2415" actId="1076"/>
          <ac:picMkLst>
            <pc:docMk/>
            <pc:sldMk cId="731297326" sldId="270"/>
            <ac:picMk id="309" creationId="{E6327F5E-7580-4BB0-940C-DB969AB35F6D}"/>
          </ac:picMkLst>
        </pc:picChg>
        <pc:picChg chg="del mod topLvl">
          <ac:chgData name="Manasweeta Angane" userId="05da2731-9352-4b35-b713-60351f56afbd" providerId="ADAL" clId="{121B3E88-C8E7-4600-B4A4-3E65BB803D64}" dt="2021-07-01T08:27:55.075" v="602" actId="478"/>
          <ac:picMkLst>
            <pc:docMk/>
            <pc:sldMk cId="731297326" sldId="270"/>
            <ac:picMk id="310" creationId="{B9D46742-84E4-4C3F-AC21-45C464F0483D}"/>
          </ac:picMkLst>
        </pc:picChg>
        <pc:picChg chg="add del mod topLvl">
          <ac:chgData name="Manasweeta Angane" userId="05da2731-9352-4b35-b713-60351f56afbd" providerId="ADAL" clId="{121B3E88-C8E7-4600-B4A4-3E65BB803D64}" dt="2021-07-01T11:34:00.997" v="2283" actId="1076"/>
          <ac:picMkLst>
            <pc:docMk/>
            <pc:sldMk cId="731297326" sldId="270"/>
            <ac:picMk id="311" creationId="{8C65D60C-4F9F-4160-B757-17E4C613A7E3}"/>
          </ac:picMkLst>
        </pc:picChg>
        <pc:picChg chg="mod topLvl">
          <ac:chgData name="Manasweeta Angane" userId="05da2731-9352-4b35-b713-60351f56afbd" providerId="ADAL" clId="{121B3E88-C8E7-4600-B4A4-3E65BB803D64}" dt="2021-07-01T11:34:00.997" v="2283" actId="1076"/>
          <ac:picMkLst>
            <pc:docMk/>
            <pc:sldMk cId="731297326" sldId="270"/>
            <ac:picMk id="312" creationId="{AE96A26E-BA0E-45B2-AAFD-06C067B70756}"/>
          </ac:picMkLst>
        </pc:picChg>
        <pc:picChg chg="del mod">
          <ac:chgData name="Manasweeta Angane" userId="05da2731-9352-4b35-b713-60351f56afbd" providerId="ADAL" clId="{121B3E88-C8E7-4600-B4A4-3E65BB803D64}" dt="2021-07-01T10:58:43.530" v="2044" actId="478"/>
          <ac:picMkLst>
            <pc:docMk/>
            <pc:sldMk cId="731297326" sldId="270"/>
            <ac:picMk id="313" creationId="{43F727DE-64E1-4C7F-A61C-286054C35947}"/>
          </ac:picMkLst>
        </pc:picChg>
        <pc:picChg chg="mod">
          <ac:chgData name="Manasweeta Angane" userId="05da2731-9352-4b35-b713-60351f56afbd" providerId="ADAL" clId="{121B3E88-C8E7-4600-B4A4-3E65BB803D64}" dt="2021-07-02T03:59:37.845" v="2438" actId="1076"/>
          <ac:picMkLst>
            <pc:docMk/>
            <pc:sldMk cId="731297326" sldId="270"/>
            <ac:picMk id="314" creationId="{620043C6-5FB5-40CB-9754-5E6F7BE3E9F2}"/>
          </ac:picMkLst>
        </pc:picChg>
        <pc:picChg chg="mod">
          <ac:chgData name="Manasweeta Angane" userId="05da2731-9352-4b35-b713-60351f56afbd" providerId="ADAL" clId="{121B3E88-C8E7-4600-B4A4-3E65BB803D64}" dt="2021-07-02T03:59:37.845" v="2438" actId="1076"/>
          <ac:picMkLst>
            <pc:docMk/>
            <pc:sldMk cId="731297326" sldId="270"/>
            <ac:picMk id="315" creationId="{A8B22FB9-4815-4D4B-938C-6319ADDC1B08}"/>
          </ac:picMkLst>
        </pc:picChg>
        <pc:picChg chg="mod">
          <ac:chgData name="Manasweeta Angane" userId="05da2731-9352-4b35-b713-60351f56afbd" providerId="ADAL" clId="{121B3E88-C8E7-4600-B4A4-3E65BB803D64}" dt="2021-07-02T03:59:37.845" v="2438" actId="1076"/>
          <ac:picMkLst>
            <pc:docMk/>
            <pc:sldMk cId="731297326" sldId="270"/>
            <ac:picMk id="316" creationId="{6A4292B4-6367-48EF-8C47-06C24D1D648C}"/>
          </ac:picMkLst>
        </pc:picChg>
        <pc:picChg chg="mod">
          <ac:chgData name="Manasweeta Angane" userId="05da2731-9352-4b35-b713-60351f56afbd" providerId="ADAL" clId="{121B3E88-C8E7-4600-B4A4-3E65BB803D64}" dt="2021-07-01T11:24:11.779" v="2200" actId="1076"/>
          <ac:picMkLst>
            <pc:docMk/>
            <pc:sldMk cId="731297326" sldId="270"/>
            <ac:picMk id="317" creationId="{E47734C6-3580-4D03-B8B0-E2C6677D310D}"/>
          </ac:picMkLst>
        </pc:picChg>
        <pc:picChg chg="mod">
          <ac:chgData name="Manasweeta Angane" userId="05da2731-9352-4b35-b713-60351f56afbd" providerId="ADAL" clId="{121B3E88-C8E7-4600-B4A4-3E65BB803D64}" dt="2021-07-01T11:24:11.779" v="2200" actId="1076"/>
          <ac:picMkLst>
            <pc:docMk/>
            <pc:sldMk cId="731297326" sldId="270"/>
            <ac:picMk id="318" creationId="{2869DD47-9F91-4F95-931D-F24C3D204405}"/>
          </ac:picMkLst>
        </pc:picChg>
        <pc:picChg chg="mod">
          <ac:chgData name="Manasweeta Angane" userId="05da2731-9352-4b35-b713-60351f56afbd" providerId="ADAL" clId="{121B3E88-C8E7-4600-B4A4-3E65BB803D64}" dt="2021-07-01T08:26:29.972" v="584" actId="165"/>
          <ac:picMkLst>
            <pc:docMk/>
            <pc:sldMk cId="731297326" sldId="270"/>
            <ac:picMk id="319" creationId="{7BA6ABD0-07EF-476C-B408-91DA20EC0329}"/>
          </ac:picMkLst>
        </pc:picChg>
        <pc:picChg chg="mod">
          <ac:chgData name="Manasweeta Angane" userId="05da2731-9352-4b35-b713-60351f56afbd" providerId="ADAL" clId="{121B3E88-C8E7-4600-B4A4-3E65BB803D64}" dt="2021-07-01T08:26:29.972" v="584" actId="165"/>
          <ac:picMkLst>
            <pc:docMk/>
            <pc:sldMk cId="731297326" sldId="270"/>
            <ac:picMk id="320" creationId="{A2C07A0B-17E3-4EE2-9FB1-3A82810F019B}"/>
          </ac:picMkLst>
        </pc:picChg>
        <pc:picChg chg="mod topLvl">
          <ac:chgData name="Manasweeta Angane" userId="05da2731-9352-4b35-b713-60351f56afbd" providerId="ADAL" clId="{121B3E88-C8E7-4600-B4A4-3E65BB803D64}" dt="2021-07-01T11:32:12.196" v="2273" actId="164"/>
          <ac:picMkLst>
            <pc:docMk/>
            <pc:sldMk cId="731297326" sldId="270"/>
            <ac:picMk id="322" creationId="{21F3F74D-5156-4498-894A-9F74F3E111A9}"/>
          </ac:picMkLst>
        </pc:picChg>
        <pc:picChg chg="mod topLvl">
          <ac:chgData name="Manasweeta Angane" userId="05da2731-9352-4b35-b713-60351f56afbd" providerId="ADAL" clId="{121B3E88-C8E7-4600-B4A4-3E65BB803D64}" dt="2021-07-01T11:32:40.515" v="2277" actId="688"/>
          <ac:picMkLst>
            <pc:docMk/>
            <pc:sldMk cId="731297326" sldId="270"/>
            <ac:picMk id="323" creationId="{19F56D6F-7BFC-45F6-8051-B64C71F03BB3}"/>
          </ac:picMkLst>
        </pc:picChg>
        <pc:picChg chg="add del mod topLvl">
          <ac:chgData name="Manasweeta Angane" userId="05da2731-9352-4b35-b713-60351f56afbd" providerId="ADAL" clId="{121B3E88-C8E7-4600-B4A4-3E65BB803D64}" dt="2021-07-02T09:18:46.445" v="2455"/>
          <ac:picMkLst>
            <pc:docMk/>
            <pc:sldMk cId="731297326" sldId="270"/>
            <ac:picMk id="324" creationId="{4D055A17-98C8-4B6A-B0BA-DD7EE6C82FD1}"/>
          </ac:picMkLst>
        </pc:picChg>
        <pc:picChg chg="mod topLvl">
          <ac:chgData name="Manasweeta Angane" userId="05da2731-9352-4b35-b713-60351f56afbd" providerId="ADAL" clId="{121B3E88-C8E7-4600-B4A4-3E65BB803D64}" dt="2021-07-01T11:25:48.998" v="2248" actId="1076"/>
          <ac:picMkLst>
            <pc:docMk/>
            <pc:sldMk cId="731297326" sldId="270"/>
            <ac:picMk id="325" creationId="{491995D0-E425-4CAA-9CA8-29DC0CF6C7A5}"/>
          </ac:picMkLst>
        </pc:picChg>
        <pc:picChg chg="mod topLvl">
          <ac:chgData name="Manasweeta Angane" userId="05da2731-9352-4b35-b713-60351f56afbd" providerId="ADAL" clId="{121B3E88-C8E7-4600-B4A4-3E65BB803D64}" dt="2021-07-02T09:18:29.411" v="2451"/>
          <ac:picMkLst>
            <pc:docMk/>
            <pc:sldMk cId="731297326" sldId="270"/>
            <ac:picMk id="328" creationId="{DFC549FB-C241-4E2F-B3F7-A4BC97A39EA8}"/>
          </ac:picMkLst>
        </pc:picChg>
        <pc:picChg chg="mod topLvl">
          <ac:chgData name="Manasweeta Angane" userId="05da2731-9352-4b35-b713-60351f56afbd" providerId="ADAL" clId="{121B3E88-C8E7-4600-B4A4-3E65BB803D64}" dt="2021-07-01T09:31:46.298" v="1715" actId="1036"/>
          <ac:picMkLst>
            <pc:docMk/>
            <pc:sldMk cId="731297326" sldId="270"/>
            <ac:picMk id="329" creationId="{928DC8AB-EEB1-4894-88C5-2E983BE3EE1D}"/>
          </ac:picMkLst>
        </pc:picChg>
        <pc:picChg chg="mod topLvl">
          <ac:chgData name="Manasweeta Angane" userId="05da2731-9352-4b35-b713-60351f56afbd" providerId="ADAL" clId="{121B3E88-C8E7-4600-B4A4-3E65BB803D64}" dt="2021-07-01T09:31:46.298" v="1715" actId="1036"/>
          <ac:picMkLst>
            <pc:docMk/>
            <pc:sldMk cId="731297326" sldId="270"/>
            <ac:picMk id="330" creationId="{C1EF5365-55E4-48C3-9D25-F86053E8C55B}"/>
          </ac:picMkLst>
        </pc:picChg>
        <pc:picChg chg="mod topLvl">
          <ac:chgData name="Manasweeta Angane" userId="05da2731-9352-4b35-b713-60351f56afbd" providerId="ADAL" clId="{121B3E88-C8E7-4600-B4A4-3E65BB803D64}" dt="2021-07-01T11:25:20.474" v="2243" actId="1038"/>
          <ac:picMkLst>
            <pc:docMk/>
            <pc:sldMk cId="731297326" sldId="270"/>
            <ac:picMk id="334" creationId="{E5B230A4-4209-4AA2-A36C-456B78064164}"/>
          </ac:picMkLst>
        </pc:picChg>
        <pc:picChg chg="mod topLvl">
          <ac:chgData name="Manasweeta Angane" userId="05da2731-9352-4b35-b713-60351f56afbd" providerId="ADAL" clId="{121B3E88-C8E7-4600-B4A4-3E65BB803D64}" dt="2021-07-01T10:45:25.055" v="1933" actId="1076"/>
          <ac:picMkLst>
            <pc:docMk/>
            <pc:sldMk cId="731297326" sldId="270"/>
            <ac:picMk id="335" creationId="{5CA495C2-85EF-4C76-9F7C-A2D078449E51}"/>
          </ac:picMkLst>
        </pc:picChg>
        <pc:picChg chg="mod topLvl">
          <ac:chgData name="Manasweeta Angane" userId="05da2731-9352-4b35-b713-60351f56afbd" providerId="ADAL" clId="{121B3E88-C8E7-4600-B4A4-3E65BB803D64}" dt="2021-07-01T09:30:27.546" v="1659" actId="1076"/>
          <ac:picMkLst>
            <pc:docMk/>
            <pc:sldMk cId="731297326" sldId="270"/>
            <ac:picMk id="340" creationId="{F4523582-D23F-4B06-8998-5BA32651631D}"/>
          </ac:picMkLst>
        </pc:picChg>
        <pc:picChg chg="mod topLvl">
          <ac:chgData name="Manasweeta Angane" userId="05da2731-9352-4b35-b713-60351f56afbd" providerId="ADAL" clId="{121B3E88-C8E7-4600-B4A4-3E65BB803D64}" dt="2021-07-02T04:00:39.484" v="2440" actId="164"/>
          <ac:picMkLst>
            <pc:docMk/>
            <pc:sldMk cId="731297326" sldId="270"/>
            <ac:picMk id="342" creationId="{3691DDDA-1257-4F1E-8C3E-B8B0B36D7263}"/>
          </ac:picMkLst>
        </pc:picChg>
        <pc:picChg chg="mod topLvl">
          <ac:chgData name="Manasweeta Angane" userId="05da2731-9352-4b35-b713-60351f56afbd" providerId="ADAL" clId="{121B3E88-C8E7-4600-B4A4-3E65BB803D64}" dt="2021-07-02T04:00:39.484" v="2440" actId="164"/>
          <ac:picMkLst>
            <pc:docMk/>
            <pc:sldMk cId="731297326" sldId="270"/>
            <ac:picMk id="343" creationId="{EDFD7AED-9127-4142-AC45-43E7350851AE}"/>
          </ac:picMkLst>
        </pc:picChg>
        <pc:picChg chg="mod topLvl">
          <ac:chgData name="Manasweeta Angane" userId="05da2731-9352-4b35-b713-60351f56afbd" providerId="ADAL" clId="{121B3E88-C8E7-4600-B4A4-3E65BB803D64}" dt="2021-07-02T04:00:39.484" v="2440" actId="164"/>
          <ac:picMkLst>
            <pc:docMk/>
            <pc:sldMk cId="731297326" sldId="270"/>
            <ac:picMk id="344" creationId="{0EDC9F02-7B13-4A62-B809-013DF0A4D821}"/>
          </ac:picMkLst>
        </pc:picChg>
        <pc:picChg chg="mod">
          <ac:chgData name="Manasweeta Angane" userId="05da2731-9352-4b35-b713-60351f56afbd" providerId="ADAL" clId="{121B3E88-C8E7-4600-B4A4-3E65BB803D64}" dt="2021-07-01T10:41:15.493" v="1893" actId="1076"/>
          <ac:picMkLst>
            <pc:docMk/>
            <pc:sldMk cId="731297326" sldId="270"/>
            <ac:picMk id="345" creationId="{125A9C9B-4086-4148-8B3D-34C36ECEEFDC}"/>
          </ac:picMkLst>
        </pc:picChg>
        <pc:picChg chg="mod">
          <ac:chgData name="Manasweeta Angane" userId="05da2731-9352-4b35-b713-60351f56afbd" providerId="ADAL" clId="{121B3E88-C8E7-4600-B4A4-3E65BB803D64}" dt="2021-07-01T10:41:15.493" v="1893" actId="1076"/>
          <ac:picMkLst>
            <pc:docMk/>
            <pc:sldMk cId="731297326" sldId="270"/>
            <ac:picMk id="346" creationId="{0A193C14-0CD4-4741-ADF5-B58912026564}"/>
          </ac:picMkLst>
        </pc:picChg>
        <pc:picChg chg="mod">
          <ac:chgData name="Manasweeta Angane" userId="05da2731-9352-4b35-b713-60351f56afbd" providerId="ADAL" clId="{121B3E88-C8E7-4600-B4A4-3E65BB803D64}" dt="2021-07-01T08:26:34.642" v="585" actId="165"/>
          <ac:picMkLst>
            <pc:docMk/>
            <pc:sldMk cId="731297326" sldId="270"/>
            <ac:picMk id="347" creationId="{DC36D8EB-D11C-4710-8258-BEB0509CB58B}"/>
          </ac:picMkLst>
        </pc:picChg>
        <pc:picChg chg="mod">
          <ac:chgData name="Manasweeta Angane" userId="05da2731-9352-4b35-b713-60351f56afbd" providerId="ADAL" clId="{121B3E88-C8E7-4600-B4A4-3E65BB803D64}" dt="2021-07-01T08:26:34.642" v="585" actId="165"/>
          <ac:picMkLst>
            <pc:docMk/>
            <pc:sldMk cId="731297326" sldId="270"/>
            <ac:picMk id="348" creationId="{7ED0DEF3-9CFC-475D-9BB4-98F26BBE10DA}"/>
          </ac:picMkLst>
        </pc:picChg>
        <pc:picChg chg="mod">
          <ac:chgData name="Manasweeta Angane" userId="05da2731-9352-4b35-b713-60351f56afbd" providerId="ADAL" clId="{121B3E88-C8E7-4600-B4A4-3E65BB803D64}" dt="2021-07-01T08:26:34.642" v="585" actId="165"/>
          <ac:picMkLst>
            <pc:docMk/>
            <pc:sldMk cId="731297326" sldId="270"/>
            <ac:picMk id="349" creationId="{AF8F3745-2AB9-4C16-8913-DDD8F0E66A55}"/>
          </ac:picMkLst>
        </pc:picChg>
        <pc:picChg chg="mod">
          <ac:chgData name="Manasweeta Angane" userId="05da2731-9352-4b35-b713-60351f56afbd" providerId="ADAL" clId="{121B3E88-C8E7-4600-B4A4-3E65BB803D64}" dt="2021-07-01T08:26:34.642" v="585" actId="165"/>
          <ac:picMkLst>
            <pc:docMk/>
            <pc:sldMk cId="731297326" sldId="270"/>
            <ac:picMk id="350" creationId="{9F6490A9-F53F-4BD5-A5FB-42399C79BC81}"/>
          </ac:picMkLst>
        </pc:picChg>
        <pc:picChg chg="mod">
          <ac:chgData name="Manasweeta Angane" userId="05da2731-9352-4b35-b713-60351f56afbd" providerId="ADAL" clId="{121B3E88-C8E7-4600-B4A4-3E65BB803D64}" dt="2021-07-01T08:26:34.642" v="585" actId="165"/>
          <ac:picMkLst>
            <pc:docMk/>
            <pc:sldMk cId="731297326" sldId="270"/>
            <ac:picMk id="351" creationId="{66EE2168-0B29-4AF3-A0D2-E7C613FD8154}"/>
          </ac:picMkLst>
        </pc:picChg>
        <pc:picChg chg="del mod topLvl">
          <ac:chgData name="Manasweeta Angane" userId="05da2731-9352-4b35-b713-60351f56afbd" providerId="ADAL" clId="{121B3E88-C8E7-4600-B4A4-3E65BB803D64}" dt="2021-07-01T10:44:02.713" v="1920" actId="478"/>
          <ac:picMkLst>
            <pc:docMk/>
            <pc:sldMk cId="731297326" sldId="270"/>
            <ac:picMk id="352" creationId="{70243EC6-9B7D-4680-9816-83CDBBB59228}"/>
          </ac:picMkLst>
        </pc:picChg>
        <pc:picChg chg="del mod topLvl">
          <ac:chgData name="Manasweeta Angane" userId="05da2731-9352-4b35-b713-60351f56afbd" providerId="ADAL" clId="{121B3E88-C8E7-4600-B4A4-3E65BB803D64}" dt="2021-07-01T08:27:39.865" v="595" actId="478"/>
          <ac:picMkLst>
            <pc:docMk/>
            <pc:sldMk cId="731297326" sldId="270"/>
            <ac:picMk id="353" creationId="{3DB3A3D0-AD67-4017-9556-284D6799688E}"/>
          </ac:picMkLst>
        </pc:picChg>
        <pc:picChg chg="mod">
          <ac:chgData name="Manasweeta Angane" userId="05da2731-9352-4b35-b713-60351f56afbd" providerId="ADAL" clId="{121B3E88-C8E7-4600-B4A4-3E65BB803D64}" dt="2021-07-01T11:25:20.474" v="2243" actId="1038"/>
          <ac:picMkLst>
            <pc:docMk/>
            <pc:sldMk cId="731297326" sldId="270"/>
            <ac:picMk id="354" creationId="{56D0CFF7-80BF-488F-A715-A4C722661A8D}"/>
          </ac:picMkLst>
        </pc:picChg>
        <pc:picChg chg="mod">
          <ac:chgData name="Manasweeta Angane" userId="05da2731-9352-4b35-b713-60351f56afbd" providerId="ADAL" clId="{121B3E88-C8E7-4600-B4A4-3E65BB803D64}" dt="2021-07-01T11:25:20.474" v="2243" actId="1038"/>
          <ac:picMkLst>
            <pc:docMk/>
            <pc:sldMk cId="731297326" sldId="270"/>
            <ac:picMk id="355" creationId="{98BAF641-90EB-4DB1-B8F8-4E047636C25D}"/>
          </ac:picMkLst>
        </pc:picChg>
        <pc:picChg chg="mod">
          <ac:chgData name="Manasweeta Angane" userId="05da2731-9352-4b35-b713-60351f56afbd" providerId="ADAL" clId="{121B3E88-C8E7-4600-B4A4-3E65BB803D64}" dt="2021-07-01T11:25:20.474" v="2243" actId="1038"/>
          <ac:picMkLst>
            <pc:docMk/>
            <pc:sldMk cId="731297326" sldId="270"/>
            <ac:picMk id="356" creationId="{55415ACE-4332-4766-9291-49C186352EEE}"/>
          </ac:picMkLst>
        </pc:picChg>
        <pc:picChg chg="del mod">
          <ac:chgData name="Manasweeta Angane" userId="05da2731-9352-4b35-b713-60351f56afbd" providerId="ADAL" clId="{121B3E88-C8E7-4600-B4A4-3E65BB803D64}" dt="2021-07-01T10:44:45.970" v="1928" actId="478"/>
          <ac:picMkLst>
            <pc:docMk/>
            <pc:sldMk cId="731297326" sldId="270"/>
            <ac:picMk id="357" creationId="{E7D1C5E1-2EC7-4604-B95B-2E7830A5C503}"/>
          </ac:picMkLst>
        </pc:picChg>
        <pc:picChg chg="mod">
          <ac:chgData name="Manasweeta Angane" userId="05da2731-9352-4b35-b713-60351f56afbd" providerId="ADAL" clId="{121B3E88-C8E7-4600-B4A4-3E65BB803D64}" dt="2021-07-01T11:25:52.855" v="2249" actId="1076"/>
          <ac:picMkLst>
            <pc:docMk/>
            <pc:sldMk cId="731297326" sldId="270"/>
            <ac:picMk id="358" creationId="{3DD567E9-1E84-45EE-93C0-99524E92CD6B}"/>
          </ac:picMkLst>
        </pc:picChg>
        <pc:picChg chg="mod">
          <ac:chgData name="Manasweeta Angane" userId="05da2731-9352-4b35-b713-60351f56afbd" providerId="ADAL" clId="{121B3E88-C8E7-4600-B4A4-3E65BB803D64}" dt="2021-07-01T11:25:52.855" v="2249" actId="1076"/>
          <ac:picMkLst>
            <pc:docMk/>
            <pc:sldMk cId="731297326" sldId="270"/>
            <ac:picMk id="359" creationId="{6A3CB17B-C20C-41B9-8DD7-08631E6A71C5}"/>
          </ac:picMkLst>
        </pc:picChg>
        <pc:picChg chg="mod">
          <ac:chgData name="Manasweeta Angane" userId="05da2731-9352-4b35-b713-60351f56afbd" providerId="ADAL" clId="{121B3E88-C8E7-4600-B4A4-3E65BB803D64}" dt="2021-07-01T08:26:34.642" v="585" actId="165"/>
          <ac:picMkLst>
            <pc:docMk/>
            <pc:sldMk cId="731297326" sldId="270"/>
            <ac:picMk id="360" creationId="{DA13C17F-13C8-4AB8-9BA3-977DE587F554}"/>
          </ac:picMkLst>
        </pc:picChg>
        <pc:picChg chg="mod">
          <ac:chgData name="Manasweeta Angane" userId="05da2731-9352-4b35-b713-60351f56afbd" providerId="ADAL" clId="{121B3E88-C8E7-4600-B4A4-3E65BB803D64}" dt="2021-07-01T08:26:34.642" v="585" actId="165"/>
          <ac:picMkLst>
            <pc:docMk/>
            <pc:sldMk cId="731297326" sldId="270"/>
            <ac:picMk id="361" creationId="{1EE76768-A4F0-4EBB-A636-6D3FA207EFA1}"/>
          </ac:picMkLst>
        </pc:picChg>
        <pc:picChg chg="del mod topLvl">
          <ac:chgData name="Manasweeta Angane" userId="05da2731-9352-4b35-b713-60351f56afbd" providerId="ADAL" clId="{121B3E88-C8E7-4600-B4A4-3E65BB803D64}" dt="2021-07-01T08:27:35.089" v="594" actId="478"/>
          <ac:picMkLst>
            <pc:docMk/>
            <pc:sldMk cId="731297326" sldId="270"/>
            <ac:picMk id="362" creationId="{77E108CF-3607-46EC-A799-CE114D8DA35B}"/>
          </ac:picMkLst>
        </pc:picChg>
        <pc:picChg chg="mod topLvl">
          <ac:chgData name="Manasweeta Angane" userId="05da2731-9352-4b35-b713-60351f56afbd" providerId="ADAL" clId="{121B3E88-C8E7-4600-B4A4-3E65BB803D64}" dt="2021-07-01T08:27:35.089" v="594" actId="478"/>
          <ac:picMkLst>
            <pc:docMk/>
            <pc:sldMk cId="731297326" sldId="270"/>
            <ac:picMk id="363" creationId="{F9EE6DF5-2C5A-4A85-8B08-5228BA4CF7C0}"/>
          </ac:picMkLst>
        </pc:picChg>
        <pc:picChg chg="add mod">
          <ac:chgData name="Manasweeta Angane" userId="05da2731-9352-4b35-b713-60351f56afbd" providerId="ADAL" clId="{121B3E88-C8E7-4600-B4A4-3E65BB803D64}" dt="2021-07-01T10:26:52.594" v="1850" actId="1076"/>
          <ac:picMkLst>
            <pc:docMk/>
            <pc:sldMk cId="731297326" sldId="270"/>
            <ac:picMk id="364" creationId="{5FB5DA92-B709-40A6-919F-2C83389F031F}"/>
          </ac:picMkLst>
        </pc:picChg>
        <pc:picChg chg="add del mod">
          <ac:chgData name="Manasweeta Angane" userId="05da2731-9352-4b35-b713-60351f56afbd" providerId="ADAL" clId="{121B3E88-C8E7-4600-B4A4-3E65BB803D64}" dt="2021-07-01T10:15:40.590" v="1775" actId="478"/>
          <ac:picMkLst>
            <pc:docMk/>
            <pc:sldMk cId="731297326" sldId="270"/>
            <ac:picMk id="365" creationId="{DC80C4FD-D29C-4DE4-971A-87B9B6D01B9C}"/>
          </ac:picMkLst>
        </pc:picChg>
        <pc:picChg chg="add del mod">
          <ac:chgData name="Manasweeta Angane" userId="05da2731-9352-4b35-b713-60351f56afbd" providerId="ADAL" clId="{121B3E88-C8E7-4600-B4A4-3E65BB803D64}" dt="2021-07-01T10:52:52.256" v="2011" actId="478"/>
          <ac:picMkLst>
            <pc:docMk/>
            <pc:sldMk cId="731297326" sldId="270"/>
            <ac:picMk id="366" creationId="{604B92FA-4315-4667-ABAF-FF0975961849}"/>
          </ac:picMkLst>
        </pc:picChg>
        <pc:picChg chg="add del mod">
          <ac:chgData name="Manasweeta Angane" userId="05da2731-9352-4b35-b713-60351f56afbd" providerId="ADAL" clId="{121B3E88-C8E7-4600-B4A4-3E65BB803D64}" dt="2021-07-01T11:26:40.232" v="2257" actId="478"/>
          <ac:picMkLst>
            <pc:docMk/>
            <pc:sldMk cId="731297326" sldId="270"/>
            <ac:picMk id="367" creationId="{CE710C86-356E-4F7A-AABA-AAC5985E2D6D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69" creationId="{FE7C4A58-E2C3-4B54-B8E6-9BC30F204ECC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70" creationId="{0DA1E419-C373-4F69-8EBF-0DE4C11CFB5F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71" creationId="{1C61B29F-3027-48C5-BFA9-3EF55DF893DE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73" creationId="{30C20C1E-319E-48C7-9622-71F786E471BD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74" creationId="{AD3F7E0E-A0A8-4DA9-B086-8DEF33B88142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75" creationId="{FD61B615-DC5C-4365-95B3-34B65493E1C8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76" creationId="{36A610AE-F10D-43B4-BDE1-62E6B2DE19A3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83" creationId="{9F013C24-8324-4D38-ADFF-A58C05916F30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84" creationId="{8C369102-00E7-4BD2-85C0-ED50486B47A0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85" creationId="{56354FE1-87AC-4C8B-B7A0-04F48BA9915B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87" creationId="{A6C8E76B-6DDB-445A-B582-5D98916B4160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89" creationId="{183C09F4-3FE0-437A-ACE2-E2DD2554D3B6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90" creationId="{6FB80F7D-F1F2-4C51-8F81-7CC5022351EE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91" creationId="{1984680F-91B3-4822-8E5D-EA789C328C74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92" creationId="{AC599CFA-4687-4C06-9ABB-2752E83C2AEF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93" creationId="{AE63DF7E-48E6-4632-A1CD-24CA6291B993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94" creationId="{11EFB1E5-EE3C-4352-984C-DBDACFD26BB6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95" creationId="{D266AD12-1248-4046-B1D4-950EDE3A6DC9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96" creationId="{EBBAE9FE-AFAE-441E-8FF9-483550FACEBB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97" creationId="{9A59BC0F-F512-432C-BC62-538CDE52F1E2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98" creationId="{B6DD0802-204F-469D-AF87-0AB1CC8F3B9C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399" creationId="{F7276543-1189-4CBA-A24C-5E4A71F04643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400" creationId="{6C965705-41C4-470C-B43A-5B8041FF47A6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401" creationId="{0971DB1F-E79B-49A6-BF7A-2B51B8726FCF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402" creationId="{9896D7B8-6F05-4212-A93A-6490DB408303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403" creationId="{5D49E6E9-474E-492F-A357-5BBB87ECE981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404" creationId="{111CF4FB-1F90-487F-B85E-93537B2B378F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405" creationId="{3C3450E2-E063-4821-AEE5-09920D648323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406" creationId="{3A301C9D-5BD2-47A0-BE26-20AD84C8A399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407" creationId="{EEC07546-1738-487C-AEF1-FE67278AA512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408" creationId="{1479B4DD-850B-4280-A7EC-B246C924887F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409" creationId="{F12A59E5-4775-420D-ADF5-90075AD571BA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410" creationId="{47EC0651-0BB7-4326-BB79-35E8BDC80BB7}"/>
          </ac:picMkLst>
        </pc:picChg>
        <pc:picChg chg="mod">
          <ac:chgData name="Manasweeta Angane" userId="05da2731-9352-4b35-b713-60351f56afbd" providerId="ADAL" clId="{121B3E88-C8E7-4600-B4A4-3E65BB803D64}" dt="2021-07-01T08:07:37.413" v="432"/>
          <ac:picMkLst>
            <pc:docMk/>
            <pc:sldMk cId="731297326" sldId="270"/>
            <ac:picMk id="411" creationId="{4244D338-AB9A-4CD4-B927-0452BBD45DAF}"/>
          </ac:picMkLst>
        </pc:picChg>
        <pc:picChg chg="del mod topLvl">
          <ac:chgData name="Manasweeta Angane" userId="05da2731-9352-4b35-b713-60351f56afbd" providerId="ADAL" clId="{121B3E88-C8E7-4600-B4A4-3E65BB803D64}" dt="2021-07-01T08:48:12.959" v="949" actId="478"/>
          <ac:picMkLst>
            <pc:docMk/>
            <pc:sldMk cId="731297326" sldId="270"/>
            <ac:picMk id="413" creationId="{7AB57AED-3A31-43AB-8C67-819BED43FD9C}"/>
          </ac:picMkLst>
        </pc:picChg>
        <pc:picChg chg="del mod topLvl">
          <ac:chgData name="Manasweeta Angane" userId="05da2731-9352-4b35-b713-60351f56afbd" providerId="ADAL" clId="{121B3E88-C8E7-4600-B4A4-3E65BB803D64}" dt="2021-07-01T11:23:20.759" v="2174" actId="478"/>
          <ac:picMkLst>
            <pc:docMk/>
            <pc:sldMk cId="731297326" sldId="270"/>
            <ac:picMk id="414" creationId="{75C87680-FED6-4579-B1ED-6B9CD2EDBCF4}"/>
          </ac:picMkLst>
        </pc:picChg>
        <pc:picChg chg="mod topLvl">
          <ac:chgData name="Manasweeta Angane" userId="05da2731-9352-4b35-b713-60351f56afbd" providerId="ADAL" clId="{121B3E88-C8E7-4600-B4A4-3E65BB803D64}" dt="2021-07-01T08:26:38.676" v="586" actId="165"/>
          <ac:picMkLst>
            <pc:docMk/>
            <pc:sldMk cId="731297326" sldId="270"/>
            <ac:picMk id="415" creationId="{72C37080-F336-4329-92FA-B8608B37F7DC}"/>
          </ac:picMkLst>
        </pc:picChg>
        <pc:picChg chg="del mod topLvl">
          <ac:chgData name="Manasweeta Angane" userId="05da2731-9352-4b35-b713-60351f56afbd" providerId="ADAL" clId="{121B3E88-C8E7-4600-B4A4-3E65BB803D64}" dt="2021-07-01T09:12:39.484" v="1431" actId="478"/>
          <ac:picMkLst>
            <pc:docMk/>
            <pc:sldMk cId="731297326" sldId="270"/>
            <ac:picMk id="417" creationId="{7750AEB1-0308-4AFD-88FB-86BA8D6E86F8}"/>
          </ac:picMkLst>
        </pc:picChg>
        <pc:picChg chg="mod topLvl">
          <ac:chgData name="Manasweeta Angane" userId="05da2731-9352-4b35-b713-60351f56afbd" providerId="ADAL" clId="{121B3E88-C8E7-4600-B4A4-3E65BB803D64}" dt="2021-07-01T08:48:22.857" v="951" actId="1076"/>
          <ac:picMkLst>
            <pc:docMk/>
            <pc:sldMk cId="731297326" sldId="270"/>
            <ac:picMk id="418" creationId="{C7D49BD0-3793-4612-B42A-4A9578770EE9}"/>
          </ac:picMkLst>
        </pc:picChg>
        <pc:picChg chg="mod topLvl">
          <ac:chgData name="Manasweeta Angane" userId="05da2731-9352-4b35-b713-60351f56afbd" providerId="ADAL" clId="{121B3E88-C8E7-4600-B4A4-3E65BB803D64}" dt="2021-07-01T08:50:27.300" v="1141" actId="1038"/>
          <ac:picMkLst>
            <pc:docMk/>
            <pc:sldMk cId="731297326" sldId="270"/>
            <ac:picMk id="419" creationId="{BDBCE160-9993-491A-BB83-1B06E56A9EFA}"/>
          </ac:picMkLst>
        </pc:picChg>
        <pc:picChg chg="mod topLvl">
          <ac:chgData name="Manasweeta Angane" userId="05da2731-9352-4b35-b713-60351f56afbd" providerId="ADAL" clId="{121B3E88-C8E7-4600-B4A4-3E65BB803D64}" dt="2021-07-01T08:26:38.676" v="586" actId="165"/>
          <ac:picMkLst>
            <pc:docMk/>
            <pc:sldMk cId="731297326" sldId="270"/>
            <ac:picMk id="420" creationId="{98E4CA24-FCEA-4826-8E6F-DD46501D47F7}"/>
          </ac:picMkLst>
        </pc:picChg>
        <pc:picChg chg="del mod topLvl">
          <ac:chgData name="Manasweeta Angane" userId="05da2731-9352-4b35-b713-60351f56afbd" providerId="ADAL" clId="{121B3E88-C8E7-4600-B4A4-3E65BB803D64}" dt="2021-07-01T08:31:07.595" v="664" actId="478"/>
          <ac:picMkLst>
            <pc:docMk/>
            <pc:sldMk cId="731297326" sldId="270"/>
            <ac:picMk id="427" creationId="{08226993-9B21-4863-9584-7D2988818739}"/>
          </ac:picMkLst>
        </pc:picChg>
        <pc:picChg chg="mod topLvl">
          <ac:chgData name="Manasweeta Angane" userId="05da2731-9352-4b35-b713-60351f56afbd" providerId="ADAL" clId="{121B3E88-C8E7-4600-B4A4-3E65BB803D64}" dt="2021-07-01T11:23:52.403" v="2197" actId="1076"/>
          <ac:picMkLst>
            <pc:docMk/>
            <pc:sldMk cId="731297326" sldId="270"/>
            <ac:picMk id="428" creationId="{BE340CD2-4119-4E30-8CDB-C0605A7B941C}"/>
          </ac:picMkLst>
        </pc:picChg>
        <pc:picChg chg="mod topLvl">
          <ac:chgData name="Manasweeta Angane" userId="05da2731-9352-4b35-b713-60351f56afbd" providerId="ADAL" clId="{121B3E88-C8E7-4600-B4A4-3E65BB803D64}" dt="2021-07-01T11:23:52.403" v="2197" actId="1076"/>
          <ac:picMkLst>
            <pc:docMk/>
            <pc:sldMk cId="731297326" sldId="270"/>
            <ac:picMk id="429" creationId="{D666D86F-4033-4E34-A8FC-4BE66356F8E6}"/>
          </ac:picMkLst>
        </pc:picChg>
        <pc:picChg chg="mod topLvl">
          <ac:chgData name="Manasweeta Angane" userId="05da2731-9352-4b35-b713-60351f56afbd" providerId="ADAL" clId="{121B3E88-C8E7-4600-B4A4-3E65BB803D64}" dt="2021-07-01T08:26:38.676" v="586" actId="165"/>
          <ac:picMkLst>
            <pc:docMk/>
            <pc:sldMk cId="731297326" sldId="270"/>
            <ac:picMk id="431" creationId="{4F1DC6AB-0603-4E31-AE40-906050FAD6B2}"/>
          </ac:picMkLst>
        </pc:picChg>
        <pc:picChg chg="mod">
          <ac:chgData name="Manasweeta Angane" userId="05da2731-9352-4b35-b713-60351f56afbd" providerId="ADAL" clId="{121B3E88-C8E7-4600-B4A4-3E65BB803D64}" dt="2021-07-01T08:26:38.676" v="586" actId="165"/>
          <ac:picMkLst>
            <pc:docMk/>
            <pc:sldMk cId="731297326" sldId="270"/>
            <ac:picMk id="433" creationId="{05F00B7D-2A93-452D-B4CA-F9603FD56F34}"/>
          </ac:picMkLst>
        </pc:picChg>
        <pc:picChg chg="mod">
          <ac:chgData name="Manasweeta Angane" userId="05da2731-9352-4b35-b713-60351f56afbd" providerId="ADAL" clId="{121B3E88-C8E7-4600-B4A4-3E65BB803D64}" dt="2021-07-01T08:26:38.676" v="586" actId="165"/>
          <ac:picMkLst>
            <pc:docMk/>
            <pc:sldMk cId="731297326" sldId="270"/>
            <ac:picMk id="434" creationId="{558AB870-7350-4DBF-807F-A7E2F164FFD8}"/>
          </ac:picMkLst>
        </pc:picChg>
        <pc:picChg chg="del mod">
          <ac:chgData name="Manasweeta Angane" userId="05da2731-9352-4b35-b713-60351f56afbd" providerId="ADAL" clId="{121B3E88-C8E7-4600-B4A4-3E65BB803D64}" dt="2021-07-01T08:31:04.666" v="663" actId="478"/>
          <ac:picMkLst>
            <pc:docMk/>
            <pc:sldMk cId="731297326" sldId="270"/>
            <ac:picMk id="435" creationId="{5911578F-D36E-4C06-9FB6-D472C2A9C5B3}"/>
          </ac:picMkLst>
        </pc:picChg>
        <pc:picChg chg="del mod">
          <ac:chgData name="Manasweeta Angane" userId="05da2731-9352-4b35-b713-60351f56afbd" providerId="ADAL" clId="{121B3E88-C8E7-4600-B4A4-3E65BB803D64}" dt="2021-07-01T08:31:03.493" v="662" actId="478"/>
          <ac:picMkLst>
            <pc:docMk/>
            <pc:sldMk cId="731297326" sldId="270"/>
            <ac:picMk id="436" creationId="{DC948AE1-1538-49C9-8D79-25E7553EEA38}"/>
          </ac:picMkLst>
        </pc:picChg>
        <pc:picChg chg="mod">
          <ac:chgData name="Manasweeta Angane" userId="05da2731-9352-4b35-b713-60351f56afbd" providerId="ADAL" clId="{121B3E88-C8E7-4600-B4A4-3E65BB803D64}" dt="2021-07-01T08:31:04.666" v="663" actId="478"/>
          <ac:picMkLst>
            <pc:docMk/>
            <pc:sldMk cId="731297326" sldId="270"/>
            <ac:picMk id="437" creationId="{C9D5DB88-6F10-4390-A4AB-F24B269DB192}"/>
          </ac:picMkLst>
        </pc:picChg>
        <pc:picChg chg="mod">
          <ac:chgData name="Manasweeta Angane" userId="05da2731-9352-4b35-b713-60351f56afbd" providerId="ADAL" clId="{121B3E88-C8E7-4600-B4A4-3E65BB803D64}" dt="2021-07-01T08:31:04.666" v="663" actId="478"/>
          <ac:picMkLst>
            <pc:docMk/>
            <pc:sldMk cId="731297326" sldId="270"/>
            <ac:picMk id="438" creationId="{23F2DD0C-F7C9-48E8-8495-469510D7E96A}"/>
          </ac:picMkLst>
        </pc:picChg>
        <pc:picChg chg="del mod">
          <ac:chgData name="Manasweeta Angane" userId="05da2731-9352-4b35-b713-60351f56afbd" providerId="ADAL" clId="{121B3E88-C8E7-4600-B4A4-3E65BB803D64}" dt="2021-07-01T08:31:15.782" v="665" actId="478"/>
          <ac:picMkLst>
            <pc:docMk/>
            <pc:sldMk cId="731297326" sldId="270"/>
            <ac:picMk id="439" creationId="{606110ED-0330-4449-B77F-DB8A2349117D}"/>
          </ac:picMkLst>
        </pc:picChg>
        <pc:picChg chg="mod">
          <ac:chgData name="Manasweeta Angane" userId="05da2731-9352-4b35-b713-60351f56afbd" providerId="ADAL" clId="{121B3E88-C8E7-4600-B4A4-3E65BB803D64}" dt="2021-07-01T08:31:15.782" v="665" actId="478"/>
          <ac:picMkLst>
            <pc:docMk/>
            <pc:sldMk cId="731297326" sldId="270"/>
            <ac:picMk id="440" creationId="{BEDF6EB7-25CC-4B01-9C72-E44DD6D6A601}"/>
          </ac:picMkLst>
        </pc:picChg>
        <pc:picChg chg="mod">
          <ac:chgData name="Manasweeta Angane" userId="05da2731-9352-4b35-b713-60351f56afbd" providerId="ADAL" clId="{121B3E88-C8E7-4600-B4A4-3E65BB803D64}" dt="2021-07-01T08:31:15.782" v="665" actId="478"/>
          <ac:picMkLst>
            <pc:docMk/>
            <pc:sldMk cId="731297326" sldId="270"/>
            <ac:picMk id="441" creationId="{713434A8-345E-4292-8C39-528E2D1B2154}"/>
          </ac:picMkLst>
        </pc:picChg>
        <pc:picChg chg="del mod">
          <ac:chgData name="Manasweeta Angane" userId="05da2731-9352-4b35-b713-60351f56afbd" providerId="ADAL" clId="{121B3E88-C8E7-4600-B4A4-3E65BB803D64}" dt="2021-07-01T08:48:43.848" v="954" actId="478"/>
          <ac:picMkLst>
            <pc:docMk/>
            <pc:sldMk cId="731297326" sldId="270"/>
            <ac:picMk id="442" creationId="{2C4B462C-0295-4BEA-997E-BDAF47C8F34E}"/>
          </ac:picMkLst>
        </pc:picChg>
        <pc:picChg chg="mod">
          <ac:chgData name="Manasweeta Angane" userId="05da2731-9352-4b35-b713-60351f56afbd" providerId="ADAL" clId="{121B3E88-C8E7-4600-B4A4-3E65BB803D64}" dt="2021-07-01T08:48:43.848" v="954" actId="478"/>
          <ac:picMkLst>
            <pc:docMk/>
            <pc:sldMk cId="731297326" sldId="270"/>
            <ac:picMk id="443" creationId="{FD14E8FF-1B94-40FA-8608-EEC476856704}"/>
          </ac:picMkLst>
        </pc:picChg>
        <pc:picChg chg="mod">
          <ac:chgData name="Manasweeta Angane" userId="05da2731-9352-4b35-b713-60351f56afbd" providerId="ADAL" clId="{121B3E88-C8E7-4600-B4A4-3E65BB803D64}" dt="2021-07-01T08:48:43.848" v="954" actId="478"/>
          <ac:picMkLst>
            <pc:docMk/>
            <pc:sldMk cId="731297326" sldId="270"/>
            <ac:picMk id="444" creationId="{01B53366-3335-48E5-AE99-E4377E114503}"/>
          </ac:picMkLst>
        </pc:picChg>
        <pc:picChg chg="del mod">
          <ac:chgData name="Manasweeta Angane" userId="05da2731-9352-4b35-b713-60351f56afbd" providerId="ADAL" clId="{121B3E88-C8E7-4600-B4A4-3E65BB803D64}" dt="2021-07-01T08:32:19.842" v="667" actId="478"/>
          <ac:picMkLst>
            <pc:docMk/>
            <pc:sldMk cId="731297326" sldId="270"/>
            <ac:picMk id="445" creationId="{2E4EF1C0-2366-4225-9D6B-129981F30CE8}"/>
          </ac:picMkLst>
        </pc:picChg>
        <pc:picChg chg="mod">
          <ac:chgData name="Manasweeta Angane" userId="05da2731-9352-4b35-b713-60351f56afbd" providerId="ADAL" clId="{121B3E88-C8E7-4600-B4A4-3E65BB803D64}" dt="2021-07-01T08:32:25.939" v="695" actId="1038"/>
          <ac:picMkLst>
            <pc:docMk/>
            <pc:sldMk cId="731297326" sldId="270"/>
            <ac:picMk id="446" creationId="{6F60382F-C015-47F5-91A6-34C40204E64D}"/>
          </ac:picMkLst>
        </pc:picChg>
        <pc:picChg chg="mod">
          <ac:chgData name="Manasweeta Angane" userId="05da2731-9352-4b35-b713-60351f56afbd" providerId="ADAL" clId="{121B3E88-C8E7-4600-B4A4-3E65BB803D64}" dt="2021-07-01T08:32:25.939" v="695" actId="1038"/>
          <ac:picMkLst>
            <pc:docMk/>
            <pc:sldMk cId="731297326" sldId="270"/>
            <ac:picMk id="447" creationId="{371A91F1-30CE-494B-8969-65283247951C}"/>
          </ac:picMkLst>
        </pc:picChg>
        <pc:picChg chg="del mod topLvl">
          <ac:chgData name="Manasweeta Angane" userId="05da2731-9352-4b35-b713-60351f56afbd" providerId="ADAL" clId="{121B3E88-C8E7-4600-B4A4-3E65BB803D64}" dt="2021-07-02T09:17:27.844" v="2448" actId="478"/>
          <ac:picMkLst>
            <pc:docMk/>
            <pc:sldMk cId="731297326" sldId="270"/>
            <ac:picMk id="448" creationId="{BC63397F-55FB-43CC-ADD5-B9BB0FDBB36F}"/>
          </ac:picMkLst>
        </pc:picChg>
        <pc:picChg chg="mod topLvl">
          <ac:chgData name="Manasweeta Angane" userId="05da2731-9352-4b35-b713-60351f56afbd" providerId="ADAL" clId="{121B3E88-C8E7-4600-B4A4-3E65BB803D64}" dt="2021-07-02T09:17:23.913" v="2447" actId="165"/>
          <ac:picMkLst>
            <pc:docMk/>
            <pc:sldMk cId="731297326" sldId="270"/>
            <ac:picMk id="449" creationId="{7D3B4507-3697-488B-B735-13908984C621}"/>
          </ac:picMkLst>
        </pc:picChg>
        <pc:picChg chg="mod">
          <ac:chgData name="Manasweeta Angane" userId="05da2731-9352-4b35-b713-60351f56afbd" providerId="ADAL" clId="{121B3E88-C8E7-4600-B4A4-3E65BB803D64}" dt="2021-07-01T11:24:05.991" v="2199" actId="1076"/>
          <ac:picMkLst>
            <pc:docMk/>
            <pc:sldMk cId="731297326" sldId="270"/>
            <ac:picMk id="450" creationId="{2A4278CE-FCC6-44D8-883F-E9FD5FC36CAA}"/>
          </ac:picMkLst>
        </pc:picChg>
        <pc:picChg chg="mod">
          <ac:chgData name="Manasweeta Angane" userId="05da2731-9352-4b35-b713-60351f56afbd" providerId="ADAL" clId="{121B3E88-C8E7-4600-B4A4-3E65BB803D64}" dt="2021-07-01T11:24:05.991" v="2199" actId="1076"/>
          <ac:picMkLst>
            <pc:docMk/>
            <pc:sldMk cId="731297326" sldId="270"/>
            <ac:picMk id="451" creationId="{CD11048D-B4A1-4EDD-A31C-238CE0EE0446}"/>
          </ac:picMkLst>
        </pc:picChg>
        <pc:picChg chg="mod">
          <ac:chgData name="Manasweeta Angane" userId="05da2731-9352-4b35-b713-60351f56afbd" providerId="ADAL" clId="{121B3E88-C8E7-4600-B4A4-3E65BB803D64}" dt="2021-07-01T08:26:38.676" v="586" actId="165"/>
          <ac:picMkLst>
            <pc:docMk/>
            <pc:sldMk cId="731297326" sldId="270"/>
            <ac:picMk id="452" creationId="{DDFB6693-B1F0-4CCE-ACC7-3EE877108291}"/>
          </ac:picMkLst>
        </pc:picChg>
        <pc:picChg chg="mod">
          <ac:chgData name="Manasweeta Angane" userId="05da2731-9352-4b35-b713-60351f56afbd" providerId="ADAL" clId="{121B3E88-C8E7-4600-B4A4-3E65BB803D64}" dt="2021-07-01T08:26:38.676" v="586" actId="165"/>
          <ac:picMkLst>
            <pc:docMk/>
            <pc:sldMk cId="731297326" sldId="270"/>
            <ac:picMk id="453" creationId="{6B8FD9EA-185E-45D4-AAD6-964EA1245593}"/>
          </ac:picMkLst>
        </pc:picChg>
        <pc:picChg chg="mod">
          <ac:chgData name="Manasweeta Angane" userId="05da2731-9352-4b35-b713-60351f56afbd" providerId="ADAL" clId="{121B3E88-C8E7-4600-B4A4-3E65BB803D64}" dt="2021-07-01T08:26:38.676" v="586" actId="165"/>
          <ac:picMkLst>
            <pc:docMk/>
            <pc:sldMk cId="731297326" sldId="270"/>
            <ac:picMk id="454" creationId="{0092CEFD-7BB9-4D96-B048-C2205FFAB4DB}"/>
          </ac:picMkLst>
        </pc:picChg>
        <pc:picChg chg="mod">
          <ac:chgData name="Manasweeta Angane" userId="05da2731-9352-4b35-b713-60351f56afbd" providerId="ADAL" clId="{121B3E88-C8E7-4600-B4A4-3E65BB803D64}" dt="2021-07-01T08:26:38.676" v="586" actId="165"/>
          <ac:picMkLst>
            <pc:docMk/>
            <pc:sldMk cId="731297326" sldId="270"/>
            <ac:picMk id="455" creationId="{1434B77C-CF81-4F7F-A1B0-838A9A5C3120}"/>
          </ac:picMkLst>
        </pc:picChg>
        <pc:picChg chg="add mod">
          <ac:chgData name="Manasweeta Angane" userId="05da2731-9352-4b35-b713-60351f56afbd" providerId="ADAL" clId="{121B3E88-C8E7-4600-B4A4-3E65BB803D64}" dt="2021-07-01T11:32:40.515" v="2277" actId="688"/>
          <ac:picMkLst>
            <pc:docMk/>
            <pc:sldMk cId="731297326" sldId="270"/>
            <ac:picMk id="456" creationId="{604988FD-D7A7-4B0B-B205-3B7E51110752}"/>
          </ac:picMkLst>
        </pc:picChg>
        <pc:picChg chg="add del mod">
          <ac:chgData name="Manasweeta Angane" userId="05da2731-9352-4b35-b713-60351f56afbd" providerId="ADAL" clId="{121B3E88-C8E7-4600-B4A4-3E65BB803D64}" dt="2021-07-01T08:37:33.389" v="802" actId="478"/>
          <ac:picMkLst>
            <pc:docMk/>
            <pc:sldMk cId="731297326" sldId="270"/>
            <ac:picMk id="457" creationId="{4CB952BF-B1F9-4D9A-AF36-8A5EE92C4776}"/>
          </ac:picMkLst>
        </pc:picChg>
        <pc:picChg chg="add del mod">
          <ac:chgData name="Manasweeta Angane" userId="05da2731-9352-4b35-b713-60351f56afbd" providerId="ADAL" clId="{121B3E88-C8E7-4600-B4A4-3E65BB803D64}" dt="2021-07-01T08:38:15.595" v="891" actId="478"/>
          <ac:picMkLst>
            <pc:docMk/>
            <pc:sldMk cId="731297326" sldId="270"/>
            <ac:picMk id="458" creationId="{EE98B55B-0A00-4431-B6BC-A81B86AE87D6}"/>
          </ac:picMkLst>
        </pc:picChg>
        <pc:picChg chg="add del mod">
          <ac:chgData name="Manasweeta Angane" userId="05da2731-9352-4b35-b713-60351f56afbd" providerId="ADAL" clId="{121B3E88-C8E7-4600-B4A4-3E65BB803D64}" dt="2021-07-01T08:41:51.468" v="920" actId="478"/>
          <ac:picMkLst>
            <pc:docMk/>
            <pc:sldMk cId="731297326" sldId="270"/>
            <ac:picMk id="459" creationId="{449296EB-E92C-4023-89C7-7BCC07F5AC66}"/>
          </ac:picMkLst>
        </pc:picChg>
        <pc:picChg chg="add mod">
          <ac:chgData name="Manasweeta Angane" userId="05da2731-9352-4b35-b713-60351f56afbd" providerId="ADAL" clId="{121B3E88-C8E7-4600-B4A4-3E65BB803D64}" dt="2021-07-01T11:32:40.515" v="2277" actId="688"/>
          <ac:picMkLst>
            <pc:docMk/>
            <pc:sldMk cId="731297326" sldId="270"/>
            <ac:picMk id="460" creationId="{EC61A0D4-8FFE-4420-9388-9A205241D780}"/>
          </ac:picMkLst>
        </pc:picChg>
        <pc:picChg chg="mod">
          <ac:chgData name="Manasweeta Angane" userId="05da2731-9352-4b35-b713-60351f56afbd" providerId="ADAL" clId="{121B3E88-C8E7-4600-B4A4-3E65BB803D64}" dt="2021-07-01T10:15:37.783" v="1774" actId="1076"/>
          <ac:picMkLst>
            <pc:docMk/>
            <pc:sldMk cId="731297326" sldId="270"/>
            <ac:picMk id="462" creationId="{444861B6-6F18-4C30-9941-9BA2B0C48794}"/>
          </ac:picMkLst>
        </pc:picChg>
        <pc:picChg chg="mod">
          <ac:chgData name="Manasweeta Angane" userId="05da2731-9352-4b35-b713-60351f56afbd" providerId="ADAL" clId="{121B3E88-C8E7-4600-B4A4-3E65BB803D64}" dt="2021-07-01T10:15:37.783" v="1774" actId="1076"/>
          <ac:picMkLst>
            <pc:docMk/>
            <pc:sldMk cId="731297326" sldId="270"/>
            <ac:picMk id="463" creationId="{4EEFBE20-40B7-40AE-871B-0C93553D0863}"/>
          </ac:picMkLst>
        </pc:picChg>
        <pc:picChg chg="mod">
          <ac:chgData name="Manasweeta Angane" userId="05da2731-9352-4b35-b713-60351f56afbd" providerId="ADAL" clId="{121B3E88-C8E7-4600-B4A4-3E65BB803D64}" dt="2021-07-01T08:50:47.872" v="1145"/>
          <ac:picMkLst>
            <pc:docMk/>
            <pc:sldMk cId="731297326" sldId="270"/>
            <ac:picMk id="466" creationId="{0DC91F05-4123-413B-974A-8136CE47EB2B}"/>
          </ac:picMkLst>
        </pc:picChg>
        <pc:picChg chg="mod">
          <ac:chgData name="Manasweeta Angane" userId="05da2731-9352-4b35-b713-60351f56afbd" providerId="ADAL" clId="{121B3E88-C8E7-4600-B4A4-3E65BB803D64}" dt="2021-07-01T08:50:47.872" v="1145"/>
          <ac:picMkLst>
            <pc:docMk/>
            <pc:sldMk cId="731297326" sldId="270"/>
            <ac:picMk id="467" creationId="{4200265F-5ECC-46A2-936D-225ED201E72D}"/>
          </ac:picMkLst>
        </pc:picChg>
        <pc:picChg chg="mod">
          <ac:chgData name="Manasweeta Angane" userId="05da2731-9352-4b35-b713-60351f56afbd" providerId="ADAL" clId="{121B3E88-C8E7-4600-B4A4-3E65BB803D64}" dt="2021-07-01T10:26:52.594" v="1850" actId="1076"/>
          <ac:picMkLst>
            <pc:docMk/>
            <pc:sldMk cId="731297326" sldId="270"/>
            <ac:picMk id="469" creationId="{F7F1F212-A2DE-4C1F-B6D2-C9CD5B92274F}"/>
          </ac:picMkLst>
        </pc:picChg>
        <pc:picChg chg="mod">
          <ac:chgData name="Manasweeta Angane" userId="05da2731-9352-4b35-b713-60351f56afbd" providerId="ADAL" clId="{121B3E88-C8E7-4600-B4A4-3E65BB803D64}" dt="2021-07-01T10:26:52.594" v="1850" actId="1076"/>
          <ac:picMkLst>
            <pc:docMk/>
            <pc:sldMk cId="731297326" sldId="270"/>
            <ac:picMk id="470" creationId="{CE24842B-92C2-4D3E-8B57-BA2534EE19BD}"/>
          </ac:picMkLst>
        </pc:picChg>
        <pc:picChg chg="mod">
          <ac:chgData name="Manasweeta Angane" userId="05da2731-9352-4b35-b713-60351f56afbd" providerId="ADAL" clId="{121B3E88-C8E7-4600-B4A4-3E65BB803D64}" dt="2021-07-01T08:59:42.215" v="1297"/>
          <ac:picMkLst>
            <pc:docMk/>
            <pc:sldMk cId="731297326" sldId="270"/>
            <ac:picMk id="472" creationId="{13172DC3-3460-40E8-A86B-A00EABEC4C1F}"/>
          </ac:picMkLst>
        </pc:picChg>
        <pc:picChg chg="mod">
          <ac:chgData name="Manasweeta Angane" userId="05da2731-9352-4b35-b713-60351f56afbd" providerId="ADAL" clId="{121B3E88-C8E7-4600-B4A4-3E65BB803D64}" dt="2021-07-01T08:59:42.215" v="1297"/>
          <ac:picMkLst>
            <pc:docMk/>
            <pc:sldMk cId="731297326" sldId="270"/>
            <ac:picMk id="473" creationId="{86C23CCD-8B75-4A54-A3FD-26DA38EA3DF7}"/>
          </ac:picMkLst>
        </pc:picChg>
        <pc:picChg chg="mod">
          <ac:chgData name="Manasweeta Angane" userId="05da2731-9352-4b35-b713-60351f56afbd" providerId="ADAL" clId="{121B3E88-C8E7-4600-B4A4-3E65BB803D64}" dt="2021-07-01T09:09:08.436" v="1306"/>
          <ac:picMkLst>
            <pc:docMk/>
            <pc:sldMk cId="731297326" sldId="270"/>
            <ac:picMk id="475" creationId="{D01F2C6E-B65D-475D-9D80-EDCD59C5C06A}"/>
          </ac:picMkLst>
        </pc:picChg>
        <pc:picChg chg="mod">
          <ac:chgData name="Manasweeta Angane" userId="05da2731-9352-4b35-b713-60351f56afbd" providerId="ADAL" clId="{121B3E88-C8E7-4600-B4A4-3E65BB803D64}" dt="2021-07-01T09:09:08.436" v="1306"/>
          <ac:picMkLst>
            <pc:docMk/>
            <pc:sldMk cId="731297326" sldId="270"/>
            <ac:picMk id="476" creationId="{0D757A04-000D-4C6B-BF10-15D58329D7FD}"/>
          </ac:picMkLst>
        </pc:picChg>
        <pc:picChg chg="mod">
          <ac:chgData name="Manasweeta Angane" userId="05da2731-9352-4b35-b713-60351f56afbd" providerId="ADAL" clId="{121B3E88-C8E7-4600-B4A4-3E65BB803D64}" dt="2021-07-01T09:11:20.745" v="1344"/>
          <ac:picMkLst>
            <pc:docMk/>
            <pc:sldMk cId="731297326" sldId="270"/>
            <ac:picMk id="478" creationId="{8E80D889-7745-442C-8259-B19E1FFCA4A7}"/>
          </ac:picMkLst>
        </pc:picChg>
        <pc:picChg chg="mod">
          <ac:chgData name="Manasweeta Angane" userId="05da2731-9352-4b35-b713-60351f56afbd" providerId="ADAL" clId="{121B3E88-C8E7-4600-B4A4-3E65BB803D64}" dt="2021-07-01T09:11:20.745" v="1344"/>
          <ac:picMkLst>
            <pc:docMk/>
            <pc:sldMk cId="731297326" sldId="270"/>
            <ac:picMk id="479" creationId="{FE999972-5509-46AC-9E84-6EDD51B28385}"/>
          </ac:picMkLst>
        </pc:picChg>
        <pc:picChg chg="mod">
          <ac:chgData name="Manasweeta Angane" userId="05da2731-9352-4b35-b713-60351f56afbd" providerId="ADAL" clId="{121B3E88-C8E7-4600-B4A4-3E65BB803D64}" dt="2021-07-01T09:12:28.682" v="1428"/>
          <ac:picMkLst>
            <pc:docMk/>
            <pc:sldMk cId="731297326" sldId="270"/>
            <ac:picMk id="481" creationId="{0C430D99-6533-472B-9B24-31E5EA5F3020}"/>
          </ac:picMkLst>
        </pc:picChg>
        <pc:picChg chg="mod">
          <ac:chgData name="Manasweeta Angane" userId="05da2731-9352-4b35-b713-60351f56afbd" providerId="ADAL" clId="{121B3E88-C8E7-4600-B4A4-3E65BB803D64}" dt="2021-07-01T09:12:28.682" v="1428"/>
          <ac:picMkLst>
            <pc:docMk/>
            <pc:sldMk cId="731297326" sldId="270"/>
            <ac:picMk id="482" creationId="{EEC8CBA2-BDC6-42DB-8B66-8DB9014EC449}"/>
          </ac:picMkLst>
        </pc:picChg>
        <pc:picChg chg="mod">
          <ac:chgData name="Manasweeta Angane" userId="05da2731-9352-4b35-b713-60351f56afbd" providerId="ADAL" clId="{121B3E88-C8E7-4600-B4A4-3E65BB803D64}" dt="2021-07-01T09:13:27.635" v="1435"/>
          <ac:picMkLst>
            <pc:docMk/>
            <pc:sldMk cId="731297326" sldId="270"/>
            <ac:picMk id="484" creationId="{8E9F4D6E-0E9E-4FD5-9D89-905D95E0B954}"/>
          </ac:picMkLst>
        </pc:picChg>
        <pc:picChg chg="mod">
          <ac:chgData name="Manasweeta Angane" userId="05da2731-9352-4b35-b713-60351f56afbd" providerId="ADAL" clId="{121B3E88-C8E7-4600-B4A4-3E65BB803D64}" dt="2021-07-01T09:13:27.635" v="1435"/>
          <ac:picMkLst>
            <pc:docMk/>
            <pc:sldMk cId="731297326" sldId="270"/>
            <ac:picMk id="485" creationId="{9648E580-F171-4311-8445-EE50E4364BEF}"/>
          </ac:picMkLst>
        </pc:picChg>
        <pc:picChg chg="mod">
          <ac:chgData name="Manasweeta Angane" userId="05da2731-9352-4b35-b713-60351f56afbd" providerId="ADAL" clId="{121B3E88-C8E7-4600-B4A4-3E65BB803D64}" dt="2021-07-01T09:13:27.635" v="1435"/>
          <ac:picMkLst>
            <pc:docMk/>
            <pc:sldMk cId="731297326" sldId="270"/>
            <ac:picMk id="486" creationId="{5F4520C2-5438-4C0D-8A30-48AD129A5604}"/>
          </ac:picMkLst>
        </pc:picChg>
        <pc:picChg chg="add mod">
          <ac:chgData name="Manasweeta Angane" userId="05da2731-9352-4b35-b713-60351f56afbd" providerId="ADAL" clId="{121B3E88-C8E7-4600-B4A4-3E65BB803D64}" dt="2021-07-01T09:14:34.898" v="1656" actId="1036"/>
          <ac:picMkLst>
            <pc:docMk/>
            <pc:sldMk cId="731297326" sldId="270"/>
            <ac:picMk id="487" creationId="{02DFC27E-26BF-4E47-9344-25BABE2EEE0E}"/>
          </ac:picMkLst>
        </pc:picChg>
        <pc:picChg chg="add mod">
          <ac:chgData name="Manasweeta Angane" userId="05da2731-9352-4b35-b713-60351f56afbd" providerId="ADAL" clId="{121B3E88-C8E7-4600-B4A4-3E65BB803D64}" dt="2021-07-01T09:14:34.898" v="1656" actId="1036"/>
          <ac:picMkLst>
            <pc:docMk/>
            <pc:sldMk cId="731297326" sldId="270"/>
            <ac:picMk id="488" creationId="{B99E4C27-486E-4E91-B0E5-8E08188A02B7}"/>
          </ac:picMkLst>
        </pc:picChg>
        <pc:picChg chg="mod">
          <ac:chgData name="Manasweeta Angane" userId="05da2731-9352-4b35-b713-60351f56afbd" providerId="ADAL" clId="{121B3E88-C8E7-4600-B4A4-3E65BB803D64}" dt="2021-07-01T09:30:50.106" v="1660"/>
          <ac:picMkLst>
            <pc:docMk/>
            <pc:sldMk cId="731297326" sldId="270"/>
            <ac:picMk id="490" creationId="{E0EAAB47-1840-4A95-A332-B69737A75FB9}"/>
          </ac:picMkLst>
        </pc:picChg>
        <pc:picChg chg="mod">
          <ac:chgData name="Manasweeta Angane" userId="05da2731-9352-4b35-b713-60351f56afbd" providerId="ADAL" clId="{121B3E88-C8E7-4600-B4A4-3E65BB803D64}" dt="2021-07-01T09:30:50.106" v="1660"/>
          <ac:picMkLst>
            <pc:docMk/>
            <pc:sldMk cId="731297326" sldId="270"/>
            <ac:picMk id="491" creationId="{BCB68283-3090-451F-AFCE-3F27AC00EC1A}"/>
          </ac:picMkLst>
        </pc:picChg>
        <pc:picChg chg="mod">
          <ac:chgData name="Manasweeta Angane" userId="05da2731-9352-4b35-b713-60351f56afbd" providerId="ADAL" clId="{121B3E88-C8E7-4600-B4A4-3E65BB803D64}" dt="2021-07-01T10:10:51.360" v="1716"/>
          <ac:picMkLst>
            <pc:docMk/>
            <pc:sldMk cId="731297326" sldId="270"/>
            <ac:picMk id="493" creationId="{583E3AA6-A612-4ABB-B646-81B68B641BDC}"/>
          </ac:picMkLst>
        </pc:picChg>
        <pc:picChg chg="mod">
          <ac:chgData name="Manasweeta Angane" userId="05da2731-9352-4b35-b713-60351f56afbd" providerId="ADAL" clId="{121B3E88-C8E7-4600-B4A4-3E65BB803D64}" dt="2021-07-01T10:10:51.360" v="1716"/>
          <ac:picMkLst>
            <pc:docMk/>
            <pc:sldMk cId="731297326" sldId="270"/>
            <ac:picMk id="494" creationId="{6E1FF49E-5802-488C-BA9A-B50841552EE2}"/>
          </ac:picMkLst>
        </pc:picChg>
        <pc:picChg chg="mod">
          <ac:chgData name="Manasweeta Angane" userId="05da2731-9352-4b35-b713-60351f56afbd" providerId="ADAL" clId="{121B3E88-C8E7-4600-B4A4-3E65BB803D64}" dt="2021-07-01T10:16:52.910" v="1778"/>
          <ac:picMkLst>
            <pc:docMk/>
            <pc:sldMk cId="731297326" sldId="270"/>
            <ac:picMk id="496" creationId="{F7172394-0267-4117-9F97-EC293452B37A}"/>
          </ac:picMkLst>
        </pc:picChg>
        <pc:picChg chg="mod">
          <ac:chgData name="Manasweeta Angane" userId="05da2731-9352-4b35-b713-60351f56afbd" providerId="ADAL" clId="{121B3E88-C8E7-4600-B4A4-3E65BB803D64}" dt="2021-07-01T10:16:52.910" v="1778"/>
          <ac:picMkLst>
            <pc:docMk/>
            <pc:sldMk cId="731297326" sldId="270"/>
            <ac:picMk id="497" creationId="{63862557-7618-4F17-90FB-E48B541E4D67}"/>
          </ac:picMkLst>
        </pc:picChg>
        <pc:picChg chg="mod">
          <ac:chgData name="Manasweeta Angane" userId="05da2731-9352-4b35-b713-60351f56afbd" providerId="ADAL" clId="{121B3E88-C8E7-4600-B4A4-3E65BB803D64}" dt="2021-07-01T11:26:33.402" v="2255" actId="1076"/>
          <ac:picMkLst>
            <pc:docMk/>
            <pc:sldMk cId="731297326" sldId="270"/>
            <ac:picMk id="499" creationId="{47438183-923E-4CD1-97F1-A26464FE51CC}"/>
          </ac:picMkLst>
        </pc:picChg>
        <pc:picChg chg="mod">
          <ac:chgData name="Manasweeta Angane" userId="05da2731-9352-4b35-b713-60351f56afbd" providerId="ADAL" clId="{121B3E88-C8E7-4600-B4A4-3E65BB803D64}" dt="2021-07-01T11:26:33.402" v="2255" actId="1076"/>
          <ac:picMkLst>
            <pc:docMk/>
            <pc:sldMk cId="731297326" sldId="270"/>
            <ac:picMk id="500" creationId="{E3FC96C7-E447-4707-B72B-95581E71FE8D}"/>
          </ac:picMkLst>
        </pc:picChg>
        <pc:picChg chg="mod">
          <ac:chgData name="Manasweeta Angane" userId="05da2731-9352-4b35-b713-60351f56afbd" providerId="ADAL" clId="{121B3E88-C8E7-4600-B4A4-3E65BB803D64}" dt="2021-07-01T10:22:31.078" v="1809"/>
          <ac:picMkLst>
            <pc:docMk/>
            <pc:sldMk cId="731297326" sldId="270"/>
            <ac:picMk id="502" creationId="{EEA7D436-E58A-4FA7-BC90-E5CEF6C232DD}"/>
          </ac:picMkLst>
        </pc:picChg>
        <pc:picChg chg="mod">
          <ac:chgData name="Manasweeta Angane" userId="05da2731-9352-4b35-b713-60351f56afbd" providerId="ADAL" clId="{121B3E88-C8E7-4600-B4A4-3E65BB803D64}" dt="2021-07-01T10:22:31.078" v="1809"/>
          <ac:picMkLst>
            <pc:docMk/>
            <pc:sldMk cId="731297326" sldId="270"/>
            <ac:picMk id="503" creationId="{609EF812-4C7D-4E66-BAAB-1C9420A837BF}"/>
          </ac:picMkLst>
        </pc:picChg>
        <pc:picChg chg="add mod ord">
          <ac:chgData name="Manasweeta Angane" userId="05da2731-9352-4b35-b713-60351f56afbd" providerId="ADAL" clId="{121B3E88-C8E7-4600-B4A4-3E65BB803D64}" dt="2021-07-01T10:45:16.251" v="1930" actId="164"/>
          <ac:picMkLst>
            <pc:docMk/>
            <pc:sldMk cId="731297326" sldId="270"/>
            <ac:picMk id="504" creationId="{3207A651-F857-4BCF-A553-B5743BFC051B}"/>
          </ac:picMkLst>
        </pc:picChg>
        <pc:picChg chg="mod">
          <ac:chgData name="Manasweeta Angane" userId="05da2731-9352-4b35-b713-60351f56afbd" providerId="ADAL" clId="{121B3E88-C8E7-4600-B4A4-3E65BB803D64}" dt="2021-07-01T10:24:10.535" v="1817"/>
          <ac:picMkLst>
            <pc:docMk/>
            <pc:sldMk cId="731297326" sldId="270"/>
            <ac:picMk id="506" creationId="{02ED1EC7-CCD2-4860-BAB9-ECF487B93BE1}"/>
          </ac:picMkLst>
        </pc:picChg>
        <pc:picChg chg="mod">
          <ac:chgData name="Manasweeta Angane" userId="05da2731-9352-4b35-b713-60351f56afbd" providerId="ADAL" clId="{121B3E88-C8E7-4600-B4A4-3E65BB803D64}" dt="2021-07-01T10:24:10.535" v="1817"/>
          <ac:picMkLst>
            <pc:docMk/>
            <pc:sldMk cId="731297326" sldId="270"/>
            <ac:picMk id="507" creationId="{45C2C99C-5DE6-449B-8783-FF531E5C8878}"/>
          </ac:picMkLst>
        </pc:picChg>
        <pc:picChg chg="add del mod">
          <ac:chgData name="Manasweeta Angane" userId="05da2731-9352-4b35-b713-60351f56afbd" providerId="ADAL" clId="{121B3E88-C8E7-4600-B4A4-3E65BB803D64}" dt="2021-07-01T10:25:13.376" v="1827" actId="478"/>
          <ac:picMkLst>
            <pc:docMk/>
            <pc:sldMk cId="731297326" sldId="270"/>
            <ac:picMk id="508" creationId="{1F1A8DE1-5F78-41A2-BEB6-DA99096E18BA}"/>
          </ac:picMkLst>
        </pc:picChg>
        <pc:picChg chg="add del mod ord">
          <ac:chgData name="Manasweeta Angane" userId="05da2731-9352-4b35-b713-60351f56afbd" providerId="ADAL" clId="{121B3E88-C8E7-4600-B4A4-3E65BB803D64}" dt="2021-07-01T10:28:19.828" v="1862" actId="1076"/>
          <ac:picMkLst>
            <pc:docMk/>
            <pc:sldMk cId="731297326" sldId="270"/>
            <ac:picMk id="509" creationId="{526632B2-9D5B-44EE-A3F8-4EC82E228D46}"/>
          </ac:picMkLst>
        </pc:picChg>
        <pc:picChg chg="add del mod">
          <ac:chgData name="Manasweeta Angane" userId="05da2731-9352-4b35-b713-60351f56afbd" providerId="ADAL" clId="{121B3E88-C8E7-4600-B4A4-3E65BB803D64}" dt="2021-07-01T10:25:41.103" v="1829" actId="478"/>
          <ac:picMkLst>
            <pc:docMk/>
            <pc:sldMk cId="731297326" sldId="270"/>
            <ac:picMk id="510" creationId="{AE084861-B7FE-4331-B824-349689EBA2CD}"/>
          </ac:picMkLst>
        </pc:picChg>
        <pc:picChg chg="add mod">
          <ac:chgData name="Manasweeta Angane" userId="05da2731-9352-4b35-b713-60351f56afbd" providerId="ADAL" clId="{121B3E88-C8E7-4600-B4A4-3E65BB803D64}" dt="2021-07-01T10:28:14.328" v="1861" actId="1076"/>
          <ac:picMkLst>
            <pc:docMk/>
            <pc:sldMk cId="731297326" sldId="270"/>
            <ac:picMk id="511" creationId="{B4B2E345-CE7D-443B-87E2-4500183AC2B7}"/>
          </ac:picMkLst>
        </pc:picChg>
        <pc:picChg chg="mod">
          <ac:chgData name="Manasweeta Angane" userId="05da2731-9352-4b35-b713-60351f56afbd" providerId="ADAL" clId="{121B3E88-C8E7-4600-B4A4-3E65BB803D64}" dt="2021-07-01T10:37:56.411" v="1864"/>
          <ac:picMkLst>
            <pc:docMk/>
            <pc:sldMk cId="731297326" sldId="270"/>
            <ac:picMk id="513" creationId="{2474A7A9-A3DB-4343-A6D5-718B64FBC23C}"/>
          </ac:picMkLst>
        </pc:picChg>
        <pc:picChg chg="mod">
          <ac:chgData name="Manasweeta Angane" userId="05da2731-9352-4b35-b713-60351f56afbd" providerId="ADAL" clId="{121B3E88-C8E7-4600-B4A4-3E65BB803D64}" dt="2021-07-01T10:37:56.411" v="1864"/>
          <ac:picMkLst>
            <pc:docMk/>
            <pc:sldMk cId="731297326" sldId="270"/>
            <ac:picMk id="514" creationId="{20E366DE-523A-4F42-ACF9-8C8464090672}"/>
          </ac:picMkLst>
        </pc:picChg>
        <pc:picChg chg="mod">
          <ac:chgData name="Manasweeta Angane" userId="05da2731-9352-4b35-b713-60351f56afbd" providerId="ADAL" clId="{121B3E88-C8E7-4600-B4A4-3E65BB803D64}" dt="2021-07-01T10:38:44.080" v="1877"/>
          <ac:picMkLst>
            <pc:docMk/>
            <pc:sldMk cId="731297326" sldId="270"/>
            <ac:picMk id="516" creationId="{DACFA916-1BDE-4711-91A7-331F44DDE1EC}"/>
          </ac:picMkLst>
        </pc:picChg>
        <pc:picChg chg="mod">
          <ac:chgData name="Manasweeta Angane" userId="05da2731-9352-4b35-b713-60351f56afbd" providerId="ADAL" clId="{121B3E88-C8E7-4600-B4A4-3E65BB803D64}" dt="2021-07-01T10:38:44.080" v="1877"/>
          <ac:picMkLst>
            <pc:docMk/>
            <pc:sldMk cId="731297326" sldId="270"/>
            <ac:picMk id="517" creationId="{682DFD51-F0A5-4FAB-9243-3D2A58095218}"/>
          </ac:picMkLst>
        </pc:picChg>
        <pc:picChg chg="mod">
          <ac:chgData name="Manasweeta Angane" userId="05da2731-9352-4b35-b713-60351f56afbd" providerId="ADAL" clId="{121B3E88-C8E7-4600-B4A4-3E65BB803D64}" dt="2021-07-01T11:26:33.402" v="2255" actId="1076"/>
          <ac:picMkLst>
            <pc:docMk/>
            <pc:sldMk cId="731297326" sldId="270"/>
            <ac:picMk id="519" creationId="{5C024A90-BA07-49EF-9D9E-DB451EF0C7F6}"/>
          </ac:picMkLst>
        </pc:picChg>
        <pc:picChg chg="mod">
          <ac:chgData name="Manasweeta Angane" userId="05da2731-9352-4b35-b713-60351f56afbd" providerId="ADAL" clId="{121B3E88-C8E7-4600-B4A4-3E65BB803D64}" dt="2021-07-01T11:26:33.402" v="2255" actId="1076"/>
          <ac:picMkLst>
            <pc:docMk/>
            <pc:sldMk cId="731297326" sldId="270"/>
            <ac:picMk id="520" creationId="{60370C0A-4D79-4305-BB01-B168B0341CEB}"/>
          </ac:picMkLst>
        </pc:picChg>
        <pc:picChg chg="add mod">
          <ac:chgData name="Manasweeta Angane" userId="05da2731-9352-4b35-b713-60351f56afbd" providerId="ADAL" clId="{121B3E88-C8E7-4600-B4A4-3E65BB803D64}" dt="2021-07-01T10:52:33.982" v="2007" actId="164"/>
          <ac:picMkLst>
            <pc:docMk/>
            <pc:sldMk cId="731297326" sldId="270"/>
            <ac:picMk id="521" creationId="{7D29073D-83D7-4244-AF74-628C540B8159}"/>
          </ac:picMkLst>
        </pc:picChg>
        <pc:picChg chg="mod">
          <ac:chgData name="Manasweeta Angane" userId="05da2731-9352-4b35-b713-60351f56afbd" providerId="ADAL" clId="{121B3E88-C8E7-4600-B4A4-3E65BB803D64}" dt="2021-07-01T10:45:20.715" v="1931"/>
          <ac:picMkLst>
            <pc:docMk/>
            <pc:sldMk cId="731297326" sldId="270"/>
            <ac:picMk id="524" creationId="{8A0E3186-2699-485A-B2EB-2A0932D35E20}"/>
          </ac:picMkLst>
        </pc:picChg>
        <pc:picChg chg="mod">
          <ac:chgData name="Manasweeta Angane" userId="05da2731-9352-4b35-b713-60351f56afbd" providerId="ADAL" clId="{121B3E88-C8E7-4600-B4A4-3E65BB803D64}" dt="2021-07-01T10:45:20.715" v="1931"/>
          <ac:picMkLst>
            <pc:docMk/>
            <pc:sldMk cId="731297326" sldId="270"/>
            <ac:picMk id="525" creationId="{3C9D533B-CE05-4E3B-9B08-D71BE3C93EFE}"/>
          </ac:picMkLst>
        </pc:picChg>
        <pc:picChg chg="mod">
          <ac:chgData name="Manasweeta Angane" userId="05da2731-9352-4b35-b713-60351f56afbd" providerId="ADAL" clId="{121B3E88-C8E7-4600-B4A4-3E65BB803D64}" dt="2021-07-01T10:45:20.715" v="1931"/>
          <ac:picMkLst>
            <pc:docMk/>
            <pc:sldMk cId="731297326" sldId="270"/>
            <ac:picMk id="526" creationId="{6A75D0CD-8EF0-4414-A5EE-5E64C738FBEF}"/>
          </ac:picMkLst>
        </pc:picChg>
        <pc:picChg chg="mod">
          <ac:chgData name="Manasweeta Angane" userId="05da2731-9352-4b35-b713-60351f56afbd" providerId="ADAL" clId="{121B3E88-C8E7-4600-B4A4-3E65BB803D64}" dt="2021-07-01T11:26:33.402" v="2255" actId="1076"/>
          <ac:picMkLst>
            <pc:docMk/>
            <pc:sldMk cId="731297326" sldId="270"/>
            <ac:picMk id="528" creationId="{45FDA3F9-2B0C-4C1E-9F0D-42423644A5EF}"/>
          </ac:picMkLst>
        </pc:picChg>
        <pc:picChg chg="mod">
          <ac:chgData name="Manasweeta Angane" userId="05da2731-9352-4b35-b713-60351f56afbd" providerId="ADAL" clId="{121B3E88-C8E7-4600-B4A4-3E65BB803D64}" dt="2021-07-01T11:26:33.402" v="2255" actId="1076"/>
          <ac:picMkLst>
            <pc:docMk/>
            <pc:sldMk cId="731297326" sldId="270"/>
            <ac:picMk id="529" creationId="{D85E138E-9110-4259-83E7-426D5A77F05E}"/>
          </ac:picMkLst>
        </pc:picChg>
        <pc:picChg chg="mod">
          <ac:chgData name="Manasweeta Angane" userId="05da2731-9352-4b35-b713-60351f56afbd" providerId="ADAL" clId="{121B3E88-C8E7-4600-B4A4-3E65BB803D64}" dt="2021-07-01T10:52:37.245" v="2008"/>
          <ac:picMkLst>
            <pc:docMk/>
            <pc:sldMk cId="731297326" sldId="270"/>
            <ac:picMk id="532" creationId="{2DCF646D-0DD5-4304-A179-0453963643A0}"/>
          </ac:picMkLst>
        </pc:picChg>
        <pc:picChg chg="mod">
          <ac:chgData name="Manasweeta Angane" userId="05da2731-9352-4b35-b713-60351f56afbd" providerId="ADAL" clId="{121B3E88-C8E7-4600-B4A4-3E65BB803D64}" dt="2021-07-01T10:52:37.245" v="2008"/>
          <ac:picMkLst>
            <pc:docMk/>
            <pc:sldMk cId="731297326" sldId="270"/>
            <ac:picMk id="533" creationId="{9D85B7B5-0107-40E7-8631-EC2C2D423EB2}"/>
          </ac:picMkLst>
        </pc:picChg>
        <pc:picChg chg="mod">
          <ac:chgData name="Manasweeta Angane" userId="05da2731-9352-4b35-b713-60351f56afbd" providerId="ADAL" clId="{121B3E88-C8E7-4600-B4A4-3E65BB803D64}" dt="2021-07-01T10:52:37.245" v="2008"/>
          <ac:picMkLst>
            <pc:docMk/>
            <pc:sldMk cId="731297326" sldId="270"/>
            <ac:picMk id="534" creationId="{010B4BD1-5851-49BD-ACDE-DF674B13322B}"/>
          </ac:picMkLst>
        </pc:picChg>
        <pc:picChg chg="mod">
          <ac:chgData name="Manasweeta Angane" userId="05da2731-9352-4b35-b713-60351f56afbd" providerId="ADAL" clId="{121B3E88-C8E7-4600-B4A4-3E65BB803D64}" dt="2021-07-01T10:54:12.245" v="2017"/>
          <ac:picMkLst>
            <pc:docMk/>
            <pc:sldMk cId="731297326" sldId="270"/>
            <ac:picMk id="537" creationId="{C45BF95C-8A48-47EF-9A67-BDF330A8CBCB}"/>
          </ac:picMkLst>
        </pc:picChg>
        <pc:picChg chg="mod">
          <ac:chgData name="Manasweeta Angane" userId="05da2731-9352-4b35-b713-60351f56afbd" providerId="ADAL" clId="{121B3E88-C8E7-4600-B4A4-3E65BB803D64}" dt="2021-07-01T10:54:12.245" v="2017"/>
          <ac:picMkLst>
            <pc:docMk/>
            <pc:sldMk cId="731297326" sldId="270"/>
            <ac:picMk id="538" creationId="{8A74F833-9194-4A67-8B6F-B100871623A0}"/>
          </ac:picMkLst>
        </pc:picChg>
        <pc:picChg chg="mod">
          <ac:chgData name="Manasweeta Angane" userId="05da2731-9352-4b35-b713-60351f56afbd" providerId="ADAL" clId="{121B3E88-C8E7-4600-B4A4-3E65BB803D64}" dt="2021-07-01T10:54:12.245" v="2017"/>
          <ac:picMkLst>
            <pc:docMk/>
            <pc:sldMk cId="731297326" sldId="270"/>
            <ac:picMk id="539" creationId="{3A60FC89-CEFA-4015-856B-452522161A76}"/>
          </ac:picMkLst>
        </pc:picChg>
        <pc:picChg chg="del mod">
          <ac:chgData name="Manasweeta Angane" userId="05da2731-9352-4b35-b713-60351f56afbd" providerId="ADAL" clId="{121B3E88-C8E7-4600-B4A4-3E65BB803D64}" dt="2021-07-01T11:33:33.665" v="2278" actId="478"/>
          <ac:picMkLst>
            <pc:docMk/>
            <pc:sldMk cId="731297326" sldId="270"/>
            <ac:picMk id="542" creationId="{33B16601-6B79-4AE3-A5D1-114A916A40A3}"/>
          </ac:picMkLst>
        </pc:picChg>
        <pc:picChg chg="del mod">
          <ac:chgData name="Manasweeta Angane" userId="05da2731-9352-4b35-b713-60351f56afbd" providerId="ADAL" clId="{121B3E88-C8E7-4600-B4A4-3E65BB803D64}" dt="2021-07-01T11:33:39.535" v="2281" actId="478"/>
          <ac:picMkLst>
            <pc:docMk/>
            <pc:sldMk cId="731297326" sldId="270"/>
            <ac:picMk id="543" creationId="{528F0721-BBB4-4B74-A149-7DD485E3ED0A}"/>
          </ac:picMkLst>
        </pc:picChg>
        <pc:picChg chg="del mod">
          <ac:chgData name="Manasweeta Angane" userId="05da2731-9352-4b35-b713-60351f56afbd" providerId="ADAL" clId="{121B3E88-C8E7-4600-B4A4-3E65BB803D64}" dt="2021-07-01T11:33:41.614" v="2282" actId="478"/>
          <ac:picMkLst>
            <pc:docMk/>
            <pc:sldMk cId="731297326" sldId="270"/>
            <ac:picMk id="544" creationId="{3660881A-EFBD-495A-86E5-1D65DF2E86A7}"/>
          </ac:picMkLst>
        </pc:picChg>
      </pc:sldChg>
      <pc:sldChg chg="addSp delSp modSp add mod">
        <pc:chgData name="Manasweeta Angane" userId="05da2731-9352-4b35-b713-60351f56afbd" providerId="ADAL" clId="{121B3E88-C8E7-4600-B4A4-3E65BB803D64}" dt="2021-07-01T20:02:33.436" v="2410" actId="1076"/>
        <pc:sldMkLst>
          <pc:docMk/>
          <pc:sldMk cId="4188440041" sldId="271"/>
        </pc:sldMkLst>
        <pc:spChg chg="del">
          <ac:chgData name="Manasweeta Angane" userId="05da2731-9352-4b35-b713-60351f56afbd" providerId="ADAL" clId="{121B3E88-C8E7-4600-B4A4-3E65BB803D64}" dt="2021-07-01T19:53:52.992" v="2285" actId="478"/>
          <ac:spMkLst>
            <pc:docMk/>
            <pc:sldMk cId="4188440041" sldId="271"/>
            <ac:spMk id="13" creationId="{4E903B95-E5BD-4DEC-B559-9D2FB529FE27}"/>
          </ac:spMkLst>
        </pc:spChg>
        <pc:spChg chg="del">
          <ac:chgData name="Manasweeta Angane" userId="05da2731-9352-4b35-b713-60351f56afbd" providerId="ADAL" clId="{121B3E88-C8E7-4600-B4A4-3E65BB803D64}" dt="2021-07-01T19:55:11.726" v="2333" actId="478"/>
          <ac:spMkLst>
            <pc:docMk/>
            <pc:sldMk cId="4188440041" sldId="271"/>
            <ac:spMk id="464" creationId="{AE7BC747-BB05-4618-82ED-600F6CECDA4B}"/>
          </ac:spMkLst>
        </pc:spChg>
        <pc:grpChg chg="del">
          <ac:chgData name="Manasweeta Angane" userId="05da2731-9352-4b35-b713-60351f56afbd" providerId="ADAL" clId="{121B3E88-C8E7-4600-B4A4-3E65BB803D64}" dt="2021-07-01T19:54:49.629" v="2325" actId="478"/>
          <ac:grpSpMkLst>
            <pc:docMk/>
            <pc:sldMk cId="4188440041" sldId="271"/>
            <ac:grpSpMk id="2" creationId="{CDDECE0C-A6EE-4B64-B730-F15394E60E37}"/>
          </ac:grpSpMkLst>
        </pc:grpChg>
        <pc:grpChg chg="del">
          <ac:chgData name="Manasweeta Angane" userId="05da2731-9352-4b35-b713-60351f56afbd" providerId="ADAL" clId="{121B3E88-C8E7-4600-B4A4-3E65BB803D64}" dt="2021-07-01T19:54:44.980" v="2320" actId="478"/>
          <ac:grpSpMkLst>
            <pc:docMk/>
            <pc:sldMk cId="4188440041" sldId="271"/>
            <ac:grpSpMk id="5" creationId="{76A86ECE-F864-4D73-8DD9-07C841466624}"/>
          </ac:grpSpMkLst>
        </pc:grpChg>
        <pc:grpChg chg="mod">
          <ac:chgData name="Manasweeta Angane" userId="05da2731-9352-4b35-b713-60351f56afbd" providerId="ADAL" clId="{121B3E88-C8E7-4600-B4A4-3E65BB803D64}" dt="2021-07-01T19:56:56.908" v="2351" actId="1076"/>
          <ac:grpSpMkLst>
            <pc:docMk/>
            <pc:sldMk cId="4188440041" sldId="271"/>
            <ac:grpSpMk id="6" creationId="{75ECB785-9F03-47B9-9993-E033DA928C01}"/>
          </ac:grpSpMkLst>
        </pc:grpChg>
        <pc:grpChg chg="del">
          <ac:chgData name="Manasweeta Angane" userId="05da2731-9352-4b35-b713-60351f56afbd" providerId="ADAL" clId="{121B3E88-C8E7-4600-B4A4-3E65BB803D64}" dt="2021-07-01T19:54:54.359" v="2326" actId="478"/>
          <ac:grpSpMkLst>
            <pc:docMk/>
            <pc:sldMk cId="4188440041" sldId="271"/>
            <ac:grpSpMk id="7" creationId="{E1C68698-1206-4D21-83CA-777640CE06F2}"/>
          </ac:grpSpMkLst>
        </pc:grpChg>
        <pc:grpChg chg="del">
          <ac:chgData name="Manasweeta Angane" userId="05da2731-9352-4b35-b713-60351f56afbd" providerId="ADAL" clId="{121B3E88-C8E7-4600-B4A4-3E65BB803D64}" dt="2021-07-01T19:53:52.992" v="2285" actId="478"/>
          <ac:grpSpMkLst>
            <pc:docMk/>
            <pc:sldMk cId="4188440041" sldId="271"/>
            <ac:grpSpMk id="12" creationId="{2A2E5B81-1D2A-43DB-986F-3B0511728A9A}"/>
          </ac:grpSpMkLst>
        </pc:grpChg>
        <pc:grpChg chg="del">
          <ac:chgData name="Manasweeta Angane" userId="05da2731-9352-4b35-b713-60351f56afbd" providerId="ADAL" clId="{121B3E88-C8E7-4600-B4A4-3E65BB803D64}" dt="2021-07-01T19:53:52.992" v="2285" actId="478"/>
          <ac:grpSpMkLst>
            <pc:docMk/>
            <pc:sldMk cId="4188440041" sldId="271"/>
            <ac:grpSpMk id="16" creationId="{19DE4891-A407-4917-BDEF-5C09D1E35A62}"/>
          </ac:grpSpMkLst>
        </pc:grpChg>
        <pc:grpChg chg="del">
          <ac:chgData name="Manasweeta Angane" userId="05da2731-9352-4b35-b713-60351f56afbd" providerId="ADAL" clId="{121B3E88-C8E7-4600-B4A4-3E65BB803D64}" dt="2021-07-01T19:54:54.359" v="2326" actId="478"/>
          <ac:grpSpMkLst>
            <pc:docMk/>
            <pc:sldMk cId="4188440041" sldId="271"/>
            <ac:grpSpMk id="18" creationId="{3C65095A-C8DF-4380-A319-15843A6451B5}"/>
          </ac:grpSpMkLst>
        </pc:grpChg>
        <pc:grpChg chg="del">
          <ac:chgData name="Manasweeta Angane" userId="05da2731-9352-4b35-b713-60351f56afbd" providerId="ADAL" clId="{121B3E88-C8E7-4600-B4A4-3E65BB803D64}" dt="2021-07-01T19:54:57.666" v="2329" actId="478"/>
          <ac:grpSpMkLst>
            <pc:docMk/>
            <pc:sldMk cId="4188440041" sldId="271"/>
            <ac:grpSpMk id="20" creationId="{EA024967-F98A-49CB-84CC-14F8ED39020B}"/>
          </ac:grpSpMkLst>
        </pc:grpChg>
        <pc:grpChg chg="del">
          <ac:chgData name="Manasweeta Angane" userId="05da2731-9352-4b35-b713-60351f56afbd" providerId="ADAL" clId="{121B3E88-C8E7-4600-B4A4-3E65BB803D64}" dt="2021-07-01T19:54:43.359" v="2318" actId="478"/>
          <ac:grpSpMkLst>
            <pc:docMk/>
            <pc:sldMk cId="4188440041" sldId="271"/>
            <ac:grpSpMk id="21" creationId="{23678D48-FA37-4B70-B7FF-DC66B62C1674}"/>
          </ac:grpSpMkLst>
        </pc:grpChg>
        <pc:grpChg chg="del">
          <ac:chgData name="Manasweeta Angane" userId="05da2731-9352-4b35-b713-60351f56afbd" providerId="ADAL" clId="{121B3E88-C8E7-4600-B4A4-3E65BB803D64}" dt="2021-07-01T19:54:56.603" v="2328" actId="478"/>
          <ac:grpSpMkLst>
            <pc:docMk/>
            <pc:sldMk cId="4188440041" sldId="271"/>
            <ac:grpSpMk id="24" creationId="{6047A8A4-E1D6-42FC-9555-BAF4A27222FD}"/>
          </ac:grpSpMkLst>
        </pc:grpChg>
        <pc:grpChg chg="del">
          <ac:chgData name="Manasweeta Angane" userId="05da2731-9352-4b35-b713-60351f56afbd" providerId="ADAL" clId="{121B3E88-C8E7-4600-B4A4-3E65BB803D64}" dt="2021-07-01T19:54:13.514" v="2300" actId="478"/>
          <ac:grpSpMkLst>
            <pc:docMk/>
            <pc:sldMk cId="4188440041" sldId="271"/>
            <ac:grpSpMk id="25" creationId="{6E7BEBA2-FC8C-480F-95F6-2E987D481AA8}"/>
          </ac:grpSpMkLst>
        </pc:grpChg>
        <pc:grpChg chg="del">
          <ac:chgData name="Manasweeta Angane" userId="05da2731-9352-4b35-b713-60351f56afbd" providerId="ADAL" clId="{121B3E88-C8E7-4600-B4A4-3E65BB803D64}" dt="2021-07-01T19:53:52.992" v="2285" actId="478"/>
          <ac:grpSpMkLst>
            <pc:docMk/>
            <pc:sldMk cId="4188440041" sldId="271"/>
            <ac:grpSpMk id="30" creationId="{89158FF9-56F5-42C8-918A-46A99E71D281}"/>
          </ac:grpSpMkLst>
        </pc:grpChg>
        <pc:grpChg chg="del">
          <ac:chgData name="Manasweeta Angane" userId="05da2731-9352-4b35-b713-60351f56afbd" providerId="ADAL" clId="{121B3E88-C8E7-4600-B4A4-3E65BB803D64}" dt="2021-07-01T19:54:27.215" v="2303" actId="478"/>
          <ac:grpSpMkLst>
            <pc:docMk/>
            <pc:sldMk cId="4188440041" sldId="271"/>
            <ac:grpSpMk id="34" creationId="{5E478530-2C31-4D20-9DBC-346296D12578}"/>
          </ac:grpSpMkLst>
        </pc:grpChg>
        <pc:grpChg chg="del">
          <ac:chgData name="Manasweeta Angane" userId="05da2731-9352-4b35-b713-60351f56afbd" providerId="ADAL" clId="{121B3E88-C8E7-4600-B4A4-3E65BB803D64}" dt="2021-07-01T19:53:52.992" v="2285" actId="478"/>
          <ac:grpSpMkLst>
            <pc:docMk/>
            <pc:sldMk cId="4188440041" sldId="271"/>
            <ac:grpSpMk id="35" creationId="{F4CAC3CF-0DC4-4031-A80B-994CB03CA8F9}"/>
          </ac:grpSpMkLst>
        </pc:grpChg>
        <pc:grpChg chg="del">
          <ac:chgData name="Manasweeta Angane" userId="05da2731-9352-4b35-b713-60351f56afbd" providerId="ADAL" clId="{121B3E88-C8E7-4600-B4A4-3E65BB803D64}" dt="2021-07-01T19:54:09.558" v="2296" actId="478"/>
          <ac:grpSpMkLst>
            <pc:docMk/>
            <pc:sldMk cId="4188440041" sldId="271"/>
            <ac:grpSpMk id="36" creationId="{2F63E80D-3BF8-4AA5-8CC4-1D04E4C8976B}"/>
          </ac:grpSpMkLst>
        </pc:grpChg>
        <pc:grpChg chg="del">
          <ac:chgData name="Manasweeta Angane" userId="05da2731-9352-4b35-b713-60351f56afbd" providerId="ADAL" clId="{121B3E88-C8E7-4600-B4A4-3E65BB803D64}" dt="2021-07-01T19:53:59.773" v="2286" actId="478"/>
          <ac:grpSpMkLst>
            <pc:docMk/>
            <pc:sldMk cId="4188440041" sldId="271"/>
            <ac:grpSpMk id="218" creationId="{B578E15F-6E9D-450A-BC10-4364FFDF4542}"/>
          </ac:grpSpMkLst>
        </pc:grpChg>
        <pc:grpChg chg="del">
          <ac:chgData name="Manasweeta Angane" userId="05da2731-9352-4b35-b713-60351f56afbd" providerId="ADAL" clId="{121B3E88-C8E7-4600-B4A4-3E65BB803D64}" dt="2021-07-01T19:55:00.337" v="2332" actId="478"/>
          <ac:grpSpMkLst>
            <pc:docMk/>
            <pc:sldMk cId="4188440041" sldId="271"/>
            <ac:grpSpMk id="266" creationId="{30884ABD-770E-4F90-8DCD-DD0DBCFA01B5}"/>
          </ac:grpSpMkLst>
        </pc:grpChg>
        <pc:grpChg chg="del">
          <ac:chgData name="Manasweeta Angane" userId="05da2731-9352-4b35-b713-60351f56afbd" providerId="ADAL" clId="{121B3E88-C8E7-4600-B4A4-3E65BB803D64}" dt="2021-07-01T19:54:45.994" v="2321" actId="478"/>
          <ac:grpSpMkLst>
            <pc:docMk/>
            <pc:sldMk cId="4188440041" sldId="271"/>
            <ac:grpSpMk id="290" creationId="{76940501-C6B1-4261-BB57-13E2A4A9A29F}"/>
          </ac:grpSpMkLst>
        </pc:grpChg>
        <pc:grpChg chg="del">
          <ac:chgData name="Manasweeta Angane" userId="05da2731-9352-4b35-b713-60351f56afbd" providerId="ADAL" clId="{121B3E88-C8E7-4600-B4A4-3E65BB803D64}" dt="2021-07-01T19:54:08.699" v="2295" actId="478"/>
          <ac:grpSpMkLst>
            <pc:docMk/>
            <pc:sldMk cId="4188440041" sldId="271"/>
            <ac:grpSpMk id="332" creationId="{185DDFD9-4BF4-4B77-862B-896EAACA3369}"/>
          </ac:grpSpMkLst>
        </pc:grpChg>
        <pc:grpChg chg="del">
          <ac:chgData name="Manasweeta Angane" userId="05da2731-9352-4b35-b713-60351f56afbd" providerId="ADAL" clId="{121B3E88-C8E7-4600-B4A4-3E65BB803D64}" dt="2021-07-01T19:54:04.911" v="2291" actId="478"/>
          <ac:grpSpMkLst>
            <pc:docMk/>
            <pc:sldMk cId="4188440041" sldId="271"/>
            <ac:grpSpMk id="341" creationId="{A839F078-44A6-420C-A82F-CF59EF10D5F0}"/>
          </ac:grpSpMkLst>
        </pc:grpChg>
        <pc:grpChg chg="del">
          <ac:chgData name="Manasweeta Angane" userId="05da2731-9352-4b35-b713-60351f56afbd" providerId="ADAL" clId="{121B3E88-C8E7-4600-B4A4-3E65BB803D64}" dt="2021-07-01T19:54:34.754" v="2310" actId="478"/>
          <ac:grpSpMkLst>
            <pc:docMk/>
            <pc:sldMk cId="4188440041" sldId="271"/>
            <ac:grpSpMk id="416" creationId="{EFEFEDFA-5C17-44DE-B624-6ABF10CC015D}"/>
          </ac:grpSpMkLst>
        </pc:grpChg>
        <pc:grpChg chg="del">
          <ac:chgData name="Manasweeta Angane" userId="05da2731-9352-4b35-b713-60351f56afbd" providerId="ADAL" clId="{121B3E88-C8E7-4600-B4A4-3E65BB803D64}" dt="2021-07-01T19:54:29.933" v="2306" actId="478"/>
          <ac:grpSpMkLst>
            <pc:docMk/>
            <pc:sldMk cId="4188440041" sldId="271"/>
            <ac:grpSpMk id="421" creationId="{ED50245C-4182-4036-9C81-4E9F69267F68}"/>
          </ac:grpSpMkLst>
        </pc:grpChg>
        <pc:grpChg chg="del">
          <ac:chgData name="Manasweeta Angane" userId="05da2731-9352-4b35-b713-60351f56afbd" providerId="ADAL" clId="{121B3E88-C8E7-4600-B4A4-3E65BB803D64}" dt="2021-07-01T19:54:37.101" v="2312" actId="478"/>
          <ac:grpSpMkLst>
            <pc:docMk/>
            <pc:sldMk cId="4188440041" sldId="271"/>
            <ac:grpSpMk id="422" creationId="{CD94E1D5-C5C8-4DDB-88A4-A6355C82402D}"/>
          </ac:grpSpMkLst>
        </pc:grpChg>
        <pc:grpChg chg="del">
          <ac:chgData name="Manasweeta Angane" userId="05da2731-9352-4b35-b713-60351f56afbd" providerId="ADAL" clId="{121B3E88-C8E7-4600-B4A4-3E65BB803D64}" dt="2021-07-01T19:54:33.285" v="2309" actId="478"/>
          <ac:grpSpMkLst>
            <pc:docMk/>
            <pc:sldMk cId="4188440041" sldId="271"/>
            <ac:grpSpMk id="423" creationId="{31A86E20-5323-4D86-93CC-715C65EA7369}"/>
          </ac:grpSpMkLst>
        </pc:grpChg>
        <pc:grpChg chg="del">
          <ac:chgData name="Manasweeta Angane" userId="05da2731-9352-4b35-b713-60351f56afbd" providerId="ADAL" clId="{121B3E88-C8E7-4600-B4A4-3E65BB803D64}" dt="2021-07-01T19:54:28.312" v="2304" actId="478"/>
          <ac:grpSpMkLst>
            <pc:docMk/>
            <pc:sldMk cId="4188440041" sldId="271"/>
            <ac:grpSpMk id="425" creationId="{3BA41A6C-461A-4E67-B0E3-B07DB9DBFED9}"/>
          </ac:grpSpMkLst>
        </pc:grpChg>
        <pc:grpChg chg="del">
          <ac:chgData name="Manasweeta Angane" userId="05da2731-9352-4b35-b713-60351f56afbd" providerId="ADAL" clId="{121B3E88-C8E7-4600-B4A4-3E65BB803D64}" dt="2021-07-01T19:54:31.300" v="2307" actId="478"/>
          <ac:grpSpMkLst>
            <pc:docMk/>
            <pc:sldMk cId="4188440041" sldId="271"/>
            <ac:grpSpMk id="430" creationId="{D3E43E59-4164-4F64-92DF-8E280487542E}"/>
          </ac:grpSpMkLst>
        </pc:grpChg>
        <pc:grpChg chg="del">
          <ac:chgData name="Manasweeta Angane" userId="05da2731-9352-4b35-b713-60351f56afbd" providerId="ADAL" clId="{121B3E88-C8E7-4600-B4A4-3E65BB803D64}" dt="2021-07-01T19:54:37.976" v="2313" actId="478"/>
          <ac:grpSpMkLst>
            <pc:docMk/>
            <pc:sldMk cId="4188440041" sldId="271"/>
            <ac:grpSpMk id="432" creationId="{EAF97BDC-67FA-4B42-86E1-DE7EB68FCC68}"/>
          </ac:grpSpMkLst>
        </pc:grpChg>
        <pc:grpChg chg="del">
          <ac:chgData name="Manasweeta Angane" userId="05da2731-9352-4b35-b713-60351f56afbd" providerId="ADAL" clId="{121B3E88-C8E7-4600-B4A4-3E65BB803D64}" dt="2021-07-01T19:53:52.992" v="2285" actId="478"/>
          <ac:grpSpMkLst>
            <pc:docMk/>
            <pc:sldMk cId="4188440041" sldId="271"/>
            <ac:grpSpMk id="474" creationId="{F639CF5E-C3BC-4BA8-A5DF-90FBE9CC83C0}"/>
          </ac:grpSpMkLst>
        </pc:grpChg>
        <pc:grpChg chg="del">
          <ac:chgData name="Manasweeta Angane" userId="05da2731-9352-4b35-b713-60351f56afbd" providerId="ADAL" clId="{121B3E88-C8E7-4600-B4A4-3E65BB803D64}" dt="2021-07-01T19:54:41.072" v="2316" actId="478"/>
          <ac:grpSpMkLst>
            <pc:docMk/>
            <pc:sldMk cId="4188440041" sldId="271"/>
            <ac:grpSpMk id="480" creationId="{CE891513-D3C2-4AE7-BFC6-67ECD9176300}"/>
          </ac:grpSpMkLst>
        </pc:grpChg>
        <pc:grpChg chg="del">
          <ac:chgData name="Manasweeta Angane" userId="05da2731-9352-4b35-b713-60351f56afbd" providerId="ADAL" clId="{121B3E88-C8E7-4600-B4A4-3E65BB803D64}" dt="2021-07-01T19:54:38.757" v="2314" actId="478"/>
          <ac:grpSpMkLst>
            <pc:docMk/>
            <pc:sldMk cId="4188440041" sldId="271"/>
            <ac:grpSpMk id="483" creationId="{E563B09B-E8DC-462C-93CD-D8327771D4CE}"/>
          </ac:grpSpMkLst>
        </pc:grpChg>
        <pc:grpChg chg="del">
          <ac:chgData name="Manasweeta Angane" userId="05da2731-9352-4b35-b713-60351f56afbd" providerId="ADAL" clId="{121B3E88-C8E7-4600-B4A4-3E65BB803D64}" dt="2021-07-01T19:53:52.992" v="2285" actId="478"/>
          <ac:grpSpMkLst>
            <pc:docMk/>
            <pc:sldMk cId="4188440041" sldId="271"/>
            <ac:grpSpMk id="489" creationId="{E92A1D04-C12D-4BBF-BBAF-A67EDFD1F432}"/>
          </ac:grpSpMkLst>
        </pc:grpChg>
        <pc:grpChg chg="del">
          <ac:chgData name="Manasweeta Angane" userId="05da2731-9352-4b35-b713-60351f56afbd" providerId="ADAL" clId="{121B3E88-C8E7-4600-B4A4-3E65BB803D64}" dt="2021-07-01T19:53:52.992" v="2285" actId="478"/>
          <ac:grpSpMkLst>
            <pc:docMk/>
            <pc:sldMk cId="4188440041" sldId="271"/>
            <ac:grpSpMk id="512" creationId="{8E9BF768-F483-48BD-95F6-EC479D734922}"/>
          </ac:grpSpMkLst>
        </pc:grpChg>
        <pc:grpChg chg="del">
          <ac:chgData name="Manasweeta Angane" userId="05da2731-9352-4b35-b713-60351f56afbd" providerId="ADAL" clId="{121B3E88-C8E7-4600-B4A4-3E65BB803D64}" dt="2021-07-01T19:53:52.992" v="2285" actId="478"/>
          <ac:grpSpMkLst>
            <pc:docMk/>
            <pc:sldMk cId="4188440041" sldId="271"/>
            <ac:grpSpMk id="515" creationId="{C72B5716-6B55-4193-B1C8-F26B508BE8F1}"/>
          </ac:grpSpMkLst>
        </pc:grpChg>
        <pc:grpChg chg="del">
          <ac:chgData name="Manasweeta Angane" userId="05da2731-9352-4b35-b713-60351f56afbd" providerId="ADAL" clId="{121B3E88-C8E7-4600-B4A4-3E65BB803D64}" dt="2021-07-01T19:54:02.229" v="2288" actId="478"/>
          <ac:grpSpMkLst>
            <pc:docMk/>
            <pc:sldMk cId="4188440041" sldId="271"/>
            <ac:grpSpMk id="522" creationId="{413888F3-470F-4C04-81A4-9DFA2D54CFFD}"/>
          </ac:grpSpMkLst>
        </pc:grpChg>
        <pc:grpChg chg="del">
          <ac:chgData name="Manasweeta Angane" userId="05da2731-9352-4b35-b713-60351f56afbd" providerId="ADAL" clId="{121B3E88-C8E7-4600-B4A4-3E65BB803D64}" dt="2021-07-01T19:54:01.136" v="2287" actId="478"/>
          <ac:grpSpMkLst>
            <pc:docMk/>
            <pc:sldMk cId="4188440041" sldId="271"/>
            <ac:grpSpMk id="530" creationId="{FB10A85E-2063-4725-B5C2-B7FCFB8C614C}"/>
          </ac:grpSpMkLst>
        </pc:grpChg>
        <pc:grpChg chg="del">
          <ac:chgData name="Manasweeta Angane" userId="05da2731-9352-4b35-b713-60351f56afbd" providerId="ADAL" clId="{121B3E88-C8E7-4600-B4A4-3E65BB803D64}" dt="2021-07-01T19:54:11.544" v="2298" actId="478"/>
          <ac:grpSpMkLst>
            <pc:docMk/>
            <pc:sldMk cId="4188440041" sldId="271"/>
            <ac:grpSpMk id="535" creationId="{C1BF51FD-33DD-486B-96F2-4060E43C9B31}"/>
          </ac:grpSpMkLst>
        </pc:grpChg>
        <pc:picChg chg="add mod">
          <ac:chgData name="Manasweeta Angane" userId="05da2731-9352-4b35-b713-60351f56afbd" providerId="ADAL" clId="{121B3E88-C8E7-4600-B4A4-3E65BB803D64}" dt="2021-07-01T20:01:07.235" v="2387" actId="1076"/>
          <ac:picMkLst>
            <pc:docMk/>
            <pc:sldMk cId="4188440041" sldId="271"/>
            <ac:picMk id="186" creationId="{4914C6D8-ACFB-4D6D-A388-C193D8D5DE73}"/>
          </ac:picMkLst>
        </pc:picChg>
        <pc:picChg chg="add mod">
          <ac:chgData name="Manasweeta Angane" userId="05da2731-9352-4b35-b713-60351f56afbd" providerId="ADAL" clId="{121B3E88-C8E7-4600-B4A4-3E65BB803D64}" dt="2021-07-01T20:02:25.490" v="2408" actId="1076"/>
          <ac:picMkLst>
            <pc:docMk/>
            <pc:sldMk cId="4188440041" sldId="271"/>
            <ac:picMk id="187" creationId="{7C2D1D29-F6A7-4E8F-85FA-8DA3C8A3F304}"/>
          </ac:picMkLst>
        </pc:picChg>
        <pc:picChg chg="add mod">
          <ac:chgData name="Manasweeta Angane" userId="05da2731-9352-4b35-b713-60351f56afbd" providerId="ADAL" clId="{121B3E88-C8E7-4600-B4A4-3E65BB803D64}" dt="2021-07-01T20:02:20.366" v="2405" actId="1076"/>
          <ac:picMkLst>
            <pc:docMk/>
            <pc:sldMk cId="4188440041" sldId="271"/>
            <ac:picMk id="188" creationId="{6531158A-1FB5-4344-8305-E704090CA3D0}"/>
          </ac:picMkLst>
        </pc:picChg>
        <pc:picChg chg="del">
          <ac:chgData name="Manasweeta Angane" userId="05da2731-9352-4b35-b713-60351f56afbd" providerId="ADAL" clId="{121B3E88-C8E7-4600-B4A4-3E65BB803D64}" dt="2021-07-01T19:53:52.992" v="2285" actId="478"/>
          <ac:picMkLst>
            <pc:docMk/>
            <pc:sldMk cId="4188440041" sldId="271"/>
            <ac:picMk id="189" creationId="{B11C9A79-94DF-47BA-A5F0-92B982AEBF7A}"/>
          </ac:picMkLst>
        </pc:picChg>
        <pc:picChg chg="add mod">
          <ac:chgData name="Manasweeta Angane" userId="05da2731-9352-4b35-b713-60351f56afbd" providerId="ADAL" clId="{121B3E88-C8E7-4600-B4A4-3E65BB803D64}" dt="2021-07-01T20:00:11.471" v="2380" actId="1076"/>
          <ac:picMkLst>
            <pc:docMk/>
            <pc:sldMk cId="4188440041" sldId="271"/>
            <ac:picMk id="190" creationId="{51EC5B09-06DD-4589-AF54-93B637BE49A7}"/>
          </ac:picMkLst>
        </pc:picChg>
        <pc:picChg chg="add mod">
          <ac:chgData name="Manasweeta Angane" userId="05da2731-9352-4b35-b713-60351f56afbd" providerId="ADAL" clId="{121B3E88-C8E7-4600-B4A4-3E65BB803D64}" dt="2021-07-01T19:59:55.324" v="2375" actId="1076"/>
          <ac:picMkLst>
            <pc:docMk/>
            <pc:sldMk cId="4188440041" sldId="271"/>
            <ac:picMk id="191" creationId="{E6D54321-3918-4337-8D39-276D6FBF471D}"/>
          </ac:picMkLst>
        </pc:picChg>
        <pc:picChg chg="add mod">
          <ac:chgData name="Manasweeta Angane" userId="05da2731-9352-4b35-b713-60351f56afbd" providerId="ADAL" clId="{121B3E88-C8E7-4600-B4A4-3E65BB803D64}" dt="2021-07-01T20:00:08.080" v="2379" actId="1076"/>
          <ac:picMkLst>
            <pc:docMk/>
            <pc:sldMk cId="4188440041" sldId="271"/>
            <ac:picMk id="192" creationId="{3D85CFDE-9251-414B-A42A-B83E2D26A66C}"/>
          </ac:picMkLst>
        </pc:picChg>
        <pc:picChg chg="add mod">
          <ac:chgData name="Manasweeta Angane" userId="05da2731-9352-4b35-b713-60351f56afbd" providerId="ADAL" clId="{121B3E88-C8E7-4600-B4A4-3E65BB803D64}" dt="2021-07-01T19:58:57.587" v="2359" actId="1076"/>
          <ac:picMkLst>
            <pc:docMk/>
            <pc:sldMk cId="4188440041" sldId="271"/>
            <ac:picMk id="193" creationId="{F89EF2CC-FAE8-44B2-B416-2B2ABC2159EF}"/>
          </ac:picMkLst>
        </pc:picChg>
        <pc:picChg chg="add mod">
          <ac:chgData name="Manasweeta Angane" userId="05da2731-9352-4b35-b713-60351f56afbd" providerId="ADAL" clId="{121B3E88-C8E7-4600-B4A4-3E65BB803D64}" dt="2021-07-01T19:59:09.526" v="2361" actId="1076"/>
          <ac:picMkLst>
            <pc:docMk/>
            <pc:sldMk cId="4188440041" sldId="271"/>
            <ac:picMk id="194" creationId="{B9772D20-8B6A-4266-B6C7-ACBB70C15D4C}"/>
          </ac:picMkLst>
        </pc:picChg>
        <pc:picChg chg="add mod">
          <ac:chgData name="Manasweeta Angane" userId="05da2731-9352-4b35-b713-60351f56afbd" providerId="ADAL" clId="{121B3E88-C8E7-4600-B4A4-3E65BB803D64}" dt="2021-07-01T19:59:56.826" v="2376" actId="1076"/>
          <ac:picMkLst>
            <pc:docMk/>
            <pc:sldMk cId="4188440041" sldId="271"/>
            <ac:picMk id="195" creationId="{93C94E12-F84B-4511-AF26-E38A99D53573}"/>
          </ac:picMkLst>
        </pc:picChg>
        <pc:picChg chg="add mod">
          <ac:chgData name="Manasweeta Angane" userId="05da2731-9352-4b35-b713-60351f56afbd" providerId="ADAL" clId="{121B3E88-C8E7-4600-B4A4-3E65BB803D64}" dt="2021-07-01T20:02:24.100" v="2407" actId="1076"/>
          <ac:picMkLst>
            <pc:docMk/>
            <pc:sldMk cId="4188440041" sldId="271"/>
            <ac:picMk id="196" creationId="{AAEAF89C-7A8F-4209-9338-5534D0A4B878}"/>
          </ac:picMkLst>
        </pc:picChg>
        <pc:picChg chg="add mod">
          <ac:chgData name="Manasweeta Angane" userId="05da2731-9352-4b35-b713-60351f56afbd" providerId="ADAL" clId="{121B3E88-C8E7-4600-B4A4-3E65BB803D64}" dt="2021-07-01T20:02:30.262" v="2409" actId="1076"/>
          <ac:picMkLst>
            <pc:docMk/>
            <pc:sldMk cId="4188440041" sldId="271"/>
            <ac:picMk id="197" creationId="{FF0A100D-809C-4C8E-A095-0E7073924E88}"/>
          </ac:picMkLst>
        </pc:picChg>
        <pc:picChg chg="add mod">
          <ac:chgData name="Manasweeta Angane" userId="05da2731-9352-4b35-b713-60351f56afbd" providerId="ADAL" clId="{121B3E88-C8E7-4600-B4A4-3E65BB803D64}" dt="2021-07-01T20:02:33.436" v="2410" actId="1076"/>
          <ac:picMkLst>
            <pc:docMk/>
            <pc:sldMk cId="4188440041" sldId="271"/>
            <ac:picMk id="198" creationId="{98D48D32-C0E3-4045-AE51-581A702F2E79}"/>
          </ac:picMkLst>
        </pc:picChg>
        <pc:picChg chg="add mod">
          <ac:chgData name="Manasweeta Angane" userId="05da2731-9352-4b35-b713-60351f56afbd" providerId="ADAL" clId="{121B3E88-C8E7-4600-B4A4-3E65BB803D64}" dt="2021-07-01T20:01:54.628" v="2401" actId="1076"/>
          <ac:picMkLst>
            <pc:docMk/>
            <pc:sldMk cId="4188440041" sldId="271"/>
            <ac:picMk id="199" creationId="{71C6E598-6233-42F7-8433-EEBDFFE66FE6}"/>
          </ac:picMkLst>
        </pc:picChg>
        <pc:picChg chg="del">
          <ac:chgData name="Manasweeta Angane" userId="05da2731-9352-4b35-b713-60351f56afbd" providerId="ADAL" clId="{121B3E88-C8E7-4600-B4A4-3E65BB803D64}" dt="2021-07-01T19:53:52.992" v="2285" actId="478"/>
          <ac:picMkLst>
            <pc:docMk/>
            <pc:sldMk cId="4188440041" sldId="271"/>
            <ac:picMk id="200" creationId="{0B22D3E6-F673-438B-95D8-2F8190AABC41}"/>
          </ac:picMkLst>
        </pc:picChg>
        <pc:picChg chg="del">
          <ac:chgData name="Manasweeta Angane" userId="05da2731-9352-4b35-b713-60351f56afbd" providerId="ADAL" clId="{121B3E88-C8E7-4600-B4A4-3E65BB803D64}" dt="2021-07-01T19:54:02.979" v="2289" actId="478"/>
          <ac:picMkLst>
            <pc:docMk/>
            <pc:sldMk cId="4188440041" sldId="271"/>
            <ac:picMk id="201" creationId="{53270373-300D-49B0-AF1A-48B4C3B3FF9E}"/>
          </ac:picMkLst>
        </pc:picChg>
        <pc:picChg chg="del">
          <ac:chgData name="Manasweeta Angane" userId="05da2731-9352-4b35-b713-60351f56afbd" providerId="ADAL" clId="{121B3E88-C8E7-4600-B4A4-3E65BB803D64}" dt="2021-07-01T19:53:59.773" v="2286" actId="478"/>
          <ac:picMkLst>
            <pc:docMk/>
            <pc:sldMk cId="4188440041" sldId="271"/>
            <ac:picMk id="213" creationId="{C840D78D-F425-4B86-8089-D1BD64C32B49}"/>
          </ac:picMkLst>
        </pc:picChg>
        <pc:picChg chg="del">
          <ac:chgData name="Manasweeta Angane" userId="05da2731-9352-4b35-b713-60351f56afbd" providerId="ADAL" clId="{121B3E88-C8E7-4600-B4A4-3E65BB803D64}" dt="2021-07-01T19:53:52.992" v="2285" actId="478"/>
          <ac:picMkLst>
            <pc:docMk/>
            <pc:sldMk cId="4188440041" sldId="271"/>
            <ac:picMk id="214" creationId="{53AB74A0-8EAB-4C13-9943-B609B03FD94B}"/>
          </ac:picMkLst>
        </pc:picChg>
        <pc:picChg chg="del">
          <ac:chgData name="Manasweeta Angane" userId="05da2731-9352-4b35-b713-60351f56afbd" providerId="ADAL" clId="{121B3E88-C8E7-4600-B4A4-3E65BB803D64}" dt="2021-07-01T19:53:52.992" v="2285" actId="478"/>
          <ac:picMkLst>
            <pc:docMk/>
            <pc:sldMk cId="4188440041" sldId="271"/>
            <ac:picMk id="215" creationId="{228EA555-CC1E-488E-9D93-309962FD983B}"/>
          </ac:picMkLst>
        </pc:picChg>
        <pc:picChg chg="del mod">
          <ac:chgData name="Manasweeta Angane" userId="05da2731-9352-4b35-b713-60351f56afbd" providerId="ADAL" clId="{121B3E88-C8E7-4600-B4A4-3E65BB803D64}" dt="2021-07-01T19:54:47.130" v="2323" actId="478"/>
          <ac:picMkLst>
            <pc:docMk/>
            <pc:sldMk cId="4188440041" sldId="271"/>
            <ac:picMk id="221" creationId="{31A98ABF-9560-45E8-91D7-5A68C504CDDD}"/>
          </ac:picMkLst>
        </pc:picChg>
        <pc:picChg chg="del">
          <ac:chgData name="Manasweeta Angane" userId="05da2731-9352-4b35-b713-60351f56afbd" providerId="ADAL" clId="{121B3E88-C8E7-4600-B4A4-3E65BB803D64}" dt="2021-07-01T19:54:42.353" v="2317" actId="478"/>
          <ac:picMkLst>
            <pc:docMk/>
            <pc:sldMk cId="4188440041" sldId="271"/>
            <ac:picMk id="223" creationId="{B0FAFCE0-8C4D-40AC-8F91-8F4B698A810C}"/>
          </ac:picMkLst>
        </pc:picChg>
        <pc:picChg chg="del">
          <ac:chgData name="Manasweeta Angane" userId="05da2731-9352-4b35-b713-60351f56afbd" providerId="ADAL" clId="{121B3E88-C8E7-4600-B4A4-3E65BB803D64}" dt="2021-07-01T19:54:59.462" v="2331" actId="478"/>
          <ac:picMkLst>
            <pc:docMk/>
            <pc:sldMk cId="4188440041" sldId="271"/>
            <ac:picMk id="224" creationId="{7AB5EBDC-9044-471F-A464-EF5F9558CFAC}"/>
          </ac:picMkLst>
        </pc:picChg>
        <pc:picChg chg="del">
          <ac:chgData name="Manasweeta Angane" userId="05da2731-9352-4b35-b713-60351f56afbd" providerId="ADAL" clId="{121B3E88-C8E7-4600-B4A4-3E65BB803D64}" dt="2021-07-01T19:54:54.359" v="2326" actId="478"/>
          <ac:picMkLst>
            <pc:docMk/>
            <pc:sldMk cId="4188440041" sldId="271"/>
            <ac:picMk id="225" creationId="{81619C0F-11DF-497F-A57A-BDC8B2DADB86}"/>
          </ac:picMkLst>
        </pc:picChg>
        <pc:picChg chg="del">
          <ac:chgData name="Manasweeta Angane" userId="05da2731-9352-4b35-b713-60351f56afbd" providerId="ADAL" clId="{121B3E88-C8E7-4600-B4A4-3E65BB803D64}" dt="2021-07-01T19:53:52.992" v="2285" actId="478"/>
          <ac:picMkLst>
            <pc:docMk/>
            <pc:sldMk cId="4188440041" sldId="271"/>
            <ac:picMk id="227" creationId="{158FE962-8BAB-4125-89DC-4B272109865F}"/>
          </ac:picMkLst>
        </pc:picChg>
        <pc:picChg chg="del">
          <ac:chgData name="Manasweeta Angane" userId="05da2731-9352-4b35-b713-60351f56afbd" providerId="ADAL" clId="{121B3E88-C8E7-4600-B4A4-3E65BB803D64}" dt="2021-07-01T19:54:44.249" v="2319" actId="478"/>
          <ac:picMkLst>
            <pc:docMk/>
            <pc:sldMk cId="4188440041" sldId="271"/>
            <ac:picMk id="275" creationId="{FE08B307-244F-44B3-BF15-991EC0B3D278}"/>
          </ac:picMkLst>
        </pc:picChg>
        <pc:picChg chg="del">
          <ac:chgData name="Manasweeta Angane" userId="05da2731-9352-4b35-b713-60351f56afbd" providerId="ADAL" clId="{121B3E88-C8E7-4600-B4A4-3E65BB803D64}" dt="2021-07-01T19:54:55.953" v="2327" actId="478"/>
          <ac:picMkLst>
            <pc:docMk/>
            <pc:sldMk cId="4188440041" sldId="271"/>
            <ac:picMk id="282" creationId="{840D2313-2C60-4D11-979A-51691A1DACB8}"/>
          </ac:picMkLst>
        </pc:picChg>
        <pc:picChg chg="del">
          <ac:chgData name="Manasweeta Angane" userId="05da2731-9352-4b35-b713-60351f56afbd" providerId="ADAL" clId="{121B3E88-C8E7-4600-B4A4-3E65BB803D64}" dt="2021-07-01T19:54:48.004" v="2324" actId="478"/>
          <ac:picMkLst>
            <pc:docMk/>
            <pc:sldMk cId="4188440041" sldId="271"/>
            <ac:picMk id="283" creationId="{D3BB7085-F3A0-4BB6-BAD9-C2F67AE51B20}"/>
          </ac:picMkLst>
        </pc:picChg>
        <pc:picChg chg="del">
          <ac:chgData name="Manasweeta Angane" userId="05da2731-9352-4b35-b713-60351f56afbd" providerId="ADAL" clId="{121B3E88-C8E7-4600-B4A4-3E65BB803D64}" dt="2021-07-01T19:54:58.431" v="2330" actId="478"/>
          <ac:picMkLst>
            <pc:docMk/>
            <pc:sldMk cId="4188440041" sldId="271"/>
            <ac:picMk id="289" creationId="{D7881C87-87DF-47C3-8AFA-CF3F121E72D7}"/>
          </ac:picMkLst>
        </pc:picChg>
        <pc:picChg chg="del">
          <ac:chgData name="Manasweeta Angane" userId="05da2731-9352-4b35-b713-60351f56afbd" providerId="ADAL" clId="{121B3E88-C8E7-4600-B4A4-3E65BB803D64}" dt="2021-07-01T19:54:03.713" v="2290" actId="478"/>
          <ac:picMkLst>
            <pc:docMk/>
            <pc:sldMk cId="4188440041" sldId="271"/>
            <ac:picMk id="309" creationId="{E6327F5E-7580-4BB0-940C-DB969AB35F6D}"/>
          </ac:picMkLst>
        </pc:picChg>
        <pc:picChg chg="del">
          <ac:chgData name="Manasweeta Angane" userId="05da2731-9352-4b35-b713-60351f56afbd" providerId="ADAL" clId="{121B3E88-C8E7-4600-B4A4-3E65BB803D64}" dt="2021-07-01T19:53:52.992" v="2285" actId="478"/>
          <ac:picMkLst>
            <pc:docMk/>
            <pc:sldMk cId="4188440041" sldId="271"/>
            <ac:picMk id="322" creationId="{21F3F74D-5156-4498-894A-9F74F3E111A9}"/>
          </ac:picMkLst>
        </pc:picChg>
        <pc:picChg chg="del">
          <ac:chgData name="Manasweeta Angane" userId="05da2731-9352-4b35-b713-60351f56afbd" providerId="ADAL" clId="{121B3E88-C8E7-4600-B4A4-3E65BB803D64}" dt="2021-07-01T19:53:52.992" v="2285" actId="478"/>
          <ac:picMkLst>
            <pc:docMk/>
            <pc:sldMk cId="4188440041" sldId="271"/>
            <ac:picMk id="324" creationId="{4D055A17-98C8-4B6A-B0BA-DD7EE6C82FD1}"/>
          </ac:picMkLst>
        </pc:picChg>
        <pc:picChg chg="del">
          <ac:chgData name="Manasweeta Angane" userId="05da2731-9352-4b35-b713-60351f56afbd" providerId="ADAL" clId="{121B3E88-C8E7-4600-B4A4-3E65BB803D64}" dt="2021-07-01T19:54:07.918" v="2294" actId="478"/>
          <ac:picMkLst>
            <pc:docMk/>
            <pc:sldMk cId="4188440041" sldId="271"/>
            <ac:picMk id="325" creationId="{491995D0-E425-4CAA-9CA8-29DC0CF6C7A5}"/>
          </ac:picMkLst>
        </pc:picChg>
        <pc:picChg chg="del">
          <ac:chgData name="Manasweeta Angane" userId="05da2731-9352-4b35-b713-60351f56afbd" providerId="ADAL" clId="{121B3E88-C8E7-4600-B4A4-3E65BB803D64}" dt="2021-07-01T19:54:10.513" v="2297" actId="478"/>
          <ac:picMkLst>
            <pc:docMk/>
            <pc:sldMk cId="4188440041" sldId="271"/>
            <ac:picMk id="328" creationId="{DFC549FB-C241-4E2F-B3F7-A4BC97A39EA8}"/>
          </ac:picMkLst>
        </pc:picChg>
        <pc:picChg chg="del">
          <ac:chgData name="Manasweeta Angane" userId="05da2731-9352-4b35-b713-60351f56afbd" providerId="ADAL" clId="{121B3E88-C8E7-4600-B4A4-3E65BB803D64}" dt="2021-07-01T19:53:52.992" v="2285" actId="478"/>
          <ac:picMkLst>
            <pc:docMk/>
            <pc:sldMk cId="4188440041" sldId="271"/>
            <ac:picMk id="329" creationId="{928DC8AB-EEB1-4894-88C5-2E983BE3EE1D}"/>
          </ac:picMkLst>
        </pc:picChg>
        <pc:picChg chg="del">
          <ac:chgData name="Manasweeta Angane" userId="05da2731-9352-4b35-b713-60351f56afbd" providerId="ADAL" clId="{121B3E88-C8E7-4600-B4A4-3E65BB803D64}" dt="2021-07-01T19:53:52.992" v="2285" actId="478"/>
          <ac:picMkLst>
            <pc:docMk/>
            <pc:sldMk cId="4188440041" sldId="271"/>
            <ac:picMk id="330" creationId="{C1EF5365-55E4-48C3-9D25-F86053E8C55B}"/>
          </ac:picMkLst>
        </pc:picChg>
        <pc:picChg chg="del">
          <ac:chgData name="Manasweeta Angane" userId="05da2731-9352-4b35-b713-60351f56afbd" providerId="ADAL" clId="{121B3E88-C8E7-4600-B4A4-3E65BB803D64}" dt="2021-07-01T19:53:52.992" v="2285" actId="478"/>
          <ac:picMkLst>
            <pc:docMk/>
            <pc:sldMk cId="4188440041" sldId="271"/>
            <ac:picMk id="335" creationId="{5CA495C2-85EF-4C76-9F7C-A2D078449E51}"/>
          </ac:picMkLst>
        </pc:picChg>
        <pc:picChg chg="del">
          <ac:chgData name="Manasweeta Angane" userId="05da2731-9352-4b35-b713-60351f56afbd" providerId="ADAL" clId="{121B3E88-C8E7-4600-B4A4-3E65BB803D64}" dt="2021-07-01T19:54:12.692" v="2299" actId="478"/>
          <ac:picMkLst>
            <pc:docMk/>
            <pc:sldMk cId="4188440041" sldId="271"/>
            <ac:picMk id="340" creationId="{F4523582-D23F-4B06-8998-5BA32651631D}"/>
          </ac:picMkLst>
        </pc:picChg>
        <pc:picChg chg="del">
          <ac:chgData name="Manasweeta Angane" userId="05da2731-9352-4b35-b713-60351f56afbd" providerId="ADAL" clId="{121B3E88-C8E7-4600-B4A4-3E65BB803D64}" dt="2021-07-01T19:54:14.453" v="2301" actId="478"/>
          <ac:picMkLst>
            <pc:docMk/>
            <pc:sldMk cId="4188440041" sldId="271"/>
            <ac:picMk id="363" creationId="{F9EE6DF5-2C5A-4A85-8B08-5228BA4CF7C0}"/>
          </ac:picMkLst>
        </pc:picChg>
        <pc:picChg chg="del">
          <ac:chgData name="Manasweeta Angane" userId="05da2731-9352-4b35-b713-60351f56afbd" providerId="ADAL" clId="{121B3E88-C8E7-4600-B4A4-3E65BB803D64}" dt="2021-07-01T19:54:36.023" v="2311" actId="478"/>
          <ac:picMkLst>
            <pc:docMk/>
            <pc:sldMk cId="4188440041" sldId="271"/>
            <ac:picMk id="415" creationId="{72C37080-F336-4329-92FA-B8608B37F7DC}"/>
          </ac:picMkLst>
        </pc:picChg>
        <pc:picChg chg="del">
          <ac:chgData name="Manasweeta Angane" userId="05da2731-9352-4b35-b713-60351f56afbd" providerId="ADAL" clId="{121B3E88-C8E7-4600-B4A4-3E65BB803D64}" dt="2021-07-01T19:54:39.506" v="2315" actId="478"/>
          <ac:picMkLst>
            <pc:docMk/>
            <pc:sldMk cId="4188440041" sldId="271"/>
            <ac:picMk id="418" creationId="{C7D49BD0-3793-4612-B42A-4A9578770EE9}"/>
          </ac:picMkLst>
        </pc:picChg>
        <pc:picChg chg="del">
          <ac:chgData name="Manasweeta Angane" userId="05da2731-9352-4b35-b713-60351f56afbd" providerId="ADAL" clId="{121B3E88-C8E7-4600-B4A4-3E65BB803D64}" dt="2021-07-01T19:54:32.319" v="2308" actId="478"/>
          <ac:picMkLst>
            <pc:docMk/>
            <pc:sldMk cId="4188440041" sldId="271"/>
            <ac:picMk id="419" creationId="{BDBCE160-9993-491A-BB83-1B06E56A9EFA}"/>
          </ac:picMkLst>
        </pc:picChg>
        <pc:picChg chg="del">
          <ac:chgData name="Manasweeta Angane" userId="05da2731-9352-4b35-b713-60351f56afbd" providerId="ADAL" clId="{121B3E88-C8E7-4600-B4A4-3E65BB803D64}" dt="2021-07-01T19:54:25.750" v="2302" actId="478"/>
          <ac:picMkLst>
            <pc:docMk/>
            <pc:sldMk cId="4188440041" sldId="271"/>
            <ac:picMk id="420" creationId="{98E4CA24-FCEA-4826-8E6F-DD46501D47F7}"/>
          </ac:picMkLst>
        </pc:picChg>
        <pc:picChg chg="del">
          <ac:chgData name="Manasweeta Angane" userId="05da2731-9352-4b35-b713-60351f56afbd" providerId="ADAL" clId="{121B3E88-C8E7-4600-B4A4-3E65BB803D64}" dt="2021-07-01T19:54:29.077" v="2305" actId="478"/>
          <ac:picMkLst>
            <pc:docMk/>
            <pc:sldMk cId="4188440041" sldId="271"/>
            <ac:picMk id="431" creationId="{4F1DC6AB-0603-4E31-AE40-906050FAD6B2}"/>
          </ac:picMkLst>
        </pc:picChg>
        <pc:picChg chg="del">
          <ac:chgData name="Manasweeta Angane" userId="05da2731-9352-4b35-b713-60351f56afbd" providerId="ADAL" clId="{121B3E88-C8E7-4600-B4A4-3E65BB803D64}" dt="2021-07-01T19:54:25.750" v="2302" actId="478"/>
          <ac:picMkLst>
            <pc:docMk/>
            <pc:sldMk cId="4188440041" sldId="271"/>
            <ac:picMk id="487" creationId="{02DFC27E-26BF-4E47-9344-25BABE2EEE0E}"/>
          </ac:picMkLst>
        </pc:picChg>
        <pc:picChg chg="del">
          <ac:chgData name="Manasweeta Angane" userId="05da2731-9352-4b35-b713-60351f56afbd" providerId="ADAL" clId="{121B3E88-C8E7-4600-B4A4-3E65BB803D64}" dt="2021-07-01T19:54:25.750" v="2302" actId="478"/>
          <ac:picMkLst>
            <pc:docMk/>
            <pc:sldMk cId="4188440041" sldId="271"/>
            <ac:picMk id="488" creationId="{B99E4C27-486E-4E91-B0E5-8E08188A02B7}"/>
          </ac:picMkLst>
        </pc:picChg>
        <pc:picChg chg="del">
          <ac:chgData name="Manasweeta Angane" userId="05da2731-9352-4b35-b713-60351f56afbd" providerId="ADAL" clId="{121B3E88-C8E7-4600-B4A4-3E65BB803D64}" dt="2021-07-01T19:54:06.730" v="2293" actId="478"/>
          <ac:picMkLst>
            <pc:docMk/>
            <pc:sldMk cId="4188440041" sldId="271"/>
            <ac:picMk id="509" creationId="{526632B2-9D5B-44EE-A3F8-4EC82E228D46}"/>
          </ac:picMkLst>
        </pc:picChg>
        <pc:picChg chg="del">
          <ac:chgData name="Manasweeta Angane" userId="05da2731-9352-4b35-b713-60351f56afbd" providerId="ADAL" clId="{121B3E88-C8E7-4600-B4A4-3E65BB803D64}" dt="2021-07-01T19:54:05.777" v="2292" actId="478"/>
          <ac:picMkLst>
            <pc:docMk/>
            <pc:sldMk cId="4188440041" sldId="271"/>
            <ac:picMk id="511" creationId="{B4B2E345-CE7D-443B-87E2-4500183AC2B7}"/>
          </ac:picMkLst>
        </pc:picChg>
      </pc:sldChg>
    </pc:docChg>
  </pc:docChgLst>
  <pc:docChgLst>
    <pc:chgData name="Manasweeta Angane" userId="05da2731-9352-4b35-b713-60351f56afbd" providerId="ADAL" clId="{C879E23B-F49E-4597-87EF-422CA62B204C}"/>
    <pc:docChg chg="undo custSel delSld modSld">
      <pc:chgData name="Manasweeta Angane" userId="05da2731-9352-4b35-b713-60351f56afbd" providerId="ADAL" clId="{C879E23B-F49E-4597-87EF-422CA62B204C}" dt="2021-05-23T00:31:27.002" v="30" actId="164"/>
      <pc:docMkLst>
        <pc:docMk/>
      </pc:docMkLst>
      <pc:sldChg chg="del">
        <pc:chgData name="Manasweeta Angane" userId="05da2731-9352-4b35-b713-60351f56afbd" providerId="ADAL" clId="{C879E23B-F49E-4597-87EF-422CA62B204C}" dt="2021-05-23T00:22:05.186" v="0" actId="2696"/>
        <pc:sldMkLst>
          <pc:docMk/>
          <pc:sldMk cId="1675651953" sldId="256"/>
        </pc:sldMkLst>
      </pc:sldChg>
      <pc:sldChg chg="del">
        <pc:chgData name="Manasweeta Angane" userId="05da2731-9352-4b35-b713-60351f56afbd" providerId="ADAL" clId="{C879E23B-F49E-4597-87EF-422CA62B204C}" dt="2021-05-23T00:22:08.123" v="1" actId="2696"/>
        <pc:sldMkLst>
          <pc:docMk/>
          <pc:sldMk cId="3227419570" sldId="257"/>
        </pc:sldMkLst>
      </pc:sldChg>
      <pc:sldChg chg="del">
        <pc:chgData name="Manasweeta Angane" userId="05da2731-9352-4b35-b713-60351f56afbd" providerId="ADAL" clId="{C879E23B-F49E-4597-87EF-422CA62B204C}" dt="2021-05-23T00:22:10.873" v="2" actId="2696"/>
        <pc:sldMkLst>
          <pc:docMk/>
          <pc:sldMk cId="3827496297" sldId="258"/>
        </pc:sldMkLst>
      </pc:sldChg>
      <pc:sldChg chg="del">
        <pc:chgData name="Manasweeta Angane" userId="05da2731-9352-4b35-b713-60351f56afbd" providerId="ADAL" clId="{C879E23B-F49E-4597-87EF-422CA62B204C}" dt="2021-05-23T00:23:00.389" v="13" actId="2696"/>
        <pc:sldMkLst>
          <pc:docMk/>
          <pc:sldMk cId="2764835349" sldId="259"/>
        </pc:sldMkLst>
      </pc:sldChg>
      <pc:sldChg chg="del">
        <pc:chgData name="Manasweeta Angane" userId="05da2731-9352-4b35-b713-60351f56afbd" providerId="ADAL" clId="{C879E23B-F49E-4597-87EF-422CA62B204C}" dt="2021-05-23T00:23:18.530" v="17" actId="2696"/>
        <pc:sldMkLst>
          <pc:docMk/>
          <pc:sldMk cId="1521514973" sldId="260"/>
        </pc:sldMkLst>
      </pc:sldChg>
      <pc:sldChg chg="del">
        <pc:chgData name="Manasweeta Angane" userId="05da2731-9352-4b35-b713-60351f56afbd" providerId="ADAL" clId="{C879E23B-F49E-4597-87EF-422CA62B204C}" dt="2021-05-23T00:22:13.467" v="3" actId="2696"/>
        <pc:sldMkLst>
          <pc:docMk/>
          <pc:sldMk cId="1300633407" sldId="261"/>
        </pc:sldMkLst>
      </pc:sldChg>
      <pc:sldChg chg="del">
        <pc:chgData name="Manasweeta Angane" userId="05da2731-9352-4b35-b713-60351f56afbd" providerId="ADAL" clId="{C879E23B-F49E-4597-87EF-422CA62B204C}" dt="2021-05-23T00:23:14.452" v="16" actId="2696"/>
        <pc:sldMkLst>
          <pc:docMk/>
          <pc:sldMk cId="2707572057" sldId="262"/>
        </pc:sldMkLst>
      </pc:sldChg>
      <pc:sldChg chg="del">
        <pc:chgData name="Manasweeta Angane" userId="05da2731-9352-4b35-b713-60351f56afbd" providerId="ADAL" clId="{C879E23B-F49E-4597-87EF-422CA62B204C}" dt="2021-05-23T00:23:10.077" v="15" actId="2696"/>
        <pc:sldMkLst>
          <pc:docMk/>
          <pc:sldMk cId="3970588774" sldId="263"/>
        </pc:sldMkLst>
      </pc:sldChg>
      <pc:sldChg chg="del">
        <pc:chgData name="Manasweeta Angane" userId="05da2731-9352-4b35-b713-60351f56afbd" providerId="ADAL" clId="{C879E23B-F49E-4597-87EF-422CA62B204C}" dt="2021-05-23T00:22:22.498" v="5" actId="2696"/>
        <pc:sldMkLst>
          <pc:docMk/>
          <pc:sldMk cId="1217524332" sldId="264"/>
        </pc:sldMkLst>
      </pc:sldChg>
      <pc:sldChg chg="del">
        <pc:chgData name="Manasweeta Angane" userId="05da2731-9352-4b35-b713-60351f56afbd" providerId="ADAL" clId="{C879E23B-F49E-4597-87EF-422CA62B204C}" dt="2021-05-23T00:22:16.905" v="4" actId="2696"/>
        <pc:sldMkLst>
          <pc:docMk/>
          <pc:sldMk cId="1649803051" sldId="265"/>
        </pc:sldMkLst>
      </pc:sldChg>
      <pc:sldChg chg="del">
        <pc:chgData name="Manasweeta Angane" userId="05da2731-9352-4b35-b713-60351f56afbd" providerId="ADAL" clId="{C879E23B-F49E-4597-87EF-422CA62B204C}" dt="2021-05-23T00:23:04.967" v="14" actId="2696"/>
        <pc:sldMkLst>
          <pc:docMk/>
          <pc:sldMk cId="937044226" sldId="266"/>
        </pc:sldMkLst>
      </pc:sldChg>
      <pc:sldChg chg="addSp delSp modSp mod">
        <pc:chgData name="Manasweeta Angane" userId="05da2731-9352-4b35-b713-60351f56afbd" providerId="ADAL" clId="{C879E23B-F49E-4597-87EF-422CA62B204C}" dt="2021-05-23T00:31:27.002" v="30" actId="164"/>
        <pc:sldMkLst>
          <pc:docMk/>
          <pc:sldMk cId="3145637976" sldId="268"/>
        </pc:sldMkLst>
        <pc:spChg chg="mod topLvl">
          <ac:chgData name="Manasweeta Angane" userId="05da2731-9352-4b35-b713-60351f56afbd" providerId="ADAL" clId="{C879E23B-F49E-4597-87EF-422CA62B204C}" dt="2021-05-23T00:31:27.002" v="30" actId="164"/>
          <ac:spMkLst>
            <pc:docMk/>
            <pc:sldMk cId="3145637976" sldId="268"/>
            <ac:spMk id="3" creationId="{AE116250-06D3-4487-927B-6ABD4B0174E0}"/>
          </ac:spMkLst>
        </pc:spChg>
        <pc:spChg chg="mod topLvl">
          <ac:chgData name="Manasweeta Angane" userId="05da2731-9352-4b35-b713-60351f56afbd" providerId="ADAL" clId="{C879E23B-F49E-4597-87EF-422CA62B204C}" dt="2021-05-23T00:31:27.002" v="30" actId="164"/>
          <ac:spMkLst>
            <pc:docMk/>
            <pc:sldMk cId="3145637976" sldId="268"/>
            <ac:spMk id="8" creationId="{9578BF0C-3884-4FD5-9C26-852AC96763B9}"/>
          </ac:spMkLst>
        </pc:spChg>
        <pc:spChg chg="mod">
          <ac:chgData name="Manasweeta Angane" userId="05da2731-9352-4b35-b713-60351f56afbd" providerId="ADAL" clId="{C879E23B-F49E-4597-87EF-422CA62B204C}" dt="2021-05-23T00:31:20.268" v="29" actId="165"/>
          <ac:spMkLst>
            <pc:docMk/>
            <pc:sldMk cId="3145637976" sldId="268"/>
            <ac:spMk id="111" creationId="{3130C39E-4D71-4B0B-AD10-2660F8CDB2E7}"/>
          </ac:spMkLst>
        </pc:spChg>
        <pc:grpChg chg="add mod">
          <ac:chgData name="Manasweeta Angane" userId="05da2731-9352-4b35-b713-60351f56afbd" providerId="ADAL" clId="{C879E23B-F49E-4597-87EF-422CA62B204C}" dt="2021-05-23T00:31:27.002" v="30" actId="164"/>
          <ac:grpSpMkLst>
            <pc:docMk/>
            <pc:sldMk cId="3145637976" sldId="268"/>
            <ac:grpSpMk id="6" creationId="{75ECB785-9F03-47B9-9993-E033DA928C01}"/>
          </ac:grpSpMkLst>
        </pc:grpChg>
        <pc:grpChg chg="add del mod">
          <ac:chgData name="Manasweeta Angane" userId="05da2731-9352-4b35-b713-60351f56afbd" providerId="ADAL" clId="{C879E23B-F49E-4597-87EF-422CA62B204C}" dt="2021-05-23T00:31:20.268" v="29" actId="165"/>
          <ac:grpSpMkLst>
            <pc:docMk/>
            <pc:sldMk cId="3145637976" sldId="268"/>
            <ac:grpSpMk id="15" creationId="{06450F43-4BDE-4F0B-89B3-854446C85461}"/>
          </ac:grpSpMkLst>
        </pc:grpChg>
        <pc:grpChg chg="mod">
          <ac:chgData name="Manasweeta Angane" userId="05da2731-9352-4b35-b713-60351f56afbd" providerId="ADAL" clId="{C879E23B-F49E-4597-87EF-422CA62B204C}" dt="2021-05-23T00:23:51.406" v="18" actId="14100"/>
          <ac:grpSpMkLst>
            <pc:docMk/>
            <pc:sldMk cId="3145637976" sldId="268"/>
            <ac:grpSpMk id="26" creationId="{CB67E6E1-6425-4F3D-BC25-7EF74174481B}"/>
          </ac:grpSpMkLst>
        </pc:grpChg>
        <pc:grpChg chg="mod topLvl">
          <ac:chgData name="Manasweeta Angane" userId="05da2731-9352-4b35-b713-60351f56afbd" providerId="ADAL" clId="{C879E23B-F49E-4597-87EF-422CA62B204C}" dt="2021-05-23T00:31:27.002" v="30" actId="164"/>
          <ac:grpSpMkLst>
            <pc:docMk/>
            <pc:sldMk cId="3145637976" sldId="268"/>
            <ac:grpSpMk id="109" creationId="{67E5F1E1-32EE-4A88-9488-CFC3EF076927}"/>
          </ac:grpSpMkLst>
        </pc:grpChg>
        <pc:grpChg chg="mod">
          <ac:chgData name="Manasweeta Angane" userId="05da2731-9352-4b35-b713-60351f56afbd" providerId="ADAL" clId="{C879E23B-F49E-4597-87EF-422CA62B204C}" dt="2021-05-23T00:31:18.471" v="27" actId="14100"/>
          <ac:grpSpMkLst>
            <pc:docMk/>
            <pc:sldMk cId="3145637976" sldId="268"/>
            <ac:grpSpMk id="145" creationId="{1CB57B06-FA75-48C9-A6BC-A4E6F430710C}"/>
          </ac:grpSpMkLst>
        </pc:grpChg>
        <pc:picChg chg="mod topLvl">
          <ac:chgData name="Manasweeta Angane" userId="05da2731-9352-4b35-b713-60351f56afbd" providerId="ADAL" clId="{C879E23B-F49E-4597-87EF-422CA62B204C}" dt="2021-05-23T00:31:27.002" v="30" actId="164"/>
          <ac:picMkLst>
            <pc:docMk/>
            <pc:sldMk cId="3145637976" sldId="268"/>
            <ac:picMk id="107" creationId="{5C0B13FE-23D3-4408-B63D-2E63CEF1FC6D}"/>
          </ac:picMkLst>
        </pc:picChg>
        <pc:picChg chg="mod topLvl">
          <ac:chgData name="Manasweeta Angane" userId="05da2731-9352-4b35-b713-60351f56afbd" providerId="ADAL" clId="{C879E23B-F49E-4597-87EF-422CA62B204C}" dt="2021-05-23T00:31:27.002" v="30" actId="164"/>
          <ac:picMkLst>
            <pc:docMk/>
            <pc:sldMk cId="3145637976" sldId="268"/>
            <ac:picMk id="108" creationId="{7F6EFE52-17E3-49DF-B205-17E2CACD5EA8}"/>
          </ac:picMkLst>
        </pc:picChg>
        <pc:picChg chg="mod">
          <ac:chgData name="Manasweeta Angane" userId="05da2731-9352-4b35-b713-60351f56afbd" providerId="ADAL" clId="{C879E23B-F49E-4597-87EF-422CA62B204C}" dt="2021-05-23T00:31:20.268" v="29" actId="165"/>
          <ac:picMkLst>
            <pc:docMk/>
            <pc:sldMk cId="3145637976" sldId="268"/>
            <ac:picMk id="110" creationId="{8A7FEBF2-7B4F-43AC-AED8-2AE6ABEAB31F}"/>
          </ac:picMkLst>
        </pc:picChg>
        <pc:picChg chg="mod">
          <ac:chgData name="Manasweeta Angane" userId="05da2731-9352-4b35-b713-60351f56afbd" providerId="ADAL" clId="{C879E23B-F49E-4597-87EF-422CA62B204C}" dt="2021-05-23T00:31:18.471" v="27" actId="14100"/>
          <ac:picMkLst>
            <pc:docMk/>
            <pc:sldMk cId="3145637976" sldId="268"/>
            <ac:picMk id="163" creationId="{9B7252B1-3E02-41B8-80B8-A333E3BA8493}"/>
          </ac:picMkLst>
        </pc:picChg>
        <pc:picChg chg="mod">
          <ac:chgData name="Manasweeta Angane" userId="05da2731-9352-4b35-b713-60351f56afbd" providerId="ADAL" clId="{C879E23B-F49E-4597-87EF-422CA62B204C}" dt="2021-05-23T00:31:18.471" v="27" actId="14100"/>
          <ac:picMkLst>
            <pc:docMk/>
            <pc:sldMk cId="3145637976" sldId="268"/>
            <ac:picMk id="164" creationId="{31441B51-883B-46EC-BD2B-6A92E1CC1934}"/>
          </ac:picMkLst>
        </pc:picChg>
        <pc:picChg chg="mod">
          <ac:chgData name="Manasweeta Angane" userId="05da2731-9352-4b35-b713-60351f56afbd" providerId="ADAL" clId="{C879E23B-F49E-4597-87EF-422CA62B204C}" dt="2021-05-23T00:31:18.471" v="27" actId="14100"/>
          <ac:picMkLst>
            <pc:docMk/>
            <pc:sldMk cId="3145637976" sldId="268"/>
            <ac:picMk id="165" creationId="{A4DF4002-EA63-4D5A-9CBF-E7E741678694}"/>
          </ac:picMkLst>
        </pc:picChg>
        <pc:picChg chg="mod">
          <ac:chgData name="Manasweeta Angane" userId="05da2731-9352-4b35-b713-60351f56afbd" providerId="ADAL" clId="{C879E23B-F49E-4597-87EF-422CA62B204C}" dt="2021-05-23T00:23:51.406" v="18" actId="14100"/>
          <ac:picMkLst>
            <pc:docMk/>
            <pc:sldMk cId="3145637976" sldId="268"/>
            <ac:picMk id="188" creationId="{9A2DDEF8-D47E-45A3-9518-4462925F77AC}"/>
          </ac:picMkLst>
        </pc:picChg>
        <pc:picChg chg="mod">
          <ac:chgData name="Manasweeta Angane" userId="05da2731-9352-4b35-b713-60351f56afbd" providerId="ADAL" clId="{C879E23B-F49E-4597-87EF-422CA62B204C}" dt="2021-05-23T00:31:19.362" v="28" actId="14100"/>
          <ac:picMkLst>
            <pc:docMk/>
            <pc:sldMk cId="3145637976" sldId="268"/>
            <ac:picMk id="194" creationId="{B9971A82-52E5-4A82-8477-3C09C1DB41F6}"/>
          </ac:picMkLst>
        </pc:picChg>
        <pc:picChg chg="mod">
          <ac:chgData name="Manasweeta Angane" userId="05da2731-9352-4b35-b713-60351f56afbd" providerId="ADAL" clId="{C879E23B-F49E-4597-87EF-422CA62B204C}" dt="2021-05-23T00:23:51.406" v="18" actId="14100"/>
          <ac:picMkLst>
            <pc:docMk/>
            <pc:sldMk cId="3145637976" sldId="268"/>
            <ac:picMk id="195" creationId="{8EBCA554-E2F9-43B0-94DD-3327893FC6D7}"/>
          </ac:picMkLst>
        </pc:picChg>
      </pc:sldChg>
      <pc:sldChg chg="del">
        <pc:chgData name="Manasweeta Angane" userId="05da2731-9352-4b35-b713-60351f56afbd" providerId="ADAL" clId="{C879E23B-F49E-4597-87EF-422CA62B204C}" dt="2021-05-23T00:22:35.249" v="8" actId="2696"/>
        <pc:sldMkLst>
          <pc:docMk/>
          <pc:sldMk cId="1930498660" sldId="269"/>
        </pc:sldMkLst>
      </pc:sldChg>
      <pc:sldChg chg="del">
        <pc:chgData name="Manasweeta Angane" userId="05da2731-9352-4b35-b713-60351f56afbd" providerId="ADAL" clId="{C879E23B-F49E-4597-87EF-422CA62B204C}" dt="2021-05-23T00:22:56.756" v="12" actId="2696"/>
        <pc:sldMkLst>
          <pc:docMk/>
          <pc:sldMk cId="3123405252" sldId="270"/>
        </pc:sldMkLst>
      </pc:sldChg>
      <pc:sldChg chg="del">
        <pc:chgData name="Manasweeta Angane" userId="05da2731-9352-4b35-b713-60351f56afbd" providerId="ADAL" clId="{C879E23B-F49E-4597-87EF-422CA62B204C}" dt="2021-05-23T00:22:37.826" v="9" actId="2696"/>
        <pc:sldMkLst>
          <pc:docMk/>
          <pc:sldMk cId="1781180117" sldId="271"/>
        </pc:sldMkLst>
      </pc:sldChg>
      <pc:sldChg chg="del">
        <pc:chgData name="Manasweeta Angane" userId="05da2731-9352-4b35-b713-60351f56afbd" providerId="ADAL" clId="{C879E23B-F49E-4597-87EF-422CA62B204C}" dt="2021-05-23T00:22:53.249" v="11" actId="2696"/>
        <pc:sldMkLst>
          <pc:docMk/>
          <pc:sldMk cId="3044405353" sldId="272"/>
        </pc:sldMkLst>
      </pc:sldChg>
      <pc:sldChg chg="del">
        <pc:chgData name="Manasweeta Angane" userId="05da2731-9352-4b35-b713-60351f56afbd" providerId="ADAL" clId="{C879E23B-F49E-4597-87EF-422CA62B204C}" dt="2021-05-23T00:22:40.530" v="10" actId="2696"/>
        <pc:sldMkLst>
          <pc:docMk/>
          <pc:sldMk cId="2923950115" sldId="273"/>
        </pc:sldMkLst>
      </pc:sldChg>
      <pc:sldChg chg="del">
        <pc:chgData name="Manasweeta Angane" userId="05da2731-9352-4b35-b713-60351f56afbd" providerId="ADAL" clId="{C879E23B-F49E-4597-87EF-422CA62B204C}" dt="2021-05-23T00:22:27.092" v="6" actId="2696"/>
        <pc:sldMkLst>
          <pc:docMk/>
          <pc:sldMk cId="730993269" sldId="274"/>
        </pc:sldMkLst>
      </pc:sldChg>
      <pc:sldChg chg="del">
        <pc:chgData name="Manasweeta Angane" userId="05da2731-9352-4b35-b713-60351f56afbd" providerId="ADAL" clId="{C879E23B-F49E-4597-87EF-422CA62B204C}" dt="2021-05-23T00:22:32.326" v="7" actId="2696"/>
        <pc:sldMkLst>
          <pc:docMk/>
          <pc:sldMk cId="2362421498" sldId="275"/>
        </pc:sldMkLst>
      </pc:sldChg>
    </pc:docChg>
  </pc:docChgLst>
  <pc:docChgLst>
    <pc:chgData name="Manasweeta Angane" userId="05da2731-9352-4b35-b713-60351f56afbd" providerId="ADAL" clId="{8FDD4CE2-C5F5-4C59-AFC9-9767684718A2}"/>
    <pc:docChg chg="undo custSel modSld">
      <pc:chgData name="Manasweeta Angane" userId="05da2731-9352-4b35-b713-60351f56afbd" providerId="ADAL" clId="{8FDD4CE2-C5F5-4C59-AFC9-9767684718A2}" dt="2021-07-01T12:10:33.067" v="24" actId="1076"/>
      <pc:docMkLst>
        <pc:docMk/>
      </pc:docMkLst>
      <pc:sldChg chg="addSp delSp modSp mod">
        <pc:chgData name="Manasweeta Angane" userId="05da2731-9352-4b35-b713-60351f56afbd" providerId="ADAL" clId="{8FDD4CE2-C5F5-4C59-AFC9-9767684718A2}" dt="2021-07-01T12:10:33.067" v="24" actId="1076"/>
        <pc:sldMkLst>
          <pc:docMk/>
          <pc:sldMk cId="731297326" sldId="270"/>
        </pc:sldMkLst>
        <pc:grpChg chg="mod">
          <ac:chgData name="Manasweeta Angane" userId="05da2731-9352-4b35-b713-60351f56afbd" providerId="ADAL" clId="{8FDD4CE2-C5F5-4C59-AFC9-9767684718A2}" dt="2021-07-01T12:10:33.067" v="24" actId="1076"/>
          <ac:grpSpMkLst>
            <pc:docMk/>
            <pc:sldMk cId="731297326" sldId="270"/>
            <ac:grpSpMk id="11" creationId="{96EFB168-73B3-4389-96A0-20C79DA25869}"/>
          </ac:grpSpMkLst>
        </pc:grpChg>
        <pc:grpChg chg="add del mod">
          <ac:chgData name="Manasweeta Angane" userId="05da2731-9352-4b35-b713-60351f56afbd" providerId="ADAL" clId="{8FDD4CE2-C5F5-4C59-AFC9-9767684718A2}" dt="2021-07-01T12:10:33.067" v="24" actId="1076"/>
          <ac:grpSpMkLst>
            <pc:docMk/>
            <pc:sldMk cId="731297326" sldId="270"/>
            <ac:grpSpMk id="12" creationId="{2A2E5B81-1D2A-43DB-986F-3B0511728A9A}"/>
          </ac:grpSpMkLst>
        </pc:grpChg>
        <pc:grpChg chg="mod">
          <ac:chgData name="Manasweeta Angane" userId="05da2731-9352-4b35-b713-60351f56afbd" providerId="ADAL" clId="{8FDD4CE2-C5F5-4C59-AFC9-9767684718A2}" dt="2021-07-01T11:56:58.415" v="8" actId="1076"/>
          <ac:grpSpMkLst>
            <pc:docMk/>
            <pc:sldMk cId="731297326" sldId="270"/>
            <ac:grpSpMk id="30" creationId="{89158FF9-56F5-42C8-918A-46A99E71D281}"/>
          </ac:grpSpMkLst>
        </pc:grpChg>
        <pc:grpChg chg="add del mod">
          <ac:chgData name="Manasweeta Angane" userId="05da2731-9352-4b35-b713-60351f56afbd" providerId="ADAL" clId="{8FDD4CE2-C5F5-4C59-AFC9-9767684718A2}" dt="2021-07-01T12:10:26.897" v="23"/>
          <ac:grpSpMkLst>
            <pc:docMk/>
            <pc:sldMk cId="731297326" sldId="270"/>
            <ac:grpSpMk id="186" creationId="{0217F18B-E3B9-4952-9AD2-46655095B819}"/>
          </ac:grpSpMkLst>
        </pc:grpChg>
        <pc:grpChg chg="mod">
          <ac:chgData name="Manasweeta Angane" userId="05da2731-9352-4b35-b713-60351f56afbd" providerId="ADAL" clId="{8FDD4CE2-C5F5-4C59-AFC9-9767684718A2}" dt="2021-07-01T12:10:02.254" v="14"/>
          <ac:grpSpMkLst>
            <pc:docMk/>
            <pc:sldMk cId="731297326" sldId="270"/>
            <ac:grpSpMk id="187" creationId="{67A2972F-CB9F-48BB-ADA9-2EBED8110876}"/>
          </ac:grpSpMkLst>
        </pc:grpChg>
        <pc:grpChg chg="mod">
          <ac:chgData name="Manasweeta Angane" userId="05da2731-9352-4b35-b713-60351f56afbd" providerId="ADAL" clId="{8FDD4CE2-C5F5-4C59-AFC9-9767684718A2}" dt="2021-07-01T11:56:54.121" v="7" actId="1076"/>
          <ac:grpSpMkLst>
            <pc:docMk/>
            <pc:sldMk cId="731297326" sldId="270"/>
            <ac:grpSpMk id="341" creationId="{A839F078-44A6-420C-A82F-CF59EF10D5F0}"/>
          </ac:grpSpMkLst>
        </pc:grpChg>
        <pc:picChg chg="mod">
          <ac:chgData name="Manasweeta Angane" userId="05da2731-9352-4b35-b713-60351f56afbd" providerId="ADAL" clId="{8FDD4CE2-C5F5-4C59-AFC9-9767684718A2}" dt="2021-07-01T12:10:02.254" v="14"/>
          <ac:picMkLst>
            <pc:docMk/>
            <pc:sldMk cId="731297326" sldId="270"/>
            <ac:picMk id="188" creationId="{64D39595-347E-4309-9D79-25224AE85439}"/>
          </ac:picMkLst>
        </pc:picChg>
        <pc:picChg chg="mod">
          <ac:chgData name="Manasweeta Angane" userId="05da2731-9352-4b35-b713-60351f56afbd" providerId="ADAL" clId="{8FDD4CE2-C5F5-4C59-AFC9-9767684718A2}" dt="2021-07-01T12:10:02.254" v="14"/>
          <ac:picMkLst>
            <pc:docMk/>
            <pc:sldMk cId="731297326" sldId="270"/>
            <ac:picMk id="190" creationId="{B9634704-C5DF-4415-A50D-D01556F477BC}"/>
          </ac:picMkLst>
        </pc:picChg>
        <pc:picChg chg="mod">
          <ac:chgData name="Manasweeta Angane" userId="05da2731-9352-4b35-b713-60351f56afbd" providerId="ADAL" clId="{8FDD4CE2-C5F5-4C59-AFC9-9767684718A2}" dt="2021-07-01T12:10:02.254" v="14"/>
          <ac:picMkLst>
            <pc:docMk/>
            <pc:sldMk cId="731297326" sldId="270"/>
            <ac:picMk id="191" creationId="{79B052B4-497C-41BD-8C9A-FD36780FCD38}"/>
          </ac:picMkLst>
        </pc:picChg>
        <pc:picChg chg="mod">
          <ac:chgData name="Manasweeta Angane" userId="05da2731-9352-4b35-b713-60351f56afbd" providerId="ADAL" clId="{8FDD4CE2-C5F5-4C59-AFC9-9767684718A2}" dt="2021-07-01T11:57:08.663" v="12" actId="1076"/>
          <ac:picMkLst>
            <pc:docMk/>
            <pc:sldMk cId="731297326" sldId="270"/>
            <ac:picMk id="227" creationId="{158FE962-8BAB-4125-89DC-4B272109865F}"/>
          </ac:picMkLst>
        </pc:picChg>
        <pc:picChg chg="mod">
          <ac:chgData name="Manasweeta Angane" userId="05da2731-9352-4b35-b713-60351f56afbd" providerId="ADAL" clId="{8FDD4CE2-C5F5-4C59-AFC9-9767684718A2}" dt="2021-07-01T11:56:58.415" v="8" actId="1076"/>
          <ac:picMkLst>
            <pc:docMk/>
            <pc:sldMk cId="731297326" sldId="270"/>
            <ac:picMk id="311" creationId="{8C65D60C-4F9F-4160-B757-17E4C613A7E3}"/>
          </ac:picMkLst>
        </pc:picChg>
        <pc:picChg chg="mod">
          <ac:chgData name="Manasweeta Angane" userId="05da2731-9352-4b35-b713-60351f56afbd" providerId="ADAL" clId="{8FDD4CE2-C5F5-4C59-AFC9-9767684718A2}" dt="2021-07-01T11:56:58.415" v="8" actId="1076"/>
          <ac:picMkLst>
            <pc:docMk/>
            <pc:sldMk cId="731297326" sldId="270"/>
            <ac:picMk id="312" creationId="{AE96A26E-BA0E-45B2-AAFD-06C067B70756}"/>
          </ac:picMkLst>
        </pc:picChg>
        <pc:picChg chg="mod">
          <ac:chgData name="Manasweeta Angane" userId="05da2731-9352-4b35-b713-60351f56afbd" providerId="ADAL" clId="{8FDD4CE2-C5F5-4C59-AFC9-9767684718A2}" dt="2021-07-01T12:10:33.067" v="24" actId="1076"/>
          <ac:picMkLst>
            <pc:docMk/>
            <pc:sldMk cId="731297326" sldId="270"/>
            <ac:picMk id="323" creationId="{19F56D6F-7BFC-45F6-8051-B64C71F03BB3}"/>
          </ac:picMkLst>
        </pc:picChg>
        <pc:picChg chg="mod">
          <ac:chgData name="Manasweeta Angane" userId="05da2731-9352-4b35-b713-60351f56afbd" providerId="ADAL" clId="{8FDD4CE2-C5F5-4C59-AFC9-9767684718A2}" dt="2021-07-01T12:10:33.067" v="24" actId="1076"/>
          <ac:picMkLst>
            <pc:docMk/>
            <pc:sldMk cId="731297326" sldId="270"/>
            <ac:picMk id="456" creationId="{604988FD-D7A7-4B0B-B205-3B7E51110752}"/>
          </ac:picMkLst>
        </pc:picChg>
        <pc:picChg chg="mod">
          <ac:chgData name="Manasweeta Angane" userId="05da2731-9352-4b35-b713-60351f56afbd" providerId="ADAL" clId="{8FDD4CE2-C5F5-4C59-AFC9-9767684718A2}" dt="2021-07-01T12:10:33.067" v="24" actId="1076"/>
          <ac:picMkLst>
            <pc:docMk/>
            <pc:sldMk cId="731297326" sldId="270"/>
            <ac:picMk id="460" creationId="{EC61A0D4-8FFE-4420-9388-9A205241D780}"/>
          </ac:picMkLst>
        </pc:picChg>
        <pc:picChg chg="mod">
          <ac:chgData name="Manasweeta Angane" userId="05da2731-9352-4b35-b713-60351f56afbd" providerId="ADAL" clId="{8FDD4CE2-C5F5-4C59-AFC9-9767684718A2}" dt="2021-07-01T11:49:37.928" v="0"/>
          <ac:picMkLst>
            <pc:docMk/>
            <pc:sldMk cId="731297326" sldId="270"/>
            <ac:picMk id="511" creationId="{B4B2E345-CE7D-443B-87E2-4500183AC2B7}"/>
          </ac:picMkLst>
        </pc:picChg>
      </pc:sldChg>
    </pc:docChg>
  </pc:docChgLst>
  <pc:docChgLst>
    <pc:chgData name="Manasweeta Angane" userId="05da2731-9352-4b35-b713-60351f56afbd" providerId="ADAL" clId="{F5F97842-A295-4F9F-B89B-A63B35E1C32D}"/>
    <pc:docChg chg="undo redo custSel addSld delSld modSld sldOrd modMainMaster">
      <pc:chgData name="Manasweeta Angane" userId="05da2731-9352-4b35-b713-60351f56afbd" providerId="ADAL" clId="{F5F97842-A295-4F9F-B89B-A63B35E1C32D}" dt="2022-10-24T12:10:31.777" v="20991" actId="1035"/>
      <pc:docMkLst>
        <pc:docMk/>
      </pc:docMkLst>
      <pc:sldChg chg="addSp delSp modSp mod">
        <pc:chgData name="Manasweeta Angane" userId="05da2731-9352-4b35-b713-60351f56afbd" providerId="ADAL" clId="{F5F97842-A295-4F9F-B89B-A63B35E1C32D}" dt="2022-10-21T03:30:40.851" v="12071" actId="12789"/>
        <pc:sldMkLst>
          <pc:docMk/>
          <pc:sldMk cId="1254738402" sldId="256"/>
        </pc:sldMkLst>
        <pc:spChg chg="add mod">
          <ac:chgData name="Manasweeta Angane" userId="05da2731-9352-4b35-b713-60351f56afbd" providerId="ADAL" clId="{F5F97842-A295-4F9F-B89B-A63B35E1C32D}" dt="2022-10-21T03:29:38.221" v="12066" actId="478"/>
          <ac:spMkLst>
            <pc:docMk/>
            <pc:sldMk cId="1254738402" sldId="256"/>
            <ac:spMk id="5" creationId="{04338863-F357-402B-809B-491B184C2878}"/>
          </ac:spMkLst>
        </pc:spChg>
        <pc:spChg chg="del mod">
          <ac:chgData name="Manasweeta Angane" userId="05da2731-9352-4b35-b713-60351f56afbd" providerId="ADAL" clId="{F5F97842-A295-4F9F-B89B-A63B35E1C32D}" dt="2022-10-19T08:32:38.291" v="11333" actId="478"/>
          <ac:spMkLst>
            <pc:docMk/>
            <pc:sldMk cId="1254738402" sldId="256"/>
            <ac:spMk id="8" creationId="{00000000-0000-0000-0000-000000000000}"/>
          </ac:spMkLst>
        </pc:spChg>
        <pc:spChg chg="mod">
          <ac:chgData name="Manasweeta Angane" userId="05da2731-9352-4b35-b713-60351f56afbd" providerId="ADAL" clId="{F5F97842-A295-4F9F-B89B-A63B35E1C32D}" dt="2022-10-21T03:30:40.851" v="12071" actId="12789"/>
          <ac:spMkLst>
            <pc:docMk/>
            <pc:sldMk cId="1254738402" sldId="256"/>
            <ac:spMk id="9" creationId="{B6B751D4-5C79-7747-9D65-B4263B4C6DDA}"/>
          </ac:spMkLst>
        </pc:spChg>
        <pc:spChg chg="del">
          <ac:chgData name="Manasweeta Angane" userId="05da2731-9352-4b35-b713-60351f56afbd" providerId="ADAL" clId="{F5F97842-A295-4F9F-B89B-A63B35E1C32D}" dt="2022-10-21T03:29:38.221" v="12066" actId="478"/>
          <ac:spMkLst>
            <pc:docMk/>
            <pc:sldMk cId="1254738402" sldId="256"/>
            <ac:spMk id="10" creationId="{F8523BA8-19CA-6241-B709-C6E421C28427}"/>
          </ac:spMkLst>
        </pc:spChg>
        <pc:spChg chg="add del mod">
          <ac:chgData name="Manasweeta Angane" userId="05da2731-9352-4b35-b713-60351f56afbd" providerId="ADAL" clId="{F5F97842-A295-4F9F-B89B-A63B35E1C32D}" dt="2022-10-19T08:31:54.033" v="11329" actId="478"/>
          <ac:spMkLst>
            <pc:docMk/>
            <pc:sldMk cId="1254738402" sldId="256"/>
            <ac:spMk id="11" creationId="{6D6C68AB-C9C9-4B1A-9AE5-497FAF36CE18}"/>
          </ac:spMkLst>
        </pc:spChg>
        <pc:spChg chg="add del mod">
          <ac:chgData name="Manasweeta Angane" userId="05da2731-9352-4b35-b713-60351f56afbd" providerId="ADAL" clId="{F5F97842-A295-4F9F-B89B-A63B35E1C32D}" dt="2022-10-19T08:32:34.274" v="11332" actId="478"/>
          <ac:spMkLst>
            <pc:docMk/>
            <pc:sldMk cId="1254738402" sldId="256"/>
            <ac:spMk id="12" creationId="{C356E1E5-C791-4591-9510-A01BA8F54705}"/>
          </ac:spMkLst>
        </pc:spChg>
        <pc:picChg chg="add del mod">
          <ac:chgData name="Manasweeta Angane" userId="05da2731-9352-4b35-b713-60351f56afbd" providerId="ADAL" clId="{F5F97842-A295-4F9F-B89B-A63B35E1C32D}" dt="2022-10-19T08:31:22.800" v="11308" actId="478"/>
          <ac:picMkLst>
            <pc:docMk/>
            <pc:sldMk cId="1254738402" sldId="256"/>
            <ac:picMk id="2" creationId="{339A27FB-322B-4847-8DA7-B2D224A4F289}"/>
          </ac:picMkLst>
        </pc:picChg>
        <pc:picChg chg="add del mod">
          <ac:chgData name="Manasweeta Angane" userId="05da2731-9352-4b35-b713-60351f56afbd" providerId="ADAL" clId="{F5F97842-A295-4F9F-B89B-A63B35E1C32D}" dt="2022-10-19T08:31:49.184" v="11328" actId="478"/>
          <ac:picMkLst>
            <pc:docMk/>
            <pc:sldMk cId="1254738402" sldId="256"/>
            <ac:picMk id="7" creationId="{9E2AA60C-DA9D-4292-ACA3-8E38856A32BA}"/>
          </ac:picMkLst>
        </pc:picChg>
      </pc:sldChg>
      <pc:sldChg chg="del">
        <pc:chgData name="Manasweeta Angane" userId="05da2731-9352-4b35-b713-60351f56afbd" providerId="ADAL" clId="{F5F97842-A295-4F9F-B89B-A63B35E1C32D}" dt="2022-10-22T07:01:59.685" v="20935" actId="2696"/>
        <pc:sldMkLst>
          <pc:docMk/>
          <pc:sldMk cId="592248708" sldId="260"/>
        </pc:sldMkLst>
      </pc:sldChg>
      <pc:sldChg chg="addSp delSp modSp mod ord modTransition">
        <pc:chgData name="Manasweeta Angane" userId="05da2731-9352-4b35-b713-60351f56afbd" providerId="ADAL" clId="{F5F97842-A295-4F9F-B89B-A63B35E1C32D}" dt="2022-10-11T11:03:31.904" v="6256"/>
        <pc:sldMkLst>
          <pc:docMk/>
          <pc:sldMk cId="4248096269" sldId="267"/>
        </pc:sldMkLst>
        <pc:spChg chg="mod">
          <ac:chgData name="Manasweeta Angane" userId="05da2731-9352-4b35-b713-60351f56afbd" providerId="ADAL" clId="{F5F97842-A295-4F9F-B89B-A63B35E1C32D}" dt="2022-10-09T13:22:35.598" v="10" actId="207"/>
          <ac:spMkLst>
            <pc:docMk/>
            <pc:sldMk cId="4248096269" sldId="267"/>
            <ac:spMk id="3" creationId="{41CF30B8-7D64-4E7B-B060-FE9DFF07A47A}"/>
          </ac:spMkLst>
        </pc:spChg>
        <pc:spChg chg="mod">
          <ac:chgData name="Manasweeta Angane" userId="05da2731-9352-4b35-b713-60351f56afbd" providerId="ADAL" clId="{F5F97842-A295-4F9F-B89B-A63B35E1C32D}" dt="2022-10-09T13:22:56.038" v="12" actId="207"/>
          <ac:spMkLst>
            <pc:docMk/>
            <pc:sldMk cId="4248096269" sldId="267"/>
            <ac:spMk id="7" creationId="{3A7FA338-5A13-4A76-AB06-1C6AFCEE49F0}"/>
          </ac:spMkLst>
        </pc:spChg>
        <pc:spChg chg="mod">
          <ac:chgData name="Manasweeta Angane" userId="05da2731-9352-4b35-b713-60351f56afbd" providerId="ADAL" clId="{F5F97842-A295-4F9F-B89B-A63B35E1C32D}" dt="2022-10-09T13:22:51.215" v="11" actId="207"/>
          <ac:spMkLst>
            <pc:docMk/>
            <pc:sldMk cId="4248096269" sldId="267"/>
            <ac:spMk id="8" creationId="{177F496A-A21B-487E-99BB-4399736E8A77}"/>
          </ac:spMkLst>
        </pc:spChg>
        <pc:spChg chg="mod">
          <ac:chgData name="Manasweeta Angane" userId="05da2731-9352-4b35-b713-60351f56afbd" providerId="ADAL" clId="{F5F97842-A295-4F9F-B89B-A63B35E1C32D}" dt="2022-10-09T13:24:34.012" v="17"/>
          <ac:spMkLst>
            <pc:docMk/>
            <pc:sldMk cId="4248096269" sldId="267"/>
            <ac:spMk id="15" creationId="{9E77A162-84D6-4E40-B05F-2D423DD9F450}"/>
          </ac:spMkLst>
        </pc:spChg>
        <pc:spChg chg="mod">
          <ac:chgData name="Manasweeta Angane" userId="05da2731-9352-4b35-b713-60351f56afbd" providerId="ADAL" clId="{F5F97842-A295-4F9F-B89B-A63B35E1C32D}" dt="2022-10-09T13:24:34.012" v="17"/>
          <ac:spMkLst>
            <pc:docMk/>
            <pc:sldMk cId="4248096269" sldId="267"/>
            <ac:spMk id="16" creationId="{4B772EF7-3F8A-4183-BDD2-A223C6764239}"/>
          </ac:spMkLst>
        </pc:spChg>
        <pc:spChg chg="mod">
          <ac:chgData name="Manasweeta Angane" userId="05da2731-9352-4b35-b713-60351f56afbd" providerId="ADAL" clId="{F5F97842-A295-4F9F-B89B-A63B35E1C32D}" dt="2022-10-09T13:24:34.012" v="17"/>
          <ac:spMkLst>
            <pc:docMk/>
            <pc:sldMk cId="4248096269" sldId="267"/>
            <ac:spMk id="17" creationId="{4CE8D01C-AD44-43E6-8F0F-CCAC788BB991}"/>
          </ac:spMkLst>
        </pc:spChg>
        <pc:spChg chg="mod">
          <ac:chgData name="Manasweeta Angane" userId="05da2731-9352-4b35-b713-60351f56afbd" providerId="ADAL" clId="{F5F97842-A295-4F9F-B89B-A63B35E1C32D}" dt="2022-10-09T13:24:34.012" v="17"/>
          <ac:spMkLst>
            <pc:docMk/>
            <pc:sldMk cId="4248096269" sldId="267"/>
            <ac:spMk id="18" creationId="{4BACB193-19CA-4E4F-BEE1-86A63514CAAD}"/>
          </ac:spMkLst>
        </pc:spChg>
        <pc:spChg chg="mod">
          <ac:chgData name="Manasweeta Angane" userId="05da2731-9352-4b35-b713-60351f56afbd" providerId="ADAL" clId="{F5F97842-A295-4F9F-B89B-A63B35E1C32D}" dt="2022-10-09T13:24:34.012" v="17"/>
          <ac:spMkLst>
            <pc:docMk/>
            <pc:sldMk cId="4248096269" sldId="267"/>
            <ac:spMk id="19" creationId="{47CA30E1-9D00-415D-B3B1-BA2CCC02FCEE}"/>
          </ac:spMkLst>
        </pc:spChg>
        <pc:spChg chg="mod">
          <ac:chgData name="Manasweeta Angane" userId="05da2731-9352-4b35-b713-60351f56afbd" providerId="ADAL" clId="{F5F97842-A295-4F9F-B89B-A63B35E1C32D}" dt="2022-10-09T13:24:34.012" v="17"/>
          <ac:spMkLst>
            <pc:docMk/>
            <pc:sldMk cId="4248096269" sldId="267"/>
            <ac:spMk id="20" creationId="{C1D22382-DD9E-40FE-A9B4-3B99150748B2}"/>
          </ac:spMkLst>
        </pc:spChg>
        <pc:spChg chg="mod">
          <ac:chgData name="Manasweeta Angane" userId="05da2731-9352-4b35-b713-60351f56afbd" providerId="ADAL" clId="{F5F97842-A295-4F9F-B89B-A63B35E1C32D}" dt="2022-10-09T13:24:34.012" v="17"/>
          <ac:spMkLst>
            <pc:docMk/>
            <pc:sldMk cId="4248096269" sldId="267"/>
            <ac:spMk id="21" creationId="{6F947260-A9E4-4F91-88E6-1FBA60026E59}"/>
          </ac:spMkLst>
        </pc:spChg>
        <pc:spChg chg="mod">
          <ac:chgData name="Manasweeta Angane" userId="05da2731-9352-4b35-b713-60351f56afbd" providerId="ADAL" clId="{F5F97842-A295-4F9F-B89B-A63B35E1C32D}" dt="2022-10-09T13:24:34.012" v="17"/>
          <ac:spMkLst>
            <pc:docMk/>
            <pc:sldMk cId="4248096269" sldId="267"/>
            <ac:spMk id="22" creationId="{59A2B372-D327-4FF1-ACDA-DA9FC84278E1}"/>
          </ac:spMkLst>
        </pc:spChg>
        <pc:spChg chg="mod">
          <ac:chgData name="Manasweeta Angane" userId="05da2731-9352-4b35-b713-60351f56afbd" providerId="ADAL" clId="{F5F97842-A295-4F9F-B89B-A63B35E1C32D}" dt="2022-10-09T13:24:34.012" v="17"/>
          <ac:spMkLst>
            <pc:docMk/>
            <pc:sldMk cId="4248096269" sldId="267"/>
            <ac:spMk id="23" creationId="{9EC729D9-AC1E-4EDA-A5CC-2CE452CCEE26}"/>
          </ac:spMkLst>
        </pc:spChg>
        <pc:spChg chg="mod">
          <ac:chgData name="Manasweeta Angane" userId="05da2731-9352-4b35-b713-60351f56afbd" providerId="ADAL" clId="{F5F97842-A295-4F9F-B89B-A63B35E1C32D}" dt="2022-10-09T13:24:34.012" v="17"/>
          <ac:spMkLst>
            <pc:docMk/>
            <pc:sldMk cId="4248096269" sldId="267"/>
            <ac:spMk id="24" creationId="{9BB3704B-AAD9-483D-8896-E02D6AF011AA}"/>
          </ac:spMkLst>
        </pc:spChg>
        <pc:spChg chg="mod">
          <ac:chgData name="Manasweeta Angane" userId="05da2731-9352-4b35-b713-60351f56afbd" providerId="ADAL" clId="{F5F97842-A295-4F9F-B89B-A63B35E1C32D}" dt="2022-10-09T13:24:34.012" v="17"/>
          <ac:spMkLst>
            <pc:docMk/>
            <pc:sldMk cId="4248096269" sldId="267"/>
            <ac:spMk id="25" creationId="{D58A2B03-F987-4AFA-8162-E8AA21FA5EDA}"/>
          </ac:spMkLst>
        </pc:spChg>
        <pc:spChg chg="mod">
          <ac:chgData name="Manasweeta Angane" userId="05da2731-9352-4b35-b713-60351f56afbd" providerId="ADAL" clId="{F5F97842-A295-4F9F-B89B-A63B35E1C32D}" dt="2022-10-09T13:24:34.012" v="17"/>
          <ac:spMkLst>
            <pc:docMk/>
            <pc:sldMk cId="4248096269" sldId="267"/>
            <ac:spMk id="26" creationId="{F09E2E0C-B44D-49A1-B58A-9DA53D5B801D}"/>
          </ac:spMkLst>
        </pc:spChg>
        <pc:spChg chg="mod">
          <ac:chgData name="Manasweeta Angane" userId="05da2731-9352-4b35-b713-60351f56afbd" providerId="ADAL" clId="{F5F97842-A295-4F9F-B89B-A63B35E1C32D}" dt="2022-10-09T13:24:34.012" v="17"/>
          <ac:spMkLst>
            <pc:docMk/>
            <pc:sldMk cId="4248096269" sldId="267"/>
            <ac:spMk id="27" creationId="{028D3D78-AC52-4ABA-AF80-7722FD7FB49B}"/>
          </ac:spMkLst>
        </pc:spChg>
        <pc:spChg chg="add del mod">
          <ac:chgData name="Manasweeta Angane" userId="05da2731-9352-4b35-b713-60351f56afbd" providerId="ADAL" clId="{F5F97842-A295-4F9F-B89B-A63B35E1C32D}" dt="2022-10-09T13:37:59.063" v="105"/>
          <ac:spMkLst>
            <pc:docMk/>
            <pc:sldMk cId="4248096269" sldId="267"/>
            <ac:spMk id="28" creationId="{A096C3EB-F9EA-4418-957A-117D19F2B682}"/>
          </ac:spMkLst>
        </pc:spChg>
        <pc:grpChg chg="add del mod">
          <ac:chgData name="Manasweeta Angane" userId="05da2731-9352-4b35-b713-60351f56afbd" providerId="ADAL" clId="{F5F97842-A295-4F9F-B89B-A63B35E1C32D}" dt="2022-10-09T13:38:04.543" v="107" actId="478"/>
          <ac:grpSpMkLst>
            <pc:docMk/>
            <pc:sldMk cId="4248096269" sldId="267"/>
            <ac:grpSpMk id="14" creationId="{6063FFC1-3902-427E-8CF7-9349BB175D43}"/>
          </ac:grpSpMkLst>
        </pc:grpChg>
        <pc:grpChg chg="add mod">
          <ac:chgData name="Manasweeta Angane" userId="05da2731-9352-4b35-b713-60351f56afbd" providerId="ADAL" clId="{F5F97842-A295-4F9F-B89B-A63B35E1C32D}" dt="2022-10-09T13:39:53.539" v="121" actId="1076"/>
          <ac:grpSpMkLst>
            <pc:docMk/>
            <pc:sldMk cId="4248096269" sldId="267"/>
            <ac:grpSpMk id="30" creationId="{1D9155F2-5557-4B4F-B91E-A441A1486D74}"/>
          </ac:grpSpMkLst>
        </pc:grpChg>
        <pc:picChg chg="add mod">
          <ac:chgData name="Manasweeta Angane" userId="05da2731-9352-4b35-b713-60351f56afbd" providerId="ADAL" clId="{F5F97842-A295-4F9F-B89B-A63B35E1C32D}" dt="2022-10-09T13:21:36.916" v="9" actId="1076"/>
          <ac:picMkLst>
            <pc:docMk/>
            <pc:sldMk cId="4248096269" sldId="267"/>
            <ac:picMk id="9" creationId="{CD55A63F-8811-41D9-8F52-DFD8A3A19A85}"/>
          </ac:picMkLst>
        </pc:picChg>
        <pc:picChg chg="add del mod">
          <ac:chgData name="Manasweeta Angane" userId="05da2731-9352-4b35-b713-60351f56afbd" providerId="ADAL" clId="{F5F97842-A295-4F9F-B89B-A63B35E1C32D}" dt="2022-10-09T13:24:04.132" v="16" actId="478"/>
          <ac:picMkLst>
            <pc:docMk/>
            <pc:sldMk cId="4248096269" sldId="267"/>
            <ac:picMk id="13" creationId="{63D8F197-B62B-4F2A-A574-EF3072AD3CC4}"/>
          </ac:picMkLst>
        </pc:picChg>
        <pc:picChg chg="add mod">
          <ac:chgData name="Manasweeta Angane" userId="05da2731-9352-4b35-b713-60351f56afbd" providerId="ADAL" clId="{F5F97842-A295-4F9F-B89B-A63B35E1C32D}" dt="2022-10-09T13:39:04.672" v="116" actId="1076"/>
          <ac:picMkLst>
            <pc:docMk/>
            <pc:sldMk cId="4248096269" sldId="267"/>
            <ac:picMk id="29" creationId="{52DCB79F-4650-4340-B095-4FB93CE2DA74}"/>
          </ac:picMkLst>
        </pc:picChg>
        <pc:picChg chg="mod">
          <ac:chgData name="Manasweeta Angane" userId="05da2731-9352-4b35-b713-60351f56afbd" providerId="ADAL" clId="{F5F97842-A295-4F9F-B89B-A63B35E1C32D}" dt="2022-10-09T13:39:53.539" v="121" actId="1076"/>
          <ac:picMkLst>
            <pc:docMk/>
            <pc:sldMk cId="4248096269" sldId="267"/>
            <ac:picMk id="31" creationId="{37F7E9D7-2A58-4071-A33E-6111B008CA5C}"/>
          </ac:picMkLst>
        </pc:picChg>
        <pc:picChg chg="mod">
          <ac:chgData name="Manasweeta Angane" userId="05da2731-9352-4b35-b713-60351f56afbd" providerId="ADAL" clId="{F5F97842-A295-4F9F-B89B-A63B35E1C32D}" dt="2022-10-09T13:39:53.539" v="121" actId="1076"/>
          <ac:picMkLst>
            <pc:docMk/>
            <pc:sldMk cId="4248096269" sldId="267"/>
            <ac:picMk id="32" creationId="{8B6F2662-0FC3-4022-A862-46033D8CFC8E}"/>
          </ac:picMkLst>
        </pc:picChg>
        <pc:picChg chg="del mod">
          <ac:chgData name="Manasweeta Angane" userId="05da2731-9352-4b35-b713-60351f56afbd" providerId="ADAL" clId="{F5F97842-A295-4F9F-B89B-A63B35E1C32D}" dt="2022-10-09T13:21:25.612" v="7" actId="478"/>
          <ac:picMkLst>
            <pc:docMk/>
            <pc:sldMk cId="4248096269" sldId="267"/>
            <ac:picMk id="2050" creationId="{0EA136DA-DA7B-4301-8B4F-55A46F7DDD5D}"/>
          </ac:picMkLst>
        </pc:picChg>
      </pc:sldChg>
      <pc:sldChg chg="del">
        <pc:chgData name="Manasweeta Angane" userId="05da2731-9352-4b35-b713-60351f56afbd" providerId="ADAL" clId="{F5F97842-A295-4F9F-B89B-A63B35E1C32D}" dt="2022-10-09T23:43:39.811" v="1789" actId="2696"/>
        <pc:sldMkLst>
          <pc:docMk/>
          <pc:sldMk cId="3145637976" sldId="268"/>
        </pc:sldMkLst>
      </pc:sldChg>
      <pc:sldChg chg="del">
        <pc:chgData name="Manasweeta Angane" userId="05da2731-9352-4b35-b713-60351f56afbd" providerId="ADAL" clId="{F5F97842-A295-4F9F-B89B-A63B35E1C32D}" dt="2022-10-09T23:43:56.499" v="1791" actId="2696"/>
        <pc:sldMkLst>
          <pc:docMk/>
          <pc:sldMk cId="2942563435" sldId="269"/>
        </pc:sldMkLst>
      </pc:sldChg>
      <pc:sldChg chg="del modTransition">
        <pc:chgData name="Manasweeta Angane" userId="05da2731-9352-4b35-b713-60351f56afbd" providerId="ADAL" clId="{F5F97842-A295-4F9F-B89B-A63B35E1C32D}" dt="2022-10-10T13:45:48.358" v="4671" actId="2696"/>
        <pc:sldMkLst>
          <pc:docMk/>
          <pc:sldMk cId="731297326" sldId="270"/>
        </pc:sldMkLst>
      </pc:sldChg>
      <pc:sldChg chg="del">
        <pc:chgData name="Manasweeta Angane" userId="05da2731-9352-4b35-b713-60351f56afbd" providerId="ADAL" clId="{F5F97842-A295-4F9F-B89B-A63B35E1C32D}" dt="2022-10-09T23:43:51.786" v="1790" actId="2696"/>
        <pc:sldMkLst>
          <pc:docMk/>
          <pc:sldMk cId="4188440041" sldId="271"/>
        </pc:sldMkLst>
      </pc:sldChg>
      <pc:sldChg chg="del">
        <pc:chgData name="Manasweeta Angane" userId="05da2731-9352-4b35-b713-60351f56afbd" providerId="ADAL" clId="{F5F97842-A295-4F9F-B89B-A63B35E1C32D}" dt="2022-10-09T23:44:30.134" v="1797" actId="2696"/>
        <pc:sldMkLst>
          <pc:docMk/>
          <pc:sldMk cId="3166259601" sldId="272"/>
        </pc:sldMkLst>
      </pc:sldChg>
      <pc:sldChg chg="del">
        <pc:chgData name="Manasweeta Angane" userId="05da2731-9352-4b35-b713-60351f56afbd" providerId="ADAL" clId="{F5F97842-A295-4F9F-B89B-A63B35E1C32D}" dt="2022-10-09T23:44:24.318" v="1796" actId="2696"/>
        <pc:sldMkLst>
          <pc:docMk/>
          <pc:sldMk cId="1115324438" sldId="273"/>
        </pc:sldMkLst>
      </pc:sldChg>
      <pc:sldChg chg="modSp del">
        <pc:chgData name="Manasweeta Angane" userId="05da2731-9352-4b35-b713-60351f56afbd" providerId="ADAL" clId="{F5F97842-A295-4F9F-B89B-A63B35E1C32D}" dt="2022-10-09T23:44:19.863" v="1795" actId="2696"/>
        <pc:sldMkLst>
          <pc:docMk/>
          <pc:sldMk cId="1520954764" sldId="274"/>
        </pc:sldMkLst>
        <pc:picChg chg="mod">
          <ac:chgData name="Manasweeta Angane" userId="05da2731-9352-4b35-b713-60351f56afbd" providerId="ADAL" clId="{F5F97842-A295-4F9F-B89B-A63B35E1C32D}" dt="2022-10-09T23:08:26.165" v="1297" actId="1076"/>
          <ac:picMkLst>
            <pc:docMk/>
            <pc:sldMk cId="1520954764" sldId="274"/>
            <ac:picMk id="1032" creationId="{99474CAB-F966-436F-B692-4E5E730E7212}"/>
          </ac:picMkLst>
        </pc:picChg>
      </pc:sldChg>
      <pc:sldChg chg="del">
        <pc:chgData name="Manasweeta Angane" userId="05da2731-9352-4b35-b713-60351f56afbd" providerId="ADAL" clId="{F5F97842-A295-4F9F-B89B-A63B35E1C32D}" dt="2022-10-09T23:44:15.181" v="1794" actId="2696"/>
        <pc:sldMkLst>
          <pc:docMk/>
          <pc:sldMk cId="1754629027" sldId="275"/>
        </pc:sldMkLst>
      </pc:sldChg>
      <pc:sldChg chg="del">
        <pc:chgData name="Manasweeta Angane" userId="05da2731-9352-4b35-b713-60351f56afbd" providerId="ADAL" clId="{F5F97842-A295-4F9F-B89B-A63B35E1C32D}" dt="2022-10-09T23:44:11.500" v="1793" actId="2696"/>
        <pc:sldMkLst>
          <pc:docMk/>
          <pc:sldMk cId="560320406" sldId="276"/>
        </pc:sldMkLst>
      </pc:sldChg>
      <pc:sldChg chg="del">
        <pc:chgData name="Manasweeta Angane" userId="05da2731-9352-4b35-b713-60351f56afbd" providerId="ADAL" clId="{F5F97842-A295-4F9F-B89B-A63B35E1C32D}" dt="2022-10-09T23:44:07.423" v="1792" actId="2696"/>
        <pc:sldMkLst>
          <pc:docMk/>
          <pc:sldMk cId="2478566023" sldId="277"/>
        </pc:sldMkLst>
      </pc:sldChg>
      <pc:sldChg chg="addSp delSp modSp new mod ord modTransition setBg setClrOvrMap delDesignElem">
        <pc:chgData name="Manasweeta Angane" userId="05da2731-9352-4b35-b713-60351f56afbd" providerId="ADAL" clId="{F5F97842-A295-4F9F-B89B-A63B35E1C32D}" dt="2022-10-17T09:42:31.383" v="6592"/>
        <pc:sldMkLst>
          <pc:docMk/>
          <pc:sldMk cId="3481556119" sldId="278"/>
        </pc:sldMkLst>
        <pc:spChg chg="del mod">
          <ac:chgData name="Manasweeta Angane" userId="05da2731-9352-4b35-b713-60351f56afbd" providerId="ADAL" clId="{F5F97842-A295-4F9F-B89B-A63B35E1C32D}" dt="2022-10-09T13:41:48.987" v="240" actId="478"/>
          <ac:spMkLst>
            <pc:docMk/>
            <pc:sldMk cId="3481556119" sldId="278"/>
            <ac:spMk id="2" creationId="{12F9AA57-0E1B-4AC6-9BF1-3BA382EB1DFC}"/>
          </ac:spMkLst>
        </pc:spChg>
        <pc:spChg chg="del mod">
          <ac:chgData name="Manasweeta Angane" userId="05da2731-9352-4b35-b713-60351f56afbd" providerId="ADAL" clId="{F5F97842-A295-4F9F-B89B-A63B35E1C32D}" dt="2022-10-09T13:41:59.426" v="242" actId="478"/>
          <ac:spMkLst>
            <pc:docMk/>
            <pc:sldMk cId="3481556119" sldId="278"/>
            <ac:spMk id="3" creationId="{36636D70-4F64-4EB9-BD87-CC7AF7F168C6}"/>
          </ac:spMkLst>
        </pc:spChg>
        <pc:spChg chg="add del">
          <ac:chgData name="Manasweeta Angane" userId="05da2731-9352-4b35-b713-60351f56afbd" providerId="ADAL" clId="{F5F97842-A295-4F9F-B89B-A63B35E1C32D}" dt="2022-10-09T13:30:36.782" v="59" actId="26606"/>
          <ac:spMkLst>
            <pc:docMk/>
            <pc:sldMk cId="3481556119" sldId="278"/>
            <ac:spMk id="7" creationId="{DF05ACD0-FF4A-4F8F-B5C5-6A4EBD0D1B38}"/>
          </ac:spMkLst>
        </pc:spChg>
        <pc:spChg chg="add del">
          <ac:chgData name="Manasweeta Angane" userId="05da2731-9352-4b35-b713-60351f56afbd" providerId="ADAL" clId="{F5F97842-A295-4F9F-B89B-A63B35E1C32D}" dt="2022-10-09T13:30:36.782" v="59" actId="26606"/>
          <ac:spMkLst>
            <pc:docMk/>
            <pc:sldMk cId="3481556119" sldId="278"/>
            <ac:spMk id="8" creationId="{4C9AFA28-B5ED-4346-9AF7-68A157F16C7E}"/>
          </ac:spMkLst>
        </pc:spChg>
        <pc:spChg chg="add del">
          <ac:chgData name="Manasweeta Angane" userId="05da2731-9352-4b35-b713-60351f56afbd" providerId="ADAL" clId="{F5F97842-A295-4F9F-B89B-A63B35E1C32D}" dt="2022-10-09T13:26:10.135" v="26" actId="26606"/>
          <ac:spMkLst>
            <pc:docMk/>
            <pc:sldMk cId="3481556119" sldId="278"/>
            <ac:spMk id="10" creationId="{E49CC64F-7275-4E33-961B-0C5CDC439875}"/>
          </ac:spMkLst>
        </pc:spChg>
        <pc:spChg chg="add del">
          <ac:chgData name="Manasweeta Angane" userId="05da2731-9352-4b35-b713-60351f56afbd" providerId="ADAL" clId="{F5F97842-A295-4F9F-B89B-A63B35E1C32D}" dt="2022-10-09T13:26:16.927" v="28" actId="26606"/>
          <ac:spMkLst>
            <pc:docMk/>
            <pc:sldMk cId="3481556119" sldId="278"/>
            <ac:spMk id="12" creationId="{658970D8-8D1D-4B5C-894B-E871CC86543D}"/>
          </ac:spMkLst>
        </pc:spChg>
        <pc:spChg chg="add del">
          <ac:chgData name="Manasweeta Angane" userId="05da2731-9352-4b35-b713-60351f56afbd" providerId="ADAL" clId="{F5F97842-A295-4F9F-B89B-A63B35E1C32D}" dt="2022-10-09T13:26:16.927" v="28" actId="26606"/>
          <ac:spMkLst>
            <pc:docMk/>
            <pc:sldMk cId="3481556119" sldId="278"/>
            <ac:spMk id="13" creationId="{362D44EE-C852-4460-B8B5-C4F2BC20510C}"/>
          </ac:spMkLst>
        </pc:spChg>
        <pc:spChg chg="add del">
          <ac:chgData name="Manasweeta Angane" userId="05da2731-9352-4b35-b713-60351f56afbd" providerId="ADAL" clId="{F5F97842-A295-4F9F-B89B-A63B35E1C32D}" dt="2022-10-09T13:26:16.927" v="28" actId="26606"/>
          <ac:spMkLst>
            <pc:docMk/>
            <pc:sldMk cId="3481556119" sldId="278"/>
            <ac:spMk id="14" creationId="{F227E5B6-9132-43CA-B503-37A18562ADF2}"/>
          </ac:spMkLst>
        </pc:spChg>
        <pc:spChg chg="add del">
          <ac:chgData name="Manasweeta Angane" userId="05da2731-9352-4b35-b713-60351f56afbd" providerId="ADAL" clId="{F5F97842-A295-4F9F-B89B-A63B35E1C32D}" dt="2022-10-09T13:26:16.927" v="28" actId="26606"/>
          <ac:spMkLst>
            <pc:docMk/>
            <pc:sldMk cId="3481556119" sldId="278"/>
            <ac:spMk id="16" creationId="{03C2051E-A88D-48E5-BACF-AAED17892722}"/>
          </ac:spMkLst>
        </pc:spChg>
        <pc:spChg chg="add del">
          <ac:chgData name="Manasweeta Angane" userId="05da2731-9352-4b35-b713-60351f56afbd" providerId="ADAL" clId="{F5F97842-A295-4F9F-B89B-A63B35E1C32D}" dt="2022-10-09T13:26:16.927" v="28" actId="26606"/>
          <ac:spMkLst>
            <pc:docMk/>
            <pc:sldMk cId="3481556119" sldId="278"/>
            <ac:spMk id="18" creationId="{7821A508-2985-4905-874A-527429BAABFA}"/>
          </ac:spMkLst>
        </pc:spChg>
        <pc:spChg chg="add del">
          <ac:chgData name="Manasweeta Angane" userId="05da2731-9352-4b35-b713-60351f56afbd" providerId="ADAL" clId="{F5F97842-A295-4F9F-B89B-A63B35E1C32D}" dt="2022-10-09T13:26:16.927" v="28" actId="26606"/>
          <ac:spMkLst>
            <pc:docMk/>
            <pc:sldMk cId="3481556119" sldId="278"/>
            <ac:spMk id="20" creationId="{D2929CB1-0E3C-4B2D-ADC5-0154FB33BA44}"/>
          </ac:spMkLst>
        </pc:spChg>
        <pc:spChg chg="add del">
          <ac:chgData name="Manasweeta Angane" userId="05da2731-9352-4b35-b713-60351f56afbd" providerId="ADAL" clId="{F5F97842-A295-4F9F-B89B-A63B35E1C32D}" dt="2022-10-09T13:28:40.165" v="40" actId="26606"/>
          <ac:spMkLst>
            <pc:docMk/>
            <pc:sldMk cId="3481556119" sldId="278"/>
            <ac:spMk id="21" creationId="{7316481C-0A49-4796-812B-0D64F063B720}"/>
          </ac:spMkLst>
        </pc:spChg>
        <pc:spChg chg="add del">
          <ac:chgData name="Manasweeta Angane" userId="05da2731-9352-4b35-b713-60351f56afbd" providerId="ADAL" clId="{F5F97842-A295-4F9F-B89B-A63B35E1C32D}" dt="2022-10-09T13:26:16.927" v="28" actId="26606"/>
          <ac:spMkLst>
            <pc:docMk/>
            <pc:sldMk cId="3481556119" sldId="278"/>
            <ac:spMk id="22" creationId="{5F2F0C84-BE8C-4DC2-A6D3-30349A801D5C}"/>
          </ac:spMkLst>
        </pc:spChg>
        <pc:spChg chg="add del">
          <ac:chgData name="Manasweeta Angane" userId="05da2731-9352-4b35-b713-60351f56afbd" providerId="ADAL" clId="{F5F97842-A295-4F9F-B89B-A63B35E1C32D}" dt="2022-10-09T13:26:21.509" v="30" actId="26606"/>
          <ac:spMkLst>
            <pc:docMk/>
            <pc:sldMk cId="3481556119" sldId="278"/>
            <ac:spMk id="24" creationId="{06DA9DF9-31F7-4056-B42E-878CC92417B8}"/>
          </ac:spMkLst>
        </pc:spChg>
        <pc:spChg chg="add del">
          <ac:chgData name="Manasweeta Angane" userId="05da2731-9352-4b35-b713-60351f56afbd" providerId="ADAL" clId="{F5F97842-A295-4F9F-B89B-A63B35E1C32D}" dt="2022-10-09T13:28:40.165" v="40" actId="26606"/>
          <ac:spMkLst>
            <pc:docMk/>
            <pc:sldMk cId="3481556119" sldId="278"/>
            <ac:spMk id="26" creationId="{A5271697-90F1-4A23-8EF2-0179F2EAFACB}"/>
          </ac:spMkLst>
        </pc:spChg>
        <pc:spChg chg="add del">
          <ac:chgData name="Manasweeta Angane" userId="05da2731-9352-4b35-b713-60351f56afbd" providerId="ADAL" clId="{F5F97842-A295-4F9F-B89B-A63B35E1C32D}" dt="2022-10-09T13:29:23.742" v="46" actId="26606"/>
          <ac:spMkLst>
            <pc:docMk/>
            <pc:sldMk cId="3481556119" sldId="278"/>
            <ac:spMk id="30" creationId="{8ED94938-268E-4C0A-A08A-B3980C78BAEB}"/>
          </ac:spMkLst>
        </pc:spChg>
        <pc:spChg chg="add del">
          <ac:chgData name="Manasweeta Angane" userId="05da2731-9352-4b35-b713-60351f56afbd" providerId="ADAL" clId="{F5F97842-A295-4F9F-B89B-A63B35E1C32D}" dt="2022-10-09T13:30:11.488" v="56" actId="26606"/>
          <ac:spMkLst>
            <pc:docMk/>
            <pc:sldMk cId="3481556119" sldId="278"/>
            <ac:spMk id="31" creationId="{B81933D1-5615-42C7-9C0B-4EB7105CCE2D}"/>
          </ac:spMkLst>
        </pc:spChg>
        <pc:spChg chg="add del">
          <ac:chgData name="Manasweeta Angane" userId="05da2731-9352-4b35-b713-60351f56afbd" providerId="ADAL" clId="{F5F97842-A295-4F9F-B89B-A63B35E1C32D}" dt="2022-10-09T13:29:35.763" v="48" actId="26606"/>
          <ac:spMkLst>
            <pc:docMk/>
            <pc:sldMk cId="3481556119" sldId="278"/>
            <ac:spMk id="32" creationId="{70A21480-D93D-46BE-9A94-B5A80469DF68}"/>
          </ac:spMkLst>
        </pc:spChg>
        <pc:spChg chg="add del">
          <ac:chgData name="Manasweeta Angane" userId="05da2731-9352-4b35-b713-60351f56afbd" providerId="ADAL" clId="{F5F97842-A295-4F9F-B89B-A63B35E1C32D}" dt="2022-10-09T13:30:11.488" v="56" actId="26606"/>
          <ac:spMkLst>
            <pc:docMk/>
            <pc:sldMk cId="3481556119" sldId="278"/>
            <ac:spMk id="33" creationId="{B089A89A-1E9C-4761-9DFF-53C275FBF870}"/>
          </ac:spMkLst>
        </pc:spChg>
        <pc:spChg chg="add del">
          <ac:chgData name="Manasweeta Angane" userId="05da2731-9352-4b35-b713-60351f56afbd" providerId="ADAL" clId="{F5F97842-A295-4F9F-B89B-A63B35E1C32D}" dt="2022-10-09T13:29:35.763" v="48" actId="26606"/>
          <ac:spMkLst>
            <pc:docMk/>
            <pc:sldMk cId="3481556119" sldId="278"/>
            <ac:spMk id="34" creationId="{33E49524-66B4-4DB0-AD09-DC8B9874E1B3}"/>
          </ac:spMkLst>
        </pc:spChg>
        <pc:spChg chg="add del">
          <ac:chgData name="Manasweeta Angane" userId="05da2731-9352-4b35-b713-60351f56afbd" providerId="ADAL" clId="{F5F97842-A295-4F9F-B89B-A63B35E1C32D}" dt="2022-10-09T13:30:11.488" v="56" actId="26606"/>
          <ac:spMkLst>
            <pc:docMk/>
            <pc:sldMk cId="3481556119" sldId="278"/>
            <ac:spMk id="35" creationId="{19C9EAEA-39D0-4B0E-A0EB-51E7B26740B1}"/>
          </ac:spMkLst>
        </pc:spChg>
        <pc:spChg chg="add del">
          <ac:chgData name="Manasweeta Angane" userId="05da2731-9352-4b35-b713-60351f56afbd" providerId="ADAL" clId="{F5F97842-A295-4F9F-B89B-A63B35E1C32D}" dt="2022-10-09T13:29:35.763" v="48" actId="26606"/>
          <ac:spMkLst>
            <pc:docMk/>
            <pc:sldMk cId="3481556119" sldId="278"/>
            <ac:spMk id="36" creationId="{E5EBF8F5-ABE5-4029-A8FC-4E32622D70A6}"/>
          </ac:spMkLst>
        </pc:spChg>
        <pc:spChg chg="add del">
          <ac:chgData name="Manasweeta Angane" userId="05da2731-9352-4b35-b713-60351f56afbd" providerId="ADAL" clId="{F5F97842-A295-4F9F-B89B-A63B35E1C32D}" dt="2022-10-09T13:28:40.165" v="40" actId="26606"/>
          <ac:spMkLst>
            <pc:docMk/>
            <pc:sldMk cId="3481556119" sldId="278"/>
            <ac:spMk id="50" creationId="{D9F5512A-48E1-4C07-B75E-3CCC517B6804}"/>
          </ac:spMkLst>
        </pc:spChg>
        <pc:spChg chg="add del">
          <ac:chgData name="Manasweeta Angane" userId="05da2731-9352-4b35-b713-60351f56afbd" providerId="ADAL" clId="{F5F97842-A295-4F9F-B89B-A63B35E1C32D}" dt="2022-10-09T13:28:56.078" v="42" actId="26606"/>
          <ac:spMkLst>
            <pc:docMk/>
            <pc:sldMk cId="3481556119" sldId="278"/>
            <ac:spMk id="52" creationId="{D6CF29CD-38B8-4924-BA11-6D60517487EF}"/>
          </ac:spMkLst>
        </pc:spChg>
        <pc:spChg chg="add del">
          <ac:chgData name="Manasweeta Angane" userId="05da2731-9352-4b35-b713-60351f56afbd" providerId="ADAL" clId="{F5F97842-A295-4F9F-B89B-A63B35E1C32D}" dt="2022-10-09T13:29:06.998" v="44" actId="26606"/>
          <ac:spMkLst>
            <pc:docMk/>
            <pc:sldMk cId="3481556119" sldId="278"/>
            <ac:spMk id="55" creationId="{41F18803-BE79-4916-AE6B-5DE238B367F0}"/>
          </ac:spMkLst>
        </pc:spChg>
        <pc:spChg chg="add del">
          <ac:chgData name="Manasweeta Angane" userId="05da2731-9352-4b35-b713-60351f56afbd" providerId="ADAL" clId="{F5F97842-A295-4F9F-B89B-A63B35E1C32D}" dt="2022-10-09T13:29:06.998" v="44" actId="26606"/>
          <ac:spMkLst>
            <pc:docMk/>
            <pc:sldMk cId="3481556119" sldId="278"/>
            <ac:spMk id="56" creationId="{C15229F3-7A2E-4558-98FE-7A5F69409DCE}"/>
          </ac:spMkLst>
        </pc:spChg>
        <pc:spChg chg="add del">
          <ac:chgData name="Manasweeta Angane" userId="05da2731-9352-4b35-b713-60351f56afbd" providerId="ADAL" clId="{F5F97842-A295-4F9F-B89B-A63B35E1C32D}" dt="2022-10-09T13:29:23.742" v="46" actId="26606"/>
          <ac:spMkLst>
            <pc:docMk/>
            <pc:sldMk cId="3481556119" sldId="278"/>
            <ac:spMk id="58" creationId="{D55CA618-78A6-47F6-B865-E9315164FB49}"/>
          </ac:spMkLst>
        </pc:spChg>
        <pc:spChg chg="add del">
          <ac:chgData name="Manasweeta Angane" userId="05da2731-9352-4b35-b713-60351f56afbd" providerId="ADAL" clId="{F5F97842-A295-4F9F-B89B-A63B35E1C32D}" dt="2022-10-09T13:29:35.763" v="48" actId="26606"/>
          <ac:spMkLst>
            <pc:docMk/>
            <pc:sldMk cId="3481556119" sldId="278"/>
            <ac:spMk id="62" creationId="{BFFB6EAD-767A-4A95-9246-C39976AD1119}"/>
          </ac:spMkLst>
        </pc:spChg>
        <pc:spChg chg="add del">
          <ac:chgData name="Manasweeta Angane" userId="05da2731-9352-4b35-b713-60351f56afbd" providerId="ADAL" clId="{F5F97842-A295-4F9F-B89B-A63B35E1C32D}" dt="2022-10-09T13:29:35.763" v="48" actId="26606"/>
          <ac:spMkLst>
            <pc:docMk/>
            <pc:sldMk cId="3481556119" sldId="278"/>
            <ac:spMk id="63" creationId="{07062BB1-E215-424E-80C4-7E1CF179A357}"/>
          </ac:spMkLst>
        </pc:spChg>
        <pc:spChg chg="add del">
          <ac:chgData name="Manasweeta Angane" userId="05da2731-9352-4b35-b713-60351f56afbd" providerId="ADAL" clId="{F5F97842-A295-4F9F-B89B-A63B35E1C32D}" dt="2022-10-09T13:29:35.763" v="48" actId="26606"/>
          <ac:spMkLst>
            <pc:docMk/>
            <pc:sldMk cId="3481556119" sldId="278"/>
            <ac:spMk id="64" creationId="{B368E167-B2D7-4904-BB6B-AE0486A2C6F8}"/>
          </ac:spMkLst>
        </pc:spChg>
        <pc:spChg chg="add del">
          <ac:chgData name="Manasweeta Angane" userId="05da2731-9352-4b35-b713-60351f56afbd" providerId="ADAL" clId="{F5F97842-A295-4F9F-B89B-A63B35E1C32D}" dt="2022-10-09T13:29:35.763" v="48" actId="26606"/>
          <ac:spMkLst>
            <pc:docMk/>
            <pc:sldMk cId="3481556119" sldId="278"/>
            <ac:spMk id="65" creationId="{6FD0FBFA-B43E-40C1-A6E4-B88234171E7A}"/>
          </ac:spMkLst>
        </pc:spChg>
        <pc:spChg chg="add del">
          <ac:chgData name="Manasweeta Angane" userId="05da2731-9352-4b35-b713-60351f56afbd" providerId="ADAL" clId="{F5F97842-A295-4F9F-B89B-A63B35E1C32D}" dt="2022-10-09T13:29:42.024" v="50" actId="26606"/>
          <ac:spMkLst>
            <pc:docMk/>
            <pc:sldMk cId="3481556119" sldId="278"/>
            <ac:spMk id="67" creationId="{AE7446D0-1ECD-41DE-B419-58C86D37ECB4}"/>
          </ac:spMkLst>
        </pc:spChg>
        <pc:spChg chg="add del">
          <ac:chgData name="Manasweeta Angane" userId="05da2731-9352-4b35-b713-60351f56afbd" providerId="ADAL" clId="{F5F97842-A295-4F9F-B89B-A63B35E1C32D}" dt="2022-10-09T13:29:42.024" v="50" actId="26606"/>
          <ac:spMkLst>
            <pc:docMk/>
            <pc:sldMk cId="3481556119" sldId="278"/>
            <ac:spMk id="68" creationId="{AC795A7F-5B31-4FB1-B065-3E746F34E947}"/>
          </ac:spMkLst>
        </pc:spChg>
        <pc:spChg chg="add del">
          <ac:chgData name="Manasweeta Angane" userId="05da2731-9352-4b35-b713-60351f56afbd" providerId="ADAL" clId="{F5F97842-A295-4F9F-B89B-A63B35E1C32D}" dt="2022-10-09T13:29:42.024" v="50" actId="26606"/>
          <ac:spMkLst>
            <pc:docMk/>
            <pc:sldMk cId="3481556119" sldId="278"/>
            <ac:spMk id="69" creationId="{B9D8496E-C924-4F8E-A90C-022E2875656E}"/>
          </ac:spMkLst>
        </pc:spChg>
        <pc:spChg chg="add del">
          <ac:chgData name="Manasweeta Angane" userId="05da2731-9352-4b35-b713-60351f56afbd" providerId="ADAL" clId="{F5F97842-A295-4F9F-B89B-A63B35E1C32D}" dt="2022-10-09T13:29:48.286" v="52" actId="26606"/>
          <ac:spMkLst>
            <pc:docMk/>
            <pc:sldMk cId="3481556119" sldId="278"/>
            <ac:spMk id="71" creationId="{B5128750-6DE7-4BD7-B6DD-399E90474D1E}"/>
          </ac:spMkLst>
        </pc:spChg>
        <pc:spChg chg="add del">
          <ac:chgData name="Manasweeta Angane" userId="05da2731-9352-4b35-b713-60351f56afbd" providerId="ADAL" clId="{F5F97842-A295-4F9F-B89B-A63B35E1C32D}" dt="2022-10-09T13:29:48.286" v="52" actId="26606"/>
          <ac:spMkLst>
            <pc:docMk/>
            <pc:sldMk cId="3481556119" sldId="278"/>
            <ac:spMk id="72" creationId="{07BA6415-1CCB-4FE4-8D1D-DE0505D993E0}"/>
          </ac:spMkLst>
        </pc:spChg>
        <pc:spChg chg="add del">
          <ac:chgData name="Manasweeta Angane" userId="05da2731-9352-4b35-b713-60351f56afbd" providerId="ADAL" clId="{F5F97842-A295-4F9F-B89B-A63B35E1C32D}" dt="2022-10-09T13:29:48.286" v="52" actId="26606"/>
          <ac:spMkLst>
            <pc:docMk/>
            <pc:sldMk cId="3481556119" sldId="278"/>
            <ac:spMk id="73" creationId="{CA1B373B-0DE9-4AE4-A839-26F801A34087}"/>
          </ac:spMkLst>
        </pc:spChg>
        <pc:spChg chg="add del">
          <ac:chgData name="Manasweeta Angane" userId="05da2731-9352-4b35-b713-60351f56afbd" providerId="ADAL" clId="{F5F97842-A295-4F9F-B89B-A63B35E1C32D}" dt="2022-10-09T13:29:57.869" v="54" actId="26606"/>
          <ac:spMkLst>
            <pc:docMk/>
            <pc:sldMk cId="3481556119" sldId="278"/>
            <ac:spMk id="75" creationId="{A2F42F6F-FDA2-4441-805F-CF30FBC9915B}"/>
          </ac:spMkLst>
        </pc:spChg>
        <pc:spChg chg="add del">
          <ac:chgData name="Manasweeta Angane" userId="05da2731-9352-4b35-b713-60351f56afbd" providerId="ADAL" clId="{F5F97842-A295-4F9F-B89B-A63B35E1C32D}" dt="2022-10-09T13:30:11.488" v="56" actId="26606"/>
          <ac:spMkLst>
            <pc:docMk/>
            <pc:sldMk cId="3481556119" sldId="278"/>
            <ac:spMk id="80" creationId="{E18F6E8B-15ED-43C7-94BA-91549A651C73}"/>
          </ac:spMkLst>
        </pc:spChg>
        <pc:spChg chg="add del">
          <ac:chgData name="Manasweeta Angane" userId="05da2731-9352-4b35-b713-60351f56afbd" providerId="ADAL" clId="{F5F97842-A295-4F9F-B89B-A63B35E1C32D}" dt="2022-10-09T13:30:36.776" v="58" actId="26606"/>
          <ac:spMkLst>
            <pc:docMk/>
            <pc:sldMk cId="3481556119" sldId="278"/>
            <ac:spMk id="86" creationId="{2DA60C47-9F76-46D7-9D57-E0C7BA42B81A}"/>
          </ac:spMkLst>
        </pc:spChg>
        <pc:spChg chg="add del">
          <ac:chgData name="Manasweeta Angane" userId="05da2731-9352-4b35-b713-60351f56afbd" providerId="ADAL" clId="{F5F97842-A295-4F9F-B89B-A63B35E1C32D}" dt="2022-10-09T13:30:36.776" v="58" actId="26606"/>
          <ac:spMkLst>
            <pc:docMk/>
            <pc:sldMk cId="3481556119" sldId="278"/>
            <ac:spMk id="87" creationId="{99413ED5-9ED4-4772-BCE4-2BCAE6B12E35}"/>
          </ac:spMkLst>
        </pc:spChg>
        <pc:spChg chg="add del">
          <ac:chgData name="Manasweeta Angane" userId="05da2731-9352-4b35-b713-60351f56afbd" providerId="ADAL" clId="{F5F97842-A295-4F9F-B89B-A63B35E1C32D}" dt="2022-10-09T13:30:36.776" v="58" actId="26606"/>
          <ac:spMkLst>
            <pc:docMk/>
            <pc:sldMk cId="3481556119" sldId="278"/>
            <ac:spMk id="88" creationId="{04357C93-F0CB-4A1C-8F77-4E9063789819}"/>
          </ac:spMkLst>
        </pc:spChg>
        <pc:spChg chg="add del">
          <ac:chgData name="Manasweeta Angane" userId="05da2731-9352-4b35-b713-60351f56afbd" providerId="ADAL" clId="{F5F97842-A295-4F9F-B89B-A63B35E1C32D}" dt="2022-10-09T13:30:36.776" v="58" actId="26606"/>
          <ac:spMkLst>
            <pc:docMk/>
            <pc:sldMk cId="3481556119" sldId="278"/>
            <ac:spMk id="89" creationId="{6CF143E5-57C3-46A3-91A2-EDAA7A8E6A75}"/>
          </ac:spMkLst>
        </pc:spChg>
        <pc:spChg chg="add del">
          <ac:chgData name="Manasweeta Angane" userId="05da2731-9352-4b35-b713-60351f56afbd" providerId="ADAL" clId="{F5F97842-A295-4F9F-B89B-A63B35E1C32D}" dt="2022-10-09T13:31:06.258" v="60" actId="26606"/>
          <ac:spMkLst>
            <pc:docMk/>
            <pc:sldMk cId="3481556119" sldId="278"/>
            <ac:spMk id="91" creationId="{D55CA618-78A6-47F6-B865-E9315164FB49}"/>
          </ac:spMkLst>
        </pc:spChg>
        <pc:spChg chg="add del">
          <ac:chgData name="Manasweeta Angane" userId="05da2731-9352-4b35-b713-60351f56afbd" providerId="ADAL" clId="{F5F97842-A295-4F9F-B89B-A63B35E1C32D}" dt="2022-10-09T13:31:06.258" v="60" actId="26606"/>
          <ac:spMkLst>
            <pc:docMk/>
            <pc:sldMk cId="3481556119" sldId="278"/>
            <ac:spMk id="94" creationId="{8ED94938-268E-4C0A-A08A-B3980C78BAEB}"/>
          </ac:spMkLst>
        </pc:spChg>
        <pc:spChg chg="add del">
          <ac:chgData name="Manasweeta Angane" userId="05da2731-9352-4b35-b713-60351f56afbd" providerId="ADAL" clId="{F5F97842-A295-4F9F-B89B-A63B35E1C32D}" dt="2022-10-09T13:34:09.119" v="68" actId="26606"/>
          <ac:spMkLst>
            <pc:docMk/>
            <pc:sldMk cId="3481556119" sldId="278"/>
            <ac:spMk id="99" creationId="{87E5499B-AC4D-4A4A-8703-C49F2827266B}"/>
          </ac:spMkLst>
        </pc:spChg>
        <pc:spChg chg="add del">
          <ac:chgData name="Manasweeta Angane" userId="05da2731-9352-4b35-b713-60351f56afbd" providerId="ADAL" clId="{F5F97842-A295-4F9F-B89B-A63B35E1C32D}" dt="2022-10-09T13:34:09.119" v="68" actId="26606"/>
          <ac:spMkLst>
            <pc:docMk/>
            <pc:sldMk cId="3481556119" sldId="278"/>
            <ac:spMk id="105" creationId="{04357C93-F0CB-4A1C-8F77-4E9063789819}"/>
          </ac:spMkLst>
        </pc:spChg>
        <pc:spChg chg="add del mod">
          <ac:chgData name="Manasweeta Angane" userId="05da2731-9352-4b35-b713-60351f56afbd" providerId="ADAL" clId="{F5F97842-A295-4F9F-B89B-A63B35E1C32D}" dt="2022-10-09T13:36:24.397" v="82"/>
          <ac:spMkLst>
            <pc:docMk/>
            <pc:sldMk cId="3481556119" sldId="278"/>
            <ac:spMk id="108" creationId="{DB7D95AB-893C-425A-A723-53DC42C2C3EB}"/>
          </ac:spMkLst>
        </pc:spChg>
        <pc:spChg chg="add del">
          <ac:chgData name="Manasweeta Angane" userId="05da2731-9352-4b35-b713-60351f56afbd" providerId="ADAL" clId="{F5F97842-A295-4F9F-B89B-A63B35E1C32D}" dt="2022-10-09T13:33:40.524" v="65" actId="26606"/>
          <ac:spMkLst>
            <pc:docMk/>
            <pc:sldMk cId="3481556119" sldId="278"/>
            <ac:spMk id="110" creationId="{D55CA618-78A6-47F6-B865-E9315164FB49}"/>
          </ac:spMkLst>
        </pc:spChg>
        <pc:spChg chg="add del">
          <ac:chgData name="Manasweeta Angane" userId="05da2731-9352-4b35-b713-60351f56afbd" providerId="ADAL" clId="{F5F97842-A295-4F9F-B89B-A63B35E1C32D}" dt="2022-10-09T13:34:43.779" v="73" actId="26606"/>
          <ac:spMkLst>
            <pc:docMk/>
            <pc:sldMk cId="3481556119" sldId="278"/>
            <ac:spMk id="114" creationId="{B368E167-B2D7-4904-BB6B-AE0486A2C6F8}"/>
          </ac:spMkLst>
        </pc:spChg>
        <pc:spChg chg="add del">
          <ac:chgData name="Manasweeta Angane" userId="05da2731-9352-4b35-b713-60351f56afbd" providerId="ADAL" clId="{F5F97842-A295-4F9F-B89B-A63B35E1C32D}" dt="2022-10-09T13:33:40.524" v="65" actId="26606"/>
          <ac:spMkLst>
            <pc:docMk/>
            <pc:sldMk cId="3481556119" sldId="278"/>
            <ac:spMk id="116" creationId="{8ED94938-268E-4C0A-A08A-B3980C78BAEB}"/>
          </ac:spMkLst>
        </pc:spChg>
        <pc:spChg chg="add mod">
          <ac:chgData name="Manasweeta Angane" userId="05da2731-9352-4b35-b713-60351f56afbd" providerId="ADAL" clId="{F5F97842-A295-4F9F-B89B-A63B35E1C32D}" dt="2022-10-09T14:10:31.374" v="642" actId="20577"/>
          <ac:spMkLst>
            <pc:docMk/>
            <pc:sldMk cId="3481556119" sldId="278"/>
            <ac:spMk id="117" creationId="{555CACB8-2D2D-4E3F-AF81-93D16C21748B}"/>
          </ac:spMkLst>
        </pc:spChg>
        <pc:spChg chg="add del">
          <ac:chgData name="Manasweeta Angane" userId="05da2731-9352-4b35-b713-60351f56afbd" providerId="ADAL" clId="{F5F97842-A295-4F9F-B89B-A63B35E1C32D}" dt="2022-10-09T13:34:09.108" v="67" actId="26606"/>
          <ac:spMkLst>
            <pc:docMk/>
            <pc:sldMk cId="3481556119" sldId="278"/>
            <ac:spMk id="118" creationId="{117FFC1C-9D26-45FE-A741-42512F545483}"/>
          </ac:spMkLst>
        </pc:spChg>
        <pc:spChg chg="add del">
          <ac:chgData name="Manasweeta Angane" userId="05da2731-9352-4b35-b713-60351f56afbd" providerId="ADAL" clId="{F5F97842-A295-4F9F-B89B-A63B35E1C32D}" dt="2022-10-09T13:34:09.108" v="67" actId="26606"/>
          <ac:spMkLst>
            <pc:docMk/>
            <pc:sldMk cId="3481556119" sldId="278"/>
            <ac:spMk id="119" creationId="{ABB34BBC-69D7-4906-8E5B-64C9EE038FF6}"/>
          </ac:spMkLst>
        </pc:spChg>
        <pc:spChg chg="add del">
          <ac:chgData name="Manasweeta Angane" userId="05da2731-9352-4b35-b713-60351f56afbd" providerId="ADAL" clId="{F5F97842-A295-4F9F-B89B-A63B35E1C32D}" dt="2022-10-09T13:34:43.779" v="73" actId="26606"/>
          <ac:spMkLst>
            <pc:docMk/>
            <pc:sldMk cId="3481556119" sldId="278"/>
            <ac:spMk id="120" creationId="{33E49524-66B4-4DB0-AD09-DC8B9874E1B3}"/>
          </ac:spMkLst>
        </pc:spChg>
        <pc:spChg chg="add del">
          <ac:chgData name="Manasweeta Angane" userId="05da2731-9352-4b35-b713-60351f56afbd" providerId="ADAL" clId="{F5F97842-A295-4F9F-B89B-A63B35E1C32D}" dt="2022-10-09T13:34:43.779" v="73" actId="26606"/>
          <ac:spMkLst>
            <pc:docMk/>
            <pc:sldMk cId="3481556119" sldId="278"/>
            <ac:spMk id="121" creationId="{BFFB6EAD-767A-4A95-9246-C39976AD1119}"/>
          </ac:spMkLst>
        </pc:spChg>
        <pc:spChg chg="add del">
          <ac:chgData name="Manasweeta Angane" userId="05da2731-9352-4b35-b713-60351f56afbd" providerId="ADAL" clId="{F5F97842-A295-4F9F-B89B-A63B35E1C32D}" dt="2022-10-09T13:34:43.779" v="73" actId="26606"/>
          <ac:spMkLst>
            <pc:docMk/>
            <pc:sldMk cId="3481556119" sldId="278"/>
            <ac:spMk id="122" creationId="{E5EBF8F5-ABE5-4029-A8FC-4E32622D70A6}"/>
          </ac:spMkLst>
        </pc:spChg>
        <pc:spChg chg="add del">
          <ac:chgData name="Manasweeta Angane" userId="05da2731-9352-4b35-b713-60351f56afbd" providerId="ADAL" clId="{F5F97842-A295-4F9F-B89B-A63B35E1C32D}" dt="2022-10-09T13:34:43.779" v="73" actId="26606"/>
          <ac:spMkLst>
            <pc:docMk/>
            <pc:sldMk cId="3481556119" sldId="278"/>
            <ac:spMk id="123" creationId="{07062BB1-E215-424E-80C4-7E1CF179A357}"/>
          </ac:spMkLst>
        </pc:spChg>
        <pc:spChg chg="add del">
          <ac:chgData name="Manasweeta Angane" userId="05da2731-9352-4b35-b713-60351f56afbd" providerId="ADAL" clId="{F5F97842-A295-4F9F-B89B-A63B35E1C32D}" dt="2022-10-09T13:34:43.779" v="73" actId="26606"/>
          <ac:spMkLst>
            <pc:docMk/>
            <pc:sldMk cId="3481556119" sldId="278"/>
            <ac:spMk id="124" creationId="{6FD0FBFA-B43E-40C1-A6E4-B88234171E7A}"/>
          </ac:spMkLst>
        </pc:spChg>
        <pc:spChg chg="add del">
          <ac:chgData name="Manasweeta Angane" userId="05da2731-9352-4b35-b713-60351f56afbd" providerId="ADAL" clId="{F5F97842-A295-4F9F-B89B-A63B35E1C32D}" dt="2022-10-09T13:34:43.779" v="73" actId="26606"/>
          <ac:spMkLst>
            <pc:docMk/>
            <pc:sldMk cId="3481556119" sldId="278"/>
            <ac:spMk id="125" creationId="{70A21480-D93D-46BE-9A94-B5A80469DF68}"/>
          </ac:spMkLst>
        </pc:spChg>
        <pc:spChg chg="add del mod">
          <ac:chgData name="Manasweeta Angane" userId="05da2731-9352-4b35-b713-60351f56afbd" providerId="ADAL" clId="{F5F97842-A295-4F9F-B89B-A63B35E1C32D}" dt="2022-10-09T14:10:20.981" v="641" actId="478"/>
          <ac:spMkLst>
            <pc:docMk/>
            <pc:sldMk cId="3481556119" sldId="278"/>
            <ac:spMk id="126" creationId="{9F448B14-05D2-4612-91AC-AC0BC26AC78F}"/>
          </ac:spMkLst>
        </pc:spChg>
        <pc:spChg chg="mod">
          <ac:chgData name="Manasweeta Angane" userId="05da2731-9352-4b35-b713-60351f56afbd" providerId="ADAL" clId="{F5F97842-A295-4F9F-B89B-A63B35E1C32D}" dt="2022-10-09T13:45:23.757" v="267"/>
          <ac:spMkLst>
            <pc:docMk/>
            <pc:sldMk cId="3481556119" sldId="278"/>
            <ac:spMk id="128" creationId="{79661AF0-3604-4012-A51F-9FA9F0D4399D}"/>
          </ac:spMkLst>
        </pc:spChg>
        <pc:spChg chg="mod">
          <ac:chgData name="Manasweeta Angane" userId="05da2731-9352-4b35-b713-60351f56afbd" providerId="ADAL" clId="{F5F97842-A295-4F9F-B89B-A63B35E1C32D}" dt="2022-10-09T13:45:23.757" v="267"/>
          <ac:spMkLst>
            <pc:docMk/>
            <pc:sldMk cId="3481556119" sldId="278"/>
            <ac:spMk id="129" creationId="{3847FB49-97A7-489F-AB97-66E5C8A3B600}"/>
          </ac:spMkLst>
        </pc:spChg>
        <pc:spChg chg="add">
          <ac:chgData name="Manasweeta Angane" userId="05da2731-9352-4b35-b713-60351f56afbd" providerId="ADAL" clId="{F5F97842-A295-4F9F-B89B-A63B35E1C32D}" dt="2022-10-09T13:34:43.779" v="73" actId="26606"/>
          <ac:spMkLst>
            <pc:docMk/>
            <pc:sldMk cId="3481556119" sldId="278"/>
            <ac:spMk id="130" creationId="{D55CA618-78A6-47F6-B865-E9315164FB49}"/>
          </ac:spMkLst>
        </pc:spChg>
        <pc:spChg chg="mod">
          <ac:chgData name="Manasweeta Angane" userId="05da2731-9352-4b35-b713-60351f56afbd" providerId="ADAL" clId="{F5F97842-A295-4F9F-B89B-A63B35E1C32D}" dt="2022-10-09T13:45:23.757" v="267"/>
          <ac:spMkLst>
            <pc:docMk/>
            <pc:sldMk cId="3481556119" sldId="278"/>
            <ac:spMk id="131" creationId="{E85FB3C0-BE52-4CFB-811D-D71C45039732}"/>
          </ac:spMkLst>
        </pc:spChg>
        <pc:spChg chg="mod">
          <ac:chgData name="Manasweeta Angane" userId="05da2731-9352-4b35-b713-60351f56afbd" providerId="ADAL" clId="{F5F97842-A295-4F9F-B89B-A63B35E1C32D}" dt="2022-10-09T13:45:23.757" v="267"/>
          <ac:spMkLst>
            <pc:docMk/>
            <pc:sldMk cId="3481556119" sldId="278"/>
            <ac:spMk id="135" creationId="{C5C092DB-BE1B-4C51-939C-AE3F727B040E}"/>
          </ac:spMkLst>
        </pc:spChg>
        <pc:spChg chg="add">
          <ac:chgData name="Manasweeta Angane" userId="05da2731-9352-4b35-b713-60351f56afbd" providerId="ADAL" clId="{F5F97842-A295-4F9F-B89B-A63B35E1C32D}" dt="2022-10-09T13:34:43.779" v="73" actId="26606"/>
          <ac:spMkLst>
            <pc:docMk/>
            <pc:sldMk cId="3481556119" sldId="278"/>
            <ac:spMk id="136" creationId="{8ED94938-268E-4C0A-A08A-B3980C78BAEB}"/>
          </ac:spMkLst>
        </pc:spChg>
        <pc:spChg chg="mod topLvl">
          <ac:chgData name="Manasweeta Angane" userId="05da2731-9352-4b35-b713-60351f56afbd" providerId="ADAL" clId="{F5F97842-A295-4F9F-B89B-A63B35E1C32D}" dt="2022-10-09T14:31:24.393" v="658" actId="165"/>
          <ac:spMkLst>
            <pc:docMk/>
            <pc:sldMk cId="3481556119" sldId="278"/>
            <ac:spMk id="138" creationId="{4BE91049-81B2-448B-93EE-3A9EE9B6FCC7}"/>
          </ac:spMkLst>
        </pc:spChg>
        <pc:spChg chg="mod topLvl">
          <ac:chgData name="Manasweeta Angane" userId="05da2731-9352-4b35-b713-60351f56afbd" providerId="ADAL" clId="{F5F97842-A295-4F9F-B89B-A63B35E1C32D}" dt="2022-10-09T14:31:24.393" v="658" actId="165"/>
          <ac:spMkLst>
            <pc:docMk/>
            <pc:sldMk cId="3481556119" sldId="278"/>
            <ac:spMk id="140" creationId="{D53C71B5-5AF9-48B5-808C-C67CDC7DE51C}"/>
          </ac:spMkLst>
        </pc:spChg>
        <pc:spChg chg="mod topLvl">
          <ac:chgData name="Manasweeta Angane" userId="05da2731-9352-4b35-b713-60351f56afbd" providerId="ADAL" clId="{F5F97842-A295-4F9F-B89B-A63B35E1C32D}" dt="2022-10-09T14:31:40.369" v="673" actId="1037"/>
          <ac:spMkLst>
            <pc:docMk/>
            <pc:sldMk cId="3481556119" sldId="278"/>
            <ac:spMk id="145" creationId="{7F0DBEA9-26D6-4012-8597-5E624BED3A74}"/>
          </ac:spMkLst>
        </pc:spChg>
        <pc:spChg chg="mod topLvl">
          <ac:chgData name="Manasweeta Angane" userId="05da2731-9352-4b35-b713-60351f56afbd" providerId="ADAL" clId="{F5F97842-A295-4F9F-B89B-A63B35E1C32D}" dt="2022-10-09T14:32:06.748" v="693" actId="1038"/>
          <ac:spMkLst>
            <pc:docMk/>
            <pc:sldMk cId="3481556119" sldId="278"/>
            <ac:spMk id="146" creationId="{9105F90D-9A4B-4676-A6E2-01507B03A1D2}"/>
          </ac:spMkLst>
        </pc:spChg>
        <pc:spChg chg="mod topLvl">
          <ac:chgData name="Manasweeta Angane" userId="05da2731-9352-4b35-b713-60351f56afbd" providerId="ADAL" clId="{F5F97842-A295-4F9F-B89B-A63B35E1C32D}" dt="2022-10-09T14:31:24.393" v="658" actId="165"/>
          <ac:spMkLst>
            <pc:docMk/>
            <pc:sldMk cId="3481556119" sldId="278"/>
            <ac:spMk id="149" creationId="{7A9AC9AE-7BCB-4356-BABA-E9617AB4AFF2}"/>
          </ac:spMkLst>
        </pc:spChg>
        <pc:spChg chg="mod topLvl">
          <ac:chgData name="Manasweeta Angane" userId="05da2731-9352-4b35-b713-60351f56afbd" providerId="ADAL" clId="{F5F97842-A295-4F9F-B89B-A63B35E1C32D}" dt="2022-10-09T14:31:24.393" v="658" actId="165"/>
          <ac:spMkLst>
            <pc:docMk/>
            <pc:sldMk cId="3481556119" sldId="278"/>
            <ac:spMk id="150" creationId="{60DE5E62-0598-4A02-977A-F81962182D2A}"/>
          </ac:spMkLst>
        </pc:spChg>
        <pc:spChg chg="mod topLvl">
          <ac:chgData name="Manasweeta Angane" userId="05da2731-9352-4b35-b713-60351f56afbd" providerId="ADAL" clId="{F5F97842-A295-4F9F-B89B-A63B35E1C32D}" dt="2022-10-09T14:31:24.393" v="658" actId="165"/>
          <ac:spMkLst>
            <pc:docMk/>
            <pc:sldMk cId="3481556119" sldId="278"/>
            <ac:spMk id="151" creationId="{5CFA3A2D-164C-44A5-AA2F-91F1E270CE22}"/>
          </ac:spMkLst>
        </pc:spChg>
        <pc:grpChg chg="add del">
          <ac:chgData name="Manasweeta Angane" userId="05da2731-9352-4b35-b713-60351f56afbd" providerId="ADAL" clId="{F5F97842-A295-4F9F-B89B-A63B35E1C32D}" dt="2022-10-09T13:28:40.165" v="40" actId="26606"/>
          <ac:grpSpMkLst>
            <pc:docMk/>
            <pc:sldMk cId="3481556119" sldId="278"/>
            <ac:grpSpMk id="28" creationId="{0924561D-756D-410B-973A-E68C2552C20C}"/>
          </ac:grpSpMkLst>
        </pc:grpChg>
        <pc:grpChg chg="add del">
          <ac:chgData name="Manasweeta Angane" userId="05da2731-9352-4b35-b713-60351f56afbd" providerId="ADAL" clId="{F5F97842-A295-4F9F-B89B-A63B35E1C32D}" dt="2022-10-09T13:29:23.742" v="46" actId="26606"/>
          <ac:grpSpMkLst>
            <pc:docMk/>
            <pc:sldMk cId="3481556119" sldId="278"/>
            <ac:grpSpMk id="59" creationId="{B83D307E-DF68-43F8-97CE-0AAE950A7129}"/>
          </ac:grpSpMkLst>
        </pc:grpChg>
        <pc:grpChg chg="add del">
          <ac:chgData name="Manasweeta Angane" userId="05da2731-9352-4b35-b713-60351f56afbd" providerId="ADAL" clId="{F5F97842-A295-4F9F-B89B-A63B35E1C32D}" dt="2022-10-09T13:29:57.869" v="54" actId="26606"/>
          <ac:grpSpMkLst>
            <pc:docMk/>
            <pc:sldMk cId="3481556119" sldId="278"/>
            <ac:grpSpMk id="76" creationId="{18226A8C-7793-4AE1-93F3-C51E771AB9F9}"/>
          </ac:grpSpMkLst>
        </pc:grpChg>
        <pc:grpChg chg="add del">
          <ac:chgData name="Manasweeta Angane" userId="05da2731-9352-4b35-b713-60351f56afbd" providerId="ADAL" clId="{F5F97842-A295-4F9F-B89B-A63B35E1C32D}" dt="2022-10-09T13:30:11.488" v="56" actId="26606"/>
          <ac:grpSpMkLst>
            <pc:docMk/>
            <pc:sldMk cId="3481556119" sldId="278"/>
            <ac:grpSpMk id="81" creationId="{032D8612-31EB-44CF-A1D0-14FD4C705424}"/>
          </ac:grpSpMkLst>
        </pc:grpChg>
        <pc:grpChg chg="add del mod">
          <ac:chgData name="Manasweeta Angane" userId="05da2731-9352-4b35-b713-60351f56afbd" providerId="ADAL" clId="{F5F97842-A295-4F9F-B89B-A63B35E1C32D}" dt="2022-10-09T13:32:39.495" v="63" actId="478"/>
          <ac:grpSpMkLst>
            <pc:docMk/>
            <pc:sldMk cId="3481556119" sldId="278"/>
            <ac:grpSpMk id="85" creationId="{0461443B-BE44-4820-A6F9-9BD3D3613855}"/>
          </ac:grpSpMkLst>
        </pc:grpChg>
        <pc:grpChg chg="add del">
          <ac:chgData name="Manasweeta Angane" userId="05da2731-9352-4b35-b713-60351f56afbd" providerId="ADAL" clId="{F5F97842-A295-4F9F-B89B-A63B35E1C32D}" dt="2022-10-09T13:31:06.258" v="60" actId="26606"/>
          <ac:grpSpMkLst>
            <pc:docMk/>
            <pc:sldMk cId="3481556119" sldId="278"/>
            <ac:grpSpMk id="92" creationId="{B83D307E-DF68-43F8-97CE-0AAE950A7129}"/>
          </ac:grpSpMkLst>
        </pc:grpChg>
        <pc:grpChg chg="add del mod">
          <ac:chgData name="Manasweeta Angane" userId="05da2731-9352-4b35-b713-60351f56afbd" providerId="ADAL" clId="{F5F97842-A295-4F9F-B89B-A63B35E1C32D}" dt="2022-10-09T13:34:39.761" v="72" actId="478"/>
          <ac:grpSpMkLst>
            <pc:docMk/>
            <pc:sldMk cId="3481556119" sldId="278"/>
            <ac:grpSpMk id="100" creationId="{3E69ECF6-E9A6-48E0-93CD-8CD13F363D3D}"/>
          </ac:grpSpMkLst>
        </pc:grpChg>
        <pc:grpChg chg="add del">
          <ac:chgData name="Manasweeta Angane" userId="05da2731-9352-4b35-b713-60351f56afbd" providerId="ADAL" clId="{F5F97842-A295-4F9F-B89B-A63B35E1C32D}" dt="2022-10-09T13:34:09.119" v="68" actId="26606"/>
          <ac:grpSpMkLst>
            <pc:docMk/>
            <pc:sldMk cId="3481556119" sldId="278"/>
            <ac:grpSpMk id="101" creationId="{3AF6A671-C637-4547-85F4-51B6D1881399}"/>
          </ac:grpSpMkLst>
        </pc:grpChg>
        <pc:grpChg chg="add del mod">
          <ac:chgData name="Manasweeta Angane" userId="05da2731-9352-4b35-b713-60351f56afbd" providerId="ADAL" clId="{F5F97842-A295-4F9F-B89B-A63B35E1C32D}" dt="2022-10-09T14:30:15.244" v="654" actId="478"/>
          <ac:grpSpMkLst>
            <pc:docMk/>
            <pc:sldMk cId="3481556119" sldId="278"/>
            <ac:grpSpMk id="109" creationId="{164482F0-3E33-4DDA-ABD3-511842E6A2AB}"/>
          </ac:grpSpMkLst>
        </pc:grpChg>
        <pc:grpChg chg="add del">
          <ac:chgData name="Manasweeta Angane" userId="05da2731-9352-4b35-b713-60351f56afbd" providerId="ADAL" clId="{F5F97842-A295-4F9F-B89B-A63B35E1C32D}" dt="2022-10-09T13:33:40.524" v="65" actId="26606"/>
          <ac:grpSpMkLst>
            <pc:docMk/>
            <pc:sldMk cId="3481556119" sldId="278"/>
            <ac:grpSpMk id="112" creationId="{B83D307E-DF68-43F8-97CE-0AAE950A7129}"/>
          </ac:grpSpMkLst>
        </pc:grpChg>
        <pc:grpChg chg="add mod">
          <ac:chgData name="Manasweeta Angane" userId="05da2731-9352-4b35-b713-60351f56afbd" providerId="ADAL" clId="{F5F97842-A295-4F9F-B89B-A63B35E1C32D}" dt="2022-10-09T13:45:23.757" v="267"/>
          <ac:grpSpMkLst>
            <pc:docMk/>
            <pc:sldMk cId="3481556119" sldId="278"/>
            <ac:grpSpMk id="127" creationId="{85FD4752-829B-4973-9C9E-35C4190B8BF3}"/>
          </ac:grpSpMkLst>
        </pc:grpChg>
        <pc:grpChg chg="add">
          <ac:chgData name="Manasweeta Angane" userId="05da2731-9352-4b35-b713-60351f56afbd" providerId="ADAL" clId="{F5F97842-A295-4F9F-B89B-A63B35E1C32D}" dt="2022-10-09T13:34:43.779" v="73" actId="26606"/>
          <ac:grpSpMkLst>
            <pc:docMk/>
            <pc:sldMk cId="3481556119" sldId="278"/>
            <ac:grpSpMk id="132" creationId="{B83D307E-DF68-43F8-97CE-0AAE950A7129}"/>
          </ac:grpSpMkLst>
        </pc:grpChg>
        <pc:grpChg chg="add del mod">
          <ac:chgData name="Manasweeta Angane" userId="05da2731-9352-4b35-b713-60351f56afbd" providerId="ADAL" clId="{F5F97842-A295-4F9F-B89B-A63B35E1C32D}" dt="2022-10-09T14:31:24.393" v="658" actId="165"/>
          <ac:grpSpMkLst>
            <pc:docMk/>
            <pc:sldMk cId="3481556119" sldId="278"/>
            <ac:grpSpMk id="137" creationId="{B9EC7B2D-B75F-4F18-A713-83373318891A}"/>
          </ac:grpSpMkLst>
        </pc:grpChg>
        <pc:graphicFrameChg chg="mod topLvl">
          <ac:chgData name="Manasweeta Angane" userId="05da2731-9352-4b35-b713-60351f56afbd" providerId="ADAL" clId="{F5F97842-A295-4F9F-B89B-A63B35E1C32D}" dt="2022-10-09T14:31:24.393" v="658" actId="165"/>
          <ac:graphicFrameMkLst>
            <pc:docMk/>
            <pc:sldMk cId="3481556119" sldId="278"/>
            <ac:graphicFrameMk id="141" creationId="{8E2DC39C-D4C7-494C-8369-77C14D9E041A}"/>
          </ac:graphicFrameMkLst>
        </pc:graphicFrameChg>
        <pc:picChg chg="add del mod">
          <ac:chgData name="Manasweeta Angane" userId="05da2731-9352-4b35-b713-60351f56afbd" providerId="ADAL" clId="{F5F97842-A295-4F9F-B89B-A63B35E1C32D}" dt="2022-10-09T13:28:17.881" v="37" actId="478"/>
          <ac:picMkLst>
            <pc:docMk/>
            <pc:sldMk cId="3481556119" sldId="278"/>
            <ac:picMk id="5" creationId="{A4DC18D9-70F2-47D9-BB93-51B942F73E80}"/>
          </ac:picMkLst>
        </pc:picChg>
        <pc:picChg chg="add mod ord">
          <ac:chgData name="Manasweeta Angane" userId="05da2731-9352-4b35-b713-60351f56afbd" providerId="ADAL" clId="{F5F97842-A295-4F9F-B89B-A63B35E1C32D}" dt="2022-10-09T13:41:12.140" v="232" actId="1037"/>
          <ac:picMkLst>
            <pc:docMk/>
            <pc:sldMk cId="3481556119" sldId="278"/>
            <ac:picMk id="9" creationId="{15EF9F5D-1641-4A65-A47F-B627C044F3BA}"/>
          </ac:picMkLst>
        </pc:picChg>
        <pc:picChg chg="add mod ord">
          <ac:chgData name="Manasweeta Angane" userId="05da2731-9352-4b35-b713-60351f56afbd" providerId="ADAL" clId="{F5F97842-A295-4F9F-B89B-A63B35E1C32D}" dt="2022-10-09T14:56:12.198" v="1017" actId="1076"/>
          <ac:picMkLst>
            <pc:docMk/>
            <pc:sldMk cId="3481556119" sldId="278"/>
            <ac:picMk id="19" creationId="{D4A0CE98-AB9D-45A1-9B97-0EBF7A24D0E7}"/>
          </ac:picMkLst>
        </pc:picChg>
        <pc:picChg chg="mod">
          <ac:chgData name="Manasweeta Angane" userId="05da2731-9352-4b35-b713-60351f56afbd" providerId="ADAL" clId="{F5F97842-A295-4F9F-B89B-A63B35E1C32D}" dt="2022-10-09T13:32:31.037" v="62" actId="1076"/>
          <ac:picMkLst>
            <pc:docMk/>
            <pc:sldMk cId="3481556119" sldId="278"/>
            <ac:picMk id="90" creationId="{1A3DE548-0021-448A-89C9-E8AFB4E69599}"/>
          </ac:picMkLst>
        </pc:picChg>
        <pc:picChg chg="mod">
          <ac:chgData name="Manasweeta Angane" userId="05da2731-9352-4b35-b713-60351f56afbd" providerId="ADAL" clId="{F5F97842-A295-4F9F-B89B-A63B35E1C32D}" dt="2022-10-09T13:32:31.037" v="62" actId="1076"/>
          <ac:picMkLst>
            <pc:docMk/>
            <pc:sldMk cId="3481556119" sldId="278"/>
            <ac:picMk id="95" creationId="{99AE1B76-D13F-4E15-8F3A-12AB4C63F18A}"/>
          </ac:picMkLst>
        </pc:picChg>
        <pc:picChg chg="mod">
          <ac:chgData name="Manasweeta Angane" userId="05da2731-9352-4b35-b713-60351f56afbd" providerId="ADAL" clId="{F5F97842-A295-4F9F-B89B-A63B35E1C32D}" dt="2022-10-09T13:34:35.065" v="71" actId="1076"/>
          <ac:picMkLst>
            <pc:docMk/>
            <pc:sldMk cId="3481556119" sldId="278"/>
            <ac:picMk id="104" creationId="{86C99B93-230F-4018-BE0F-38743CD6CFCF}"/>
          </ac:picMkLst>
        </pc:picChg>
        <pc:picChg chg="mod">
          <ac:chgData name="Manasweeta Angane" userId="05da2731-9352-4b35-b713-60351f56afbd" providerId="ADAL" clId="{F5F97842-A295-4F9F-B89B-A63B35E1C32D}" dt="2022-10-09T13:34:35.065" v="71" actId="1076"/>
          <ac:picMkLst>
            <pc:docMk/>
            <pc:sldMk cId="3481556119" sldId="278"/>
            <ac:picMk id="106" creationId="{C70C8ACC-E8CB-4E03-A914-8E0B36AE0F75}"/>
          </ac:picMkLst>
        </pc:picChg>
        <pc:picChg chg="mod">
          <ac:chgData name="Manasweeta Angane" userId="05da2731-9352-4b35-b713-60351f56afbd" providerId="ADAL" clId="{F5F97842-A295-4F9F-B89B-A63B35E1C32D}" dt="2022-10-09T13:43:12.479" v="258" actId="1038"/>
          <ac:picMkLst>
            <pc:docMk/>
            <pc:sldMk cId="3481556119" sldId="278"/>
            <ac:picMk id="111" creationId="{78FDDE86-EF45-49CF-8C20-E55105DA0678}"/>
          </ac:picMkLst>
        </pc:picChg>
        <pc:picChg chg="mod">
          <ac:chgData name="Manasweeta Angane" userId="05da2731-9352-4b35-b713-60351f56afbd" providerId="ADAL" clId="{F5F97842-A295-4F9F-B89B-A63B35E1C32D}" dt="2022-10-09T13:43:12.479" v="258" actId="1038"/>
          <ac:picMkLst>
            <pc:docMk/>
            <pc:sldMk cId="3481556119" sldId="278"/>
            <ac:picMk id="115" creationId="{B0EA49E3-30EB-48FB-8930-E2B5A38034EA}"/>
          </ac:picMkLst>
        </pc:picChg>
        <pc:picChg chg="mod topLvl">
          <ac:chgData name="Manasweeta Angane" userId="05da2731-9352-4b35-b713-60351f56afbd" providerId="ADAL" clId="{F5F97842-A295-4F9F-B89B-A63B35E1C32D}" dt="2022-10-09T14:31:24.393" v="658" actId="165"/>
          <ac:picMkLst>
            <pc:docMk/>
            <pc:sldMk cId="3481556119" sldId="278"/>
            <ac:picMk id="139" creationId="{ECB89AB6-6EC9-42F1-B2D6-07721136CBF6}"/>
          </ac:picMkLst>
        </pc:picChg>
        <pc:picChg chg="mod topLvl">
          <ac:chgData name="Manasweeta Angane" userId="05da2731-9352-4b35-b713-60351f56afbd" providerId="ADAL" clId="{F5F97842-A295-4F9F-B89B-A63B35E1C32D}" dt="2022-10-09T14:31:24.393" v="658" actId="165"/>
          <ac:picMkLst>
            <pc:docMk/>
            <pc:sldMk cId="3481556119" sldId="278"/>
            <ac:picMk id="142" creationId="{75CC4772-093F-4FE7-81FF-B10C4DEB913E}"/>
          </ac:picMkLst>
        </pc:picChg>
        <pc:picChg chg="mod topLvl">
          <ac:chgData name="Manasweeta Angane" userId="05da2731-9352-4b35-b713-60351f56afbd" providerId="ADAL" clId="{F5F97842-A295-4F9F-B89B-A63B35E1C32D}" dt="2022-10-09T14:31:24.393" v="658" actId="165"/>
          <ac:picMkLst>
            <pc:docMk/>
            <pc:sldMk cId="3481556119" sldId="278"/>
            <ac:picMk id="143" creationId="{4A1D488A-9D23-40EC-B182-3E50405915D5}"/>
          </ac:picMkLst>
        </pc:picChg>
        <pc:picChg chg="mod topLvl">
          <ac:chgData name="Manasweeta Angane" userId="05da2731-9352-4b35-b713-60351f56afbd" providerId="ADAL" clId="{F5F97842-A295-4F9F-B89B-A63B35E1C32D}" dt="2022-10-09T14:31:24.393" v="658" actId="165"/>
          <ac:picMkLst>
            <pc:docMk/>
            <pc:sldMk cId="3481556119" sldId="278"/>
            <ac:picMk id="144" creationId="{F04D4C0D-37F3-4F61-8E44-AE246AD06010}"/>
          </ac:picMkLst>
        </pc:picChg>
        <pc:picChg chg="mod topLvl">
          <ac:chgData name="Manasweeta Angane" userId="05da2731-9352-4b35-b713-60351f56afbd" providerId="ADAL" clId="{F5F97842-A295-4F9F-B89B-A63B35E1C32D}" dt="2022-10-09T14:31:24.393" v="658" actId="165"/>
          <ac:picMkLst>
            <pc:docMk/>
            <pc:sldMk cId="3481556119" sldId="278"/>
            <ac:picMk id="147" creationId="{B750500A-CEEF-4D41-91E1-95D18FCE9AEA}"/>
          </ac:picMkLst>
        </pc:picChg>
        <pc:picChg chg="mod topLvl">
          <ac:chgData name="Manasweeta Angane" userId="05da2731-9352-4b35-b713-60351f56afbd" providerId="ADAL" clId="{F5F97842-A295-4F9F-B89B-A63B35E1C32D}" dt="2022-10-09T14:31:24.393" v="658" actId="165"/>
          <ac:picMkLst>
            <pc:docMk/>
            <pc:sldMk cId="3481556119" sldId="278"/>
            <ac:picMk id="148" creationId="{530628F3-3797-4460-88FA-C349A176746E}"/>
          </ac:picMkLst>
        </pc:picChg>
        <pc:cxnChg chg="add del">
          <ac:chgData name="Manasweeta Angane" userId="05da2731-9352-4b35-b713-60351f56afbd" providerId="ADAL" clId="{F5F97842-A295-4F9F-B89B-A63B35E1C32D}" dt="2022-10-09T13:28:56.078" v="42" actId="26606"/>
          <ac:cxnSpMkLst>
            <pc:docMk/>
            <pc:sldMk cId="3481556119" sldId="278"/>
            <ac:cxnSpMk id="53" creationId="{3D83F26F-C55B-4A92-9AFF-4894D14E27C5}"/>
          </ac:cxnSpMkLst>
        </pc:cxnChg>
      </pc:sldChg>
      <pc:sldChg chg="addSp delSp modSp new mod ord modTransition">
        <pc:chgData name="Manasweeta Angane" userId="05da2731-9352-4b35-b713-60351f56afbd" providerId="ADAL" clId="{F5F97842-A295-4F9F-B89B-A63B35E1C32D}" dt="2022-10-19T07:21:06.514" v="10866"/>
        <pc:sldMkLst>
          <pc:docMk/>
          <pc:sldMk cId="81594327" sldId="279"/>
        </pc:sldMkLst>
        <pc:spChg chg="add del mod">
          <ac:chgData name="Manasweeta Angane" userId="05da2731-9352-4b35-b713-60351f56afbd" providerId="ADAL" clId="{F5F97842-A295-4F9F-B89B-A63B35E1C32D}" dt="2022-10-09T14:46:25.084" v="728" actId="478"/>
          <ac:spMkLst>
            <pc:docMk/>
            <pc:sldMk cId="81594327" sldId="279"/>
            <ac:spMk id="2" creationId="{5ADC21E3-C510-40D3-A822-8B882BB1966A}"/>
          </ac:spMkLst>
        </pc:spChg>
        <pc:spChg chg="add del mod">
          <ac:chgData name="Manasweeta Angane" userId="05da2731-9352-4b35-b713-60351f56afbd" providerId="ADAL" clId="{F5F97842-A295-4F9F-B89B-A63B35E1C32D}" dt="2022-10-09T14:46:30.883" v="731" actId="478"/>
          <ac:spMkLst>
            <pc:docMk/>
            <pc:sldMk cId="81594327" sldId="279"/>
            <ac:spMk id="3" creationId="{BF6B4F14-5C4A-442C-BF41-EE3A082B4D23}"/>
          </ac:spMkLst>
        </pc:spChg>
        <pc:spChg chg="mod">
          <ac:chgData name="Manasweeta Angane" userId="05da2731-9352-4b35-b713-60351f56afbd" providerId="ADAL" clId="{F5F97842-A295-4F9F-B89B-A63B35E1C32D}" dt="2022-10-09T14:23:20.511" v="646"/>
          <ac:spMkLst>
            <pc:docMk/>
            <pc:sldMk cId="81594327" sldId="279"/>
            <ac:spMk id="5" creationId="{D6EA4027-C091-4519-B09D-E78F24FE1D11}"/>
          </ac:spMkLst>
        </pc:spChg>
        <pc:spChg chg="mod">
          <ac:chgData name="Manasweeta Angane" userId="05da2731-9352-4b35-b713-60351f56afbd" providerId="ADAL" clId="{F5F97842-A295-4F9F-B89B-A63B35E1C32D}" dt="2022-10-09T14:23:20.511" v="646"/>
          <ac:spMkLst>
            <pc:docMk/>
            <pc:sldMk cId="81594327" sldId="279"/>
            <ac:spMk id="6" creationId="{68BA112F-D749-47CD-8196-F14D98D7DC83}"/>
          </ac:spMkLst>
        </pc:spChg>
        <pc:spChg chg="mod">
          <ac:chgData name="Manasweeta Angane" userId="05da2731-9352-4b35-b713-60351f56afbd" providerId="ADAL" clId="{F5F97842-A295-4F9F-B89B-A63B35E1C32D}" dt="2022-10-09T14:23:20.511" v="646"/>
          <ac:spMkLst>
            <pc:docMk/>
            <pc:sldMk cId="81594327" sldId="279"/>
            <ac:spMk id="7" creationId="{D4016A87-96B5-4034-8E84-06B9C380A90B}"/>
          </ac:spMkLst>
        </pc:spChg>
        <pc:spChg chg="mod">
          <ac:chgData name="Manasweeta Angane" userId="05da2731-9352-4b35-b713-60351f56afbd" providerId="ADAL" clId="{F5F97842-A295-4F9F-B89B-A63B35E1C32D}" dt="2022-10-09T14:23:20.511" v="646"/>
          <ac:spMkLst>
            <pc:docMk/>
            <pc:sldMk cId="81594327" sldId="279"/>
            <ac:spMk id="8" creationId="{6EAADF73-D41D-4D2D-8C30-FFCBCB826CD2}"/>
          </ac:spMkLst>
        </pc:spChg>
        <pc:spChg chg="add del mod">
          <ac:chgData name="Manasweeta Angane" userId="05da2731-9352-4b35-b713-60351f56afbd" providerId="ADAL" clId="{F5F97842-A295-4F9F-B89B-A63B35E1C32D}" dt="2022-10-09T14:45:41.301" v="716"/>
          <ac:spMkLst>
            <pc:docMk/>
            <pc:sldMk cId="81594327" sldId="279"/>
            <ac:spMk id="9" creationId="{A51FDFB6-41DC-42AD-9461-F8550A82AB5F}"/>
          </ac:spMkLst>
        </pc:spChg>
        <pc:spChg chg="add del mod">
          <ac:chgData name="Manasweeta Angane" userId="05da2731-9352-4b35-b713-60351f56afbd" providerId="ADAL" clId="{F5F97842-A295-4F9F-B89B-A63B35E1C32D}" dt="2022-10-09T14:45:52.668" v="718"/>
          <ac:spMkLst>
            <pc:docMk/>
            <pc:sldMk cId="81594327" sldId="279"/>
            <ac:spMk id="13" creationId="{7EC4A5EF-299D-4655-A971-0F3C6A252071}"/>
          </ac:spMkLst>
        </pc:spChg>
        <pc:spChg chg="add del mod">
          <ac:chgData name="Manasweeta Angane" userId="05da2731-9352-4b35-b713-60351f56afbd" providerId="ADAL" clId="{F5F97842-A295-4F9F-B89B-A63B35E1C32D}" dt="2022-10-09T14:50:15.441" v="804" actId="478"/>
          <ac:spMkLst>
            <pc:docMk/>
            <pc:sldMk cId="81594327" sldId="279"/>
            <ac:spMk id="17" creationId="{8DB771DF-C627-44BB-8716-44C80EF9D83F}"/>
          </ac:spMkLst>
        </pc:spChg>
        <pc:spChg chg="add mod">
          <ac:chgData name="Manasweeta Angane" userId="05da2731-9352-4b35-b713-60351f56afbd" providerId="ADAL" clId="{F5F97842-A295-4F9F-B89B-A63B35E1C32D}" dt="2022-10-09T14:48:59.713" v="801" actId="255"/>
          <ac:spMkLst>
            <pc:docMk/>
            <pc:sldMk cId="81594327" sldId="279"/>
            <ac:spMk id="18" creationId="{45F2BEED-A6BE-45AE-BED7-62E52E5E5868}"/>
          </ac:spMkLst>
        </pc:spChg>
        <pc:spChg chg="mod">
          <ac:chgData name="Manasweeta Angane" userId="05da2731-9352-4b35-b713-60351f56afbd" providerId="ADAL" clId="{F5F97842-A295-4F9F-B89B-A63B35E1C32D}" dt="2022-10-09T14:52:58.598" v="825" actId="1076"/>
          <ac:spMkLst>
            <pc:docMk/>
            <pc:sldMk cId="81594327" sldId="279"/>
            <ac:spMk id="23" creationId="{A24420EC-0AC2-46CD-9642-CC61AD3FA4B1}"/>
          </ac:spMkLst>
        </pc:spChg>
        <pc:spChg chg="mod">
          <ac:chgData name="Manasweeta Angane" userId="05da2731-9352-4b35-b713-60351f56afbd" providerId="ADAL" clId="{F5F97842-A295-4F9F-B89B-A63B35E1C32D}" dt="2022-10-09T14:52:58.598" v="825" actId="1076"/>
          <ac:spMkLst>
            <pc:docMk/>
            <pc:sldMk cId="81594327" sldId="279"/>
            <ac:spMk id="25" creationId="{CEDAC4C0-B883-4F43-8B1C-B92CD127C6CC}"/>
          </ac:spMkLst>
        </pc:spChg>
        <pc:spChg chg="mod">
          <ac:chgData name="Manasweeta Angane" userId="05da2731-9352-4b35-b713-60351f56afbd" providerId="ADAL" clId="{F5F97842-A295-4F9F-B89B-A63B35E1C32D}" dt="2022-10-09T14:52:58.598" v="825" actId="1076"/>
          <ac:spMkLst>
            <pc:docMk/>
            <pc:sldMk cId="81594327" sldId="279"/>
            <ac:spMk id="30" creationId="{995F8013-AF62-4F3D-AC6F-224C36D2AF92}"/>
          </ac:spMkLst>
        </pc:spChg>
        <pc:spChg chg="mod">
          <ac:chgData name="Manasweeta Angane" userId="05da2731-9352-4b35-b713-60351f56afbd" providerId="ADAL" clId="{F5F97842-A295-4F9F-B89B-A63B35E1C32D}" dt="2022-10-09T14:52:58.598" v="825" actId="1076"/>
          <ac:spMkLst>
            <pc:docMk/>
            <pc:sldMk cId="81594327" sldId="279"/>
            <ac:spMk id="31" creationId="{529EA32F-A5E8-48EF-A5A9-8DAFABC2566F}"/>
          </ac:spMkLst>
        </pc:spChg>
        <pc:spChg chg="mod">
          <ac:chgData name="Manasweeta Angane" userId="05da2731-9352-4b35-b713-60351f56afbd" providerId="ADAL" clId="{F5F97842-A295-4F9F-B89B-A63B35E1C32D}" dt="2022-10-09T14:52:58.598" v="825" actId="1076"/>
          <ac:spMkLst>
            <pc:docMk/>
            <pc:sldMk cId="81594327" sldId="279"/>
            <ac:spMk id="34" creationId="{8F6DBE81-9BF8-4B36-B358-F8E5E2E87035}"/>
          </ac:spMkLst>
        </pc:spChg>
        <pc:spChg chg="mod">
          <ac:chgData name="Manasweeta Angane" userId="05da2731-9352-4b35-b713-60351f56afbd" providerId="ADAL" clId="{F5F97842-A295-4F9F-B89B-A63B35E1C32D}" dt="2022-10-09T14:52:58.598" v="825" actId="1076"/>
          <ac:spMkLst>
            <pc:docMk/>
            <pc:sldMk cId="81594327" sldId="279"/>
            <ac:spMk id="35" creationId="{DA80AC76-0BA7-4FF7-9352-AF4E7DBCF519}"/>
          </ac:spMkLst>
        </pc:spChg>
        <pc:spChg chg="mod">
          <ac:chgData name="Manasweeta Angane" userId="05da2731-9352-4b35-b713-60351f56afbd" providerId="ADAL" clId="{F5F97842-A295-4F9F-B89B-A63B35E1C32D}" dt="2022-10-09T14:52:58.598" v="825" actId="1076"/>
          <ac:spMkLst>
            <pc:docMk/>
            <pc:sldMk cId="81594327" sldId="279"/>
            <ac:spMk id="36" creationId="{74C06158-CB05-405D-BC9D-D85314E537CC}"/>
          </ac:spMkLst>
        </pc:spChg>
        <pc:spChg chg="mod">
          <ac:chgData name="Manasweeta Angane" userId="05da2731-9352-4b35-b713-60351f56afbd" providerId="ADAL" clId="{F5F97842-A295-4F9F-B89B-A63B35E1C32D}" dt="2022-10-09T14:54:04.844" v="1008" actId="1037"/>
          <ac:spMkLst>
            <pc:docMk/>
            <pc:sldMk cId="81594327" sldId="279"/>
            <ac:spMk id="41" creationId="{B53094FF-FD58-4CD6-8C8C-1C1F235F1B9A}"/>
          </ac:spMkLst>
        </pc:spChg>
        <pc:spChg chg="mod">
          <ac:chgData name="Manasweeta Angane" userId="05da2731-9352-4b35-b713-60351f56afbd" providerId="ADAL" clId="{F5F97842-A295-4F9F-B89B-A63B35E1C32D}" dt="2022-10-09T14:54:04.844" v="1008" actId="1037"/>
          <ac:spMkLst>
            <pc:docMk/>
            <pc:sldMk cId="81594327" sldId="279"/>
            <ac:spMk id="42" creationId="{A80E4640-6275-4981-9717-A2C1F9AF40C5}"/>
          </ac:spMkLst>
        </pc:spChg>
        <pc:grpChg chg="add mod">
          <ac:chgData name="Manasweeta Angane" userId="05da2731-9352-4b35-b713-60351f56afbd" providerId="ADAL" clId="{F5F97842-A295-4F9F-B89B-A63B35E1C32D}" dt="2022-10-09T14:23:20.511" v="646"/>
          <ac:grpSpMkLst>
            <pc:docMk/>
            <pc:sldMk cId="81594327" sldId="279"/>
            <ac:grpSpMk id="4" creationId="{3F0E3FD0-07DB-4674-861B-D61E237388B2}"/>
          </ac:grpSpMkLst>
        </pc:grpChg>
        <pc:grpChg chg="add del mod">
          <ac:chgData name="Manasweeta Angane" userId="05da2731-9352-4b35-b713-60351f56afbd" providerId="ADAL" clId="{F5F97842-A295-4F9F-B89B-A63B35E1C32D}" dt="2022-10-09T14:53:51.799" v="902" actId="478"/>
          <ac:grpSpMkLst>
            <pc:docMk/>
            <pc:sldMk cId="81594327" sldId="279"/>
            <ac:grpSpMk id="22" creationId="{D8F74855-CFE0-4A73-ABE3-A7090F82C91E}"/>
          </ac:grpSpMkLst>
        </pc:grpChg>
        <pc:grpChg chg="add mod">
          <ac:chgData name="Manasweeta Angane" userId="05da2731-9352-4b35-b713-60351f56afbd" providerId="ADAL" clId="{F5F97842-A295-4F9F-B89B-A63B35E1C32D}" dt="2022-10-09T14:54:04.844" v="1008" actId="1037"/>
          <ac:grpSpMkLst>
            <pc:docMk/>
            <pc:sldMk cId="81594327" sldId="279"/>
            <ac:grpSpMk id="37" creationId="{1F9B28C2-A98A-4FDA-B0D4-32DAB697ECB8}"/>
          </ac:grpSpMkLst>
        </pc:grpChg>
        <pc:graphicFrameChg chg="add del mod">
          <ac:chgData name="Manasweeta Angane" userId="05da2731-9352-4b35-b713-60351f56afbd" providerId="ADAL" clId="{F5F97842-A295-4F9F-B89B-A63B35E1C32D}" dt="2022-10-09T14:45:41.301" v="716"/>
          <ac:graphicFrameMkLst>
            <pc:docMk/>
            <pc:sldMk cId="81594327" sldId="279"/>
            <ac:graphicFrameMk id="12" creationId="{01D46A1B-9948-495F-A44A-AF92FDDCC765}"/>
          </ac:graphicFrameMkLst>
        </pc:graphicFrameChg>
        <pc:graphicFrameChg chg="add del mod">
          <ac:chgData name="Manasweeta Angane" userId="05da2731-9352-4b35-b713-60351f56afbd" providerId="ADAL" clId="{F5F97842-A295-4F9F-B89B-A63B35E1C32D}" dt="2022-10-09T14:45:52.668" v="718"/>
          <ac:graphicFrameMkLst>
            <pc:docMk/>
            <pc:sldMk cId="81594327" sldId="279"/>
            <ac:graphicFrameMk id="16" creationId="{0117F517-1500-4A06-86FE-0084D9A52DDE}"/>
          </ac:graphicFrameMkLst>
        </pc:graphicFrameChg>
        <pc:graphicFrameChg chg="add mod">
          <ac:chgData name="Manasweeta Angane" userId="05da2731-9352-4b35-b713-60351f56afbd" providerId="ADAL" clId="{F5F97842-A295-4F9F-B89B-A63B35E1C32D}" dt="2022-10-09T14:53:04.704" v="855" actId="1038"/>
          <ac:graphicFrameMkLst>
            <pc:docMk/>
            <pc:sldMk cId="81594327" sldId="279"/>
            <ac:graphicFrameMk id="20" creationId="{9C0908DD-C5E4-4E94-A494-C1CF818B57E1}"/>
          </ac:graphicFrameMkLst>
        </pc:graphicFrameChg>
        <pc:graphicFrameChg chg="mod">
          <ac:chgData name="Manasweeta Angane" userId="05da2731-9352-4b35-b713-60351f56afbd" providerId="ADAL" clId="{F5F97842-A295-4F9F-B89B-A63B35E1C32D}" dt="2022-10-09T14:52:58.598" v="825" actId="1076"/>
          <ac:graphicFrameMkLst>
            <pc:docMk/>
            <pc:sldMk cId="81594327" sldId="279"/>
            <ac:graphicFrameMk id="26" creationId="{4E78C60F-FC1E-4B27-A803-51517EB376B3}"/>
          </ac:graphicFrameMkLst>
        </pc:graphicFrameChg>
        <pc:picChg chg="add del mod">
          <ac:chgData name="Manasweeta Angane" userId="05da2731-9352-4b35-b713-60351f56afbd" providerId="ADAL" clId="{F5F97842-A295-4F9F-B89B-A63B35E1C32D}" dt="2022-10-09T14:45:41.301" v="716"/>
          <ac:picMkLst>
            <pc:docMk/>
            <pc:sldMk cId="81594327" sldId="279"/>
            <ac:picMk id="10" creationId="{E8D5DE65-CB4B-48BC-8D82-E246A3BE59E8}"/>
          </ac:picMkLst>
        </pc:picChg>
        <pc:picChg chg="add del mod">
          <ac:chgData name="Manasweeta Angane" userId="05da2731-9352-4b35-b713-60351f56afbd" providerId="ADAL" clId="{F5F97842-A295-4F9F-B89B-A63B35E1C32D}" dt="2022-10-09T14:45:41.301" v="716"/>
          <ac:picMkLst>
            <pc:docMk/>
            <pc:sldMk cId="81594327" sldId="279"/>
            <ac:picMk id="11" creationId="{98FD5B6D-F75C-4C85-9FEF-87748D43163F}"/>
          </ac:picMkLst>
        </pc:picChg>
        <pc:picChg chg="add del mod">
          <ac:chgData name="Manasweeta Angane" userId="05da2731-9352-4b35-b713-60351f56afbd" providerId="ADAL" clId="{F5F97842-A295-4F9F-B89B-A63B35E1C32D}" dt="2022-10-09T14:45:52.668" v="718"/>
          <ac:picMkLst>
            <pc:docMk/>
            <pc:sldMk cId="81594327" sldId="279"/>
            <ac:picMk id="14" creationId="{87210098-D706-4F35-95BC-B0871ABF8433}"/>
          </ac:picMkLst>
        </pc:picChg>
        <pc:picChg chg="add del mod">
          <ac:chgData name="Manasweeta Angane" userId="05da2731-9352-4b35-b713-60351f56afbd" providerId="ADAL" clId="{F5F97842-A295-4F9F-B89B-A63B35E1C32D}" dt="2022-10-09T14:45:52.668" v="718"/>
          <ac:picMkLst>
            <pc:docMk/>
            <pc:sldMk cId="81594327" sldId="279"/>
            <ac:picMk id="15" creationId="{9C20AFFC-C050-4913-A24C-580384350579}"/>
          </ac:picMkLst>
        </pc:picChg>
        <pc:picChg chg="add mod">
          <ac:chgData name="Manasweeta Angane" userId="05da2731-9352-4b35-b713-60351f56afbd" providerId="ADAL" clId="{F5F97842-A295-4F9F-B89B-A63B35E1C32D}" dt="2022-10-09T15:00:30.312" v="1160" actId="14100"/>
          <ac:picMkLst>
            <pc:docMk/>
            <pc:sldMk cId="81594327" sldId="279"/>
            <ac:picMk id="19" creationId="{75559BD9-400F-463B-B2BE-7FBAD55D4E91}"/>
          </ac:picMkLst>
        </pc:picChg>
        <pc:picChg chg="add mod">
          <ac:chgData name="Manasweeta Angane" userId="05da2731-9352-4b35-b713-60351f56afbd" providerId="ADAL" clId="{F5F97842-A295-4F9F-B89B-A63B35E1C32D}" dt="2022-10-09T14:53:08.983" v="870" actId="1038"/>
          <ac:picMkLst>
            <pc:docMk/>
            <pc:sldMk cId="81594327" sldId="279"/>
            <ac:picMk id="21" creationId="{46E9B6CC-99DB-4840-B273-C223B197FB34}"/>
          </ac:picMkLst>
        </pc:picChg>
        <pc:picChg chg="mod">
          <ac:chgData name="Manasweeta Angane" userId="05da2731-9352-4b35-b713-60351f56afbd" providerId="ADAL" clId="{F5F97842-A295-4F9F-B89B-A63B35E1C32D}" dt="2022-10-09T14:52:58.598" v="825" actId="1076"/>
          <ac:picMkLst>
            <pc:docMk/>
            <pc:sldMk cId="81594327" sldId="279"/>
            <ac:picMk id="24" creationId="{500D80A1-DE1F-4668-9E35-C1909B9808CB}"/>
          </ac:picMkLst>
        </pc:picChg>
        <pc:picChg chg="mod">
          <ac:chgData name="Manasweeta Angane" userId="05da2731-9352-4b35-b713-60351f56afbd" providerId="ADAL" clId="{F5F97842-A295-4F9F-B89B-A63B35E1C32D}" dt="2022-10-09T14:52:58.598" v="825" actId="1076"/>
          <ac:picMkLst>
            <pc:docMk/>
            <pc:sldMk cId="81594327" sldId="279"/>
            <ac:picMk id="27" creationId="{0B54C52F-159C-4A95-B0D2-8863D4B49922}"/>
          </ac:picMkLst>
        </pc:picChg>
        <pc:picChg chg="mod">
          <ac:chgData name="Manasweeta Angane" userId="05da2731-9352-4b35-b713-60351f56afbd" providerId="ADAL" clId="{F5F97842-A295-4F9F-B89B-A63B35E1C32D}" dt="2022-10-09T14:52:58.598" v="825" actId="1076"/>
          <ac:picMkLst>
            <pc:docMk/>
            <pc:sldMk cId="81594327" sldId="279"/>
            <ac:picMk id="28" creationId="{470B9494-2682-430A-A1C6-6E51E351DC73}"/>
          </ac:picMkLst>
        </pc:picChg>
        <pc:picChg chg="mod">
          <ac:chgData name="Manasweeta Angane" userId="05da2731-9352-4b35-b713-60351f56afbd" providerId="ADAL" clId="{F5F97842-A295-4F9F-B89B-A63B35E1C32D}" dt="2022-10-09T14:52:58.598" v="825" actId="1076"/>
          <ac:picMkLst>
            <pc:docMk/>
            <pc:sldMk cId="81594327" sldId="279"/>
            <ac:picMk id="29" creationId="{E99C6B2A-6BB1-4B30-A09E-3A95AE82A1E1}"/>
          </ac:picMkLst>
        </pc:picChg>
        <pc:picChg chg="mod">
          <ac:chgData name="Manasweeta Angane" userId="05da2731-9352-4b35-b713-60351f56afbd" providerId="ADAL" clId="{F5F97842-A295-4F9F-B89B-A63B35E1C32D}" dt="2022-10-09T14:52:58.598" v="825" actId="1076"/>
          <ac:picMkLst>
            <pc:docMk/>
            <pc:sldMk cId="81594327" sldId="279"/>
            <ac:picMk id="32" creationId="{7EED7FB7-76DC-4B4A-A3CE-AB0EC18201A6}"/>
          </ac:picMkLst>
        </pc:picChg>
        <pc:picChg chg="mod">
          <ac:chgData name="Manasweeta Angane" userId="05da2731-9352-4b35-b713-60351f56afbd" providerId="ADAL" clId="{F5F97842-A295-4F9F-B89B-A63B35E1C32D}" dt="2022-10-09T14:52:58.598" v="825" actId="1076"/>
          <ac:picMkLst>
            <pc:docMk/>
            <pc:sldMk cId="81594327" sldId="279"/>
            <ac:picMk id="33" creationId="{6CEE9306-8F6D-4E42-B7FC-C8E8AAF08D5D}"/>
          </ac:picMkLst>
        </pc:picChg>
        <pc:picChg chg="mod">
          <ac:chgData name="Manasweeta Angane" userId="05da2731-9352-4b35-b713-60351f56afbd" providerId="ADAL" clId="{F5F97842-A295-4F9F-B89B-A63B35E1C32D}" dt="2022-10-09T14:54:04.844" v="1008" actId="1037"/>
          <ac:picMkLst>
            <pc:docMk/>
            <pc:sldMk cId="81594327" sldId="279"/>
            <ac:picMk id="38" creationId="{323060B5-7712-4AE1-A878-4DD95D9C3E5C}"/>
          </ac:picMkLst>
        </pc:picChg>
        <pc:picChg chg="mod">
          <ac:chgData name="Manasweeta Angane" userId="05da2731-9352-4b35-b713-60351f56afbd" providerId="ADAL" clId="{F5F97842-A295-4F9F-B89B-A63B35E1C32D}" dt="2022-10-09T14:54:04.844" v="1008" actId="1037"/>
          <ac:picMkLst>
            <pc:docMk/>
            <pc:sldMk cId="81594327" sldId="279"/>
            <ac:picMk id="39" creationId="{58E375A6-E701-404C-BD01-FFF1D377E2AE}"/>
          </ac:picMkLst>
        </pc:picChg>
        <pc:picChg chg="mod">
          <ac:chgData name="Manasweeta Angane" userId="05da2731-9352-4b35-b713-60351f56afbd" providerId="ADAL" clId="{F5F97842-A295-4F9F-B89B-A63B35E1C32D}" dt="2022-10-09T14:54:04.844" v="1008" actId="1037"/>
          <ac:picMkLst>
            <pc:docMk/>
            <pc:sldMk cId="81594327" sldId="279"/>
            <ac:picMk id="40" creationId="{31244A06-8916-4ED0-B73B-EAADE5739EF8}"/>
          </ac:picMkLst>
        </pc:picChg>
        <pc:picChg chg="add mod">
          <ac:chgData name="Manasweeta Angane" userId="05da2731-9352-4b35-b713-60351f56afbd" providerId="ADAL" clId="{F5F97842-A295-4F9F-B89B-A63B35E1C32D}" dt="2022-10-09T14:54:04.844" v="1008" actId="1037"/>
          <ac:picMkLst>
            <pc:docMk/>
            <pc:sldMk cId="81594327" sldId="279"/>
            <ac:picMk id="43" creationId="{F6854C01-0992-4560-A1D6-2620B367F0D0}"/>
          </ac:picMkLst>
        </pc:picChg>
        <pc:picChg chg="add mod">
          <ac:chgData name="Manasweeta Angane" userId="05da2731-9352-4b35-b713-60351f56afbd" providerId="ADAL" clId="{F5F97842-A295-4F9F-B89B-A63B35E1C32D}" dt="2022-10-09T14:59:31.025" v="1157" actId="1076"/>
          <ac:picMkLst>
            <pc:docMk/>
            <pc:sldMk cId="81594327" sldId="279"/>
            <ac:picMk id="44" creationId="{6C787306-7517-4965-89B6-839193B3E580}"/>
          </ac:picMkLst>
        </pc:picChg>
        <pc:picChg chg="add mod">
          <ac:chgData name="Manasweeta Angane" userId="05da2731-9352-4b35-b713-60351f56afbd" providerId="ADAL" clId="{F5F97842-A295-4F9F-B89B-A63B35E1C32D}" dt="2022-10-09T14:58:34.030" v="1124" actId="14100"/>
          <ac:picMkLst>
            <pc:docMk/>
            <pc:sldMk cId="81594327" sldId="279"/>
            <ac:picMk id="45" creationId="{94E669BE-1D4C-4D80-8733-4A5D3A89FD81}"/>
          </ac:picMkLst>
        </pc:picChg>
      </pc:sldChg>
      <pc:sldChg chg="new del">
        <pc:chgData name="Manasweeta Angane" userId="05da2731-9352-4b35-b713-60351f56afbd" providerId="ADAL" clId="{F5F97842-A295-4F9F-B89B-A63B35E1C32D}" dt="2022-10-09T23:43:31.610" v="1787" actId="2696"/>
        <pc:sldMkLst>
          <pc:docMk/>
          <pc:sldMk cId="3326847251" sldId="280"/>
        </pc:sldMkLst>
      </pc:sldChg>
      <pc:sldChg chg="new del">
        <pc:chgData name="Manasweeta Angane" userId="05da2731-9352-4b35-b713-60351f56afbd" providerId="ADAL" clId="{F5F97842-A295-4F9F-B89B-A63B35E1C32D}" dt="2022-10-09T23:43:35.460" v="1788" actId="2696"/>
        <pc:sldMkLst>
          <pc:docMk/>
          <pc:sldMk cId="1161121195" sldId="281"/>
        </pc:sldMkLst>
      </pc:sldChg>
      <pc:sldChg chg="add del">
        <pc:chgData name="Manasweeta Angane" userId="05da2731-9352-4b35-b713-60351f56afbd" providerId="ADAL" clId="{F5F97842-A295-4F9F-B89B-A63B35E1C32D}" dt="2022-10-09T23:43:25.646" v="1786" actId="2696"/>
        <pc:sldMkLst>
          <pc:docMk/>
          <pc:sldMk cId="1245720304" sldId="282"/>
        </pc:sldMkLst>
      </pc:sldChg>
      <pc:sldChg chg="addSp delSp modSp add del mod modTransition">
        <pc:chgData name="Manasweeta Angane" userId="05da2731-9352-4b35-b713-60351f56afbd" providerId="ADAL" clId="{F5F97842-A295-4F9F-B89B-A63B35E1C32D}" dt="2022-10-10T13:45:35.825" v="4670" actId="2696"/>
        <pc:sldMkLst>
          <pc:docMk/>
          <pc:sldMk cId="42916203" sldId="283"/>
        </pc:sldMkLst>
        <pc:spChg chg="add del mod">
          <ac:chgData name="Manasweeta Angane" userId="05da2731-9352-4b35-b713-60351f56afbd" providerId="ADAL" clId="{F5F97842-A295-4F9F-B89B-A63B35E1C32D}" dt="2022-10-09T14:29:46.933" v="650" actId="478"/>
          <ac:spMkLst>
            <pc:docMk/>
            <pc:sldMk cId="42916203" sldId="283"/>
            <ac:spMk id="9" creationId="{4E9B3BE7-9AD3-4DCF-B9E7-4A30B998F511}"/>
          </ac:spMkLst>
        </pc:spChg>
        <pc:spChg chg="add del mod">
          <ac:chgData name="Manasweeta Angane" userId="05da2731-9352-4b35-b713-60351f56afbd" providerId="ADAL" clId="{F5F97842-A295-4F9F-B89B-A63B35E1C32D}" dt="2022-10-09T14:29:46.933" v="650" actId="478"/>
          <ac:spMkLst>
            <pc:docMk/>
            <pc:sldMk cId="42916203" sldId="283"/>
            <ac:spMk id="10" creationId="{F36A20BF-B1CA-4CE2-B6A4-6C7684A0432C}"/>
          </ac:spMkLst>
        </pc:spChg>
        <pc:spChg chg="add mod">
          <ac:chgData name="Manasweeta Angane" userId="05da2731-9352-4b35-b713-60351f56afbd" providerId="ADAL" clId="{F5F97842-A295-4F9F-B89B-A63B35E1C32D}" dt="2022-10-09T14:29:54.414" v="652" actId="164"/>
          <ac:spMkLst>
            <pc:docMk/>
            <pc:sldMk cId="42916203" sldId="283"/>
            <ac:spMk id="11" creationId="{71059710-394F-4DCC-9E51-CD5E9CE5BECE}"/>
          </ac:spMkLst>
        </pc:spChg>
        <pc:spChg chg="add mod">
          <ac:chgData name="Manasweeta Angane" userId="05da2731-9352-4b35-b713-60351f56afbd" providerId="ADAL" clId="{F5F97842-A295-4F9F-B89B-A63B35E1C32D}" dt="2022-10-09T14:29:54.414" v="652" actId="164"/>
          <ac:spMkLst>
            <pc:docMk/>
            <pc:sldMk cId="42916203" sldId="283"/>
            <ac:spMk id="13" creationId="{7F000AC5-304E-4238-BC78-0BD073E10672}"/>
          </ac:spMkLst>
        </pc:spChg>
        <pc:spChg chg="add mod">
          <ac:chgData name="Manasweeta Angane" userId="05da2731-9352-4b35-b713-60351f56afbd" providerId="ADAL" clId="{F5F97842-A295-4F9F-B89B-A63B35E1C32D}" dt="2022-10-09T14:29:54.414" v="652" actId="164"/>
          <ac:spMkLst>
            <pc:docMk/>
            <pc:sldMk cId="42916203" sldId="283"/>
            <ac:spMk id="18" creationId="{6347892A-575A-4024-9493-4EA809EB5E98}"/>
          </ac:spMkLst>
        </pc:spChg>
        <pc:spChg chg="add mod">
          <ac:chgData name="Manasweeta Angane" userId="05da2731-9352-4b35-b713-60351f56afbd" providerId="ADAL" clId="{F5F97842-A295-4F9F-B89B-A63B35E1C32D}" dt="2022-10-09T14:29:54.414" v="652" actId="164"/>
          <ac:spMkLst>
            <pc:docMk/>
            <pc:sldMk cId="42916203" sldId="283"/>
            <ac:spMk id="19" creationId="{5831A6D7-905F-49E7-BCD6-C5341BAD5177}"/>
          </ac:spMkLst>
        </pc:spChg>
        <pc:spChg chg="add mod">
          <ac:chgData name="Manasweeta Angane" userId="05da2731-9352-4b35-b713-60351f56afbd" providerId="ADAL" clId="{F5F97842-A295-4F9F-B89B-A63B35E1C32D}" dt="2022-10-09T14:29:54.414" v="652" actId="164"/>
          <ac:spMkLst>
            <pc:docMk/>
            <pc:sldMk cId="42916203" sldId="283"/>
            <ac:spMk id="22" creationId="{88A7FF17-252A-42C2-8FAB-1E523A4F2B01}"/>
          </ac:spMkLst>
        </pc:spChg>
        <pc:spChg chg="add mod">
          <ac:chgData name="Manasweeta Angane" userId="05da2731-9352-4b35-b713-60351f56afbd" providerId="ADAL" clId="{F5F97842-A295-4F9F-B89B-A63B35E1C32D}" dt="2022-10-09T14:29:54.414" v="652" actId="164"/>
          <ac:spMkLst>
            <pc:docMk/>
            <pc:sldMk cId="42916203" sldId="283"/>
            <ac:spMk id="23" creationId="{90601829-3558-4BC7-9670-0FF8D4BB5665}"/>
          </ac:spMkLst>
        </pc:spChg>
        <pc:spChg chg="add mod">
          <ac:chgData name="Manasweeta Angane" userId="05da2731-9352-4b35-b713-60351f56afbd" providerId="ADAL" clId="{F5F97842-A295-4F9F-B89B-A63B35E1C32D}" dt="2022-10-09T14:29:54.414" v="652" actId="164"/>
          <ac:spMkLst>
            <pc:docMk/>
            <pc:sldMk cId="42916203" sldId="283"/>
            <ac:spMk id="24" creationId="{34C78458-1B3E-4AA6-9F15-43AA37CBAE7E}"/>
          </ac:spMkLst>
        </pc:spChg>
        <pc:grpChg chg="add mod">
          <ac:chgData name="Manasweeta Angane" userId="05da2731-9352-4b35-b713-60351f56afbd" providerId="ADAL" clId="{F5F97842-A295-4F9F-B89B-A63B35E1C32D}" dt="2022-10-09T14:29:54.414" v="652" actId="164"/>
          <ac:grpSpMkLst>
            <pc:docMk/>
            <pc:sldMk cId="42916203" sldId="283"/>
            <ac:grpSpMk id="25" creationId="{286DAE54-5843-4AC5-AD9E-283860139B0E}"/>
          </ac:grpSpMkLst>
        </pc:grpChg>
        <pc:graphicFrameChg chg="add mod">
          <ac:chgData name="Manasweeta Angane" userId="05da2731-9352-4b35-b713-60351f56afbd" providerId="ADAL" clId="{F5F97842-A295-4F9F-B89B-A63B35E1C32D}" dt="2022-10-09T14:29:54.414" v="652" actId="164"/>
          <ac:graphicFrameMkLst>
            <pc:docMk/>
            <pc:sldMk cId="42916203" sldId="283"/>
            <ac:graphicFrameMk id="14" creationId="{344985DC-E5CD-4DBE-B453-D164DBDEAC79}"/>
          </ac:graphicFrameMkLst>
        </pc:graphicFrameChg>
        <pc:picChg chg="add mod">
          <ac:chgData name="Manasweeta Angane" userId="05da2731-9352-4b35-b713-60351f56afbd" providerId="ADAL" clId="{F5F97842-A295-4F9F-B89B-A63B35E1C32D}" dt="2022-10-09T14:29:54.414" v="652" actId="164"/>
          <ac:picMkLst>
            <pc:docMk/>
            <pc:sldMk cId="42916203" sldId="283"/>
            <ac:picMk id="12" creationId="{2F48793B-6BAC-4680-85F7-C3DD7DF216BD}"/>
          </ac:picMkLst>
        </pc:picChg>
        <pc:picChg chg="add mod">
          <ac:chgData name="Manasweeta Angane" userId="05da2731-9352-4b35-b713-60351f56afbd" providerId="ADAL" clId="{F5F97842-A295-4F9F-B89B-A63B35E1C32D}" dt="2022-10-09T14:29:54.414" v="652" actId="164"/>
          <ac:picMkLst>
            <pc:docMk/>
            <pc:sldMk cId="42916203" sldId="283"/>
            <ac:picMk id="15" creationId="{4CDFB15E-B218-4291-9762-AE6569F1E935}"/>
          </ac:picMkLst>
        </pc:picChg>
        <pc:picChg chg="add mod">
          <ac:chgData name="Manasweeta Angane" userId="05da2731-9352-4b35-b713-60351f56afbd" providerId="ADAL" clId="{F5F97842-A295-4F9F-B89B-A63B35E1C32D}" dt="2022-10-09T14:29:54.414" v="652" actId="164"/>
          <ac:picMkLst>
            <pc:docMk/>
            <pc:sldMk cId="42916203" sldId="283"/>
            <ac:picMk id="16" creationId="{A22E3E04-FDB9-465E-886F-597041D056EC}"/>
          </ac:picMkLst>
        </pc:picChg>
        <pc:picChg chg="add mod">
          <ac:chgData name="Manasweeta Angane" userId="05da2731-9352-4b35-b713-60351f56afbd" providerId="ADAL" clId="{F5F97842-A295-4F9F-B89B-A63B35E1C32D}" dt="2022-10-09T14:29:54.414" v="652" actId="164"/>
          <ac:picMkLst>
            <pc:docMk/>
            <pc:sldMk cId="42916203" sldId="283"/>
            <ac:picMk id="17" creationId="{965992C6-1B64-448B-AC8A-6BE27ADB07FC}"/>
          </ac:picMkLst>
        </pc:picChg>
        <pc:picChg chg="add mod">
          <ac:chgData name="Manasweeta Angane" userId="05da2731-9352-4b35-b713-60351f56afbd" providerId="ADAL" clId="{F5F97842-A295-4F9F-B89B-A63B35E1C32D}" dt="2022-10-09T14:29:54.414" v="652" actId="164"/>
          <ac:picMkLst>
            <pc:docMk/>
            <pc:sldMk cId="42916203" sldId="283"/>
            <ac:picMk id="20" creationId="{447A6A98-B7C6-428A-AF80-E5F3E83E7C2F}"/>
          </ac:picMkLst>
        </pc:picChg>
        <pc:picChg chg="add mod">
          <ac:chgData name="Manasweeta Angane" userId="05da2731-9352-4b35-b713-60351f56afbd" providerId="ADAL" clId="{F5F97842-A295-4F9F-B89B-A63B35E1C32D}" dt="2022-10-09T14:29:54.414" v="652" actId="164"/>
          <ac:picMkLst>
            <pc:docMk/>
            <pc:sldMk cId="42916203" sldId="283"/>
            <ac:picMk id="21" creationId="{87C37A05-FE2E-44DF-85A1-C3EE4F8FF654}"/>
          </ac:picMkLst>
        </pc:picChg>
      </pc:sldChg>
      <pc:sldChg chg="addSp delSp modSp add mod modTransition delDesignElem">
        <pc:chgData name="Manasweeta Angane" userId="05da2731-9352-4b35-b713-60351f56afbd" providerId="ADAL" clId="{F5F97842-A295-4F9F-B89B-A63B35E1C32D}" dt="2022-10-19T08:13:42.687" v="11118" actId="21"/>
        <pc:sldMkLst>
          <pc:docMk/>
          <pc:sldMk cId="2988400537" sldId="284"/>
        </pc:sldMkLst>
        <pc:spChg chg="del">
          <ac:chgData name="Manasweeta Angane" userId="05da2731-9352-4b35-b713-60351f56afbd" providerId="ADAL" clId="{F5F97842-A295-4F9F-B89B-A63B35E1C32D}" dt="2022-10-09T14:33:37.790" v="695" actId="478"/>
          <ac:spMkLst>
            <pc:docMk/>
            <pc:sldMk cId="2988400537" sldId="284"/>
            <ac:spMk id="138" creationId="{4BE91049-81B2-448B-93EE-3A9EE9B6FCC7}"/>
          </ac:spMkLst>
        </pc:spChg>
        <pc:spChg chg="del">
          <ac:chgData name="Manasweeta Angane" userId="05da2731-9352-4b35-b713-60351f56afbd" providerId="ADAL" clId="{F5F97842-A295-4F9F-B89B-A63B35E1C32D}" dt="2022-10-09T14:34:00.858" v="706" actId="478"/>
          <ac:spMkLst>
            <pc:docMk/>
            <pc:sldMk cId="2988400537" sldId="284"/>
            <ac:spMk id="140" creationId="{D53C71B5-5AF9-48B5-808C-C67CDC7DE51C}"/>
          </ac:spMkLst>
        </pc:spChg>
        <pc:spChg chg="del">
          <ac:chgData name="Manasweeta Angane" userId="05da2731-9352-4b35-b713-60351f56afbd" providerId="ADAL" clId="{F5F97842-A295-4F9F-B89B-A63B35E1C32D}" dt="2022-10-09T14:33:50.902" v="701" actId="478"/>
          <ac:spMkLst>
            <pc:docMk/>
            <pc:sldMk cId="2988400537" sldId="284"/>
            <ac:spMk id="145" creationId="{7F0DBEA9-26D6-4012-8597-5E624BED3A74}"/>
          </ac:spMkLst>
        </pc:spChg>
        <pc:spChg chg="del">
          <ac:chgData name="Manasweeta Angane" userId="05da2731-9352-4b35-b713-60351f56afbd" providerId="ADAL" clId="{F5F97842-A295-4F9F-B89B-A63B35E1C32D}" dt="2022-10-09T14:33:46.162" v="698" actId="478"/>
          <ac:spMkLst>
            <pc:docMk/>
            <pc:sldMk cId="2988400537" sldId="284"/>
            <ac:spMk id="146" creationId="{9105F90D-9A4B-4676-A6E2-01507B03A1D2}"/>
          </ac:spMkLst>
        </pc:spChg>
        <pc:spChg chg="del mod">
          <ac:chgData name="Manasweeta Angane" userId="05da2731-9352-4b35-b713-60351f56afbd" providerId="ADAL" clId="{F5F97842-A295-4F9F-B89B-A63B35E1C32D}" dt="2022-10-09T14:33:56.608" v="703" actId="478"/>
          <ac:spMkLst>
            <pc:docMk/>
            <pc:sldMk cId="2988400537" sldId="284"/>
            <ac:spMk id="149" creationId="{7A9AC9AE-7BCB-4356-BABA-E9617AB4AFF2}"/>
          </ac:spMkLst>
        </pc:spChg>
        <pc:spChg chg="del">
          <ac:chgData name="Manasweeta Angane" userId="05da2731-9352-4b35-b713-60351f56afbd" providerId="ADAL" clId="{F5F97842-A295-4F9F-B89B-A63B35E1C32D}" dt="2022-10-09T14:33:49.541" v="700" actId="478"/>
          <ac:spMkLst>
            <pc:docMk/>
            <pc:sldMk cId="2988400537" sldId="284"/>
            <ac:spMk id="150" creationId="{60DE5E62-0598-4A02-977A-F81962182D2A}"/>
          </ac:spMkLst>
        </pc:spChg>
        <pc:spChg chg="del mod">
          <ac:chgData name="Manasweeta Angane" userId="05da2731-9352-4b35-b713-60351f56afbd" providerId="ADAL" clId="{F5F97842-A295-4F9F-B89B-A63B35E1C32D}" dt="2022-10-09T14:34:08.421" v="710" actId="478"/>
          <ac:spMkLst>
            <pc:docMk/>
            <pc:sldMk cId="2988400537" sldId="284"/>
            <ac:spMk id="151" creationId="{5CFA3A2D-164C-44A5-AA2F-91F1E270CE22}"/>
          </ac:spMkLst>
        </pc:spChg>
        <pc:grpChg chg="add mod">
          <ac:chgData name="Manasweeta Angane" userId="05da2731-9352-4b35-b713-60351f56afbd" providerId="ADAL" clId="{F5F97842-A295-4F9F-B89B-A63B35E1C32D}" dt="2022-10-09T14:34:20.612" v="712" actId="1076"/>
          <ac:grpSpMkLst>
            <pc:docMk/>
            <pc:sldMk cId="2988400537" sldId="284"/>
            <ac:grpSpMk id="29" creationId="{FF2EE273-79DD-4824-8CBA-36D5DA645FA1}"/>
          </ac:grpSpMkLst>
        </pc:grpChg>
        <pc:graphicFrameChg chg="del">
          <ac:chgData name="Manasweeta Angane" userId="05da2731-9352-4b35-b713-60351f56afbd" providerId="ADAL" clId="{F5F97842-A295-4F9F-B89B-A63B35E1C32D}" dt="2022-10-09T14:33:59.634" v="705" actId="478"/>
          <ac:graphicFrameMkLst>
            <pc:docMk/>
            <pc:sldMk cId="2988400537" sldId="284"/>
            <ac:graphicFrameMk id="141" creationId="{8E2DC39C-D4C7-494C-8369-77C14D9E041A}"/>
          </ac:graphicFrameMkLst>
        </pc:graphicFrameChg>
        <pc:picChg chg="add del mod">
          <ac:chgData name="Manasweeta Angane" userId="05da2731-9352-4b35-b713-60351f56afbd" providerId="ADAL" clId="{F5F97842-A295-4F9F-B89B-A63B35E1C32D}" dt="2022-10-19T08:13:42.687" v="11118" actId="21"/>
          <ac:picMkLst>
            <pc:docMk/>
            <pc:sldMk cId="2988400537" sldId="284"/>
            <ac:picMk id="3" creationId="{C45D2A09-B8BE-45BB-B267-E3FE3E89C66B}"/>
          </ac:picMkLst>
        </pc:picChg>
        <pc:picChg chg="mod">
          <ac:chgData name="Manasweeta Angane" userId="05da2731-9352-4b35-b713-60351f56afbd" providerId="ADAL" clId="{F5F97842-A295-4F9F-B89B-A63B35E1C32D}" dt="2022-10-09T14:34:20.612" v="712" actId="1076"/>
          <ac:picMkLst>
            <pc:docMk/>
            <pc:sldMk cId="2988400537" sldId="284"/>
            <ac:picMk id="30" creationId="{9E0F0ADD-E1AA-4445-B57C-0D3114E22686}"/>
          </ac:picMkLst>
        </pc:picChg>
        <pc:picChg chg="mod">
          <ac:chgData name="Manasweeta Angane" userId="05da2731-9352-4b35-b713-60351f56afbd" providerId="ADAL" clId="{F5F97842-A295-4F9F-B89B-A63B35E1C32D}" dt="2022-10-09T14:34:20.612" v="712" actId="1076"/>
          <ac:picMkLst>
            <pc:docMk/>
            <pc:sldMk cId="2988400537" sldId="284"/>
            <ac:picMk id="31" creationId="{08B443CB-D651-4E7F-9799-A62C1711031B}"/>
          </ac:picMkLst>
        </pc:picChg>
        <pc:picChg chg="del">
          <ac:chgData name="Manasweeta Angane" userId="05da2731-9352-4b35-b713-60351f56afbd" providerId="ADAL" clId="{F5F97842-A295-4F9F-B89B-A63B35E1C32D}" dt="2022-10-09T14:33:58.055" v="704" actId="478"/>
          <ac:picMkLst>
            <pc:docMk/>
            <pc:sldMk cId="2988400537" sldId="284"/>
            <ac:picMk id="139" creationId="{ECB89AB6-6EC9-42F1-B2D6-07721136CBF6}"/>
          </ac:picMkLst>
        </pc:picChg>
        <pc:picChg chg="del">
          <ac:chgData name="Manasweeta Angane" userId="05da2731-9352-4b35-b713-60351f56afbd" providerId="ADAL" clId="{F5F97842-A295-4F9F-B89B-A63B35E1C32D}" dt="2022-10-09T14:34:02.900" v="707" actId="478"/>
          <ac:picMkLst>
            <pc:docMk/>
            <pc:sldMk cId="2988400537" sldId="284"/>
            <ac:picMk id="142" creationId="{75CC4772-093F-4FE7-81FF-B10C4DEB913E}"/>
          </ac:picMkLst>
        </pc:picChg>
        <pc:picChg chg="del">
          <ac:chgData name="Manasweeta Angane" userId="05da2731-9352-4b35-b713-60351f56afbd" providerId="ADAL" clId="{F5F97842-A295-4F9F-B89B-A63B35E1C32D}" dt="2022-10-09T14:34:04.135" v="708" actId="478"/>
          <ac:picMkLst>
            <pc:docMk/>
            <pc:sldMk cId="2988400537" sldId="284"/>
            <ac:picMk id="143" creationId="{4A1D488A-9D23-40EC-B182-3E50405915D5}"/>
          </ac:picMkLst>
        </pc:picChg>
        <pc:picChg chg="del">
          <ac:chgData name="Manasweeta Angane" userId="05da2731-9352-4b35-b713-60351f56afbd" providerId="ADAL" clId="{F5F97842-A295-4F9F-B89B-A63B35E1C32D}" dt="2022-10-09T14:33:52.416" v="702" actId="478"/>
          <ac:picMkLst>
            <pc:docMk/>
            <pc:sldMk cId="2988400537" sldId="284"/>
            <ac:picMk id="144" creationId="{F04D4C0D-37F3-4F61-8E44-AE246AD06010}"/>
          </ac:picMkLst>
        </pc:picChg>
        <pc:picChg chg="del">
          <ac:chgData name="Manasweeta Angane" userId="05da2731-9352-4b35-b713-60351f56afbd" providerId="ADAL" clId="{F5F97842-A295-4F9F-B89B-A63B35E1C32D}" dt="2022-10-09T14:33:47.876" v="699" actId="478"/>
          <ac:picMkLst>
            <pc:docMk/>
            <pc:sldMk cId="2988400537" sldId="284"/>
            <ac:picMk id="147" creationId="{B750500A-CEEF-4D41-91E1-95D18FCE9AEA}"/>
          </ac:picMkLst>
        </pc:picChg>
        <pc:picChg chg="del">
          <ac:chgData name="Manasweeta Angane" userId="05da2731-9352-4b35-b713-60351f56afbd" providerId="ADAL" clId="{F5F97842-A295-4F9F-B89B-A63B35E1C32D}" dt="2022-10-09T14:33:40.773" v="696" actId="478"/>
          <ac:picMkLst>
            <pc:docMk/>
            <pc:sldMk cId="2988400537" sldId="284"/>
            <ac:picMk id="148" creationId="{530628F3-3797-4460-88FA-C349A176746E}"/>
          </ac:picMkLst>
        </pc:picChg>
      </pc:sldChg>
      <pc:sldChg chg="new del">
        <pc:chgData name="Manasweeta Angane" userId="05da2731-9352-4b35-b713-60351f56afbd" providerId="ADAL" clId="{F5F97842-A295-4F9F-B89B-A63B35E1C32D}" dt="2022-10-09T23:43:18.241" v="1785" actId="2696"/>
        <pc:sldMkLst>
          <pc:docMk/>
          <pc:sldMk cId="152049981" sldId="285"/>
        </pc:sldMkLst>
      </pc:sldChg>
      <pc:sldChg chg="addSp delSp modSp add mod modTransition delAnim modAnim">
        <pc:chgData name="Manasweeta Angane" userId="05da2731-9352-4b35-b713-60351f56afbd" providerId="ADAL" clId="{F5F97842-A295-4F9F-B89B-A63B35E1C32D}" dt="2022-10-11T10:52:33.648" v="6252" actId="1038"/>
        <pc:sldMkLst>
          <pc:docMk/>
          <pc:sldMk cId="3862015218" sldId="286"/>
        </pc:sldMkLst>
        <pc:spChg chg="mod">
          <ac:chgData name="Manasweeta Angane" userId="05da2731-9352-4b35-b713-60351f56afbd" providerId="ADAL" clId="{F5F97842-A295-4F9F-B89B-A63B35E1C32D}" dt="2022-10-09T22:56:55.673" v="1293" actId="1037"/>
          <ac:spMkLst>
            <pc:docMk/>
            <pc:sldMk cId="3862015218" sldId="286"/>
            <ac:spMk id="10" creationId="{04615909-65C8-4723-80AF-36A8B244A44B}"/>
          </ac:spMkLst>
        </pc:spChg>
        <pc:spChg chg="mod">
          <ac:chgData name="Manasweeta Angane" userId="05da2731-9352-4b35-b713-60351f56afbd" providerId="ADAL" clId="{F5F97842-A295-4F9F-B89B-A63B35E1C32D}" dt="2022-10-09T22:56:55.673" v="1293" actId="1037"/>
          <ac:spMkLst>
            <pc:docMk/>
            <pc:sldMk cId="3862015218" sldId="286"/>
            <ac:spMk id="12" creationId="{F524BCC7-F235-4A54-B943-A005656C21AF}"/>
          </ac:spMkLst>
        </pc:spChg>
        <pc:spChg chg="del mod">
          <ac:chgData name="Manasweeta Angane" userId="05da2731-9352-4b35-b713-60351f56afbd" providerId="ADAL" clId="{F5F97842-A295-4F9F-B89B-A63B35E1C32D}" dt="2022-10-09T22:56:09.750" v="1239" actId="478"/>
          <ac:spMkLst>
            <pc:docMk/>
            <pc:sldMk cId="3862015218" sldId="286"/>
            <ac:spMk id="17" creationId="{8DB771DF-C627-44BB-8716-44C80EF9D83F}"/>
          </ac:spMkLst>
        </pc:spChg>
        <pc:spChg chg="mod">
          <ac:chgData name="Manasweeta Angane" userId="05da2731-9352-4b35-b713-60351f56afbd" providerId="ADAL" clId="{F5F97842-A295-4F9F-B89B-A63B35E1C32D}" dt="2022-10-09T23:42:57.884" v="1784" actId="20577"/>
          <ac:spMkLst>
            <pc:docMk/>
            <pc:sldMk cId="3862015218" sldId="286"/>
            <ac:spMk id="18" creationId="{45F2BEED-A6BE-45AE-BED7-62E52E5E5868}"/>
          </ac:spMkLst>
        </pc:spChg>
        <pc:spChg chg="mod">
          <ac:chgData name="Manasweeta Angane" userId="05da2731-9352-4b35-b713-60351f56afbd" providerId="ADAL" clId="{F5F97842-A295-4F9F-B89B-A63B35E1C32D}" dt="2022-10-09T22:56:55.673" v="1293" actId="1037"/>
          <ac:spMkLst>
            <pc:docMk/>
            <pc:sldMk cId="3862015218" sldId="286"/>
            <ac:spMk id="19" creationId="{2A0E6F03-EE8A-4C34-83C3-7AA26CD89AE7}"/>
          </ac:spMkLst>
        </pc:spChg>
        <pc:spChg chg="mod">
          <ac:chgData name="Manasweeta Angane" userId="05da2731-9352-4b35-b713-60351f56afbd" providerId="ADAL" clId="{F5F97842-A295-4F9F-B89B-A63B35E1C32D}" dt="2022-10-09T22:56:55.673" v="1293" actId="1037"/>
          <ac:spMkLst>
            <pc:docMk/>
            <pc:sldMk cId="3862015218" sldId="286"/>
            <ac:spMk id="20" creationId="{ECE79FEE-8E1F-4412-86BF-B12BB9DD54E7}"/>
          </ac:spMkLst>
        </pc:spChg>
        <pc:spChg chg="mod">
          <ac:chgData name="Manasweeta Angane" userId="05da2731-9352-4b35-b713-60351f56afbd" providerId="ADAL" clId="{F5F97842-A295-4F9F-B89B-A63B35E1C32D}" dt="2022-10-09T22:56:55.673" v="1293" actId="1037"/>
          <ac:spMkLst>
            <pc:docMk/>
            <pc:sldMk cId="3862015218" sldId="286"/>
            <ac:spMk id="23" creationId="{E1B046F7-9074-42EA-B14A-EBB7C79B6AE8}"/>
          </ac:spMkLst>
        </pc:spChg>
        <pc:spChg chg="mod">
          <ac:chgData name="Manasweeta Angane" userId="05da2731-9352-4b35-b713-60351f56afbd" providerId="ADAL" clId="{F5F97842-A295-4F9F-B89B-A63B35E1C32D}" dt="2022-10-09T22:56:55.673" v="1293" actId="1037"/>
          <ac:spMkLst>
            <pc:docMk/>
            <pc:sldMk cId="3862015218" sldId="286"/>
            <ac:spMk id="24" creationId="{A2F07207-8EA3-4B60-A70B-FA60A75904AA}"/>
          </ac:spMkLst>
        </pc:spChg>
        <pc:spChg chg="mod">
          <ac:chgData name="Manasweeta Angane" userId="05da2731-9352-4b35-b713-60351f56afbd" providerId="ADAL" clId="{F5F97842-A295-4F9F-B89B-A63B35E1C32D}" dt="2022-10-09T22:56:55.673" v="1293" actId="1037"/>
          <ac:spMkLst>
            <pc:docMk/>
            <pc:sldMk cId="3862015218" sldId="286"/>
            <ac:spMk id="25" creationId="{FF0E607F-3830-42DA-A0E7-61E58B740116}"/>
          </ac:spMkLst>
        </pc:spChg>
        <pc:spChg chg="mod">
          <ac:chgData name="Manasweeta Angane" userId="05da2731-9352-4b35-b713-60351f56afbd" providerId="ADAL" clId="{F5F97842-A295-4F9F-B89B-A63B35E1C32D}" dt="2022-10-10T01:14:45.516" v="2031" actId="1037"/>
          <ac:spMkLst>
            <pc:docMk/>
            <pc:sldMk cId="3862015218" sldId="286"/>
            <ac:spMk id="35" creationId="{ED7956F5-5427-412B-A115-BE4B0DCC8CE7}"/>
          </ac:spMkLst>
        </pc:spChg>
        <pc:spChg chg="mod">
          <ac:chgData name="Manasweeta Angane" userId="05da2731-9352-4b35-b713-60351f56afbd" providerId="ADAL" clId="{F5F97842-A295-4F9F-B89B-A63B35E1C32D}" dt="2022-10-10T01:14:45.516" v="2031" actId="1037"/>
          <ac:spMkLst>
            <pc:docMk/>
            <pc:sldMk cId="3862015218" sldId="286"/>
            <ac:spMk id="37" creationId="{2EA2F03E-68E8-444D-828A-1573BBAA1328}"/>
          </ac:spMkLst>
        </pc:spChg>
        <pc:spChg chg="mod">
          <ac:chgData name="Manasweeta Angane" userId="05da2731-9352-4b35-b713-60351f56afbd" providerId="ADAL" clId="{F5F97842-A295-4F9F-B89B-A63B35E1C32D}" dt="2022-10-10T01:14:45.516" v="2031" actId="1037"/>
          <ac:spMkLst>
            <pc:docMk/>
            <pc:sldMk cId="3862015218" sldId="286"/>
            <ac:spMk id="42" creationId="{75A89FA6-8EC9-4DFB-87D0-50E2E6E1A434}"/>
          </ac:spMkLst>
        </pc:spChg>
        <pc:spChg chg="mod">
          <ac:chgData name="Manasweeta Angane" userId="05da2731-9352-4b35-b713-60351f56afbd" providerId="ADAL" clId="{F5F97842-A295-4F9F-B89B-A63B35E1C32D}" dt="2022-10-10T01:14:45.516" v="2031" actId="1037"/>
          <ac:spMkLst>
            <pc:docMk/>
            <pc:sldMk cId="3862015218" sldId="286"/>
            <ac:spMk id="43" creationId="{EBCA8E4B-5E8F-4AFF-A87B-47BC97EF981B}"/>
          </ac:spMkLst>
        </pc:spChg>
        <pc:spChg chg="mod">
          <ac:chgData name="Manasweeta Angane" userId="05da2731-9352-4b35-b713-60351f56afbd" providerId="ADAL" clId="{F5F97842-A295-4F9F-B89B-A63B35E1C32D}" dt="2022-10-10T01:14:45.516" v="2031" actId="1037"/>
          <ac:spMkLst>
            <pc:docMk/>
            <pc:sldMk cId="3862015218" sldId="286"/>
            <ac:spMk id="46" creationId="{451EA93A-D46C-4257-9FBF-BD80D54CA5EC}"/>
          </ac:spMkLst>
        </pc:spChg>
        <pc:spChg chg="mod">
          <ac:chgData name="Manasweeta Angane" userId="05da2731-9352-4b35-b713-60351f56afbd" providerId="ADAL" clId="{F5F97842-A295-4F9F-B89B-A63B35E1C32D}" dt="2022-10-10T01:14:45.516" v="2031" actId="1037"/>
          <ac:spMkLst>
            <pc:docMk/>
            <pc:sldMk cId="3862015218" sldId="286"/>
            <ac:spMk id="47" creationId="{A5C1BCC7-9242-4458-B326-C5BA080EB1F7}"/>
          </ac:spMkLst>
        </pc:spChg>
        <pc:spChg chg="mod">
          <ac:chgData name="Manasweeta Angane" userId="05da2731-9352-4b35-b713-60351f56afbd" providerId="ADAL" clId="{F5F97842-A295-4F9F-B89B-A63B35E1C32D}" dt="2022-10-10T01:14:45.516" v="2031" actId="1037"/>
          <ac:spMkLst>
            <pc:docMk/>
            <pc:sldMk cId="3862015218" sldId="286"/>
            <ac:spMk id="48" creationId="{E4E18B60-7A2C-4BF3-ACE1-334365F114D8}"/>
          </ac:spMkLst>
        </pc:spChg>
        <pc:grpChg chg="add del mod">
          <ac:chgData name="Manasweeta Angane" userId="05da2731-9352-4b35-b713-60351f56afbd" providerId="ADAL" clId="{F5F97842-A295-4F9F-B89B-A63B35E1C32D}" dt="2022-10-09T23:09:59.474" v="1305" actId="21"/>
          <ac:grpSpMkLst>
            <pc:docMk/>
            <pc:sldMk cId="3862015218" sldId="286"/>
            <ac:grpSpMk id="9" creationId="{03E8F8D8-D1B0-48A4-A886-4F73B96523CC}"/>
          </ac:grpSpMkLst>
        </pc:grpChg>
        <pc:grpChg chg="add mod">
          <ac:chgData name="Manasweeta Angane" userId="05da2731-9352-4b35-b713-60351f56afbd" providerId="ADAL" clId="{F5F97842-A295-4F9F-B89B-A63B35E1C32D}" dt="2022-10-10T01:14:45.516" v="2031" actId="1037"/>
          <ac:grpSpMkLst>
            <pc:docMk/>
            <pc:sldMk cId="3862015218" sldId="286"/>
            <ac:grpSpMk id="34" creationId="{6FC6E2FE-1F7D-4FC9-BB06-C1EBF5003E8A}"/>
          </ac:grpSpMkLst>
        </pc:grpChg>
        <pc:graphicFrameChg chg="mod">
          <ac:chgData name="Manasweeta Angane" userId="05da2731-9352-4b35-b713-60351f56afbd" providerId="ADAL" clId="{F5F97842-A295-4F9F-B89B-A63B35E1C32D}" dt="2022-10-09T22:56:55.673" v="1293" actId="1037"/>
          <ac:graphicFrameMkLst>
            <pc:docMk/>
            <pc:sldMk cId="3862015218" sldId="286"/>
            <ac:graphicFrameMk id="13" creationId="{DEB5F675-8223-4F8D-B5BD-7759CCD6FE08}"/>
          </ac:graphicFrameMkLst>
        </pc:graphicFrameChg>
        <pc:graphicFrameChg chg="add del mod">
          <ac:chgData name="Manasweeta Angane" userId="05da2731-9352-4b35-b713-60351f56afbd" providerId="ADAL" clId="{F5F97842-A295-4F9F-B89B-A63B35E1C32D}" dt="2022-10-09T15:02:15.427" v="1162"/>
          <ac:graphicFrameMkLst>
            <pc:docMk/>
            <pc:sldMk cId="3862015218" sldId="286"/>
            <ac:graphicFrameMk id="30" creationId="{33A2A8D4-399B-478D-B280-80ECCF8B7480}"/>
          </ac:graphicFrameMkLst>
        </pc:graphicFrameChg>
        <pc:graphicFrameChg chg="add mod modGraphic">
          <ac:chgData name="Manasweeta Angane" userId="05da2731-9352-4b35-b713-60351f56afbd" providerId="ADAL" clId="{F5F97842-A295-4F9F-B89B-A63B35E1C32D}" dt="2022-10-11T10:52:33.648" v="6252" actId="1038"/>
          <ac:graphicFrameMkLst>
            <pc:docMk/>
            <pc:sldMk cId="3862015218" sldId="286"/>
            <ac:graphicFrameMk id="31" creationId="{BE0D5562-6A0F-402B-87FC-A4197454E781}"/>
          </ac:graphicFrameMkLst>
        </pc:graphicFrameChg>
        <pc:graphicFrameChg chg="add del mod">
          <ac:chgData name="Manasweeta Angane" userId="05da2731-9352-4b35-b713-60351f56afbd" providerId="ADAL" clId="{F5F97842-A295-4F9F-B89B-A63B35E1C32D}" dt="2022-10-09T15:02:45.422" v="1165" actId="478"/>
          <ac:graphicFrameMkLst>
            <pc:docMk/>
            <pc:sldMk cId="3862015218" sldId="286"/>
            <ac:graphicFrameMk id="32" creationId="{1D96827A-85BF-4D6C-8FCC-F7D2CC1E816E}"/>
          </ac:graphicFrameMkLst>
        </pc:graphicFrameChg>
        <pc:graphicFrameChg chg="mod">
          <ac:chgData name="Manasweeta Angane" userId="05da2731-9352-4b35-b713-60351f56afbd" providerId="ADAL" clId="{F5F97842-A295-4F9F-B89B-A63B35E1C32D}" dt="2022-10-10T01:14:45.516" v="2031" actId="1037"/>
          <ac:graphicFrameMkLst>
            <pc:docMk/>
            <pc:sldMk cId="3862015218" sldId="286"/>
            <ac:graphicFrameMk id="38" creationId="{3A5A4E91-6405-40BE-847C-CB0713F2FED5}"/>
          </ac:graphicFrameMkLst>
        </pc:graphicFrameChg>
        <pc:picChg chg="mod">
          <ac:chgData name="Manasweeta Angane" userId="05da2731-9352-4b35-b713-60351f56afbd" providerId="ADAL" clId="{F5F97842-A295-4F9F-B89B-A63B35E1C32D}" dt="2022-10-09T22:56:55.673" v="1293" actId="1037"/>
          <ac:picMkLst>
            <pc:docMk/>
            <pc:sldMk cId="3862015218" sldId="286"/>
            <ac:picMk id="11" creationId="{9DA3634A-3173-4F8C-A166-A1F26642EA0E}"/>
          </ac:picMkLst>
        </pc:picChg>
        <pc:picChg chg="mod">
          <ac:chgData name="Manasweeta Angane" userId="05da2731-9352-4b35-b713-60351f56afbd" providerId="ADAL" clId="{F5F97842-A295-4F9F-B89B-A63B35E1C32D}" dt="2022-10-09T22:56:55.673" v="1293" actId="1037"/>
          <ac:picMkLst>
            <pc:docMk/>
            <pc:sldMk cId="3862015218" sldId="286"/>
            <ac:picMk id="14" creationId="{271124C5-BED8-4F20-9A1A-BEAE913E000F}"/>
          </ac:picMkLst>
        </pc:picChg>
        <pc:picChg chg="mod">
          <ac:chgData name="Manasweeta Angane" userId="05da2731-9352-4b35-b713-60351f56afbd" providerId="ADAL" clId="{F5F97842-A295-4F9F-B89B-A63B35E1C32D}" dt="2022-10-09T22:56:55.673" v="1293" actId="1037"/>
          <ac:picMkLst>
            <pc:docMk/>
            <pc:sldMk cId="3862015218" sldId="286"/>
            <ac:picMk id="15" creationId="{D6F4EE43-AD97-4130-95F0-41CE31083D51}"/>
          </ac:picMkLst>
        </pc:picChg>
        <pc:picChg chg="mod">
          <ac:chgData name="Manasweeta Angane" userId="05da2731-9352-4b35-b713-60351f56afbd" providerId="ADAL" clId="{F5F97842-A295-4F9F-B89B-A63B35E1C32D}" dt="2022-10-09T22:56:55.673" v="1293" actId="1037"/>
          <ac:picMkLst>
            <pc:docMk/>
            <pc:sldMk cId="3862015218" sldId="286"/>
            <ac:picMk id="16" creationId="{41707EFA-3C3F-440D-848F-01AFA1397F5B}"/>
          </ac:picMkLst>
        </pc:picChg>
        <pc:picChg chg="mod">
          <ac:chgData name="Manasweeta Angane" userId="05da2731-9352-4b35-b713-60351f56afbd" providerId="ADAL" clId="{F5F97842-A295-4F9F-B89B-A63B35E1C32D}" dt="2022-10-09T22:56:55.673" v="1293" actId="1037"/>
          <ac:picMkLst>
            <pc:docMk/>
            <pc:sldMk cId="3862015218" sldId="286"/>
            <ac:picMk id="21" creationId="{AC84F25D-920B-4460-BA90-2F7BB87928C3}"/>
          </ac:picMkLst>
        </pc:picChg>
        <pc:picChg chg="mod">
          <ac:chgData name="Manasweeta Angane" userId="05da2731-9352-4b35-b713-60351f56afbd" providerId="ADAL" clId="{F5F97842-A295-4F9F-B89B-A63B35E1C32D}" dt="2022-10-09T22:56:55.673" v="1293" actId="1037"/>
          <ac:picMkLst>
            <pc:docMk/>
            <pc:sldMk cId="3862015218" sldId="286"/>
            <ac:picMk id="22" creationId="{E8ED68C8-CA9B-4460-BF57-6EEC640C64E2}"/>
          </ac:picMkLst>
        </pc:picChg>
        <pc:picChg chg="add del mod">
          <ac:chgData name="Manasweeta Angane" userId="05da2731-9352-4b35-b713-60351f56afbd" providerId="ADAL" clId="{F5F97842-A295-4F9F-B89B-A63B35E1C32D}" dt="2022-10-09T14:59:23.333" v="1154" actId="478"/>
          <ac:picMkLst>
            <pc:docMk/>
            <pc:sldMk cId="3862015218" sldId="286"/>
            <ac:picMk id="26" creationId="{67EDE171-F943-4898-A9ED-EFF93A3C9AEA}"/>
          </ac:picMkLst>
        </pc:picChg>
        <pc:picChg chg="add del mod">
          <ac:chgData name="Manasweeta Angane" userId="05da2731-9352-4b35-b713-60351f56afbd" providerId="ADAL" clId="{F5F97842-A295-4F9F-B89B-A63B35E1C32D}" dt="2022-10-09T14:59:26.427" v="1156" actId="478"/>
          <ac:picMkLst>
            <pc:docMk/>
            <pc:sldMk cId="3862015218" sldId="286"/>
            <ac:picMk id="27" creationId="{A563CF8D-E727-4C1B-8F74-C4CC45DCB3B1}"/>
          </ac:picMkLst>
        </pc:picChg>
        <pc:picChg chg="add mod">
          <ac:chgData name="Manasweeta Angane" userId="05da2731-9352-4b35-b713-60351f56afbd" providerId="ADAL" clId="{F5F97842-A295-4F9F-B89B-A63B35E1C32D}" dt="2022-10-10T03:24:15.399" v="2657" actId="1076"/>
          <ac:picMkLst>
            <pc:docMk/>
            <pc:sldMk cId="3862015218" sldId="286"/>
            <ac:picMk id="28" creationId="{1C59CD32-AC62-442B-B3AF-BEE9F58FB7B5}"/>
          </ac:picMkLst>
        </pc:picChg>
        <pc:picChg chg="add mod">
          <ac:chgData name="Manasweeta Angane" userId="05da2731-9352-4b35-b713-60351f56afbd" providerId="ADAL" clId="{F5F97842-A295-4F9F-B89B-A63B35E1C32D}" dt="2022-10-09T14:59:43.653" v="1158"/>
          <ac:picMkLst>
            <pc:docMk/>
            <pc:sldMk cId="3862015218" sldId="286"/>
            <ac:picMk id="29" creationId="{650C1A9D-6CAC-40FB-8CA1-1956E70A43BF}"/>
          </ac:picMkLst>
        </pc:picChg>
        <pc:picChg chg="add mod">
          <ac:chgData name="Manasweeta Angane" userId="05da2731-9352-4b35-b713-60351f56afbd" providerId="ADAL" clId="{F5F97842-A295-4F9F-B89B-A63B35E1C32D}" dt="2022-10-11T10:52:25.294" v="6233" actId="12789"/>
          <ac:picMkLst>
            <pc:docMk/>
            <pc:sldMk cId="3862015218" sldId="286"/>
            <ac:picMk id="33" creationId="{C4E68141-671C-42B3-8871-8862C1C837B6}"/>
          </ac:picMkLst>
        </pc:picChg>
        <pc:picChg chg="mod">
          <ac:chgData name="Manasweeta Angane" userId="05da2731-9352-4b35-b713-60351f56afbd" providerId="ADAL" clId="{F5F97842-A295-4F9F-B89B-A63B35E1C32D}" dt="2022-10-10T01:14:45.516" v="2031" actId="1037"/>
          <ac:picMkLst>
            <pc:docMk/>
            <pc:sldMk cId="3862015218" sldId="286"/>
            <ac:picMk id="36" creationId="{7DAE8B75-CE68-4951-8180-4056C83DEF0D}"/>
          </ac:picMkLst>
        </pc:picChg>
        <pc:picChg chg="mod">
          <ac:chgData name="Manasweeta Angane" userId="05da2731-9352-4b35-b713-60351f56afbd" providerId="ADAL" clId="{F5F97842-A295-4F9F-B89B-A63B35E1C32D}" dt="2022-10-10T01:14:45.516" v="2031" actId="1037"/>
          <ac:picMkLst>
            <pc:docMk/>
            <pc:sldMk cId="3862015218" sldId="286"/>
            <ac:picMk id="39" creationId="{602DC8E1-92AA-4A5E-9384-940AEB453259}"/>
          </ac:picMkLst>
        </pc:picChg>
        <pc:picChg chg="mod">
          <ac:chgData name="Manasweeta Angane" userId="05da2731-9352-4b35-b713-60351f56afbd" providerId="ADAL" clId="{F5F97842-A295-4F9F-B89B-A63B35E1C32D}" dt="2022-10-10T01:14:45.516" v="2031" actId="1037"/>
          <ac:picMkLst>
            <pc:docMk/>
            <pc:sldMk cId="3862015218" sldId="286"/>
            <ac:picMk id="40" creationId="{E03222D7-EA0A-45A4-B3CA-70D35F062C4C}"/>
          </ac:picMkLst>
        </pc:picChg>
        <pc:picChg chg="mod">
          <ac:chgData name="Manasweeta Angane" userId="05da2731-9352-4b35-b713-60351f56afbd" providerId="ADAL" clId="{F5F97842-A295-4F9F-B89B-A63B35E1C32D}" dt="2022-10-10T01:14:45.516" v="2031" actId="1037"/>
          <ac:picMkLst>
            <pc:docMk/>
            <pc:sldMk cId="3862015218" sldId="286"/>
            <ac:picMk id="41" creationId="{BFE36339-F6CD-42E7-9BAA-72C1B5E81D8E}"/>
          </ac:picMkLst>
        </pc:picChg>
        <pc:picChg chg="mod">
          <ac:chgData name="Manasweeta Angane" userId="05da2731-9352-4b35-b713-60351f56afbd" providerId="ADAL" clId="{F5F97842-A295-4F9F-B89B-A63B35E1C32D}" dt="2022-10-10T01:14:45.516" v="2031" actId="1037"/>
          <ac:picMkLst>
            <pc:docMk/>
            <pc:sldMk cId="3862015218" sldId="286"/>
            <ac:picMk id="44" creationId="{8D136B3E-518C-4761-96B2-46833AD84012}"/>
          </ac:picMkLst>
        </pc:picChg>
        <pc:picChg chg="mod">
          <ac:chgData name="Manasweeta Angane" userId="05da2731-9352-4b35-b713-60351f56afbd" providerId="ADAL" clId="{F5F97842-A295-4F9F-B89B-A63B35E1C32D}" dt="2022-10-10T01:14:45.516" v="2031" actId="1037"/>
          <ac:picMkLst>
            <pc:docMk/>
            <pc:sldMk cId="3862015218" sldId="286"/>
            <ac:picMk id="45" creationId="{96223293-8E3E-4C35-958E-6820245B0DB0}"/>
          </ac:picMkLst>
        </pc:picChg>
      </pc:sldChg>
      <pc:sldChg chg="addSp delSp modSp add del mod ord modTransition modAnim">
        <pc:chgData name="Manasweeta Angane" userId="05da2731-9352-4b35-b713-60351f56afbd" providerId="ADAL" clId="{F5F97842-A295-4F9F-B89B-A63B35E1C32D}" dt="2022-10-22T07:00:37.336" v="20934" actId="2696"/>
        <pc:sldMkLst>
          <pc:docMk/>
          <pc:sldMk cId="2548705943" sldId="287"/>
        </pc:sldMkLst>
        <pc:spChg chg="mod">
          <ac:chgData name="Manasweeta Angane" userId="05da2731-9352-4b35-b713-60351f56afbd" providerId="ADAL" clId="{F5F97842-A295-4F9F-B89B-A63B35E1C32D}" dt="2022-10-09T23:17:58.469" v="1399" actId="1076"/>
          <ac:spMkLst>
            <pc:docMk/>
            <pc:sldMk cId="2548705943" sldId="287"/>
            <ac:spMk id="10" creationId="{2D429308-7BDF-494C-9E08-76FC1DD3B81D}"/>
          </ac:spMkLst>
        </pc:spChg>
        <pc:spChg chg="mod">
          <ac:chgData name="Manasweeta Angane" userId="05da2731-9352-4b35-b713-60351f56afbd" providerId="ADAL" clId="{F5F97842-A295-4F9F-B89B-A63B35E1C32D}" dt="2022-10-09T23:17:58.469" v="1399" actId="1076"/>
          <ac:spMkLst>
            <pc:docMk/>
            <pc:sldMk cId="2548705943" sldId="287"/>
            <ac:spMk id="12" creationId="{383C3DCE-9D32-4F67-9203-4AA00AD04734}"/>
          </ac:spMkLst>
        </pc:spChg>
        <pc:spChg chg="del">
          <ac:chgData name="Manasweeta Angane" userId="05da2731-9352-4b35-b713-60351f56afbd" providerId="ADAL" clId="{F5F97842-A295-4F9F-B89B-A63B35E1C32D}" dt="2022-10-09T23:18:26.664" v="1424" actId="478"/>
          <ac:spMkLst>
            <pc:docMk/>
            <pc:sldMk cId="2548705943" sldId="287"/>
            <ac:spMk id="17" creationId="{8DB771DF-C627-44BB-8716-44C80EF9D83F}"/>
          </ac:spMkLst>
        </pc:spChg>
        <pc:spChg chg="mod">
          <ac:chgData name="Manasweeta Angane" userId="05da2731-9352-4b35-b713-60351f56afbd" providerId="ADAL" clId="{F5F97842-A295-4F9F-B89B-A63B35E1C32D}" dt="2022-10-09T23:40:14.248" v="1749" actId="20577"/>
          <ac:spMkLst>
            <pc:docMk/>
            <pc:sldMk cId="2548705943" sldId="287"/>
            <ac:spMk id="18" creationId="{45F2BEED-A6BE-45AE-BED7-62E52E5E5868}"/>
          </ac:spMkLst>
        </pc:spChg>
        <pc:spChg chg="mod">
          <ac:chgData name="Manasweeta Angane" userId="05da2731-9352-4b35-b713-60351f56afbd" providerId="ADAL" clId="{F5F97842-A295-4F9F-B89B-A63B35E1C32D}" dt="2022-10-09T23:17:58.469" v="1399" actId="1076"/>
          <ac:spMkLst>
            <pc:docMk/>
            <pc:sldMk cId="2548705943" sldId="287"/>
            <ac:spMk id="19" creationId="{0F98CCD0-5496-4639-A888-95FD7C409EB4}"/>
          </ac:spMkLst>
        </pc:spChg>
        <pc:spChg chg="mod">
          <ac:chgData name="Manasweeta Angane" userId="05da2731-9352-4b35-b713-60351f56afbd" providerId="ADAL" clId="{F5F97842-A295-4F9F-B89B-A63B35E1C32D}" dt="2022-10-09T23:17:58.469" v="1399" actId="1076"/>
          <ac:spMkLst>
            <pc:docMk/>
            <pc:sldMk cId="2548705943" sldId="287"/>
            <ac:spMk id="20" creationId="{D7EB6264-D97A-4C99-9888-724285FCD713}"/>
          </ac:spMkLst>
        </pc:spChg>
        <pc:spChg chg="mod">
          <ac:chgData name="Manasweeta Angane" userId="05da2731-9352-4b35-b713-60351f56afbd" providerId="ADAL" clId="{F5F97842-A295-4F9F-B89B-A63B35E1C32D}" dt="2022-10-09T23:17:58.469" v="1399" actId="1076"/>
          <ac:spMkLst>
            <pc:docMk/>
            <pc:sldMk cId="2548705943" sldId="287"/>
            <ac:spMk id="23" creationId="{4DA6195A-F752-4B58-98E3-AD06ED5E0AB7}"/>
          </ac:spMkLst>
        </pc:spChg>
        <pc:spChg chg="mod">
          <ac:chgData name="Manasweeta Angane" userId="05da2731-9352-4b35-b713-60351f56afbd" providerId="ADAL" clId="{F5F97842-A295-4F9F-B89B-A63B35E1C32D}" dt="2022-10-09T23:17:58.469" v="1399" actId="1076"/>
          <ac:spMkLst>
            <pc:docMk/>
            <pc:sldMk cId="2548705943" sldId="287"/>
            <ac:spMk id="24" creationId="{FF973B07-AEED-4294-9E52-52679FA19A36}"/>
          </ac:spMkLst>
        </pc:spChg>
        <pc:spChg chg="mod">
          <ac:chgData name="Manasweeta Angane" userId="05da2731-9352-4b35-b713-60351f56afbd" providerId="ADAL" clId="{F5F97842-A295-4F9F-B89B-A63B35E1C32D}" dt="2022-10-09T23:17:58.469" v="1399" actId="1076"/>
          <ac:spMkLst>
            <pc:docMk/>
            <pc:sldMk cId="2548705943" sldId="287"/>
            <ac:spMk id="25" creationId="{695381F4-9150-4DDE-B3FD-787133A7449C}"/>
          </ac:spMkLst>
        </pc:spChg>
        <pc:spChg chg="mod topLvl">
          <ac:chgData name="Manasweeta Angane" userId="05da2731-9352-4b35-b713-60351f56afbd" providerId="ADAL" clId="{F5F97842-A295-4F9F-B89B-A63B35E1C32D}" dt="2022-10-09T23:37:03.747" v="1607" actId="1038"/>
          <ac:spMkLst>
            <pc:docMk/>
            <pc:sldMk cId="2548705943" sldId="287"/>
            <ac:spMk id="28" creationId="{D5C7C28C-CA34-4027-9F4E-CF8BAD765AFF}"/>
          </ac:spMkLst>
        </pc:spChg>
        <pc:spChg chg="mod topLvl">
          <ac:chgData name="Manasweeta Angane" userId="05da2731-9352-4b35-b713-60351f56afbd" providerId="ADAL" clId="{F5F97842-A295-4F9F-B89B-A63B35E1C32D}" dt="2022-10-10T02:04:37.874" v="2458" actId="2711"/>
          <ac:spMkLst>
            <pc:docMk/>
            <pc:sldMk cId="2548705943" sldId="287"/>
            <ac:spMk id="29" creationId="{4FDD9FBC-75BB-4AC7-943C-3CC5859E1E2D}"/>
          </ac:spMkLst>
        </pc:spChg>
        <pc:spChg chg="mod">
          <ac:chgData name="Manasweeta Angane" userId="05da2731-9352-4b35-b713-60351f56afbd" providerId="ADAL" clId="{F5F97842-A295-4F9F-B89B-A63B35E1C32D}" dt="2022-10-09T23:36:15.894" v="1557" actId="165"/>
          <ac:spMkLst>
            <pc:docMk/>
            <pc:sldMk cId="2548705943" sldId="287"/>
            <ac:spMk id="30" creationId="{3C7E639F-048B-46A5-A98D-9E1C95D494BF}"/>
          </ac:spMkLst>
        </pc:spChg>
        <pc:spChg chg="mod">
          <ac:chgData name="Manasweeta Angane" userId="05da2731-9352-4b35-b713-60351f56afbd" providerId="ADAL" clId="{F5F97842-A295-4F9F-B89B-A63B35E1C32D}" dt="2022-10-10T02:04:45.175" v="2459" actId="2711"/>
          <ac:spMkLst>
            <pc:docMk/>
            <pc:sldMk cId="2548705943" sldId="287"/>
            <ac:spMk id="31" creationId="{FB51625B-422B-40EB-B7F9-879FCD117ED3}"/>
          </ac:spMkLst>
        </pc:spChg>
        <pc:spChg chg="mod topLvl">
          <ac:chgData name="Manasweeta Angane" userId="05da2731-9352-4b35-b713-60351f56afbd" providerId="ADAL" clId="{F5F97842-A295-4F9F-B89B-A63B35E1C32D}" dt="2022-10-09T23:38:25.685" v="1694" actId="1038"/>
          <ac:spMkLst>
            <pc:docMk/>
            <pc:sldMk cId="2548705943" sldId="287"/>
            <ac:spMk id="34" creationId="{C3416F54-E762-4F41-B00A-532ECE793E54}"/>
          </ac:spMkLst>
        </pc:spChg>
        <pc:spChg chg="mod topLvl">
          <ac:chgData name="Manasweeta Angane" userId="05da2731-9352-4b35-b713-60351f56afbd" providerId="ADAL" clId="{F5F97842-A295-4F9F-B89B-A63B35E1C32D}" dt="2022-10-10T02:04:51.457" v="2460" actId="2711"/>
          <ac:spMkLst>
            <pc:docMk/>
            <pc:sldMk cId="2548705943" sldId="287"/>
            <ac:spMk id="35" creationId="{50BBB729-D15F-4ADB-AB93-D7FD76433DC7}"/>
          </ac:spMkLst>
        </pc:spChg>
        <pc:spChg chg="mod">
          <ac:chgData name="Manasweeta Angane" userId="05da2731-9352-4b35-b713-60351f56afbd" providerId="ADAL" clId="{F5F97842-A295-4F9F-B89B-A63B35E1C32D}" dt="2022-10-09T23:36:15.894" v="1557" actId="165"/>
          <ac:spMkLst>
            <pc:docMk/>
            <pc:sldMk cId="2548705943" sldId="287"/>
            <ac:spMk id="36" creationId="{2DEE1CBE-AFE1-4D37-9B9A-A9B8F41AFDE8}"/>
          </ac:spMkLst>
        </pc:spChg>
        <pc:spChg chg="mod">
          <ac:chgData name="Manasweeta Angane" userId="05da2731-9352-4b35-b713-60351f56afbd" providerId="ADAL" clId="{F5F97842-A295-4F9F-B89B-A63B35E1C32D}" dt="2022-10-10T02:04:58.685" v="2461" actId="2711"/>
          <ac:spMkLst>
            <pc:docMk/>
            <pc:sldMk cId="2548705943" sldId="287"/>
            <ac:spMk id="37" creationId="{3F00E0D9-A697-46E7-B19E-0B1887AF9A68}"/>
          </ac:spMkLst>
        </pc:spChg>
        <pc:spChg chg="mod topLvl">
          <ac:chgData name="Manasweeta Angane" userId="05da2731-9352-4b35-b713-60351f56afbd" providerId="ADAL" clId="{F5F97842-A295-4F9F-B89B-A63B35E1C32D}" dt="2022-10-09T23:36:15.894" v="1557" actId="165"/>
          <ac:spMkLst>
            <pc:docMk/>
            <pc:sldMk cId="2548705943" sldId="287"/>
            <ac:spMk id="41" creationId="{4852D380-0339-4E0F-92C9-5368D82508F7}"/>
          </ac:spMkLst>
        </pc:spChg>
        <pc:grpChg chg="add del mod">
          <ac:chgData name="Manasweeta Angane" userId="05da2731-9352-4b35-b713-60351f56afbd" providerId="ADAL" clId="{F5F97842-A295-4F9F-B89B-A63B35E1C32D}" dt="2022-10-09T23:34:32.559" v="1471" actId="21"/>
          <ac:grpSpMkLst>
            <pc:docMk/>
            <pc:sldMk cId="2548705943" sldId="287"/>
            <ac:grpSpMk id="9" creationId="{E2E92AE9-A200-4B2A-98E2-05D39228B453}"/>
          </ac:grpSpMkLst>
        </pc:grpChg>
        <pc:grpChg chg="add del mod">
          <ac:chgData name="Manasweeta Angane" userId="05da2731-9352-4b35-b713-60351f56afbd" providerId="ADAL" clId="{F5F97842-A295-4F9F-B89B-A63B35E1C32D}" dt="2022-10-09T23:36:15.894" v="1557" actId="165"/>
          <ac:grpSpMkLst>
            <pc:docMk/>
            <pc:sldMk cId="2548705943" sldId="287"/>
            <ac:grpSpMk id="26" creationId="{B902D31A-830E-4BE8-874C-1315F2B83906}"/>
          </ac:grpSpMkLst>
        </pc:grpChg>
        <pc:grpChg chg="mod topLvl">
          <ac:chgData name="Manasweeta Angane" userId="05da2731-9352-4b35-b713-60351f56afbd" providerId="ADAL" clId="{F5F97842-A295-4F9F-B89B-A63B35E1C32D}" dt="2022-10-09T23:37:03.747" v="1607" actId="1038"/>
          <ac:grpSpMkLst>
            <pc:docMk/>
            <pc:sldMk cId="2548705943" sldId="287"/>
            <ac:grpSpMk id="27" creationId="{50C03BE2-6DBE-4769-9744-A9C987E61B3D}"/>
          </ac:grpSpMkLst>
        </pc:grpChg>
        <pc:grpChg chg="add del mod">
          <ac:chgData name="Manasweeta Angane" userId="05da2731-9352-4b35-b713-60351f56afbd" providerId="ADAL" clId="{F5F97842-A295-4F9F-B89B-A63B35E1C32D}" dt="2022-10-09T23:36:15.894" v="1557" actId="165"/>
          <ac:grpSpMkLst>
            <pc:docMk/>
            <pc:sldMk cId="2548705943" sldId="287"/>
            <ac:grpSpMk id="32" creationId="{17D5A25D-BDAB-425A-8F65-4652ECC7BA45}"/>
          </ac:grpSpMkLst>
        </pc:grpChg>
        <pc:grpChg chg="mod topLvl">
          <ac:chgData name="Manasweeta Angane" userId="05da2731-9352-4b35-b713-60351f56afbd" providerId="ADAL" clId="{F5F97842-A295-4F9F-B89B-A63B35E1C32D}" dt="2022-10-09T23:38:25.685" v="1694" actId="1038"/>
          <ac:grpSpMkLst>
            <pc:docMk/>
            <pc:sldMk cId="2548705943" sldId="287"/>
            <ac:grpSpMk id="33" creationId="{8624B138-9E32-4C42-896D-BF78DD31D96D}"/>
          </ac:grpSpMkLst>
        </pc:grpChg>
        <pc:grpChg chg="add del mod">
          <ac:chgData name="Manasweeta Angane" userId="05da2731-9352-4b35-b713-60351f56afbd" providerId="ADAL" clId="{F5F97842-A295-4F9F-B89B-A63B35E1C32D}" dt="2022-10-09T23:36:15.894" v="1557" actId="165"/>
          <ac:grpSpMkLst>
            <pc:docMk/>
            <pc:sldMk cId="2548705943" sldId="287"/>
            <ac:grpSpMk id="39" creationId="{4931B428-525E-477A-B23D-49C00458C7C0}"/>
          </ac:grpSpMkLst>
        </pc:grpChg>
        <pc:graphicFrameChg chg="mod">
          <ac:chgData name="Manasweeta Angane" userId="05da2731-9352-4b35-b713-60351f56afbd" providerId="ADAL" clId="{F5F97842-A295-4F9F-B89B-A63B35E1C32D}" dt="2022-10-09T23:17:58.469" v="1399" actId="1076"/>
          <ac:graphicFrameMkLst>
            <pc:docMk/>
            <pc:sldMk cId="2548705943" sldId="287"/>
            <ac:graphicFrameMk id="13" creationId="{B042E530-77A2-4363-8BD3-10CC6738E162}"/>
          </ac:graphicFrameMkLst>
        </pc:graphicFrameChg>
        <pc:picChg chg="mod">
          <ac:chgData name="Manasweeta Angane" userId="05da2731-9352-4b35-b713-60351f56afbd" providerId="ADAL" clId="{F5F97842-A295-4F9F-B89B-A63B35E1C32D}" dt="2022-10-09T23:17:58.469" v="1399" actId="1076"/>
          <ac:picMkLst>
            <pc:docMk/>
            <pc:sldMk cId="2548705943" sldId="287"/>
            <ac:picMk id="11" creationId="{26B3F7DD-EE36-4A4A-82F4-7C1689134DC4}"/>
          </ac:picMkLst>
        </pc:picChg>
        <pc:picChg chg="mod">
          <ac:chgData name="Manasweeta Angane" userId="05da2731-9352-4b35-b713-60351f56afbd" providerId="ADAL" clId="{F5F97842-A295-4F9F-B89B-A63B35E1C32D}" dt="2022-10-09T23:17:58.469" v="1399" actId="1076"/>
          <ac:picMkLst>
            <pc:docMk/>
            <pc:sldMk cId="2548705943" sldId="287"/>
            <ac:picMk id="14" creationId="{3F4395B2-E4F5-46A9-A87E-9C09B3B33068}"/>
          </ac:picMkLst>
        </pc:picChg>
        <pc:picChg chg="mod">
          <ac:chgData name="Manasweeta Angane" userId="05da2731-9352-4b35-b713-60351f56afbd" providerId="ADAL" clId="{F5F97842-A295-4F9F-B89B-A63B35E1C32D}" dt="2022-10-09T23:17:58.469" v="1399" actId="1076"/>
          <ac:picMkLst>
            <pc:docMk/>
            <pc:sldMk cId="2548705943" sldId="287"/>
            <ac:picMk id="15" creationId="{8D3297A7-D5A6-4812-BAE7-FA61E89E03E6}"/>
          </ac:picMkLst>
        </pc:picChg>
        <pc:picChg chg="mod">
          <ac:chgData name="Manasweeta Angane" userId="05da2731-9352-4b35-b713-60351f56afbd" providerId="ADAL" clId="{F5F97842-A295-4F9F-B89B-A63B35E1C32D}" dt="2022-10-09T23:17:58.469" v="1399" actId="1076"/>
          <ac:picMkLst>
            <pc:docMk/>
            <pc:sldMk cId="2548705943" sldId="287"/>
            <ac:picMk id="16" creationId="{467CBDB7-3D15-4554-85B8-C10499DE660A}"/>
          </ac:picMkLst>
        </pc:picChg>
        <pc:picChg chg="mod">
          <ac:chgData name="Manasweeta Angane" userId="05da2731-9352-4b35-b713-60351f56afbd" providerId="ADAL" clId="{F5F97842-A295-4F9F-B89B-A63B35E1C32D}" dt="2022-10-09T23:17:58.469" v="1399" actId="1076"/>
          <ac:picMkLst>
            <pc:docMk/>
            <pc:sldMk cId="2548705943" sldId="287"/>
            <ac:picMk id="21" creationId="{92202D8C-F623-4057-AFEF-790FFCD03102}"/>
          </ac:picMkLst>
        </pc:picChg>
        <pc:picChg chg="mod">
          <ac:chgData name="Manasweeta Angane" userId="05da2731-9352-4b35-b713-60351f56afbd" providerId="ADAL" clId="{F5F97842-A295-4F9F-B89B-A63B35E1C32D}" dt="2022-10-09T23:17:58.469" v="1399" actId="1076"/>
          <ac:picMkLst>
            <pc:docMk/>
            <pc:sldMk cId="2548705943" sldId="287"/>
            <ac:picMk id="22" creationId="{6471788D-0B80-475A-9F04-07518FFF596C}"/>
          </ac:picMkLst>
        </pc:picChg>
        <pc:picChg chg="add mod">
          <ac:chgData name="Manasweeta Angane" userId="05da2731-9352-4b35-b713-60351f56afbd" providerId="ADAL" clId="{F5F97842-A295-4F9F-B89B-A63B35E1C32D}" dt="2022-10-09T23:39:10.045" v="1726" actId="1036"/>
          <ac:picMkLst>
            <pc:docMk/>
            <pc:sldMk cId="2548705943" sldId="287"/>
            <ac:picMk id="38" creationId="{A97F5E14-5F29-47F5-9B17-CE16260F23AA}"/>
          </ac:picMkLst>
        </pc:picChg>
        <pc:picChg chg="del mod topLvl">
          <ac:chgData name="Manasweeta Angane" userId="05da2731-9352-4b35-b713-60351f56afbd" providerId="ADAL" clId="{F5F97842-A295-4F9F-B89B-A63B35E1C32D}" dt="2022-10-09T23:39:02.525" v="1716" actId="478"/>
          <ac:picMkLst>
            <pc:docMk/>
            <pc:sldMk cId="2548705943" sldId="287"/>
            <ac:picMk id="40" creationId="{C02D9EFB-0F7F-4E8D-9880-7D2D7AA783B7}"/>
          </ac:picMkLst>
        </pc:picChg>
        <pc:picChg chg="add mod">
          <ac:chgData name="Manasweeta Angane" userId="05da2731-9352-4b35-b713-60351f56afbd" providerId="ADAL" clId="{F5F97842-A295-4F9F-B89B-A63B35E1C32D}" dt="2022-10-09T23:37:15.326" v="1638" actId="1037"/>
          <ac:picMkLst>
            <pc:docMk/>
            <pc:sldMk cId="2548705943" sldId="287"/>
            <ac:picMk id="42" creationId="{E08CEE52-DBDA-40FE-BAD4-952EE7B20244}"/>
          </ac:picMkLst>
        </pc:picChg>
      </pc:sldChg>
      <pc:sldChg chg="addSp delSp modSp add mod modTransition delAnim modAnim">
        <pc:chgData name="Manasweeta Angane" userId="05da2731-9352-4b35-b713-60351f56afbd" providerId="ADAL" clId="{F5F97842-A295-4F9F-B89B-A63B35E1C32D}" dt="2022-10-21T03:09:52.857" v="11911" actId="1036"/>
        <pc:sldMkLst>
          <pc:docMk/>
          <pc:sldMk cId="1960085715" sldId="288"/>
        </pc:sldMkLst>
        <pc:spChg chg="mod">
          <ac:chgData name="Manasweeta Angane" userId="05da2731-9352-4b35-b713-60351f56afbd" providerId="ADAL" clId="{F5F97842-A295-4F9F-B89B-A63B35E1C32D}" dt="2022-10-09T23:34:52.668" v="1474"/>
          <ac:spMkLst>
            <pc:docMk/>
            <pc:sldMk cId="1960085715" sldId="288"/>
            <ac:spMk id="10" creationId="{E9BFB844-49F4-4C29-9984-AE0827BE04BB}"/>
          </ac:spMkLst>
        </pc:spChg>
        <pc:spChg chg="mod">
          <ac:chgData name="Manasweeta Angane" userId="05da2731-9352-4b35-b713-60351f56afbd" providerId="ADAL" clId="{F5F97842-A295-4F9F-B89B-A63B35E1C32D}" dt="2022-10-09T23:34:52.668" v="1474"/>
          <ac:spMkLst>
            <pc:docMk/>
            <pc:sldMk cId="1960085715" sldId="288"/>
            <ac:spMk id="12" creationId="{7B152BB7-D9A6-4DD6-A8A0-AFC554A91E8E}"/>
          </ac:spMkLst>
        </pc:spChg>
        <pc:spChg chg="del mod">
          <ac:chgData name="Manasweeta Angane" userId="05da2731-9352-4b35-b713-60351f56afbd" providerId="ADAL" clId="{F5F97842-A295-4F9F-B89B-A63B35E1C32D}" dt="2022-10-10T02:03:01.278" v="2429" actId="478"/>
          <ac:spMkLst>
            <pc:docMk/>
            <pc:sldMk cId="1960085715" sldId="288"/>
            <ac:spMk id="17" creationId="{8DB771DF-C627-44BB-8716-44C80EF9D83F}"/>
          </ac:spMkLst>
        </pc:spChg>
        <pc:spChg chg="mod">
          <ac:chgData name="Manasweeta Angane" userId="05da2731-9352-4b35-b713-60351f56afbd" providerId="ADAL" clId="{F5F97842-A295-4F9F-B89B-A63B35E1C32D}" dt="2022-10-10T03:22:39.360" v="2649" actId="20577"/>
          <ac:spMkLst>
            <pc:docMk/>
            <pc:sldMk cId="1960085715" sldId="288"/>
            <ac:spMk id="18" creationId="{45F2BEED-A6BE-45AE-BED7-62E52E5E5868}"/>
          </ac:spMkLst>
        </pc:spChg>
        <pc:spChg chg="mod">
          <ac:chgData name="Manasweeta Angane" userId="05da2731-9352-4b35-b713-60351f56afbd" providerId="ADAL" clId="{F5F97842-A295-4F9F-B89B-A63B35E1C32D}" dt="2022-10-09T23:34:52.668" v="1474"/>
          <ac:spMkLst>
            <pc:docMk/>
            <pc:sldMk cId="1960085715" sldId="288"/>
            <ac:spMk id="19" creationId="{D6A1A7AE-174B-4F35-B20F-8085065810F3}"/>
          </ac:spMkLst>
        </pc:spChg>
        <pc:spChg chg="mod">
          <ac:chgData name="Manasweeta Angane" userId="05da2731-9352-4b35-b713-60351f56afbd" providerId="ADAL" clId="{F5F97842-A295-4F9F-B89B-A63B35E1C32D}" dt="2022-10-09T23:34:52.668" v="1474"/>
          <ac:spMkLst>
            <pc:docMk/>
            <pc:sldMk cId="1960085715" sldId="288"/>
            <ac:spMk id="20" creationId="{B9C74C5C-5F68-434C-B48C-9981E828F67B}"/>
          </ac:spMkLst>
        </pc:spChg>
        <pc:spChg chg="mod">
          <ac:chgData name="Manasweeta Angane" userId="05da2731-9352-4b35-b713-60351f56afbd" providerId="ADAL" clId="{F5F97842-A295-4F9F-B89B-A63B35E1C32D}" dt="2022-10-09T23:34:52.668" v="1474"/>
          <ac:spMkLst>
            <pc:docMk/>
            <pc:sldMk cId="1960085715" sldId="288"/>
            <ac:spMk id="23" creationId="{D963E460-653C-4AD7-8A95-120293C0F951}"/>
          </ac:spMkLst>
        </pc:spChg>
        <pc:spChg chg="mod">
          <ac:chgData name="Manasweeta Angane" userId="05da2731-9352-4b35-b713-60351f56afbd" providerId="ADAL" clId="{F5F97842-A295-4F9F-B89B-A63B35E1C32D}" dt="2022-10-09T23:34:52.668" v="1474"/>
          <ac:spMkLst>
            <pc:docMk/>
            <pc:sldMk cId="1960085715" sldId="288"/>
            <ac:spMk id="24" creationId="{74882598-E412-46A3-AF79-900849E4D2C1}"/>
          </ac:spMkLst>
        </pc:spChg>
        <pc:spChg chg="mod">
          <ac:chgData name="Manasweeta Angane" userId="05da2731-9352-4b35-b713-60351f56afbd" providerId="ADAL" clId="{F5F97842-A295-4F9F-B89B-A63B35E1C32D}" dt="2022-10-09T23:34:52.668" v="1474"/>
          <ac:spMkLst>
            <pc:docMk/>
            <pc:sldMk cId="1960085715" sldId="288"/>
            <ac:spMk id="25" creationId="{CFD305EE-CE69-4E11-8C19-17C6977065E5}"/>
          </ac:spMkLst>
        </pc:spChg>
        <pc:spChg chg="mod">
          <ac:chgData name="Manasweeta Angane" userId="05da2731-9352-4b35-b713-60351f56afbd" providerId="ADAL" clId="{F5F97842-A295-4F9F-B89B-A63B35E1C32D}" dt="2022-10-10T01:58:44.389" v="2280"/>
          <ac:spMkLst>
            <pc:docMk/>
            <pc:sldMk cId="1960085715" sldId="288"/>
            <ac:spMk id="27" creationId="{980644A0-46A7-4590-90D0-E7FD2A5901CF}"/>
          </ac:spMkLst>
        </pc:spChg>
        <pc:spChg chg="mod">
          <ac:chgData name="Manasweeta Angane" userId="05da2731-9352-4b35-b713-60351f56afbd" providerId="ADAL" clId="{F5F97842-A295-4F9F-B89B-A63B35E1C32D}" dt="2022-10-10T01:58:44.389" v="2280"/>
          <ac:spMkLst>
            <pc:docMk/>
            <pc:sldMk cId="1960085715" sldId="288"/>
            <ac:spMk id="28" creationId="{256A29FD-BCA3-45F6-BB72-8E95304F66FF}"/>
          </ac:spMkLst>
        </pc:spChg>
        <pc:spChg chg="mod">
          <ac:chgData name="Manasweeta Angane" userId="05da2731-9352-4b35-b713-60351f56afbd" providerId="ADAL" clId="{F5F97842-A295-4F9F-B89B-A63B35E1C32D}" dt="2022-10-10T01:58:44.389" v="2280"/>
          <ac:spMkLst>
            <pc:docMk/>
            <pc:sldMk cId="1960085715" sldId="288"/>
            <ac:spMk id="29" creationId="{A128DE20-33FD-4637-B3DD-1E0DFE46068D}"/>
          </ac:spMkLst>
        </pc:spChg>
        <pc:spChg chg="mod">
          <ac:chgData name="Manasweeta Angane" userId="05da2731-9352-4b35-b713-60351f56afbd" providerId="ADAL" clId="{F5F97842-A295-4F9F-B89B-A63B35E1C32D}" dt="2022-10-10T01:58:44.389" v="2280"/>
          <ac:spMkLst>
            <pc:docMk/>
            <pc:sldMk cId="1960085715" sldId="288"/>
            <ac:spMk id="30" creationId="{E0C6C3CD-F8FA-4187-BB52-69765DA92452}"/>
          </ac:spMkLst>
        </pc:spChg>
        <pc:spChg chg="mod">
          <ac:chgData name="Manasweeta Angane" userId="05da2731-9352-4b35-b713-60351f56afbd" providerId="ADAL" clId="{F5F97842-A295-4F9F-B89B-A63B35E1C32D}" dt="2022-10-10T01:58:44.389" v="2280"/>
          <ac:spMkLst>
            <pc:docMk/>
            <pc:sldMk cId="1960085715" sldId="288"/>
            <ac:spMk id="31" creationId="{DA63A34C-3834-4A1C-BE6E-89E418A7078E}"/>
          </ac:spMkLst>
        </pc:spChg>
        <pc:spChg chg="mod">
          <ac:chgData name="Manasweeta Angane" userId="05da2731-9352-4b35-b713-60351f56afbd" providerId="ADAL" clId="{F5F97842-A295-4F9F-B89B-A63B35E1C32D}" dt="2022-10-10T01:58:44.389" v="2280"/>
          <ac:spMkLst>
            <pc:docMk/>
            <pc:sldMk cId="1960085715" sldId="288"/>
            <ac:spMk id="32" creationId="{07192DBA-9270-4C14-8BCA-ACA526580772}"/>
          </ac:spMkLst>
        </pc:spChg>
        <pc:spChg chg="add del mod">
          <ac:chgData name="Manasweeta Angane" userId="05da2731-9352-4b35-b713-60351f56afbd" providerId="ADAL" clId="{F5F97842-A295-4F9F-B89B-A63B35E1C32D}" dt="2022-10-10T01:59:37.238" v="2327" actId="478"/>
          <ac:spMkLst>
            <pc:docMk/>
            <pc:sldMk cId="1960085715" sldId="288"/>
            <ac:spMk id="33" creationId="{82554B81-7AE5-4443-9B52-6A4727A5FB23}"/>
          </ac:spMkLst>
        </pc:spChg>
        <pc:spChg chg="mod">
          <ac:chgData name="Manasweeta Angane" userId="05da2731-9352-4b35-b713-60351f56afbd" providerId="ADAL" clId="{F5F97842-A295-4F9F-B89B-A63B35E1C32D}" dt="2022-10-10T02:06:40.419" v="2467" actId="165"/>
          <ac:spMkLst>
            <pc:docMk/>
            <pc:sldMk cId="1960085715" sldId="288"/>
            <ac:spMk id="35" creationId="{7948D0E6-C056-490F-8AC5-93EE51C31547}"/>
          </ac:spMkLst>
        </pc:spChg>
        <pc:spChg chg="mod">
          <ac:chgData name="Manasweeta Angane" userId="05da2731-9352-4b35-b713-60351f56afbd" providerId="ADAL" clId="{F5F97842-A295-4F9F-B89B-A63B35E1C32D}" dt="2022-10-10T02:06:40.419" v="2467" actId="165"/>
          <ac:spMkLst>
            <pc:docMk/>
            <pc:sldMk cId="1960085715" sldId="288"/>
            <ac:spMk id="36" creationId="{19121078-CF68-414E-A00F-9DBDBAB8163E}"/>
          </ac:spMkLst>
        </pc:spChg>
        <pc:spChg chg="mod">
          <ac:chgData name="Manasweeta Angane" userId="05da2731-9352-4b35-b713-60351f56afbd" providerId="ADAL" clId="{F5F97842-A295-4F9F-B89B-A63B35E1C32D}" dt="2022-10-10T02:06:40.419" v="2467" actId="165"/>
          <ac:spMkLst>
            <pc:docMk/>
            <pc:sldMk cId="1960085715" sldId="288"/>
            <ac:spMk id="37" creationId="{5508DB4C-3176-48E0-B89D-3A9BA67CC83F}"/>
          </ac:spMkLst>
        </pc:spChg>
        <pc:spChg chg="mod">
          <ac:chgData name="Manasweeta Angane" userId="05da2731-9352-4b35-b713-60351f56afbd" providerId="ADAL" clId="{F5F97842-A295-4F9F-B89B-A63B35E1C32D}" dt="2022-10-10T02:06:40.419" v="2467" actId="165"/>
          <ac:spMkLst>
            <pc:docMk/>
            <pc:sldMk cId="1960085715" sldId="288"/>
            <ac:spMk id="38" creationId="{29871D1A-B29B-4568-91D3-204B54D5A49D}"/>
          </ac:spMkLst>
        </pc:spChg>
        <pc:spChg chg="mod">
          <ac:chgData name="Manasweeta Angane" userId="05da2731-9352-4b35-b713-60351f56afbd" providerId="ADAL" clId="{F5F97842-A295-4F9F-B89B-A63B35E1C32D}" dt="2022-10-10T02:06:40.419" v="2467" actId="165"/>
          <ac:spMkLst>
            <pc:docMk/>
            <pc:sldMk cId="1960085715" sldId="288"/>
            <ac:spMk id="39" creationId="{19FADCB5-FF1F-4D15-9FD6-003E8E8A1270}"/>
          </ac:spMkLst>
        </pc:spChg>
        <pc:spChg chg="mod">
          <ac:chgData name="Manasweeta Angane" userId="05da2731-9352-4b35-b713-60351f56afbd" providerId="ADAL" clId="{F5F97842-A295-4F9F-B89B-A63B35E1C32D}" dt="2022-10-10T02:06:40.419" v="2467" actId="165"/>
          <ac:spMkLst>
            <pc:docMk/>
            <pc:sldMk cId="1960085715" sldId="288"/>
            <ac:spMk id="40" creationId="{3A10ACAA-C401-4C5F-A8EA-6D6133679479}"/>
          </ac:spMkLst>
        </pc:spChg>
        <pc:spChg chg="add del mod topLvl">
          <ac:chgData name="Manasweeta Angane" userId="05da2731-9352-4b35-b713-60351f56afbd" providerId="ADAL" clId="{F5F97842-A295-4F9F-B89B-A63B35E1C32D}" dt="2022-10-21T03:08:19.193" v="11875" actId="478"/>
          <ac:spMkLst>
            <pc:docMk/>
            <pc:sldMk cId="1960085715" sldId="288"/>
            <ac:spMk id="41" creationId="{91AA073D-4FE5-4A25-9CA5-BE7F86CF821C}"/>
          </ac:spMkLst>
        </pc:spChg>
        <pc:spChg chg="add mod topLvl">
          <ac:chgData name="Manasweeta Angane" userId="05da2731-9352-4b35-b713-60351f56afbd" providerId="ADAL" clId="{F5F97842-A295-4F9F-B89B-A63B35E1C32D}" dt="2022-10-10T02:06:40.419" v="2467" actId="165"/>
          <ac:spMkLst>
            <pc:docMk/>
            <pc:sldMk cId="1960085715" sldId="288"/>
            <ac:spMk id="42" creationId="{46B3A340-1179-44B0-9191-2542E37C882F}"/>
          </ac:spMkLst>
        </pc:spChg>
        <pc:spChg chg="add mod topLvl">
          <ac:chgData name="Manasweeta Angane" userId="05da2731-9352-4b35-b713-60351f56afbd" providerId="ADAL" clId="{F5F97842-A295-4F9F-B89B-A63B35E1C32D}" dt="2022-10-10T02:06:40.419" v="2467" actId="165"/>
          <ac:spMkLst>
            <pc:docMk/>
            <pc:sldMk cId="1960085715" sldId="288"/>
            <ac:spMk id="43" creationId="{FE432853-EBCB-4EC6-9C83-9F2D1323C5F0}"/>
          </ac:spMkLst>
        </pc:spChg>
        <pc:spChg chg="add mod topLvl">
          <ac:chgData name="Manasweeta Angane" userId="05da2731-9352-4b35-b713-60351f56afbd" providerId="ADAL" clId="{F5F97842-A295-4F9F-B89B-A63B35E1C32D}" dt="2022-10-10T02:06:40.419" v="2467" actId="165"/>
          <ac:spMkLst>
            <pc:docMk/>
            <pc:sldMk cId="1960085715" sldId="288"/>
            <ac:spMk id="44" creationId="{D466E386-ED36-4C8A-AB0C-73945F64EFE8}"/>
          </ac:spMkLst>
        </pc:spChg>
        <pc:spChg chg="add mod topLvl">
          <ac:chgData name="Manasweeta Angane" userId="05da2731-9352-4b35-b713-60351f56afbd" providerId="ADAL" clId="{F5F97842-A295-4F9F-B89B-A63B35E1C32D}" dt="2022-10-10T02:06:40.419" v="2467" actId="165"/>
          <ac:spMkLst>
            <pc:docMk/>
            <pc:sldMk cId="1960085715" sldId="288"/>
            <ac:spMk id="45" creationId="{77A3860B-71D3-45FB-B71C-B5EB2909825E}"/>
          </ac:spMkLst>
        </pc:spChg>
        <pc:spChg chg="add mod">
          <ac:chgData name="Manasweeta Angane" userId="05da2731-9352-4b35-b713-60351f56afbd" providerId="ADAL" clId="{F5F97842-A295-4F9F-B89B-A63B35E1C32D}" dt="2022-10-21T03:09:01.416" v="11880" actId="12789"/>
          <ac:spMkLst>
            <pc:docMk/>
            <pc:sldMk cId="1960085715" sldId="288"/>
            <ac:spMk id="47" creationId="{205A05A8-5B20-462E-89DF-D45A8C19E3A8}"/>
          </ac:spMkLst>
        </pc:spChg>
        <pc:grpChg chg="add del mod">
          <ac:chgData name="Manasweeta Angane" userId="05da2731-9352-4b35-b713-60351f56afbd" providerId="ADAL" clId="{F5F97842-A295-4F9F-B89B-A63B35E1C32D}" dt="2022-10-10T01:59:51.209" v="2376" actId="165"/>
          <ac:grpSpMkLst>
            <pc:docMk/>
            <pc:sldMk cId="1960085715" sldId="288"/>
            <ac:grpSpMk id="2" creationId="{E8224998-8656-4BBF-B7CE-0FC5E32FF95E}"/>
          </ac:grpSpMkLst>
        </pc:grpChg>
        <pc:grpChg chg="add del mod">
          <ac:chgData name="Manasweeta Angane" userId="05da2731-9352-4b35-b713-60351f56afbd" providerId="ADAL" clId="{F5F97842-A295-4F9F-B89B-A63B35E1C32D}" dt="2022-10-10T02:00:54.086" v="2381" actId="165"/>
          <ac:grpSpMkLst>
            <pc:docMk/>
            <pc:sldMk cId="1960085715" sldId="288"/>
            <ac:grpSpMk id="3" creationId="{AE93CF8A-9BD2-41A4-9952-22E444849277}"/>
          </ac:grpSpMkLst>
        </pc:grpChg>
        <pc:grpChg chg="add del mod">
          <ac:chgData name="Manasweeta Angane" userId="05da2731-9352-4b35-b713-60351f56afbd" providerId="ADAL" clId="{F5F97842-A295-4F9F-B89B-A63B35E1C32D}" dt="2022-10-10T01:14:34.891" v="2004" actId="21"/>
          <ac:grpSpMkLst>
            <pc:docMk/>
            <pc:sldMk cId="1960085715" sldId="288"/>
            <ac:grpSpMk id="9" creationId="{FD33C0FE-1F27-436B-9E9E-987D6FE7F682}"/>
          </ac:grpSpMkLst>
        </pc:grpChg>
        <pc:grpChg chg="add del mod">
          <ac:chgData name="Manasweeta Angane" userId="05da2731-9352-4b35-b713-60351f56afbd" providerId="ADAL" clId="{F5F97842-A295-4F9F-B89B-A63B35E1C32D}" dt="2022-10-10T01:59:38.452" v="2328" actId="478"/>
          <ac:grpSpMkLst>
            <pc:docMk/>
            <pc:sldMk cId="1960085715" sldId="288"/>
            <ac:grpSpMk id="26" creationId="{041BE667-2242-4495-A5C6-91598C17BBDF}"/>
          </ac:grpSpMkLst>
        </pc:grpChg>
        <pc:grpChg chg="add del mod topLvl">
          <ac:chgData name="Manasweeta Angane" userId="05da2731-9352-4b35-b713-60351f56afbd" providerId="ADAL" clId="{F5F97842-A295-4F9F-B89B-A63B35E1C32D}" dt="2022-10-21T03:08:18.201" v="11874" actId="478"/>
          <ac:grpSpMkLst>
            <pc:docMk/>
            <pc:sldMk cId="1960085715" sldId="288"/>
            <ac:grpSpMk id="34" creationId="{C50DAA6D-DE9A-4E89-9B83-FAC064F77BA3}"/>
          </ac:grpSpMkLst>
        </pc:grpChg>
        <pc:grpChg chg="add del mod topLvl">
          <ac:chgData name="Manasweeta Angane" userId="05da2731-9352-4b35-b713-60351f56afbd" providerId="ADAL" clId="{F5F97842-A295-4F9F-B89B-A63B35E1C32D}" dt="2022-10-21T03:08:21.628" v="11876" actId="478"/>
          <ac:grpSpMkLst>
            <pc:docMk/>
            <pc:sldMk cId="1960085715" sldId="288"/>
            <ac:grpSpMk id="46" creationId="{13F5FB98-C3CC-4F16-AC84-000CEE901D0C}"/>
          </ac:grpSpMkLst>
        </pc:grpChg>
        <pc:grpChg chg="add del mod">
          <ac:chgData name="Manasweeta Angane" userId="05da2731-9352-4b35-b713-60351f56afbd" providerId="ADAL" clId="{F5F97842-A295-4F9F-B89B-A63B35E1C32D}" dt="2022-10-10T02:06:40.419" v="2467" actId="165"/>
          <ac:grpSpMkLst>
            <pc:docMk/>
            <pc:sldMk cId="1960085715" sldId="288"/>
            <ac:grpSpMk id="48" creationId="{C203ABE8-1D29-4425-9A3D-7E3DAD4F5929}"/>
          </ac:grpSpMkLst>
        </pc:grpChg>
        <pc:graphicFrameChg chg="mod">
          <ac:chgData name="Manasweeta Angane" userId="05da2731-9352-4b35-b713-60351f56afbd" providerId="ADAL" clId="{F5F97842-A295-4F9F-B89B-A63B35E1C32D}" dt="2022-10-09T23:34:52.668" v="1474"/>
          <ac:graphicFrameMkLst>
            <pc:docMk/>
            <pc:sldMk cId="1960085715" sldId="288"/>
            <ac:graphicFrameMk id="13" creationId="{6C29CA0C-E597-4641-A75C-BBCC108B907B}"/>
          </ac:graphicFrameMkLst>
        </pc:graphicFrameChg>
        <pc:picChg chg="del">
          <ac:chgData name="Manasweeta Angane" userId="05da2731-9352-4b35-b713-60351f56afbd" providerId="ADAL" clId="{F5F97842-A295-4F9F-B89B-A63B35E1C32D}" dt="2022-10-21T03:08:06.313" v="11872" actId="478"/>
          <ac:picMkLst>
            <pc:docMk/>
            <pc:sldMk cId="1960085715" sldId="288"/>
            <ac:picMk id="2" creationId="{09CA5792-4561-4886-B327-26F7CBDE7471}"/>
          </ac:picMkLst>
        </pc:picChg>
        <pc:picChg chg="mod">
          <ac:chgData name="Manasweeta Angane" userId="05da2731-9352-4b35-b713-60351f56afbd" providerId="ADAL" clId="{F5F97842-A295-4F9F-B89B-A63B35E1C32D}" dt="2022-10-21T03:09:52.857" v="11911" actId="1036"/>
          <ac:picMkLst>
            <pc:docMk/>
            <pc:sldMk cId="1960085715" sldId="288"/>
            <ac:picMk id="3" creationId="{F438DF10-E870-4D00-8692-5136BBB5A12B}"/>
          </ac:picMkLst>
        </pc:picChg>
        <pc:picChg chg="mod">
          <ac:chgData name="Manasweeta Angane" userId="05da2731-9352-4b35-b713-60351f56afbd" providerId="ADAL" clId="{F5F97842-A295-4F9F-B89B-A63B35E1C32D}" dt="2022-10-09T23:34:52.668" v="1474"/>
          <ac:picMkLst>
            <pc:docMk/>
            <pc:sldMk cId="1960085715" sldId="288"/>
            <ac:picMk id="11" creationId="{CBAA9425-B50A-41FD-A702-030A9ED88576}"/>
          </ac:picMkLst>
        </pc:picChg>
        <pc:picChg chg="mod">
          <ac:chgData name="Manasweeta Angane" userId="05da2731-9352-4b35-b713-60351f56afbd" providerId="ADAL" clId="{F5F97842-A295-4F9F-B89B-A63B35E1C32D}" dt="2022-10-09T23:34:52.668" v="1474"/>
          <ac:picMkLst>
            <pc:docMk/>
            <pc:sldMk cId="1960085715" sldId="288"/>
            <ac:picMk id="14" creationId="{16CC40C2-9A57-494D-8E0D-D60BDDEF7826}"/>
          </ac:picMkLst>
        </pc:picChg>
        <pc:picChg chg="mod">
          <ac:chgData name="Manasweeta Angane" userId="05da2731-9352-4b35-b713-60351f56afbd" providerId="ADAL" clId="{F5F97842-A295-4F9F-B89B-A63B35E1C32D}" dt="2022-10-09T23:34:52.668" v="1474"/>
          <ac:picMkLst>
            <pc:docMk/>
            <pc:sldMk cId="1960085715" sldId="288"/>
            <ac:picMk id="15" creationId="{064A0127-FC81-4245-BEE9-9164D87EF1D5}"/>
          </ac:picMkLst>
        </pc:picChg>
        <pc:picChg chg="mod">
          <ac:chgData name="Manasweeta Angane" userId="05da2731-9352-4b35-b713-60351f56afbd" providerId="ADAL" clId="{F5F97842-A295-4F9F-B89B-A63B35E1C32D}" dt="2022-10-09T23:34:52.668" v="1474"/>
          <ac:picMkLst>
            <pc:docMk/>
            <pc:sldMk cId="1960085715" sldId="288"/>
            <ac:picMk id="16" creationId="{B092295E-170E-4F2A-AA6A-A64C85C032E3}"/>
          </ac:picMkLst>
        </pc:picChg>
        <pc:picChg chg="mod">
          <ac:chgData name="Manasweeta Angane" userId="05da2731-9352-4b35-b713-60351f56afbd" providerId="ADAL" clId="{F5F97842-A295-4F9F-B89B-A63B35E1C32D}" dt="2022-10-09T23:34:52.668" v="1474"/>
          <ac:picMkLst>
            <pc:docMk/>
            <pc:sldMk cId="1960085715" sldId="288"/>
            <ac:picMk id="21" creationId="{B8C45A7B-DB0C-4ABD-871A-65745D971639}"/>
          </ac:picMkLst>
        </pc:picChg>
        <pc:picChg chg="mod">
          <ac:chgData name="Manasweeta Angane" userId="05da2731-9352-4b35-b713-60351f56afbd" providerId="ADAL" clId="{F5F97842-A295-4F9F-B89B-A63B35E1C32D}" dt="2022-10-09T23:34:52.668" v="1474"/>
          <ac:picMkLst>
            <pc:docMk/>
            <pc:sldMk cId="1960085715" sldId="288"/>
            <ac:picMk id="22" creationId="{11897B3E-1CD2-4020-94B3-F56D5424C2CA}"/>
          </ac:picMkLst>
        </pc:picChg>
        <pc:picChg chg="add mod">
          <ac:chgData name="Manasweeta Angane" userId="05da2731-9352-4b35-b713-60351f56afbd" providerId="ADAL" clId="{F5F97842-A295-4F9F-B89B-A63B35E1C32D}" dt="2022-10-10T03:24:25.414" v="2658"/>
          <ac:picMkLst>
            <pc:docMk/>
            <pc:sldMk cId="1960085715" sldId="288"/>
            <ac:picMk id="49" creationId="{A035ECC9-FC85-461A-A713-3AB228649C45}"/>
          </ac:picMkLst>
        </pc:picChg>
        <pc:picChg chg="add mod">
          <ac:chgData name="Manasweeta Angane" userId="05da2731-9352-4b35-b713-60351f56afbd" providerId="ADAL" clId="{F5F97842-A295-4F9F-B89B-A63B35E1C32D}" dt="2022-10-10T03:24:25.414" v="2658"/>
          <ac:picMkLst>
            <pc:docMk/>
            <pc:sldMk cId="1960085715" sldId="288"/>
            <ac:picMk id="50" creationId="{EF3C7F16-C26F-4772-BD2E-68C38B0168C1}"/>
          </ac:picMkLst>
        </pc:picChg>
      </pc:sldChg>
      <pc:sldChg chg="addSp delSp modSp new del">
        <pc:chgData name="Manasweeta Angane" userId="05da2731-9352-4b35-b713-60351f56afbd" providerId="ADAL" clId="{F5F97842-A295-4F9F-B89B-A63B35E1C32D}" dt="2022-10-09T14:55:42.753" v="1016" actId="2696"/>
        <pc:sldMkLst>
          <pc:docMk/>
          <pc:sldMk cId="3114086462" sldId="288"/>
        </pc:sldMkLst>
        <pc:spChg chg="mod">
          <ac:chgData name="Manasweeta Angane" userId="05da2731-9352-4b35-b713-60351f56afbd" providerId="ADAL" clId="{F5F97842-A295-4F9F-B89B-A63B35E1C32D}" dt="2022-10-09T14:54:54.036" v="1010"/>
          <ac:spMkLst>
            <pc:docMk/>
            <pc:sldMk cId="3114086462" sldId="288"/>
            <ac:spMk id="5" creationId="{AB16EB96-0DC1-4FAB-BE06-C3F527A72BF9}"/>
          </ac:spMkLst>
        </pc:spChg>
        <pc:spChg chg="mod">
          <ac:chgData name="Manasweeta Angane" userId="05da2731-9352-4b35-b713-60351f56afbd" providerId="ADAL" clId="{F5F97842-A295-4F9F-B89B-A63B35E1C32D}" dt="2022-10-09T14:54:54.036" v="1010"/>
          <ac:spMkLst>
            <pc:docMk/>
            <pc:sldMk cId="3114086462" sldId="288"/>
            <ac:spMk id="7" creationId="{6B01D7D5-18DB-491C-B0D3-B2984A04E271}"/>
          </ac:spMkLst>
        </pc:spChg>
        <pc:spChg chg="mod">
          <ac:chgData name="Manasweeta Angane" userId="05da2731-9352-4b35-b713-60351f56afbd" providerId="ADAL" clId="{F5F97842-A295-4F9F-B89B-A63B35E1C32D}" dt="2022-10-09T14:54:54.036" v="1010"/>
          <ac:spMkLst>
            <pc:docMk/>
            <pc:sldMk cId="3114086462" sldId="288"/>
            <ac:spMk id="12" creationId="{A4EBD3D7-AE61-41DD-A7AA-21EFCD20C31B}"/>
          </ac:spMkLst>
        </pc:spChg>
        <pc:spChg chg="mod">
          <ac:chgData name="Manasweeta Angane" userId="05da2731-9352-4b35-b713-60351f56afbd" providerId="ADAL" clId="{F5F97842-A295-4F9F-B89B-A63B35E1C32D}" dt="2022-10-09T14:54:54.036" v="1010"/>
          <ac:spMkLst>
            <pc:docMk/>
            <pc:sldMk cId="3114086462" sldId="288"/>
            <ac:spMk id="13" creationId="{FDE9A39E-BAF8-4FDC-9151-7E1144930C42}"/>
          </ac:spMkLst>
        </pc:spChg>
        <pc:spChg chg="mod">
          <ac:chgData name="Manasweeta Angane" userId="05da2731-9352-4b35-b713-60351f56afbd" providerId="ADAL" clId="{F5F97842-A295-4F9F-B89B-A63B35E1C32D}" dt="2022-10-09T14:54:54.036" v="1010"/>
          <ac:spMkLst>
            <pc:docMk/>
            <pc:sldMk cId="3114086462" sldId="288"/>
            <ac:spMk id="16" creationId="{1852773B-27D7-4CFB-AA1B-090F61FADF2B}"/>
          </ac:spMkLst>
        </pc:spChg>
        <pc:spChg chg="mod">
          <ac:chgData name="Manasweeta Angane" userId="05da2731-9352-4b35-b713-60351f56afbd" providerId="ADAL" clId="{F5F97842-A295-4F9F-B89B-A63B35E1C32D}" dt="2022-10-09T14:54:54.036" v="1010"/>
          <ac:spMkLst>
            <pc:docMk/>
            <pc:sldMk cId="3114086462" sldId="288"/>
            <ac:spMk id="17" creationId="{4E2B577C-C5FA-4B69-BBFE-34E79DC1847E}"/>
          </ac:spMkLst>
        </pc:spChg>
        <pc:spChg chg="mod">
          <ac:chgData name="Manasweeta Angane" userId="05da2731-9352-4b35-b713-60351f56afbd" providerId="ADAL" clId="{F5F97842-A295-4F9F-B89B-A63B35E1C32D}" dt="2022-10-09T14:54:54.036" v="1010"/>
          <ac:spMkLst>
            <pc:docMk/>
            <pc:sldMk cId="3114086462" sldId="288"/>
            <ac:spMk id="18" creationId="{B020C339-66BB-4B1A-AEB7-53465AE90541}"/>
          </ac:spMkLst>
        </pc:spChg>
        <pc:grpChg chg="add del mod">
          <ac:chgData name="Manasweeta Angane" userId="05da2731-9352-4b35-b713-60351f56afbd" providerId="ADAL" clId="{F5F97842-A295-4F9F-B89B-A63B35E1C32D}" dt="2022-10-09T14:55:15.831" v="1011" actId="21"/>
          <ac:grpSpMkLst>
            <pc:docMk/>
            <pc:sldMk cId="3114086462" sldId="288"/>
            <ac:grpSpMk id="4" creationId="{75E03280-C834-48BD-974C-15A58FF271BE}"/>
          </ac:grpSpMkLst>
        </pc:grpChg>
        <pc:graphicFrameChg chg="mod">
          <ac:chgData name="Manasweeta Angane" userId="05da2731-9352-4b35-b713-60351f56afbd" providerId="ADAL" clId="{F5F97842-A295-4F9F-B89B-A63B35E1C32D}" dt="2022-10-09T14:54:54.036" v="1010"/>
          <ac:graphicFrameMkLst>
            <pc:docMk/>
            <pc:sldMk cId="3114086462" sldId="288"/>
            <ac:graphicFrameMk id="8" creationId="{7EE77EF1-6E94-4B26-B1CE-E21856914396}"/>
          </ac:graphicFrameMkLst>
        </pc:graphicFrameChg>
        <pc:picChg chg="mod">
          <ac:chgData name="Manasweeta Angane" userId="05da2731-9352-4b35-b713-60351f56afbd" providerId="ADAL" clId="{F5F97842-A295-4F9F-B89B-A63B35E1C32D}" dt="2022-10-09T14:54:54.036" v="1010"/>
          <ac:picMkLst>
            <pc:docMk/>
            <pc:sldMk cId="3114086462" sldId="288"/>
            <ac:picMk id="6" creationId="{81D8510B-3D3C-4B2F-A90D-C3667C409E88}"/>
          </ac:picMkLst>
        </pc:picChg>
        <pc:picChg chg="mod">
          <ac:chgData name="Manasweeta Angane" userId="05da2731-9352-4b35-b713-60351f56afbd" providerId="ADAL" clId="{F5F97842-A295-4F9F-B89B-A63B35E1C32D}" dt="2022-10-09T14:54:54.036" v="1010"/>
          <ac:picMkLst>
            <pc:docMk/>
            <pc:sldMk cId="3114086462" sldId="288"/>
            <ac:picMk id="9" creationId="{2CCC4F29-B433-49B7-BB2A-B6BF0FF9C27D}"/>
          </ac:picMkLst>
        </pc:picChg>
        <pc:picChg chg="mod">
          <ac:chgData name="Manasweeta Angane" userId="05da2731-9352-4b35-b713-60351f56afbd" providerId="ADAL" clId="{F5F97842-A295-4F9F-B89B-A63B35E1C32D}" dt="2022-10-09T14:54:54.036" v="1010"/>
          <ac:picMkLst>
            <pc:docMk/>
            <pc:sldMk cId="3114086462" sldId="288"/>
            <ac:picMk id="10" creationId="{CF8A7A84-7802-494D-BD80-EA03086C07A0}"/>
          </ac:picMkLst>
        </pc:picChg>
        <pc:picChg chg="mod">
          <ac:chgData name="Manasweeta Angane" userId="05da2731-9352-4b35-b713-60351f56afbd" providerId="ADAL" clId="{F5F97842-A295-4F9F-B89B-A63B35E1C32D}" dt="2022-10-09T14:54:54.036" v="1010"/>
          <ac:picMkLst>
            <pc:docMk/>
            <pc:sldMk cId="3114086462" sldId="288"/>
            <ac:picMk id="11" creationId="{887A3BD3-F138-4F25-AEB0-BDECF9ECE25B}"/>
          </ac:picMkLst>
        </pc:picChg>
        <pc:picChg chg="mod">
          <ac:chgData name="Manasweeta Angane" userId="05da2731-9352-4b35-b713-60351f56afbd" providerId="ADAL" clId="{F5F97842-A295-4F9F-B89B-A63B35E1C32D}" dt="2022-10-09T14:54:54.036" v="1010"/>
          <ac:picMkLst>
            <pc:docMk/>
            <pc:sldMk cId="3114086462" sldId="288"/>
            <ac:picMk id="14" creationId="{2A655362-C516-43F2-8EBF-77B3E851135A}"/>
          </ac:picMkLst>
        </pc:picChg>
        <pc:picChg chg="mod">
          <ac:chgData name="Manasweeta Angane" userId="05da2731-9352-4b35-b713-60351f56afbd" providerId="ADAL" clId="{F5F97842-A295-4F9F-B89B-A63B35E1C32D}" dt="2022-10-09T14:54:54.036" v="1010"/>
          <ac:picMkLst>
            <pc:docMk/>
            <pc:sldMk cId="3114086462" sldId="288"/>
            <ac:picMk id="15" creationId="{C3BC8E67-E939-4900-A214-5BF1137A32A4}"/>
          </ac:picMkLst>
        </pc:picChg>
      </pc:sldChg>
      <pc:sldChg chg="addSp delSp modSp add mod modTransition modAnim">
        <pc:chgData name="Manasweeta Angane" userId="05da2731-9352-4b35-b713-60351f56afbd" providerId="ADAL" clId="{F5F97842-A295-4F9F-B89B-A63B35E1C32D}" dt="2022-10-22T06:58:56.299" v="20933" actId="1035"/>
        <pc:sldMkLst>
          <pc:docMk/>
          <pc:sldMk cId="1953099216" sldId="289"/>
        </pc:sldMkLst>
        <pc:spChg chg="add mod">
          <ac:chgData name="Manasweeta Angane" userId="05da2731-9352-4b35-b713-60351f56afbd" providerId="ADAL" clId="{F5F97842-A295-4F9F-B89B-A63B35E1C32D}" dt="2022-10-10T03:27:16.618" v="2726" actId="1035"/>
          <ac:spMkLst>
            <pc:docMk/>
            <pc:sldMk cId="1953099216" sldId="289"/>
            <ac:spMk id="13" creationId="{92F2CB15-6FE9-452C-B9E1-50D0BA10C698}"/>
          </ac:spMkLst>
        </pc:spChg>
        <pc:spChg chg="add mod">
          <ac:chgData name="Manasweeta Angane" userId="05da2731-9352-4b35-b713-60351f56afbd" providerId="ADAL" clId="{F5F97842-A295-4F9F-B89B-A63B35E1C32D}" dt="2022-10-22T06:58:56.299" v="20933" actId="1035"/>
          <ac:spMkLst>
            <pc:docMk/>
            <pc:sldMk cId="1953099216" sldId="289"/>
            <ac:spMk id="14" creationId="{A859DC6D-2729-4536-94D1-92728E265192}"/>
          </ac:spMkLst>
        </pc:spChg>
        <pc:spChg chg="add mod">
          <ac:chgData name="Manasweeta Angane" userId="05da2731-9352-4b35-b713-60351f56afbd" providerId="ADAL" clId="{F5F97842-A295-4F9F-B89B-A63B35E1C32D}" dt="2022-10-22T06:58:49.243" v="20910" actId="1036"/>
          <ac:spMkLst>
            <pc:docMk/>
            <pc:sldMk cId="1953099216" sldId="289"/>
            <ac:spMk id="15" creationId="{F79A7B21-56E8-4D45-8A21-3453BC8D2143}"/>
          </ac:spMkLst>
        </pc:spChg>
        <pc:spChg chg="add mod">
          <ac:chgData name="Manasweeta Angane" userId="05da2731-9352-4b35-b713-60351f56afbd" providerId="ADAL" clId="{F5F97842-A295-4F9F-B89B-A63B35E1C32D}" dt="2022-10-10T03:30:48.113" v="2790" actId="1038"/>
          <ac:spMkLst>
            <pc:docMk/>
            <pc:sldMk cId="1953099216" sldId="289"/>
            <ac:spMk id="16" creationId="{C26E4E70-6B6D-461B-A1DB-C5F42F1E72B9}"/>
          </ac:spMkLst>
        </pc:spChg>
        <pc:spChg chg="del">
          <ac:chgData name="Manasweeta Angane" userId="05da2731-9352-4b35-b713-60351f56afbd" providerId="ADAL" clId="{F5F97842-A295-4F9F-B89B-A63B35E1C32D}" dt="2022-10-10T03:23:31.788" v="2653" actId="478"/>
          <ac:spMkLst>
            <pc:docMk/>
            <pc:sldMk cId="1953099216" sldId="289"/>
            <ac:spMk id="17" creationId="{8DB771DF-C627-44BB-8716-44C80EF9D83F}"/>
          </ac:spMkLst>
        </pc:spChg>
        <pc:spChg chg="del">
          <ac:chgData name="Manasweeta Angane" userId="05da2731-9352-4b35-b713-60351f56afbd" providerId="ADAL" clId="{F5F97842-A295-4F9F-B89B-A63B35E1C32D}" dt="2022-10-10T03:23:28.617" v="2652" actId="478"/>
          <ac:spMkLst>
            <pc:docMk/>
            <pc:sldMk cId="1953099216" sldId="289"/>
            <ac:spMk id="18" creationId="{45F2BEED-A6BE-45AE-BED7-62E52E5E5868}"/>
          </ac:spMkLst>
        </pc:spChg>
        <pc:picChg chg="add mod">
          <ac:chgData name="Manasweeta Angane" userId="05da2731-9352-4b35-b713-60351f56afbd" providerId="ADAL" clId="{F5F97842-A295-4F9F-B89B-A63B35E1C32D}" dt="2022-10-22T06:58:33.707" v="20891" actId="1036"/>
          <ac:picMkLst>
            <pc:docMk/>
            <pc:sldMk cId="1953099216" sldId="289"/>
            <ac:picMk id="9" creationId="{2813D886-29CB-4A3D-B5E9-8F2690276BD7}"/>
          </ac:picMkLst>
        </pc:picChg>
        <pc:picChg chg="add mod">
          <ac:chgData name="Manasweeta Angane" userId="05da2731-9352-4b35-b713-60351f56afbd" providerId="ADAL" clId="{F5F97842-A295-4F9F-B89B-A63B35E1C32D}" dt="2022-10-10T03:24:43.019" v="2659"/>
          <ac:picMkLst>
            <pc:docMk/>
            <pc:sldMk cId="1953099216" sldId="289"/>
            <ac:picMk id="10" creationId="{67C5C4FE-393E-4488-80FE-7991250FDD2B}"/>
          </ac:picMkLst>
        </pc:picChg>
        <pc:picChg chg="add mod">
          <ac:chgData name="Manasweeta Angane" userId="05da2731-9352-4b35-b713-60351f56afbd" providerId="ADAL" clId="{F5F97842-A295-4F9F-B89B-A63B35E1C32D}" dt="2022-10-10T03:24:43.019" v="2659"/>
          <ac:picMkLst>
            <pc:docMk/>
            <pc:sldMk cId="1953099216" sldId="289"/>
            <ac:picMk id="11" creationId="{F33FEFC2-C582-4FE3-95FE-7DE6975F9951}"/>
          </ac:picMkLst>
        </pc:picChg>
        <pc:picChg chg="add del mod">
          <ac:chgData name="Manasweeta Angane" userId="05da2731-9352-4b35-b713-60351f56afbd" providerId="ADAL" clId="{F5F97842-A295-4F9F-B89B-A63B35E1C32D}" dt="2022-10-10T03:25:18.602" v="2661"/>
          <ac:picMkLst>
            <pc:docMk/>
            <pc:sldMk cId="1953099216" sldId="289"/>
            <ac:picMk id="12" creationId="{62AB9D5D-03C4-4165-B732-D960E932F387}"/>
          </ac:picMkLst>
        </pc:picChg>
      </pc:sldChg>
      <pc:sldChg chg="addSp delSp modSp add mod modTransition modAnim">
        <pc:chgData name="Manasweeta Angane" userId="05da2731-9352-4b35-b713-60351f56afbd" providerId="ADAL" clId="{F5F97842-A295-4F9F-B89B-A63B35E1C32D}" dt="2022-10-11T12:29:51.494" v="6590" actId="12789"/>
        <pc:sldMkLst>
          <pc:docMk/>
          <pc:sldMk cId="1953356484" sldId="290"/>
        </pc:sldMkLst>
        <pc:spChg chg="add mod">
          <ac:chgData name="Manasweeta Angane" userId="05da2731-9352-4b35-b713-60351f56afbd" providerId="ADAL" clId="{F5F97842-A295-4F9F-B89B-A63B35E1C32D}" dt="2022-10-11T12:28:22.619" v="6584" actId="12789"/>
          <ac:spMkLst>
            <pc:docMk/>
            <pc:sldMk cId="1953356484" sldId="290"/>
            <ac:spMk id="9" creationId="{E82D2DE3-65BE-438A-BA63-F9357C37226B}"/>
          </ac:spMkLst>
        </pc:spChg>
        <pc:spChg chg="add del mod">
          <ac:chgData name="Manasweeta Angane" userId="05da2731-9352-4b35-b713-60351f56afbd" providerId="ADAL" clId="{F5F97842-A295-4F9F-B89B-A63B35E1C32D}" dt="2022-10-10T08:40:18.466" v="3009"/>
          <ac:spMkLst>
            <pc:docMk/>
            <pc:sldMk cId="1953356484" sldId="290"/>
            <ac:spMk id="13" creationId="{D50E8EB8-01BE-40B5-9F9E-F5A1429E842D}"/>
          </ac:spMkLst>
        </pc:spChg>
        <pc:spChg chg="add mod">
          <ac:chgData name="Manasweeta Angane" userId="05da2731-9352-4b35-b713-60351f56afbd" providerId="ADAL" clId="{F5F97842-A295-4F9F-B89B-A63B35E1C32D}" dt="2022-10-10T08:43:09.263" v="3021" actId="12789"/>
          <ac:spMkLst>
            <pc:docMk/>
            <pc:sldMk cId="1953356484" sldId="290"/>
            <ac:spMk id="14" creationId="{0DABDE25-6706-4F92-B530-52E5212FA2CC}"/>
          </ac:spMkLst>
        </pc:spChg>
        <pc:spChg chg="del">
          <ac:chgData name="Manasweeta Angane" userId="05da2731-9352-4b35-b713-60351f56afbd" providerId="ADAL" clId="{F5F97842-A295-4F9F-B89B-A63B35E1C32D}" dt="2022-10-10T08:37:20.463" v="2979" actId="478"/>
          <ac:spMkLst>
            <pc:docMk/>
            <pc:sldMk cId="1953356484" sldId="290"/>
            <ac:spMk id="17" creationId="{8DB771DF-C627-44BB-8716-44C80EF9D83F}"/>
          </ac:spMkLst>
        </pc:spChg>
        <pc:spChg chg="mod">
          <ac:chgData name="Manasweeta Angane" userId="05da2731-9352-4b35-b713-60351f56afbd" providerId="ADAL" clId="{F5F97842-A295-4F9F-B89B-A63B35E1C32D}" dt="2022-10-11T12:29:51.494" v="6590" actId="12789"/>
          <ac:spMkLst>
            <pc:docMk/>
            <pc:sldMk cId="1953356484" sldId="290"/>
            <ac:spMk id="18" creationId="{45F2BEED-A6BE-45AE-BED7-62E52E5E5868}"/>
          </ac:spMkLst>
        </pc:spChg>
        <pc:picChg chg="add mod">
          <ac:chgData name="Manasweeta Angane" userId="05da2731-9352-4b35-b713-60351f56afbd" providerId="ADAL" clId="{F5F97842-A295-4F9F-B89B-A63B35E1C32D}" dt="2022-10-11T12:28:34.535" v="6585" actId="1076"/>
          <ac:picMkLst>
            <pc:docMk/>
            <pc:sldMk cId="1953356484" sldId="290"/>
            <ac:picMk id="10" creationId="{998B70E0-BB2F-45B0-84B8-499A7FB4BDD6}"/>
          </ac:picMkLst>
        </pc:picChg>
        <pc:picChg chg="add mod">
          <ac:chgData name="Manasweeta Angane" userId="05da2731-9352-4b35-b713-60351f56afbd" providerId="ADAL" clId="{F5F97842-A295-4F9F-B89B-A63B35E1C32D}" dt="2022-10-11T12:28:42.965" v="6587" actId="1076"/>
          <ac:picMkLst>
            <pc:docMk/>
            <pc:sldMk cId="1953356484" sldId="290"/>
            <ac:picMk id="11" creationId="{58C5010A-4A14-435F-A343-6D955C65F9E3}"/>
          </ac:picMkLst>
        </pc:picChg>
        <pc:picChg chg="add mod">
          <ac:chgData name="Manasweeta Angane" userId="05da2731-9352-4b35-b713-60351f56afbd" providerId="ADAL" clId="{F5F97842-A295-4F9F-B89B-A63B35E1C32D}" dt="2022-10-11T12:28:38.310" v="6586" actId="1076"/>
          <ac:picMkLst>
            <pc:docMk/>
            <pc:sldMk cId="1953356484" sldId="290"/>
            <ac:picMk id="12" creationId="{7BBFFF3C-2C0B-4153-BA4C-F1C7027694D2}"/>
          </ac:picMkLst>
        </pc:picChg>
        <pc:picChg chg="add mod">
          <ac:chgData name="Manasweeta Angane" userId="05da2731-9352-4b35-b713-60351f56afbd" providerId="ADAL" clId="{F5F97842-A295-4F9F-B89B-A63B35E1C32D}" dt="2022-10-10T09:01:08.658" v="3022"/>
          <ac:picMkLst>
            <pc:docMk/>
            <pc:sldMk cId="1953356484" sldId="290"/>
            <ac:picMk id="15" creationId="{17C185FB-019D-4BDF-8A85-013DB7CCD9DA}"/>
          </ac:picMkLst>
        </pc:picChg>
        <pc:picChg chg="add mod">
          <ac:chgData name="Manasweeta Angane" userId="05da2731-9352-4b35-b713-60351f56afbd" providerId="ADAL" clId="{F5F97842-A295-4F9F-B89B-A63B35E1C32D}" dt="2022-10-10T09:01:08.658" v="3022"/>
          <ac:picMkLst>
            <pc:docMk/>
            <pc:sldMk cId="1953356484" sldId="290"/>
            <ac:picMk id="16" creationId="{7B658784-A069-47B9-ADBA-5DE80F3D8F22}"/>
          </ac:picMkLst>
        </pc:picChg>
      </pc:sldChg>
      <pc:sldChg chg="addSp delSp modSp add mod ord delAnim modAnim">
        <pc:chgData name="Manasweeta Angane" userId="05da2731-9352-4b35-b713-60351f56afbd" providerId="ADAL" clId="{F5F97842-A295-4F9F-B89B-A63B35E1C32D}" dt="2022-10-10T08:31:15.371" v="2903"/>
        <pc:sldMkLst>
          <pc:docMk/>
          <pc:sldMk cId="2272868319" sldId="291"/>
        </pc:sldMkLst>
        <pc:spChg chg="mod">
          <ac:chgData name="Manasweeta Angane" userId="05da2731-9352-4b35-b713-60351f56afbd" providerId="ADAL" clId="{F5F97842-A295-4F9F-B89B-A63B35E1C32D}" dt="2022-10-10T08:30:20.027" v="2795"/>
          <ac:spMkLst>
            <pc:docMk/>
            <pc:sldMk cId="2272868319" sldId="291"/>
            <ac:spMk id="25" creationId="{9D663F19-4E9B-4EDE-9CB1-2C44D62BD0B7}"/>
          </ac:spMkLst>
        </pc:spChg>
        <pc:spChg chg="mod">
          <ac:chgData name="Manasweeta Angane" userId="05da2731-9352-4b35-b713-60351f56afbd" providerId="ADAL" clId="{F5F97842-A295-4F9F-B89B-A63B35E1C32D}" dt="2022-10-10T08:30:20.027" v="2795"/>
          <ac:spMkLst>
            <pc:docMk/>
            <pc:sldMk cId="2272868319" sldId="291"/>
            <ac:spMk id="26" creationId="{F32E4CFB-D464-44DB-BC49-600F34646103}"/>
          </ac:spMkLst>
        </pc:spChg>
        <pc:spChg chg="del">
          <ac:chgData name="Manasweeta Angane" userId="05da2731-9352-4b35-b713-60351f56afbd" providerId="ADAL" clId="{F5F97842-A295-4F9F-B89B-A63B35E1C32D}" dt="2022-10-10T08:29:57.357" v="2792" actId="478"/>
          <ac:spMkLst>
            <pc:docMk/>
            <pc:sldMk cId="2272868319" sldId="291"/>
            <ac:spMk id="41" creationId="{91AA073D-4FE5-4A25-9CA5-BE7F86CF821C}"/>
          </ac:spMkLst>
        </pc:spChg>
        <pc:spChg chg="mod">
          <ac:chgData name="Manasweeta Angane" userId="05da2731-9352-4b35-b713-60351f56afbd" providerId="ADAL" clId="{F5F97842-A295-4F9F-B89B-A63B35E1C32D}" dt="2022-10-10T08:30:20.027" v="2795"/>
          <ac:spMkLst>
            <pc:docMk/>
            <pc:sldMk cId="2272868319" sldId="291"/>
            <ac:spMk id="53" creationId="{8ABDA12D-608D-4A8C-BD65-27061222AAE0}"/>
          </ac:spMkLst>
        </pc:spChg>
        <pc:spChg chg="mod">
          <ac:chgData name="Manasweeta Angane" userId="05da2731-9352-4b35-b713-60351f56afbd" providerId="ADAL" clId="{F5F97842-A295-4F9F-B89B-A63B35E1C32D}" dt="2022-10-10T08:30:20.027" v="2795"/>
          <ac:spMkLst>
            <pc:docMk/>
            <pc:sldMk cId="2272868319" sldId="291"/>
            <ac:spMk id="54" creationId="{4511AFC5-6CE0-4CCD-9F66-68A3173E9820}"/>
          </ac:spMkLst>
        </pc:spChg>
        <pc:spChg chg="mod">
          <ac:chgData name="Manasweeta Angane" userId="05da2731-9352-4b35-b713-60351f56afbd" providerId="ADAL" clId="{F5F97842-A295-4F9F-B89B-A63B35E1C32D}" dt="2022-10-10T08:30:20.027" v="2795"/>
          <ac:spMkLst>
            <pc:docMk/>
            <pc:sldMk cId="2272868319" sldId="291"/>
            <ac:spMk id="58" creationId="{DB6675B2-6ED9-4E08-93D3-92ED23154725}"/>
          </ac:spMkLst>
        </pc:spChg>
        <pc:spChg chg="mod">
          <ac:chgData name="Manasweeta Angane" userId="05da2731-9352-4b35-b713-60351f56afbd" providerId="ADAL" clId="{F5F97842-A295-4F9F-B89B-A63B35E1C32D}" dt="2022-10-10T08:30:20.027" v="2795"/>
          <ac:spMkLst>
            <pc:docMk/>
            <pc:sldMk cId="2272868319" sldId="291"/>
            <ac:spMk id="59" creationId="{4B13FC94-ED66-4145-80A5-A611C5FAC346}"/>
          </ac:spMkLst>
        </pc:spChg>
        <pc:spChg chg="mod">
          <ac:chgData name="Manasweeta Angane" userId="05da2731-9352-4b35-b713-60351f56afbd" providerId="ADAL" clId="{F5F97842-A295-4F9F-B89B-A63B35E1C32D}" dt="2022-10-10T08:30:20.027" v="2795"/>
          <ac:spMkLst>
            <pc:docMk/>
            <pc:sldMk cId="2272868319" sldId="291"/>
            <ac:spMk id="60" creationId="{1F126CC1-6223-42EA-9F4A-BD6C09D81810}"/>
          </ac:spMkLst>
        </pc:spChg>
        <pc:spChg chg="mod">
          <ac:chgData name="Manasweeta Angane" userId="05da2731-9352-4b35-b713-60351f56afbd" providerId="ADAL" clId="{F5F97842-A295-4F9F-B89B-A63B35E1C32D}" dt="2022-10-10T08:30:20.027" v="2795"/>
          <ac:spMkLst>
            <pc:docMk/>
            <pc:sldMk cId="2272868319" sldId="291"/>
            <ac:spMk id="61" creationId="{F33D950E-5732-4088-9586-19EA45CA8E05}"/>
          </ac:spMkLst>
        </pc:spChg>
        <pc:spChg chg="mod">
          <ac:chgData name="Manasweeta Angane" userId="05da2731-9352-4b35-b713-60351f56afbd" providerId="ADAL" clId="{F5F97842-A295-4F9F-B89B-A63B35E1C32D}" dt="2022-10-10T08:30:20.027" v="2795"/>
          <ac:spMkLst>
            <pc:docMk/>
            <pc:sldMk cId="2272868319" sldId="291"/>
            <ac:spMk id="62" creationId="{466202A8-A2D0-44FD-9BFE-260D94962A32}"/>
          </ac:spMkLst>
        </pc:spChg>
        <pc:spChg chg="mod">
          <ac:chgData name="Manasweeta Angane" userId="05da2731-9352-4b35-b713-60351f56afbd" providerId="ADAL" clId="{F5F97842-A295-4F9F-B89B-A63B35E1C32D}" dt="2022-10-10T08:30:20.027" v="2795"/>
          <ac:spMkLst>
            <pc:docMk/>
            <pc:sldMk cId="2272868319" sldId="291"/>
            <ac:spMk id="63" creationId="{11E23F01-7784-4450-A9E7-D0BF4354189A}"/>
          </ac:spMkLst>
        </pc:spChg>
        <pc:spChg chg="mod">
          <ac:chgData name="Manasweeta Angane" userId="05da2731-9352-4b35-b713-60351f56afbd" providerId="ADAL" clId="{F5F97842-A295-4F9F-B89B-A63B35E1C32D}" dt="2022-10-10T08:30:20.027" v="2795"/>
          <ac:spMkLst>
            <pc:docMk/>
            <pc:sldMk cId="2272868319" sldId="291"/>
            <ac:spMk id="64" creationId="{B98F28FE-35E3-4318-9058-26C0A5C20F6B}"/>
          </ac:spMkLst>
        </pc:spChg>
        <pc:spChg chg="mod">
          <ac:chgData name="Manasweeta Angane" userId="05da2731-9352-4b35-b713-60351f56afbd" providerId="ADAL" clId="{F5F97842-A295-4F9F-B89B-A63B35E1C32D}" dt="2022-10-10T08:30:20.027" v="2795"/>
          <ac:spMkLst>
            <pc:docMk/>
            <pc:sldMk cId="2272868319" sldId="291"/>
            <ac:spMk id="65" creationId="{7698A058-D0FF-4A5A-96D0-E9AFDF606665}"/>
          </ac:spMkLst>
        </pc:spChg>
        <pc:spChg chg="mod">
          <ac:chgData name="Manasweeta Angane" userId="05da2731-9352-4b35-b713-60351f56afbd" providerId="ADAL" clId="{F5F97842-A295-4F9F-B89B-A63B35E1C32D}" dt="2022-10-10T08:30:20.027" v="2795"/>
          <ac:spMkLst>
            <pc:docMk/>
            <pc:sldMk cId="2272868319" sldId="291"/>
            <ac:spMk id="66" creationId="{7D603E5B-8A42-4F80-B28D-1154D4521FED}"/>
          </ac:spMkLst>
        </pc:spChg>
        <pc:spChg chg="mod">
          <ac:chgData name="Manasweeta Angane" userId="05da2731-9352-4b35-b713-60351f56afbd" providerId="ADAL" clId="{F5F97842-A295-4F9F-B89B-A63B35E1C32D}" dt="2022-10-10T08:30:20.027" v="2795"/>
          <ac:spMkLst>
            <pc:docMk/>
            <pc:sldMk cId="2272868319" sldId="291"/>
            <ac:spMk id="67" creationId="{27004B55-C4DC-40C9-8DE8-7EAE76FF7D9C}"/>
          </ac:spMkLst>
        </pc:spChg>
        <pc:grpChg chg="add mod">
          <ac:chgData name="Manasweeta Angane" userId="05da2731-9352-4b35-b713-60351f56afbd" providerId="ADAL" clId="{F5F97842-A295-4F9F-B89B-A63B35E1C32D}" dt="2022-10-10T08:30:41.183" v="2901" actId="1038"/>
          <ac:grpSpMkLst>
            <pc:docMk/>
            <pc:sldMk cId="2272868319" sldId="291"/>
            <ac:grpSpMk id="24" creationId="{3DC69D65-A246-4E16-B66D-EF209448649D}"/>
          </ac:grpSpMkLst>
        </pc:grpChg>
        <pc:grpChg chg="add mod">
          <ac:chgData name="Manasweeta Angane" userId="05da2731-9352-4b35-b713-60351f56afbd" providerId="ADAL" clId="{F5F97842-A295-4F9F-B89B-A63B35E1C32D}" dt="2022-10-10T08:30:41.183" v="2901" actId="1038"/>
          <ac:grpSpMkLst>
            <pc:docMk/>
            <pc:sldMk cId="2272868319" sldId="291"/>
            <ac:grpSpMk id="27" creationId="{8047749D-D76B-4843-9940-B56976D6C33C}"/>
          </ac:grpSpMkLst>
        </pc:grpChg>
        <pc:grpChg chg="mod">
          <ac:chgData name="Manasweeta Angane" userId="05da2731-9352-4b35-b713-60351f56afbd" providerId="ADAL" clId="{F5F97842-A295-4F9F-B89B-A63B35E1C32D}" dt="2022-10-10T08:30:20.027" v="2795"/>
          <ac:grpSpMkLst>
            <pc:docMk/>
            <pc:sldMk cId="2272868319" sldId="291"/>
            <ac:grpSpMk id="30" creationId="{FF1AF661-E6CF-4250-AF45-1DB9FBE00FA9}"/>
          </ac:grpSpMkLst>
        </pc:grpChg>
        <pc:grpChg chg="del">
          <ac:chgData name="Manasweeta Angane" userId="05da2731-9352-4b35-b713-60351f56afbd" providerId="ADAL" clId="{F5F97842-A295-4F9F-B89B-A63B35E1C32D}" dt="2022-10-10T08:30:00.276" v="2794" actId="478"/>
          <ac:grpSpMkLst>
            <pc:docMk/>
            <pc:sldMk cId="2272868319" sldId="291"/>
            <ac:grpSpMk id="34" creationId="{C50DAA6D-DE9A-4E89-9B83-FAC064F77BA3}"/>
          </ac:grpSpMkLst>
        </pc:grpChg>
        <pc:grpChg chg="del">
          <ac:chgData name="Manasweeta Angane" userId="05da2731-9352-4b35-b713-60351f56afbd" providerId="ADAL" clId="{F5F97842-A295-4F9F-B89B-A63B35E1C32D}" dt="2022-10-10T08:29:58.668" v="2793" actId="478"/>
          <ac:grpSpMkLst>
            <pc:docMk/>
            <pc:sldMk cId="2272868319" sldId="291"/>
            <ac:grpSpMk id="46" creationId="{13F5FB98-C3CC-4F16-AC84-000CEE901D0C}"/>
          </ac:grpSpMkLst>
        </pc:grpChg>
        <pc:grpChg chg="add mod">
          <ac:chgData name="Manasweeta Angane" userId="05da2731-9352-4b35-b713-60351f56afbd" providerId="ADAL" clId="{F5F97842-A295-4F9F-B89B-A63B35E1C32D}" dt="2022-10-10T08:30:41.183" v="2901" actId="1038"/>
          <ac:grpSpMkLst>
            <pc:docMk/>
            <pc:sldMk cId="2272868319" sldId="291"/>
            <ac:grpSpMk id="55" creationId="{0BFFDF22-7445-46A6-A2FD-18BC1E207A55}"/>
          </ac:grpSpMkLst>
        </pc:grpChg>
        <pc:grpChg chg="mod">
          <ac:chgData name="Manasweeta Angane" userId="05da2731-9352-4b35-b713-60351f56afbd" providerId="ADAL" clId="{F5F97842-A295-4F9F-B89B-A63B35E1C32D}" dt="2022-10-10T08:30:20.027" v="2795"/>
          <ac:grpSpMkLst>
            <pc:docMk/>
            <pc:sldMk cId="2272868319" sldId="291"/>
            <ac:grpSpMk id="56" creationId="{DB41BD5F-76A9-4DBB-AA5E-F560B4CA6989}"/>
          </ac:grpSpMkLst>
        </pc:grpChg>
        <pc:grpChg chg="mod">
          <ac:chgData name="Manasweeta Angane" userId="05da2731-9352-4b35-b713-60351f56afbd" providerId="ADAL" clId="{F5F97842-A295-4F9F-B89B-A63B35E1C32D}" dt="2022-10-10T08:30:20.027" v="2795"/>
          <ac:grpSpMkLst>
            <pc:docMk/>
            <pc:sldMk cId="2272868319" sldId="291"/>
            <ac:grpSpMk id="57" creationId="{55A309E3-E446-4EC0-A107-69AE3E42530B}"/>
          </ac:grpSpMkLst>
        </pc:grpChg>
        <pc:cxnChg chg="mod">
          <ac:chgData name="Manasweeta Angane" userId="05da2731-9352-4b35-b713-60351f56afbd" providerId="ADAL" clId="{F5F97842-A295-4F9F-B89B-A63B35E1C32D}" dt="2022-10-10T08:30:20.027" v="2795"/>
          <ac:cxnSpMkLst>
            <pc:docMk/>
            <pc:sldMk cId="2272868319" sldId="291"/>
            <ac:cxnSpMk id="28" creationId="{B1D0D7ED-A919-41B6-8BC0-5E8916C9DF14}"/>
          </ac:cxnSpMkLst>
        </pc:cxnChg>
        <pc:cxnChg chg="mod">
          <ac:chgData name="Manasweeta Angane" userId="05da2731-9352-4b35-b713-60351f56afbd" providerId="ADAL" clId="{F5F97842-A295-4F9F-B89B-A63B35E1C32D}" dt="2022-10-10T08:30:20.027" v="2795"/>
          <ac:cxnSpMkLst>
            <pc:docMk/>
            <pc:sldMk cId="2272868319" sldId="291"/>
            <ac:cxnSpMk id="29" creationId="{A763318C-885E-4551-A339-FD2A9AA66061}"/>
          </ac:cxnSpMkLst>
        </pc:cxnChg>
        <pc:cxnChg chg="mod">
          <ac:chgData name="Manasweeta Angane" userId="05da2731-9352-4b35-b713-60351f56afbd" providerId="ADAL" clId="{F5F97842-A295-4F9F-B89B-A63B35E1C32D}" dt="2022-10-10T08:30:20.027" v="2795"/>
          <ac:cxnSpMkLst>
            <pc:docMk/>
            <pc:sldMk cId="2272868319" sldId="291"/>
            <ac:cxnSpMk id="31" creationId="{3A3348FF-14F2-464B-9B91-CF1393DBDC42}"/>
          </ac:cxnSpMkLst>
        </pc:cxnChg>
        <pc:cxnChg chg="mod">
          <ac:chgData name="Manasweeta Angane" userId="05da2731-9352-4b35-b713-60351f56afbd" providerId="ADAL" clId="{F5F97842-A295-4F9F-B89B-A63B35E1C32D}" dt="2022-10-10T08:30:20.027" v="2795"/>
          <ac:cxnSpMkLst>
            <pc:docMk/>
            <pc:sldMk cId="2272868319" sldId="291"/>
            <ac:cxnSpMk id="32" creationId="{83BCC8A7-7FBC-4D4D-AC37-5B956577FF7D}"/>
          </ac:cxnSpMkLst>
        </pc:cxnChg>
        <pc:cxnChg chg="mod">
          <ac:chgData name="Manasweeta Angane" userId="05da2731-9352-4b35-b713-60351f56afbd" providerId="ADAL" clId="{F5F97842-A295-4F9F-B89B-A63B35E1C32D}" dt="2022-10-10T08:30:20.027" v="2795"/>
          <ac:cxnSpMkLst>
            <pc:docMk/>
            <pc:sldMk cId="2272868319" sldId="291"/>
            <ac:cxnSpMk id="33" creationId="{86975DA6-9F70-45A6-8B87-5F57095E5E8C}"/>
          </ac:cxnSpMkLst>
        </pc:cxnChg>
        <pc:cxnChg chg="mod">
          <ac:chgData name="Manasweeta Angane" userId="05da2731-9352-4b35-b713-60351f56afbd" providerId="ADAL" clId="{F5F97842-A295-4F9F-B89B-A63B35E1C32D}" dt="2022-10-10T08:30:20.027" v="2795"/>
          <ac:cxnSpMkLst>
            <pc:docMk/>
            <pc:sldMk cId="2272868319" sldId="291"/>
            <ac:cxnSpMk id="48" creationId="{D57F2689-9534-46F5-8177-923B775FDF08}"/>
          </ac:cxnSpMkLst>
        </pc:cxnChg>
        <pc:cxnChg chg="mod">
          <ac:chgData name="Manasweeta Angane" userId="05da2731-9352-4b35-b713-60351f56afbd" providerId="ADAL" clId="{F5F97842-A295-4F9F-B89B-A63B35E1C32D}" dt="2022-10-10T08:30:20.027" v="2795"/>
          <ac:cxnSpMkLst>
            <pc:docMk/>
            <pc:sldMk cId="2272868319" sldId="291"/>
            <ac:cxnSpMk id="51" creationId="{877A2BD2-F18A-4772-9DC9-7277381BBBEF}"/>
          </ac:cxnSpMkLst>
        </pc:cxnChg>
        <pc:cxnChg chg="mod">
          <ac:chgData name="Manasweeta Angane" userId="05da2731-9352-4b35-b713-60351f56afbd" providerId="ADAL" clId="{F5F97842-A295-4F9F-B89B-A63B35E1C32D}" dt="2022-10-10T08:30:20.027" v="2795"/>
          <ac:cxnSpMkLst>
            <pc:docMk/>
            <pc:sldMk cId="2272868319" sldId="291"/>
            <ac:cxnSpMk id="52" creationId="{98EF0CD3-9357-4ED2-A5AA-92CBBF8CE270}"/>
          </ac:cxnSpMkLst>
        </pc:cxnChg>
      </pc:sldChg>
      <pc:sldChg chg="addSp delSp modSp add mod ord modAnim">
        <pc:chgData name="Manasweeta Angane" userId="05da2731-9352-4b35-b713-60351f56afbd" providerId="ADAL" clId="{F5F97842-A295-4F9F-B89B-A63B35E1C32D}" dt="2022-10-21T04:49:32.760" v="13250"/>
        <pc:sldMkLst>
          <pc:docMk/>
          <pc:sldMk cId="2092801620" sldId="292"/>
        </pc:sldMkLst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14" creationId="{0C626F31-067F-4827-9214-14D4A64EB86B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15" creationId="{D79075E2-8424-4928-AADB-7F0DEEB0F87A}"/>
          </ac:spMkLst>
        </pc:spChg>
        <pc:spChg chg="del">
          <ac:chgData name="Manasweeta Angane" userId="05da2731-9352-4b35-b713-60351f56afbd" providerId="ADAL" clId="{F5F97842-A295-4F9F-B89B-A63B35E1C32D}" dt="2022-10-10T09:13:51.316" v="3064" actId="478"/>
          <ac:spMkLst>
            <pc:docMk/>
            <pc:sldMk cId="2092801620" sldId="292"/>
            <ac:spMk id="17" creationId="{8DB771DF-C627-44BB-8716-44C80EF9D83F}"/>
          </ac:spMkLst>
        </pc:spChg>
        <pc:spChg chg="mod">
          <ac:chgData name="Manasweeta Angane" userId="05da2731-9352-4b35-b713-60351f56afbd" providerId="ADAL" clId="{F5F97842-A295-4F9F-B89B-A63B35E1C32D}" dt="2022-10-10T11:42:56.039" v="3852" actId="20577"/>
          <ac:spMkLst>
            <pc:docMk/>
            <pc:sldMk cId="2092801620" sldId="292"/>
            <ac:spMk id="18" creationId="{45F2BEED-A6BE-45AE-BED7-62E52E5E5868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19" creationId="{FFD92B4A-12BD-4320-844C-60EC269E27A2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25" creationId="{39CC4811-C17A-44FC-9C0F-2C9CC8CE130B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26" creationId="{19A15380-0A02-4C3F-8A67-A310233551A5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27" creationId="{77488D01-9112-4A79-8409-23B41891E39F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28" creationId="{43EAEF57-E54E-4C61-8E5B-35FA3614F381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30" creationId="{EE860F3C-F5D2-4541-8B69-4453FD454AAD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32" creationId="{5ADEAAE5-55A8-4A08-83D3-D3138E84B571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34" creationId="{347428DE-7F30-4660-BF87-C79920B935C5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38" creationId="{77CB3A54-6ECD-4562-8042-877135B42577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40" creationId="{9A31B4F6-10D9-44DC-93CA-A07181203A6E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41" creationId="{410C7ED7-C880-433A-8CC5-D536AF4042BB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44" creationId="{B13656CB-9289-4904-A3FE-433BD380CCD1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45" creationId="{89CA948D-3794-48EB-9459-F2ECF2CFA159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46" creationId="{05916637-C027-44F3-AF24-3E2EC88F5F84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47" creationId="{66D0C4A3-D01E-43BB-86CC-1C936DBBE49F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48" creationId="{A6FF5E01-FA7C-4B75-ABC3-D9B750C18E12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49" creationId="{1753F4E7-BC30-49EC-BACF-05733A5CDFAA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50" creationId="{B1AD5298-4A68-4323-9680-B66E95238ABA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52" creationId="{CCE04F90-519D-48F8-8A05-56A616F5FB6B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57" creationId="{98A12F59-4FD2-4190-B1E8-42BE3BC7C93F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58" creationId="{F3EBA792-9ADD-4945-83F5-5551FC58DF79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59" creationId="{CE5A9182-506A-4D37-85C1-F920F7AAE96F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60" creationId="{B114A232-FEAE-45A4-A3A5-5C29FE6AD175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61" creationId="{F0711884-1016-42BC-9E7F-20AE1E13D927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62" creationId="{BCCE52A1-EDDF-4704-AD47-FF9C3D7B3E2B}"/>
          </ac:spMkLst>
        </pc:spChg>
        <pc:spChg chg="mod">
          <ac:chgData name="Manasweeta Angane" userId="05da2731-9352-4b35-b713-60351f56afbd" providerId="ADAL" clId="{F5F97842-A295-4F9F-B89B-A63B35E1C32D}" dt="2022-10-10T09:13:30.316" v="3060"/>
          <ac:spMkLst>
            <pc:docMk/>
            <pc:sldMk cId="2092801620" sldId="292"/>
            <ac:spMk id="63" creationId="{988F1B6B-C53B-4EFA-ACEF-3B5F39A72236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67" creationId="{4FF0B307-5E2C-40A3-BA07-1BA6D33951CE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68" creationId="{3E4857E5-D07A-4940-B212-967598081A48}"/>
          </ac:spMkLst>
        </pc:spChg>
        <pc:spChg chg="mod">
          <ac:chgData name="Manasweeta Angane" userId="05da2731-9352-4b35-b713-60351f56afbd" providerId="ADAL" clId="{F5F97842-A295-4F9F-B89B-A63B35E1C32D}" dt="2022-10-21T03:22:02.309" v="11949" actId="255"/>
          <ac:spMkLst>
            <pc:docMk/>
            <pc:sldMk cId="2092801620" sldId="292"/>
            <ac:spMk id="70" creationId="{BCC9994E-B229-4B5F-87B1-0DCBA6BD0463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76" creationId="{3F9C7559-95D5-4BFE-B1FD-EBC3461129D5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77" creationId="{ACE43024-A6B6-42A6-845C-6978C59977B0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78" creationId="{45A44F39-6B8B-4DA7-AEFB-AA6C1DB37B3F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79" creationId="{3612ADFF-B9D4-4EF8-87C7-8605E3ED60CF}"/>
          </ac:spMkLst>
        </pc:spChg>
        <pc:spChg chg="mod">
          <ac:chgData name="Manasweeta Angane" userId="05da2731-9352-4b35-b713-60351f56afbd" providerId="ADAL" clId="{F5F97842-A295-4F9F-B89B-A63B35E1C32D}" dt="2022-10-21T03:22:30.628" v="11967" actId="1037"/>
          <ac:spMkLst>
            <pc:docMk/>
            <pc:sldMk cId="2092801620" sldId="292"/>
            <ac:spMk id="81" creationId="{721040B1-31B7-4A55-B02C-52121A338FAB}"/>
          </ac:spMkLst>
        </pc:spChg>
        <pc:spChg chg="mod">
          <ac:chgData name="Manasweeta Angane" userId="05da2731-9352-4b35-b713-60351f56afbd" providerId="ADAL" clId="{F5F97842-A295-4F9F-B89B-A63B35E1C32D}" dt="2022-10-21T03:21:46.213" v="11948" actId="1035"/>
          <ac:spMkLst>
            <pc:docMk/>
            <pc:sldMk cId="2092801620" sldId="292"/>
            <ac:spMk id="83" creationId="{736C6B34-0000-4CD5-BC65-4384D653D791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85" creationId="{036C5DAD-0CF0-428C-83B2-2183F7BA73C3}"/>
          </ac:spMkLst>
        </pc:spChg>
        <pc:spChg chg="mod">
          <ac:chgData name="Manasweeta Angane" userId="05da2731-9352-4b35-b713-60351f56afbd" providerId="ADAL" clId="{F5F97842-A295-4F9F-B89B-A63B35E1C32D}" dt="2022-10-21T03:22:09.646" v="11950" actId="255"/>
          <ac:spMkLst>
            <pc:docMk/>
            <pc:sldMk cId="2092801620" sldId="292"/>
            <ac:spMk id="89" creationId="{4E2B4EAB-4970-4B11-9B53-6BB3B9ACF8B0}"/>
          </ac:spMkLst>
        </pc:spChg>
        <pc:spChg chg="mod">
          <ac:chgData name="Manasweeta Angane" userId="05da2731-9352-4b35-b713-60351f56afbd" providerId="ADAL" clId="{F5F97842-A295-4F9F-B89B-A63B35E1C32D}" dt="2022-10-21T03:22:18.838" v="11951" actId="255"/>
          <ac:spMkLst>
            <pc:docMk/>
            <pc:sldMk cId="2092801620" sldId="292"/>
            <ac:spMk id="91" creationId="{1636DA86-AA08-47A8-A50E-E5D459900F52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92" creationId="{608A71F6-48A0-4937-9362-0C77C1DCA185}"/>
          </ac:spMkLst>
        </pc:spChg>
        <pc:spChg chg="mod">
          <ac:chgData name="Manasweeta Angane" userId="05da2731-9352-4b35-b713-60351f56afbd" providerId="ADAL" clId="{F5F97842-A295-4F9F-B89B-A63B35E1C32D}" dt="2022-10-21T03:22:35.813" v="11982" actId="1035"/>
          <ac:spMkLst>
            <pc:docMk/>
            <pc:sldMk cId="2092801620" sldId="292"/>
            <ac:spMk id="95" creationId="{776DFCAA-32AD-4738-ACE8-5F13E0ED477F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96" creationId="{BEF4919A-C1E9-43C2-8F45-2AF51524185B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97" creationId="{D1F0F92E-7C27-41CD-A009-57E13D872E8F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98" creationId="{08D793F3-F547-4663-99A9-AC2DBA6C78B7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99" creationId="{7C4B0DF8-7024-45D2-BFDB-8FC087892281}"/>
          </ac:spMkLst>
        </pc:spChg>
        <pc:spChg chg="mod">
          <ac:chgData name="Manasweeta Angane" userId="05da2731-9352-4b35-b713-60351f56afbd" providerId="ADAL" clId="{F5F97842-A295-4F9F-B89B-A63B35E1C32D}" dt="2022-10-21T03:20:23.118" v="11928" actId="12788"/>
          <ac:spMkLst>
            <pc:docMk/>
            <pc:sldMk cId="2092801620" sldId="292"/>
            <ac:spMk id="100" creationId="{E69D69E4-4D32-403A-B38A-A6EAFC647D3C}"/>
          </ac:spMkLst>
        </pc:spChg>
        <pc:spChg chg="mod">
          <ac:chgData name="Manasweeta Angane" userId="05da2731-9352-4b35-b713-60351f56afbd" providerId="ADAL" clId="{F5F97842-A295-4F9F-B89B-A63B35E1C32D}" dt="2022-10-21T03:20:23.118" v="11928" actId="12788"/>
          <ac:spMkLst>
            <pc:docMk/>
            <pc:sldMk cId="2092801620" sldId="292"/>
            <ac:spMk id="101" creationId="{759E44FE-2F5D-41ED-8054-902853101961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103" creationId="{85DCC42E-D0EA-4FD9-AAEB-15A1F6079657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108" creationId="{88D1C83C-B3CF-4D58-BECF-CC7ABA817E00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109" creationId="{F027FCD6-DE9D-4ABF-98E9-32D485F8E90B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110" creationId="{1E27A70F-BF8E-424C-9E58-4CDB0C0F9DC3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111" creationId="{911613FC-D6C0-468F-B177-42594B116600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112" creationId="{5A7269C2-4C0A-4FBD-9029-6B98BC9711FE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113" creationId="{D9632E54-DF64-4B30-B5E6-B4CE120A505D}"/>
          </ac:spMkLst>
        </pc:spChg>
        <pc:spChg chg="mod">
          <ac:chgData name="Manasweeta Angane" userId="05da2731-9352-4b35-b713-60351f56afbd" providerId="ADAL" clId="{F5F97842-A295-4F9F-B89B-A63B35E1C32D}" dt="2022-10-10T09:13:40.574" v="3062"/>
          <ac:spMkLst>
            <pc:docMk/>
            <pc:sldMk cId="2092801620" sldId="292"/>
            <ac:spMk id="114" creationId="{DE54FA86-19A7-4134-8599-C3CB843F7A37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18" creationId="{0CBF507D-4660-40DE-8863-3E167C7A5DAD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21" creationId="{14368017-13C3-4D4F-8A20-E7C9D73D5CB9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23" creationId="{C6A5CB87-EE68-47DB-87B9-906FF2448ADC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24" creationId="{EB6ABC7E-BBAF-48EA-84B7-FBEBB9662F91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25" creationId="{3811CB3B-2AE3-43D8-8F8B-7169389C0955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29" creationId="{90E49370-DD32-4C56-AAC3-6FEC78DA6351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30" creationId="{B39E93A1-B679-44F2-8769-0613C576BCE3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31" creationId="{7D3356DE-5FAE-4D11-9240-D0F357103D8C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32" creationId="{455C9520-B38D-4E1A-A271-8C93927685E7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33" creationId="{7A731C4E-A7EE-4C7C-BD6E-9C3E75743EB8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34" creationId="{7C52038D-D2A7-4411-B3DB-3C619D392AD7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35" creationId="{0F22109B-57F2-4E33-95DD-A7490807574F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36" creationId="{B6276131-949A-4447-B24B-AEFC19F70E5B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37" creationId="{23F50CFA-0F47-4F9F-86C4-D89EC0929E45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38" creationId="{00972772-0999-4447-82D9-F3725D42033C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39" creationId="{BF6AB3FE-311E-48C1-824D-85B0ECBDB3FD}"/>
          </ac:spMkLst>
        </pc:spChg>
        <pc:spChg chg="mod">
          <ac:chgData name="Manasweeta Angane" userId="05da2731-9352-4b35-b713-60351f56afbd" providerId="ADAL" clId="{F5F97842-A295-4F9F-B89B-A63B35E1C32D}" dt="2022-10-10T09:14:09.303" v="3066"/>
          <ac:spMkLst>
            <pc:docMk/>
            <pc:sldMk cId="2092801620" sldId="292"/>
            <ac:spMk id="140" creationId="{808F8E19-DEA3-40AE-9DCA-FD4A44C121A7}"/>
          </ac:spMkLst>
        </pc:spChg>
        <pc:spChg chg="mod">
          <ac:chgData name="Manasweeta Angane" userId="05da2731-9352-4b35-b713-60351f56afbd" providerId="ADAL" clId="{F5F97842-A295-4F9F-B89B-A63B35E1C32D}" dt="2022-10-10T09:14:34.140" v="3070"/>
          <ac:spMkLst>
            <pc:docMk/>
            <pc:sldMk cId="2092801620" sldId="292"/>
            <ac:spMk id="146" creationId="{49B1C3A8-C305-4EF3-BBEF-19972523BED6}"/>
          </ac:spMkLst>
        </pc:spChg>
        <pc:spChg chg="mod">
          <ac:chgData name="Manasweeta Angane" userId="05da2731-9352-4b35-b713-60351f56afbd" providerId="ADAL" clId="{F5F97842-A295-4F9F-B89B-A63B35E1C32D}" dt="2022-10-10T09:14:34.140" v="3070"/>
          <ac:spMkLst>
            <pc:docMk/>
            <pc:sldMk cId="2092801620" sldId="292"/>
            <ac:spMk id="149" creationId="{FD5023D0-D826-4C2C-B7A1-C33E2039F93E}"/>
          </ac:spMkLst>
        </pc:spChg>
        <pc:spChg chg="mod">
          <ac:chgData name="Manasweeta Angane" userId="05da2731-9352-4b35-b713-60351f56afbd" providerId="ADAL" clId="{F5F97842-A295-4F9F-B89B-A63B35E1C32D}" dt="2022-10-10T09:14:34.140" v="3070"/>
          <ac:spMkLst>
            <pc:docMk/>
            <pc:sldMk cId="2092801620" sldId="292"/>
            <ac:spMk id="151" creationId="{9183C309-643C-4E0E-BDE6-4DBB899D2F9D}"/>
          </ac:spMkLst>
        </pc:spChg>
        <pc:spChg chg="mod">
          <ac:chgData name="Manasweeta Angane" userId="05da2731-9352-4b35-b713-60351f56afbd" providerId="ADAL" clId="{F5F97842-A295-4F9F-B89B-A63B35E1C32D}" dt="2022-10-10T09:14:34.140" v="3070"/>
          <ac:spMkLst>
            <pc:docMk/>
            <pc:sldMk cId="2092801620" sldId="292"/>
            <ac:spMk id="152" creationId="{ADD8D23F-997A-4E45-A8F2-539ECA00555E}"/>
          </ac:spMkLst>
        </pc:spChg>
        <pc:spChg chg="mod">
          <ac:chgData name="Manasweeta Angane" userId="05da2731-9352-4b35-b713-60351f56afbd" providerId="ADAL" clId="{F5F97842-A295-4F9F-B89B-A63B35E1C32D}" dt="2022-10-10T09:14:34.140" v="3070"/>
          <ac:spMkLst>
            <pc:docMk/>
            <pc:sldMk cId="2092801620" sldId="292"/>
            <ac:spMk id="153" creationId="{6E92EADD-FFAA-45A6-B4BD-B455D738E750}"/>
          </ac:spMkLst>
        </pc:spChg>
        <pc:spChg chg="mod">
          <ac:chgData name="Manasweeta Angane" userId="05da2731-9352-4b35-b713-60351f56afbd" providerId="ADAL" clId="{F5F97842-A295-4F9F-B89B-A63B35E1C32D}" dt="2022-10-10T09:14:34.140" v="3070"/>
          <ac:spMkLst>
            <pc:docMk/>
            <pc:sldMk cId="2092801620" sldId="292"/>
            <ac:spMk id="157" creationId="{8AC96F57-D326-4672-B64A-084A71AE70E1}"/>
          </ac:spMkLst>
        </pc:spChg>
        <pc:spChg chg="mod">
          <ac:chgData name="Manasweeta Angane" userId="05da2731-9352-4b35-b713-60351f56afbd" providerId="ADAL" clId="{F5F97842-A295-4F9F-B89B-A63B35E1C32D}" dt="2022-10-10T09:14:34.140" v="3070"/>
          <ac:spMkLst>
            <pc:docMk/>
            <pc:sldMk cId="2092801620" sldId="292"/>
            <ac:spMk id="158" creationId="{67081D61-63D2-46F4-8F97-D478CE52FD03}"/>
          </ac:spMkLst>
        </pc:spChg>
        <pc:spChg chg="mod">
          <ac:chgData name="Manasweeta Angane" userId="05da2731-9352-4b35-b713-60351f56afbd" providerId="ADAL" clId="{F5F97842-A295-4F9F-B89B-A63B35E1C32D}" dt="2022-10-10T09:14:34.140" v="3070"/>
          <ac:spMkLst>
            <pc:docMk/>
            <pc:sldMk cId="2092801620" sldId="292"/>
            <ac:spMk id="159" creationId="{6C5771DF-A8B0-4BE0-8239-99F3845DB51A}"/>
          </ac:spMkLst>
        </pc:spChg>
        <pc:spChg chg="mod">
          <ac:chgData name="Manasweeta Angane" userId="05da2731-9352-4b35-b713-60351f56afbd" providerId="ADAL" clId="{F5F97842-A295-4F9F-B89B-A63B35E1C32D}" dt="2022-10-10T09:14:34.140" v="3070"/>
          <ac:spMkLst>
            <pc:docMk/>
            <pc:sldMk cId="2092801620" sldId="292"/>
            <ac:spMk id="160" creationId="{065D854C-2C92-4321-83DE-82C23D318A48}"/>
          </ac:spMkLst>
        </pc:spChg>
        <pc:spChg chg="mod">
          <ac:chgData name="Manasweeta Angane" userId="05da2731-9352-4b35-b713-60351f56afbd" providerId="ADAL" clId="{F5F97842-A295-4F9F-B89B-A63B35E1C32D}" dt="2022-10-10T09:14:34.140" v="3070"/>
          <ac:spMkLst>
            <pc:docMk/>
            <pc:sldMk cId="2092801620" sldId="292"/>
            <ac:spMk id="161" creationId="{AC1F07CB-B900-438D-8EAA-D94DA43666B7}"/>
          </ac:spMkLst>
        </pc:spChg>
        <pc:spChg chg="mod">
          <ac:chgData name="Manasweeta Angane" userId="05da2731-9352-4b35-b713-60351f56afbd" providerId="ADAL" clId="{F5F97842-A295-4F9F-B89B-A63B35E1C32D}" dt="2022-10-10T09:14:34.140" v="3070"/>
          <ac:spMkLst>
            <pc:docMk/>
            <pc:sldMk cId="2092801620" sldId="292"/>
            <ac:spMk id="162" creationId="{48AA4649-C705-4F67-982D-E01BA77C2627}"/>
          </ac:spMkLst>
        </pc:spChg>
        <pc:spChg chg="mod">
          <ac:chgData name="Manasweeta Angane" userId="05da2731-9352-4b35-b713-60351f56afbd" providerId="ADAL" clId="{F5F97842-A295-4F9F-B89B-A63B35E1C32D}" dt="2022-10-10T09:14:34.140" v="3070"/>
          <ac:spMkLst>
            <pc:docMk/>
            <pc:sldMk cId="2092801620" sldId="292"/>
            <ac:spMk id="163" creationId="{CAAA0F70-D851-42AE-BBBA-3E7C64C7A2BB}"/>
          </ac:spMkLst>
        </pc:spChg>
        <pc:spChg chg="mod">
          <ac:chgData name="Manasweeta Angane" userId="05da2731-9352-4b35-b713-60351f56afbd" providerId="ADAL" clId="{F5F97842-A295-4F9F-B89B-A63B35E1C32D}" dt="2022-10-21T03:24:14.197" v="12059" actId="1036"/>
          <ac:spMkLst>
            <pc:docMk/>
            <pc:sldMk cId="2092801620" sldId="292"/>
            <ac:spMk id="164" creationId="{8AF68C66-1A25-4941-AD0A-FA72C35DECFD}"/>
          </ac:spMkLst>
        </pc:spChg>
        <pc:spChg chg="mod">
          <ac:chgData name="Manasweeta Angane" userId="05da2731-9352-4b35-b713-60351f56afbd" providerId="ADAL" clId="{F5F97842-A295-4F9F-B89B-A63B35E1C32D}" dt="2022-10-21T03:24:22.644" v="12065" actId="1035"/>
          <ac:spMkLst>
            <pc:docMk/>
            <pc:sldMk cId="2092801620" sldId="292"/>
            <ac:spMk id="165" creationId="{5FD8B23D-7606-45D0-8471-478F90D10559}"/>
          </ac:spMkLst>
        </pc:spChg>
        <pc:spChg chg="mod">
          <ac:chgData name="Manasweeta Angane" userId="05da2731-9352-4b35-b713-60351f56afbd" providerId="ADAL" clId="{F5F97842-A295-4F9F-B89B-A63B35E1C32D}" dt="2022-10-10T09:14:34.140" v="3070"/>
          <ac:spMkLst>
            <pc:docMk/>
            <pc:sldMk cId="2092801620" sldId="292"/>
            <ac:spMk id="166" creationId="{38A45943-4B25-4430-ABD7-24760463A08B}"/>
          </ac:spMkLst>
        </pc:spChg>
        <pc:spChg chg="mod">
          <ac:chgData name="Manasweeta Angane" userId="05da2731-9352-4b35-b713-60351f56afbd" providerId="ADAL" clId="{F5F97842-A295-4F9F-B89B-A63B35E1C32D}" dt="2022-10-10T09:14:34.140" v="3070"/>
          <ac:spMkLst>
            <pc:docMk/>
            <pc:sldMk cId="2092801620" sldId="292"/>
            <ac:spMk id="167" creationId="{DF7F78F0-B1B4-47EC-A976-699C70C31ECF}"/>
          </ac:spMkLst>
        </pc:spChg>
        <pc:spChg chg="mod">
          <ac:chgData name="Manasweeta Angane" userId="05da2731-9352-4b35-b713-60351f56afbd" providerId="ADAL" clId="{F5F97842-A295-4F9F-B89B-A63B35E1C32D}" dt="2022-10-10T09:14:34.140" v="3070"/>
          <ac:spMkLst>
            <pc:docMk/>
            <pc:sldMk cId="2092801620" sldId="292"/>
            <ac:spMk id="168" creationId="{9AD61D39-D6EF-4CE0-9443-E5A665A51CED}"/>
          </ac:spMkLst>
        </pc:spChg>
        <pc:spChg chg="add mod">
          <ac:chgData name="Manasweeta Angane" userId="05da2731-9352-4b35-b713-60351f56afbd" providerId="ADAL" clId="{F5F97842-A295-4F9F-B89B-A63B35E1C32D}" dt="2022-10-21T03:21:09.392" v="11931" actId="207"/>
          <ac:spMkLst>
            <pc:docMk/>
            <pc:sldMk cId="2092801620" sldId="292"/>
            <ac:spMk id="171" creationId="{DEAD341C-AFD0-435B-9F31-BB9DF4974427}"/>
          </ac:spMkLst>
        </pc:spChg>
        <pc:grpChg chg="add del mod">
          <ac:chgData name="Manasweeta Angane" userId="05da2731-9352-4b35-b713-60351f56afbd" providerId="ADAL" clId="{F5F97842-A295-4F9F-B89B-A63B35E1C32D}" dt="2022-10-10T09:13:35.067" v="3061"/>
          <ac:grpSpMkLst>
            <pc:docMk/>
            <pc:sldMk cId="2092801620" sldId="292"/>
            <ac:grpSpMk id="11" creationId="{DDEA467D-8831-4834-9BAD-C482B5CE36B9}"/>
          </ac:grpSpMkLst>
        </pc:grpChg>
        <pc:grpChg chg="mod">
          <ac:chgData name="Manasweeta Angane" userId="05da2731-9352-4b35-b713-60351f56afbd" providerId="ADAL" clId="{F5F97842-A295-4F9F-B89B-A63B35E1C32D}" dt="2022-10-10T09:13:30.316" v="3060"/>
          <ac:grpSpMkLst>
            <pc:docMk/>
            <pc:sldMk cId="2092801620" sldId="292"/>
            <ac:grpSpMk id="12" creationId="{FB969E94-2E44-4DA0-93FB-D78D935105FA}"/>
          </ac:grpSpMkLst>
        </pc:grpChg>
        <pc:grpChg chg="mod">
          <ac:chgData name="Manasweeta Angane" userId="05da2731-9352-4b35-b713-60351f56afbd" providerId="ADAL" clId="{F5F97842-A295-4F9F-B89B-A63B35E1C32D}" dt="2022-10-10T09:13:30.316" v="3060"/>
          <ac:grpSpMkLst>
            <pc:docMk/>
            <pc:sldMk cId="2092801620" sldId="292"/>
            <ac:grpSpMk id="29" creationId="{B22CE320-396C-4E2B-9418-57CF5D5905C0}"/>
          </ac:grpSpMkLst>
        </pc:grpChg>
        <pc:grpChg chg="mod">
          <ac:chgData name="Manasweeta Angane" userId="05da2731-9352-4b35-b713-60351f56afbd" providerId="ADAL" clId="{F5F97842-A295-4F9F-B89B-A63B35E1C32D}" dt="2022-10-10T09:13:30.316" v="3060"/>
          <ac:grpSpMkLst>
            <pc:docMk/>
            <pc:sldMk cId="2092801620" sldId="292"/>
            <ac:grpSpMk id="36" creationId="{44A84FF4-B262-4014-AE3A-ABB327562956}"/>
          </ac:grpSpMkLst>
        </pc:grpChg>
        <pc:grpChg chg="mod">
          <ac:chgData name="Manasweeta Angane" userId="05da2731-9352-4b35-b713-60351f56afbd" providerId="ADAL" clId="{F5F97842-A295-4F9F-B89B-A63B35E1C32D}" dt="2022-10-10T09:13:30.316" v="3060"/>
          <ac:grpSpMkLst>
            <pc:docMk/>
            <pc:sldMk cId="2092801620" sldId="292"/>
            <ac:grpSpMk id="39" creationId="{496971E0-D4E6-4821-81A1-4623B6540142}"/>
          </ac:grpSpMkLst>
        </pc:grpChg>
        <pc:grpChg chg="mod">
          <ac:chgData name="Manasweeta Angane" userId="05da2731-9352-4b35-b713-60351f56afbd" providerId="ADAL" clId="{F5F97842-A295-4F9F-B89B-A63B35E1C32D}" dt="2022-10-10T09:13:30.316" v="3060"/>
          <ac:grpSpMkLst>
            <pc:docMk/>
            <pc:sldMk cId="2092801620" sldId="292"/>
            <ac:grpSpMk id="42" creationId="{EB60D75B-771A-4A2C-A573-5522B33F0F1F}"/>
          </ac:grpSpMkLst>
        </pc:grpChg>
        <pc:grpChg chg="add mod">
          <ac:chgData name="Manasweeta Angane" userId="05da2731-9352-4b35-b713-60351f56afbd" providerId="ADAL" clId="{F5F97842-A295-4F9F-B89B-A63B35E1C32D}" dt="2022-10-21T03:22:42.737" v="11992" actId="1036"/>
          <ac:grpSpMkLst>
            <pc:docMk/>
            <pc:sldMk cId="2092801620" sldId="292"/>
            <ac:grpSpMk id="64" creationId="{2ADC9E17-DE2D-49AC-B5E3-4D993BA6F45A}"/>
          </ac:grpSpMkLst>
        </pc:grpChg>
        <pc:grpChg chg="mod">
          <ac:chgData name="Manasweeta Angane" userId="05da2731-9352-4b35-b713-60351f56afbd" providerId="ADAL" clId="{F5F97842-A295-4F9F-B89B-A63B35E1C32D}" dt="2022-10-10T09:13:40.574" v="3062"/>
          <ac:grpSpMkLst>
            <pc:docMk/>
            <pc:sldMk cId="2092801620" sldId="292"/>
            <ac:grpSpMk id="65" creationId="{642B901A-6EE2-4B75-A552-C74E59BFDDC1}"/>
          </ac:grpSpMkLst>
        </pc:grpChg>
        <pc:grpChg chg="mod">
          <ac:chgData name="Manasweeta Angane" userId="05da2731-9352-4b35-b713-60351f56afbd" providerId="ADAL" clId="{F5F97842-A295-4F9F-B89B-A63B35E1C32D}" dt="2022-10-10T09:13:40.574" v="3062"/>
          <ac:grpSpMkLst>
            <pc:docMk/>
            <pc:sldMk cId="2092801620" sldId="292"/>
            <ac:grpSpMk id="80" creationId="{A5E51030-2E69-4335-A55A-A30BF0623AF2}"/>
          </ac:grpSpMkLst>
        </pc:grpChg>
        <pc:grpChg chg="mod">
          <ac:chgData name="Manasweeta Angane" userId="05da2731-9352-4b35-b713-60351f56afbd" providerId="ADAL" clId="{F5F97842-A295-4F9F-B89B-A63B35E1C32D}" dt="2022-10-10T09:13:40.574" v="3062"/>
          <ac:grpSpMkLst>
            <pc:docMk/>
            <pc:sldMk cId="2092801620" sldId="292"/>
            <ac:grpSpMk id="87" creationId="{A249D343-D6F8-4135-BD83-A6D16D3A85ED}"/>
          </ac:grpSpMkLst>
        </pc:grpChg>
        <pc:grpChg chg="mod">
          <ac:chgData name="Manasweeta Angane" userId="05da2731-9352-4b35-b713-60351f56afbd" providerId="ADAL" clId="{F5F97842-A295-4F9F-B89B-A63B35E1C32D}" dt="2022-10-10T09:13:40.574" v="3062"/>
          <ac:grpSpMkLst>
            <pc:docMk/>
            <pc:sldMk cId="2092801620" sldId="292"/>
            <ac:grpSpMk id="90" creationId="{E6C07E5F-4822-451F-BFE3-2D974C43B5AE}"/>
          </ac:grpSpMkLst>
        </pc:grpChg>
        <pc:grpChg chg="mod">
          <ac:chgData name="Manasweeta Angane" userId="05da2731-9352-4b35-b713-60351f56afbd" providerId="ADAL" clId="{F5F97842-A295-4F9F-B89B-A63B35E1C32D}" dt="2022-10-10T09:13:40.574" v="3062"/>
          <ac:grpSpMkLst>
            <pc:docMk/>
            <pc:sldMk cId="2092801620" sldId="292"/>
            <ac:grpSpMk id="93" creationId="{5D1462B6-6A2D-4594-8A84-CA4BD0625688}"/>
          </ac:grpSpMkLst>
        </pc:grpChg>
        <pc:grpChg chg="add del mod">
          <ac:chgData name="Manasweeta Angane" userId="05da2731-9352-4b35-b713-60351f56afbd" providerId="ADAL" clId="{F5F97842-A295-4F9F-B89B-A63B35E1C32D}" dt="2022-10-10T09:14:23.644" v="3069"/>
          <ac:grpSpMkLst>
            <pc:docMk/>
            <pc:sldMk cId="2092801620" sldId="292"/>
            <ac:grpSpMk id="115" creationId="{AC09D3F4-8AA2-4232-89A2-1B78C1FA1630}"/>
          </ac:grpSpMkLst>
        </pc:grpChg>
        <pc:grpChg chg="mod">
          <ac:chgData name="Manasweeta Angane" userId="05da2731-9352-4b35-b713-60351f56afbd" providerId="ADAL" clId="{F5F97842-A295-4F9F-B89B-A63B35E1C32D}" dt="2022-10-10T09:14:09.303" v="3066"/>
          <ac:grpSpMkLst>
            <pc:docMk/>
            <pc:sldMk cId="2092801620" sldId="292"/>
            <ac:grpSpMk id="116" creationId="{BE3030EC-7716-4CAF-9B62-73F0AF101322}"/>
          </ac:grpSpMkLst>
        </pc:grpChg>
        <pc:grpChg chg="mod">
          <ac:chgData name="Manasweeta Angane" userId="05da2731-9352-4b35-b713-60351f56afbd" providerId="ADAL" clId="{F5F97842-A295-4F9F-B89B-A63B35E1C32D}" dt="2022-10-10T09:14:09.303" v="3066"/>
          <ac:grpSpMkLst>
            <pc:docMk/>
            <pc:sldMk cId="2092801620" sldId="292"/>
            <ac:grpSpMk id="117" creationId="{53D31163-3E43-4BB7-8FE1-766DCB673EB6}"/>
          </ac:grpSpMkLst>
        </pc:grpChg>
        <pc:grpChg chg="mod">
          <ac:chgData name="Manasweeta Angane" userId="05da2731-9352-4b35-b713-60351f56afbd" providerId="ADAL" clId="{F5F97842-A295-4F9F-B89B-A63B35E1C32D}" dt="2022-10-10T09:14:09.303" v="3066"/>
          <ac:grpSpMkLst>
            <pc:docMk/>
            <pc:sldMk cId="2092801620" sldId="292"/>
            <ac:grpSpMk id="119" creationId="{8BDD10EF-346D-40AC-A5CF-5311FD93DF74}"/>
          </ac:grpSpMkLst>
        </pc:grpChg>
        <pc:grpChg chg="mod">
          <ac:chgData name="Manasweeta Angane" userId="05da2731-9352-4b35-b713-60351f56afbd" providerId="ADAL" clId="{F5F97842-A295-4F9F-B89B-A63B35E1C32D}" dt="2022-10-10T09:14:09.303" v="3066"/>
          <ac:grpSpMkLst>
            <pc:docMk/>
            <pc:sldMk cId="2092801620" sldId="292"/>
            <ac:grpSpMk id="122" creationId="{8239F7EC-6D7D-42AF-8B63-B0BB6D32B3AD}"/>
          </ac:grpSpMkLst>
        </pc:grpChg>
        <pc:grpChg chg="add mod">
          <ac:chgData name="Manasweeta Angane" userId="05da2731-9352-4b35-b713-60351f56afbd" providerId="ADAL" clId="{F5F97842-A295-4F9F-B89B-A63B35E1C32D}" dt="2022-10-21T03:22:52.514" v="12016" actId="1035"/>
          <ac:grpSpMkLst>
            <pc:docMk/>
            <pc:sldMk cId="2092801620" sldId="292"/>
            <ac:grpSpMk id="143" creationId="{EF09ADBD-53B0-43BA-887D-9ECC5A7591B0}"/>
          </ac:grpSpMkLst>
        </pc:grpChg>
        <pc:grpChg chg="mod">
          <ac:chgData name="Manasweeta Angane" userId="05da2731-9352-4b35-b713-60351f56afbd" providerId="ADAL" clId="{F5F97842-A295-4F9F-B89B-A63B35E1C32D}" dt="2022-10-10T09:14:34.140" v="3070"/>
          <ac:grpSpMkLst>
            <pc:docMk/>
            <pc:sldMk cId="2092801620" sldId="292"/>
            <ac:grpSpMk id="144" creationId="{9F3B76DA-AA70-4B04-9368-35CD6EA5F403}"/>
          </ac:grpSpMkLst>
        </pc:grpChg>
        <pc:grpChg chg="mod">
          <ac:chgData name="Manasweeta Angane" userId="05da2731-9352-4b35-b713-60351f56afbd" providerId="ADAL" clId="{F5F97842-A295-4F9F-B89B-A63B35E1C32D}" dt="2022-10-10T09:14:34.140" v="3070"/>
          <ac:grpSpMkLst>
            <pc:docMk/>
            <pc:sldMk cId="2092801620" sldId="292"/>
            <ac:grpSpMk id="145" creationId="{26F4C132-5647-4237-B63B-1EADBB746A1E}"/>
          </ac:grpSpMkLst>
        </pc:grpChg>
        <pc:grpChg chg="mod">
          <ac:chgData name="Manasweeta Angane" userId="05da2731-9352-4b35-b713-60351f56afbd" providerId="ADAL" clId="{F5F97842-A295-4F9F-B89B-A63B35E1C32D}" dt="2022-10-10T09:14:34.140" v="3070"/>
          <ac:grpSpMkLst>
            <pc:docMk/>
            <pc:sldMk cId="2092801620" sldId="292"/>
            <ac:grpSpMk id="147" creationId="{7CFE7FE4-ED48-4B60-9A8B-DFB9B7349648}"/>
          </ac:grpSpMkLst>
        </pc:grpChg>
        <pc:grpChg chg="mod">
          <ac:chgData name="Manasweeta Angane" userId="05da2731-9352-4b35-b713-60351f56afbd" providerId="ADAL" clId="{F5F97842-A295-4F9F-B89B-A63B35E1C32D}" dt="2022-10-10T09:14:34.140" v="3070"/>
          <ac:grpSpMkLst>
            <pc:docMk/>
            <pc:sldMk cId="2092801620" sldId="292"/>
            <ac:grpSpMk id="150" creationId="{DDBC1F8A-EF43-4268-8D5F-CCF632A09BC6}"/>
          </ac:grpSpMkLst>
        </pc:grpChg>
        <pc:picChg chg="add mod">
          <ac:chgData name="Manasweeta Angane" userId="05da2731-9352-4b35-b713-60351f56afbd" providerId="ADAL" clId="{F5F97842-A295-4F9F-B89B-A63B35E1C32D}" dt="2022-10-10T09:01:16.508" v="3023"/>
          <ac:picMkLst>
            <pc:docMk/>
            <pc:sldMk cId="2092801620" sldId="292"/>
            <ac:picMk id="9" creationId="{EB88AE66-C88F-4245-899C-8B6ADA9F2E88}"/>
          </ac:picMkLst>
        </pc:picChg>
        <pc:picChg chg="add mod">
          <ac:chgData name="Manasweeta Angane" userId="05da2731-9352-4b35-b713-60351f56afbd" providerId="ADAL" clId="{F5F97842-A295-4F9F-B89B-A63B35E1C32D}" dt="2022-10-10T09:01:16.508" v="3023"/>
          <ac:picMkLst>
            <pc:docMk/>
            <pc:sldMk cId="2092801620" sldId="292"/>
            <ac:picMk id="10" creationId="{D8FC0E91-F448-43A3-8AD1-C93802E75046}"/>
          </ac:picMkLst>
        </pc:picChg>
        <pc:picChg chg="mod">
          <ac:chgData name="Manasweeta Angane" userId="05da2731-9352-4b35-b713-60351f56afbd" providerId="ADAL" clId="{F5F97842-A295-4F9F-B89B-A63B35E1C32D}" dt="2022-10-10T09:13:30.316" v="3060"/>
          <ac:picMkLst>
            <pc:docMk/>
            <pc:sldMk cId="2092801620" sldId="292"/>
            <ac:picMk id="13" creationId="{3355F337-CF1C-4C3C-BD87-50C2E7C67B77}"/>
          </ac:picMkLst>
        </pc:picChg>
        <pc:picChg chg="mod">
          <ac:chgData name="Manasweeta Angane" userId="05da2731-9352-4b35-b713-60351f56afbd" providerId="ADAL" clId="{F5F97842-A295-4F9F-B89B-A63B35E1C32D}" dt="2022-10-10T09:13:30.316" v="3060"/>
          <ac:picMkLst>
            <pc:docMk/>
            <pc:sldMk cId="2092801620" sldId="292"/>
            <ac:picMk id="20" creationId="{FE96D0ED-717D-4ACB-85E5-C614AE347AA5}"/>
          </ac:picMkLst>
        </pc:picChg>
        <pc:picChg chg="mod">
          <ac:chgData name="Manasweeta Angane" userId="05da2731-9352-4b35-b713-60351f56afbd" providerId="ADAL" clId="{F5F97842-A295-4F9F-B89B-A63B35E1C32D}" dt="2022-10-10T09:13:30.316" v="3060"/>
          <ac:picMkLst>
            <pc:docMk/>
            <pc:sldMk cId="2092801620" sldId="292"/>
            <ac:picMk id="21" creationId="{0A1ACE04-0822-4A6E-812B-98E326FE31CB}"/>
          </ac:picMkLst>
        </pc:picChg>
        <pc:picChg chg="mod">
          <ac:chgData name="Manasweeta Angane" userId="05da2731-9352-4b35-b713-60351f56afbd" providerId="ADAL" clId="{F5F97842-A295-4F9F-B89B-A63B35E1C32D}" dt="2022-10-10T09:13:30.316" v="3060"/>
          <ac:picMkLst>
            <pc:docMk/>
            <pc:sldMk cId="2092801620" sldId="292"/>
            <ac:picMk id="22" creationId="{66B89286-299B-465A-A38F-52863A79FF2B}"/>
          </ac:picMkLst>
        </pc:picChg>
        <pc:picChg chg="mod">
          <ac:chgData name="Manasweeta Angane" userId="05da2731-9352-4b35-b713-60351f56afbd" providerId="ADAL" clId="{F5F97842-A295-4F9F-B89B-A63B35E1C32D}" dt="2022-10-10T09:13:30.316" v="3060"/>
          <ac:picMkLst>
            <pc:docMk/>
            <pc:sldMk cId="2092801620" sldId="292"/>
            <ac:picMk id="23" creationId="{0B7AEC5D-E2C3-4464-87CF-FA86B77CE4C8}"/>
          </ac:picMkLst>
        </pc:picChg>
        <pc:picChg chg="mod">
          <ac:chgData name="Manasweeta Angane" userId="05da2731-9352-4b35-b713-60351f56afbd" providerId="ADAL" clId="{F5F97842-A295-4F9F-B89B-A63B35E1C32D}" dt="2022-10-10T09:13:30.316" v="3060"/>
          <ac:picMkLst>
            <pc:docMk/>
            <pc:sldMk cId="2092801620" sldId="292"/>
            <ac:picMk id="24" creationId="{4C919352-7019-4705-84D3-D93DFDDC57EB}"/>
          </ac:picMkLst>
        </pc:picChg>
        <pc:picChg chg="mod">
          <ac:chgData name="Manasweeta Angane" userId="05da2731-9352-4b35-b713-60351f56afbd" providerId="ADAL" clId="{F5F97842-A295-4F9F-B89B-A63B35E1C32D}" dt="2022-10-10T09:13:30.316" v="3060"/>
          <ac:picMkLst>
            <pc:docMk/>
            <pc:sldMk cId="2092801620" sldId="292"/>
            <ac:picMk id="35" creationId="{A3A88618-D4F9-4758-9FCF-DD0A365DC232}"/>
          </ac:picMkLst>
        </pc:picChg>
        <pc:picChg chg="mod">
          <ac:chgData name="Manasweeta Angane" userId="05da2731-9352-4b35-b713-60351f56afbd" providerId="ADAL" clId="{F5F97842-A295-4F9F-B89B-A63B35E1C32D}" dt="2022-10-10T09:13:30.316" v="3060"/>
          <ac:picMkLst>
            <pc:docMk/>
            <pc:sldMk cId="2092801620" sldId="292"/>
            <ac:picMk id="55" creationId="{6F057EDC-0383-46EB-A1A0-49B8A96222CF}"/>
          </ac:picMkLst>
        </pc:picChg>
        <pc:picChg chg="mod">
          <ac:chgData name="Manasweeta Angane" userId="05da2731-9352-4b35-b713-60351f56afbd" providerId="ADAL" clId="{F5F97842-A295-4F9F-B89B-A63B35E1C32D}" dt="2022-10-10T09:13:30.316" v="3060"/>
          <ac:picMkLst>
            <pc:docMk/>
            <pc:sldMk cId="2092801620" sldId="292"/>
            <ac:picMk id="56" creationId="{49A4F67B-8598-4C06-A1F5-A36E1615AB95}"/>
          </ac:picMkLst>
        </pc:picChg>
        <pc:picChg chg="mod">
          <ac:chgData name="Manasweeta Angane" userId="05da2731-9352-4b35-b713-60351f56afbd" providerId="ADAL" clId="{F5F97842-A295-4F9F-B89B-A63B35E1C32D}" dt="2022-10-10T09:13:40.574" v="3062"/>
          <ac:picMkLst>
            <pc:docMk/>
            <pc:sldMk cId="2092801620" sldId="292"/>
            <ac:picMk id="66" creationId="{15DFCA8E-90B8-4215-A4E4-EACABA5FDC73}"/>
          </ac:picMkLst>
        </pc:picChg>
        <pc:picChg chg="mod">
          <ac:chgData name="Manasweeta Angane" userId="05da2731-9352-4b35-b713-60351f56afbd" providerId="ADAL" clId="{F5F97842-A295-4F9F-B89B-A63B35E1C32D}" dt="2022-10-10T09:13:40.574" v="3062"/>
          <ac:picMkLst>
            <pc:docMk/>
            <pc:sldMk cId="2092801620" sldId="292"/>
            <ac:picMk id="71" creationId="{4EA3EA5A-B14D-4C3F-B6C8-B9DE24D95510}"/>
          </ac:picMkLst>
        </pc:picChg>
        <pc:picChg chg="mod">
          <ac:chgData name="Manasweeta Angane" userId="05da2731-9352-4b35-b713-60351f56afbd" providerId="ADAL" clId="{F5F97842-A295-4F9F-B89B-A63B35E1C32D}" dt="2022-10-10T09:13:40.574" v="3062"/>
          <ac:picMkLst>
            <pc:docMk/>
            <pc:sldMk cId="2092801620" sldId="292"/>
            <ac:picMk id="72" creationId="{90FD1F72-AF84-4B76-8C08-F560891487F9}"/>
          </ac:picMkLst>
        </pc:picChg>
        <pc:picChg chg="mod">
          <ac:chgData name="Manasweeta Angane" userId="05da2731-9352-4b35-b713-60351f56afbd" providerId="ADAL" clId="{F5F97842-A295-4F9F-B89B-A63B35E1C32D}" dt="2022-10-10T09:13:40.574" v="3062"/>
          <ac:picMkLst>
            <pc:docMk/>
            <pc:sldMk cId="2092801620" sldId="292"/>
            <ac:picMk id="73" creationId="{AA7CC86B-F0CB-4A89-9AEB-C7D1346B6ABE}"/>
          </ac:picMkLst>
        </pc:picChg>
        <pc:picChg chg="mod">
          <ac:chgData name="Manasweeta Angane" userId="05da2731-9352-4b35-b713-60351f56afbd" providerId="ADAL" clId="{F5F97842-A295-4F9F-B89B-A63B35E1C32D}" dt="2022-10-10T09:13:40.574" v="3062"/>
          <ac:picMkLst>
            <pc:docMk/>
            <pc:sldMk cId="2092801620" sldId="292"/>
            <ac:picMk id="74" creationId="{82B6D780-7717-4492-9A90-92A865B50B82}"/>
          </ac:picMkLst>
        </pc:picChg>
        <pc:picChg chg="mod">
          <ac:chgData name="Manasweeta Angane" userId="05da2731-9352-4b35-b713-60351f56afbd" providerId="ADAL" clId="{F5F97842-A295-4F9F-B89B-A63B35E1C32D}" dt="2022-10-10T09:13:40.574" v="3062"/>
          <ac:picMkLst>
            <pc:docMk/>
            <pc:sldMk cId="2092801620" sldId="292"/>
            <ac:picMk id="75" creationId="{F49B19FC-297B-417C-838E-DF80A3917A45}"/>
          </ac:picMkLst>
        </pc:picChg>
        <pc:picChg chg="mod">
          <ac:chgData name="Manasweeta Angane" userId="05da2731-9352-4b35-b713-60351f56afbd" providerId="ADAL" clId="{F5F97842-A295-4F9F-B89B-A63B35E1C32D}" dt="2022-10-10T09:13:40.574" v="3062"/>
          <ac:picMkLst>
            <pc:docMk/>
            <pc:sldMk cId="2092801620" sldId="292"/>
            <ac:picMk id="86" creationId="{3BAB4654-00B8-4C4A-9D7F-786212DA5239}"/>
          </ac:picMkLst>
        </pc:picChg>
        <pc:picChg chg="mod">
          <ac:chgData name="Manasweeta Angane" userId="05da2731-9352-4b35-b713-60351f56afbd" providerId="ADAL" clId="{F5F97842-A295-4F9F-B89B-A63B35E1C32D}" dt="2022-10-10T09:13:40.574" v="3062"/>
          <ac:picMkLst>
            <pc:docMk/>
            <pc:sldMk cId="2092801620" sldId="292"/>
            <ac:picMk id="106" creationId="{3B7C81DE-F42E-474E-8D04-F33550A8A77D}"/>
          </ac:picMkLst>
        </pc:picChg>
        <pc:picChg chg="mod">
          <ac:chgData name="Manasweeta Angane" userId="05da2731-9352-4b35-b713-60351f56afbd" providerId="ADAL" clId="{F5F97842-A295-4F9F-B89B-A63B35E1C32D}" dt="2022-10-10T09:13:40.574" v="3062"/>
          <ac:picMkLst>
            <pc:docMk/>
            <pc:sldMk cId="2092801620" sldId="292"/>
            <ac:picMk id="107" creationId="{F7324336-1C96-490B-97C8-5E39005E83B8}"/>
          </ac:picMkLst>
        </pc:picChg>
        <pc:picChg chg="mod">
          <ac:chgData name="Manasweeta Angane" userId="05da2731-9352-4b35-b713-60351f56afbd" providerId="ADAL" clId="{F5F97842-A295-4F9F-B89B-A63B35E1C32D}" dt="2022-10-10T09:14:09.303" v="3066"/>
          <ac:picMkLst>
            <pc:docMk/>
            <pc:sldMk cId="2092801620" sldId="292"/>
            <ac:picMk id="141" creationId="{A70F4153-1DC3-4FE6-A6D6-8C76933A6BA4}"/>
          </ac:picMkLst>
        </pc:picChg>
        <pc:picChg chg="mod">
          <ac:chgData name="Manasweeta Angane" userId="05da2731-9352-4b35-b713-60351f56afbd" providerId="ADAL" clId="{F5F97842-A295-4F9F-B89B-A63B35E1C32D}" dt="2022-10-10T09:14:09.303" v="3066"/>
          <ac:picMkLst>
            <pc:docMk/>
            <pc:sldMk cId="2092801620" sldId="292"/>
            <ac:picMk id="142" creationId="{902EF23D-761E-4C6E-9DB8-83D9DAA76F47}"/>
          </ac:picMkLst>
        </pc:picChg>
        <pc:picChg chg="mod">
          <ac:chgData name="Manasweeta Angane" userId="05da2731-9352-4b35-b713-60351f56afbd" providerId="ADAL" clId="{F5F97842-A295-4F9F-B89B-A63B35E1C32D}" dt="2022-10-10T09:14:34.140" v="3070"/>
          <ac:picMkLst>
            <pc:docMk/>
            <pc:sldMk cId="2092801620" sldId="292"/>
            <ac:picMk id="169" creationId="{F686F8EF-E365-4378-A4F5-FA48890CF8D2}"/>
          </ac:picMkLst>
        </pc:picChg>
        <pc:picChg chg="mod">
          <ac:chgData name="Manasweeta Angane" userId="05da2731-9352-4b35-b713-60351f56afbd" providerId="ADAL" clId="{F5F97842-A295-4F9F-B89B-A63B35E1C32D}" dt="2022-10-10T09:14:34.140" v="3070"/>
          <ac:picMkLst>
            <pc:docMk/>
            <pc:sldMk cId="2092801620" sldId="292"/>
            <ac:picMk id="170" creationId="{706517B5-15E4-41D7-B28F-D59B8E4FC9C4}"/>
          </ac:picMkLst>
        </pc:picChg>
        <pc:cxnChg chg="mod">
          <ac:chgData name="Manasweeta Angane" userId="05da2731-9352-4b35-b713-60351f56afbd" providerId="ADAL" clId="{F5F97842-A295-4F9F-B89B-A63B35E1C32D}" dt="2022-10-10T09:13:30.316" v="3060"/>
          <ac:cxnSpMkLst>
            <pc:docMk/>
            <pc:sldMk cId="2092801620" sldId="292"/>
            <ac:cxnSpMk id="16" creationId="{80F2EB42-F051-4B8A-A2B0-355C34BD72FE}"/>
          </ac:cxnSpMkLst>
        </pc:cxnChg>
        <pc:cxnChg chg="mod">
          <ac:chgData name="Manasweeta Angane" userId="05da2731-9352-4b35-b713-60351f56afbd" providerId="ADAL" clId="{F5F97842-A295-4F9F-B89B-A63B35E1C32D}" dt="2022-10-10T09:13:30.316" v="3060"/>
          <ac:cxnSpMkLst>
            <pc:docMk/>
            <pc:sldMk cId="2092801620" sldId="292"/>
            <ac:cxnSpMk id="31" creationId="{84170332-8707-4E63-A2F4-F9B30F3DD6D7}"/>
          </ac:cxnSpMkLst>
        </pc:cxnChg>
        <pc:cxnChg chg="mod">
          <ac:chgData name="Manasweeta Angane" userId="05da2731-9352-4b35-b713-60351f56afbd" providerId="ADAL" clId="{F5F97842-A295-4F9F-B89B-A63B35E1C32D}" dt="2022-10-10T09:13:30.316" v="3060"/>
          <ac:cxnSpMkLst>
            <pc:docMk/>
            <pc:sldMk cId="2092801620" sldId="292"/>
            <ac:cxnSpMk id="33" creationId="{49BC056A-14A8-40D3-A080-E6715341D928}"/>
          </ac:cxnSpMkLst>
        </pc:cxnChg>
        <pc:cxnChg chg="mod">
          <ac:chgData name="Manasweeta Angane" userId="05da2731-9352-4b35-b713-60351f56afbd" providerId="ADAL" clId="{F5F97842-A295-4F9F-B89B-A63B35E1C32D}" dt="2022-10-10T09:13:30.316" v="3060"/>
          <ac:cxnSpMkLst>
            <pc:docMk/>
            <pc:sldMk cId="2092801620" sldId="292"/>
            <ac:cxnSpMk id="37" creationId="{D0C875C0-9362-4391-AA09-4AB3251BFDB0}"/>
          </ac:cxnSpMkLst>
        </pc:cxnChg>
        <pc:cxnChg chg="mod">
          <ac:chgData name="Manasweeta Angane" userId="05da2731-9352-4b35-b713-60351f56afbd" providerId="ADAL" clId="{F5F97842-A295-4F9F-B89B-A63B35E1C32D}" dt="2022-10-10T09:13:30.316" v="3060"/>
          <ac:cxnSpMkLst>
            <pc:docMk/>
            <pc:sldMk cId="2092801620" sldId="292"/>
            <ac:cxnSpMk id="43" creationId="{7E57159F-AE00-4114-AAA3-F39A2A4C41BC}"/>
          </ac:cxnSpMkLst>
        </pc:cxnChg>
        <pc:cxnChg chg="mod">
          <ac:chgData name="Manasweeta Angane" userId="05da2731-9352-4b35-b713-60351f56afbd" providerId="ADAL" clId="{F5F97842-A295-4F9F-B89B-A63B35E1C32D}" dt="2022-10-10T09:13:30.316" v="3060"/>
          <ac:cxnSpMkLst>
            <pc:docMk/>
            <pc:sldMk cId="2092801620" sldId="292"/>
            <ac:cxnSpMk id="51" creationId="{E367ECF1-A98B-4F95-85E3-9725BE1BB4F2}"/>
          </ac:cxnSpMkLst>
        </pc:cxnChg>
        <pc:cxnChg chg="mod">
          <ac:chgData name="Manasweeta Angane" userId="05da2731-9352-4b35-b713-60351f56afbd" providerId="ADAL" clId="{F5F97842-A295-4F9F-B89B-A63B35E1C32D}" dt="2022-10-10T09:13:30.316" v="3060"/>
          <ac:cxnSpMkLst>
            <pc:docMk/>
            <pc:sldMk cId="2092801620" sldId="292"/>
            <ac:cxnSpMk id="53" creationId="{98D7795D-2FE2-4442-96FD-125CF8AFAD8D}"/>
          </ac:cxnSpMkLst>
        </pc:cxnChg>
        <pc:cxnChg chg="mod">
          <ac:chgData name="Manasweeta Angane" userId="05da2731-9352-4b35-b713-60351f56afbd" providerId="ADAL" clId="{F5F97842-A295-4F9F-B89B-A63B35E1C32D}" dt="2022-10-10T09:13:30.316" v="3060"/>
          <ac:cxnSpMkLst>
            <pc:docMk/>
            <pc:sldMk cId="2092801620" sldId="292"/>
            <ac:cxnSpMk id="54" creationId="{AC3578F9-6185-468B-8286-C7FC3CEEFAC3}"/>
          </ac:cxnSpMkLst>
        </pc:cxnChg>
        <pc:cxnChg chg="mod">
          <ac:chgData name="Manasweeta Angane" userId="05da2731-9352-4b35-b713-60351f56afbd" providerId="ADAL" clId="{F5F97842-A295-4F9F-B89B-A63B35E1C32D}" dt="2022-10-10T09:13:40.574" v="3062"/>
          <ac:cxnSpMkLst>
            <pc:docMk/>
            <pc:sldMk cId="2092801620" sldId="292"/>
            <ac:cxnSpMk id="69" creationId="{D8D151FE-FF1B-4226-BF4D-EBBEA55F4F4B}"/>
          </ac:cxnSpMkLst>
        </pc:cxnChg>
        <pc:cxnChg chg="mod">
          <ac:chgData name="Manasweeta Angane" userId="05da2731-9352-4b35-b713-60351f56afbd" providerId="ADAL" clId="{F5F97842-A295-4F9F-B89B-A63B35E1C32D}" dt="2022-10-10T09:13:40.574" v="3062"/>
          <ac:cxnSpMkLst>
            <pc:docMk/>
            <pc:sldMk cId="2092801620" sldId="292"/>
            <ac:cxnSpMk id="82" creationId="{BCBE3374-F716-4336-9373-AD41BE39F069}"/>
          </ac:cxnSpMkLst>
        </pc:cxnChg>
        <pc:cxnChg chg="mod">
          <ac:chgData name="Manasweeta Angane" userId="05da2731-9352-4b35-b713-60351f56afbd" providerId="ADAL" clId="{F5F97842-A295-4F9F-B89B-A63B35E1C32D}" dt="2022-10-10T09:13:40.574" v="3062"/>
          <ac:cxnSpMkLst>
            <pc:docMk/>
            <pc:sldMk cId="2092801620" sldId="292"/>
            <ac:cxnSpMk id="84" creationId="{96BC8F66-0926-49E4-B543-6FF515FFCF10}"/>
          </ac:cxnSpMkLst>
        </pc:cxnChg>
        <pc:cxnChg chg="mod">
          <ac:chgData name="Manasweeta Angane" userId="05da2731-9352-4b35-b713-60351f56afbd" providerId="ADAL" clId="{F5F97842-A295-4F9F-B89B-A63B35E1C32D}" dt="2022-10-10T09:13:40.574" v="3062"/>
          <ac:cxnSpMkLst>
            <pc:docMk/>
            <pc:sldMk cId="2092801620" sldId="292"/>
            <ac:cxnSpMk id="88" creationId="{33B301A1-1D3B-4C21-ADA0-72005773DE83}"/>
          </ac:cxnSpMkLst>
        </pc:cxnChg>
        <pc:cxnChg chg="mod">
          <ac:chgData name="Manasweeta Angane" userId="05da2731-9352-4b35-b713-60351f56afbd" providerId="ADAL" clId="{F5F97842-A295-4F9F-B89B-A63B35E1C32D}" dt="2022-10-10T09:13:40.574" v="3062"/>
          <ac:cxnSpMkLst>
            <pc:docMk/>
            <pc:sldMk cId="2092801620" sldId="292"/>
            <ac:cxnSpMk id="94" creationId="{E6942C2B-5A00-4C36-946E-1EE72E61F567}"/>
          </ac:cxnSpMkLst>
        </pc:cxnChg>
        <pc:cxnChg chg="mod">
          <ac:chgData name="Manasweeta Angane" userId="05da2731-9352-4b35-b713-60351f56afbd" providerId="ADAL" clId="{F5F97842-A295-4F9F-B89B-A63B35E1C32D}" dt="2022-10-10T09:13:40.574" v="3062"/>
          <ac:cxnSpMkLst>
            <pc:docMk/>
            <pc:sldMk cId="2092801620" sldId="292"/>
            <ac:cxnSpMk id="102" creationId="{EFF848A6-A446-40AA-A4AA-A9BB181245D3}"/>
          </ac:cxnSpMkLst>
        </pc:cxnChg>
        <pc:cxnChg chg="mod">
          <ac:chgData name="Manasweeta Angane" userId="05da2731-9352-4b35-b713-60351f56afbd" providerId="ADAL" clId="{F5F97842-A295-4F9F-B89B-A63B35E1C32D}" dt="2022-10-10T09:13:40.574" v="3062"/>
          <ac:cxnSpMkLst>
            <pc:docMk/>
            <pc:sldMk cId="2092801620" sldId="292"/>
            <ac:cxnSpMk id="104" creationId="{90BAD1EC-48AB-4DE8-A232-5B128E7053A4}"/>
          </ac:cxnSpMkLst>
        </pc:cxnChg>
        <pc:cxnChg chg="mod">
          <ac:chgData name="Manasweeta Angane" userId="05da2731-9352-4b35-b713-60351f56afbd" providerId="ADAL" clId="{F5F97842-A295-4F9F-B89B-A63B35E1C32D}" dt="2022-10-10T09:13:40.574" v="3062"/>
          <ac:cxnSpMkLst>
            <pc:docMk/>
            <pc:sldMk cId="2092801620" sldId="292"/>
            <ac:cxnSpMk id="105" creationId="{37CB5D8E-4B46-4109-8A7A-0C1FC8C2D502}"/>
          </ac:cxnSpMkLst>
        </pc:cxnChg>
        <pc:cxnChg chg="mod">
          <ac:chgData name="Manasweeta Angane" userId="05da2731-9352-4b35-b713-60351f56afbd" providerId="ADAL" clId="{F5F97842-A295-4F9F-B89B-A63B35E1C32D}" dt="2022-10-10T09:14:09.303" v="3066"/>
          <ac:cxnSpMkLst>
            <pc:docMk/>
            <pc:sldMk cId="2092801620" sldId="292"/>
            <ac:cxnSpMk id="120" creationId="{0A9EF185-195E-41A8-B702-4CCBC14C6636}"/>
          </ac:cxnSpMkLst>
        </pc:cxnChg>
        <pc:cxnChg chg="mod">
          <ac:chgData name="Manasweeta Angane" userId="05da2731-9352-4b35-b713-60351f56afbd" providerId="ADAL" clId="{F5F97842-A295-4F9F-B89B-A63B35E1C32D}" dt="2022-10-10T09:14:09.303" v="3066"/>
          <ac:cxnSpMkLst>
            <pc:docMk/>
            <pc:sldMk cId="2092801620" sldId="292"/>
            <ac:cxnSpMk id="126" creationId="{A3CC762A-C753-426A-8F94-76AA1A65850D}"/>
          </ac:cxnSpMkLst>
        </pc:cxnChg>
        <pc:cxnChg chg="mod">
          <ac:chgData name="Manasweeta Angane" userId="05da2731-9352-4b35-b713-60351f56afbd" providerId="ADAL" clId="{F5F97842-A295-4F9F-B89B-A63B35E1C32D}" dt="2022-10-10T09:14:09.303" v="3066"/>
          <ac:cxnSpMkLst>
            <pc:docMk/>
            <pc:sldMk cId="2092801620" sldId="292"/>
            <ac:cxnSpMk id="127" creationId="{A3BEFF45-EB07-4B6D-B01C-091155D38243}"/>
          </ac:cxnSpMkLst>
        </pc:cxnChg>
        <pc:cxnChg chg="mod">
          <ac:chgData name="Manasweeta Angane" userId="05da2731-9352-4b35-b713-60351f56afbd" providerId="ADAL" clId="{F5F97842-A295-4F9F-B89B-A63B35E1C32D}" dt="2022-10-10T09:14:09.303" v="3066"/>
          <ac:cxnSpMkLst>
            <pc:docMk/>
            <pc:sldMk cId="2092801620" sldId="292"/>
            <ac:cxnSpMk id="128" creationId="{01B4C89D-0BF7-4146-AA46-B098DA7847BF}"/>
          </ac:cxnSpMkLst>
        </pc:cxnChg>
        <pc:cxnChg chg="mod">
          <ac:chgData name="Manasweeta Angane" userId="05da2731-9352-4b35-b713-60351f56afbd" providerId="ADAL" clId="{F5F97842-A295-4F9F-B89B-A63B35E1C32D}" dt="2022-10-10T09:14:34.140" v="3070"/>
          <ac:cxnSpMkLst>
            <pc:docMk/>
            <pc:sldMk cId="2092801620" sldId="292"/>
            <ac:cxnSpMk id="148" creationId="{F04580BB-2800-455C-BDA4-E65C187FAB4B}"/>
          </ac:cxnSpMkLst>
        </pc:cxnChg>
        <pc:cxnChg chg="mod">
          <ac:chgData name="Manasweeta Angane" userId="05da2731-9352-4b35-b713-60351f56afbd" providerId="ADAL" clId="{F5F97842-A295-4F9F-B89B-A63B35E1C32D}" dt="2022-10-10T09:14:34.140" v="3070"/>
          <ac:cxnSpMkLst>
            <pc:docMk/>
            <pc:sldMk cId="2092801620" sldId="292"/>
            <ac:cxnSpMk id="154" creationId="{8715D00B-F65D-4389-81CF-649322183E68}"/>
          </ac:cxnSpMkLst>
        </pc:cxnChg>
        <pc:cxnChg chg="mod">
          <ac:chgData name="Manasweeta Angane" userId="05da2731-9352-4b35-b713-60351f56afbd" providerId="ADAL" clId="{F5F97842-A295-4F9F-B89B-A63B35E1C32D}" dt="2022-10-10T09:14:34.140" v="3070"/>
          <ac:cxnSpMkLst>
            <pc:docMk/>
            <pc:sldMk cId="2092801620" sldId="292"/>
            <ac:cxnSpMk id="155" creationId="{A7C2BA59-AC17-4B9D-A93D-0B2AE221ED35}"/>
          </ac:cxnSpMkLst>
        </pc:cxnChg>
        <pc:cxnChg chg="mod">
          <ac:chgData name="Manasweeta Angane" userId="05da2731-9352-4b35-b713-60351f56afbd" providerId="ADAL" clId="{F5F97842-A295-4F9F-B89B-A63B35E1C32D}" dt="2022-10-10T09:14:34.140" v="3070"/>
          <ac:cxnSpMkLst>
            <pc:docMk/>
            <pc:sldMk cId="2092801620" sldId="292"/>
            <ac:cxnSpMk id="156" creationId="{3D64DCAE-4547-401B-8238-DAACFDA54EEA}"/>
          </ac:cxnSpMkLst>
        </pc:cxnChg>
      </pc:sldChg>
      <pc:sldChg chg="addSp delSp modSp add mod ord">
        <pc:chgData name="Manasweeta Angane" userId="05da2731-9352-4b35-b713-60351f56afbd" providerId="ADAL" clId="{F5F97842-A295-4F9F-B89B-A63B35E1C32D}" dt="2022-10-10T12:23:01.184" v="4126" actId="1035"/>
        <pc:sldMkLst>
          <pc:docMk/>
          <pc:sldMk cId="1046971931" sldId="293"/>
        </pc:sldMkLst>
        <pc:spChg chg="add mod">
          <ac:chgData name="Manasweeta Angane" userId="05da2731-9352-4b35-b713-60351f56afbd" providerId="ADAL" clId="{F5F97842-A295-4F9F-B89B-A63B35E1C32D}" dt="2022-10-10T10:30:35.725" v="3765" actId="1036"/>
          <ac:spMkLst>
            <pc:docMk/>
            <pc:sldMk cId="1046971931" sldId="293"/>
            <ac:spMk id="11" creationId="{7D80F4E0-502C-4D49-85AC-4E84CA18DCC7}"/>
          </ac:spMkLst>
        </pc:spChg>
        <pc:spChg chg="del">
          <ac:chgData name="Manasweeta Angane" userId="05da2731-9352-4b35-b713-60351f56afbd" providerId="ADAL" clId="{F5F97842-A295-4F9F-B89B-A63B35E1C32D}" dt="2022-10-10T10:31:14.523" v="3766" actId="478"/>
          <ac:spMkLst>
            <pc:docMk/>
            <pc:sldMk cId="1046971931" sldId="293"/>
            <ac:spMk id="17" creationId="{8DB771DF-C627-44BB-8716-44C80EF9D83F}"/>
          </ac:spMkLst>
        </pc:spChg>
        <pc:spChg chg="del mod">
          <ac:chgData name="Manasweeta Angane" userId="05da2731-9352-4b35-b713-60351f56afbd" providerId="ADAL" clId="{F5F97842-A295-4F9F-B89B-A63B35E1C32D}" dt="2022-10-10T10:29:46.695" v="3706" actId="478"/>
          <ac:spMkLst>
            <pc:docMk/>
            <pc:sldMk cId="1046971931" sldId="293"/>
            <ac:spMk id="18" creationId="{45F2BEED-A6BE-45AE-BED7-62E52E5E5868}"/>
          </ac:spMkLst>
        </pc:spChg>
        <pc:spChg chg="add mod">
          <ac:chgData name="Manasweeta Angane" userId="05da2731-9352-4b35-b713-60351f56afbd" providerId="ADAL" clId="{F5F97842-A295-4F9F-B89B-A63B35E1C32D}" dt="2022-10-10T10:32:14.789" v="3768" actId="164"/>
          <ac:spMkLst>
            <pc:docMk/>
            <pc:sldMk cId="1046971931" sldId="293"/>
            <ac:spMk id="19" creationId="{39BB0AA1-5485-4301-A73F-29A1922DA998}"/>
          </ac:spMkLst>
        </pc:spChg>
        <pc:spChg chg="add mod">
          <ac:chgData name="Manasweeta Angane" userId="05da2731-9352-4b35-b713-60351f56afbd" providerId="ADAL" clId="{F5F97842-A295-4F9F-B89B-A63B35E1C32D}" dt="2022-10-10T10:32:14.789" v="3768" actId="164"/>
          <ac:spMkLst>
            <pc:docMk/>
            <pc:sldMk cId="1046971931" sldId="293"/>
            <ac:spMk id="20" creationId="{10156484-AAC7-45DF-A092-FAC7D85EB9B9}"/>
          </ac:spMkLst>
        </pc:spChg>
        <pc:spChg chg="add mod">
          <ac:chgData name="Manasweeta Angane" userId="05da2731-9352-4b35-b713-60351f56afbd" providerId="ADAL" clId="{F5F97842-A295-4F9F-B89B-A63B35E1C32D}" dt="2022-10-10T10:32:14.789" v="3768" actId="164"/>
          <ac:spMkLst>
            <pc:docMk/>
            <pc:sldMk cId="1046971931" sldId="293"/>
            <ac:spMk id="21" creationId="{C2E8FEDD-5388-464C-8F98-FA85764AE303}"/>
          </ac:spMkLst>
        </pc:spChg>
        <pc:spChg chg="add mod">
          <ac:chgData name="Manasweeta Angane" userId="05da2731-9352-4b35-b713-60351f56afbd" providerId="ADAL" clId="{F5F97842-A295-4F9F-B89B-A63B35E1C32D}" dt="2022-10-10T10:32:14.789" v="3768" actId="164"/>
          <ac:spMkLst>
            <pc:docMk/>
            <pc:sldMk cId="1046971931" sldId="293"/>
            <ac:spMk id="22" creationId="{6AF76752-EA2E-41C4-BBA9-EC723B27A591}"/>
          </ac:spMkLst>
        </pc:spChg>
        <pc:spChg chg="add mod">
          <ac:chgData name="Manasweeta Angane" userId="05da2731-9352-4b35-b713-60351f56afbd" providerId="ADAL" clId="{F5F97842-A295-4F9F-B89B-A63B35E1C32D}" dt="2022-10-10T12:22:52.168" v="4116" actId="1035"/>
          <ac:spMkLst>
            <pc:docMk/>
            <pc:sldMk cId="1046971931" sldId="293"/>
            <ac:spMk id="23" creationId="{4C715F5C-562C-4951-8683-8A7B45B99983}"/>
          </ac:spMkLst>
        </pc:spChg>
        <pc:spChg chg="add mod">
          <ac:chgData name="Manasweeta Angane" userId="05da2731-9352-4b35-b713-60351f56afbd" providerId="ADAL" clId="{F5F97842-A295-4F9F-B89B-A63B35E1C32D}" dt="2022-10-10T12:22:57.278" v="4121" actId="1035"/>
          <ac:spMkLst>
            <pc:docMk/>
            <pc:sldMk cId="1046971931" sldId="293"/>
            <ac:spMk id="24" creationId="{B69BCE85-BD7B-4E48-A163-58B643F99E35}"/>
          </ac:spMkLst>
        </pc:spChg>
        <pc:spChg chg="add mod">
          <ac:chgData name="Manasweeta Angane" userId="05da2731-9352-4b35-b713-60351f56afbd" providerId="ADAL" clId="{F5F97842-A295-4F9F-B89B-A63B35E1C32D}" dt="2022-10-10T12:23:01.184" v="4126" actId="1035"/>
          <ac:spMkLst>
            <pc:docMk/>
            <pc:sldMk cId="1046971931" sldId="293"/>
            <ac:spMk id="25" creationId="{5BFD7D79-2525-4D46-9923-247D6D654495}"/>
          </ac:spMkLst>
        </pc:spChg>
        <pc:spChg chg="add mod">
          <ac:chgData name="Manasweeta Angane" userId="05da2731-9352-4b35-b713-60351f56afbd" providerId="ADAL" clId="{F5F97842-A295-4F9F-B89B-A63B35E1C32D}" dt="2022-10-10T12:22:43.262" v="4086" actId="1035"/>
          <ac:spMkLst>
            <pc:docMk/>
            <pc:sldMk cId="1046971931" sldId="293"/>
            <ac:spMk id="26" creationId="{EF3E1FB5-A979-4AC9-940B-BAF4B16EA53F}"/>
          </ac:spMkLst>
        </pc:spChg>
        <pc:grpChg chg="add mod">
          <ac:chgData name="Manasweeta Angane" userId="05da2731-9352-4b35-b713-60351f56afbd" providerId="ADAL" clId="{F5F97842-A295-4F9F-B89B-A63B35E1C32D}" dt="2022-10-10T12:22:13.011" v="3936" actId="1076"/>
          <ac:grpSpMkLst>
            <pc:docMk/>
            <pc:sldMk cId="1046971931" sldId="293"/>
            <ac:grpSpMk id="2" creationId="{3A4A3B8D-71E8-485F-B477-237D5D7EC03E}"/>
          </ac:grpSpMkLst>
        </pc:grpChg>
        <pc:picChg chg="add mod">
          <ac:chgData name="Manasweeta Angane" userId="05da2731-9352-4b35-b713-60351f56afbd" providerId="ADAL" clId="{F5F97842-A295-4F9F-B89B-A63B35E1C32D}" dt="2022-10-10T09:01:19.183" v="3024"/>
          <ac:picMkLst>
            <pc:docMk/>
            <pc:sldMk cId="1046971931" sldId="293"/>
            <ac:picMk id="9" creationId="{6D54F64C-D71E-4CDA-B525-73CCBBF6E677}"/>
          </ac:picMkLst>
        </pc:picChg>
        <pc:picChg chg="add mod">
          <ac:chgData name="Manasweeta Angane" userId="05da2731-9352-4b35-b713-60351f56afbd" providerId="ADAL" clId="{F5F97842-A295-4F9F-B89B-A63B35E1C32D}" dt="2022-10-10T09:01:19.183" v="3024"/>
          <ac:picMkLst>
            <pc:docMk/>
            <pc:sldMk cId="1046971931" sldId="293"/>
            <ac:picMk id="10" creationId="{3C3B5F41-5D33-418A-9025-AADE291159F3}"/>
          </ac:picMkLst>
        </pc:picChg>
        <pc:picChg chg="add mod">
          <ac:chgData name="Manasweeta Angane" userId="05da2731-9352-4b35-b713-60351f56afbd" providerId="ADAL" clId="{F5F97842-A295-4F9F-B89B-A63B35E1C32D}" dt="2022-10-10T10:32:14.789" v="3768" actId="164"/>
          <ac:picMkLst>
            <pc:docMk/>
            <pc:sldMk cId="1046971931" sldId="293"/>
            <ac:picMk id="12" creationId="{7E11D957-01BE-4D03-ACE6-C254C3DD6B2E}"/>
          </ac:picMkLst>
        </pc:picChg>
        <pc:picChg chg="add mod">
          <ac:chgData name="Manasweeta Angane" userId="05da2731-9352-4b35-b713-60351f56afbd" providerId="ADAL" clId="{F5F97842-A295-4F9F-B89B-A63B35E1C32D}" dt="2022-10-10T10:32:14.789" v="3768" actId="164"/>
          <ac:picMkLst>
            <pc:docMk/>
            <pc:sldMk cId="1046971931" sldId="293"/>
            <ac:picMk id="13" creationId="{B6F741A9-2236-4D79-A317-7013707678F7}"/>
          </ac:picMkLst>
        </pc:picChg>
        <pc:picChg chg="add mod">
          <ac:chgData name="Manasweeta Angane" userId="05da2731-9352-4b35-b713-60351f56afbd" providerId="ADAL" clId="{F5F97842-A295-4F9F-B89B-A63B35E1C32D}" dt="2022-10-10T10:32:14.789" v="3768" actId="164"/>
          <ac:picMkLst>
            <pc:docMk/>
            <pc:sldMk cId="1046971931" sldId="293"/>
            <ac:picMk id="14" creationId="{976D58F9-8ED5-4A6B-BFFD-32B872FFDD62}"/>
          </ac:picMkLst>
        </pc:picChg>
        <pc:cxnChg chg="add mod">
          <ac:chgData name="Manasweeta Angane" userId="05da2731-9352-4b35-b713-60351f56afbd" providerId="ADAL" clId="{F5F97842-A295-4F9F-B89B-A63B35E1C32D}" dt="2022-10-10T10:32:14.789" v="3768" actId="164"/>
          <ac:cxnSpMkLst>
            <pc:docMk/>
            <pc:sldMk cId="1046971931" sldId="293"/>
            <ac:cxnSpMk id="15" creationId="{38995F14-65A0-4C6A-9083-5B3C4ED519D4}"/>
          </ac:cxnSpMkLst>
        </pc:cxnChg>
        <pc:cxnChg chg="add mod">
          <ac:chgData name="Manasweeta Angane" userId="05da2731-9352-4b35-b713-60351f56afbd" providerId="ADAL" clId="{F5F97842-A295-4F9F-B89B-A63B35E1C32D}" dt="2022-10-10T10:32:14.789" v="3768" actId="164"/>
          <ac:cxnSpMkLst>
            <pc:docMk/>
            <pc:sldMk cId="1046971931" sldId="293"/>
            <ac:cxnSpMk id="16" creationId="{A1F1F32A-B05F-45A2-9743-6E92841DA733}"/>
          </ac:cxnSpMkLst>
        </pc:cxnChg>
      </pc:sldChg>
      <pc:sldChg chg="addSp delSp modSp add mod modAnim">
        <pc:chgData name="Manasweeta Angane" userId="05da2731-9352-4b35-b713-60351f56afbd" providerId="ADAL" clId="{F5F97842-A295-4F9F-B89B-A63B35E1C32D}" dt="2022-10-10T12:48:56.667" v="4213" actId="1037"/>
        <pc:sldMkLst>
          <pc:docMk/>
          <pc:sldMk cId="72074382" sldId="294"/>
        </pc:sldMkLst>
        <pc:spChg chg="del">
          <ac:chgData name="Manasweeta Angane" userId="05da2731-9352-4b35-b713-60351f56afbd" providerId="ADAL" clId="{F5F97842-A295-4F9F-B89B-A63B35E1C32D}" dt="2022-10-10T11:27:28.264" v="3780" actId="478"/>
          <ac:spMkLst>
            <pc:docMk/>
            <pc:sldMk cId="72074382" sldId="294"/>
            <ac:spMk id="17" creationId="{8DB771DF-C627-44BB-8716-44C80EF9D83F}"/>
          </ac:spMkLst>
        </pc:spChg>
        <pc:spChg chg="mod">
          <ac:chgData name="Manasweeta Angane" userId="05da2731-9352-4b35-b713-60351f56afbd" providerId="ADAL" clId="{F5F97842-A295-4F9F-B89B-A63B35E1C32D}" dt="2022-10-10T12:48:56.667" v="4213" actId="1037"/>
          <ac:spMkLst>
            <pc:docMk/>
            <pc:sldMk cId="72074382" sldId="294"/>
            <ac:spMk id="18" creationId="{45F2BEED-A6BE-45AE-BED7-62E52E5E5868}"/>
          </ac:spMkLst>
        </pc:spChg>
        <pc:spChg chg="add del mod">
          <ac:chgData name="Manasweeta Angane" userId="05da2731-9352-4b35-b713-60351f56afbd" providerId="ADAL" clId="{F5F97842-A295-4F9F-B89B-A63B35E1C32D}" dt="2022-10-10T11:43:24.102" v="3854"/>
          <ac:spMkLst>
            <pc:docMk/>
            <pc:sldMk cId="72074382" sldId="294"/>
            <ac:spMk id="21" creationId="{69BE2F2B-7FCF-4665-A516-DFA3A657CD14}"/>
          </ac:spMkLst>
        </pc:spChg>
        <pc:spChg chg="add del mod">
          <ac:chgData name="Manasweeta Angane" userId="05da2731-9352-4b35-b713-60351f56afbd" providerId="ADAL" clId="{F5F97842-A295-4F9F-B89B-A63B35E1C32D}" dt="2022-10-10T11:43:31.680" v="3856"/>
          <ac:spMkLst>
            <pc:docMk/>
            <pc:sldMk cId="72074382" sldId="294"/>
            <ac:spMk id="22" creationId="{FDD3AD47-6820-41DF-8B17-FD200FEDA2D2}"/>
          </ac:spMkLst>
        </pc:spChg>
        <pc:spChg chg="add mod">
          <ac:chgData name="Manasweeta Angane" userId="05da2731-9352-4b35-b713-60351f56afbd" providerId="ADAL" clId="{F5F97842-A295-4F9F-B89B-A63B35E1C32D}" dt="2022-10-10T12:14:14.383" v="3917" actId="20577"/>
          <ac:spMkLst>
            <pc:docMk/>
            <pc:sldMk cId="72074382" sldId="294"/>
            <ac:spMk id="23" creationId="{F32DEE11-D5BD-4CD3-8559-BC8D5569FBB0}"/>
          </ac:spMkLst>
        </pc:spChg>
        <pc:graphicFrameChg chg="add del mod">
          <ac:chgData name="Manasweeta Angane" userId="05da2731-9352-4b35-b713-60351f56afbd" providerId="ADAL" clId="{F5F97842-A295-4F9F-B89B-A63B35E1C32D}" dt="2022-10-10T11:27:50.671" v="3785" actId="478"/>
          <ac:graphicFrameMkLst>
            <pc:docMk/>
            <pc:sldMk cId="72074382" sldId="294"/>
            <ac:graphicFrameMk id="11" creationId="{33330969-3E3F-42F6-A12E-568F7B8FBEAD}"/>
          </ac:graphicFrameMkLst>
        </pc:graphicFrameChg>
        <pc:graphicFrameChg chg="add del mod">
          <ac:chgData name="Manasweeta Angane" userId="05da2731-9352-4b35-b713-60351f56afbd" providerId="ADAL" clId="{F5F97842-A295-4F9F-B89B-A63B35E1C32D}" dt="2022-10-10T11:27:36.109" v="3782" actId="478"/>
          <ac:graphicFrameMkLst>
            <pc:docMk/>
            <pc:sldMk cId="72074382" sldId="294"/>
            <ac:graphicFrameMk id="12" creationId="{7531F538-D7B5-458B-9D6D-96FEC0BCE172}"/>
          </ac:graphicFrameMkLst>
        </pc:graphicFrameChg>
        <pc:graphicFrameChg chg="add del mod">
          <ac:chgData name="Manasweeta Angane" userId="05da2731-9352-4b35-b713-60351f56afbd" providerId="ADAL" clId="{F5F97842-A295-4F9F-B89B-A63B35E1C32D}" dt="2022-10-10T11:27:57.707" v="3787"/>
          <ac:graphicFrameMkLst>
            <pc:docMk/>
            <pc:sldMk cId="72074382" sldId="294"/>
            <ac:graphicFrameMk id="13" creationId="{58E7A6DD-0124-4D54-AD9F-2EF39CEC9D65}"/>
          </ac:graphicFrameMkLst>
        </pc:graphicFrameChg>
        <pc:graphicFrameChg chg="add mod modGraphic">
          <ac:chgData name="Manasweeta Angane" userId="05da2731-9352-4b35-b713-60351f56afbd" providerId="ADAL" clId="{F5F97842-A295-4F9F-B89B-A63B35E1C32D}" dt="2022-10-10T11:40:25.585" v="3848" actId="1036"/>
          <ac:graphicFrameMkLst>
            <pc:docMk/>
            <pc:sldMk cId="72074382" sldId="294"/>
            <ac:graphicFrameMk id="14" creationId="{AF1C1A4D-6DE2-4344-B335-B83D1CAF92C3}"/>
          </ac:graphicFrameMkLst>
        </pc:graphicFrameChg>
        <pc:graphicFrameChg chg="add del mod">
          <ac:chgData name="Manasweeta Angane" userId="05da2731-9352-4b35-b713-60351f56afbd" providerId="ADAL" clId="{F5F97842-A295-4F9F-B89B-A63B35E1C32D}" dt="2022-10-10T11:29:41.266" v="3794"/>
          <ac:graphicFrameMkLst>
            <pc:docMk/>
            <pc:sldMk cId="72074382" sldId="294"/>
            <ac:graphicFrameMk id="16" creationId="{3CB63437-7508-453E-BB68-E1EC33A2E12C}"/>
          </ac:graphicFrameMkLst>
        </pc:graphicFrameChg>
        <pc:graphicFrameChg chg="add del mod">
          <ac:chgData name="Manasweeta Angane" userId="05da2731-9352-4b35-b713-60351f56afbd" providerId="ADAL" clId="{F5F97842-A295-4F9F-B89B-A63B35E1C32D}" dt="2022-10-10T11:29:53.953" v="3797" actId="21"/>
          <ac:graphicFrameMkLst>
            <pc:docMk/>
            <pc:sldMk cId="72074382" sldId="294"/>
            <ac:graphicFrameMk id="19" creationId="{D1906F57-D696-4DA7-BCB1-43ACAAD353F9}"/>
          </ac:graphicFrameMkLst>
        </pc:graphicFrameChg>
        <pc:graphicFrameChg chg="add del mod">
          <ac:chgData name="Manasweeta Angane" userId="05da2731-9352-4b35-b713-60351f56afbd" providerId="ADAL" clId="{F5F97842-A295-4F9F-B89B-A63B35E1C32D}" dt="2022-10-10T11:30:00.735" v="3799" actId="21"/>
          <ac:graphicFrameMkLst>
            <pc:docMk/>
            <pc:sldMk cId="72074382" sldId="294"/>
            <ac:graphicFrameMk id="20" creationId="{F40B99AA-E047-4886-B1BA-E746AC198068}"/>
          </ac:graphicFrameMkLst>
        </pc:graphicFrameChg>
        <pc:picChg chg="mod">
          <ac:chgData name="Manasweeta Angane" userId="05da2731-9352-4b35-b713-60351f56afbd" providerId="ADAL" clId="{F5F97842-A295-4F9F-B89B-A63B35E1C32D}" dt="2022-10-10T11:40:15.803" v="3840" actId="1076"/>
          <ac:picMkLst>
            <pc:docMk/>
            <pc:sldMk cId="72074382" sldId="294"/>
            <ac:picMk id="2" creationId="{47410F70-FEDE-4C00-9054-F61F56F1C191}"/>
          </ac:picMkLst>
        </pc:picChg>
        <pc:picChg chg="del mod">
          <ac:chgData name="Manasweeta Angane" userId="05da2731-9352-4b35-b713-60351f56afbd" providerId="ADAL" clId="{F5F97842-A295-4F9F-B89B-A63B35E1C32D}" dt="2022-10-10T11:29:26.360" v="3792" actId="478"/>
          <ac:picMkLst>
            <pc:docMk/>
            <pc:sldMk cId="72074382" sldId="294"/>
            <ac:picMk id="3" creationId="{C34BDB21-3F82-4205-82C4-6A8EBE786A27}"/>
          </ac:picMkLst>
        </pc:picChg>
        <pc:picChg chg="add mod">
          <ac:chgData name="Manasweeta Angane" userId="05da2731-9352-4b35-b713-60351f56afbd" providerId="ADAL" clId="{F5F97842-A295-4F9F-B89B-A63B35E1C32D}" dt="2022-10-10T09:01:22.564" v="3025"/>
          <ac:picMkLst>
            <pc:docMk/>
            <pc:sldMk cId="72074382" sldId="294"/>
            <ac:picMk id="9" creationId="{9CFD5098-D197-40D2-BF3B-0EFEF6105E56}"/>
          </ac:picMkLst>
        </pc:picChg>
        <pc:picChg chg="add mod">
          <ac:chgData name="Manasweeta Angane" userId="05da2731-9352-4b35-b713-60351f56afbd" providerId="ADAL" clId="{F5F97842-A295-4F9F-B89B-A63B35E1C32D}" dt="2022-10-10T09:01:22.564" v="3025"/>
          <ac:picMkLst>
            <pc:docMk/>
            <pc:sldMk cId="72074382" sldId="294"/>
            <ac:picMk id="10" creationId="{64FA096A-8156-4287-968E-CF843C012768}"/>
          </ac:picMkLst>
        </pc:picChg>
      </pc:sldChg>
      <pc:sldChg chg="addSp delSp modSp add mod ord">
        <pc:chgData name="Manasweeta Angane" userId="05da2731-9352-4b35-b713-60351f56afbd" providerId="ADAL" clId="{F5F97842-A295-4F9F-B89B-A63B35E1C32D}" dt="2022-10-23T00:29:11.301" v="20939" actId="114"/>
        <pc:sldMkLst>
          <pc:docMk/>
          <pc:sldMk cId="3407421633" sldId="295"/>
        </pc:sldMkLst>
        <pc:spChg chg="add del mod">
          <ac:chgData name="Manasweeta Angane" userId="05da2731-9352-4b35-b713-60351f56afbd" providerId="ADAL" clId="{F5F97842-A295-4F9F-B89B-A63B35E1C32D}" dt="2022-10-18T04:42:40.437" v="10364" actId="22"/>
          <ac:spMkLst>
            <pc:docMk/>
            <pc:sldMk cId="3407421633" sldId="295"/>
            <ac:spMk id="13" creationId="{E821691C-2DFA-4E9D-A0FA-20713809E9A5}"/>
          </ac:spMkLst>
        </pc:spChg>
        <pc:spChg chg="add mod">
          <ac:chgData name="Manasweeta Angane" userId="05da2731-9352-4b35-b713-60351f56afbd" providerId="ADAL" clId="{F5F97842-A295-4F9F-B89B-A63B35E1C32D}" dt="2022-10-23T00:29:11.301" v="20939" actId="114"/>
          <ac:spMkLst>
            <pc:docMk/>
            <pc:sldMk cId="3407421633" sldId="295"/>
            <ac:spMk id="14" creationId="{0AA85FB1-2E66-4D23-B5C3-EB99AE50DB9F}"/>
          </ac:spMkLst>
        </pc:spChg>
        <pc:spChg chg="del">
          <ac:chgData name="Manasweeta Angane" userId="05da2731-9352-4b35-b713-60351f56afbd" providerId="ADAL" clId="{F5F97842-A295-4F9F-B89B-A63B35E1C32D}" dt="2022-10-10T13:00:07.564" v="4217" actId="478"/>
          <ac:spMkLst>
            <pc:docMk/>
            <pc:sldMk cId="3407421633" sldId="295"/>
            <ac:spMk id="17" creationId="{8DB771DF-C627-44BB-8716-44C80EF9D83F}"/>
          </ac:spMkLst>
        </pc:spChg>
        <pc:spChg chg="mod">
          <ac:chgData name="Manasweeta Angane" userId="05da2731-9352-4b35-b713-60351f56afbd" providerId="ADAL" clId="{F5F97842-A295-4F9F-B89B-A63B35E1C32D}" dt="2022-10-18T09:33:13.401" v="10658" actId="1035"/>
          <ac:spMkLst>
            <pc:docMk/>
            <pc:sldMk cId="3407421633" sldId="295"/>
            <ac:spMk id="18" creationId="{45F2BEED-A6BE-45AE-BED7-62E52E5E5868}"/>
          </ac:spMkLst>
        </pc:spChg>
        <pc:graphicFrameChg chg="add del mod">
          <ac:chgData name="Manasweeta Angane" userId="05da2731-9352-4b35-b713-60351f56afbd" providerId="ADAL" clId="{F5F97842-A295-4F9F-B89B-A63B35E1C32D}" dt="2022-10-10T11:30:07.839" v="3801"/>
          <ac:graphicFrameMkLst>
            <pc:docMk/>
            <pc:sldMk cId="3407421633" sldId="295"/>
            <ac:graphicFrameMk id="11" creationId="{AE3E39AD-E8E4-4B99-BE13-747450864CD4}"/>
          </ac:graphicFrameMkLst>
        </pc:graphicFrameChg>
        <pc:picChg chg="del mod">
          <ac:chgData name="Manasweeta Angane" userId="05da2731-9352-4b35-b713-60351f56afbd" providerId="ADAL" clId="{F5F97842-A295-4F9F-B89B-A63B35E1C32D}" dt="2022-10-10T13:20:57.133" v="4220" actId="478"/>
          <ac:picMkLst>
            <pc:docMk/>
            <pc:sldMk cId="3407421633" sldId="295"/>
            <ac:picMk id="2" creationId="{46BD6456-F19B-45C4-9BE6-860061418AF9}"/>
          </ac:picMkLst>
        </pc:picChg>
        <pc:picChg chg="del mod">
          <ac:chgData name="Manasweeta Angane" userId="05da2731-9352-4b35-b713-60351f56afbd" providerId="ADAL" clId="{F5F97842-A295-4F9F-B89B-A63B35E1C32D}" dt="2022-10-11T12:27:03.978" v="6544" actId="478"/>
          <ac:picMkLst>
            <pc:docMk/>
            <pc:sldMk cId="3407421633" sldId="295"/>
            <ac:picMk id="3" creationId="{0D7574BE-E720-4DB6-9E72-48272B8ADBF5}"/>
          </ac:picMkLst>
        </pc:picChg>
        <pc:picChg chg="mod">
          <ac:chgData name="Manasweeta Angane" userId="05da2731-9352-4b35-b713-60351f56afbd" providerId="ADAL" clId="{F5F97842-A295-4F9F-B89B-A63B35E1C32D}" dt="2022-10-18T09:33:04.220" v="10639" actId="1076"/>
          <ac:picMkLst>
            <pc:docMk/>
            <pc:sldMk cId="3407421633" sldId="295"/>
            <ac:picMk id="12" creationId="{70688E3F-A6B4-4C51-9251-69BA145F3629}"/>
          </ac:picMkLst>
        </pc:picChg>
      </pc:sldChg>
      <pc:sldChg chg="addSp delSp modSp add del mod delAnim modAnim">
        <pc:chgData name="Manasweeta Angane" userId="05da2731-9352-4b35-b713-60351f56afbd" providerId="ADAL" clId="{F5F97842-A295-4F9F-B89B-A63B35E1C32D}" dt="2022-10-10T09:41:22.994" v="3623" actId="2696"/>
        <pc:sldMkLst>
          <pc:docMk/>
          <pc:sldMk cId="2506831184" sldId="296"/>
        </pc:sldMkLst>
        <pc:spChg chg="del">
          <ac:chgData name="Manasweeta Angane" userId="05da2731-9352-4b35-b713-60351f56afbd" providerId="ADAL" clId="{F5F97842-A295-4F9F-B89B-A63B35E1C32D}" dt="2022-10-10T09:18:47.208" v="3197" actId="478"/>
          <ac:spMkLst>
            <pc:docMk/>
            <pc:sldMk cId="2506831184" sldId="296"/>
            <ac:spMk id="9" creationId="{E82D2DE3-65BE-438A-BA63-F9357C37226B}"/>
          </ac:spMkLst>
        </pc:spChg>
        <pc:spChg chg="del mod">
          <ac:chgData name="Manasweeta Angane" userId="05da2731-9352-4b35-b713-60351f56afbd" providerId="ADAL" clId="{F5F97842-A295-4F9F-B89B-A63B35E1C32D}" dt="2022-10-10T09:18:54.708" v="3201" actId="478"/>
          <ac:spMkLst>
            <pc:docMk/>
            <pc:sldMk cId="2506831184" sldId="296"/>
            <ac:spMk id="14" creationId="{0DABDE25-6706-4F92-B530-52E5212FA2CC}"/>
          </ac:spMkLst>
        </pc:spChg>
        <pc:spChg chg="mod">
          <ac:chgData name="Manasweeta Angane" userId="05da2731-9352-4b35-b713-60351f56afbd" providerId="ADAL" clId="{F5F97842-A295-4F9F-B89B-A63B35E1C32D}" dt="2022-10-10T09:21:00.602" v="3399" actId="20577"/>
          <ac:spMkLst>
            <pc:docMk/>
            <pc:sldMk cId="2506831184" sldId="296"/>
            <ac:spMk id="18" creationId="{45F2BEED-A6BE-45AE-BED7-62E52E5E5868}"/>
          </ac:spMkLst>
        </pc:spChg>
        <pc:spChg chg="mod">
          <ac:chgData name="Manasweeta Angane" userId="05da2731-9352-4b35-b713-60351f56afbd" providerId="ADAL" clId="{F5F97842-A295-4F9F-B89B-A63B35E1C32D}" dt="2022-10-10T09:21:29.873" v="3400"/>
          <ac:spMkLst>
            <pc:docMk/>
            <pc:sldMk cId="2506831184" sldId="296"/>
            <ac:spMk id="43" creationId="{53184F22-7C52-4CA6-ABAC-18090816E88B}"/>
          </ac:spMkLst>
        </pc:spChg>
        <pc:spChg chg="add del mod">
          <ac:chgData name="Manasweeta Angane" userId="05da2731-9352-4b35-b713-60351f56afbd" providerId="ADAL" clId="{F5F97842-A295-4F9F-B89B-A63B35E1C32D}" dt="2022-10-10T09:21:34.405" v="3401"/>
          <ac:spMkLst>
            <pc:docMk/>
            <pc:sldMk cId="2506831184" sldId="296"/>
            <ac:spMk id="44" creationId="{FA6E3DC5-0D92-40B7-BEFF-9CF80925D1E1}"/>
          </ac:spMkLst>
        </pc:spChg>
        <pc:spChg chg="add del mod">
          <ac:chgData name="Manasweeta Angane" userId="05da2731-9352-4b35-b713-60351f56afbd" providerId="ADAL" clId="{F5F97842-A295-4F9F-B89B-A63B35E1C32D}" dt="2022-10-10T09:21:34.405" v="3401"/>
          <ac:spMkLst>
            <pc:docMk/>
            <pc:sldMk cId="2506831184" sldId="296"/>
            <ac:spMk id="45" creationId="{742276AC-688D-468D-AB8F-384C550B4EB7}"/>
          </ac:spMkLst>
        </pc:spChg>
        <pc:spChg chg="add del mod">
          <ac:chgData name="Manasweeta Angane" userId="05da2731-9352-4b35-b713-60351f56afbd" providerId="ADAL" clId="{F5F97842-A295-4F9F-B89B-A63B35E1C32D}" dt="2022-10-10T09:21:34.405" v="3401"/>
          <ac:spMkLst>
            <pc:docMk/>
            <pc:sldMk cId="2506831184" sldId="296"/>
            <ac:spMk id="46" creationId="{8E92D5AE-870A-4B90-B70D-FDDE2D72F05C}"/>
          </ac:spMkLst>
        </pc:spChg>
        <pc:spChg chg="add del mod">
          <ac:chgData name="Manasweeta Angane" userId="05da2731-9352-4b35-b713-60351f56afbd" providerId="ADAL" clId="{F5F97842-A295-4F9F-B89B-A63B35E1C32D}" dt="2022-10-10T09:21:34.405" v="3401"/>
          <ac:spMkLst>
            <pc:docMk/>
            <pc:sldMk cId="2506831184" sldId="296"/>
            <ac:spMk id="47" creationId="{BB136DAE-C7B7-4041-B7F4-6E39F20ADFDD}"/>
          </ac:spMkLst>
        </pc:spChg>
        <pc:spChg chg="add del mod">
          <ac:chgData name="Manasweeta Angane" userId="05da2731-9352-4b35-b713-60351f56afbd" providerId="ADAL" clId="{F5F97842-A295-4F9F-B89B-A63B35E1C32D}" dt="2022-10-10T09:21:34.405" v="3401"/>
          <ac:spMkLst>
            <pc:docMk/>
            <pc:sldMk cId="2506831184" sldId="296"/>
            <ac:spMk id="48" creationId="{F01C042D-5C05-4500-8B89-BEA3B2FEFCEB}"/>
          </ac:spMkLst>
        </pc:spChg>
        <pc:spChg chg="add del mod">
          <ac:chgData name="Manasweeta Angane" userId="05da2731-9352-4b35-b713-60351f56afbd" providerId="ADAL" clId="{F5F97842-A295-4F9F-B89B-A63B35E1C32D}" dt="2022-10-10T09:21:34.405" v="3401"/>
          <ac:spMkLst>
            <pc:docMk/>
            <pc:sldMk cId="2506831184" sldId="296"/>
            <ac:spMk id="53" creationId="{DA7079B8-3CD5-4925-8C5D-8D70EFE17C85}"/>
          </ac:spMkLst>
        </pc:spChg>
        <pc:spChg chg="mod">
          <ac:chgData name="Manasweeta Angane" userId="05da2731-9352-4b35-b713-60351f56afbd" providerId="ADAL" clId="{F5F97842-A295-4F9F-B89B-A63B35E1C32D}" dt="2022-10-10T09:21:29.873" v="3400"/>
          <ac:spMkLst>
            <pc:docMk/>
            <pc:sldMk cId="2506831184" sldId="296"/>
            <ac:spMk id="56" creationId="{C98861C1-12A9-470F-9ACD-7A9DFA2F01D3}"/>
          </ac:spMkLst>
        </pc:spChg>
        <pc:spChg chg="mod">
          <ac:chgData name="Manasweeta Angane" userId="05da2731-9352-4b35-b713-60351f56afbd" providerId="ADAL" clId="{F5F97842-A295-4F9F-B89B-A63B35E1C32D}" dt="2022-10-10T09:21:29.873" v="3400"/>
          <ac:spMkLst>
            <pc:docMk/>
            <pc:sldMk cId="2506831184" sldId="296"/>
            <ac:spMk id="61" creationId="{B2720000-5C31-47E8-AA23-1D961AF3FF35}"/>
          </ac:spMkLst>
        </pc:spChg>
        <pc:spChg chg="add del mod">
          <ac:chgData name="Manasweeta Angane" userId="05da2731-9352-4b35-b713-60351f56afbd" providerId="ADAL" clId="{F5F97842-A295-4F9F-B89B-A63B35E1C32D}" dt="2022-10-10T09:21:34.405" v="3401"/>
          <ac:spMkLst>
            <pc:docMk/>
            <pc:sldMk cId="2506831184" sldId="296"/>
            <ac:spMk id="64" creationId="{8136B03C-AB40-445B-B994-30A36DA08B4F}"/>
          </ac:spMkLst>
        </pc:spChg>
        <pc:spChg chg="add del mod">
          <ac:chgData name="Manasweeta Angane" userId="05da2731-9352-4b35-b713-60351f56afbd" providerId="ADAL" clId="{F5F97842-A295-4F9F-B89B-A63B35E1C32D}" dt="2022-10-10T09:21:34.405" v="3401"/>
          <ac:spMkLst>
            <pc:docMk/>
            <pc:sldMk cId="2506831184" sldId="296"/>
            <ac:spMk id="65" creationId="{4ACB7C4B-91B4-435B-8628-2C96037A81A4}"/>
          </ac:spMkLst>
        </pc:spChg>
        <pc:spChg chg="add del mod">
          <ac:chgData name="Manasweeta Angane" userId="05da2731-9352-4b35-b713-60351f56afbd" providerId="ADAL" clId="{F5F97842-A295-4F9F-B89B-A63B35E1C32D}" dt="2022-10-10T09:21:34.405" v="3401"/>
          <ac:spMkLst>
            <pc:docMk/>
            <pc:sldMk cId="2506831184" sldId="296"/>
            <ac:spMk id="66" creationId="{ABAE1F60-3EFF-4106-A4BC-497FB8D0B32A}"/>
          </ac:spMkLst>
        </pc:spChg>
        <pc:spChg chg="add del mod">
          <ac:chgData name="Manasweeta Angane" userId="05da2731-9352-4b35-b713-60351f56afbd" providerId="ADAL" clId="{F5F97842-A295-4F9F-B89B-A63B35E1C32D}" dt="2022-10-10T09:21:34.405" v="3401"/>
          <ac:spMkLst>
            <pc:docMk/>
            <pc:sldMk cId="2506831184" sldId="296"/>
            <ac:spMk id="69" creationId="{6FA22699-CCB6-4005-AF91-FCA4538BCD1A}"/>
          </ac:spMkLst>
        </pc:spChg>
        <pc:spChg chg="mod">
          <ac:chgData name="Manasweeta Angane" userId="05da2731-9352-4b35-b713-60351f56afbd" providerId="ADAL" clId="{F5F97842-A295-4F9F-B89B-A63B35E1C32D}" dt="2022-10-10T09:21:49.084" v="3402"/>
          <ac:spMkLst>
            <pc:docMk/>
            <pc:sldMk cId="2506831184" sldId="296"/>
            <ac:spMk id="97" creationId="{1710CCD6-D9BF-48EE-A2D9-B400573B7609}"/>
          </ac:spMkLst>
        </pc:spChg>
        <pc:spChg chg="add del mod">
          <ac:chgData name="Manasweeta Angane" userId="05da2731-9352-4b35-b713-60351f56afbd" providerId="ADAL" clId="{F5F97842-A295-4F9F-B89B-A63B35E1C32D}" dt="2022-10-10T09:21:56.631" v="3403"/>
          <ac:spMkLst>
            <pc:docMk/>
            <pc:sldMk cId="2506831184" sldId="296"/>
            <ac:spMk id="98" creationId="{FEE784C0-DACD-4E45-A30B-69829F39165C}"/>
          </ac:spMkLst>
        </pc:spChg>
        <pc:spChg chg="add del mod">
          <ac:chgData name="Manasweeta Angane" userId="05da2731-9352-4b35-b713-60351f56afbd" providerId="ADAL" clId="{F5F97842-A295-4F9F-B89B-A63B35E1C32D}" dt="2022-10-10T09:21:56.631" v="3403"/>
          <ac:spMkLst>
            <pc:docMk/>
            <pc:sldMk cId="2506831184" sldId="296"/>
            <ac:spMk id="99" creationId="{AB28F719-D4F3-426B-9BCA-B1140239D188}"/>
          </ac:spMkLst>
        </pc:spChg>
        <pc:spChg chg="add del mod">
          <ac:chgData name="Manasweeta Angane" userId="05da2731-9352-4b35-b713-60351f56afbd" providerId="ADAL" clId="{F5F97842-A295-4F9F-B89B-A63B35E1C32D}" dt="2022-10-10T09:21:56.631" v="3403"/>
          <ac:spMkLst>
            <pc:docMk/>
            <pc:sldMk cId="2506831184" sldId="296"/>
            <ac:spMk id="100" creationId="{74FC26C8-F259-49DA-A2AA-7EF6D934D532}"/>
          </ac:spMkLst>
        </pc:spChg>
        <pc:spChg chg="add del mod">
          <ac:chgData name="Manasweeta Angane" userId="05da2731-9352-4b35-b713-60351f56afbd" providerId="ADAL" clId="{F5F97842-A295-4F9F-B89B-A63B35E1C32D}" dt="2022-10-10T09:21:56.631" v="3403"/>
          <ac:spMkLst>
            <pc:docMk/>
            <pc:sldMk cId="2506831184" sldId="296"/>
            <ac:spMk id="101" creationId="{D996DE14-FBB7-4343-AD30-555F3E46CC44}"/>
          </ac:spMkLst>
        </pc:spChg>
        <pc:spChg chg="add del mod">
          <ac:chgData name="Manasweeta Angane" userId="05da2731-9352-4b35-b713-60351f56afbd" providerId="ADAL" clId="{F5F97842-A295-4F9F-B89B-A63B35E1C32D}" dt="2022-10-10T09:21:56.631" v="3403"/>
          <ac:spMkLst>
            <pc:docMk/>
            <pc:sldMk cId="2506831184" sldId="296"/>
            <ac:spMk id="102" creationId="{6744ED30-4134-43D9-AB73-0C69B0E8370D}"/>
          </ac:spMkLst>
        </pc:spChg>
        <pc:spChg chg="add del mod">
          <ac:chgData name="Manasweeta Angane" userId="05da2731-9352-4b35-b713-60351f56afbd" providerId="ADAL" clId="{F5F97842-A295-4F9F-B89B-A63B35E1C32D}" dt="2022-10-10T09:21:56.631" v="3403"/>
          <ac:spMkLst>
            <pc:docMk/>
            <pc:sldMk cId="2506831184" sldId="296"/>
            <ac:spMk id="107" creationId="{FF364FAF-BB32-4EB4-B0F1-06AE25B7DCF4}"/>
          </ac:spMkLst>
        </pc:spChg>
        <pc:spChg chg="mod">
          <ac:chgData name="Manasweeta Angane" userId="05da2731-9352-4b35-b713-60351f56afbd" providerId="ADAL" clId="{F5F97842-A295-4F9F-B89B-A63B35E1C32D}" dt="2022-10-10T09:21:49.084" v="3402"/>
          <ac:spMkLst>
            <pc:docMk/>
            <pc:sldMk cId="2506831184" sldId="296"/>
            <ac:spMk id="110" creationId="{5EF1FF65-18EF-4864-843A-7169FA720E99}"/>
          </ac:spMkLst>
        </pc:spChg>
        <pc:spChg chg="mod">
          <ac:chgData name="Manasweeta Angane" userId="05da2731-9352-4b35-b713-60351f56afbd" providerId="ADAL" clId="{F5F97842-A295-4F9F-B89B-A63B35E1C32D}" dt="2022-10-10T09:21:49.084" v="3402"/>
          <ac:spMkLst>
            <pc:docMk/>
            <pc:sldMk cId="2506831184" sldId="296"/>
            <ac:spMk id="115" creationId="{F9487C21-0E2E-4303-AAC5-B2FBD9155F63}"/>
          </ac:spMkLst>
        </pc:spChg>
        <pc:spChg chg="add del mod">
          <ac:chgData name="Manasweeta Angane" userId="05da2731-9352-4b35-b713-60351f56afbd" providerId="ADAL" clId="{F5F97842-A295-4F9F-B89B-A63B35E1C32D}" dt="2022-10-10T09:21:56.631" v="3403"/>
          <ac:spMkLst>
            <pc:docMk/>
            <pc:sldMk cId="2506831184" sldId="296"/>
            <ac:spMk id="118" creationId="{D593687A-D568-4174-A820-BD8D492E1E3A}"/>
          </ac:spMkLst>
        </pc:spChg>
        <pc:spChg chg="add del mod">
          <ac:chgData name="Manasweeta Angane" userId="05da2731-9352-4b35-b713-60351f56afbd" providerId="ADAL" clId="{F5F97842-A295-4F9F-B89B-A63B35E1C32D}" dt="2022-10-10T09:21:56.631" v="3403"/>
          <ac:spMkLst>
            <pc:docMk/>
            <pc:sldMk cId="2506831184" sldId="296"/>
            <ac:spMk id="119" creationId="{7F4B979F-33E7-44C1-8E95-731347404AB4}"/>
          </ac:spMkLst>
        </pc:spChg>
        <pc:spChg chg="add del mod">
          <ac:chgData name="Manasweeta Angane" userId="05da2731-9352-4b35-b713-60351f56afbd" providerId="ADAL" clId="{F5F97842-A295-4F9F-B89B-A63B35E1C32D}" dt="2022-10-10T09:21:56.631" v="3403"/>
          <ac:spMkLst>
            <pc:docMk/>
            <pc:sldMk cId="2506831184" sldId="296"/>
            <ac:spMk id="120" creationId="{A3529333-392C-48B6-B69A-520A821E4D5D}"/>
          </ac:spMkLst>
        </pc:spChg>
        <pc:spChg chg="add del mod">
          <ac:chgData name="Manasweeta Angane" userId="05da2731-9352-4b35-b713-60351f56afbd" providerId="ADAL" clId="{F5F97842-A295-4F9F-B89B-A63B35E1C32D}" dt="2022-10-10T09:21:56.631" v="3403"/>
          <ac:spMkLst>
            <pc:docMk/>
            <pc:sldMk cId="2506831184" sldId="296"/>
            <ac:spMk id="123" creationId="{93FC45D0-758E-4439-BA99-1014CA21E88D}"/>
          </ac:spMkLst>
        </pc:spChg>
        <pc:spChg chg="mod">
          <ac:chgData name="Manasweeta Angane" userId="05da2731-9352-4b35-b713-60351f56afbd" providerId="ADAL" clId="{F5F97842-A295-4F9F-B89B-A63B35E1C32D}" dt="2022-10-10T09:21:59.271" v="3404"/>
          <ac:spMkLst>
            <pc:docMk/>
            <pc:sldMk cId="2506831184" sldId="296"/>
            <ac:spMk id="151" creationId="{E20E3620-BF5D-41EE-964E-8AB510213C5F}"/>
          </ac:spMkLst>
        </pc:spChg>
        <pc:spChg chg="add del mod">
          <ac:chgData name="Manasweeta Angane" userId="05da2731-9352-4b35-b713-60351f56afbd" providerId="ADAL" clId="{F5F97842-A295-4F9F-B89B-A63B35E1C32D}" dt="2022-10-10T09:22:12.756" v="3405"/>
          <ac:spMkLst>
            <pc:docMk/>
            <pc:sldMk cId="2506831184" sldId="296"/>
            <ac:spMk id="152" creationId="{0FA21DED-68F8-4F5A-92E8-6CDA7AEF3856}"/>
          </ac:spMkLst>
        </pc:spChg>
        <pc:spChg chg="add del mod">
          <ac:chgData name="Manasweeta Angane" userId="05da2731-9352-4b35-b713-60351f56afbd" providerId="ADAL" clId="{F5F97842-A295-4F9F-B89B-A63B35E1C32D}" dt="2022-10-10T09:22:12.756" v="3405"/>
          <ac:spMkLst>
            <pc:docMk/>
            <pc:sldMk cId="2506831184" sldId="296"/>
            <ac:spMk id="153" creationId="{2B5C0AB1-DEC3-4658-BA8D-9D66666E8A52}"/>
          </ac:spMkLst>
        </pc:spChg>
        <pc:spChg chg="add del mod">
          <ac:chgData name="Manasweeta Angane" userId="05da2731-9352-4b35-b713-60351f56afbd" providerId="ADAL" clId="{F5F97842-A295-4F9F-B89B-A63B35E1C32D}" dt="2022-10-10T09:22:12.756" v="3405"/>
          <ac:spMkLst>
            <pc:docMk/>
            <pc:sldMk cId="2506831184" sldId="296"/>
            <ac:spMk id="154" creationId="{C6EA5D6A-B429-4568-A45A-7CDC1D639C54}"/>
          </ac:spMkLst>
        </pc:spChg>
        <pc:spChg chg="add del mod">
          <ac:chgData name="Manasweeta Angane" userId="05da2731-9352-4b35-b713-60351f56afbd" providerId="ADAL" clId="{F5F97842-A295-4F9F-B89B-A63B35E1C32D}" dt="2022-10-10T09:22:12.756" v="3405"/>
          <ac:spMkLst>
            <pc:docMk/>
            <pc:sldMk cId="2506831184" sldId="296"/>
            <ac:spMk id="155" creationId="{F9F58F8F-7043-49F1-B577-9C3392585149}"/>
          </ac:spMkLst>
        </pc:spChg>
        <pc:spChg chg="add del mod">
          <ac:chgData name="Manasweeta Angane" userId="05da2731-9352-4b35-b713-60351f56afbd" providerId="ADAL" clId="{F5F97842-A295-4F9F-B89B-A63B35E1C32D}" dt="2022-10-10T09:22:12.756" v="3405"/>
          <ac:spMkLst>
            <pc:docMk/>
            <pc:sldMk cId="2506831184" sldId="296"/>
            <ac:spMk id="156" creationId="{D39C5409-66C2-444A-8EA3-09E38022AED0}"/>
          </ac:spMkLst>
        </pc:spChg>
        <pc:spChg chg="add del mod">
          <ac:chgData name="Manasweeta Angane" userId="05da2731-9352-4b35-b713-60351f56afbd" providerId="ADAL" clId="{F5F97842-A295-4F9F-B89B-A63B35E1C32D}" dt="2022-10-10T09:22:12.756" v="3405"/>
          <ac:spMkLst>
            <pc:docMk/>
            <pc:sldMk cId="2506831184" sldId="296"/>
            <ac:spMk id="161" creationId="{6D793248-F45E-4565-84E3-41872A30775E}"/>
          </ac:spMkLst>
        </pc:spChg>
        <pc:spChg chg="mod">
          <ac:chgData name="Manasweeta Angane" userId="05da2731-9352-4b35-b713-60351f56afbd" providerId="ADAL" clId="{F5F97842-A295-4F9F-B89B-A63B35E1C32D}" dt="2022-10-10T09:21:59.271" v="3404"/>
          <ac:spMkLst>
            <pc:docMk/>
            <pc:sldMk cId="2506831184" sldId="296"/>
            <ac:spMk id="164" creationId="{D7630177-49EE-4F44-939C-5C208917BF37}"/>
          </ac:spMkLst>
        </pc:spChg>
        <pc:spChg chg="mod">
          <ac:chgData name="Manasweeta Angane" userId="05da2731-9352-4b35-b713-60351f56afbd" providerId="ADAL" clId="{F5F97842-A295-4F9F-B89B-A63B35E1C32D}" dt="2022-10-10T09:21:59.271" v="3404"/>
          <ac:spMkLst>
            <pc:docMk/>
            <pc:sldMk cId="2506831184" sldId="296"/>
            <ac:spMk id="169" creationId="{FB8E4F96-364F-497E-8A2C-119CB0FE83D4}"/>
          </ac:spMkLst>
        </pc:spChg>
        <pc:spChg chg="add del mod">
          <ac:chgData name="Manasweeta Angane" userId="05da2731-9352-4b35-b713-60351f56afbd" providerId="ADAL" clId="{F5F97842-A295-4F9F-B89B-A63B35E1C32D}" dt="2022-10-10T09:22:12.756" v="3405"/>
          <ac:spMkLst>
            <pc:docMk/>
            <pc:sldMk cId="2506831184" sldId="296"/>
            <ac:spMk id="172" creationId="{BE78B7CE-EE5C-4348-B57F-CDE35CB591F8}"/>
          </ac:spMkLst>
        </pc:spChg>
        <pc:spChg chg="add del mod">
          <ac:chgData name="Manasweeta Angane" userId="05da2731-9352-4b35-b713-60351f56afbd" providerId="ADAL" clId="{F5F97842-A295-4F9F-B89B-A63B35E1C32D}" dt="2022-10-10T09:22:12.756" v="3405"/>
          <ac:spMkLst>
            <pc:docMk/>
            <pc:sldMk cId="2506831184" sldId="296"/>
            <ac:spMk id="173" creationId="{2B4B100E-3154-4661-8E1C-9F3CD10C93DD}"/>
          </ac:spMkLst>
        </pc:spChg>
        <pc:spChg chg="add del mod">
          <ac:chgData name="Manasweeta Angane" userId="05da2731-9352-4b35-b713-60351f56afbd" providerId="ADAL" clId="{F5F97842-A295-4F9F-B89B-A63B35E1C32D}" dt="2022-10-10T09:22:12.756" v="3405"/>
          <ac:spMkLst>
            <pc:docMk/>
            <pc:sldMk cId="2506831184" sldId="296"/>
            <ac:spMk id="174" creationId="{1DADE6DE-B06E-4F6C-875C-CCF774C8F44E}"/>
          </ac:spMkLst>
        </pc:spChg>
        <pc:spChg chg="add del mod">
          <ac:chgData name="Manasweeta Angane" userId="05da2731-9352-4b35-b713-60351f56afbd" providerId="ADAL" clId="{F5F97842-A295-4F9F-B89B-A63B35E1C32D}" dt="2022-10-10T09:22:12.756" v="3405"/>
          <ac:spMkLst>
            <pc:docMk/>
            <pc:sldMk cId="2506831184" sldId="296"/>
            <ac:spMk id="177" creationId="{F6B79D9D-7DE1-4AD3-AC67-D259A7948AA5}"/>
          </ac:spMkLst>
        </pc:spChg>
        <pc:spChg chg="mod">
          <ac:chgData name="Manasweeta Angane" userId="05da2731-9352-4b35-b713-60351f56afbd" providerId="ADAL" clId="{F5F97842-A295-4F9F-B89B-A63B35E1C32D}" dt="2022-10-10T09:29:32.148" v="3406"/>
          <ac:spMkLst>
            <pc:docMk/>
            <pc:sldMk cId="2506831184" sldId="296"/>
            <ac:spMk id="205" creationId="{B1FB22A7-C803-4BCA-945F-0D5ACDEAF9F4}"/>
          </ac:spMkLst>
        </pc:spChg>
        <pc:spChg chg="add del mod">
          <ac:chgData name="Manasweeta Angane" userId="05da2731-9352-4b35-b713-60351f56afbd" providerId="ADAL" clId="{F5F97842-A295-4F9F-B89B-A63B35E1C32D}" dt="2022-10-10T09:33:42.164" v="3480"/>
          <ac:spMkLst>
            <pc:docMk/>
            <pc:sldMk cId="2506831184" sldId="296"/>
            <ac:spMk id="206" creationId="{DA774114-98AD-48BD-8E9C-6A83736B6659}"/>
          </ac:spMkLst>
        </pc:spChg>
        <pc:spChg chg="add del mod">
          <ac:chgData name="Manasweeta Angane" userId="05da2731-9352-4b35-b713-60351f56afbd" providerId="ADAL" clId="{F5F97842-A295-4F9F-B89B-A63B35E1C32D}" dt="2022-10-10T09:33:42.164" v="3480"/>
          <ac:spMkLst>
            <pc:docMk/>
            <pc:sldMk cId="2506831184" sldId="296"/>
            <ac:spMk id="207" creationId="{2C1293C1-9426-46F9-88B5-759944C14826}"/>
          </ac:spMkLst>
        </pc:spChg>
        <pc:spChg chg="add del mod">
          <ac:chgData name="Manasweeta Angane" userId="05da2731-9352-4b35-b713-60351f56afbd" providerId="ADAL" clId="{F5F97842-A295-4F9F-B89B-A63B35E1C32D}" dt="2022-10-10T09:33:42.164" v="3480"/>
          <ac:spMkLst>
            <pc:docMk/>
            <pc:sldMk cId="2506831184" sldId="296"/>
            <ac:spMk id="208" creationId="{E0D4F278-7E3F-4EAB-8A9C-57CAE6A4C858}"/>
          </ac:spMkLst>
        </pc:spChg>
        <pc:spChg chg="add del mod">
          <ac:chgData name="Manasweeta Angane" userId="05da2731-9352-4b35-b713-60351f56afbd" providerId="ADAL" clId="{F5F97842-A295-4F9F-B89B-A63B35E1C32D}" dt="2022-10-10T09:33:42.164" v="3480"/>
          <ac:spMkLst>
            <pc:docMk/>
            <pc:sldMk cId="2506831184" sldId="296"/>
            <ac:spMk id="209" creationId="{1FD859BA-810C-46CA-BA28-ADE344D40666}"/>
          </ac:spMkLst>
        </pc:spChg>
        <pc:spChg chg="add del mod">
          <ac:chgData name="Manasweeta Angane" userId="05da2731-9352-4b35-b713-60351f56afbd" providerId="ADAL" clId="{F5F97842-A295-4F9F-B89B-A63B35E1C32D}" dt="2022-10-10T09:33:42.164" v="3480"/>
          <ac:spMkLst>
            <pc:docMk/>
            <pc:sldMk cId="2506831184" sldId="296"/>
            <ac:spMk id="210" creationId="{60FBE0DB-58D8-4DAA-BEDA-C63DD1EF23A1}"/>
          </ac:spMkLst>
        </pc:spChg>
        <pc:spChg chg="add del mod">
          <ac:chgData name="Manasweeta Angane" userId="05da2731-9352-4b35-b713-60351f56afbd" providerId="ADAL" clId="{F5F97842-A295-4F9F-B89B-A63B35E1C32D}" dt="2022-10-10T09:33:42.164" v="3480"/>
          <ac:spMkLst>
            <pc:docMk/>
            <pc:sldMk cId="2506831184" sldId="296"/>
            <ac:spMk id="215" creationId="{2EC51716-4A9F-4C3E-A805-AA6883BC5472}"/>
          </ac:spMkLst>
        </pc:spChg>
        <pc:spChg chg="mod">
          <ac:chgData name="Manasweeta Angane" userId="05da2731-9352-4b35-b713-60351f56afbd" providerId="ADAL" clId="{F5F97842-A295-4F9F-B89B-A63B35E1C32D}" dt="2022-10-10T09:29:32.148" v="3406"/>
          <ac:spMkLst>
            <pc:docMk/>
            <pc:sldMk cId="2506831184" sldId="296"/>
            <ac:spMk id="218" creationId="{694CBC3A-7379-4931-B46F-9658E1A0D112}"/>
          </ac:spMkLst>
        </pc:spChg>
        <pc:spChg chg="mod">
          <ac:chgData name="Manasweeta Angane" userId="05da2731-9352-4b35-b713-60351f56afbd" providerId="ADAL" clId="{F5F97842-A295-4F9F-B89B-A63B35E1C32D}" dt="2022-10-10T09:29:32.148" v="3406"/>
          <ac:spMkLst>
            <pc:docMk/>
            <pc:sldMk cId="2506831184" sldId="296"/>
            <ac:spMk id="223" creationId="{04EE4D3C-1B51-403D-A435-809BDC17FFB4}"/>
          </ac:spMkLst>
        </pc:spChg>
        <pc:spChg chg="add del mod">
          <ac:chgData name="Manasweeta Angane" userId="05da2731-9352-4b35-b713-60351f56afbd" providerId="ADAL" clId="{F5F97842-A295-4F9F-B89B-A63B35E1C32D}" dt="2022-10-10T09:33:42.164" v="3480"/>
          <ac:spMkLst>
            <pc:docMk/>
            <pc:sldMk cId="2506831184" sldId="296"/>
            <ac:spMk id="226" creationId="{2A07F601-676B-47B2-8450-9823D1FFCBE1}"/>
          </ac:spMkLst>
        </pc:spChg>
        <pc:spChg chg="add del mod">
          <ac:chgData name="Manasweeta Angane" userId="05da2731-9352-4b35-b713-60351f56afbd" providerId="ADAL" clId="{F5F97842-A295-4F9F-B89B-A63B35E1C32D}" dt="2022-10-10T09:33:42.164" v="3480"/>
          <ac:spMkLst>
            <pc:docMk/>
            <pc:sldMk cId="2506831184" sldId="296"/>
            <ac:spMk id="227" creationId="{7A86ABDB-762C-451D-B3F3-90BE0A3EB3D8}"/>
          </ac:spMkLst>
        </pc:spChg>
        <pc:spChg chg="add del mod">
          <ac:chgData name="Manasweeta Angane" userId="05da2731-9352-4b35-b713-60351f56afbd" providerId="ADAL" clId="{F5F97842-A295-4F9F-B89B-A63B35E1C32D}" dt="2022-10-10T09:33:42.164" v="3480"/>
          <ac:spMkLst>
            <pc:docMk/>
            <pc:sldMk cId="2506831184" sldId="296"/>
            <ac:spMk id="228" creationId="{1BF6B78D-DCAA-448B-B5B4-DF9241864432}"/>
          </ac:spMkLst>
        </pc:spChg>
        <pc:spChg chg="add del mod">
          <ac:chgData name="Manasweeta Angane" userId="05da2731-9352-4b35-b713-60351f56afbd" providerId="ADAL" clId="{F5F97842-A295-4F9F-B89B-A63B35E1C32D}" dt="2022-10-10T09:33:42.164" v="3480"/>
          <ac:spMkLst>
            <pc:docMk/>
            <pc:sldMk cId="2506831184" sldId="296"/>
            <ac:spMk id="231" creationId="{F7EB21C1-A783-4C9E-8BFA-2B2125F44DD5}"/>
          </ac:spMkLst>
        </pc:spChg>
        <pc:spChg chg="add del mod">
          <ac:chgData name="Manasweeta Angane" userId="05da2731-9352-4b35-b713-60351f56afbd" providerId="ADAL" clId="{F5F97842-A295-4F9F-B89B-A63B35E1C32D}" dt="2022-10-10T09:33:42.164" v="3480"/>
          <ac:spMkLst>
            <pc:docMk/>
            <pc:sldMk cId="2506831184" sldId="296"/>
            <ac:spMk id="233" creationId="{FD9B378A-B3FF-42B7-A22B-63646F832341}"/>
          </ac:spMkLst>
        </pc:spChg>
        <pc:spChg chg="mod">
          <ac:chgData name="Manasweeta Angane" userId="05da2731-9352-4b35-b713-60351f56afbd" providerId="ADAL" clId="{F5F97842-A295-4F9F-B89B-A63B35E1C32D}" dt="2022-10-10T09:34:40.899" v="3481"/>
          <ac:spMkLst>
            <pc:docMk/>
            <pc:sldMk cId="2506831184" sldId="296"/>
            <ac:spMk id="238" creationId="{1ADE897E-3699-4328-89D4-FBF5677526CD}"/>
          </ac:spMkLst>
        </pc:spChg>
        <pc:spChg chg="mod">
          <ac:chgData name="Manasweeta Angane" userId="05da2731-9352-4b35-b713-60351f56afbd" providerId="ADAL" clId="{F5F97842-A295-4F9F-B89B-A63B35E1C32D}" dt="2022-10-10T09:34:40.899" v="3481"/>
          <ac:spMkLst>
            <pc:docMk/>
            <pc:sldMk cId="2506831184" sldId="296"/>
            <ac:spMk id="239" creationId="{5AB849C0-5B1B-469F-9262-72538CD6EDCB}"/>
          </ac:spMkLst>
        </pc:spChg>
        <pc:spChg chg="mod">
          <ac:chgData name="Manasweeta Angane" userId="05da2731-9352-4b35-b713-60351f56afbd" providerId="ADAL" clId="{F5F97842-A295-4F9F-B89B-A63B35E1C32D}" dt="2022-10-10T09:34:40.899" v="3481"/>
          <ac:spMkLst>
            <pc:docMk/>
            <pc:sldMk cId="2506831184" sldId="296"/>
            <ac:spMk id="240" creationId="{62F68B05-AF8E-4F65-86A5-C6C1D7A8EF77}"/>
          </ac:spMkLst>
        </pc:spChg>
        <pc:spChg chg="mod">
          <ac:chgData name="Manasweeta Angane" userId="05da2731-9352-4b35-b713-60351f56afbd" providerId="ADAL" clId="{F5F97842-A295-4F9F-B89B-A63B35E1C32D}" dt="2022-10-10T09:34:40.899" v="3481"/>
          <ac:spMkLst>
            <pc:docMk/>
            <pc:sldMk cId="2506831184" sldId="296"/>
            <ac:spMk id="241" creationId="{29EDAC2A-6099-4C15-9C5A-780D10BF2C9F}"/>
          </ac:spMkLst>
        </pc:spChg>
        <pc:spChg chg="mod">
          <ac:chgData name="Manasweeta Angane" userId="05da2731-9352-4b35-b713-60351f56afbd" providerId="ADAL" clId="{F5F97842-A295-4F9F-B89B-A63B35E1C32D}" dt="2022-10-10T09:34:40.899" v="3481"/>
          <ac:spMkLst>
            <pc:docMk/>
            <pc:sldMk cId="2506831184" sldId="296"/>
            <ac:spMk id="242" creationId="{0F648610-D27B-4137-AE1C-5E16A8B1FE18}"/>
          </ac:spMkLst>
        </pc:spChg>
        <pc:spChg chg="mod">
          <ac:chgData name="Manasweeta Angane" userId="05da2731-9352-4b35-b713-60351f56afbd" providerId="ADAL" clId="{F5F97842-A295-4F9F-B89B-A63B35E1C32D}" dt="2022-10-10T09:34:40.899" v="3481"/>
          <ac:spMkLst>
            <pc:docMk/>
            <pc:sldMk cId="2506831184" sldId="296"/>
            <ac:spMk id="245" creationId="{26A0DC2C-0175-4F70-AF96-AF5819BDA1BE}"/>
          </ac:spMkLst>
        </pc:spChg>
        <pc:spChg chg="mod">
          <ac:chgData name="Manasweeta Angane" userId="05da2731-9352-4b35-b713-60351f56afbd" providerId="ADAL" clId="{F5F97842-A295-4F9F-B89B-A63B35E1C32D}" dt="2022-10-10T09:34:40.899" v="3481"/>
          <ac:spMkLst>
            <pc:docMk/>
            <pc:sldMk cId="2506831184" sldId="296"/>
            <ac:spMk id="248" creationId="{26BB25E5-23E3-4E5D-9C6E-A232EF0B9C72}"/>
          </ac:spMkLst>
        </pc:spChg>
        <pc:spChg chg="mod">
          <ac:chgData name="Manasweeta Angane" userId="05da2731-9352-4b35-b713-60351f56afbd" providerId="ADAL" clId="{F5F97842-A295-4F9F-B89B-A63B35E1C32D}" dt="2022-10-10T09:34:40.899" v="3481"/>
          <ac:spMkLst>
            <pc:docMk/>
            <pc:sldMk cId="2506831184" sldId="296"/>
            <ac:spMk id="249" creationId="{24374A85-B905-4B9C-BCA3-14D4C8B2B5C5}"/>
          </ac:spMkLst>
        </pc:spChg>
        <pc:spChg chg="mod">
          <ac:chgData name="Manasweeta Angane" userId="05da2731-9352-4b35-b713-60351f56afbd" providerId="ADAL" clId="{F5F97842-A295-4F9F-B89B-A63B35E1C32D}" dt="2022-10-10T09:34:40.899" v="3481"/>
          <ac:spMkLst>
            <pc:docMk/>
            <pc:sldMk cId="2506831184" sldId="296"/>
            <ac:spMk id="250" creationId="{B99FE518-7C1E-42BF-A921-CF18620E9174}"/>
          </ac:spMkLst>
        </pc:spChg>
        <pc:spChg chg="mod">
          <ac:chgData name="Manasweeta Angane" userId="05da2731-9352-4b35-b713-60351f56afbd" providerId="ADAL" clId="{F5F97842-A295-4F9F-B89B-A63B35E1C32D}" dt="2022-10-10T09:34:40.899" v="3481"/>
          <ac:spMkLst>
            <pc:docMk/>
            <pc:sldMk cId="2506831184" sldId="296"/>
            <ac:spMk id="253" creationId="{5A61817D-85CD-4679-9958-D2BCEB7B0009}"/>
          </ac:spMkLst>
        </pc:spChg>
        <pc:spChg chg="mod">
          <ac:chgData name="Manasweeta Angane" userId="05da2731-9352-4b35-b713-60351f56afbd" providerId="ADAL" clId="{F5F97842-A295-4F9F-B89B-A63B35E1C32D}" dt="2022-10-10T09:34:40.899" v="3481"/>
          <ac:spMkLst>
            <pc:docMk/>
            <pc:sldMk cId="2506831184" sldId="296"/>
            <ac:spMk id="255" creationId="{E9E79550-86D4-4230-AA6A-B5433C307FFD}"/>
          </ac:spMkLst>
        </pc:spChg>
        <pc:spChg chg="mod">
          <ac:chgData name="Manasweeta Angane" userId="05da2731-9352-4b35-b713-60351f56afbd" providerId="ADAL" clId="{F5F97842-A295-4F9F-B89B-A63B35E1C32D}" dt="2022-10-10T09:34:40.899" v="3481"/>
          <ac:spMkLst>
            <pc:docMk/>
            <pc:sldMk cId="2506831184" sldId="296"/>
            <ac:spMk id="257" creationId="{3309CEFC-0CB1-43C6-A95A-199C31063AE8}"/>
          </ac:spMkLst>
        </pc:spChg>
        <pc:spChg chg="mod">
          <ac:chgData name="Manasweeta Angane" userId="05da2731-9352-4b35-b713-60351f56afbd" providerId="ADAL" clId="{F5F97842-A295-4F9F-B89B-A63B35E1C32D}" dt="2022-10-10T09:34:40.899" v="3481"/>
          <ac:spMkLst>
            <pc:docMk/>
            <pc:sldMk cId="2506831184" sldId="296"/>
            <ac:spMk id="261" creationId="{806CD6F1-2292-49B6-B210-3C196C262FAB}"/>
          </ac:spMkLst>
        </pc:spChg>
        <pc:spChg chg="mod">
          <ac:chgData name="Manasweeta Angane" userId="05da2731-9352-4b35-b713-60351f56afbd" providerId="ADAL" clId="{F5F97842-A295-4F9F-B89B-A63B35E1C32D}" dt="2022-10-10T09:34:40.899" v="3481"/>
          <ac:spMkLst>
            <pc:docMk/>
            <pc:sldMk cId="2506831184" sldId="296"/>
            <ac:spMk id="278" creationId="{B0FF4EA7-2A7D-41A2-83EF-4E7109344C40}"/>
          </ac:spMkLst>
        </pc:spChg>
        <pc:spChg chg="mod">
          <ac:chgData name="Manasweeta Angane" userId="05da2731-9352-4b35-b713-60351f56afbd" providerId="ADAL" clId="{F5F97842-A295-4F9F-B89B-A63B35E1C32D}" dt="2022-10-10T09:37:06.571" v="3526" actId="1038"/>
          <ac:spMkLst>
            <pc:docMk/>
            <pc:sldMk cId="2506831184" sldId="296"/>
            <ac:spMk id="294" creationId="{9E2890EC-DFE7-4A33-A687-504651A59441}"/>
          </ac:spMkLst>
        </pc:spChg>
        <pc:spChg chg="mod">
          <ac:chgData name="Manasweeta Angane" userId="05da2731-9352-4b35-b713-60351f56afbd" providerId="ADAL" clId="{F5F97842-A295-4F9F-B89B-A63B35E1C32D}" dt="2022-10-10T09:36:55.837" v="3505"/>
          <ac:spMkLst>
            <pc:docMk/>
            <pc:sldMk cId="2506831184" sldId="296"/>
            <ac:spMk id="295" creationId="{1F34F933-C48F-426A-B321-45D197C3095E}"/>
          </ac:spMkLst>
        </pc:spChg>
        <pc:spChg chg="mod">
          <ac:chgData name="Manasweeta Angane" userId="05da2731-9352-4b35-b713-60351f56afbd" providerId="ADAL" clId="{F5F97842-A295-4F9F-B89B-A63B35E1C32D}" dt="2022-10-10T09:36:55.837" v="3505"/>
          <ac:spMkLst>
            <pc:docMk/>
            <pc:sldMk cId="2506831184" sldId="296"/>
            <ac:spMk id="296" creationId="{88929EC0-A5C3-4D5B-A33C-668018EB93E5}"/>
          </ac:spMkLst>
        </pc:spChg>
        <pc:spChg chg="mod">
          <ac:chgData name="Manasweeta Angane" userId="05da2731-9352-4b35-b713-60351f56afbd" providerId="ADAL" clId="{F5F97842-A295-4F9F-B89B-A63B35E1C32D}" dt="2022-10-10T09:36:55.837" v="3505"/>
          <ac:spMkLst>
            <pc:docMk/>
            <pc:sldMk cId="2506831184" sldId="296"/>
            <ac:spMk id="297" creationId="{04E256A1-C807-4A5E-BBA2-532000A5947A}"/>
          </ac:spMkLst>
        </pc:spChg>
        <pc:spChg chg="mod">
          <ac:chgData name="Manasweeta Angane" userId="05da2731-9352-4b35-b713-60351f56afbd" providerId="ADAL" clId="{F5F97842-A295-4F9F-B89B-A63B35E1C32D}" dt="2022-10-10T09:36:55.837" v="3505"/>
          <ac:spMkLst>
            <pc:docMk/>
            <pc:sldMk cId="2506831184" sldId="296"/>
            <ac:spMk id="298" creationId="{F563BE34-C4BE-4FC5-A619-B1DF0946D507}"/>
          </ac:spMkLst>
        </pc:spChg>
        <pc:spChg chg="mod">
          <ac:chgData name="Manasweeta Angane" userId="05da2731-9352-4b35-b713-60351f56afbd" providerId="ADAL" clId="{F5F97842-A295-4F9F-B89B-A63B35E1C32D}" dt="2022-10-10T09:36:55.837" v="3505"/>
          <ac:spMkLst>
            <pc:docMk/>
            <pc:sldMk cId="2506831184" sldId="296"/>
            <ac:spMk id="301" creationId="{1A8D56D9-42E0-42D2-A1DF-2396C69F7616}"/>
          </ac:spMkLst>
        </pc:spChg>
        <pc:spChg chg="mod">
          <ac:chgData name="Manasweeta Angane" userId="05da2731-9352-4b35-b713-60351f56afbd" providerId="ADAL" clId="{F5F97842-A295-4F9F-B89B-A63B35E1C32D}" dt="2022-10-10T09:36:55.837" v="3505"/>
          <ac:spMkLst>
            <pc:docMk/>
            <pc:sldMk cId="2506831184" sldId="296"/>
            <ac:spMk id="304" creationId="{DE1D475D-F92E-4DC4-9CB7-565FC4747A52}"/>
          </ac:spMkLst>
        </pc:spChg>
        <pc:spChg chg="mod">
          <ac:chgData name="Manasweeta Angane" userId="05da2731-9352-4b35-b713-60351f56afbd" providerId="ADAL" clId="{F5F97842-A295-4F9F-B89B-A63B35E1C32D}" dt="2022-10-10T09:36:55.837" v="3505"/>
          <ac:spMkLst>
            <pc:docMk/>
            <pc:sldMk cId="2506831184" sldId="296"/>
            <ac:spMk id="305" creationId="{F72C0D26-0570-47C6-92C5-1234AB2EF30A}"/>
          </ac:spMkLst>
        </pc:spChg>
        <pc:spChg chg="mod">
          <ac:chgData name="Manasweeta Angane" userId="05da2731-9352-4b35-b713-60351f56afbd" providerId="ADAL" clId="{F5F97842-A295-4F9F-B89B-A63B35E1C32D}" dt="2022-10-10T09:36:55.837" v="3505"/>
          <ac:spMkLst>
            <pc:docMk/>
            <pc:sldMk cId="2506831184" sldId="296"/>
            <ac:spMk id="306" creationId="{F39E53D8-033B-4523-9A86-F90BF2A1579E}"/>
          </ac:spMkLst>
        </pc:spChg>
        <pc:spChg chg="mod">
          <ac:chgData name="Manasweeta Angane" userId="05da2731-9352-4b35-b713-60351f56afbd" providerId="ADAL" clId="{F5F97842-A295-4F9F-B89B-A63B35E1C32D}" dt="2022-10-10T09:36:55.837" v="3505"/>
          <ac:spMkLst>
            <pc:docMk/>
            <pc:sldMk cId="2506831184" sldId="296"/>
            <ac:spMk id="309" creationId="{64D31CE2-752C-4B46-9E0B-F4742381D38E}"/>
          </ac:spMkLst>
        </pc:spChg>
        <pc:spChg chg="mod">
          <ac:chgData name="Manasweeta Angane" userId="05da2731-9352-4b35-b713-60351f56afbd" providerId="ADAL" clId="{F5F97842-A295-4F9F-B89B-A63B35E1C32D}" dt="2022-10-10T09:36:55.837" v="3505"/>
          <ac:spMkLst>
            <pc:docMk/>
            <pc:sldMk cId="2506831184" sldId="296"/>
            <ac:spMk id="311" creationId="{56397CAF-D3E2-4BAB-97F7-44430EFA682B}"/>
          </ac:spMkLst>
        </pc:spChg>
        <pc:spChg chg="mod">
          <ac:chgData name="Manasweeta Angane" userId="05da2731-9352-4b35-b713-60351f56afbd" providerId="ADAL" clId="{F5F97842-A295-4F9F-B89B-A63B35E1C32D}" dt="2022-10-10T09:36:55.837" v="3505"/>
          <ac:spMkLst>
            <pc:docMk/>
            <pc:sldMk cId="2506831184" sldId="296"/>
            <ac:spMk id="313" creationId="{FF0AD4F1-75AC-4688-9E4F-1F9A6E0F21FA}"/>
          </ac:spMkLst>
        </pc:spChg>
        <pc:spChg chg="mod">
          <ac:chgData name="Manasweeta Angane" userId="05da2731-9352-4b35-b713-60351f56afbd" providerId="ADAL" clId="{F5F97842-A295-4F9F-B89B-A63B35E1C32D}" dt="2022-10-10T09:36:55.837" v="3505"/>
          <ac:spMkLst>
            <pc:docMk/>
            <pc:sldMk cId="2506831184" sldId="296"/>
            <ac:spMk id="317" creationId="{9CE01342-38C6-49A3-A7F6-D82600051026}"/>
          </ac:spMkLst>
        </pc:spChg>
        <pc:spChg chg="mod">
          <ac:chgData name="Manasweeta Angane" userId="05da2731-9352-4b35-b713-60351f56afbd" providerId="ADAL" clId="{F5F97842-A295-4F9F-B89B-A63B35E1C32D}" dt="2022-10-10T09:36:55.837" v="3505"/>
          <ac:spMkLst>
            <pc:docMk/>
            <pc:sldMk cId="2506831184" sldId="296"/>
            <ac:spMk id="334" creationId="{4B16832D-E6EB-428B-A0C3-0655EFC6CC5B}"/>
          </ac:spMkLst>
        </pc:spChg>
        <pc:spChg chg="mod">
          <ac:chgData name="Manasweeta Angane" userId="05da2731-9352-4b35-b713-60351f56afbd" providerId="ADAL" clId="{F5F97842-A295-4F9F-B89B-A63B35E1C32D}" dt="2022-10-10T09:38:48.728" v="3533" actId="255"/>
          <ac:spMkLst>
            <pc:docMk/>
            <pc:sldMk cId="2506831184" sldId="296"/>
            <ac:spMk id="348" creationId="{EFBD5ED8-1FCF-47E9-ADF8-1A1AB425B51F}"/>
          </ac:spMkLst>
        </pc:spChg>
        <pc:spChg chg="mod">
          <ac:chgData name="Manasweeta Angane" userId="05da2731-9352-4b35-b713-60351f56afbd" providerId="ADAL" clId="{F5F97842-A295-4F9F-B89B-A63B35E1C32D}" dt="2022-10-10T09:39:03.893" v="3534"/>
          <ac:spMkLst>
            <pc:docMk/>
            <pc:sldMk cId="2506831184" sldId="296"/>
            <ac:spMk id="353" creationId="{582B4639-7DE4-4435-8812-3066E8C29656}"/>
          </ac:spMkLst>
        </pc:spChg>
        <pc:grpChg chg="add del mod">
          <ac:chgData name="Manasweeta Angane" userId="05da2731-9352-4b35-b713-60351f56afbd" providerId="ADAL" clId="{F5F97842-A295-4F9F-B89B-A63B35E1C32D}" dt="2022-10-10T09:21:34.405" v="3401"/>
          <ac:grpSpMkLst>
            <pc:docMk/>
            <pc:sldMk cId="2506831184" sldId="296"/>
            <ac:grpSpMk id="17" creationId="{7635B5C7-3FA9-407F-81CA-6093F4702E3A}"/>
          </ac:grpSpMkLst>
        </pc:grpChg>
        <pc:grpChg chg="add del mod">
          <ac:chgData name="Manasweeta Angane" userId="05da2731-9352-4b35-b713-60351f56afbd" providerId="ADAL" clId="{F5F97842-A295-4F9F-B89B-A63B35E1C32D}" dt="2022-10-10T09:21:34.405" v="3401"/>
          <ac:grpSpMkLst>
            <pc:docMk/>
            <pc:sldMk cId="2506831184" sldId="296"/>
            <ac:grpSpMk id="30" creationId="{61BFF5F8-B7C1-440D-B29A-BDD7D6113FC7}"/>
          </ac:grpSpMkLst>
        </pc:grpChg>
        <pc:grpChg chg="add del mod">
          <ac:chgData name="Manasweeta Angane" userId="05da2731-9352-4b35-b713-60351f56afbd" providerId="ADAL" clId="{F5F97842-A295-4F9F-B89B-A63B35E1C32D}" dt="2022-10-10T09:21:34.405" v="3401"/>
          <ac:grpSpMkLst>
            <pc:docMk/>
            <pc:sldMk cId="2506831184" sldId="296"/>
            <ac:grpSpMk id="49" creationId="{D197EC21-5918-4D6F-BE1F-CC54E16D95ED}"/>
          </ac:grpSpMkLst>
        </pc:grpChg>
        <pc:grpChg chg="add del mod">
          <ac:chgData name="Manasweeta Angane" userId="05da2731-9352-4b35-b713-60351f56afbd" providerId="ADAL" clId="{F5F97842-A295-4F9F-B89B-A63B35E1C32D}" dt="2022-10-10T09:21:34.405" v="3401"/>
          <ac:grpSpMkLst>
            <pc:docMk/>
            <pc:sldMk cId="2506831184" sldId="296"/>
            <ac:grpSpMk id="54" creationId="{DC060F54-2BFB-4726-890D-8EF1FA04B42E}"/>
          </ac:grpSpMkLst>
        </pc:grpChg>
        <pc:grpChg chg="mod">
          <ac:chgData name="Manasweeta Angane" userId="05da2731-9352-4b35-b713-60351f56afbd" providerId="ADAL" clId="{F5F97842-A295-4F9F-B89B-A63B35E1C32D}" dt="2022-10-10T09:21:29.873" v="3400"/>
          <ac:grpSpMkLst>
            <pc:docMk/>
            <pc:sldMk cId="2506831184" sldId="296"/>
            <ac:grpSpMk id="55" creationId="{E9494CC2-8BFB-4109-844B-2AC6B510F20B}"/>
          </ac:grpSpMkLst>
        </pc:grpChg>
        <pc:grpChg chg="add del mod">
          <ac:chgData name="Manasweeta Angane" userId="05da2731-9352-4b35-b713-60351f56afbd" providerId="ADAL" clId="{F5F97842-A295-4F9F-B89B-A63B35E1C32D}" dt="2022-10-10T09:21:34.405" v="3401"/>
          <ac:grpSpMkLst>
            <pc:docMk/>
            <pc:sldMk cId="2506831184" sldId="296"/>
            <ac:grpSpMk id="59" creationId="{34A13E80-B30B-4C8F-8C12-82A7D9891E0E}"/>
          </ac:grpSpMkLst>
        </pc:grpChg>
        <pc:grpChg chg="mod">
          <ac:chgData name="Manasweeta Angane" userId="05da2731-9352-4b35-b713-60351f56afbd" providerId="ADAL" clId="{F5F97842-A295-4F9F-B89B-A63B35E1C32D}" dt="2022-10-10T09:21:29.873" v="3400"/>
          <ac:grpSpMkLst>
            <pc:docMk/>
            <pc:sldMk cId="2506831184" sldId="296"/>
            <ac:grpSpMk id="60" creationId="{FCD34956-FE81-4D32-94DB-EC65C3678CDF}"/>
          </ac:grpSpMkLst>
        </pc:grpChg>
        <pc:grpChg chg="add del mod">
          <ac:chgData name="Manasweeta Angane" userId="05da2731-9352-4b35-b713-60351f56afbd" providerId="ADAL" clId="{F5F97842-A295-4F9F-B89B-A63B35E1C32D}" dt="2022-10-10T09:21:56.631" v="3403"/>
          <ac:grpSpMkLst>
            <pc:docMk/>
            <pc:sldMk cId="2506831184" sldId="296"/>
            <ac:grpSpMk id="72" creationId="{FA2A6A32-E8A7-4A77-B248-04FD082022FF}"/>
          </ac:grpSpMkLst>
        </pc:grpChg>
        <pc:grpChg chg="add del mod">
          <ac:chgData name="Manasweeta Angane" userId="05da2731-9352-4b35-b713-60351f56afbd" providerId="ADAL" clId="{F5F97842-A295-4F9F-B89B-A63B35E1C32D}" dt="2022-10-10T09:21:56.631" v="3403"/>
          <ac:grpSpMkLst>
            <pc:docMk/>
            <pc:sldMk cId="2506831184" sldId="296"/>
            <ac:grpSpMk id="84" creationId="{4AAB560B-B07C-4CED-A5D3-ADB599929330}"/>
          </ac:grpSpMkLst>
        </pc:grpChg>
        <pc:grpChg chg="add del mod">
          <ac:chgData name="Manasweeta Angane" userId="05da2731-9352-4b35-b713-60351f56afbd" providerId="ADAL" clId="{F5F97842-A295-4F9F-B89B-A63B35E1C32D}" dt="2022-10-10T09:21:56.631" v="3403"/>
          <ac:grpSpMkLst>
            <pc:docMk/>
            <pc:sldMk cId="2506831184" sldId="296"/>
            <ac:grpSpMk id="103" creationId="{DB020427-E02F-447F-89F7-5FC9DD8BC6CD}"/>
          </ac:grpSpMkLst>
        </pc:grpChg>
        <pc:grpChg chg="add del mod">
          <ac:chgData name="Manasweeta Angane" userId="05da2731-9352-4b35-b713-60351f56afbd" providerId="ADAL" clId="{F5F97842-A295-4F9F-B89B-A63B35E1C32D}" dt="2022-10-10T09:21:56.631" v="3403"/>
          <ac:grpSpMkLst>
            <pc:docMk/>
            <pc:sldMk cId="2506831184" sldId="296"/>
            <ac:grpSpMk id="108" creationId="{A1338BC9-1012-4F1C-9DFC-506DEDFC235A}"/>
          </ac:grpSpMkLst>
        </pc:grpChg>
        <pc:grpChg chg="mod">
          <ac:chgData name="Manasweeta Angane" userId="05da2731-9352-4b35-b713-60351f56afbd" providerId="ADAL" clId="{F5F97842-A295-4F9F-B89B-A63B35E1C32D}" dt="2022-10-10T09:21:49.084" v="3402"/>
          <ac:grpSpMkLst>
            <pc:docMk/>
            <pc:sldMk cId="2506831184" sldId="296"/>
            <ac:grpSpMk id="109" creationId="{F433D40C-8548-4165-B637-F1B325BC7ACA}"/>
          </ac:grpSpMkLst>
        </pc:grpChg>
        <pc:grpChg chg="add del mod">
          <ac:chgData name="Manasweeta Angane" userId="05da2731-9352-4b35-b713-60351f56afbd" providerId="ADAL" clId="{F5F97842-A295-4F9F-B89B-A63B35E1C32D}" dt="2022-10-10T09:21:56.631" v="3403"/>
          <ac:grpSpMkLst>
            <pc:docMk/>
            <pc:sldMk cId="2506831184" sldId="296"/>
            <ac:grpSpMk id="113" creationId="{7DFC5C24-90B9-4EC6-95BB-C51DEEE7874B}"/>
          </ac:grpSpMkLst>
        </pc:grpChg>
        <pc:grpChg chg="mod">
          <ac:chgData name="Manasweeta Angane" userId="05da2731-9352-4b35-b713-60351f56afbd" providerId="ADAL" clId="{F5F97842-A295-4F9F-B89B-A63B35E1C32D}" dt="2022-10-10T09:21:49.084" v="3402"/>
          <ac:grpSpMkLst>
            <pc:docMk/>
            <pc:sldMk cId="2506831184" sldId="296"/>
            <ac:grpSpMk id="114" creationId="{C2254C63-56C3-4850-95BE-26C7314C073B}"/>
          </ac:grpSpMkLst>
        </pc:grpChg>
        <pc:grpChg chg="add del mod">
          <ac:chgData name="Manasweeta Angane" userId="05da2731-9352-4b35-b713-60351f56afbd" providerId="ADAL" clId="{F5F97842-A295-4F9F-B89B-A63B35E1C32D}" dt="2022-10-10T09:22:12.756" v="3405"/>
          <ac:grpSpMkLst>
            <pc:docMk/>
            <pc:sldMk cId="2506831184" sldId="296"/>
            <ac:grpSpMk id="126" creationId="{CFFE770D-36B1-46E5-A3B1-5A8B4A385285}"/>
          </ac:grpSpMkLst>
        </pc:grpChg>
        <pc:grpChg chg="add del mod">
          <ac:chgData name="Manasweeta Angane" userId="05da2731-9352-4b35-b713-60351f56afbd" providerId="ADAL" clId="{F5F97842-A295-4F9F-B89B-A63B35E1C32D}" dt="2022-10-10T09:22:12.756" v="3405"/>
          <ac:grpSpMkLst>
            <pc:docMk/>
            <pc:sldMk cId="2506831184" sldId="296"/>
            <ac:grpSpMk id="138" creationId="{1FF2EB40-2B9C-4499-B17E-936F71DB101A}"/>
          </ac:grpSpMkLst>
        </pc:grpChg>
        <pc:grpChg chg="add del mod">
          <ac:chgData name="Manasweeta Angane" userId="05da2731-9352-4b35-b713-60351f56afbd" providerId="ADAL" clId="{F5F97842-A295-4F9F-B89B-A63B35E1C32D}" dt="2022-10-10T09:22:12.756" v="3405"/>
          <ac:grpSpMkLst>
            <pc:docMk/>
            <pc:sldMk cId="2506831184" sldId="296"/>
            <ac:grpSpMk id="157" creationId="{9E389669-C888-47CD-B86E-821E752DC74E}"/>
          </ac:grpSpMkLst>
        </pc:grpChg>
        <pc:grpChg chg="add del mod">
          <ac:chgData name="Manasweeta Angane" userId="05da2731-9352-4b35-b713-60351f56afbd" providerId="ADAL" clId="{F5F97842-A295-4F9F-B89B-A63B35E1C32D}" dt="2022-10-10T09:22:12.756" v="3405"/>
          <ac:grpSpMkLst>
            <pc:docMk/>
            <pc:sldMk cId="2506831184" sldId="296"/>
            <ac:grpSpMk id="162" creationId="{66EC108A-FA1B-4368-850F-C404AF13C74A}"/>
          </ac:grpSpMkLst>
        </pc:grpChg>
        <pc:grpChg chg="mod">
          <ac:chgData name="Manasweeta Angane" userId="05da2731-9352-4b35-b713-60351f56afbd" providerId="ADAL" clId="{F5F97842-A295-4F9F-B89B-A63B35E1C32D}" dt="2022-10-10T09:21:59.271" v="3404"/>
          <ac:grpSpMkLst>
            <pc:docMk/>
            <pc:sldMk cId="2506831184" sldId="296"/>
            <ac:grpSpMk id="163" creationId="{924EF69F-AD7E-40C0-972F-AB1F938FB671}"/>
          </ac:grpSpMkLst>
        </pc:grpChg>
        <pc:grpChg chg="add del mod">
          <ac:chgData name="Manasweeta Angane" userId="05da2731-9352-4b35-b713-60351f56afbd" providerId="ADAL" clId="{F5F97842-A295-4F9F-B89B-A63B35E1C32D}" dt="2022-10-10T09:22:12.756" v="3405"/>
          <ac:grpSpMkLst>
            <pc:docMk/>
            <pc:sldMk cId="2506831184" sldId="296"/>
            <ac:grpSpMk id="167" creationId="{7E5BA3A6-D7E3-4744-9515-B649C24E318F}"/>
          </ac:grpSpMkLst>
        </pc:grpChg>
        <pc:grpChg chg="mod">
          <ac:chgData name="Manasweeta Angane" userId="05da2731-9352-4b35-b713-60351f56afbd" providerId="ADAL" clId="{F5F97842-A295-4F9F-B89B-A63B35E1C32D}" dt="2022-10-10T09:21:59.271" v="3404"/>
          <ac:grpSpMkLst>
            <pc:docMk/>
            <pc:sldMk cId="2506831184" sldId="296"/>
            <ac:grpSpMk id="168" creationId="{2E274BC2-2C5A-4A82-880F-A80064473A24}"/>
          </ac:grpSpMkLst>
        </pc:grpChg>
        <pc:grpChg chg="add del mod">
          <ac:chgData name="Manasweeta Angane" userId="05da2731-9352-4b35-b713-60351f56afbd" providerId="ADAL" clId="{F5F97842-A295-4F9F-B89B-A63B35E1C32D}" dt="2022-10-10T09:33:42.164" v="3480"/>
          <ac:grpSpMkLst>
            <pc:docMk/>
            <pc:sldMk cId="2506831184" sldId="296"/>
            <ac:grpSpMk id="180" creationId="{59643392-94B2-454B-A176-3CDB87D552D0}"/>
          </ac:grpSpMkLst>
        </pc:grpChg>
        <pc:grpChg chg="add del mod">
          <ac:chgData name="Manasweeta Angane" userId="05da2731-9352-4b35-b713-60351f56afbd" providerId="ADAL" clId="{F5F97842-A295-4F9F-B89B-A63B35E1C32D}" dt="2022-10-10T09:33:42.164" v="3480"/>
          <ac:grpSpMkLst>
            <pc:docMk/>
            <pc:sldMk cId="2506831184" sldId="296"/>
            <ac:grpSpMk id="192" creationId="{6FF80A58-A0DE-452C-AE3D-319A03F6848B}"/>
          </ac:grpSpMkLst>
        </pc:grpChg>
        <pc:grpChg chg="add del mod">
          <ac:chgData name="Manasweeta Angane" userId="05da2731-9352-4b35-b713-60351f56afbd" providerId="ADAL" clId="{F5F97842-A295-4F9F-B89B-A63B35E1C32D}" dt="2022-10-10T09:33:42.164" v="3480"/>
          <ac:grpSpMkLst>
            <pc:docMk/>
            <pc:sldMk cId="2506831184" sldId="296"/>
            <ac:grpSpMk id="211" creationId="{6BE22D52-0792-4AE7-BFB1-9FED4E003D6A}"/>
          </ac:grpSpMkLst>
        </pc:grpChg>
        <pc:grpChg chg="add del mod">
          <ac:chgData name="Manasweeta Angane" userId="05da2731-9352-4b35-b713-60351f56afbd" providerId="ADAL" clId="{F5F97842-A295-4F9F-B89B-A63B35E1C32D}" dt="2022-10-10T09:33:42.164" v="3480"/>
          <ac:grpSpMkLst>
            <pc:docMk/>
            <pc:sldMk cId="2506831184" sldId="296"/>
            <ac:grpSpMk id="216" creationId="{5E41F848-CBBF-4556-B545-D11D49ABEC6D}"/>
          </ac:grpSpMkLst>
        </pc:grpChg>
        <pc:grpChg chg="mod">
          <ac:chgData name="Manasweeta Angane" userId="05da2731-9352-4b35-b713-60351f56afbd" providerId="ADAL" clId="{F5F97842-A295-4F9F-B89B-A63B35E1C32D}" dt="2022-10-10T09:29:32.148" v="3406"/>
          <ac:grpSpMkLst>
            <pc:docMk/>
            <pc:sldMk cId="2506831184" sldId="296"/>
            <ac:grpSpMk id="217" creationId="{ADFFC97E-EE8B-4D86-8337-F7448CFF7B99}"/>
          </ac:grpSpMkLst>
        </pc:grpChg>
        <pc:grpChg chg="add del mod">
          <ac:chgData name="Manasweeta Angane" userId="05da2731-9352-4b35-b713-60351f56afbd" providerId="ADAL" clId="{F5F97842-A295-4F9F-B89B-A63B35E1C32D}" dt="2022-10-10T09:33:42.164" v="3480"/>
          <ac:grpSpMkLst>
            <pc:docMk/>
            <pc:sldMk cId="2506831184" sldId="296"/>
            <ac:grpSpMk id="221" creationId="{87D56CF9-7499-4641-8506-9949CB0EE178}"/>
          </ac:grpSpMkLst>
        </pc:grpChg>
        <pc:grpChg chg="mod">
          <ac:chgData name="Manasweeta Angane" userId="05da2731-9352-4b35-b713-60351f56afbd" providerId="ADAL" clId="{F5F97842-A295-4F9F-B89B-A63B35E1C32D}" dt="2022-10-10T09:29:32.148" v="3406"/>
          <ac:grpSpMkLst>
            <pc:docMk/>
            <pc:sldMk cId="2506831184" sldId="296"/>
            <ac:grpSpMk id="222" creationId="{D4BF3C09-A755-4E96-A045-F68EA92394D1}"/>
          </ac:grpSpMkLst>
        </pc:grpChg>
        <pc:grpChg chg="add del mod">
          <ac:chgData name="Manasweeta Angane" userId="05da2731-9352-4b35-b713-60351f56afbd" providerId="ADAL" clId="{F5F97842-A295-4F9F-B89B-A63B35E1C32D}" dt="2022-10-10T09:35:25.091" v="3504" actId="478"/>
          <ac:grpSpMkLst>
            <pc:docMk/>
            <pc:sldMk cId="2506831184" sldId="296"/>
            <ac:grpSpMk id="234" creationId="{A05234D9-14D5-4495-8EB8-695574F605FE}"/>
          </ac:grpSpMkLst>
        </pc:grpChg>
        <pc:grpChg chg="mod">
          <ac:chgData name="Manasweeta Angane" userId="05da2731-9352-4b35-b713-60351f56afbd" providerId="ADAL" clId="{F5F97842-A295-4F9F-B89B-A63B35E1C32D}" dt="2022-10-10T09:34:40.899" v="3481"/>
          <ac:grpSpMkLst>
            <pc:docMk/>
            <pc:sldMk cId="2506831184" sldId="296"/>
            <ac:grpSpMk id="236" creationId="{21FE0D49-69C2-41E3-9CE2-ED6E5D89DE58}"/>
          </ac:grpSpMkLst>
        </pc:grpChg>
        <pc:grpChg chg="mod">
          <ac:chgData name="Manasweeta Angane" userId="05da2731-9352-4b35-b713-60351f56afbd" providerId="ADAL" clId="{F5F97842-A295-4F9F-B89B-A63B35E1C32D}" dt="2022-10-10T09:34:40.899" v="3481"/>
          <ac:grpSpMkLst>
            <pc:docMk/>
            <pc:sldMk cId="2506831184" sldId="296"/>
            <ac:grpSpMk id="237" creationId="{0EF45334-68FF-48BE-99E7-A342C7EFFBA6}"/>
          </ac:grpSpMkLst>
        </pc:grpChg>
        <pc:grpChg chg="mod">
          <ac:chgData name="Manasweeta Angane" userId="05da2731-9352-4b35-b713-60351f56afbd" providerId="ADAL" clId="{F5F97842-A295-4F9F-B89B-A63B35E1C32D}" dt="2022-10-10T09:34:40.899" v="3481"/>
          <ac:grpSpMkLst>
            <pc:docMk/>
            <pc:sldMk cId="2506831184" sldId="296"/>
            <ac:grpSpMk id="243" creationId="{82357EFE-F448-4754-B0E5-F0160011FB21}"/>
          </ac:grpSpMkLst>
        </pc:grpChg>
        <pc:grpChg chg="mod">
          <ac:chgData name="Manasweeta Angane" userId="05da2731-9352-4b35-b713-60351f56afbd" providerId="ADAL" clId="{F5F97842-A295-4F9F-B89B-A63B35E1C32D}" dt="2022-10-10T09:34:40.899" v="3481"/>
          <ac:grpSpMkLst>
            <pc:docMk/>
            <pc:sldMk cId="2506831184" sldId="296"/>
            <ac:grpSpMk id="246" creationId="{2351A00D-69AF-409D-A6FF-789CADC1F342}"/>
          </ac:grpSpMkLst>
        </pc:grpChg>
        <pc:grpChg chg="mod">
          <ac:chgData name="Manasweeta Angane" userId="05da2731-9352-4b35-b713-60351f56afbd" providerId="ADAL" clId="{F5F97842-A295-4F9F-B89B-A63B35E1C32D}" dt="2022-10-10T09:34:40.899" v="3481"/>
          <ac:grpSpMkLst>
            <pc:docMk/>
            <pc:sldMk cId="2506831184" sldId="296"/>
            <ac:grpSpMk id="247" creationId="{238E2612-2AB4-4AE1-9663-7FA0ED81A9A3}"/>
          </ac:grpSpMkLst>
        </pc:grpChg>
        <pc:grpChg chg="mod">
          <ac:chgData name="Manasweeta Angane" userId="05da2731-9352-4b35-b713-60351f56afbd" providerId="ADAL" clId="{F5F97842-A295-4F9F-B89B-A63B35E1C32D}" dt="2022-10-10T09:34:40.899" v="3481"/>
          <ac:grpSpMkLst>
            <pc:docMk/>
            <pc:sldMk cId="2506831184" sldId="296"/>
            <ac:grpSpMk id="256" creationId="{3A390F5C-FA8B-4B2F-A466-0D21D59510E5}"/>
          </ac:grpSpMkLst>
        </pc:grpChg>
        <pc:grpChg chg="mod">
          <ac:chgData name="Manasweeta Angane" userId="05da2731-9352-4b35-b713-60351f56afbd" providerId="ADAL" clId="{F5F97842-A295-4F9F-B89B-A63B35E1C32D}" dt="2022-10-10T09:34:40.899" v="3481"/>
          <ac:grpSpMkLst>
            <pc:docMk/>
            <pc:sldMk cId="2506831184" sldId="296"/>
            <ac:grpSpMk id="260" creationId="{0F5981E3-66DA-44F5-A7FD-ED368319F27A}"/>
          </ac:grpSpMkLst>
        </pc:grpChg>
        <pc:grpChg chg="add del mod">
          <ac:chgData name="Manasweeta Angane" userId="05da2731-9352-4b35-b713-60351f56afbd" providerId="ADAL" clId="{F5F97842-A295-4F9F-B89B-A63B35E1C32D}" dt="2022-10-10T09:37:58.228" v="3528" actId="478"/>
          <ac:grpSpMkLst>
            <pc:docMk/>
            <pc:sldMk cId="2506831184" sldId="296"/>
            <ac:grpSpMk id="290" creationId="{280A51DD-9425-4788-B9F3-48CC9C74C7DA}"/>
          </ac:grpSpMkLst>
        </pc:grpChg>
        <pc:grpChg chg="mod">
          <ac:chgData name="Manasweeta Angane" userId="05da2731-9352-4b35-b713-60351f56afbd" providerId="ADAL" clId="{F5F97842-A295-4F9F-B89B-A63B35E1C32D}" dt="2022-10-10T09:36:55.837" v="3505"/>
          <ac:grpSpMkLst>
            <pc:docMk/>
            <pc:sldMk cId="2506831184" sldId="296"/>
            <ac:grpSpMk id="292" creationId="{09C4DA82-B513-4C9B-AB38-CBAE629A0956}"/>
          </ac:grpSpMkLst>
        </pc:grpChg>
        <pc:grpChg chg="mod">
          <ac:chgData name="Manasweeta Angane" userId="05da2731-9352-4b35-b713-60351f56afbd" providerId="ADAL" clId="{F5F97842-A295-4F9F-B89B-A63B35E1C32D}" dt="2022-10-10T09:36:55.837" v="3505"/>
          <ac:grpSpMkLst>
            <pc:docMk/>
            <pc:sldMk cId="2506831184" sldId="296"/>
            <ac:grpSpMk id="293" creationId="{3C3F1CE4-68F3-44B7-B241-8E47F1AB9910}"/>
          </ac:grpSpMkLst>
        </pc:grpChg>
        <pc:grpChg chg="mod">
          <ac:chgData name="Manasweeta Angane" userId="05da2731-9352-4b35-b713-60351f56afbd" providerId="ADAL" clId="{F5F97842-A295-4F9F-B89B-A63B35E1C32D}" dt="2022-10-10T09:36:55.837" v="3505"/>
          <ac:grpSpMkLst>
            <pc:docMk/>
            <pc:sldMk cId="2506831184" sldId="296"/>
            <ac:grpSpMk id="299" creationId="{02D9EA00-D001-4575-96D2-E0091B069001}"/>
          </ac:grpSpMkLst>
        </pc:grpChg>
        <pc:grpChg chg="mod">
          <ac:chgData name="Manasweeta Angane" userId="05da2731-9352-4b35-b713-60351f56afbd" providerId="ADAL" clId="{F5F97842-A295-4F9F-B89B-A63B35E1C32D}" dt="2022-10-10T09:36:55.837" v="3505"/>
          <ac:grpSpMkLst>
            <pc:docMk/>
            <pc:sldMk cId="2506831184" sldId="296"/>
            <ac:grpSpMk id="302" creationId="{9DD7C0D2-DA01-4BC3-B93F-2650447433A1}"/>
          </ac:grpSpMkLst>
        </pc:grpChg>
        <pc:grpChg chg="mod">
          <ac:chgData name="Manasweeta Angane" userId="05da2731-9352-4b35-b713-60351f56afbd" providerId="ADAL" clId="{F5F97842-A295-4F9F-B89B-A63B35E1C32D}" dt="2022-10-10T09:36:55.837" v="3505"/>
          <ac:grpSpMkLst>
            <pc:docMk/>
            <pc:sldMk cId="2506831184" sldId="296"/>
            <ac:grpSpMk id="303" creationId="{108EE755-B024-4169-AC48-064738E0BC47}"/>
          </ac:grpSpMkLst>
        </pc:grpChg>
        <pc:grpChg chg="mod">
          <ac:chgData name="Manasweeta Angane" userId="05da2731-9352-4b35-b713-60351f56afbd" providerId="ADAL" clId="{F5F97842-A295-4F9F-B89B-A63B35E1C32D}" dt="2022-10-10T09:36:55.837" v="3505"/>
          <ac:grpSpMkLst>
            <pc:docMk/>
            <pc:sldMk cId="2506831184" sldId="296"/>
            <ac:grpSpMk id="312" creationId="{53F1DE56-AF54-4578-ABEE-464B9252419A}"/>
          </ac:grpSpMkLst>
        </pc:grpChg>
        <pc:grpChg chg="mod">
          <ac:chgData name="Manasweeta Angane" userId="05da2731-9352-4b35-b713-60351f56afbd" providerId="ADAL" clId="{F5F97842-A295-4F9F-B89B-A63B35E1C32D}" dt="2022-10-10T09:36:55.837" v="3505"/>
          <ac:grpSpMkLst>
            <pc:docMk/>
            <pc:sldMk cId="2506831184" sldId="296"/>
            <ac:grpSpMk id="316" creationId="{B4278899-4747-4A95-8C75-B140C7529FEE}"/>
          </ac:grpSpMkLst>
        </pc:grpChg>
        <pc:grpChg chg="add mod">
          <ac:chgData name="Manasweeta Angane" userId="05da2731-9352-4b35-b713-60351f56afbd" providerId="ADAL" clId="{F5F97842-A295-4F9F-B89B-A63B35E1C32D}" dt="2022-10-10T09:38:34.395" v="3531" actId="1076"/>
          <ac:grpSpMkLst>
            <pc:docMk/>
            <pc:sldMk cId="2506831184" sldId="296"/>
            <ac:grpSpMk id="346" creationId="{AF5D778D-D69A-4151-8AD4-B3F151D8D44B}"/>
          </ac:grpSpMkLst>
        </pc:grpChg>
        <pc:grpChg chg="mod">
          <ac:chgData name="Manasweeta Angane" userId="05da2731-9352-4b35-b713-60351f56afbd" providerId="ADAL" clId="{F5F97842-A295-4F9F-B89B-A63B35E1C32D}" dt="2022-10-10T09:38:23.348" v="3530"/>
          <ac:grpSpMkLst>
            <pc:docMk/>
            <pc:sldMk cId="2506831184" sldId="296"/>
            <ac:grpSpMk id="347" creationId="{D9F1739C-441D-4BAA-96C3-E5F4510F8199}"/>
          </ac:grpSpMkLst>
        </pc:grpChg>
        <pc:grpChg chg="add mod">
          <ac:chgData name="Manasweeta Angane" userId="05da2731-9352-4b35-b713-60351f56afbd" providerId="ADAL" clId="{F5F97842-A295-4F9F-B89B-A63B35E1C32D}" dt="2022-10-10T09:39:21.290" v="3589" actId="1037"/>
          <ac:grpSpMkLst>
            <pc:docMk/>
            <pc:sldMk cId="2506831184" sldId="296"/>
            <ac:grpSpMk id="351" creationId="{00EDB567-614A-4021-ACD4-3E3A60191B69}"/>
          </ac:grpSpMkLst>
        </pc:grpChg>
        <pc:grpChg chg="mod">
          <ac:chgData name="Manasweeta Angane" userId="05da2731-9352-4b35-b713-60351f56afbd" providerId="ADAL" clId="{F5F97842-A295-4F9F-B89B-A63B35E1C32D}" dt="2022-10-10T09:39:03.893" v="3534"/>
          <ac:grpSpMkLst>
            <pc:docMk/>
            <pc:sldMk cId="2506831184" sldId="296"/>
            <ac:grpSpMk id="352" creationId="{65B6449E-CE49-4E15-AAE3-547991157CDD}"/>
          </ac:grpSpMkLst>
        </pc:grpChg>
        <pc:picChg chg="del">
          <ac:chgData name="Manasweeta Angane" userId="05da2731-9352-4b35-b713-60351f56afbd" providerId="ADAL" clId="{F5F97842-A295-4F9F-B89B-A63B35E1C32D}" dt="2022-10-10T09:18:48.286" v="3198" actId="478"/>
          <ac:picMkLst>
            <pc:docMk/>
            <pc:sldMk cId="2506831184" sldId="296"/>
            <ac:picMk id="10" creationId="{998B70E0-BB2F-45B0-84B8-499A7FB4BDD6}"/>
          </ac:picMkLst>
        </pc:picChg>
        <pc:picChg chg="del">
          <ac:chgData name="Manasweeta Angane" userId="05da2731-9352-4b35-b713-60351f56afbd" providerId="ADAL" clId="{F5F97842-A295-4F9F-B89B-A63B35E1C32D}" dt="2022-10-10T09:18:44.959" v="3196" actId="478"/>
          <ac:picMkLst>
            <pc:docMk/>
            <pc:sldMk cId="2506831184" sldId="296"/>
            <ac:picMk id="11" creationId="{58C5010A-4A14-435F-A343-6D955C65F9E3}"/>
          </ac:picMkLst>
        </pc:picChg>
        <pc:picChg chg="del">
          <ac:chgData name="Manasweeta Angane" userId="05da2731-9352-4b35-b713-60351f56afbd" providerId="ADAL" clId="{F5F97842-A295-4F9F-B89B-A63B35E1C32D}" dt="2022-10-10T09:18:49.411" v="3199" actId="478"/>
          <ac:picMkLst>
            <pc:docMk/>
            <pc:sldMk cId="2506831184" sldId="296"/>
            <ac:picMk id="12" creationId="{7BBFFF3C-2C0B-4153-BA4C-F1C7027694D2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19" creationId="{31E43267-54CA-46AE-AA8C-2E9D1FFB4A91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20" creationId="{B78428B7-2A1D-46E1-986F-6A45FA9AFDA2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21" creationId="{B2160A37-60BC-41ED-8F42-E038F14198AB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22" creationId="{BB0C7887-B8B8-4C50-8616-64E533C2F767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23" creationId="{5A7AB35D-97AA-4954-B3A7-365CA4940B4D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24" creationId="{280A4D3F-C851-4B93-A047-2B6539142E37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25" creationId="{834B5140-C953-4F2D-BC56-D4D73AD23721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26" creationId="{742B554B-0E55-4F3A-9113-582306989C19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27" creationId="{62958BED-0433-436F-AA10-096C52E191E7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28" creationId="{6F9E5721-2B14-4D94-84F0-46459D8A48BD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29" creationId="{0073BA80-BA61-4527-B968-35009AF79082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50" creationId="{0178913B-626D-43AC-8809-368407355D10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51" creationId="{2C2609BE-15FC-4196-B2A1-9C8A16747801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57" creationId="{6DB19505-8076-474B-ACBB-B705AFB3434D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58" creationId="{74B92BE6-0385-4CB0-8260-DCC7B5A771C0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62" creationId="{9F65633E-E02D-4CDB-A7FC-3A5537947711}"/>
          </ac:picMkLst>
        </pc:picChg>
        <pc:picChg chg="mod">
          <ac:chgData name="Manasweeta Angane" userId="05da2731-9352-4b35-b713-60351f56afbd" providerId="ADAL" clId="{F5F97842-A295-4F9F-B89B-A63B35E1C32D}" dt="2022-10-10T09:21:29.873" v="3400"/>
          <ac:picMkLst>
            <pc:docMk/>
            <pc:sldMk cId="2506831184" sldId="296"/>
            <ac:picMk id="63" creationId="{048C70E8-1627-4DA6-994C-C71F17A8CEDE}"/>
          </ac:picMkLst>
        </pc:picChg>
        <pc:picChg chg="add del mod">
          <ac:chgData name="Manasweeta Angane" userId="05da2731-9352-4b35-b713-60351f56afbd" providerId="ADAL" clId="{F5F97842-A295-4F9F-B89B-A63B35E1C32D}" dt="2022-10-10T09:21:34.405" v="3401"/>
          <ac:picMkLst>
            <pc:docMk/>
            <pc:sldMk cId="2506831184" sldId="296"/>
            <ac:picMk id="67" creationId="{10F554EC-83C4-4D15-8D52-49587527B088}"/>
          </ac:picMkLst>
        </pc:picChg>
        <pc:picChg chg="add del mod">
          <ac:chgData name="Manasweeta Angane" userId="05da2731-9352-4b35-b713-60351f56afbd" providerId="ADAL" clId="{F5F97842-A295-4F9F-B89B-A63B35E1C32D}" dt="2022-10-10T09:21:34.405" v="3401"/>
          <ac:picMkLst>
            <pc:docMk/>
            <pc:sldMk cId="2506831184" sldId="296"/>
            <ac:picMk id="70" creationId="{D6333278-4742-4BA7-97C4-81CB2E3111DE}"/>
          </ac:picMkLst>
        </pc:picChg>
        <pc:picChg chg="add del mod">
          <ac:chgData name="Manasweeta Angane" userId="05da2731-9352-4b35-b713-60351f56afbd" providerId="ADAL" clId="{F5F97842-A295-4F9F-B89B-A63B35E1C32D}" dt="2022-10-10T09:21:56.631" v="3403"/>
          <ac:picMkLst>
            <pc:docMk/>
            <pc:sldMk cId="2506831184" sldId="296"/>
            <ac:picMk id="71" creationId="{B1705656-7D6C-43E0-A4D8-7B55C9D6CEF4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73" creationId="{49E088F9-D64A-4BA0-BC7A-B1B4833A2F31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74" creationId="{CECC405D-1F8B-4DC8-B2C9-811E091265DB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75" creationId="{3A063C10-6A2D-4AEE-9001-EBF756125871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76" creationId="{14E72FA1-32DE-4E44-A881-98791AF2C76C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77" creationId="{B5B013F8-8260-459B-A129-A5341622852E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78" creationId="{A9535FE6-3B46-40A6-ABA7-41BA9185D555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79" creationId="{F10B1EA4-A08F-4CB3-810F-3A4235B08B02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80" creationId="{C1063CE9-F501-4A90-8DD4-987B70FAA6FE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81" creationId="{9DD58EA5-9A1D-4B97-8902-7B6186908DED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82" creationId="{1D50814F-CB9E-41DE-987B-49EDFEA2DA5D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83" creationId="{D5DBD59B-2FB1-4C80-A386-82CD72F6C07A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104" creationId="{B43A9773-89B1-4286-862F-B1428EA3E700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105" creationId="{1C5216D0-9C4B-404A-80E0-B046D528560E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111" creationId="{F8F7F49B-BE3A-4521-A3C1-478D0FB731CA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112" creationId="{D97E0C0B-CF49-4711-8AD3-57CCEC05BB8B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116" creationId="{B06C058D-05E4-4BEC-83DF-6A53670CAFCE}"/>
          </ac:picMkLst>
        </pc:picChg>
        <pc:picChg chg="mod">
          <ac:chgData name="Manasweeta Angane" userId="05da2731-9352-4b35-b713-60351f56afbd" providerId="ADAL" clId="{F5F97842-A295-4F9F-B89B-A63B35E1C32D}" dt="2022-10-10T09:21:49.084" v="3402"/>
          <ac:picMkLst>
            <pc:docMk/>
            <pc:sldMk cId="2506831184" sldId="296"/>
            <ac:picMk id="117" creationId="{7C2AFD39-06E9-4455-B18E-09201A99AF24}"/>
          </ac:picMkLst>
        </pc:picChg>
        <pc:picChg chg="add del mod">
          <ac:chgData name="Manasweeta Angane" userId="05da2731-9352-4b35-b713-60351f56afbd" providerId="ADAL" clId="{F5F97842-A295-4F9F-B89B-A63B35E1C32D}" dt="2022-10-10T09:21:56.631" v="3403"/>
          <ac:picMkLst>
            <pc:docMk/>
            <pc:sldMk cId="2506831184" sldId="296"/>
            <ac:picMk id="121" creationId="{DF91385D-502F-4087-BF8E-AFADFC845A71}"/>
          </ac:picMkLst>
        </pc:picChg>
        <pc:picChg chg="add del mod">
          <ac:chgData name="Manasweeta Angane" userId="05da2731-9352-4b35-b713-60351f56afbd" providerId="ADAL" clId="{F5F97842-A295-4F9F-B89B-A63B35E1C32D}" dt="2022-10-10T09:21:56.631" v="3403"/>
          <ac:picMkLst>
            <pc:docMk/>
            <pc:sldMk cId="2506831184" sldId="296"/>
            <ac:picMk id="124" creationId="{9E41B84F-DF0C-451C-82E1-8004FDB0ADEF}"/>
          </ac:picMkLst>
        </pc:picChg>
        <pc:picChg chg="add del mod">
          <ac:chgData name="Manasweeta Angane" userId="05da2731-9352-4b35-b713-60351f56afbd" providerId="ADAL" clId="{F5F97842-A295-4F9F-B89B-A63B35E1C32D}" dt="2022-10-10T09:22:12.756" v="3405"/>
          <ac:picMkLst>
            <pc:docMk/>
            <pc:sldMk cId="2506831184" sldId="296"/>
            <ac:picMk id="125" creationId="{E6C2D1E2-7FC4-4D14-BD23-CE681A32B630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27" creationId="{1839789D-C416-4369-80AC-2BA05B393710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28" creationId="{F8C3846D-7A3C-4CA3-BB89-356A7F5AD193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29" creationId="{C89B943A-706B-44A5-B534-8ED08DDDD95D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30" creationId="{791ED3C7-0963-46C4-AAC1-71F20A440095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31" creationId="{4961DF1B-4B75-43AE-9B61-74D3652A07DC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32" creationId="{FD04BF65-8046-49A6-84B2-36721CCFC231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33" creationId="{2FBEC350-75C7-4A46-BF34-BBA65CB15395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34" creationId="{A045773E-AABE-4471-80C5-CCDB1C649094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35" creationId="{DB9F0FA1-A042-42AC-9063-FEB863BE1189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36" creationId="{4B18EFEC-322A-46FF-8E21-A0696CC5A8A9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37" creationId="{6B2701E1-B4F8-455B-B4FF-284D37A9D0A8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58" creationId="{E621B606-0336-477E-BDC2-EE565A86C1E7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59" creationId="{B19E829D-ECA1-4D7C-B144-5AEAC4766BBE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65" creationId="{2E5B0CA9-FAE1-413E-97F8-C6A52F805AD8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66" creationId="{0EAA2321-ED78-4B53-B06A-216660FA9FE6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70" creationId="{D01952AC-92AD-4AD4-8F58-CB8EDB3AD701}"/>
          </ac:picMkLst>
        </pc:picChg>
        <pc:picChg chg="mod">
          <ac:chgData name="Manasweeta Angane" userId="05da2731-9352-4b35-b713-60351f56afbd" providerId="ADAL" clId="{F5F97842-A295-4F9F-B89B-A63B35E1C32D}" dt="2022-10-10T09:21:59.271" v="3404"/>
          <ac:picMkLst>
            <pc:docMk/>
            <pc:sldMk cId="2506831184" sldId="296"/>
            <ac:picMk id="171" creationId="{C5D6B387-99A8-4562-83CB-BCEE51FBD5B8}"/>
          </ac:picMkLst>
        </pc:picChg>
        <pc:picChg chg="add del mod">
          <ac:chgData name="Manasweeta Angane" userId="05da2731-9352-4b35-b713-60351f56afbd" providerId="ADAL" clId="{F5F97842-A295-4F9F-B89B-A63B35E1C32D}" dt="2022-10-10T09:22:12.756" v="3405"/>
          <ac:picMkLst>
            <pc:docMk/>
            <pc:sldMk cId="2506831184" sldId="296"/>
            <ac:picMk id="175" creationId="{629E300D-0396-4E11-9281-101CA82E770A}"/>
          </ac:picMkLst>
        </pc:picChg>
        <pc:picChg chg="add del mod">
          <ac:chgData name="Manasweeta Angane" userId="05da2731-9352-4b35-b713-60351f56afbd" providerId="ADAL" clId="{F5F97842-A295-4F9F-B89B-A63B35E1C32D}" dt="2022-10-10T09:22:12.756" v="3405"/>
          <ac:picMkLst>
            <pc:docMk/>
            <pc:sldMk cId="2506831184" sldId="296"/>
            <ac:picMk id="178" creationId="{38FA56EB-25A2-4412-9B8C-259AE7C76127}"/>
          </ac:picMkLst>
        </pc:picChg>
        <pc:picChg chg="add del mod">
          <ac:chgData name="Manasweeta Angane" userId="05da2731-9352-4b35-b713-60351f56afbd" providerId="ADAL" clId="{F5F97842-A295-4F9F-B89B-A63B35E1C32D}" dt="2022-10-10T09:33:42.164" v="3480"/>
          <ac:picMkLst>
            <pc:docMk/>
            <pc:sldMk cId="2506831184" sldId="296"/>
            <ac:picMk id="179" creationId="{1DCF7E13-634D-4E61-A4C7-7E0FFC5117C0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181" creationId="{982BCA46-1B1C-42DE-A955-D43935732281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182" creationId="{B09D90C5-0405-4306-8B97-0B9DA080B65C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183" creationId="{22EEBFCC-1913-4115-A01F-A82E8F305307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184" creationId="{2C23919B-463A-4740-B3AD-E124B3AF4E29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185" creationId="{FC9CD372-60CB-492E-A728-40BC1F41BF5D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186" creationId="{451988AF-46AE-465D-B50B-CDB4C4AAD2B2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187" creationId="{628CE7B7-DEE4-4CC0-AB03-C0CBC9CD344A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188" creationId="{17CBE6DD-E6C0-4C16-A2AE-35A47ECCD803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189" creationId="{A62EE188-4B92-472B-BB64-8A8B3DF1FE0A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190" creationId="{61AED92E-01D3-4DDC-83CA-77B2321D0AC9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191" creationId="{4DAACFA6-18DB-4422-903A-DF0A7B684F60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212" creationId="{D251EB48-8747-4B3C-966D-B95A1264F37F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213" creationId="{2C4F1FB2-BEE3-4A80-B4D2-1BC7ADF11E61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219" creationId="{5AE7F3F3-A172-445C-B01C-7D386163BE8E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220" creationId="{A4E46A8A-435C-4851-9925-2A060CBD7600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224" creationId="{7CB8BD5D-F553-4760-93BA-9B66F9ABF08F}"/>
          </ac:picMkLst>
        </pc:picChg>
        <pc:picChg chg="mod">
          <ac:chgData name="Manasweeta Angane" userId="05da2731-9352-4b35-b713-60351f56afbd" providerId="ADAL" clId="{F5F97842-A295-4F9F-B89B-A63B35E1C32D}" dt="2022-10-10T09:29:32.148" v="3406"/>
          <ac:picMkLst>
            <pc:docMk/>
            <pc:sldMk cId="2506831184" sldId="296"/>
            <ac:picMk id="225" creationId="{7527AF78-8350-41DA-BFBF-1859D3F055A5}"/>
          </ac:picMkLst>
        </pc:picChg>
        <pc:picChg chg="add del mod">
          <ac:chgData name="Manasweeta Angane" userId="05da2731-9352-4b35-b713-60351f56afbd" providerId="ADAL" clId="{F5F97842-A295-4F9F-B89B-A63B35E1C32D}" dt="2022-10-10T09:33:42.164" v="3480"/>
          <ac:picMkLst>
            <pc:docMk/>
            <pc:sldMk cId="2506831184" sldId="296"/>
            <ac:picMk id="229" creationId="{BC49E319-148C-4EA6-8B48-19BFC801B4C3}"/>
          </ac:picMkLst>
        </pc:picChg>
        <pc:picChg chg="add del mod">
          <ac:chgData name="Manasweeta Angane" userId="05da2731-9352-4b35-b713-60351f56afbd" providerId="ADAL" clId="{F5F97842-A295-4F9F-B89B-A63B35E1C32D}" dt="2022-10-10T09:33:42.164" v="3480"/>
          <ac:picMkLst>
            <pc:docMk/>
            <pc:sldMk cId="2506831184" sldId="296"/>
            <ac:picMk id="232" creationId="{B988D726-F07E-482E-96EF-E98F51389593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35" creationId="{15C3E634-0187-4EB8-ADEC-B4B463A40EF1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51" creationId="{C58B4395-290E-407D-A0F0-1A793F23B605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54" creationId="{A5B97082-C813-4653-982C-13A6FC71E876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58" creationId="{39AAD82C-93BA-422C-A0A5-58E465F7BD46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59" creationId="{689EB1E2-0A1C-46A5-B0EE-96C55ABB90B8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62" creationId="{C4701234-295A-45C2-BED8-D76EBF3767DC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63" creationId="{BCA7F757-9D4D-43E2-A613-392D8A5CD809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64" creationId="{9EE47B02-4C4D-4B7C-B03E-027942C514D6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65" creationId="{4C010DC1-214E-4D8B-80FF-E185572596A3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79" creationId="{29A0ADD2-7C53-46C3-82D0-31FE355D5442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80" creationId="{82A54945-0BC4-478A-9CF9-ED94F42DF0C4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81" creationId="{1CFA6856-91FB-470D-8231-0F276505292C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82" creationId="{5979F003-6409-4C74-9DE3-79BCC3621969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83" creationId="{B0EB3BAF-4A01-4E1F-87B5-C01FB177D7A6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84" creationId="{3A516FC9-B65B-4539-9F72-AC0095C8C50D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85" creationId="{91B7960C-F5E1-4194-B644-D025898F2E9C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86" creationId="{41205F53-4A9C-4D98-BD10-468DA4EB48C8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87" creationId="{D99571EE-C451-4AE9-8952-1A0B65F89367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88" creationId="{ECE381ED-C041-4F3B-A5ED-51FC79DDF8FA}"/>
          </ac:picMkLst>
        </pc:picChg>
        <pc:picChg chg="mod">
          <ac:chgData name="Manasweeta Angane" userId="05da2731-9352-4b35-b713-60351f56afbd" providerId="ADAL" clId="{F5F97842-A295-4F9F-B89B-A63B35E1C32D}" dt="2022-10-10T09:34:40.899" v="3481"/>
          <ac:picMkLst>
            <pc:docMk/>
            <pc:sldMk cId="2506831184" sldId="296"/>
            <ac:picMk id="289" creationId="{A4DE9267-EBA8-4475-85AB-62562676317A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291" creationId="{787F1EDF-26F2-460F-B049-4D2C5933F431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07" creationId="{1C427A80-AC03-4637-A0F0-6AD1899EE633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10" creationId="{2080A72C-2591-4F1C-96DB-3F930AE35D02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14" creationId="{AF9C4CE7-A22A-4EDA-BF98-0EAB0E15D53A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15" creationId="{C2588346-D48C-4F69-A09A-28F223648E5D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18" creationId="{8B491C27-C940-4338-ADF0-79F642B1F544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19" creationId="{5D5DAB43-D57E-448A-855D-A5E8DDB130C5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20" creationId="{1608BE8E-4032-4370-8D92-39522B9A0891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21" creationId="{FCC0A85F-AA83-4099-8260-D6A37E951D9C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35" creationId="{42158EB5-E39B-4CA1-BF5A-37E14B8A08FD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36" creationId="{AF9449CB-6B3E-4119-9571-A13BBC738B73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37" creationId="{37F3DED1-E6B8-4497-BD88-4B03EE4D04E6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38" creationId="{C1C64546-BAEC-47C6-840D-33AB837F16F8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39" creationId="{D1D74B07-C081-40F4-8F92-30AC26A60E6B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40" creationId="{D037420B-B47C-4242-8BAD-F085E00BECAC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41" creationId="{2DE3519B-63AE-4C4D-A0F3-5A39E1E19AF2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42" creationId="{0A7D3E44-B862-4C05-B6AA-065EB88BE872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43" creationId="{F84D1B23-8C41-47D8-BC9B-6220CE8B2CE1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44" creationId="{8631FC73-4868-425E-A24B-BF6EF81EFA15}"/>
          </ac:picMkLst>
        </pc:picChg>
        <pc:picChg chg="mod">
          <ac:chgData name="Manasweeta Angane" userId="05da2731-9352-4b35-b713-60351f56afbd" providerId="ADAL" clId="{F5F97842-A295-4F9F-B89B-A63B35E1C32D}" dt="2022-10-10T09:36:55.837" v="3505"/>
          <ac:picMkLst>
            <pc:docMk/>
            <pc:sldMk cId="2506831184" sldId="296"/>
            <ac:picMk id="345" creationId="{B814A226-E735-424B-8DF2-422E2F91CFBE}"/>
          </ac:picMkLst>
        </pc:picChg>
        <pc:picChg chg="mod">
          <ac:chgData name="Manasweeta Angane" userId="05da2731-9352-4b35-b713-60351f56afbd" providerId="ADAL" clId="{F5F97842-A295-4F9F-B89B-A63B35E1C32D}" dt="2022-10-10T09:38:23.348" v="3530"/>
          <ac:picMkLst>
            <pc:docMk/>
            <pc:sldMk cId="2506831184" sldId="296"/>
            <ac:picMk id="349" creationId="{E381FF72-C65E-4B4D-9C9F-0541C46D7EAA}"/>
          </ac:picMkLst>
        </pc:picChg>
        <pc:picChg chg="mod">
          <ac:chgData name="Manasweeta Angane" userId="05da2731-9352-4b35-b713-60351f56afbd" providerId="ADAL" clId="{F5F97842-A295-4F9F-B89B-A63B35E1C32D}" dt="2022-10-10T09:38:23.348" v="3530"/>
          <ac:picMkLst>
            <pc:docMk/>
            <pc:sldMk cId="2506831184" sldId="296"/>
            <ac:picMk id="350" creationId="{05E45079-D931-4DFF-A876-C930D912ECB6}"/>
          </ac:picMkLst>
        </pc:picChg>
        <pc:picChg chg="mod">
          <ac:chgData name="Manasweeta Angane" userId="05da2731-9352-4b35-b713-60351f56afbd" providerId="ADAL" clId="{F5F97842-A295-4F9F-B89B-A63B35E1C32D}" dt="2022-10-10T09:39:03.893" v="3534"/>
          <ac:picMkLst>
            <pc:docMk/>
            <pc:sldMk cId="2506831184" sldId="296"/>
            <ac:picMk id="354" creationId="{E61CECFE-D9CC-4DA0-AD96-6D9C7623A18A}"/>
          </ac:picMkLst>
        </pc:picChg>
        <pc:picChg chg="mod">
          <ac:chgData name="Manasweeta Angane" userId="05da2731-9352-4b35-b713-60351f56afbd" providerId="ADAL" clId="{F5F97842-A295-4F9F-B89B-A63B35E1C32D}" dt="2022-10-10T09:39:03.893" v="3534"/>
          <ac:picMkLst>
            <pc:docMk/>
            <pc:sldMk cId="2506831184" sldId="296"/>
            <ac:picMk id="355" creationId="{7A4453F0-1F1F-4536-B48B-7163181E395A}"/>
          </ac:picMkLst>
        </pc:picChg>
        <pc:inkChg chg="add del mod">
          <ac:chgData name="Manasweeta Angane" userId="05da2731-9352-4b35-b713-60351f56afbd" providerId="ADAL" clId="{F5F97842-A295-4F9F-B89B-A63B35E1C32D}" dt="2022-10-10T09:21:34.405" v="3401"/>
          <ac:inkMkLst>
            <pc:docMk/>
            <pc:sldMk cId="2506831184" sldId="296"/>
            <ac:inkMk id="52" creationId="{DA9F1650-508A-42E7-AE64-02AB62F178F6}"/>
          </ac:inkMkLst>
        </pc:inkChg>
        <pc:inkChg chg="add del mod">
          <ac:chgData name="Manasweeta Angane" userId="05da2731-9352-4b35-b713-60351f56afbd" providerId="ADAL" clId="{F5F97842-A295-4F9F-B89B-A63B35E1C32D}" dt="2022-10-10T09:21:56.631" v="3403"/>
          <ac:inkMkLst>
            <pc:docMk/>
            <pc:sldMk cId="2506831184" sldId="296"/>
            <ac:inkMk id="106" creationId="{464D3969-3FAD-40F4-8D76-43B5CFB0DAED}"/>
          </ac:inkMkLst>
        </pc:inkChg>
        <pc:inkChg chg="add del mod">
          <ac:chgData name="Manasweeta Angane" userId="05da2731-9352-4b35-b713-60351f56afbd" providerId="ADAL" clId="{F5F97842-A295-4F9F-B89B-A63B35E1C32D}" dt="2022-10-10T09:22:12.756" v="3405"/>
          <ac:inkMkLst>
            <pc:docMk/>
            <pc:sldMk cId="2506831184" sldId="296"/>
            <ac:inkMk id="160" creationId="{3ABC1974-C74C-4067-94C1-11C18A4D99AE}"/>
          </ac:inkMkLst>
        </pc:inkChg>
        <pc:inkChg chg="add del mod">
          <ac:chgData name="Manasweeta Angane" userId="05da2731-9352-4b35-b713-60351f56afbd" providerId="ADAL" clId="{F5F97842-A295-4F9F-B89B-A63B35E1C32D}" dt="2022-10-10T09:33:42.164" v="3480"/>
          <ac:inkMkLst>
            <pc:docMk/>
            <pc:sldMk cId="2506831184" sldId="296"/>
            <ac:inkMk id="214" creationId="{6B3456DB-7366-453E-987A-D139DD3236B1}"/>
          </ac:inkMkLst>
        </pc:inkChg>
        <pc:inkChg chg="mod">
          <ac:chgData name="Manasweeta Angane" userId="05da2731-9352-4b35-b713-60351f56afbd" providerId="ADAL" clId="{F5F97842-A295-4F9F-B89B-A63B35E1C32D}" dt="2022-10-10T09:34:40.899" v="3481"/>
          <ac:inkMkLst>
            <pc:docMk/>
            <pc:sldMk cId="2506831184" sldId="296"/>
            <ac:inkMk id="244" creationId="{D1EA22F0-9645-4788-8E56-C7157AD49225}"/>
          </ac:inkMkLst>
        </pc:inkChg>
        <pc:inkChg chg="mod">
          <ac:chgData name="Manasweeta Angane" userId="05da2731-9352-4b35-b713-60351f56afbd" providerId="ADAL" clId="{F5F97842-A295-4F9F-B89B-A63B35E1C32D}" dt="2022-10-10T09:36:55.837" v="3505"/>
          <ac:inkMkLst>
            <pc:docMk/>
            <pc:sldMk cId="2506831184" sldId="296"/>
            <ac:inkMk id="300" creationId="{20EBC11E-D1F8-4404-8C5C-8EB3AFEE4FF5}"/>
          </ac:inkMkLst>
        </pc:inkChg>
        <pc:cxnChg chg="mod">
          <ac:chgData name="Manasweeta Angane" userId="05da2731-9352-4b35-b713-60351f56afbd" providerId="ADAL" clId="{F5F97842-A295-4F9F-B89B-A63B35E1C32D}" dt="2022-10-10T09:21:29.873" v="3400"/>
          <ac:cxnSpMkLst>
            <pc:docMk/>
            <pc:sldMk cId="2506831184" sldId="296"/>
            <ac:cxnSpMk id="31" creationId="{1D1A09B2-AE7A-4BDC-9BD7-E067F295BA77}"/>
          </ac:cxnSpMkLst>
        </pc:cxnChg>
        <pc:cxnChg chg="mod">
          <ac:chgData name="Manasweeta Angane" userId="05da2731-9352-4b35-b713-60351f56afbd" providerId="ADAL" clId="{F5F97842-A295-4F9F-B89B-A63B35E1C32D}" dt="2022-10-10T09:21:29.873" v="3400"/>
          <ac:cxnSpMkLst>
            <pc:docMk/>
            <pc:sldMk cId="2506831184" sldId="296"/>
            <ac:cxnSpMk id="32" creationId="{5464BD78-F485-4418-83DC-8FBD7026D748}"/>
          </ac:cxnSpMkLst>
        </pc:cxnChg>
        <pc:cxnChg chg="mod">
          <ac:chgData name="Manasweeta Angane" userId="05da2731-9352-4b35-b713-60351f56afbd" providerId="ADAL" clId="{F5F97842-A295-4F9F-B89B-A63B35E1C32D}" dt="2022-10-10T09:21:29.873" v="3400"/>
          <ac:cxnSpMkLst>
            <pc:docMk/>
            <pc:sldMk cId="2506831184" sldId="296"/>
            <ac:cxnSpMk id="33" creationId="{4A56275D-10E3-42C6-9F6E-17EB89CF79C8}"/>
          </ac:cxnSpMkLst>
        </pc:cxnChg>
        <pc:cxnChg chg="mod">
          <ac:chgData name="Manasweeta Angane" userId="05da2731-9352-4b35-b713-60351f56afbd" providerId="ADAL" clId="{F5F97842-A295-4F9F-B89B-A63B35E1C32D}" dt="2022-10-10T09:21:29.873" v="3400"/>
          <ac:cxnSpMkLst>
            <pc:docMk/>
            <pc:sldMk cId="2506831184" sldId="296"/>
            <ac:cxnSpMk id="34" creationId="{5E5C55A5-F2CF-440C-A574-26A817C46BA3}"/>
          </ac:cxnSpMkLst>
        </pc:cxnChg>
        <pc:cxnChg chg="mod">
          <ac:chgData name="Manasweeta Angane" userId="05da2731-9352-4b35-b713-60351f56afbd" providerId="ADAL" clId="{F5F97842-A295-4F9F-B89B-A63B35E1C32D}" dt="2022-10-10T09:21:29.873" v="3400"/>
          <ac:cxnSpMkLst>
            <pc:docMk/>
            <pc:sldMk cId="2506831184" sldId="296"/>
            <ac:cxnSpMk id="35" creationId="{EBBA1595-5DDD-460E-92E9-9155D8134F1A}"/>
          </ac:cxnSpMkLst>
        </pc:cxnChg>
        <pc:cxnChg chg="mod">
          <ac:chgData name="Manasweeta Angane" userId="05da2731-9352-4b35-b713-60351f56afbd" providerId="ADAL" clId="{F5F97842-A295-4F9F-B89B-A63B35E1C32D}" dt="2022-10-10T09:21:29.873" v="3400"/>
          <ac:cxnSpMkLst>
            <pc:docMk/>
            <pc:sldMk cId="2506831184" sldId="296"/>
            <ac:cxnSpMk id="36" creationId="{3AED77B2-F0B4-4283-93B8-0ACD9249BA51}"/>
          </ac:cxnSpMkLst>
        </pc:cxnChg>
        <pc:cxnChg chg="mod">
          <ac:chgData name="Manasweeta Angane" userId="05da2731-9352-4b35-b713-60351f56afbd" providerId="ADAL" clId="{F5F97842-A295-4F9F-B89B-A63B35E1C32D}" dt="2022-10-10T09:21:29.873" v="3400"/>
          <ac:cxnSpMkLst>
            <pc:docMk/>
            <pc:sldMk cId="2506831184" sldId="296"/>
            <ac:cxnSpMk id="37" creationId="{EBAD6B45-1D8C-4CE7-91E1-E502A266AC38}"/>
          </ac:cxnSpMkLst>
        </pc:cxnChg>
        <pc:cxnChg chg="mod">
          <ac:chgData name="Manasweeta Angane" userId="05da2731-9352-4b35-b713-60351f56afbd" providerId="ADAL" clId="{F5F97842-A295-4F9F-B89B-A63B35E1C32D}" dt="2022-10-10T09:21:29.873" v="3400"/>
          <ac:cxnSpMkLst>
            <pc:docMk/>
            <pc:sldMk cId="2506831184" sldId="296"/>
            <ac:cxnSpMk id="38" creationId="{3C5FC21D-41EF-48BC-93E0-33FEF2B23A0D}"/>
          </ac:cxnSpMkLst>
        </pc:cxnChg>
        <pc:cxnChg chg="mod">
          <ac:chgData name="Manasweeta Angane" userId="05da2731-9352-4b35-b713-60351f56afbd" providerId="ADAL" clId="{F5F97842-A295-4F9F-B89B-A63B35E1C32D}" dt="2022-10-10T09:21:29.873" v="3400"/>
          <ac:cxnSpMkLst>
            <pc:docMk/>
            <pc:sldMk cId="2506831184" sldId="296"/>
            <ac:cxnSpMk id="39" creationId="{2C8A1203-4DA8-47E4-948E-7EB3B79E86F7}"/>
          </ac:cxnSpMkLst>
        </pc:cxnChg>
        <pc:cxnChg chg="mod">
          <ac:chgData name="Manasweeta Angane" userId="05da2731-9352-4b35-b713-60351f56afbd" providerId="ADAL" clId="{F5F97842-A295-4F9F-B89B-A63B35E1C32D}" dt="2022-10-10T09:21:29.873" v="3400"/>
          <ac:cxnSpMkLst>
            <pc:docMk/>
            <pc:sldMk cId="2506831184" sldId="296"/>
            <ac:cxnSpMk id="40" creationId="{66BECA56-F525-467B-AB20-D32B5691AF29}"/>
          </ac:cxnSpMkLst>
        </pc:cxnChg>
        <pc:cxnChg chg="mod">
          <ac:chgData name="Manasweeta Angane" userId="05da2731-9352-4b35-b713-60351f56afbd" providerId="ADAL" clId="{F5F97842-A295-4F9F-B89B-A63B35E1C32D}" dt="2022-10-10T09:21:29.873" v="3400"/>
          <ac:cxnSpMkLst>
            <pc:docMk/>
            <pc:sldMk cId="2506831184" sldId="296"/>
            <ac:cxnSpMk id="41" creationId="{488A7A55-D1A3-4BCB-A5B7-F15451540D35}"/>
          </ac:cxnSpMkLst>
        </pc:cxnChg>
        <pc:cxnChg chg="mod">
          <ac:chgData name="Manasweeta Angane" userId="05da2731-9352-4b35-b713-60351f56afbd" providerId="ADAL" clId="{F5F97842-A295-4F9F-B89B-A63B35E1C32D}" dt="2022-10-10T09:21:29.873" v="3400"/>
          <ac:cxnSpMkLst>
            <pc:docMk/>
            <pc:sldMk cId="2506831184" sldId="296"/>
            <ac:cxnSpMk id="42" creationId="{4E86DD21-3FE0-43C7-95A4-2801E4CA92A9}"/>
          </ac:cxnSpMkLst>
        </pc:cxnChg>
        <pc:cxnChg chg="add del mod">
          <ac:chgData name="Manasweeta Angane" userId="05da2731-9352-4b35-b713-60351f56afbd" providerId="ADAL" clId="{F5F97842-A295-4F9F-B89B-A63B35E1C32D}" dt="2022-10-10T09:21:34.405" v="3401"/>
          <ac:cxnSpMkLst>
            <pc:docMk/>
            <pc:sldMk cId="2506831184" sldId="296"/>
            <ac:cxnSpMk id="68" creationId="{6D58C0A4-7D4F-40A4-B601-53E8B84BA6F7}"/>
          </ac:cxnSpMkLst>
        </pc:cxnChg>
        <pc:cxnChg chg="mod">
          <ac:chgData name="Manasweeta Angane" userId="05da2731-9352-4b35-b713-60351f56afbd" providerId="ADAL" clId="{F5F97842-A295-4F9F-B89B-A63B35E1C32D}" dt="2022-10-10T09:21:49.084" v="3402"/>
          <ac:cxnSpMkLst>
            <pc:docMk/>
            <pc:sldMk cId="2506831184" sldId="296"/>
            <ac:cxnSpMk id="85" creationId="{2C23141B-C14C-4302-A878-5BA6EB3A435C}"/>
          </ac:cxnSpMkLst>
        </pc:cxnChg>
        <pc:cxnChg chg="mod">
          <ac:chgData name="Manasweeta Angane" userId="05da2731-9352-4b35-b713-60351f56afbd" providerId="ADAL" clId="{F5F97842-A295-4F9F-B89B-A63B35E1C32D}" dt="2022-10-10T09:21:49.084" v="3402"/>
          <ac:cxnSpMkLst>
            <pc:docMk/>
            <pc:sldMk cId="2506831184" sldId="296"/>
            <ac:cxnSpMk id="86" creationId="{F5EAF836-7422-47CE-B2A1-6E06E0E8FF20}"/>
          </ac:cxnSpMkLst>
        </pc:cxnChg>
        <pc:cxnChg chg="mod">
          <ac:chgData name="Manasweeta Angane" userId="05da2731-9352-4b35-b713-60351f56afbd" providerId="ADAL" clId="{F5F97842-A295-4F9F-B89B-A63B35E1C32D}" dt="2022-10-10T09:21:49.084" v="3402"/>
          <ac:cxnSpMkLst>
            <pc:docMk/>
            <pc:sldMk cId="2506831184" sldId="296"/>
            <ac:cxnSpMk id="87" creationId="{C7A709E9-4017-44EA-AB3F-5C0BFB94616F}"/>
          </ac:cxnSpMkLst>
        </pc:cxnChg>
        <pc:cxnChg chg="mod">
          <ac:chgData name="Manasweeta Angane" userId="05da2731-9352-4b35-b713-60351f56afbd" providerId="ADAL" clId="{F5F97842-A295-4F9F-B89B-A63B35E1C32D}" dt="2022-10-10T09:21:49.084" v="3402"/>
          <ac:cxnSpMkLst>
            <pc:docMk/>
            <pc:sldMk cId="2506831184" sldId="296"/>
            <ac:cxnSpMk id="88" creationId="{DE71B2A3-9936-4EEA-9DFA-39868A8D7EA6}"/>
          </ac:cxnSpMkLst>
        </pc:cxnChg>
        <pc:cxnChg chg="mod">
          <ac:chgData name="Manasweeta Angane" userId="05da2731-9352-4b35-b713-60351f56afbd" providerId="ADAL" clId="{F5F97842-A295-4F9F-B89B-A63B35E1C32D}" dt="2022-10-10T09:21:49.084" v="3402"/>
          <ac:cxnSpMkLst>
            <pc:docMk/>
            <pc:sldMk cId="2506831184" sldId="296"/>
            <ac:cxnSpMk id="89" creationId="{E008555F-338D-48E5-ADA6-D7EBF6DB5E3E}"/>
          </ac:cxnSpMkLst>
        </pc:cxnChg>
        <pc:cxnChg chg="mod">
          <ac:chgData name="Manasweeta Angane" userId="05da2731-9352-4b35-b713-60351f56afbd" providerId="ADAL" clId="{F5F97842-A295-4F9F-B89B-A63B35E1C32D}" dt="2022-10-10T09:21:49.084" v="3402"/>
          <ac:cxnSpMkLst>
            <pc:docMk/>
            <pc:sldMk cId="2506831184" sldId="296"/>
            <ac:cxnSpMk id="90" creationId="{0EEFC623-747E-4BF5-9667-62AA62703AFC}"/>
          </ac:cxnSpMkLst>
        </pc:cxnChg>
        <pc:cxnChg chg="mod">
          <ac:chgData name="Manasweeta Angane" userId="05da2731-9352-4b35-b713-60351f56afbd" providerId="ADAL" clId="{F5F97842-A295-4F9F-B89B-A63B35E1C32D}" dt="2022-10-10T09:21:49.084" v="3402"/>
          <ac:cxnSpMkLst>
            <pc:docMk/>
            <pc:sldMk cId="2506831184" sldId="296"/>
            <ac:cxnSpMk id="91" creationId="{30CD9B59-A85E-4802-889A-C30ABFD2940A}"/>
          </ac:cxnSpMkLst>
        </pc:cxnChg>
        <pc:cxnChg chg="mod">
          <ac:chgData name="Manasweeta Angane" userId="05da2731-9352-4b35-b713-60351f56afbd" providerId="ADAL" clId="{F5F97842-A295-4F9F-B89B-A63B35E1C32D}" dt="2022-10-10T09:21:49.084" v="3402"/>
          <ac:cxnSpMkLst>
            <pc:docMk/>
            <pc:sldMk cId="2506831184" sldId="296"/>
            <ac:cxnSpMk id="92" creationId="{86D52062-965E-4951-92DC-97A2BF2752A6}"/>
          </ac:cxnSpMkLst>
        </pc:cxnChg>
        <pc:cxnChg chg="mod">
          <ac:chgData name="Manasweeta Angane" userId="05da2731-9352-4b35-b713-60351f56afbd" providerId="ADAL" clId="{F5F97842-A295-4F9F-B89B-A63B35E1C32D}" dt="2022-10-10T09:21:49.084" v="3402"/>
          <ac:cxnSpMkLst>
            <pc:docMk/>
            <pc:sldMk cId="2506831184" sldId="296"/>
            <ac:cxnSpMk id="93" creationId="{C4CD5A47-21E8-48AA-BC29-EF44B43CF2C3}"/>
          </ac:cxnSpMkLst>
        </pc:cxnChg>
        <pc:cxnChg chg="mod">
          <ac:chgData name="Manasweeta Angane" userId="05da2731-9352-4b35-b713-60351f56afbd" providerId="ADAL" clId="{F5F97842-A295-4F9F-B89B-A63B35E1C32D}" dt="2022-10-10T09:21:49.084" v="3402"/>
          <ac:cxnSpMkLst>
            <pc:docMk/>
            <pc:sldMk cId="2506831184" sldId="296"/>
            <ac:cxnSpMk id="94" creationId="{0409CAF5-AB5A-4BE3-BC27-F0EAF795A586}"/>
          </ac:cxnSpMkLst>
        </pc:cxnChg>
        <pc:cxnChg chg="mod">
          <ac:chgData name="Manasweeta Angane" userId="05da2731-9352-4b35-b713-60351f56afbd" providerId="ADAL" clId="{F5F97842-A295-4F9F-B89B-A63B35E1C32D}" dt="2022-10-10T09:21:49.084" v="3402"/>
          <ac:cxnSpMkLst>
            <pc:docMk/>
            <pc:sldMk cId="2506831184" sldId="296"/>
            <ac:cxnSpMk id="95" creationId="{2695A319-0533-4394-A02D-DDF827963BA8}"/>
          </ac:cxnSpMkLst>
        </pc:cxnChg>
        <pc:cxnChg chg="mod">
          <ac:chgData name="Manasweeta Angane" userId="05da2731-9352-4b35-b713-60351f56afbd" providerId="ADAL" clId="{F5F97842-A295-4F9F-B89B-A63B35E1C32D}" dt="2022-10-10T09:21:49.084" v="3402"/>
          <ac:cxnSpMkLst>
            <pc:docMk/>
            <pc:sldMk cId="2506831184" sldId="296"/>
            <ac:cxnSpMk id="96" creationId="{D91A20A9-4998-48A6-9D4E-D311C841AD56}"/>
          </ac:cxnSpMkLst>
        </pc:cxnChg>
        <pc:cxnChg chg="add del mod">
          <ac:chgData name="Manasweeta Angane" userId="05da2731-9352-4b35-b713-60351f56afbd" providerId="ADAL" clId="{F5F97842-A295-4F9F-B89B-A63B35E1C32D}" dt="2022-10-10T09:21:56.631" v="3403"/>
          <ac:cxnSpMkLst>
            <pc:docMk/>
            <pc:sldMk cId="2506831184" sldId="296"/>
            <ac:cxnSpMk id="122" creationId="{B6CAE9EC-0F65-48DF-889F-FF8340C187B5}"/>
          </ac:cxnSpMkLst>
        </pc:cxnChg>
        <pc:cxnChg chg="mod">
          <ac:chgData name="Manasweeta Angane" userId="05da2731-9352-4b35-b713-60351f56afbd" providerId="ADAL" clId="{F5F97842-A295-4F9F-B89B-A63B35E1C32D}" dt="2022-10-10T09:21:59.271" v="3404"/>
          <ac:cxnSpMkLst>
            <pc:docMk/>
            <pc:sldMk cId="2506831184" sldId="296"/>
            <ac:cxnSpMk id="139" creationId="{107053C6-DB8C-4855-865B-C472C896758C}"/>
          </ac:cxnSpMkLst>
        </pc:cxnChg>
        <pc:cxnChg chg="mod">
          <ac:chgData name="Manasweeta Angane" userId="05da2731-9352-4b35-b713-60351f56afbd" providerId="ADAL" clId="{F5F97842-A295-4F9F-B89B-A63B35E1C32D}" dt="2022-10-10T09:21:59.271" v="3404"/>
          <ac:cxnSpMkLst>
            <pc:docMk/>
            <pc:sldMk cId="2506831184" sldId="296"/>
            <ac:cxnSpMk id="140" creationId="{20C45206-0C17-4AED-AB64-F59176661DE4}"/>
          </ac:cxnSpMkLst>
        </pc:cxnChg>
        <pc:cxnChg chg="mod">
          <ac:chgData name="Manasweeta Angane" userId="05da2731-9352-4b35-b713-60351f56afbd" providerId="ADAL" clId="{F5F97842-A295-4F9F-B89B-A63B35E1C32D}" dt="2022-10-10T09:21:59.271" v="3404"/>
          <ac:cxnSpMkLst>
            <pc:docMk/>
            <pc:sldMk cId="2506831184" sldId="296"/>
            <ac:cxnSpMk id="141" creationId="{2286B769-3FDA-4A6C-BF4C-FF6251ABCD29}"/>
          </ac:cxnSpMkLst>
        </pc:cxnChg>
        <pc:cxnChg chg="mod">
          <ac:chgData name="Manasweeta Angane" userId="05da2731-9352-4b35-b713-60351f56afbd" providerId="ADAL" clId="{F5F97842-A295-4F9F-B89B-A63B35E1C32D}" dt="2022-10-10T09:21:59.271" v="3404"/>
          <ac:cxnSpMkLst>
            <pc:docMk/>
            <pc:sldMk cId="2506831184" sldId="296"/>
            <ac:cxnSpMk id="142" creationId="{C10C66E9-4170-4BDC-B0A0-F042AF9F95E3}"/>
          </ac:cxnSpMkLst>
        </pc:cxnChg>
        <pc:cxnChg chg="mod">
          <ac:chgData name="Manasweeta Angane" userId="05da2731-9352-4b35-b713-60351f56afbd" providerId="ADAL" clId="{F5F97842-A295-4F9F-B89B-A63B35E1C32D}" dt="2022-10-10T09:21:59.271" v="3404"/>
          <ac:cxnSpMkLst>
            <pc:docMk/>
            <pc:sldMk cId="2506831184" sldId="296"/>
            <ac:cxnSpMk id="143" creationId="{D11C6873-C186-4878-B776-FFC1B6BF8FEE}"/>
          </ac:cxnSpMkLst>
        </pc:cxnChg>
        <pc:cxnChg chg="mod">
          <ac:chgData name="Manasweeta Angane" userId="05da2731-9352-4b35-b713-60351f56afbd" providerId="ADAL" clId="{F5F97842-A295-4F9F-B89B-A63B35E1C32D}" dt="2022-10-10T09:21:59.271" v="3404"/>
          <ac:cxnSpMkLst>
            <pc:docMk/>
            <pc:sldMk cId="2506831184" sldId="296"/>
            <ac:cxnSpMk id="144" creationId="{6C48E35E-413D-432A-B7A8-05D66CEC202E}"/>
          </ac:cxnSpMkLst>
        </pc:cxnChg>
        <pc:cxnChg chg="mod">
          <ac:chgData name="Manasweeta Angane" userId="05da2731-9352-4b35-b713-60351f56afbd" providerId="ADAL" clId="{F5F97842-A295-4F9F-B89B-A63B35E1C32D}" dt="2022-10-10T09:21:59.271" v="3404"/>
          <ac:cxnSpMkLst>
            <pc:docMk/>
            <pc:sldMk cId="2506831184" sldId="296"/>
            <ac:cxnSpMk id="145" creationId="{10379FC5-D896-4F89-B8E9-3146C37979DD}"/>
          </ac:cxnSpMkLst>
        </pc:cxnChg>
        <pc:cxnChg chg="mod">
          <ac:chgData name="Manasweeta Angane" userId="05da2731-9352-4b35-b713-60351f56afbd" providerId="ADAL" clId="{F5F97842-A295-4F9F-B89B-A63B35E1C32D}" dt="2022-10-10T09:21:59.271" v="3404"/>
          <ac:cxnSpMkLst>
            <pc:docMk/>
            <pc:sldMk cId="2506831184" sldId="296"/>
            <ac:cxnSpMk id="146" creationId="{0FED864A-A1E6-48F0-8B67-DFE98305FBA4}"/>
          </ac:cxnSpMkLst>
        </pc:cxnChg>
        <pc:cxnChg chg="mod">
          <ac:chgData name="Manasweeta Angane" userId="05da2731-9352-4b35-b713-60351f56afbd" providerId="ADAL" clId="{F5F97842-A295-4F9F-B89B-A63B35E1C32D}" dt="2022-10-10T09:21:59.271" v="3404"/>
          <ac:cxnSpMkLst>
            <pc:docMk/>
            <pc:sldMk cId="2506831184" sldId="296"/>
            <ac:cxnSpMk id="147" creationId="{104EE104-9002-470B-8522-92078F77CF1E}"/>
          </ac:cxnSpMkLst>
        </pc:cxnChg>
        <pc:cxnChg chg="mod">
          <ac:chgData name="Manasweeta Angane" userId="05da2731-9352-4b35-b713-60351f56afbd" providerId="ADAL" clId="{F5F97842-A295-4F9F-B89B-A63B35E1C32D}" dt="2022-10-10T09:21:59.271" v="3404"/>
          <ac:cxnSpMkLst>
            <pc:docMk/>
            <pc:sldMk cId="2506831184" sldId="296"/>
            <ac:cxnSpMk id="148" creationId="{DC72C7E0-4A0D-444A-BD62-9B8C412BC14D}"/>
          </ac:cxnSpMkLst>
        </pc:cxnChg>
        <pc:cxnChg chg="mod">
          <ac:chgData name="Manasweeta Angane" userId="05da2731-9352-4b35-b713-60351f56afbd" providerId="ADAL" clId="{F5F97842-A295-4F9F-B89B-A63B35E1C32D}" dt="2022-10-10T09:21:59.271" v="3404"/>
          <ac:cxnSpMkLst>
            <pc:docMk/>
            <pc:sldMk cId="2506831184" sldId="296"/>
            <ac:cxnSpMk id="149" creationId="{8B636055-1258-4F66-8203-4BC7B23CA20A}"/>
          </ac:cxnSpMkLst>
        </pc:cxnChg>
        <pc:cxnChg chg="mod">
          <ac:chgData name="Manasweeta Angane" userId="05da2731-9352-4b35-b713-60351f56afbd" providerId="ADAL" clId="{F5F97842-A295-4F9F-B89B-A63B35E1C32D}" dt="2022-10-10T09:21:59.271" v="3404"/>
          <ac:cxnSpMkLst>
            <pc:docMk/>
            <pc:sldMk cId="2506831184" sldId="296"/>
            <ac:cxnSpMk id="150" creationId="{34B8BA57-125B-44AE-A378-261E7C2E5160}"/>
          </ac:cxnSpMkLst>
        </pc:cxnChg>
        <pc:cxnChg chg="add del mod">
          <ac:chgData name="Manasweeta Angane" userId="05da2731-9352-4b35-b713-60351f56afbd" providerId="ADAL" clId="{F5F97842-A295-4F9F-B89B-A63B35E1C32D}" dt="2022-10-10T09:22:12.756" v="3405"/>
          <ac:cxnSpMkLst>
            <pc:docMk/>
            <pc:sldMk cId="2506831184" sldId="296"/>
            <ac:cxnSpMk id="176" creationId="{E403C88A-7301-4D0A-8C86-0E9BDD258A88}"/>
          </ac:cxnSpMkLst>
        </pc:cxnChg>
        <pc:cxnChg chg="mod">
          <ac:chgData name="Manasweeta Angane" userId="05da2731-9352-4b35-b713-60351f56afbd" providerId="ADAL" clId="{F5F97842-A295-4F9F-B89B-A63B35E1C32D}" dt="2022-10-10T09:29:32.148" v="3406"/>
          <ac:cxnSpMkLst>
            <pc:docMk/>
            <pc:sldMk cId="2506831184" sldId="296"/>
            <ac:cxnSpMk id="193" creationId="{3B9B3C3F-51D2-4DAC-A743-4C513A8971F9}"/>
          </ac:cxnSpMkLst>
        </pc:cxnChg>
        <pc:cxnChg chg="mod">
          <ac:chgData name="Manasweeta Angane" userId="05da2731-9352-4b35-b713-60351f56afbd" providerId="ADAL" clId="{F5F97842-A295-4F9F-B89B-A63B35E1C32D}" dt="2022-10-10T09:29:32.148" v="3406"/>
          <ac:cxnSpMkLst>
            <pc:docMk/>
            <pc:sldMk cId="2506831184" sldId="296"/>
            <ac:cxnSpMk id="194" creationId="{DD64A633-2B7B-4EDA-A9CF-CF57651B6BCC}"/>
          </ac:cxnSpMkLst>
        </pc:cxnChg>
        <pc:cxnChg chg="mod">
          <ac:chgData name="Manasweeta Angane" userId="05da2731-9352-4b35-b713-60351f56afbd" providerId="ADAL" clId="{F5F97842-A295-4F9F-B89B-A63B35E1C32D}" dt="2022-10-10T09:29:32.148" v="3406"/>
          <ac:cxnSpMkLst>
            <pc:docMk/>
            <pc:sldMk cId="2506831184" sldId="296"/>
            <ac:cxnSpMk id="195" creationId="{7F90ED65-943D-405C-A570-537E4736C67F}"/>
          </ac:cxnSpMkLst>
        </pc:cxnChg>
        <pc:cxnChg chg="mod">
          <ac:chgData name="Manasweeta Angane" userId="05da2731-9352-4b35-b713-60351f56afbd" providerId="ADAL" clId="{F5F97842-A295-4F9F-B89B-A63B35E1C32D}" dt="2022-10-10T09:29:32.148" v="3406"/>
          <ac:cxnSpMkLst>
            <pc:docMk/>
            <pc:sldMk cId="2506831184" sldId="296"/>
            <ac:cxnSpMk id="196" creationId="{3068433C-B30F-4CA2-AAC8-ECD0982B5F2B}"/>
          </ac:cxnSpMkLst>
        </pc:cxnChg>
        <pc:cxnChg chg="mod">
          <ac:chgData name="Manasweeta Angane" userId="05da2731-9352-4b35-b713-60351f56afbd" providerId="ADAL" clId="{F5F97842-A295-4F9F-B89B-A63B35E1C32D}" dt="2022-10-10T09:29:32.148" v="3406"/>
          <ac:cxnSpMkLst>
            <pc:docMk/>
            <pc:sldMk cId="2506831184" sldId="296"/>
            <ac:cxnSpMk id="197" creationId="{0BE94A9B-3DE2-4705-BF6C-6B6138376CB7}"/>
          </ac:cxnSpMkLst>
        </pc:cxnChg>
        <pc:cxnChg chg="mod">
          <ac:chgData name="Manasweeta Angane" userId="05da2731-9352-4b35-b713-60351f56afbd" providerId="ADAL" clId="{F5F97842-A295-4F9F-B89B-A63B35E1C32D}" dt="2022-10-10T09:29:32.148" v="3406"/>
          <ac:cxnSpMkLst>
            <pc:docMk/>
            <pc:sldMk cId="2506831184" sldId="296"/>
            <ac:cxnSpMk id="198" creationId="{9267A167-34E2-4826-8962-AEA4A30A5966}"/>
          </ac:cxnSpMkLst>
        </pc:cxnChg>
        <pc:cxnChg chg="mod">
          <ac:chgData name="Manasweeta Angane" userId="05da2731-9352-4b35-b713-60351f56afbd" providerId="ADAL" clId="{F5F97842-A295-4F9F-B89B-A63B35E1C32D}" dt="2022-10-10T09:29:32.148" v="3406"/>
          <ac:cxnSpMkLst>
            <pc:docMk/>
            <pc:sldMk cId="2506831184" sldId="296"/>
            <ac:cxnSpMk id="199" creationId="{AF7ED4D9-8A50-467A-A73D-D2F95ADF6106}"/>
          </ac:cxnSpMkLst>
        </pc:cxnChg>
        <pc:cxnChg chg="mod">
          <ac:chgData name="Manasweeta Angane" userId="05da2731-9352-4b35-b713-60351f56afbd" providerId="ADAL" clId="{F5F97842-A295-4F9F-B89B-A63B35E1C32D}" dt="2022-10-10T09:29:32.148" v="3406"/>
          <ac:cxnSpMkLst>
            <pc:docMk/>
            <pc:sldMk cId="2506831184" sldId="296"/>
            <ac:cxnSpMk id="200" creationId="{113AB1BB-D67F-4471-A249-FF40874D948F}"/>
          </ac:cxnSpMkLst>
        </pc:cxnChg>
        <pc:cxnChg chg="mod">
          <ac:chgData name="Manasweeta Angane" userId="05da2731-9352-4b35-b713-60351f56afbd" providerId="ADAL" clId="{F5F97842-A295-4F9F-B89B-A63B35E1C32D}" dt="2022-10-10T09:29:32.148" v="3406"/>
          <ac:cxnSpMkLst>
            <pc:docMk/>
            <pc:sldMk cId="2506831184" sldId="296"/>
            <ac:cxnSpMk id="201" creationId="{8EB168E7-6A0A-480E-AE9F-606F2B78CF6D}"/>
          </ac:cxnSpMkLst>
        </pc:cxnChg>
        <pc:cxnChg chg="mod">
          <ac:chgData name="Manasweeta Angane" userId="05da2731-9352-4b35-b713-60351f56afbd" providerId="ADAL" clId="{F5F97842-A295-4F9F-B89B-A63B35E1C32D}" dt="2022-10-10T09:29:32.148" v="3406"/>
          <ac:cxnSpMkLst>
            <pc:docMk/>
            <pc:sldMk cId="2506831184" sldId="296"/>
            <ac:cxnSpMk id="202" creationId="{A847CD6C-3487-421F-AE2F-2D0235CE2EB8}"/>
          </ac:cxnSpMkLst>
        </pc:cxnChg>
        <pc:cxnChg chg="mod">
          <ac:chgData name="Manasweeta Angane" userId="05da2731-9352-4b35-b713-60351f56afbd" providerId="ADAL" clId="{F5F97842-A295-4F9F-B89B-A63B35E1C32D}" dt="2022-10-10T09:29:32.148" v="3406"/>
          <ac:cxnSpMkLst>
            <pc:docMk/>
            <pc:sldMk cId="2506831184" sldId="296"/>
            <ac:cxnSpMk id="203" creationId="{1B870CA2-D821-4186-9E00-0016239C5CE8}"/>
          </ac:cxnSpMkLst>
        </pc:cxnChg>
        <pc:cxnChg chg="mod">
          <ac:chgData name="Manasweeta Angane" userId="05da2731-9352-4b35-b713-60351f56afbd" providerId="ADAL" clId="{F5F97842-A295-4F9F-B89B-A63B35E1C32D}" dt="2022-10-10T09:29:32.148" v="3406"/>
          <ac:cxnSpMkLst>
            <pc:docMk/>
            <pc:sldMk cId="2506831184" sldId="296"/>
            <ac:cxnSpMk id="204" creationId="{143A6609-7511-4DF5-9262-3E08577CDF67}"/>
          </ac:cxnSpMkLst>
        </pc:cxnChg>
        <pc:cxnChg chg="add del mod">
          <ac:chgData name="Manasweeta Angane" userId="05da2731-9352-4b35-b713-60351f56afbd" providerId="ADAL" clId="{F5F97842-A295-4F9F-B89B-A63B35E1C32D}" dt="2022-10-10T09:33:42.164" v="3480"/>
          <ac:cxnSpMkLst>
            <pc:docMk/>
            <pc:sldMk cId="2506831184" sldId="296"/>
            <ac:cxnSpMk id="230" creationId="{63D52C82-3BBE-448F-BF99-A81A7297EC6E}"/>
          </ac:cxnSpMkLst>
        </pc:cxnChg>
        <pc:cxnChg chg="mod">
          <ac:chgData name="Manasweeta Angane" userId="05da2731-9352-4b35-b713-60351f56afbd" providerId="ADAL" clId="{F5F97842-A295-4F9F-B89B-A63B35E1C32D}" dt="2022-10-10T09:34:40.899" v="3481"/>
          <ac:cxnSpMkLst>
            <pc:docMk/>
            <pc:sldMk cId="2506831184" sldId="296"/>
            <ac:cxnSpMk id="252" creationId="{10330CFA-050D-4EDD-9636-217A249C7BFC}"/>
          </ac:cxnSpMkLst>
        </pc:cxnChg>
        <pc:cxnChg chg="mod">
          <ac:chgData name="Manasweeta Angane" userId="05da2731-9352-4b35-b713-60351f56afbd" providerId="ADAL" clId="{F5F97842-A295-4F9F-B89B-A63B35E1C32D}" dt="2022-10-10T09:34:40.899" v="3481"/>
          <ac:cxnSpMkLst>
            <pc:docMk/>
            <pc:sldMk cId="2506831184" sldId="296"/>
            <ac:cxnSpMk id="266" creationId="{72EA1F4C-CAC1-49F2-B7A7-4B819DF24FA4}"/>
          </ac:cxnSpMkLst>
        </pc:cxnChg>
        <pc:cxnChg chg="mod">
          <ac:chgData name="Manasweeta Angane" userId="05da2731-9352-4b35-b713-60351f56afbd" providerId="ADAL" clId="{F5F97842-A295-4F9F-B89B-A63B35E1C32D}" dt="2022-10-10T09:34:40.899" v="3481"/>
          <ac:cxnSpMkLst>
            <pc:docMk/>
            <pc:sldMk cId="2506831184" sldId="296"/>
            <ac:cxnSpMk id="267" creationId="{8CF98E2E-63BE-4A0B-97C9-D4417776CF87}"/>
          </ac:cxnSpMkLst>
        </pc:cxnChg>
        <pc:cxnChg chg="mod">
          <ac:chgData name="Manasweeta Angane" userId="05da2731-9352-4b35-b713-60351f56afbd" providerId="ADAL" clId="{F5F97842-A295-4F9F-B89B-A63B35E1C32D}" dt="2022-10-10T09:34:40.899" v="3481"/>
          <ac:cxnSpMkLst>
            <pc:docMk/>
            <pc:sldMk cId="2506831184" sldId="296"/>
            <ac:cxnSpMk id="268" creationId="{AA858E0E-6698-4286-8152-9D597EA220EB}"/>
          </ac:cxnSpMkLst>
        </pc:cxnChg>
        <pc:cxnChg chg="mod">
          <ac:chgData name="Manasweeta Angane" userId="05da2731-9352-4b35-b713-60351f56afbd" providerId="ADAL" clId="{F5F97842-A295-4F9F-B89B-A63B35E1C32D}" dt="2022-10-10T09:34:40.899" v="3481"/>
          <ac:cxnSpMkLst>
            <pc:docMk/>
            <pc:sldMk cId="2506831184" sldId="296"/>
            <ac:cxnSpMk id="269" creationId="{547A3BBF-72A3-4814-9A0F-20444DDB0A6D}"/>
          </ac:cxnSpMkLst>
        </pc:cxnChg>
        <pc:cxnChg chg="mod">
          <ac:chgData name="Manasweeta Angane" userId="05da2731-9352-4b35-b713-60351f56afbd" providerId="ADAL" clId="{F5F97842-A295-4F9F-B89B-A63B35E1C32D}" dt="2022-10-10T09:34:40.899" v="3481"/>
          <ac:cxnSpMkLst>
            <pc:docMk/>
            <pc:sldMk cId="2506831184" sldId="296"/>
            <ac:cxnSpMk id="270" creationId="{CB16C7E7-4E46-4C24-AEAF-2E9FD4BBDA4C}"/>
          </ac:cxnSpMkLst>
        </pc:cxnChg>
        <pc:cxnChg chg="mod">
          <ac:chgData name="Manasweeta Angane" userId="05da2731-9352-4b35-b713-60351f56afbd" providerId="ADAL" clId="{F5F97842-A295-4F9F-B89B-A63B35E1C32D}" dt="2022-10-10T09:34:40.899" v="3481"/>
          <ac:cxnSpMkLst>
            <pc:docMk/>
            <pc:sldMk cId="2506831184" sldId="296"/>
            <ac:cxnSpMk id="271" creationId="{5B922852-BD50-4C67-B4C9-F9AB4C3C218C}"/>
          </ac:cxnSpMkLst>
        </pc:cxnChg>
        <pc:cxnChg chg="mod">
          <ac:chgData name="Manasweeta Angane" userId="05da2731-9352-4b35-b713-60351f56afbd" providerId="ADAL" clId="{F5F97842-A295-4F9F-B89B-A63B35E1C32D}" dt="2022-10-10T09:34:40.899" v="3481"/>
          <ac:cxnSpMkLst>
            <pc:docMk/>
            <pc:sldMk cId="2506831184" sldId="296"/>
            <ac:cxnSpMk id="272" creationId="{C43EBA24-61FA-43F2-B3C9-7C000A1C3005}"/>
          </ac:cxnSpMkLst>
        </pc:cxnChg>
        <pc:cxnChg chg="mod">
          <ac:chgData name="Manasweeta Angane" userId="05da2731-9352-4b35-b713-60351f56afbd" providerId="ADAL" clId="{F5F97842-A295-4F9F-B89B-A63B35E1C32D}" dt="2022-10-10T09:34:40.899" v="3481"/>
          <ac:cxnSpMkLst>
            <pc:docMk/>
            <pc:sldMk cId="2506831184" sldId="296"/>
            <ac:cxnSpMk id="273" creationId="{09D34771-886B-4982-B7DD-6624DA5C879B}"/>
          </ac:cxnSpMkLst>
        </pc:cxnChg>
        <pc:cxnChg chg="mod">
          <ac:chgData name="Manasweeta Angane" userId="05da2731-9352-4b35-b713-60351f56afbd" providerId="ADAL" clId="{F5F97842-A295-4F9F-B89B-A63B35E1C32D}" dt="2022-10-10T09:34:40.899" v="3481"/>
          <ac:cxnSpMkLst>
            <pc:docMk/>
            <pc:sldMk cId="2506831184" sldId="296"/>
            <ac:cxnSpMk id="274" creationId="{6DB21C86-3CDA-41F3-84C4-D07A82B0E8D2}"/>
          </ac:cxnSpMkLst>
        </pc:cxnChg>
        <pc:cxnChg chg="mod">
          <ac:chgData name="Manasweeta Angane" userId="05da2731-9352-4b35-b713-60351f56afbd" providerId="ADAL" clId="{F5F97842-A295-4F9F-B89B-A63B35E1C32D}" dt="2022-10-10T09:34:40.899" v="3481"/>
          <ac:cxnSpMkLst>
            <pc:docMk/>
            <pc:sldMk cId="2506831184" sldId="296"/>
            <ac:cxnSpMk id="275" creationId="{32F722DF-206F-443C-A3C8-983B0C9C33EC}"/>
          </ac:cxnSpMkLst>
        </pc:cxnChg>
        <pc:cxnChg chg="mod">
          <ac:chgData name="Manasweeta Angane" userId="05da2731-9352-4b35-b713-60351f56afbd" providerId="ADAL" clId="{F5F97842-A295-4F9F-B89B-A63B35E1C32D}" dt="2022-10-10T09:34:40.899" v="3481"/>
          <ac:cxnSpMkLst>
            <pc:docMk/>
            <pc:sldMk cId="2506831184" sldId="296"/>
            <ac:cxnSpMk id="276" creationId="{AEBFFBB3-D6AC-4D9D-9D5C-3DF70CC0447C}"/>
          </ac:cxnSpMkLst>
        </pc:cxnChg>
        <pc:cxnChg chg="mod">
          <ac:chgData name="Manasweeta Angane" userId="05da2731-9352-4b35-b713-60351f56afbd" providerId="ADAL" clId="{F5F97842-A295-4F9F-B89B-A63B35E1C32D}" dt="2022-10-10T09:34:40.899" v="3481"/>
          <ac:cxnSpMkLst>
            <pc:docMk/>
            <pc:sldMk cId="2506831184" sldId="296"/>
            <ac:cxnSpMk id="277" creationId="{3AAB1BA2-2ECD-40E1-88BC-1FC8DB921A4A}"/>
          </ac:cxnSpMkLst>
        </pc:cxnChg>
        <pc:cxnChg chg="mod">
          <ac:chgData name="Manasweeta Angane" userId="05da2731-9352-4b35-b713-60351f56afbd" providerId="ADAL" clId="{F5F97842-A295-4F9F-B89B-A63B35E1C32D}" dt="2022-10-10T09:36:55.837" v="3505"/>
          <ac:cxnSpMkLst>
            <pc:docMk/>
            <pc:sldMk cId="2506831184" sldId="296"/>
            <ac:cxnSpMk id="308" creationId="{5DD909FA-0B69-40B0-9BC4-FF7CE75174B5}"/>
          </ac:cxnSpMkLst>
        </pc:cxnChg>
        <pc:cxnChg chg="mod">
          <ac:chgData name="Manasweeta Angane" userId="05da2731-9352-4b35-b713-60351f56afbd" providerId="ADAL" clId="{F5F97842-A295-4F9F-B89B-A63B35E1C32D}" dt="2022-10-10T09:36:55.837" v="3505"/>
          <ac:cxnSpMkLst>
            <pc:docMk/>
            <pc:sldMk cId="2506831184" sldId="296"/>
            <ac:cxnSpMk id="322" creationId="{8716706A-8469-4CA9-BCC3-B8BBE3B983C2}"/>
          </ac:cxnSpMkLst>
        </pc:cxnChg>
        <pc:cxnChg chg="mod">
          <ac:chgData name="Manasweeta Angane" userId="05da2731-9352-4b35-b713-60351f56afbd" providerId="ADAL" clId="{F5F97842-A295-4F9F-B89B-A63B35E1C32D}" dt="2022-10-10T09:36:55.837" v="3505"/>
          <ac:cxnSpMkLst>
            <pc:docMk/>
            <pc:sldMk cId="2506831184" sldId="296"/>
            <ac:cxnSpMk id="323" creationId="{5B380E89-4536-44C7-9CEC-08476B1CE4E4}"/>
          </ac:cxnSpMkLst>
        </pc:cxnChg>
        <pc:cxnChg chg="mod">
          <ac:chgData name="Manasweeta Angane" userId="05da2731-9352-4b35-b713-60351f56afbd" providerId="ADAL" clId="{F5F97842-A295-4F9F-B89B-A63B35E1C32D}" dt="2022-10-10T09:36:55.837" v="3505"/>
          <ac:cxnSpMkLst>
            <pc:docMk/>
            <pc:sldMk cId="2506831184" sldId="296"/>
            <ac:cxnSpMk id="324" creationId="{9E7DE94B-9B5D-4A74-B33B-C9F5918F0934}"/>
          </ac:cxnSpMkLst>
        </pc:cxnChg>
        <pc:cxnChg chg="mod">
          <ac:chgData name="Manasweeta Angane" userId="05da2731-9352-4b35-b713-60351f56afbd" providerId="ADAL" clId="{F5F97842-A295-4F9F-B89B-A63B35E1C32D}" dt="2022-10-10T09:36:55.837" v="3505"/>
          <ac:cxnSpMkLst>
            <pc:docMk/>
            <pc:sldMk cId="2506831184" sldId="296"/>
            <ac:cxnSpMk id="325" creationId="{CBA3A063-8DB9-4F21-BE38-4CE3F0C80647}"/>
          </ac:cxnSpMkLst>
        </pc:cxnChg>
        <pc:cxnChg chg="mod">
          <ac:chgData name="Manasweeta Angane" userId="05da2731-9352-4b35-b713-60351f56afbd" providerId="ADAL" clId="{F5F97842-A295-4F9F-B89B-A63B35E1C32D}" dt="2022-10-10T09:36:55.837" v="3505"/>
          <ac:cxnSpMkLst>
            <pc:docMk/>
            <pc:sldMk cId="2506831184" sldId="296"/>
            <ac:cxnSpMk id="326" creationId="{8A84DA99-4C32-45ED-AEA8-3070AFA19D4A}"/>
          </ac:cxnSpMkLst>
        </pc:cxnChg>
        <pc:cxnChg chg="mod">
          <ac:chgData name="Manasweeta Angane" userId="05da2731-9352-4b35-b713-60351f56afbd" providerId="ADAL" clId="{F5F97842-A295-4F9F-B89B-A63B35E1C32D}" dt="2022-10-10T09:36:55.837" v="3505"/>
          <ac:cxnSpMkLst>
            <pc:docMk/>
            <pc:sldMk cId="2506831184" sldId="296"/>
            <ac:cxnSpMk id="327" creationId="{CAF459FE-E53A-4BEF-8EC6-7097F9446228}"/>
          </ac:cxnSpMkLst>
        </pc:cxnChg>
        <pc:cxnChg chg="mod">
          <ac:chgData name="Manasweeta Angane" userId="05da2731-9352-4b35-b713-60351f56afbd" providerId="ADAL" clId="{F5F97842-A295-4F9F-B89B-A63B35E1C32D}" dt="2022-10-10T09:36:55.837" v="3505"/>
          <ac:cxnSpMkLst>
            <pc:docMk/>
            <pc:sldMk cId="2506831184" sldId="296"/>
            <ac:cxnSpMk id="328" creationId="{7B9EE6F2-9E67-4ABB-8793-6D406F737011}"/>
          </ac:cxnSpMkLst>
        </pc:cxnChg>
        <pc:cxnChg chg="mod">
          <ac:chgData name="Manasweeta Angane" userId="05da2731-9352-4b35-b713-60351f56afbd" providerId="ADAL" clId="{F5F97842-A295-4F9F-B89B-A63B35E1C32D}" dt="2022-10-10T09:36:55.837" v="3505"/>
          <ac:cxnSpMkLst>
            <pc:docMk/>
            <pc:sldMk cId="2506831184" sldId="296"/>
            <ac:cxnSpMk id="329" creationId="{519155F3-FFDA-4636-8F05-30B4A6249711}"/>
          </ac:cxnSpMkLst>
        </pc:cxnChg>
        <pc:cxnChg chg="mod">
          <ac:chgData name="Manasweeta Angane" userId="05da2731-9352-4b35-b713-60351f56afbd" providerId="ADAL" clId="{F5F97842-A295-4F9F-B89B-A63B35E1C32D}" dt="2022-10-10T09:36:55.837" v="3505"/>
          <ac:cxnSpMkLst>
            <pc:docMk/>
            <pc:sldMk cId="2506831184" sldId="296"/>
            <ac:cxnSpMk id="330" creationId="{0E0E6D54-AB95-4F78-956C-607C0A711035}"/>
          </ac:cxnSpMkLst>
        </pc:cxnChg>
        <pc:cxnChg chg="mod">
          <ac:chgData name="Manasweeta Angane" userId="05da2731-9352-4b35-b713-60351f56afbd" providerId="ADAL" clId="{F5F97842-A295-4F9F-B89B-A63B35E1C32D}" dt="2022-10-10T09:36:55.837" v="3505"/>
          <ac:cxnSpMkLst>
            <pc:docMk/>
            <pc:sldMk cId="2506831184" sldId="296"/>
            <ac:cxnSpMk id="331" creationId="{D7F70C4B-EA77-4104-8C09-1D16D47EC087}"/>
          </ac:cxnSpMkLst>
        </pc:cxnChg>
        <pc:cxnChg chg="mod">
          <ac:chgData name="Manasweeta Angane" userId="05da2731-9352-4b35-b713-60351f56afbd" providerId="ADAL" clId="{F5F97842-A295-4F9F-B89B-A63B35E1C32D}" dt="2022-10-10T09:36:55.837" v="3505"/>
          <ac:cxnSpMkLst>
            <pc:docMk/>
            <pc:sldMk cId="2506831184" sldId="296"/>
            <ac:cxnSpMk id="332" creationId="{380B7287-FB04-4D8C-926D-5AA3B8664C52}"/>
          </ac:cxnSpMkLst>
        </pc:cxnChg>
        <pc:cxnChg chg="mod">
          <ac:chgData name="Manasweeta Angane" userId="05da2731-9352-4b35-b713-60351f56afbd" providerId="ADAL" clId="{F5F97842-A295-4F9F-B89B-A63B35E1C32D}" dt="2022-10-10T09:36:55.837" v="3505"/>
          <ac:cxnSpMkLst>
            <pc:docMk/>
            <pc:sldMk cId="2506831184" sldId="296"/>
            <ac:cxnSpMk id="333" creationId="{7EA449AC-65DE-4725-A181-0F3519FF3A4B}"/>
          </ac:cxnSpMkLst>
        </pc:cxnChg>
      </pc:sldChg>
      <pc:sldChg chg="addSp delSp modSp add mod modAnim">
        <pc:chgData name="Manasweeta Angane" userId="05da2731-9352-4b35-b713-60351f56afbd" providerId="ADAL" clId="{F5F97842-A295-4F9F-B89B-A63B35E1C32D}" dt="2022-10-23T00:22:01.706" v="20937"/>
        <pc:sldMkLst>
          <pc:docMk/>
          <pc:sldMk cId="3975102812" sldId="297"/>
        </pc:sldMkLst>
        <pc:spChg chg="mod">
          <ac:chgData name="Manasweeta Angane" userId="05da2731-9352-4b35-b713-60351f56afbd" providerId="ADAL" clId="{F5F97842-A295-4F9F-B89B-A63B35E1C32D}" dt="2022-10-10T09:42:16.466" v="3639" actId="1035"/>
          <ac:spMkLst>
            <pc:docMk/>
            <pc:sldMk cId="3975102812" sldId="297"/>
            <ac:spMk id="18" creationId="{45F2BEED-A6BE-45AE-BED7-62E52E5E5868}"/>
          </ac:spMkLst>
        </pc:spChg>
        <pc:spChg chg="add mod">
          <ac:chgData name="Manasweeta Angane" userId="05da2731-9352-4b35-b713-60351f56afbd" providerId="ADAL" clId="{F5F97842-A295-4F9F-B89B-A63B35E1C32D}" dt="2022-10-10T12:12:22.085" v="3905" actId="1035"/>
          <ac:spMkLst>
            <pc:docMk/>
            <pc:sldMk cId="3975102812" sldId="297"/>
            <ac:spMk id="67" creationId="{DDCAE617-DC97-41A4-937C-D39D2E39BE93}"/>
          </ac:spMkLst>
        </pc:spChg>
        <pc:spChg chg="mod topLvl">
          <ac:chgData name="Manasweeta Angane" userId="05da2731-9352-4b35-b713-60351f56afbd" providerId="ADAL" clId="{F5F97842-A295-4F9F-B89B-A63B35E1C32D}" dt="2022-10-10T09:40:59.853" v="3622" actId="165"/>
          <ac:spMkLst>
            <pc:docMk/>
            <pc:sldMk cId="3975102812" sldId="297"/>
            <ac:spMk id="294" creationId="{9E2890EC-DFE7-4A33-A687-504651A59441}"/>
          </ac:spMkLst>
        </pc:spChg>
        <pc:spChg chg="mod topLvl">
          <ac:chgData name="Manasweeta Angane" userId="05da2731-9352-4b35-b713-60351f56afbd" providerId="ADAL" clId="{F5F97842-A295-4F9F-B89B-A63B35E1C32D}" dt="2022-10-10T09:40:59.853" v="3622" actId="165"/>
          <ac:spMkLst>
            <pc:docMk/>
            <pc:sldMk cId="3975102812" sldId="297"/>
            <ac:spMk id="295" creationId="{1F34F933-C48F-426A-B321-45D197C3095E}"/>
          </ac:spMkLst>
        </pc:spChg>
        <pc:spChg chg="mod topLvl">
          <ac:chgData name="Manasweeta Angane" userId="05da2731-9352-4b35-b713-60351f56afbd" providerId="ADAL" clId="{F5F97842-A295-4F9F-B89B-A63B35E1C32D}" dt="2022-10-10T09:40:59.853" v="3622" actId="165"/>
          <ac:spMkLst>
            <pc:docMk/>
            <pc:sldMk cId="3975102812" sldId="297"/>
            <ac:spMk id="296" creationId="{88929EC0-A5C3-4D5B-A33C-668018EB93E5}"/>
          </ac:spMkLst>
        </pc:spChg>
        <pc:spChg chg="mod topLvl">
          <ac:chgData name="Manasweeta Angane" userId="05da2731-9352-4b35-b713-60351f56afbd" providerId="ADAL" clId="{F5F97842-A295-4F9F-B89B-A63B35E1C32D}" dt="2022-10-21T03:35:37.877" v="12083" actId="255"/>
          <ac:spMkLst>
            <pc:docMk/>
            <pc:sldMk cId="3975102812" sldId="297"/>
            <ac:spMk id="297" creationId="{04E256A1-C807-4A5E-BBA2-532000A5947A}"/>
          </ac:spMkLst>
        </pc:spChg>
        <pc:spChg chg="mod topLvl">
          <ac:chgData name="Manasweeta Angane" userId="05da2731-9352-4b35-b713-60351f56afbd" providerId="ADAL" clId="{F5F97842-A295-4F9F-B89B-A63B35E1C32D}" dt="2022-10-21T03:35:31.158" v="12082" actId="255"/>
          <ac:spMkLst>
            <pc:docMk/>
            <pc:sldMk cId="3975102812" sldId="297"/>
            <ac:spMk id="298" creationId="{F563BE34-C4BE-4FC5-A619-B1DF0946D507}"/>
          </ac:spMkLst>
        </pc:spChg>
        <pc:spChg chg="mod topLvl">
          <ac:chgData name="Manasweeta Angane" userId="05da2731-9352-4b35-b713-60351f56afbd" providerId="ADAL" clId="{F5F97842-A295-4F9F-B89B-A63B35E1C32D}" dt="2022-10-21T03:35:10.091" v="12079" actId="255"/>
          <ac:spMkLst>
            <pc:docMk/>
            <pc:sldMk cId="3975102812" sldId="297"/>
            <ac:spMk id="301" creationId="{1A8D56D9-42E0-42D2-A1DF-2396C69F7616}"/>
          </ac:spMkLst>
        </pc:spChg>
        <pc:spChg chg="mod topLvl">
          <ac:chgData name="Manasweeta Angane" userId="05da2731-9352-4b35-b713-60351f56afbd" providerId="ADAL" clId="{F5F97842-A295-4F9F-B89B-A63B35E1C32D}" dt="2022-10-10T09:40:59.853" v="3622" actId="165"/>
          <ac:spMkLst>
            <pc:docMk/>
            <pc:sldMk cId="3975102812" sldId="297"/>
            <ac:spMk id="304" creationId="{DE1D475D-F92E-4DC4-9CB7-565FC4747A52}"/>
          </ac:spMkLst>
        </pc:spChg>
        <pc:spChg chg="mod topLvl">
          <ac:chgData name="Manasweeta Angane" userId="05da2731-9352-4b35-b713-60351f56afbd" providerId="ADAL" clId="{F5F97842-A295-4F9F-B89B-A63B35E1C32D}" dt="2022-10-21T03:34:50.805" v="12077" actId="255"/>
          <ac:spMkLst>
            <pc:docMk/>
            <pc:sldMk cId="3975102812" sldId="297"/>
            <ac:spMk id="305" creationId="{F72C0D26-0570-47C6-92C5-1234AB2EF30A}"/>
          </ac:spMkLst>
        </pc:spChg>
        <pc:spChg chg="mod topLvl">
          <ac:chgData name="Manasweeta Angane" userId="05da2731-9352-4b35-b713-60351f56afbd" providerId="ADAL" clId="{F5F97842-A295-4F9F-B89B-A63B35E1C32D}" dt="2022-10-21T03:34:58.695" v="12078" actId="255"/>
          <ac:spMkLst>
            <pc:docMk/>
            <pc:sldMk cId="3975102812" sldId="297"/>
            <ac:spMk id="306" creationId="{F39E53D8-033B-4523-9A86-F90BF2A1579E}"/>
          </ac:spMkLst>
        </pc:spChg>
        <pc:spChg chg="mod topLvl">
          <ac:chgData name="Manasweeta Angane" userId="05da2731-9352-4b35-b713-60351f56afbd" providerId="ADAL" clId="{F5F97842-A295-4F9F-B89B-A63B35E1C32D}" dt="2022-10-21T03:35:16.918" v="12080" actId="255"/>
          <ac:spMkLst>
            <pc:docMk/>
            <pc:sldMk cId="3975102812" sldId="297"/>
            <ac:spMk id="309" creationId="{64D31CE2-752C-4B46-9E0B-F4742381D38E}"/>
          </ac:spMkLst>
        </pc:spChg>
        <pc:spChg chg="mod topLvl">
          <ac:chgData name="Manasweeta Angane" userId="05da2731-9352-4b35-b713-60351f56afbd" providerId="ADAL" clId="{F5F97842-A295-4F9F-B89B-A63B35E1C32D}" dt="2022-10-21T03:35:23.926" v="12081" actId="255"/>
          <ac:spMkLst>
            <pc:docMk/>
            <pc:sldMk cId="3975102812" sldId="297"/>
            <ac:spMk id="311" creationId="{56397CAF-D3E2-4BAB-97F7-44430EFA682B}"/>
          </ac:spMkLst>
        </pc:spChg>
        <pc:spChg chg="mod">
          <ac:chgData name="Manasweeta Angane" userId="05da2731-9352-4b35-b713-60351f56afbd" providerId="ADAL" clId="{F5F97842-A295-4F9F-B89B-A63B35E1C32D}" dt="2022-10-21T03:34:32.358" v="12075" actId="255"/>
          <ac:spMkLst>
            <pc:docMk/>
            <pc:sldMk cId="3975102812" sldId="297"/>
            <ac:spMk id="313" creationId="{FF0AD4F1-75AC-4688-9E4F-1F9A6E0F21FA}"/>
          </ac:spMkLst>
        </pc:spChg>
        <pc:spChg chg="mod">
          <ac:chgData name="Manasweeta Angane" userId="05da2731-9352-4b35-b713-60351f56afbd" providerId="ADAL" clId="{F5F97842-A295-4F9F-B89B-A63B35E1C32D}" dt="2022-10-21T03:34:42.449" v="12076" actId="255"/>
          <ac:spMkLst>
            <pc:docMk/>
            <pc:sldMk cId="3975102812" sldId="297"/>
            <ac:spMk id="317" creationId="{9CE01342-38C6-49A3-A7F6-D82600051026}"/>
          </ac:spMkLst>
        </pc:spChg>
        <pc:spChg chg="mod">
          <ac:chgData name="Manasweeta Angane" userId="05da2731-9352-4b35-b713-60351f56afbd" providerId="ADAL" clId="{F5F97842-A295-4F9F-B89B-A63B35E1C32D}" dt="2022-10-10T09:40:59.853" v="3622" actId="165"/>
          <ac:spMkLst>
            <pc:docMk/>
            <pc:sldMk cId="3975102812" sldId="297"/>
            <ac:spMk id="334" creationId="{4B16832D-E6EB-428B-A0C3-0655EFC6CC5B}"/>
          </ac:spMkLst>
        </pc:spChg>
        <pc:grpChg chg="add del mod">
          <ac:chgData name="Manasweeta Angane" userId="05da2731-9352-4b35-b713-60351f56afbd" providerId="ADAL" clId="{F5F97842-A295-4F9F-B89B-A63B35E1C32D}" dt="2022-10-10T09:40:59.853" v="3622" actId="165"/>
          <ac:grpSpMkLst>
            <pc:docMk/>
            <pc:sldMk cId="3975102812" sldId="297"/>
            <ac:grpSpMk id="2" creationId="{88E8E8D5-7714-4F8B-AD62-212F23BC551C}"/>
          </ac:grpSpMkLst>
        </pc:grpChg>
        <pc:grpChg chg="del">
          <ac:chgData name="Manasweeta Angane" userId="05da2731-9352-4b35-b713-60351f56afbd" providerId="ADAL" clId="{F5F97842-A295-4F9F-B89B-A63B35E1C32D}" dt="2022-10-10T09:38:07.915" v="3529" actId="165"/>
          <ac:grpSpMkLst>
            <pc:docMk/>
            <pc:sldMk cId="3975102812" sldId="297"/>
            <ac:grpSpMk id="290" creationId="{280A51DD-9425-4788-B9F3-48CC9C74C7DA}"/>
          </ac:grpSpMkLst>
        </pc:grpChg>
        <pc:grpChg chg="mod topLvl">
          <ac:chgData name="Manasweeta Angane" userId="05da2731-9352-4b35-b713-60351f56afbd" providerId="ADAL" clId="{F5F97842-A295-4F9F-B89B-A63B35E1C32D}" dt="2022-10-10T09:40:59.853" v="3622" actId="165"/>
          <ac:grpSpMkLst>
            <pc:docMk/>
            <pc:sldMk cId="3975102812" sldId="297"/>
            <ac:grpSpMk id="292" creationId="{09C4DA82-B513-4C9B-AB38-CBAE629A0956}"/>
          </ac:grpSpMkLst>
        </pc:grpChg>
        <pc:grpChg chg="mod topLvl">
          <ac:chgData name="Manasweeta Angane" userId="05da2731-9352-4b35-b713-60351f56afbd" providerId="ADAL" clId="{F5F97842-A295-4F9F-B89B-A63B35E1C32D}" dt="2022-10-10T09:40:59.853" v="3622" actId="165"/>
          <ac:grpSpMkLst>
            <pc:docMk/>
            <pc:sldMk cId="3975102812" sldId="297"/>
            <ac:grpSpMk id="293" creationId="{3C3F1CE4-68F3-44B7-B241-8E47F1AB9910}"/>
          </ac:grpSpMkLst>
        </pc:grpChg>
        <pc:grpChg chg="mod topLvl">
          <ac:chgData name="Manasweeta Angane" userId="05da2731-9352-4b35-b713-60351f56afbd" providerId="ADAL" clId="{F5F97842-A295-4F9F-B89B-A63B35E1C32D}" dt="2022-10-10T09:40:59.853" v="3622" actId="165"/>
          <ac:grpSpMkLst>
            <pc:docMk/>
            <pc:sldMk cId="3975102812" sldId="297"/>
            <ac:grpSpMk id="299" creationId="{02D9EA00-D001-4575-96D2-E0091B069001}"/>
          </ac:grpSpMkLst>
        </pc:grpChg>
        <pc:grpChg chg="mod topLvl">
          <ac:chgData name="Manasweeta Angane" userId="05da2731-9352-4b35-b713-60351f56afbd" providerId="ADAL" clId="{F5F97842-A295-4F9F-B89B-A63B35E1C32D}" dt="2022-10-10T09:40:59.853" v="3622" actId="165"/>
          <ac:grpSpMkLst>
            <pc:docMk/>
            <pc:sldMk cId="3975102812" sldId="297"/>
            <ac:grpSpMk id="302" creationId="{9DD7C0D2-DA01-4BC3-B93F-2650447433A1}"/>
          </ac:grpSpMkLst>
        </pc:grpChg>
        <pc:grpChg chg="mod topLvl">
          <ac:chgData name="Manasweeta Angane" userId="05da2731-9352-4b35-b713-60351f56afbd" providerId="ADAL" clId="{F5F97842-A295-4F9F-B89B-A63B35E1C32D}" dt="2022-10-10T09:40:59.853" v="3622" actId="165"/>
          <ac:grpSpMkLst>
            <pc:docMk/>
            <pc:sldMk cId="3975102812" sldId="297"/>
            <ac:grpSpMk id="303" creationId="{108EE755-B024-4169-AC48-064738E0BC47}"/>
          </ac:grpSpMkLst>
        </pc:grpChg>
        <pc:grpChg chg="mod">
          <ac:chgData name="Manasweeta Angane" userId="05da2731-9352-4b35-b713-60351f56afbd" providerId="ADAL" clId="{F5F97842-A295-4F9F-B89B-A63B35E1C32D}" dt="2022-10-10T09:40:59.853" v="3622" actId="165"/>
          <ac:grpSpMkLst>
            <pc:docMk/>
            <pc:sldMk cId="3975102812" sldId="297"/>
            <ac:grpSpMk id="312" creationId="{53F1DE56-AF54-4578-ABEE-464B9252419A}"/>
          </ac:grpSpMkLst>
        </pc:grpChg>
        <pc:grpChg chg="mod">
          <ac:chgData name="Manasweeta Angane" userId="05da2731-9352-4b35-b713-60351f56afbd" providerId="ADAL" clId="{F5F97842-A295-4F9F-B89B-A63B35E1C32D}" dt="2022-10-10T09:40:59.853" v="3622" actId="165"/>
          <ac:grpSpMkLst>
            <pc:docMk/>
            <pc:sldMk cId="3975102812" sldId="297"/>
            <ac:grpSpMk id="316" creationId="{B4278899-4747-4A95-8C75-B140C7529FEE}"/>
          </ac:grpSpMkLst>
        </pc:grpChg>
        <pc:picChg chg="mod topLvl">
          <ac:chgData name="Manasweeta Angane" userId="05da2731-9352-4b35-b713-60351f56afbd" providerId="ADAL" clId="{F5F97842-A295-4F9F-B89B-A63B35E1C32D}" dt="2022-10-10T10:03:06.421" v="3661" actId="1038"/>
          <ac:picMkLst>
            <pc:docMk/>
            <pc:sldMk cId="3975102812" sldId="297"/>
            <ac:picMk id="291" creationId="{787F1EDF-26F2-460F-B049-4D2C5933F431}"/>
          </ac:picMkLst>
        </pc:picChg>
        <pc:picChg chg="mod topLvl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07" creationId="{1C427A80-AC03-4637-A0F0-6AD1899EE633}"/>
          </ac:picMkLst>
        </pc:picChg>
        <pc:picChg chg="mod topLvl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10" creationId="{2080A72C-2591-4F1C-96DB-3F930AE35D02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14" creationId="{AF9C4CE7-A22A-4EDA-BF98-0EAB0E15D53A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15" creationId="{C2588346-D48C-4F69-A09A-28F223648E5D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18" creationId="{8B491C27-C940-4338-ADF0-79F642B1F544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19" creationId="{5D5DAB43-D57E-448A-855D-A5E8DDB130C5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20" creationId="{1608BE8E-4032-4370-8D92-39522B9A0891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21" creationId="{FCC0A85F-AA83-4099-8260-D6A37E951D9C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35" creationId="{42158EB5-E39B-4CA1-BF5A-37E14B8A08FD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36" creationId="{AF9449CB-6B3E-4119-9571-A13BBC738B73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37" creationId="{37F3DED1-E6B8-4497-BD88-4B03EE4D04E6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38" creationId="{C1C64546-BAEC-47C6-840D-33AB837F16F8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39" creationId="{D1D74B07-C081-40F4-8F92-30AC26A60E6B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40" creationId="{D037420B-B47C-4242-8BAD-F085E00BECAC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41" creationId="{2DE3519B-63AE-4C4D-A0F3-5A39E1E19AF2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42" creationId="{0A7D3E44-B862-4C05-B6AA-065EB88BE872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43" creationId="{F84D1B23-8C41-47D8-BC9B-6220CE8B2CE1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44" creationId="{8631FC73-4868-425E-A24B-BF6EF81EFA15}"/>
          </ac:picMkLst>
        </pc:picChg>
        <pc:picChg chg="mod">
          <ac:chgData name="Manasweeta Angane" userId="05da2731-9352-4b35-b713-60351f56afbd" providerId="ADAL" clId="{F5F97842-A295-4F9F-B89B-A63B35E1C32D}" dt="2022-10-10T09:40:59.853" v="3622" actId="165"/>
          <ac:picMkLst>
            <pc:docMk/>
            <pc:sldMk cId="3975102812" sldId="297"/>
            <ac:picMk id="345" creationId="{B814A226-E735-424B-8DF2-422E2F91CFBE}"/>
          </ac:picMkLst>
        </pc:picChg>
        <pc:inkChg chg="mod topLvl">
          <ac:chgData name="Manasweeta Angane" userId="05da2731-9352-4b35-b713-60351f56afbd" providerId="ADAL" clId="{F5F97842-A295-4F9F-B89B-A63B35E1C32D}" dt="2022-10-10T09:40:59.853" v="3622" actId="165"/>
          <ac:inkMkLst>
            <pc:docMk/>
            <pc:sldMk cId="3975102812" sldId="297"/>
            <ac:inkMk id="300" creationId="{20EBC11E-D1F8-4404-8C5C-8EB3AFEE4FF5}"/>
          </ac:inkMkLst>
        </pc:inkChg>
        <pc:cxnChg chg="mod topLvl">
          <ac:chgData name="Manasweeta Angane" userId="05da2731-9352-4b35-b713-60351f56afbd" providerId="ADAL" clId="{F5F97842-A295-4F9F-B89B-A63B35E1C32D}" dt="2022-10-10T09:40:59.853" v="3622" actId="165"/>
          <ac:cxnSpMkLst>
            <pc:docMk/>
            <pc:sldMk cId="3975102812" sldId="297"/>
            <ac:cxnSpMk id="308" creationId="{5DD909FA-0B69-40B0-9BC4-FF7CE75174B5}"/>
          </ac:cxnSpMkLst>
        </pc:cxnChg>
        <pc:cxnChg chg="mod">
          <ac:chgData name="Manasweeta Angane" userId="05da2731-9352-4b35-b713-60351f56afbd" providerId="ADAL" clId="{F5F97842-A295-4F9F-B89B-A63B35E1C32D}" dt="2022-10-10T09:40:59.853" v="3622" actId="165"/>
          <ac:cxnSpMkLst>
            <pc:docMk/>
            <pc:sldMk cId="3975102812" sldId="297"/>
            <ac:cxnSpMk id="322" creationId="{8716706A-8469-4CA9-BCC3-B8BBE3B983C2}"/>
          </ac:cxnSpMkLst>
        </pc:cxnChg>
        <pc:cxnChg chg="mod">
          <ac:chgData name="Manasweeta Angane" userId="05da2731-9352-4b35-b713-60351f56afbd" providerId="ADAL" clId="{F5F97842-A295-4F9F-B89B-A63B35E1C32D}" dt="2022-10-10T09:40:59.853" v="3622" actId="165"/>
          <ac:cxnSpMkLst>
            <pc:docMk/>
            <pc:sldMk cId="3975102812" sldId="297"/>
            <ac:cxnSpMk id="323" creationId="{5B380E89-4536-44C7-9CEC-08476B1CE4E4}"/>
          </ac:cxnSpMkLst>
        </pc:cxnChg>
        <pc:cxnChg chg="mod">
          <ac:chgData name="Manasweeta Angane" userId="05da2731-9352-4b35-b713-60351f56afbd" providerId="ADAL" clId="{F5F97842-A295-4F9F-B89B-A63B35E1C32D}" dt="2022-10-10T09:40:59.853" v="3622" actId="165"/>
          <ac:cxnSpMkLst>
            <pc:docMk/>
            <pc:sldMk cId="3975102812" sldId="297"/>
            <ac:cxnSpMk id="324" creationId="{9E7DE94B-9B5D-4A74-B33B-C9F5918F0934}"/>
          </ac:cxnSpMkLst>
        </pc:cxnChg>
        <pc:cxnChg chg="mod">
          <ac:chgData name="Manasweeta Angane" userId="05da2731-9352-4b35-b713-60351f56afbd" providerId="ADAL" clId="{F5F97842-A295-4F9F-B89B-A63B35E1C32D}" dt="2022-10-10T09:40:59.853" v="3622" actId="165"/>
          <ac:cxnSpMkLst>
            <pc:docMk/>
            <pc:sldMk cId="3975102812" sldId="297"/>
            <ac:cxnSpMk id="325" creationId="{CBA3A063-8DB9-4F21-BE38-4CE3F0C80647}"/>
          </ac:cxnSpMkLst>
        </pc:cxnChg>
        <pc:cxnChg chg="mod">
          <ac:chgData name="Manasweeta Angane" userId="05da2731-9352-4b35-b713-60351f56afbd" providerId="ADAL" clId="{F5F97842-A295-4F9F-B89B-A63B35E1C32D}" dt="2022-10-10T09:40:59.853" v="3622" actId="165"/>
          <ac:cxnSpMkLst>
            <pc:docMk/>
            <pc:sldMk cId="3975102812" sldId="297"/>
            <ac:cxnSpMk id="326" creationId="{8A84DA99-4C32-45ED-AEA8-3070AFA19D4A}"/>
          </ac:cxnSpMkLst>
        </pc:cxnChg>
        <pc:cxnChg chg="mod">
          <ac:chgData name="Manasweeta Angane" userId="05da2731-9352-4b35-b713-60351f56afbd" providerId="ADAL" clId="{F5F97842-A295-4F9F-B89B-A63B35E1C32D}" dt="2022-10-10T09:40:59.853" v="3622" actId="165"/>
          <ac:cxnSpMkLst>
            <pc:docMk/>
            <pc:sldMk cId="3975102812" sldId="297"/>
            <ac:cxnSpMk id="327" creationId="{CAF459FE-E53A-4BEF-8EC6-7097F9446228}"/>
          </ac:cxnSpMkLst>
        </pc:cxnChg>
        <pc:cxnChg chg="mod">
          <ac:chgData name="Manasweeta Angane" userId="05da2731-9352-4b35-b713-60351f56afbd" providerId="ADAL" clId="{F5F97842-A295-4F9F-B89B-A63B35E1C32D}" dt="2022-10-10T09:40:59.853" v="3622" actId="165"/>
          <ac:cxnSpMkLst>
            <pc:docMk/>
            <pc:sldMk cId="3975102812" sldId="297"/>
            <ac:cxnSpMk id="328" creationId="{7B9EE6F2-9E67-4ABB-8793-6D406F737011}"/>
          </ac:cxnSpMkLst>
        </pc:cxnChg>
        <pc:cxnChg chg="mod">
          <ac:chgData name="Manasweeta Angane" userId="05da2731-9352-4b35-b713-60351f56afbd" providerId="ADAL" clId="{F5F97842-A295-4F9F-B89B-A63B35E1C32D}" dt="2022-10-10T09:40:59.853" v="3622" actId="165"/>
          <ac:cxnSpMkLst>
            <pc:docMk/>
            <pc:sldMk cId="3975102812" sldId="297"/>
            <ac:cxnSpMk id="329" creationId="{519155F3-FFDA-4636-8F05-30B4A6249711}"/>
          </ac:cxnSpMkLst>
        </pc:cxnChg>
        <pc:cxnChg chg="mod">
          <ac:chgData name="Manasweeta Angane" userId="05da2731-9352-4b35-b713-60351f56afbd" providerId="ADAL" clId="{F5F97842-A295-4F9F-B89B-A63B35E1C32D}" dt="2022-10-10T09:40:59.853" v="3622" actId="165"/>
          <ac:cxnSpMkLst>
            <pc:docMk/>
            <pc:sldMk cId="3975102812" sldId="297"/>
            <ac:cxnSpMk id="330" creationId="{0E0E6D54-AB95-4F78-956C-607C0A711035}"/>
          </ac:cxnSpMkLst>
        </pc:cxnChg>
        <pc:cxnChg chg="mod">
          <ac:chgData name="Manasweeta Angane" userId="05da2731-9352-4b35-b713-60351f56afbd" providerId="ADAL" clId="{F5F97842-A295-4F9F-B89B-A63B35E1C32D}" dt="2022-10-10T09:40:59.853" v="3622" actId="165"/>
          <ac:cxnSpMkLst>
            <pc:docMk/>
            <pc:sldMk cId="3975102812" sldId="297"/>
            <ac:cxnSpMk id="331" creationId="{D7F70C4B-EA77-4104-8C09-1D16D47EC087}"/>
          </ac:cxnSpMkLst>
        </pc:cxnChg>
        <pc:cxnChg chg="mod">
          <ac:chgData name="Manasweeta Angane" userId="05da2731-9352-4b35-b713-60351f56afbd" providerId="ADAL" clId="{F5F97842-A295-4F9F-B89B-A63B35E1C32D}" dt="2022-10-10T09:40:59.853" v="3622" actId="165"/>
          <ac:cxnSpMkLst>
            <pc:docMk/>
            <pc:sldMk cId="3975102812" sldId="297"/>
            <ac:cxnSpMk id="332" creationId="{380B7287-FB04-4D8C-926D-5AA3B8664C52}"/>
          </ac:cxnSpMkLst>
        </pc:cxnChg>
        <pc:cxnChg chg="mod">
          <ac:chgData name="Manasweeta Angane" userId="05da2731-9352-4b35-b713-60351f56afbd" providerId="ADAL" clId="{F5F97842-A295-4F9F-B89B-A63B35E1C32D}" dt="2022-10-10T09:40:59.853" v="3622" actId="165"/>
          <ac:cxnSpMkLst>
            <pc:docMk/>
            <pc:sldMk cId="3975102812" sldId="297"/>
            <ac:cxnSpMk id="333" creationId="{7EA449AC-65DE-4725-A181-0F3519FF3A4B}"/>
          </ac:cxnSpMkLst>
        </pc:cxnChg>
      </pc:sldChg>
      <pc:sldChg chg="addSp delSp modSp add mod modAnim">
        <pc:chgData name="Manasweeta Angane" userId="05da2731-9352-4b35-b713-60351f56afbd" providerId="ADAL" clId="{F5F97842-A295-4F9F-B89B-A63B35E1C32D}" dt="2022-10-20T20:10:20.113" v="11628"/>
        <pc:sldMkLst>
          <pc:docMk/>
          <pc:sldMk cId="3738010429" sldId="298"/>
        </pc:sldMkLst>
        <pc:spChg chg="add mod">
          <ac:chgData name="Manasweeta Angane" userId="05da2731-9352-4b35-b713-60351f56afbd" providerId="ADAL" clId="{F5F97842-A295-4F9F-B89B-A63B35E1C32D}" dt="2022-10-19T07:22:47.549" v="10908" actId="1076"/>
          <ac:spMkLst>
            <pc:docMk/>
            <pc:sldMk cId="3738010429" sldId="298"/>
            <ac:spMk id="14" creationId="{919454DB-2760-45BB-B0C3-070D3C763BCB}"/>
          </ac:spMkLst>
        </pc:spChg>
        <pc:spChg chg="add mod">
          <ac:chgData name="Manasweeta Angane" userId="05da2731-9352-4b35-b713-60351f56afbd" providerId="ADAL" clId="{F5F97842-A295-4F9F-B89B-A63B35E1C32D}" dt="2022-10-19T07:23:27.893" v="10933" actId="1076"/>
          <ac:spMkLst>
            <pc:docMk/>
            <pc:sldMk cId="3738010429" sldId="298"/>
            <ac:spMk id="15" creationId="{76FEE19C-2603-4082-B96F-FF50205C7D59}"/>
          </ac:spMkLst>
        </pc:spChg>
        <pc:spChg chg="add mod">
          <ac:chgData name="Manasweeta Angane" userId="05da2731-9352-4b35-b713-60351f56afbd" providerId="ADAL" clId="{F5F97842-A295-4F9F-B89B-A63B35E1C32D}" dt="2022-10-19T08:44:33.012" v="11473" actId="2710"/>
          <ac:spMkLst>
            <pc:docMk/>
            <pc:sldMk cId="3738010429" sldId="298"/>
            <ac:spMk id="16" creationId="{E2D7AC56-61BF-45AF-B8DD-039B767A1193}"/>
          </ac:spMkLst>
        </pc:spChg>
        <pc:spChg chg="del mod">
          <ac:chgData name="Manasweeta Angane" userId="05da2731-9352-4b35-b713-60351f56afbd" providerId="ADAL" clId="{F5F97842-A295-4F9F-B89B-A63B35E1C32D}" dt="2022-10-11T09:59:07.264" v="6139" actId="478"/>
          <ac:spMkLst>
            <pc:docMk/>
            <pc:sldMk cId="3738010429" sldId="298"/>
            <ac:spMk id="17" creationId="{8DB771DF-C627-44BB-8716-44C80EF9D83F}"/>
          </ac:spMkLst>
        </pc:spChg>
        <pc:spChg chg="mod">
          <ac:chgData name="Manasweeta Angane" userId="05da2731-9352-4b35-b713-60351f56afbd" providerId="ADAL" clId="{F5F97842-A295-4F9F-B89B-A63B35E1C32D}" dt="2022-10-11T11:59:49.607" v="6446" actId="1036"/>
          <ac:spMkLst>
            <pc:docMk/>
            <pc:sldMk cId="3738010429" sldId="298"/>
            <ac:spMk id="18" creationId="{45F2BEED-A6BE-45AE-BED7-62E52E5E5868}"/>
          </ac:spMkLst>
        </pc:spChg>
        <pc:picChg chg="mod">
          <ac:chgData name="Manasweeta Angane" userId="05da2731-9352-4b35-b713-60351f56afbd" providerId="ADAL" clId="{F5F97842-A295-4F9F-B89B-A63B35E1C32D}" dt="2022-10-19T07:15:30.574" v="10768" actId="1037"/>
          <ac:picMkLst>
            <pc:docMk/>
            <pc:sldMk cId="3738010429" sldId="298"/>
            <ac:picMk id="2" creationId="{2A95060D-B5FD-4EF2-B4C7-75300E298BD9}"/>
          </ac:picMkLst>
        </pc:picChg>
        <pc:picChg chg="del">
          <ac:chgData name="Manasweeta Angane" userId="05da2731-9352-4b35-b713-60351f56afbd" providerId="ADAL" clId="{F5F97842-A295-4F9F-B89B-A63B35E1C32D}" dt="2022-10-11T09:57:59.029" v="6135" actId="478"/>
          <ac:picMkLst>
            <pc:docMk/>
            <pc:sldMk cId="3738010429" sldId="298"/>
            <ac:picMk id="2" creationId="{844E427A-4793-49FE-A23B-5715FE1D486A}"/>
          </ac:picMkLst>
        </pc:picChg>
        <pc:picChg chg="mod">
          <ac:chgData name="Manasweeta Angane" userId="05da2731-9352-4b35-b713-60351f56afbd" providerId="ADAL" clId="{F5F97842-A295-4F9F-B89B-A63B35E1C32D}" dt="2022-10-19T07:20:19.986" v="10864" actId="1038"/>
          <ac:picMkLst>
            <pc:docMk/>
            <pc:sldMk cId="3738010429" sldId="298"/>
            <ac:picMk id="3" creationId="{152A1DB3-79C2-45CF-8F89-C4DC4E51D69E}"/>
          </ac:picMkLst>
        </pc:picChg>
        <pc:picChg chg="del">
          <ac:chgData name="Manasweeta Angane" userId="05da2731-9352-4b35-b713-60351f56afbd" providerId="ADAL" clId="{F5F97842-A295-4F9F-B89B-A63B35E1C32D}" dt="2022-10-11T09:58:36.483" v="6136" actId="478"/>
          <ac:picMkLst>
            <pc:docMk/>
            <pc:sldMk cId="3738010429" sldId="298"/>
            <ac:picMk id="3" creationId="{6790B46D-21A7-406D-87F3-57A007681B56}"/>
          </ac:picMkLst>
        </pc:picChg>
        <pc:picChg chg="del mod">
          <ac:chgData name="Manasweeta Angane" userId="05da2731-9352-4b35-b713-60351f56afbd" providerId="ADAL" clId="{F5F97842-A295-4F9F-B89B-A63B35E1C32D}" dt="2022-10-19T07:20:07.972" v="10833" actId="478"/>
          <ac:picMkLst>
            <pc:docMk/>
            <pc:sldMk cId="3738010429" sldId="298"/>
            <ac:picMk id="11" creationId="{0B0E2E51-4D19-4619-B44A-796241AE2C04}"/>
          </ac:picMkLst>
        </pc:picChg>
        <pc:picChg chg="del mod">
          <ac:chgData name="Manasweeta Angane" userId="05da2731-9352-4b35-b713-60351f56afbd" providerId="ADAL" clId="{F5F97842-A295-4F9F-B89B-A63B35E1C32D}" dt="2022-10-19T07:15:19.799" v="10709" actId="478"/>
          <ac:picMkLst>
            <pc:docMk/>
            <pc:sldMk cId="3738010429" sldId="298"/>
            <ac:picMk id="12" creationId="{54987B74-6546-4FDF-9345-5F0846E6FA7F}"/>
          </ac:picMkLst>
        </pc:picChg>
      </pc:sldChg>
      <pc:sldChg chg="addSp delSp modSp add mod modAnim">
        <pc:chgData name="Manasweeta Angane" userId="05da2731-9352-4b35-b713-60351f56afbd" providerId="ADAL" clId="{F5F97842-A295-4F9F-B89B-A63B35E1C32D}" dt="2022-10-20T20:10:26.375" v="11629"/>
        <pc:sldMkLst>
          <pc:docMk/>
          <pc:sldMk cId="2478878667" sldId="299"/>
        </pc:sldMkLst>
        <pc:spChg chg="add mod">
          <ac:chgData name="Manasweeta Angane" userId="05da2731-9352-4b35-b713-60351f56afbd" providerId="ADAL" clId="{F5F97842-A295-4F9F-B89B-A63B35E1C32D}" dt="2022-10-19T07:58:50.505" v="11106"/>
          <ac:spMkLst>
            <pc:docMk/>
            <pc:sldMk cId="2478878667" sldId="299"/>
            <ac:spMk id="13" creationId="{CF8E3641-3CD8-4C16-8865-1B68B1E48B8B}"/>
          </ac:spMkLst>
        </pc:spChg>
        <pc:spChg chg="add mod">
          <ac:chgData name="Manasweeta Angane" userId="05da2731-9352-4b35-b713-60351f56afbd" providerId="ADAL" clId="{F5F97842-A295-4F9F-B89B-A63B35E1C32D}" dt="2022-10-19T07:58:59.112" v="11107"/>
          <ac:spMkLst>
            <pc:docMk/>
            <pc:sldMk cId="2478878667" sldId="299"/>
            <ac:spMk id="14" creationId="{B337D65C-21A5-46B3-A447-50488654C8B8}"/>
          </ac:spMkLst>
        </pc:spChg>
        <pc:spChg chg="add mod">
          <ac:chgData name="Manasweeta Angane" userId="05da2731-9352-4b35-b713-60351f56afbd" providerId="ADAL" clId="{F5F97842-A295-4F9F-B89B-A63B35E1C32D}" dt="2022-10-19T08:44:46.325" v="11474"/>
          <ac:spMkLst>
            <pc:docMk/>
            <pc:sldMk cId="2478878667" sldId="299"/>
            <ac:spMk id="15" creationId="{CAD50CC3-6393-4521-B1DD-08C1EF0F89C7}"/>
          </ac:spMkLst>
        </pc:spChg>
        <pc:spChg chg="del">
          <ac:chgData name="Manasweeta Angane" userId="05da2731-9352-4b35-b713-60351f56afbd" providerId="ADAL" clId="{F5F97842-A295-4F9F-B89B-A63B35E1C32D}" dt="2022-10-11T11:15:41.013" v="6257" actId="478"/>
          <ac:spMkLst>
            <pc:docMk/>
            <pc:sldMk cId="2478878667" sldId="299"/>
            <ac:spMk id="17" creationId="{8DB771DF-C627-44BB-8716-44C80EF9D83F}"/>
          </ac:spMkLst>
        </pc:spChg>
        <pc:spChg chg="mod">
          <ac:chgData name="Manasweeta Angane" userId="05da2731-9352-4b35-b713-60351f56afbd" providerId="ADAL" clId="{F5F97842-A295-4F9F-B89B-A63B35E1C32D}" dt="2022-10-11T11:59:59.708" v="6454" actId="1035"/>
          <ac:spMkLst>
            <pc:docMk/>
            <pc:sldMk cId="2478878667" sldId="299"/>
            <ac:spMk id="18" creationId="{45F2BEED-A6BE-45AE-BED7-62E52E5E5868}"/>
          </ac:spMkLst>
        </pc:spChg>
        <pc:picChg chg="mod">
          <ac:chgData name="Manasweeta Angane" userId="05da2731-9352-4b35-b713-60351f56afbd" providerId="ADAL" clId="{F5F97842-A295-4F9F-B89B-A63B35E1C32D}" dt="2022-10-19T07:58:37.732" v="11105" actId="1037"/>
          <ac:picMkLst>
            <pc:docMk/>
            <pc:sldMk cId="2478878667" sldId="299"/>
            <ac:picMk id="2" creationId="{41AD79F6-87F4-45AA-AEF1-B4DFFEB21F05}"/>
          </ac:picMkLst>
        </pc:picChg>
        <pc:picChg chg="del mod">
          <ac:chgData name="Manasweeta Angane" userId="05da2731-9352-4b35-b713-60351f56afbd" providerId="ADAL" clId="{F5F97842-A295-4F9F-B89B-A63B35E1C32D}" dt="2022-10-19T07:30:52.531" v="10936" actId="478"/>
          <ac:picMkLst>
            <pc:docMk/>
            <pc:sldMk cId="2478878667" sldId="299"/>
            <ac:picMk id="2" creationId="{9F123612-6A4C-49FF-9BD2-2FC42F1438D1}"/>
          </ac:picMkLst>
        </pc:picChg>
        <pc:picChg chg="del mod">
          <ac:chgData name="Manasweeta Angane" userId="05da2731-9352-4b35-b713-60351f56afbd" providerId="ADAL" clId="{F5F97842-A295-4F9F-B89B-A63B35E1C32D}" dt="2022-10-19T07:58:27.317" v="11072" actId="478"/>
          <ac:picMkLst>
            <pc:docMk/>
            <pc:sldMk cId="2478878667" sldId="299"/>
            <ac:picMk id="3" creationId="{DCA4FFE0-3730-4788-B193-4670B8FB13F0}"/>
          </ac:picMkLst>
        </pc:picChg>
        <pc:picChg chg="mod">
          <ac:chgData name="Manasweeta Angane" userId="05da2731-9352-4b35-b713-60351f56afbd" providerId="ADAL" clId="{F5F97842-A295-4F9F-B89B-A63B35E1C32D}" dt="2022-10-19T07:31:06.242" v="11021" actId="1038"/>
          <ac:picMkLst>
            <pc:docMk/>
            <pc:sldMk cId="2478878667" sldId="299"/>
            <ac:picMk id="11" creationId="{954D21B5-EA61-42FC-B3FD-A6CCBA12A851}"/>
          </ac:picMkLst>
        </pc:picChg>
      </pc:sldChg>
      <pc:sldChg chg="addSp delSp modSp add mod modAnim">
        <pc:chgData name="Manasweeta Angane" userId="05da2731-9352-4b35-b713-60351f56afbd" providerId="ADAL" clId="{F5F97842-A295-4F9F-B89B-A63B35E1C32D}" dt="2022-10-20T20:10:34.348" v="11630"/>
        <pc:sldMkLst>
          <pc:docMk/>
          <pc:sldMk cId="3664014045" sldId="300"/>
        </pc:sldMkLst>
        <pc:spChg chg="add mod">
          <ac:chgData name="Manasweeta Angane" userId="05da2731-9352-4b35-b713-60351f56afbd" providerId="ADAL" clId="{F5F97842-A295-4F9F-B89B-A63B35E1C32D}" dt="2022-10-19T08:40:57.526" v="11352"/>
          <ac:spMkLst>
            <pc:docMk/>
            <pc:sldMk cId="3664014045" sldId="300"/>
            <ac:spMk id="15" creationId="{A79FA22E-F737-4FE4-9D81-6B9BEC97B3AB}"/>
          </ac:spMkLst>
        </pc:spChg>
        <pc:spChg chg="add mod">
          <ac:chgData name="Manasweeta Angane" userId="05da2731-9352-4b35-b713-60351f56afbd" providerId="ADAL" clId="{F5F97842-A295-4F9F-B89B-A63B35E1C32D}" dt="2022-10-19T08:41:07.751" v="11353"/>
          <ac:spMkLst>
            <pc:docMk/>
            <pc:sldMk cId="3664014045" sldId="300"/>
            <ac:spMk id="16" creationId="{86C89A6E-3A0B-4983-9D34-2F40C75BE8E9}"/>
          </ac:spMkLst>
        </pc:spChg>
        <pc:spChg chg="add mod">
          <ac:chgData name="Manasweeta Angane" userId="05da2731-9352-4b35-b713-60351f56afbd" providerId="ADAL" clId="{F5F97842-A295-4F9F-B89B-A63B35E1C32D}" dt="2022-10-19T08:44:49.621" v="11475"/>
          <ac:spMkLst>
            <pc:docMk/>
            <pc:sldMk cId="3664014045" sldId="300"/>
            <ac:spMk id="17" creationId="{65B68917-3A64-41C6-963A-4B4407BA35CC}"/>
          </ac:spMkLst>
        </pc:spChg>
        <pc:spChg chg="del">
          <ac:chgData name="Manasweeta Angane" userId="05da2731-9352-4b35-b713-60351f56afbd" providerId="ADAL" clId="{F5F97842-A295-4F9F-B89B-A63B35E1C32D}" dt="2022-10-11T12:05:39.503" v="6455" actId="478"/>
          <ac:spMkLst>
            <pc:docMk/>
            <pc:sldMk cId="3664014045" sldId="300"/>
            <ac:spMk id="17" creationId="{8DB771DF-C627-44BB-8716-44C80EF9D83F}"/>
          </ac:spMkLst>
        </pc:spChg>
        <pc:spChg chg="mod">
          <ac:chgData name="Manasweeta Angane" userId="05da2731-9352-4b35-b713-60351f56afbd" providerId="ADAL" clId="{F5F97842-A295-4F9F-B89B-A63B35E1C32D}" dt="2022-10-11T12:23:30.477" v="6519" actId="1035"/>
          <ac:spMkLst>
            <pc:docMk/>
            <pc:sldMk cId="3664014045" sldId="300"/>
            <ac:spMk id="18" creationId="{45F2BEED-A6BE-45AE-BED7-62E52E5E5868}"/>
          </ac:spMkLst>
        </pc:spChg>
        <pc:picChg chg="del mod">
          <ac:chgData name="Manasweeta Angane" userId="05da2731-9352-4b35-b713-60351f56afbd" providerId="ADAL" clId="{F5F97842-A295-4F9F-B89B-A63B35E1C32D}" dt="2022-10-11T12:21:52.125" v="6473" actId="478"/>
          <ac:picMkLst>
            <pc:docMk/>
            <pc:sldMk cId="3664014045" sldId="300"/>
            <ac:picMk id="2" creationId="{10E49921-B94E-4EAB-9015-10A8D4B65CEE}"/>
          </ac:picMkLst>
        </pc:picChg>
        <pc:picChg chg="del mod">
          <ac:chgData name="Manasweeta Angane" userId="05da2731-9352-4b35-b713-60351f56afbd" providerId="ADAL" clId="{F5F97842-A295-4F9F-B89B-A63B35E1C32D}" dt="2022-10-19T08:37:18.098" v="11338" actId="478"/>
          <ac:picMkLst>
            <pc:docMk/>
            <pc:sldMk cId="3664014045" sldId="300"/>
            <ac:picMk id="2" creationId="{85F9694F-1DBF-4C18-A735-DF2008363809}"/>
          </ac:picMkLst>
        </pc:picChg>
        <pc:picChg chg="del mod">
          <ac:chgData name="Manasweeta Angane" userId="05da2731-9352-4b35-b713-60351f56afbd" providerId="ADAL" clId="{F5F97842-A295-4F9F-B89B-A63B35E1C32D}" dt="2022-10-19T08:40:06.706" v="11348" actId="478"/>
          <ac:picMkLst>
            <pc:docMk/>
            <pc:sldMk cId="3664014045" sldId="300"/>
            <ac:picMk id="3" creationId="{F31E2A64-69D3-4D7E-8448-48C105D64B28}"/>
          </ac:picMkLst>
        </pc:picChg>
        <pc:picChg chg="del mod">
          <ac:chgData name="Manasweeta Angane" userId="05da2731-9352-4b35-b713-60351f56afbd" providerId="ADAL" clId="{F5F97842-A295-4F9F-B89B-A63B35E1C32D}" dt="2022-10-19T08:38:17.570" v="11342" actId="478"/>
          <ac:picMkLst>
            <pc:docMk/>
            <pc:sldMk cId="3664014045" sldId="300"/>
            <ac:picMk id="11" creationId="{A263CC8A-06E0-4653-8BBB-40D0967227BE}"/>
          </ac:picMkLst>
        </pc:picChg>
        <pc:picChg chg="mod">
          <ac:chgData name="Manasweeta Angane" userId="05da2731-9352-4b35-b713-60351f56afbd" providerId="ADAL" clId="{F5F97842-A295-4F9F-B89B-A63B35E1C32D}" dt="2022-10-19T08:41:17.529" v="11354" actId="14100"/>
          <ac:picMkLst>
            <pc:docMk/>
            <pc:sldMk cId="3664014045" sldId="300"/>
            <ac:picMk id="12" creationId="{F7E0BA92-B966-4C3E-A319-80C50D003C11}"/>
          </ac:picMkLst>
        </pc:picChg>
        <pc:picChg chg="mod">
          <ac:chgData name="Manasweeta Angane" userId="05da2731-9352-4b35-b713-60351f56afbd" providerId="ADAL" clId="{F5F97842-A295-4F9F-B89B-A63B35E1C32D}" dt="2022-10-19T08:40:33.210" v="11350" actId="1076"/>
          <ac:picMkLst>
            <pc:docMk/>
            <pc:sldMk cId="3664014045" sldId="300"/>
            <ac:picMk id="13" creationId="{56F59310-191A-402F-9593-92BC69C91FF0}"/>
          </ac:picMkLst>
        </pc:picChg>
      </pc:sldChg>
      <pc:sldChg chg="addSp delSp modSp add mod delAnim modAnim">
        <pc:chgData name="Manasweeta Angane" userId="05da2731-9352-4b35-b713-60351f56afbd" providerId="ADAL" clId="{F5F97842-A295-4F9F-B89B-A63B35E1C32D}" dt="2022-10-22T04:48:44.705" v="17928" actId="1035"/>
        <pc:sldMkLst>
          <pc:docMk/>
          <pc:sldMk cId="2580936858" sldId="301"/>
        </pc:sldMkLst>
        <pc:spChg chg="add mod">
          <ac:chgData name="Manasweeta Angane" userId="05da2731-9352-4b35-b713-60351f56afbd" providerId="ADAL" clId="{F5F97842-A295-4F9F-B89B-A63B35E1C32D}" dt="2022-10-22T04:48:44.705" v="17928" actId="1035"/>
          <ac:spMkLst>
            <pc:docMk/>
            <pc:sldMk cId="2580936858" sldId="301"/>
            <ac:spMk id="13" creationId="{C27B41C7-3C48-4916-AA0D-DD785C5BB86D}"/>
          </ac:spMkLst>
        </pc:spChg>
        <pc:spChg chg="del">
          <ac:chgData name="Manasweeta Angane" userId="05da2731-9352-4b35-b713-60351f56afbd" providerId="ADAL" clId="{F5F97842-A295-4F9F-B89B-A63B35E1C32D}" dt="2022-10-10T13:50:53.437" v="4672" actId="478"/>
          <ac:spMkLst>
            <pc:docMk/>
            <pc:sldMk cId="2580936858" sldId="301"/>
            <ac:spMk id="17" creationId="{8DB771DF-C627-44BB-8716-44C80EF9D83F}"/>
          </ac:spMkLst>
        </pc:spChg>
        <pc:spChg chg="mod">
          <ac:chgData name="Manasweeta Angane" userId="05da2731-9352-4b35-b713-60351f56afbd" providerId="ADAL" clId="{F5F97842-A295-4F9F-B89B-A63B35E1C32D}" dt="2022-10-11T12:23:48.419" v="6532" actId="1035"/>
          <ac:spMkLst>
            <pc:docMk/>
            <pc:sldMk cId="2580936858" sldId="301"/>
            <ac:spMk id="18" creationId="{45F2BEED-A6BE-45AE-BED7-62E52E5E5868}"/>
          </ac:spMkLst>
        </pc:spChg>
        <pc:spChg chg="add del mod">
          <ac:chgData name="Manasweeta Angane" userId="05da2731-9352-4b35-b713-60351f56afbd" providerId="ADAL" clId="{F5F97842-A295-4F9F-B89B-A63B35E1C32D}" dt="2022-10-22T04:48:37.158" v="17898" actId="21"/>
          <ac:spMkLst>
            <pc:docMk/>
            <pc:sldMk cId="2580936858" sldId="301"/>
            <ac:spMk id="42" creationId="{005084CB-9D80-4A04-8CED-C0A8549AD5BE}"/>
          </ac:spMkLst>
        </pc:spChg>
        <pc:graphicFrameChg chg="add del mod">
          <ac:chgData name="Manasweeta Angane" userId="05da2731-9352-4b35-b713-60351f56afbd" providerId="ADAL" clId="{F5F97842-A295-4F9F-B89B-A63B35E1C32D}" dt="2022-10-10T14:03:51.856" v="4674"/>
          <ac:graphicFrameMkLst>
            <pc:docMk/>
            <pc:sldMk cId="2580936858" sldId="301"/>
            <ac:graphicFrameMk id="2" creationId="{26B446A9-E6C1-4901-B5AE-05085BC9C657}"/>
          </ac:graphicFrameMkLst>
        </pc:graphicFrameChg>
        <pc:graphicFrameChg chg="add del mod">
          <ac:chgData name="Manasweeta Angane" userId="05da2731-9352-4b35-b713-60351f56afbd" providerId="ADAL" clId="{F5F97842-A295-4F9F-B89B-A63B35E1C32D}" dt="2022-10-10T14:04:18.175" v="4680"/>
          <ac:graphicFrameMkLst>
            <pc:docMk/>
            <pc:sldMk cId="2580936858" sldId="301"/>
            <ac:graphicFrameMk id="3" creationId="{719CDE1E-0EA9-4895-9D6C-691C542137C6}"/>
          </ac:graphicFrameMkLst>
        </pc:graphicFrameChg>
        <pc:graphicFrameChg chg="add del mod">
          <ac:chgData name="Manasweeta Angane" userId="05da2731-9352-4b35-b713-60351f56afbd" providerId="ADAL" clId="{F5F97842-A295-4F9F-B89B-A63B35E1C32D}" dt="2022-10-10T14:04:17.534" v="4679"/>
          <ac:graphicFrameMkLst>
            <pc:docMk/>
            <pc:sldMk cId="2580936858" sldId="301"/>
            <ac:graphicFrameMk id="11" creationId="{4413D648-C7AE-42BD-95B4-DC3F9C983A9E}"/>
          </ac:graphicFrameMkLst>
        </pc:graphicFrameChg>
        <pc:graphicFrameChg chg="add del mod">
          <ac:chgData name="Manasweeta Angane" userId="05da2731-9352-4b35-b713-60351f56afbd" providerId="ADAL" clId="{F5F97842-A295-4F9F-B89B-A63B35E1C32D}" dt="2022-10-10T14:10:02.037" v="4685" actId="478"/>
          <ac:graphicFrameMkLst>
            <pc:docMk/>
            <pc:sldMk cId="2580936858" sldId="301"/>
            <ac:graphicFrameMk id="12" creationId="{1F50B2A5-FE35-4E2E-8899-4D3C17F94503}"/>
          </ac:graphicFrameMkLst>
        </pc:graphicFrameChg>
        <pc:graphicFrameChg chg="add del mod">
          <ac:chgData name="Manasweeta Angane" userId="05da2731-9352-4b35-b713-60351f56afbd" providerId="ADAL" clId="{F5F97842-A295-4F9F-B89B-A63B35E1C32D}" dt="2022-10-10T14:04:53.472" v="4684"/>
          <ac:graphicFrameMkLst>
            <pc:docMk/>
            <pc:sldMk cId="2580936858" sldId="301"/>
            <ac:graphicFrameMk id="13" creationId="{C875FD6A-1EE5-4696-A4A9-412E8A67E6DD}"/>
          </ac:graphicFrameMkLst>
        </pc:graphicFrameChg>
        <pc:graphicFrameChg chg="add del mod">
          <ac:chgData name="Manasweeta Angane" userId="05da2731-9352-4b35-b713-60351f56afbd" providerId="ADAL" clId="{F5F97842-A295-4F9F-B89B-A63B35E1C32D}" dt="2022-10-11T00:42:16.015" v="4884" actId="478"/>
          <ac:graphicFrameMkLst>
            <pc:docMk/>
            <pc:sldMk cId="2580936858" sldId="301"/>
            <ac:graphicFrameMk id="14" creationId="{C24C3F88-B645-4010-A408-052EC87CAA95}"/>
          </ac:graphicFrameMkLst>
        </pc:graphicFrameChg>
        <pc:graphicFrameChg chg="add del mod">
          <ac:chgData name="Manasweeta Angane" userId="05da2731-9352-4b35-b713-60351f56afbd" providerId="ADAL" clId="{F5F97842-A295-4F9F-B89B-A63B35E1C32D}" dt="2022-10-10T14:11:30.177" v="4841" actId="478"/>
          <ac:graphicFrameMkLst>
            <pc:docMk/>
            <pc:sldMk cId="2580936858" sldId="301"/>
            <ac:graphicFrameMk id="35" creationId="{D2F9ACC7-E41B-4FE2-AE93-504D5BACB831}"/>
          </ac:graphicFrameMkLst>
        </pc:graphicFrameChg>
        <pc:picChg chg="del mod">
          <ac:chgData name="Manasweeta Angane" userId="05da2731-9352-4b35-b713-60351f56afbd" providerId="ADAL" clId="{F5F97842-A295-4F9F-B89B-A63B35E1C32D}" dt="2022-10-11T00:43:17.969" v="4920" actId="478"/>
          <ac:picMkLst>
            <pc:docMk/>
            <pc:sldMk cId="2580936858" sldId="301"/>
            <ac:picMk id="15" creationId="{74F38BAD-98F2-4CBE-9630-8E9781E31EB9}"/>
          </ac:picMkLst>
        </pc:picChg>
        <pc:picChg chg="del mod">
          <ac:chgData name="Manasweeta Angane" userId="05da2731-9352-4b35-b713-60351f56afbd" providerId="ADAL" clId="{F5F97842-A295-4F9F-B89B-A63B35E1C32D}" dt="2022-10-11T00:44:27.781" v="4988" actId="478"/>
          <ac:picMkLst>
            <pc:docMk/>
            <pc:sldMk cId="2580936858" sldId="301"/>
            <ac:picMk id="16" creationId="{C2BE2F1A-AA37-4D33-A56E-2FAA324FC1F6}"/>
          </ac:picMkLst>
        </pc:picChg>
        <pc:picChg chg="del mod">
          <ac:chgData name="Manasweeta Angane" userId="05da2731-9352-4b35-b713-60351f56afbd" providerId="ADAL" clId="{F5F97842-A295-4F9F-B89B-A63B35E1C32D}" dt="2022-10-11T00:48:58.643" v="5091" actId="478"/>
          <ac:picMkLst>
            <pc:docMk/>
            <pc:sldMk cId="2580936858" sldId="301"/>
            <ac:picMk id="19" creationId="{21592049-09AB-4708-A244-2D18B65318F2}"/>
          </ac:picMkLst>
        </pc:picChg>
        <pc:picChg chg="mod">
          <ac:chgData name="Manasweeta Angane" userId="05da2731-9352-4b35-b713-60351f56afbd" providerId="ADAL" clId="{F5F97842-A295-4F9F-B89B-A63B35E1C32D}" dt="2022-10-11T04:12:43.750" v="5857" actId="1038"/>
          <ac:picMkLst>
            <pc:docMk/>
            <pc:sldMk cId="2580936858" sldId="301"/>
            <ac:picMk id="20" creationId="{C703D7E3-9FBF-4139-8E34-D93A6B82F9FC}"/>
          </ac:picMkLst>
        </pc:picChg>
        <pc:picChg chg="del mod">
          <ac:chgData name="Manasweeta Angane" userId="05da2731-9352-4b35-b713-60351f56afbd" providerId="ADAL" clId="{F5F97842-A295-4F9F-B89B-A63B35E1C32D}" dt="2022-10-11T00:52:45.800" v="5229"/>
          <ac:picMkLst>
            <pc:docMk/>
            <pc:sldMk cId="2580936858" sldId="301"/>
            <ac:picMk id="21" creationId="{33E6CE56-5C98-4F84-A7CD-2631A26888B3}"/>
          </ac:picMkLst>
        </pc:picChg>
        <pc:picChg chg="del mod">
          <ac:chgData name="Manasweeta Angane" userId="05da2731-9352-4b35-b713-60351f56afbd" providerId="ADAL" clId="{F5F97842-A295-4F9F-B89B-A63B35E1C32D}" dt="2022-10-11T00:59:08.550" v="5386" actId="478"/>
          <ac:picMkLst>
            <pc:docMk/>
            <pc:sldMk cId="2580936858" sldId="301"/>
            <ac:picMk id="22" creationId="{D0FB052F-EBCB-49B1-A2C6-EAEF07E0CF2A}"/>
          </ac:picMkLst>
        </pc:picChg>
        <pc:picChg chg="mod">
          <ac:chgData name="Manasweeta Angane" userId="05da2731-9352-4b35-b713-60351f56afbd" providerId="ADAL" clId="{F5F97842-A295-4F9F-B89B-A63B35E1C32D}" dt="2022-10-11T04:12:28.883" v="5830" actId="1038"/>
          <ac:picMkLst>
            <pc:docMk/>
            <pc:sldMk cId="2580936858" sldId="301"/>
            <ac:picMk id="23" creationId="{B8E31F49-FEE6-4AE2-A84B-A25B2200844C}"/>
          </ac:picMkLst>
        </pc:picChg>
        <pc:picChg chg="add del mod">
          <ac:chgData name="Manasweeta Angane" userId="05da2731-9352-4b35-b713-60351f56afbd" providerId="ADAL" clId="{F5F97842-A295-4F9F-B89B-A63B35E1C32D}" dt="2022-10-10T14:03:51.856" v="4674"/>
          <ac:picMkLst>
            <pc:docMk/>
            <pc:sldMk cId="2580936858" sldId="301"/>
            <ac:picMk id="4097" creationId="{E4B04E93-74EB-414E-931C-B38669966CEB}"/>
          </ac:picMkLst>
        </pc:picChg>
        <pc:picChg chg="add del mod">
          <ac:chgData name="Manasweeta Angane" userId="05da2731-9352-4b35-b713-60351f56afbd" providerId="ADAL" clId="{F5F97842-A295-4F9F-B89B-A63B35E1C32D}" dt="2022-10-10T14:03:51.856" v="4674"/>
          <ac:picMkLst>
            <pc:docMk/>
            <pc:sldMk cId="2580936858" sldId="301"/>
            <ac:picMk id="4098" creationId="{EE6D95D1-10C5-46C5-8044-437CE2186893}"/>
          </ac:picMkLst>
        </pc:picChg>
        <pc:picChg chg="add del mod">
          <ac:chgData name="Manasweeta Angane" userId="05da2731-9352-4b35-b713-60351f56afbd" providerId="ADAL" clId="{F5F97842-A295-4F9F-B89B-A63B35E1C32D}" dt="2022-10-10T14:03:51.856" v="4674"/>
          <ac:picMkLst>
            <pc:docMk/>
            <pc:sldMk cId="2580936858" sldId="301"/>
            <ac:picMk id="4099" creationId="{F7BA9537-2B6D-4947-A022-B2DA1624E41E}"/>
          </ac:picMkLst>
        </pc:picChg>
        <pc:picChg chg="add del mod">
          <ac:chgData name="Manasweeta Angane" userId="05da2731-9352-4b35-b713-60351f56afbd" providerId="ADAL" clId="{F5F97842-A295-4F9F-B89B-A63B35E1C32D}" dt="2022-10-10T14:03:51.856" v="4674"/>
          <ac:picMkLst>
            <pc:docMk/>
            <pc:sldMk cId="2580936858" sldId="301"/>
            <ac:picMk id="4100" creationId="{CED992B7-951B-4C03-9B77-66817A7BD4D8}"/>
          </ac:picMkLst>
        </pc:picChg>
        <pc:picChg chg="add del mod">
          <ac:chgData name="Manasweeta Angane" userId="05da2731-9352-4b35-b713-60351f56afbd" providerId="ADAL" clId="{F5F97842-A295-4F9F-B89B-A63B35E1C32D}" dt="2022-10-10T14:03:51.856" v="4674"/>
          <ac:picMkLst>
            <pc:docMk/>
            <pc:sldMk cId="2580936858" sldId="301"/>
            <ac:picMk id="4101" creationId="{EA242397-DCAA-485E-AC5D-CD249D11AC52}"/>
          </ac:picMkLst>
        </pc:picChg>
        <pc:picChg chg="add del mod">
          <ac:chgData name="Manasweeta Angane" userId="05da2731-9352-4b35-b713-60351f56afbd" providerId="ADAL" clId="{F5F97842-A295-4F9F-B89B-A63B35E1C32D}" dt="2022-10-10T14:03:51.856" v="4674"/>
          <ac:picMkLst>
            <pc:docMk/>
            <pc:sldMk cId="2580936858" sldId="301"/>
            <ac:picMk id="4102" creationId="{165766AA-734F-4767-8F75-14EEB1E21C7D}"/>
          </ac:picMkLst>
        </pc:picChg>
        <pc:picChg chg="add del mod">
          <ac:chgData name="Manasweeta Angane" userId="05da2731-9352-4b35-b713-60351f56afbd" providerId="ADAL" clId="{F5F97842-A295-4F9F-B89B-A63B35E1C32D}" dt="2022-10-10T14:04:18.175" v="4680"/>
          <ac:picMkLst>
            <pc:docMk/>
            <pc:sldMk cId="2580936858" sldId="301"/>
            <ac:picMk id="4103" creationId="{DD0430E6-616A-4D75-857E-373F77D1ACF4}"/>
          </ac:picMkLst>
        </pc:picChg>
        <pc:picChg chg="add del mod">
          <ac:chgData name="Manasweeta Angane" userId="05da2731-9352-4b35-b713-60351f56afbd" providerId="ADAL" clId="{F5F97842-A295-4F9F-B89B-A63B35E1C32D}" dt="2022-10-10T14:04:18.175" v="4680"/>
          <ac:picMkLst>
            <pc:docMk/>
            <pc:sldMk cId="2580936858" sldId="301"/>
            <ac:picMk id="4104" creationId="{3AFBE797-A01D-4319-BF7F-61846FEB3D7C}"/>
          </ac:picMkLst>
        </pc:picChg>
        <pc:picChg chg="add del mod">
          <ac:chgData name="Manasweeta Angane" userId="05da2731-9352-4b35-b713-60351f56afbd" providerId="ADAL" clId="{F5F97842-A295-4F9F-B89B-A63B35E1C32D}" dt="2022-10-10T14:04:18.175" v="4680"/>
          <ac:picMkLst>
            <pc:docMk/>
            <pc:sldMk cId="2580936858" sldId="301"/>
            <ac:picMk id="4105" creationId="{E699F40E-C33A-4BF0-8135-3B103AB96EC9}"/>
          </ac:picMkLst>
        </pc:picChg>
        <pc:picChg chg="add del mod">
          <ac:chgData name="Manasweeta Angane" userId="05da2731-9352-4b35-b713-60351f56afbd" providerId="ADAL" clId="{F5F97842-A295-4F9F-B89B-A63B35E1C32D}" dt="2022-10-10T14:04:18.175" v="4680"/>
          <ac:picMkLst>
            <pc:docMk/>
            <pc:sldMk cId="2580936858" sldId="301"/>
            <ac:picMk id="4106" creationId="{669F0F72-6CF8-4885-AE49-48EE6CA3D124}"/>
          </ac:picMkLst>
        </pc:picChg>
        <pc:picChg chg="add del mod">
          <ac:chgData name="Manasweeta Angane" userId="05da2731-9352-4b35-b713-60351f56afbd" providerId="ADAL" clId="{F5F97842-A295-4F9F-B89B-A63B35E1C32D}" dt="2022-10-10T14:04:18.175" v="4680"/>
          <ac:picMkLst>
            <pc:docMk/>
            <pc:sldMk cId="2580936858" sldId="301"/>
            <ac:picMk id="4107" creationId="{0340F7F7-C845-458F-B629-FE742CDADAA5}"/>
          </ac:picMkLst>
        </pc:picChg>
        <pc:picChg chg="add del mod">
          <ac:chgData name="Manasweeta Angane" userId="05da2731-9352-4b35-b713-60351f56afbd" providerId="ADAL" clId="{F5F97842-A295-4F9F-B89B-A63B35E1C32D}" dt="2022-10-10T14:04:18.175" v="4680"/>
          <ac:picMkLst>
            <pc:docMk/>
            <pc:sldMk cId="2580936858" sldId="301"/>
            <ac:picMk id="4108" creationId="{9B4FFAAB-408E-4765-BAE9-6C3556C9A277}"/>
          </ac:picMkLst>
        </pc:picChg>
        <pc:picChg chg="add del mod">
          <ac:chgData name="Manasweeta Angane" userId="05da2731-9352-4b35-b713-60351f56afbd" providerId="ADAL" clId="{F5F97842-A295-4F9F-B89B-A63B35E1C32D}" dt="2022-10-10T14:04:53.472" v="4684"/>
          <ac:picMkLst>
            <pc:docMk/>
            <pc:sldMk cId="2580936858" sldId="301"/>
            <ac:picMk id="4109" creationId="{A94B26D3-01B6-4B0C-A9B2-25789CACA19B}"/>
          </ac:picMkLst>
        </pc:picChg>
        <pc:picChg chg="add del mod">
          <ac:chgData name="Manasweeta Angane" userId="05da2731-9352-4b35-b713-60351f56afbd" providerId="ADAL" clId="{F5F97842-A295-4F9F-B89B-A63B35E1C32D}" dt="2022-10-10T14:04:53.472" v="4684"/>
          <ac:picMkLst>
            <pc:docMk/>
            <pc:sldMk cId="2580936858" sldId="301"/>
            <ac:picMk id="4110" creationId="{894C5262-E135-4E67-9B1E-B3F7D54D80A2}"/>
          </ac:picMkLst>
        </pc:picChg>
        <pc:picChg chg="add del mod">
          <ac:chgData name="Manasweeta Angane" userId="05da2731-9352-4b35-b713-60351f56afbd" providerId="ADAL" clId="{F5F97842-A295-4F9F-B89B-A63B35E1C32D}" dt="2022-10-10T14:04:53.472" v="4684"/>
          <ac:picMkLst>
            <pc:docMk/>
            <pc:sldMk cId="2580936858" sldId="301"/>
            <ac:picMk id="4111" creationId="{333B57A0-3FDE-4FB6-B842-0407D88ED55E}"/>
          </ac:picMkLst>
        </pc:picChg>
        <pc:picChg chg="add del mod">
          <ac:chgData name="Manasweeta Angane" userId="05da2731-9352-4b35-b713-60351f56afbd" providerId="ADAL" clId="{F5F97842-A295-4F9F-B89B-A63B35E1C32D}" dt="2022-10-10T14:04:53.472" v="4684"/>
          <ac:picMkLst>
            <pc:docMk/>
            <pc:sldMk cId="2580936858" sldId="301"/>
            <ac:picMk id="4112" creationId="{C0E96A52-1318-42D7-827B-5E2E706E8645}"/>
          </ac:picMkLst>
        </pc:picChg>
        <pc:picChg chg="add del mod">
          <ac:chgData name="Manasweeta Angane" userId="05da2731-9352-4b35-b713-60351f56afbd" providerId="ADAL" clId="{F5F97842-A295-4F9F-B89B-A63B35E1C32D}" dt="2022-10-10T14:04:53.472" v="4684"/>
          <ac:picMkLst>
            <pc:docMk/>
            <pc:sldMk cId="2580936858" sldId="301"/>
            <ac:picMk id="4113" creationId="{7F292123-C3CD-4F4D-A7B9-2985B2890C03}"/>
          </ac:picMkLst>
        </pc:picChg>
        <pc:picChg chg="add del mod">
          <ac:chgData name="Manasweeta Angane" userId="05da2731-9352-4b35-b713-60351f56afbd" providerId="ADAL" clId="{F5F97842-A295-4F9F-B89B-A63B35E1C32D}" dt="2022-10-10T14:04:53.472" v="4684"/>
          <ac:picMkLst>
            <pc:docMk/>
            <pc:sldMk cId="2580936858" sldId="301"/>
            <ac:picMk id="4114" creationId="{6E26D40E-342E-46E6-A9C8-05A7A1012B7E}"/>
          </ac:picMkLst>
        </pc:picChg>
      </pc:sldChg>
      <pc:sldChg chg="addSp delSp modSp add del mod delAnim modAnim modNotesTx">
        <pc:chgData name="Manasweeta Angane" userId="05da2731-9352-4b35-b713-60351f56afbd" providerId="ADAL" clId="{F5F97842-A295-4F9F-B89B-A63B35E1C32D}" dt="2022-10-22T00:22:59.523" v="15795" actId="20577"/>
        <pc:sldMkLst>
          <pc:docMk/>
          <pc:sldMk cId="1184162767" sldId="302"/>
        </pc:sldMkLst>
        <pc:spChg chg="add mod">
          <ac:chgData name="Manasweeta Angane" userId="05da2731-9352-4b35-b713-60351f56afbd" providerId="ADAL" clId="{F5F97842-A295-4F9F-B89B-A63B35E1C32D}" dt="2022-10-11T04:16:27.601" v="5899" actId="1035"/>
          <ac:spMkLst>
            <pc:docMk/>
            <pc:sldMk cId="1184162767" sldId="302"/>
            <ac:spMk id="12" creationId="{F3178B0D-E024-47A1-BF35-738371929F9D}"/>
          </ac:spMkLst>
        </pc:spChg>
        <pc:spChg chg="add mod">
          <ac:chgData name="Manasweeta Angane" userId="05da2731-9352-4b35-b713-60351f56afbd" providerId="ADAL" clId="{F5F97842-A295-4F9F-B89B-A63B35E1C32D}" dt="2022-10-19T08:45:10.036" v="11489" actId="1035"/>
          <ac:spMkLst>
            <pc:docMk/>
            <pc:sldMk cId="1184162767" sldId="302"/>
            <ac:spMk id="13" creationId="{A44C175A-ABB9-4709-B11B-2C81904D9A35}"/>
          </ac:spMkLst>
        </pc:spChg>
        <pc:spChg chg="del">
          <ac:chgData name="Manasweeta Angane" userId="05da2731-9352-4b35-b713-60351f56afbd" providerId="ADAL" clId="{F5F97842-A295-4F9F-B89B-A63B35E1C32D}" dt="2022-10-11T04:09:46.193" v="5625" actId="478"/>
          <ac:spMkLst>
            <pc:docMk/>
            <pc:sldMk cId="1184162767" sldId="302"/>
            <ac:spMk id="17" creationId="{8DB771DF-C627-44BB-8716-44C80EF9D83F}"/>
          </ac:spMkLst>
        </pc:spChg>
        <pc:spChg chg="mod">
          <ac:chgData name="Manasweeta Angane" userId="05da2731-9352-4b35-b713-60351f56afbd" providerId="ADAL" clId="{F5F97842-A295-4F9F-B89B-A63B35E1C32D}" dt="2022-10-11T09:23:31.518" v="6008" actId="1035"/>
          <ac:spMkLst>
            <pc:docMk/>
            <pc:sldMk cId="1184162767" sldId="302"/>
            <ac:spMk id="18" creationId="{45F2BEED-A6BE-45AE-BED7-62E52E5E5868}"/>
          </ac:spMkLst>
        </pc:spChg>
        <pc:grpChg chg="mod">
          <ac:chgData name="Manasweeta Angane" userId="05da2731-9352-4b35-b713-60351f56afbd" providerId="ADAL" clId="{F5F97842-A295-4F9F-B89B-A63B35E1C32D}" dt="2022-10-11T12:24:06.632" v="6543" actId="1036"/>
          <ac:grpSpMkLst>
            <pc:docMk/>
            <pc:sldMk cId="1184162767" sldId="302"/>
            <ac:grpSpMk id="4" creationId="{3F0E3FD0-07DB-4674-861B-D61E237388B2}"/>
          </ac:grpSpMkLst>
        </pc:grpChg>
        <pc:picChg chg="mod">
          <ac:chgData name="Manasweeta Angane" userId="05da2731-9352-4b35-b713-60351f56afbd" providerId="ADAL" clId="{F5F97842-A295-4F9F-B89B-A63B35E1C32D}" dt="2022-10-11T04:11:38.507" v="5801" actId="1038"/>
          <ac:picMkLst>
            <pc:docMk/>
            <pc:sldMk cId="1184162767" sldId="302"/>
            <ac:picMk id="2" creationId="{6F65ABDA-F1A7-484B-9DDC-84F68A02E9CF}"/>
          </ac:picMkLst>
        </pc:picChg>
        <pc:picChg chg="mod ord">
          <ac:chgData name="Manasweeta Angane" userId="05da2731-9352-4b35-b713-60351f56afbd" providerId="ADAL" clId="{F5F97842-A295-4F9F-B89B-A63B35E1C32D}" dt="2022-10-21T02:57:18.476" v="11764" actId="1076"/>
          <ac:picMkLst>
            <pc:docMk/>
            <pc:sldMk cId="1184162767" sldId="302"/>
            <ac:picMk id="3" creationId="{6D700831-CAEB-4A93-835A-052DD8E746FB}"/>
          </ac:picMkLst>
        </pc:picChg>
        <pc:picChg chg="del mod">
          <ac:chgData name="Manasweeta Angane" userId="05da2731-9352-4b35-b713-60351f56afbd" providerId="ADAL" clId="{F5F97842-A295-4F9F-B89B-A63B35E1C32D}" dt="2022-10-18T02:09:12.889" v="9975" actId="478"/>
          <ac:picMkLst>
            <pc:docMk/>
            <pc:sldMk cId="1184162767" sldId="302"/>
            <ac:picMk id="3" creationId="{CF71E62D-5B85-42FB-A83E-89B87E2457D2}"/>
          </ac:picMkLst>
        </pc:picChg>
        <pc:cxnChg chg="add mod">
          <ac:chgData name="Manasweeta Angane" userId="05da2731-9352-4b35-b713-60351f56afbd" providerId="ADAL" clId="{F5F97842-A295-4F9F-B89B-A63B35E1C32D}" dt="2022-10-21T02:44:01.962" v="11691" actId="14100"/>
          <ac:cxnSpMkLst>
            <pc:docMk/>
            <pc:sldMk cId="1184162767" sldId="302"/>
            <ac:cxnSpMk id="14" creationId="{1674F91A-B961-4988-8341-98B65D267439}"/>
          </ac:cxnSpMkLst>
        </pc:cxnChg>
        <pc:cxnChg chg="add mod">
          <ac:chgData name="Manasweeta Angane" userId="05da2731-9352-4b35-b713-60351f56afbd" providerId="ADAL" clId="{F5F97842-A295-4F9F-B89B-A63B35E1C32D}" dt="2022-10-21T02:41:52.964" v="11671" actId="1582"/>
          <ac:cxnSpMkLst>
            <pc:docMk/>
            <pc:sldMk cId="1184162767" sldId="302"/>
            <ac:cxnSpMk id="17" creationId="{D4B4FCD7-A494-45B1-8A8B-6224F58189C2}"/>
          </ac:cxnSpMkLst>
        </pc:cxnChg>
        <pc:cxnChg chg="add mod">
          <ac:chgData name="Manasweeta Angane" userId="05da2731-9352-4b35-b713-60351f56afbd" providerId="ADAL" clId="{F5F97842-A295-4F9F-B89B-A63B35E1C32D}" dt="2022-10-21T02:44:09.370" v="11692" actId="14100"/>
          <ac:cxnSpMkLst>
            <pc:docMk/>
            <pc:sldMk cId="1184162767" sldId="302"/>
            <ac:cxnSpMk id="20" creationId="{37967FE7-4446-4BA9-8167-6263AF9BA3CB}"/>
          </ac:cxnSpMkLst>
        </pc:cxnChg>
        <pc:cxnChg chg="add mod">
          <ac:chgData name="Manasweeta Angane" userId="05da2731-9352-4b35-b713-60351f56afbd" providerId="ADAL" clId="{F5F97842-A295-4F9F-B89B-A63B35E1C32D}" dt="2022-10-21T02:42:30.170" v="11682" actId="1037"/>
          <ac:cxnSpMkLst>
            <pc:docMk/>
            <pc:sldMk cId="1184162767" sldId="302"/>
            <ac:cxnSpMk id="22" creationId="{3DBC5AAD-FFFE-429C-A61B-9BCD245C0D54}"/>
          </ac:cxnSpMkLst>
        </pc:cxnChg>
        <pc:cxnChg chg="add mod">
          <ac:chgData name="Manasweeta Angane" userId="05da2731-9352-4b35-b713-60351f56afbd" providerId="ADAL" clId="{F5F97842-A295-4F9F-B89B-A63B35E1C32D}" dt="2022-10-21T02:43:16.370" v="11685" actId="14100"/>
          <ac:cxnSpMkLst>
            <pc:docMk/>
            <pc:sldMk cId="1184162767" sldId="302"/>
            <ac:cxnSpMk id="25" creationId="{FB81330B-6835-4A3B-97C9-2A1825E18C9C}"/>
          </ac:cxnSpMkLst>
        </pc:cxnChg>
        <pc:cxnChg chg="add mod">
          <ac:chgData name="Manasweeta Angane" userId="05da2731-9352-4b35-b713-60351f56afbd" providerId="ADAL" clId="{F5F97842-A295-4F9F-B89B-A63B35E1C32D}" dt="2022-10-21T02:44:18.787" v="11693" actId="14100"/>
          <ac:cxnSpMkLst>
            <pc:docMk/>
            <pc:sldMk cId="1184162767" sldId="302"/>
            <ac:cxnSpMk id="27" creationId="{E5C47FCF-0CBA-4EA8-BBB5-E4EBFC90535B}"/>
          </ac:cxnSpMkLst>
        </pc:cxnChg>
        <pc:cxnChg chg="add mod">
          <ac:chgData name="Manasweeta Angane" userId="05da2731-9352-4b35-b713-60351f56afbd" providerId="ADAL" clId="{F5F97842-A295-4F9F-B89B-A63B35E1C32D}" dt="2022-10-21T02:44:53.660" v="11701" actId="1076"/>
          <ac:cxnSpMkLst>
            <pc:docMk/>
            <pc:sldMk cId="1184162767" sldId="302"/>
            <ac:cxnSpMk id="33" creationId="{2D592B89-4F1D-405B-9A5C-2F7FD0E24243}"/>
          </ac:cxnSpMkLst>
        </pc:cxnChg>
        <pc:cxnChg chg="add mod">
          <ac:chgData name="Manasweeta Angane" userId="05da2731-9352-4b35-b713-60351f56afbd" providerId="ADAL" clId="{F5F97842-A295-4F9F-B89B-A63B35E1C32D}" dt="2022-10-21T02:46:34.428" v="11727" actId="1038"/>
          <ac:cxnSpMkLst>
            <pc:docMk/>
            <pc:sldMk cId="1184162767" sldId="302"/>
            <ac:cxnSpMk id="38" creationId="{CE602E88-E813-4735-A716-15DDDD02525B}"/>
          </ac:cxnSpMkLst>
        </pc:cxnChg>
        <pc:cxnChg chg="add mod">
          <ac:chgData name="Manasweeta Angane" userId="05da2731-9352-4b35-b713-60351f56afbd" providerId="ADAL" clId="{F5F97842-A295-4F9F-B89B-A63B35E1C32D}" dt="2022-10-21T02:46:53.436" v="11730" actId="1076"/>
          <ac:cxnSpMkLst>
            <pc:docMk/>
            <pc:sldMk cId="1184162767" sldId="302"/>
            <ac:cxnSpMk id="40" creationId="{8F5945D1-9309-4DBA-A0C4-408D46A540B4}"/>
          </ac:cxnSpMkLst>
        </pc:cxnChg>
        <pc:cxnChg chg="add mod ord">
          <ac:chgData name="Manasweeta Angane" userId="05da2731-9352-4b35-b713-60351f56afbd" providerId="ADAL" clId="{F5F97842-A295-4F9F-B89B-A63B35E1C32D}" dt="2022-10-21T02:58:06.203" v="11831" actId="1076"/>
          <ac:cxnSpMkLst>
            <pc:docMk/>
            <pc:sldMk cId="1184162767" sldId="302"/>
            <ac:cxnSpMk id="41" creationId="{35864F47-13BE-4FBA-943B-28C34F072D09}"/>
          </ac:cxnSpMkLst>
        </pc:cxnChg>
        <pc:cxnChg chg="add mod">
          <ac:chgData name="Manasweeta Angane" userId="05da2731-9352-4b35-b713-60351f56afbd" providerId="ADAL" clId="{F5F97842-A295-4F9F-B89B-A63B35E1C32D}" dt="2022-10-21T02:58:24.980" v="11834" actId="14100"/>
          <ac:cxnSpMkLst>
            <pc:docMk/>
            <pc:sldMk cId="1184162767" sldId="302"/>
            <ac:cxnSpMk id="42" creationId="{99E46067-38A2-4CBA-AA14-4403BCD158BD}"/>
          </ac:cxnSpMkLst>
        </pc:cxnChg>
        <pc:cxnChg chg="add mod">
          <ac:chgData name="Manasweeta Angane" userId="05da2731-9352-4b35-b713-60351f56afbd" providerId="ADAL" clId="{F5F97842-A295-4F9F-B89B-A63B35E1C32D}" dt="2022-10-21T02:58:39.723" v="11836" actId="1076"/>
          <ac:cxnSpMkLst>
            <pc:docMk/>
            <pc:sldMk cId="1184162767" sldId="302"/>
            <ac:cxnSpMk id="44" creationId="{72586703-355C-4E17-8F2B-06986A47DAD7}"/>
          </ac:cxnSpMkLst>
        </pc:cxnChg>
        <pc:cxnChg chg="add mod">
          <ac:chgData name="Manasweeta Angane" userId="05da2731-9352-4b35-b713-60351f56afbd" providerId="ADAL" clId="{F5F97842-A295-4F9F-B89B-A63B35E1C32D}" dt="2022-10-21T02:59:11.452" v="11841" actId="1076"/>
          <ac:cxnSpMkLst>
            <pc:docMk/>
            <pc:sldMk cId="1184162767" sldId="302"/>
            <ac:cxnSpMk id="45" creationId="{6143AA30-F122-4EE4-B5F7-404E13543564}"/>
          </ac:cxnSpMkLst>
        </pc:cxnChg>
        <pc:cxnChg chg="add mod">
          <ac:chgData name="Manasweeta Angane" userId="05da2731-9352-4b35-b713-60351f56afbd" providerId="ADAL" clId="{F5F97842-A295-4F9F-B89B-A63B35E1C32D}" dt="2022-10-21T02:59:44.820" v="11847" actId="14100"/>
          <ac:cxnSpMkLst>
            <pc:docMk/>
            <pc:sldMk cId="1184162767" sldId="302"/>
            <ac:cxnSpMk id="47" creationId="{9952AAFD-B69E-4FA2-A0EE-9E0AB56CD669}"/>
          </ac:cxnSpMkLst>
        </pc:cxnChg>
        <pc:cxnChg chg="add mod">
          <ac:chgData name="Manasweeta Angane" userId="05da2731-9352-4b35-b713-60351f56afbd" providerId="ADAL" clId="{F5F97842-A295-4F9F-B89B-A63B35E1C32D}" dt="2022-10-21T03:00:20.228" v="11860" actId="1036"/>
          <ac:cxnSpMkLst>
            <pc:docMk/>
            <pc:sldMk cId="1184162767" sldId="302"/>
            <ac:cxnSpMk id="50" creationId="{0A0DD77B-9E0E-4C85-AC9F-797658E3FC22}"/>
          </ac:cxnSpMkLst>
        </pc:cxnChg>
        <pc:cxnChg chg="add mod">
          <ac:chgData name="Manasweeta Angane" userId="05da2731-9352-4b35-b713-60351f56afbd" providerId="ADAL" clId="{F5F97842-A295-4F9F-B89B-A63B35E1C32D}" dt="2022-10-21T03:00:41.285" v="11865" actId="14100"/>
          <ac:cxnSpMkLst>
            <pc:docMk/>
            <pc:sldMk cId="1184162767" sldId="302"/>
            <ac:cxnSpMk id="54" creationId="{3A12F596-AB3E-472E-96D7-3278D2818FE3}"/>
          </ac:cxnSpMkLst>
        </pc:cxnChg>
      </pc:sldChg>
      <pc:sldChg chg="addSp delSp modSp add mod setBg modAnim modNotesTx">
        <pc:chgData name="Manasweeta Angane" userId="05da2731-9352-4b35-b713-60351f56afbd" providerId="ADAL" clId="{F5F97842-A295-4F9F-B89B-A63B35E1C32D}" dt="2022-10-22T01:44:18.047" v="16513" actId="478"/>
        <pc:sldMkLst>
          <pc:docMk/>
          <pc:sldMk cId="1394747819" sldId="303"/>
        </pc:sldMkLst>
        <pc:spChg chg="add mod topLvl">
          <ac:chgData name="Manasweeta Angane" userId="05da2731-9352-4b35-b713-60351f56afbd" providerId="ADAL" clId="{F5F97842-A295-4F9F-B89B-A63B35E1C32D}" dt="2022-10-18T04:20:13.602" v="10304" actId="12788"/>
          <ac:spMkLst>
            <pc:docMk/>
            <pc:sldMk cId="1394747819" sldId="303"/>
            <ac:spMk id="2" creationId="{55655917-0702-4F70-ACE9-E8D70F27F024}"/>
          </ac:spMkLst>
        </pc:spChg>
        <pc:spChg chg="add mod topLvl">
          <ac:chgData name="Manasweeta Angane" userId="05da2731-9352-4b35-b713-60351f56afbd" providerId="ADAL" clId="{F5F97842-A295-4F9F-B89B-A63B35E1C32D}" dt="2022-10-18T04:20:22.227" v="10307" actId="12788"/>
          <ac:spMkLst>
            <pc:docMk/>
            <pc:sldMk cId="1394747819" sldId="303"/>
            <ac:spMk id="3" creationId="{D37F9895-1632-417F-BF3C-CFDDC5E79900}"/>
          </ac:spMkLst>
        </pc:spChg>
        <pc:spChg chg="add del mod">
          <ac:chgData name="Manasweeta Angane" userId="05da2731-9352-4b35-b713-60351f56afbd" providerId="ADAL" clId="{F5F97842-A295-4F9F-B89B-A63B35E1C32D}" dt="2022-10-17T10:28:20.462" v="7127"/>
          <ac:spMkLst>
            <pc:docMk/>
            <pc:sldMk cId="1394747819" sldId="303"/>
            <ac:spMk id="11" creationId="{CA34E0ED-E478-42BF-A998-C9588CB4931B}"/>
          </ac:spMkLst>
        </pc:spChg>
        <pc:spChg chg="add del mod">
          <ac:chgData name="Manasweeta Angane" userId="05da2731-9352-4b35-b713-60351f56afbd" providerId="ADAL" clId="{F5F97842-A295-4F9F-B89B-A63B35E1C32D}" dt="2022-10-17T10:28:20.462" v="7127"/>
          <ac:spMkLst>
            <pc:docMk/>
            <pc:sldMk cId="1394747819" sldId="303"/>
            <ac:spMk id="12" creationId="{F68CB043-DE5C-4955-8B27-9C3EF2F23338}"/>
          </ac:spMkLst>
        </pc:spChg>
        <pc:spChg chg="add mod topLvl">
          <ac:chgData name="Manasweeta Angane" userId="05da2731-9352-4b35-b713-60351f56afbd" providerId="ADAL" clId="{F5F97842-A295-4F9F-B89B-A63B35E1C32D}" dt="2022-10-18T01:05:56.511" v="9304"/>
          <ac:spMkLst>
            <pc:docMk/>
            <pc:sldMk cId="1394747819" sldId="303"/>
            <ac:spMk id="14" creationId="{6D4AD53B-9E1A-4010-9907-094AC6C59069}"/>
          </ac:spMkLst>
        </pc:spChg>
        <pc:spChg chg="mod">
          <ac:chgData name="Manasweeta Angane" userId="05da2731-9352-4b35-b713-60351f56afbd" providerId="ADAL" clId="{F5F97842-A295-4F9F-B89B-A63B35E1C32D}" dt="2022-10-17T10:27:21.714" v="7115"/>
          <ac:spMkLst>
            <pc:docMk/>
            <pc:sldMk cId="1394747819" sldId="303"/>
            <ac:spMk id="15" creationId="{A32CC199-5084-4D7B-AC21-FF67DB66138A}"/>
          </ac:spMkLst>
        </pc:spChg>
        <pc:spChg chg="del mod">
          <ac:chgData name="Manasweeta Angane" userId="05da2731-9352-4b35-b713-60351f56afbd" providerId="ADAL" clId="{F5F97842-A295-4F9F-B89B-A63B35E1C32D}" dt="2022-10-17T22:29:26.967" v="7286" actId="478"/>
          <ac:spMkLst>
            <pc:docMk/>
            <pc:sldMk cId="1394747819" sldId="303"/>
            <ac:spMk id="16" creationId="{EAADE812-97BC-4F61-83F4-8E64478F2333}"/>
          </ac:spMkLst>
        </pc:spChg>
        <pc:spChg chg="del mod">
          <ac:chgData name="Manasweeta Angane" userId="05da2731-9352-4b35-b713-60351f56afbd" providerId="ADAL" clId="{F5F97842-A295-4F9F-B89B-A63B35E1C32D}" dt="2022-10-17T09:52:03.969" v="6593" actId="478"/>
          <ac:spMkLst>
            <pc:docMk/>
            <pc:sldMk cId="1394747819" sldId="303"/>
            <ac:spMk id="17" creationId="{8DB771DF-C627-44BB-8716-44C80EF9D83F}"/>
          </ac:spMkLst>
        </pc:spChg>
        <pc:spChg chg="mod">
          <ac:chgData name="Manasweeta Angane" userId="05da2731-9352-4b35-b713-60351f56afbd" providerId="ADAL" clId="{F5F97842-A295-4F9F-B89B-A63B35E1C32D}" dt="2022-10-18T01:59:03.759" v="9920" actId="1076"/>
          <ac:spMkLst>
            <pc:docMk/>
            <pc:sldMk cId="1394747819" sldId="303"/>
            <ac:spMk id="18" creationId="{45F2BEED-A6BE-45AE-BED7-62E52E5E5868}"/>
          </ac:spMkLst>
        </pc:spChg>
        <pc:spChg chg="add del mod">
          <ac:chgData name="Manasweeta Angane" userId="05da2731-9352-4b35-b713-60351f56afbd" providerId="ADAL" clId="{F5F97842-A295-4F9F-B89B-A63B35E1C32D}" dt="2022-10-17T22:29:28.342" v="7287" actId="478"/>
          <ac:spMkLst>
            <pc:docMk/>
            <pc:sldMk cId="1394747819" sldId="303"/>
            <ac:spMk id="19" creationId="{0BB37EEE-1F27-433A-8783-979CA5281221}"/>
          </ac:spMkLst>
        </pc:spChg>
        <pc:spChg chg="add mod ord">
          <ac:chgData name="Manasweeta Angane" userId="05da2731-9352-4b35-b713-60351f56afbd" providerId="ADAL" clId="{F5F97842-A295-4F9F-B89B-A63B35E1C32D}" dt="2022-10-18T04:45:26.078" v="10420" actId="12789"/>
          <ac:spMkLst>
            <pc:docMk/>
            <pc:sldMk cId="1394747819" sldId="303"/>
            <ac:spMk id="20" creationId="{17803703-EF94-4050-AAD3-AF2146ABD865}"/>
          </ac:spMkLst>
        </pc:spChg>
        <pc:spChg chg="add mod ord">
          <ac:chgData name="Manasweeta Angane" userId="05da2731-9352-4b35-b713-60351f56afbd" providerId="ADAL" clId="{F5F97842-A295-4F9F-B89B-A63B35E1C32D}" dt="2022-10-22T01:40:45.924" v="16386" actId="12789"/>
          <ac:spMkLst>
            <pc:docMk/>
            <pc:sldMk cId="1394747819" sldId="303"/>
            <ac:spMk id="21" creationId="{013D6C74-9FB2-47E2-9B68-B089A27AA7FA}"/>
          </ac:spMkLst>
        </pc:spChg>
        <pc:spChg chg="add del mod">
          <ac:chgData name="Manasweeta Angane" userId="05da2731-9352-4b35-b713-60351f56afbd" providerId="ADAL" clId="{F5F97842-A295-4F9F-B89B-A63B35E1C32D}" dt="2022-10-17T22:29:29.795" v="7288" actId="478"/>
          <ac:spMkLst>
            <pc:docMk/>
            <pc:sldMk cId="1394747819" sldId="303"/>
            <ac:spMk id="22" creationId="{ABB6C0F4-BB91-467C-82F5-FC0B16EDC18B}"/>
          </ac:spMkLst>
        </pc:spChg>
        <pc:spChg chg="add del mod">
          <ac:chgData name="Manasweeta Angane" userId="05da2731-9352-4b35-b713-60351f56afbd" providerId="ADAL" clId="{F5F97842-A295-4F9F-B89B-A63B35E1C32D}" dt="2022-10-17T22:39:46.956" v="7463" actId="478"/>
          <ac:spMkLst>
            <pc:docMk/>
            <pc:sldMk cId="1394747819" sldId="303"/>
            <ac:spMk id="23" creationId="{8E039BE1-A461-49B6-987B-C5B518FFD062}"/>
          </ac:spMkLst>
        </pc:spChg>
        <pc:spChg chg="add del mod">
          <ac:chgData name="Manasweeta Angane" userId="05da2731-9352-4b35-b713-60351f56afbd" providerId="ADAL" clId="{F5F97842-A295-4F9F-B89B-A63B35E1C32D}" dt="2022-10-17T22:39:48.485" v="7464" actId="478"/>
          <ac:spMkLst>
            <pc:docMk/>
            <pc:sldMk cId="1394747819" sldId="303"/>
            <ac:spMk id="24" creationId="{1F254014-1EE9-48D2-90EE-67760C16C0B4}"/>
          </ac:spMkLst>
        </pc:spChg>
        <pc:spChg chg="add del mod">
          <ac:chgData name="Manasweeta Angane" userId="05da2731-9352-4b35-b713-60351f56afbd" providerId="ADAL" clId="{F5F97842-A295-4F9F-B89B-A63B35E1C32D}" dt="2022-10-17T22:39:50.048" v="7465" actId="478"/>
          <ac:spMkLst>
            <pc:docMk/>
            <pc:sldMk cId="1394747819" sldId="303"/>
            <ac:spMk id="25" creationId="{514928B8-A4DF-4E14-90CB-9AD451CD6670}"/>
          </ac:spMkLst>
        </pc:spChg>
        <pc:spChg chg="add mod ord">
          <ac:chgData name="Manasweeta Angane" userId="05da2731-9352-4b35-b713-60351f56afbd" providerId="ADAL" clId="{F5F97842-A295-4F9F-B89B-A63B35E1C32D}" dt="2022-10-22T01:22:03.504" v="16356" actId="12789"/>
          <ac:spMkLst>
            <pc:docMk/>
            <pc:sldMk cId="1394747819" sldId="303"/>
            <ac:spMk id="26" creationId="{1DD1E2ED-A387-4ECC-AD48-3775E9FD4058}"/>
          </ac:spMkLst>
        </pc:spChg>
        <pc:spChg chg="add mod ord">
          <ac:chgData name="Manasweeta Angane" userId="05da2731-9352-4b35-b713-60351f56afbd" providerId="ADAL" clId="{F5F97842-A295-4F9F-B89B-A63B35E1C32D}" dt="2022-10-18T04:19:43.243" v="10278" actId="1037"/>
          <ac:spMkLst>
            <pc:docMk/>
            <pc:sldMk cId="1394747819" sldId="303"/>
            <ac:spMk id="27" creationId="{AA045F81-5508-484A-855D-929E3AED6123}"/>
          </ac:spMkLst>
        </pc:spChg>
        <pc:spChg chg="add mod topLvl">
          <ac:chgData name="Manasweeta Angane" userId="05da2731-9352-4b35-b713-60351f56afbd" providerId="ADAL" clId="{F5F97842-A295-4F9F-B89B-A63B35E1C32D}" dt="2022-10-18T01:05:56.511" v="9304"/>
          <ac:spMkLst>
            <pc:docMk/>
            <pc:sldMk cId="1394747819" sldId="303"/>
            <ac:spMk id="28" creationId="{B0557321-6CF8-42E5-8DEB-676CCA0717F7}"/>
          </ac:spMkLst>
        </pc:spChg>
        <pc:spChg chg="add mod">
          <ac:chgData name="Manasweeta Angane" userId="05da2731-9352-4b35-b713-60351f56afbd" providerId="ADAL" clId="{F5F97842-A295-4F9F-B89B-A63B35E1C32D}" dt="2022-10-18T01:05:56.511" v="9304"/>
          <ac:spMkLst>
            <pc:docMk/>
            <pc:sldMk cId="1394747819" sldId="303"/>
            <ac:spMk id="33" creationId="{6961D78F-B715-4785-973F-93F268A3E870}"/>
          </ac:spMkLst>
        </pc:spChg>
        <pc:spChg chg="mod topLvl">
          <ac:chgData name="Manasweeta Angane" userId="05da2731-9352-4b35-b713-60351f56afbd" providerId="ADAL" clId="{F5F97842-A295-4F9F-B89B-A63B35E1C32D}" dt="2022-10-18T01:31:32.990" v="9407" actId="164"/>
          <ac:spMkLst>
            <pc:docMk/>
            <pc:sldMk cId="1394747819" sldId="303"/>
            <ac:spMk id="35" creationId="{5285D51C-C683-49B7-86C1-C7A9CFE99FFF}"/>
          </ac:spMkLst>
        </pc:spChg>
        <pc:spChg chg="mod topLvl">
          <ac:chgData name="Manasweeta Angane" userId="05da2731-9352-4b35-b713-60351f56afbd" providerId="ADAL" clId="{F5F97842-A295-4F9F-B89B-A63B35E1C32D}" dt="2022-10-18T01:31:32.990" v="9407" actId="164"/>
          <ac:spMkLst>
            <pc:docMk/>
            <pc:sldMk cId="1394747819" sldId="303"/>
            <ac:spMk id="36" creationId="{1E44FF00-13AA-4328-9027-0ED65BE86640}"/>
          </ac:spMkLst>
        </pc:spChg>
        <pc:spChg chg="mod topLvl">
          <ac:chgData name="Manasweeta Angane" userId="05da2731-9352-4b35-b713-60351f56afbd" providerId="ADAL" clId="{F5F97842-A295-4F9F-B89B-A63B35E1C32D}" dt="2022-10-18T01:31:36.265" v="9408" actId="164"/>
          <ac:spMkLst>
            <pc:docMk/>
            <pc:sldMk cId="1394747819" sldId="303"/>
            <ac:spMk id="38" creationId="{12845A24-9F67-4126-8741-D331B08BB4D4}"/>
          </ac:spMkLst>
        </pc:spChg>
        <pc:spChg chg="mod topLvl">
          <ac:chgData name="Manasweeta Angane" userId="05da2731-9352-4b35-b713-60351f56afbd" providerId="ADAL" clId="{F5F97842-A295-4F9F-B89B-A63B35E1C32D}" dt="2022-10-18T01:31:36.265" v="9408" actId="164"/>
          <ac:spMkLst>
            <pc:docMk/>
            <pc:sldMk cId="1394747819" sldId="303"/>
            <ac:spMk id="39" creationId="{EC657382-BF8E-466A-8DEC-61305D2754F4}"/>
          </ac:spMkLst>
        </pc:spChg>
        <pc:spChg chg="mod topLvl">
          <ac:chgData name="Manasweeta Angane" userId="05da2731-9352-4b35-b713-60351f56afbd" providerId="ADAL" clId="{F5F97842-A295-4F9F-B89B-A63B35E1C32D}" dt="2022-10-18T01:31:39.081" v="9409" actId="164"/>
          <ac:spMkLst>
            <pc:docMk/>
            <pc:sldMk cId="1394747819" sldId="303"/>
            <ac:spMk id="41" creationId="{44427234-F401-4CAD-B749-A0FC64E4F588}"/>
          </ac:spMkLst>
        </pc:spChg>
        <pc:spChg chg="mod topLvl">
          <ac:chgData name="Manasweeta Angane" userId="05da2731-9352-4b35-b713-60351f56afbd" providerId="ADAL" clId="{F5F97842-A295-4F9F-B89B-A63B35E1C32D}" dt="2022-10-18T01:31:39.081" v="9409" actId="164"/>
          <ac:spMkLst>
            <pc:docMk/>
            <pc:sldMk cId="1394747819" sldId="303"/>
            <ac:spMk id="42" creationId="{3141B07A-DA0C-41C0-BC91-4E265E1806C5}"/>
          </ac:spMkLst>
        </pc:spChg>
        <pc:spChg chg="add del">
          <ac:chgData name="Manasweeta Angane" userId="05da2731-9352-4b35-b713-60351f56afbd" providerId="ADAL" clId="{F5F97842-A295-4F9F-B89B-A63B35E1C32D}" dt="2022-10-18T01:35:35.005" v="9440" actId="478"/>
          <ac:spMkLst>
            <pc:docMk/>
            <pc:sldMk cId="1394747819" sldId="303"/>
            <ac:spMk id="48" creationId="{F99C61EA-92E0-4135-9E85-3E521CD0A564}"/>
          </ac:spMkLst>
        </pc:spChg>
        <pc:spChg chg="add del">
          <ac:chgData name="Manasweeta Angane" userId="05da2731-9352-4b35-b713-60351f56afbd" providerId="ADAL" clId="{F5F97842-A295-4F9F-B89B-A63B35E1C32D}" dt="2022-10-18T01:36:06.579" v="9442" actId="478"/>
          <ac:spMkLst>
            <pc:docMk/>
            <pc:sldMk cId="1394747819" sldId="303"/>
            <ac:spMk id="49" creationId="{20828173-E8A8-4B26-AED2-1D9DDD556B29}"/>
          </ac:spMkLst>
        </pc:spChg>
        <pc:spChg chg="add del">
          <ac:chgData name="Manasweeta Angane" userId="05da2731-9352-4b35-b713-60351f56afbd" providerId="ADAL" clId="{F5F97842-A295-4F9F-B89B-A63B35E1C32D}" dt="2022-10-18T01:36:30.079" v="9444" actId="11529"/>
          <ac:spMkLst>
            <pc:docMk/>
            <pc:sldMk cId="1394747819" sldId="303"/>
            <ac:spMk id="50" creationId="{364165AF-078B-4D36-A1B5-9B429102E82C}"/>
          </ac:spMkLst>
        </pc:spChg>
        <pc:spChg chg="add del">
          <ac:chgData name="Manasweeta Angane" userId="05da2731-9352-4b35-b713-60351f56afbd" providerId="ADAL" clId="{F5F97842-A295-4F9F-B89B-A63B35E1C32D}" dt="2022-10-18T01:37:25.907" v="9446" actId="11529"/>
          <ac:spMkLst>
            <pc:docMk/>
            <pc:sldMk cId="1394747819" sldId="303"/>
            <ac:spMk id="51" creationId="{623C0A7D-0110-44E3-8581-75C8DE1033B2}"/>
          </ac:spMkLst>
        </pc:spChg>
        <pc:spChg chg="add del mod">
          <ac:chgData name="Manasweeta Angane" userId="05da2731-9352-4b35-b713-60351f56afbd" providerId="ADAL" clId="{F5F97842-A295-4F9F-B89B-A63B35E1C32D}" dt="2022-10-18T01:37:51.964" v="9450" actId="478"/>
          <ac:spMkLst>
            <pc:docMk/>
            <pc:sldMk cId="1394747819" sldId="303"/>
            <ac:spMk id="52" creationId="{6B793CC5-8845-4328-96EF-57CCC570F405}"/>
          </ac:spMkLst>
        </pc:spChg>
        <pc:spChg chg="add mod">
          <ac:chgData name="Manasweeta Angane" userId="05da2731-9352-4b35-b713-60351f56afbd" providerId="ADAL" clId="{F5F97842-A295-4F9F-B89B-A63B35E1C32D}" dt="2022-10-18T01:42:55.678" v="9568" actId="164"/>
          <ac:spMkLst>
            <pc:docMk/>
            <pc:sldMk cId="1394747819" sldId="303"/>
            <ac:spMk id="53" creationId="{325A1E02-C795-4952-9FDC-A3B88632FAD4}"/>
          </ac:spMkLst>
        </pc:spChg>
        <pc:spChg chg="add mod ord">
          <ac:chgData name="Manasweeta Angane" userId="05da2731-9352-4b35-b713-60351f56afbd" providerId="ADAL" clId="{F5F97842-A295-4F9F-B89B-A63B35E1C32D}" dt="2022-10-18T01:42:55.678" v="9568" actId="164"/>
          <ac:spMkLst>
            <pc:docMk/>
            <pc:sldMk cId="1394747819" sldId="303"/>
            <ac:spMk id="54" creationId="{4D0DB251-59CF-425E-9B1C-59389748E1A2}"/>
          </ac:spMkLst>
        </pc:spChg>
        <pc:spChg chg="mod">
          <ac:chgData name="Manasweeta Angane" userId="05da2731-9352-4b35-b713-60351f56afbd" providerId="ADAL" clId="{F5F97842-A295-4F9F-B89B-A63B35E1C32D}" dt="2022-10-18T01:45:56.286" v="9685"/>
          <ac:spMkLst>
            <pc:docMk/>
            <pc:sldMk cId="1394747819" sldId="303"/>
            <ac:spMk id="67" creationId="{C42FDB3E-5FF4-4713-BDC2-0BBD88A65425}"/>
          </ac:spMkLst>
        </pc:spChg>
        <pc:spChg chg="mod">
          <ac:chgData name="Manasweeta Angane" userId="05da2731-9352-4b35-b713-60351f56afbd" providerId="ADAL" clId="{F5F97842-A295-4F9F-B89B-A63B35E1C32D}" dt="2022-10-18T01:45:56.286" v="9685"/>
          <ac:spMkLst>
            <pc:docMk/>
            <pc:sldMk cId="1394747819" sldId="303"/>
            <ac:spMk id="68" creationId="{5968AB2D-ECB2-4765-972A-8F57AF26D054}"/>
          </ac:spMkLst>
        </pc:spChg>
        <pc:spChg chg="mod">
          <ac:chgData name="Manasweeta Angane" userId="05da2731-9352-4b35-b713-60351f56afbd" providerId="ADAL" clId="{F5F97842-A295-4F9F-B89B-A63B35E1C32D}" dt="2022-10-18T01:46:17.067" v="9689"/>
          <ac:spMkLst>
            <pc:docMk/>
            <pc:sldMk cId="1394747819" sldId="303"/>
            <ac:spMk id="74" creationId="{DE4244B1-DD8E-4B96-8B9A-871A4B2ADC6C}"/>
          </ac:spMkLst>
        </pc:spChg>
        <pc:spChg chg="mod">
          <ac:chgData name="Manasweeta Angane" userId="05da2731-9352-4b35-b713-60351f56afbd" providerId="ADAL" clId="{F5F97842-A295-4F9F-B89B-A63B35E1C32D}" dt="2022-10-18T01:46:17.067" v="9689"/>
          <ac:spMkLst>
            <pc:docMk/>
            <pc:sldMk cId="1394747819" sldId="303"/>
            <ac:spMk id="75" creationId="{89185546-8FDA-4413-B95B-D6BFFA45CAA7}"/>
          </ac:spMkLst>
        </pc:spChg>
        <pc:spChg chg="add del mod">
          <ac:chgData name="Manasweeta Angane" userId="05da2731-9352-4b35-b713-60351f56afbd" providerId="ADAL" clId="{F5F97842-A295-4F9F-B89B-A63B35E1C32D}" dt="2022-10-22T01:44:18.047" v="16513" actId="478"/>
          <ac:spMkLst>
            <pc:docMk/>
            <pc:sldMk cId="1394747819" sldId="303"/>
            <ac:spMk id="76" creationId="{7B9F6238-F909-4AFC-BEB6-96DAEB733D2D}"/>
          </ac:spMkLst>
        </pc:spChg>
        <pc:spChg chg="add mod">
          <ac:chgData name="Manasweeta Angane" userId="05da2731-9352-4b35-b713-60351f56afbd" providerId="ADAL" clId="{F5F97842-A295-4F9F-B89B-A63B35E1C32D}" dt="2022-10-18T01:46:27.349" v="9692"/>
          <ac:spMkLst>
            <pc:docMk/>
            <pc:sldMk cId="1394747819" sldId="303"/>
            <ac:spMk id="76" creationId="{D6B491E3-285D-4A79-80D3-F7D9C026CE2E}"/>
          </ac:spMkLst>
        </pc:spChg>
        <pc:spChg chg="mod">
          <ac:chgData name="Manasweeta Angane" userId="05da2731-9352-4b35-b713-60351f56afbd" providerId="ADAL" clId="{F5F97842-A295-4F9F-B89B-A63B35E1C32D}" dt="2022-10-18T01:46:30.521" v="9693"/>
          <ac:spMkLst>
            <pc:docMk/>
            <pc:sldMk cId="1394747819" sldId="303"/>
            <ac:spMk id="82" creationId="{E02045A6-8F23-40CD-BC3D-97653A1E38BA}"/>
          </ac:spMkLst>
        </pc:spChg>
        <pc:spChg chg="mod">
          <ac:chgData name="Manasweeta Angane" userId="05da2731-9352-4b35-b713-60351f56afbd" providerId="ADAL" clId="{F5F97842-A295-4F9F-B89B-A63B35E1C32D}" dt="2022-10-18T01:46:30.521" v="9693"/>
          <ac:spMkLst>
            <pc:docMk/>
            <pc:sldMk cId="1394747819" sldId="303"/>
            <ac:spMk id="83" creationId="{B0B9A121-0C42-41B1-8359-EAE058B23F92}"/>
          </ac:spMkLst>
        </pc:spChg>
        <pc:spChg chg="add mod">
          <ac:chgData name="Manasweeta Angane" userId="05da2731-9352-4b35-b713-60351f56afbd" providerId="ADAL" clId="{F5F97842-A295-4F9F-B89B-A63B35E1C32D}" dt="2022-10-22T01:40:57.990" v="16389" actId="20577"/>
          <ac:spMkLst>
            <pc:docMk/>
            <pc:sldMk cId="1394747819" sldId="303"/>
            <ac:spMk id="91" creationId="{3AA06A77-7EA8-422A-867B-642AA957F4D4}"/>
          </ac:spMkLst>
        </pc:spChg>
        <pc:spChg chg="add mod">
          <ac:chgData name="Manasweeta Angane" userId="05da2731-9352-4b35-b713-60351f56afbd" providerId="ADAL" clId="{F5F97842-A295-4F9F-B89B-A63B35E1C32D}" dt="2022-10-22T01:20:10.583" v="16212" actId="20577"/>
          <ac:spMkLst>
            <pc:docMk/>
            <pc:sldMk cId="1394747819" sldId="303"/>
            <ac:spMk id="92" creationId="{FE9F49C4-2ECF-47A1-B861-7CF619CBB0B8}"/>
          </ac:spMkLst>
        </pc:spChg>
        <pc:spChg chg="add mod">
          <ac:chgData name="Manasweeta Angane" userId="05da2731-9352-4b35-b713-60351f56afbd" providerId="ADAL" clId="{F5F97842-A295-4F9F-B89B-A63B35E1C32D}" dt="2022-10-22T01:22:03.504" v="16356" actId="12789"/>
          <ac:spMkLst>
            <pc:docMk/>
            <pc:sldMk cId="1394747819" sldId="303"/>
            <ac:spMk id="93" creationId="{B9C079EC-682B-458C-925D-BE993C48FA31}"/>
          </ac:spMkLst>
        </pc:spChg>
        <pc:spChg chg="add mod">
          <ac:chgData name="Manasweeta Angane" userId="05da2731-9352-4b35-b713-60351f56afbd" providerId="ADAL" clId="{F5F97842-A295-4F9F-B89B-A63B35E1C32D}" dt="2022-10-22T01:43:58.897" v="16512" actId="20577"/>
          <ac:spMkLst>
            <pc:docMk/>
            <pc:sldMk cId="1394747819" sldId="303"/>
            <ac:spMk id="94" creationId="{5A70E324-BC03-4D60-A243-66779526C2B5}"/>
          </ac:spMkLst>
        </pc:spChg>
        <pc:grpChg chg="del">
          <ac:chgData name="Manasweeta Angane" userId="05da2731-9352-4b35-b713-60351f56afbd" providerId="ADAL" clId="{F5F97842-A295-4F9F-B89B-A63B35E1C32D}" dt="2022-10-17T23:01:33.816" v="8645" actId="478"/>
          <ac:grpSpMkLst>
            <pc:docMk/>
            <pc:sldMk cId="1394747819" sldId="303"/>
            <ac:grpSpMk id="4" creationId="{3F0E3FD0-07DB-4674-861B-D61E237388B2}"/>
          </ac:grpSpMkLst>
        </pc:grpChg>
        <pc:grpChg chg="add del mod">
          <ac:chgData name="Manasweeta Angane" userId="05da2731-9352-4b35-b713-60351f56afbd" providerId="ADAL" clId="{F5F97842-A295-4F9F-B89B-A63B35E1C32D}" dt="2022-10-17T22:36:04.156" v="7455" actId="165"/>
          <ac:grpSpMkLst>
            <pc:docMk/>
            <pc:sldMk cId="1394747819" sldId="303"/>
            <ac:grpSpMk id="13" creationId="{50AA4810-2181-4B7E-AB06-39583D39920D}"/>
          </ac:grpSpMkLst>
        </pc:grpChg>
        <pc:grpChg chg="add mod">
          <ac:chgData name="Manasweeta Angane" userId="05da2731-9352-4b35-b713-60351f56afbd" providerId="ADAL" clId="{F5F97842-A295-4F9F-B89B-A63B35E1C32D}" dt="2022-10-18T00:59:21.297" v="9199" actId="164"/>
          <ac:grpSpMkLst>
            <pc:docMk/>
            <pc:sldMk cId="1394747819" sldId="303"/>
            <ac:grpSpMk id="29" creationId="{20E784B4-5902-4A6A-A20E-050F2F053104}"/>
          </ac:grpSpMkLst>
        </pc:grpChg>
        <pc:grpChg chg="add del mod">
          <ac:chgData name="Manasweeta Angane" userId="05da2731-9352-4b35-b713-60351f56afbd" providerId="ADAL" clId="{F5F97842-A295-4F9F-B89B-A63B35E1C32D}" dt="2022-10-18T01:03:04.580" v="9288" actId="165"/>
          <ac:grpSpMkLst>
            <pc:docMk/>
            <pc:sldMk cId="1394747819" sldId="303"/>
            <ac:grpSpMk id="30" creationId="{E93F7A12-CC2A-44C8-9C57-2F8BE8DF7A28}"/>
          </ac:grpSpMkLst>
        </pc:grpChg>
        <pc:grpChg chg="add del mod">
          <ac:chgData name="Manasweeta Angane" userId="05da2731-9352-4b35-b713-60351f56afbd" providerId="ADAL" clId="{F5F97842-A295-4F9F-B89B-A63B35E1C32D}" dt="2022-10-18T01:05:21.894" v="9299" actId="165"/>
          <ac:grpSpMkLst>
            <pc:docMk/>
            <pc:sldMk cId="1394747819" sldId="303"/>
            <ac:grpSpMk id="31" creationId="{35D7F0E7-4806-4891-BC6E-D02F4A0B2217}"/>
          </ac:grpSpMkLst>
        </pc:grpChg>
        <pc:grpChg chg="add mod ord">
          <ac:chgData name="Manasweeta Angane" userId="05da2731-9352-4b35-b713-60351f56afbd" providerId="ADAL" clId="{F5F97842-A295-4F9F-B89B-A63B35E1C32D}" dt="2022-10-18T01:53:13.779" v="9833" actId="164"/>
          <ac:grpSpMkLst>
            <pc:docMk/>
            <pc:sldMk cId="1394747819" sldId="303"/>
            <ac:grpSpMk id="32" creationId="{29632932-A2CF-45B4-9C56-400358BF561A}"/>
          </ac:grpSpMkLst>
        </pc:grpChg>
        <pc:grpChg chg="add del mod">
          <ac:chgData name="Manasweeta Angane" userId="05da2731-9352-4b35-b713-60351f56afbd" providerId="ADAL" clId="{F5F97842-A295-4F9F-B89B-A63B35E1C32D}" dt="2022-10-18T01:09:01.036" v="9320" actId="165"/>
          <ac:grpSpMkLst>
            <pc:docMk/>
            <pc:sldMk cId="1394747819" sldId="303"/>
            <ac:grpSpMk id="34" creationId="{C80ACD14-BFA5-4C83-9B07-8853E4DF9AD3}"/>
          </ac:grpSpMkLst>
        </pc:grpChg>
        <pc:grpChg chg="add del mod">
          <ac:chgData name="Manasweeta Angane" userId="05da2731-9352-4b35-b713-60351f56afbd" providerId="ADAL" clId="{F5F97842-A295-4F9F-B89B-A63B35E1C32D}" dt="2022-10-18T01:10:18.958" v="9324" actId="165"/>
          <ac:grpSpMkLst>
            <pc:docMk/>
            <pc:sldMk cId="1394747819" sldId="303"/>
            <ac:grpSpMk id="37" creationId="{2A26253F-28FD-4AF3-8485-77675FB8DC49}"/>
          </ac:grpSpMkLst>
        </pc:grpChg>
        <pc:grpChg chg="add del mod">
          <ac:chgData name="Manasweeta Angane" userId="05da2731-9352-4b35-b713-60351f56afbd" providerId="ADAL" clId="{F5F97842-A295-4F9F-B89B-A63B35E1C32D}" dt="2022-10-18T01:10:23.349" v="9325" actId="165"/>
          <ac:grpSpMkLst>
            <pc:docMk/>
            <pc:sldMk cId="1394747819" sldId="303"/>
            <ac:grpSpMk id="40" creationId="{F72A9C79-753F-4D58-8AEA-35D2598CFDD0}"/>
          </ac:grpSpMkLst>
        </pc:grpChg>
        <pc:grpChg chg="add mod ord">
          <ac:chgData name="Manasweeta Angane" userId="05da2731-9352-4b35-b713-60351f56afbd" providerId="ADAL" clId="{F5F97842-A295-4F9F-B89B-A63B35E1C32D}" dt="2022-10-18T01:53:33.830" v="9851" actId="164"/>
          <ac:grpSpMkLst>
            <pc:docMk/>
            <pc:sldMk cId="1394747819" sldId="303"/>
            <ac:grpSpMk id="43" creationId="{C31B24D9-EB5E-4562-B726-4BEB6078B465}"/>
          </ac:grpSpMkLst>
        </pc:grpChg>
        <pc:grpChg chg="add mod ord">
          <ac:chgData name="Manasweeta Angane" userId="05da2731-9352-4b35-b713-60351f56afbd" providerId="ADAL" clId="{F5F97842-A295-4F9F-B89B-A63B35E1C32D}" dt="2022-10-18T01:53:42.086" v="9852" actId="164"/>
          <ac:grpSpMkLst>
            <pc:docMk/>
            <pc:sldMk cId="1394747819" sldId="303"/>
            <ac:grpSpMk id="44" creationId="{FB40D4E7-7D41-41D1-9401-1D8685B78760}"/>
          </ac:grpSpMkLst>
        </pc:grpChg>
        <pc:grpChg chg="add mod ord">
          <ac:chgData name="Manasweeta Angane" userId="05da2731-9352-4b35-b713-60351f56afbd" providerId="ADAL" clId="{F5F97842-A295-4F9F-B89B-A63B35E1C32D}" dt="2022-10-18T01:53:48.305" v="9853" actId="164"/>
          <ac:grpSpMkLst>
            <pc:docMk/>
            <pc:sldMk cId="1394747819" sldId="303"/>
            <ac:grpSpMk id="45" creationId="{62FD6F63-A248-4614-BB9D-F63C54000909}"/>
          </ac:grpSpMkLst>
        </pc:grpChg>
        <pc:grpChg chg="add mod">
          <ac:chgData name="Manasweeta Angane" userId="05da2731-9352-4b35-b713-60351f56afbd" providerId="ADAL" clId="{F5F97842-A295-4F9F-B89B-A63B35E1C32D}" dt="2022-10-18T01:45:50.920" v="9684" actId="164"/>
          <ac:grpSpMkLst>
            <pc:docMk/>
            <pc:sldMk cId="1394747819" sldId="303"/>
            <ac:grpSpMk id="55" creationId="{CA22F28F-AC0C-4897-ABF5-685125998B02}"/>
          </ac:grpSpMkLst>
        </pc:grpChg>
        <pc:grpChg chg="add mod">
          <ac:chgData name="Manasweeta Angane" userId="05da2731-9352-4b35-b713-60351f56afbd" providerId="ADAL" clId="{F5F97842-A295-4F9F-B89B-A63B35E1C32D}" dt="2022-10-18T01:42:55.678" v="9568" actId="164"/>
          <ac:grpSpMkLst>
            <pc:docMk/>
            <pc:sldMk cId="1394747819" sldId="303"/>
            <ac:grpSpMk id="56" creationId="{72E8E594-DD99-469F-B38C-F0C5EF3953C5}"/>
          </ac:grpSpMkLst>
        </pc:grpChg>
        <pc:grpChg chg="add mod">
          <ac:chgData name="Manasweeta Angane" userId="05da2731-9352-4b35-b713-60351f56afbd" providerId="ADAL" clId="{F5F97842-A295-4F9F-B89B-A63B35E1C32D}" dt="2022-10-18T01:45:50.920" v="9684" actId="164"/>
          <ac:grpSpMkLst>
            <pc:docMk/>
            <pc:sldMk cId="1394747819" sldId="303"/>
            <ac:grpSpMk id="60" creationId="{953A7DC6-A029-4A2D-B88A-487A5D3F64E3}"/>
          </ac:grpSpMkLst>
        </pc:grpChg>
        <pc:grpChg chg="add mod">
          <ac:chgData name="Manasweeta Angane" userId="05da2731-9352-4b35-b713-60351f56afbd" providerId="ADAL" clId="{F5F97842-A295-4F9F-B89B-A63B35E1C32D}" dt="2022-10-18T01:53:13.779" v="9833" actId="164"/>
          <ac:grpSpMkLst>
            <pc:docMk/>
            <pc:sldMk cId="1394747819" sldId="303"/>
            <ac:grpSpMk id="61" creationId="{1550358C-EE61-4727-86A7-FB3E5F0F3F8C}"/>
          </ac:grpSpMkLst>
        </pc:grpChg>
        <pc:grpChg chg="add mod ord">
          <ac:chgData name="Manasweeta Angane" userId="05da2731-9352-4b35-b713-60351f56afbd" providerId="ADAL" clId="{F5F97842-A295-4F9F-B89B-A63B35E1C32D}" dt="2022-10-18T01:53:33.830" v="9851" actId="164"/>
          <ac:grpSpMkLst>
            <pc:docMk/>
            <pc:sldMk cId="1394747819" sldId="303"/>
            <ac:grpSpMk id="62" creationId="{68C3A921-E6DB-47E4-B0FB-4C2E8F7C1843}"/>
          </ac:grpSpMkLst>
        </pc:grpChg>
        <pc:grpChg chg="mod">
          <ac:chgData name="Manasweeta Angane" userId="05da2731-9352-4b35-b713-60351f56afbd" providerId="ADAL" clId="{F5F97842-A295-4F9F-B89B-A63B35E1C32D}" dt="2022-10-18T01:45:56.286" v="9685"/>
          <ac:grpSpMkLst>
            <pc:docMk/>
            <pc:sldMk cId="1394747819" sldId="303"/>
            <ac:grpSpMk id="63" creationId="{18EDCF70-119E-4CCE-BFBB-5CCC2C06011C}"/>
          </ac:grpSpMkLst>
        </pc:grpChg>
        <pc:grpChg chg="mod">
          <ac:chgData name="Manasweeta Angane" userId="05da2731-9352-4b35-b713-60351f56afbd" providerId="ADAL" clId="{F5F97842-A295-4F9F-B89B-A63B35E1C32D}" dt="2022-10-18T01:45:56.286" v="9685"/>
          <ac:grpSpMkLst>
            <pc:docMk/>
            <pc:sldMk cId="1394747819" sldId="303"/>
            <ac:grpSpMk id="64" creationId="{F4FE9CDF-DA0F-428D-AD6B-4A101D89A58B}"/>
          </ac:grpSpMkLst>
        </pc:grpChg>
        <pc:grpChg chg="add mod">
          <ac:chgData name="Manasweeta Angane" userId="05da2731-9352-4b35-b713-60351f56afbd" providerId="ADAL" clId="{F5F97842-A295-4F9F-B89B-A63B35E1C32D}" dt="2022-10-18T01:53:42.086" v="9852" actId="164"/>
          <ac:grpSpMkLst>
            <pc:docMk/>
            <pc:sldMk cId="1394747819" sldId="303"/>
            <ac:grpSpMk id="69" creationId="{EFF836B7-F4E7-49C3-90A7-EF3B610AEB5F}"/>
          </ac:grpSpMkLst>
        </pc:grpChg>
        <pc:grpChg chg="mod">
          <ac:chgData name="Manasweeta Angane" userId="05da2731-9352-4b35-b713-60351f56afbd" providerId="ADAL" clId="{F5F97842-A295-4F9F-B89B-A63B35E1C32D}" dt="2022-10-18T01:46:17.067" v="9689"/>
          <ac:grpSpMkLst>
            <pc:docMk/>
            <pc:sldMk cId="1394747819" sldId="303"/>
            <ac:grpSpMk id="70" creationId="{4649A4E8-012D-4EFD-8D6A-F6A3100A5864}"/>
          </ac:grpSpMkLst>
        </pc:grpChg>
        <pc:grpChg chg="mod">
          <ac:chgData name="Manasweeta Angane" userId="05da2731-9352-4b35-b713-60351f56afbd" providerId="ADAL" clId="{F5F97842-A295-4F9F-B89B-A63B35E1C32D}" dt="2022-10-18T01:46:17.067" v="9689"/>
          <ac:grpSpMkLst>
            <pc:docMk/>
            <pc:sldMk cId="1394747819" sldId="303"/>
            <ac:grpSpMk id="71" creationId="{3D16B941-A618-4C7A-96EF-69FB94A231A0}"/>
          </ac:grpSpMkLst>
        </pc:grpChg>
        <pc:grpChg chg="add mod ord">
          <ac:chgData name="Manasweeta Angane" userId="05da2731-9352-4b35-b713-60351f56afbd" providerId="ADAL" clId="{F5F97842-A295-4F9F-B89B-A63B35E1C32D}" dt="2022-10-18T01:53:48.305" v="9853" actId="164"/>
          <ac:grpSpMkLst>
            <pc:docMk/>
            <pc:sldMk cId="1394747819" sldId="303"/>
            <ac:grpSpMk id="77" creationId="{62350C52-BB63-4376-89D2-149C85F75206}"/>
          </ac:grpSpMkLst>
        </pc:grpChg>
        <pc:grpChg chg="mod">
          <ac:chgData name="Manasweeta Angane" userId="05da2731-9352-4b35-b713-60351f56afbd" providerId="ADAL" clId="{F5F97842-A295-4F9F-B89B-A63B35E1C32D}" dt="2022-10-18T01:46:30.521" v="9693"/>
          <ac:grpSpMkLst>
            <pc:docMk/>
            <pc:sldMk cId="1394747819" sldId="303"/>
            <ac:grpSpMk id="78" creationId="{77841151-7F77-4812-9131-E596DC6A82C9}"/>
          </ac:grpSpMkLst>
        </pc:grpChg>
        <pc:grpChg chg="mod">
          <ac:chgData name="Manasweeta Angane" userId="05da2731-9352-4b35-b713-60351f56afbd" providerId="ADAL" clId="{F5F97842-A295-4F9F-B89B-A63B35E1C32D}" dt="2022-10-18T01:46:30.521" v="9693"/>
          <ac:grpSpMkLst>
            <pc:docMk/>
            <pc:sldMk cId="1394747819" sldId="303"/>
            <ac:grpSpMk id="79" creationId="{08FD7A75-94F2-496E-96E1-DC5F16D74CE8}"/>
          </ac:grpSpMkLst>
        </pc:grpChg>
        <pc:grpChg chg="add mod">
          <ac:chgData name="Manasweeta Angane" userId="05da2731-9352-4b35-b713-60351f56afbd" providerId="ADAL" clId="{F5F97842-A295-4F9F-B89B-A63B35E1C32D}" dt="2022-10-18T01:59:12.729" v="9923" actId="164"/>
          <ac:grpSpMkLst>
            <pc:docMk/>
            <pc:sldMk cId="1394747819" sldId="303"/>
            <ac:grpSpMk id="87" creationId="{7F76D2DB-051B-42EF-8F12-190F0D8DB817}"/>
          </ac:grpSpMkLst>
        </pc:grpChg>
        <pc:grpChg chg="add mod">
          <ac:chgData name="Manasweeta Angane" userId="05da2731-9352-4b35-b713-60351f56afbd" providerId="ADAL" clId="{F5F97842-A295-4F9F-B89B-A63B35E1C32D}" dt="2022-10-18T01:59:15.901" v="9924" actId="164"/>
          <ac:grpSpMkLst>
            <pc:docMk/>
            <pc:sldMk cId="1394747819" sldId="303"/>
            <ac:grpSpMk id="88" creationId="{F1037B36-8C2E-4770-8B4A-8AC21ED2FCEA}"/>
          </ac:grpSpMkLst>
        </pc:grpChg>
        <pc:grpChg chg="add mod">
          <ac:chgData name="Manasweeta Angane" userId="05da2731-9352-4b35-b713-60351f56afbd" providerId="ADAL" clId="{F5F97842-A295-4F9F-B89B-A63B35E1C32D}" dt="2022-10-18T01:59:20.352" v="9925" actId="164"/>
          <ac:grpSpMkLst>
            <pc:docMk/>
            <pc:sldMk cId="1394747819" sldId="303"/>
            <ac:grpSpMk id="89" creationId="{ECCDE155-07BF-44CD-8F73-E900F3DCE98D}"/>
          </ac:grpSpMkLst>
        </pc:grpChg>
        <pc:grpChg chg="add mod">
          <ac:chgData name="Manasweeta Angane" userId="05da2731-9352-4b35-b713-60351f56afbd" providerId="ADAL" clId="{F5F97842-A295-4F9F-B89B-A63B35E1C32D}" dt="2022-10-18T01:59:23.414" v="9926" actId="164"/>
          <ac:grpSpMkLst>
            <pc:docMk/>
            <pc:sldMk cId="1394747819" sldId="303"/>
            <ac:grpSpMk id="90" creationId="{09D40FD7-8051-410B-B849-47036388B35D}"/>
          </ac:grpSpMkLst>
        </pc:grpChg>
        <pc:grpChg chg="add mod">
          <ac:chgData name="Manasweeta Angane" userId="05da2731-9352-4b35-b713-60351f56afbd" providerId="ADAL" clId="{F5F97842-A295-4F9F-B89B-A63B35E1C32D}" dt="2022-10-18T04:17:52.749" v="10225" actId="1037"/>
          <ac:grpSpMkLst>
            <pc:docMk/>
            <pc:sldMk cId="1394747819" sldId="303"/>
            <ac:grpSpMk id="95" creationId="{170F5844-57A9-4643-8486-36CC7248870B}"/>
          </ac:grpSpMkLst>
        </pc:grpChg>
        <pc:grpChg chg="add mod">
          <ac:chgData name="Manasweeta Angane" userId="05da2731-9352-4b35-b713-60351f56afbd" providerId="ADAL" clId="{F5F97842-A295-4F9F-B89B-A63B35E1C32D}" dt="2022-10-18T01:59:15.901" v="9924" actId="164"/>
          <ac:grpSpMkLst>
            <pc:docMk/>
            <pc:sldMk cId="1394747819" sldId="303"/>
            <ac:grpSpMk id="96" creationId="{254E0212-4E30-47AC-87AB-A1FB76432441}"/>
          </ac:grpSpMkLst>
        </pc:grpChg>
        <pc:grpChg chg="add mod">
          <ac:chgData name="Manasweeta Angane" userId="05da2731-9352-4b35-b713-60351f56afbd" providerId="ADAL" clId="{F5F97842-A295-4F9F-B89B-A63B35E1C32D}" dt="2022-10-18T04:18:56.368" v="10257" actId="1038"/>
          <ac:grpSpMkLst>
            <pc:docMk/>
            <pc:sldMk cId="1394747819" sldId="303"/>
            <ac:grpSpMk id="97" creationId="{378AA917-CAEB-404F-9430-E57746960404}"/>
          </ac:grpSpMkLst>
        </pc:grpChg>
        <pc:grpChg chg="add mod">
          <ac:chgData name="Manasweeta Angane" userId="05da2731-9352-4b35-b713-60351f56afbd" providerId="ADAL" clId="{F5F97842-A295-4F9F-B89B-A63B35E1C32D}" dt="2022-10-18T04:19:56.068" v="10300" actId="1038"/>
          <ac:grpSpMkLst>
            <pc:docMk/>
            <pc:sldMk cId="1394747819" sldId="303"/>
            <ac:grpSpMk id="98" creationId="{784A794A-EB72-4CDA-8B0D-7BC56C11B4F6}"/>
          </ac:grpSpMkLst>
        </pc:grpChg>
        <pc:cxnChg chg="add mod ord">
          <ac:chgData name="Manasweeta Angane" userId="05da2731-9352-4b35-b713-60351f56afbd" providerId="ADAL" clId="{F5F97842-A295-4F9F-B89B-A63B35E1C32D}" dt="2022-10-18T01:53:13.779" v="9833" actId="164"/>
          <ac:cxnSpMkLst>
            <pc:docMk/>
            <pc:sldMk cId="1394747819" sldId="303"/>
            <ac:cxnSpMk id="47" creationId="{5107A219-0735-4C29-8CA6-2DDC1B4D3EC5}"/>
          </ac:cxnSpMkLst>
        </pc:cxnChg>
        <pc:cxnChg chg="add mod">
          <ac:chgData name="Manasweeta Angane" userId="05da2731-9352-4b35-b713-60351f56afbd" providerId="ADAL" clId="{F5F97842-A295-4F9F-B89B-A63B35E1C32D}" dt="2022-10-18T01:45:43.056" v="9683" actId="164"/>
          <ac:cxnSpMkLst>
            <pc:docMk/>
            <pc:sldMk cId="1394747819" sldId="303"/>
            <ac:cxnSpMk id="58" creationId="{5D6E26C4-86D9-4254-AA98-28E378BF55B6}"/>
          </ac:cxnSpMkLst>
        </pc:cxnChg>
        <pc:cxnChg chg="add mod">
          <ac:chgData name="Manasweeta Angane" userId="05da2731-9352-4b35-b713-60351f56afbd" providerId="ADAL" clId="{F5F97842-A295-4F9F-B89B-A63B35E1C32D}" dt="2022-10-18T01:45:43.056" v="9683" actId="164"/>
          <ac:cxnSpMkLst>
            <pc:docMk/>
            <pc:sldMk cId="1394747819" sldId="303"/>
            <ac:cxnSpMk id="59" creationId="{7DAFF243-9864-418F-9ED5-FAE1D57AE542}"/>
          </ac:cxnSpMkLst>
        </pc:cxnChg>
        <pc:cxnChg chg="mod">
          <ac:chgData name="Manasweeta Angane" userId="05da2731-9352-4b35-b713-60351f56afbd" providerId="ADAL" clId="{F5F97842-A295-4F9F-B89B-A63B35E1C32D}" dt="2022-10-18T01:45:56.286" v="9685"/>
          <ac:cxnSpMkLst>
            <pc:docMk/>
            <pc:sldMk cId="1394747819" sldId="303"/>
            <ac:cxnSpMk id="65" creationId="{8A3C13BB-06F3-4577-86DC-D21419FA9E9A}"/>
          </ac:cxnSpMkLst>
        </pc:cxnChg>
        <pc:cxnChg chg="mod">
          <ac:chgData name="Manasweeta Angane" userId="05da2731-9352-4b35-b713-60351f56afbd" providerId="ADAL" clId="{F5F97842-A295-4F9F-B89B-A63B35E1C32D}" dt="2022-10-18T01:45:56.286" v="9685"/>
          <ac:cxnSpMkLst>
            <pc:docMk/>
            <pc:sldMk cId="1394747819" sldId="303"/>
            <ac:cxnSpMk id="66" creationId="{F940B093-2BD2-4995-8A9E-139DE982991A}"/>
          </ac:cxnSpMkLst>
        </pc:cxnChg>
        <pc:cxnChg chg="mod">
          <ac:chgData name="Manasweeta Angane" userId="05da2731-9352-4b35-b713-60351f56afbd" providerId="ADAL" clId="{F5F97842-A295-4F9F-B89B-A63B35E1C32D}" dt="2022-10-18T01:46:17.067" v="9689"/>
          <ac:cxnSpMkLst>
            <pc:docMk/>
            <pc:sldMk cId="1394747819" sldId="303"/>
            <ac:cxnSpMk id="72" creationId="{2D556214-3F89-4037-892D-625DA000E70C}"/>
          </ac:cxnSpMkLst>
        </pc:cxnChg>
        <pc:cxnChg chg="mod">
          <ac:chgData name="Manasweeta Angane" userId="05da2731-9352-4b35-b713-60351f56afbd" providerId="ADAL" clId="{F5F97842-A295-4F9F-B89B-A63B35E1C32D}" dt="2022-10-18T01:46:17.067" v="9689"/>
          <ac:cxnSpMkLst>
            <pc:docMk/>
            <pc:sldMk cId="1394747819" sldId="303"/>
            <ac:cxnSpMk id="73" creationId="{D30A4083-701A-4A87-99C4-61241B6AB760}"/>
          </ac:cxnSpMkLst>
        </pc:cxnChg>
        <pc:cxnChg chg="mod">
          <ac:chgData name="Manasweeta Angane" userId="05da2731-9352-4b35-b713-60351f56afbd" providerId="ADAL" clId="{F5F97842-A295-4F9F-B89B-A63B35E1C32D}" dt="2022-10-18T01:46:30.521" v="9693"/>
          <ac:cxnSpMkLst>
            <pc:docMk/>
            <pc:sldMk cId="1394747819" sldId="303"/>
            <ac:cxnSpMk id="80" creationId="{91F1A7DE-7215-49CC-9F6C-6980BC35098D}"/>
          </ac:cxnSpMkLst>
        </pc:cxnChg>
        <pc:cxnChg chg="mod">
          <ac:chgData name="Manasweeta Angane" userId="05da2731-9352-4b35-b713-60351f56afbd" providerId="ADAL" clId="{F5F97842-A295-4F9F-B89B-A63B35E1C32D}" dt="2022-10-18T01:46:30.521" v="9693"/>
          <ac:cxnSpMkLst>
            <pc:docMk/>
            <pc:sldMk cId="1394747819" sldId="303"/>
            <ac:cxnSpMk id="81" creationId="{78CA6329-DB4C-468D-8933-AA4B6DBA9618}"/>
          </ac:cxnSpMkLst>
        </pc:cxnChg>
        <pc:cxnChg chg="add mod">
          <ac:chgData name="Manasweeta Angane" userId="05da2731-9352-4b35-b713-60351f56afbd" providerId="ADAL" clId="{F5F97842-A295-4F9F-B89B-A63B35E1C32D}" dt="2022-10-18T01:53:33.830" v="9851" actId="164"/>
          <ac:cxnSpMkLst>
            <pc:docMk/>
            <pc:sldMk cId="1394747819" sldId="303"/>
            <ac:cxnSpMk id="84" creationId="{4A15EFA7-54DA-44FF-863D-130913E363ED}"/>
          </ac:cxnSpMkLst>
        </pc:cxnChg>
        <pc:cxnChg chg="add mod ord">
          <ac:chgData name="Manasweeta Angane" userId="05da2731-9352-4b35-b713-60351f56afbd" providerId="ADAL" clId="{F5F97842-A295-4F9F-B89B-A63B35E1C32D}" dt="2022-10-18T01:53:42.086" v="9852" actId="164"/>
          <ac:cxnSpMkLst>
            <pc:docMk/>
            <pc:sldMk cId="1394747819" sldId="303"/>
            <ac:cxnSpMk id="85" creationId="{65574628-BCD9-4AA1-AC7D-E38356E0DE23}"/>
          </ac:cxnSpMkLst>
        </pc:cxnChg>
        <pc:cxnChg chg="add mod">
          <ac:chgData name="Manasweeta Angane" userId="05da2731-9352-4b35-b713-60351f56afbd" providerId="ADAL" clId="{F5F97842-A295-4F9F-B89B-A63B35E1C32D}" dt="2022-10-18T01:53:48.305" v="9853" actId="164"/>
          <ac:cxnSpMkLst>
            <pc:docMk/>
            <pc:sldMk cId="1394747819" sldId="303"/>
            <ac:cxnSpMk id="86" creationId="{E307610C-8DE6-4E3D-9CD7-61DE2491C9F2}"/>
          </ac:cxnSpMkLst>
        </pc:cxnChg>
      </pc:sldChg>
      <pc:sldChg chg="addSp delSp modSp add mod addAnim delAnim modAnim">
        <pc:chgData name="Manasweeta Angane" userId="05da2731-9352-4b35-b713-60351f56afbd" providerId="ADAL" clId="{F5F97842-A295-4F9F-B89B-A63B35E1C32D}" dt="2022-10-19T09:04:41.784" v="11627" actId="1036"/>
        <pc:sldMkLst>
          <pc:docMk/>
          <pc:sldMk cId="411859700" sldId="304"/>
        </pc:sldMkLst>
        <pc:spChg chg="add mod">
          <ac:chgData name="Manasweeta Angane" userId="05da2731-9352-4b35-b713-60351f56afbd" providerId="ADAL" clId="{F5F97842-A295-4F9F-B89B-A63B35E1C32D}" dt="2022-10-19T09:01:21.406" v="11583"/>
          <ac:spMkLst>
            <pc:docMk/>
            <pc:sldMk cId="411859700" sldId="304"/>
            <ac:spMk id="11" creationId="{7ED0C65C-86DC-437F-A7EA-47F139F8FB67}"/>
          </ac:spMkLst>
        </pc:spChg>
        <pc:spChg chg="add mod">
          <ac:chgData name="Manasweeta Angane" userId="05da2731-9352-4b35-b713-60351f56afbd" providerId="ADAL" clId="{F5F97842-A295-4F9F-B89B-A63B35E1C32D}" dt="2022-10-19T09:01:21.406" v="11583"/>
          <ac:spMkLst>
            <pc:docMk/>
            <pc:sldMk cId="411859700" sldId="304"/>
            <ac:spMk id="12" creationId="{94B81056-5E32-40C3-996A-9BF7C942299E}"/>
          </ac:spMkLst>
        </pc:spChg>
        <pc:spChg chg="add del mod">
          <ac:chgData name="Manasweeta Angane" userId="05da2731-9352-4b35-b713-60351f56afbd" providerId="ADAL" clId="{F5F97842-A295-4F9F-B89B-A63B35E1C32D}" dt="2022-10-19T09:02:07.987" v="11594" actId="207"/>
          <ac:spMkLst>
            <pc:docMk/>
            <pc:sldMk cId="411859700" sldId="304"/>
            <ac:spMk id="13" creationId="{34DDEC2E-DD78-4281-83B4-A34119ACDCB9}"/>
          </ac:spMkLst>
        </pc:spChg>
        <pc:spChg chg="add del mod">
          <ac:chgData name="Manasweeta Angane" userId="05da2731-9352-4b35-b713-60351f56afbd" providerId="ADAL" clId="{F5F97842-A295-4F9F-B89B-A63B35E1C32D}" dt="2022-10-19T09:02:14.018" v="11595" actId="207"/>
          <ac:spMkLst>
            <pc:docMk/>
            <pc:sldMk cId="411859700" sldId="304"/>
            <ac:spMk id="14" creationId="{EEB3E611-6FC9-4E2F-8FAA-1880ABA4BC34}"/>
          </ac:spMkLst>
        </pc:spChg>
        <pc:spChg chg="add del mod">
          <ac:chgData name="Manasweeta Angane" userId="05da2731-9352-4b35-b713-60351f56afbd" providerId="ADAL" clId="{F5F97842-A295-4F9F-B89B-A63B35E1C32D}" dt="2022-10-19T09:02:26.730" v="11597" actId="207"/>
          <ac:spMkLst>
            <pc:docMk/>
            <pc:sldMk cId="411859700" sldId="304"/>
            <ac:spMk id="15" creationId="{8D15FE56-5597-4065-B004-BC50611EC35A}"/>
          </ac:spMkLst>
        </pc:spChg>
        <pc:spChg chg="add del mod">
          <ac:chgData name="Manasweeta Angane" userId="05da2731-9352-4b35-b713-60351f56afbd" providerId="ADAL" clId="{F5F97842-A295-4F9F-B89B-A63B35E1C32D}" dt="2022-10-19T09:02:20.701" v="11596" actId="207"/>
          <ac:spMkLst>
            <pc:docMk/>
            <pc:sldMk cId="411859700" sldId="304"/>
            <ac:spMk id="16" creationId="{4D163F17-1AA4-4262-BE89-92C3EEC4A78F}"/>
          </ac:spMkLst>
        </pc:spChg>
        <pc:spChg chg="del">
          <ac:chgData name="Manasweeta Angane" userId="05da2731-9352-4b35-b713-60351f56afbd" providerId="ADAL" clId="{F5F97842-A295-4F9F-B89B-A63B35E1C32D}" dt="2022-10-19T09:01:20.137" v="11582" actId="478"/>
          <ac:spMkLst>
            <pc:docMk/>
            <pc:sldMk cId="411859700" sldId="304"/>
            <ac:spMk id="17" creationId="{8DB771DF-C627-44BB-8716-44C80EF9D83F}"/>
          </ac:spMkLst>
        </pc:spChg>
        <pc:spChg chg="mod">
          <ac:chgData name="Manasweeta Angane" userId="05da2731-9352-4b35-b713-60351f56afbd" providerId="ADAL" clId="{F5F97842-A295-4F9F-B89B-A63B35E1C32D}" dt="2022-10-10T13:42:33.230" v="4528" actId="20577"/>
          <ac:spMkLst>
            <pc:docMk/>
            <pc:sldMk cId="411859700" sldId="304"/>
            <ac:spMk id="18" creationId="{45F2BEED-A6BE-45AE-BED7-62E52E5E5868}"/>
          </ac:spMkLst>
        </pc:spChg>
        <pc:spChg chg="add mod">
          <ac:chgData name="Manasweeta Angane" userId="05da2731-9352-4b35-b713-60351f56afbd" providerId="ADAL" clId="{F5F97842-A295-4F9F-B89B-A63B35E1C32D}" dt="2022-10-19T09:01:21.406" v="11583"/>
          <ac:spMkLst>
            <pc:docMk/>
            <pc:sldMk cId="411859700" sldId="304"/>
            <ac:spMk id="19" creationId="{B437DCF9-46AB-44BC-83F7-ED1690F7C6DC}"/>
          </ac:spMkLst>
        </pc:spChg>
        <pc:spChg chg="add mod">
          <ac:chgData name="Manasweeta Angane" userId="05da2731-9352-4b35-b713-60351f56afbd" providerId="ADAL" clId="{F5F97842-A295-4F9F-B89B-A63B35E1C32D}" dt="2022-10-19T09:01:21.406" v="11583"/>
          <ac:spMkLst>
            <pc:docMk/>
            <pc:sldMk cId="411859700" sldId="304"/>
            <ac:spMk id="20" creationId="{E4CB7FC0-CBE8-48D5-B4BD-647B669C882F}"/>
          </ac:spMkLst>
        </pc:spChg>
        <pc:spChg chg="add del mod">
          <ac:chgData name="Manasweeta Angane" userId="05da2731-9352-4b35-b713-60351f56afbd" providerId="ADAL" clId="{F5F97842-A295-4F9F-B89B-A63B35E1C32D}" dt="2022-10-19T09:02:29.920" v="11598" actId="207"/>
          <ac:spMkLst>
            <pc:docMk/>
            <pc:sldMk cId="411859700" sldId="304"/>
            <ac:spMk id="21" creationId="{6516AE9C-3A7A-4E6D-8CD1-A0E7C22D0BCA}"/>
          </ac:spMkLst>
        </pc:spChg>
        <pc:spChg chg="add mod">
          <ac:chgData name="Manasweeta Angane" userId="05da2731-9352-4b35-b713-60351f56afbd" providerId="ADAL" clId="{F5F97842-A295-4F9F-B89B-A63B35E1C32D}" dt="2022-10-19T09:04:41.784" v="11627" actId="1036"/>
          <ac:spMkLst>
            <pc:docMk/>
            <pc:sldMk cId="411859700" sldId="304"/>
            <ac:spMk id="22" creationId="{95A00C29-D505-4801-8E56-EBA805E69D86}"/>
          </ac:spMkLst>
        </pc:spChg>
      </pc:sldChg>
      <pc:sldChg chg="addSp delSp modSp add mod ord">
        <pc:chgData name="Manasweeta Angane" userId="05da2731-9352-4b35-b713-60351f56afbd" providerId="ADAL" clId="{F5F97842-A295-4F9F-B89B-A63B35E1C32D}" dt="2022-10-10T13:44:44.575" v="4655"/>
        <pc:sldMkLst>
          <pc:docMk/>
          <pc:sldMk cId="2938349037" sldId="305"/>
        </pc:sldMkLst>
        <pc:spChg chg="mod">
          <ac:chgData name="Manasweeta Angane" userId="05da2731-9352-4b35-b713-60351f56afbd" providerId="ADAL" clId="{F5F97842-A295-4F9F-B89B-A63B35E1C32D}" dt="2022-10-10T13:43:16.668" v="4549"/>
          <ac:spMkLst>
            <pc:docMk/>
            <pc:sldMk cId="2938349037" sldId="305"/>
            <ac:spMk id="15" creationId="{00461A2A-6FFC-4CBA-94FD-42D24CFF0EBC}"/>
          </ac:spMkLst>
        </pc:spChg>
        <pc:spChg chg="mod">
          <ac:chgData name="Manasweeta Angane" userId="05da2731-9352-4b35-b713-60351f56afbd" providerId="ADAL" clId="{F5F97842-A295-4F9F-B89B-A63B35E1C32D}" dt="2022-10-10T13:43:16.668" v="4549"/>
          <ac:spMkLst>
            <pc:docMk/>
            <pc:sldMk cId="2938349037" sldId="305"/>
            <ac:spMk id="16" creationId="{F4FF8A92-6359-41D8-9427-3D0F8FD3647B}"/>
          </ac:spMkLst>
        </pc:spChg>
        <pc:spChg chg="del">
          <ac:chgData name="Manasweeta Angane" userId="05da2731-9352-4b35-b713-60351f56afbd" providerId="ADAL" clId="{F5F97842-A295-4F9F-B89B-A63B35E1C32D}" dt="2022-10-10T13:43:15.372" v="4548" actId="478"/>
          <ac:spMkLst>
            <pc:docMk/>
            <pc:sldMk cId="2938349037" sldId="305"/>
            <ac:spMk id="17" creationId="{8DB771DF-C627-44BB-8716-44C80EF9D83F}"/>
          </ac:spMkLst>
        </pc:spChg>
        <pc:spChg chg="mod">
          <ac:chgData name="Manasweeta Angane" userId="05da2731-9352-4b35-b713-60351f56afbd" providerId="ADAL" clId="{F5F97842-A295-4F9F-B89B-A63B35E1C32D}" dt="2022-10-10T13:42:53.715" v="4547" actId="20577"/>
          <ac:spMkLst>
            <pc:docMk/>
            <pc:sldMk cId="2938349037" sldId="305"/>
            <ac:spMk id="18" creationId="{45F2BEED-A6BE-45AE-BED7-62E52E5E5868}"/>
          </ac:spMkLst>
        </pc:spChg>
        <pc:spChg chg="mod">
          <ac:chgData name="Manasweeta Angane" userId="05da2731-9352-4b35-b713-60351f56afbd" providerId="ADAL" clId="{F5F97842-A295-4F9F-B89B-A63B35E1C32D}" dt="2022-10-10T13:43:16.668" v="4549"/>
          <ac:spMkLst>
            <pc:docMk/>
            <pc:sldMk cId="2938349037" sldId="305"/>
            <ac:spMk id="19" creationId="{19097E1C-007D-46C9-9CD1-E603B9CD2ECD}"/>
          </ac:spMkLst>
        </pc:spChg>
        <pc:spChg chg="mod">
          <ac:chgData name="Manasweeta Angane" userId="05da2731-9352-4b35-b713-60351f56afbd" providerId="ADAL" clId="{F5F97842-A295-4F9F-B89B-A63B35E1C32D}" dt="2022-10-10T13:43:16.668" v="4549"/>
          <ac:spMkLst>
            <pc:docMk/>
            <pc:sldMk cId="2938349037" sldId="305"/>
            <ac:spMk id="21" creationId="{3612463E-6D76-44D3-A53E-1ADDC2EA4D0C}"/>
          </ac:spMkLst>
        </pc:spChg>
        <pc:spChg chg="mod">
          <ac:chgData name="Manasweeta Angane" userId="05da2731-9352-4b35-b713-60351f56afbd" providerId="ADAL" clId="{F5F97842-A295-4F9F-B89B-A63B35E1C32D}" dt="2022-10-10T13:44:26.887" v="4652" actId="1035"/>
          <ac:spMkLst>
            <pc:docMk/>
            <pc:sldMk cId="2938349037" sldId="305"/>
            <ac:spMk id="24" creationId="{02A0C572-6D3B-47E5-AF52-B490BB7FC0EF}"/>
          </ac:spMkLst>
        </pc:spChg>
        <pc:grpChg chg="add mod">
          <ac:chgData name="Manasweeta Angane" userId="05da2731-9352-4b35-b713-60351f56afbd" providerId="ADAL" clId="{F5F97842-A295-4F9F-B89B-A63B35E1C32D}" dt="2022-10-10T13:43:44.841" v="4596" actId="1036"/>
          <ac:grpSpMkLst>
            <pc:docMk/>
            <pc:sldMk cId="2938349037" sldId="305"/>
            <ac:grpSpMk id="11" creationId="{75C28389-F916-4A47-A22A-B57A898691AF}"/>
          </ac:grpSpMkLst>
        </pc:grpChg>
        <pc:grpChg chg="add mod">
          <ac:chgData name="Manasweeta Angane" userId="05da2731-9352-4b35-b713-60351f56afbd" providerId="ADAL" clId="{F5F97842-A295-4F9F-B89B-A63B35E1C32D}" dt="2022-10-10T13:44:26.887" v="4652" actId="1035"/>
          <ac:grpSpMkLst>
            <pc:docMk/>
            <pc:sldMk cId="2938349037" sldId="305"/>
            <ac:grpSpMk id="22" creationId="{0444CFF7-7840-40B4-B146-77EFBCDD57F3}"/>
          </ac:grpSpMkLst>
        </pc:grpChg>
        <pc:picChg chg="mod">
          <ac:chgData name="Manasweeta Angane" userId="05da2731-9352-4b35-b713-60351f56afbd" providerId="ADAL" clId="{F5F97842-A295-4F9F-B89B-A63B35E1C32D}" dt="2022-10-10T13:43:16.668" v="4549"/>
          <ac:picMkLst>
            <pc:docMk/>
            <pc:sldMk cId="2938349037" sldId="305"/>
            <ac:picMk id="12" creationId="{0DE17B83-F01E-4A3F-86C1-06559D3A076C}"/>
          </ac:picMkLst>
        </pc:picChg>
        <pc:picChg chg="mod">
          <ac:chgData name="Manasweeta Angane" userId="05da2731-9352-4b35-b713-60351f56afbd" providerId="ADAL" clId="{F5F97842-A295-4F9F-B89B-A63B35E1C32D}" dt="2022-10-10T13:43:16.668" v="4549"/>
          <ac:picMkLst>
            <pc:docMk/>
            <pc:sldMk cId="2938349037" sldId="305"/>
            <ac:picMk id="13" creationId="{A38D61B3-F525-4FE2-80B9-7A4474CB7A60}"/>
          </ac:picMkLst>
        </pc:picChg>
        <pc:picChg chg="mod">
          <ac:chgData name="Manasweeta Angane" userId="05da2731-9352-4b35-b713-60351f56afbd" providerId="ADAL" clId="{F5F97842-A295-4F9F-B89B-A63B35E1C32D}" dt="2022-10-10T13:43:33.074" v="4553" actId="1035"/>
          <ac:picMkLst>
            <pc:docMk/>
            <pc:sldMk cId="2938349037" sldId="305"/>
            <ac:picMk id="14" creationId="{8B1A5605-77FE-48FE-A48F-62E676D172CF}"/>
          </ac:picMkLst>
        </pc:picChg>
        <pc:picChg chg="mod">
          <ac:chgData name="Manasweeta Angane" userId="05da2731-9352-4b35-b713-60351f56afbd" providerId="ADAL" clId="{F5F97842-A295-4F9F-B89B-A63B35E1C32D}" dt="2022-10-10T13:43:16.668" v="4549"/>
          <ac:picMkLst>
            <pc:docMk/>
            <pc:sldMk cId="2938349037" sldId="305"/>
            <ac:picMk id="20" creationId="{3BBA10E8-E4CC-4499-ADB5-078BC85C0D55}"/>
          </ac:picMkLst>
        </pc:picChg>
        <pc:picChg chg="mod">
          <ac:chgData name="Manasweeta Angane" userId="05da2731-9352-4b35-b713-60351f56afbd" providerId="ADAL" clId="{F5F97842-A295-4F9F-B89B-A63B35E1C32D}" dt="2022-10-10T13:44:26.887" v="4652" actId="1035"/>
          <ac:picMkLst>
            <pc:docMk/>
            <pc:sldMk cId="2938349037" sldId="305"/>
            <ac:picMk id="23" creationId="{1E03B1BD-B9FA-45EA-9620-A258B948BB11}"/>
          </ac:picMkLst>
        </pc:picChg>
      </pc:sldChg>
      <pc:sldChg chg="delSp modSp add del mod">
        <pc:chgData name="Manasweeta Angane" userId="05da2731-9352-4b35-b713-60351f56afbd" providerId="ADAL" clId="{F5F97842-A295-4F9F-B89B-A63B35E1C32D}" dt="2022-10-22T07:02:03.504" v="20936" actId="2696"/>
        <pc:sldMkLst>
          <pc:docMk/>
          <pc:sldMk cId="1814822090" sldId="306"/>
        </pc:sldMkLst>
        <pc:spChg chg="del">
          <ac:chgData name="Manasweeta Angane" userId="05da2731-9352-4b35-b713-60351f56afbd" providerId="ADAL" clId="{F5F97842-A295-4F9F-B89B-A63B35E1C32D}" dt="2022-10-10T13:44:55.059" v="4656" actId="478"/>
          <ac:spMkLst>
            <pc:docMk/>
            <pc:sldMk cId="1814822090" sldId="306"/>
            <ac:spMk id="17" creationId="{8DB771DF-C627-44BB-8716-44C80EF9D83F}"/>
          </ac:spMkLst>
        </pc:spChg>
        <pc:spChg chg="mod">
          <ac:chgData name="Manasweeta Angane" userId="05da2731-9352-4b35-b713-60351f56afbd" providerId="ADAL" clId="{F5F97842-A295-4F9F-B89B-A63B35E1C32D}" dt="2022-10-11T09:31:00.519" v="6134" actId="12789"/>
          <ac:spMkLst>
            <pc:docMk/>
            <pc:sldMk cId="1814822090" sldId="306"/>
            <ac:spMk id="18" creationId="{45F2BEED-A6BE-45AE-BED7-62E52E5E5868}"/>
          </ac:spMkLst>
        </pc:spChg>
      </pc:sldChg>
      <pc:sldChg chg="add del">
        <pc:chgData name="Manasweeta Angane" userId="05da2731-9352-4b35-b713-60351f56afbd" providerId="ADAL" clId="{F5F97842-A295-4F9F-B89B-A63B35E1C32D}" dt="2022-10-11T00:56:08.691" v="5332"/>
        <pc:sldMkLst>
          <pc:docMk/>
          <pc:sldMk cId="2805890609" sldId="307"/>
        </pc:sldMkLst>
      </pc:sldChg>
      <pc:sldChg chg="modSp mod">
        <pc:chgData name="Manasweeta Angane" userId="05da2731-9352-4b35-b713-60351f56afbd" providerId="ADAL" clId="{F5F97842-A295-4F9F-B89B-A63B35E1C32D}" dt="2022-10-18T09:32:22.125" v="10636" actId="20577"/>
        <pc:sldMkLst>
          <pc:docMk/>
          <pc:sldMk cId="2867490092" sldId="307"/>
        </pc:sldMkLst>
        <pc:spChg chg="mod">
          <ac:chgData name="Manasweeta Angane" userId="05da2731-9352-4b35-b713-60351f56afbd" providerId="ADAL" clId="{F5F97842-A295-4F9F-B89B-A63B35E1C32D}" dt="2022-10-18T09:32:22.125" v="10636" actId="20577"/>
          <ac:spMkLst>
            <pc:docMk/>
            <pc:sldMk cId="2867490092" sldId="307"/>
            <ac:spMk id="8" creationId="{00000000-0000-0000-0000-000000000000}"/>
          </ac:spMkLst>
        </pc:spChg>
      </pc:sldChg>
      <pc:sldChg chg="modSp add mod ord">
        <pc:chgData name="Manasweeta Angane" userId="05da2731-9352-4b35-b713-60351f56afbd" providerId="ADAL" clId="{F5F97842-A295-4F9F-B89B-A63B35E1C32D}" dt="2022-10-19T08:56:46.824" v="11549" actId="1036"/>
        <pc:sldMkLst>
          <pc:docMk/>
          <pc:sldMk cId="1466805410" sldId="308"/>
        </pc:sldMkLst>
        <pc:picChg chg="mod">
          <ac:chgData name="Manasweeta Angane" userId="05da2731-9352-4b35-b713-60351f56afbd" providerId="ADAL" clId="{F5F97842-A295-4F9F-B89B-A63B35E1C32D}" dt="2022-10-19T08:56:46.824" v="11549" actId="1036"/>
          <ac:picMkLst>
            <pc:docMk/>
            <pc:sldMk cId="1466805410" sldId="308"/>
            <ac:picMk id="7" creationId="{9E2AA60C-DA9D-4292-ACA3-8E38856A32BA}"/>
          </ac:picMkLst>
        </pc:picChg>
      </pc:sldChg>
      <pc:sldChg chg="addSp modSp add mod">
        <pc:chgData name="Manasweeta Angane" userId="05da2731-9352-4b35-b713-60351f56afbd" providerId="ADAL" clId="{F5F97842-A295-4F9F-B89B-A63B35E1C32D}" dt="2022-10-19T08:58:12.696" v="11581" actId="1038"/>
        <pc:sldMkLst>
          <pc:docMk/>
          <pc:sldMk cId="2017596650" sldId="309"/>
        </pc:sldMkLst>
        <pc:picChg chg="add mod">
          <ac:chgData name="Manasweeta Angane" userId="05da2731-9352-4b35-b713-60351f56afbd" providerId="ADAL" clId="{F5F97842-A295-4F9F-B89B-A63B35E1C32D}" dt="2022-10-19T08:58:12.696" v="11581" actId="1038"/>
          <ac:picMkLst>
            <pc:docMk/>
            <pc:sldMk cId="2017596650" sldId="309"/>
            <ac:picMk id="7" creationId="{3C3F3E6B-FF3A-41D8-81B9-7557BDD1EC39}"/>
          </ac:picMkLst>
        </pc:picChg>
      </pc:sldChg>
      <pc:sldChg chg="addSp delSp modSp add mod modAnim">
        <pc:chgData name="Manasweeta Angane" userId="05da2731-9352-4b35-b713-60351f56afbd" providerId="ADAL" clId="{F5F97842-A295-4F9F-B89B-A63B35E1C32D}" dt="2022-10-24T12:08:24.250" v="20977" actId="108"/>
        <pc:sldMkLst>
          <pc:docMk/>
          <pc:sldMk cId="2034698016" sldId="310"/>
        </pc:sldMkLst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5" creationId="{D6EA4027-C091-4519-B09D-E78F24FE1D11}"/>
          </ac:spMkLst>
        </pc:spChg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6" creationId="{68BA112F-D749-47CD-8196-F14D98D7DC83}"/>
          </ac:spMkLst>
        </pc:spChg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7" creationId="{D4016A87-96B5-4034-8E84-06B9C380A90B}"/>
          </ac:spMkLst>
        </pc:spChg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8" creationId="{6EAADF73-D41D-4D2D-8C30-FFCBCB826CD2}"/>
          </ac:spMkLst>
        </pc:spChg>
        <pc:spChg chg="del">
          <ac:chgData name="Manasweeta Angane" userId="05da2731-9352-4b35-b713-60351f56afbd" providerId="ADAL" clId="{F5F97842-A295-4F9F-B89B-A63B35E1C32D}" dt="2022-10-21T03:32:37.493" v="12074" actId="478"/>
          <ac:spMkLst>
            <pc:docMk/>
            <pc:sldMk cId="2034698016" sldId="310"/>
            <ac:spMk id="14" creationId="{0AA85FB1-2E66-4D23-B5C3-EB99AE50DB9F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5" creationId="{8FE60339-47C4-4D13-B217-97456347BB7F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6" creationId="{A5E09AF3-23DB-4F10-AB28-44C109205750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7" creationId="{206ADDDC-F977-4041-99C8-3E0839168A83}"/>
          </ac:spMkLst>
        </pc:spChg>
        <pc:spChg chg="mod">
          <ac:chgData name="Manasweeta Angane" userId="05da2731-9352-4b35-b713-60351f56afbd" providerId="ADAL" clId="{F5F97842-A295-4F9F-B89B-A63B35E1C32D}" dt="2022-10-21T08:44:34.703" v="14281" actId="255"/>
          <ac:spMkLst>
            <pc:docMk/>
            <pc:sldMk cId="2034698016" sldId="310"/>
            <ac:spMk id="18" creationId="{45F2BEED-A6BE-45AE-BED7-62E52E5E5868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9" creationId="{82256C46-03FF-4C90-9ECB-F2CA627205F7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20" creationId="{2B02ADE2-6F3B-4BE6-BDD0-895493E32A12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21" creationId="{9BEA9372-8149-4E23-878C-CD771F6BF6EB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22" creationId="{B4354B35-D7CB-4C69-8EED-25C25ED9AC6C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23" creationId="{6D92757D-4164-4D3E-9742-990BB7FD1E5C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24" creationId="{6767438C-E028-4EBE-9388-BCA3DCB6F247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25" creationId="{BF76D543-D635-4948-B232-E7EE847A948C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26" creationId="{E6DAD37E-ACE1-4B99-AD82-E28A90E78531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27" creationId="{77D21E0B-03B3-4FF1-A0B1-F9164FC5EB51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28" creationId="{A41D5AE9-2011-4085-96E3-A1680173978A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29" creationId="{EDC1320F-7038-4B1C-8844-A702BB8482B6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30" creationId="{4DD1EE51-43B8-4EF2-A97C-13CAB47F736D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31" creationId="{E0D5885E-1C73-4228-8C0A-492F3656C1A7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32" creationId="{D8EB9CEE-3656-4B9D-A8F8-0FEC7DF3BAE2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33" creationId="{2148F5EA-5885-4682-9803-E19BFF3D3D42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34" creationId="{C20D171C-F164-40DD-9364-BFD603264BF3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35" creationId="{824DF1A9-6EEE-41D2-A34F-F1D67FA5C524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36" creationId="{AB299F1B-501C-489B-ABAC-48669BFB6067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37" creationId="{83020353-2146-4553-A3AA-30ECDEC2F28F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38" creationId="{ABB6159B-9138-42EF-AA62-7B9054481C82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39" creationId="{8E723700-6BA1-43FC-96DC-9F9ABEF7CF32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40" creationId="{A454E29F-F0A3-431B-AB40-70DE3CEC32F1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41" creationId="{604AFEC3-75DD-4AB7-ACD0-700873923E7C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42" creationId="{ED5BC769-D18C-469C-90B1-6B9600DBDB03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43" creationId="{32918BB4-BA4B-4F1D-B7EB-3E22EBA41EFF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44" creationId="{E0F6CF0F-7E86-4883-87CE-78E3743B4A1F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45" creationId="{8BEAAEEC-6719-4913-B24D-AFA33DE82547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46" creationId="{443E3A56-8274-49C0-996B-971950F47C51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47" creationId="{251B59F4-C63B-4CF2-A7C0-2A6416D1AE6F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48" creationId="{81223C22-9C64-478F-B7A0-B8D87845F619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49" creationId="{697D99C3-F70E-481A-BE14-29E0C2CCE053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50" creationId="{33CA7308-0173-4D37-BF38-E767052C6FD6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51" creationId="{28493FEE-8024-4C70-8346-9514D00C1D41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52" creationId="{8E997E09-F82D-429E-A722-A0285844D7BA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53" creationId="{2733FC66-592A-4E87-BEC9-D7CF7A3BFD03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54" creationId="{7B0E968E-6D9C-4669-AE3A-39FA461DCC9B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55" creationId="{80A15FD3-6C3C-4B76-A401-B6542605D668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56" creationId="{261C0D37-5BF5-4814-8522-4AD11E83FA0C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57" creationId="{D539D2FF-D71A-4752-BAA7-956FCED53683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58" creationId="{9FEDB1CB-5007-45BE-B94A-3FC05FE892D7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59" creationId="{55A12B99-FE03-4E34-B648-E0F15BCA0AE4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60" creationId="{7F83C3A6-4909-4F4D-BF5C-C85A44594DB8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61" creationId="{B0E18F91-0194-45D5-B15A-3067938E29F7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62" creationId="{337E38C6-8BC9-4434-9DA0-E5C6E1DFC36F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63" creationId="{07290B78-3421-42C4-81A6-7AFD982E5233}"/>
          </ac:spMkLst>
        </pc:spChg>
        <pc:spChg chg="add mod">
          <ac:chgData name="Manasweeta Angane" userId="05da2731-9352-4b35-b713-60351f56afbd" providerId="ADAL" clId="{F5F97842-A295-4F9F-B89B-A63B35E1C32D}" dt="2022-10-24T12:08:24.250" v="20977" actId="108"/>
          <ac:spMkLst>
            <pc:docMk/>
            <pc:sldMk cId="2034698016" sldId="310"/>
            <ac:spMk id="78" creationId="{A4233CF2-CF4E-40DB-952B-F71388A2FBA8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11" creationId="{0CF0D076-8653-4602-9A91-9CA70B5D7B2C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12" creationId="{AE2CAFD6-574A-4749-8B28-80D84B7F426F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13" creationId="{C3419D71-94E6-4658-96E3-3827CBA3C560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14" creationId="{63473D05-6FDD-45C8-9927-A9D0DFB753D6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15" creationId="{DD09DB81-D31F-481A-969D-3E02C6BFAA65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16" creationId="{02C2117A-5ED9-427B-863F-FD4AC0DCBF0A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17" creationId="{AD46F40B-0AE7-47C9-9F6B-BBB75F6FB6F2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18" creationId="{1728C4A5-2CD8-446A-8661-20FC9D9D8DA8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19" creationId="{2C76B7E9-E237-471C-BD53-42C15FD923DC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20" creationId="{0D8C7E99-FD72-4515-B6FD-10A53E146AEF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21" creationId="{7D624E20-0EB2-41E3-8DDD-7EC683B90390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22" creationId="{75131A34-CDB5-45C3-8CCB-36CF3263DD16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23" creationId="{5D4AF2AD-8BC6-4174-9A9D-B86F5733F781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24" creationId="{6CB7C2B2-DCE5-4B89-80E7-9D9E7722106A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25" creationId="{A271B557-D86B-443C-AB7C-845302FEBD8F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26" creationId="{FA3AD18B-F16E-486E-A56C-466A732CA5C8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27" creationId="{A78FB849-E923-4C10-9064-99E30B51C222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28" creationId="{44A15986-1991-4984-A96F-A98E6B3B23D5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29" creationId="{93203FDF-DFB6-4C66-BE83-FE8BC1ADEAE7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30" creationId="{282F0D7B-5641-43C8-B36A-66B602AF29B0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31" creationId="{165D5F8A-32AA-4150-8D93-E3C2B5AE3C5E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32" creationId="{B9D66AC3-2876-40D2-9868-862CE44964A9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33" creationId="{6C4762E6-3772-445B-A480-BE8E8D5B2622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34" creationId="{44E290D4-4893-47EF-8727-6C3D3E54A67F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35" creationId="{E0E1BAA5-556F-40FE-9A82-04F15801BAB4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36" creationId="{B87EA3A6-A94E-4FD3-839D-D0EB3ED9B893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37" creationId="{1658F915-5635-43A1-A136-E8EC204642A1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38" creationId="{5E60DF2B-ADB0-4CB2-A961-312C53772CBC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39" creationId="{BEF923FD-B175-4397-BD4F-38B2E2F7E34B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40" creationId="{05DDE9E5-B2EC-4ACB-B85A-D6823F8008D5}"/>
          </ac:spMkLst>
        </pc:spChg>
        <pc:spChg chg="mod">
          <ac:chgData name="Manasweeta Angane" userId="05da2731-9352-4b35-b713-60351f56afbd" providerId="ADAL" clId="{F5F97842-A295-4F9F-B89B-A63B35E1C32D}" dt="2022-10-21T03:42:03.405" v="12104"/>
          <ac:spMkLst>
            <pc:docMk/>
            <pc:sldMk cId="2034698016" sldId="310"/>
            <ac:spMk id="141" creationId="{8ED3E5D8-4F1F-4849-82B6-8986BCE6AD95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43" creationId="{6C0DDD82-D04E-44AB-AADF-4140928C45D2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44" creationId="{C6044383-2F62-44B4-BA71-CF8E40DB8F39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45" creationId="{C2A99BB9-68E8-4D6A-BDB8-DEB39F2DE85D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46" creationId="{78FEE5B1-A842-4ABA-873C-84ED77AD8F69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47" creationId="{0B0CC176-2031-49CB-AE28-1BDAEB60B77D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48" creationId="{7317F20F-9338-4563-A9ED-3E24A9633AB9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49" creationId="{DEC446B1-5E20-458C-AEA3-20676C79522B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50" creationId="{6A22AA7E-4FD8-4612-B642-E652A7085420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51" creationId="{5DC8F76C-C225-4C31-8F4E-9C0E61CBEB89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52" creationId="{FF717575-58FF-4C20-8067-C231CBBF6253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53" creationId="{F74EA559-D8F6-42FE-9537-B73EF96079E0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54" creationId="{0D250C9C-586A-48BF-A745-4A8CEFAB90B8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55" creationId="{9546C92F-E475-46EC-8FAA-47D746862F02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56" creationId="{69A2EECE-9F46-45F2-9B6C-4F3A41DF6277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57" creationId="{D4B86109-BDA8-4E85-B121-30C89972E78D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58" creationId="{6EAF1368-7597-46D3-BF3F-6B33A33487FF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59" creationId="{2B65E597-F173-4534-BCF7-D0F681E5BAE9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60" creationId="{72EFC0FF-2484-4E95-BE2B-05BA4BF748F9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61" creationId="{451454E0-8196-49DF-AF91-B4AF4CB972D5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62" creationId="{E4F0E056-3B65-414F-9F44-9DC6EE9BB2A5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63" creationId="{BEF244AB-76E8-42ED-8628-61BCF8F9EDE1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64" creationId="{E74242B4-D627-4039-ABEC-9C9AE92E6451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65" creationId="{CCF903F3-5489-474A-A67D-40C24474419C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66" creationId="{1206E83B-5B94-404A-87AE-33F783C01678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67" creationId="{1FDEE572-F647-4037-B307-725D38BB6598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68" creationId="{E83D5F90-94DF-41B4-B8D6-5B6389D3E73B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69" creationId="{F5AEC232-9090-4C77-909F-61561610B68A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70" creationId="{2A46B8CF-7C10-45B7-9814-6DB6B6D1AA2F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71" creationId="{5FD4B2CB-C3F3-4E15-AEB9-6C1A31C62A8E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72" creationId="{F249B5A9-F8D1-407F-8358-3B52DA33EA48}"/>
          </ac:spMkLst>
        </pc:spChg>
        <pc:spChg chg="mod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73" creationId="{5736ACC1-D637-4EC6-AEAA-7C99E353D9B2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10" creationId="{DB0A13EC-4943-4960-A018-C70FC036FCE2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11" creationId="{D74D78CF-D9B4-4DA9-B5DE-7C808F983AC6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12" creationId="{5CCBEB7C-19F4-4D4D-8C72-DE1FBD0541F4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13" creationId="{1BF581E4-D96D-4ED7-B405-7903F7D7B213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14" creationId="{A0294BEB-ADEE-481B-905C-143B9E60BB89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15" creationId="{48E1DA8C-AA0F-4FC9-A036-7A7069EAEC69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16" creationId="{27CBA07E-E413-48F7-A984-75B4B50F705C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17" creationId="{F24C6EB9-8122-4C12-AC2B-AAB29EBF6851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18" creationId="{2D924EF2-6C75-412A-8A4F-A25CB6A9B1E7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19" creationId="{6567BABC-78FF-4806-BCE5-C0061D64F6BA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20" creationId="{E3CB5600-9826-40DD-A1B3-FEF98434AEAC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21" creationId="{064F2F51-00DC-4ABE-9638-26B42B378F26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22" creationId="{C20966EB-105E-4A31-918D-083643686B95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23" creationId="{68967CD3-0571-4267-A966-A2ECB88B6DE1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24" creationId="{82C56146-1893-4471-9C58-3998AA42CDAF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25" creationId="{84D86068-1B33-461C-82FF-3B4036FB595B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26" creationId="{15EB5179-F1B1-4C9B-9620-560CAC3B5B57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27" creationId="{A276C189-F0BC-4025-B084-B0C71B44E8D7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28" creationId="{BA1459EF-90DE-4B05-9FC2-76474433B8AC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29" creationId="{319DE510-2CF8-4FA5-B359-51E3EB70B9B8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30" creationId="{2C899532-4B10-4550-9CA7-7C624698CD9C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31" creationId="{C38C5FCC-4514-469F-87E0-2613286FF733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32" creationId="{40766956-6368-4120-9F40-5CD078D91AAB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33" creationId="{5FD0CF54-D4F4-450B-B251-007193A2D8E3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34" creationId="{2C8EC0FC-678A-4853-9DA7-A55953FACAA5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35" creationId="{B1CCD31A-DF14-4DA1-96D4-009D046FAF95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36" creationId="{8EDF0E44-F051-477A-84F4-F0DFEFB73D52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37" creationId="{F4687DC3-A949-40C5-A255-47B7D3357CC5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38" creationId="{B9E816B7-A696-4143-9BA1-C5B7CF52FB70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39" creationId="{1CFDFD2A-E667-4712-B33C-714C0FBEACF0}"/>
          </ac:spMkLst>
        </pc:spChg>
        <pc:spChg chg="mod">
          <ac:chgData name="Manasweeta Angane" userId="05da2731-9352-4b35-b713-60351f56afbd" providerId="ADAL" clId="{F5F97842-A295-4F9F-B89B-A63B35E1C32D}" dt="2022-10-21T04:23:27.546" v="12832" actId="165"/>
          <ac:spMkLst>
            <pc:docMk/>
            <pc:sldMk cId="2034698016" sldId="310"/>
            <ac:spMk id="240" creationId="{C61E0B8C-45FB-458B-ABF1-6E4A42A0AAD5}"/>
          </ac:spMkLst>
        </pc:spChg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242" creationId="{DDC0E755-34C4-4E90-B0D4-2372E5AC7BD9}"/>
          </ac:spMkLst>
        </pc:spChg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243" creationId="{1172C0DC-70B1-4020-B2C7-8480B258597C}"/>
          </ac:spMkLst>
        </pc:spChg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245" creationId="{DC4265B6-3637-4935-8D15-1B561CDA6525}"/>
          </ac:spMkLst>
        </pc:spChg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246" creationId="{281D4A99-F0E1-44EF-BA77-FE1DB7868226}"/>
          </ac:spMkLst>
        </pc:spChg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247" creationId="{42466F89-2498-44C1-9D8B-FAC56EE08A44}"/>
          </ac:spMkLst>
        </pc:spChg>
        <pc:spChg chg="add mod topLvl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248" creationId="{35CDBE6C-DB91-4344-AA5A-FB39101864EA}"/>
          </ac:spMkLst>
        </pc:spChg>
        <pc:spChg chg="add mod topLvl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249" creationId="{139AB0CB-0D3E-41BE-A542-ED7E0B7D915C}"/>
          </ac:spMkLst>
        </pc:spChg>
        <pc:spChg chg="add mod topLvl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250" creationId="{B7ECD312-1882-4CE6-8AF8-F6B12714807F}"/>
          </ac:spMkLst>
        </pc:spChg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251" creationId="{E3841FE9-DE3C-413C-94C7-56FD8D912678}"/>
          </ac:spMkLst>
        </pc:spChg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252" creationId="{82DF5D6D-1A03-496F-84A3-39F6ED45C898}"/>
          </ac:spMkLst>
        </pc:spChg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253" creationId="{67C556AA-71C9-45B2-9363-864C19F670DE}"/>
          </ac:spMkLst>
        </pc:spChg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254" creationId="{F58AF449-36C0-490F-BDCD-05780DB49FA0}"/>
          </ac:spMkLst>
        </pc:spChg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255" creationId="{A852FF63-FDAF-4497-A6F9-FE804031A445}"/>
          </ac:spMkLst>
        </pc:spChg>
        <pc:spChg chg="add mod">
          <ac:chgData name="Manasweeta Angane" userId="05da2731-9352-4b35-b713-60351f56afbd" providerId="ADAL" clId="{F5F97842-A295-4F9F-B89B-A63B35E1C32D}" dt="2022-10-21T07:08:40.396" v="13585" actId="164"/>
          <ac:spMkLst>
            <pc:docMk/>
            <pc:sldMk cId="2034698016" sldId="310"/>
            <ac:spMk id="473" creationId="{566BAA24-2DA6-48D9-9E17-C695F9C7CD02}"/>
          </ac:spMkLst>
        </pc:spChg>
        <pc:spChg chg="add mod">
          <ac:chgData name="Manasweeta Angane" userId="05da2731-9352-4b35-b713-60351f56afbd" providerId="ADAL" clId="{F5F97842-A295-4F9F-B89B-A63B35E1C32D}" dt="2022-10-21T07:08:40.396" v="13585" actId="164"/>
          <ac:spMkLst>
            <pc:docMk/>
            <pc:sldMk cId="2034698016" sldId="310"/>
            <ac:spMk id="474" creationId="{5A349D89-1715-4F05-BDEC-D02AED0DDE6A}"/>
          </ac:spMkLst>
        </pc:spChg>
        <pc:spChg chg="add mod topLvl">
          <ac:chgData name="Manasweeta Angane" userId="05da2731-9352-4b35-b713-60351f56afbd" providerId="ADAL" clId="{F5F97842-A295-4F9F-B89B-A63B35E1C32D}" dt="2022-10-21T09:47:42.251" v="15353" actId="1036"/>
          <ac:spMkLst>
            <pc:docMk/>
            <pc:sldMk cId="2034698016" sldId="310"/>
            <ac:spMk id="475" creationId="{025D039D-3EE2-44F2-BB2C-9DEC5C8532A6}"/>
          </ac:spMkLst>
        </pc:spChg>
        <pc:spChg chg="add mod">
          <ac:chgData name="Manasweeta Angane" userId="05da2731-9352-4b35-b713-60351f56afbd" providerId="ADAL" clId="{F5F97842-A295-4F9F-B89B-A63B35E1C32D}" dt="2022-10-21T08:45:49.281" v="14299" actId="1037"/>
          <ac:spMkLst>
            <pc:docMk/>
            <pc:sldMk cId="2034698016" sldId="310"/>
            <ac:spMk id="477" creationId="{76900971-055B-4F3D-AFD6-B26DD9DF2496}"/>
          </ac:spMkLst>
        </pc:spChg>
        <pc:spChg chg="add mod">
          <ac:chgData name="Manasweeta Angane" userId="05da2731-9352-4b35-b713-60351f56afbd" providerId="ADAL" clId="{F5F97842-A295-4F9F-B89B-A63B35E1C32D}" dt="2022-10-22T00:15:35.770" v="15474" actId="20577"/>
          <ac:spMkLst>
            <pc:docMk/>
            <pc:sldMk cId="2034698016" sldId="310"/>
            <ac:spMk id="482" creationId="{EA0575F1-7B6D-41C1-AA49-86E49E7DA329}"/>
          </ac:spMkLst>
        </pc:spChg>
        <pc:spChg chg="add mod">
          <ac:chgData name="Manasweeta Angane" userId="05da2731-9352-4b35-b713-60351f56afbd" providerId="ADAL" clId="{F5F97842-A295-4F9F-B89B-A63B35E1C32D}" dt="2022-10-21T09:24:20.883" v="14652" actId="164"/>
          <ac:spMkLst>
            <pc:docMk/>
            <pc:sldMk cId="2034698016" sldId="310"/>
            <ac:spMk id="484" creationId="{3920F9D0-EE63-4940-9585-8D991D80DA14}"/>
          </ac:spMkLst>
        </pc:spChg>
        <pc:spChg chg="add mod">
          <ac:chgData name="Manasweeta Angane" userId="05da2731-9352-4b35-b713-60351f56afbd" providerId="ADAL" clId="{F5F97842-A295-4F9F-B89B-A63B35E1C32D}" dt="2022-10-21T09:14:53.376" v="14547" actId="164"/>
          <ac:spMkLst>
            <pc:docMk/>
            <pc:sldMk cId="2034698016" sldId="310"/>
            <ac:spMk id="485" creationId="{C766542A-E691-42EC-B2A1-85AB2039D332}"/>
          </ac:spMkLst>
        </pc:spChg>
        <pc:spChg chg="add mod">
          <ac:chgData name="Manasweeta Angane" userId="05da2731-9352-4b35-b713-60351f56afbd" providerId="ADAL" clId="{F5F97842-A295-4F9F-B89B-A63B35E1C32D}" dt="2022-10-21T09:14:53.376" v="14547" actId="164"/>
          <ac:spMkLst>
            <pc:docMk/>
            <pc:sldMk cId="2034698016" sldId="310"/>
            <ac:spMk id="486" creationId="{6730B94B-CF91-4618-A01D-FCCF54E10A06}"/>
          </ac:spMkLst>
        </pc:spChg>
        <pc:spChg chg="add mod">
          <ac:chgData name="Manasweeta Angane" userId="05da2731-9352-4b35-b713-60351f56afbd" providerId="ADAL" clId="{F5F97842-A295-4F9F-B89B-A63B35E1C32D}" dt="2022-10-21T09:24:25.699" v="14653" actId="164"/>
          <ac:spMkLst>
            <pc:docMk/>
            <pc:sldMk cId="2034698016" sldId="310"/>
            <ac:spMk id="488" creationId="{C50BDD34-225E-4E0B-B8BB-2080A4FB04BD}"/>
          </ac:spMkLst>
        </pc:spChg>
        <pc:spChg chg="add mod">
          <ac:chgData name="Manasweeta Angane" userId="05da2731-9352-4b35-b713-60351f56afbd" providerId="ADAL" clId="{F5F97842-A295-4F9F-B89B-A63B35E1C32D}" dt="2022-10-21T09:47:23.452" v="15324" actId="1036"/>
          <ac:spMkLst>
            <pc:docMk/>
            <pc:sldMk cId="2034698016" sldId="310"/>
            <ac:spMk id="494" creationId="{A1255983-FDC9-4D5A-9D36-E810A7FBEC34}"/>
          </ac:spMkLst>
        </pc:spChg>
        <pc:spChg chg="add del mod">
          <ac:chgData name="Manasweeta Angane" userId="05da2731-9352-4b35-b713-60351f56afbd" providerId="ADAL" clId="{F5F97842-A295-4F9F-B89B-A63B35E1C32D}" dt="2022-10-21T09:41:22.855" v="14851" actId="478"/>
          <ac:spMkLst>
            <pc:docMk/>
            <pc:sldMk cId="2034698016" sldId="310"/>
            <ac:spMk id="495" creationId="{50A96D69-C0AA-47F3-8126-EFCB51020D17}"/>
          </ac:spMkLst>
        </pc:spChg>
        <pc:spChg chg="add mod">
          <ac:chgData name="Manasweeta Angane" userId="05da2731-9352-4b35-b713-60351f56afbd" providerId="ADAL" clId="{F5F97842-A295-4F9F-B89B-A63B35E1C32D}" dt="2022-10-23T00:31:18.983" v="20940" actId="20577"/>
          <ac:spMkLst>
            <pc:docMk/>
            <pc:sldMk cId="2034698016" sldId="310"/>
            <ac:spMk id="496" creationId="{695FC70B-15C6-4EB5-AE8C-5D26BCB14FEA}"/>
          </ac:spMkLst>
        </pc:spChg>
        <pc:spChg chg="add mod">
          <ac:chgData name="Manasweeta Angane" userId="05da2731-9352-4b35-b713-60351f56afbd" providerId="ADAL" clId="{F5F97842-A295-4F9F-B89B-A63B35E1C32D}" dt="2022-10-22T00:17:34.531" v="15562" actId="1036"/>
          <ac:spMkLst>
            <pc:docMk/>
            <pc:sldMk cId="2034698016" sldId="310"/>
            <ac:spMk id="497" creationId="{20D244DF-80B0-4BEB-8DE4-BAC52DE4951E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24" creationId="{3D6207CA-CF97-4591-8311-980B82480CAF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25" creationId="{6E279F9E-CA9A-4652-86ED-CDA4BFDEDD76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26" creationId="{3F944BF7-E7E2-42F3-B2F7-4248F25FD0F3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27" creationId="{C7A1483E-75BD-44A2-8559-D0AA9454EB8C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28" creationId="{29D72E2F-872B-45CD-96C0-D5B488DC03CC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29" creationId="{949109E8-14B6-45F0-A64F-3FAA7C86884E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30" creationId="{9AF50642-E483-473C-A7DC-0070169CFDC9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31" creationId="{17BBA4B3-DAB3-48DF-8821-7E7ED7943B56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32" creationId="{86B7BC02-9E23-4A29-82BC-C81697780778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33" creationId="{D1643F37-53C5-4DB5-9C70-169609B996DD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34" creationId="{5BB727EE-6843-4501-88F8-48612CD4313E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35" creationId="{1B5BE6C0-9F9C-4C69-94BE-08FB2A0A8D65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36" creationId="{89263337-619C-4423-A566-15A546910B48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37" creationId="{F16389B1-D8DB-4029-821F-7D6EA197367A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38" creationId="{16CC1214-EE47-49E2-A06B-8848EE24C9BC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39" creationId="{E3299E35-974D-497A-A7E3-043A0C6F7534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40" creationId="{E50D2775-00A7-4C3B-9E95-CD36D6D3D9B6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41" creationId="{5BC0D0E6-9318-44CB-961A-F9D808A316C0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42" creationId="{7A938624-8644-4B29-AECC-DE8E049C1DE1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45" creationId="{36AC4FF6-087C-42BE-ADA6-F339C3F57574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46" creationId="{347D7FD8-2402-41BF-95FE-C9D5DC68083A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47" creationId="{A5DAED50-992C-4D4B-89EB-9486C1667BB9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48" creationId="{4BBE1F25-3C8B-4952-812D-0821EC40BD8D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49" creationId="{C9FD10A1-589D-4B66-962F-D6E177CCEA1B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50" creationId="{F4791DE2-370A-4E52-A245-99D80A8A7F13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51" creationId="{E8A5C570-5394-4D71-BFFC-09D397BDF790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52" creationId="{5D126ADD-E3DE-4763-826F-1551E84415B3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53" creationId="{FB74ECAF-01A7-4E85-855D-7311168AB61F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54" creationId="{AB3ACA84-C66F-4741-A0DA-92803EDFA058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55" creationId="{9DA30B5B-D837-4DD4-B239-DFFAD82C6109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56" creationId="{7B04D47E-7E09-443B-9BB0-E1BECC545CD3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57" creationId="{DAEDEB19-0741-4A75-8910-D9A1837221AA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60" creationId="{0F94B47B-4086-49E9-B5D2-16004D48C141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61" creationId="{291795BF-FB89-4082-B33C-42BCA0450716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62" creationId="{78BCF4F5-957F-483B-AF35-F8FEB4EAB2F3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63" creationId="{FF7C0A13-B7EE-4D82-A7DC-6A9FE4B9B043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64" creationId="{0B2ED746-7EA3-4E95-B17B-9D7C798AAA9B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65" creationId="{3D7CFBC4-0864-405C-A232-704C0AF62BFD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66" creationId="{7CB0DE30-6FBF-46D7-8494-4D0A9AA525D1}"/>
          </ac:spMkLst>
        </pc:spChg>
        <pc:spChg chg="mod">
          <ac:chgData name="Manasweeta Angane" userId="05da2731-9352-4b35-b713-60351f56afbd" providerId="ADAL" clId="{F5F97842-A295-4F9F-B89B-A63B35E1C32D}" dt="2022-10-21T03:41:32.718" v="12103" actId="338"/>
          <ac:spMkLst>
            <pc:docMk/>
            <pc:sldMk cId="2034698016" sldId="310"/>
            <ac:spMk id="1067" creationId="{F6816407-E5ED-42D2-BA70-4BE6B110E8C3}"/>
          </ac:spMkLst>
        </pc:spChg>
        <pc:spChg chg="add mod topLvl">
          <ac:chgData name="Manasweeta Angane" userId="05da2731-9352-4b35-b713-60351f56afbd" providerId="ADAL" clId="{F5F97842-A295-4F9F-B89B-A63B35E1C32D}" dt="2022-10-21T09:50:25.822" v="15356" actId="165"/>
          <ac:spMkLst>
            <pc:docMk/>
            <pc:sldMk cId="2034698016" sldId="310"/>
            <ac:spMk id="1071" creationId="{7C8CB4CB-5602-4FCE-85E3-0B41816B967A}"/>
          </ac:spMkLst>
        </pc:spChg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1082" creationId="{9F797947-2E5B-491A-8758-FFE1193DB5FE}"/>
          </ac:spMkLst>
        </pc:spChg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1084" creationId="{2173EB8F-B944-48B3-A6DF-6E818F5B2920}"/>
          </ac:spMkLst>
        </pc:spChg>
        <pc:spChg chg="mod">
          <ac:chgData name="Manasweeta Angane" userId="05da2731-9352-4b35-b713-60351f56afbd" providerId="ADAL" clId="{F5F97842-A295-4F9F-B89B-A63B35E1C32D}" dt="2022-10-21T05:20:47.041" v="13511" actId="338"/>
          <ac:spMkLst>
            <pc:docMk/>
            <pc:sldMk cId="2034698016" sldId="310"/>
            <ac:spMk id="1087" creationId="{18F360B8-125D-41D5-A75B-F57DAA0A1E4D}"/>
          </ac:spMkLst>
        </pc:spChg>
        <pc:grpChg chg="mod">
          <ac:chgData name="Manasweeta Angane" userId="05da2731-9352-4b35-b713-60351f56afbd" providerId="ADAL" clId="{F5F97842-A295-4F9F-B89B-A63B35E1C32D}" dt="2022-10-21T05:20:47.041" v="13511" actId="338"/>
          <ac:grpSpMkLst>
            <pc:docMk/>
            <pc:sldMk cId="2034698016" sldId="310"/>
            <ac:grpSpMk id="1" creationId="{00000000-0000-0000-0000-000000000000}"/>
          </ac:grpSpMkLst>
        </pc:grpChg>
        <pc:grpChg chg="mod">
          <ac:chgData name="Manasweeta Angane" userId="05da2731-9352-4b35-b713-60351f56afbd" providerId="ADAL" clId="{F5F97842-A295-4F9F-B89B-A63B35E1C32D}" dt="2022-10-21T05:20:47.041" v="13511" actId="338"/>
          <ac:grpSpMkLst>
            <pc:docMk/>
            <pc:sldMk cId="2034698016" sldId="310"/>
            <ac:grpSpMk id="4" creationId="{3F0E3FD0-07DB-4674-861B-D61E237388B2}"/>
          </ac:grpSpMkLst>
        </pc:grpChg>
        <pc:grpChg chg="del mod">
          <ac:chgData name="Manasweeta Angane" userId="05da2731-9352-4b35-b713-60351f56afbd" providerId="ADAL" clId="{F5F97842-A295-4F9F-B89B-A63B35E1C32D}" dt="2022-10-21T03:42:51.351" v="12334" actId="478"/>
          <ac:grpSpMkLst>
            <pc:docMk/>
            <pc:sldMk cId="2034698016" sldId="310"/>
            <ac:grpSpMk id="11" creationId="{E97DFB22-5E42-4EC2-86AA-29DDBDF8AC2D}"/>
          </ac:grpSpMkLst>
        </pc:grpChg>
        <pc:grpChg chg="add del mod">
          <ac:chgData name="Manasweeta Angane" userId="05da2731-9352-4b35-b713-60351f56afbd" providerId="ADAL" clId="{F5F97842-A295-4F9F-B89B-A63B35E1C32D}" dt="2022-10-21T03:43:04.600" v="12372" actId="478"/>
          <ac:grpSpMkLst>
            <pc:docMk/>
            <pc:sldMk cId="2034698016" sldId="310"/>
            <ac:grpSpMk id="13" creationId="{FD288796-B743-4F80-BEC5-C910F905B56E}"/>
          </ac:grpSpMkLst>
        </pc:grpChg>
        <pc:grpChg chg="add mod">
          <ac:chgData name="Manasweeta Angane" userId="05da2731-9352-4b35-b713-60351f56afbd" providerId="ADAL" clId="{F5F97842-A295-4F9F-B89B-A63B35E1C32D}" dt="2022-10-21T07:08:40.396" v="13585" actId="164"/>
          <ac:grpSpMkLst>
            <pc:docMk/>
            <pc:sldMk cId="2034698016" sldId="310"/>
            <ac:grpSpMk id="102" creationId="{E3FE00B4-8EA1-4B96-9711-7DB11DCAF954}"/>
          </ac:grpSpMkLst>
        </pc:grpChg>
        <pc:grpChg chg="add mod">
          <ac:chgData name="Manasweeta Angane" userId="05da2731-9352-4b35-b713-60351f56afbd" providerId="ADAL" clId="{F5F97842-A295-4F9F-B89B-A63B35E1C32D}" dt="2022-10-21T09:47:34.939" v="15345" actId="1035"/>
          <ac:grpSpMkLst>
            <pc:docMk/>
            <pc:sldMk cId="2034698016" sldId="310"/>
            <ac:grpSpMk id="103" creationId="{62236B92-8A60-4655-A41B-31B69262D051}"/>
          </ac:grpSpMkLst>
        </pc:grpChg>
        <pc:grpChg chg="add mod">
          <ac:chgData name="Manasweeta Angane" userId="05da2731-9352-4b35-b713-60351f56afbd" providerId="ADAL" clId="{F5F97842-A295-4F9F-B89B-A63B35E1C32D}" dt="2022-10-21T09:14:53.376" v="14547" actId="164"/>
          <ac:grpSpMkLst>
            <pc:docMk/>
            <pc:sldMk cId="2034698016" sldId="310"/>
            <ac:grpSpMk id="105" creationId="{828D873E-9A8B-4E3D-BBCF-DE81188106B7}"/>
          </ac:grpSpMkLst>
        </pc:grpChg>
        <pc:grpChg chg="add mod">
          <ac:chgData name="Manasweeta Angane" userId="05da2731-9352-4b35-b713-60351f56afbd" providerId="ADAL" clId="{F5F97842-A295-4F9F-B89B-A63B35E1C32D}" dt="2022-10-21T08:53:25.592" v="14376" actId="1037"/>
          <ac:grpSpMkLst>
            <pc:docMk/>
            <pc:sldMk cId="2034698016" sldId="310"/>
            <ac:grpSpMk id="107" creationId="{049F56DA-AB58-4271-9770-D53684910237}"/>
          </ac:grpSpMkLst>
        </pc:grpChg>
        <pc:grpChg chg="add mod">
          <ac:chgData name="Manasweeta Angane" userId="05da2731-9352-4b35-b713-60351f56afbd" providerId="ADAL" clId="{F5F97842-A295-4F9F-B89B-A63B35E1C32D}" dt="2022-10-21T09:24:25.699" v="14653" actId="164"/>
          <ac:grpSpMkLst>
            <pc:docMk/>
            <pc:sldMk cId="2034698016" sldId="310"/>
            <ac:grpSpMk id="108" creationId="{BBDD4F48-DCCB-4505-85EE-F3AE27FD8615}"/>
          </ac:grpSpMkLst>
        </pc:grpChg>
        <pc:grpChg chg="add mod topLvl">
          <ac:chgData name="Manasweeta Angane" userId="05da2731-9352-4b35-b713-60351f56afbd" providerId="ADAL" clId="{F5F97842-A295-4F9F-B89B-A63B35E1C32D}" dt="2022-10-22T00:17:26.587" v="15542" actId="1035"/>
          <ac:grpSpMkLst>
            <pc:docMk/>
            <pc:sldMk cId="2034698016" sldId="310"/>
            <ac:grpSpMk id="109" creationId="{9785307F-7B3A-47B0-8EEF-C3ACBE02F1A6}"/>
          </ac:grpSpMkLst>
        </pc:grpChg>
        <pc:grpChg chg="add del mod">
          <ac:chgData name="Manasweeta Angane" userId="05da2731-9352-4b35-b713-60351f56afbd" providerId="ADAL" clId="{F5F97842-A295-4F9F-B89B-A63B35E1C32D}" dt="2022-10-21T03:53:27.836" v="12573" actId="478"/>
          <ac:grpSpMkLst>
            <pc:docMk/>
            <pc:sldMk cId="2034698016" sldId="310"/>
            <ac:grpSpMk id="110" creationId="{45E58C6B-EB97-4A01-BE87-CD4EC984A06F}"/>
          </ac:grpSpMkLst>
        </pc:grpChg>
        <pc:grpChg chg="add mod topLvl">
          <ac:chgData name="Manasweeta Angane" userId="05da2731-9352-4b35-b713-60351f56afbd" providerId="ADAL" clId="{F5F97842-A295-4F9F-B89B-A63B35E1C32D}" dt="2022-10-21T09:50:25.822" v="15356" actId="165"/>
          <ac:grpSpMkLst>
            <pc:docMk/>
            <pc:sldMk cId="2034698016" sldId="310"/>
            <ac:grpSpMk id="142" creationId="{D238E638-4CA2-4C58-ACA0-4D137508B1A1}"/>
          </ac:grpSpMkLst>
        </pc:grpChg>
        <pc:grpChg chg="del mod">
          <ac:chgData name="Manasweeta Angane" userId="05da2731-9352-4b35-b713-60351f56afbd" providerId="ADAL" clId="{F5F97842-A295-4F9F-B89B-A63B35E1C32D}" dt="2022-10-21T04:14:11.988" v="12599" actId="478"/>
          <ac:grpSpMkLst>
            <pc:docMk/>
            <pc:sldMk cId="2034698016" sldId="310"/>
            <ac:grpSpMk id="174" creationId="{52F6DE5C-B6D3-4358-B965-AB077C9705D9}"/>
          </ac:grpSpMkLst>
        </pc:grpChg>
        <pc:grpChg chg="add del mod">
          <ac:chgData name="Manasweeta Angane" userId="05da2731-9352-4b35-b713-60351f56afbd" providerId="ADAL" clId="{F5F97842-A295-4F9F-B89B-A63B35E1C32D}" dt="2022-10-21T09:16:41.761" v="14573" actId="165"/>
          <ac:grpSpMkLst>
            <pc:docMk/>
            <pc:sldMk cId="2034698016" sldId="310"/>
            <ac:grpSpMk id="206" creationId="{120FB752-8E4F-405C-98AB-88AA1EC54268}"/>
          </ac:grpSpMkLst>
        </pc:grpChg>
        <pc:grpChg chg="add mod">
          <ac:chgData name="Manasweeta Angane" userId="05da2731-9352-4b35-b713-60351f56afbd" providerId="ADAL" clId="{F5F97842-A295-4F9F-B89B-A63B35E1C32D}" dt="2022-10-21T09:24:20.883" v="14652" actId="164"/>
          <ac:grpSpMkLst>
            <pc:docMk/>
            <pc:sldMk cId="2034698016" sldId="310"/>
            <ac:grpSpMk id="207" creationId="{11F93083-E9E6-4E02-9E47-0C252251DEEC}"/>
          </ac:grpSpMkLst>
        </pc:grpChg>
        <pc:grpChg chg="add mod">
          <ac:chgData name="Manasweeta Angane" userId="05da2731-9352-4b35-b713-60351f56afbd" providerId="ADAL" clId="{F5F97842-A295-4F9F-B89B-A63B35E1C32D}" dt="2022-10-21T09:25:13.235" v="14678" actId="1036"/>
          <ac:grpSpMkLst>
            <pc:docMk/>
            <pc:sldMk cId="2034698016" sldId="310"/>
            <ac:grpSpMk id="208" creationId="{812710C9-0D05-4FD5-93C5-BAD244E3CE75}"/>
          </ac:grpSpMkLst>
        </pc:grpChg>
        <pc:grpChg chg="add del mod topLvl">
          <ac:chgData name="Manasweeta Angane" userId="05da2731-9352-4b35-b713-60351f56afbd" providerId="ADAL" clId="{F5F97842-A295-4F9F-B89B-A63B35E1C32D}" dt="2022-10-21T04:23:30.647" v="12833" actId="478"/>
          <ac:grpSpMkLst>
            <pc:docMk/>
            <pc:sldMk cId="2034698016" sldId="310"/>
            <ac:grpSpMk id="209" creationId="{6B48BDE0-06BB-40FA-9EC9-3530DBB3270F}"/>
          </ac:grpSpMkLst>
        </pc:grpChg>
        <pc:grpChg chg="add del mod">
          <ac:chgData name="Manasweeta Angane" userId="05da2731-9352-4b35-b713-60351f56afbd" providerId="ADAL" clId="{F5F97842-A295-4F9F-B89B-A63B35E1C32D}" dt="2022-10-21T04:23:27.546" v="12832" actId="165"/>
          <ac:grpSpMkLst>
            <pc:docMk/>
            <pc:sldMk cId="2034698016" sldId="310"/>
            <ac:grpSpMk id="1072" creationId="{05A10B70-47D6-403D-B1C3-A51C5F77F6F2}"/>
          </ac:grpSpMkLst>
        </pc:grpChg>
        <pc:grpChg chg="add del mod">
          <ac:chgData name="Manasweeta Angane" userId="05da2731-9352-4b35-b713-60351f56afbd" providerId="ADAL" clId="{F5F97842-A295-4F9F-B89B-A63B35E1C32D}" dt="2022-10-21T04:50:23.061" v="13309" actId="165"/>
          <ac:grpSpMkLst>
            <pc:docMk/>
            <pc:sldMk cId="2034698016" sldId="310"/>
            <ac:grpSpMk id="1076" creationId="{DFB869FB-95D3-4758-9A94-AED839AA2154}"/>
          </ac:grpSpMkLst>
        </pc:grpChg>
        <pc:grpChg chg="add del mod">
          <ac:chgData name="Manasweeta Angane" userId="05da2731-9352-4b35-b713-60351f56afbd" providerId="ADAL" clId="{F5F97842-A295-4F9F-B89B-A63B35E1C32D}" dt="2022-10-21T09:50:25.822" v="15356" actId="165"/>
          <ac:grpSpMkLst>
            <pc:docMk/>
            <pc:sldMk cId="2034698016" sldId="310"/>
            <ac:grpSpMk id="1077" creationId="{22BFD680-F981-4767-9235-F264FBF8D11C}"/>
          </ac:grpSpMkLst>
        </pc:grpChg>
        <pc:grpChg chg="del mod">
          <ac:chgData name="Manasweeta Angane" userId="05da2731-9352-4b35-b713-60351f56afbd" providerId="ADAL" clId="{F5F97842-A295-4F9F-B89B-A63B35E1C32D}" dt="2022-10-21T05:22:18.182" v="13513" actId="478"/>
          <ac:grpSpMkLst>
            <pc:docMk/>
            <pc:sldMk cId="2034698016" sldId="310"/>
            <ac:grpSpMk id="1081" creationId="{DAFC526F-7611-4B95-8A91-36BA7AF88F4F}"/>
          </ac:grpSpMkLst>
        </pc:grpChg>
        <pc:grpChg chg="mod">
          <ac:chgData name="Manasweeta Angane" userId="05da2731-9352-4b35-b713-60351f56afbd" providerId="ADAL" clId="{F5F97842-A295-4F9F-B89B-A63B35E1C32D}" dt="2022-10-21T05:20:47.041" v="13511" actId="338"/>
          <ac:grpSpMkLst>
            <pc:docMk/>
            <pc:sldMk cId="2034698016" sldId="310"/>
            <ac:grpSpMk id="1083" creationId="{A0BF0C54-C038-4AFF-94FE-974DE799FCAD}"/>
          </ac:grpSpMkLst>
        </pc:grpChg>
        <pc:graphicFrameChg chg="add del mod">
          <ac:chgData name="Manasweeta Angane" userId="05da2731-9352-4b35-b713-60351f56afbd" providerId="ADAL" clId="{F5F97842-A295-4F9F-B89B-A63B35E1C32D}" dt="2022-10-21T04:22:04.730" v="12819" actId="478"/>
          <ac:graphicFrameMkLst>
            <pc:docMk/>
            <pc:sldMk cId="2034698016" sldId="310"/>
            <ac:graphicFrameMk id="241" creationId="{4C135C33-61DC-4002-96FA-716FC5E632E7}"/>
          </ac:graphicFrameMkLst>
        </pc:graphicFrameChg>
        <pc:graphicFrameChg chg="add mod">
          <ac:chgData name="Manasweeta Angane" userId="05da2731-9352-4b35-b713-60351f56afbd" providerId="ADAL" clId="{F5F97842-A295-4F9F-B89B-A63B35E1C32D}" dt="2022-10-21T04:35:59.826" v="12932"/>
          <ac:graphicFrameMkLst>
            <pc:docMk/>
            <pc:sldMk cId="2034698016" sldId="310"/>
            <ac:graphicFrameMk id="244" creationId="{9C8176B6-93A5-424A-A8E6-5F85581396D7}"/>
          </ac:graphicFrameMkLst>
        </pc:graphicFrameChg>
        <pc:picChg chg="add del mod">
          <ac:chgData name="Manasweeta Angane" userId="05da2731-9352-4b35-b713-60351f56afbd" providerId="ADAL" clId="{F5F97842-A295-4F9F-B89B-A63B35E1C32D}" dt="2022-10-21T03:42:52.872" v="12335" actId="478"/>
          <ac:picMkLst>
            <pc:docMk/>
            <pc:sldMk cId="2034698016" sldId="310"/>
            <ac:picMk id="2" creationId="{3BCE8F83-0B82-404B-9268-222322AEFDE8}"/>
          </ac:picMkLst>
        </pc:picChg>
        <pc:picChg chg="del mod">
          <ac:chgData name="Manasweeta Angane" userId="05da2731-9352-4b35-b713-60351f56afbd" providerId="ADAL" clId="{F5F97842-A295-4F9F-B89B-A63B35E1C32D}" dt="2022-10-21T03:41:32.718" v="12103" actId="338"/>
          <ac:picMkLst>
            <pc:docMk/>
            <pc:sldMk cId="2034698016" sldId="310"/>
            <ac:picMk id="3" creationId="{07366E84-D530-4D57-9122-E1B1C5425282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9" creationId="{9CFD5098-D197-40D2-BF3B-0EFEF6105E56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0" creationId="{64FA096A-8156-4287-968E-CF843C012768}"/>
          </ac:picMkLst>
        </pc:picChg>
        <pc:picChg chg="del">
          <ac:chgData name="Manasweeta Angane" userId="05da2731-9352-4b35-b713-60351f56afbd" providerId="ADAL" clId="{F5F97842-A295-4F9F-B89B-A63B35E1C32D}" dt="2022-10-21T03:32:34.579" v="12073" actId="478"/>
          <ac:picMkLst>
            <pc:docMk/>
            <pc:sldMk cId="2034698016" sldId="310"/>
            <ac:picMk id="12" creationId="{70688E3F-A6B4-4C51-9251-69BA145F3629}"/>
          </ac:picMkLst>
        </pc:picChg>
        <pc:picChg chg="del mod">
          <ac:chgData name="Manasweeta Angane" userId="05da2731-9352-4b35-b713-60351f56afbd" providerId="ADAL" clId="{F5F97842-A295-4F9F-B89B-A63B35E1C32D}" dt="2022-10-21T05:39:43.817" v="13517" actId="478"/>
          <ac:picMkLst>
            <pc:docMk/>
            <pc:sldMk cId="2034698016" sldId="310"/>
            <ac:picMk id="96" creationId="{CA3E84FE-F0D2-48F4-9900-0B886C25F6A2}"/>
          </ac:picMkLst>
        </pc:picChg>
        <pc:picChg chg="mod modCrop">
          <ac:chgData name="Manasweeta Angane" userId="05da2731-9352-4b35-b713-60351f56afbd" providerId="ADAL" clId="{F5F97842-A295-4F9F-B89B-A63B35E1C32D}" dt="2022-10-21T08:05:31.326" v="14098" actId="164"/>
          <ac:picMkLst>
            <pc:docMk/>
            <pc:sldMk cId="2034698016" sldId="310"/>
            <ac:picMk id="97" creationId="{9AA91EAD-E524-461A-AFF7-A342776BEA85}"/>
          </ac:picMkLst>
        </pc:picChg>
        <pc:picChg chg="add mod modCrop">
          <ac:chgData name="Manasweeta Angane" userId="05da2731-9352-4b35-b713-60351f56afbd" providerId="ADAL" clId="{F5F97842-A295-4F9F-B89B-A63B35E1C32D}" dt="2022-10-21T06:04:26.969" v="13560" actId="164"/>
          <ac:picMkLst>
            <pc:docMk/>
            <pc:sldMk cId="2034698016" sldId="310"/>
            <ac:picMk id="99" creationId="{59FB13E0-2D7D-4163-B4C5-D5E12294BE28}"/>
          </ac:picMkLst>
        </pc:picChg>
        <pc:picChg chg="add mod ord modCrop">
          <ac:chgData name="Manasweeta Angane" userId="05da2731-9352-4b35-b713-60351f56afbd" providerId="ADAL" clId="{F5F97842-A295-4F9F-B89B-A63B35E1C32D}" dt="2022-10-21T06:04:26.969" v="13560" actId="164"/>
          <ac:picMkLst>
            <pc:docMk/>
            <pc:sldMk cId="2034698016" sldId="310"/>
            <ac:picMk id="101" creationId="{D86EAD0C-3EBF-4902-B40A-57F086734450}"/>
          </ac:picMkLst>
        </pc:picChg>
        <pc:picChg chg="mod">
          <ac:chgData name="Manasweeta Angane" userId="05da2731-9352-4b35-b713-60351f56afbd" providerId="ADAL" clId="{F5F97842-A295-4F9F-B89B-A63B35E1C32D}" dt="2022-10-21T08:53:22.149" v="14365" actId="164"/>
          <ac:picMkLst>
            <pc:docMk/>
            <pc:sldMk cId="2034698016" sldId="310"/>
            <ac:picMk id="104" creationId="{6BA2B7E3-1956-4FFF-83E2-C78A419A274B}"/>
          </ac:picMkLst>
        </pc:picChg>
        <pc:picChg chg="mod modCrop">
          <ac:chgData name="Manasweeta Angane" userId="05da2731-9352-4b35-b713-60351f56afbd" providerId="ADAL" clId="{F5F97842-A295-4F9F-B89B-A63B35E1C32D}" dt="2022-10-21T09:46:59.163" v="15283" actId="1035"/>
          <ac:picMkLst>
            <pc:docMk/>
            <pc:sldMk cId="2034698016" sldId="310"/>
            <ac:picMk id="106" creationId="{B18DBDFF-E382-4B92-9708-56602DD05A0C}"/>
          </ac:picMkLst>
        </pc:picChg>
        <pc:picChg chg="add del 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256" creationId="{F15288FC-BE43-4C45-B265-9DB576AC23AB}"/>
          </ac:picMkLst>
        </pc:picChg>
        <pc:picChg chg="mod">
          <ac:chgData name="Manasweeta Angane" userId="05da2731-9352-4b35-b713-60351f56afbd" providerId="ADAL" clId="{F5F97842-A295-4F9F-B89B-A63B35E1C32D}" dt="2022-10-21T03:41:32.718" v="12103" actId="338"/>
          <ac:picMkLst>
            <pc:docMk/>
            <pc:sldMk cId="2034698016" sldId="310"/>
            <ac:picMk id="1043" creationId="{B206BD9E-EC06-4896-980A-8C3D0A8ED601}"/>
          </ac:picMkLst>
        </pc:picChg>
        <pc:picChg chg="mod">
          <ac:chgData name="Manasweeta Angane" userId="05da2731-9352-4b35-b713-60351f56afbd" providerId="ADAL" clId="{F5F97842-A295-4F9F-B89B-A63B35E1C32D}" dt="2022-10-21T03:41:32.718" v="12103" actId="338"/>
          <ac:picMkLst>
            <pc:docMk/>
            <pc:sldMk cId="2034698016" sldId="310"/>
            <ac:picMk id="1044" creationId="{2733B94B-4F3D-4E16-8D97-F9714ED52335}"/>
          </ac:picMkLst>
        </pc:picChg>
        <pc:picChg chg="mod">
          <ac:chgData name="Manasweeta Angane" userId="05da2731-9352-4b35-b713-60351f56afbd" providerId="ADAL" clId="{F5F97842-A295-4F9F-B89B-A63B35E1C32D}" dt="2022-10-21T03:41:32.718" v="12103" actId="338"/>
          <ac:picMkLst>
            <pc:docMk/>
            <pc:sldMk cId="2034698016" sldId="310"/>
            <ac:picMk id="1058" creationId="{41F084F5-FD55-4209-B93A-4766323AA521}"/>
          </ac:picMkLst>
        </pc:picChg>
        <pc:picChg chg="mod">
          <ac:chgData name="Manasweeta Angane" userId="05da2731-9352-4b35-b713-60351f56afbd" providerId="ADAL" clId="{F5F97842-A295-4F9F-B89B-A63B35E1C32D}" dt="2022-10-21T03:41:32.718" v="12103" actId="338"/>
          <ac:picMkLst>
            <pc:docMk/>
            <pc:sldMk cId="2034698016" sldId="310"/>
            <ac:picMk id="1059" creationId="{DD3CF086-F945-4653-A0DC-3AD857A7D69B}"/>
          </ac:picMkLst>
        </pc:picChg>
        <pc:picChg chg="mod modCrop">
          <ac:chgData name="Manasweeta Angane" userId="05da2731-9352-4b35-b713-60351f56afbd" providerId="ADAL" clId="{F5F97842-A295-4F9F-B89B-A63B35E1C32D}" dt="2022-10-21T08:53:22.149" v="14365" actId="164"/>
          <ac:picMkLst>
            <pc:docMk/>
            <pc:sldMk cId="2034698016" sldId="310"/>
            <ac:picMk id="1068" creationId="{4687DF4E-4211-479C-9CB8-0EC62ECCC299}"/>
          </ac:picMkLst>
        </pc:picChg>
        <pc:picChg chg="del">
          <ac:chgData name="Manasweeta Angane" userId="05da2731-9352-4b35-b713-60351f56afbd" providerId="ADAL" clId="{F5F97842-A295-4F9F-B89B-A63B35E1C32D}" dt="2022-10-21T04:11:12.978" v="12583" actId="478"/>
          <ac:picMkLst>
            <pc:docMk/>
            <pc:sldMk cId="2034698016" sldId="310"/>
            <ac:picMk id="1069" creationId="{6C1A23D9-0632-4ACE-BC21-A0BA3AC62FC8}"/>
          </ac:picMkLst>
        </pc:picChg>
        <pc:picChg chg="mod modCrop">
          <ac:chgData name="Manasweeta Angane" userId="05da2731-9352-4b35-b713-60351f56afbd" providerId="ADAL" clId="{F5F97842-A295-4F9F-B89B-A63B35E1C32D}" dt="2022-10-21T09:24:20.883" v="14652" actId="164"/>
          <ac:picMkLst>
            <pc:docMk/>
            <pc:sldMk cId="2034698016" sldId="310"/>
            <ac:picMk id="1070" creationId="{0C2451D6-5DA3-4BE3-893D-9B2179C65B7C}"/>
          </ac:picMkLst>
        </pc:picChg>
        <pc:picChg chg="del mod">
          <ac:chgData name="Manasweeta Angane" userId="05da2731-9352-4b35-b713-60351f56afbd" providerId="ADAL" clId="{F5F97842-A295-4F9F-B89B-A63B35E1C32D}" dt="2022-10-21T04:37:29.595" v="12938" actId="478"/>
          <ac:picMkLst>
            <pc:docMk/>
            <pc:sldMk cId="2034698016" sldId="310"/>
            <ac:picMk id="1073" creationId="{E2D2A14B-9AD3-4F58-91BF-011F66805B25}"/>
          </ac:picMkLst>
        </pc:picChg>
        <pc:picChg chg="del mod">
          <ac:chgData name="Manasweeta Angane" userId="05da2731-9352-4b35-b713-60351f56afbd" providerId="ADAL" clId="{F5F97842-A295-4F9F-B89B-A63B35E1C32D}" dt="2022-10-21T04:39:15.179" v="12953" actId="478"/>
          <ac:picMkLst>
            <pc:docMk/>
            <pc:sldMk cId="2034698016" sldId="310"/>
            <ac:picMk id="1074" creationId="{1699D5C0-049D-431E-8372-86A0AE859700}"/>
          </ac:picMkLst>
        </pc:picChg>
        <pc:picChg chg="mod">
          <ac:chgData name="Manasweeta Angane" userId="05da2731-9352-4b35-b713-60351f56afbd" providerId="ADAL" clId="{F5F97842-A295-4F9F-B89B-A63B35E1C32D}" dt="2022-10-21T08:05:31.326" v="14098" actId="164"/>
          <ac:picMkLst>
            <pc:docMk/>
            <pc:sldMk cId="2034698016" sldId="310"/>
            <ac:picMk id="1075" creationId="{3A9BC25E-6939-4B01-9ED9-6062A13FFB6C}"/>
          </ac:picMkLst>
        </pc:picChg>
        <pc:picChg chg="mod">
          <ac:chgData name="Manasweeta Angane" userId="05da2731-9352-4b35-b713-60351f56afbd" providerId="ADAL" clId="{F5F97842-A295-4F9F-B89B-A63B35E1C32D}" dt="2022-10-21T09:16:41.761" v="14573" actId="165"/>
          <ac:picMkLst>
            <pc:docMk/>
            <pc:sldMk cId="2034698016" sldId="310"/>
            <ac:picMk id="1078" creationId="{17E99CA4-5107-4AF2-AD6B-3E3914951FA7}"/>
          </ac:picMkLst>
        </pc:picChg>
        <pc:picChg chg="del mod">
          <ac:chgData name="Manasweeta Angane" userId="05da2731-9352-4b35-b713-60351f56afbd" providerId="ADAL" clId="{F5F97842-A295-4F9F-B89B-A63B35E1C32D}" dt="2022-10-21T05:08:11.443" v="13376" actId="478"/>
          <ac:picMkLst>
            <pc:docMk/>
            <pc:sldMk cId="2034698016" sldId="310"/>
            <ac:picMk id="1079" creationId="{A0563A2A-9865-420D-B648-02385A6F4789}"/>
          </ac:picMkLst>
        </pc:picChg>
        <pc:picChg chg="mod modCrop">
          <ac:chgData name="Manasweeta Angane" userId="05da2731-9352-4b35-b713-60351f56afbd" providerId="ADAL" clId="{F5F97842-A295-4F9F-B89B-A63B35E1C32D}" dt="2022-10-21T09:16:41.761" v="14573" actId="165"/>
          <ac:picMkLst>
            <pc:docMk/>
            <pc:sldMk cId="2034698016" sldId="310"/>
            <ac:picMk id="1080" creationId="{1B0F524F-73E9-4421-8E5C-F252233E0B87}"/>
          </ac:picMkLst>
        </pc:picChg>
        <pc:picChg chg="mod">
          <ac:chgData name="Manasweeta Angane" userId="05da2731-9352-4b35-b713-60351f56afbd" providerId="ADAL" clId="{F5F97842-A295-4F9F-B89B-A63B35E1C32D}" dt="2022-10-21T03:41:32.718" v="12103" actId="338"/>
          <ac:picMkLst>
            <pc:docMk/>
            <pc:sldMk cId="2034698016" sldId="310"/>
            <ac:picMk id="1085" creationId="{5B0F2511-0083-4134-8606-33B5C3357D41}"/>
          </ac:picMkLst>
        </pc:picChg>
        <pc:picChg chg="mod">
          <ac:chgData name="Manasweeta Angane" userId="05da2731-9352-4b35-b713-60351f56afbd" providerId="ADAL" clId="{F5F97842-A295-4F9F-B89B-A63B35E1C32D}" dt="2022-10-21T03:41:32.718" v="12103" actId="338"/>
          <ac:picMkLst>
            <pc:docMk/>
            <pc:sldMk cId="2034698016" sldId="310"/>
            <ac:picMk id="1086" creationId="{93D27E51-7455-486F-9C8E-757EA69E8409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096" creationId="{E421CC80-07F5-4454-9A4F-0689DC4EC73C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097" creationId="{43D6B8C8-C0BB-4408-BB59-892CDFE26408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06" creationId="{65B96B32-BDC0-4985-94EA-ED569E86D73B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07" creationId="{317D0D31-D7D4-4302-B427-1524B983367F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08" creationId="{130F90BA-CA71-41F6-A318-1DB21C8B753B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09" creationId="{38CD41F0-4685-40A2-A84B-332396291A19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10" creationId="{CF22E243-9459-4D4A-A479-DB190785F89D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11" creationId="{3F59D4A6-584D-44B5-A643-3F8FC93F4A96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12" creationId="{68D45ED9-CC38-49AC-ACFA-FDDF124D95E2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13" creationId="{2CB98886-DDCB-40CD-AC46-D0BB1035EA0B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14" creationId="{BD39FB90-52C7-44F1-8E41-A6FF207A1D26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15" creationId="{86CFFD34-B9A6-4B46-A1E7-B4EFFBA429C1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16" creationId="{9EFC2148-D453-4DDB-A78D-9D7F294B2584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17" creationId="{F6A5B07F-2677-466D-8A90-C5425CFDE78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18" creationId="{760298D1-67A8-454E-94B5-B951DE30308B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19" creationId="{FAAF70B0-27AC-4184-8D48-4500746AD457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20" creationId="{A10C7F7C-2CDD-4AFB-B226-0506202E528A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21" creationId="{B0DEACF7-1DDB-4957-AD16-69973CA9656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22" creationId="{3CCA08B6-6F31-453C-92AB-B7ED5FE2318B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23" creationId="{997EA04E-B979-492C-A314-C11F0091B4FB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24" creationId="{579A79EC-F09D-49FF-90C3-08A9AC6FC3EE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25" creationId="{DD579F93-893D-41A7-9077-3B5C540DEEE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26" creationId="{CCF2CFB5-4932-4B85-8685-2C44F82EB69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27" creationId="{1E4E9997-4695-4B5C-A38B-813F8C792827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28" creationId="{8E2C638C-4532-4B2F-BF82-36CFDF60D79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29" creationId="{4D87DCAB-2E8C-44DE-AD79-0A1FA5CD79D1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30" creationId="{B1E0414D-2557-4B5C-AF4F-2F1A5F7FA34F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31" creationId="{FF9123BF-B5E7-43D0-A6EA-D1802D0E410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32" creationId="{83261AE0-5550-41E8-B735-3111F9C9CB7C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33" creationId="{F5A115E5-A538-4A8C-8FC6-5D281C4ADA67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34" creationId="{82634E76-4775-43DA-B91C-28BDAA019A3E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35" creationId="{2A6E7526-A334-4104-99E1-AFC176E40B24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36" creationId="{9F32E247-A564-4F06-A4C6-E52F518B96C4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37" creationId="{88EF7D5B-2596-4D2E-A87E-70A66DEDB985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38" creationId="{2C2CC94E-73D9-44B1-850D-22FBC0410D05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39" creationId="{5F5C09EC-8A06-4724-8800-1D85BBA2C5F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40" creationId="{22A10D4A-D1C3-4AD6-B21E-4A99D2E3A22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41" creationId="{D73324D0-9802-4E64-91BF-AB0C3A9B70B7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42" creationId="{2C430244-C281-4270-9FD6-11A9D767DC90}"/>
          </ac:picMkLst>
        </pc:picChg>
        <pc:picChg chg="mod">
          <ac:chgData name="Manasweeta Angane" userId="05da2731-9352-4b35-b713-60351f56afbd" providerId="ADAL" clId="{F5F97842-A295-4F9F-B89B-A63B35E1C32D}" dt="2022-10-21T05:21:48.662" v="13512"/>
          <ac:picMkLst>
            <pc:docMk/>
            <pc:sldMk cId="2034698016" sldId="310"/>
            <ac:picMk id="1143" creationId="{35DB5EFC-4699-4ED7-962A-EF3F7F3754E9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44" creationId="{88232F13-07B5-4E3D-8A64-7DAEAD3614D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45" creationId="{ACB8B8F8-0724-46D4-AF35-2A1E201C505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46" creationId="{0FFC4359-6D17-4648-B94A-2503CC3919D2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47" creationId="{995A7154-A47B-4E7C-BD6C-9B7B35192A54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48" creationId="{64EB02C9-D19E-4088-9354-1DD21C4D129C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49" creationId="{002CAB32-D465-430B-920D-C97A5E6C0C81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50" creationId="{9C3FF02C-668E-4D38-BD77-4A24728F3037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51" creationId="{AD0258DC-9B9B-48F0-9F5C-BCC343C942B1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52" creationId="{3A60F62D-D7BA-4B15-9DA2-84680B3D5F3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53" creationId="{A45A1BD5-5FF6-4549-965C-420490C2B2D4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54" creationId="{8B3E287D-8AA3-4CE3-B2C9-1B2AA15F5BCF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55" creationId="{5DDDF499-0E7F-433F-A2CC-C580603B5777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56" creationId="{8A8B2EDB-7DA4-4EDD-A47E-1EF260563076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57" creationId="{1A648624-F5B1-4989-A059-846253A0C565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58" creationId="{24496494-DFAF-43C2-8D98-C53FFFA1EB5E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59" creationId="{10D866CF-6234-4851-95B6-22D86B8C640E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60" creationId="{E317116A-4DDE-4F55-9A6E-0A05F9BC5BEE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61" creationId="{3E159050-1071-44CC-A64D-6C87A4BE0D1D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62" creationId="{FBEE370A-0572-4A95-BC2F-6401418D427A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63" creationId="{33F2D590-C2D1-4B2B-A76E-EDE9DC4D6C6F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64" creationId="{5D51AA3A-BF2D-4EC5-91BE-CB1B78C81972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65" creationId="{9D61024F-B63E-4C9D-A15E-B6FF5131F46C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66" creationId="{20B49A48-04B2-417D-9048-83D820BF84BF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67" creationId="{0E373EAA-70B3-42FC-9156-81E334F2405C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68" creationId="{9AB8FD47-C9BB-44AA-8DA2-E35A4ADB8DF1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69" creationId="{F558B1FF-69B8-4939-B357-62F11168B191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70" creationId="{209170A3-F585-4E47-8C28-2D0EB68244F9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71" creationId="{0C2F8A69-F1F1-4BA5-965C-35323B146E28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72" creationId="{A16589C4-04EE-4ECD-BDBB-0F05225028E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73" creationId="{C8D9CCBC-8861-469F-8F40-44B5AB48CE26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74" creationId="{EDE15E6C-2F4B-4C9A-95D1-99F0C5D0FB58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75" creationId="{F467E652-BB59-4DAC-97E1-A20FE96886BB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76" creationId="{977C2613-87E2-43CD-B8EA-7A44ABDEA7B2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77" creationId="{49BD1B90-372C-4592-8546-B492E73C7789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78" creationId="{F60E85A9-1102-4965-80CB-D9904882E787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79" creationId="{F56F90B7-D79D-4983-A2BC-F03FFFEEC221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80" creationId="{751B1CD9-C843-4188-9FB2-DFA986882DF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81" creationId="{8C7B37A8-AAE7-4AD5-AF68-EFFA42C6DA5C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82" creationId="{0104309A-43AE-45DA-B48D-EBED82E4D51D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83" creationId="{5FA4AF21-371E-4EA1-A7CA-F835099C8607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84" creationId="{CAADC844-3F4F-4CA6-AD99-E0BB6A9397BD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85" creationId="{EBCD0405-16E2-48C6-AA3C-F05591112EA9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86" creationId="{14052868-96C4-4EFF-BA88-36AE00C1D9C6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87" creationId="{2668F8EE-CCAC-4462-A17C-BA88699E2162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88" creationId="{39361109-43F2-4249-BDBA-D167FF0BA13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89" creationId="{483A0D1F-1FC0-45A8-88FA-6EEEB8CEBC12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90" creationId="{E3BD40FA-7C56-4720-8286-EA8D617048B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91" creationId="{048BF6A6-8485-4214-BE7F-45E73BAD68C7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92" creationId="{386D72D2-D3F4-4FE3-8B56-8464650D475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93" creationId="{C7330DCC-D482-4945-8B5E-6877ED7BD1AD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94" creationId="{B5E2C5D6-6425-4E9F-904F-CB312AE3C716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95" creationId="{D53D47FB-EAA8-4708-9437-7A9E13A43CA1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96" creationId="{B79A2DB0-DED3-4B93-AB48-DA2D71078362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97" creationId="{4695BBF5-F27F-4B53-A780-49FEDC4C0E9C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98" creationId="{43031753-2C54-4E36-8327-0D4033E79FB4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199" creationId="{E39BF9B4-38A2-4F52-9D0C-5C3FD31F0605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00" creationId="{855FA159-1B16-4CAA-A89B-4E6C94CFE0A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01" creationId="{7AE7AF79-CD37-4A7C-84E2-A034EECA34AC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02" creationId="{2C406AA8-05A9-4C75-909A-1BC75C5B12B7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03" creationId="{5198A5E4-FED0-462F-8E5A-5B059387896A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04" creationId="{DBA18FDE-20D6-4AE4-9A0B-1D62D33D7379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05" creationId="{BBEF317C-CC5F-4BE3-9EF2-32056D6C5322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06" creationId="{E71B0CDC-F1BF-41B4-AA35-247A58608C9F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07" creationId="{757C4911-5499-47A2-BEE1-CA7174F4120F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08" creationId="{4CBBCAE7-0350-481C-80B7-D2A741BD1B5B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09" creationId="{3F75CA8B-7236-4EBE-8858-7642FF226186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10" creationId="{C43960A4-725C-426B-B688-F5555CA7687B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11" creationId="{94975951-4E4A-466D-A206-72E2AA9557CE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12" creationId="{4E4A623D-F0FE-4759-837F-8B725156697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13" creationId="{94283B12-4693-422E-ADCE-CC21AFAA01AC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14" creationId="{6955B266-40C2-4DCD-9E02-9F5190C420C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15" creationId="{E649881E-F839-4C26-B162-9258FB7A7C09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16" creationId="{9FE162D4-E256-4590-B9FB-2599BB51519A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17" creationId="{5EAFB34F-8FB8-4AFF-AB03-BAE17339CE4F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18" creationId="{1C6E5491-65C7-4E74-B0B5-98A6F1AF39F6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19" creationId="{EC2ED281-CB87-4B0F-8D97-D93B5320BAE8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20" creationId="{753D1971-CBAE-4ECC-B7C9-AE818766C614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21" creationId="{6D1E1FA5-6A1A-47C6-983E-C96EDD151B2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22" creationId="{25494427-5784-4E49-A0B1-AE98AA165934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23" creationId="{88287B0B-A69C-4BB7-85B3-5995802FFD11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24" creationId="{D94DEC28-D4A2-4E6A-B846-48E699EC54E5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25" creationId="{4C446914-BD65-4229-816C-C7727AC0829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26" creationId="{23E853CF-A23A-47E6-B5D3-4B992EC713BC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27" creationId="{659D3C0A-2883-49F2-A916-FF062F15BE4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28" creationId="{04BBFFE4-AF14-460A-86EF-5B6BC0A4A83D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29" creationId="{6DE2EA68-3249-424B-ADA9-9E5023ED1A5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30" creationId="{EF80FF68-7C8B-4E4B-9D6D-D88E438440F6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31" creationId="{D6D6FF26-D3C1-4290-B309-97226E6F9E3B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32" creationId="{F76CA8B1-5E02-430A-8632-71B6501CC6D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33" creationId="{01DDEBB4-D91D-48CC-A17F-62D720D8A021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34" creationId="{DB4AD5F5-BA1C-4B31-89FA-579FC96F456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35" creationId="{C1697AED-891D-4A46-B480-527A11E41987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36" creationId="{BC2F2E5F-C566-4058-8056-0A8F63B489E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37" creationId="{F864EFAC-AF82-4C70-8A40-4C512D3DE319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38" creationId="{5DB8E5F9-DA9A-41B6-A42C-7F7E220424DF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39" creationId="{D9C27115-531D-4BDF-A302-5C982A999F6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40" creationId="{61279544-53FF-4E8A-921A-C6492B78792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41" creationId="{DC506BF4-EC46-4B44-A520-0003E8215844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42" creationId="{09DC06E8-891C-403D-B52B-5514C3C9044A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43" creationId="{49057B73-54E9-42D4-82F4-D8FD75807D81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44" creationId="{89E8EDD1-C79C-41E2-9DD4-0F32A9236E9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45" creationId="{EC1A262F-4C90-401E-9386-962C5574FBA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46" creationId="{3F27BE1D-C6B0-4BDA-BAFA-0DB06269F44B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47" creationId="{A320D9A1-08EC-4E3C-8C7D-57AA08A76DFF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48" creationId="{67D9B66E-8505-469F-91D2-1C5E8C9297C9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49" creationId="{91E06F04-2C38-4F2C-A1CA-D03937A676D2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50" creationId="{94B3878D-A6DC-44DC-9B3C-E40A6D424C6D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51" creationId="{6C51DE50-7948-4F73-8933-D699036F54FD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52" creationId="{F4977A26-1632-41F9-8B5F-FE4E379295DA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53" creationId="{B32B435A-790A-452B-B9E9-8C31CAAAE1B7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54" creationId="{C0528BEA-A0DA-4C30-920D-A1F12FF5B1D6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55" creationId="{295D1415-1123-4C43-87AB-709C1965B99E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56" creationId="{42577040-946D-4652-AD90-962F2AA519CA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57" creationId="{B03A40E8-39FC-47C3-A532-050D088A7CF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58" creationId="{61AA99F0-8D0C-4883-BF30-2A1A8FD26FE6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59" creationId="{BEB7A97A-3C6B-4BC3-A516-8F66937E862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60" creationId="{3E3E7DFD-225E-4EA5-B4A1-C7958E60252C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61" creationId="{D9D4D126-B1A2-4B42-A4E3-C9A683D448E1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62" creationId="{12487660-95A6-48DD-99B7-81493BFAC924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63" creationId="{73A6EEB1-AB97-4674-96E3-724CCE6945FE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64" creationId="{56E97B02-5967-4894-870E-147C943B83F5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65" creationId="{EE39F7BD-2EAD-4A77-801C-5ED145A8DE17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66" creationId="{2EA8A7B8-D6D8-4996-9E14-9CA9BA84651E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67" creationId="{355134EC-6E55-488F-B01B-0DB36E374E9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68" creationId="{4C630980-114B-49E1-B663-0BB3349B46EB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69" creationId="{33390800-D9D1-4DE1-BBF6-B50944553FB9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70" creationId="{6C5197FF-323C-4AC0-B17F-40B99F0A47C5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71" creationId="{C75C989D-E369-4A9C-B879-E6620DBEF21D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72" creationId="{D015B5E3-E11D-465D-8D27-C825C9ADB8C2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73" creationId="{F69D6FDB-0725-43D5-B9A4-554A4D7CAA34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74" creationId="{01E7B9A1-D4B7-4D62-956D-8BB0E0A331C1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75" creationId="{EF033D46-4707-428B-B7A4-2F28F619524A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76" creationId="{07A8F08A-4835-49D5-8707-0EDD95479BBE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77" creationId="{37645AB1-C041-4B63-9B42-4D9BAAEA0EFC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78" creationId="{7340224D-10FA-4B1D-ABC6-34E074B26B94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79" creationId="{2C264FBA-87EB-47FD-B3F9-1BBF4767B46A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80" creationId="{8E4A64F6-9136-448D-9387-CA648D64C03A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81" creationId="{89CD531F-42A4-47DD-A049-E287D28C93FC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82" creationId="{D3428386-5FBF-4DCA-83B0-69639E15094A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83" creationId="{270C85CC-DF70-4A78-8BC0-071AF4764017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84" creationId="{10EC8628-E3BA-4BD7-B29B-59F5E546E9A0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85" creationId="{4F932F07-C85D-4F1C-84FE-97E46E0ABCBD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86" creationId="{71FDBD90-2AD8-41C0-8937-A8B36B99EC16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87" creationId="{863EC3AA-582A-4E6D-8919-C173DCA52AB3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88" creationId="{CDD24852-E798-4410-B44B-990E854D0EBD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89" creationId="{D7503303-1D24-40A0-A48E-8EA783A0B544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90" creationId="{33C3A04F-FCFC-4E5A-9181-2B9FCE7210F2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91" creationId="{BE7C74EF-420D-4302-A574-3C967514747C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92" creationId="{5B9CA966-6798-40FA-B737-8EA7165FE09B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94" creationId="{018E52D2-457B-48EC-99C9-CCB02460C5E1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95" creationId="{6391ABC7-D780-41AF-8B9B-543DB8CBBCEA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96" creationId="{46DCFF8C-2BD8-4720-A3B1-103EDA11B7EC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97" creationId="{DC8F1EC4-616C-4789-BAF9-C69BEE26E13F}"/>
          </ac:picMkLst>
        </pc:picChg>
        <pc:picChg chg="mod">
          <ac:chgData name="Manasweeta Angane" userId="05da2731-9352-4b35-b713-60351f56afbd" providerId="ADAL" clId="{F5F97842-A295-4F9F-B89B-A63B35E1C32D}" dt="2022-10-21T05:20:47.041" v="13511" actId="338"/>
          <ac:picMkLst>
            <pc:docMk/>
            <pc:sldMk cId="2034698016" sldId="310"/>
            <ac:picMk id="1298" creationId="{463EA16F-5004-46E6-BA75-212AE4FFE239}"/>
          </ac:picMkLst>
        </pc:picChg>
        <pc:cxnChg chg="add mod">
          <ac:chgData name="Manasweeta Angane" userId="05da2731-9352-4b35-b713-60351f56afbd" providerId="ADAL" clId="{F5F97842-A295-4F9F-B89B-A63B35E1C32D}" dt="2022-10-21T08:05:45.295" v="14121" actId="1037"/>
          <ac:cxnSpMkLst>
            <pc:docMk/>
            <pc:sldMk cId="2034698016" sldId="310"/>
            <ac:cxnSpMk id="479" creationId="{3B38B226-38B9-424A-8CEA-2AA67FF63C28}"/>
          </ac:cxnSpMkLst>
        </pc:cxnChg>
        <pc:cxnChg chg="add mod">
          <ac:chgData name="Manasweeta Angane" userId="05da2731-9352-4b35-b713-60351f56afbd" providerId="ADAL" clId="{F5F97842-A295-4F9F-B89B-A63B35E1C32D}" dt="2022-10-21T09:25:17.156" v="14685" actId="1036"/>
          <ac:cxnSpMkLst>
            <pc:docMk/>
            <pc:sldMk cId="2034698016" sldId="310"/>
            <ac:cxnSpMk id="493" creationId="{2E71FF4C-FDEA-4784-91AA-844874B9601D}"/>
          </ac:cxnSpMkLst>
        </pc:cxnChg>
      </pc:sldChg>
      <pc:sldChg chg="addSp delSp modSp add mod ord modAnim">
        <pc:chgData name="Manasweeta Angane" userId="05da2731-9352-4b35-b713-60351f56afbd" providerId="ADAL" clId="{F5F97842-A295-4F9F-B89B-A63B35E1C32D}" dt="2022-10-24T12:10:31.777" v="20991" actId="1035"/>
        <pc:sldMkLst>
          <pc:docMk/>
          <pc:sldMk cId="3124133690" sldId="311"/>
        </pc:sldMkLst>
        <pc:spChg chg="mod">
          <ac:chgData name="Manasweeta Angane" userId="05da2731-9352-4b35-b713-60351f56afbd" providerId="ADAL" clId="{F5F97842-A295-4F9F-B89B-A63B35E1C32D}" dt="2022-10-22T04:09:08.630" v="17288" actId="12788"/>
          <ac:spMkLst>
            <pc:docMk/>
            <pc:sldMk cId="3124133690" sldId="311"/>
            <ac:spMk id="18" creationId="{45F2BEED-A6BE-45AE-BED7-62E52E5E5868}"/>
          </ac:spMkLst>
        </pc:spChg>
        <pc:spChg chg="add mod">
          <ac:chgData name="Manasweeta Angane" userId="05da2731-9352-4b35-b713-60351f56afbd" providerId="ADAL" clId="{F5F97842-A295-4F9F-B89B-A63B35E1C32D}" dt="2022-10-22T05:16:53.740" v="18616" actId="12788"/>
          <ac:spMkLst>
            <pc:docMk/>
            <pc:sldMk cId="3124133690" sldId="311"/>
            <ac:spMk id="26" creationId="{0A745E1B-87AB-4754-93F4-3A24C8F3DFBA}"/>
          </ac:spMkLst>
        </pc:spChg>
        <pc:spChg chg="add mod topLvl">
          <ac:chgData name="Manasweeta Angane" userId="05da2731-9352-4b35-b713-60351f56afbd" providerId="ADAL" clId="{F5F97842-A295-4F9F-B89B-A63B35E1C32D}" dt="2022-10-22T06:52:24.961" v="20848" actId="165"/>
          <ac:spMkLst>
            <pc:docMk/>
            <pc:sldMk cId="3124133690" sldId="311"/>
            <ac:spMk id="52" creationId="{38F5A0D5-844A-41E0-BAD0-EEFCCD954690}"/>
          </ac:spMkLst>
        </pc:spChg>
        <pc:spChg chg="add mod">
          <ac:chgData name="Manasweeta Angane" userId="05da2731-9352-4b35-b713-60351f56afbd" providerId="ADAL" clId="{F5F97842-A295-4F9F-B89B-A63B35E1C32D}" dt="2022-10-22T04:10:25.386" v="17367" actId="164"/>
          <ac:spMkLst>
            <pc:docMk/>
            <pc:sldMk cId="3124133690" sldId="311"/>
            <ac:spMk id="54" creationId="{699496DF-8498-4499-9F97-0A2BB05C70FC}"/>
          </ac:spMkLst>
        </pc:spChg>
        <pc:spChg chg="add mod">
          <ac:chgData name="Manasweeta Angane" userId="05da2731-9352-4b35-b713-60351f56afbd" providerId="ADAL" clId="{F5F97842-A295-4F9F-B89B-A63B35E1C32D}" dt="2022-10-22T04:14:05.471" v="17456" actId="14100"/>
          <ac:spMkLst>
            <pc:docMk/>
            <pc:sldMk cId="3124133690" sldId="311"/>
            <ac:spMk id="64" creationId="{F37F6ECD-88F4-4639-AEAB-5B43D35EC87F}"/>
          </ac:spMkLst>
        </pc:spChg>
        <pc:spChg chg="add mod">
          <ac:chgData name="Manasweeta Angane" userId="05da2731-9352-4b35-b713-60351f56afbd" providerId="ADAL" clId="{F5F97842-A295-4F9F-B89B-A63B35E1C32D}" dt="2022-10-22T04:14:15.931" v="17462" actId="14100"/>
          <ac:spMkLst>
            <pc:docMk/>
            <pc:sldMk cId="3124133690" sldId="311"/>
            <ac:spMk id="66" creationId="{F1E54F94-E988-492A-8DA3-448CD7AD3B1C}"/>
          </ac:spMkLst>
        </pc:spChg>
        <pc:spChg chg="add mod">
          <ac:chgData name="Manasweeta Angane" userId="05da2731-9352-4b35-b713-60351f56afbd" providerId="ADAL" clId="{F5F97842-A295-4F9F-B89B-A63B35E1C32D}" dt="2022-10-22T04:49:24.973" v="17958" actId="20577"/>
          <ac:spMkLst>
            <pc:docMk/>
            <pc:sldMk cId="3124133690" sldId="311"/>
            <ac:spMk id="71" creationId="{E4C7642D-BF07-44CC-B151-5A8FCFA72D08}"/>
          </ac:spMkLst>
        </pc:spChg>
        <pc:spChg chg="add mod">
          <ac:chgData name="Manasweeta Angane" userId="05da2731-9352-4b35-b713-60351f56afbd" providerId="ADAL" clId="{F5F97842-A295-4F9F-B89B-A63B35E1C32D}" dt="2022-10-22T06:45:20.995" v="20822" actId="1035"/>
          <ac:spMkLst>
            <pc:docMk/>
            <pc:sldMk cId="3124133690" sldId="311"/>
            <ac:spMk id="77" creationId="{6EEE9CEB-7173-4781-89E3-014698E46E8E}"/>
          </ac:spMkLst>
        </pc:spChg>
        <pc:spChg chg="add mod">
          <ac:chgData name="Manasweeta Angane" userId="05da2731-9352-4b35-b713-60351f56afbd" providerId="ADAL" clId="{F5F97842-A295-4F9F-B89B-A63B35E1C32D}" dt="2022-10-24T12:10:31.777" v="20991" actId="1035"/>
          <ac:spMkLst>
            <pc:docMk/>
            <pc:sldMk cId="3124133690" sldId="311"/>
            <ac:spMk id="78" creationId="{B1D406A0-98D7-45D5-BAC3-CA19C8AB0B11}"/>
          </ac:spMkLst>
        </pc:spChg>
        <pc:spChg chg="add mod topLvl">
          <ac:chgData name="Manasweeta Angane" userId="05da2731-9352-4b35-b713-60351f56afbd" providerId="ADAL" clId="{F5F97842-A295-4F9F-B89B-A63B35E1C32D}" dt="2022-10-22T05:17:06.094" v="18624" actId="1035"/>
          <ac:spMkLst>
            <pc:docMk/>
            <pc:sldMk cId="3124133690" sldId="311"/>
            <ac:spMk id="81" creationId="{CB12C39A-60AC-40B6-AD20-2E985B975C3A}"/>
          </ac:spMkLst>
        </pc:spChg>
        <pc:spChg chg="add mod topLvl">
          <ac:chgData name="Manasweeta Angane" userId="05da2731-9352-4b35-b713-60351f56afbd" providerId="ADAL" clId="{F5F97842-A295-4F9F-B89B-A63B35E1C32D}" dt="2022-10-22T05:19:00.516" v="18632" actId="164"/>
          <ac:spMkLst>
            <pc:docMk/>
            <pc:sldMk cId="3124133690" sldId="311"/>
            <ac:spMk id="86" creationId="{C82DEA89-D969-48E8-B118-CA9137A8DA79}"/>
          </ac:spMkLst>
        </pc:spChg>
        <pc:spChg chg="add mod topLvl">
          <ac:chgData name="Manasweeta Angane" userId="05da2731-9352-4b35-b713-60351f56afbd" providerId="ADAL" clId="{F5F97842-A295-4F9F-B89B-A63B35E1C32D}" dt="2022-10-22T05:19:00.516" v="18632" actId="164"/>
          <ac:spMkLst>
            <pc:docMk/>
            <pc:sldMk cId="3124133690" sldId="311"/>
            <ac:spMk id="87" creationId="{A7C8FEFA-763E-4A70-BEA1-0DBD9EEB82CE}"/>
          </ac:spMkLst>
        </pc:spChg>
        <pc:spChg chg="add mod topLvl">
          <ac:chgData name="Manasweeta Angane" userId="05da2731-9352-4b35-b713-60351f56afbd" providerId="ADAL" clId="{F5F97842-A295-4F9F-B89B-A63B35E1C32D}" dt="2022-10-22T05:19:00.516" v="18632" actId="164"/>
          <ac:spMkLst>
            <pc:docMk/>
            <pc:sldMk cId="3124133690" sldId="311"/>
            <ac:spMk id="88" creationId="{CBB2C059-BE4A-4915-B3A1-9969070A5525}"/>
          </ac:spMkLst>
        </pc:spChg>
        <pc:spChg chg="add mod">
          <ac:chgData name="Manasweeta Angane" userId="05da2731-9352-4b35-b713-60351f56afbd" providerId="ADAL" clId="{F5F97842-A295-4F9F-B89B-A63B35E1C32D}" dt="2022-10-22T05:17:06.094" v="18624" actId="1035"/>
          <ac:spMkLst>
            <pc:docMk/>
            <pc:sldMk cId="3124133690" sldId="311"/>
            <ac:spMk id="90" creationId="{264CF712-DC0C-4F57-B583-AC8FDCB32A00}"/>
          </ac:spMkLst>
        </pc:spChg>
        <pc:spChg chg="add mod">
          <ac:chgData name="Manasweeta Angane" userId="05da2731-9352-4b35-b713-60351f56afbd" providerId="ADAL" clId="{F5F97842-A295-4F9F-B89B-A63B35E1C32D}" dt="2022-10-22T05:19:00.516" v="18632" actId="164"/>
          <ac:spMkLst>
            <pc:docMk/>
            <pc:sldMk cId="3124133690" sldId="311"/>
            <ac:spMk id="95" creationId="{B50B3A51-6775-45C7-82C2-F529D46493DF}"/>
          </ac:spMkLst>
        </pc:spChg>
        <pc:spChg chg="add mod">
          <ac:chgData name="Manasweeta Angane" userId="05da2731-9352-4b35-b713-60351f56afbd" providerId="ADAL" clId="{F5F97842-A295-4F9F-B89B-A63B35E1C32D}" dt="2022-10-22T06:21:24.061" v="20015" actId="1037"/>
          <ac:spMkLst>
            <pc:docMk/>
            <pc:sldMk cId="3124133690" sldId="311"/>
            <ac:spMk id="97" creationId="{6A81BD7B-0D86-40D6-8877-7743A4122FA3}"/>
          </ac:spMkLst>
        </pc:spChg>
        <pc:spChg chg="mod">
          <ac:chgData name="Manasweeta Angane" userId="05da2731-9352-4b35-b713-60351f56afbd" providerId="ADAL" clId="{F5F97842-A295-4F9F-B89B-A63B35E1C32D}" dt="2022-10-22T05:22:16.881" v="18762" actId="571"/>
          <ac:spMkLst>
            <pc:docMk/>
            <pc:sldMk cId="3124133690" sldId="311"/>
            <ac:spMk id="101" creationId="{38D9B253-6FBB-40FC-AF48-428932FD89C6}"/>
          </ac:spMkLst>
        </pc:spChg>
        <pc:spChg chg="mod">
          <ac:chgData name="Manasweeta Angane" userId="05da2731-9352-4b35-b713-60351f56afbd" providerId="ADAL" clId="{F5F97842-A295-4F9F-B89B-A63B35E1C32D}" dt="2022-10-22T05:22:16.881" v="18762" actId="571"/>
          <ac:spMkLst>
            <pc:docMk/>
            <pc:sldMk cId="3124133690" sldId="311"/>
            <ac:spMk id="102" creationId="{3A8FCD4B-96C2-43B8-ABB9-8B67D0A3E332}"/>
          </ac:spMkLst>
        </pc:spChg>
        <pc:spChg chg="mod">
          <ac:chgData name="Manasweeta Angane" userId="05da2731-9352-4b35-b713-60351f56afbd" providerId="ADAL" clId="{F5F97842-A295-4F9F-B89B-A63B35E1C32D}" dt="2022-10-22T05:22:16.881" v="18762" actId="571"/>
          <ac:spMkLst>
            <pc:docMk/>
            <pc:sldMk cId="3124133690" sldId="311"/>
            <ac:spMk id="104" creationId="{6C9B69B1-5415-4493-A0F4-5EF362957059}"/>
          </ac:spMkLst>
        </pc:spChg>
        <pc:spChg chg="add mod">
          <ac:chgData name="Manasweeta Angane" userId="05da2731-9352-4b35-b713-60351f56afbd" providerId="ADAL" clId="{F5F97842-A295-4F9F-B89B-A63B35E1C32D}" dt="2022-10-22T06:47:23.918" v="20837" actId="164"/>
          <ac:spMkLst>
            <pc:docMk/>
            <pc:sldMk cId="3124133690" sldId="311"/>
            <ac:spMk id="115" creationId="{C52C4008-9287-4E09-93FD-28C4EB740E93}"/>
          </ac:spMkLst>
        </pc:spChg>
        <pc:spChg chg="add mod">
          <ac:chgData name="Manasweeta Angane" userId="05da2731-9352-4b35-b713-60351f56afbd" providerId="ADAL" clId="{F5F97842-A295-4F9F-B89B-A63B35E1C32D}" dt="2022-10-22T06:24:12.882" v="20140" actId="164"/>
          <ac:spMkLst>
            <pc:docMk/>
            <pc:sldMk cId="3124133690" sldId="311"/>
            <ac:spMk id="120" creationId="{0B2C87B8-CB49-4F7B-948D-4D783A766515}"/>
          </ac:spMkLst>
        </pc:spChg>
        <pc:spChg chg="add mod">
          <ac:chgData name="Manasweeta Angane" userId="05da2731-9352-4b35-b713-60351f56afbd" providerId="ADAL" clId="{F5F97842-A295-4F9F-B89B-A63B35E1C32D}" dt="2022-10-22T06:20:20.905" v="19970" actId="164"/>
          <ac:spMkLst>
            <pc:docMk/>
            <pc:sldMk cId="3124133690" sldId="311"/>
            <ac:spMk id="121" creationId="{4A78292E-6FC6-420E-97CB-C75E564BA3D7}"/>
          </ac:spMkLst>
        </pc:spChg>
        <pc:spChg chg="add mod">
          <ac:chgData name="Manasweeta Angane" userId="05da2731-9352-4b35-b713-60351f56afbd" providerId="ADAL" clId="{F5F97842-A295-4F9F-B89B-A63B35E1C32D}" dt="2022-10-22T06:20:20.905" v="19970" actId="164"/>
          <ac:spMkLst>
            <pc:docMk/>
            <pc:sldMk cId="3124133690" sldId="311"/>
            <ac:spMk id="122" creationId="{C4D2546E-1F8C-4AB9-826D-61C973C542CF}"/>
          </ac:spMkLst>
        </pc:spChg>
        <pc:spChg chg="add mod">
          <ac:chgData name="Manasweeta Angane" userId="05da2731-9352-4b35-b713-60351f56afbd" providerId="ADAL" clId="{F5F97842-A295-4F9F-B89B-A63B35E1C32D}" dt="2022-10-22T06:34:23.096" v="20319" actId="164"/>
          <ac:spMkLst>
            <pc:docMk/>
            <pc:sldMk cId="3124133690" sldId="311"/>
            <ac:spMk id="125" creationId="{8F784296-3627-4CB0-A1EA-7F4382EF2EB0}"/>
          </ac:spMkLst>
        </pc:spChg>
        <pc:spChg chg="add mod">
          <ac:chgData name="Manasweeta Angane" userId="05da2731-9352-4b35-b713-60351f56afbd" providerId="ADAL" clId="{F5F97842-A295-4F9F-B89B-A63B35E1C32D}" dt="2022-10-22T06:43:02.327" v="20760" actId="164"/>
          <ac:spMkLst>
            <pc:docMk/>
            <pc:sldMk cId="3124133690" sldId="311"/>
            <ac:spMk id="131" creationId="{286E390D-C26F-4B70-9173-3A3992429E78}"/>
          </ac:spMkLst>
        </pc:spChg>
        <pc:spChg chg="add mod">
          <ac:chgData name="Manasweeta Angane" userId="05da2731-9352-4b35-b713-60351f56afbd" providerId="ADAL" clId="{F5F97842-A295-4F9F-B89B-A63B35E1C32D}" dt="2022-10-22T06:43:06.791" v="20761" actId="164"/>
          <ac:spMkLst>
            <pc:docMk/>
            <pc:sldMk cId="3124133690" sldId="311"/>
            <ac:spMk id="132" creationId="{C28F270E-E343-4B39-A6B3-25147FFA4D95}"/>
          </ac:spMkLst>
        </pc:spChg>
        <pc:spChg chg="add mod">
          <ac:chgData name="Manasweeta Angane" userId="05da2731-9352-4b35-b713-60351f56afbd" providerId="ADAL" clId="{F5F97842-A295-4F9F-B89B-A63B35E1C32D}" dt="2022-10-22T06:47:23.918" v="20837" actId="164"/>
          <ac:spMkLst>
            <pc:docMk/>
            <pc:sldMk cId="3124133690" sldId="311"/>
            <ac:spMk id="137" creationId="{9BA52F8D-9BDB-4518-B1D6-2E33C5122FAC}"/>
          </ac:spMkLst>
        </pc:spChg>
        <pc:spChg chg="mod">
          <ac:chgData name="Manasweeta Angane" userId="05da2731-9352-4b35-b713-60351f56afbd" providerId="ADAL" clId="{F5F97842-A295-4F9F-B89B-A63B35E1C32D}" dt="2022-10-22T06:54:11.167" v="20865" actId="571"/>
          <ac:spMkLst>
            <pc:docMk/>
            <pc:sldMk cId="3124133690" sldId="311"/>
            <ac:spMk id="141" creationId="{A64B049F-9AF7-416C-8A98-3CA882E6D173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43" creationId="{6C0DDD82-D04E-44AB-AADF-4140928C45D2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44" creationId="{C6044383-2F62-44B4-BA71-CF8E40DB8F39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45" creationId="{C2A99BB9-68E8-4D6A-BDB8-DEB39F2DE85D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46" creationId="{78FEE5B1-A842-4ABA-873C-84ED77AD8F69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47" creationId="{0B0CC176-2031-49CB-AE28-1BDAEB60B77D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48" creationId="{7317F20F-9338-4563-A9ED-3E24A9633AB9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49" creationId="{DEC446B1-5E20-458C-AEA3-20676C79522B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50" creationId="{6A22AA7E-4FD8-4612-B642-E652A7085420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51" creationId="{5DC8F76C-C225-4C31-8F4E-9C0E61CBEB89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52" creationId="{FF717575-58FF-4C20-8067-C231CBBF6253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53" creationId="{F74EA559-D8F6-42FE-9537-B73EF96079E0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54" creationId="{0D250C9C-586A-48BF-A745-4A8CEFAB90B8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55" creationId="{9546C92F-E475-46EC-8FAA-47D746862F02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56" creationId="{69A2EECE-9F46-45F2-9B6C-4F3A41DF6277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57" creationId="{D4B86109-BDA8-4E85-B121-30C89972E78D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58" creationId="{6EAF1368-7597-46D3-BF3F-6B33A33487FF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59" creationId="{2B65E597-F173-4534-BCF7-D0F681E5BAE9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60" creationId="{72EFC0FF-2484-4E95-BE2B-05BA4BF748F9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61" creationId="{451454E0-8196-49DF-AF91-B4AF4CB972D5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62" creationId="{E4F0E056-3B65-414F-9F44-9DC6EE9BB2A5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63" creationId="{BEF244AB-76E8-42ED-8628-61BCF8F9EDE1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64" creationId="{E74242B4-D627-4039-ABEC-9C9AE92E6451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65" creationId="{CCF903F3-5489-474A-A67D-40C24474419C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66" creationId="{1206E83B-5B94-404A-87AE-33F783C01678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67" creationId="{1FDEE572-F647-4037-B307-725D38BB6598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68" creationId="{E83D5F90-94DF-41B4-B8D6-5B6389D3E73B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69" creationId="{F5AEC232-9090-4C77-909F-61561610B68A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70" creationId="{2A46B8CF-7C10-45B7-9814-6DB6B6D1AA2F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71" creationId="{5FD4B2CB-C3F3-4E15-AEB9-6C1A31C62A8E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72" creationId="{F249B5A9-F8D1-407F-8358-3B52DA33EA48}"/>
          </ac:spMkLst>
        </pc:spChg>
        <pc:spChg chg="mod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73" creationId="{5736ACC1-D637-4EC6-AEAA-7C99E353D9B2}"/>
          </ac:spMkLst>
        </pc:spChg>
        <pc:spChg chg="mod topLvl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248" creationId="{35CDBE6C-DB91-4344-AA5A-FB39101864EA}"/>
          </ac:spMkLst>
        </pc:spChg>
        <pc:spChg chg="mod topLvl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249" creationId="{139AB0CB-0D3E-41BE-A542-ED7E0B7D915C}"/>
          </ac:spMkLst>
        </pc:spChg>
        <pc:spChg chg="mod topLvl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250" creationId="{B7ECD312-1882-4CE6-8AF8-F6B12714807F}"/>
          </ac:spMkLst>
        </pc:spChg>
        <pc:spChg chg="mod topLvl">
          <ac:chgData name="Manasweeta Angane" userId="05da2731-9352-4b35-b713-60351f56afbd" providerId="ADAL" clId="{F5F97842-A295-4F9F-B89B-A63B35E1C32D}" dt="2022-10-22T06:52:31.097" v="20849" actId="165"/>
          <ac:spMkLst>
            <pc:docMk/>
            <pc:sldMk cId="3124133690" sldId="311"/>
            <ac:spMk id="1071" creationId="{7C8CB4CB-5602-4FCE-85E3-0B41816B967A}"/>
          </ac:spMkLst>
        </pc:spChg>
        <pc:grpChg chg="add del mod">
          <ac:chgData name="Manasweeta Angane" userId="05da2731-9352-4b35-b713-60351f56afbd" providerId="ADAL" clId="{F5F97842-A295-4F9F-B89B-A63B35E1C32D}" dt="2022-10-22T06:52:24.961" v="20848" actId="165"/>
          <ac:grpSpMkLst>
            <pc:docMk/>
            <pc:sldMk cId="3124133690" sldId="311"/>
            <ac:grpSpMk id="20" creationId="{A748ACAF-53E2-441F-AD55-7A8B91A1A09C}"/>
          </ac:grpSpMkLst>
        </pc:grpChg>
        <pc:grpChg chg="add mod">
          <ac:chgData name="Manasweeta Angane" userId="05da2731-9352-4b35-b713-60351f56afbd" providerId="ADAL" clId="{F5F97842-A295-4F9F-B89B-A63B35E1C32D}" dt="2022-10-22T04:21:02.745" v="17808" actId="1038"/>
          <ac:grpSpMkLst>
            <pc:docMk/>
            <pc:sldMk cId="3124133690" sldId="311"/>
            <ac:grpSpMk id="21" creationId="{5CFB8308-9787-45CD-AFBE-48C009BBCCD6}"/>
          </ac:grpSpMkLst>
        </pc:grpChg>
        <pc:grpChg chg="add mod">
          <ac:chgData name="Manasweeta Angane" userId="05da2731-9352-4b35-b713-60351f56afbd" providerId="ADAL" clId="{F5F97842-A295-4F9F-B89B-A63B35E1C32D}" dt="2022-10-22T06:01:10.126" v="19373" actId="1076"/>
          <ac:grpSpMkLst>
            <pc:docMk/>
            <pc:sldMk cId="3124133690" sldId="311"/>
            <ac:grpSpMk id="22" creationId="{05599663-ACA8-426C-BFE2-C506AF4099E9}"/>
          </ac:grpSpMkLst>
        </pc:grpChg>
        <pc:grpChg chg="add mod">
          <ac:chgData name="Manasweeta Angane" userId="05da2731-9352-4b35-b713-60351f56afbd" providerId="ADAL" clId="{F5F97842-A295-4F9F-B89B-A63B35E1C32D}" dt="2022-10-22T06:43:42.357" v="20768" actId="12789"/>
          <ac:grpSpMkLst>
            <pc:docMk/>
            <pc:sldMk cId="3124133690" sldId="311"/>
            <ac:grpSpMk id="23" creationId="{3E94874F-79FA-4FC4-9829-5BFA3F87144A}"/>
          </ac:grpSpMkLst>
        </pc:grpChg>
        <pc:grpChg chg="add mod">
          <ac:chgData name="Manasweeta Angane" userId="05da2731-9352-4b35-b713-60351f56afbd" providerId="ADAL" clId="{F5F97842-A295-4F9F-B89B-A63B35E1C32D}" dt="2022-10-22T05:22:32.594" v="18764" actId="164"/>
          <ac:grpSpMkLst>
            <pc:docMk/>
            <pc:sldMk cId="3124133690" sldId="311"/>
            <ac:grpSpMk id="25" creationId="{4BAE3B65-BEB8-492D-86AC-9C06F46DE22E}"/>
          </ac:grpSpMkLst>
        </pc:grpChg>
        <pc:grpChg chg="add mod topLvl">
          <ac:chgData name="Manasweeta Angane" userId="05da2731-9352-4b35-b713-60351f56afbd" providerId="ADAL" clId="{F5F97842-A295-4F9F-B89B-A63B35E1C32D}" dt="2022-10-22T05:09:45.911" v="18512" actId="164"/>
          <ac:grpSpMkLst>
            <pc:docMk/>
            <pc:sldMk cId="3124133690" sldId="311"/>
            <ac:grpSpMk id="27" creationId="{8B4AF89A-4650-4DC0-8414-2421483F13A2}"/>
          </ac:grpSpMkLst>
        </pc:grpChg>
        <pc:grpChg chg="add del mod topLvl">
          <ac:chgData name="Manasweeta Angane" userId="05da2731-9352-4b35-b713-60351f56afbd" providerId="ADAL" clId="{F5F97842-A295-4F9F-B89B-A63B35E1C32D}" dt="2022-10-22T05:07:45.903" v="18469" actId="165"/>
          <ac:grpSpMkLst>
            <pc:docMk/>
            <pc:sldMk cId="3124133690" sldId="311"/>
            <ac:grpSpMk id="28" creationId="{8D87E9CE-8710-4EEA-8BBF-3C0BBA0A4652}"/>
          </ac:grpSpMkLst>
        </pc:grpChg>
        <pc:grpChg chg="add del mod">
          <ac:chgData name="Manasweeta Angane" userId="05da2731-9352-4b35-b713-60351f56afbd" providerId="ADAL" clId="{F5F97842-A295-4F9F-B89B-A63B35E1C32D}" dt="2022-10-22T05:06:43.847" v="18461" actId="165"/>
          <ac:grpSpMkLst>
            <pc:docMk/>
            <pc:sldMk cId="3124133690" sldId="311"/>
            <ac:grpSpMk id="29" creationId="{B7E3D9AD-9A23-4E1D-82DC-53DE6C400C62}"/>
          </ac:grpSpMkLst>
        </pc:grpChg>
        <pc:grpChg chg="add mod">
          <ac:chgData name="Manasweeta Angane" userId="05da2731-9352-4b35-b713-60351f56afbd" providerId="ADAL" clId="{F5F97842-A295-4F9F-B89B-A63B35E1C32D}" dt="2022-10-22T05:22:23.355" v="18763" actId="164"/>
          <ac:grpSpMkLst>
            <pc:docMk/>
            <pc:sldMk cId="3124133690" sldId="311"/>
            <ac:grpSpMk id="30" creationId="{4F691DE7-53CE-4B5E-A030-0E2A745A1954}"/>
          </ac:grpSpMkLst>
        </pc:grpChg>
        <pc:grpChg chg="add mod">
          <ac:chgData name="Manasweeta Angane" userId="05da2731-9352-4b35-b713-60351f56afbd" providerId="ADAL" clId="{F5F97842-A295-4F9F-B89B-A63B35E1C32D}" dt="2022-10-22T05:22:16.881" v="18762" actId="571"/>
          <ac:grpSpMkLst>
            <pc:docMk/>
            <pc:sldMk cId="3124133690" sldId="311"/>
            <ac:grpSpMk id="99" creationId="{8995A7A1-3BCA-4468-84F2-B61213121A04}"/>
          </ac:grpSpMkLst>
        </pc:grpChg>
        <pc:grpChg chg="mod">
          <ac:chgData name="Manasweeta Angane" userId="05da2731-9352-4b35-b713-60351f56afbd" providerId="ADAL" clId="{F5F97842-A295-4F9F-B89B-A63B35E1C32D}" dt="2022-10-22T05:22:16.881" v="18762" actId="571"/>
          <ac:grpSpMkLst>
            <pc:docMk/>
            <pc:sldMk cId="3124133690" sldId="311"/>
            <ac:grpSpMk id="100" creationId="{B8CC375E-D5C7-4F75-9119-D043125E3FFC}"/>
          </ac:grpSpMkLst>
        </pc:grpChg>
        <pc:grpChg chg="add mod">
          <ac:chgData name="Manasweeta Angane" userId="05da2731-9352-4b35-b713-60351f56afbd" providerId="ADAL" clId="{F5F97842-A295-4F9F-B89B-A63B35E1C32D}" dt="2022-10-22T06:54:11.167" v="20865" actId="571"/>
          <ac:grpSpMkLst>
            <pc:docMk/>
            <pc:sldMk cId="3124133690" sldId="311"/>
            <ac:grpSpMk id="139" creationId="{E27EB0E4-706B-4DC5-9B84-28601B1125C6}"/>
          </ac:grpSpMkLst>
        </pc:grpChg>
        <pc:grpChg chg="mod topLvl">
          <ac:chgData name="Manasweeta Angane" userId="05da2731-9352-4b35-b713-60351f56afbd" providerId="ADAL" clId="{F5F97842-A295-4F9F-B89B-A63B35E1C32D}" dt="2022-10-22T06:52:31.097" v="20849" actId="165"/>
          <ac:grpSpMkLst>
            <pc:docMk/>
            <pc:sldMk cId="3124133690" sldId="311"/>
            <ac:grpSpMk id="142" creationId="{D238E638-4CA2-4C58-ACA0-4D137508B1A1}"/>
          </ac:grpSpMkLst>
        </pc:grpChg>
        <pc:grpChg chg="add mod">
          <ac:chgData name="Manasweeta Angane" userId="05da2731-9352-4b35-b713-60351f56afbd" providerId="ADAL" clId="{F5F97842-A295-4F9F-B89B-A63B35E1C32D}" dt="2022-10-22T05:22:23.355" v="18763" actId="164"/>
          <ac:grpSpMkLst>
            <pc:docMk/>
            <pc:sldMk cId="3124133690" sldId="311"/>
            <ac:grpSpMk id="227" creationId="{E1EE20B2-0A4D-40AD-8648-DF63A08E5553}"/>
          </ac:grpSpMkLst>
        </pc:grpChg>
        <pc:grpChg chg="add mod">
          <ac:chgData name="Manasweeta Angane" userId="05da2731-9352-4b35-b713-60351f56afbd" providerId="ADAL" clId="{F5F97842-A295-4F9F-B89B-A63B35E1C32D}" dt="2022-10-22T05:22:38.946" v="18765" actId="164"/>
          <ac:grpSpMkLst>
            <pc:docMk/>
            <pc:sldMk cId="3124133690" sldId="311"/>
            <ac:grpSpMk id="228" creationId="{3654CA47-74CC-405D-9870-082A97B04B2D}"/>
          </ac:grpSpMkLst>
        </pc:grpChg>
        <pc:grpChg chg="add mod">
          <ac:chgData name="Manasweeta Angane" userId="05da2731-9352-4b35-b713-60351f56afbd" providerId="ADAL" clId="{F5F97842-A295-4F9F-B89B-A63B35E1C32D}" dt="2022-10-22T05:22:49.223" v="18773" actId="1035"/>
          <ac:grpSpMkLst>
            <pc:docMk/>
            <pc:sldMk cId="3124133690" sldId="311"/>
            <ac:grpSpMk id="229" creationId="{85B6F95C-387C-4FA3-86C4-1EFF95361AE9}"/>
          </ac:grpSpMkLst>
        </pc:grpChg>
        <pc:grpChg chg="add mod">
          <ac:chgData name="Manasweeta Angane" userId="05da2731-9352-4b35-b713-60351f56afbd" providerId="ADAL" clId="{F5F97842-A295-4F9F-B89B-A63B35E1C32D}" dt="2022-10-22T05:23:52.405" v="18906" actId="1035"/>
          <ac:grpSpMkLst>
            <pc:docMk/>
            <pc:sldMk cId="3124133690" sldId="311"/>
            <ac:grpSpMk id="230" creationId="{CEE69124-CBDC-483E-9A72-1D2697141F1C}"/>
          </ac:grpSpMkLst>
        </pc:grpChg>
        <pc:grpChg chg="add mod">
          <ac:chgData name="Manasweeta Angane" userId="05da2731-9352-4b35-b713-60351f56afbd" providerId="ADAL" clId="{F5F97842-A295-4F9F-B89B-A63B35E1C32D}" dt="2022-10-22T06:47:23.918" v="20837" actId="164"/>
          <ac:grpSpMkLst>
            <pc:docMk/>
            <pc:sldMk cId="3124133690" sldId="311"/>
            <ac:grpSpMk id="231" creationId="{0E43E59D-ED60-4D11-868A-824D3846EF65}"/>
          </ac:grpSpMkLst>
        </pc:grpChg>
        <pc:grpChg chg="add mod">
          <ac:chgData name="Manasweeta Angane" userId="05da2731-9352-4b35-b713-60351f56afbd" providerId="ADAL" clId="{F5F97842-A295-4F9F-B89B-A63B35E1C32D}" dt="2022-10-22T06:34:23.096" v="20319" actId="164"/>
          <ac:grpSpMkLst>
            <pc:docMk/>
            <pc:sldMk cId="3124133690" sldId="311"/>
            <ac:grpSpMk id="234" creationId="{82CF6C1B-A61A-49C1-ACD8-831543C8CFF8}"/>
          </ac:grpSpMkLst>
        </pc:grpChg>
        <pc:grpChg chg="add mod">
          <ac:chgData name="Manasweeta Angane" userId="05da2731-9352-4b35-b713-60351f56afbd" providerId="ADAL" clId="{F5F97842-A295-4F9F-B89B-A63B35E1C32D}" dt="2022-10-22T06:35:18.897" v="20320" actId="12788"/>
          <ac:grpSpMkLst>
            <pc:docMk/>
            <pc:sldMk cId="3124133690" sldId="311"/>
            <ac:grpSpMk id="235" creationId="{9D96D2E8-FECB-4FF0-AD3A-145625EA7531}"/>
          </ac:grpSpMkLst>
        </pc:grpChg>
        <pc:grpChg chg="add mod">
          <ac:chgData name="Manasweeta Angane" userId="05da2731-9352-4b35-b713-60351f56afbd" providerId="ADAL" clId="{F5F97842-A295-4F9F-B89B-A63B35E1C32D}" dt="2022-10-22T06:35:18.897" v="20320" actId="12788"/>
          <ac:grpSpMkLst>
            <pc:docMk/>
            <pc:sldMk cId="3124133690" sldId="311"/>
            <ac:grpSpMk id="236" creationId="{2DFCB3E0-46E1-4AA1-83F2-636064B4BA1B}"/>
          </ac:grpSpMkLst>
        </pc:grpChg>
        <pc:grpChg chg="add mod">
          <ac:chgData name="Manasweeta Angane" userId="05da2731-9352-4b35-b713-60351f56afbd" providerId="ADAL" clId="{F5F97842-A295-4F9F-B89B-A63B35E1C32D}" dt="2022-10-22T06:43:27.240" v="20763" actId="164"/>
          <ac:grpSpMkLst>
            <pc:docMk/>
            <pc:sldMk cId="3124133690" sldId="311"/>
            <ac:grpSpMk id="239" creationId="{35CBDE6F-08E3-4BFA-860C-BA885267B74A}"/>
          </ac:grpSpMkLst>
        </pc:grpChg>
        <pc:grpChg chg="add mod">
          <ac:chgData name="Manasweeta Angane" userId="05da2731-9352-4b35-b713-60351f56afbd" providerId="ADAL" clId="{F5F97842-A295-4F9F-B89B-A63B35E1C32D}" dt="2022-10-22T06:43:27.240" v="20763" actId="164"/>
          <ac:grpSpMkLst>
            <pc:docMk/>
            <pc:sldMk cId="3124133690" sldId="311"/>
            <ac:grpSpMk id="240" creationId="{BD7200D5-1F7E-4955-8F86-CDF8D672DB55}"/>
          </ac:grpSpMkLst>
        </pc:grpChg>
        <pc:grpChg chg="add mod">
          <ac:chgData name="Manasweeta Angane" userId="05da2731-9352-4b35-b713-60351f56afbd" providerId="ADAL" clId="{F5F97842-A295-4F9F-B89B-A63B35E1C32D}" dt="2022-10-22T06:43:42.357" v="20768" actId="12789"/>
          <ac:grpSpMkLst>
            <pc:docMk/>
            <pc:sldMk cId="3124133690" sldId="311"/>
            <ac:grpSpMk id="241" creationId="{30BCD7D0-D545-408D-A9D9-8D2B3827E83A}"/>
          </ac:grpSpMkLst>
        </pc:grpChg>
        <pc:grpChg chg="add mod">
          <ac:chgData name="Manasweeta Angane" userId="05da2731-9352-4b35-b713-60351f56afbd" providerId="ADAL" clId="{F5F97842-A295-4F9F-B89B-A63B35E1C32D}" dt="2022-10-22T06:47:23.918" v="20837" actId="164"/>
          <ac:grpSpMkLst>
            <pc:docMk/>
            <pc:sldMk cId="3124133690" sldId="311"/>
            <ac:grpSpMk id="243" creationId="{72934B66-7218-4FA2-A2A7-49720ABF9B89}"/>
          </ac:grpSpMkLst>
        </pc:grpChg>
        <pc:grpChg chg="del mod topLvl">
          <ac:chgData name="Manasweeta Angane" userId="05da2731-9352-4b35-b713-60351f56afbd" providerId="ADAL" clId="{F5F97842-A295-4F9F-B89B-A63B35E1C32D}" dt="2022-10-22T06:52:31.097" v="20849" actId="165"/>
          <ac:grpSpMkLst>
            <pc:docMk/>
            <pc:sldMk cId="3124133690" sldId="311"/>
            <ac:grpSpMk id="1077" creationId="{22BFD680-F981-4767-9235-F264FBF8D11C}"/>
          </ac:grpSpMkLst>
        </pc:grpChg>
        <pc:graphicFrameChg chg="add del mod modGraphic">
          <ac:chgData name="Manasweeta Angane" userId="05da2731-9352-4b35-b713-60351f56afbd" providerId="ADAL" clId="{F5F97842-A295-4F9F-B89B-A63B35E1C32D}" dt="2022-10-22T03:09:54.616" v="16893" actId="478"/>
          <ac:graphicFrameMkLst>
            <pc:docMk/>
            <pc:sldMk cId="3124133690" sldId="311"/>
            <ac:graphicFrameMk id="14" creationId="{A2705259-526D-44DC-BD75-DBD15D54A6B2}"/>
          </ac:graphicFrameMkLst>
        </pc:graphicFrameChg>
        <pc:graphicFrameChg chg="add del mod modGraphic">
          <ac:chgData name="Manasweeta Angane" userId="05da2731-9352-4b35-b713-60351f56afbd" providerId="ADAL" clId="{F5F97842-A295-4F9F-B89B-A63B35E1C32D}" dt="2022-10-22T03:09:53.035" v="16892" actId="478"/>
          <ac:graphicFrameMkLst>
            <pc:docMk/>
            <pc:sldMk cId="3124133690" sldId="311"/>
            <ac:graphicFrameMk id="15" creationId="{50825B9B-D03B-4C7C-9040-C697F87D5059}"/>
          </ac:graphicFrameMkLst>
        </pc:graphicFrameChg>
        <pc:graphicFrameChg chg="add del mod">
          <ac:chgData name="Manasweeta Angane" userId="05da2731-9352-4b35-b713-60351f56afbd" providerId="ADAL" clId="{F5F97842-A295-4F9F-B89B-A63B35E1C32D}" dt="2022-10-22T02:54:21.522" v="16810" actId="478"/>
          <ac:graphicFrameMkLst>
            <pc:docMk/>
            <pc:sldMk cId="3124133690" sldId="311"/>
            <ac:graphicFrameMk id="60" creationId="{B103486C-4F09-4A44-8D67-9522F6879C9C}"/>
          </ac:graphicFrameMkLst>
        </pc:graphicFrameChg>
        <pc:picChg chg="mod modCrop">
          <ac:chgData name="Manasweeta Angane" userId="05da2731-9352-4b35-b713-60351f56afbd" providerId="ADAL" clId="{F5F97842-A295-4F9F-B89B-A63B35E1C32D}" dt="2022-10-22T04:10:25.386" v="17367" actId="164"/>
          <ac:picMkLst>
            <pc:docMk/>
            <pc:sldMk cId="3124133690" sldId="311"/>
            <ac:picMk id="2" creationId="{A4EDEA74-FCD4-434E-A13A-8EAFE5A72D8B}"/>
          </ac:picMkLst>
        </pc:picChg>
        <pc:picChg chg="mod">
          <ac:chgData name="Manasweeta Angane" userId="05da2731-9352-4b35-b713-60351f56afbd" providerId="ADAL" clId="{F5F97842-A295-4F9F-B89B-A63B35E1C32D}" dt="2022-10-22T06:19:49.205" v="19965" actId="1036"/>
          <ac:picMkLst>
            <pc:docMk/>
            <pc:sldMk cId="3124133690" sldId="311"/>
            <ac:picMk id="9" creationId="{9CFD5098-D197-40D2-BF3B-0EFEF6105E56}"/>
          </ac:picMkLst>
        </pc:picChg>
        <pc:picChg chg="mod">
          <ac:chgData name="Manasweeta Angane" userId="05da2731-9352-4b35-b713-60351f56afbd" providerId="ADAL" clId="{F5F97842-A295-4F9F-B89B-A63B35E1C32D}" dt="2022-10-22T06:19:33.789" v="19954" actId="1035"/>
          <ac:picMkLst>
            <pc:docMk/>
            <pc:sldMk cId="3124133690" sldId="311"/>
            <ac:picMk id="10" creationId="{64FA096A-8156-4287-968E-CF843C012768}"/>
          </ac:picMkLst>
        </pc:picChg>
        <pc:picChg chg="add del mod">
          <ac:chgData name="Manasweeta Angane" userId="05da2731-9352-4b35-b713-60351f56afbd" providerId="ADAL" clId="{F5F97842-A295-4F9F-B89B-A63B35E1C32D}" dt="2022-10-22T02:17:03.640" v="16608" actId="478"/>
          <ac:picMkLst>
            <pc:docMk/>
            <pc:sldMk cId="3124133690" sldId="311"/>
            <ac:picMk id="11" creationId="{D9F48CA9-F588-482C-9580-6F1F1FF9946C}"/>
          </ac:picMkLst>
        </pc:picChg>
        <pc:picChg chg="add del mod modCrop">
          <ac:chgData name="Manasweeta Angane" userId="05da2731-9352-4b35-b713-60351f56afbd" providerId="ADAL" clId="{F5F97842-A295-4F9F-B89B-A63B35E1C32D}" dt="2022-10-22T02:29:06.175" v="16625" actId="478"/>
          <ac:picMkLst>
            <pc:docMk/>
            <pc:sldMk cId="3124133690" sldId="311"/>
            <ac:picMk id="12" creationId="{1CE34E43-95BD-4FF5-A5E9-07AF3791C9CF}"/>
          </ac:picMkLst>
        </pc:picChg>
        <pc:picChg chg="mod modCrop">
          <ac:chgData name="Manasweeta Angane" userId="05da2731-9352-4b35-b713-60351f56afbd" providerId="ADAL" clId="{F5F97842-A295-4F9F-B89B-A63B35E1C32D}" dt="2022-10-22T04:13:16.555" v="17410" actId="164"/>
          <ac:picMkLst>
            <pc:docMk/>
            <pc:sldMk cId="3124133690" sldId="311"/>
            <ac:picMk id="13" creationId="{C220CC71-3C72-430B-A254-4D23667C2784}"/>
          </ac:picMkLst>
        </pc:picChg>
        <pc:picChg chg="mod modCrop">
          <ac:chgData name="Manasweeta Angane" userId="05da2731-9352-4b35-b713-60351f56afbd" providerId="ADAL" clId="{F5F97842-A295-4F9F-B89B-A63B35E1C32D}" dt="2022-10-22T04:13:16.555" v="17410" actId="164"/>
          <ac:picMkLst>
            <pc:docMk/>
            <pc:sldMk cId="3124133690" sldId="311"/>
            <ac:picMk id="16" creationId="{60076562-6219-4705-B689-0681A808397F}"/>
          </ac:picMkLst>
        </pc:picChg>
        <pc:picChg chg="del mod modCrop">
          <ac:chgData name="Manasweeta Angane" userId="05da2731-9352-4b35-b713-60351f56afbd" providerId="ADAL" clId="{F5F97842-A295-4F9F-B89B-A63B35E1C32D}" dt="2022-10-22T03:25:30.624" v="16904" actId="478"/>
          <ac:picMkLst>
            <pc:docMk/>
            <pc:sldMk cId="3124133690" sldId="311"/>
            <ac:picMk id="17" creationId="{B8EA9F13-0473-4882-A3DB-866833655926}"/>
          </ac:picMkLst>
        </pc:picChg>
        <pc:picChg chg="mod modCrop">
          <ac:chgData name="Manasweeta Angane" userId="05da2731-9352-4b35-b713-60351f56afbd" providerId="ADAL" clId="{F5F97842-A295-4F9F-B89B-A63B35E1C32D}" dt="2022-10-22T04:19:23.372" v="17643" actId="164"/>
          <ac:picMkLst>
            <pc:docMk/>
            <pc:sldMk cId="3124133690" sldId="311"/>
            <ac:picMk id="19" creationId="{50454113-D0D8-4EEC-A945-B7801736EE15}"/>
          </ac:picMkLst>
        </pc:picChg>
        <pc:picChg chg="mod">
          <ac:chgData name="Manasweeta Angane" userId="05da2731-9352-4b35-b713-60351f56afbd" providerId="ADAL" clId="{F5F97842-A295-4F9F-B89B-A63B35E1C32D}" dt="2022-10-22T05:10:49.920" v="18535" actId="1035"/>
          <ac:picMkLst>
            <pc:docMk/>
            <pc:sldMk cId="3124133690" sldId="311"/>
            <ac:picMk id="24" creationId="{7D08EAB5-DB09-4628-BDB7-01213D578686}"/>
          </ac:picMkLst>
        </pc:picChg>
        <pc:picChg chg="add mod">
          <ac:chgData name="Manasweeta Angane" userId="05da2731-9352-4b35-b713-60351f56afbd" providerId="ADAL" clId="{F5F97842-A295-4F9F-B89B-A63B35E1C32D}" dt="2022-10-22T03:50:30.984" v="16945" actId="571"/>
          <ac:picMkLst>
            <pc:docMk/>
            <pc:sldMk cId="3124133690" sldId="311"/>
            <ac:picMk id="65" creationId="{AD27ABF6-7C2B-410A-8DCE-F2C039C36496}"/>
          </ac:picMkLst>
        </pc:picChg>
        <pc:picChg chg="add mod">
          <ac:chgData name="Manasweeta Angane" userId="05da2731-9352-4b35-b713-60351f56afbd" providerId="ADAL" clId="{F5F97842-A295-4F9F-B89B-A63B35E1C32D}" dt="2022-10-22T04:29:28.845" v="17841" actId="164"/>
          <ac:picMkLst>
            <pc:docMk/>
            <pc:sldMk cId="3124133690" sldId="311"/>
            <ac:picMk id="74" creationId="{53A809EB-C49F-4FD3-8922-01791062871B}"/>
          </ac:picMkLst>
        </pc:picChg>
        <pc:picChg chg="add mod">
          <ac:chgData name="Manasweeta Angane" userId="05da2731-9352-4b35-b713-60351f56afbd" providerId="ADAL" clId="{F5F97842-A295-4F9F-B89B-A63B35E1C32D}" dt="2022-10-22T04:29:28.845" v="17841" actId="164"/>
          <ac:picMkLst>
            <pc:docMk/>
            <pc:sldMk cId="3124133690" sldId="311"/>
            <ac:picMk id="75" creationId="{BDDB013B-0C16-442A-BB08-79114FA0D286}"/>
          </ac:picMkLst>
        </pc:picChg>
        <pc:picChg chg="mod">
          <ac:chgData name="Manasweeta Angane" userId="05da2731-9352-4b35-b713-60351f56afbd" providerId="ADAL" clId="{F5F97842-A295-4F9F-B89B-A63B35E1C32D}" dt="2022-10-22T05:22:16.881" v="18762" actId="571"/>
          <ac:picMkLst>
            <pc:docMk/>
            <pc:sldMk cId="3124133690" sldId="311"/>
            <ac:picMk id="103" creationId="{665EC926-F1C9-41C2-9ADE-3C61DC205CCF}"/>
          </ac:picMkLst>
        </pc:picChg>
        <pc:picChg chg="add mod">
          <ac:chgData name="Manasweeta Angane" userId="05da2731-9352-4b35-b713-60351f56afbd" providerId="ADAL" clId="{F5F97842-A295-4F9F-B89B-A63B35E1C32D}" dt="2022-10-22T05:38:52.579" v="18917" actId="164"/>
          <ac:picMkLst>
            <pc:docMk/>
            <pc:sldMk cId="3124133690" sldId="311"/>
            <ac:picMk id="109" creationId="{91293A49-C3F6-4C9C-B9C1-DC1F75786907}"/>
          </ac:picMkLst>
        </pc:picChg>
        <pc:picChg chg="add del mod">
          <ac:chgData name="Manasweeta Angane" userId="05da2731-9352-4b35-b713-60351f56afbd" providerId="ADAL" clId="{F5F97842-A295-4F9F-B89B-A63B35E1C32D}" dt="2022-10-22T05:30:36.795" v="18910"/>
          <ac:picMkLst>
            <pc:docMk/>
            <pc:sldMk cId="3124133690" sldId="311"/>
            <ac:picMk id="110" creationId="{C249E0AC-E59F-4C1A-A48A-4F4E50BBDE2F}"/>
          </ac:picMkLst>
        </pc:picChg>
        <pc:picChg chg="add mod">
          <ac:chgData name="Manasweeta Angane" userId="05da2731-9352-4b35-b713-60351f56afbd" providerId="ADAL" clId="{F5F97842-A295-4F9F-B89B-A63B35E1C32D}" dt="2022-10-22T05:38:52.579" v="18917" actId="164"/>
          <ac:picMkLst>
            <pc:docMk/>
            <pc:sldMk cId="3124133690" sldId="311"/>
            <ac:picMk id="111" creationId="{F07DB223-C138-4E07-BC50-0B8010EB2382}"/>
          </ac:picMkLst>
        </pc:picChg>
        <pc:picChg chg="mod">
          <ac:chgData name="Manasweeta Angane" userId="05da2731-9352-4b35-b713-60351f56afbd" providerId="ADAL" clId="{F5F97842-A295-4F9F-B89B-A63B35E1C32D}" dt="2022-10-22T06:54:11.167" v="20865" actId="571"/>
          <ac:picMkLst>
            <pc:docMk/>
            <pc:sldMk cId="3124133690" sldId="311"/>
            <ac:picMk id="140" creationId="{9E44E037-9E5E-411C-AAC1-40C475CCE8B0}"/>
          </ac:picMkLst>
        </pc:picChg>
        <pc:picChg chg="add del mod modCrop">
          <ac:chgData name="Manasweeta Angane" userId="05da2731-9352-4b35-b713-60351f56afbd" providerId="ADAL" clId="{F5F97842-A295-4F9F-B89B-A63B35E1C32D}" dt="2022-10-22T06:24:12.882" v="20140" actId="164"/>
          <ac:picMkLst>
            <pc:docMk/>
            <pc:sldMk cId="3124133690" sldId="311"/>
            <ac:picMk id="232" creationId="{0F180423-B61D-4515-9EE0-34E7C3331FA6}"/>
          </ac:picMkLst>
        </pc:picChg>
        <pc:picChg chg="add del mod modCrop">
          <ac:chgData name="Manasweeta Angane" userId="05da2731-9352-4b35-b713-60351f56afbd" providerId="ADAL" clId="{F5F97842-A295-4F9F-B89B-A63B35E1C32D}" dt="2022-10-22T06:20:20.905" v="19970" actId="164"/>
          <ac:picMkLst>
            <pc:docMk/>
            <pc:sldMk cId="3124133690" sldId="311"/>
            <ac:picMk id="233" creationId="{377B2B18-8E2C-4830-8B2B-BC202502D2DF}"/>
          </ac:picMkLst>
        </pc:picChg>
        <pc:picChg chg="mod">
          <ac:chgData name="Manasweeta Angane" userId="05da2731-9352-4b35-b713-60351f56afbd" providerId="ADAL" clId="{F5F97842-A295-4F9F-B89B-A63B35E1C32D}" dt="2022-10-22T06:43:02.327" v="20760" actId="164"/>
          <ac:picMkLst>
            <pc:docMk/>
            <pc:sldMk cId="3124133690" sldId="311"/>
            <ac:picMk id="237" creationId="{27C3AD6D-E755-4E0C-849F-21910F6641B1}"/>
          </ac:picMkLst>
        </pc:picChg>
        <pc:picChg chg="mod">
          <ac:chgData name="Manasweeta Angane" userId="05da2731-9352-4b35-b713-60351f56afbd" providerId="ADAL" clId="{F5F97842-A295-4F9F-B89B-A63B35E1C32D}" dt="2022-10-22T06:43:06.791" v="20761" actId="164"/>
          <ac:picMkLst>
            <pc:docMk/>
            <pc:sldMk cId="3124133690" sldId="311"/>
            <ac:picMk id="238" creationId="{285E09D0-9C26-45B2-B731-AB50FF658DFC}"/>
          </ac:picMkLst>
        </pc:picChg>
        <pc:picChg chg="del">
          <ac:chgData name="Manasweeta Angane" userId="05da2731-9352-4b35-b713-60351f56afbd" providerId="ADAL" clId="{F5F97842-A295-4F9F-B89B-A63B35E1C32D}" dt="2022-10-21T10:58:45.699" v="15396" actId="478"/>
          <ac:picMkLst>
            <pc:docMk/>
            <pc:sldMk cId="3124133690" sldId="311"/>
            <ac:picMk id="1068" creationId="{4687DF4E-4211-479C-9CB8-0EC62ECCC299}"/>
          </ac:picMkLst>
        </pc:picChg>
        <pc:picChg chg="del">
          <ac:chgData name="Manasweeta Angane" userId="05da2731-9352-4b35-b713-60351f56afbd" providerId="ADAL" clId="{F5F97842-A295-4F9F-B89B-A63B35E1C32D}" dt="2022-10-21T10:58:47.170" v="15397" actId="478"/>
          <ac:picMkLst>
            <pc:docMk/>
            <pc:sldMk cId="3124133690" sldId="311"/>
            <ac:picMk id="1070" creationId="{0C2451D6-5DA3-4BE3-893D-9B2179C65B7C}"/>
          </ac:picMkLst>
        </pc:picChg>
        <pc:picChg chg="del">
          <ac:chgData name="Manasweeta Angane" userId="05da2731-9352-4b35-b713-60351f56afbd" providerId="ADAL" clId="{F5F97842-A295-4F9F-B89B-A63B35E1C32D}" dt="2022-10-21T10:58:48.606" v="15398" actId="478"/>
          <ac:picMkLst>
            <pc:docMk/>
            <pc:sldMk cId="3124133690" sldId="311"/>
            <ac:picMk id="1075" creationId="{3A9BC25E-6939-4B01-9ED9-6062A13FFB6C}"/>
          </ac:picMkLst>
        </pc:picChg>
        <pc:picChg chg="del">
          <ac:chgData name="Manasweeta Angane" userId="05da2731-9352-4b35-b713-60351f56afbd" providerId="ADAL" clId="{F5F97842-A295-4F9F-B89B-A63B35E1C32D}" dt="2022-10-21T10:58:43.759" v="15395" actId="478"/>
          <ac:picMkLst>
            <pc:docMk/>
            <pc:sldMk cId="3124133690" sldId="311"/>
            <ac:picMk id="1078" creationId="{17E99CA4-5107-4AF2-AD6B-3E3914951FA7}"/>
          </ac:picMkLst>
        </pc:picChg>
        <pc:picChg chg="del">
          <ac:chgData name="Manasweeta Angane" userId="05da2731-9352-4b35-b713-60351f56afbd" providerId="ADAL" clId="{F5F97842-A295-4F9F-B89B-A63B35E1C32D}" dt="2022-10-21T10:58:42.010" v="15394" actId="478"/>
          <ac:picMkLst>
            <pc:docMk/>
            <pc:sldMk cId="3124133690" sldId="311"/>
            <ac:picMk id="1080" creationId="{1B0F524F-73E9-4421-8E5C-F252233E0B87}"/>
          </ac:picMkLst>
        </pc:picChg>
        <pc:cxnChg chg="add mod topLvl">
          <ac:chgData name="Manasweeta Angane" userId="05da2731-9352-4b35-b713-60351f56afbd" providerId="ADAL" clId="{F5F97842-A295-4F9F-B89B-A63B35E1C32D}" dt="2022-10-22T05:19:00.516" v="18632" actId="164"/>
          <ac:cxnSpMkLst>
            <pc:docMk/>
            <pc:sldMk cId="3124133690" sldId="311"/>
            <ac:cxnSpMk id="83" creationId="{F813A6C4-C8F4-47C3-8D20-F985C43187FA}"/>
          </ac:cxnSpMkLst>
        </pc:cxnChg>
        <pc:cxnChg chg="add mod topLvl">
          <ac:chgData name="Manasweeta Angane" userId="05da2731-9352-4b35-b713-60351f56afbd" providerId="ADAL" clId="{F5F97842-A295-4F9F-B89B-A63B35E1C32D}" dt="2022-10-22T05:19:00.516" v="18632" actId="164"/>
          <ac:cxnSpMkLst>
            <pc:docMk/>
            <pc:sldMk cId="3124133690" sldId="311"/>
            <ac:cxnSpMk id="84" creationId="{382D1D14-E87D-481C-A1AE-24B47846D64B}"/>
          </ac:cxnSpMkLst>
        </pc:cxnChg>
        <pc:cxnChg chg="add mod topLvl">
          <ac:chgData name="Manasweeta Angane" userId="05da2731-9352-4b35-b713-60351f56afbd" providerId="ADAL" clId="{F5F97842-A295-4F9F-B89B-A63B35E1C32D}" dt="2022-10-22T05:19:00.516" v="18632" actId="164"/>
          <ac:cxnSpMkLst>
            <pc:docMk/>
            <pc:sldMk cId="3124133690" sldId="311"/>
            <ac:cxnSpMk id="85" creationId="{905DE1A3-09A1-472E-877A-705050C0F917}"/>
          </ac:cxnSpMkLst>
        </pc:cxnChg>
        <pc:cxnChg chg="add del mod">
          <ac:chgData name="Manasweeta Angane" userId="05da2731-9352-4b35-b713-60351f56afbd" providerId="ADAL" clId="{F5F97842-A295-4F9F-B89B-A63B35E1C32D}" dt="2022-10-22T05:23:43.344" v="18900" actId="478"/>
          <ac:cxnSpMkLst>
            <pc:docMk/>
            <pc:sldMk cId="3124133690" sldId="311"/>
            <ac:cxnSpMk id="108" creationId="{907B5089-E44E-48B6-BC70-7D5B2E594B16}"/>
          </ac:cxnSpMkLst>
        </pc:cxnChg>
        <pc:cxnChg chg="add mod">
          <ac:chgData name="Manasweeta Angane" userId="05da2731-9352-4b35-b713-60351f56afbd" providerId="ADAL" clId="{F5F97842-A295-4F9F-B89B-A63B35E1C32D}" dt="2022-10-22T05:40:01.951" v="18922" actId="14100"/>
          <ac:cxnSpMkLst>
            <pc:docMk/>
            <pc:sldMk cId="3124133690" sldId="311"/>
            <ac:cxnSpMk id="113" creationId="{1E84FC7E-6CC0-4145-A216-D9359937279F}"/>
          </ac:cxnSpMkLst>
        </pc:cxnChg>
        <pc:cxnChg chg="add del mod">
          <ac:chgData name="Manasweeta Angane" userId="05da2731-9352-4b35-b713-60351f56afbd" providerId="ADAL" clId="{F5F97842-A295-4F9F-B89B-A63B35E1C32D}" dt="2022-10-22T06:48:46.890" v="20842" actId="478"/>
          <ac:cxnSpMkLst>
            <pc:docMk/>
            <pc:sldMk cId="3124133690" sldId="311"/>
            <ac:cxnSpMk id="114" creationId="{9C97A83A-E28E-4E58-B0D3-7291D8349C0E}"/>
          </ac:cxnSpMkLst>
        </pc:cxnChg>
        <pc:cxnChg chg="add mod">
          <ac:chgData name="Manasweeta Angane" userId="05da2731-9352-4b35-b713-60351f56afbd" providerId="ADAL" clId="{F5F97842-A295-4F9F-B89B-A63B35E1C32D}" dt="2022-10-22T06:01:23.895" v="19405" actId="1036"/>
          <ac:cxnSpMkLst>
            <pc:docMk/>
            <pc:sldMk cId="3124133690" sldId="311"/>
            <ac:cxnSpMk id="117" creationId="{CACA3A4D-2353-4917-B4CB-09877C948173}"/>
          </ac:cxnSpMkLst>
        </pc:cxnChg>
        <pc:cxnChg chg="add mod">
          <ac:chgData name="Manasweeta Angane" userId="05da2731-9352-4b35-b713-60351f56afbd" providerId="ADAL" clId="{F5F97842-A295-4F9F-B89B-A63B35E1C32D}" dt="2022-10-22T06:24:22.430" v="20181" actId="1038"/>
          <ac:cxnSpMkLst>
            <pc:docMk/>
            <pc:sldMk cId="3124133690" sldId="311"/>
            <ac:cxnSpMk id="119" creationId="{2CCCDFA0-83FD-4218-B91A-FC6DBC7499A1}"/>
          </ac:cxnSpMkLst>
        </pc:cxnChg>
        <pc:cxnChg chg="add mod">
          <ac:chgData name="Manasweeta Angane" userId="05da2731-9352-4b35-b713-60351f56afbd" providerId="ADAL" clId="{F5F97842-A295-4F9F-B89B-A63B35E1C32D}" dt="2022-10-22T06:35:18.897" v="20320" actId="12788"/>
          <ac:cxnSpMkLst>
            <pc:docMk/>
            <pc:sldMk cId="3124133690" sldId="311"/>
            <ac:cxnSpMk id="123" creationId="{79D26363-DE0B-4782-AC0B-83B4A781D94C}"/>
          </ac:cxnSpMkLst>
        </pc:cxnChg>
        <pc:cxnChg chg="add mod">
          <ac:chgData name="Manasweeta Angane" userId="05da2731-9352-4b35-b713-60351f56afbd" providerId="ADAL" clId="{F5F97842-A295-4F9F-B89B-A63B35E1C32D}" dt="2022-10-22T06:39:59.481" v="20498" actId="1038"/>
          <ac:cxnSpMkLst>
            <pc:docMk/>
            <pc:sldMk cId="3124133690" sldId="311"/>
            <ac:cxnSpMk id="130" creationId="{9600927A-7383-4F9C-A2C6-C83317D8B2FD}"/>
          </ac:cxnSpMkLst>
        </pc:cxnChg>
        <pc:cxnChg chg="add mod">
          <ac:chgData name="Manasweeta Angane" userId="05da2731-9352-4b35-b713-60351f56afbd" providerId="ADAL" clId="{F5F97842-A295-4F9F-B89B-A63B35E1C32D}" dt="2022-10-22T05:20:53.661" v="18760" actId="1037"/>
          <ac:cxnSpMkLst>
            <pc:docMk/>
            <pc:sldMk cId="3124133690" sldId="311"/>
            <ac:cxnSpMk id="224" creationId="{A9B5E218-F0B3-4068-870E-3D5B3153B299}"/>
          </ac:cxnSpMkLst>
        </pc:cxnChg>
      </pc:sldChg>
      <pc:sldMasterChg chg="modTransition modSldLayout">
        <pc:chgData name="Manasweeta Angane" userId="05da2731-9352-4b35-b713-60351f56afbd" providerId="ADAL" clId="{F5F97842-A295-4F9F-B89B-A63B35E1C32D}" dt="2022-10-10T01:16:10.969" v="2120"/>
        <pc:sldMasterMkLst>
          <pc:docMk/>
          <pc:sldMasterMk cId="2346274836" sldId="2147483660"/>
        </pc:sldMasterMkLst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2346274836" sldId="2147483660"/>
            <pc:sldLayoutMk cId="2216657117" sldId="2147483661"/>
          </pc:sldLayoutMkLst>
        </pc:sldLayoutChg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2346274836" sldId="2147483660"/>
            <pc:sldLayoutMk cId="3978972879" sldId="2147483662"/>
          </pc:sldLayoutMkLst>
        </pc:sldLayoutChg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2346274836" sldId="2147483660"/>
            <pc:sldLayoutMk cId="876340843" sldId="2147483663"/>
          </pc:sldLayoutMkLst>
        </pc:sldLayoutChg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2346274836" sldId="2147483660"/>
            <pc:sldLayoutMk cId="1175675121" sldId="2147483664"/>
          </pc:sldLayoutMkLst>
        </pc:sldLayoutChg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2346274836" sldId="2147483660"/>
            <pc:sldLayoutMk cId="2476942322" sldId="2147483665"/>
          </pc:sldLayoutMkLst>
        </pc:sldLayoutChg>
      </pc:sldMasterChg>
      <pc:sldMasterChg chg="modTransition modSldLayout">
        <pc:chgData name="Manasweeta Angane" userId="05da2731-9352-4b35-b713-60351f56afbd" providerId="ADAL" clId="{F5F97842-A295-4F9F-B89B-A63B35E1C32D}" dt="2022-10-10T01:16:10.969" v="2120"/>
        <pc:sldMasterMkLst>
          <pc:docMk/>
          <pc:sldMasterMk cId="4024890882" sldId="2147483666"/>
        </pc:sldMasterMkLst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4024890882" sldId="2147483666"/>
            <pc:sldLayoutMk cId="4167067787" sldId="2147483667"/>
          </pc:sldLayoutMkLst>
        </pc:sldLayoutChg>
      </pc:sldMasterChg>
      <pc:sldMasterChg chg="modTransition modSldLayout">
        <pc:chgData name="Manasweeta Angane" userId="05da2731-9352-4b35-b713-60351f56afbd" providerId="ADAL" clId="{F5F97842-A295-4F9F-B89B-A63B35E1C32D}" dt="2022-10-10T01:16:10.969" v="2120"/>
        <pc:sldMasterMkLst>
          <pc:docMk/>
          <pc:sldMasterMk cId="4264021447" sldId="2147483668"/>
        </pc:sldMasterMkLst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4264021447" sldId="2147483668"/>
            <pc:sldLayoutMk cId="3808492308" sldId="2147483669"/>
          </pc:sldLayoutMkLst>
        </pc:sldLayoutChg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4264021447" sldId="2147483668"/>
            <pc:sldLayoutMk cId="3393857703" sldId="2147483670"/>
          </pc:sldLayoutMkLst>
        </pc:sldLayoutChg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4264021447" sldId="2147483668"/>
            <pc:sldLayoutMk cId="1965983508" sldId="2147483671"/>
          </pc:sldLayoutMkLst>
        </pc:sldLayoutChg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4264021447" sldId="2147483668"/>
            <pc:sldLayoutMk cId="1897747998" sldId="2147483672"/>
          </pc:sldLayoutMkLst>
        </pc:sldLayoutChg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4264021447" sldId="2147483668"/>
            <pc:sldLayoutMk cId="1325548044" sldId="2147483673"/>
          </pc:sldLayoutMkLst>
        </pc:sldLayoutChg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4264021447" sldId="2147483668"/>
            <pc:sldLayoutMk cId="1909620909" sldId="2147483674"/>
          </pc:sldLayoutMkLst>
        </pc:sldLayoutChg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4264021447" sldId="2147483668"/>
            <pc:sldLayoutMk cId="2732246600" sldId="2147483675"/>
          </pc:sldLayoutMkLst>
        </pc:sldLayoutChg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4264021447" sldId="2147483668"/>
            <pc:sldLayoutMk cId="3489134843" sldId="2147483676"/>
          </pc:sldLayoutMkLst>
        </pc:sldLayoutChg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4264021447" sldId="2147483668"/>
            <pc:sldLayoutMk cId="4157787240" sldId="2147483677"/>
          </pc:sldLayoutMkLst>
        </pc:sldLayoutChg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4264021447" sldId="2147483668"/>
            <pc:sldLayoutMk cId="3000985003" sldId="2147483678"/>
          </pc:sldLayoutMkLst>
        </pc:sldLayoutChg>
        <pc:sldLayoutChg chg="modTransition">
          <pc:chgData name="Manasweeta Angane" userId="05da2731-9352-4b35-b713-60351f56afbd" providerId="ADAL" clId="{F5F97842-A295-4F9F-B89B-A63B35E1C32D}" dt="2022-10-10T01:16:10.969" v="2120"/>
          <pc:sldLayoutMkLst>
            <pc:docMk/>
            <pc:sldMasterMk cId="4264021447" sldId="2147483668"/>
            <pc:sldLayoutMk cId="1103787972" sldId="2147483679"/>
          </pc:sldLayoutMkLst>
        </pc:sldLayoutChg>
      </pc:sldMasterChg>
      <pc:sldMasterChg chg="delSldLayout">
        <pc:chgData name="Manasweeta Angane" userId="05da2731-9352-4b35-b713-60351f56afbd" providerId="ADAL" clId="{F5F97842-A295-4F9F-B89B-A63B35E1C32D}" dt="2022-10-22T07:01:59.685" v="20935" actId="2696"/>
        <pc:sldMasterMkLst>
          <pc:docMk/>
          <pc:sldMasterMk cId="1446668091" sldId="2147483682"/>
        </pc:sldMasterMkLst>
        <pc:sldLayoutChg chg="del">
          <pc:chgData name="Manasweeta Angane" userId="05da2731-9352-4b35-b713-60351f56afbd" providerId="ADAL" clId="{F5F97842-A295-4F9F-B89B-A63B35E1C32D}" dt="2022-10-22T07:01:59.685" v="20935" actId="2696"/>
          <pc:sldLayoutMkLst>
            <pc:docMk/>
            <pc:sldMasterMk cId="1446668091" sldId="2147483682"/>
            <pc:sldLayoutMk cId="803515361" sldId="2147483695"/>
          </pc:sldLayoutMkLst>
        </pc:sldLayoutChg>
      </pc:sldMasterChg>
    </pc:docChg>
  </pc:docChgLst>
  <pc:docChgLst>
    <pc:chgData name="Manasweeta Angane" userId="05da2731-9352-4b35-b713-60351f56afbd" providerId="ADAL" clId="{B454A7FE-BA51-47AB-9E36-428FB157FB0F}"/>
    <pc:docChg chg="undo custSel modSld">
      <pc:chgData name="Manasweeta Angane" userId="05da2731-9352-4b35-b713-60351f56afbd" providerId="ADAL" clId="{B454A7FE-BA51-47AB-9E36-428FB157FB0F}" dt="2022-06-11T11:05:10.883" v="33"/>
      <pc:docMkLst>
        <pc:docMk/>
      </pc:docMkLst>
      <pc:sldChg chg="addSp delSp modSp mod">
        <pc:chgData name="Manasweeta Angane" userId="05da2731-9352-4b35-b713-60351f56afbd" providerId="ADAL" clId="{B454A7FE-BA51-47AB-9E36-428FB157FB0F}" dt="2022-06-11T11:05:05.248" v="32" actId="21"/>
        <pc:sldMkLst>
          <pc:docMk/>
          <pc:sldMk cId="2942563435" sldId="269"/>
        </pc:sldMkLst>
        <pc:spChg chg="mod topLvl">
          <ac:chgData name="Manasweeta Angane" userId="05da2731-9352-4b35-b713-60351f56afbd" providerId="ADAL" clId="{B454A7FE-BA51-47AB-9E36-428FB157FB0F}" dt="2022-06-11T11:01:25.815" v="26" actId="14100"/>
          <ac:spMkLst>
            <pc:docMk/>
            <pc:sldMk cId="2942563435" sldId="269"/>
            <ac:spMk id="7" creationId="{ACF66282-DA63-4AA5-A67E-16B2F01D29BA}"/>
          </ac:spMkLst>
        </pc:spChg>
        <pc:grpChg chg="del mod">
          <ac:chgData name="Manasweeta Angane" userId="05da2731-9352-4b35-b713-60351f56afbd" providerId="ADAL" clId="{B454A7FE-BA51-47AB-9E36-428FB157FB0F}" dt="2022-06-11T11:01:17.027" v="22" actId="165"/>
          <ac:grpSpMkLst>
            <pc:docMk/>
            <pc:sldMk cId="2942563435" sldId="269"/>
            <ac:grpSpMk id="8" creationId="{B49938D0-205B-408A-B870-7A56930DD9E8}"/>
          </ac:grpSpMkLst>
        </pc:grpChg>
        <pc:graphicFrameChg chg="modGraphic">
          <ac:chgData name="Manasweeta Angane" userId="05da2731-9352-4b35-b713-60351f56afbd" providerId="ADAL" clId="{B454A7FE-BA51-47AB-9E36-428FB157FB0F}" dt="2022-06-11T11:01:07.069" v="20" actId="339"/>
          <ac:graphicFrameMkLst>
            <pc:docMk/>
            <pc:sldMk cId="2942563435" sldId="269"/>
            <ac:graphicFrameMk id="9" creationId="{37FE6962-AFEC-4665-A02F-AF37CD0998BD}"/>
          </ac:graphicFrameMkLst>
        </pc:graphicFrameChg>
        <pc:picChg chg="mod topLvl">
          <ac:chgData name="Manasweeta Angane" userId="05da2731-9352-4b35-b713-60351f56afbd" providerId="ADAL" clId="{B454A7FE-BA51-47AB-9E36-428FB157FB0F}" dt="2022-06-11T11:01:51.748" v="31" actId="1076"/>
          <ac:picMkLst>
            <pc:docMk/>
            <pc:sldMk cId="2942563435" sldId="269"/>
            <ac:picMk id="6" creationId="{874E6535-A81B-41C3-8618-5E72016A79BA}"/>
          </ac:picMkLst>
        </pc:picChg>
        <pc:picChg chg="add mod">
          <ac:chgData name="Manasweeta Angane" userId="05da2731-9352-4b35-b713-60351f56afbd" providerId="ADAL" clId="{B454A7FE-BA51-47AB-9E36-428FB157FB0F}" dt="2022-06-10T11:40:46.406" v="14" actId="1076"/>
          <ac:picMkLst>
            <pc:docMk/>
            <pc:sldMk cId="2942563435" sldId="269"/>
            <ac:picMk id="11" creationId="{0F3DD18D-64CF-B728-1223-51DD88F6A088}"/>
          </ac:picMkLst>
        </pc:picChg>
        <pc:picChg chg="add mod">
          <ac:chgData name="Manasweeta Angane" userId="05da2731-9352-4b35-b713-60351f56afbd" providerId="ADAL" clId="{B454A7FE-BA51-47AB-9E36-428FB157FB0F}" dt="2022-06-10T11:40:59.254" v="16" actId="1076"/>
          <ac:picMkLst>
            <pc:docMk/>
            <pc:sldMk cId="2942563435" sldId="269"/>
            <ac:picMk id="12" creationId="{ED6AF8BF-9805-DAE4-F29A-E5886A3BA6F4}"/>
          </ac:picMkLst>
        </pc:picChg>
        <pc:picChg chg="add mod">
          <ac:chgData name="Manasweeta Angane" userId="05da2731-9352-4b35-b713-60351f56afbd" providerId="ADAL" clId="{B454A7FE-BA51-47AB-9E36-428FB157FB0F}" dt="2022-06-11T11:01:28.184" v="27" actId="1076"/>
          <ac:picMkLst>
            <pc:docMk/>
            <pc:sldMk cId="2942563435" sldId="269"/>
            <ac:picMk id="13" creationId="{C8584449-B3DF-EB19-09EB-A1B5C2D3CECC}"/>
          </ac:picMkLst>
        </pc:picChg>
        <pc:picChg chg="mod">
          <ac:chgData name="Manasweeta Angane" userId="05da2731-9352-4b35-b713-60351f56afbd" providerId="ADAL" clId="{B454A7FE-BA51-47AB-9E36-428FB157FB0F}" dt="2022-06-11T11:01:46.599" v="30" actId="1076"/>
          <ac:picMkLst>
            <pc:docMk/>
            <pc:sldMk cId="2942563435" sldId="269"/>
            <ac:picMk id="1028" creationId="{EFFAC93C-329D-4C38-BBE0-5A7455662851}"/>
          </ac:picMkLst>
        </pc:picChg>
        <pc:picChg chg="del">
          <ac:chgData name="Manasweeta Angane" userId="05da2731-9352-4b35-b713-60351f56afbd" providerId="ADAL" clId="{B454A7FE-BA51-47AB-9E36-428FB157FB0F}" dt="2022-06-11T11:05:05.248" v="32" actId="21"/>
          <ac:picMkLst>
            <pc:docMk/>
            <pc:sldMk cId="2942563435" sldId="269"/>
            <ac:picMk id="1034" creationId="{3E6DF42D-CF2B-4856-8653-284239E14632}"/>
          </ac:picMkLst>
        </pc:picChg>
        <pc:picChg chg="mod">
          <ac:chgData name="Manasweeta Angane" userId="05da2731-9352-4b35-b713-60351f56afbd" providerId="ADAL" clId="{B454A7FE-BA51-47AB-9E36-428FB157FB0F}" dt="2022-06-10T11:39:14.836" v="9" actId="14100"/>
          <ac:picMkLst>
            <pc:docMk/>
            <pc:sldMk cId="2942563435" sldId="269"/>
            <ac:picMk id="1036" creationId="{1D8EE2AA-F50C-4A4C-8964-F14F928562B3}"/>
          </ac:picMkLst>
        </pc:picChg>
        <pc:picChg chg="mod">
          <ac:chgData name="Manasweeta Angane" userId="05da2731-9352-4b35-b713-60351f56afbd" providerId="ADAL" clId="{B454A7FE-BA51-47AB-9E36-428FB157FB0F}" dt="2022-06-10T11:39:49.437" v="12" actId="14100"/>
          <ac:picMkLst>
            <pc:docMk/>
            <pc:sldMk cId="2942563435" sldId="269"/>
            <ac:picMk id="1040" creationId="{E07DEFC9-931C-4FD2-912E-6D069C6D6C48}"/>
          </ac:picMkLst>
        </pc:picChg>
      </pc:sldChg>
      <pc:sldChg chg="addSp modSp mod">
        <pc:chgData name="Manasweeta Angane" userId="05da2731-9352-4b35-b713-60351f56afbd" providerId="ADAL" clId="{B454A7FE-BA51-47AB-9E36-428FB157FB0F}" dt="2022-06-11T11:05:10.883" v="33"/>
        <pc:sldMkLst>
          <pc:docMk/>
          <pc:sldMk cId="1115324438" sldId="273"/>
        </pc:sldMkLst>
        <pc:grpChg chg="mod">
          <ac:chgData name="Manasweeta Angane" userId="05da2731-9352-4b35-b713-60351f56afbd" providerId="ADAL" clId="{B454A7FE-BA51-47AB-9E36-428FB157FB0F}" dt="2022-06-10T11:36:34.531" v="1" actId="1076"/>
          <ac:grpSpMkLst>
            <pc:docMk/>
            <pc:sldMk cId="1115324438" sldId="273"/>
            <ac:grpSpMk id="8" creationId="{B49938D0-205B-408A-B870-7A56930DD9E8}"/>
          </ac:grpSpMkLst>
        </pc:grpChg>
        <pc:picChg chg="mod">
          <ac:chgData name="Manasweeta Angane" userId="05da2731-9352-4b35-b713-60351f56afbd" providerId="ADAL" clId="{B454A7FE-BA51-47AB-9E36-428FB157FB0F}" dt="2022-06-10T11:36:22.247" v="0" actId="1076"/>
          <ac:picMkLst>
            <pc:docMk/>
            <pc:sldMk cId="1115324438" sldId="273"/>
            <ac:picMk id="10" creationId="{0425E1B5-6271-4131-B6E9-31D9887827B2}"/>
          </ac:picMkLst>
        </pc:picChg>
        <pc:picChg chg="mod">
          <ac:chgData name="Manasweeta Angane" userId="05da2731-9352-4b35-b713-60351f56afbd" providerId="ADAL" clId="{B454A7FE-BA51-47AB-9E36-428FB157FB0F}" dt="2022-06-10T11:37:13.182" v="2" actId="1076"/>
          <ac:picMkLst>
            <pc:docMk/>
            <pc:sldMk cId="1115324438" sldId="273"/>
            <ac:picMk id="11" creationId="{B545896D-C959-4C03-BFE2-7DB3B0DEFC07}"/>
          </ac:picMkLst>
        </pc:picChg>
        <pc:picChg chg="add mod">
          <ac:chgData name="Manasweeta Angane" userId="05da2731-9352-4b35-b713-60351f56afbd" providerId="ADAL" clId="{B454A7FE-BA51-47AB-9E36-428FB157FB0F}" dt="2022-06-10T11:37:21.597" v="4" actId="1076"/>
          <ac:picMkLst>
            <pc:docMk/>
            <pc:sldMk cId="1115324438" sldId="273"/>
            <ac:picMk id="12" creationId="{268EDCAF-4D27-ABA4-DBF7-97DFF49AE2DA}"/>
          </ac:picMkLst>
        </pc:picChg>
        <pc:picChg chg="add mod">
          <ac:chgData name="Manasweeta Angane" userId="05da2731-9352-4b35-b713-60351f56afbd" providerId="ADAL" clId="{B454A7FE-BA51-47AB-9E36-428FB157FB0F}" dt="2022-06-11T11:05:10.883" v="33"/>
          <ac:picMkLst>
            <pc:docMk/>
            <pc:sldMk cId="1115324438" sldId="273"/>
            <ac:picMk id="13" creationId="{79C905BE-13C3-3316-5D9A-7E0BA5E3679D}"/>
          </ac:picMkLst>
        </pc:picChg>
      </pc:sldChg>
    </pc:docChg>
  </pc:docChgLst>
  <pc:docChgLst>
    <pc:chgData name="Manasweeta Angane" userId="05da2731-9352-4b35-b713-60351f56afbd" providerId="ADAL" clId="{D444FAE6-B328-4AB8-9A10-764831A715E0}"/>
    <pc:docChg chg="undo redo custSel addSld delSld modSld sldOrd">
      <pc:chgData name="Manasweeta Angane" userId="05da2731-9352-4b35-b713-60351f56afbd" providerId="ADAL" clId="{D444FAE6-B328-4AB8-9A10-764831A715E0}" dt="2021-05-21T17:11:55.489" v="4248" actId="166"/>
      <pc:docMkLst>
        <pc:docMk/>
      </pc:docMkLst>
      <pc:sldChg chg="addSp delSp modSp mod">
        <pc:chgData name="Manasweeta Angane" userId="05da2731-9352-4b35-b713-60351f56afbd" providerId="ADAL" clId="{D444FAE6-B328-4AB8-9A10-764831A715E0}" dt="2021-03-25T11:51:39.278" v="12" actId="164"/>
        <pc:sldMkLst>
          <pc:docMk/>
          <pc:sldMk cId="1675651953" sldId="256"/>
        </pc:sldMkLst>
        <pc:grpChg chg="add mod">
          <ac:chgData name="Manasweeta Angane" userId="05da2731-9352-4b35-b713-60351f56afbd" providerId="ADAL" clId="{D444FAE6-B328-4AB8-9A10-764831A715E0}" dt="2021-03-25T11:51:39.278" v="12" actId="164"/>
          <ac:grpSpMkLst>
            <pc:docMk/>
            <pc:sldMk cId="1675651953" sldId="256"/>
            <ac:grpSpMk id="9" creationId="{B9F22647-E5E1-482A-A7CD-7E425F95151A}"/>
          </ac:grpSpMkLst>
        </pc:grpChg>
        <pc:picChg chg="mod">
          <ac:chgData name="Manasweeta Angane" userId="05da2731-9352-4b35-b713-60351f56afbd" providerId="ADAL" clId="{D444FAE6-B328-4AB8-9A10-764831A715E0}" dt="2021-03-25T11:51:39.278" v="12" actId="164"/>
          <ac:picMkLst>
            <pc:docMk/>
            <pc:sldMk cId="1675651953" sldId="256"/>
            <ac:picMk id="2" creationId="{27719C49-0427-40D3-9AED-CF732CA91CA9}"/>
          </ac:picMkLst>
        </pc:picChg>
        <pc:picChg chg="mod">
          <ac:chgData name="Manasweeta Angane" userId="05da2731-9352-4b35-b713-60351f56afbd" providerId="ADAL" clId="{D444FAE6-B328-4AB8-9A10-764831A715E0}" dt="2021-03-25T11:51:39.278" v="12" actId="164"/>
          <ac:picMkLst>
            <pc:docMk/>
            <pc:sldMk cId="1675651953" sldId="256"/>
            <ac:picMk id="4" creationId="{6F5113BA-6816-45DA-883C-D958DF0E88C0}"/>
          </ac:picMkLst>
        </pc:picChg>
        <pc:picChg chg="add del mod modCrop">
          <ac:chgData name="Manasweeta Angane" userId="05da2731-9352-4b35-b713-60351f56afbd" providerId="ADAL" clId="{D444FAE6-B328-4AB8-9A10-764831A715E0}" dt="2021-03-25T11:51:05.956" v="9" actId="21"/>
          <ac:picMkLst>
            <pc:docMk/>
            <pc:sldMk cId="1675651953" sldId="256"/>
            <ac:picMk id="8" creationId="{F9D06575-66C1-4CB5-AC98-AB505E409820}"/>
          </ac:picMkLst>
        </pc:picChg>
      </pc:sldChg>
      <pc:sldChg chg="addSp modSp">
        <pc:chgData name="Manasweeta Angane" userId="05da2731-9352-4b35-b713-60351f56afbd" providerId="ADAL" clId="{D444FAE6-B328-4AB8-9A10-764831A715E0}" dt="2021-05-04T10:25:03.885" v="83" actId="164"/>
        <pc:sldMkLst>
          <pc:docMk/>
          <pc:sldMk cId="3827496297" sldId="258"/>
        </pc:sldMkLst>
        <pc:spChg chg="mod">
          <ac:chgData name="Manasweeta Angane" userId="05da2731-9352-4b35-b713-60351f56afbd" providerId="ADAL" clId="{D444FAE6-B328-4AB8-9A10-764831A715E0}" dt="2021-05-04T10:25:03.885" v="83" actId="164"/>
          <ac:spMkLst>
            <pc:docMk/>
            <pc:sldMk cId="3827496297" sldId="258"/>
            <ac:spMk id="19" creationId="{4524C53F-DFA9-4AEB-8017-53E29AEEAD17}"/>
          </ac:spMkLst>
        </pc:spChg>
        <pc:grpChg chg="add mod">
          <ac:chgData name="Manasweeta Angane" userId="05da2731-9352-4b35-b713-60351f56afbd" providerId="ADAL" clId="{D444FAE6-B328-4AB8-9A10-764831A715E0}" dt="2021-05-04T10:25:03.885" v="83" actId="164"/>
          <ac:grpSpMkLst>
            <pc:docMk/>
            <pc:sldMk cId="3827496297" sldId="258"/>
            <ac:grpSpMk id="12" creationId="{E9A2B69E-8082-4E2F-A190-39210225BE3A}"/>
          </ac:grpSpMkLst>
        </pc:grpChg>
        <pc:picChg chg="mod">
          <ac:chgData name="Manasweeta Angane" userId="05da2731-9352-4b35-b713-60351f56afbd" providerId="ADAL" clId="{D444FAE6-B328-4AB8-9A10-764831A715E0}" dt="2021-05-04T10:25:03.885" v="83" actId="164"/>
          <ac:picMkLst>
            <pc:docMk/>
            <pc:sldMk cId="3827496297" sldId="258"/>
            <ac:picMk id="5" creationId="{8C579C4E-0108-4414-9949-CAFBF72B588E}"/>
          </ac:picMkLst>
        </pc:picChg>
        <pc:picChg chg="mod">
          <ac:chgData name="Manasweeta Angane" userId="05da2731-9352-4b35-b713-60351f56afbd" providerId="ADAL" clId="{D444FAE6-B328-4AB8-9A10-764831A715E0}" dt="2021-05-04T10:25:03.885" v="83" actId="164"/>
          <ac:picMkLst>
            <pc:docMk/>
            <pc:sldMk cId="3827496297" sldId="258"/>
            <ac:picMk id="6" creationId="{F0A491D4-3259-46C7-8C77-6241CBED1A4A}"/>
          </ac:picMkLst>
        </pc:picChg>
        <pc:picChg chg="mod">
          <ac:chgData name="Manasweeta Angane" userId="05da2731-9352-4b35-b713-60351f56afbd" providerId="ADAL" clId="{D444FAE6-B328-4AB8-9A10-764831A715E0}" dt="2021-05-04T10:25:03.885" v="83" actId="164"/>
          <ac:picMkLst>
            <pc:docMk/>
            <pc:sldMk cId="3827496297" sldId="258"/>
            <ac:picMk id="8" creationId="{63040BB8-6243-432A-80AB-D95BD0E90B48}"/>
          </ac:picMkLst>
        </pc:picChg>
      </pc:sldChg>
      <pc:sldChg chg="addSp delSp modSp mod">
        <pc:chgData name="Manasweeta Angane" userId="05da2731-9352-4b35-b713-60351f56afbd" providerId="ADAL" clId="{D444FAE6-B328-4AB8-9A10-764831A715E0}" dt="2021-05-11T12:01:10.624" v="840" actId="1076"/>
        <pc:sldMkLst>
          <pc:docMk/>
          <pc:sldMk cId="2764835349" sldId="259"/>
        </pc:sldMkLst>
        <pc:spChg chg="del mod">
          <ac:chgData name="Manasweeta Angane" userId="05da2731-9352-4b35-b713-60351f56afbd" providerId="ADAL" clId="{D444FAE6-B328-4AB8-9A10-764831A715E0}" dt="2021-05-04T10:05:36.181" v="35" actId="478"/>
          <ac:spMkLst>
            <pc:docMk/>
            <pc:sldMk cId="2764835349" sldId="259"/>
            <ac:spMk id="2" creationId="{7B458757-9953-486D-8B0B-6060AA1A2CE0}"/>
          </ac:spMkLst>
        </pc:spChg>
        <pc:spChg chg="mod">
          <ac:chgData name="Manasweeta Angane" userId="05da2731-9352-4b35-b713-60351f56afbd" providerId="ADAL" clId="{D444FAE6-B328-4AB8-9A10-764831A715E0}" dt="2021-05-04T10:55:53.702" v="184"/>
          <ac:spMkLst>
            <pc:docMk/>
            <pc:sldMk cId="2764835349" sldId="259"/>
            <ac:spMk id="24" creationId="{EE451566-5961-4A91-A70F-0F623657BCFE}"/>
          </ac:spMkLst>
        </pc:spChg>
        <pc:grpChg chg="add mod">
          <ac:chgData name="Manasweeta Angane" userId="05da2731-9352-4b35-b713-60351f56afbd" providerId="ADAL" clId="{D444FAE6-B328-4AB8-9A10-764831A715E0}" dt="2021-05-11T08:45:48.870" v="459" actId="1076"/>
          <ac:grpSpMkLst>
            <pc:docMk/>
            <pc:sldMk cId="2764835349" sldId="259"/>
            <ac:grpSpMk id="2" creationId="{1BE1D928-7A39-4997-ABBE-C56BD9A597B1}"/>
          </ac:grpSpMkLst>
        </pc:grpChg>
        <pc:grpChg chg="add mod">
          <ac:chgData name="Manasweeta Angane" userId="05da2731-9352-4b35-b713-60351f56afbd" providerId="ADAL" clId="{D444FAE6-B328-4AB8-9A10-764831A715E0}" dt="2021-05-11T08:45:51.744" v="461" actId="164"/>
          <ac:grpSpMkLst>
            <pc:docMk/>
            <pc:sldMk cId="2764835349" sldId="259"/>
            <ac:grpSpMk id="3" creationId="{512B2A83-6F65-4832-A3F2-95B5475602FA}"/>
          </ac:grpSpMkLst>
        </pc:grpChg>
        <pc:grpChg chg="add mod">
          <ac:chgData name="Manasweeta Angane" userId="05da2731-9352-4b35-b713-60351f56afbd" providerId="ADAL" clId="{D444FAE6-B328-4AB8-9A10-764831A715E0}" dt="2021-05-11T08:45:59.818" v="463" actId="164"/>
          <ac:grpSpMkLst>
            <pc:docMk/>
            <pc:sldMk cId="2764835349" sldId="259"/>
            <ac:grpSpMk id="4" creationId="{2BFEAA74-BB69-4536-8A67-5E5215BCFAA8}"/>
          </ac:grpSpMkLst>
        </pc:grpChg>
        <pc:grpChg chg="del">
          <ac:chgData name="Manasweeta Angane" userId="05da2731-9352-4b35-b713-60351f56afbd" providerId="ADAL" clId="{D444FAE6-B328-4AB8-9A10-764831A715E0}" dt="2021-05-04T10:05:31.621" v="33" actId="478"/>
          <ac:grpSpMkLst>
            <pc:docMk/>
            <pc:sldMk cId="2764835349" sldId="259"/>
            <ac:grpSpMk id="4" creationId="{A5E145EA-B2A8-4549-8D43-B60DCB1CC13E}"/>
          </ac:grpSpMkLst>
        </pc:grpChg>
        <pc:grpChg chg="add mod">
          <ac:chgData name="Manasweeta Angane" userId="05da2731-9352-4b35-b713-60351f56afbd" providerId="ADAL" clId="{D444FAE6-B328-4AB8-9A10-764831A715E0}" dt="2021-05-11T09:04:06.345" v="481" actId="1076"/>
          <ac:grpSpMkLst>
            <pc:docMk/>
            <pc:sldMk cId="2764835349" sldId="259"/>
            <ac:grpSpMk id="5" creationId="{2F84AD72-9BAF-41B2-BF46-1C06486CE0ED}"/>
          </ac:grpSpMkLst>
        </pc:grpChg>
        <pc:grpChg chg="add mod">
          <ac:chgData name="Manasweeta Angane" userId="05da2731-9352-4b35-b713-60351f56afbd" providerId="ADAL" clId="{D444FAE6-B328-4AB8-9A10-764831A715E0}" dt="2021-05-11T09:05:05.943" v="527" actId="1036"/>
          <ac:grpSpMkLst>
            <pc:docMk/>
            <pc:sldMk cId="2764835349" sldId="259"/>
            <ac:grpSpMk id="6" creationId="{7C286CEC-07BB-422E-9F2B-98D42B21E58B}"/>
          </ac:grpSpMkLst>
        </pc:grpChg>
        <pc:grpChg chg="add mod">
          <ac:chgData name="Manasweeta Angane" userId="05da2731-9352-4b35-b713-60351f56afbd" providerId="ADAL" clId="{D444FAE6-B328-4AB8-9A10-764831A715E0}" dt="2021-05-11T11:33:39.549" v="689" actId="1076"/>
          <ac:grpSpMkLst>
            <pc:docMk/>
            <pc:sldMk cId="2764835349" sldId="259"/>
            <ac:grpSpMk id="7" creationId="{E5B4890C-B51E-49EC-A03A-7F3891CD1C66}"/>
          </ac:grpSpMkLst>
        </pc:grpChg>
        <pc:grpChg chg="add mod">
          <ac:chgData name="Manasweeta Angane" userId="05da2731-9352-4b35-b713-60351f56afbd" providerId="ADAL" clId="{D444FAE6-B328-4AB8-9A10-764831A715E0}" dt="2021-05-11T11:52:12.914" v="707" actId="164"/>
          <ac:grpSpMkLst>
            <pc:docMk/>
            <pc:sldMk cId="2764835349" sldId="259"/>
            <ac:grpSpMk id="8" creationId="{78A05356-6206-4C96-A8D6-F3340F533B2C}"/>
          </ac:grpSpMkLst>
        </pc:grpChg>
        <pc:grpChg chg="add mod">
          <ac:chgData name="Manasweeta Angane" userId="05da2731-9352-4b35-b713-60351f56afbd" providerId="ADAL" clId="{D444FAE6-B328-4AB8-9A10-764831A715E0}" dt="2021-05-11T11:52:24.249" v="708" actId="164"/>
          <ac:grpSpMkLst>
            <pc:docMk/>
            <pc:sldMk cId="2764835349" sldId="259"/>
            <ac:grpSpMk id="9" creationId="{E22C013F-2FF9-49CF-BC06-CAACD8F64518}"/>
          </ac:grpSpMkLst>
        </pc:grpChg>
        <pc:grpChg chg="del">
          <ac:chgData name="Manasweeta Angane" userId="05da2731-9352-4b35-b713-60351f56afbd" providerId="ADAL" clId="{D444FAE6-B328-4AB8-9A10-764831A715E0}" dt="2021-05-04T10:05:27.758" v="31" actId="478"/>
          <ac:grpSpMkLst>
            <pc:docMk/>
            <pc:sldMk cId="2764835349" sldId="259"/>
            <ac:grpSpMk id="17" creationId="{725AAB17-22B0-40CC-AB71-822FC7F9F2A9}"/>
          </ac:grpSpMkLst>
        </pc:grpChg>
        <pc:grpChg chg="add del mod">
          <ac:chgData name="Manasweeta Angane" userId="05da2731-9352-4b35-b713-60351f56afbd" providerId="ADAL" clId="{D444FAE6-B328-4AB8-9A10-764831A715E0}" dt="2021-05-04T11:44:21.147" v="230" actId="478"/>
          <ac:grpSpMkLst>
            <pc:docMk/>
            <pc:sldMk cId="2764835349" sldId="259"/>
            <ac:grpSpMk id="21" creationId="{9145CF07-E463-4E2D-838D-58DFF48DA910}"/>
          </ac:grpSpMkLst>
        </pc:grpChg>
        <pc:grpChg chg="add mod">
          <ac:chgData name="Manasweeta Angane" userId="05da2731-9352-4b35-b713-60351f56afbd" providerId="ADAL" clId="{D444FAE6-B328-4AB8-9A10-764831A715E0}" dt="2021-05-11T11:35:23.811" v="701" actId="1076"/>
          <ac:grpSpMkLst>
            <pc:docMk/>
            <pc:sldMk cId="2764835349" sldId="259"/>
            <ac:grpSpMk id="64" creationId="{FC5C2C94-1FAF-4FBB-9C08-3F6B2698C510}"/>
          </ac:grpSpMkLst>
        </pc:grpChg>
        <pc:grpChg chg="add mod">
          <ac:chgData name="Manasweeta Angane" userId="05da2731-9352-4b35-b713-60351f56afbd" providerId="ADAL" clId="{D444FAE6-B328-4AB8-9A10-764831A715E0}" dt="2021-05-11T11:26:44.015" v="633" actId="1076"/>
          <ac:grpSpMkLst>
            <pc:docMk/>
            <pc:sldMk cId="2764835349" sldId="259"/>
            <ac:grpSpMk id="78" creationId="{017A5463-1763-42F3-BE4C-BCFEC99C1120}"/>
          </ac:grpSpMkLst>
        </pc:grpChg>
        <pc:grpChg chg="add mod">
          <ac:chgData name="Manasweeta Angane" userId="05da2731-9352-4b35-b713-60351f56afbd" providerId="ADAL" clId="{D444FAE6-B328-4AB8-9A10-764831A715E0}" dt="2021-05-11T11:52:52.909" v="782" actId="1076"/>
          <ac:grpSpMkLst>
            <pc:docMk/>
            <pc:sldMk cId="2764835349" sldId="259"/>
            <ac:grpSpMk id="87" creationId="{BEB97D29-67E7-420B-87F4-B01BE583E078}"/>
          </ac:grpSpMkLst>
        </pc:grpChg>
        <pc:grpChg chg="add mod">
          <ac:chgData name="Manasweeta Angane" userId="05da2731-9352-4b35-b713-60351f56afbd" providerId="ADAL" clId="{D444FAE6-B328-4AB8-9A10-764831A715E0}" dt="2021-05-11T11:57:19.998" v="811" actId="1076"/>
          <ac:grpSpMkLst>
            <pc:docMk/>
            <pc:sldMk cId="2764835349" sldId="259"/>
            <ac:grpSpMk id="94" creationId="{4E186A31-705F-4642-B242-D774E53C53AA}"/>
          </ac:grpSpMkLst>
        </pc:grpChg>
        <pc:grpChg chg="add mod">
          <ac:chgData name="Manasweeta Angane" userId="05da2731-9352-4b35-b713-60351f56afbd" providerId="ADAL" clId="{D444FAE6-B328-4AB8-9A10-764831A715E0}" dt="2021-05-11T12:00:18.451" v="828" actId="1076"/>
          <ac:grpSpMkLst>
            <pc:docMk/>
            <pc:sldMk cId="2764835349" sldId="259"/>
            <ac:grpSpMk id="99" creationId="{EB3AD489-4C3F-4B34-93FE-F09066D850D3}"/>
          </ac:grpSpMkLst>
        </pc:grpChg>
        <pc:grpChg chg="add mod">
          <ac:chgData name="Manasweeta Angane" userId="05da2731-9352-4b35-b713-60351f56afbd" providerId="ADAL" clId="{D444FAE6-B328-4AB8-9A10-764831A715E0}" dt="2021-05-11T12:01:10.624" v="840" actId="1076"/>
          <ac:grpSpMkLst>
            <pc:docMk/>
            <pc:sldMk cId="2764835349" sldId="259"/>
            <ac:grpSpMk id="102" creationId="{69254C08-5F62-4D5A-BF3A-82D69BE3C4E6}"/>
          </ac:grpSpMkLst>
        </pc:grpChg>
        <pc:picChg chg="del">
          <ac:chgData name="Manasweeta Angane" userId="05da2731-9352-4b35-b713-60351f56afbd" providerId="ADAL" clId="{D444FAE6-B328-4AB8-9A10-764831A715E0}" dt="2021-05-04T10:05:29.314" v="32" actId="478"/>
          <ac:picMkLst>
            <pc:docMk/>
            <pc:sldMk cId="2764835349" sldId="259"/>
            <ac:picMk id="3" creationId="{A74C2E98-B596-47AD-BB6A-7624DAD15923}"/>
          </ac:picMkLst>
        </pc:picChg>
        <pc:picChg chg="add mod">
          <ac:chgData name="Manasweeta Angane" userId="05da2731-9352-4b35-b713-60351f56afbd" providerId="ADAL" clId="{D444FAE6-B328-4AB8-9A10-764831A715E0}" dt="2021-05-09T04:05:35.063" v="371" actId="1076"/>
          <ac:picMkLst>
            <pc:docMk/>
            <pc:sldMk cId="2764835349" sldId="259"/>
            <ac:picMk id="16" creationId="{0C632A22-601E-4654-98A4-B752DAB0A5BB}"/>
          </ac:picMkLst>
        </pc:picChg>
        <pc:picChg chg="add del mod">
          <ac:chgData name="Manasweeta Angane" userId="05da2731-9352-4b35-b713-60351f56afbd" providerId="ADAL" clId="{D444FAE6-B328-4AB8-9A10-764831A715E0}" dt="2021-05-04T11:41:07.092" v="207" actId="478"/>
          <ac:picMkLst>
            <pc:docMk/>
            <pc:sldMk cId="2764835349" sldId="259"/>
            <ac:picMk id="20" creationId="{81F36863-E26B-4026-9CCC-9A91B42E0CF6}"/>
          </ac:picMkLst>
        </pc:picChg>
        <pc:picChg chg="mod">
          <ac:chgData name="Manasweeta Angane" userId="05da2731-9352-4b35-b713-60351f56afbd" providerId="ADAL" clId="{D444FAE6-B328-4AB8-9A10-764831A715E0}" dt="2021-05-04T10:55:53.702" v="184"/>
          <ac:picMkLst>
            <pc:docMk/>
            <pc:sldMk cId="2764835349" sldId="259"/>
            <ac:picMk id="22" creationId="{0BB15684-9916-4DA8-A7CE-FCDBCD78A5D9}"/>
          </ac:picMkLst>
        </pc:picChg>
        <pc:picChg chg="mod">
          <ac:chgData name="Manasweeta Angane" userId="05da2731-9352-4b35-b713-60351f56afbd" providerId="ADAL" clId="{D444FAE6-B328-4AB8-9A10-764831A715E0}" dt="2021-05-04T10:55:53.702" v="184"/>
          <ac:picMkLst>
            <pc:docMk/>
            <pc:sldMk cId="2764835349" sldId="259"/>
            <ac:picMk id="23" creationId="{EC675987-5508-4447-8E52-1B18FCAC871D}"/>
          </ac:picMkLst>
        </pc:picChg>
        <pc:picChg chg="mod">
          <ac:chgData name="Manasweeta Angane" userId="05da2731-9352-4b35-b713-60351f56afbd" providerId="ADAL" clId="{D444FAE6-B328-4AB8-9A10-764831A715E0}" dt="2021-05-04T10:55:53.702" v="184"/>
          <ac:picMkLst>
            <pc:docMk/>
            <pc:sldMk cId="2764835349" sldId="259"/>
            <ac:picMk id="25" creationId="{F6FC2A26-12E1-47B6-882F-FC5596BA2097}"/>
          </ac:picMkLst>
        </pc:picChg>
        <pc:picChg chg="add del mod">
          <ac:chgData name="Manasweeta Angane" userId="05da2731-9352-4b35-b713-60351f56afbd" providerId="ADAL" clId="{D444FAE6-B328-4AB8-9A10-764831A715E0}" dt="2021-05-04T11:52:05.918" v="247" actId="478"/>
          <ac:picMkLst>
            <pc:docMk/>
            <pc:sldMk cId="2764835349" sldId="259"/>
            <ac:picMk id="26" creationId="{33B80AC6-C0F1-47A9-A0BF-600040066768}"/>
          </ac:picMkLst>
        </pc:picChg>
        <pc:picChg chg="add mod">
          <ac:chgData name="Manasweeta Angane" userId="05da2731-9352-4b35-b713-60351f56afbd" providerId="ADAL" clId="{D444FAE6-B328-4AB8-9A10-764831A715E0}" dt="2021-05-11T12:00:40.866" v="832" actId="1076"/>
          <ac:picMkLst>
            <pc:docMk/>
            <pc:sldMk cId="2764835349" sldId="259"/>
            <ac:picMk id="27" creationId="{AD90960C-5D7B-42B1-BCEA-05C5E386F7E8}"/>
          </ac:picMkLst>
        </pc:picChg>
        <pc:picChg chg="mod">
          <ac:chgData name="Manasweeta Angane" userId="05da2731-9352-4b35-b713-60351f56afbd" providerId="ADAL" clId="{D444FAE6-B328-4AB8-9A10-764831A715E0}" dt="2021-05-11T11:33:39.549" v="689" actId="1076"/>
          <ac:picMkLst>
            <pc:docMk/>
            <pc:sldMk cId="2764835349" sldId="259"/>
            <ac:picMk id="28" creationId="{14464A21-7546-4B1B-8F2D-8446CE74DBFF}"/>
          </ac:picMkLst>
        </pc:picChg>
        <pc:picChg chg="add del mod">
          <ac:chgData name="Manasweeta Angane" userId="05da2731-9352-4b35-b713-60351f56afbd" providerId="ADAL" clId="{D444FAE6-B328-4AB8-9A10-764831A715E0}" dt="2021-05-04T11:55:18.229" v="303" actId="478"/>
          <ac:picMkLst>
            <pc:docMk/>
            <pc:sldMk cId="2764835349" sldId="259"/>
            <ac:picMk id="29" creationId="{6479957C-CD56-484E-B890-61B979A7C400}"/>
          </ac:picMkLst>
        </pc:picChg>
        <pc:picChg chg="add del mod">
          <ac:chgData name="Manasweeta Angane" userId="05da2731-9352-4b35-b713-60351f56afbd" providerId="ADAL" clId="{D444FAE6-B328-4AB8-9A10-764831A715E0}" dt="2021-05-04T11:55:17.589" v="302" actId="478"/>
          <ac:picMkLst>
            <pc:docMk/>
            <pc:sldMk cId="2764835349" sldId="259"/>
            <ac:picMk id="30" creationId="{322E8E24-4D6B-4AD4-9F0D-86E9862F96D7}"/>
          </ac:picMkLst>
        </pc:picChg>
        <pc:picChg chg="mod">
          <ac:chgData name="Manasweeta Angane" userId="05da2731-9352-4b35-b713-60351f56afbd" providerId="ADAL" clId="{D444FAE6-B328-4AB8-9A10-764831A715E0}" dt="2021-05-11T09:36:56.641" v="572" actId="1076"/>
          <ac:picMkLst>
            <pc:docMk/>
            <pc:sldMk cId="2764835349" sldId="259"/>
            <ac:picMk id="31" creationId="{318D01EE-B552-46A9-8EA2-F37ECF766573}"/>
          </ac:picMkLst>
        </pc:picChg>
        <pc:picChg chg="add del mod">
          <ac:chgData name="Manasweeta Angane" userId="05da2731-9352-4b35-b713-60351f56afbd" providerId="ADAL" clId="{D444FAE6-B328-4AB8-9A10-764831A715E0}" dt="2021-05-04T11:55:16.890" v="301" actId="478"/>
          <ac:picMkLst>
            <pc:docMk/>
            <pc:sldMk cId="2764835349" sldId="259"/>
            <ac:picMk id="31" creationId="{7FB92A71-CFCB-4A9A-B976-DDC30A30CC71}"/>
          </ac:picMkLst>
        </pc:picChg>
        <pc:picChg chg="mod">
          <ac:chgData name="Manasweeta Angane" userId="05da2731-9352-4b35-b713-60351f56afbd" providerId="ADAL" clId="{D444FAE6-B328-4AB8-9A10-764831A715E0}" dt="2021-05-11T11:52:24.249" v="708" actId="164"/>
          <ac:picMkLst>
            <pc:docMk/>
            <pc:sldMk cId="2764835349" sldId="259"/>
            <ac:picMk id="32" creationId="{78F641C7-DEC6-4A2C-B4F1-78C77B3E6CC9}"/>
          </ac:picMkLst>
        </pc:picChg>
        <pc:picChg chg="add del mod">
          <ac:chgData name="Manasweeta Angane" userId="05da2731-9352-4b35-b713-60351f56afbd" providerId="ADAL" clId="{D444FAE6-B328-4AB8-9A10-764831A715E0}" dt="2021-05-04T11:55:16.150" v="300" actId="478"/>
          <ac:picMkLst>
            <pc:docMk/>
            <pc:sldMk cId="2764835349" sldId="259"/>
            <ac:picMk id="32" creationId="{EA1F8C16-CE37-41B9-9994-02AE0ADD27DB}"/>
          </ac:picMkLst>
        </pc:picChg>
        <pc:picChg chg="mod">
          <ac:chgData name="Manasweeta Angane" userId="05da2731-9352-4b35-b713-60351f56afbd" providerId="ADAL" clId="{D444FAE6-B328-4AB8-9A10-764831A715E0}" dt="2021-05-11T11:52:24.249" v="708" actId="164"/>
          <ac:picMkLst>
            <pc:docMk/>
            <pc:sldMk cId="2764835349" sldId="259"/>
            <ac:picMk id="33" creationId="{83E4B70F-3591-48E4-90F3-916C383129BF}"/>
          </ac:picMkLst>
        </pc:picChg>
        <pc:picChg chg="add del mod">
          <ac:chgData name="Manasweeta Angane" userId="05da2731-9352-4b35-b713-60351f56afbd" providerId="ADAL" clId="{D444FAE6-B328-4AB8-9A10-764831A715E0}" dt="2021-05-04T11:55:06.938" v="299"/>
          <ac:picMkLst>
            <pc:docMk/>
            <pc:sldMk cId="2764835349" sldId="259"/>
            <ac:picMk id="33" creationId="{F1597A93-DDFE-4CC6-B293-4E48DB8C0F9B}"/>
          </ac:picMkLst>
        </pc:picChg>
        <pc:picChg chg="add del mod">
          <ac:chgData name="Manasweeta Angane" userId="05da2731-9352-4b35-b713-60351f56afbd" providerId="ADAL" clId="{D444FAE6-B328-4AB8-9A10-764831A715E0}" dt="2021-05-04T11:55:06.704" v="298"/>
          <ac:picMkLst>
            <pc:docMk/>
            <pc:sldMk cId="2764835349" sldId="259"/>
            <ac:picMk id="34" creationId="{398A595B-2C20-4098-BA43-8D67496DE137}"/>
          </ac:picMkLst>
        </pc:picChg>
        <pc:picChg chg="add del mod">
          <ac:chgData name="Manasweeta Angane" userId="05da2731-9352-4b35-b713-60351f56afbd" providerId="ADAL" clId="{D444FAE6-B328-4AB8-9A10-764831A715E0}" dt="2021-05-04T11:55:06.470" v="297"/>
          <ac:picMkLst>
            <pc:docMk/>
            <pc:sldMk cId="2764835349" sldId="259"/>
            <ac:picMk id="35" creationId="{FE672D2E-4688-4B8A-A30C-6BD7A4090D42}"/>
          </ac:picMkLst>
        </pc:picChg>
        <pc:picChg chg="add del mod">
          <ac:chgData name="Manasweeta Angane" userId="05da2731-9352-4b35-b713-60351f56afbd" providerId="ADAL" clId="{D444FAE6-B328-4AB8-9A10-764831A715E0}" dt="2021-05-04T11:55:06.235" v="296"/>
          <ac:picMkLst>
            <pc:docMk/>
            <pc:sldMk cId="2764835349" sldId="259"/>
            <ac:picMk id="36" creationId="{11F1C50B-34D7-404B-A276-83CA3F17F960}"/>
          </ac:picMkLst>
        </pc:picChg>
        <pc:picChg chg="mod">
          <ac:chgData name="Manasweeta Angane" userId="05da2731-9352-4b35-b713-60351f56afbd" providerId="ADAL" clId="{D444FAE6-B328-4AB8-9A10-764831A715E0}" dt="2021-05-11T11:33:39.549" v="689" actId="1076"/>
          <ac:picMkLst>
            <pc:docMk/>
            <pc:sldMk cId="2764835349" sldId="259"/>
            <ac:picMk id="37" creationId="{2F85DFBD-A06B-4761-85DF-C4E7EEBA173B}"/>
          </ac:picMkLst>
        </pc:picChg>
        <pc:picChg chg="add del mod">
          <ac:chgData name="Manasweeta Angane" userId="05da2731-9352-4b35-b713-60351f56afbd" providerId="ADAL" clId="{D444FAE6-B328-4AB8-9A10-764831A715E0}" dt="2021-05-04T11:55:05.986" v="295"/>
          <ac:picMkLst>
            <pc:docMk/>
            <pc:sldMk cId="2764835349" sldId="259"/>
            <ac:picMk id="37" creationId="{84891ECA-007D-495F-8261-FC83EC3E3292}"/>
          </ac:picMkLst>
        </pc:picChg>
        <pc:picChg chg="mod">
          <ac:chgData name="Manasweeta Angane" userId="05da2731-9352-4b35-b713-60351f56afbd" providerId="ADAL" clId="{D444FAE6-B328-4AB8-9A10-764831A715E0}" dt="2021-05-11T09:05:05.943" v="527" actId="1036"/>
          <ac:picMkLst>
            <pc:docMk/>
            <pc:sldMk cId="2764835349" sldId="259"/>
            <ac:picMk id="38" creationId="{2BFF88E3-46CC-42FF-B795-6F79E5DE7560}"/>
          </ac:picMkLst>
        </pc:picChg>
        <pc:picChg chg="add del mod">
          <ac:chgData name="Manasweeta Angane" userId="05da2731-9352-4b35-b713-60351f56afbd" providerId="ADAL" clId="{D444FAE6-B328-4AB8-9A10-764831A715E0}" dt="2021-05-04T11:55:05.767" v="294"/>
          <ac:picMkLst>
            <pc:docMk/>
            <pc:sldMk cId="2764835349" sldId="259"/>
            <ac:picMk id="38" creationId="{F96CE350-D5FB-4052-8A81-27F59D089F27}"/>
          </ac:picMkLst>
        </pc:picChg>
        <pc:picChg chg="add del mod">
          <ac:chgData name="Manasweeta Angane" userId="05da2731-9352-4b35-b713-60351f56afbd" providerId="ADAL" clId="{D444FAE6-B328-4AB8-9A10-764831A715E0}" dt="2021-05-04T11:55:05.517" v="293"/>
          <ac:picMkLst>
            <pc:docMk/>
            <pc:sldMk cId="2764835349" sldId="259"/>
            <ac:picMk id="39" creationId="{0B3822B3-C761-4B3B-936A-8FE66E8EF801}"/>
          </ac:picMkLst>
        </pc:picChg>
        <pc:picChg chg="mod">
          <ac:chgData name="Manasweeta Angane" userId="05da2731-9352-4b35-b713-60351f56afbd" providerId="ADAL" clId="{D444FAE6-B328-4AB8-9A10-764831A715E0}" dt="2021-05-11T09:05:05.943" v="527" actId="1036"/>
          <ac:picMkLst>
            <pc:docMk/>
            <pc:sldMk cId="2764835349" sldId="259"/>
            <ac:picMk id="39" creationId="{242F7324-EDB9-4D37-8751-21991421DF37}"/>
          </ac:picMkLst>
        </pc:picChg>
        <pc:picChg chg="add del mod">
          <ac:chgData name="Manasweeta Angane" userId="05da2731-9352-4b35-b713-60351f56afbd" providerId="ADAL" clId="{D444FAE6-B328-4AB8-9A10-764831A715E0}" dt="2021-05-04T11:55:05.282" v="292"/>
          <ac:picMkLst>
            <pc:docMk/>
            <pc:sldMk cId="2764835349" sldId="259"/>
            <ac:picMk id="40" creationId="{3B9F5B04-C4F0-4E86-9BE0-D7D6DA870CDD}"/>
          </ac:picMkLst>
        </pc:picChg>
        <pc:picChg chg="add del mod">
          <ac:chgData name="Manasweeta Angane" userId="05da2731-9352-4b35-b713-60351f56afbd" providerId="ADAL" clId="{D444FAE6-B328-4AB8-9A10-764831A715E0}" dt="2021-05-04T11:55:05.048" v="291"/>
          <ac:picMkLst>
            <pc:docMk/>
            <pc:sldMk cId="2764835349" sldId="259"/>
            <ac:picMk id="41" creationId="{23766ACE-FF9C-47C9-A39E-4ECE51648316}"/>
          </ac:picMkLst>
        </pc:picChg>
        <pc:picChg chg="add del mod">
          <ac:chgData name="Manasweeta Angane" userId="05da2731-9352-4b35-b713-60351f56afbd" providerId="ADAL" clId="{D444FAE6-B328-4AB8-9A10-764831A715E0}" dt="2021-05-04T11:55:04.810" v="290"/>
          <ac:picMkLst>
            <pc:docMk/>
            <pc:sldMk cId="2764835349" sldId="259"/>
            <ac:picMk id="42" creationId="{9F03592B-C0D0-49DF-95AF-46FD1D1F577C}"/>
          </ac:picMkLst>
        </pc:picChg>
        <pc:picChg chg="add del mod">
          <ac:chgData name="Manasweeta Angane" userId="05da2731-9352-4b35-b713-60351f56afbd" providerId="ADAL" clId="{D444FAE6-B328-4AB8-9A10-764831A715E0}" dt="2021-05-04T11:55:04.576" v="289"/>
          <ac:picMkLst>
            <pc:docMk/>
            <pc:sldMk cId="2764835349" sldId="259"/>
            <ac:picMk id="43" creationId="{29634666-9D8C-462A-851F-67DC151509DA}"/>
          </ac:picMkLst>
        </pc:picChg>
        <pc:picChg chg="mod">
          <ac:chgData name="Manasweeta Angane" userId="05da2731-9352-4b35-b713-60351f56afbd" providerId="ADAL" clId="{D444FAE6-B328-4AB8-9A10-764831A715E0}" dt="2021-05-11T09:05:07.444" v="528" actId="1076"/>
          <ac:picMkLst>
            <pc:docMk/>
            <pc:sldMk cId="2764835349" sldId="259"/>
            <ac:picMk id="43" creationId="{8E9A5AD6-8D1B-4D83-8357-0F87E97A9A19}"/>
          </ac:picMkLst>
        </pc:picChg>
        <pc:picChg chg="add del mod">
          <ac:chgData name="Manasweeta Angane" userId="05da2731-9352-4b35-b713-60351f56afbd" providerId="ADAL" clId="{D444FAE6-B328-4AB8-9A10-764831A715E0}" dt="2021-05-04T11:55:04.357" v="288"/>
          <ac:picMkLst>
            <pc:docMk/>
            <pc:sldMk cId="2764835349" sldId="259"/>
            <ac:picMk id="44" creationId="{891C3952-8394-406D-BDFA-F8A93379AAD3}"/>
          </ac:picMkLst>
        </pc:picChg>
        <pc:picChg chg="add del mod">
          <ac:chgData name="Manasweeta Angane" userId="05da2731-9352-4b35-b713-60351f56afbd" providerId="ADAL" clId="{D444FAE6-B328-4AB8-9A10-764831A715E0}" dt="2021-05-04T11:55:04.114" v="287"/>
          <ac:picMkLst>
            <pc:docMk/>
            <pc:sldMk cId="2764835349" sldId="259"/>
            <ac:picMk id="45" creationId="{AA9AFA97-D16F-49B7-B1CE-E9E4FDD23CBA}"/>
          </ac:picMkLst>
        </pc:picChg>
        <pc:picChg chg="mod">
          <ac:chgData name="Manasweeta Angane" userId="05da2731-9352-4b35-b713-60351f56afbd" providerId="ADAL" clId="{D444FAE6-B328-4AB8-9A10-764831A715E0}" dt="2021-05-11T09:04:06.345" v="481" actId="1076"/>
          <ac:picMkLst>
            <pc:docMk/>
            <pc:sldMk cId="2764835349" sldId="259"/>
            <ac:picMk id="45" creationId="{DCDD893A-A216-4D98-AEC9-7705132EAC57}"/>
          </ac:picMkLst>
        </pc:picChg>
        <pc:picChg chg="mod">
          <ac:chgData name="Manasweeta Angane" userId="05da2731-9352-4b35-b713-60351f56afbd" providerId="ADAL" clId="{D444FAE6-B328-4AB8-9A10-764831A715E0}" dt="2021-05-11T09:04:06.345" v="481" actId="1076"/>
          <ac:picMkLst>
            <pc:docMk/>
            <pc:sldMk cId="2764835349" sldId="259"/>
            <ac:picMk id="46" creationId="{6D7250C2-0218-49F5-A51E-3AC98D7D08C1}"/>
          </ac:picMkLst>
        </pc:picChg>
        <pc:picChg chg="add del mod">
          <ac:chgData name="Manasweeta Angane" userId="05da2731-9352-4b35-b713-60351f56afbd" providerId="ADAL" clId="{D444FAE6-B328-4AB8-9A10-764831A715E0}" dt="2021-05-04T11:55:03.848" v="286"/>
          <ac:picMkLst>
            <pc:docMk/>
            <pc:sldMk cId="2764835349" sldId="259"/>
            <ac:picMk id="46" creationId="{AF03FFFA-04D1-4A2D-A196-90F5D6F84AEB}"/>
          </ac:picMkLst>
        </pc:picChg>
        <pc:picChg chg="add del mod">
          <ac:chgData name="Manasweeta Angane" userId="05da2731-9352-4b35-b713-60351f56afbd" providerId="ADAL" clId="{D444FAE6-B328-4AB8-9A10-764831A715E0}" dt="2021-05-04T11:55:03.635" v="285"/>
          <ac:picMkLst>
            <pc:docMk/>
            <pc:sldMk cId="2764835349" sldId="259"/>
            <ac:picMk id="47" creationId="{8F14C9FB-E9A7-4B97-BA1D-4DF886346EAC}"/>
          </ac:picMkLst>
        </pc:picChg>
        <pc:picChg chg="add mod">
          <ac:chgData name="Manasweeta Angane" userId="05da2731-9352-4b35-b713-60351f56afbd" providerId="ADAL" clId="{D444FAE6-B328-4AB8-9A10-764831A715E0}" dt="2021-05-11T09:05:17.437" v="529" actId="1076"/>
          <ac:picMkLst>
            <pc:docMk/>
            <pc:sldMk cId="2764835349" sldId="259"/>
            <ac:picMk id="48" creationId="{9E12AB79-711F-446B-80CC-19BB58595955}"/>
          </ac:picMkLst>
        </pc:picChg>
        <pc:picChg chg="add mod">
          <ac:chgData name="Manasweeta Angane" userId="05da2731-9352-4b35-b713-60351f56afbd" providerId="ADAL" clId="{D444FAE6-B328-4AB8-9A10-764831A715E0}" dt="2021-05-04T11:57:53.529" v="333" actId="1076"/>
          <ac:picMkLst>
            <pc:docMk/>
            <pc:sldMk cId="2764835349" sldId="259"/>
            <ac:picMk id="49" creationId="{E0A7E8B5-4176-42F5-B3C5-5431802FABE7}"/>
          </ac:picMkLst>
        </pc:picChg>
        <pc:picChg chg="add mod">
          <ac:chgData name="Manasweeta Angane" userId="05da2731-9352-4b35-b713-60351f56afbd" providerId="ADAL" clId="{D444FAE6-B328-4AB8-9A10-764831A715E0}" dt="2021-05-04T12:03:27.041" v="356" actId="1076"/>
          <ac:picMkLst>
            <pc:docMk/>
            <pc:sldMk cId="2764835349" sldId="259"/>
            <ac:picMk id="50" creationId="{10681031-75A0-4A0B-9DC7-88249CDB6B3A}"/>
          </ac:picMkLst>
        </pc:picChg>
        <pc:picChg chg="add mod">
          <ac:chgData name="Manasweeta Angane" userId="05da2731-9352-4b35-b713-60351f56afbd" providerId="ADAL" clId="{D444FAE6-B328-4AB8-9A10-764831A715E0}" dt="2021-05-11T11:51:37.687" v="704" actId="1076"/>
          <ac:picMkLst>
            <pc:docMk/>
            <pc:sldMk cId="2764835349" sldId="259"/>
            <ac:picMk id="51" creationId="{510C70A0-8345-4C2D-BAE4-A57622817052}"/>
          </ac:picMkLst>
        </pc:picChg>
        <pc:picChg chg="add mod">
          <ac:chgData name="Manasweeta Angane" userId="05da2731-9352-4b35-b713-60351f56afbd" providerId="ADAL" clId="{D444FAE6-B328-4AB8-9A10-764831A715E0}" dt="2021-05-04T12:00:31.027" v="345" actId="1076"/>
          <ac:picMkLst>
            <pc:docMk/>
            <pc:sldMk cId="2764835349" sldId="259"/>
            <ac:picMk id="52" creationId="{2A9CE1E7-B2B0-4DAB-BA6D-D2442DB2F362}"/>
          </ac:picMkLst>
        </pc:picChg>
        <pc:picChg chg="add mod">
          <ac:chgData name="Manasweeta Angane" userId="05da2731-9352-4b35-b713-60351f56afbd" providerId="ADAL" clId="{D444FAE6-B328-4AB8-9A10-764831A715E0}" dt="2021-05-04T12:01:21.304" v="349" actId="14861"/>
          <ac:picMkLst>
            <pc:docMk/>
            <pc:sldMk cId="2764835349" sldId="259"/>
            <ac:picMk id="53" creationId="{D0520211-CAE7-46EC-922C-DBD66A6DDE5C}"/>
          </ac:picMkLst>
        </pc:picChg>
        <pc:picChg chg="add mod">
          <ac:chgData name="Manasweeta Angane" userId="05da2731-9352-4b35-b713-60351f56afbd" providerId="ADAL" clId="{D444FAE6-B328-4AB8-9A10-764831A715E0}" dt="2021-05-04T12:05:43.504" v="365"/>
          <ac:picMkLst>
            <pc:docMk/>
            <pc:sldMk cId="2764835349" sldId="259"/>
            <ac:picMk id="54" creationId="{F44A9757-E37A-498E-B7F6-B63EF6220C2E}"/>
          </ac:picMkLst>
        </pc:picChg>
        <pc:picChg chg="mod">
          <ac:chgData name="Manasweeta Angane" userId="05da2731-9352-4b35-b713-60351f56afbd" providerId="ADAL" clId="{D444FAE6-B328-4AB8-9A10-764831A715E0}" dt="2021-05-11T08:44:17.984" v="443" actId="1076"/>
          <ac:picMkLst>
            <pc:docMk/>
            <pc:sldMk cId="2764835349" sldId="259"/>
            <ac:picMk id="55" creationId="{76AC46E1-1529-441A-B7C7-5BF677A619E6}"/>
          </ac:picMkLst>
        </pc:picChg>
        <pc:picChg chg="add mod">
          <ac:chgData name="Manasweeta Angane" userId="05da2731-9352-4b35-b713-60351f56afbd" providerId="ADAL" clId="{D444FAE6-B328-4AB8-9A10-764831A715E0}" dt="2021-05-11T08:42:50.443" v="429" actId="1076"/>
          <ac:picMkLst>
            <pc:docMk/>
            <pc:sldMk cId="2764835349" sldId="259"/>
            <ac:picMk id="58" creationId="{9142907A-7BDC-4B8A-824C-FBB6FC5CF01D}"/>
          </ac:picMkLst>
        </pc:picChg>
        <pc:picChg chg="add del mod">
          <ac:chgData name="Manasweeta Angane" userId="05da2731-9352-4b35-b713-60351f56afbd" providerId="ADAL" clId="{D444FAE6-B328-4AB8-9A10-764831A715E0}" dt="2021-05-11T08:43:37.918" v="437"/>
          <ac:picMkLst>
            <pc:docMk/>
            <pc:sldMk cId="2764835349" sldId="259"/>
            <ac:picMk id="59" creationId="{4D37D338-F613-4989-9D7A-B373B3B54247}"/>
          </ac:picMkLst>
        </pc:picChg>
        <pc:picChg chg="add del mod">
          <ac:chgData name="Manasweeta Angane" userId="05da2731-9352-4b35-b713-60351f56afbd" providerId="ADAL" clId="{D444FAE6-B328-4AB8-9A10-764831A715E0}" dt="2021-05-11T08:43:37.918" v="437"/>
          <ac:picMkLst>
            <pc:docMk/>
            <pc:sldMk cId="2764835349" sldId="259"/>
            <ac:picMk id="60" creationId="{EAA56B77-EC12-4B7A-BED9-27C1195867AD}"/>
          </ac:picMkLst>
        </pc:picChg>
        <pc:picChg chg="add mod">
          <ac:chgData name="Manasweeta Angane" userId="05da2731-9352-4b35-b713-60351f56afbd" providerId="ADAL" clId="{D444FAE6-B328-4AB8-9A10-764831A715E0}" dt="2021-05-11T08:45:48.870" v="459" actId="1076"/>
          <ac:picMkLst>
            <pc:docMk/>
            <pc:sldMk cId="2764835349" sldId="259"/>
            <ac:picMk id="61" creationId="{AC35923A-BF64-41B7-82A5-EA50D1037C6D}"/>
          </ac:picMkLst>
        </pc:picChg>
        <pc:picChg chg="add mod">
          <ac:chgData name="Manasweeta Angane" userId="05da2731-9352-4b35-b713-60351f56afbd" providerId="ADAL" clId="{D444FAE6-B328-4AB8-9A10-764831A715E0}" dt="2021-05-11T08:45:48.870" v="459" actId="1076"/>
          <ac:picMkLst>
            <pc:docMk/>
            <pc:sldMk cId="2764835349" sldId="259"/>
            <ac:picMk id="62" creationId="{02745D71-C1F7-41AA-82B4-F4AAC14A03E1}"/>
          </ac:picMkLst>
        </pc:picChg>
        <pc:picChg chg="add del mod">
          <ac:chgData name="Manasweeta Angane" userId="05da2731-9352-4b35-b713-60351f56afbd" providerId="ADAL" clId="{D444FAE6-B328-4AB8-9A10-764831A715E0}" dt="2021-05-11T08:45:22.445" v="455"/>
          <ac:picMkLst>
            <pc:docMk/>
            <pc:sldMk cId="2764835349" sldId="259"/>
            <ac:picMk id="63" creationId="{93ADC690-2FA6-4BF3-916A-2B1BA5D91B56}"/>
          </ac:picMkLst>
        </pc:picChg>
        <pc:picChg chg="mod">
          <ac:chgData name="Manasweeta Angane" userId="05da2731-9352-4b35-b713-60351f56afbd" providerId="ADAL" clId="{D444FAE6-B328-4AB8-9A10-764831A715E0}" dt="2021-05-11T11:35:23.811" v="701" actId="1076"/>
          <ac:picMkLst>
            <pc:docMk/>
            <pc:sldMk cId="2764835349" sldId="259"/>
            <ac:picMk id="65" creationId="{DDA440EB-D17C-409A-90C6-F2CB416FE5F3}"/>
          </ac:picMkLst>
        </pc:picChg>
        <pc:picChg chg="mod">
          <ac:chgData name="Manasweeta Angane" userId="05da2731-9352-4b35-b713-60351f56afbd" providerId="ADAL" clId="{D444FAE6-B328-4AB8-9A10-764831A715E0}" dt="2021-05-11T11:35:23.811" v="701" actId="1076"/>
          <ac:picMkLst>
            <pc:docMk/>
            <pc:sldMk cId="2764835349" sldId="259"/>
            <ac:picMk id="66" creationId="{C8B29F4A-A6E7-4694-ACD1-DD692EEB09D5}"/>
          </ac:picMkLst>
        </pc:picChg>
        <pc:picChg chg="add mod">
          <ac:chgData name="Manasweeta Angane" userId="05da2731-9352-4b35-b713-60351f56afbd" providerId="ADAL" clId="{D444FAE6-B328-4AB8-9A10-764831A715E0}" dt="2021-05-11T09:05:31.184" v="531" actId="1076"/>
          <ac:picMkLst>
            <pc:docMk/>
            <pc:sldMk cId="2764835349" sldId="259"/>
            <ac:picMk id="67" creationId="{9736C47D-50DB-49C2-A9DA-ECD546B601EA}"/>
          </ac:picMkLst>
        </pc:picChg>
        <pc:picChg chg="add mod">
          <ac:chgData name="Manasweeta Angane" userId="05da2731-9352-4b35-b713-60351f56afbd" providerId="ADAL" clId="{D444FAE6-B328-4AB8-9A10-764831A715E0}" dt="2021-05-11T09:04:29.882" v="485" actId="1076"/>
          <ac:picMkLst>
            <pc:docMk/>
            <pc:sldMk cId="2764835349" sldId="259"/>
            <ac:picMk id="68" creationId="{68524BC3-E839-45A8-A0F2-6005980F7F15}"/>
          </ac:picMkLst>
        </pc:picChg>
        <pc:picChg chg="add mod">
          <ac:chgData name="Manasweeta Angane" userId="05da2731-9352-4b35-b713-60351f56afbd" providerId="ADAL" clId="{D444FAE6-B328-4AB8-9A10-764831A715E0}" dt="2021-05-11T09:04:19.586" v="482" actId="1076"/>
          <ac:picMkLst>
            <pc:docMk/>
            <pc:sldMk cId="2764835349" sldId="259"/>
            <ac:picMk id="69" creationId="{A7838FD7-C060-4898-A40D-ACD3E18CB54A}"/>
          </ac:picMkLst>
        </pc:picChg>
        <pc:picChg chg="add mod">
          <ac:chgData name="Manasweeta Angane" userId="05da2731-9352-4b35-b713-60351f56afbd" providerId="ADAL" clId="{D444FAE6-B328-4AB8-9A10-764831A715E0}" dt="2021-05-11T11:57:54.037" v="815" actId="1076"/>
          <ac:picMkLst>
            <pc:docMk/>
            <pc:sldMk cId="2764835349" sldId="259"/>
            <ac:picMk id="70" creationId="{564BB657-BB08-4B8C-9CD5-6EEACA2CE31F}"/>
          </ac:picMkLst>
        </pc:picChg>
        <pc:picChg chg="add mod">
          <ac:chgData name="Manasweeta Angane" userId="05da2731-9352-4b35-b713-60351f56afbd" providerId="ADAL" clId="{D444FAE6-B328-4AB8-9A10-764831A715E0}" dt="2021-05-11T09:03:39.745" v="478" actId="1076"/>
          <ac:picMkLst>
            <pc:docMk/>
            <pc:sldMk cId="2764835349" sldId="259"/>
            <ac:picMk id="71" creationId="{6E0B42A9-CDEE-4B97-95E4-97F20506BC8B}"/>
          </ac:picMkLst>
        </pc:picChg>
        <pc:picChg chg="add mod">
          <ac:chgData name="Manasweeta Angane" userId="05da2731-9352-4b35-b713-60351f56afbd" providerId="ADAL" clId="{D444FAE6-B328-4AB8-9A10-764831A715E0}" dt="2021-05-11T12:01:04.528" v="839" actId="1076"/>
          <ac:picMkLst>
            <pc:docMk/>
            <pc:sldMk cId="2764835349" sldId="259"/>
            <ac:picMk id="72" creationId="{9C668B2F-AB67-4B5A-BEC4-4C2A008A5C21}"/>
          </ac:picMkLst>
        </pc:picChg>
        <pc:picChg chg="add del mod">
          <ac:chgData name="Manasweeta Angane" userId="05da2731-9352-4b35-b713-60351f56afbd" providerId="ADAL" clId="{D444FAE6-B328-4AB8-9A10-764831A715E0}" dt="2021-05-11T09:08:16.082" v="566" actId="478"/>
          <ac:picMkLst>
            <pc:docMk/>
            <pc:sldMk cId="2764835349" sldId="259"/>
            <ac:picMk id="73" creationId="{E2E674D5-5635-47E7-9680-C097AEAA90B4}"/>
          </ac:picMkLst>
        </pc:picChg>
        <pc:picChg chg="add mod">
          <ac:chgData name="Manasweeta Angane" userId="05da2731-9352-4b35-b713-60351f56afbd" providerId="ADAL" clId="{D444FAE6-B328-4AB8-9A10-764831A715E0}" dt="2021-05-11T09:06:38.203" v="543" actId="1076"/>
          <ac:picMkLst>
            <pc:docMk/>
            <pc:sldMk cId="2764835349" sldId="259"/>
            <ac:picMk id="74" creationId="{FE1942F6-89D4-42C8-ADFB-37FB02A572D3}"/>
          </ac:picMkLst>
        </pc:picChg>
        <pc:picChg chg="add mod">
          <ac:chgData name="Manasweeta Angane" userId="05da2731-9352-4b35-b713-60351f56afbd" providerId="ADAL" clId="{D444FAE6-B328-4AB8-9A10-764831A715E0}" dt="2021-05-11T11:24:06.630" v="583" actId="1076"/>
          <ac:picMkLst>
            <pc:docMk/>
            <pc:sldMk cId="2764835349" sldId="259"/>
            <ac:picMk id="75" creationId="{B56C8172-E660-4F61-B413-A6E179C8266A}"/>
          </ac:picMkLst>
        </pc:picChg>
        <pc:picChg chg="add mod">
          <ac:chgData name="Manasweeta Angane" userId="05da2731-9352-4b35-b713-60351f56afbd" providerId="ADAL" clId="{D444FAE6-B328-4AB8-9A10-764831A715E0}" dt="2021-05-11T11:25:16.394" v="594" actId="1076"/>
          <ac:picMkLst>
            <pc:docMk/>
            <pc:sldMk cId="2764835349" sldId="259"/>
            <ac:picMk id="76" creationId="{B46F448E-5E4E-4884-9AAB-6C9B90993F0E}"/>
          </ac:picMkLst>
        </pc:picChg>
        <pc:picChg chg="add mod">
          <ac:chgData name="Manasweeta Angane" userId="05da2731-9352-4b35-b713-60351f56afbd" providerId="ADAL" clId="{D444FAE6-B328-4AB8-9A10-764831A715E0}" dt="2021-05-11T11:25:57.171" v="597" actId="1076"/>
          <ac:picMkLst>
            <pc:docMk/>
            <pc:sldMk cId="2764835349" sldId="259"/>
            <ac:picMk id="77" creationId="{1D0EE913-226C-4A18-BBF2-90A93766C6E2}"/>
          </ac:picMkLst>
        </pc:picChg>
        <pc:picChg chg="mod">
          <ac:chgData name="Manasweeta Angane" userId="05da2731-9352-4b35-b713-60351f56afbd" providerId="ADAL" clId="{D444FAE6-B328-4AB8-9A10-764831A715E0}" dt="2021-05-11T11:26:44.015" v="633" actId="1076"/>
          <ac:picMkLst>
            <pc:docMk/>
            <pc:sldMk cId="2764835349" sldId="259"/>
            <ac:picMk id="79" creationId="{423926C3-05B3-48C6-8369-F6844567222A}"/>
          </ac:picMkLst>
        </pc:picChg>
        <pc:picChg chg="mod">
          <ac:chgData name="Manasweeta Angane" userId="05da2731-9352-4b35-b713-60351f56afbd" providerId="ADAL" clId="{D444FAE6-B328-4AB8-9A10-764831A715E0}" dt="2021-05-11T11:26:44.015" v="633" actId="1076"/>
          <ac:picMkLst>
            <pc:docMk/>
            <pc:sldMk cId="2764835349" sldId="259"/>
            <ac:picMk id="80" creationId="{CDBC8590-6E19-4875-910F-773C01DD9794}"/>
          </ac:picMkLst>
        </pc:picChg>
        <pc:picChg chg="add mod">
          <ac:chgData name="Manasweeta Angane" userId="05da2731-9352-4b35-b713-60351f56afbd" providerId="ADAL" clId="{D444FAE6-B328-4AB8-9A10-764831A715E0}" dt="2021-05-11T11:28:00.288" v="639" actId="1076"/>
          <ac:picMkLst>
            <pc:docMk/>
            <pc:sldMk cId="2764835349" sldId="259"/>
            <ac:picMk id="81" creationId="{D250D50D-7E55-4215-A116-7DD641FC3EB9}"/>
          </ac:picMkLst>
        </pc:picChg>
        <pc:picChg chg="add mod">
          <ac:chgData name="Manasweeta Angane" userId="05da2731-9352-4b35-b713-60351f56afbd" providerId="ADAL" clId="{D444FAE6-B328-4AB8-9A10-764831A715E0}" dt="2021-05-11T11:28:50.342" v="647" actId="1076"/>
          <ac:picMkLst>
            <pc:docMk/>
            <pc:sldMk cId="2764835349" sldId="259"/>
            <ac:picMk id="82" creationId="{3E74BE48-BB22-4BD9-B2C6-29A1541333B1}"/>
          </ac:picMkLst>
        </pc:picChg>
        <pc:picChg chg="add mod">
          <ac:chgData name="Manasweeta Angane" userId="05da2731-9352-4b35-b713-60351f56afbd" providerId="ADAL" clId="{D444FAE6-B328-4AB8-9A10-764831A715E0}" dt="2021-05-11T11:33:27.526" v="688" actId="14100"/>
          <ac:picMkLst>
            <pc:docMk/>
            <pc:sldMk cId="2764835349" sldId="259"/>
            <ac:picMk id="83" creationId="{98317C7F-8CDA-4BD2-A1EA-C771895BC6D4}"/>
          </ac:picMkLst>
        </pc:picChg>
        <pc:picChg chg="add mod">
          <ac:chgData name="Manasweeta Angane" userId="05da2731-9352-4b35-b713-60351f56afbd" providerId="ADAL" clId="{D444FAE6-B328-4AB8-9A10-764831A715E0}" dt="2021-05-11T11:30:51.812" v="664" actId="1076"/>
          <ac:picMkLst>
            <pc:docMk/>
            <pc:sldMk cId="2764835349" sldId="259"/>
            <ac:picMk id="84" creationId="{DB7D06D8-8CF4-4065-A840-6FF812D26DC3}"/>
          </ac:picMkLst>
        </pc:picChg>
        <pc:picChg chg="add mod">
          <ac:chgData name="Manasweeta Angane" userId="05da2731-9352-4b35-b713-60351f56afbd" providerId="ADAL" clId="{D444FAE6-B328-4AB8-9A10-764831A715E0}" dt="2021-05-11T11:31:48.835" v="673" actId="1076"/>
          <ac:picMkLst>
            <pc:docMk/>
            <pc:sldMk cId="2764835349" sldId="259"/>
            <ac:picMk id="85" creationId="{B4C24787-5B2B-4E0A-AC84-EF278C32A804}"/>
          </ac:picMkLst>
        </pc:picChg>
        <pc:picChg chg="add mod">
          <ac:chgData name="Manasweeta Angane" userId="05da2731-9352-4b35-b713-60351f56afbd" providerId="ADAL" clId="{D444FAE6-B328-4AB8-9A10-764831A715E0}" dt="2021-05-11T11:34:37.578" v="697" actId="1076"/>
          <ac:picMkLst>
            <pc:docMk/>
            <pc:sldMk cId="2764835349" sldId="259"/>
            <ac:picMk id="86" creationId="{6076695E-3104-44A7-8BEA-99DA4C7F28AB}"/>
          </ac:picMkLst>
        </pc:picChg>
        <pc:picChg chg="mod">
          <ac:chgData name="Manasweeta Angane" userId="05da2731-9352-4b35-b713-60351f56afbd" providerId="ADAL" clId="{D444FAE6-B328-4AB8-9A10-764831A715E0}" dt="2021-05-11T11:52:52.909" v="782" actId="1076"/>
          <ac:picMkLst>
            <pc:docMk/>
            <pc:sldMk cId="2764835349" sldId="259"/>
            <ac:picMk id="88" creationId="{B29010D4-E057-4D41-8AAB-9400C0C3E905}"/>
          </ac:picMkLst>
        </pc:picChg>
        <pc:picChg chg="mod">
          <ac:chgData name="Manasweeta Angane" userId="05da2731-9352-4b35-b713-60351f56afbd" providerId="ADAL" clId="{D444FAE6-B328-4AB8-9A10-764831A715E0}" dt="2021-05-11T11:52:52.909" v="782" actId="1076"/>
          <ac:picMkLst>
            <pc:docMk/>
            <pc:sldMk cId="2764835349" sldId="259"/>
            <ac:picMk id="89" creationId="{6E34AD2C-9222-4899-9245-425D0808A398}"/>
          </ac:picMkLst>
        </pc:picChg>
        <pc:picChg chg="add mod">
          <ac:chgData name="Manasweeta Angane" userId="05da2731-9352-4b35-b713-60351f56afbd" providerId="ADAL" clId="{D444FAE6-B328-4AB8-9A10-764831A715E0}" dt="2021-05-11T11:53:21.817" v="785" actId="1076"/>
          <ac:picMkLst>
            <pc:docMk/>
            <pc:sldMk cId="2764835349" sldId="259"/>
            <ac:picMk id="90" creationId="{7E513889-6580-4137-A42E-EAB2DF792BBE}"/>
          </ac:picMkLst>
        </pc:picChg>
        <pc:picChg chg="add mod">
          <ac:chgData name="Manasweeta Angane" userId="05da2731-9352-4b35-b713-60351f56afbd" providerId="ADAL" clId="{D444FAE6-B328-4AB8-9A10-764831A715E0}" dt="2021-05-11T11:54:06.256" v="793" actId="1076"/>
          <ac:picMkLst>
            <pc:docMk/>
            <pc:sldMk cId="2764835349" sldId="259"/>
            <ac:picMk id="91" creationId="{0BE992B8-9C7C-4D03-8702-5C316C2C5B44}"/>
          </ac:picMkLst>
        </pc:picChg>
        <pc:picChg chg="add mod">
          <ac:chgData name="Manasweeta Angane" userId="05da2731-9352-4b35-b713-60351f56afbd" providerId="ADAL" clId="{D444FAE6-B328-4AB8-9A10-764831A715E0}" dt="2021-05-11T11:55:57.681" v="804" actId="1076"/>
          <ac:picMkLst>
            <pc:docMk/>
            <pc:sldMk cId="2764835349" sldId="259"/>
            <ac:picMk id="92" creationId="{6EF6E06A-BC61-4D8F-B504-8128E7584F2E}"/>
          </ac:picMkLst>
        </pc:picChg>
        <pc:picChg chg="add mod">
          <ac:chgData name="Manasweeta Angane" userId="05da2731-9352-4b35-b713-60351f56afbd" providerId="ADAL" clId="{D444FAE6-B328-4AB8-9A10-764831A715E0}" dt="2021-05-11T11:56:41.572" v="807" actId="1076"/>
          <ac:picMkLst>
            <pc:docMk/>
            <pc:sldMk cId="2764835349" sldId="259"/>
            <ac:picMk id="93" creationId="{BDF3C75D-8CB3-45F8-8CF1-067C1F6FE252}"/>
          </ac:picMkLst>
        </pc:picChg>
        <pc:picChg chg="mod">
          <ac:chgData name="Manasweeta Angane" userId="05da2731-9352-4b35-b713-60351f56afbd" providerId="ADAL" clId="{D444FAE6-B328-4AB8-9A10-764831A715E0}" dt="2021-05-11T11:57:19.998" v="811" actId="1076"/>
          <ac:picMkLst>
            <pc:docMk/>
            <pc:sldMk cId="2764835349" sldId="259"/>
            <ac:picMk id="95" creationId="{09BCF5B3-5728-4C68-812C-3B238F32029A}"/>
          </ac:picMkLst>
        </pc:picChg>
        <pc:picChg chg="mod">
          <ac:chgData name="Manasweeta Angane" userId="05da2731-9352-4b35-b713-60351f56afbd" providerId="ADAL" clId="{D444FAE6-B328-4AB8-9A10-764831A715E0}" dt="2021-05-11T11:57:19.998" v="811" actId="1076"/>
          <ac:picMkLst>
            <pc:docMk/>
            <pc:sldMk cId="2764835349" sldId="259"/>
            <ac:picMk id="96" creationId="{0801F256-F6B4-4734-81C5-67EEE3E1615F}"/>
          </ac:picMkLst>
        </pc:picChg>
        <pc:picChg chg="add del mod">
          <ac:chgData name="Manasweeta Angane" userId="05da2731-9352-4b35-b713-60351f56afbd" providerId="ADAL" clId="{D444FAE6-B328-4AB8-9A10-764831A715E0}" dt="2021-05-11T11:57:45.251" v="813"/>
          <ac:picMkLst>
            <pc:docMk/>
            <pc:sldMk cId="2764835349" sldId="259"/>
            <ac:picMk id="97" creationId="{1A3D622F-E590-42A6-8233-3C1DA64B0F38}"/>
          </ac:picMkLst>
        </pc:picChg>
        <pc:picChg chg="add mod">
          <ac:chgData name="Manasweeta Angane" userId="05da2731-9352-4b35-b713-60351f56afbd" providerId="ADAL" clId="{D444FAE6-B328-4AB8-9A10-764831A715E0}" dt="2021-05-11T11:59:05.987" v="820" actId="1076"/>
          <ac:picMkLst>
            <pc:docMk/>
            <pc:sldMk cId="2764835349" sldId="259"/>
            <ac:picMk id="98" creationId="{90F8C793-315C-44FE-AD34-A2CFDEC5B1ED}"/>
          </ac:picMkLst>
        </pc:picChg>
        <pc:picChg chg="mod">
          <ac:chgData name="Manasweeta Angane" userId="05da2731-9352-4b35-b713-60351f56afbd" providerId="ADAL" clId="{D444FAE6-B328-4AB8-9A10-764831A715E0}" dt="2021-05-11T12:00:18.451" v="828" actId="1076"/>
          <ac:picMkLst>
            <pc:docMk/>
            <pc:sldMk cId="2764835349" sldId="259"/>
            <ac:picMk id="100" creationId="{9F304B02-5E30-4F30-9D39-9DF57918576B}"/>
          </ac:picMkLst>
        </pc:picChg>
        <pc:picChg chg="mod">
          <ac:chgData name="Manasweeta Angane" userId="05da2731-9352-4b35-b713-60351f56afbd" providerId="ADAL" clId="{D444FAE6-B328-4AB8-9A10-764831A715E0}" dt="2021-05-11T12:00:18.451" v="828" actId="1076"/>
          <ac:picMkLst>
            <pc:docMk/>
            <pc:sldMk cId="2764835349" sldId="259"/>
            <ac:picMk id="101" creationId="{B8EE9BC6-D703-4AAC-83BF-5D194FEF27BB}"/>
          </ac:picMkLst>
        </pc:picChg>
        <pc:picChg chg="mod">
          <ac:chgData name="Manasweeta Angane" userId="05da2731-9352-4b35-b713-60351f56afbd" providerId="ADAL" clId="{D444FAE6-B328-4AB8-9A10-764831A715E0}" dt="2021-05-11T12:01:10.624" v="840" actId="1076"/>
          <ac:picMkLst>
            <pc:docMk/>
            <pc:sldMk cId="2764835349" sldId="259"/>
            <ac:picMk id="103" creationId="{1B12A011-4013-4563-A992-0A1A1673ACC0}"/>
          </ac:picMkLst>
        </pc:picChg>
        <pc:picChg chg="mod">
          <ac:chgData name="Manasweeta Angane" userId="05da2731-9352-4b35-b713-60351f56afbd" providerId="ADAL" clId="{D444FAE6-B328-4AB8-9A10-764831A715E0}" dt="2021-05-11T12:01:10.624" v="840" actId="1076"/>
          <ac:picMkLst>
            <pc:docMk/>
            <pc:sldMk cId="2764835349" sldId="259"/>
            <ac:picMk id="104" creationId="{F0BF17E7-C49F-4DBC-AD9A-DCC33B0227C5}"/>
          </ac:picMkLst>
        </pc:picChg>
        <pc:picChg chg="mod">
          <ac:chgData name="Manasweeta Angane" userId="05da2731-9352-4b35-b713-60351f56afbd" providerId="ADAL" clId="{D444FAE6-B328-4AB8-9A10-764831A715E0}" dt="2021-05-11T08:43:24.491" v="435" actId="1076"/>
          <ac:picMkLst>
            <pc:docMk/>
            <pc:sldMk cId="2764835349" sldId="259"/>
            <ac:picMk id="1026" creationId="{137C4FFD-2974-4454-B897-C812188AA1E5}"/>
          </ac:picMkLst>
        </pc:picChg>
      </pc:sldChg>
      <pc:sldChg chg="addSp delSp modSp new mod">
        <pc:chgData name="Manasweeta Angane" userId="05da2731-9352-4b35-b713-60351f56afbd" providerId="ADAL" clId="{D444FAE6-B328-4AB8-9A10-764831A715E0}" dt="2021-03-25T11:53:24.496" v="29" actId="478"/>
        <pc:sldMkLst>
          <pc:docMk/>
          <pc:sldMk cId="1521514973" sldId="260"/>
        </pc:sldMkLst>
        <pc:grpChg chg="add del mod">
          <ac:chgData name="Manasweeta Angane" userId="05da2731-9352-4b35-b713-60351f56afbd" providerId="ADAL" clId="{D444FAE6-B328-4AB8-9A10-764831A715E0}" dt="2021-03-25T11:53:24.496" v="29" actId="478"/>
          <ac:grpSpMkLst>
            <pc:docMk/>
            <pc:sldMk cId="1521514973" sldId="260"/>
            <ac:grpSpMk id="3" creationId="{3D20BA94-058F-4419-B444-55BDE44111CD}"/>
          </ac:grpSpMkLst>
        </pc:grpChg>
        <pc:picChg chg="add mod">
          <ac:chgData name="Manasweeta Angane" userId="05da2731-9352-4b35-b713-60351f56afbd" providerId="ADAL" clId="{D444FAE6-B328-4AB8-9A10-764831A715E0}" dt="2021-03-25T11:52:51.830" v="25" actId="1076"/>
          <ac:picMkLst>
            <pc:docMk/>
            <pc:sldMk cId="1521514973" sldId="260"/>
            <ac:picMk id="2" creationId="{A1960901-F870-4D4F-915C-DF22F7ED76B3}"/>
          </ac:picMkLst>
        </pc:picChg>
        <pc:picChg chg="mod">
          <ac:chgData name="Manasweeta Angane" userId="05da2731-9352-4b35-b713-60351f56afbd" providerId="ADAL" clId="{D444FAE6-B328-4AB8-9A10-764831A715E0}" dt="2021-03-25T11:51:44.601" v="13"/>
          <ac:picMkLst>
            <pc:docMk/>
            <pc:sldMk cId="1521514973" sldId="260"/>
            <ac:picMk id="4" creationId="{22AA7012-3978-4203-BCF8-9445E689C5E0}"/>
          </ac:picMkLst>
        </pc:picChg>
        <pc:picChg chg="mod">
          <ac:chgData name="Manasweeta Angane" userId="05da2731-9352-4b35-b713-60351f56afbd" providerId="ADAL" clId="{D444FAE6-B328-4AB8-9A10-764831A715E0}" dt="2021-03-25T11:51:44.601" v="13"/>
          <ac:picMkLst>
            <pc:docMk/>
            <pc:sldMk cId="1521514973" sldId="260"/>
            <ac:picMk id="5" creationId="{865A8A7E-E6DA-438A-8E32-7BE4263EF240}"/>
          </ac:picMkLst>
        </pc:picChg>
        <pc:picChg chg="add mod">
          <ac:chgData name="Manasweeta Angane" userId="05da2731-9352-4b35-b713-60351f56afbd" providerId="ADAL" clId="{D444FAE6-B328-4AB8-9A10-764831A715E0}" dt="2021-03-25T11:53:16.892" v="28" actId="14100"/>
          <ac:picMkLst>
            <pc:docMk/>
            <pc:sldMk cId="1521514973" sldId="260"/>
            <ac:picMk id="6" creationId="{9E309EB5-605F-47A9-B2B9-9D804DC2A327}"/>
          </ac:picMkLst>
        </pc:picChg>
      </pc:sldChg>
      <pc:sldChg chg="addSp modSp">
        <pc:chgData name="Manasweeta Angane" userId="05da2731-9352-4b35-b713-60351f56afbd" providerId="ADAL" clId="{D444FAE6-B328-4AB8-9A10-764831A715E0}" dt="2021-05-12T08:48:15.376" v="853"/>
        <pc:sldMkLst>
          <pc:docMk/>
          <pc:sldMk cId="1300633407" sldId="261"/>
        </pc:sldMkLst>
        <pc:grpChg chg="add mod">
          <ac:chgData name="Manasweeta Angane" userId="05da2731-9352-4b35-b713-60351f56afbd" providerId="ADAL" clId="{D444FAE6-B328-4AB8-9A10-764831A715E0}" dt="2021-05-12T08:48:15.376" v="853"/>
          <ac:grpSpMkLst>
            <pc:docMk/>
            <pc:sldMk cId="1300633407" sldId="261"/>
            <ac:grpSpMk id="15" creationId="{2F84AD72-9BAF-41B2-BF46-1C06486CE0ED}"/>
          </ac:grpSpMkLst>
        </pc:grpChg>
        <pc:picChg chg="add mod">
          <ac:chgData name="Manasweeta Angane" userId="05da2731-9352-4b35-b713-60351f56afbd" providerId="ADAL" clId="{D444FAE6-B328-4AB8-9A10-764831A715E0}" dt="2021-05-12T08:48:15.376" v="853"/>
          <ac:picMkLst>
            <pc:docMk/>
            <pc:sldMk cId="1300633407" sldId="261"/>
            <ac:picMk id="17" creationId="{DCDD893A-A216-4D98-AEC9-7705132EAC57}"/>
          </ac:picMkLst>
        </pc:picChg>
        <pc:picChg chg="add mod">
          <ac:chgData name="Manasweeta Angane" userId="05da2731-9352-4b35-b713-60351f56afbd" providerId="ADAL" clId="{D444FAE6-B328-4AB8-9A10-764831A715E0}" dt="2021-05-12T08:48:15.376" v="853"/>
          <ac:picMkLst>
            <pc:docMk/>
            <pc:sldMk cId="1300633407" sldId="261"/>
            <ac:picMk id="20" creationId="{6D7250C2-0218-49F5-A51E-3AC98D7D08C1}"/>
          </ac:picMkLst>
        </pc:picChg>
      </pc:sldChg>
      <pc:sldChg chg="add">
        <pc:chgData name="Manasweeta Angane" userId="05da2731-9352-4b35-b713-60351f56afbd" providerId="ADAL" clId="{D444FAE6-B328-4AB8-9A10-764831A715E0}" dt="2021-05-04T10:05:20.964" v="30" actId="2890"/>
        <pc:sldMkLst>
          <pc:docMk/>
          <pc:sldMk cId="2707572057" sldId="262"/>
        </pc:sldMkLst>
      </pc:sldChg>
      <pc:sldChg chg="new del">
        <pc:chgData name="Manasweeta Angane" userId="05da2731-9352-4b35-b713-60351f56afbd" providerId="ADAL" clId="{D444FAE6-B328-4AB8-9A10-764831A715E0}" dt="2021-05-04T10:18:00.778" v="73" actId="680"/>
        <pc:sldMkLst>
          <pc:docMk/>
          <pc:sldMk cId="2715297689" sldId="263"/>
        </pc:sldMkLst>
      </pc:sldChg>
      <pc:sldChg chg="addSp delSp modSp add mod">
        <pc:chgData name="Manasweeta Angane" userId="05da2731-9352-4b35-b713-60351f56afbd" providerId="ADAL" clId="{D444FAE6-B328-4AB8-9A10-764831A715E0}" dt="2021-05-04T11:01:31.218" v="205" actId="688"/>
        <pc:sldMkLst>
          <pc:docMk/>
          <pc:sldMk cId="3970588774" sldId="263"/>
        </pc:sldMkLst>
        <pc:spChg chg="mod ord topLvl">
          <ac:chgData name="Manasweeta Angane" userId="05da2731-9352-4b35-b713-60351f56afbd" providerId="ADAL" clId="{D444FAE6-B328-4AB8-9A10-764831A715E0}" dt="2021-05-04T10:54:20.544" v="174" actId="164"/>
          <ac:spMkLst>
            <pc:docMk/>
            <pc:sldMk cId="3970588774" sldId="263"/>
            <ac:spMk id="8" creationId="{845CBCD6-11CF-4DEA-8489-D44719408E57}"/>
          </ac:spMkLst>
        </pc:spChg>
        <pc:spChg chg="mod">
          <ac:chgData name="Manasweeta Angane" userId="05da2731-9352-4b35-b713-60351f56afbd" providerId="ADAL" clId="{D444FAE6-B328-4AB8-9A10-764831A715E0}" dt="2021-05-04T10:53:48.474" v="169"/>
          <ac:spMkLst>
            <pc:docMk/>
            <pc:sldMk cId="3970588774" sldId="263"/>
            <ac:spMk id="14" creationId="{BB2BE29D-9428-46CA-BC09-ED65C63CDD8C}"/>
          </ac:spMkLst>
        </pc:spChg>
        <pc:spChg chg="add mod">
          <ac:chgData name="Manasweeta Angane" userId="05da2731-9352-4b35-b713-60351f56afbd" providerId="ADAL" clId="{D444FAE6-B328-4AB8-9A10-764831A715E0}" dt="2021-05-04T10:59:04.002" v="189" actId="208"/>
          <ac:spMkLst>
            <pc:docMk/>
            <pc:sldMk cId="3970588774" sldId="263"/>
            <ac:spMk id="19" creationId="{59834D5E-DD2F-4BD4-9BEF-5F08538199AF}"/>
          </ac:spMkLst>
        </pc:spChg>
        <pc:grpChg chg="add del mod">
          <ac:chgData name="Manasweeta Angane" userId="05da2731-9352-4b35-b713-60351f56afbd" providerId="ADAL" clId="{D444FAE6-B328-4AB8-9A10-764831A715E0}" dt="2021-05-04T10:55:50.825" v="183" actId="21"/>
          <ac:grpSpMkLst>
            <pc:docMk/>
            <pc:sldMk cId="3970588774" sldId="263"/>
            <ac:grpSpMk id="2" creationId="{9B9CA001-4785-45B2-8704-2A967B0F1959}"/>
          </ac:grpSpMkLst>
        </pc:grpChg>
        <pc:grpChg chg="add del mod">
          <ac:chgData name="Manasweeta Angane" userId="05da2731-9352-4b35-b713-60351f56afbd" providerId="ADAL" clId="{D444FAE6-B328-4AB8-9A10-764831A715E0}" dt="2021-05-04T10:26:01.755" v="89" actId="165"/>
          <ac:grpSpMkLst>
            <pc:docMk/>
            <pc:sldMk cId="3970588774" sldId="263"/>
            <ac:grpSpMk id="4" creationId="{94474BDD-ED27-4303-9D0F-A6040EB1BB46}"/>
          </ac:grpSpMkLst>
        </pc:grpChg>
        <pc:grpChg chg="add mod">
          <ac:chgData name="Manasweeta Angane" userId="05da2731-9352-4b35-b713-60351f56afbd" providerId="ADAL" clId="{D444FAE6-B328-4AB8-9A10-764831A715E0}" dt="2021-05-04T10:55:01.895" v="179" actId="1076"/>
          <ac:grpSpMkLst>
            <pc:docMk/>
            <pc:sldMk cId="3970588774" sldId="263"/>
            <ac:grpSpMk id="10" creationId="{5F108F01-69A0-41CC-9661-7A6328E149C7}"/>
          </ac:grpSpMkLst>
        </pc:grpChg>
        <pc:picChg chg="add mod">
          <ac:chgData name="Manasweeta Angane" userId="05da2731-9352-4b35-b713-60351f56afbd" providerId="ADAL" clId="{D444FAE6-B328-4AB8-9A10-764831A715E0}" dt="2021-05-04T10:55:28.555" v="180" actId="1076"/>
          <ac:picMkLst>
            <pc:docMk/>
            <pc:sldMk cId="3970588774" sldId="263"/>
            <ac:picMk id="3" creationId="{395996A1-64EA-470E-8C77-F60F1DCCE677}"/>
          </ac:picMkLst>
        </pc:picChg>
        <pc:picChg chg="mod ord topLvl">
          <ac:chgData name="Manasweeta Angane" userId="05da2731-9352-4b35-b713-60351f56afbd" providerId="ADAL" clId="{D444FAE6-B328-4AB8-9A10-764831A715E0}" dt="2021-05-04T10:54:20.544" v="174" actId="164"/>
          <ac:picMkLst>
            <pc:docMk/>
            <pc:sldMk cId="3970588774" sldId="263"/>
            <ac:picMk id="5" creationId="{EF720200-6F85-4009-B518-DC67B231C0D5}"/>
          </ac:picMkLst>
        </pc:picChg>
        <pc:picChg chg="mod ord topLvl">
          <ac:chgData name="Manasweeta Angane" userId="05da2731-9352-4b35-b713-60351f56afbd" providerId="ADAL" clId="{D444FAE6-B328-4AB8-9A10-764831A715E0}" dt="2021-05-04T10:54:20.544" v="174" actId="164"/>
          <ac:picMkLst>
            <pc:docMk/>
            <pc:sldMk cId="3970588774" sldId="263"/>
            <ac:picMk id="6" creationId="{EE858448-E077-4CD5-9B2B-934594F56240}"/>
          </ac:picMkLst>
        </pc:picChg>
        <pc:picChg chg="mod ord topLvl">
          <ac:chgData name="Manasweeta Angane" userId="05da2731-9352-4b35-b713-60351f56afbd" providerId="ADAL" clId="{D444FAE6-B328-4AB8-9A10-764831A715E0}" dt="2021-05-04T10:54:20.544" v="174" actId="164"/>
          <ac:picMkLst>
            <pc:docMk/>
            <pc:sldMk cId="3970588774" sldId="263"/>
            <ac:picMk id="7" creationId="{15A60045-64EC-474A-A083-583970882F71}"/>
          </ac:picMkLst>
        </pc:picChg>
        <pc:picChg chg="add mod">
          <ac:chgData name="Manasweeta Angane" userId="05da2731-9352-4b35-b713-60351f56afbd" providerId="ADAL" clId="{D444FAE6-B328-4AB8-9A10-764831A715E0}" dt="2021-05-04T10:55:31.059" v="181" actId="1076"/>
          <ac:picMkLst>
            <pc:docMk/>
            <pc:sldMk cId="3970588774" sldId="263"/>
            <ac:picMk id="9" creationId="{9F623296-685E-4D26-80CB-5BED352490B8}"/>
          </ac:picMkLst>
        </pc:picChg>
        <pc:picChg chg="mod">
          <ac:chgData name="Manasweeta Angane" userId="05da2731-9352-4b35-b713-60351f56afbd" providerId="ADAL" clId="{D444FAE6-B328-4AB8-9A10-764831A715E0}" dt="2021-05-04T10:53:48.474" v="169"/>
          <ac:picMkLst>
            <pc:docMk/>
            <pc:sldMk cId="3970588774" sldId="263"/>
            <ac:picMk id="11" creationId="{5BD5DD00-716A-43A9-ADAC-F5F1DFFA83D5}"/>
          </ac:picMkLst>
        </pc:picChg>
        <pc:picChg chg="mod">
          <ac:chgData name="Manasweeta Angane" userId="05da2731-9352-4b35-b713-60351f56afbd" providerId="ADAL" clId="{D444FAE6-B328-4AB8-9A10-764831A715E0}" dt="2021-05-04T10:53:48.474" v="169"/>
          <ac:picMkLst>
            <pc:docMk/>
            <pc:sldMk cId="3970588774" sldId="263"/>
            <ac:picMk id="12" creationId="{F253838C-F94C-42EF-B8B8-54C73BBD9E5C}"/>
          </ac:picMkLst>
        </pc:picChg>
        <pc:picChg chg="mod">
          <ac:chgData name="Manasweeta Angane" userId="05da2731-9352-4b35-b713-60351f56afbd" providerId="ADAL" clId="{D444FAE6-B328-4AB8-9A10-764831A715E0}" dt="2021-05-04T10:53:48.474" v="169"/>
          <ac:picMkLst>
            <pc:docMk/>
            <pc:sldMk cId="3970588774" sldId="263"/>
            <ac:picMk id="13" creationId="{46E16DED-4921-4490-B057-C4791A8FB7A1}"/>
          </ac:picMkLst>
        </pc:picChg>
        <pc:picChg chg="add mod">
          <ac:chgData name="Manasweeta Angane" userId="05da2731-9352-4b35-b713-60351f56afbd" providerId="ADAL" clId="{D444FAE6-B328-4AB8-9A10-764831A715E0}" dt="2021-05-04T10:59:24.730" v="190" actId="1076"/>
          <ac:picMkLst>
            <pc:docMk/>
            <pc:sldMk cId="3970588774" sldId="263"/>
            <ac:picMk id="16" creationId="{131861EB-9D74-452E-AEAF-D90D470B62DD}"/>
          </ac:picMkLst>
        </pc:picChg>
        <pc:picChg chg="add mod">
          <ac:chgData name="Manasweeta Angane" userId="05da2731-9352-4b35-b713-60351f56afbd" providerId="ADAL" clId="{D444FAE6-B328-4AB8-9A10-764831A715E0}" dt="2021-05-04T10:59:26.761" v="191" actId="1076"/>
          <ac:picMkLst>
            <pc:docMk/>
            <pc:sldMk cId="3970588774" sldId="263"/>
            <ac:picMk id="17" creationId="{DDB04871-35A4-407A-AFAA-516142013268}"/>
          </ac:picMkLst>
        </pc:picChg>
        <pc:picChg chg="add mod">
          <ac:chgData name="Manasweeta Angane" userId="05da2731-9352-4b35-b713-60351f56afbd" providerId="ADAL" clId="{D444FAE6-B328-4AB8-9A10-764831A715E0}" dt="2021-05-04T10:59:30.044" v="192" actId="1076"/>
          <ac:picMkLst>
            <pc:docMk/>
            <pc:sldMk cId="3970588774" sldId="263"/>
            <ac:picMk id="18" creationId="{A391BE30-9105-43DC-8D5C-BFB2839A1DE6}"/>
          </ac:picMkLst>
        </pc:picChg>
        <pc:picChg chg="del">
          <ac:chgData name="Manasweeta Angane" userId="05da2731-9352-4b35-b713-60351f56afbd" providerId="ADAL" clId="{D444FAE6-B328-4AB8-9A10-764831A715E0}" dt="2021-05-04T10:22:47.073" v="79" actId="478"/>
          <ac:picMkLst>
            <pc:docMk/>
            <pc:sldMk cId="3970588774" sldId="263"/>
            <ac:picMk id="20" creationId="{81F36863-E26B-4026-9CCC-9A91B42E0CF6}"/>
          </ac:picMkLst>
        </pc:picChg>
        <pc:picChg chg="add mod">
          <ac:chgData name="Manasweeta Angane" userId="05da2731-9352-4b35-b713-60351f56afbd" providerId="ADAL" clId="{D444FAE6-B328-4AB8-9A10-764831A715E0}" dt="2021-05-04T11:00:14.261" v="194" actId="1076"/>
          <ac:picMkLst>
            <pc:docMk/>
            <pc:sldMk cId="3970588774" sldId="263"/>
            <ac:picMk id="21" creationId="{D113C418-53AB-40B1-B950-8946CF718B96}"/>
          </ac:picMkLst>
        </pc:picChg>
        <pc:picChg chg="add mod modCrop">
          <ac:chgData name="Manasweeta Angane" userId="05da2731-9352-4b35-b713-60351f56afbd" providerId="ADAL" clId="{D444FAE6-B328-4AB8-9A10-764831A715E0}" dt="2021-05-04T11:01:31.218" v="205" actId="688"/>
          <ac:picMkLst>
            <pc:docMk/>
            <pc:sldMk cId="3970588774" sldId="263"/>
            <ac:picMk id="22" creationId="{B126E304-FEC1-476D-9089-65AB98369A09}"/>
          </ac:picMkLst>
        </pc:picChg>
      </pc:sldChg>
      <pc:sldChg chg="new del">
        <pc:chgData name="Manasweeta Angane" userId="05da2731-9352-4b35-b713-60351f56afbd" providerId="ADAL" clId="{D444FAE6-B328-4AB8-9A10-764831A715E0}" dt="2021-05-04T10:18:00.309" v="72" actId="680"/>
        <pc:sldMkLst>
          <pc:docMk/>
          <pc:sldMk cId="37503968" sldId="264"/>
        </pc:sldMkLst>
      </pc:sldChg>
      <pc:sldChg chg="addSp delSp modSp add mod ord">
        <pc:chgData name="Manasweeta Angane" userId="05da2731-9352-4b35-b713-60351f56afbd" providerId="ADAL" clId="{D444FAE6-B328-4AB8-9A10-764831A715E0}" dt="2021-05-21T16:29:26.802" v="3546" actId="571"/>
        <pc:sldMkLst>
          <pc:docMk/>
          <pc:sldMk cId="1217524332" sldId="264"/>
        </pc:sldMkLst>
        <pc:spChg chg="add mod topLvl">
          <ac:chgData name="Manasweeta Angane" userId="05da2731-9352-4b35-b713-60351f56afbd" providerId="ADAL" clId="{D444FAE6-B328-4AB8-9A10-764831A715E0}" dt="2021-05-18T10:04:25.716" v="2755" actId="208"/>
          <ac:spMkLst>
            <pc:docMk/>
            <pc:sldMk cId="1217524332" sldId="264"/>
            <ac:spMk id="3" creationId="{AE116250-06D3-4487-927B-6ABD4B0174E0}"/>
          </ac:spMkLst>
        </pc:spChg>
        <pc:spChg chg="add mod">
          <ac:chgData name="Manasweeta Angane" userId="05da2731-9352-4b35-b713-60351f56afbd" providerId="ADAL" clId="{D444FAE6-B328-4AB8-9A10-764831A715E0}" dt="2021-05-17T12:02:24.535" v="1504" actId="208"/>
          <ac:spMkLst>
            <pc:docMk/>
            <pc:sldMk cId="1217524332" sldId="264"/>
            <ac:spMk id="4" creationId="{4AE5A754-CBD5-4B6D-92E4-E0E9DC5E10E3}"/>
          </ac:spMkLst>
        </pc:spChg>
        <pc:spChg chg="add mod topLvl">
          <ac:chgData name="Manasweeta Angane" userId="05da2731-9352-4b35-b713-60351f56afbd" providerId="ADAL" clId="{D444FAE6-B328-4AB8-9A10-764831A715E0}" dt="2021-05-18T10:04:26.339" v="2756" actId="207"/>
          <ac:spMkLst>
            <pc:docMk/>
            <pc:sldMk cId="1217524332" sldId="264"/>
            <ac:spMk id="8" creationId="{9578BF0C-3884-4FD5-9C26-852AC96763B9}"/>
          </ac:spMkLst>
        </pc:spChg>
        <pc:spChg chg="mod">
          <ac:chgData name="Manasweeta Angane" userId="05da2731-9352-4b35-b713-60351f56afbd" providerId="ADAL" clId="{D444FAE6-B328-4AB8-9A10-764831A715E0}" dt="2021-05-17T11:59:43.300" v="1494" actId="165"/>
          <ac:spMkLst>
            <pc:docMk/>
            <pc:sldMk cId="1217524332" sldId="264"/>
            <ac:spMk id="111" creationId="{3130C39E-4D71-4B0B-AD10-2660F8CDB2E7}"/>
          </ac:spMkLst>
        </pc:spChg>
        <pc:spChg chg="add mod">
          <ac:chgData name="Manasweeta Angane" userId="05da2731-9352-4b35-b713-60351f56afbd" providerId="ADAL" clId="{D444FAE6-B328-4AB8-9A10-764831A715E0}" dt="2021-05-17T12:02:34.614" v="1508" actId="208"/>
          <ac:spMkLst>
            <pc:docMk/>
            <pc:sldMk cId="1217524332" sldId="264"/>
            <ac:spMk id="112" creationId="{A8532107-6208-4D80-8926-B447E0FCCA7F}"/>
          </ac:spMkLst>
        </pc:spChg>
        <pc:spChg chg="add mod ord">
          <ac:chgData name="Manasweeta Angane" userId="05da2731-9352-4b35-b713-60351f56afbd" providerId="ADAL" clId="{D444FAE6-B328-4AB8-9A10-764831A715E0}" dt="2021-05-17T12:02:29.884" v="1506" actId="208"/>
          <ac:spMkLst>
            <pc:docMk/>
            <pc:sldMk cId="1217524332" sldId="264"/>
            <ac:spMk id="113" creationId="{3B01C123-C096-40D9-ACDE-6BDAF936C1F5}"/>
          </ac:spMkLst>
        </pc:spChg>
        <pc:spChg chg="add mod">
          <ac:chgData name="Manasweeta Angane" userId="05da2731-9352-4b35-b713-60351f56afbd" providerId="ADAL" clId="{D444FAE6-B328-4AB8-9A10-764831A715E0}" dt="2021-05-17T12:02:20.192" v="1503" actId="208"/>
          <ac:spMkLst>
            <pc:docMk/>
            <pc:sldMk cId="1217524332" sldId="264"/>
            <ac:spMk id="114" creationId="{EF234447-80A7-40F9-9DBD-254FE22BABF3}"/>
          </ac:spMkLst>
        </pc:spChg>
        <pc:grpChg chg="mod">
          <ac:chgData name="Manasweeta Angane" userId="05da2731-9352-4b35-b713-60351f56afbd" providerId="ADAL" clId="{D444FAE6-B328-4AB8-9A10-764831A715E0}" dt="2021-05-18T09:40:55.057" v="2535" actId="1076"/>
          <ac:grpSpMkLst>
            <pc:docMk/>
            <pc:sldMk cId="1217524332" sldId="264"/>
            <ac:grpSpMk id="6" creationId="{7C286CEC-07BB-422E-9F2B-98D42B21E58B}"/>
          </ac:grpSpMkLst>
        </pc:grpChg>
        <pc:grpChg chg="add del mod ord">
          <ac:chgData name="Manasweeta Angane" userId="05da2731-9352-4b35-b713-60351f56afbd" providerId="ADAL" clId="{D444FAE6-B328-4AB8-9A10-764831A715E0}" dt="2021-05-17T11:59:43.300" v="1494" actId="165"/>
          <ac:grpSpMkLst>
            <pc:docMk/>
            <pc:sldMk cId="1217524332" sldId="264"/>
            <ac:grpSpMk id="10" creationId="{0F2B4E76-2A51-4411-B50A-A3A836BBF9B3}"/>
          </ac:grpSpMkLst>
        </pc:grpChg>
        <pc:grpChg chg="add mod">
          <ac:chgData name="Manasweeta Angane" userId="05da2731-9352-4b35-b713-60351f56afbd" providerId="ADAL" clId="{D444FAE6-B328-4AB8-9A10-764831A715E0}" dt="2021-05-12T08:48:20.785" v="855"/>
          <ac:grpSpMkLst>
            <pc:docMk/>
            <pc:sldMk cId="1217524332" sldId="264"/>
            <ac:grpSpMk id="97" creationId="{2F84AD72-9BAF-41B2-BF46-1C06486CE0ED}"/>
          </ac:grpSpMkLst>
        </pc:grpChg>
        <pc:grpChg chg="add mod">
          <ac:chgData name="Manasweeta Angane" userId="05da2731-9352-4b35-b713-60351f56afbd" providerId="ADAL" clId="{D444FAE6-B328-4AB8-9A10-764831A715E0}" dt="2021-05-18T09:41:32.270" v="2650" actId="1076"/>
          <ac:grpSpMkLst>
            <pc:docMk/>
            <pc:sldMk cId="1217524332" sldId="264"/>
            <ac:grpSpMk id="106" creationId="{09917107-35EC-483D-B25B-A54102142EE8}"/>
          </ac:grpSpMkLst>
        </pc:grpChg>
        <pc:grpChg chg="add mod topLvl">
          <ac:chgData name="Manasweeta Angane" userId="05da2731-9352-4b35-b713-60351f56afbd" providerId="ADAL" clId="{D444FAE6-B328-4AB8-9A10-764831A715E0}" dt="2021-05-17T11:59:43.300" v="1494" actId="165"/>
          <ac:grpSpMkLst>
            <pc:docMk/>
            <pc:sldMk cId="1217524332" sldId="264"/>
            <ac:grpSpMk id="109" creationId="{67E5F1E1-32EE-4A88-9488-CFC3EF076927}"/>
          </ac:grpSpMkLst>
        </pc:grpChg>
        <pc:picChg chg="mod">
          <ac:chgData name="Manasweeta Angane" userId="05da2731-9352-4b35-b713-60351f56afbd" providerId="ADAL" clId="{D444FAE6-B328-4AB8-9A10-764831A715E0}" dt="2021-05-12T08:58:33.277" v="1017" actId="1076"/>
          <ac:picMkLst>
            <pc:docMk/>
            <pc:sldMk cId="1217524332" sldId="264"/>
            <ac:picMk id="27" creationId="{AD90960C-5D7B-42B1-BCEA-05C5E386F7E8}"/>
          </ac:picMkLst>
        </pc:picChg>
        <pc:picChg chg="mod">
          <ac:chgData name="Manasweeta Angane" userId="05da2731-9352-4b35-b713-60351f56afbd" providerId="ADAL" clId="{D444FAE6-B328-4AB8-9A10-764831A715E0}" dt="2021-05-17T11:59:18.607" v="1493" actId="1076"/>
          <ac:picMkLst>
            <pc:docMk/>
            <pc:sldMk cId="1217524332" sldId="264"/>
            <ac:picMk id="34" creationId="{11CC7DF1-B1F0-4AE6-93EC-0529CD492466}"/>
          </ac:picMkLst>
        </pc:picChg>
        <pc:picChg chg="mod">
          <ac:chgData name="Manasweeta Angane" userId="05da2731-9352-4b35-b713-60351f56afbd" providerId="ADAL" clId="{D444FAE6-B328-4AB8-9A10-764831A715E0}" dt="2021-05-18T09:40:55.057" v="2535" actId="1076"/>
          <ac:picMkLst>
            <pc:docMk/>
            <pc:sldMk cId="1217524332" sldId="264"/>
            <ac:picMk id="38" creationId="{2BFF88E3-46CC-42FF-B795-6F79E5DE7560}"/>
          </ac:picMkLst>
        </pc:picChg>
        <pc:picChg chg="mod">
          <ac:chgData name="Manasweeta Angane" userId="05da2731-9352-4b35-b713-60351f56afbd" providerId="ADAL" clId="{D444FAE6-B328-4AB8-9A10-764831A715E0}" dt="2021-05-18T09:40:55.057" v="2535" actId="1076"/>
          <ac:picMkLst>
            <pc:docMk/>
            <pc:sldMk cId="1217524332" sldId="264"/>
            <ac:picMk id="39" creationId="{242F7324-EDB9-4D37-8751-21991421DF37}"/>
          </ac:picMkLst>
        </pc:picChg>
        <pc:picChg chg="mod">
          <ac:chgData name="Manasweeta Angane" userId="05da2731-9352-4b35-b713-60351f56afbd" providerId="ADAL" clId="{D444FAE6-B328-4AB8-9A10-764831A715E0}" dt="2021-05-15T01:31:43.762" v="1466" actId="1076"/>
          <ac:picMkLst>
            <pc:docMk/>
            <pc:sldMk cId="1217524332" sldId="264"/>
            <ac:picMk id="40" creationId="{D8B5B8F6-095A-4C97-9813-4C593D708C71}"/>
          </ac:picMkLst>
        </pc:picChg>
        <pc:picChg chg="mod">
          <ac:chgData name="Manasweeta Angane" userId="05da2731-9352-4b35-b713-60351f56afbd" providerId="ADAL" clId="{D444FAE6-B328-4AB8-9A10-764831A715E0}" dt="2021-05-18T09:40:14.928" v="2495" actId="1076"/>
          <ac:picMkLst>
            <pc:docMk/>
            <pc:sldMk cId="1217524332" sldId="264"/>
            <ac:picMk id="76" creationId="{B46F448E-5E4E-4884-9AAB-6C9B90993F0E}"/>
          </ac:picMkLst>
        </pc:picChg>
        <pc:picChg chg="add mod">
          <ac:chgData name="Manasweeta Angane" userId="05da2731-9352-4b35-b713-60351f56afbd" providerId="ADAL" clId="{D444FAE6-B328-4AB8-9A10-764831A715E0}" dt="2021-05-15T01:31:02.543" v="1360" actId="1076"/>
          <ac:picMkLst>
            <pc:docMk/>
            <pc:sldMk cId="1217524332" sldId="264"/>
            <ac:picMk id="105" creationId="{089D3380-4C78-4B6B-BB2C-3ECC905346CC}"/>
          </ac:picMkLst>
        </pc:picChg>
        <pc:picChg chg="add mod">
          <ac:chgData name="Manasweeta Angane" userId="05da2731-9352-4b35-b713-60351f56afbd" providerId="ADAL" clId="{D444FAE6-B328-4AB8-9A10-764831A715E0}" dt="2021-05-12T08:48:20.785" v="855"/>
          <ac:picMkLst>
            <pc:docMk/>
            <pc:sldMk cId="1217524332" sldId="264"/>
            <ac:picMk id="105" creationId="{DCDD893A-A216-4D98-AEC9-7705132EAC57}"/>
          </ac:picMkLst>
        </pc:picChg>
        <pc:picChg chg="add mod">
          <ac:chgData name="Manasweeta Angane" userId="05da2731-9352-4b35-b713-60351f56afbd" providerId="ADAL" clId="{D444FAE6-B328-4AB8-9A10-764831A715E0}" dt="2021-05-12T08:48:20.785" v="855"/>
          <ac:picMkLst>
            <pc:docMk/>
            <pc:sldMk cId="1217524332" sldId="264"/>
            <ac:picMk id="106" creationId="{6D7250C2-0218-49F5-A51E-3AC98D7D08C1}"/>
          </ac:picMkLst>
        </pc:picChg>
        <pc:picChg chg="add mod topLvl">
          <ac:chgData name="Manasweeta Angane" userId="05da2731-9352-4b35-b713-60351f56afbd" providerId="ADAL" clId="{D444FAE6-B328-4AB8-9A10-764831A715E0}" dt="2021-05-17T11:59:43.300" v="1494" actId="165"/>
          <ac:picMkLst>
            <pc:docMk/>
            <pc:sldMk cId="1217524332" sldId="264"/>
            <ac:picMk id="107" creationId="{5C0B13FE-23D3-4408-B63D-2E63CEF1FC6D}"/>
          </ac:picMkLst>
        </pc:picChg>
        <pc:picChg chg="add mod topLvl">
          <ac:chgData name="Manasweeta Angane" userId="05da2731-9352-4b35-b713-60351f56afbd" providerId="ADAL" clId="{D444FAE6-B328-4AB8-9A10-764831A715E0}" dt="2021-05-17T11:59:43.300" v="1494" actId="165"/>
          <ac:picMkLst>
            <pc:docMk/>
            <pc:sldMk cId="1217524332" sldId="264"/>
            <ac:picMk id="108" creationId="{7F6EFE52-17E3-49DF-B205-17E2CACD5EA8}"/>
          </ac:picMkLst>
        </pc:picChg>
        <pc:picChg chg="mod">
          <ac:chgData name="Manasweeta Angane" userId="05da2731-9352-4b35-b713-60351f56afbd" providerId="ADAL" clId="{D444FAE6-B328-4AB8-9A10-764831A715E0}" dt="2021-05-17T11:59:43.300" v="1494" actId="165"/>
          <ac:picMkLst>
            <pc:docMk/>
            <pc:sldMk cId="1217524332" sldId="264"/>
            <ac:picMk id="110" creationId="{8A7FEBF2-7B4F-43AC-AED8-2AE6ABEAB31F}"/>
          </ac:picMkLst>
        </pc:picChg>
        <pc:picChg chg="mod">
          <ac:chgData name="Manasweeta Angane" userId="05da2731-9352-4b35-b713-60351f56afbd" providerId="ADAL" clId="{D444FAE6-B328-4AB8-9A10-764831A715E0}" dt="2021-05-18T09:41:32.270" v="2650" actId="1076"/>
          <ac:picMkLst>
            <pc:docMk/>
            <pc:sldMk cId="1217524332" sldId="264"/>
            <ac:picMk id="115" creationId="{8BC75DED-DAFD-4844-A830-D85ADB7AFF18}"/>
          </ac:picMkLst>
        </pc:picChg>
        <pc:picChg chg="mod">
          <ac:chgData name="Manasweeta Angane" userId="05da2731-9352-4b35-b713-60351f56afbd" providerId="ADAL" clId="{D444FAE6-B328-4AB8-9A10-764831A715E0}" dt="2021-05-18T09:41:32.270" v="2650" actId="1076"/>
          <ac:picMkLst>
            <pc:docMk/>
            <pc:sldMk cId="1217524332" sldId="264"/>
            <ac:picMk id="116" creationId="{C1E996DE-A453-4257-89F7-86A03BC3BEA2}"/>
          </ac:picMkLst>
        </pc:picChg>
        <pc:picChg chg="add mod">
          <ac:chgData name="Manasweeta Angane" userId="05da2731-9352-4b35-b713-60351f56afbd" providerId="ADAL" clId="{D444FAE6-B328-4AB8-9A10-764831A715E0}" dt="2021-05-21T16:29:09.376" v="3538" actId="571"/>
          <ac:picMkLst>
            <pc:docMk/>
            <pc:sldMk cId="1217524332" sldId="264"/>
            <ac:picMk id="117" creationId="{90AF9CDE-3E3E-47E7-89F2-58D22C92C0F0}"/>
          </ac:picMkLst>
        </pc:picChg>
        <pc:picChg chg="add mod">
          <ac:chgData name="Manasweeta Angane" userId="05da2731-9352-4b35-b713-60351f56afbd" providerId="ADAL" clId="{D444FAE6-B328-4AB8-9A10-764831A715E0}" dt="2021-05-21T16:29:20.252" v="3544" actId="571"/>
          <ac:picMkLst>
            <pc:docMk/>
            <pc:sldMk cId="1217524332" sldId="264"/>
            <ac:picMk id="118" creationId="{E6E842F2-3AE2-4417-BE93-79FF5F12C512}"/>
          </ac:picMkLst>
        </pc:picChg>
        <pc:picChg chg="add mod">
          <ac:chgData name="Manasweeta Angane" userId="05da2731-9352-4b35-b713-60351f56afbd" providerId="ADAL" clId="{D444FAE6-B328-4AB8-9A10-764831A715E0}" dt="2021-05-21T16:29:26.802" v="3546" actId="571"/>
          <ac:picMkLst>
            <pc:docMk/>
            <pc:sldMk cId="1217524332" sldId="264"/>
            <ac:picMk id="119" creationId="{2BAD282A-D046-4D0C-9CE2-2C4A76350363}"/>
          </ac:picMkLst>
        </pc:picChg>
        <pc:picChg chg="mod">
          <ac:chgData name="Manasweeta Angane" userId="05da2731-9352-4b35-b713-60351f56afbd" providerId="ADAL" clId="{D444FAE6-B328-4AB8-9A10-764831A715E0}" dt="2021-05-18T09:40:36.335" v="2533" actId="1076"/>
          <ac:picMkLst>
            <pc:docMk/>
            <pc:sldMk cId="1217524332" sldId="264"/>
            <ac:picMk id="1026" creationId="{137C4FFD-2974-4454-B897-C812188AA1E5}"/>
          </ac:picMkLst>
        </pc:picChg>
      </pc:sldChg>
      <pc:sldChg chg="addSp delSp modSp new mod ord">
        <pc:chgData name="Manasweeta Angane" userId="05da2731-9352-4b35-b713-60351f56afbd" providerId="ADAL" clId="{D444FAE6-B328-4AB8-9A10-764831A715E0}" dt="2021-05-17T12:59:48.068" v="1862" actId="478"/>
        <pc:sldMkLst>
          <pc:docMk/>
          <pc:sldMk cId="1649803051" sldId="265"/>
        </pc:sldMkLst>
        <pc:spChg chg="del">
          <ac:chgData name="Manasweeta Angane" userId="05da2731-9352-4b35-b713-60351f56afbd" providerId="ADAL" clId="{D444FAE6-B328-4AB8-9A10-764831A715E0}" dt="2021-05-15T01:22:52.408" v="1157" actId="478"/>
          <ac:spMkLst>
            <pc:docMk/>
            <pc:sldMk cId="1649803051" sldId="265"/>
            <ac:spMk id="2" creationId="{59C9C63E-CD64-4FF3-986C-08297E945510}"/>
          </ac:spMkLst>
        </pc:spChg>
        <pc:spChg chg="del">
          <ac:chgData name="Manasweeta Angane" userId="05da2731-9352-4b35-b713-60351f56afbd" providerId="ADAL" clId="{D444FAE6-B328-4AB8-9A10-764831A715E0}" dt="2021-05-15T01:22:54.058" v="1158" actId="478"/>
          <ac:spMkLst>
            <pc:docMk/>
            <pc:sldMk cId="1649803051" sldId="265"/>
            <ac:spMk id="3" creationId="{00F8E095-41BA-47BA-9FC9-740EFA10E54D}"/>
          </ac:spMkLst>
        </pc:spChg>
        <pc:spChg chg="add del mod">
          <ac:chgData name="Manasweeta Angane" userId="05da2731-9352-4b35-b713-60351f56afbd" providerId="ADAL" clId="{D444FAE6-B328-4AB8-9A10-764831A715E0}" dt="2021-05-15T01:23:04.398" v="1160"/>
          <ac:spMkLst>
            <pc:docMk/>
            <pc:sldMk cId="1649803051" sldId="265"/>
            <ac:spMk id="4" creationId="{B6EEEFF7-23F6-4A8F-A71C-B68084A544E1}"/>
          </ac:spMkLst>
        </pc:spChg>
        <pc:spChg chg="mod">
          <ac:chgData name="Manasweeta Angane" userId="05da2731-9352-4b35-b713-60351f56afbd" providerId="ADAL" clId="{D444FAE6-B328-4AB8-9A10-764831A715E0}" dt="2021-05-15T01:23:50.307" v="1161"/>
          <ac:spMkLst>
            <pc:docMk/>
            <pc:sldMk cId="1649803051" sldId="265"/>
            <ac:spMk id="6" creationId="{7B4C0530-CB67-482F-A89B-5A124BBE7CB1}"/>
          </ac:spMkLst>
        </pc:spChg>
        <pc:spChg chg="mod">
          <ac:chgData name="Manasweeta Angane" userId="05da2731-9352-4b35-b713-60351f56afbd" providerId="ADAL" clId="{D444FAE6-B328-4AB8-9A10-764831A715E0}" dt="2021-05-15T01:23:50.307" v="1161"/>
          <ac:spMkLst>
            <pc:docMk/>
            <pc:sldMk cId="1649803051" sldId="265"/>
            <ac:spMk id="7" creationId="{53337AD2-20F1-49EE-BA19-52AE8816A48B}"/>
          </ac:spMkLst>
        </pc:spChg>
        <pc:spChg chg="mod">
          <ac:chgData name="Manasweeta Angane" userId="05da2731-9352-4b35-b713-60351f56afbd" providerId="ADAL" clId="{D444FAE6-B328-4AB8-9A10-764831A715E0}" dt="2021-05-15T01:23:50.307" v="1161"/>
          <ac:spMkLst>
            <pc:docMk/>
            <pc:sldMk cId="1649803051" sldId="265"/>
            <ac:spMk id="8" creationId="{E1A50D98-FD0D-4F96-813F-0C43E0962C26}"/>
          </ac:spMkLst>
        </pc:spChg>
        <pc:spChg chg="mod">
          <ac:chgData name="Manasweeta Angane" userId="05da2731-9352-4b35-b713-60351f56afbd" providerId="ADAL" clId="{D444FAE6-B328-4AB8-9A10-764831A715E0}" dt="2021-05-15T01:23:50.307" v="1161"/>
          <ac:spMkLst>
            <pc:docMk/>
            <pc:sldMk cId="1649803051" sldId="265"/>
            <ac:spMk id="9" creationId="{B033A35B-0B83-41A8-8083-C81F06719DD7}"/>
          </ac:spMkLst>
        </pc:spChg>
        <pc:spChg chg="add del mod">
          <ac:chgData name="Manasweeta Angane" userId="05da2731-9352-4b35-b713-60351f56afbd" providerId="ADAL" clId="{D444FAE6-B328-4AB8-9A10-764831A715E0}" dt="2021-05-15T01:23:58.733" v="1162"/>
          <ac:spMkLst>
            <pc:docMk/>
            <pc:sldMk cId="1649803051" sldId="265"/>
            <ac:spMk id="10" creationId="{8A2B3634-A46F-4EDF-A053-30152AC10E1D}"/>
          </ac:spMkLst>
        </pc:spChg>
        <pc:spChg chg="mod">
          <ac:chgData name="Manasweeta Angane" userId="05da2731-9352-4b35-b713-60351f56afbd" providerId="ADAL" clId="{D444FAE6-B328-4AB8-9A10-764831A715E0}" dt="2021-05-15T01:23:50.307" v="1161"/>
          <ac:spMkLst>
            <pc:docMk/>
            <pc:sldMk cId="1649803051" sldId="265"/>
            <ac:spMk id="19" creationId="{5C67922C-C91D-4CEA-8C55-E3045CDB8AA0}"/>
          </ac:spMkLst>
        </pc:spChg>
        <pc:spChg chg="mod">
          <ac:chgData name="Manasweeta Angane" userId="05da2731-9352-4b35-b713-60351f56afbd" providerId="ADAL" clId="{D444FAE6-B328-4AB8-9A10-764831A715E0}" dt="2021-05-15T01:23:50.307" v="1161"/>
          <ac:spMkLst>
            <pc:docMk/>
            <pc:sldMk cId="1649803051" sldId="265"/>
            <ac:spMk id="20" creationId="{CFAE1118-91EC-4290-B2BE-03BE51963AC4}"/>
          </ac:spMkLst>
        </pc:spChg>
        <pc:spChg chg="add del mod">
          <ac:chgData name="Manasweeta Angane" userId="05da2731-9352-4b35-b713-60351f56afbd" providerId="ADAL" clId="{D444FAE6-B328-4AB8-9A10-764831A715E0}" dt="2021-05-15T01:33:16.451" v="1473"/>
          <ac:spMkLst>
            <pc:docMk/>
            <pc:sldMk cId="1649803051" sldId="265"/>
            <ac:spMk id="21" creationId="{72728F57-D08E-4A22-8F96-88228ABDDA7E}"/>
          </ac:spMkLst>
        </pc:spChg>
        <pc:spChg chg="add mod">
          <ac:chgData name="Manasweeta Angane" userId="05da2731-9352-4b35-b713-60351f56afbd" providerId="ADAL" clId="{D444FAE6-B328-4AB8-9A10-764831A715E0}" dt="2021-05-15T01:33:24.100" v="1474"/>
          <ac:spMkLst>
            <pc:docMk/>
            <pc:sldMk cId="1649803051" sldId="265"/>
            <ac:spMk id="22" creationId="{1110318C-ABBE-4DAE-83FA-8D9EE9CDD91A}"/>
          </ac:spMkLst>
        </pc:spChg>
        <pc:spChg chg="mod topLvl">
          <ac:chgData name="Manasweeta Angane" userId="05da2731-9352-4b35-b713-60351f56afbd" providerId="ADAL" clId="{D444FAE6-B328-4AB8-9A10-764831A715E0}" dt="2021-05-17T12:52:57.187" v="1532" actId="14100"/>
          <ac:spMkLst>
            <pc:docMk/>
            <pc:sldMk cId="1649803051" sldId="265"/>
            <ac:spMk id="24" creationId="{7945605E-2AF0-49E6-A55E-B091C1DDC208}"/>
          </ac:spMkLst>
        </pc:spChg>
        <pc:spChg chg="mod topLvl">
          <ac:chgData name="Manasweeta Angane" userId="05da2731-9352-4b35-b713-60351f56afbd" providerId="ADAL" clId="{D444FAE6-B328-4AB8-9A10-764831A715E0}" dt="2021-05-17T12:52:57.187" v="1532" actId="14100"/>
          <ac:spMkLst>
            <pc:docMk/>
            <pc:sldMk cId="1649803051" sldId="265"/>
            <ac:spMk id="25" creationId="{CCBB74BB-DBF1-4497-B990-5AF30434EAF6}"/>
          </ac:spMkLst>
        </pc:spChg>
        <pc:grpChg chg="add del mod">
          <ac:chgData name="Manasweeta Angane" userId="05da2731-9352-4b35-b713-60351f56afbd" providerId="ADAL" clId="{D444FAE6-B328-4AB8-9A10-764831A715E0}" dt="2021-05-15T01:23:58.733" v="1162"/>
          <ac:grpSpMkLst>
            <pc:docMk/>
            <pc:sldMk cId="1649803051" sldId="265"/>
            <ac:grpSpMk id="5" creationId="{ADE7CE52-B97B-4C6E-8AE5-241594CDDFDA}"/>
          </ac:grpSpMkLst>
        </pc:grpChg>
        <pc:grpChg chg="add del mod">
          <ac:chgData name="Manasweeta Angane" userId="05da2731-9352-4b35-b713-60351f56afbd" providerId="ADAL" clId="{D444FAE6-B328-4AB8-9A10-764831A715E0}" dt="2021-05-15T01:23:58.733" v="1162"/>
          <ac:grpSpMkLst>
            <pc:docMk/>
            <pc:sldMk cId="1649803051" sldId="265"/>
            <ac:grpSpMk id="14" creationId="{DFDBC712-3F71-43F3-B451-9977275DC0D8}"/>
          </ac:grpSpMkLst>
        </pc:grpChg>
        <pc:grpChg chg="add del mod">
          <ac:chgData name="Manasweeta Angane" userId="05da2731-9352-4b35-b713-60351f56afbd" providerId="ADAL" clId="{D444FAE6-B328-4AB8-9A10-764831A715E0}" dt="2021-05-15T01:23:58.733" v="1162"/>
          <ac:grpSpMkLst>
            <pc:docMk/>
            <pc:sldMk cId="1649803051" sldId="265"/>
            <ac:grpSpMk id="18" creationId="{1B53F914-F1B1-4AA2-A306-BA5A22E3ABFB}"/>
          </ac:grpSpMkLst>
        </pc:grpChg>
        <pc:grpChg chg="add del mod">
          <ac:chgData name="Manasweeta Angane" userId="05da2731-9352-4b35-b713-60351f56afbd" providerId="ADAL" clId="{D444FAE6-B328-4AB8-9A10-764831A715E0}" dt="2021-05-17T12:52:57.187" v="1532" actId="14100"/>
          <ac:grpSpMkLst>
            <pc:docMk/>
            <pc:sldMk cId="1649803051" sldId="265"/>
            <ac:grpSpMk id="23" creationId="{0CE4A5CD-5ACE-4712-8ECB-18ADFFC504F3}"/>
          </ac:grpSpMkLst>
        </pc:grpChg>
        <pc:picChg chg="add del mod">
          <ac:chgData name="Manasweeta Angane" userId="05da2731-9352-4b35-b713-60351f56afbd" providerId="ADAL" clId="{D444FAE6-B328-4AB8-9A10-764831A715E0}" dt="2021-05-15T01:23:58.733" v="1162"/>
          <ac:picMkLst>
            <pc:docMk/>
            <pc:sldMk cId="1649803051" sldId="265"/>
            <ac:picMk id="11" creationId="{ED6EAF8F-BB05-42DF-B681-F15423E1654B}"/>
          </ac:picMkLst>
        </pc:picChg>
        <pc:picChg chg="add del mod">
          <ac:chgData name="Manasweeta Angane" userId="05da2731-9352-4b35-b713-60351f56afbd" providerId="ADAL" clId="{D444FAE6-B328-4AB8-9A10-764831A715E0}" dt="2021-05-15T01:23:58.733" v="1162"/>
          <ac:picMkLst>
            <pc:docMk/>
            <pc:sldMk cId="1649803051" sldId="265"/>
            <ac:picMk id="12" creationId="{BCAD0713-C274-469E-9E99-CCCEA98155F8}"/>
          </ac:picMkLst>
        </pc:picChg>
        <pc:picChg chg="add del mod">
          <ac:chgData name="Manasweeta Angane" userId="05da2731-9352-4b35-b713-60351f56afbd" providerId="ADAL" clId="{D444FAE6-B328-4AB8-9A10-764831A715E0}" dt="2021-05-15T01:23:58.733" v="1162"/>
          <ac:picMkLst>
            <pc:docMk/>
            <pc:sldMk cId="1649803051" sldId="265"/>
            <ac:picMk id="13" creationId="{E5298E63-C898-445F-82B7-A6A0DEE0108A}"/>
          </ac:picMkLst>
        </pc:picChg>
        <pc:picChg chg="mod">
          <ac:chgData name="Manasweeta Angane" userId="05da2731-9352-4b35-b713-60351f56afbd" providerId="ADAL" clId="{D444FAE6-B328-4AB8-9A10-764831A715E0}" dt="2021-05-15T01:23:50.307" v="1161"/>
          <ac:picMkLst>
            <pc:docMk/>
            <pc:sldMk cId="1649803051" sldId="265"/>
            <ac:picMk id="15" creationId="{397027FF-2C0B-42A2-B243-FFAD11CEFE2C}"/>
          </ac:picMkLst>
        </pc:picChg>
        <pc:picChg chg="mod">
          <ac:chgData name="Manasweeta Angane" userId="05da2731-9352-4b35-b713-60351f56afbd" providerId="ADAL" clId="{D444FAE6-B328-4AB8-9A10-764831A715E0}" dt="2021-05-15T01:23:50.307" v="1161"/>
          <ac:picMkLst>
            <pc:docMk/>
            <pc:sldMk cId="1649803051" sldId="265"/>
            <ac:picMk id="16" creationId="{C6E1670C-A3B4-44D0-9B62-BC7B87A0A752}"/>
          </ac:picMkLst>
        </pc:picChg>
        <pc:picChg chg="mod">
          <ac:chgData name="Manasweeta Angane" userId="05da2731-9352-4b35-b713-60351f56afbd" providerId="ADAL" clId="{D444FAE6-B328-4AB8-9A10-764831A715E0}" dt="2021-05-15T01:23:50.307" v="1161"/>
          <ac:picMkLst>
            <pc:docMk/>
            <pc:sldMk cId="1649803051" sldId="265"/>
            <ac:picMk id="17" creationId="{4F680D82-37CE-482E-84DF-5B4F7FD231E2}"/>
          </ac:picMkLst>
        </pc:picChg>
        <pc:picChg chg="add del mod">
          <ac:chgData name="Manasweeta Angane" userId="05da2731-9352-4b35-b713-60351f56afbd" providerId="ADAL" clId="{D444FAE6-B328-4AB8-9A10-764831A715E0}" dt="2021-05-17T12:59:48.068" v="1862" actId="478"/>
          <ac:picMkLst>
            <pc:docMk/>
            <pc:sldMk cId="1649803051" sldId="265"/>
            <ac:picMk id="1026" creationId="{94558A46-42BE-4664-B146-5890381068E8}"/>
          </ac:picMkLst>
        </pc:picChg>
      </pc:sldChg>
      <pc:sldChg chg="new del">
        <pc:chgData name="Manasweeta Angane" userId="05da2731-9352-4b35-b713-60351f56afbd" providerId="ADAL" clId="{D444FAE6-B328-4AB8-9A10-764831A715E0}" dt="2021-05-04T10:18:00.012" v="71" actId="680"/>
        <pc:sldMkLst>
          <pc:docMk/>
          <pc:sldMk cId="2786079615" sldId="265"/>
        </pc:sldMkLst>
      </pc:sldChg>
      <pc:sldChg chg="new del">
        <pc:chgData name="Manasweeta Angane" userId="05da2731-9352-4b35-b713-60351f56afbd" providerId="ADAL" clId="{D444FAE6-B328-4AB8-9A10-764831A715E0}" dt="2021-05-17T11:56:31.406" v="1478" actId="680"/>
        <pc:sldMkLst>
          <pc:docMk/>
          <pc:sldMk cId="304000908" sldId="266"/>
        </pc:sldMkLst>
      </pc:sldChg>
      <pc:sldChg chg="modSp add mod">
        <pc:chgData name="Manasweeta Angane" userId="05da2731-9352-4b35-b713-60351f56afbd" providerId="ADAL" clId="{D444FAE6-B328-4AB8-9A10-764831A715E0}" dt="2021-05-17T12:04:18.217" v="1517" actId="207"/>
        <pc:sldMkLst>
          <pc:docMk/>
          <pc:sldMk cId="937044226" sldId="266"/>
        </pc:sldMkLst>
        <pc:spChg chg="mod">
          <ac:chgData name="Manasweeta Angane" userId="05da2731-9352-4b35-b713-60351f56afbd" providerId="ADAL" clId="{D444FAE6-B328-4AB8-9A10-764831A715E0}" dt="2021-05-17T12:03:46.134" v="1510" actId="208"/>
          <ac:spMkLst>
            <pc:docMk/>
            <pc:sldMk cId="937044226" sldId="266"/>
            <ac:spMk id="3" creationId="{AE116250-06D3-4487-927B-6ABD4B0174E0}"/>
          </ac:spMkLst>
        </pc:spChg>
        <pc:spChg chg="mod">
          <ac:chgData name="Manasweeta Angane" userId="05da2731-9352-4b35-b713-60351f56afbd" providerId="ADAL" clId="{D444FAE6-B328-4AB8-9A10-764831A715E0}" dt="2021-05-17T12:03:50.961" v="1511" actId="208"/>
          <ac:spMkLst>
            <pc:docMk/>
            <pc:sldMk cId="937044226" sldId="266"/>
            <ac:spMk id="4" creationId="{4AE5A754-CBD5-4B6D-92E4-E0E9DC5E10E3}"/>
          </ac:spMkLst>
        </pc:spChg>
        <pc:spChg chg="mod">
          <ac:chgData name="Manasweeta Angane" userId="05da2731-9352-4b35-b713-60351f56afbd" providerId="ADAL" clId="{D444FAE6-B328-4AB8-9A10-764831A715E0}" dt="2021-05-17T12:04:18.217" v="1517" actId="207"/>
          <ac:spMkLst>
            <pc:docMk/>
            <pc:sldMk cId="937044226" sldId="266"/>
            <ac:spMk id="8" creationId="{9578BF0C-3884-4FD5-9C26-852AC96763B9}"/>
          </ac:spMkLst>
        </pc:spChg>
        <pc:spChg chg="mod">
          <ac:chgData name="Manasweeta Angane" userId="05da2731-9352-4b35-b713-60351f56afbd" providerId="ADAL" clId="{D444FAE6-B328-4AB8-9A10-764831A715E0}" dt="2021-05-17T12:03:59.677" v="1514" actId="208"/>
          <ac:spMkLst>
            <pc:docMk/>
            <pc:sldMk cId="937044226" sldId="266"/>
            <ac:spMk id="112" creationId="{A8532107-6208-4D80-8926-B447E0FCCA7F}"/>
          </ac:spMkLst>
        </pc:spChg>
        <pc:spChg chg="mod">
          <ac:chgData name="Manasweeta Angane" userId="05da2731-9352-4b35-b713-60351f56afbd" providerId="ADAL" clId="{D444FAE6-B328-4AB8-9A10-764831A715E0}" dt="2021-05-17T12:04:03.942" v="1516" actId="208"/>
          <ac:spMkLst>
            <pc:docMk/>
            <pc:sldMk cId="937044226" sldId="266"/>
            <ac:spMk id="113" creationId="{3B01C123-C096-40D9-ACDE-6BDAF936C1F5}"/>
          </ac:spMkLst>
        </pc:spChg>
        <pc:spChg chg="mod">
          <ac:chgData name="Manasweeta Angane" userId="05da2731-9352-4b35-b713-60351f56afbd" providerId="ADAL" clId="{D444FAE6-B328-4AB8-9A10-764831A715E0}" dt="2021-05-17T12:03:55.140" v="1513" actId="208"/>
          <ac:spMkLst>
            <pc:docMk/>
            <pc:sldMk cId="937044226" sldId="266"/>
            <ac:spMk id="114" creationId="{EF234447-80A7-40F9-9DBD-254FE22BABF3}"/>
          </ac:spMkLst>
        </pc:spChg>
      </pc:sldChg>
      <pc:sldChg chg="new del">
        <pc:chgData name="Manasweeta Angane" userId="05da2731-9352-4b35-b713-60351f56afbd" providerId="ADAL" clId="{D444FAE6-B328-4AB8-9A10-764831A715E0}" dt="2021-05-04T10:17:59.590" v="70" actId="680"/>
        <pc:sldMkLst>
          <pc:docMk/>
          <pc:sldMk cId="1822752059" sldId="266"/>
        </pc:sldMkLst>
      </pc:sldChg>
      <pc:sldChg chg="new del">
        <pc:chgData name="Manasweeta Angane" userId="05da2731-9352-4b35-b713-60351f56afbd" providerId="ADAL" clId="{D444FAE6-B328-4AB8-9A10-764831A715E0}" dt="2021-05-04T10:17:59.215" v="69" actId="680"/>
        <pc:sldMkLst>
          <pc:docMk/>
          <pc:sldMk cId="3000908610" sldId="267"/>
        </pc:sldMkLst>
      </pc:sldChg>
      <pc:sldChg chg="addSp delSp modSp new mod modAnim">
        <pc:chgData name="Manasweeta Angane" userId="05da2731-9352-4b35-b713-60351f56afbd" providerId="ADAL" clId="{D444FAE6-B328-4AB8-9A10-764831A715E0}" dt="2021-05-21T11:24:35.606" v="2821" actId="1037"/>
        <pc:sldMkLst>
          <pc:docMk/>
          <pc:sldMk cId="4248096269" sldId="267"/>
        </pc:sldMkLst>
        <pc:spChg chg="add mod">
          <ac:chgData name="Manasweeta Angane" userId="05da2731-9352-4b35-b713-60351f56afbd" providerId="ADAL" clId="{D444FAE6-B328-4AB8-9A10-764831A715E0}" dt="2021-05-17T12:58:08.508" v="1856" actId="14100"/>
          <ac:spMkLst>
            <pc:docMk/>
            <pc:sldMk cId="4248096269" sldId="267"/>
            <ac:spMk id="3" creationId="{41CF30B8-7D64-4E7B-B060-FE9DFF07A47A}"/>
          </ac:spMkLst>
        </pc:spChg>
        <pc:spChg chg="mod">
          <ac:chgData name="Manasweeta Angane" userId="05da2731-9352-4b35-b713-60351f56afbd" providerId="ADAL" clId="{D444FAE6-B328-4AB8-9A10-764831A715E0}" dt="2021-05-17T12:59:17.802" v="1860" actId="207"/>
          <ac:spMkLst>
            <pc:docMk/>
            <pc:sldMk cId="4248096269" sldId="267"/>
            <ac:spMk id="5" creationId="{5609BEFA-42B1-41BF-8CAE-7A32A4471A8B}"/>
          </ac:spMkLst>
        </pc:spChg>
        <pc:spChg chg="mod">
          <ac:chgData name="Manasweeta Angane" userId="05da2731-9352-4b35-b713-60351f56afbd" providerId="ADAL" clId="{D444FAE6-B328-4AB8-9A10-764831A715E0}" dt="2021-05-17T12:59:03.395" v="1858" actId="207"/>
          <ac:spMkLst>
            <pc:docMk/>
            <pc:sldMk cId="4248096269" sldId="267"/>
            <ac:spMk id="6" creationId="{3D3B9BF0-57AF-486F-8223-5F6829491B48}"/>
          </ac:spMkLst>
        </pc:spChg>
        <pc:spChg chg="mod">
          <ac:chgData name="Manasweeta Angane" userId="05da2731-9352-4b35-b713-60351f56afbd" providerId="ADAL" clId="{D444FAE6-B328-4AB8-9A10-764831A715E0}" dt="2021-05-17T12:59:24.511" v="1861" actId="207"/>
          <ac:spMkLst>
            <pc:docMk/>
            <pc:sldMk cId="4248096269" sldId="267"/>
            <ac:spMk id="7" creationId="{3A7FA338-5A13-4A76-AB06-1C6AFCEE49F0}"/>
          </ac:spMkLst>
        </pc:spChg>
        <pc:spChg chg="mod">
          <ac:chgData name="Manasweeta Angane" userId="05da2731-9352-4b35-b713-60351f56afbd" providerId="ADAL" clId="{D444FAE6-B328-4AB8-9A10-764831A715E0}" dt="2021-05-17T12:59:11.442" v="1859" actId="207"/>
          <ac:spMkLst>
            <pc:docMk/>
            <pc:sldMk cId="4248096269" sldId="267"/>
            <ac:spMk id="8" creationId="{177F496A-A21B-487E-99BB-4399736E8A77}"/>
          </ac:spMkLst>
        </pc:spChg>
        <pc:spChg chg="mod topLvl">
          <ac:chgData name="Manasweeta Angane" userId="05da2731-9352-4b35-b713-60351f56afbd" providerId="ADAL" clId="{D444FAE6-B328-4AB8-9A10-764831A715E0}" dt="2021-05-18T10:23:55.606" v="2757" actId="20577"/>
          <ac:spMkLst>
            <pc:docMk/>
            <pc:sldMk cId="4248096269" sldId="267"/>
            <ac:spMk id="10" creationId="{F754395B-DA89-41A0-AD45-85B4C0268995}"/>
          </ac:spMkLst>
        </pc:spChg>
        <pc:spChg chg="mod topLvl">
          <ac:chgData name="Manasweeta Angane" userId="05da2731-9352-4b35-b713-60351f56afbd" providerId="ADAL" clId="{D444FAE6-B328-4AB8-9A10-764831A715E0}" dt="2021-05-18T09:39:18.404" v="2487" actId="1038"/>
          <ac:spMkLst>
            <pc:docMk/>
            <pc:sldMk cId="4248096269" sldId="267"/>
            <ac:spMk id="11" creationId="{CF1D697D-F442-431C-87D6-DCDA087EF3F7}"/>
          </ac:spMkLst>
        </pc:spChg>
        <pc:grpChg chg="add mod">
          <ac:chgData name="Manasweeta Angane" userId="05da2731-9352-4b35-b713-60351f56afbd" providerId="ADAL" clId="{D444FAE6-B328-4AB8-9A10-764831A715E0}" dt="2021-05-17T12:56:00.643" v="1701" actId="1076"/>
          <ac:grpSpMkLst>
            <pc:docMk/>
            <pc:sldMk cId="4248096269" sldId="267"/>
            <ac:grpSpMk id="4" creationId="{FB29A824-3831-41DB-8B5B-C982CC2BE6DA}"/>
          </ac:grpSpMkLst>
        </pc:grpChg>
        <pc:grpChg chg="add del mod">
          <ac:chgData name="Manasweeta Angane" userId="05da2731-9352-4b35-b713-60351f56afbd" providerId="ADAL" clId="{D444FAE6-B328-4AB8-9A10-764831A715E0}" dt="2021-05-18T09:24:47.488" v="1880" actId="165"/>
          <ac:grpSpMkLst>
            <pc:docMk/>
            <pc:sldMk cId="4248096269" sldId="267"/>
            <ac:grpSpMk id="9" creationId="{C8DA74C4-C119-49BF-9634-60588C80D8AC}"/>
          </ac:grpSpMkLst>
        </pc:grpChg>
        <pc:picChg chg="add mod">
          <ac:chgData name="Manasweeta Angane" userId="05da2731-9352-4b35-b713-60351f56afbd" providerId="ADAL" clId="{D444FAE6-B328-4AB8-9A10-764831A715E0}" dt="2021-05-21T11:24:35.606" v="2821" actId="1037"/>
          <ac:picMkLst>
            <pc:docMk/>
            <pc:sldMk cId="4248096269" sldId="267"/>
            <ac:picMk id="2050" creationId="{0EA136DA-DA7B-4301-8B4F-55A46F7DDD5D}"/>
          </ac:picMkLst>
        </pc:picChg>
      </pc:sldChg>
      <pc:sldChg chg="addSp delSp modSp add mod">
        <pc:chgData name="Manasweeta Angane" userId="05da2731-9352-4b35-b713-60351f56afbd" providerId="ADAL" clId="{D444FAE6-B328-4AB8-9A10-764831A715E0}" dt="2021-05-21T17:11:55.489" v="4248" actId="166"/>
        <pc:sldMkLst>
          <pc:docMk/>
          <pc:sldMk cId="3145637976" sldId="268"/>
        </pc:sldMkLst>
        <pc:spChg chg="mod ord">
          <ac:chgData name="Manasweeta Angane" userId="05da2731-9352-4b35-b713-60351f56afbd" providerId="ADAL" clId="{D444FAE6-B328-4AB8-9A10-764831A715E0}" dt="2021-05-21T17:11:55.489" v="4248" actId="166"/>
          <ac:spMkLst>
            <pc:docMk/>
            <pc:sldMk cId="3145637976" sldId="268"/>
            <ac:spMk id="3" creationId="{AE116250-06D3-4487-927B-6ABD4B0174E0}"/>
          </ac:spMkLst>
        </pc:spChg>
        <pc:spChg chg="mod">
          <ac:chgData name="Manasweeta Angane" userId="05da2731-9352-4b35-b713-60351f56afbd" providerId="ADAL" clId="{D444FAE6-B328-4AB8-9A10-764831A715E0}" dt="2021-05-21T11:32:13.320" v="2868" actId="1582"/>
          <ac:spMkLst>
            <pc:docMk/>
            <pc:sldMk cId="3145637976" sldId="268"/>
            <ac:spMk id="4" creationId="{4AE5A754-CBD5-4B6D-92E4-E0E9DC5E10E3}"/>
          </ac:spMkLst>
        </pc:spChg>
        <pc:spChg chg="mod">
          <ac:chgData name="Manasweeta Angane" userId="05da2731-9352-4b35-b713-60351f56afbd" providerId="ADAL" clId="{D444FAE6-B328-4AB8-9A10-764831A715E0}" dt="2021-05-21T17:06:34.215" v="3935" actId="1076"/>
          <ac:spMkLst>
            <pc:docMk/>
            <pc:sldMk cId="3145637976" sldId="268"/>
            <ac:spMk id="8" creationId="{9578BF0C-3884-4FD5-9C26-852AC96763B9}"/>
          </ac:spMkLst>
        </pc:spChg>
        <pc:spChg chg="mod">
          <ac:chgData name="Manasweeta Angane" userId="05da2731-9352-4b35-b713-60351f56afbd" providerId="ADAL" clId="{D444FAE6-B328-4AB8-9A10-764831A715E0}" dt="2021-05-21T11:32:25.086" v="2870" actId="208"/>
          <ac:spMkLst>
            <pc:docMk/>
            <pc:sldMk cId="3145637976" sldId="268"/>
            <ac:spMk id="112" creationId="{A8532107-6208-4D80-8926-B447E0FCCA7F}"/>
          </ac:spMkLst>
        </pc:spChg>
        <pc:spChg chg="mod">
          <ac:chgData name="Manasweeta Angane" userId="05da2731-9352-4b35-b713-60351f56afbd" providerId="ADAL" clId="{D444FAE6-B328-4AB8-9A10-764831A715E0}" dt="2021-05-21T11:32:21.238" v="2869" actId="208"/>
          <ac:spMkLst>
            <pc:docMk/>
            <pc:sldMk cId="3145637976" sldId="268"/>
            <ac:spMk id="113" creationId="{3B01C123-C096-40D9-ACDE-6BDAF936C1F5}"/>
          </ac:spMkLst>
        </pc:spChg>
        <pc:spChg chg="mod">
          <ac:chgData name="Manasweeta Angane" userId="05da2731-9352-4b35-b713-60351f56afbd" providerId="ADAL" clId="{D444FAE6-B328-4AB8-9A10-764831A715E0}" dt="2021-05-21T11:32:29.050" v="2871" actId="208"/>
          <ac:spMkLst>
            <pc:docMk/>
            <pc:sldMk cId="3145637976" sldId="268"/>
            <ac:spMk id="114" creationId="{EF234447-80A7-40F9-9DBD-254FE22BABF3}"/>
          </ac:spMkLst>
        </pc:spChg>
        <pc:grpChg chg="del">
          <ac:chgData name="Manasweeta Angane" userId="05da2731-9352-4b35-b713-60351f56afbd" providerId="ADAL" clId="{D444FAE6-B328-4AB8-9A10-764831A715E0}" dt="2021-05-21T16:52:38.339" v="3718" actId="478"/>
          <ac:grpSpMkLst>
            <pc:docMk/>
            <pc:sldMk cId="3145637976" sldId="268"/>
            <ac:grpSpMk id="2" creationId="{1BE1D928-7A39-4997-ABBE-C56BD9A597B1}"/>
          </ac:grpSpMkLst>
        </pc:grpChg>
        <pc:grpChg chg="del">
          <ac:chgData name="Manasweeta Angane" userId="05da2731-9352-4b35-b713-60351f56afbd" providerId="ADAL" clId="{D444FAE6-B328-4AB8-9A10-764831A715E0}" dt="2021-05-21T16:52:49.074" v="3730" actId="478"/>
          <ac:grpSpMkLst>
            <pc:docMk/>
            <pc:sldMk cId="3145637976" sldId="268"/>
            <ac:grpSpMk id="5" creationId="{2F84AD72-9BAF-41B2-BF46-1C06486CE0ED}"/>
          </ac:grpSpMkLst>
        </pc:grpChg>
        <pc:grpChg chg="del">
          <ac:chgData name="Manasweeta Angane" userId="05da2731-9352-4b35-b713-60351f56afbd" providerId="ADAL" clId="{D444FAE6-B328-4AB8-9A10-764831A715E0}" dt="2021-05-21T11:22:49.988" v="2805" actId="478"/>
          <ac:grpSpMkLst>
            <pc:docMk/>
            <pc:sldMk cId="3145637976" sldId="268"/>
            <ac:grpSpMk id="6" creationId="{7C286CEC-07BB-422E-9F2B-98D42B21E58B}"/>
          </ac:grpSpMkLst>
        </pc:grpChg>
        <pc:grpChg chg="del">
          <ac:chgData name="Manasweeta Angane" userId="05da2731-9352-4b35-b713-60351f56afbd" providerId="ADAL" clId="{D444FAE6-B328-4AB8-9A10-764831A715E0}" dt="2021-05-21T16:52:45.403" v="3726" actId="478"/>
          <ac:grpSpMkLst>
            <pc:docMk/>
            <pc:sldMk cId="3145637976" sldId="268"/>
            <ac:grpSpMk id="7" creationId="{E5B4890C-B51E-49EC-A03A-7F3891CD1C66}"/>
          </ac:grpSpMkLst>
        </pc:grpChg>
        <pc:grpChg chg="del">
          <ac:chgData name="Manasweeta Angane" userId="05da2731-9352-4b35-b713-60351f56afbd" providerId="ADAL" clId="{D444FAE6-B328-4AB8-9A10-764831A715E0}" dt="2021-05-21T16:52:35.061" v="3714" actId="478"/>
          <ac:grpSpMkLst>
            <pc:docMk/>
            <pc:sldMk cId="3145637976" sldId="268"/>
            <ac:grpSpMk id="9" creationId="{E22C013F-2FF9-49CF-BC06-CAACD8F64518}"/>
          </ac:grpSpMkLst>
        </pc:grpChg>
        <pc:grpChg chg="add mod">
          <ac:chgData name="Manasweeta Angane" userId="05da2731-9352-4b35-b713-60351f56afbd" providerId="ADAL" clId="{D444FAE6-B328-4AB8-9A10-764831A715E0}" dt="2021-05-21T17:10:36.473" v="4169" actId="164"/>
          <ac:grpSpMkLst>
            <pc:docMk/>
            <pc:sldMk cId="3145637976" sldId="268"/>
            <ac:grpSpMk id="10" creationId="{55D4762B-384F-4E4A-A433-57756592495B}"/>
          </ac:grpSpMkLst>
        </pc:grpChg>
        <pc:grpChg chg="add mod">
          <ac:chgData name="Manasweeta Angane" userId="05da2731-9352-4b35-b713-60351f56afbd" providerId="ADAL" clId="{D444FAE6-B328-4AB8-9A10-764831A715E0}" dt="2021-05-21T17:10:36.473" v="4169" actId="164"/>
          <ac:grpSpMkLst>
            <pc:docMk/>
            <pc:sldMk cId="3145637976" sldId="268"/>
            <ac:grpSpMk id="11" creationId="{3446A069-2D41-4239-9B2E-A6B31AEE84C9}"/>
          </ac:grpSpMkLst>
        </pc:grpChg>
        <pc:grpChg chg="add mod">
          <ac:chgData name="Manasweeta Angane" userId="05da2731-9352-4b35-b713-60351f56afbd" providerId="ADAL" clId="{D444FAE6-B328-4AB8-9A10-764831A715E0}" dt="2021-05-21T17:10:36.473" v="4169" actId="164"/>
          <ac:grpSpMkLst>
            <pc:docMk/>
            <pc:sldMk cId="3145637976" sldId="268"/>
            <ac:grpSpMk id="12" creationId="{80C288FA-EC2A-44F4-84C2-93F7B86E1639}"/>
          </ac:grpSpMkLst>
        </pc:grpChg>
        <pc:grpChg chg="del">
          <ac:chgData name="Manasweeta Angane" userId="05da2731-9352-4b35-b713-60351f56afbd" providerId="ADAL" clId="{D444FAE6-B328-4AB8-9A10-764831A715E0}" dt="2021-05-21T11:13:40.811" v="2760" actId="478"/>
          <ac:grpSpMkLst>
            <pc:docMk/>
            <pc:sldMk cId="3145637976" sldId="268"/>
            <ac:grpSpMk id="21" creationId="{9145CF07-E463-4E2D-838D-58DFF48DA910}"/>
          </ac:grpSpMkLst>
        </pc:grpChg>
        <pc:grpChg chg="add del mod">
          <ac:chgData name="Manasweeta Angane" userId="05da2731-9352-4b35-b713-60351f56afbd" providerId="ADAL" clId="{D444FAE6-B328-4AB8-9A10-764831A715E0}" dt="2021-05-21T17:01:10.043" v="3834" actId="478"/>
          <ac:grpSpMkLst>
            <pc:docMk/>
            <pc:sldMk cId="3145637976" sldId="268"/>
            <ac:grpSpMk id="74" creationId="{B6B17016-1056-43E7-BEA0-A12A4816BD2F}"/>
          </ac:grpSpMkLst>
        </pc:grpChg>
        <pc:grpChg chg="del">
          <ac:chgData name="Manasweeta Angane" userId="05da2731-9352-4b35-b713-60351f56afbd" providerId="ADAL" clId="{D444FAE6-B328-4AB8-9A10-764831A715E0}" dt="2021-05-21T11:14:56.319" v="2782" actId="478"/>
          <ac:grpSpMkLst>
            <pc:docMk/>
            <pc:sldMk cId="3145637976" sldId="268"/>
            <ac:grpSpMk id="78" creationId="{017A5463-1763-42F3-BE4C-BCFEC99C1120}"/>
          </ac:grpSpMkLst>
        </pc:grpChg>
        <pc:grpChg chg="del">
          <ac:chgData name="Manasweeta Angane" userId="05da2731-9352-4b35-b713-60351f56afbd" providerId="ADAL" clId="{D444FAE6-B328-4AB8-9A10-764831A715E0}" dt="2021-05-21T11:14:40.695" v="2766" actId="478"/>
          <ac:grpSpMkLst>
            <pc:docMk/>
            <pc:sldMk cId="3145637976" sldId="268"/>
            <ac:grpSpMk id="87" creationId="{BEB97D29-67E7-420B-87F4-B01BE583E078}"/>
          </ac:grpSpMkLst>
        </pc:grpChg>
        <pc:grpChg chg="mod">
          <ac:chgData name="Manasweeta Angane" userId="05da2731-9352-4b35-b713-60351f56afbd" providerId="ADAL" clId="{D444FAE6-B328-4AB8-9A10-764831A715E0}" dt="2021-05-21T16:55:29.025" v="3769" actId="1076"/>
          <ac:grpSpMkLst>
            <pc:docMk/>
            <pc:sldMk cId="3145637976" sldId="268"/>
            <ac:grpSpMk id="93" creationId="{A08B6DE1-97CA-4171-8523-734E80EE25A9}"/>
          </ac:grpSpMkLst>
        </pc:grpChg>
        <pc:grpChg chg="del">
          <ac:chgData name="Manasweeta Angane" userId="05da2731-9352-4b35-b713-60351f56afbd" providerId="ADAL" clId="{D444FAE6-B328-4AB8-9A10-764831A715E0}" dt="2021-05-21T11:22:45.967" v="2802" actId="478"/>
          <ac:grpSpMkLst>
            <pc:docMk/>
            <pc:sldMk cId="3145637976" sldId="268"/>
            <ac:grpSpMk id="94" creationId="{4E186A31-705F-4642-B242-D774E53C53AA}"/>
          </ac:grpSpMkLst>
        </pc:grpChg>
        <pc:grpChg chg="del">
          <ac:chgData name="Manasweeta Angane" userId="05da2731-9352-4b35-b713-60351f56afbd" providerId="ADAL" clId="{D444FAE6-B328-4AB8-9A10-764831A715E0}" dt="2021-05-21T16:52:40.157" v="3720" actId="478"/>
          <ac:grpSpMkLst>
            <pc:docMk/>
            <pc:sldMk cId="3145637976" sldId="268"/>
            <ac:grpSpMk id="99" creationId="{EB3AD489-4C3F-4B34-93FE-F09066D850D3}"/>
          </ac:grpSpMkLst>
        </pc:grpChg>
        <pc:grpChg chg="del">
          <ac:chgData name="Manasweeta Angane" userId="05da2731-9352-4b35-b713-60351f56afbd" providerId="ADAL" clId="{D444FAE6-B328-4AB8-9A10-764831A715E0}" dt="2021-05-21T16:52:43.363" v="3724" actId="478"/>
          <ac:grpSpMkLst>
            <pc:docMk/>
            <pc:sldMk cId="3145637976" sldId="268"/>
            <ac:grpSpMk id="102" creationId="{69254C08-5F62-4D5A-BF3A-82D69BE3C4E6}"/>
          </ac:grpSpMkLst>
        </pc:grpChg>
        <pc:grpChg chg="del">
          <ac:chgData name="Manasweeta Angane" userId="05da2731-9352-4b35-b713-60351f56afbd" providerId="ADAL" clId="{D444FAE6-B328-4AB8-9A10-764831A715E0}" dt="2021-05-21T11:15:08.093" v="2793" actId="478"/>
          <ac:grpSpMkLst>
            <pc:docMk/>
            <pc:sldMk cId="3145637976" sldId="268"/>
            <ac:grpSpMk id="106" creationId="{09917107-35EC-483D-B25B-A54102142EE8}"/>
          </ac:grpSpMkLst>
        </pc:grpChg>
        <pc:grpChg chg="mod">
          <ac:chgData name="Manasweeta Angane" userId="05da2731-9352-4b35-b713-60351f56afbd" providerId="ADAL" clId="{D444FAE6-B328-4AB8-9A10-764831A715E0}" dt="2021-05-21T17:07:01.084" v="3942" actId="12789"/>
          <ac:grpSpMkLst>
            <pc:docMk/>
            <pc:sldMk cId="3145637976" sldId="268"/>
            <ac:grpSpMk id="109" creationId="{67E5F1E1-32EE-4A88-9488-CFC3EF076927}"/>
          </ac:grpSpMkLst>
        </pc:grpChg>
        <pc:grpChg chg="add mod ord">
          <ac:chgData name="Manasweeta Angane" userId="05da2731-9352-4b35-b713-60351f56afbd" providerId="ADAL" clId="{D444FAE6-B328-4AB8-9A10-764831A715E0}" dt="2021-05-21T17:10:36.473" v="4169" actId="164"/>
          <ac:grpSpMkLst>
            <pc:docMk/>
            <pc:sldMk cId="3145637976" sldId="268"/>
            <ac:grpSpMk id="118" creationId="{A0782B21-5323-4FD2-B719-58E1F0497BB2}"/>
          </ac:grpSpMkLst>
        </pc:grpChg>
        <pc:grpChg chg="add mod">
          <ac:chgData name="Manasweeta Angane" userId="05da2731-9352-4b35-b713-60351f56afbd" providerId="ADAL" clId="{D444FAE6-B328-4AB8-9A10-764831A715E0}" dt="2021-05-21T17:11:22.729" v="4246" actId="196"/>
          <ac:grpSpMkLst>
            <pc:docMk/>
            <pc:sldMk cId="3145637976" sldId="268"/>
            <ac:grpSpMk id="133" creationId="{B3114FD7-986A-4987-B7B2-665717B3A15E}"/>
          </ac:grpSpMkLst>
        </pc:grpChg>
        <pc:grpChg chg="mod">
          <ac:chgData name="Manasweeta Angane" userId="05da2731-9352-4b35-b713-60351f56afbd" providerId="ADAL" clId="{D444FAE6-B328-4AB8-9A10-764831A715E0}" dt="2021-05-21T17:10:42.670" v="4170"/>
          <ac:grpSpMkLst>
            <pc:docMk/>
            <pc:sldMk cId="3145637976" sldId="268"/>
            <ac:grpSpMk id="134" creationId="{7E55AE15-68E0-49D3-A13A-C405CD593034}"/>
          </ac:grpSpMkLst>
        </pc:grpChg>
        <pc:grpChg chg="mod">
          <ac:chgData name="Manasweeta Angane" userId="05da2731-9352-4b35-b713-60351f56afbd" providerId="ADAL" clId="{D444FAE6-B328-4AB8-9A10-764831A715E0}" dt="2021-05-21T17:10:42.670" v="4170"/>
          <ac:grpSpMkLst>
            <pc:docMk/>
            <pc:sldMk cId="3145637976" sldId="268"/>
            <ac:grpSpMk id="135" creationId="{BE0E3A2A-CACB-43F9-AC93-B584951D57CD}"/>
          </ac:grpSpMkLst>
        </pc:grpChg>
        <pc:grpChg chg="mod">
          <ac:chgData name="Manasweeta Angane" userId="05da2731-9352-4b35-b713-60351f56afbd" providerId="ADAL" clId="{D444FAE6-B328-4AB8-9A10-764831A715E0}" dt="2021-05-21T17:10:42.670" v="4170"/>
          <ac:grpSpMkLst>
            <pc:docMk/>
            <pc:sldMk cId="3145637976" sldId="268"/>
            <ac:grpSpMk id="136" creationId="{3186EFCF-AD47-4083-BA6A-079EF47C425A}"/>
          </ac:grpSpMkLst>
        </pc:grpChg>
        <pc:picChg chg="del">
          <ac:chgData name="Manasweeta Angane" userId="05da2731-9352-4b35-b713-60351f56afbd" providerId="ADAL" clId="{D444FAE6-B328-4AB8-9A10-764831A715E0}" dt="2021-05-21T16:52:35.827" v="3715" actId="478"/>
          <ac:picMkLst>
            <pc:docMk/>
            <pc:sldMk cId="3145637976" sldId="268"/>
            <ac:picMk id="16" creationId="{0C632A22-601E-4654-98A4-B752DAB0A5BB}"/>
          </ac:picMkLst>
        </pc:picChg>
        <pc:picChg chg="del">
          <ac:chgData name="Manasweeta Angane" userId="05da2731-9352-4b35-b713-60351f56afbd" providerId="ADAL" clId="{D444FAE6-B328-4AB8-9A10-764831A715E0}" dt="2021-05-21T11:15:01.222" v="2786" actId="478"/>
          <ac:picMkLst>
            <pc:docMk/>
            <pc:sldMk cId="3145637976" sldId="268"/>
            <ac:picMk id="17" creationId="{38F0623C-1AF6-479B-B595-A800114A58E6}"/>
          </ac:picMkLst>
        </pc:picChg>
        <pc:picChg chg="del">
          <ac:chgData name="Manasweeta Angane" userId="05da2731-9352-4b35-b713-60351f56afbd" providerId="ADAL" clId="{D444FAE6-B328-4AB8-9A10-764831A715E0}" dt="2021-05-21T11:15:06.344" v="2791" actId="478"/>
          <ac:picMkLst>
            <pc:docMk/>
            <pc:sldMk cId="3145637976" sldId="268"/>
            <ac:picMk id="18" creationId="{693716A8-F217-4C3C-9390-BF8D34EA63BC}"/>
          </ac:picMkLst>
        </pc:picChg>
        <pc:picChg chg="del">
          <ac:chgData name="Manasweeta Angane" userId="05da2731-9352-4b35-b713-60351f56afbd" providerId="ADAL" clId="{D444FAE6-B328-4AB8-9A10-764831A715E0}" dt="2021-05-21T11:15:05.664" v="2790" actId="478"/>
          <ac:picMkLst>
            <pc:docMk/>
            <pc:sldMk cId="3145637976" sldId="268"/>
            <ac:picMk id="19" creationId="{B7587D7F-18C7-4E38-B82C-D76225ECF0AD}"/>
          </ac:picMkLst>
        </pc:picChg>
        <pc:picChg chg="del">
          <ac:chgData name="Manasweeta Angane" userId="05da2731-9352-4b35-b713-60351f56afbd" providerId="ADAL" clId="{D444FAE6-B328-4AB8-9A10-764831A715E0}" dt="2021-05-21T11:14:57.246" v="2783" actId="478"/>
          <ac:picMkLst>
            <pc:docMk/>
            <pc:sldMk cId="3145637976" sldId="268"/>
            <ac:picMk id="20" creationId="{50B70FDF-93B1-4D04-AD61-1C03C186CA64}"/>
          </ac:picMkLst>
        </pc:picChg>
        <pc:picChg chg="del">
          <ac:chgData name="Manasweeta Angane" userId="05da2731-9352-4b35-b713-60351f56afbd" providerId="ADAL" clId="{D444FAE6-B328-4AB8-9A10-764831A715E0}" dt="2021-05-21T11:14:58.190" v="2784" actId="478"/>
          <ac:picMkLst>
            <pc:docMk/>
            <pc:sldMk cId="3145637976" sldId="268"/>
            <ac:picMk id="26" creationId="{17767071-EEEB-47A6-9C9F-EC579458EAD2}"/>
          </ac:picMkLst>
        </pc:picChg>
        <pc:picChg chg="del mod">
          <ac:chgData name="Manasweeta Angane" userId="05da2731-9352-4b35-b713-60351f56afbd" providerId="ADAL" clId="{D444FAE6-B328-4AB8-9A10-764831A715E0}" dt="2021-05-21T16:17:39.225" v="3303" actId="21"/>
          <ac:picMkLst>
            <pc:docMk/>
            <pc:sldMk cId="3145637976" sldId="268"/>
            <ac:picMk id="27" creationId="{AD90960C-5D7B-42B1-BCEA-05C5E386F7E8}"/>
          </ac:picMkLst>
        </pc:picChg>
        <pc:picChg chg="del">
          <ac:chgData name="Manasweeta Angane" userId="05da2731-9352-4b35-b713-60351f56afbd" providerId="ADAL" clId="{D444FAE6-B328-4AB8-9A10-764831A715E0}" dt="2021-05-21T11:14:41.758" v="2767" actId="478"/>
          <ac:picMkLst>
            <pc:docMk/>
            <pc:sldMk cId="3145637976" sldId="268"/>
            <ac:picMk id="29" creationId="{02A73C63-BECD-47DA-830F-3177CAE5D067}"/>
          </ac:picMkLst>
        </pc:picChg>
        <pc:picChg chg="del">
          <ac:chgData name="Manasweeta Angane" userId="05da2731-9352-4b35-b713-60351f56afbd" providerId="ADAL" clId="{D444FAE6-B328-4AB8-9A10-764831A715E0}" dt="2021-05-21T11:14:47.039" v="2773" actId="478"/>
          <ac:picMkLst>
            <pc:docMk/>
            <pc:sldMk cId="3145637976" sldId="268"/>
            <ac:picMk id="30" creationId="{D0C48259-0540-4F71-A869-2FD8D071695D}"/>
          </ac:picMkLst>
        </pc:picChg>
        <pc:picChg chg="del">
          <ac:chgData name="Manasweeta Angane" userId="05da2731-9352-4b35-b713-60351f56afbd" providerId="ADAL" clId="{D444FAE6-B328-4AB8-9A10-764831A715E0}" dt="2021-05-21T11:15:09.639" v="2795" actId="478"/>
          <ac:picMkLst>
            <pc:docMk/>
            <pc:sldMk cId="3145637976" sldId="268"/>
            <ac:picMk id="31" creationId="{318D01EE-B552-46A9-8EA2-F37ECF766573}"/>
          </ac:picMkLst>
        </pc:picChg>
        <pc:picChg chg="del">
          <ac:chgData name="Manasweeta Angane" userId="05da2731-9352-4b35-b713-60351f56afbd" providerId="ADAL" clId="{D444FAE6-B328-4AB8-9A10-764831A715E0}" dt="2021-05-21T16:52:36.698" v="3716" actId="478"/>
          <ac:picMkLst>
            <pc:docMk/>
            <pc:sldMk cId="3145637976" sldId="268"/>
            <ac:picMk id="34" creationId="{11CC7DF1-B1F0-4AE6-93EC-0529CD492466}"/>
          </ac:picMkLst>
        </pc:picChg>
        <pc:picChg chg="del">
          <ac:chgData name="Manasweeta Angane" userId="05da2731-9352-4b35-b713-60351f56afbd" providerId="ADAL" clId="{D444FAE6-B328-4AB8-9A10-764831A715E0}" dt="2021-05-21T11:14:55.485" v="2781" actId="478"/>
          <ac:picMkLst>
            <pc:docMk/>
            <pc:sldMk cId="3145637976" sldId="268"/>
            <ac:picMk id="35" creationId="{93F7C139-363C-45B3-B7AE-EF89DF394249}"/>
          </ac:picMkLst>
        </pc:picChg>
        <pc:picChg chg="del">
          <ac:chgData name="Manasweeta Angane" userId="05da2731-9352-4b35-b713-60351f56afbd" providerId="ADAL" clId="{D444FAE6-B328-4AB8-9A10-764831A715E0}" dt="2021-05-21T11:14:42.942" v="2768" actId="478"/>
          <ac:picMkLst>
            <pc:docMk/>
            <pc:sldMk cId="3145637976" sldId="268"/>
            <ac:picMk id="36" creationId="{2EB6F462-D2BE-4641-AED0-6114EDD0E4A0}"/>
          </ac:picMkLst>
        </pc:picChg>
        <pc:picChg chg="del">
          <ac:chgData name="Manasweeta Angane" userId="05da2731-9352-4b35-b713-60351f56afbd" providerId="ADAL" clId="{D444FAE6-B328-4AB8-9A10-764831A715E0}" dt="2021-05-21T17:09:00.351" v="4014" actId="478"/>
          <ac:picMkLst>
            <pc:docMk/>
            <pc:sldMk cId="3145637976" sldId="268"/>
            <ac:picMk id="40" creationId="{D8B5B8F6-095A-4C97-9813-4C593D708C71}"/>
          </ac:picMkLst>
        </pc:picChg>
        <pc:picChg chg="del">
          <ac:chgData name="Manasweeta Angane" userId="05da2731-9352-4b35-b713-60351f56afbd" providerId="ADAL" clId="{D444FAE6-B328-4AB8-9A10-764831A715E0}" dt="2021-05-21T11:14:48.373" v="2775" actId="478"/>
          <ac:picMkLst>
            <pc:docMk/>
            <pc:sldMk cId="3145637976" sldId="268"/>
            <ac:picMk id="44" creationId="{E3CEDA3F-C0A9-44D3-8BFC-576CB5CE9915}"/>
          </ac:picMkLst>
        </pc:picChg>
        <pc:picChg chg="del">
          <ac:chgData name="Manasweeta Angane" userId="05da2731-9352-4b35-b713-60351f56afbd" providerId="ADAL" clId="{D444FAE6-B328-4AB8-9A10-764831A715E0}" dt="2021-05-21T11:14:51.389" v="2779" actId="478"/>
          <ac:picMkLst>
            <pc:docMk/>
            <pc:sldMk cId="3145637976" sldId="268"/>
            <ac:picMk id="47" creationId="{2150154C-339B-4C71-933B-329D5CAE9346}"/>
          </ac:picMkLst>
        </pc:picChg>
        <pc:picChg chg="del">
          <ac:chgData name="Manasweeta Angane" userId="05da2731-9352-4b35-b713-60351f56afbd" providerId="ADAL" clId="{D444FAE6-B328-4AB8-9A10-764831A715E0}" dt="2021-05-21T16:52:41.098" v="3721" actId="478"/>
          <ac:picMkLst>
            <pc:docMk/>
            <pc:sldMk cId="3145637976" sldId="268"/>
            <ac:picMk id="49" creationId="{E0A7E8B5-4176-42F5-B3C5-5431802FABE7}"/>
          </ac:picMkLst>
        </pc:picChg>
        <pc:picChg chg="del">
          <ac:chgData name="Manasweeta Angane" userId="05da2731-9352-4b35-b713-60351f56afbd" providerId="ADAL" clId="{D444FAE6-B328-4AB8-9A10-764831A715E0}" dt="2021-05-21T16:52:39.483" v="3719" actId="478"/>
          <ac:picMkLst>
            <pc:docMk/>
            <pc:sldMk cId="3145637976" sldId="268"/>
            <ac:picMk id="50" creationId="{10681031-75A0-4A0B-9DC7-88249CDB6B3A}"/>
          </ac:picMkLst>
        </pc:picChg>
        <pc:picChg chg="del">
          <ac:chgData name="Manasweeta Angane" userId="05da2731-9352-4b35-b713-60351f56afbd" providerId="ADAL" clId="{D444FAE6-B328-4AB8-9A10-764831A715E0}" dt="2021-05-21T16:52:42.082" v="3722" actId="478"/>
          <ac:picMkLst>
            <pc:docMk/>
            <pc:sldMk cId="3145637976" sldId="268"/>
            <ac:picMk id="51" creationId="{510C70A0-8345-4C2D-BAE4-A57622817052}"/>
          </ac:picMkLst>
        </pc:picChg>
        <pc:picChg chg="del">
          <ac:chgData name="Manasweeta Angane" userId="05da2731-9352-4b35-b713-60351f56afbd" providerId="ADAL" clId="{D444FAE6-B328-4AB8-9A10-764831A715E0}" dt="2021-05-21T11:14:43.766" v="2769" actId="478"/>
          <ac:picMkLst>
            <pc:docMk/>
            <pc:sldMk cId="3145637976" sldId="268"/>
            <ac:picMk id="52" creationId="{2A9CE1E7-B2B0-4DAB-BA6D-D2442DB2F362}"/>
          </ac:picMkLst>
        </pc:picChg>
        <pc:picChg chg="del">
          <ac:chgData name="Manasweeta Angane" userId="05da2731-9352-4b35-b713-60351f56afbd" providerId="ADAL" clId="{D444FAE6-B328-4AB8-9A10-764831A715E0}" dt="2021-05-21T11:14:45.084" v="2771" actId="478"/>
          <ac:picMkLst>
            <pc:docMk/>
            <pc:sldMk cId="3145637976" sldId="268"/>
            <ac:picMk id="53" creationId="{D0520211-CAE7-46EC-922C-DBD66A6DDE5C}"/>
          </ac:picMkLst>
        </pc:picChg>
        <pc:picChg chg="del">
          <ac:chgData name="Manasweeta Angane" userId="05da2731-9352-4b35-b713-60351f56afbd" providerId="ADAL" clId="{D444FAE6-B328-4AB8-9A10-764831A715E0}" dt="2021-05-21T11:14:50.630" v="2778" actId="478"/>
          <ac:picMkLst>
            <pc:docMk/>
            <pc:sldMk cId="3145637976" sldId="268"/>
            <ac:picMk id="54" creationId="{F44A9757-E37A-498E-B7F6-B63EF6220C2E}"/>
          </ac:picMkLst>
        </pc:picChg>
        <pc:picChg chg="del">
          <ac:chgData name="Manasweeta Angane" userId="05da2731-9352-4b35-b713-60351f56afbd" providerId="ADAL" clId="{D444FAE6-B328-4AB8-9A10-764831A715E0}" dt="2021-05-21T11:22:47.501" v="2803" actId="478"/>
          <ac:picMkLst>
            <pc:docMk/>
            <pc:sldMk cId="3145637976" sldId="268"/>
            <ac:picMk id="55" creationId="{76AC46E1-1529-441A-B7C7-5BF677A619E6}"/>
          </ac:picMkLst>
        </pc:picChg>
        <pc:picChg chg="del mod">
          <ac:chgData name="Manasweeta Angane" userId="05da2731-9352-4b35-b713-60351f56afbd" providerId="ADAL" clId="{D444FAE6-B328-4AB8-9A10-764831A715E0}" dt="2021-05-21T11:15:02.278" v="2787" actId="478"/>
          <ac:picMkLst>
            <pc:docMk/>
            <pc:sldMk cId="3145637976" sldId="268"/>
            <ac:picMk id="56" creationId="{62AA8308-46F3-4043-9755-F0611BDFC493}"/>
          </ac:picMkLst>
        </pc:picChg>
        <pc:picChg chg="del">
          <ac:chgData name="Manasweeta Angane" userId="05da2731-9352-4b35-b713-60351f56afbd" providerId="ADAL" clId="{D444FAE6-B328-4AB8-9A10-764831A715E0}" dt="2021-05-21T11:15:03.294" v="2788" actId="478"/>
          <ac:picMkLst>
            <pc:docMk/>
            <pc:sldMk cId="3145637976" sldId="268"/>
            <ac:picMk id="57" creationId="{5C5CA2EF-6EB2-4FDF-9ADE-9E4D42D8ACEE}"/>
          </ac:picMkLst>
        </pc:picChg>
        <pc:picChg chg="add mod">
          <ac:chgData name="Manasweeta Angane" userId="05da2731-9352-4b35-b713-60351f56afbd" providerId="ADAL" clId="{D444FAE6-B328-4AB8-9A10-764831A715E0}" dt="2021-05-21T16:58:25.751" v="3798" actId="164"/>
          <ac:picMkLst>
            <pc:docMk/>
            <pc:sldMk cId="3145637976" sldId="268"/>
            <ac:picMk id="63" creationId="{FFD12E96-C47E-4680-A42F-BE0666A83820}"/>
          </ac:picMkLst>
        </pc:picChg>
        <pc:picChg chg="add mod">
          <ac:chgData name="Manasweeta Angane" userId="05da2731-9352-4b35-b713-60351f56afbd" providerId="ADAL" clId="{D444FAE6-B328-4AB8-9A10-764831A715E0}" dt="2021-05-21T16:58:25.751" v="3798" actId="164"/>
          <ac:picMkLst>
            <pc:docMk/>
            <pc:sldMk cId="3145637976" sldId="268"/>
            <ac:picMk id="69" creationId="{268A7AD0-ED0E-4F7B-BF30-7C92EAE07824}"/>
          </ac:picMkLst>
        </pc:picChg>
        <pc:picChg chg="del">
          <ac:chgData name="Manasweeta Angane" userId="05da2731-9352-4b35-b713-60351f56afbd" providerId="ADAL" clId="{D444FAE6-B328-4AB8-9A10-764831A715E0}" dt="2021-05-21T11:14:54.443" v="2780" actId="478"/>
          <ac:picMkLst>
            <pc:docMk/>
            <pc:sldMk cId="3145637976" sldId="268"/>
            <ac:picMk id="69" creationId="{A7838FD7-C060-4898-A40D-ACD3E18CB54A}"/>
          </ac:picMkLst>
        </pc:picChg>
        <pc:picChg chg="del">
          <ac:chgData name="Manasweeta Angane" userId="05da2731-9352-4b35-b713-60351f56afbd" providerId="ADAL" clId="{D444FAE6-B328-4AB8-9A10-764831A715E0}" dt="2021-05-21T11:15:04.831" v="2789" actId="478"/>
          <ac:picMkLst>
            <pc:docMk/>
            <pc:sldMk cId="3145637976" sldId="268"/>
            <ac:picMk id="70" creationId="{564BB657-BB08-4B8C-9CD5-6EEACA2CE31F}"/>
          </ac:picMkLst>
        </pc:picChg>
        <pc:picChg chg="add mod">
          <ac:chgData name="Manasweeta Angane" userId="05da2731-9352-4b35-b713-60351f56afbd" providerId="ADAL" clId="{D444FAE6-B328-4AB8-9A10-764831A715E0}" dt="2021-05-21T16:58:25.751" v="3798" actId="164"/>
          <ac:picMkLst>
            <pc:docMk/>
            <pc:sldMk cId="3145637976" sldId="268"/>
            <ac:picMk id="70" creationId="{A1F40D6A-62A0-4AB5-A38C-5F8C48038D5F}"/>
          </ac:picMkLst>
        </pc:picChg>
        <pc:picChg chg="del">
          <ac:chgData name="Manasweeta Angane" userId="05da2731-9352-4b35-b713-60351f56afbd" providerId="ADAL" clId="{D444FAE6-B328-4AB8-9A10-764831A715E0}" dt="2021-05-21T16:52:50.987" v="3732" actId="478"/>
          <ac:picMkLst>
            <pc:docMk/>
            <pc:sldMk cId="3145637976" sldId="268"/>
            <ac:picMk id="71" creationId="{6E0B42A9-CDEE-4B97-95E4-97F20506BC8B}"/>
          </ac:picMkLst>
        </pc:picChg>
        <pc:picChg chg="del">
          <ac:chgData name="Manasweeta Angane" userId="05da2731-9352-4b35-b713-60351f56afbd" providerId="ADAL" clId="{D444FAE6-B328-4AB8-9A10-764831A715E0}" dt="2021-05-21T16:52:42.738" v="3723" actId="478"/>
          <ac:picMkLst>
            <pc:docMk/>
            <pc:sldMk cId="3145637976" sldId="268"/>
            <ac:picMk id="72" creationId="{9C668B2F-AB67-4B5A-BEC4-4C2A008A5C21}"/>
          </ac:picMkLst>
        </pc:picChg>
        <pc:picChg chg="add mod">
          <ac:chgData name="Manasweeta Angane" userId="05da2731-9352-4b35-b713-60351f56afbd" providerId="ADAL" clId="{D444FAE6-B328-4AB8-9A10-764831A715E0}" dt="2021-05-21T16:58:25.751" v="3798" actId="164"/>
          <ac:picMkLst>
            <pc:docMk/>
            <pc:sldMk cId="3145637976" sldId="268"/>
            <ac:picMk id="73" creationId="{F1DC4C44-9167-47C8-8408-EBD03807B7C5}"/>
          </ac:picMkLst>
        </pc:picChg>
        <pc:picChg chg="del">
          <ac:chgData name="Manasweeta Angane" userId="05da2731-9352-4b35-b713-60351f56afbd" providerId="ADAL" clId="{D444FAE6-B328-4AB8-9A10-764831A715E0}" dt="2021-05-21T11:14:59.942" v="2785" actId="478"/>
          <ac:picMkLst>
            <pc:docMk/>
            <pc:sldMk cId="3145637976" sldId="268"/>
            <ac:picMk id="74" creationId="{FE1942F6-89D4-42C8-ADFB-37FB02A572D3}"/>
          </ac:picMkLst>
        </pc:picChg>
        <pc:picChg chg="del">
          <ac:chgData name="Manasweeta Angane" userId="05da2731-9352-4b35-b713-60351f56afbd" providerId="ADAL" clId="{D444FAE6-B328-4AB8-9A10-764831A715E0}" dt="2021-05-21T11:15:07.368" v="2792" actId="478"/>
          <ac:picMkLst>
            <pc:docMk/>
            <pc:sldMk cId="3145637976" sldId="268"/>
            <ac:picMk id="75" creationId="{B56C8172-E660-4F61-B413-A6E179C8266A}"/>
          </ac:picMkLst>
        </pc:picChg>
        <pc:picChg chg="mod">
          <ac:chgData name="Manasweeta Angane" userId="05da2731-9352-4b35-b713-60351f56afbd" providerId="ADAL" clId="{D444FAE6-B328-4AB8-9A10-764831A715E0}" dt="2021-05-21T16:55:29.025" v="3769" actId="1076"/>
          <ac:picMkLst>
            <pc:docMk/>
            <pc:sldMk cId="3145637976" sldId="268"/>
            <ac:picMk id="75" creationId="{EA9BC265-1670-44F1-AE79-405EAC7AE732}"/>
          </ac:picMkLst>
        </pc:picChg>
        <pc:picChg chg="mod">
          <ac:chgData name="Manasweeta Angane" userId="05da2731-9352-4b35-b713-60351f56afbd" providerId="ADAL" clId="{D444FAE6-B328-4AB8-9A10-764831A715E0}" dt="2021-05-21T16:55:29.025" v="3769" actId="1076"/>
          <ac:picMkLst>
            <pc:docMk/>
            <pc:sldMk cId="3145637976" sldId="268"/>
            <ac:picMk id="76" creationId="{ABB4DB65-B0CF-4A93-A8CD-F42B05A6E7A9}"/>
          </ac:picMkLst>
        </pc:picChg>
        <pc:picChg chg="del">
          <ac:chgData name="Manasweeta Angane" userId="05da2731-9352-4b35-b713-60351f56afbd" providerId="ADAL" clId="{D444FAE6-B328-4AB8-9A10-764831A715E0}" dt="2021-05-21T11:15:08.910" v="2794" actId="478"/>
          <ac:picMkLst>
            <pc:docMk/>
            <pc:sldMk cId="3145637976" sldId="268"/>
            <ac:picMk id="76" creationId="{B46F448E-5E4E-4884-9AAB-6C9B90993F0E}"/>
          </ac:picMkLst>
        </pc:picChg>
        <pc:picChg chg="del">
          <ac:chgData name="Manasweeta Angane" userId="05da2731-9352-4b35-b713-60351f56afbd" providerId="ADAL" clId="{D444FAE6-B328-4AB8-9A10-764831A715E0}" dt="2021-05-21T16:52:34.178" v="3713" actId="478"/>
          <ac:picMkLst>
            <pc:docMk/>
            <pc:sldMk cId="3145637976" sldId="268"/>
            <ac:picMk id="77" creationId="{1D0EE913-226C-4A18-BBF2-90A93766C6E2}"/>
          </ac:picMkLst>
        </pc:picChg>
        <pc:picChg chg="mod">
          <ac:chgData name="Manasweeta Angane" userId="05da2731-9352-4b35-b713-60351f56afbd" providerId="ADAL" clId="{D444FAE6-B328-4AB8-9A10-764831A715E0}" dt="2021-05-21T16:55:29.025" v="3769" actId="1076"/>
          <ac:picMkLst>
            <pc:docMk/>
            <pc:sldMk cId="3145637976" sldId="268"/>
            <ac:picMk id="78" creationId="{892097BE-A1C8-4D5F-8829-CCDDDDFFF267}"/>
          </ac:picMkLst>
        </pc:picChg>
        <pc:picChg chg="mod">
          <ac:chgData name="Manasweeta Angane" userId="05da2731-9352-4b35-b713-60351f56afbd" providerId="ADAL" clId="{D444FAE6-B328-4AB8-9A10-764831A715E0}" dt="2021-05-21T16:55:29.025" v="3769" actId="1076"/>
          <ac:picMkLst>
            <pc:docMk/>
            <pc:sldMk cId="3145637976" sldId="268"/>
            <ac:picMk id="79" creationId="{BAF0C88E-63FC-4A35-8DDD-FB24B34CD170}"/>
          </ac:picMkLst>
        </pc:picChg>
        <pc:picChg chg="mod">
          <ac:chgData name="Manasweeta Angane" userId="05da2731-9352-4b35-b713-60351f56afbd" providerId="ADAL" clId="{D444FAE6-B328-4AB8-9A10-764831A715E0}" dt="2021-05-21T16:55:29.025" v="3769" actId="1076"/>
          <ac:picMkLst>
            <pc:docMk/>
            <pc:sldMk cId="3145637976" sldId="268"/>
            <ac:picMk id="80" creationId="{A1358E18-43E0-4F54-B85C-9C88D7858656}"/>
          </ac:picMkLst>
        </pc:picChg>
        <pc:picChg chg="del">
          <ac:chgData name="Manasweeta Angane" userId="05da2731-9352-4b35-b713-60351f56afbd" providerId="ADAL" clId="{D444FAE6-B328-4AB8-9A10-764831A715E0}" dt="2021-05-21T11:14:49.837" v="2777" actId="478"/>
          <ac:picMkLst>
            <pc:docMk/>
            <pc:sldMk cId="3145637976" sldId="268"/>
            <ac:picMk id="81" creationId="{D250D50D-7E55-4215-A116-7DD641FC3EB9}"/>
          </ac:picMkLst>
        </pc:picChg>
        <pc:picChg chg="mod">
          <ac:chgData name="Manasweeta Angane" userId="05da2731-9352-4b35-b713-60351f56afbd" providerId="ADAL" clId="{D444FAE6-B328-4AB8-9A10-764831A715E0}" dt="2021-05-21T16:55:29.025" v="3769" actId="1076"/>
          <ac:picMkLst>
            <pc:docMk/>
            <pc:sldMk cId="3145637976" sldId="268"/>
            <ac:picMk id="81" creationId="{E92D6C00-911A-4A13-997B-8BEC547A19FB}"/>
          </ac:picMkLst>
        </pc:picChg>
        <pc:picChg chg="del">
          <ac:chgData name="Manasweeta Angane" userId="05da2731-9352-4b35-b713-60351f56afbd" providerId="ADAL" clId="{D444FAE6-B328-4AB8-9A10-764831A715E0}" dt="2021-05-21T11:14:49.238" v="2776" actId="478"/>
          <ac:picMkLst>
            <pc:docMk/>
            <pc:sldMk cId="3145637976" sldId="268"/>
            <ac:picMk id="82" creationId="{3E74BE48-BB22-4BD9-B2C6-29A1541333B1}"/>
          </ac:picMkLst>
        </pc:picChg>
        <pc:picChg chg="mod">
          <ac:chgData name="Manasweeta Angane" userId="05da2731-9352-4b35-b713-60351f56afbd" providerId="ADAL" clId="{D444FAE6-B328-4AB8-9A10-764831A715E0}" dt="2021-05-21T16:55:29.025" v="3769" actId="1076"/>
          <ac:picMkLst>
            <pc:docMk/>
            <pc:sldMk cId="3145637976" sldId="268"/>
            <ac:picMk id="82" creationId="{4D7F019A-0EDE-44A1-8DA0-365A5ED328E3}"/>
          </ac:picMkLst>
        </pc:picChg>
        <pc:picChg chg="del">
          <ac:chgData name="Manasweeta Angane" userId="05da2731-9352-4b35-b713-60351f56afbd" providerId="ADAL" clId="{D444FAE6-B328-4AB8-9A10-764831A715E0}" dt="2021-05-21T16:52:44.036" v="3725" actId="478"/>
          <ac:picMkLst>
            <pc:docMk/>
            <pc:sldMk cId="3145637976" sldId="268"/>
            <ac:picMk id="83" creationId="{98317C7F-8CDA-4BD2-A1EA-C771895BC6D4}"/>
          </ac:picMkLst>
        </pc:picChg>
        <pc:picChg chg="del">
          <ac:chgData name="Manasweeta Angane" userId="05da2731-9352-4b35-b713-60351f56afbd" providerId="ADAL" clId="{D444FAE6-B328-4AB8-9A10-764831A715E0}" dt="2021-05-21T16:52:47.186" v="3728" actId="478"/>
          <ac:picMkLst>
            <pc:docMk/>
            <pc:sldMk cId="3145637976" sldId="268"/>
            <ac:picMk id="84" creationId="{DB7D06D8-8CF4-4065-A840-6FF812D26DC3}"/>
          </ac:picMkLst>
        </pc:picChg>
        <pc:picChg chg="del">
          <ac:chgData name="Manasweeta Angane" userId="05da2731-9352-4b35-b713-60351f56afbd" providerId="ADAL" clId="{D444FAE6-B328-4AB8-9A10-764831A715E0}" dt="2021-05-21T16:52:46.514" v="3727" actId="478"/>
          <ac:picMkLst>
            <pc:docMk/>
            <pc:sldMk cId="3145637976" sldId="268"/>
            <ac:picMk id="85" creationId="{B4C24787-5B2B-4E0A-AC84-EF278C32A804}"/>
          </ac:picMkLst>
        </pc:picChg>
        <pc:picChg chg="del">
          <ac:chgData name="Manasweeta Angane" userId="05da2731-9352-4b35-b713-60351f56afbd" providerId="ADAL" clId="{D444FAE6-B328-4AB8-9A10-764831A715E0}" dt="2021-05-21T16:52:50.034" v="3731" actId="478"/>
          <ac:picMkLst>
            <pc:docMk/>
            <pc:sldMk cId="3145637976" sldId="268"/>
            <ac:picMk id="86" creationId="{6076695E-3104-44A7-8BEA-99DA4C7F28AB}"/>
          </ac:picMkLst>
        </pc:picChg>
        <pc:picChg chg="mod">
          <ac:chgData name="Manasweeta Angane" userId="05da2731-9352-4b35-b713-60351f56afbd" providerId="ADAL" clId="{D444FAE6-B328-4AB8-9A10-764831A715E0}" dt="2021-05-21T16:55:29.025" v="3769" actId="1076"/>
          <ac:picMkLst>
            <pc:docMk/>
            <pc:sldMk cId="3145637976" sldId="268"/>
            <ac:picMk id="87" creationId="{7A3ACFE1-4071-455F-87D9-212E4EDF13C2}"/>
          </ac:picMkLst>
        </pc:picChg>
        <pc:picChg chg="mod">
          <ac:chgData name="Manasweeta Angane" userId="05da2731-9352-4b35-b713-60351f56afbd" providerId="ADAL" clId="{D444FAE6-B328-4AB8-9A10-764831A715E0}" dt="2021-05-21T16:55:29.025" v="3769" actId="1076"/>
          <ac:picMkLst>
            <pc:docMk/>
            <pc:sldMk cId="3145637976" sldId="268"/>
            <ac:picMk id="88" creationId="{7BC794E1-647B-4906-BF58-F501598934C3}"/>
          </ac:picMkLst>
        </pc:picChg>
        <pc:picChg chg="mod">
          <ac:chgData name="Manasweeta Angane" userId="05da2731-9352-4b35-b713-60351f56afbd" providerId="ADAL" clId="{D444FAE6-B328-4AB8-9A10-764831A715E0}" dt="2021-05-21T16:55:29.025" v="3769" actId="1076"/>
          <ac:picMkLst>
            <pc:docMk/>
            <pc:sldMk cId="3145637976" sldId="268"/>
            <ac:picMk id="89" creationId="{3B236C49-54FC-4F3C-ABBF-8C922268E814}"/>
          </ac:picMkLst>
        </pc:picChg>
        <pc:picChg chg="del">
          <ac:chgData name="Manasweeta Angane" userId="05da2731-9352-4b35-b713-60351f56afbd" providerId="ADAL" clId="{D444FAE6-B328-4AB8-9A10-764831A715E0}" dt="2021-05-21T11:14:45.894" v="2772" actId="478"/>
          <ac:picMkLst>
            <pc:docMk/>
            <pc:sldMk cId="3145637976" sldId="268"/>
            <ac:picMk id="90" creationId="{7E513889-6580-4137-A42E-EAB2DF792BBE}"/>
          </ac:picMkLst>
        </pc:picChg>
        <pc:picChg chg="mod">
          <ac:chgData name="Manasweeta Angane" userId="05da2731-9352-4b35-b713-60351f56afbd" providerId="ADAL" clId="{D444FAE6-B328-4AB8-9A10-764831A715E0}" dt="2021-05-21T16:55:29.025" v="3769" actId="1076"/>
          <ac:picMkLst>
            <pc:docMk/>
            <pc:sldMk cId="3145637976" sldId="268"/>
            <ac:picMk id="90" creationId="{FC75D7EC-EBFA-4EB3-BF86-401D46454586}"/>
          </ac:picMkLst>
        </pc:picChg>
        <pc:picChg chg="mod">
          <ac:chgData name="Manasweeta Angane" userId="05da2731-9352-4b35-b713-60351f56afbd" providerId="ADAL" clId="{D444FAE6-B328-4AB8-9A10-764831A715E0}" dt="2021-05-21T16:55:29.025" v="3769" actId="1076"/>
          <ac:picMkLst>
            <pc:docMk/>
            <pc:sldMk cId="3145637976" sldId="268"/>
            <ac:picMk id="91" creationId="{04E488E1-FD63-4A28-B155-74AF721421C5}"/>
          </ac:picMkLst>
        </pc:picChg>
        <pc:picChg chg="del">
          <ac:chgData name="Manasweeta Angane" userId="05da2731-9352-4b35-b713-60351f56afbd" providerId="ADAL" clId="{D444FAE6-B328-4AB8-9A10-764831A715E0}" dt="2021-05-21T11:14:44.422" v="2770" actId="478"/>
          <ac:picMkLst>
            <pc:docMk/>
            <pc:sldMk cId="3145637976" sldId="268"/>
            <ac:picMk id="91" creationId="{0BE992B8-9C7C-4D03-8702-5C316C2C5B44}"/>
          </ac:picMkLst>
        </pc:picChg>
        <pc:picChg chg="del">
          <ac:chgData name="Manasweeta Angane" userId="05da2731-9352-4b35-b713-60351f56afbd" providerId="ADAL" clId="{D444FAE6-B328-4AB8-9A10-764831A715E0}" dt="2021-05-21T16:52:37.547" v="3717" actId="478"/>
          <ac:picMkLst>
            <pc:docMk/>
            <pc:sldMk cId="3145637976" sldId="268"/>
            <ac:picMk id="92" creationId="{6EF6E06A-BC61-4D8F-B504-8128E7584F2E}"/>
          </ac:picMkLst>
        </pc:picChg>
        <pc:picChg chg="del">
          <ac:chgData name="Manasweeta Angane" userId="05da2731-9352-4b35-b713-60351f56afbd" providerId="ADAL" clId="{D444FAE6-B328-4AB8-9A10-764831A715E0}" dt="2021-05-21T11:14:47.725" v="2774" actId="478"/>
          <ac:picMkLst>
            <pc:docMk/>
            <pc:sldMk cId="3145637976" sldId="268"/>
            <ac:picMk id="93" creationId="{BDF3C75D-8CB3-45F8-8CF1-067C1F6FE252}"/>
          </ac:picMkLst>
        </pc:picChg>
        <pc:picChg chg="mod">
          <ac:chgData name="Manasweeta Angane" userId="05da2731-9352-4b35-b713-60351f56afbd" providerId="ADAL" clId="{D444FAE6-B328-4AB8-9A10-764831A715E0}" dt="2021-05-21T16:55:29.025" v="3769" actId="1076"/>
          <ac:picMkLst>
            <pc:docMk/>
            <pc:sldMk cId="3145637976" sldId="268"/>
            <ac:picMk id="97" creationId="{8F19F89B-F9CE-4384-A188-205B7BEE2CCE}"/>
          </ac:picMkLst>
        </pc:picChg>
        <pc:picChg chg="del">
          <ac:chgData name="Manasweeta Angane" userId="05da2731-9352-4b35-b713-60351f56afbd" providerId="ADAL" clId="{D444FAE6-B328-4AB8-9A10-764831A715E0}" dt="2021-05-21T16:52:48.292" v="3729" actId="478"/>
          <ac:picMkLst>
            <pc:docMk/>
            <pc:sldMk cId="3145637976" sldId="268"/>
            <ac:picMk id="98" creationId="{90F8C793-315C-44FE-AD34-A2CFDEC5B1ED}"/>
          </ac:picMkLst>
        </pc:picChg>
        <pc:picChg chg="del">
          <ac:chgData name="Manasweeta Angane" userId="05da2731-9352-4b35-b713-60351f56afbd" providerId="ADAL" clId="{D444FAE6-B328-4AB8-9A10-764831A715E0}" dt="2021-05-21T11:22:48.892" v="2804" actId="478"/>
          <ac:picMkLst>
            <pc:docMk/>
            <pc:sldMk cId="3145637976" sldId="268"/>
            <ac:picMk id="105" creationId="{089D3380-4C78-4B6B-BB2C-3ECC905346CC}"/>
          </ac:picMkLst>
        </pc:picChg>
        <pc:picChg chg="mod">
          <ac:chgData name="Manasweeta Angane" userId="05da2731-9352-4b35-b713-60351f56afbd" providerId="ADAL" clId="{D444FAE6-B328-4AB8-9A10-764831A715E0}" dt="2021-05-21T16:55:29.025" v="3769" actId="1076"/>
          <ac:picMkLst>
            <pc:docMk/>
            <pc:sldMk cId="3145637976" sldId="268"/>
            <ac:picMk id="106" creationId="{4E71776F-EFBF-4B9B-837E-7E3B23E233F4}"/>
          </ac:picMkLst>
        </pc:picChg>
        <pc:picChg chg="mod">
          <ac:chgData name="Manasweeta Angane" userId="05da2731-9352-4b35-b713-60351f56afbd" providerId="ADAL" clId="{D444FAE6-B328-4AB8-9A10-764831A715E0}" dt="2021-05-21T17:06:49.775" v="3939" actId="1076"/>
          <ac:picMkLst>
            <pc:docMk/>
            <pc:sldMk cId="3145637976" sldId="268"/>
            <ac:picMk id="107" creationId="{5C0B13FE-23D3-4408-B63D-2E63CEF1FC6D}"/>
          </ac:picMkLst>
        </pc:picChg>
        <pc:picChg chg="mod">
          <ac:chgData name="Manasweeta Angane" userId="05da2731-9352-4b35-b713-60351f56afbd" providerId="ADAL" clId="{D444FAE6-B328-4AB8-9A10-764831A715E0}" dt="2021-05-21T17:06:38.826" v="3936" actId="14100"/>
          <ac:picMkLst>
            <pc:docMk/>
            <pc:sldMk cId="3145637976" sldId="268"/>
            <ac:picMk id="108" creationId="{7F6EFE52-17E3-49DF-B205-17E2CACD5EA8}"/>
          </ac:picMkLst>
        </pc:picChg>
        <pc:picChg chg="mod">
          <ac:chgData name="Manasweeta Angane" userId="05da2731-9352-4b35-b713-60351f56afbd" providerId="ADAL" clId="{D444FAE6-B328-4AB8-9A10-764831A715E0}" dt="2021-05-21T16:55:29.025" v="3769" actId="1076"/>
          <ac:picMkLst>
            <pc:docMk/>
            <pc:sldMk cId="3145637976" sldId="268"/>
            <ac:picMk id="115" creationId="{0E5EC708-5081-4504-AC39-6BB5EE1FD403}"/>
          </ac:picMkLst>
        </pc:picChg>
        <pc:picChg chg="add mod">
          <ac:chgData name="Manasweeta Angane" userId="05da2731-9352-4b35-b713-60351f56afbd" providerId="ADAL" clId="{D444FAE6-B328-4AB8-9A10-764831A715E0}" dt="2021-05-21T16:58:25.751" v="3798" actId="164"/>
          <ac:picMkLst>
            <pc:docMk/>
            <pc:sldMk cId="3145637976" sldId="268"/>
            <ac:picMk id="116" creationId="{EE901BD3-59B1-4F2A-9522-2595EEF17AB9}"/>
          </ac:picMkLst>
        </pc:picChg>
        <pc:picChg chg="add mod ord">
          <ac:chgData name="Manasweeta Angane" userId="05da2731-9352-4b35-b713-60351f56afbd" providerId="ADAL" clId="{D444FAE6-B328-4AB8-9A10-764831A715E0}" dt="2021-05-21T16:58:25.751" v="3798" actId="164"/>
          <ac:picMkLst>
            <pc:docMk/>
            <pc:sldMk cId="3145637976" sldId="268"/>
            <ac:picMk id="117" creationId="{E3DE838B-D6D1-4AB6-ADE7-C6D29C994B00}"/>
          </ac:picMkLst>
        </pc:picChg>
        <pc:picChg chg="mod">
          <ac:chgData name="Manasweeta Angane" userId="05da2731-9352-4b35-b713-60351f56afbd" providerId="ADAL" clId="{D444FAE6-B328-4AB8-9A10-764831A715E0}" dt="2021-05-21T17:08:11.907" v="3976" actId="1036"/>
          <ac:picMkLst>
            <pc:docMk/>
            <pc:sldMk cId="3145637976" sldId="268"/>
            <ac:picMk id="119" creationId="{8266D51C-5B54-453C-9811-ECCC4E2CB7E9}"/>
          </ac:picMkLst>
        </pc:picChg>
        <pc:picChg chg="del mod">
          <ac:chgData name="Manasweeta Angane" userId="05da2731-9352-4b35-b713-60351f56afbd" providerId="ADAL" clId="{D444FAE6-B328-4AB8-9A10-764831A715E0}" dt="2021-05-21T17:05:36.363" v="3927" actId="478"/>
          <ac:picMkLst>
            <pc:docMk/>
            <pc:sldMk cId="3145637976" sldId="268"/>
            <ac:picMk id="120" creationId="{765830AB-F831-4893-8F1F-E62E9EB0DE10}"/>
          </ac:picMkLst>
        </pc:picChg>
        <pc:picChg chg="mod">
          <ac:chgData name="Manasweeta Angane" userId="05da2731-9352-4b35-b713-60351f56afbd" providerId="ADAL" clId="{D444FAE6-B328-4AB8-9A10-764831A715E0}" dt="2021-05-21T17:01:34.921" v="3868" actId="1036"/>
          <ac:picMkLst>
            <pc:docMk/>
            <pc:sldMk cId="3145637976" sldId="268"/>
            <ac:picMk id="121" creationId="{A699C752-50E6-4562-8EDA-0EBA9EBD69E6}"/>
          </ac:picMkLst>
        </pc:picChg>
        <pc:picChg chg="mod">
          <ac:chgData name="Manasweeta Angane" userId="05da2731-9352-4b35-b713-60351f56afbd" providerId="ADAL" clId="{D444FAE6-B328-4AB8-9A10-764831A715E0}" dt="2021-05-21T17:01:40.848" v="3906" actId="1035"/>
          <ac:picMkLst>
            <pc:docMk/>
            <pc:sldMk cId="3145637976" sldId="268"/>
            <ac:picMk id="122" creationId="{AA92527F-8035-4404-84E0-045D401AC189}"/>
          </ac:picMkLst>
        </pc:picChg>
        <pc:picChg chg="mod">
          <ac:chgData name="Manasweeta Angane" userId="05da2731-9352-4b35-b713-60351f56afbd" providerId="ADAL" clId="{D444FAE6-B328-4AB8-9A10-764831A715E0}" dt="2021-05-21T17:08:11.907" v="3976" actId="1036"/>
          <ac:picMkLst>
            <pc:docMk/>
            <pc:sldMk cId="3145637976" sldId="268"/>
            <ac:picMk id="123" creationId="{C987DDFD-24DA-47A5-9660-AF7B1759AFD5}"/>
          </ac:picMkLst>
        </pc:picChg>
        <pc:picChg chg="mod">
          <ac:chgData name="Manasweeta Angane" userId="05da2731-9352-4b35-b713-60351f56afbd" providerId="ADAL" clId="{D444FAE6-B328-4AB8-9A10-764831A715E0}" dt="2021-05-21T17:08:30.472" v="4013" actId="1036"/>
          <ac:picMkLst>
            <pc:docMk/>
            <pc:sldMk cId="3145637976" sldId="268"/>
            <ac:picMk id="124" creationId="{48E1E8CB-8408-49CE-96CB-394C698E5CE0}"/>
          </ac:picMkLst>
        </pc:picChg>
        <pc:picChg chg="add mod">
          <ac:chgData name="Manasweeta Angane" userId="05da2731-9352-4b35-b713-60351f56afbd" providerId="ADAL" clId="{D444FAE6-B328-4AB8-9A10-764831A715E0}" dt="2021-05-21T17:07:35.272" v="3945" actId="1076"/>
          <ac:picMkLst>
            <pc:docMk/>
            <pc:sldMk cId="3145637976" sldId="268"/>
            <ac:picMk id="125" creationId="{9B17EEF0-E6EF-4DA2-A876-AAB9102F32DA}"/>
          </ac:picMkLst>
        </pc:picChg>
        <pc:picChg chg="add mod">
          <ac:chgData name="Manasweeta Angane" userId="05da2731-9352-4b35-b713-60351f56afbd" providerId="ADAL" clId="{D444FAE6-B328-4AB8-9A10-764831A715E0}" dt="2021-05-21T17:04:27.228" v="3916" actId="164"/>
          <ac:picMkLst>
            <pc:docMk/>
            <pc:sldMk cId="3145637976" sldId="268"/>
            <ac:picMk id="126" creationId="{1D9453B5-ACFA-41B6-AD30-7C67EBBFAA8D}"/>
          </ac:picMkLst>
        </pc:picChg>
        <pc:picChg chg="add mod">
          <ac:chgData name="Manasweeta Angane" userId="05da2731-9352-4b35-b713-60351f56afbd" providerId="ADAL" clId="{D444FAE6-B328-4AB8-9A10-764831A715E0}" dt="2021-05-21T17:04:27.228" v="3916" actId="164"/>
          <ac:picMkLst>
            <pc:docMk/>
            <pc:sldMk cId="3145637976" sldId="268"/>
            <ac:picMk id="127" creationId="{D57632DB-9A15-4173-971E-D8569C8DECF1}"/>
          </ac:picMkLst>
        </pc:picChg>
        <pc:picChg chg="add mod">
          <ac:chgData name="Manasweeta Angane" userId="05da2731-9352-4b35-b713-60351f56afbd" providerId="ADAL" clId="{D444FAE6-B328-4AB8-9A10-764831A715E0}" dt="2021-05-21T17:09:24.922" v="4167" actId="1038"/>
          <ac:picMkLst>
            <pc:docMk/>
            <pc:sldMk cId="3145637976" sldId="268"/>
            <ac:picMk id="128" creationId="{1F09F4B5-BE47-4D8B-A8A9-38F04D8F33A0}"/>
          </ac:picMkLst>
        </pc:picChg>
        <pc:picChg chg="add mod">
          <ac:chgData name="Manasweeta Angane" userId="05da2731-9352-4b35-b713-60351f56afbd" providerId="ADAL" clId="{D444FAE6-B328-4AB8-9A10-764831A715E0}" dt="2021-05-21T17:10:36.473" v="4169" actId="164"/>
          <ac:picMkLst>
            <pc:docMk/>
            <pc:sldMk cId="3145637976" sldId="268"/>
            <ac:picMk id="129" creationId="{6110A799-576F-4B76-B552-AEE3F142F0C7}"/>
          </ac:picMkLst>
        </pc:picChg>
        <pc:picChg chg="add mod">
          <ac:chgData name="Manasweeta Angane" userId="05da2731-9352-4b35-b713-60351f56afbd" providerId="ADAL" clId="{D444FAE6-B328-4AB8-9A10-764831A715E0}" dt="2021-05-21T17:05:20.057" v="3925" actId="1076"/>
          <ac:picMkLst>
            <pc:docMk/>
            <pc:sldMk cId="3145637976" sldId="268"/>
            <ac:picMk id="130" creationId="{89ADDBA9-E143-4048-8131-22EE00C0C031}"/>
          </ac:picMkLst>
        </pc:picChg>
        <pc:picChg chg="add mod">
          <ac:chgData name="Manasweeta Angane" userId="05da2731-9352-4b35-b713-60351f56afbd" providerId="ADAL" clId="{D444FAE6-B328-4AB8-9A10-764831A715E0}" dt="2021-05-21T17:07:53.446" v="3949" actId="1076"/>
          <ac:picMkLst>
            <pc:docMk/>
            <pc:sldMk cId="3145637976" sldId="268"/>
            <ac:picMk id="131" creationId="{DBE65334-0AF4-44BE-84C1-2F1B7E2B7E11}"/>
          </ac:picMkLst>
        </pc:picChg>
        <pc:picChg chg="add mod">
          <ac:chgData name="Manasweeta Angane" userId="05da2731-9352-4b35-b713-60351f56afbd" providerId="ADAL" clId="{D444FAE6-B328-4AB8-9A10-764831A715E0}" dt="2021-05-21T17:10:36.473" v="4169" actId="164"/>
          <ac:picMkLst>
            <pc:docMk/>
            <pc:sldMk cId="3145637976" sldId="268"/>
            <ac:picMk id="132" creationId="{E3155331-5D9B-4813-A963-2CA6AC52C304}"/>
          </ac:picMkLst>
        </pc:picChg>
        <pc:picChg chg="mod">
          <ac:chgData name="Manasweeta Angane" userId="05da2731-9352-4b35-b713-60351f56afbd" providerId="ADAL" clId="{D444FAE6-B328-4AB8-9A10-764831A715E0}" dt="2021-05-21T17:10:42.670" v="4170"/>
          <ac:picMkLst>
            <pc:docMk/>
            <pc:sldMk cId="3145637976" sldId="268"/>
            <ac:picMk id="137" creationId="{DCC05991-7C1B-4B58-9C17-489D548BAAAF}"/>
          </ac:picMkLst>
        </pc:picChg>
        <pc:picChg chg="mod">
          <ac:chgData name="Manasweeta Angane" userId="05da2731-9352-4b35-b713-60351f56afbd" providerId="ADAL" clId="{D444FAE6-B328-4AB8-9A10-764831A715E0}" dt="2021-05-21T17:10:42.670" v="4170"/>
          <ac:picMkLst>
            <pc:docMk/>
            <pc:sldMk cId="3145637976" sldId="268"/>
            <ac:picMk id="138" creationId="{3DAD79E4-20DD-4787-89A8-1E91A41E7BC9}"/>
          </ac:picMkLst>
        </pc:picChg>
        <pc:picChg chg="mod">
          <ac:chgData name="Manasweeta Angane" userId="05da2731-9352-4b35-b713-60351f56afbd" providerId="ADAL" clId="{D444FAE6-B328-4AB8-9A10-764831A715E0}" dt="2021-05-21T17:10:42.670" v="4170"/>
          <ac:picMkLst>
            <pc:docMk/>
            <pc:sldMk cId="3145637976" sldId="268"/>
            <ac:picMk id="139" creationId="{68F7618E-4F34-4AF7-8DE4-F10FA7ADA34B}"/>
          </ac:picMkLst>
        </pc:picChg>
        <pc:picChg chg="mod">
          <ac:chgData name="Manasweeta Angane" userId="05da2731-9352-4b35-b713-60351f56afbd" providerId="ADAL" clId="{D444FAE6-B328-4AB8-9A10-764831A715E0}" dt="2021-05-21T17:10:42.670" v="4170"/>
          <ac:picMkLst>
            <pc:docMk/>
            <pc:sldMk cId="3145637976" sldId="268"/>
            <ac:picMk id="140" creationId="{DD8DBEC0-C453-41ED-B037-EAA071D3B981}"/>
          </ac:picMkLst>
        </pc:picChg>
        <pc:picChg chg="mod">
          <ac:chgData name="Manasweeta Angane" userId="05da2731-9352-4b35-b713-60351f56afbd" providerId="ADAL" clId="{D444FAE6-B328-4AB8-9A10-764831A715E0}" dt="2021-05-21T17:10:42.670" v="4170"/>
          <ac:picMkLst>
            <pc:docMk/>
            <pc:sldMk cId="3145637976" sldId="268"/>
            <ac:picMk id="141" creationId="{95081022-6449-4CD6-BC05-4AEC7BCDFE7E}"/>
          </ac:picMkLst>
        </pc:picChg>
        <pc:picChg chg="mod">
          <ac:chgData name="Manasweeta Angane" userId="05da2731-9352-4b35-b713-60351f56afbd" providerId="ADAL" clId="{D444FAE6-B328-4AB8-9A10-764831A715E0}" dt="2021-05-21T17:10:42.670" v="4170"/>
          <ac:picMkLst>
            <pc:docMk/>
            <pc:sldMk cId="3145637976" sldId="268"/>
            <ac:picMk id="142" creationId="{B1FC479E-E8B1-451B-9D14-578581ABB629}"/>
          </ac:picMkLst>
        </pc:picChg>
        <pc:picChg chg="mod">
          <ac:chgData name="Manasweeta Angane" userId="05da2731-9352-4b35-b713-60351f56afbd" providerId="ADAL" clId="{D444FAE6-B328-4AB8-9A10-764831A715E0}" dt="2021-05-21T17:10:42.670" v="4170"/>
          <ac:picMkLst>
            <pc:docMk/>
            <pc:sldMk cId="3145637976" sldId="268"/>
            <ac:picMk id="143" creationId="{B30E3754-EB3B-4F1C-BEB2-BA27A7330096}"/>
          </ac:picMkLst>
        </pc:picChg>
        <pc:picChg chg="mod">
          <ac:chgData name="Manasweeta Angane" userId="05da2731-9352-4b35-b713-60351f56afbd" providerId="ADAL" clId="{D444FAE6-B328-4AB8-9A10-764831A715E0}" dt="2021-05-21T17:10:42.670" v="4170"/>
          <ac:picMkLst>
            <pc:docMk/>
            <pc:sldMk cId="3145637976" sldId="268"/>
            <ac:picMk id="144" creationId="{E56B0820-9398-45F5-AEEA-55D044250757}"/>
          </ac:picMkLst>
        </pc:picChg>
        <pc:picChg chg="mod">
          <ac:chgData name="Manasweeta Angane" userId="05da2731-9352-4b35-b713-60351f56afbd" providerId="ADAL" clId="{D444FAE6-B328-4AB8-9A10-764831A715E0}" dt="2021-05-21T17:10:42.670" v="4170"/>
          <ac:picMkLst>
            <pc:docMk/>
            <pc:sldMk cId="3145637976" sldId="268"/>
            <ac:picMk id="145" creationId="{4FC342F3-FA02-4EFD-9371-B64062892C0B}"/>
          </ac:picMkLst>
        </pc:picChg>
        <pc:picChg chg="mod">
          <ac:chgData name="Manasweeta Angane" userId="05da2731-9352-4b35-b713-60351f56afbd" providerId="ADAL" clId="{D444FAE6-B328-4AB8-9A10-764831A715E0}" dt="2021-05-21T17:10:42.670" v="4170"/>
          <ac:picMkLst>
            <pc:docMk/>
            <pc:sldMk cId="3145637976" sldId="268"/>
            <ac:picMk id="146" creationId="{934BF055-510B-42BB-BF92-F794EF1AC248}"/>
          </ac:picMkLst>
        </pc:picChg>
        <pc:picChg chg="mod">
          <ac:chgData name="Manasweeta Angane" userId="05da2731-9352-4b35-b713-60351f56afbd" providerId="ADAL" clId="{D444FAE6-B328-4AB8-9A10-764831A715E0}" dt="2021-05-21T17:10:42.670" v="4170"/>
          <ac:picMkLst>
            <pc:docMk/>
            <pc:sldMk cId="3145637976" sldId="268"/>
            <ac:picMk id="147" creationId="{AA821B60-2069-4B11-8364-5F82BD721EF6}"/>
          </ac:picMkLst>
        </pc:picChg>
        <pc:picChg chg="mod">
          <ac:chgData name="Manasweeta Angane" userId="05da2731-9352-4b35-b713-60351f56afbd" providerId="ADAL" clId="{D444FAE6-B328-4AB8-9A10-764831A715E0}" dt="2021-05-21T17:10:42.670" v="4170"/>
          <ac:picMkLst>
            <pc:docMk/>
            <pc:sldMk cId="3145637976" sldId="268"/>
            <ac:picMk id="148" creationId="{83DB76E7-9BF5-4494-8CBA-A97A3E159A08}"/>
          </ac:picMkLst>
        </pc:picChg>
        <pc:picChg chg="mod">
          <ac:chgData name="Manasweeta Angane" userId="05da2731-9352-4b35-b713-60351f56afbd" providerId="ADAL" clId="{D444FAE6-B328-4AB8-9A10-764831A715E0}" dt="2021-05-21T17:10:42.670" v="4170"/>
          <ac:picMkLst>
            <pc:docMk/>
            <pc:sldMk cId="3145637976" sldId="268"/>
            <ac:picMk id="149" creationId="{6A215709-DD33-4D7D-B125-36D301E187B1}"/>
          </ac:picMkLst>
        </pc:picChg>
        <pc:picChg chg="mod">
          <ac:chgData name="Manasweeta Angane" userId="05da2731-9352-4b35-b713-60351f56afbd" providerId="ADAL" clId="{D444FAE6-B328-4AB8-9A10-764831A715E0}" dt="2021-05-21T17:10:42.670" v="4170"/>
          <ac:picMkLst>
            <pc:docMk/>
            <pc:sldMk cId="3145637976" sldId="268"/>
            <ac:picMk id="150" creationId="{A435353C-9E86-47C2-9FC0-8A2D7EE0D891}"/>
          </ac:picMkLst>
        </pc:picChg>
        <pc:picChg chg="mod">
          <ac:chgData name="Manasweeta Angane" userId="05da2731-9352-4b35-b713-60351f56afbd" providerId="ADAL" clId="{D444FAE6-B328-4AB8-9A10-764831A715E0}" dt="2021-05-21T17:10:42.670" v="4170"/>
          <ac:picMkLst>
            <pc:docMk/>
            <pc:sldMk cId="3145637976" sldId="268"/>
            <ac:picMk id="151" creationId="{7DA680C1-1BFB-4CA2-9DC7-15DD1FE7DB60}"/>
          </ac:picMkLst>
        </pc:picChg>
        <pc:picChg chg="del">
          <ac:chgData name="Manasweeta Angane" userId="05da2731-9352-4b35-b713-60351f56afbd" providerId="ADAL" clId="{D444FAE6-B328-4AB8-9A10-764831A715E0}" dt="2021-05-21T11:15:10.367" v="2796" actId="478"/>
          <ac:picMkLst>
            <pc:docMk/>
            <pc:sldMk cId="3145637976" sldId="268"/>
            <ac:picMk id="1026" creationId="{137C4FFD-2974-4454-B897-C812188AA1E5}"/>
          </ac:picMkLst>
        </pc:picChg>
      </pc:sldChg>
      <pc:sldChg chg="new del">
        <pc:chgData name="Manasweeta Angane" userId="05da2731-9352-4b35-b713-60351f56afbd" providerId="ADAL" clId="{D444FAE6-B328-4AB8-9A10-764831A715E0}" dt="2021-05-04T10:17:58.731" v="68" actId="680"/>
        <pc:sldMkLst>
          <pc:docMk/>
          <pc:sldMk cId="3644999890" sldId="268"/>
        </pc:sldMkLst>
      </pc:sldChg>
      <pc:sldChg chg="addSp delSp modSp new mod">
        <pc:chgData name="Manasweeta Angane" userId="05da2731-9352-4b35-b713-60351f56afbd" providerId="ADAL" clId="{D444FAE6-B328-4AB8-9A10-764831A715E0}" dt="2021-05-21T16:31:20.986" v="3553" actId="21"/>
        <pc:sldMkLst>
          <pc:docMk/>
          <pc:sldMk cId="1930498660" sldId="269"/>
        </pc:sldMkLst>
        <pc:grpChg chg="add del mod">
          <ac:chgData name="Manasweeta Angane" userId="05da2731-9352-4b35-b713-60351f56afbd" providerId="ADAL" clId="{D444FAE6-B328-4AB8-9A10-764831A715E0}" dt="2021-05-21T16:31:20.986" v="3553" actId="21"/>
          <ac:grpSpMkLst>
            <pc:docMk/>
            <pc:sldMk cId="1930498660" sldId="269"/>
            <ac:grpSpMk id="20" creationId="{C4888A1E-CCC9-43E2-A722-586B81B758EE}"/>
          </ac:grpSpMkLst>
        </pc:grpChg>
        <pc:grpChg chg="mod">
          <ac:chgData name="Manasweeta Angane" userId="05da2731-9352-4b35-b713-60351f56afbd" providerId="ADAL" clId="{D444FAE6-B328-4AB8-9A10-764831A715E0}" dt="2021-05-21T16:31:02.633" v="3552" actId="1076"/>
          <ac:grpSpMkLst>
            <pc:docMk/>
            <pc:sldMk cId="1930498660" sldId="269"/>
            <ac:grpSpMk id="33" creationId="{FA855E5E-174B-42DD-9329-2A62AEC50920}"/>
          </ac:grpSpMkLst>
        </pc:grpChg>
        <pc:picChg chg="add del mod modCrop">
          <ac:chgData name="Manasweeta Angane" userId="05da2731-9352-4b35-b713-60351f56afbd" providerId="ADAL" clId="{D444FAE6-B328-4AB8-9A10-764831A715E0}" dt="2021-05-21T16:23:18.824" v="3483" actId="478"/>
          <ac:picMkLst>
            <pc:docMk/>
            <pc:sldMk cId="1930498660" sldId="269"/>
            <ac:picMk id="2" creationId="{ECA2290E-03F6-4CF8-BD9D-30BBC453657C}"/>
          </ac:picMkLst>
        </pc:picChg>
        <pc:picChg chg="add mod modCrop">
          <ac:chgData name="Manasweeta Angane" userId="05da2731-9352-4b35-b713-60351f56afbd" providerId="ADAL" clId="{D444FAE6-B328-4AB8-9A10-764831A715E0}" dt="2021-05-21T16:29:16.223" v="3542" actId="1076"/>
          <ac:picMkLst>
            <pc:docMk/>
            <pc:sldMk cId="1930498660" sldId="269"/>
            <ac:picMk id="3" creationId="{018A899A-E6FD-46D8-A517-A3E486D17F99}"/>
          </ac:picMkLst>
        </pc:picChg>
        <pc:picChg chg="add mod">
          <ac:chgData name="Manasweeta Angane" userId="05da2731-9352-4b35-b713-60351f56afbd" providerId="ADAL" clId="{D444FAE6-B328-4AB8-9A10-764831A715E0}" dt="2021-05-21T15:53:45.654" v="2978" actId="1076"/>
          <ac:picMkLst>
            <pc:docMk/>
            <pc:sldMk cId="1930498660" sldId="269"/>
            <ac:picMk id="6" creationId="{106115F6-A43C-46EE-9953-F5D73215E8B3}"/>
          </ac:picMkLst>
        </pc:picChg>
        <pc:picChg chg="add mod">
          <ac:chgData name="Manasweeta Angane" userId="05da2731-9352-4b35-b713-60351f56afbd" providerId="ADAL" clId="{D444FAE6-B328-4AB8-9A10-764831A715E0}" dt="2021-05-21T16:08:56.321" v="3178" actId="1076"/>
          <ac:picMkLst>
            <pc:docMk/>
            <pc:sldMk cId="1930498660" sldId="269"/>
            <ac:picMk id="7" creationId="{B394809B-2E52-4B71-B922-6F30608E557F}"/>
          </ac:picMkLst>
        </pc:picChg>
        <pc:picChg chg="add mod">
          <ac:chgData name="Manasweeta Angane" userId="05da2731-9352-4b35-b713-60351f56afbd" providerId="ADAL" clId="{D444FAE6-B328-4AB8-9A10-764831A715E0}" dt="2021-05-21T16:08:31.765" v="3168" actId="1076"/>
          <ac:picMkLst>
            <pc:docMk/>
            <pc:sldMk cId="1930498660" sldId="269"/>
            <ac:picMk id="8" creationId="{C9742DAC-83FF-4023-B48E-A0F2B6D17F68}"/>
          </ac:picMkLst>
        </pc:picChg>
        <pc:picChg chg="add mod">
          <ac:chgData name="Manasweeta Angane" userId="05da2731-9352-4b35-b713-60351f56afbd" providerId="ADAL" clId="{D444FAE6-B328-4AB8-9A10-764831A715E0}" dt="2021-05-21T16:08:38.942" v="3171" actId="1076"/>
          <ac:picMkLst>
            <pc:docMk/>
            <pc:sldMk cId="1930498660" sldId="269"/>
            <ac:picMk id="9" creationId="{CE246089-3FD7-4316-AE4F-9722721652E3}"/>
          </ac:picMkLst>
        </pc:picChg>
        <pc:picChg chg="add mod">
          <ac:chgData name="Manasweeta Angane" userId="05da2731-9352-4b35-b713-60351f56afbd" providerId="ADAL" clId="{D444FAE6-B328-4AB8-9A10-764831A715E0}" dt="2021-05-21T16:08:46.323" v="3174" actId="1076"/>
          <ac:picMkLst>
            <pc:docMk/>
            <pc:sldMk cId="1930498660" sldId="269"/>
            <ac:picMk id="10" creationId="{4F9E3F00-AA9D-42EB-ABDA-67A188BF71D4}"/>
          </ac:picMkLst>
        </pc:picChg>
        <pc:picChg chg="add mod">
          <ac:chgData name="Manasweeta Angane" userId="05da2731-9352-4b35-b713-60351f56afbd" providerId="ADAL" clId="{D444FAE6-B328-4AB8-9A10-764831A715E0}" dt="2021-05-21T16:08:53.443" v="3177" actId="1076"/>
          <ac:picMkLst>
            <pc:docMk/>
            <pc:sldMk cId="1930498660" sldId="269"/>
            <ac:picMk id="11" creationId="{41CAE1C8-50D0-4CCB-924A-B199676D6F84}"/>
          </ac:picMkLst>
        </pc:picChg>
        <pc:picChg chg="add mod">
          <ac:chgData name="Manasweeta Angane" userId="05da2731-9352-4b35-b713-60351f56afbd" providerId="ADAL" clId="{D444FAE6-B328-4AB8-9A10-764831A715E0}" dt="2021-05-21T16:09:06.739" v="3181" actId="1076"/>
          <ac:picMkLst>
            <pc:docMk/>
            <pc:sldMk cId="1930498660" sldId="269"/>
            <ac:picMk id="12" creationId="{04B730A9-8613-413B-B738-E154E80C6B50}"/>
          </ac:picMkLst>
        </pc:picChg>
        <pc:picChg chg="add mod">
          <ac:chgData name="Manasweeta Angane" userId="05da2731-9352-4b35-b713-60351f56afbd" providerId="ADAL" clId="{D444FAE6-B328-4AB8-9A10-764831A715E0}" dt="2021-05-21T16:09:14.564" v="3184" actId="1076"/>
          <ac:picMkLst>
            <pc:docMk/>
            <pc:sldMk cId="1930498660" sldId="269"/>
            <ac:picMk id="13" creationId="{1543F01A-C716-4C39-BFA1-3CFE4382BB96}"/>
          </ac:picMkLst>
        </pc:picChg>
        <pc:picChg chg="add mod">
          <ac:chgData name="Manasweeta Angane" userId="05da2731-9352-4b35-b713-60351f56afbd" providerId="ADAL" clId="{D444FAE6-B328-4AB8-9A10-764831A715E0}" dt="2021-05-21T16:17:05.823" v="3293" actId="1076"/>
          <ac:picMkLst>
            <pc:docMk/>
            <pc:sldMk cId="1930498660" sldId="269"/>
            <ac:picMk id="14" creationId="{83768D81-DBA1-4356-8528-B6730BCE8D34}"/>
          </ac:picMkLst>
        </pc:picChg>
        <pc:picChg chg="add mod">
          <ac:chgData name="Manasweeta Angane" userId="05da2731-9352-4b35-b713-60351f56afbd" providerId="ADAL" clId="{D444FAE6-B328-4AB8-9A10-764831A715E0}" dt="2021-05-21T16:17:13.699" v="3296" actId="1076"/>
          <ac:picMkLst>
            <pc:docMk/>
            <pc:sldMk cId="1930498660" sldId="269"/>
            <ac:picMk id="15" creationId="{63F5CD3A-CB8F-41B4-ABEA-3DECCA1E91E7}"/>
          </ac:picMkLst>
        </pc:picChg>
        <pc:picChg chg="add mod">
          <ac:chgData name="Manasweeta Angane" userId="05da2731-9352-4b35-b713-60351f56afbd" providerId="ADAL" clId="{D444FAE6-B328-4AB8-9A10-764831A715E0}" dt="2021-05-21T16:17:21.397" v="3299" actId="1076"/>
          <ac:picMkLst>
            <pc:docMk/>
            <pc:sldMk cId="1930498660" sldId="269"/>
            <ac:picMk id="16" creationId="{49ABCBDF-FF0B-4F91-89DE-F9807A6E4A68}"/>
          </ac:picMkLst>
        </pc:picChg>
        <pc:picChg chg="add mod">
          <ac:chgData name="Manasweeta Angane" userId="05da2731-9352-4b35-b713-60351f56afbd" providerId="ADAL" clId="{D444FAE6-B328-4AB8-9A10-764831A715E0}" dt="2021-05-21T16:17:28.901" v="3302" actId="1076"/>
          <ac:picMkLst>
            <pc:docMk/>
            <pc:sldMk cId="1930498660" sldId="269"/>
            <ac:picMk id="17" creationId="{0A64311B-1908-4868-B664-3214C37055DA}"/>
          </ac:picMkLst>
        </pc:picChg>
        <pc:picChg chg="mod">
          <ac:chgData name="Manasweeta Angane" userId="05da2731-9352-4b35-b713-60351f56afbd" providerId="ADAL" clId="{D444FAE6-B328-4AB8-9A10-764831A715E0}" dt="2021-05-21T16:31:02.633" v="3552" actId="1076"/>
          <ac:picMkLst>
            <pc:docMk/>
            <pc:sldMk cId="1930498660" sldId="269"/>
            <ac:picMk id="21" creationId="{9FA05F9C-8D3E-4087-9EEB-B8BB22482532}"/>
          </ac:picMkLst>
        </pc:picChg>
        <pc:picChg chg="mod">
          <ac:chgData name="Manasweeta Angane" userId="05da2731-9352-4b35-b713-60351f56afbd" providerId="ADAL" clId="{D444FAE6-B328-4AB8-9A10-764831A715E0}" dt="2021-05-21T16:31:02.633" v="3552" actId="1076"/>
          <ac:picMkLst>
            <pc:docMk/>
            <pc:sldMk cId="1930498660" sldId="269"/>
            <ac:picMk id="22" creationId="{C0092D5B-A749-4E4D-9A16-65B030B6A32A}"/>
          </ac:picMkLst>
        </pc:picChg>
        <pc:picChg chg="mod">
          <ac:chgData name="Manasweeta Angane" userId="05da2731-9352-4b35-b713-60351f56afbd" providerId="ADAL" clId="{D444FAE6-B328-4AB8-9A10-764831A715E0}" dt="2021-05-21T16:31:02.633" v="3552" actId="1076"/>
          <ac:picMkLst>
            <pc:docMk/>
            <pc:sldMk cId="1930498660" sldId="269"/>
            <ac:picMk id="23" creationId="{6E514C7B-8E12-474F-8368-719C0C44429C}"/>
          </ac:picMkLst>
        </pc:picChg>
        <pc:picChg chg="mod">
          <ac:chgData name="Manasweeta Angane" userId="05da2731-9352-4b35-b713-60351f56afbd" providerId="ADAL" clId="{D444FAE6-B328-4AB8-9A10-764831A715E0}" dt="2021-05-21T16:31:02.633" v="3552" actId="1076"/>
          <ac:picMkLst>
            <pc:docMk/>
            <pc:sldMk cId="1930498660" sldId="269"/>
            <ac:picMk id="24" creationId="{E3740BDD-C5FF-4689-A35A-D7616E86668B}"/>
          </ac:picMkLst>
        </pc:picChg>
        <pc:picChg chg="mod">
          <ac:chgData name="Manasweeta Angane" userId="05da2731-9352-4b35-b713-60351f56afbd" providerId="ADAL" clId="{D444FAE6-B328-4AB8-9A10-764831A715E0}" dt="2021-05-21T16:31:02.633" v="3552" actId="1076"/>
          <ac:picMkLst>
            <pc:docMk/>
            <pc:sldMk cId="1930498660" sldId="269"/>
            <ac:picMk id="25" creationId="{AD31491A-DAF5-4A67-A0EF-5942CFABED41}"/>
          </ac:picMkLst>
        </pc:picChg>
        <pc:picChg chg="mod">
          <ac:chgData name="Manasweeta Angane" userId="05da2731-9352-4b35-b713-60351f56afbd" providerId="ADAL" clId="{D444FAE6-B328-4AB8-9A10-764831A715E0}" dt="2021-05-21T16:31:02.633" v="3552" actId="1076"/>
          <ac:picMkLst>
            <pc:docMk/>
            <pc:sldMk cId="1930498660" sldId="269"/>
            <ac:picMk id="26" creationId="{E1A04FCB-3D7B-4D2F-B47A-325DC2F0CB7F}"/>
          </ac:picMkLst>
        </pc:picChg>
        <pc:picChg chg="mod">
          <ac:chgData name="Manasweeta Angane" userId="05da2731-9352-4b35-b713-60351f56afbd" providerId="ADAL" clId="{D444FAE6-B328-4AB8-9A10-764831A715E0}" dt="2021-05-21T16:31:02.633" v="3552" actId="1076"/>
          <ac:picMkLst>
            <pc:docMk/>
            <pc:sldMk cId="1930498660" sldId="269"/>
            <ac:picMk id="27" creationId="{838DD0A3-4DF2-4C56-AA07-50443340ECD2}"/>
          </ac:picMkLst>
        </pc:picChg>
        <pc:picChg chg="mod">
          <ac:chgData name="Manasweeta Angane" userId="05da2731-9352-4b35-b713-60351f56afbd" providerId="ADAL" clId="{D444FAE6-B328-4AB8-9A10-764831A715E0}" dt="2021-05-21T16:31:02.633" v="3552" actId="1076"/>
          <ac:picMkLst>
            <pc:docMk/>
            <pc:sldMk cId="1930498660" sldId="269"/>
            <ac:picMk id="28" creationId="{B673E5AC-A470-4A86-B591-786515A8AED2}"/>
          </ac:picMkLst>
        </pc:picChg>
        <pc:picChg chg="mod">
          <ac:chgData name="Manasweeta Angane" userId="05da2731-9352-4b35-b713-60351f56afbd" providerId="ADAL" clId="{D444FAE6-B328-4AB8-9A10-764831A715E0}" dt="2021-05-21T16:31:02.633" v="3552" actId="1076"/>
          <ac:picMkLst>
            <pc:docMk/>
            <pc:sldMk cId="1930498660" sldId="269"/>
            <ac:picMk id="29" creationId="{10C2620B-7F16-40B8-BEC2-F8C0CD6741F2}"/>
          </ac:picMkLst>
        </pc:picChg>
        <pc:picChg chg="mod">
          <ac:chgData name="Manasweeta Angane" userId="05da2731-9352-4b35-b713-60351f56afbd" providerId="ADAL" clId="{D444FAE6-B328-4AB8-9A10-764831A715E0}" dt="2021-05-21T16:31:02.633" v="3552" actId="1076"/>
          <ac:picMkLst>
            <pc:docMk/>
            <pc:sldMk cId="1930498660" sldId="269"/>
            <ac:picMk id="30" creationId="{F73B2D89-A785-49EC-8A50-CE64A9A71949}"/>
          </ac:picMkLst>
        </pc:picChg>
        <pc:picChg chg="mod">
          <ac:chgData name="Manasweeta Angane" userId="05da2731-9352-4b35-b713-60351f56afbd" providerId="ADAL" clId="{D444FAE6-B328-4AB8-9A10-764831A715E0}" dt="2021-05-21T16:31:02.633" v="3552" actId="1076"/>
          <ac:picMkLst>
            <pc:docMk/>
            <pc:sldMk cId="1930498660" sldId="269"/>
            <ac:picMk id="31" creationId="{7C5CA9BD-7D8A-47B4-94A7-A2478FE5BE24}"/>
          </ac:picMkLst>
        </pc:picChg>
        <pc:picChg chg="mod">
          <ac:chgData name="Manasweeta Angane" userId="05da2731-9352-4b35-b713-60351f56afbd" providerId="ADAL" clId="{D444FAE6-B328-4AB8-9A10-764831A715E0}" dt="2021-05-21T16:31:02.633" v="3552" actId="1076"/>
          <ac:picMkLst>
            <pc:docMk/>
            <pc:sldMk cId="1930498660" sldId="269"/>
            <ac:picMk id="32" creationId="{5E8EAC4B-1755-4002-AA20-BE3AF2BB3B10}"/>
          </ac:picMkLst>
        </pc:picChg>
        <pc:picChg chg="mod">
          <ac:chgData name="Manasweeta Angane" userId="05da2731-9352-4b35-b713-60351f56afbd" providerId="ADAL" clId="{D444FAE6-B328-4AB8-9A10-764831A715E0}" dt="2021-05-21T16:31:02.633" v="3552" actId="1076"/>
          <ac:picMkLst>
            <pc:docMk/>
            <pc:sldMk cId="1930498660" sldId="269"/>
            <ac:picMk id="34" creationId="{1123726F-DEA9-492F-8110-3F3BC1CAD730}"/>
          </ac:picMkLst>
        </pc:picChg>
        <pc:picChg chg="mod">
          <ac:chgData name="Manasweeta Angane" userId="05da2731-9352-4b35-b713-60351f56afbd" providerId="ADAL" clId="{D444FAE6-B328-4AB8-9A10-764831A715E0}" dt="2021-05-21T16:31:02.633" v="3552" actId="1076"/>
          <ac:picMkLst>
            <pc:docMk/>
            <pc:sldMk cId="1930498660" sldId="269"/>
            <ac:picMk id="35" creationId="{365CE8AA-B5E3-48F4-A4B8-5B3FE245D07C}"/>
          </ac:picMkLst>
        </pc:picChg>
        <pc:picChg chg="mod">
          <ac:chgData name="Manasweeta Angane" userId="05da2731-9352-4b35-b713-60351f56afbd" providerId="ADAL" clId="{D444FAE6-B328-4AB8-9A10-764831A715E0}" dt="2021-05-21T16:31:02.633" v="3552" actId="1076"/>
          <ac:picMkLst>
            <pc:docMk/>
            <pc:sldMk cId="1930498660" sldId="269"/>
            <ac:picMk id="36" creationId="{D8913E8A-82B7-41A3-AC8C-972BBC5F3E83}"/>
          </ac:picMkLst>
        </pc:picChg>
        <pc:picChg chg="add mod">
          <ac:chgData name="Manasweeta Angane" userId="05da2731-9352-4b35-b713-60351f56afbd" providerId="ADAL" clId="{D444FAE6-B328-4AB8-9A10-764831A715E0}" dt="2021-05-21T15:44:53.036" v="2899" actId="1076"/>
          <ac:picMkLst>
            <pc:docMk/>
            <pc:sldMk cId="1930498660" sldId="269"/>
            <ac:picMk id="1026" creationId="{58ABC590-A7B8-442B-AA27-5522D6BE376A}"/>
          </ac:picMkLst>
        </pc:picChg>
        <pc:picChg chg="add mod">
          <ac:chgData name="Manasweeta Angane" userId="05da2731-9352-4b35-b713-60351f56afbd" providerId="ADAL" clId="{D444FAE6-B328-4AB8-9A10-764831A715E0}" dt="2021-05-21T15:46:15.935" v="2914" actId="1076"/>
          <ac:picMkLst>
            <pc:docMk/>
            <pc:sldMk cId="1930498660" sldId="269"/>
            <ac:picMk id="1028" creationId="{3F7D096B-9AD5-4200-90DE-7709DA068146}"/>
          </ac:picMkLst>
        </pc:picChg>
        <pc:picChg chg="add mod">
          <ac:chgData name="Manasweeta Angane" userId="05da2731-9352-4b35-b713-60351f56afbd" providerId="ADAL" clId="{D444FAE6-B328-4AB8-9A10-764831A715E0}" dt="2021-05-21T15:48:34.040" v="2948" actId="1076"/>
          <ac:picMkLst>
            <pc:docMk/>
            <pc:sldMk cId="1930498660" sldId="269"/>
            <ac:picMk id="1030" creationId="{930D383E-B4E8-4A31-BFF7-771761F0FC2D}"/>
          </ac:picMkLst>
        </pc:picChg>
        <pc:picChg chg="add del">
          <ac:chgData name="Manasweeta Angane" userId="05da2731-9352-4b35-b713-60351f56afbd" providerId="ADAL" clId="{D444FAE6-B328-4AB8-9A10-764831A715E0}" dt="2021-05-21T15:49:01.580" v="2952" actId="478"/>
          <ac:picMkLst>
            <pc:docMk/>
            <pc:sldMk cId="1930498660" sldId="269"/>
            <ac:picMk id="1032" creationId="{AF3325AA-D4DD-4509-A613-A32248468B3E}"/>
          </ac:picMkLst>
        </pc:picChg>
      </pc:sldChg>
      <pc:sldChg chg="new del">
        <pc:chgData name="Manasweeta Angane" userId="05da2731-9352-4b35-b713-60351f56afbd" providerId="ADAL" clId="{D444FAE6-B328-4AB8-9A10-764831A715E0}" dt="2021-05-04T10:17:58.184" v="67" actId="680"/>
        <pc:sldMkLst>
          <pc:docMk/>
          <pc:sldMk cId="3932699384" sldId="269"/>
        </pc:sldMkLst>
      </pc:sldChg>
      <pc:sldChg chg="new del">
        <pc:chgData name="Manasweeta Angane" userId="05da2731-9352-4b35-b713-60351f56afbd" providerId="ADAL" clId="{D444FAE6-B328-4AB8-9A10-764831A715E0}" dt="2021-05-04T10:17:57.884" v="66" actId="680"/>
        <pc:sldMkLst>
          <pc:docMk/>
          <pc:sldMk cId="1626561157" sldId="270"/>
        </pc:sldMkLst>
      </pc:sldChg>
      <pc:sldChg chg="addSp new">
        <pc:chgData name="Manasweeta Angane" userId="05da2731-9352-4b35-b713-60351f56afbd" providerId="ADAL" clId="{D444FAE6-B328-4AB8-9A10-764831A715E0}" dt="2021-05-21T15:48:56.983" v="2951"/>
        <pc:sldMkLst>
          <pc:docMk/>
          <pc:sldMk cId="3123405252" sldId="270"/>
        </pc:sldMkLst>
        <pc:picChg chg="add">
          <ac:chgData name="Manasweeta Angane" userId="05da2731-9352-4b35-b713-60351f56afbd" providerId="ADAL" clId="{D444FAE6-B328-4AB8-9A10-764831A715E0}" dt="2021-05-21T15:48:56.983" v="2951"/>
          <ac:picMkLst>
            <pc:docMk/>
            <pc:sldMk cId="3123405252" sldId="270"/>
            <ac:picMk id="2050" creationId="{5088B9A7-1079-4E93-A127-D97A98114FC8}"/>
          </ac:picMkLst>
        </pc:picChg>
      </pc:sldChg>
      <pc:sldChg chg="addSp delSp modSp new">
        <pc:chgData name="Manasweeta Angane" userId="05da2731-9352-4b35-b713-60351f56afbd" providerId="ADAL" clId="{D444FAE6-B328-4AB8-9A10-764831A715E0}" dt="2021-05-21T16:32:06.454" v="3712" actId="1037"/>
        <pc:sldMkLst>
          <pc:docMk/>
          <pc:sldMk cId="1781180117" sldId="271"/>
        </pc:sldMkLst>
        <pc:grpChg chg="add mod">
          <ac:chgData name="Manasweeta Angane" userId="05da2731-9352-4b35-b713-60351f56afbd" providerId="ADAL" clId="{D444FAE6-B328-4AB8-9A10-764831A715E0}" dt="2021-05-21T16:32:06.454" v="3712" actId="1037"/>
          <ac:grpSpMkLst>
            <pc:docMk/>
            <pc:sldMk cId="1781180117" sldId="271"/>
            <ac:grpSpMk id="7" creationId="{76E6C64D-FEDF-4990-82B8-84BAE456137A}"/>
          </ac:grpSpMkLst>
        </pc:grpChg>
        <pc:grpChg chg="mod">
          <ac:chgData name="Manasweeta Angane" userId="05da2731-9352-4b35-b713-60351f56afbd" providerId="ADAL" clId="{D444FAE6-B328-4AB8-9A10-764831A715E0}" dt="2021-05-21T16:32:06.454" v="3712" actId="1037"/>
          <ac:grpSpMkLst>
            <pc:docMk/>
            <pc:sldMk cId="1781180117" sldId="271"/>
            <ac:grpSpMk id="20" creationId="{92CA3099-332E-4A61-85C5-24EE99DCEA8E}"/>
          </ac:grpSpMkLst>
        </pc:grpChg>
        <pc:picChg chg="mod">
          <ac:chgData name="Manasweeta Angane" userId="05da2731-9352-4b35-b713-60351f56afbd" providerId="ADAL" clId="{D444FAE6-B328-4AB8-9A10-764831A715E0}" dt="2021-05-21T16:32:06.454" v="3712" actId="1037"/>
          <ac:picMkLst>
            <pc:docMk/>
            <pc:sldMk cId="1781180117" sldId="271"/>
            <ac:picMk id="8" creationId="{F95EDC07-C191-4D8A-BA51-66557CFF9945}"/>
          </ac:picMkLst>
        </pc:picChg>
        <pc:picChg chg="mod">
          <ac:chgData name="Manasweeta Angane" userId="05da2731-9352-4b35-b713-60351f56afbd" providerId="ADAL" clId="{D444FAE6-B328-4AB8-9A10-764831A715E0}" dt="2021-05-21T16:32:06.454" v="3712" actId="1037"/>
          <ac:picMkLst>
            <pc:docMk/>
            <pc:sldMk cId="1781180117" sldId="271"/>
            <ac:picMk id="9" creationId="{3A04B500-60BE-44F6-BEB0-EEA8E576CBB0}"/>
          </ac:picMkLst>
        </pc:picChg>
        <pc:picChg chg="mod">
          <ac:chgData name="Manasweeta Angane" userId="05da2731-9352-4b35-b713-60351f56afbd" providerId="ADAL" clId="{D444FAE6-B328-4AB8-9A10-764831A715E0}" dt="2021-05-21T16:32:06.454" v="3712" actId="1037"/>
          <ac:picMkLst>
            <pc:docMk/>
            <pc:sldMk cId="1781180117" sldId="271"/>
            <ac:picMk id="10" creationId="{A39207E0-2196-420D-867B-EEF37531CC7B}"/>
          </ac:picMkLst>
        </pc:picChg>
        <pc:picChg chg="mod">
          <ac:chgData name="Manasweeta Angane" userId="05da2731-9352-4b35-b713-60351f56afbd" providerId="ADAL" clId="{D444FAE6-B328-4AB8-9A10-764831A715E0}" dt="2021-05-21T16:32:06.454" v="3712" actId="1037"/>
          <ac:picMkLst>
            <pc:docMk/>
            <pc:sldMk cId="1781180117" sldId="271"/>
            <ac:picMk id="11" creationId="{BF08F329-756A-41BF-8A75-AA437694C066}"/>
          </ac:picMkLst>
        </pc:picChg>
        <pc:picChg chg="mod">
          <ac:chgData name="Manasweeta Angane" userId="05da2731-9352-4b35-b713-60351f56afbd" providerId="ADAL" clId="{D444FAE6-B328-4AB8-9A10-764831A715E0}" dt="2021-05-21T16:32:06.454" v="3712" actId="1037"/>
          <ac:picMkLst>
            <pc:docMk/>
            <pc:sldMk cId="1781180117" sldId="271"/>
            <ac:picMk id="12" creationId="{82AD8798-A676-4DAB-9F05-AFEB7B89076E}"/>
          </ac:picMkLst>
        </pc:picChg>
        <pc:picChg chg="mod">
          <ac:chgData name="Manasweeta Angane" userId="05da2731-9352-4b35-b713-60351f56afbd" providerId="ADAL" clId="{D444FAE6-B328-4AB8-9A10-764831A715E0}" dt="2021-05-21T16:32:06.454" v="3712" actId="1037"/>
          <ac:picMkLst>
            <pc:docMk/>
            <pc:sldMk cId="1781180117" sldId="271"/>
            <ac:picMk id="13" creationId="{1FEBEE22-2496-4B23-A3DA-B7FA55C37663}"/>
          </ac:picMkLst>
        </pc:picChg>
        <pc:picChg chg="mod">
          <ac:chgData name="Manasweeta Angane" userId="05da2731-9352-4b35-b713-60351f56afbd" providerId="ADAL" clId="{D444FAE6-B328-4AB8-9A10-764831A715E0}" dt="2021-05-21T16:32:06.454" v="3712" actId="1037"/>
          <ac:picMkLst>
            <pc:docMk/>
            <pc:sldMk cId="1781180117" sldId="271"/>
            <ac:picMk id="14" creationId="{37F0434A-7B1C-4283-B83D-290A52B8A609}"/>
          </ac:picMkLst>
        </pc:picChg>
        <pc:picChg chg="mod">
          <ac:chgData name="Manasweeta Angane" userId="05da2731-9352-4b35-b713-60351f56afbd" providerId="ADAL" clId="{D444FAE6-B328-4AB8-9A10-764831A715E0}" dt="2021-05-21T16:32:06.454" v="3712" actId="1037"/>
          <ac:picMkLst>
            <pc:docMk/>
            <pc:sldMk cId="1781180117" sldId="271"/>
            <ac:picMk id="15" creationId="{18D33480-43A3-44D7-BA7A-4AB555456799}"/>
          </ac:picMkLst>
        </pc:picChg>
        <pc:picChg chg="mod">
          <ac:chgData name="Manasweeta Angane" userId="05da2731-9352-4b35-b713-60351f56afbd" providerId="ADAL" clId="{D444FAE6-B328-4AB8-9A10-764831A715E0}" dt="2021-05-21T16:32:06.454" v="3712" actId="1037"/>
          <ac:picMkLst>
            <pc:docMk/>
            <pc:sldMk cId="1781180117" sldId="271"/>
            <ac:picMk id="16" creationId="{57D5D0D1-6623-44E5-AB8F-58782B386A86}"/>
          </ac:picMkLst>
        </pc:picChg>
        <pc:picChg chg="mod">
          <ac:chgData name="Manasweeta Angane" userId="05da2731-9352-4b35-b713-60351f56afbd" providerId="ADAL" clId="{D444FAE6-B328-4AB8-9A10-764831A715E0}" dt="2021-05-21T16:32:06.454" v="3712" actId="1037"/>
          <ac:picMkLst>
            <pc:docMk/>
            <pc:sldMk cId="1781180117" sldId="271"/>
            <ac:picMk id="17" creationId="{6DA2B64D-8DE3-4EC9-9BB8-76DCBC485321}"/>
          </ac:picMkLst>
        </pc:picChg>
        <pc:picChg chg="mod">
          <ac:chgData name="Manasweeta Angane" userId="05da2731-9352-4b35-b713-60351f56afbd" providerId="ADAL" clId="{D444FAE6-B328-4AB8-9A10-764831A715E0}" dt="2021-05-21T16:32:06.454" v="3712" actId="1037"/>
          <ac:picMkLst>
            <pc:docMk/>
            <pc:sldMk cId="1781180117" sldId="271"/>
            <ac:picMk id="18" creationId="{1B7A0AF5-37CA-40D4-9ECE-1BEA34620A11}"/>
          </ac:picMkLst>
        </pc:picChg>
        <pc:picChg chg="mod">
          <ac:chgData name="Manasweeta Angane" userId="05da2731-9352-4b35-b713-60351f56afbd" providerId="ADAL" clId="{D444FAE6-B328-4AB8-9A10-764831A715E0}" dt="2021-05-21T16:32:06.454" v="3712" actId="1037"/>
          <ac:picMkLst>
            <pc:docMk/>
            <pc:sldMk cId="1781180117" sldId="271"/>
            <ac:picMk id="19" creationId="{0D478ADA-43BE-4BF6-A7A6-286751BBA5CC}"/>
          </ac:picMkLst>
        </pc:picChg>
        <pc:picChg chg="mod">
          <ac:chgData name="Manasweeta Angane" userId="05da2731-9352-4b35-b713-60351f56afbd" providerId="ADAL" clId="{D444FAE6-B328-4AB8-9A10-764831A715E0}" dt="2021-05-21T16:32:06.454" v="3712" actId="1037"/>
          <ac:picMkLst>
            <pc:docMk/>
            <pc:sldMk cId="1781180117" sldId="271"/>
            <ac:picMk id="21" creationId="{95EB91DF-0F9F-4077-A340-C3AE33B0122D}"/>
          </ac:picMkLst>
        </pc:picChg>
        <pc:picChg chg="mod">
          <ac:chgData name="Manasweeta Angane" userId="05da2731-9352-4b35-b713-60351f56afbd" providerId="ADAL" clId="{D444FAE6-B328-4AB8-9A10-764831A715E0}" dt="2021-05-21T16:32:06.454" v="3712" actId="1037"/>
          <ac:picMkLst>
            <pc:docMk/>
            <pc:sldMk cId="1781180117" sldId="271"/>
            <ac:picMk id="22" creationId="{37F83028-F5C2-4AE5-84FB-AA72507576B8}"/>
          </ac:picMkLst>
        </pc:picChg>
        <pc:picChg chg="mod">
          <ac:chgData name="Manasweeta Angane" userId="05da2731-9352-4b35-b713-60351f56afbd" providerId="ADAL" clId="{D444FAE6-B328-4AB8-9A10-764831A715E0}" dt="2021-05-21T16:32:06.454" v="3712" actId="1037"/>
          <ac:picMkLst>
            <pc:docMk/>
            <pc:sldMk cId="1781180117" sldId="271"/>
            <ac:picMk id="23" creationId="{BCA409E6-CE34-4898-8BF9-10A3419DB873}"/>
          </ac:picMkLst>
        </pc:picChg>
        <pc:picChg chg="add del mod">
          <ac:chgData name="Manasweeta Angane" userId="05da2731-9352-4b35-b713-60351f56afbd" providerId="ADAL" clId="{D444FAE6-B328-4AB8-9A10-764831A715E0}" dt="2021-05-21T16:08:42.060" v="3172" actId="21"/>
          <ac:picMkLst>
            <pc:docMk/>
            <pc:sldMk cId="1781180117" sldId="271"/>
            <ac:picMk id="3074" creationId="{E5EBD7AC-C40D-4492-A8B1-6B5684170968}"/>
          </ac:picMkLst>
        </pc:picChg>
        <pc:picChg chg="add del mod">
          <ac:chgData name="Manasweeta Angane" userId="05da2731-9352-4b35-b713-60351f56afbd" providerId="ADAL" clId="{D444FAE6-B328-4AB8-9A10-764831A715E0}" dt="2021-05-21T16:09:01.146" v="3179" actId="21"/>
          <ac:picMkLst>
            <pc:docMk/>
            <pc:sldMk cId="1781180117" sldId="271"/>
            <ac:picMk id="3076" creationId="{3DE1E053-71B6-48E7-B468-91DD9FF38B69}"/>
          </ac:picMkLst>
        </pc:picChg>
        <pc:picChg chg="add del mod">
          <ac:chgData name="Manasweeta Angane" userId="05da2731-9352-4b35-b713-60351f56afbd" providerId="ADAL" clId="{D444FAE6-B328-4AB8-9A10-764831A715E0}" dt="2021-05-21T16:08:49.081" v="3175" actId="21"/>
          <ac:picMkLst>
            <pc:docMk/>
            <pc:sldMk cId="1781180117" sldId="271"/>
            <ac:picMk id="3078" creationId="{6C4B3A66-6DF4-4CDD-BD26-70E9CFAE80BA}"/>
          </ac:picMkLst>
        </pc:picChg>
        <pc:picChg chg="add del mod">
          <ac:chgData name="Manasweeta Angane" userId="05da2731-9352-4b35-b713-60351f56afbd" providerId="ADAL" clId="{D444FAE6-B328-4AB8-9A10-764831A715E0}" dt="2021-05-21T16:09:10.405" v="3182" actId="21"/>
          <ac:picMkLst>
            <pc:docMk/>
            <pc:sldMk cId="1781180117" sldId="271"/>
            <ac:picMk id="3080" creationId="{33E98BB8-1DEC-4A5D-BF1A-75C37A2DCB6E}"/>
          </ac:picMkLst>
        </pc:picChg>
        <pc:picChg chg="add del mod">
          <ac:chgData name="Manasweeta Angane" userId="05da2731-9352-4b35-b713-60351f56afbd" providerId="ADAL" clId="{D444FAE6-B328-4AB8-9A10-764831A715E0}" dt="2021-05-21T16:08:34.451" v="3169" actId="21"/>
          <ac:picMkLst>
            <pc:docMk/>
            <pc:sldMk cId="1781180117" sldId="271"/>
            <ac:picMk id="3082" creationId="{459B7B52-587D-454A-BA50-7DCC0A64B3F7}"/>
          </ac:picMkLst>
        </pc:picChg>
      </pc:sldChg>
      <pc:sldChg chg="new del">
        <pc:chgData name="Manasweeta Angane" userId="05da2731-9352-4b35-b713-60351f56afbd" providerId="ADAL" clId="{D444FAE6-B328-4AB8-9A10-764831A715E0}" dt="2021-05-04T10:17:57.634" v="65" actId="680"/>
        <pc:sldMkLst>
          <pc:docMk/>
          <pc:sldMk cId="3638852091" sldId="271"/>
        </pc:sldMkLst>
      </pc:sldChg>
      <pc:sldChg chg="new del">
        <pc:chgData name="Manasweeta Angane" userId="05da2731-9352-4b35-b713-60351f56afbd" providerId="ADAL" clId="{D444FAE6-B328-4AB8-9A10-764831A715E0}" dt="2021-05-04T10:17:57.394" v="64" actId="680"/>
        <pc:sldMkLst>
          <pc:docMk/>
          <pc:sldMk cId="909367417" sldId="272"/>
        </pc:sldMkLst>
      </pc:sldChg>
      <pc:sldChg chg="addSp new ord">
        <pc:chgData name="Manasweeta Angane" userId="05da2731-9352-4b35-b713-60351f56afbd" providerId="ADAL" clId="{D444FAE6-B328-4AB8-9A10-764831A715E0}" dt="2021-05-21T15:52:22.150" v="2958"/>
        <pc:sldMkLst>
          <pc:docMk/>
          <pc:sldMk cId="3044405353" sldId="272"/>
        </pc:sldMkLst>
        <pc:picChg chg="add">
          <ac:chgData name="Manasweeta Angane" userId="05da2731-9352-4b35-b713-60351f56afbd" providerId="ADAL" clId="{D444FAE6-B328-4AB8-9A10-764831A715E0}" dt="2021-05-21T15:52:22.150" v="2958"/>
          <ac:picMkLst>
            <pc:docMk/>
            <pc:sldMk cId="3044405353" sldId="272"/>
            <ac:picMk id="4098" creationId="{9AEBDF64-1FAC-4699-B961-F62782AE2305}"/>
          </ac:picMkLst>
        </pc:picChg>
      </pc:sldChg>
      <pc:sldChg chg="new del">
        <pc:chgData name="Manasweeta Angane" userId="05da2731-9352-4b35-b713-60351f56afbd" providerId="ADAL" clId="{D444FAE6-B328-4AB8-9A10-764831A715E0}" dt="2021-05-04T10:17:57.120" v="63" actId="680"/>
        <pc:sldMkLst>
          <pc:docMk/>
          <pc:sldMk cId="1126775676" sldId="273"/>
        </pc:sldMkLst>
      </pc:sldChg>
      <pc:sldChg chg="addSp delSp modSp new mod ord">
        <pc:chgData name="Manasweeta Angane" userId="05da2731-9352-4b35-b713-60351f56afbd" providerId="ADAL" clId="{D444FAE6-B328-4AB8-9A10-764831A715E0}" dt="2021-05-21T16:18:00.326" v="3306" actId="14861"/>
        <pc:sldMkLst>
          <pc:docMk/>
          <pc:sldMk cId="2923950115" sldId="273"/>
        </pc:sldMkLst>
        <pc:picChg chg="add del mod modCrop">
          <ac:chgData name="Manasweeta Angane" userId="05da2731-9352-4b35-b713-60351f56afbd" providerId="ADAL" clId="{D444FAE6-B328-4AB8-9A10-764831A715E0}" dt="2021-05-21T16:17:09.597" v="3294" actId="21"/>
          <ac:picMkLst>
            <pc:docMk/>
            <pc:sldMk cId="2923950115" sldId="273"/>
            <ac:picMk id="2" creationId="{C1FBA8C6-6704-4FED-AE14-B0826DBC8225}"/>
          </ac:picMkLst>
        </pc:picChg>
        <pc:picChg chg="add del mod">
          <ac:chgData name="Manasweeta Angane" userId="05da2731-9352-4b35-b713-60351f56afbd" providerId="ADAL" clId="{D444FAE6-B328-4AB8-9A10-764831A715E0}" dt="2021-05-21T16:12:51.998" v="3198"/>
          <ac:picMkLst>
            <pc:docMk/>
            <pc:sldMk cId="2923950115" sldId="273"/>
            <ac:picMk id="4" creationId="{C8F8DEA9-C9DD-4C13-A93F-CEE49B394130}"/>
          </ac:picMkLst>
        </pc:picChg>
        <pc:picChg chg="add del mod modCrop">
          <ac:chgData name="Manasweeta Angane" userId="05da2731-9352-4b35-b713-60351f56afbd" providerId="ADAL" clId="{D444FAE6-B328-4AB8-9A10-764831A715E0}" dt="2021-05-21T16:17:24.210" v="3300" actId="21"/>
          <ac:picMkLst>
            <pc:docMk/>
            <pc:sldMk cId="2923950115" sldId="273"/>
            <ac:picMk id="5" creationId="{C8C71A2B-176C-40B0-B6C9-F00CBFE5F8BC}"/>
          </ac:picMkLst>
        </pc:picChg>
        <pc:picChg chg="add del mod modCrop">
          <ac:chgData name="Manasweeta Angane" userId="05da2731-9352-4b35-b713-60351f56afbd" providerId="ADAL" clId="{D444FAE6-B328-4AB8-9A10-764831A715E0}" dt="2021-05-21T16:17:16.535" v="3297" actId="21"/>
          <ac:picMkLst>
            <pc:docMk/>
            <pc:sldMk cId="2923950115" sldId="273"/>
            <ac:picMk id="6" creationId="{168D3C1C-99E8-457B-9C43-62EC45248DE6}"/>
          </ac:picMkLst>
        </pc:picChg>
        <pc:picChg chg="add del mod modCrop">
          <ac:chgData name="Manasweeta Angane" userId="05da2731-9352-4b35-b713-60351f56afbd" providerId="ADAL" clId="{D444FAE6-B328-4AB8-9A10-764831A715E0}" dt="2021-05-21T16:17:02.059" v="3291" actId="21"/>
          <ac:picMkLst>
            <pc:docMk/>
            <pc:sldMk cId="2923950115" sldId="273"/>
            <ac:picMk id="7" creationId="{F76D0B64-73B8-4CEC-9F08-F033F0E746BE}"/>
          </ac:picMkLst>
        </pc:picChg>
        <pc:picChg chg="add mod">
          <ac:chgData name="Manasweeta Angane" userId="05da2731-9352-4b35-b713-60351f56afbd" providerId="ADAL" clId="{D444FAE6-B328-4AB8-9A10-764831A715E0}" dt="2021-05-21T16:18:00.326" v="3306" actId="14861"/>
          <ac:picMkLst>
            <pc:docMk/>
            <pc:sldMk cId="2923950115" sldId="273"/>
            <ac:picMk id="11" creationId="{5C787466-893A-48DE-BE4F-D0DB1155C02D}"/>
          </ac:picMkLst>
        </pc:picChg>
        <pc:picChg chg="add del mod">
          <ac:chgData name="Manasweeta Angane" userId="05da2731-9352-4b35-b713-60351f56afbd" providerId="ADAL" clId="{D444FAE6-B328-4AB8-9A10-764831A715E0}" dt="2021-05-21T16:08:04.643" v="3161" actId="21"/>
          <ac:picMkLst>
            <pc:docMk/>
            <pc:sldMk cId="2923950115" sldId="273"/>
            <ac:picMk id="5122" creationId="{960FE5D9-6D3B-4E9C-8483-48C9E41A7DA6}"/>
          </ac:picMkLst>
        </pc:picChg>
        <pc:picChg chg="add del mod">
          <ac:chgData name="Manasweeta Angane" userId="05da2731-9352-4b35-b713-60351f56afbd" providerId="ADAL" clId="{D444FAE6-B328-4AB8-9A10-764831A715E0}" dt="2021-05-21T16:08:27.596" v="3166" actId="21"/>
          <ac:picMkLst>
            <pc:docMk/>
            <pc:sldMk cId="2923950115" sldId="273"/>
            <ac:picMk id="5124" creationId="{87FBD145-30E9-4362-98AE-663FFA11D558}"/>
          </ac:picMkLst>
        </pc:picChg>
        <pc:picChg chg="add del">
          <ac:chgData name="Manasweeta Angane" userId="05da2731-9352-4b35-b713-60351f56afbd" providerId="ADAL" clId="{D444FAE6-B328-4AB8-9A10-764831A715E0}" dt="2021-05-21T16:08:00.498" v="3160" actId="478"/>
          <ac:picMkLst>
            <pc:docMk/>
            <pc:sldMk cId="2923950115" sldId="273"/>
            <ac:picMk id="5126" creationId="{1B070D23-FA7B-4F12-A6E7-E201C1DEAD23}"/>
          </ac:picMkLst>
        </pc:picChg>
      </pc:sldChg>
      <pc:sldChg chg="addSp delSp modSp add mod">
        <pc:chgData name="Manasweeta Angane" userId="05da2731-9352-4b35-b713-60351f56afbd" providerId="ADAL" clId="{D444FAE6-B328-4AB8-9A10-764831A715E0}" dt="2021-05-21T16:54:59.354" v="3762"/>
        <pc:sldMkLst>
          <pc:docMk/>
          <pc:sldMk cId="730993269" sldId="274"/>
        </pc:sldMkLst>
        <pc:grpChg chg="add mod">
          <ac:chgData name="Manasweeta Angane" userId="05da2731-9352-4b35-b713-60351f56afbd" providerId="ADAL" clId="{D444FAE6-B328-4AB8-9A10-764831A715E0}" dt="2021-05-21T16:30:38.507" v="3550" actId="164"/>
          <ac:grpSpMkLst>
            <pc:docMk/>
            <pc:sldMk cId="730993269" sldId="274"/>
            <ac:grpSpMk id="10" creationId="{A0BC8299-B304-40F8-90B0-E79ABD29317C}"/>
          </ac:grpSpMkLst>
        </pc:grpChg>
        <pc:grpChg chg="del">
          <ac:chgData name="Manasweeta Angane" userId="05da2731-9352-4b35-b713-60351f56afbd" providerId="ADAL" clId="{D444FAE6-B328-4AB8-9A10-764831A715E0}" dt="2021-05-21T16:29:54.161" v="3549" actId="478"/>
          <ac:grpSpMkLst>
            <pc:docMk/>
            <pc:sldMk cId="730993269" sldId="274"/>
            <ac:grpSpMk id="21" creationId="{9145CF07-E463-4E2D-838D-58DFF48DA910}"/>
          </ac:grpSpMkLst>
        </pc:grpChg>
        <pc:grpChg chg="mod">
          <ac:chgData name="Manasweeta Angane" userId="05da2731-9352-4b35-b713-60351f56afbd" providerId="ADAL" clId="{D444FAE6-B328-4AB8-9A10-764831A715E0}" dt="2021-05-21T16:30:38.507" v="3550" actId="164"/>
          <ac:grpSpMkLst>
            <pc:docMk/>
            <pc:sldMk cId="730993269" sldId="274"/>
            <ac:grpSpMk id="78" creationId="{017A5463-1763-42F3-BE4C-BCFEC99C1120}"/>
          </ac:grpSpMkLst>
        </pc:grpChg>
        <pc:grpChg chg="add del mod">
          <ac:chgData name="Manasweeta Angane" userId="05da2731-9352-4b35-b713-60351f56afbd" providerId="ADAL" clId="{D444FAE6-B328-4AB8-9A10-764831A715E0}" dt="2021-05-21T16:54:59.354" v="3762"/>
          <ac:grpSpMkLst>
            <pc:docMk/>
            <pc:sldMk cId="730993269" sldId="274"/>
            <ac:grpSpMk id="117" creationId="{995FF0DA-F7C8-4A67-B7F5-0F7A9A4E2FE8}"/>
          </ac:grpSpMkLst>
        </pc:grpChg>
        <pc:grpChg chg="mod">
          <ac:chgData name="Manasweeta Angane" userId="05da2731-9352-4b35-b713-60351f56afbd" providerId="ADAL" clId="{D444FAE6-B328-4AB8-9A10-764831A715E0}" dt="2021-05-21T16:54:56.620" v="3761"/>
          <ac:grpSpMkLst>
            <pc:docMk/>
            <pc:sldMk cId="730993269" sldId="274"/>
            <ac:grpSpMk id="130" creationId="{9B765207-3BB2-4112-9A31-95EC954A4E53}"/>
          </ac:grpSpMkLst>
        </pc:grpChg>
        <pc:picChg chg="mod">
          <ac:chgData name="Manasweeta Angane" userId="05da2731-9352-4b35-b713-60351f56afbd" providerId="ADAL" clId="{D444FAE6-B328-4AB8-9A10-764831A715E0}" dt="2021-05-21T16:30:38.507" v="3550" actId="164"/>
          <ac:picMkLst>
            <pc:docMk/>
            <pc:sldMk cId="730993269" sldId="274"/>
            <ac:picMk id="17" creationId="{38F0623C-1AF6-479B-B595-A800114A58E6}"/>
          </ac:picMkLst>
        </pc:picChg>
        <pc:picChg chg="mod">
          <ac:chgData name="Manasweeta Angane" userId="05da2731-9352-4b35-b713-60351f56afbd" providerId="ADAL" clId="{D444FAE6-B328-4AB8-9A10-764831A715E0}" dt="2021-05-21T16:30:38.507" v="3550" actId="164"/>
          <ac:picMkLst>
            <pc:docMk/>
            <pc:sldMk cId="730993269" sldId="274"/>
            <ac:picMk id="18" creationId="{693716A8-F217-4C3C-9390-BF8D34EA63BC}"/>
          </ac:picMkLst>
        </pc:picChg>
        <pc:picChg chg="del">
          <ac:chgData name="Manasweeta Angane" userId="05da2731-9352-4b35-b713-60351f56afbd" providerId="ADAL" clId="{D444FAE6-B328-4AB8-9A10-764831A715E0}" dt="2021-05-21T16:29:46.824" v="3548" actId="478"/>
          <ac:picMkLst>
            <pc:docMk/>
            <pc:sldMk cId="730993269" sldId="274"/>
            <ac:picMk id="27" creationId="{AD90960C-5D7B-42B1-BCEA-05C5E386F7E8}"/>
          </ac:picMkLst>
        </pc:picChg>
        <pc:picChg chg="mod">
          <ac:chgData name="Manasweeta Angane" userId="05da2731-9352-4b35-b713-60351f56afbd" providerId="ADAL" clId="{D444FAE6-B328-4AB8-9A10-764831A715E0}" dt="2021-05-21T16:30:38.507" v="3550" actId="164"/>
          <ac:picMkLst>
            <pc:docMk/>
            <pc:sldMk cId="730993269" sldId="274"/>
            <ac:picMk id="31" creationId="{318D01EE-B552-46A9-8EA2-F37ECF766573}"/>
          </ac:picMkLst>
        </pc:picChg>
        <pc:picChg chg="mod">
          <ac:chgData name="Manasweeta Angane" userId="05da2731-9352-4b35-b713-60351f56afbd" providerId="ADAL" clId="{D444FAE6-B328-4AB8-9A10-764831A715E0}" dt="2021-05-21T16:30:38.507" v="3550" actId="164"/>
          <ac:picMkLst>
            <pc:docMk/>
            <pc:sldMk cId="730993269" sldId="274"/>
            <ac:picMk id="35" creationId="{93F7C139-363C-45B3-B7AE-EF89DF394249}"/>
          </ac:picMkLst>
        </pc:picChg>
        <pc:picChg chg="mod">
          <ac:chgData name="Manasweeta Angane" userId="05da2731-9352-4b35-b713-60351f56afbd" providerId="ADAL" clId="{D444FAE6-B328-4AB8-9A10-764831A715E0}" dt="2021-05-21T16:30:38.507" v="3550" actId="164"/>
          <ac:picMkLst>
            <pc:docMk/>
            <pc:sldMk cId="730993269" sldId="274"/>
            <ac:picMk id="55" creationId="{76AC46E1-1529-441A-B7C7-5BF677A619E6}"/>
          </ac:picMkLst>
        </pc:picChg>
        <pc:picChg chg="mod">
          <ac:chgData name="Manasweeta Angane" userId="05da2731-9352-4b35-b713-60351f56afbd" providerId="ADAL" clId="{D444FAE6-B328-4AB8-9A10-764831A715E0}" dt="2021-05-21T16:30:38.507" v="3550" actId="164"/>
          <ac:picMkLst>
            <pc:docMk/>
            <pc:sldMk cId="730993269" sldId="274"/>
            <ac:picMk id="57" creationId="{5C5CA2EF-6EB2-4FDF-9ADE-9E4D42D8ACEE}"/>
          </ac:picMkLst>
        </pc:picChg>
        <pc:picChg chg="mod">
          <ac:chgData name="Manasweeta Angane" userId="05da2731-9352-4b35-b713-60351f56afbd" providerId="ADAL" clId="{D444FAE6-B328-4AB8-9A10-764831A715E0}" dt="2021-05-21T16:30:38.507" v="3550" actId="164"/>
          <ac:picMkLst>
            <pc:docMk/>
            <pc:sldMk cId="730993269" sldId="274"/>
            <ac:picMk id="69" creationId="{A7838FD7-C060-4898-A40D-ACD3E18CB54A}"/>
          </ac:picMkLst>
        </pc:picChg>
        <pc:picChg chg="mod">
          <ac:chgData name="Manasweeta Angane" userId="05da2731-9352-4b35-b713-60351f56afbd" providerId="ADAL" clId="{D444FAE6-B328-4AB8-9A10-764831A715E0}" dt="2021-05-21T16:30:38.507" v="3550" actId="164"/>
          <ac:picMkLst>
            <pc:docMk/>
            <pc:sldMk cId="730993269" sldId="274"/>
            <ac:picMk id="70" creationId="{564BB657-BB08-4B8C-9CD5-6EEACA2CE31F}"/>
          </ac:picMkLst>
        </pc:picChg>
        <pc:picChg chg="mod">
          <ac:chgData name="Manasweeta Angane" userId="05da2731-9352-4b35-b713-60351f56afbd" providerId="ADAL" clId="{D444FAE6-B328-4AB8-9A10-764831A715E0}" dt="2021-05-21T16:30:38.507" v="3550" actId="164"/>
          <ac:picMkLst>
            <pc:docMk/>
            <pc:sldMk cId="730993269" sldId="274"/>
            <ac:picMk id="74" creationId="{FE1942F6-89D4-42C8-ADFB-37FB02A572D3}"/>
          </ac:picMkLst>
        </pc:picChg>
        <pc:picChg chg="mod">
          <ac:chgData name="Manasweeta Angane" userId="05da2731-9352-4b35-b713-60351f56afbd" providerId="ADAL" clId="{D444FAE6-B328-4AB8-9A10-764831A715E0}" dt="2021-05-21T16:30:38.507" v="3550" actId="164"/>
          <ac:picMkLst>
            <pc:docMk/>
            <pc:sldMk cId="730993269" sldId="274"/>
            <ac:picMk id="75" creationId="{B56C8172-E660-4F61-B413-A6E179C8266A}"/>
          </ac:picMkLst>
        </pc:picChg>
        <pc:picChg chg="mod">
          <ac:chgData name="Manasweeta Angane" userId="05da2731-9352-4b35-b713-60351f56afbd" providerId="ADAL" clId="{D444FAE6-B328-4AB8-9A10-764831A715E0}" dt="2021-05-21T16:30:38.507" v="3550" actId="164"/>
          <ac:picMkLst>
            <pc:docMk/>
            <pc:sldMk cId="730993269" sldId="274"/>
            <ac:picMk id="76" creationId="{B46F448E-5E4E-4884-9AAB-6C9B90993F0E}"/>
          </ac:picMkLst>
        </pc:picChg>
        <pc:picChg chg="mod">
          <ac:chgData name="Manasweeta Angane" userId="05da2731-9352-4b35-b713-60351f56afbd" providerId="ADAL" clId="{D444FAE6-B328-4AB8-9A10-764831A715E0}" dt="2021-05-21T16:30:38.507" v="3550" actId="164"/>
          <ac:picMkLst>
            <pc:docMk/>
            <pc:sldMk cId="730993269" sldId="274"/>
            <ac:picMk id="105" creationId="{089D3380-4C78-4B6B-BB2C-3ECC905346CC}"/>
          </ac:picMkLst>
        </pc:picChg>
        <pc:picChg chg="mod">
          <ac:chgData name="Manasweeta Angane" userId="05da2731-9352-4b35-b713-60351f56afbd" providerId="ADAL" clId="{D444FAE6-B328-4AB8-9A10-764831A715E0}" dt="2021-05-21T16:54:56.620" v="3761"/>
          <ac:picMkLst>
            <pc:docMk/>
            <pc:sldMk cId="730993269" sldId="274"/>
            <ac:picMk id="118" creationId="{6EDF0CCE-E2F8-428F-B6E2-0E8176B5A18C}"/>
          </ac:picMkLst>
        </pc:picChg>
        <pc:picChg chg="mod">
          <ac:chgData name="Manasweeta Angane" userId="05da2731-9352-4b35-b713-60351f56afbd" providerId="ADAL" clId="{D444FAE6-B328-4AB8-9A10-764831A715E0}" dt="2021-05-21T16:54:56.620" v="3761"/>
          <ac:picMkLst>
            <pc:docMk/>
            <pc:sldMk cId="730993269" sldId="274"/>
            <ac:picMk id="119" creationId="{2EF4C1B9-AEEA-4C6D-803C-B87381673C9B}"/>
          </ac:picMkLst>
        </pc:picChg>
        <pc:picChg chg="mod">
          <ac:chgData name="Manasweeta Angane" userId="05da2731-9352-4b35-b713-60351f56afbd" providerId="ADAL" clId="{D444FAE6-B328-4AB8-9A10-764831A715E0}" dt="2021-05-21T16:54:56.620" v="3761"/>
          <ac:picMkLst>
            <pc:docMk/>
            <pc:sldMk cId="730993269" sldId="274"/>
            <ac:picMk id="120" creationId="{184705EF-A491-4211-A9B2-1DB0E80CAADE}"/>
          </ac:picMkLst>
        </pc:picChg>
        <pc:picChg chg="mod">
          <ac:chgData name="Manasweeta Angane" userId="05da2731-9352-4b35-b713-60351f56afbd" providerId="ADAL" clId="{D444FAE6-B328-4AB8-9A10-764831A715E0}" dt="2021-05-21T16:54:56.620" v="3761"/>
          <ac:picMkLst>
            <pc:docMk/>
            <pc:sldMk cId="730993269" sldId="274"/>
            <ac:picMk id="121" creationId="{21610FFA-C4EF-44FE-A2EE-1ADD8191CA9D}"/>
          </ac:picMkLst>
        </pc:picChg>
        <pc:picChg chg="mod">
          <ac:chgData name="Manasweeta Angane" userId="05da2731-9352-4b35-b713-60351f56afbd" providerId="ADAL" clId="{D444FAE6-B328-4AB8-9A10-764831A715E0}" dt="2021-05-21T16:54:56.620" v="3761"/>
          <ac:picMkLst>
            <pc:docMk/>
            <pc:sldMk cId="730993269" sldId="274"/>
            <ac:picMk id="122" creationId="{340351B9-0951-4CC4-AD37-0D39E2465729}"/>
          </ac:picMkLst>
        </pc:picChg>
        <pc:picChg chg="mod">
          <ac:chgData name="Manasweeta Angane" userId="05da2731-9352-4b35-b713-60351f56afbd" providerId="ADAL" clId="{D444FAE6-B328-4AB8-9A10-764831A715E0}" dt="2021-05-21T16:54:56.620" v="3761"/>
          <ac:picMkLst>
            <pc:docMk/>
            <pc:sldMk cId="730993269" sldId="274"/>
            <ac:picMk id="123" creationId="{65BD45CF-5E90-4307-919A-EECE3A6CACC4}"/>
          </ac:picMkLst>
        </pc:picChg>
        <pc:picChg chg="mod">
          <ac:chgData name="Manasweeta Angane" userId="05da2731-9352-4b35-b713-60351f56afbd" providerId="ADAL" clId="{D444FAE6-B328-4AB8-9A10-764831A715E0}" dt="2021-05-21T16:54:56.620" v="3761"/>
          <ac:picMkLst>
            <pc:docMk/>
            <pc:sldMk cId="730993269" sldId="274"/>
            <ac:picMk id="124" creationId="{9390C835-F582-42B9-8D5F-EB672E8AB417}"/>
          </ac:picMkLst>
        </pc:picChg>
        <pc:picChg chg="mod">
          <ac:chgData name="Manasweeta Angane" userId="05da2731-9352-4b35-b713-60351f56afbd" providerId="ADAL" clId="{D444FAE6-B328-4AB8-9A10-764831A715E0}" dt="2021-05-21T16:54:56.620" v="3761"/>
          <ac:picMkLst>
            <pc:docMk/>
            <pc:sldMk cId="730993269" sldId="274"/>
            <ac:picMk id="125" creationId="{590E4538-8EB2-4FA2-8FD4-7353D4A621A1}"/>
          </ac:picMkLst>
        </pc:picChg>
        <pc:picChg chg="mod">
          <ac:chgData name="Manasweeta Angane" userId="05da2731-9352-4b35-b713-60351f56afbd" providerId="ADAL" clId="{D444FAE6-B328-4AB8-9A10-764831A715E0}" dt="2021-05-21T16:54:56.620" v="3761"/>
          <ac:picMkLst>
            <pc:docMk/>
            <pc:sldMk cId="730993269" sldId="274"/>
            <ac:picMk id="126" creationId="{22EE6A94-A673-4BFF-ABF2-188ABDE671D0}"/>
          </ac:picMkLst>
        </pc:picChg>
        <pc:picChg chg="mod">
          <ac:chgData name="Manasweeta Angane" userId="05da2731-9352-4b35-b713-60351f56afbd" providerId="ADAL" clId="{D444FAE6-B328-4AB8-9A10-764831A715E0}" dt="2021-05-21T16:54:56.620" v="3761"/>
          <ac:picMkLst>
            <pc:docMk/>
            <pc:sldMk cId="730993269" sldId="274"/>
            <ac:picMk id="127" creationId="{773CB10A-869D-48F7-B713-C71D542001A2}"/>
          </ac:picMkLst>
        </pc:picChg>
        <pc:picChg chg="mod">
          <ac:chgData name="Manasweeta Angane" userId="05da2731-9352-4b35-b713-60351f56afbd" providerId="ADAL" clId="{D444FAE6-B328-4AB8-9A10-764831A715E0}" dt="2021-05-21T16:54:56.620" v="3761"/>
          <ac:picMkLst>
            <pc:docMk/>
            <pc:sldMk cId="730993269" sldId="274"/>
            <ac:picMk id="128" creationId="{9DFC7276-5F2D-40EE-BC64-42B3270C1871}"/>
          </ac:picMkLst>
        </pc:picChg>
        <pc:picChg chg="mod">
          <ac:chgData name="Manasweeta Angane" userId="05da2731-9352-4b35-b713-60351f56afbd" providerId="ADAL" clId="{D444FAE6-B328-4AB8-9A10-764831A715E0}" dt="2021-05-21T16:54:56.620" v="3761"/>
          <ac:picMkLst>
            <pc:docMk/>
            <pc:sldMk cId="730993269" sldId="274"/>
            <ac:picMk id="129" creationId="{879B0F9C-F8AF-4898-BB82-444F2840A250}"/>
          </ac:picMkLst>
        </pc:picChg>
        <pc:picChg chg="mod">
          <ac:chgData name="Manasweeta Angane" userId="05da2731-9352-4b35-b713-60351f56afbd" providerId="ADAL" clId="{D444FAE6-B328-4AB8-9A10-764831A715E0}" dt="2021-05-21T16:54:56.620" v="3761"/>
          <ac:picMkLst>
            <pc:docMk/>
            <pc:sldMk cId="730993269" sldId="274"/>
            <ac:picMk id="131" creationId="{82521691-35D5-4B55-ACD6-0B875DBF9D8D}"/>
          </ac:picMkLst>
        </pc:picChg>
        <pc:picChg chg="mod">
          <ac:chgData name="Manasweeta Angane" userId="05da2731-9352-4b35-b713-60351f56afbd" providerId="ADAL" clId="{D444FAE6-B328-4AB8-9A10-764831A715E0}" dt="2021-05-21T16:54:56.620" v="3761"/>
          <ac:picMkLst>
            <pc:docMk/>
            <pc:sldMk cId="730993269" sldId="274"/>
            <ac:picMk id="132" creationId="{F56EBB7E-ECC3-469D-B8A5-66D1B572E65C}"/>
          </ac:picMkLst>
        </pc:picChg>
        <pc:picChg chg="mod">
          <ac:chgData name="Manasweeta Angane" userId="05da2731-9352-4b35-b713-60351f56afbd" providerId="ADAL" clId="{D444FAE6-B328-4AB8-9A10-764831A715E0}" dt="2021-05-21T16:54:56.620" v="3761"/>
          <ac:picMkLst>
            <pc:docMk/>
            <pc:sldMk cId="730993269" sldId="274"/>
            <ac:picMk id="133" creationId="{38DA17A5-39DD-4040-82BB-A26E31495BFD}"/>
          </ac:picMkLst>
        </pc:picChg>
        <pc:picChg chg="mod">
          <ac:chgData name="Manasweeta Angane" userId="05da2731-9352-4b35-b713-60351f56afbd" providerId="ADAL" clId="{D444FAE6-B328-4AB8-9A10-764831A715E0}" dt="2021-05-21T16:30:38.507" v="3550" actId="164"/>
          <ac:picMkLst>
            <pc:docMk/>
            <pc:sldMk cId="730993269" sldId="274"/>
            <ac:picMk id="1026" creationId="{137C4FFD-2974-4454-B897-C812188AA1E5}"/>
          </ac:picMkLst>
        </pc:picChg>
      </pc:sldChg>
      <pc:sldChg chg="new del">
        <pc:chgData name="Manasweeta Angane" userId="05da2731-9352-4b35-b713-60351f56afbd" providerId="ADAL" clId="{D444FAE6-B328-4AB8-9A10-764831A715E0}" dt="2021-05-04T10:17:56.854" v="62" actId="680"/>
        <pc:sldMkLst>
          <pc:docMk/>
          <pc:sldMk cId="2163112400" sldId="274"/>
        </pc:sldMkLst>
      </pc:sldChg>
      <pc:sldChg chg="new del">
        <pc:chgData name="Manasweeta Angane" userId="05da2731-9352-4b35-b713-60351f56afbd" providerId="ADAL" clId="{D444FAE6-B328-4AB8-9A10-764831A715E0}" dt="2021-05-04T10:17:56.573" v="61" actId="680"/>
        <pc:sldMkLst>
          <pc:docMk/>
          <pc:sldMk cId="2825477908" sldId="275"/>
        </pc:sldMkLst>
      </pc:sldChg>
      <pc:sldChg chg="new del">
        <pc:chgData name="Manasweeta Angane" userId="05da2731-9352-4b35-b713-60351f56afbd" providerId="ADAL" clId="{D444FAE6-B328-4AB8-9A10-764831A715E0}" dt="2021-05-04T10:17:56.198" v="60" actId="680"/>
        <pc:sldMkLst>
          <pc:docMk/>
          <pc:sldMk cId="485212646" sldId="276"/>
        </pc:sldMkLst>
      </pc:sldChg>
      <pc:sldChg chg="new del">
        <pc:chgData name="Manasweeta Angane" userId="05da2731-9352-4b35-b713-60351f56afbd" providerId="ADAL" clId="{D444FAE6-B328-4AB8-9A10-764831A715E0}" dt="2021-05-04T10:17:55.761" v="59" actId="680"/>
        <pc:sldMkLst>
          <pc:docMk/>
          <pc:sldMk cId="2041418392" sldId="277"/>
        </pc:sldMkLst>
      </pc:sldChg>
      <pc:sldChg chg="new del">
        <pc:chgData name="Manasweeta Angane" userId="05da2731-9352-4b35-b713-60351f56afbd" providerId="ADAL" clId="{D444FAE6-B328-4AB8-9A10-764831A715E0}" dt="2021-05-04T10:17:55.245" v="58" actId="680"/>
        <pc:sldMkLst>
          <pc:docMk/>
          <pc:sldMk cId="2088484656" sldId="278"/>
        </pc:sldMkLst>
      </pc:sldChg>
      <pc:sldChg chg="new del">
        <pc:chgData name="Manasweeta Angane" userId="05da2731-9352-4b35-b713-60351f56afbd" providerId="ADAL" clId="{D444FAE6-B328-4AB8-9A10-764831A715E0}" dt="2021-05-04T10:17:54.636" v="57" actId="680"/>
        <pc:sldMkLst>
          <pc:docMk/>
          <pc:sldMk cId="3335831815" sldId="279"/>
        </pc:sldMkLst>
      </pc:sldChg>
      <pc:sldChg chg="new del">
        <pc:chgData name="Manasweeta Angane" userId="05da2731-9352-4b35-b713-60351f56afbd" providerId="ADAL" clId="{D444FAE6-B328-4AB8-9A10-764831A715E0}" dt="2021-05-04T10:17:54.136" v="56" actId="680"/>
        <pc:sldMkLst>
          <pc:docMk/>
          <pc:sldMk cId="2299485878" sldId="280"/>
        </pc:sldMkLst>
      </pc:sldChg>
      <pc:sldChg chg="new del">
        <pc:chgData name="Manasweeta Angane" userId="05da2731-9352-4b35-b713-60351f56afbd" providerId="ADAL" clId="{D444FAE6-B328-4AB8-9A10-764831A715E0}" dt="2021-05-04T10:17:53.417" v="55" actId="680"/>
        <pc:sldMkLst>
          <pc:docMk/>
          <pc:sldMk cId="1681170682" sldId="281"/>
        </pc:sldMkLst>
      </pc:sldChg>
    </pc:docChg>
  </pc:docChgLst>
  <pc:docChgLst>
    <pc:chgData name="Manasweeta Angane" userId="05da2731-9352-4b35-b713-60351f56afbd" providerId="ADAL" clId="{56648E15-03AE-499C-9A09-94B4A17BC0DB}"/>
    <pc:docChg chg="undo custSel addSld delSld modSld">
      <pc:chgData name="Manasweeta Angane" userId="05da2731-9352-4b35-b713-60351f56afbd" providerId="ADAL" clId="{56648E15-03AE-499C-9A09-94B4A17BC0DB}" dt="2023-05-19T03:51:32.056" v="189" actId="14734"/>
      <pc:docMkLst>
        <pc:docMk/>
      </pc:docMkLst>
      <pc:sldChg chg="del">
        <pc:chgData name="Manasweeta Angane" userId="05da2731-9352-4b35-b713-60351f56afbd" providerId="ADAL" clId="{56648E15-03AE-499C-9A09-94B4A17BC0DB}" dt="2023-05-05T00:16:33.777" v="0" actId="2696"/>
        <pc:sldMkLst>
          <pc:docMk/>
          <pc:sldMk cId="1254738402" sldId="256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4248096269" sldId="267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3481556119" sldId="278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81594327" sldId="279"/>
        </pc:sldMkLst>
      </pc:sldChg>
      <pc:sldChg chg="del">
        <pc:chgData name="Manasweeta Angane" userId="05da2731-9352-4b35-b713-60351f56afbd" providerId="ADAL" clId="{56648E15-03AE-499C-9A09-94B4A17BC0DB}" dt="2023-05-05T00:16:33.777" v="0" actId="2696"/>
        <pc:sldMkLst>
          <pc:docMk/>
          <pc:sldMk cId="2988400537" sldId="284"/>
        </pc:sldMkLst>
      </pc:sldChg>
      <pc:sldChg chg="del">
        <pc:chgData name="Manasweeta Angane" userId="05da2731-9352-4b35-b713-60351f56afbd" providerId="ADAL" clId="{56648E15-03AE-499C-9A09-94B4A17BC0DB}" dt="2023-05-05T00:16:33.777" v="0" actId="2696"/>
        <pc:sldMkLst>
          <pc:docMk/>
          <pc:sldMk cId="3862015218" sldId="286"/>
        </pc:sldMkLst>
      </pc:sldChg>
      <pc:sldChg chg="del">
        <pc:chgData name="Manasweeta Angane" userId="05da2731-9352-4b35-b713-60351f56afbd" providerId="ADAL" clId="{56648E15-03AE-499C-9A09-94B4A17BC0DB}" dt="2023-05-05T00:16:33.777" v="0" actId="2696"/>
        <pc:sldMkLst>
          <pc:docMk/>
          <pc:sldMk cId="1960085715" sldId="288"/>
        </pc:sldMkLst>
      </pc:sldChg>
      <pc:sldChg chg="del">
        <pc:chgData name="Manasweeta Angane" userId="05da2731-9352-4b35-b713-60351f56afbd" providerId="ADAL" clId="{56648E15-03AE-499C-9A09-94B4A17BC0DB}" dt="2023-05-05T00:16:33.777" v="0" actId="2696"/>
        <pc:sldMkLst>
          <pc:docMk/>
          <pc:sldMk cId="1953099216" sldId="289"/>
        </pc:sldMkLst>
      </pc:sldChg>
      <pc:sldChg chg="del">
        <pc:chgData name="Manasweeta Angane" userId="05da2731-9352-4b35-b713-60351f56afbd" providerId="ADAL" clId="{56648E15-03AE-499C-9A09-94B4A17BC0DB}" dt="2023-05-05T00:16:33.777" v="0" actId="2696"/>
        <pc:sldMkLst>
          <pc:docMk/>
          <pc:sldMk cId="1953356484" sldId="290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2272868319" sldId="291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2092801620" sldId="292"/>
        </pc:sldMkLst>
      </pc:sldChg>
      <pc:sldChg chg="addSp delSp modSp mod">
        <pc:chgData name="Manasweeta Angane" userId="05da2731-9352-4b35-b713-60351f56afbd" providerId="ADAL" clId="{56648E15-03AE-499C-9A09-94B4A17BC0DB}" dt="2023-05-05T01:04:24.762" v="146" actId="1036"/>
        <pc:sldMkLst>
          <pc:docMk/>
          <pc:sldMk cId="1046971931" sldId="293"/>
        </pc:sldMkLst>
        <pc:spChg chg="mod">
          <ac:chgData name="Manasweeta Angane" userId="05da2731-9352-4b35-b713-60351f56afbd" providerId="ADAL" clId="{56648E15-03AE-499C-9A09-94B4A17BC0DB}" dt="2023-05-05T01:01:21.295" v="64" actId="255"/>
          <ac:spMkLst>
            <pc:docMk/>
            <pc:sldMk cId="1046971931" sldId="293"/>
            <ac:spMk id="11" creationId="{7D80F4E0-502C-4D49-85AC-4E84CA18DCC7}"/>
          </ac:spMkLst>
        </pc:spChg>
        <pc:spChg chg="add del mod">
          <ac:chgData name="Manasweeta Angane" userId="05da2731-9352-4b35-b713-60351f56afbd" providerId="ADAL" clId="{56648E15-03AE-499C-9A09-94B4A17BC0DB}" dt="2023-05-05T01:02:41.024" v="74"/>
          <ac:spMkLst>
            <pc:docMk/>
            <pc:sldMk cId="1046971931" sldId="293"/>
            <ac:spMk id="17" creationId="{3A0904F4-9317-EFC5-5986-CE0878C04F9F}"/>
          </ac:spMkLst>
        </pc:spChg>
        <pc:spChg chg="add del mod">
          <ac:chgData name="Manasweeta Angane" userId="05da2731-9352-4b35-b713-60351f56afbd" providerId="ADAL" clId="{56648E15-03AE-499C-9A09-94B4A17BC0DB}" dt="2023-05-05T01:02:41.024" v="74"/>
          <ac:spMkLst>
            <pc:docMk/>
            <pc:sldMk cId="1046971931" sldId="293"/>
            <ac:spMk id="18" creationId="{168B07CD-7A30-EC96-89A9-CA500C913C04}"/>
          </ac:spMkLst>
        </pc:spChg>
        <pc:spChg chg="del">
          <ac:chgData name="Manasweeta Angane" userId="05da2731-9352-4b35-b713-60351f56afbd" providerId="ADAL" clId="{56648E15-03AE-499C-9A09-94B4A17BC0DB}" dt="2023-05-05T01:02:19.768" v="70" actId="478"/>
          <ac:spMkLst>
            <pc:docMk/>
            <pc:sldMk cId="1046971931" sldId="293"/>
            <ac:spMk id="23" creationId="{4C715F5C-562C-4951-8683-8A7B45B99983}"/>
          </ac:spMkLst>
        </pc:spChg>
        <pc:spChg chg="del">
          <ac:chgData name="Manasweeta Angane" userId="05da2731-9352-4b35-b713-60351f56afbd" providerId="ADAL" clId="{56648E15-03AE-499C-9A09-94B4A17BC0DB}" dt="2023-05-05T01:02:16.991" v="69" actId="478"/>
          <ac:spMkLst>
            <pc:docMk/>
            <pc:sldMk cId="1046971931" sldId="293"/>
            <ac:spMk id="24" creationId="{B69BCE85-BD7B-4E48-A163-58B643F99E35}"/>
          </ac:spMkLst>
        </pc:spChg>
        <pc:spChg chg="del mod">
          <ac:chgData name="Manasweeta Angane" userId="05da2731-9352-4b35-b713-60351f56afbd" providerId="ADAL" clId="{56648E15-03AE-499C-9A09-94B4A17BC0DB}" dt="2023-05-05T01:02:14.299" v="68" actId="478"/>
          <ac:spMkLst>
            <pc:docMk/>
            <pc:sldMk cId="1046971931" sldId="293"/>
            <ac:spMk id="25" creationId="{5BFD7D79-2525-4D46-9923-247D6D654495}"/>
          </ac:spMkLst>
        </pc:spChg>
        <pc:spChg chg="del">
          <ac:chgData name="Manasweeta Angane" userId="05da2731-9352-4b35-b713-60351f56afbd" providerId="ADAL" clId="{56648E15-03AE-499C-9A09-94B4A17BC0DB}" dt="2023-05-05T01:02:10.810" v="66" actId="478"/>
          <ac:spMkLst>
            <pc:docMk/>
            <pc:sldMk cId="1046971931" sldId="293"/>
            <ac:spMk id="26" creationId="{EF3E1FB5-A979-4AC9-940B-BAF4B16EA53F}"/>
          </ac:spMkLst>
        </pc:spChg>
        <pc:spChg chg="add mod">
          <ac:chgData name="Manasweeta Angane" userId="05da2731-9352-4b35-b713-60351f56afbd" providerId="ADAL" clId="{56648E15-03AE-499C-9A09-94B4A17BC0DB}" dt="2023-05-05T01:04:24.762" v="146" actId="1036"/>
          <ac:spMkLst>
            <pc:docMk/>
            <pc:sldMk cId="1046971931" sldId="293"/>
            <ac:spMk id="29" creationId="{04949A8C-2557-11F3-CF2C-47C4434D5FAB}"/>
          </ac:spMkLst>
        </pc:spChg>
        <pc:grpChg chg="mod">
          <ac:chgData name="Manasweeta Angane" userId="05da2731-9352-4b35-b713-60351f56afbd" providerId="ADAL" clId="{56648E15-03AE-499C-9A09-94B4A17BC0DB}" dt="2023-05-05T01:03:27.170" v="117" actId="1037"/>
          <ac:grpSpMkLst>
            <pc:docMk/>
            <pc:sldMk cId="1046971931" sldId="293"/>
            <ac:grpSpMk id="2" creationId="{3A4A3B8D-71E8-485F-B477-237D5D7EC03E}"/>
          </ac:grpSpMkLst>
        </pc:grpChg>
        <pc:picChg chg="del">
          <ac:chgData name="Manasweeta Angane" userId="05da2731-9352-4b35-b713-60351f56afbd" providerId="ADAL" clId="{56648E15-03AE-499C-9A09-94B4A17BC0DB}" dt="2023-05-05T01:00:12.205" v="2" actId="478"/>
          <ac:picMkLst>
            <pc:docMk/>
            <pc:sldMk cId="1046971931" sldId="293"/>
            <ac:picMk id="9" creationId="{6D54F64C-D71E-4CDA-B525-73CCBBF6E677}"/>
          </ac:picMkLst>
        </pc:picChg>
        <pc:picChg chg="del">
          <ac:chgData name="Manasweeta Angane" userId="05da2731-9352-4b35-b713-60351f56afbd" providerId="ADAL" clId="{56648E15-03AE-499C-9A09-94B4A17BC0DB}" dt="2023-05-05T01:00:13.828" v="3" actId="478"/>
          <ac:picMkLst>
            <pc:docMk/>
            <pc:sldMk cId="1046971931" sldId="293"/>
            <ac:picMk id="10" creationId="{3C3B5F41-5D33-418A-9025-AADE291159F3}"/>
          </ac:picMkLst>
        </pc:picChg>
        <pc:picChg chg="add mod">
          <ac:chgData name="Manasweeta Angane" userId="05da2731-9352-4b35-b713-60351f56afbd" providerId="ADAL" clId="{56648E15-03AE-499C-9A09-94B4A17BC0DB}" dt="2023-05-05T01:02:59.324" v="76" actId="1076"/>
          <ac:picMkLst>
            <pc:docMk/>
            <pc:sldMk cId="1046971931" sldId="293"/>
            <ac:picMk id="27" creationId="{4B6F685A-C7CB-FC97-6622-CD8F7889E257}"/>
          </ac:picMkLst>
        </pc:picChg>
        <pc:picChg chg="add del mod">
          <ac:chgData name="Manasweeta Angane" userId="05da2731-9352-4b35-b713-60351f56afbd" providerId="ADAL" clId="{56648E15-03AE-499C-9A09-94B4A17BC0DB}" dt="2023-05-05T01:02:41.024" v="74"/>
          <ac:picMkLst>
            <pc:docMk/>
            <pc:sldMk cId="1046971931" sldId="293"/>
            <ac:picMk id="1025" creationId="{2B879D20-95A7-6926-D33F-FB0DB1063FD5}"/>
          </ac:picMkLst>
        </pc:picChg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72074382" sldId="294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3407421633" sldId="295"/>
        </pc:sldMkLst>
      </pc:sldChg>
      <pc:sldChg chg="delSp modSp mod">
        <pc:chgData name="Manasweeta Angane" userId="05da2731-9352-4b35-b713-60351f56afbd" providerId="ADAL" clId="{56648E15-03AE-499C-9A09-94B4A17BC0DB}" dt="2023-05-05T01:01:30.170" v="65" actId="255"/>
        <pc:sldMkLst>
          <pc:docMk/>
          <pc:sldMk cId="3975102812" sldId="297"/>
        </pc:sldMkLst>
        <pc:spChg chg="mod">
          <ac:chgData name="Manasweeta Angane" userId="05da2731-9352-4b35-b713-60351f56afbd" providerId="ADAL" clId="{56648E15-03AE-499C-9A09-94B4A17BC0DB}" dt="2023-05-05T01:01:30.170" v="65" actId="255"/>
          <ac:spMkLst>
            <pc:docMk/>
            <pc:sldMk cId="3975102812" sldId="297"/>
            <ac:spMk id="18" creationId="{45F2BEED-A6BE-45AE-BED7-62E52E5E5868}"/>
          </ac:spMkLst>
        </pc:spChg>
        <pc:picChg chg="del">
          <ac:chgData name="Manasweeta Angane" userId="05da2731-9352-4b35-b713-60351f56afbd" providerId="ADAL" clId="{56648E15-03AE-499C-9A09-94B4A17BC0DB}" dt="2023-05-05T01:00:16.371" v="4" actId="478"/>
          <ac:picMkLst>
            <pc:docMk/>
            <pc:sldMk cId="3975102812" sldId="297"/>
            <ac:picMk id="15" creationId="{17C185FB-019D-4BDF-8A85-013DB7CCD9DA}"/>
          </ac:picMkLst>
        </pc:picChg>
        <pc:picChg chg="del">
          <ac:chgData name="Manasweeta Angane" userId="05da2731-9352-4b35-b713-60351f56afbd" providerId="ADAL" clId="{56648E15-03AE-499C-9A09-94B4A17BC0DB}" dt="2023-05-05T01:00:17.644" v="5" actId="478"/>
          <ac:picMkLst>
            <pc:docMk/>
            <pc:sldMk cId="3975102812" sldId="297"/>
            <ac:picMk id="16" creationId="{7B658784-A069-47B9-ADBA-5DE80F3D8F22}"/>
          </ac:picMkLst>
        </pc:picChg>
      </pc:sldChg>
      <pc:sldChg chg="addSp delSp modSp add mod">
        <pc:chgData name="Manasweeta Angane" userId="05da2731-9352-4b35-b713-60351f56afbd" providerId="ADAL" clId="{56648E15-03AE-499C-9A09-94B4A17BC0DB}" dt="2023-05-19T03:51:32.056" v="189" actId="14734"/>
        <pc:sldMkLst>
          <pc:docMk/>
          <pc:sldMk cId="1417210217" sldId="298"/>
        </pc:sldMkLst>
        <pc:spChg chg="del">
          <ac:chgData name="Manasweeta Angane" userId="05da2731-9352-4b35-b713-60351f56afbd" providerId="ADAL" clId="{56648E15-03AE-499C-9A09-94B4A17BC0DB}" dt="2023-05-19T03:46:28.158" v="169" actId="478"/>
          <ac:spMkLst>
            <pc:docMk/>
            <pc:sldMk cId="1417210217" sldId="298"/>
            <ac:spMk id="3" creationId="{3301C9F2-50F5-0A61-696D-1A66819DE51A}"/>
          </ac:spMkLst>
        </pc:spChg>
        <pc:spChg chg="mod">
          <ac:chgData name="Manasweeta Angane" userId="05da2731-9352-4b35-b713-60351f56afbd" providerId="ADAL" clId="{56648E15-03AE-499C-9A09-94B4A17BC0DB}" dt="2023-05-19T03:45:42.492" v="168" actId="12788"/>
          <ac:spMkLst>
            <pc:docMk/>
            <pc:sldMk cId="1417210217" sldId="298"/>
            <ac:spMk id="11" creationId="{7D80F4E0-502C-4D49-85AC-4E84CA18DCC7}"/>
          </ac:spMkLst>
        </pc:spChg>
        <pc:spChg chg="del">
          <ac:chgData name="Manasweeta Angane" userId="05da2731-9352-4b35-b713-60351f56afbd" providerId="ADAL" clId="{56648E15-03AE-499C-9A09-94B4A17BC0DB}" dt="2023-05-19T03:37:32.459" v="157" actId="478"/>
          <ac:spMkLst>
            <pc:docMk/>
            <pc:sldMk cId="1417210217" sldId="298"/>
            <ac:spMk id="29" creationId="{04949A8C-2557-11F3-CF2C-47C4434D5FAB}"/>
          </ac:spMkLst>
        </pc:spChg>
        <pc:grpChg chg="del">
          <ac:chgData name="Manasweeta Angane" userId="05da2731-9352-4b35-b713-60351f56afbd" providerId="ADAL" clId="{56648E15-03AE-499C-9A09-94B4A17BC0DB}" dt="2023-05-19T03:37:28.945" v="155" actId="478"/>
          <ac:grpSpMkLst>
            <pc:docMk/>
            <pc:sldMk cId="1417210217" sldId="298"/>
            <ac:grpSpMk id="2" creationId="{3A4A3B8D-71E8-485F-B477-237D5D7EC03E}"/>
          </ac:grpSpMkLst>
        </pc:grpChg>
        <pc:graphicFrameChg chg="add del mod">
          <ac:chgData name="Manasweeta Angane" userId="05da2731-9352-4b35-b713-60351f56afbd" providerId="ADAL" clId="{56648E15-03AE-499C-9A09-94B4A17BC0DB}" dt="2023-05-19T03:44:14.299" v="160" actId="478"/>
          <ac:graphicFrameMkLst>
            <pc:docMk/>
            <pc:sldMk cId="1417210217" sldId="298"/>
            <ac:graphicFrameMk id="9" creationId="{B90CE671-4BD7-1B60-8AE5-1D386F5C1E57}"/>
          </ac:graphicFrameMkLst>
        </pc:graphicFrameChg>
        <pc:graphicFrameChg chg="add del mod">
          <ac:chgData name="Manasweeta Angane" userId="05da2731-9352-4b35-b713-60351f56afbd" providerId="ADAL" clId="{56648E15-03AE-499C-9A09-94B4A17BC0DB}" dt="2023-05-19T03:44:36.694" v="162"/>
          <ac:graphicFrameMkLst>
            <pc:docMk/>
            <pc:sldMk cId="1417210217" sldId="298"/>
            <ac:graphicFrameMk id="10" creationId="{C0AD2A13-2365-3406-16A9-87CB209A4764}"/>
          </ac:graphicFrameMkLst>
        </pc:graphicFrameChg>
        <pc:graphicFrameChg chg="add mod modGraphic">
          <ac:chgData name="Manasweeta Angane" userId="05da2731-9352-4b35-b713-60351f56afbd" providerId="ADAL" clId="{56648E15-03AE-499C-9A09-94B4A17BC0DB}" dt="2023-05-19T03:51:32.056" v="189" actId="14734"/>
          <ac:graphicFrameMkLst>
            <pc:docMk/>
            <pc:sldMk cId="1417210217" sldId="298"/>
            <ac:graphicFrameMk id="17" creationId="{24870EB8-A193-932B-9A24-02C1753FA340}"/>
          </ac:graphicFrameMkLst>
        </pc:graphicFrameChg>
        <pc:picChg chg="del">
          <ac:chgData name="Manasweeta Angane" userId="05da2731-9352-4b35-b713-60351f56afbd" providerId="ADAL" clId="{56648E15-03AE-499C-9A09-94B4A17BC0DB}" dt="2023-05-19T03:37:30.011" v="156" actId="478"/>
          <ac:picMkLst>
            <pc:docMk/>
            <pc:sldMk cId="1417210217" sldId="298"/>
            <ac:picMk id="27" creationId="{4B6F685A-C7CB-FC97-6622-CD8F7889E257}"/>
          </ac:picMkLst>
        </pc:picChg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3738010429" sldId="298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2478878667" sldId="299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3664014045" sldId="300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2580936858" sldId="301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1184162767" sldId="302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1394747819" sldId="303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411859700" sldId="304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2938349037" sldId="305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2867490092" sldId="307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1466805410" sldId="308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2017596650" sldId="309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2034698016" sldId="310"/>
        </pc:sldMkLst>
      </pc:sldChg>
      <pc:sldChg chg="del">
        <pc:chgData name="Manasweeta Angane" userId="05da2731-9352-4b35-b713-60351f56afbd" providerId="ADAL" clId="{56648E15-03AE-499C-9A09-94B4A17BC0DB}" dt="2023-05-05T00:16:44.923" v="1" actId="2696"/>
        <pc:sldMkLst>
          <pc:docMk/>
          <pc:sldMk cId="3124133690" sldId="311"/>
        </pc:sldMkLst>
      </pc:sldChg>
      <pc:sldMasterChg chg="delSldLayout">
        <pc:chgData name="Manasweeta Angane" userId="05da2731-9352-4b35-b713-60351f56afbd" providerId="ADAL" clId="{56648E15-03AE-499C-9A09-94B4A17BC0DB}" dt="2023-05-05T00:16:44.923" v="1" actId="2696"/>
        <pc:sldMasterMkLst>
          <pc:docMk/>
          <pc:sldMasterMk cId="1446668091" sldId="2147483682"/>
        </pc:sldMasterMkLst>
        <pc:sldLayoutChg chg="del">
          <pc:chgData name="Manasweeta Angane" userId="05da2731-9352-4b35-b713-60351f56afbd" providerId="ADAL" clId="{56648E15-03AE-499C-9A09-94B4A17BC0DB}" dt="2023-05-05T00:16:44.923" v="1" actId="2696"/>
          <pc:sldLayoutMkLst>
            <pc:docMk/>
            <pc:sldMasterMk cId="1446668091" sldId="2147483682"/>
            <pc:sldLayoutMk cId="606905729" sldId="2147483694"/>
          </pc:sldLayoutMkLst>
        </pc:sldLayoutChg>
      </pc:sldMasterChg>
    </pc:docChg>
  </pc:docChgLst>
</pc:chgInfo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22-10-10T09:36:55.821"/>
    </inkml:context>
    <inkml:brush xml:id="br0">
      <inkml:brushProperty name="width" value="0.05" units="cm"/>
      <inkml:brushProperty name="height" value="0.05" units="cm"/>
      <inkml:brushProperty name="ignorePressure" value="1"/>
    </inkml:brush>
  </inkml:definitions>
  <inkml:trace contextRef="#ctx0" brushRef="#br0">1 0,'0'0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57922D-F0A1-4025-BD06-AF8FDF61A205}" type="datetimeFigureOut">
              <a:rPr lang="en-NZ" smtClean="0"/>
              <a:t>12/06/2023</a:t>
            </a:fld>
            <a:endParaRPr lang="en-N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NZ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781F41-9CD0-4EBE-B8D5-0498ABD0BCB6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8982822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1pPr>
    <a:lvl2pPr marL="3429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2pPr>
    <a:lvl3pPr marL="6858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3pPr>
    <a:lvl4pPr marL="10287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4pPr>
    <a:lvl5pPr marL="13716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5pPr>
    <a:lvl6pPr marL="17145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6pPr>
    <a:lvl7pPr marL="20574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7pPr>
    <a:lvl8pPr marL="24003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8pPr>
    <a:lvl9pPr marL="2743200" algn="l" defTabSz="685800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216657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92EE5-A5DC-457F-9FAA-ADACF1BB8B45}" type="datetimeFigureOut">
              <a:rPr lang="en-IN" smtClean="0"/>
              <a:t>12-06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0B436-1AC9-4A23-BECF-1D148F7225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77195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73844"/>
            <a:ext cx="7886700" cy="99417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260872"/>
            <a:ext cx="3887391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878806"/>
            <a:ext cx="3887391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92EE5-A5DC-457F-9FAA-ADACF1BB8B45}" type="datetimeFigureOut">
              <a:rPr lang="en-IN" smtClean="0"/>
              <a:t>12-06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0B436-1AC9-4A23-BECF-1D148F7225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0616822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92EE5-A5DC-457F-9FAA-ADACF1BB8B45}" type="datetimeFigureOut">
              <a:rPr lang="en-IN" smtClean="0"/>
              <a:t>12-06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0B436-1AC9-4A23-BECF-1D148F7225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3075870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92EE5-A5DC-457F-9FAA-ADACF1BB8B45}" type="datetimeFigureOut">
              <a:rPr lang="en-IN" smtClean="0"/>
              <a:t>12-06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0B436-1AC9-4A23-BECF-1D148F7225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4976358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92EE5-A5DC-457F-9FAA-ADACF1BB8B45}" type="datetimeFigureOut">
              <a:rPr lang="en-IN" smtClean="0"/>
              <a:t>12-06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0B436-1AC9-4A23-BECF-1D148F7225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079414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740569"/>
            <a:ext cx="4629150" cy="365521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92EE5-A5DC-457F-9FAA-ADACF1BB8B45}" type="datetimeFigureOut">
              <a:rPr lang="en-IN" smtClean="0"/>
              <a:t>12-06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0B436-1AC9-4A23-BECF-1D148F7225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0572038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92EE5-A5DC-457F-9FAA-ADACF1BB8B45}" type="datetimeFigureOut">
              <a:rPr lang="en-IN" smtClean="0"/>
              <a:t>12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0B436-1AC9-4A23-BECF-1D148F7225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3734601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73844"/>
            <a:ext cx="1971675" cy="43588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73844"/>
            <a:ext cx="5800725" cy="435887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92EE5-A5DC-457F-9FAA-ADACF1BB8B45}" type="datetimeFigureOut">
              <a:rPr lang="en-IN" smtClean="0"/>
              <a:t>12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0B436-1AC9-4A23-BECF-1D148F7225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67117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-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6174F8-1206-42B4-8253-0D1E82F521D8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387820" y="730531"/>
            <a:ext cx="8368363" cy="173255"/>
          </a:xfrm>
          <a:prstGeom prst="rect">
            <a:avLst/>
          </a:prstGeom>
        </p:spPr>
        <p:txBody>
          <a:bodyPr wrap="none" lIns="0" tIns="0" rIns="0" bIns="0" anchor="ctr">
            <a:noAutofit/>
          </a:bodyPr>
          <a:lstStyle>
            <a:lvl1pPr marL="0" indent="0" algn="l">
              <a:buNone/>
              <a:defRPr sz="1100" b="0" baseline="0">
                <a:solidFill>
                  <a:schemeClr val="bg1">
                    <a:lumMod val="50000"/>
                  </a:schemeClr>
                </a:solidFill>
                <a:latin typeface="+mj-lt"/>
                <a:ea typeface="Roboto" panose="02000000000000000000" pitchFamily="2" charset="0"/>
              </a:defRPr>
            </a:lvl1pPr>
            <a:lvl2pPr marL="457178" indent="0">
              <a:buNone/>
              <a:defRPr sz="1200"/>
            </a:lvl2pPr>
            <a:lvl3pPr marL="914354" indent="0">
              <a:buNone/>
              <a:defRPr sz="1000"/>
            </a:lvl3pPr>
            <a:lvl4pPr marL="1371532" indent="0">
              <a:buNone/>
              <a:defRPr sz="900"/>
            </a:lvl4pPr>
            <a:lvl5pPr marL="1828709" indent="0">
              <a:buNone/>
              <a:defRPr sz="900"/>
            </a:lvl5pPr>
            <a:lvl6pPr marL="2285886" indent="0">
              <a:buNone/>
              <a:defRPr sz="900"/>
            </a:lvl6pPr>
            <a:lvl7pPr marL="2743063" indent="0">
              <a:buNone/>
              <a:defRPr sz="900"/>
            </a:lvl7pPr>
            <a:lvl8pPr marL="3200240" indent="0">
              <a:buNone/>
              <a:defRPr sz="900"/>
            </a:lvl8pPr>
            <a:lvl9pPr marL="3657418" indent="0">
              <a:buNone/>
              <a:defRPr sz="900"/>
            </a:lvl9pPr>
          </a:lstStyle>
          <a:p>
            <a:pPr lvl="0"/>
            <a:r>
              <a:rPr lang="en-US" dirty="0"/>
              <a:t>CLICK TO EDITE SUBTITLE</a:t>
            </a:r>
          </a:p>
        </p:txBody>
      </p:sp>
      <p:sp>
        <p:nvSpPr>
          <p:cNvPr id="5" name="Title 2">
            <a:extLst>
              <a:ext uri="{FF2B5EF4-FFF2-40B4-BE49-F238E27FC236}">
                <a16:creationId xmlns:a16="http://schemas.microsoft.com/office/drawing/2014/main" id="{CE59A572-76E8-4055-881A-EC3A9E6FDA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7820" y="282612"/>
            <a:ext cx="8368363" cy="409459"/>
          </a:xfrm>
          <a:prstGeom prst="rect">
            <a:avLst/>
          </a:prstGeom>
        </p:spPr>
        <p:txBody>
          <a:bodyPr lIns="0" tIns="0" rIns="0" bIns="0" anchor="ctr"/>
          <a:lstStyle>
            <a:lvl1pPr algn="l">
              <a:defRPr sz="280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78972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SPTD0008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3949701" y="0"/>
            <a:ext cx="5194300" cy="5143500"/>
          </a:xfrm>
          <a:custGeom>
            <a:avLst/>
            <a:gdLst>
              <a:gd name="connsiteX0" fmla="*/ 1762115 w 5194300"/>
              <a:gd name="connsiteY0" fmla="*/ 0 h 5143500"/>
              <a:gd name="connsiteX1" fmla="*/ 3362315 w 5194300"/>
              <a:gd name="connsiteY1" fmla="*/ 0 h 5143500"/>
              <a:gd name="connsiteX2" fmla="*/ 3594100 w 5194300"/>
              <a:gd name="connsiteY2" fmla="*/ 0 h 5143500"/>
              <a:gd name="connsiteX3" fmla="*/ 5194300 w 5194300"/>
              <a:gd name="connsiteY3" fmla="*/ 0 h 5143500"/>
              <a:gd name="connsiteX4" fmla="*/ 3432185 w 5194300"/>
              <a:gd name="connsiteY4" fmla="*/ 5143500 h 5143500"/>
              <a:gd name="connsiteX5" fmla="*/ 1831985 w 5194300"/>
              <a:gd name="connsiteY5" fmla="*/ 5143500 h 5143500"/>
              <a:gd name="connsiteX6" fmla="*/ 1600200 w 5194300"/>
              <a:gd name="connsiteY6" fmla="*/ 5143500 h 5143500"/>
              <a:gd name="connsiteX7" fmla="*/ 0 w 5194300"/>
              <a:gd name="connsiteY7" fmla="*/ 5143500 h 51435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5194300" h="5143500">
                <a:moveTo>
                  <a:pt x="1762115" y="0"/>
                </a:moveTo>
                <a:lnTo>
                  <a:pt x="3362315" y="0"/>
                </a:lnTo>
                <a:lnTo>
                  <a:pt x="3594100" y="0"/>
                </a:lnTo>
                <a:lnTo>
                  <a:pt x="5194300" y="0"/>
                </a:lnTo>
                <a:lnTo>
                  <a:pt x="3432185" y="5143500"/>
                </a:lnTo>
                <a:lnTo>
                  <a:pt x="1831985" y="5143500"/>
                </a:lnTo>
                <a:lnTo>
                  <a:pt x="1600200" y="5143500"/>
                </a:lnTo>
                <a:lnTo>
                  <a:pt x="0" y="5143500"/>
                </a:lnTo>
                <a:close/>
              </a:path>
            </a:pathLst>
          </a:custGeom>
          <a:solidFill>
            <a:schemeClr val="tx1">
              <a:lumMod val="10000"/>
              <a:lumOff val="90000"/>
            </a:schemeClr>
          </a:solidFill>
        </p:spPr>
        <p:txBody>
          <a:bodyPr wrap="square" tIns="1548000" bIns="274320" anchor="ctr">
            <a:noAutofit/>
          </a:bodyPr>
          <a:lstStyle>
            <a:lvl1pPr marL="0" indent="0" algn="ctr">
              <a:buNone/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n-US"/>
              <a:t>Click icon to add picture</a:t>
            </a:r>
          </a:p>
        </p:txBody>
      </p:sp>
    </p:spTree>
    <p:extLst>
      <p:ext uri="{BB962C8B-B14F-4D97-AF65-F5344CB8AC3E}">
        <p14:creationId xmlns:p14="http://schemas.microsoft.com/office/powerpoint/2010/main" val="876340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SDT 10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 bwMode="auto">
          <a:xfrm>
            <a:off x="0" y="0"/>
            <a:ext cx="9144000" cy="5143500"/>
          </a:xfrm>
          <a:prstGeom prst="rect">
            <a:avLst/>
          </a:prstGeom>
          <a:solidFill>
            <a:schemeClr val="accent2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rtlCol="0" anchor="ctr" anchorCtr="0" compatLnSpc="1">
            <a:prstTxWarp prst="textNoShape">
              <a:avLst/>
            </a:prstTxWarp>
          </a:bodyPr>
          <a:lstStyle/>
          <a:p>
            <a:pPr algn="ctr"/>
            <a:endParaRPr lang="en-US" sz="28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75675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19B6F8-DE48-4A81-8211-58F9E331BE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78F2A6-A36E-4F77-B733-926699F35D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2D394D-A0F2-4B90-AB91-602AA46F88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A6ADCA-4E8D-45EA-9B62-D833961F8F44}" type="datetimeFigureOut">
              <a:rPr lang="en-IN" smtClean="0"/>
              <a:t>12-06-2023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3153A1-154C-4884-9A56-40609297A5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67F270-F105-4B60-9085-DF8D284A3E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8E8E8-614F-40C4-AC49-7AF2596773E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76942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235AB1-3A9D-4256-B6BB-6B3272A5686D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387820" y="730531"/>
            <a:ext cx="8368363" cy="173255"/>
          </a:xfrm>
          <a:prstGeom prst="rect">
            <a:avLst/>
          </a:prstGeom>
        </p:spPr>
        <p:txBody>
          <a:bodyPr wrap="none" lIns="0" tIns="0" rIns="0" bIns="0" anchor="ctr">
            <a:noAutofit/>
          </a:bodyPr>
          <a:lstStyle>
            <a:lvl1pPr marL="0" indent="0" algn="l">
              <a:buNone/>
              <a:defRPr sz="1100" b="0" baseline="0">
                <a:solidFill>
                  <a:schemeClr val="bg1"/>
                </a:solidFill>
                <a:latin typeface="+mj-lt"/>
                <a:ea typeface="Roboto" panose="02000000000000000000" pitchFamily="2" charset="0"/>
              </a:defRPr>
            </a:lvl1pPr>
            <a:lvl2pPr marL="457178" indent="0">
              <a:buNone/>
              <a:defRPr sz="1200"/>
            </a:lvl2pPr>
            <a:lvl3pPr marL="914354" indent="0">
              <a:buNone/>
              <a:defRPr sz="1000"/>
            </a:lvl3pPr>
            <a:lvl4pPr marL="1371532" indent="0">
              <a:buNone/>
              <a:defRPr sz="900"/>
            </a:lvl4pPr>
            <a:lvl5pPr marL="1828709" indent="0">
              <a:buNone/>
              <a:defRPr sz="900"/>
            </a:lvl5pPr>
            <a:lvl6pPr marL="2285886" indent="0">
              <a:buNone/>
              <a:defRPr sz="900"/>
            </a:lvl6pPr>
            <a:lvl7pPr marL="2743063" indent="0">
              <a:buNone/>
              <a:defRPr sz="900"/>
            </a:lvl7pPr>
            <a:lvl8pPr marL="3200240" indent="0">
              <a:buNone/>
              <a:defRPr sz="900"/>
            </a:lvl8pPr>
            <a:lvl9pPr marL="3657418" indent="0">
              <a:buNone/>
              <a:defRPr sz="900"/>
            </a:lvl9pPr>
          </a:lstStyle>
          <a:p>
            <a:pPr lvl="0"/>
            <a:r>
              <a:rPr lang="en-US" dirty="0"/>
              <a:t>CLICK TO EDITE SUBTITLE</a:t>
            </a:r>
          </a:p>
        </p:txBody>
      </p:sp>
      <p:sp>
        <p:nvSpPr>
          <p:cNvPr id="5" name="Title 2">
            <a:extLst>
              <a:ext uri="{FF2B5EF4-FFF2-40B4-BE49-F238E27FC236}">
                <a16:creationId xmlns:a16="http://schemas.microsoft.com/office/drawing/2014/main" id="{2C460F2B-268D-49B2-9922-3D4C88D7F6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7820" y="282612"/>
            <a:ext cx="8368363" cy="409459"/>
          </a:xfrm>
          <a:prstGeom prst="rect">
            <a:avLst/>
          </a:prstGeom>
        </p:spPr>
        <p:txBody>
          <a:bodyPr lIns="0" tIns="0" rIns="0" bIns="0" anchor="ctr"/>
          <a:lstStyle>
            <a:lvl1pPr algn="l">
              <a:defRPr sz="2800">
                <a:solidFill>
                  <a:schemeClr val="bg1"/>
                </a:solidFill>
                <a:latin typeface="+mj-l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67067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A6ADCA-4E8D-45EA-9B62-D833961F8F44}" type="datetimeFigureOut">
              <a:rPr lang="en-IN" smtClean="0"/>
              <a:t>12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8E8E8-614F-40C4-AC49-7AF2596773E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9554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92EE5-A5DC-457F-9FAA-ADACF1BB8B45}" type="datetimeFigureOut">
              <a:rPr lang="en-IN" smtClean="0"/>
              <a:t>12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0B436-1AC9-4A23-BECF-1D148F7225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71130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282304"/>
            <a:ext cx="7886700" cy="213955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442098"/>
            <a:ext cx="7886700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92EE5-A5DC-457F-9FAA-ADACF1BB8B45}" type="datetimeFigureOut">
              <a:rPr lang="en-IN" smtClean="0"/>
              <a:t>12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0B436-1AC9-4A23-BECF-1D148F7225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05674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2.xml"/><Relationship Id="rId1" Type="http://schemas.openxmlformats.org/officeDocument/2006/relationships/slideLayout" Target="../slideLayouts/slideLayout6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4.xml"/><Relationship Id="rId3" Type="http://schemas.openxmlformats.org/officeDocument/2006/relationships/slideLayout" Target="../slideLayouts/slideLayout9.xml"/><Relationship Id="rId7" Type="http://schemas.openxmlformats.org/officeDocument/2006/relationships/slideLayout" Target="../slideLayouts/slideLayout13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8.xml"/><Relationship Id="rId1" Type="http://schemas.openxmlformats.org/officeDocument/2006/relationships/slideLayout" Target="../slideLayouts/slideLayout7.xml"/><Relationship Id="rId6" Type="http://schemas.openxmlformats.org/officeDocument/2006/relationships/slideLayout" Target="../slideLayouts/slideLayout12.xml"/><Relationship Id="rId11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0.xml"/><Relationship Id="rId9" Type="http://schemas.openxmlformats.org/officeDocument/2006/relationships/slideLayout" Target="../slideLayouts/slideLayout1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>
            <a:alpha val="7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Inhaltsplatzhalter 4"/>
          <p:cNvSpPr txBox="1">
            <a:spLocks/>
          </p:cNvSpPr>
          <p:nvPr/>
        </p:nvSpPr>
        <p:spPr>
          <a:xfrm>
            <a:off x="5715000" y="4849916"/>
            <a:ext cx="3048000" cy="138499"/>
          </a:xfrm>
          <a:prstGeom prst="rect">
            <a:avLst/>
          </a:prstGeom>
        </p:spPr>
        <p:txBody>
          <a:bodyPr wrap="square" lIns="0" tIns="0" rIns="0" bIns="0" anchor="ctr">
            <a:spAutoFit/>
          </a:bodyPr>
          <a:lstStyle>
            <a:lvl1pPr marL="272967" indent="-272967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Wingdings" panose="05000000000000000000" pitchFamily="2" charset="2"/>
              <a:buChar char="§"/>
              <a:defRPr sz="23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1pPr>
            <a:lvl2pPr marL="807798" indent="-272967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20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2pPr>
            <a:lvl3pPr marL="1080764" indent="-177748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9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3pPr>
            <a:lvl4pPr marL="1436256" indent="-177748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6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4pPr>
            <a:lvl5pPr marL="1793335" indent="-179335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6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5pPr>
            <a:lvl6pPr marL="2513847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0910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7972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5034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r">
              <a:buNone/>
            </a:pPr>
            <a:r>
              <a:rPr lang="en-US" sz="1000" kern="1200" dirty="0">
                <a:solidFill>
                  <a:schemeClr val="bg1">
                    <a:lumMod val="75000"/>
                  </a:schemeClr>
                </a:solidFill>
                <a:effectLst/>
                <a:latin typeface="Calibri Light" panose="020F0302020204030204" pitchFamily="34" charset="0"/>
                <a:ea typeface="+mn-ea"/>
                <a:cs typeface="+mn-cs"/>
              </a:rPr>
              <a:t>Copyright (C)</a:t>
            </a:r>
            <a:r>
              <a:rPr lang="en-US" sz="1000" kern="1200" baseline="0" dirty="0">
                <a:solidFill>
                  <a:schemeClr val="bg1">
                    <a:lumMod val="75000"/>
                  </a:schemeClr>
                </a:solidFill>
                <a:effectLst/>
                <a:latin typeface="Calibri Light" panose="020F0302020204030204" pitchFamily="34" charset="0"/>
                <a:ea typeface="+mn-ea"/>
                <a:cs typeface="+mn-cs"/>
              </a:rPr>
              <a:t> </a:t>
            </a:r>
            <a:r>
              <a:rPr lang="en-US" sz="1000" kern="1200" dirty="0">
                <a:solidFill>
                  <a:schemeClr val="bg1">
                    <a:lumMod val="75000"/>
                  </a:schemeClr>
                </a:solidFill>
                <a:effectLst/>
                <a:latin typeface="Calibri Light" panose="020F0302020204030204" pitchFamily="34" charset="0"/>
                <a:ea typeface="+mn-ea"/>
                <a:cs typeface="+mn-cs"/>
              </a:rPr>
              <a:t>SlideSalad.com All rights reserved.</a:t>
            </a:r>
          </a:p>
        </p:txBody>
      </p:sp>
      <p:sp>
        <p:nvSpPr>
          <p:cNvPr id="15" name="Inhaltsplatzhalter 4"/>
          <p:cNvSpPr txBox="1">
            <a:spLocks/>
          </p:cNvSpPr>
          <p:nvPr/>
        </p:nvSpPr>
        <p:spPr>
          <a:xfrm>
            <a:off x="400050" y="4849916"/>
            <a:ext cx="3048000" cy="138499"/>
          </a:xfrm>
          <a:prstGeom prst="rect">
            <a:avLst/>
          </a:prstGeom>
        </p:spPr>
        <p:txBody>
          <a:bodyPr wrap="square" lIns="0" tIns="0" rIns="0" bIns="0" anchor="ctr">
            <a:spAutoFit/>
          </a:bodyPr>
          <a:lstStyle>
            <a:lvl1pPr marL="272967" indent="-272967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Wingdings" panose="05000000000000000000" pitchFamily="2" charset="2"/>
              <a:buChar char="§"/>
              <a:defRPr sz="23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1pPr>
            <a:lvl2pPr marL="807798" indent="-272967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20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2pPr>
            <a:lvl3pPr marL="1080764" indent="-177748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9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3pPr>
            <a:lvl4pPr marL="1436256" indent="-177748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6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4pPr>
            <a:lvl5pPr marL="1793335" indent="-179335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6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5pPr>
            <a:lvl6pPr marL="2513847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0910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7972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5034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l">
              <a:buNone/>
            </a:pPr>
            <a:r>
              <a:rPr lang="en-US" sz="1000" kern="1200" dirty="0">
                <a:solidFill>
                  <a:schemeClr val="bg1">
                    <a:lumMod val="75000"/>
                  </a:schemeClr>
                </a:solidFill>
                <a:effectLst/>
                <a:latin typeface="Calibri Light" panose="020F0302020204030204" pitchFamily="34" charset="0"/>
                <a:ea typeface="+mn-ea"/>
                <a:cs typeface="+mn-cs"/>
              </a:rPr>
              <a:t>Free SlideSalad</a:t>
            </a:r>
            <a:r>
              <a:rPr lang="en-US" sz="1000" kern="1200" baseline="0" dirty="0">
                <a:solidFill>
                  <a:schemeClr val="bg1">
                    <a:lumMod val="75000"/>
                  </a:schemeClr>
                </a:solidFill>
                <a:effectLst/>
                <a:latin typeface="Calibri Light" panose="020F0302020204030204" pitchFamily="34" charset="0"/>
                <a:ea typeface="+mn-ea"/>
                <a:cs typeface="+mn-cs"/>
              </a:rPr>
              <a:t> PowerPoint Template</a:t>
            </a:r>
            <a:endParaRPr lang="en-US" sz="1000" kern="1200" dirty="0">
              <a:solidFill>
                <a:schemeClr val="bg1">
                  <a:lumMod val="75000"/>
                </a:schemeClr>
              </a:solidFill>
              <a:effectLst/>
              <a:latin typeface="Calibri Light" panose="020F0302020204030204" pitchFamily="34" charset="0"/>
              <a:ea typeface="+mn-ea"/>
              <a:cs typeface="+mn-cs"/>
            </a:endParaRPr>
          </a:p>
        </p:txBody>
      </p:sp>
      <p:cxnSp>
        <p:nvCxnSpPr>
          <p:cNvPr id="17" name="Straight Connector 16"/>
          <p:cNvCxnSpPr/>
          <p:nvPr/>
        </p:nvCxnSpPr>
        <p:spPr>
          <a:xfrm>
            <a:off x="0" y="4682490"/>
            <a:ext cx="9144000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1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8600" y="4826200"/>
            <a:ext cx="1066802" cy="1859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6274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 algn="ctr" defTabSz="914378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2" indent="-342892" algn="l" defTabSz="914378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1" indent="-285743" algn="l" defTabSz="914378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8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914378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>
            <a:alpha val="7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0" y="0"/>
            <a:ext cx="9144000" cy="5143500"/>
          </a:xfrm>
          <a:prstGeom prst="rect">
            <a:avLst/>
          </a:prstGeom>
          <a:solidFill>
            <a:srgbClr val="72B35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7" name="Inhaltsplatzhalter 4"/>
          <p:cNvSpPr txBox="1">
            <a:spLocks/>
          </p:cNvSpPr>
          <p:nvPr/>
        </p:nvSpPr>
        <p:spPr>
          <a:xfrm>
            <a:off x="5715000" y="4849916"/>
            <a:ext cx="3048000" cy="138499"/>
          </a:xfrm>
          <a:prstGeom prst="rect">
            <a:avLst/>
          </a:prstGeom>
        </p:spPr>
        <p:txBody>
          <a:bodyPr wrap="square" lIns="0" tIns="0" rIns="0" bIns="0" anchor="ctr">
            <a:spAutoFit/>
          </a:bodyPr>
          <a:lstStyle>
            <a:lvl1pPr marL="272967" indent="-272967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Wingdings" panose="05000000000000000000" pitchFamily="2" charset="2"/>
              <a:buChar char="§"/>
              <a:defRPr sz="23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1pPr>
            <a:lvl2pPr marL="807798" indent="-272967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20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2pPr>
            <a:lvl3pPr marL="1080764" indent="-177748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9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3pPr>
            <a:lvl4pPr marL="1436256" indent="-177748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6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4pPr>
            <a:lvl5pPr marL="1793335" indent="-179335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6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5pPr>
            <a:lvl6pPr marL="2513847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0910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7972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5034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r">
              <a:buNone/>
            </a:pPr>
            <a:r>
              <a:rPr lang="en-US" sz="1000" kern="1200" dirty="0">
                <a:solidFill>
                  <a:schemeClr val="bg1"/>
                </a:solidFill>
                <a:effectLst/>
                <a:latin typeface="Calibri Light" panose="020F0302020204030204" pitchFamily="34" charset="0"/>
                <a:ea typeface="+mn-ea"/>
                <a:cs typeface="+mn-cs"/>
              </a:rPr>
              <a:t>Copyright (C)</a:t>
            </a:r>
            <a:r>
              <a:rPr lang="en-US" sz="1000" kern="1200" baseline="0" dirty="0">
                <a:solidFill>
                  <a:schemeClr val="bg1"/>
                </a:solidFill>
                <a:effectLst/>
                <a:latin typeface="Calibri Light" panose="020F0302020204030204" pitchFamily="34" charset="0"/>
                <a:ea typeface="+mn-ea"/>
                <a:cs typeface="+mn-cs"/>
              </a:rPr>
              <a:t> </a:t>
            </a:r>
            <a:r>
              <a:rPr lang="en-US" sz="1000" kern="1200" dirty="0">
                <a:solidFill>
                  <a:schemeClr val="bg1"/>
                </a:solidFill>
                <a:effectLst/>
                <a:latin typeface="Calibri Light" panose="020F0302020204030204" pitchFamily="34" charset="0"/>
                <a:ea typeface="+mn-ea"/>
                <a:cs typeface="+mn-cs"/>
              </a:rPr>
              <a:t>SlideSalad.com All rights reserved.</a:t>
            </a:r>
          </a:p>
        </p:txBody>
      </p:sp>
      <p:sp>
        <p:nvSpPr>
          <p:cNvPr id="8" name="Inhaltsplatzhalter 4"/>
          <p:cNvSpPr txBox="1">
            <a:spLocks/>
          </p:cNvSpPr>
          <p:nvPr/>
        </p:nvSpPr>
        <p:spPr>
          <a:xfrm>
            <a:off x="400050" y="4849916"/>
            <a:ext cx="3048000" cy="138499"/>
          </a:xfrm>
          <a:prstGeom prst="rect">
            <a:avLst/>
          </a:prstGeom>
        </p:spPr>
        <p:txBody>
          <a:bodyPr wrap="square" lIns="0" tIns="0" rIns="0" bIns="0" anchor="ctr">
            <a:spAutoFit/>
          </a:bodyPr>
          <a:lstStyle>
            <a:lvl1pPr marL="272967" indent="-272967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Wingdings" panose="05000000000000000000" pitchFamily="2" charset="2"/>
              <a:buChar char="§"/>
              <a:defRPr sz="23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1pPr>
            <a:lvl2pPr marL="807798" indent="-272967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20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2pPr>
            <a:lvl3pPr marL="1080764" indent="-177748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9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3pPr>
            <a:lvl4pPr marL="1436256" indent="-177748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6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4pPr>
            <a:lvl5pPr marL="1793335" indent="-179335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6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5pPr>
            <a:lvl6pPr marL="2513847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0910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7972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5034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l">
              <a:buNone/>
            </a:pPr>
            <a:r>
              <a:rPr lang="en-US" sz="1000" kern="1200" dirty="0">
                <a:solidFill>
                  <a:schemeClr val="bg1"/>
                </a:solidFill>
                <a:effectLst/>
                <a:latin typeface="Calibri Light" panose="020F0302020204030204" pitchFamily="34" charset="0"/>
                <a:ea typeface="+mn-ea"/>
                <a:cs typeface="+mn-cs"/>
              </a:rPr>
              <a:t>Free SlideSalad</a:t>
            </a:r>
            <a:r>
              <a:rPr lang="en-US" sz="1000" kern="1200" baseline="0" dirty="0">
                <a:solidFill>
                  <a:schemeClr val="bg1"/>
                </a:solidFill>
                <a:effectLst/>
                <a:latin typeface="Calibri Light" panose="020F0302020204030204" pitchFamily="34" charset="0"/>
                <a:ea typeface="+mn-ea"/>
                <a:cs typeface="+mn-cs"/>
              </a:rPr>
              <a:t> PowerPoint Template</a:t>
            </a:r>
            <a:endParaRPr lang="en-US" sz="1000" kern="1200" dirty="0">
              <a:solidFill>
                <a:schemeClr val="bg1"/>
              </a:solidFill>
              <a:effectLst/>
              <a:latin typeface="Calibri Light" panose="020F0302020204030204" pitchFamily="34" charset="0"/>
              <a:ea typeface="+mn-ea"/>
              <a:cs typeface="+mn-cs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8600" y="4826200"/>
            <a:ext cx="1066802" cy="185928"/>
          </a:xfrm>
          <a:prstGeom prst="rect">
            <a:avLst/>
          </a:prstGeom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1033B07F-7277-437C-B588-EC1DB23275A6}"/>
              </a:ext>
            </a:extLst>
          </p:cNvPr>
          <p:cNvCxnSpPr/>
          <p:nvPr/>
        </p:nvCxnSpPr>
        <p:spPr>
          <a:xfrm>
            <a:off x="0" y="4682490"/>
            <a:ext cx="9144000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24890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7" r:id="rId1"/>
  </p:sldLayoutIdLst>
  <p:txStyles>
    <p:titleStyle>
      <a:lvl1pPr algn="l" defTabSz="914378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8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273844"/>
            <a:ext cx="7886700" cy="9941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369219"/>
            <a:ext cx="7886700" cy="3263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6/12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6668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3" r:id="rId1"/>
    <p:sldLayoutId id="2147483684" r:id="rId2"/>
    <p:sldLayoutId id="2147483685" r:id="rId3"/>
    <p:sldLayoutId id="2147483686" r:id="rId4"/>
    <p:sldLayoutId id="2147483687" r:id="rId5"/>
    <p:sldLayoutId id="2147483688" r:id="rId6"/>
    <p:sldLayoutId id="2147483689" r:id="rId7"/>
    <p:sldLayoutId id="2147483690" r:id="rId8"/>
    <p:sldLayoutId id="2147483691" r:id="rId9"/>
    <p:sldLayoutId id="2147483692" r:id="rId10"/>
    <p:sldLayoutId id="214748369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8.jpeg"/><Relationship Id="rId18" Type="http://schemas.openxmlformats.org/officeDocument/2006/relationships/image" Target="../media/image11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30.png"/><Relationship Id="rId17" Type="http://schemas.openxmlformats.org/officeDocument/2006/relationships/image" Target="../media/image10.png"/><Relationship Id="rId2" Type="http://schemas.openxmlformats.org/officeDocument/2006/relationships/image" Target="../media/image2.png"/><Relationship Id="rId16" Type="http://schemas.microsoft.com/office/2007/relationships/hdphoto" Target="../media/hdphoto2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svg"/><Relationship Id="rId15" Type="http://schemas.openxmlformats.org/officeDocument/2006/relationships/image" Target="../media/image9.png"/><Relationship Id="rId4" Type="http://schemas.openxmlformats.org/officeDocument/2006/relationships/image" Target="../media/image4.svg"/><Relationship Id="rId9" Type="http://schemas.openxmlformats.org/officeDocument/2006/relationships/customXml" Target="../ink/ink1.xml"/><Relationship Id="rId14" Type="http://schemas.openxmlformats.org/officeDocument/2006/relationships/hyperlink" Target="http://sarah-thescienceofbeauty.blogspot.com/2013/07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emf"/><Relationship Id="rId4" Type="http://schemas.openxmlformats.org/officeDocument/2006/relationships/image" Target="../media/image14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F0E3FD0-07DB-4674-861B-D61E237388B2}"/>
              </a:ext>
            </a:extLst>
          </p:cNvPr>
          <p:cNvGrpSpPr/>
          <p:nvPr/>
        </p:nvGrpSpPr>
        <p:grpSpPr>
          <a:xfrm>
            <a:off x="180594" y="4800505"/>
            <a:ext cx="8673084" cy="219878"/>
            <a:chOff x="76200" y="4827470"/>
            <a:chExt cx="8991600" cy="182680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D6EA4027-C091-4519-B09D-E78F24FE1D11}"/>
                </a:ext>
              </a:extLst>
            </p:cNvPr>
            <p:cNvSpPr/>
            <p:nvPr/>
          </p:nvSpPr>
          <p:spPr bwMode="auto">
            <a:xfrm>
              <a:off x="4572000" y="4827470"/>
              <a:ext cx="2241550" cy="182680"/>
            </a:xfrm>
            <a:prstGeom prst="rect">
              <a:avLst/>
            </a:prstGeom>
            <a:solidFill>
              <a:srgbClr val="00206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en-IN" sz="1013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68BA112F-D749-47CD-8196-F14D98D7DC83}"/>
                </a:ext>
              </a:extLst>
            </p:cNvPr>
            <p:cNvSpPr/>
            <p:nvPr/>
          </p:nvSpPr>
          <p:spPr bwMode="auto">
            <a:xfrm>
              <a:off x="76200" y="4827470"/>
              <a:ext cx="2235200" cy="182680"/>
            </a:xfrm>
            <a:prstGeom prst="rect">
              <a:avLst/>
            </a:prstGeom>
            <a:solidFill>
              <a:srgbClr val="00206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en-IN" sz="1013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D4016A87-96B5-4034-8E84-06B9C380A90B}"/>
                </a:ext>
              </a:extLst>
            </p:cNvPr>
            <p:cNvSpPr/>
            <p:nvPr/>
          </p:nvSpPr>
          <p:spPr bwMode="auto">
            <a:xfrm>
              <a:off x="6832600" y="4827470"/>
              <a:ext cx="2235200" cy="182680"/>
            </a:xfrm>
            <a:prstGeom prst="rect">
              <a:avLst/>
            </a:prstGeom>
            <a:solidFill>
              <a:srgbClr val="FFCC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en-IN" sz="1013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6EAADF73-D41D-4D2D-8C30-FFCBCB826CD2}"/>
                </a:ext>
              </a:extLst>
            </p:cNvPr>
            <p:cNvSpPr/>
            <p:nvPr/>
          </p:nvSpPr>
          <p:spPr bwMode="auto">
            <a:xfrm>
              <a:off x="2324100" y="4827470"/>
              <a:ext cx="2235200" cy="182680"/>
            </a:xfrm>
            <a:prstGeom prst="rect">
              <a:avLst/>
            </a:prstGeom>
            <a:solidFill>
              <a:srgbClr val="FFCC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en-IN" sz="1013" dirty="0"/>
            </a:p>
          </p:txBody>
        </p:sp>
      </p:grpSp>
      <p:sp>
        <p:nvSpPr>
          <p:cNvPr id="18" name="Inhaltsplatzhalter 4">
            <a:extLst>
              <a:ext uri="{FF2B5EF4-FFF2-40B4-BE49-F238E27FC236}">
                <a16:creationId xmlns:a16="http://schemas.microsoft.com/office/drawing/2014/main" id="{45F2BEED-A6BE-45AE-BED7-62E52E5E5868}"/>
              </a:ext>
            </a:extLst>
          </p:cNvPr>
          <p:cNvSpPr txBox="1">
            <a:spLocks/>
          </p:cNvSpPr>
          <p:nvPr/>
        </p:nvSpPr>
        <p:spPr>
          <a:xfrm>
            <a:off x="1873727" y="288123"/>
            <a:ext cx="5170043" cy="5719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marL="272967" indent="-272967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Wingdings" panose="05000000000000000000" pitchFamily="2" charset="2"/>
              <a:buChar char="§"/>
              <a:defRPr sz="23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1pPr>
            <a:lvl2pPr marL="807798" indent="-272967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20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2pPr>
            <a:lvl3pPr marL="1080764" indent="-177748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9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3pPr>
            <a:lvl4pPr marL="1436256" indent="-177748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6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4pPr>
            <a:lvl5pPr marL="1793335" indent="-179335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6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5pPr>
            <a:lvl6pPr marL="2513847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0910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7972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5034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100000"/>
              </a:lnSpc>
              <a:spcAft>
                <a:spcPts val="450"/>
              </a:spcAft>
              <a:buNone/>
            </a:pPr>
            <a:r>
              <a:rPr lang="en-US" sz="1200" b="1" dirty="0">
                <a:solidFill>
                  <a:srgbClr val="262626">
                    <a:lumMod val="75000"/>
                    <a:lumOff val="25000"/>
                  </a:srgbClr>
                </a:solidFill>
                <a:latin typeface="Roboto"/>
              </a:rPr>
              <a:t>Appendix 1: Minimum inhibitory concentration (MIC) and minimum bactericidal concentration (MBC) assay</a:t>
            </a:r>
          </a:p>
          <a:p>
            <a:pPr marL="0" indent="0">
              <a:lnSpc>
                <a:spcPct val="100000"/>
              </a:lnSpc>
              <a:spcAft>
                <a:spcPts val="450"/>
              </a:spcAft>
              <a:buNone/>
            </a:pPr>
            <a:endParaRPr lang="en-US" sz="900" b="1" dirty="0">
              <a:solidFill>
                <a:srgbClr val="262626">
                  <a:lumMod val="75000"/>
                  <a:lumOff val="25000"/>
                </a:srgbClr>
              </a:solidFill>
              <a:latin typeface="Roboto"/>
            </a:endParaRPr>
          </a:p>
        </p:txBody>
      </p:sp>
      <p:pic>
        <p:nvPicPr>
          <p:cNvPr id="291" name="Picture 290">
            <a:extLst>
              <a:ext uri="{FF2B5EF4-FFF2-40B4-BE49-F238E27FC236}">
                <a16:creationId xmlns:a16="http://schemas.microsoft.com/office/drawing/2014/main" id="{787F1EDF-26F2-460F-B049-4D2C5933F4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5067" y="2368689"/>
            <a:ext cx="3597279" cy="2117324"/>
          </a:xfrm>
          <a:prstGeom prst="rect">
            <a:avLst/>
          </a:prstGeom>
        </p:spPr>
      </p:pic>
      <p:grpSp>
        <p:nvGrpSpPr>
          <p:cNvPr id="292" name="Group 291">
            <a:extLst>
              <a:ext uri="{FF2B5EF4-FFF2-40B4-BE49-F238E27FC236}">
                <a16:creationId xmlns:a16="http://schemas.microsoft.com/office/drawing/2014/main" id="{09C4DA82-B513-4C9B-AB38-CBAE629A0956}"/>
              </a:ext>
            </a:extLst>
          </p:cNvPr>
          <p:cNvGrpSpPr/>
          <p:nvPr/>
        </p:nvGrpSpPr>
        <p:grpSpPr>
          <a:xfrm>
            <a:off x="2738935" y="2664948"/>
            <a:ext cx="1955370" cy="869788"/>
            <a:chOff x="2644775" y="2669877"/>
            <a:chExt cx="2165311" cy="924148"/>
          </a:xfrm>
        </p:grpSpPr>
        <p:pic>
          <p:nvPicPr>
            <p:cNvPr id="335" name="Graphic 334" descr="Arrow Rotate right">
              <a:extLst>
                <a:ext uri="{FF2B5EF4-FFF2-40B4-BE49-F238E27FC236}">
                  <a16:creationId xmlns:a16="http://schemas.microsoft.com/office/drawing/2014/main" id="{42158EB5-E39B-4CA1-BF5A-37E14B8A08F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2644775" y="3336849"/>
              <a:ext cx="257176" cy="257176"/>
            </a:xfrm>
            <a:prstGeom prst="rect">
              <a:avLst/>
            </a:prstGeom>
          </p:spPr>
        </p:pic>
        <p:pic>
          <p:nvPicPr>
            <p:cNvPr id="336" name="Graphic 335" descr="Arrow Rotate right">
              <a:extLst>
                <a:ext uri="{FF2B5EF4-FFF2-40B4-BE49-F238E27FC236}">
                  <a16:creationId xmlns:a16="http://schemas.microsoft.com/office/drawing/2014/main" id="{AF9449CB-6B3E-4119-9571-A13BBC738B7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3248025" y="3143858"/>
              <a:ext cx="257176" cy="257176"/>
            </a:xfrm>
            <a:prstGeom prst="rect">
              <a:avLst/>
            </a:prstGeom>
          </p:spPr>
        </p:pic>
        <p:pic>
          <p:nvPicPr>
            <p:cNvPr id="337" name="Graphic 336" descr="Arrow Rotate right">
              <a:extLst>
                <a:ext uri="{FF2B5EF4-FFF2-40B4-BE49-F238E27FC236}">
                  <a16:creationId xmlns:a16="http://schemas.microsoft.com/office/drawing/2014/main" id="{37F3DED1-E6B8-4497-BD88-4B03EE4D04E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3054351" y="3204334"/>
              <a:ext cx="257176" cy="257176"/>
            </a:xfrm>
            <a:prstGeom prst="rect">
              <a:avLst/>
            </a:prstGeom>
          </p:spPr>
        </p:pic>
        <p:pic>
          <p:nvPicPr>
            <p:cNvPr id="338" name="Graphic 337" descr="Arrow Rotate right">
              <a:extLst>
                <a:ext uri="{FF2B5EF4-FFF2-40B4-BE49-F238E27FC236}">
                  <a16:creationId xmlns:a16="http://schemas.microsoft.com/office/drawing/2014/main" id="{C1C64546-BAEC-47C6-840D-33AB837F16F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3457062" y="3075746"/>
              <a:ext cx="257176" cy="257176"/>
            </a:xfrm>
            <a:prstGeom prst="rect">
              <a:avLst/>
            </a:prstGeom>
          </p:spPr>
        </p:pic>
        <p:pic>
          <p:nvPicPr>
            <p:cNvPr id="339" name="Graphic 338" descr="Arrow Rotate right">
              <a:extLst>
                <a:ext uri="{FF2B5EF4-FFF2-40B4-BE49-F238E27FC236}">
                  <a16:creationId xmlns:a16="http://schemas.microsoft.com/office/drawing/2014/main" id="{D1D74B07-C081-40F4-8F92-30AC26A60E6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3647561" y="2991662"/>
              <a:ext cx="257176" cy="257176"/>
            </a:xfrm>
            <a:prstGeom prst="rect">
              <a:avLst/>
            </a:prstGeom>
          </p:spPr>
        </p:pic>
        <p:pic>
          <p:nvPicPr>
            <p:cNvPr id="340" name="Graphic 339" descr="Arrow Rotate right">
              <a:extLst>
                <a:ext uri="{FF2B5EF4-FFF2-40B4-BE49-F238E27FC236}">
                  <a16:creationId xmlns:a16="http://schemas.microsoft.com/office/drawing/2014/main" id="{D037420B-B47C-4242-8BAD-F085E00BECA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3822699" y="2936510"/>
              <a:ext cx="257176" cy="257176"/>
            </a:xfrm>
            <a:prstGeom prst="rect">
              <a:avLst/>
            </a:prstGeom>
          </p:spPr>
        </p:pic>
        <p:pic>
          <p:nvPicPr>
            <p:cNvPr id="341" name="Graphic 340" descr="Arrow Rotate right">
              <a:extLst>
                <a:ext uri="{FF2B5EF4-FFF2-40B4-BE49-F238E27FC236}">
                  <a16:creationId xmlns:a16="http://schemas.microsoft.com/office/drawing/2014/main" id="{2DE3519B-63AE-4C4D-A0F3-5A39E1E19AF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4022723" y="2869676"/>
              <a:ext cx="257176" cy="257176"/>
            </a:xfrm>
            <a:prstGeom prst="rect">
              <a:avLst/>
            </a:prstGeom>
          </p:spPr>
        </p:pic>
        <p:pic>
          <p:nvPicPr>
            <p:cNvPr id="342" name="Graphic 341" descr="Arrow Rotate right">
              <a:extLst>
                <a:ext uri="{FF2B5EF4-FFF2-40B4-BE49-F238E27FC236}">
                  <a16:creationId xmlns:a16="http://schemas.microsoft.com/office/drawing/2014/main" id="{0A7D3E44-B862-4C05-B6AA-065EB88BE87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2843213" y="3273864"/>
              <a:ext cx="257176" cy="257176"/>
            </a:xfrm>
            <a:prstGeom prst="rect">
              <a:avLst/>
            </a:prstGeom>
          </p:spPr>
        </p:pic>
        <p:pic>
          <p:nvPicPr>
            <p:cNvPr id="343" name="Graphic 342" descr="Arrow Rotate right">
              <a:extLst>
                <a:ext uri="{FF2B5EF4-FFF2-40B4-BE49-F238E27FC236}">
                  <a16:creationId xmlns:a16="http://schemas.microsoft.com/office/drawing/2014/main" id="{F84D1B23-8C41-47D8-BC9B-6220CE8B2CE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4205328" y="2802842"/>
              <a:ext cx="257176" cy="257176"/>
            </a:xfrm>
            <a:prstGeom prst="rect">
              <a:avLst/>
            </a:prstGeom>
          </p:spPr>
        </p:pic>
        <p:pic>
          <p:nvPicPr>
            <p:cNvPr id="344" name="Graphic 343" descr="Arrow Rotate right">
              <a:extLst>
                <a:ext uri="{FF2B5EF4-FFF2-40B4-BE49-F238E27FC236}">
                  <a16:creationId xmlns:a16="http://schemas.microsoft.com/office/drawing/2014/main" id="{8631FC73-4868-425E-A24B-BF6EF81EFA1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4375283" y="2734486"/>
              <a:ext cx="257176" cy="257176"/>
            </a:xfrm>
            <a:prstGeom prst="rect">
              <a:avLst/>
            </a:prstGeom>
          </p:spPr>
        </p:pic>
        <p:pic>
          <p:nvPicPr>
            <p:cNvPr id="345" name="Graphic 344" descr="Arrow Rotate right">
              <a:extLst>
                <a:ext uri="{FF2B5EF4-FFF2-40B4-BE49-F238E27FC236}">
                  <a16:creationId xmlns:a16="http://schemas.microsoft.com/office/drawing/2014/main" id="{B814A226-E735-424B-8DF2-422E2F91CFB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4552910" y="2669877"/>
              <a:ext cx="257176" cy="257176"/>
            </a:xfrm>
            <a:prstGeom prst="rect">
              <a:avLst/>
            </a:prstGeom>
          </p:spPr>
        </p:pic>
      </p:grpSp>
      <p:grpSp>
        <p:nvGrpSpPr>
          <p:cNvPr id="293" name="Group 292">
            <a:extLst>
              <a:ext uri="{FF2B5EF4-FFF2-40B4-BE49-F238E27FC236}">
                <a16:creationId xmlns:a16="http://schemas.microsoft.com/office/drawing/2014/main" id="{3C3F1CE4-68F3-44B7-B241-8E47F1AB9910}"/>
              </a:ext>
            </a:extLst>
          </p:cNvPr>
          <p:cNvGrpSpPr/>
          <p:nvPr/>
        </p:nvGrpSpPr>
        <p:grpSpPr>
          <a:xfrm>
            <a:off x="2649607" y="2633506"/>
            <a:ext cx="1870973" cy="639911"/>
            <a:chOff x="2514600" y="2641972"/>
            <a:chExt cx="2130813" cy="690950"/>
          </a:xfrm>
        </p:grpSpPr>
        <p:cxnSp>
          <p:nvCxnSpPr>
            <p:cNvPr id="322" name="Straight Arrow Connector 321">
              <a:extLst>
                <a:ext uri="{FF2B5EF4-FFF2-40B4-BE49-F238E27FC236}">
                  <a16:creationId xmlns:a16="http://schemas.microsoft.com/office/drawing/2014/main" id="{8716706A-8469-4CA9-BCC3-B8BBE3B983C2}"/>
                </a:ext>
              </a:extLst>
            </p:cNvPr>
            <p:cNvCxnSpPr/>
            <p:nvPr/>
          </p:nvCxnSpPr>
          <p:spPr>
            <a:xfrm flipH="1">
              <a:off x="2514600" y="2760833"/>
              <a:ext cx="862013" cy="572089"/>
            </a:xfrm>
            <a:prstGeom prst="straightConnector1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3" name="Straight Arrow Connector 322">
              <a:extLst>
                <a:ext uri="{FF2B5EF4-FFF2-40B4-BE49-F238E27FC236}">
                  <a16:creationId xmlns:a16="http://schemas.microsoft.com/office/drawing/2014/main" id="{5B380E89-4536-44C7-9CEC-08476B1CE4E4}"/>
                </a:ext>
              </a:extLst>
            </p:cNvPr>
            <p:cNvCxnSpPr/>
            <p:nvPr/>
          </p:nvCxnSpPr>
          <p:spPr>
            <a:xfrm flipH="1">
              <a:off x="2745839" y="2765195"/>
              <a:ext cx="624962" cy="508669"/>
            </a:xfrm>
            <a:prstGeom prst="straightConnector1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4" name="Straight Arrow Connector 323">
              <a:extLst>
                <a:ext uri="{FF2B5EF4-FFF2-40B4-BE49-F238E27FC236}">
                  <a16:creationId xmlns:a16="http://schemas.microsoft.com/office/drawing/2014/main" id="{9E7DE94B-9B5D-4A74-B33B-C9F5918F0934}"/>
                </a:ext>
              </a:extLst>
            </p:cNvPr>
            <p:cNvCxnSpPr/>
            <p:nvPr/>
          </p:nvCxnSpPr>
          <p:spPr>
            <a:xfrm flipH="1">
              <a:off x="2971801" y="2765425"/>
              <a:ext cx="404812" cy="473893"/>
            </a:xfrm>
            <a:prstGeom prst="straightConnector1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5" name="Straight Arrow Connector 324">
              <a:extLst>
                <a:ext uri="{FF2B5EF4-FFF2-40B4-BE49-F238E27FC236}">
                  <a16:creationId xmlns:a16="http://schemas.microsoft.com/office/drawing/2014/main" id="{CBA3A063-8DB9-4F21-BE38-4CE3F0C80647}"/>
                </a:ext>
              </a:extLst>
            </p:cNvPr>
            <p:cNvCxnSpPr/>
            <p:nvPr/>
          </p:nvCxnSpPr>
          <p:spPr>
            <a:xfrm flipH="1">
              <a:off x="3178887" y="2760833"/>
              <a:ext cx="206676" cy="386906"/>
            </a:xfrm>
            <a:prstGeom prst="straightConnector1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6" name="Straight Arrow Connector 325">
              <a:extLst>
                <a:ext uri="{FF2B5EF4-FFF2-40B4-BE49-F238E27FC236}">
                  <a16:creationId xmlns:a16="http://schemas.microsoft.com/office/drawing/2014/main" id="{8A84DA99-4C32-45ED-AEA8-3070AFA19D4A}"/>
                </a:ext>
              </a:extLst>
            </p:cNvPr>
            <p:cNvCxnSpPr/>
            <p:nvPr/>
          </p:nvCxnSpPr>
          <p:spPr>
            <a:xfrm flipH="1">
              <a:off x="3375100" y="2753738"/>
              <a:ext cx="13130" cy="348562"/>
            </a:xfrm>
            <a:prstGeom prst="straightConnector1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7" name="Straight Arrow Connector 326">
              <a:extLst>
                <a:ext uri="{FF2B5EF4-FFF2-40B4-BE49-F238E27FC236}">
                  <a16:creationId xmlns:a16="http://schemas.microsoft.com/office/drawing/2014/main" id="{CAF459FE-E53A-4BEF-8EC6-7097F9446228}"/>
                </a:ext>
              </a:extLst>
            </p:cNvPr>
            <p:cNvCxnSpPr/>
            <p:nvPr/>
          </p:nvCxnSpPr>
          <p:spPr>
            <a:xfrm>
              <a:off x="3394615" y="2745303"/>
              <a:ext cx="157760" cy="271413"/>
            </a:xfrm>
            <a:prstGeom prst="straightConnector1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8" name="Straight Arrow Connector 327">
              <a:extLst>
                <a:ext uri="{FF2B5EF4-FFF2-40B4-BE49-F238E27FC236}">
                  <a16:creationId xmlns:a16="http://schemas.microsoft.com/office/drawing/2014/main" id="{7B9EE6F2-9E67-4ABB-8793-6D406F737011}"/>
                </a:ext>
              </a:extLst>
            </p:cNvPr>
            <p:cNvCxnSpPr/>
            <p:nvPr/>
          </p:nvCxnSpPr>
          <p:spPr>
            <a:xfrm>
              <a:off x="3402869" y="2765195"/>
              <a:ext cx="354744" cy="193426"/>
            </a:xfrm>
            <a:prstGeom prst="straightConnector1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9" name="Straight Arrow Connector 328">
              <a:extLst>
                <a:ext uri="{FF2B5EF4-FFF2-40B4-BE49-F238E27FC236}">
                  <a16:creationId xmlns:a16="http://schemas.microsoft.com/office/drawing/2014/main" id="{519155F3-FFDA-4636-8F05-30B4A6249711}"/>
                </a:ext>
              </a:extLst>
            </p:cNvPr>
            <p:cNvCxnSpPr/>
            <p:nvPr/>
          </p:nvCxnSpPr>
          <p:spPr>
            <a:xfrm>
              <a:off x="3396306" y="2748497"/>
              <a:ext cx="551400" cy="137918"/>
            </a:xfrm>
            <a:prstGeom prst="straightConnector1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0" name="Straight Arrow Connector 329">
              <a:extLst>
                <a:ext uri="{FF2B5EF4-FFF2-40B4-BE49-F238E27FC236}">
                  <a16:creationId xmlns:a16="http://schemas.microsoft.com/office/drawing/2014/main" id="{0E0E6D54-AB95-4F78-956C-607C0A711035}"/>
                </a:ext>
              </a:extLst>
            </p:cNvPr>
            <p:cNvCxnSpPr/>
            <p:nvPr/>
          </p:nvCxnSpPr>
          <p:spPr>
            <a:xfrm>
              <a:off x="3402869" y="2751273"/>
              <a:ext cx="712053" cy="73625"/>
            </a:xfrm>
            <a:prstGeom prst="straightConnector1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1" name="Straight Arrow Connector 330">
              <a:extLst>
                <a:ext uri="{FF2B5EF4-FFF2-40B4-BE49-F238E27FC236}">
                  <a16:creationId xmlns:a16="http://schemas.microsoft.com/office/drawing/2014/main" id="{D7F70C4B-EA77-4104-8C09-1D16D47EC087}"/>
                </a:ext>
              </a:extLst>
            </p:cNvPr>
            <p:cNvCxnSpPr/>
            <p:nvPr/>
          </p:nvCxnSpPr>
          <p:spPr>
            <a:xfrm>
              <a:off x="3407569" y="2740245"/>
              <a:ext cx="894301" cy="17819"/>
            </a:xfrm>
            <a:prstGeom prst="straightConnector1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2" name="Straight Arrow Connector 331">
              <a:extLst>
                <a:ext uri="{FF2B5EF4-FFF2-40B4-BE49-F238E27FC236}">
                  <a16:creationId xmlns:a16="http://schemas.microsoft.com/office/drawing/2014/main" id="{380B7287-FB04-4D8C-926D-5AA3B8664C52}"/>
                </a:ext>
              </a:extLst>
            </p:cNvPr>
            <p:cNvCxnSpPr/>
            <p:nvPr/>
          </p:nvCxnSpPr>
          <p:spPr>
            <a:xfrm flipV="1">
              <a:off x="3402869" y="2693345"/>
              <a:ext cx="1089582" cy="60760"/>
            </a:xfrm>
            <a:prstGeom prst="straightConnector1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3" name="Straight Arrow Connector 332">
              <a:extLst>
                <a:ext uri="{FF2B5EF4-FFF2-40B4-BE49-F238E27FC236}">
                  <a16:creationId xmlns:a16="http://schemas.microsoft.com/office/drawing/2014/main" id="{7EA449AC-65DE-4725-A181-0F3519FF3A4B}"/>
                </a:ext>
              </a:extLst>
            </p:cNvPr>
            <p:cNvCxnSpPr/>
            <p:nvPr/>
          </p:nvCxnSpPr>
          <p:spPr>
            <a:xfrm flipV="1">
              <a:off x="3396306" y="2641972"/>
              <a:ext cx="1249107" cy="108740"/>
            </a:xfrm>
            <a:prstGeom prst="straightConnector1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4" name="Oval 333">
              <a:extLst>
                <a:ext uri="{FF2B5EF4-FFF2-40B4-BE49-F238E27FC236}">
                  <a16:creationId xmlns:a16="http://schemas.microsoft.com/office/drawing/2014/main" id="{4B16832D-E6EB-428B-A0C3-0655EFC6CC5B}"/>
                </a:ext>
              </a:extLst>
            </p:cNvPr>
            <p:cNvSpPr/>
            <p:nvPr/>
          </p:nvSpPr>
          <p:spPr bwMode="auto">
            <a:xfrm>
              <a:off x="3377186" y="2738234"/>
              <a:ext cx="45719" cy="45719"/>
            </a:xfrm>
            <a:prstGeom prst="ellipse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  <a:headEnd/>
              <a:tailEnd/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en-IN" sz="1013"/>
            </a:p>
          </p:txBody>
        </p:sp>
      </p:grpSp>
      <p:sp>
        <p:nvSpPr>
          <p:cNvPr id="294" name="TextBox 293">
            <a:extLst>
              <a:ext uri="{FF2B5EF4-FFF2-40B4-BE49-F238E27FC236}">
                <a16:creationId xmlns:a16="http://schemas.microsoft.com/office/drawing/2014/main" id="{9E2890EC-DFE7-4A33-A687-504651A59441}"/>
              </a:ext>
            </a:extLst>
          </p:cNvPr>
          <p:cNvSpPr txBox="1"/>
          <p:nvPr/>
        </p:nvSpPr>
        <p:spPr>
          <a:xfrm rot="20378672">
            <a:off x="3025144" y="3244717"/>
            <a:ext cx="184261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NZ" sz="6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5) Perform two-fold dilution by transferring 50 µL from row 1 to 2 and so on </a:t>
            </a:r>
            <a:endParaRPr lang="en-IN" sz="6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295" name="Rectangle 97">
            <a:extLst>
              <a:ext uri="{FF2B5EF4-FFF2-40B4-BE49-F238E27FC236}">
                <a16:creationId xmlns:a16="http://schemas.microsoft.com/office/drawing/2014/main" id="{1F34F933-C48F-426A-B321-45D197C3095E}"/>
              </a:ext>
            </a:extLst>
          </p:cNvPr>
          <p:cNvSpPr/>
          <p:nvPr/>
        </p:nvSpPr>
        <p:spPr bwMode="auto">
          <a:xfrm rot="20243487">
            <a:off x="3331359" y="3620676"/>
            <a:ext cx="2109822" cy="205889"/>
          </a:xfrm>
          <a:custGeom>
            <a:avLst/>
            <a:gdLst>
              <a:gd name="connsiteX0" fmla="*/ 0 w 2313441"/>
              <a:gd name="connsiteY0" fmla="*/ 0 h 195956"/>
              <a:gd name="connsiteX1" fmla="*/ 2313441 w 2313441"/>
              <a:gd name="connsiteY1" fmla="*/ 0 h 195956"/>
              <a:gd name="connsiteX2" fmla="*/ 2313441 w 2313441"/>
              <a:gd name="connsiteY2" fmla="*/ 195956 h 195956"/>
              <a:gd name="connsiteX3" fmla="*/ 0 w 2313441"/>
              <a:gd name="connsiteY3" fmla="*/ 195956 h 195956"/>
              <a:gd name="connsiteX4" fmla="*/ 0 w 2313441"/>
              <a:gd name="connsiteY4" fmla="*/ 0 h 195956"/>
              <a:gd name="connsiteX0" fmla="*/ 0 w 2402833"/>
              <a:gd name="connsiteY0" fmla="*/ 0 h 212546"/>
              <a:gd name="connsiteX1" fmla="*/ 2313441 w 2402833"/>
              <a:gd name="connsiteY1" fmla="*/ 0 h 212546"/>
              <a:gd name="connsiteX2" fmla="*/ 2402833 w 2402833"/>
              <a:gd name="connsiteY2" fmla="*/ 212546 h 212546"/>
              <a:gd name="connsiteX3" fmla="*/ 0 w 2402833"/>
              <a:gd name="connsiteY3" fmla="*/ 195956 h 212546"/>
              <a:gd name="connsiteX4" fmla="*/ 0 w 2402833"/>
              <a:gd name="connsiteY4" fmla="*/ 0 h 212546"/>
              <a:gd name="connsiteX0" fmla="*/ 0 w 2402833"/>
              <a:gd name="connsiteY0" fmla="*/ 9765 h 222311"/>
              <a:gd name="connsiteX1" fmla="*/ 2289993 w 2402833"/>
              <a:gd name="connsiteY1" fmla="*/ 0 h 222311"/>
              <a:gd name="connsiteX2" fmla="*/ 2402833 w 2402833"/>
              <a:gd name="connsiteY2" fmla="*/ 222311 h 222311"/>
              <a:gd name="connsiteX3" fmla="*/ 0 w 2402833"/>
              <a:gd name="connsiteY3" fmla="*/ 205721 h 222311"/>
              <a:gd name="connsiteX4" fmla="*/ 0 w 2402833"/>
              <a:gd name="connsiteY4" fmla="*/ 9765 h 2223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02833" h="222311">
                <a:moveTo>
                  <a:pt x="0" y="9765"/>
                </a:moveTo>
                <a:lnTo>
                  <a:pt x="2289993" y="0"/>
                </a:lnTo>
                <a:lnTo>
                  <a:pt x="2402833" y="222311"/>
                </a:lnTo>
                <a:lnTo>
                  <a:pt x="0" y="205721"/>
                </a:lnTo>
                <a:lnTo>
                  <a:pt x="0" y="9765"/>
                </a:lnTo>
                <a:close/>
              </a:path>
            </a:pathLst>
          </a:custGeom>
          <a:noFill/>
          <a:ln w="3175">
            <a:headEnd/>
            <a:tailEnd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vert="horz" wrap="square" lIns="68580" tIns="34290" rIns="68580" bIns="34290" numCol="1" rtlCol="0" anchor="t" anchorCtr="0" compatLnSpc="1">
            <a:prstTxWarp prst="textNoShape">
              <a:avLst/>
            </a:prstTxWarp>
          </a:bodyPr>
          <a:lstStyle/>
          <a:p>
            <a:pPr algn="ctr"/>
            <a:endParaRPr lang="en-IN" sz="1013"/>
          </a:p>
        </p:txBody>
      </p:sp>
      <p:sp>
        <p:nvSpPr>
          <p:cNvPr id="296" name="Rectangle 110">
            <a:extLst>
              <a:ext uri="{FF2B5EF4-FFF2-40B4-BE49-F238E27FC236}">
                <a16:creationId xmlns:a16="http://schemas.microsoft.com/office/drawing/2014/main" id="{88929EC0-A5C3-4D5B-A33C-668018EB93E5}"/>
              </a:ext>
            </a:extLst>
          </p:cNvPr>
          <p:cNvSpPr/>
          <p:nvPr/>
        </p:nvSpPr>
        <p:spPr bwMode="auto">
          <a:xfrm rot="12962993">
            <a:off x="4484911" y="2949336"/>
            <a:ext cx="1115687" cy="138149"/>
          </a:xfrm>
          <a:custGeom>
            <a:avLst/>
            <a:gdLst>
              <a:gd name="connsiteX0" fmla="*/ 0 w 1188000"/>
              <a:gd name="connsiteY0" fmla="*/ 0 h 144000"/>
              <a:gd name="connsiteX1" fmla="*/ 1188000 w 1188000"/>
              <a:gd name="connsiteY1" fmla="*/ 0 h 144000"/>
              <a:gd name="connsiteX2" fmla="*/ 1188000 w 1188000"/>
              <a:gd name="connsiteY2" fmla="*/ 144000 h 144000"/>
              <a:gd name="connsiteX3" fmla="*/ 0 w 1188000"/>
              <a:gd name="connsiteY3" fmla="*/ 144000 h 144000"/>
              <a:gd name="connsiteX4" fmla="*/ 0 w 1188000"/>
              <a:gd name="connsiteY4" fmla="*/ 0 h 144000"/>
              <a:gd name="connsiteX0" fmla="*/ 82633 w 1270633"/>
              <a:gd name="connsiteY0" fmla="*/ 0 h 149168"/>
              <a:gd name="connsiteX1" fmla="*/ 1270633 w 1270633"/>
              <a:gd name="connsiteY1" fmla="*/ 0 h 149168"/>
              <a:gd name="connsiteX2" fmla="*/ 1270633 w 1270633"/>
              <a:gd name="connsiteY2" fmla="*/ 144000 h 149168"/>
              <a:gd name="connsiteX3" fmla="*/ 0 w 1270633"/>
              <a:gd name="connsiteY3" fmla="*/ 149168 h 149168"/>
              <a:gd name="connsiteX4" fmla="*/ 82633 w 1270633"/>
              <a:gd name="connsiteY4" fmla="*/ 0 h 14916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70633" h="149168">
                <a:moveTo>
                  <a:pt x="82633" y="0"/>
                </a:moveTo>
                <a:lnTo>
                  <a:pt x="1270633" y="0"/>
                </a:lnTo>
                <a:lnTo>
                  <a:pt x="1270633" y="144000"/>
                </a:lnTo>
                <a:lnTo>
                  <a:pt x="0" y="149168"/>
                </a:lnTo>
                <a:lnTo>
                  <a:pt x="82633" y="0"/>
                </a:lnTo>
                <a:close/>
              </a:path>
            </a:pathLst>
          </a:custGeom>
          <a:noFill/>
          <a:ln w="3175">
            <a:headEnd/>
            <a:tailEnd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vert="horz" wrap="square" lIns="68580" tIns="34290" rIns="68580" bIns="34290" numCol="1" rtlCol="0" anchor="t" anchorCtr="0" compatLnSpc="1">
            <a:prstTxWarp prst="textNoShape">
              <a:avLst/>
            </a:prstTxWarp>
          </a:bodyPr>
          <a:lstStyle/>
          <a:p>
            <a:pPr algn="ctr"/>
            <a:endParaRPr lang="en-IN" sz="1013"/>
          </a:p>
        </p:txBody>
      </p:sp>
      <p:sp>
        <p:nvSpPr>
          <p:cNvPr id="297" name="TextBox 296">
            <a:extLst>
              <a:ext uri="{FF2B5EF4-FFF2-40B4-BE49-F238E27FC236}">
                <a16:creationId xmlns:a16="http://schemas.microsoft.com/office/drawing/2014/main" id="{04E256A1-C807-4A5E-BBA2-532000A5947A}"/>
              </a:ext>
            </a:extLst>
          </p:cNvPr>
          <p:cNvSpPr txBox="1"/>
          <p:nvPr/>
        </p:nvSpPr>
        <p:spPr>
          <a:xfrm rot="2134044">
            <a:off x="4716550" y="2732387"/>
            <a:ext cx="7902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7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Ethanol control</a:t>
            </a:r>
            <a:endParaRPr lang="en-IN" sz="7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298" name="TextBox 297">
            <a:extLst>
              <a:ext uri="{FF2B5EF4-FFF2-40B4-BE49-F238E27FC236}">
                <a16:creationId xmlns:a16="http://schemas.microsoft.com/office/drawing/2014/main" id="{F563BE34-C4BE-4FC5-A619-B1DF0946D507}"/>
              </a:ext>
            </a:extLst>
          </p:cNvPr>
          <p:cNvSpPr txBox="1"/>
          <p:nvPr/>
        </p:nvSpPr>
        <p:spPr>
          <a:xfrm rot="20202151">
            <a:off x="4306851" y="3836839"/>
            <a:ext cx="7902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7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Growth control</a:t>
            </a:r>
            <a:endParaRPr lang="en-IN" sz="7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grpSp>
        <p:nvGrpSpPr>
          <p:cNvPr id="299" name="Group 298">
            <a:extLst>
              <a:ext uri="{FF2B5EF4-FFF2-40B4-BE49-F238E27FC236}">
                <a16:creationId xmlns:a16="http://schemas.microsoft.com/office/drawing/2014/main" id="{02D9EA00-D001-4575-96D2-E0091B069001}"/>
              </a:ext>
            </a:extLst>
          </p:cNvPr>
          <p:cNvGrpSpPr/>
          <p:nvPr/>
        </p:nvGrpSpPr>
        <p:grpSpPr>
          <a:xfrm>
            <a:off x="3653225" y="1058479"/>
            <a:ext cx="657980" cy="1455959"/>
            <a:chOff x="4050545" y="919805"/>
            <a:chExt cx="749360" cy="1572084"/>
          </a:xfrm>
        </p:grpSpPr>
        <p:pic>
          <p:nvPicPr>
            <p:cNvPr id="320" name="Picture 319">
              <a:extLst>
                <a:ext uri="{FF2B5EF4-FFF2-40B4-BE49-F238E27FC236}">
                  <a16:creationId xmlns:a16="http://schemas.microsoft.com/office/drawing/2014/main" id="{1608BE8E-4032-4370-8D92-39522B9A089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050545" y="919805"/>
              <a:ext cx="749360" cy="1572084"/>
            </a:xfrm>
            <a:prstGeom prst="rect">
              <a:avLst/>
            </a:prstGeom>
          </p:spPr>
        </p:pic>
        <p:pic>
          <p:nvPicPr>
            <p:cNvPr id="321" name="Picture 320">
              <a:extLst>
                <a:ext uri="{FF2B5EF4-FFF2-40B4-BE49-F238E27FC236}">
                  <a16:creationId xmlns:a16="http://schemas.microsoft.com/office/drawing/2014/main" id="{FCC0A85F-AA83-4099-8260-D6A37E951D9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ackgroundRemoval t="59067" b="98400" l="280" r="98322">
                          <a14:foregroundMark x1="45874" y1="76267" x2="45874" y2="76267"/>
                          <a14:foregroundMark x1="45874" y1="76267" x2="45874" y2="76267"/>
                          <a14:foregroundMark x1="45874" y1="75933" x2="45874" y2="75933"/>
                          <a14:foregroundMark x1="44336" y1="75600" x2="44336" y2="75600"/>
                          <a14:foregroundMark x1="15245" y1="64533" x2="24196" y2="79133"/>
                          <a14:foregroundMark x1="5455" y1="60600" x2="15245" y2="91667"/>
                          <a14:foregroundMark x1="15245" y1="91667" x2="80839" y2="92667"/>
                          <a14:foregroundMark x1="80839" y1="92667" x2="85734" y2="62267"/>
                          <a14:foregroundMark x1="85734" y1="62267" x2="13007" y2="64533"/>
                          <a14:foregroundMark x1="51888" y1="82733" x2="51888" y2="82733"/>
                          <a14:foregroundMark x1="4755" y1="63067" x2="11469" y2="88800"/>
                          <a14:foregroundMark x1="979" y1="61667" x2="6154" y2="88067"/>
                          <a14:foregroundMark x1="3916" y1="63467" x2="3916" y2="63467"/>
                          <a14:foregroundMark x1="2517" y1="60933" x2="3916" y2="89133"/>
                          <a14:foregroundMark x1="40699" y1="65933" x2="70629" y2="82000"/>
                          <a14:foregroundMark x1="28671" y1="83800" x2="27972" y2="83400"/>
                          <a14:foregroundMark x1="12168" y1="60933" x2="78042" y2="61333"/>
                          <a14:foregroundMark x1="78042" y1="61333" x2="88531" y2="60933"/>
                          <a14:foregroundMark x1="2517" y1="60933" x2="85594" y2="62400"/>
                          <a14:foregroundMark x1="90070" y1="61333" x2="93007" y2="89467"/>
                          <a14:foregroundMark x1="84755" y1="60600" x2="280" y2="62000"/>
                          <a14:foregroundMark x1="84755" y1="60600" x2="18182" y2="63067"/>
                          <a14:foregroundMark x1="70629" y1="61667" x2="30909" y2="61333"/>
                          <a14:foregroundMark x1="49650" y1="60933" x2="49650" y2="60933"/>
                          <a14:foregroundMark x1="49650" y1="60933" x2="49650" y2="60933"/>
                          <a14:foregroundMark x1="66154" y1="60933" x2="98322" y2="59133"/>
                          <a14:foregroundMark x1="66154" y1="60267" x2="3217" y2="60600"/>
                          <a14:foregroundMark x1="93846" y1="87333" x2="30070" y2="94933"/>
                          <a14:foregroundMark x1="30070" y1="94933" x2="29371" y2="95200"/>
                          <a14:foregroundMark x1="88531" y1="91267" x2="48112" y2="98400"/>
                        </a14:backgroundRemoval>
                      </a14:imgEffect>
                      <a14:imgEffect>
                        <a14:colorTemperature colorTemp="11200"/>
                      </a14:imgEffect>
                    </a14:imgLayer>
                  </a14:imgProps>
                </a:ext>
              </a:extLst>
            </a:blip>
            <a:srcRect l="1102" t="59777" r="4211" b="2394"/>
            <a:stretch/>
          </p:blipFill>
          <p:spPr>
            <a:xfrm>
              <a:off x="4068026" y="1880595"/>
              <a:ext cx="709552" cy="594719"/>
            </a:xfrm>
            <a:prstGeom prst="rect">
              <a:avLst/>
            </a:prstGeom>
          </p:spPr>
        </p:pic>
      </p:grpSp>
      <mc:AlternateContent xmlns:mc="http://schemas.openxmlformats.org/markup-compatibility/2006" xmlns:p14="http://schemas.microsoft.com/office/powerpoint/2010/main">
        <mc:Choice Requires="p14">
          <p:contentPart p14:bwMode="auto" r:id="rId9">
            <p14:nvContentPartPr>
              <p14:cNvPr id="300" name="Ink 299">
                <a:extLst>
                  <a:ext uri="{FF2B5EF4-FFF2-40B4-BE49-F238E27FC236}">
                    <a16:creationId xmlns:a16="http://schemas.microsoft.com/office/drawing/2014/main" id="{20EBC11E-D1F8-4404-8C5C-8EB3AFEE4FF5}"/>
                  </a:ext>
                </a:extLst>
              </p14:cNvPr>
              <p14:cNvContentPartPr/>
              <p14:nvPr/>
            </p14:nvContentPartPr>
            <p14:xfrm>
              <a:off x="2043296" y="3243306"/>
              <a:ext cx="316" cy="334"/>
            </p14:xfrm>
          </p:contentPart>
        </mc:Choice>
        <mc:Fallback xmlns="">
          <p:pic>
            <p:nvPicPr>
              <p:cNvPr id="300" name="Ink 299">
                <a:extLst>
                  <a:ext uri="{FF2B5EF4-FFF2-40B4-BE49-F238E27FC236}">
                    <a16:creationId xmlns:a16="http://schemas.microsoft.com/office/drawing/2014/main" id="{20EBC11E-D1F8-4404-8C5C-8EB3AFEE4FF5}"/>
                  </a:ext>
                </a:extLst>
              </p:cNvPr>
              <p:cNvPicPr/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2035396" y="3234956"/>
                <a:ext cx="15800" cy="16700"/>
              </a:xfrm>
              <a:prstGeom prst="rect">
                <a:avLst/>
              </a:prstGeom>
            </p:spPr>
          </p:pic>
        </mc:Fallback>
      </mc:AlternateContent>
      <p:sp>
        <p:nvSpPr>
          <p:cNvPr id="301" name="TextBox 300">
            <a:extLst>
              <a:ext uri="{FF2B5EF4-FFF2-40B4-BE49-F238E27FC236}">
                <a16:creationId xmlns:a16="http://schemas.microsoft.com/office/drawing/2014/main" id="{1A8D56D9-42E0-42D2-A1DF-2396C69F7616}"/>
              </a:ext>
            </a:extLst>
          </p:cNvPr>
          <p:cNvSpPr txBox="1"/>
          <p:nvPr/>
        </p:nvSpPr>
        <p:spPr>
          <a:xfrm>
            <a:off x="4523026" y="1731335"/>
            <a:ext cx="140190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7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3) Transfer 50 µL of MHB*+ 1% Tween 80 to all wells except the wells in the first row</a:t>
            </a:r>
            <a:endParaRPr lang="en-IN" sz="7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grpSp>
        <p:nvGrpSpPr>
          <p:cNvPr id="302" name="Group 301">
            <a:extLst>
              <a:ext uri="{FF2B5EF4-FFF2-40B4-BE49-F238E27FC236}">
                <a16:creationId xmlns:a16="http://schemas.microsoft.com/office/drawing/2014/main" id="{9DD7C0D2-DA01-4BC3-B93F-2650447433A1}"/>
              </a:ext>
            </a:extLst>
          </p:cNvPr>
          <p:cNvGrpSpPr/>
          <p:nvPr/>
        </p:nvGrpSpPr>
        <p:grpSpPr>
          <a:xfrm>
            <a:off x="843094" y="1348813"/>
            <a:ext cx="1222717" cy="1427517"/>
            <a:chOff x="532800" y="1188656"/>
            <a:chExt cx="1392527" cy="1541374"/>
          </a:xfrm>
        </p:grpSpPr>
        <p:grpSp>
          <p:nvGrpSpPr>
            <p:cNvPr id="316" name="Group 315">
              <a:extLst>
                <a:ext uri="{FF2B5EF4-FFF2-40B4-BE49-F238E27FC236}">
                  <a16:creationId xmlns:a16="http://schemas.microsoft.com/office/drawing/2014/main" id="{B4278899-4747-4A95-8C75-B140C7529FEE}"/>
                </a:ext>
              </a:extLst>
            </p:cNvPr>
            <p:cNvGrpSpPr/>
            <p:nvPr/>
          </p:nvGrpSpPr>
          <p:grpSpPr>
            <a:xfrm>
              <a:off x="647123" y="1188656"/>
              <a:ext cx="1060450" cy="1060450"/>
              <a:chOff x="1793875" y="1070091"/>
              <a:chExt cx="1060450" cy="1060450"/>
            </a:xfrm>
          </p:grpSpPr>
          <p:pic>
            <p:nvPicPr>
              <p:cNvPr id="318" name="Picture 317" descr="A picture containing vessel, bottle, tableware, jar&#10;&#10;Description automatically generated">
                <a:extLst>
                  <a:ext uri="{FF2B5EF4-FFF2-40B4-BE49-F238E27FC236}">
                    <a16:creationId xmlns:a16="http://schemas.microsoft.com/office/drawing/2014/main" id="{8B491C27-C940-4338-ADF0-79F642B1F5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  <a:ext uri="{837473B0-CC2E-450A-ABE3-18F120FF3D39}">
                    <a1611:picAttrSrcUrl xmlns:a1611="http://schemas.microsoft.com/office/drawing/2016/11/main" r:id="rId14"/>
                  </a:ext>
                </a:extLst>
              </a:blip>
              <a:stretch>
                <a:fillRect/>
              </a:stretch>
            </p:blipFill>
            <p:spPr>
              <a:xfrm>
                <a:off x="1793875" y="1070091"/>
                <a:ext cx="1060450" cy="1060450"/>
              </a:xfrm>
              <a:prstGeom prst="rect">
                <a:avLst/>
              </a:prstGeom>
            </p:spPr>
          </p:pic>
          <p:pic>
            <p:nvPicPr>
              <p:cNvPr id="319" name="Picture 318" descr="A picture containing vessel, bottle, tableware, jar&#10;&#10;Description automatically generated">
                <a:extLst>
                  <a:ext uri="{FF2B5EF4-FFF2-40B4-BE49-F238E27FC236}">
                    <a16:creationId xmlns:a16="http://schemas.microsoft.com/office/drawing/2014/main" id="{5D5DAB43-D57E-448A-855D-A5E8DDB130C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duotone>
                  <a:prstClr val="black"/>
                  <a:srgbClr val="FDCD5A">
                    <a:tint val="45000"/>
                    <a:satMod val="400000"/>
                  </a:srgbClr>
                </a:duotone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ackgroundRemoval t="10000" b="94922" l="10000" r="90000">
                            <a14:foregroundMark x1="51719" y1="90156" x2="51719" y2="90156"/>
                            <a14:foregroundMark x1="51719" y1="90156" x2="51719" y2="90156"/>
                            <a14:foregroundMark x1="51719" y1="93750" x2="51719" y2="93750"/>
                            <a14:foregroundMark x1="51719" y1="94922" x2="51719" y2="94922"/>
                            <a14:backgroundMark x1="41797" y1="79219" x2="42891" y2="92344"/>
                            <a14:backgroundMark x1="42031" y1="78672" x2="43984" y2="91875"/>
                          </a14:backgroundRemoval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  <a:ext uri="{837473B0-CC2E-450A-ABE3-18F120FF3D39}">
                    <a1611:picAttrSrcUrl xmlns:a1611="http://schemas.microsoft.com/office/drawing/2016/11/main" r:id="rId14"/>
                  </a:ext>
                </a:extLst>
              </a:blip>
              <a:srcRect t="59248"/>
              <a:stretch/>
            </p:blipFill>
            <p:spPr>
              <a:xfrm>
                <a:off x="1793875" y="1721082"/>
                <a:ext cx="1060450" cy="409459"/>
              </a:xfrm>
              <a:prstGeom prst="rect">
                <a:avLst/>
              </a:prstGeom>
            </p:spPr>
          </p:pic>
        </p:grpSp>
        <p:sp>
          <p:nvSpPr>
            <p:cNvPr id="317" name="TextBox 316">
              <a:extLst>
                <a:ext uri="{FF2B5EF4-FFF2-40B4-BE49-F238E27FC236}">
                  <a16:creationId xmlns:a16="http://schemas.microsoft.com/office/drawing/2014/main" id="{9CE01342-38C6-49A3-A7F6-D82600051026}"/>
                </a:ext>
              </a:extLst>
            </p:cNvPr>
            <p:cNvSpPr txBox="1"/>
            <p:nvPr/>
          </p:nvSpPr>
          <p:spPr>
            <a:xfrm>
              <a:off x="532800" y="2281392"/>
              <a:ext cx="1392527" cy="4486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700" dirty="0">
                  <a:solidFill>
                    <a:schemeClr val="tx1">
                      <a:lumMod val="75000"/>
                      <a:lumOff val="25000"/>
                    </a:schemeClr>
                  </a:solidFill>
                </a:rPr>
                <a:t>1) Prepare stock solution by diluting with ethanol at a ratio of 4:6</a:t>
              </a:r>
              <a:endParaRPr lang="en-IN" sz="700" dirty="0">
                <a:solidFill>
                  <a:schemeClr val="tx1">
                    <a:lumMod val="75000"/>
                    <a:lumOff val="25000"/>
                  </a:schemeClr>
                </a:solidFill>
              </a:endParaRPr>
            </a:p>
          </p:txBody>
        </p:sp>
      </p:grpSp>
      <p:grpSp>
        <p:nvGrpSpPr>
          <p:cNvPr id="303" name="Group 302">
            <a:extLst>
              <a:ext uri="{FF2B5EF4-FFF2-40B4-BE49-F238E27FC236}">
                <a16:creationId xmlns:a16="http://schemas.microsoft.com/office/drawing/2014/main" id="{108EE755-B024-4169-AC48-064738E0BC47}"/>
              </a:ext>
            </a:extLst>
          </p:cNvPr>
          <p:cNvGrpSpPr/>
          <p:nvPr/>
        </p:nvGrpSpPr>
        <p:grpSpPr>
          <a:xfrm>
            <a:off x="1536583" y="1349308"/>
            <a:ext cx="1715722" cy="982118"/>
            <a:chOff x="1322600" y="1189191"/>
            <a:chExt cx="1954000" cy="1060450"/>
          </a:xfrm>
        </p:grpSpPr>
        <p:grpSp>
          <p:nvGrpSpPr>
            <p:cNvPr id="312" name="Group 311">
              <a:extLst>
                <a:ext uri="{FF2B5EF4-FFF2-40B4-BE49-F238E27FC236}">
                  <a16:creationId xmlns:a16="http://schemas.microsoft.com/office/drawing/2014/main" id="{53F1DE56-AF54-4578-ABEE-464B9252419A}"/>
                </a:ext>
              </a:extLst>
            </p:cNvPr>
            <p:cNvGrpSpPr/>
            <p:nvPr/>
          </p:nvGrpSpPr>
          <p:grpSpPr>
            <a:xfrm>
              <a:off x="2216150" y="1189191"/>
              <a:ext cx="1060450" cy="1060450"/>
              <a:chOff x="575655" y="1063741"/>
              <a:chExt cx="1060450" cy="1060450"/>
            </a:xfrm>
          </p:grpSpPr>
          <p:pic>
            <p:nvPicPr>
              <p:cNvPr id="314" name="Picture 313" descr="A picture containing vessel, bottle, tableware, jar&#10;&#10;Description automatically generated">
                <a:extLst>
                  <a:ext uri="{FF2B5EF4-FFF2-40B4-BE49-F238E27FC236}">
                    <a16:creationId xmlns:a16="http://schemas.microsoft.com/office/drawing/2014/main" id="{AF9C4CE7-A22A-4EDA-BF98-0EAB0E15D53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  <a:ext uri="{837473B0-CC2E-450A-ABE3-18F120FF3D39}">
                    <a1611:picAttrSrcUrl xmlns:a1611="http://schemas.microsoft.com/office/drawing/2016/11/main" r:id="rId14"/>
                  </a:ext>
                </a:extLst>
              </a:blip>
              <a:stretch>
                <a:fillRect/>
              </a:stretch>
            </p:blipFill>
            <p:spPr>
              <a:xfrm>
                <a:off x="575655" y="1063741"/>
                <a:ext cx="1060450" cy="1060450"/>
              </a:xfrm>
              <a:prstGeom prst="rect">
                <a:avLst/>
              </a:prstGeom>
            </p:spPr>
          </p:pic>
          <p:pic>
            <p:nvPicPr>
              <p:cNvPr id="315" name="Picture 314" descr="A picture containing vessel, bottle, tableware, jar&#10;&#10;Description automatically generated">
                <a:extLst>
                  <a:ext uri="{FF2B5EF4-FFF2-40B4-BE49-F238E27FC236}">
                    <a16:creationId xmlns:a16="http://schemas.microsoft.com/office/drawing/2014/main" id="{C2588346-D48C-4F69-A09A-28F223648E5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duotone>
                  <a:prstClr val="black"/>
                  <a:srgbClr val="FDCD5A">
                    <a:tint val="45000"/>
                    <a:satMod val="400000"/>
                  </a:srgbClr>
                </a:duotone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ackgroundRemoval t="10000" b="94922" l="10000" r="90000">
                            <a14:foregroundMark x1="51719" y1="90156" x2="51719" y2="90156"/>
                            <a14:foregroundMark x1="51719" y1="90156" x2="51719" y2="90156"/>
                            <a14:foregroundMark x1="51719" y1="93750" x2="51719" y2="93750"/>
                            <a14:foregroundMark x1="51719" y1="94922" x2="51719" y2="94922"/>
                            <a14:backgroundMark x1="41797" y1="79219" x2="42891" y2="92344"/>
                            <a14:backgroundMark x1="42031" y1="78672" x2="43984" y2="91875"/>
                          </a14:backgroundRemoval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  <a:ext uri="{837473B0-CC2E-450A-ABE3-18F120FF3D39}">
                    <a1611:picAttrSrcUrl xmlns:a1611="http://schemas.microsoft.com/office/drawing/2016/11/main" r:id="rId14"/>
                  </a:ext>
                </a:extLst>
              </a:blip>
              <a:srcRect t="38369"/>
              <a:stretch/>
            </p:blipFill>
            <p:spPr>
              <a:xfrm>
                <a:off x="575655" y="1504949"/>
                <a:ext cx="1060450" cy="619241"/>
              </a:xfrm>
              <a:prstGeom prst="rect">
                <a:avLst/>
              </a:prstGeom>
            </p:spPr>
          </p:pic>
        </p:grpSp>
        <p:sp>
          <p:nvSpPr>
            <p:cNvPr id="313" name="TextBox 312">
              <a:extLst>
                <a:ext uri="{FF2B5EF4-FFF2-40B4-BE49-F238E27FC236}">
                  <a16:creationId xmlns:a16="http://schemas.microsoft.com/office/drawing/2014/main" id="{FF0AD4F1-75AC-4688-9E4F-1F9A6E0F21FA}"/>
                </a:ext>
              </a:extLst>
            </p:cNvPr>
            <p:cNvSpPr txBox="1"/>
            <p:nvPr/>
          </p:nvSpPr>
          <p:spPr>
            <a:xfrm>
              <a:off x="1322600" y="1523548"/>
              <a:ext cx="1368000" cy="4486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700" dirty="0">
                  <a:solidFill>
                    <a:schemeClr val="tx1">
                      <a:lumMod val="75000"/>
                      <a:lumOff val="25000"/>
                    </a:schemeClr>
                  </a:solidFill>
                </a:rPr>
                <a:t>2) Dilute the stock solution with MHB*+1% Tween 80 at a ratio of 1:1</a:t>
              </a:r>
              <a:endParaRPr lang="en-IN" sz="700" dirty="0">
                <a:solidFill>
                  <a:schemeClr val="tx1">
                    <a:lumMod val="75000"/>
                    <a:lumOff val="25000"/>
                  </a:schemeClr>
                </a:solidFill>
              </a:endParaRPr>
            </a:p>
          </p:txBody>
        </p:sp>
      </p:grpSp>
      <p:sp>
        <p:nvSpPr>
          <p:cNvPr id="304" name="Arrow: Curved Down 303">
            <a:extLst>
              <a:ext uri="{FF2B5EF4-FFF2-40B4-BE49-F238E27FC236}">
                <a16:creationId xmlns:a16="http://schemas.microsoft.com/office/drawing/2014/main" id="{DE1D475D-F92E-4DC4-9CB7-565FC4747A52}"/>
              </a:ext>
            </a:extLst>
          </p:cNvPr>
          <p:cNvSpPr/>
          <p:nvPr/>
        </p:nvSpPr>
        <p:spPr bwMode="auto">
          <a:xfrm>
            <a:off x="1423489" y="1006602"/>
            <a:ext cx="1427368" cy="379213"/>
          </a:xfrm>
          <a:prstGeom prst="curvedDownArrow">
            <a:avLst/>
          </a:prstGeom>
          <a:solidFill>
            <a:schemeClr val="bg1"/>
          </a:solidFill>
          <a:ln w="9525">
            <a:solidFill>
              <a:schemeClr val="tx1">
                <a:lumMod val="75000"/>
                <a:lumOff val="25000"/>
              </a:schemeClr>
            </a:solidFill>
            <a:round/>
            <a:headEnd/>
            <a:tailEnd/>
          </a:ln>
        </p:spPr>
        <p:txBody>
          <a:bodyPr vert="horz" wrap="square" lIns="68580" tIns="34290" rIns="68580" bIns="34290" numCol="1" rtlCol="0" anchor="t" anchorCtr="0" compatLnSpc="1">
            <a:prstTxWarp prst="textNoShape">
              <a:avLst/>
            </a:prstTxWarp>
          </a:bodyPr>
          <a:lstStyle/>
          <a:p>
            <a:pPr algn="ctr"/>
            <a:endParaRPr lang="en-IN" sz="1013"/>
          </a:p>
        </p:txBody>
      </p:sp>
      <p:sp>
        <p:nvSpPr>
          <p:cNvPr id="305" name="TextBox 304">
            <a:extLst>
              <a:ext uri="{FF2B5EF4-FFF2-40B4-BE49-F238E27FC236}">
                <a16:creationId xmlns:a16="http://schemas.microsoft.com/office/drawing/2014/main" id="{F72C0D26-0570-47C6-92C5-1234AB2EF30A}"/>
              </a:ext>
            </a:extLst>
          </p:cNvPr>
          <p:cNvSpPr txBox="1"/>
          <p:nvPr/>
        </p:nvSpPr>
        <p:spPr>
          <a:xfrm>
            <a:off x="2200783" y="2346809"/>
            <a:ext cx="125171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7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4) Transfer 100 µL of working stock solution to the wells in the first row</a:t>
            </a:r>
            <a:endParaRPr lang="en-IN" sz="7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306" name="TextBox 305">
            <a:extLst>
              <a:ext uri="{FF2B5EF4-FFF2-40B4-BE49-F238E27FC236}">
                <a16:creationId xmlns:a16="http://schemas.microsoft.com/office/drawing/2014/main" id="{F39E53D8-033B-4523-9A86-F90BF2A1579E}"/>
              </a:ext>
            </a:extLst>
          </p:cNvPr>
          <p:cNvSpPr txBox="1"/>
          <p:nvPr/>
        </p:nvSpPr>
        <p:spPr>
          <a:xfrm>
            <a:off x="1043817" y="3352965"/>
            <a:ext cx="161887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7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6) Inoculate 50 </a:t>
            </a:r>
            <a:r>
              <a:rPr lang="el-GR" sz="7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μ</a:t>
            </a:r>
            <a:r>
              <a:rPr lang="en-NZ" sz="7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L of bacterial suspension adjusted at </a:t>
            </a:r>
            <a:r>
              <a:rPr lang="en-IN" sz="700" dirty="0">
                <a:solidFill>
                  <a:schemeClr val="tx1">
                    <a:lumMod val="75000"/>
                    <a:lumOff val="25000"/>
                  </a:schemeClr>
                </a:solidFill>
                <a:ea typeface="Calibri" panose="020F0502020204030204" pitchFamily="34" charset="0"/>
              </a:rPr>
              <a:t>10</a:t>
            </a:r>
            <a:r>
              <a:rPr lang="en-IN" sz="700" baseline="30000" dirty="0">
                <a:solidFill>
                  <a:schemeClr val="tx1">
                    <a:lumMod val="75000"/>
                    <a:lumOff val="25000"/>
                  </a:schemeClr>
                </a:solidFill>
                <a:ea typeface="Calibri" panose="020F0502020204030204" pitchFamily="34" charset="0"/>
              </a:rPr>
              <a:t>6 </a:t>
            </a:r>
            <a:r>
              <a:rPr lang="en-NZ" sz="7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CFU/mL and incubate the plate at 37</a:t>
            </a:r>
            <a:r>
              <a:rPr lang="en-IN" sz="7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° C for 24 hrs with shaking at 200 rpm </a:t>
            </a:r>
          </a:p>
        </p:txBody>
      </p:sp>
      <p:pic>
        <p:nvPicPr>
          <p:cNvPr id="307" name="Picture 306">
            <a:extLst>
              <a:ext uri="{FF2B5EF4-FFF2-40B4-BE49-F238E27FC236}">
                <a16:creationId xmlns:a16="http://schemas.microsoft.com/office/drawing/2014/main" id="{1C427A80-AC03-4637-A0F0-6AD1899EE633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710604" y="1659253"/>
            <a:ext cx="1091091" cy="1166927"/>
          </a:xfrm>
          <a:prstGeom prst="rect">
            <a:avLst/>
          </a:prstGeom>
        </p:spPr>
      </p:pic>
      <p:cxnSp>
        <p:nvCxnSpPr>
          <p:cNvPr id="308" name="Straight Arrow Connector 307">
            <a:extLst>
              <a:ext uri="{FF2B5EF4-FFF2-40B4-BE49-F238E27FC236}">
                <a16:creationId xmlns:a16="http://schemas.microsoft.com/office/drawing/2014/main" id="{5DD909FA-0B69-40B0-9BC4-FF7CE75174B5}"/>
              </a:ext>
            </a:extLst>
          </p:cNvPr>
          <p:cNvCxnSpPr/>
          <p:nvPr/>
        </p:nvCxnSpPr>
        <p:spPr>
          <a:xfrm>
            <a:off x="5727368" y="3000108"/>
            <a:ext cx="535263" cy="0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9" name="TextBox 308">
            <a:extLst>
              <a:ext uri="{FF2B5EF4-FFF2-40B4-BE49-F238E27FC236}">
                <a16:creationId xmlns:a16="http://schemas.microsoft.com/office/drawing/2014/main" id="{64D31CE2-752C-4B46-9E0B-F4742381D38E}"/>
              </a:ext>
            </a:extLst>
          </p:cNvPr>
          <p:cNvSpPr txBox="1"/>
          <p:nvPr/>
        </p:nvSpPr>
        <p:spPr>
          <a:xfrm>
            <a:off x="5392829" y="2447588"/>
            <a:ext cx="126816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7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7) Transfer 10 µL of aliquot from each well to MHA* agar plate and incubate at 37</a:t>
            </a:r>
            <a:r>
              <a:rPr lang="en-IN" sz="7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</a:rPr>
              <a:t>° C for 24 hrs</a:t>
            </a:r>
            <a:r>
              <a:rPr lang="en-NZ" sz="7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 </a:t>
            </a:r>
            <a:endParaRPr lang="en-IN" sz="7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pic>
        <p:nvPicPr>
          <p:cNvPr id="310" name="Picture 309">
            <a:extLst>
              <a:ext uri="{FF2B5EF4-FFF2-40B4-BE49-F238E27FC236}">
                <a16:creationId xmlns:a16="http://schemas.microsoft.com/office/drawing/2014/main" id="{2080A72C-2591-4F1C-96DB-3F930AE35D02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4959264">
            <a:off x="6691837" y="2872470"/>
            <a:ext cx="1150257" cy="1120838"/>
          </a:xfrm>
          <a:prstGeom prst="rect">
            <a:avLst/>
          </a:prstGeom>
        </p:spPr>
      </p:pic>
      <p:sp>
        <p:nvSpPr>
          <p:cNvPr id="311" name="TextBox 310">
            <a:extLst>
              <a:ext uri="{FF2B5EF4-FFF2-40B4-BE49-F238E27FC236}">
                <a16:creationId xmlns:a16="http://schemas.microsoft.com/office/drawing/2014/main" id="{56397CAF-D3E2-4BAB-97F7-44430EFA682B}"/>
              </a:ext>
            </a:extLst>
          </p:cNvPr>
          <p:cNvSpPr txBox="1"/>
          <p:nvPr/>
        </p:nvSpPr>
        <p:spPr>
          <a:xfrm>
            <a:off x="6667167" y="4011099"/>
            <a:ext cx="132937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700" dirty="0">
                <a:solidFill>
                  <a:schemeClr val="tx1">
                    <a:lumMod val="75000"/>
                    <a:lumOff val="25000"/>
                  </a:schemeClr>
                </a:solidFill>
              </a:rPr>
              <a:t>8) The concentration with complete inhibition on the plate is recorded as the MBC</a:t>
            </a:r>
            <a:endParaRPr lang="en-IN" sz="7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DCAE617-DC97-41A4-937C-D39D2E39BE93}"/>
              </a:ext>
            </a:extLst>
          </p:cNvPr>
          <p:cNvSpPr txBox="1"/>
          <p:nvPr/>
        </p:nvSpPr>
        <p:spPr>
          <a:xfrm>
            <a:off x="0" y="4622204"/>
            <a:ext cx="23931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600" dirty="0">
                <a:solidFill>
                  <a:schemeClr val="tx1">
                    <a:lumMod val="75000"/>
                    <a:lumOff val="25000"/>
                  </a:schemeClr>
                </a:solidFill>
                <a:latin typeface="Adobe Devanagari" panose="02040503050201020203" pitchFamily="18" charset="0"/>
                <a:cs typeface="Adobe Devanagari" panose="02040503050201020203" pitchFamily="18" charset="0"/>
              </a:rPr>
              <a:t>* MHB: Muller Hinton broth; MHA: Mueller Hinton Agar</a:t>
            </a:r>
            <a:endParaRPr lang="en-IN" sz="600" dirty="0">
              <a:solidFill>
                <a:schemeClr val="tx1">
                  <a:lumMod val="75000"/>
                  <a:lumOff val="25000"/>
                </a:schemeClr>
              </a:solidFill>
              <a:latin typeface="Adobe Devanagari" panose="02040503050201020203" pitchFamily="18" charset="0"/>
              <a:cs typeface="Adobe Devanagari" panose="02040503050201020203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51028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F0E3FD0-07DB-4674-861B-D61E237388B2}"/>
              </a:ext>
            </a:extLst>
          </p:cNvPr>
          <p:cNvGrpSpPr/>
          <p:nvPr/>
        </p:nvGrpSpPr>
        <p:grpSpPr>
          <a:xfrm>
            <a:off x="180594" y="4800505"/>
            <a:ext cx="8673084" cy="219878"/>
            <a:chOff x="76200" y="4827470"/>
            <a:chExt cx="8991600" cy="182680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D6EA4027-C091-4519-B09D-E78F24FE1D11}"/>
                </a:ext>
              </a:extLst>
            </p:cNvPr>
            <p:cNvSpPr/>
            <p:nvPr/>
          </p:nvSpPr>
          <p:spPr bwMode="auto">
            <a:xfrm>
              <a:off x="4572000" y="4827470"/>
              <a:ext cx="2241550" cy="182680"/>
            </a:xfrm>
            <a:prstGeom prst="rect">
              <a:avLst/>
            </a:prstGeom>
            <a:solidFill>
              <a:srgbClr val="00206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en-IN" sz="1013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68BA112F-D749-47CD-8196-F14D98D7DC83}"/>
                </a:ext>
              </a:extLst>
            </p:cNvPr>
            <p:cNvSpPr/>
            <p:nvPr/>
          </p:nvSpPr>
          <p:spPr bwMode="auto">
            <a:xfrm>
              <a:off x="76200" y="4827470"/>
              <a:ext cx="2235200" cy="182680"/>
            </a:xfrm>
            <a:prstGeom prst="rect">
              <a:avLst/>
            </a:prstGeom>
            <a:solidFill>
              <a:srgbClr val="00206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en-IN" sz="1013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D4016A87-96B5-4034-8E84-06B9C380A90B}"/>
                </a:ext>
              </a:extLst>
            </p:cNvPr>
            <p:cNvSpPr/>
            <p:nvPr/>
          </p:nvSpPr>
          <p:spPr bwMode="auto">
            <a:xfrm>
              <a:off x="6832600" y="4827470"/>
              <a:ext cx="2235200" cy="182680"/>
            </a:xfrm>
            <a:prstGeom prst="rect">
              <a:avLst/>
            </a:prstGeom>
            <a:solidFill>
              <a:srgbClr val="FFCC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en-IN" sz="1013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6EAADF73-D41D-4D2D-8C30-FFCBCB826CD2}"/>
                </a:ext>
              </a:extLst>
            </p:cNvPr>
            <p:cNvSpPr/>
            <p:nvPr/>
          </p:nvSpPr>
          <p:spPr bwMode="auto">
            <a:xfrm>
              <a:off x="2324100" y="4827470"/>
              <a:ext cx="2235200" cy="182680"/>
            </a:xfrm>
            <a:prstGeom prst="rect">
              <a:avLst/>
            </a:prstGeom>
            <a:solidFill>
              <a:srgbClr val="FFCC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en-IN" sz="1013" dirty="0"/>
            </a:p>
          </p:txBody>
        </p:sp>
      </p:grpSp>
      <p:sp>
        <p:nvSpPr>
          <p:cNvPr id="11" name="Inhaltsplatzhalter 4">
            <a:extLst>
              <a:ext uri="{FF2B5EF4-FFF2-40B4-BE49-F238E27FC236}">
                <a16:creationId xmlns:a16="http://schemas.microsoft.com/office/drawing/2014/main" id="{7D80F4E0-502C-4D49-85AC-4E84CA18DCC7}"/>
              </a:ext>
            </a:extLst>
          </p:cNvPr>
          <p:cNvSpPr txBox="1">
            <a:spLocks/>
          </p:cNvSpPr>
          <p:nvPr/>
        </p:nvSpPr>
        <p:spPr>
          <a:xfrm>
            <a:off x="1873727" y="300707"/>
            <a:ext cx="5170043" cy="38728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marL="272967" indent="-272967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Wingdings" panose="05000000000000000000" pitchFamily="2" charset="2"/>
              <a:buChar char="§"/>
              <a:defRPr sz="23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1pPr>
            <a:lvl2pPr marL="807798" indent="-272967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20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2pPr>
            <a:lvl3pPr marL="1080764" indent="-177748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9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3pPr>
            <a:lvl4pPr marL="1436256" indent="-177748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6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4pPr>
            <a:lvl5pPr marL="1793335" indent="-179335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6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5pPr>
            <a:lvl6pPr marL="2513847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0910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7972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5034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100000"/>
              </a:lnSpc>
              <a:spcAft>
                <a:spcPts val="450"/>
              </a:spcAft>
              <a:buNone/>
            </a:pPr>
            <a:r>
              <a:rPr lang="en-US" sz="1200" b="1" dirty="0">
                <a:solidFill>
                  <a:srgbClr val="262626">
                    <a:lumMod val="75000"/>
                    <a:lumOff val="25000"/>
                  </a:srgbClr>
                </a:solidFill>
                <a:latin typeface="Roboto"/>
              </a:rPr>
              <a:t>Appendix 2: Synergistic Assays</a:t>
            </a:r>
          </a:p>
          <a:p>
            <a:pPr marL="0" indent="0">
              <a:lnSpc>
                <a:spcPct val="100000"/>
              </a:lnSpc>
              <a:spcAft>
                <a:spcPts val="450"/>
              </a:spcAft>
              <a:buNone/>
            </a:pPr>
            <a:endParaRPr lang="en-US" sz="900" b="1" dirty="0">
              <a:solidFill>
                <a:srgbClr val="262626">
                  <a:lumMod val="75000"/>
                  <a:lumOff val="25000"/>
                </a:srgbClr>
              </a:solidFill>
              <a:latin typeface="Roboto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3A4A3B8D-71E8-485F-B477-237D5D7EC03E}"/>
              </a:ext>
            </a:extLst>
          </p:cNvPr>
          <p:cNvGrpSpPr/>
          <p:nvPr/>
        </p:nvGrpSpPr>
        <p:grpSpPr>
          <a:xfrm>
            <a:off x="58188" y="1091787"/>
            <a:ext cx="5170042" cy="3438268"/>
            <a:chOff x="1543989" y="865235"/>
            <a:chExt cx="5644863" cy="3792112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7E11D957-01BE-4D03-ACE6-C254C3DD6B2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91052" y="2936872"/>
              <a:ext cx="2375552" cy="1720475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B6F741A9-2236-4D79-A317-7013707678F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27507" y="933200"/>
              <a:ext cx="2375552" cy="1720696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976D58F9-8ED5-4A6B-BFFD-32B872FFDD6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813300" y="933200"/>
              <a:ext cx="2375552" cy="1720696"/>
            </a:xfrm>
            <a:prstGeom prst="rect">
              <a:avLst/>
            </a:prstGeom>
          </p:spPr>
        </p:pic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38995F14-65A0-4C6A-9083-5B3C4ED519D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025364" y="865235"/>
              <a:ext cx="1980000" cy="0"/>
            </a:xfrm>
            <a:prstGeom prst="straightConnector1">
              <a:avLst/>
            </a:prstGeom>
            <a:noFill/>
            <a:ln w="28575" cap="flat" cmpd="sng" algn="ctr">
              <a:solidFill>
                <a:srgbClr val="262626">
                  <a:lumMod val="75000"/>
                  <a:lumOff val="25000"/>
                </a:srgbClr>
              </a:solidFill>
              <a:prstDash val="solid"/>
              <a:headEnd type="none" w="med" len="med"/>
              <a:tailEnd type="triangle" w="med" len="med"/>
            </a:ln>
            <a:effectLst/>
          </p:spPr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A1F1F32A-B05F-45A2-9743-6E92841DA733}"/>
                </a:ext>
              </a:extLst>
            </p:cNvPr>
            <p:cNvCxnSpPr>
              <a:cxnSpLocks/>
            </p:cNvCxnSpPr>
            <p:nvPr/>
          </p:nvCxnSpPr>
          <p:spPr>
            <a:xfrm rot="16200000" flipH="1" flipV="1">
              <a:off x="1072203" y="1794997"/>
              <a:ext cx="1512000" cy="0"/>
            </a:xfrm>
            <a:prstGeom prst="straightConnector1">
              <a:avLst/>
            </a:prstGeom>
            <a:noFill/>
            <a:ln w="28575" cap="flat" cmpd="sng" algn="ctr">
              <a:solidFill>
                <a:srgbClr val="262626">
                  <a:lumMod val="75000"/>
                  <a:lumOff val="25000"/>
                </a:srgbClr>
              </a:solidFill>
              <a:prstDash val="solid"/>
              <a:headEnd type="none" w="med" len="med"/>
              <a:tailEnd type="triangle" w="med" len="med"/>
            </a:ln>
            <a:effectLst/>
          </p:spPr>
        </p:cxnSp>
        <p:sp>
          <p:nvSpPr>
            <p:cNvPr id="19" name="Oval 18">
              <a:extLst>
                <a:ext uri="{FF2B5EF4-FFF2-40B4-BE49-F238E27FC236}">
                  <a16:creationId xmlns:a16="http://schemas.microsoft.com/office/drawing/2014/main" id="{39BB0AA1-5485-4301-A73F-29A1922DA998}"/>
                </a:ext>
              </a:extLst>
            </p:cNvPr>
            <p:cNvSpPr/>
            <p:nvPr/>
          </p:nvSpPr>
          <p:spPr>
            <a:xfrm>
              <a:off x="1638667" y="3163304"/>
              <a:ext cx="118697" cy="137119"/>
            </a:xfrm>
            <a:prstGeom prst="ellipse">
              <a:avLst/>
            </a:prstGeom>
            <a:solidFill>
              <a:srgbClr val="800000"/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/>
          </p:spPr>
          <p:txBody>
            <a:bodyPr rtlCol="0" anchor="ctr"/>
            <a:lstStyle/>
            <a:p>
              <a:pPr algn="ctr"/>
              <a:endParaRPr lang="en-NZ" kern="0">
                <a:solidFill>
                  <a:srgbClr val="FFFFFF"/>
                </a:solidFill>
                <a:latin typeface="Roboto"/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10156484-AAC7-45DF-A092-FAC7D85EB9B9}"/>
                </a:ext>
              </a:extLst>
            </p:cNvPr>
            <p:cNvSpPr/>
            <p:nvPr/>
          </p:nvSpPr>
          <p:spPr>
            <a:xfrm>
              <a:off x="1543989" y="3067242"/>
              <a:ext cx="1671636" cy="5721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sz="788" dirty="0">
                  <a:solidFill>
                    <a:srgbClr val="262626">
                      <a:lumMod val="75000"/>
                      <a:lumOff val="25000"/>
                    </a:srgbClr>
                  </a:solidFill>
                  <a:latin typeface="Roboto"/>
                </a:rPr>
                <a:t>       </a:t>
              </a:r>
              <a:r>
                <a:rPr lang="en-US" sz="788" dirty="0">
                  <a:solidFill>
                    <a:srgbClr val="262626">
                      <a:lumMod val="75000"/>
                      <a:lumOff val="25000"/>
                    </a:srgbClr>
                  </a:solidFill>
                  <a:cs typeface="Calibri" panose="020F0502020204030204" pitchFamily="34" charset="0"/>
                </a:rPr>
                <a:t>Compound A</a:t>
              </a:r>
            </a:p>
            <a:p>
              <a:pPr>
                <a:lnSpc>
                  <a:spcPct val="120000"/>
                </a:lnSpc>
              </a:pPr>
              <a:r>
                <a:rPr lang="en-US" sz="788" dirty="0">
                  <a:solidFill>
                    <a:srgbClr val="262626">
                      <a:lumMod val="75000"/>
                      <a:lumOff val="25000"/>
                    </a:srgbClr>
                  </a:solidFill>
                  <a:latin typeface="Roboto"/>
                </a:rPr>
                <a:t>       </a:t>
              </a:r>
              <a:r>
                <a:rPr lang="en-US" sz="788" dirty="0">
                  <a:solidFill>
                    <a:srgbClr val="262626">
                      <a:lumMod val="75000"/>
                      <a:lumOff val="25000"/>
                    </a:srgbClr>
                  </a:solidFill>
                  <a:cs typeface="Calibri" panose="020F0502020204030204" pitchFamily="34" charset="0"/>
                </a:rPr>
                <a:t>Compound B</a:t>
              </a:r>
            </a:p>
            <a:p>
              <a:pPr>
                <a:lnSpc>
                  <a:spcPct val="120000"/>
                </a:lnSpc>
              </a:pPr>
              <a:r>
                <a:rPr lang="en-US" sz="788" dirty="0">
                  <a:solidFill>
                    <a:srgbClr val="262626">
                      <a:lumMod val="75000"/>
                      <a:lumOff val="25000"/>
                    </a:srgbClr>
                  </a:solidFill>
                  <a:latin typeface="Roboto"/>
                </a:rPr>
                <a:t>       </a:t>
              </a:r>
              <a:r>
                <a:rPr lang="en-US" sz="788" dirty="0">
                  <a:solidFill>
                    <a:srgbClr val="262626">
                      <a:lumMod val="75000"/>
                      <a:lumOff val="25000"/>
                    </a:srgbClr>
                  </a:solidFill>
                  <a:cs typeface="Calibri" panose="020F0502020204030204" pitchFamily="34" charset="0"/>
                </a:rPr>
                <a:t>Control</a:t>
              </a:r>
            </a:p>
          </p:txBody>
        </p:sp>
        <p:sp>
          <p:nvSpPr>
            <p:cNvPr id="21" name="Oval 20">
              <a:extLst>
                <a:ext uri="{FF2B5EF4-FFF2-40B4-BE49-F238E27FC236}">
                  <a16:creationId xmlns:a16="http://schemas.microsoft.com/office/drawing/2014/main" id="{C2E8FEDD-5388-464C-8F98-FA85764AE303}"/>
                </a:ext>
              </a:extLst>
            </p:cNvPr>
            <p:cNvSpPr/>
            <p:nvPr/>
          </p:nvSpPr>
          <p:spPr>
            <a:xfrm>
              <a:off x="1636693" y="3370267"/>
              <a:ext cx="118800" cy="136800"/>
            </a:xfrm>
            <a:prstGeom prst="ellipse">
              <a:avLst/>
            </a:prstGeom>
            <a:gradFill>
              <a:gsLst>
                <a:gs pos="0">
                  <a:srgbClr val="FFC000">
                    <a:lumMod val="50000"/>
                    <a:shade val="30000"/>
                    <a:satMod val="115000"/>
                  </a:srgbClr>
                </a:gs>
                <a:gs pos="50000">
                  <a:srgbClr val="FFC000">
                    <a:lumMod val="50000"/>
                    <a:shade val="67500"/>
                    <a:satMod val="115000"/>
                  </a:srgbClr>
                </a:gs>
                <a:gs pos="100000">
                  <a:srgbClr val="FFC000">
                    <a:lumMod val="50000"/>
                    <a:shade val="100000"/>
                    <a:satMod val="115000"/>
                  </a:srgbClr>
                </a:gs>
              </a:gsLst>
              <a:lin ang="10800000" scaled="1"/>
            </a:gradFill>
            <a:ln w="12700" cap="flat" cmpd="sng" algn="ctr">
              <a:noFill/>
              <a:prstDash val="solid"/>
              <a:miter lim="800000"/>
            </a:ln>
            <a:effectLst/>
            <a:scene3d>
              <a:camera prst="orthographicFront"/>
              <a:lightRig rig="threePt" dir="t"/>
            </a:scene3d>
            <a:sp3d/>
          </p:spPr>
          <p:txBody>
            <a:bodyPr rtlCol="0" anchor="ctr"/>
            <a:lstStyle/>
            <a:p>
              <a:pPr algn="ctr">
                <a:defRPr/>
              </a:pPr>
              <a:endParaRPr lang="en-NZ" kern="0" dirty="0">
                <a:solidFill>
                  <a:prstClr val="white"/>
                </a:solidFill>
              </a:endParaRPr>
            </a:p>
          </p:txBody>
        </p:sp>
        <p:sp>
          <p:nvSpPr>
            <p:cNvPr id="22" name="Oval 21">
              <a:extLst>
                <a:ext uri="{FF2B5EF4-FFF2-40B4-BE49-F238E27FC236}">
                  <a16:creationId xmlns:a16="http://schemas.microsoft.com/office/drawing/2014/main" id="{6AF76752-EA2E-41C4-BBA9-EC723B27A591}"/>
                </a:ext>
              </a:extLst>
            </p:cNvPr>
            <p:cNvSpPr/>
            <p:nvPr/>
          </p:nvSpPr>
          <p:spPr>
            <a:xfrm>
              <a:off x="1630767" y="3570293"/>
              <a:ext cx="118800" cy="136800"/>
            </a:xfrm>
            <a:prstGeom prst="ellipse">
              <a:avLst/>
            </a:prstGeom>
            <a:solidFill>
              <a:srgbClr val="FFFFFF">
                <a:lumMod val="50000"/>
              </a:srgbClr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/>
          </p:spPr>
          <p:txBody>
            <a:bodyPr rtlCol="0" anchor="ctr"/>
            <a:lstStyle/>
            <a:p>
              <a:pPr algn="ctr"/>
              <a:endParaRPr lang="en-NZ" kern="0">
                <a:solidFill>
                  <a:srgbClr val="FFFFFF"/>
                </a:solidFill>
                <a:latin typeface="Roboto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3301C9F2-50F5-0A61-696D-1A66819DE51A}"/>
              </a:ext>
            </a:extLst>
          </p:cNvPr>
          <p:cNvSpPr txBox="1"/>
          <p:nvPr/>
        </p:nvSpPr>
        <p:spPr>
          <a:xfrm>
            <a:off x="0" y="4622204"/>
            <a:ext cx="23931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600" dirty="0">
                <a:solidFill>
                  <a:schemeClr val="tx1">
                    <a:lumMod val="75000"/>
                    <a:lumOff val="25000"/>
                  </a:schemeClr>
                </a:solidFill>
                <a:latin typeface="Adobe Devanagari" panose="02040503050201020203" pitchFamily="18" charset="0"/>
                <a:cs typeface="Adobe Devanagari" panose="02040503050201020203" pitchFamily="18" charset="0"/>
              </a:rPr>
              <a:t>* FBC- Fractional Bactericidal Concentration</a:t>
            </a:r>
            <a:endParaRPr lang="en-IN" sz="600" dirty="0">
              <a:solidFill>
                <a:schemeClr val="tx1">
                  <a:lumMod val="75000"/>
                  <a:lumOff val="25000"/>
                </a:schemeClr>
              </a:solidFill>
              <a:latin typeface="Adobe Devanagari" panose="02040503050201020203" pitchFamily="18" charset="0"/>
              <a:cs typeface="Adobe Devanagari" panose="02040503050201020203" pitchFamily="18" charset="0"/>
            </a:endParaRP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4B6F685A-C7CB-FC97-6622-CD8F7889E25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13620" y="1091787"/>
            <a:ext cx="3484880" cy="2076450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04949A8C-2557-11F3-CF2C-47C4434D5FAB}"/>
              </a:ext>
            </a:extLst>
          </p:cNvPr>
          <p:cNvSpPr txBox="1"/>
          <p:nvPr/>
        </p:nvSpPr>
        <p:spPr>
          <a:xfrm>
            <a:off x="5402587" y="3107918"/>
            <a:ext cx="3393033" cy="4090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28600" algn="ctr">
              <a:lnSpc>
                <a:spcPct val="200000"/>
              </a:lnSpc>
              <a:spcAft>
                <a:spcPts val="800"/>
              </a:spcAft>
            </a:pPr>
            <a:r>
              <a:rPr lang="en-NZ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pothetical outcomes of the synergistic assay</a:t>
            </a:r>
            <a:endParaRPr lang="en-NZ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69719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F0E3FD0-07DB-4674-861B-D61E237388B2}"/>
              </a:ext>
            </a:extLst>
          </p:cNvPr>
          <p:cNvGrpSpPr/>
          <p:nvPr/>
        </p:nvGrpSpPr>
        <p:grpSpPr>
          <a:xfrm>
            <a:off x="180594" y="4800505"/>
            <a:ext cx="8673084" cy="219878"/>
            <a:chOff x="76200" y="4827470"/>
            <a:chExt cx="8991600" cy="182680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D6EA4027-C091-4519-B09D-E78F24FE1D11}"/>
                </a:ext>
              </a:extLst>
            </p:cNvPr>
            <p:cNvSpPr/>
            <p:nvPr/>
          </p:nvSpPr>
          <p:spPr bwMode="auto">
            <a:xfrm>
              <a:off x="4572000" y="4827470"/>
              <a:ext cx="2241550" cy="182680"/>
            </a:xfrm>
            <a:prstGeom prst="rect">
              <a:avLst/>
            </a:prstGeom>
            <a:solidFill>
              <a:srgbClr val="00206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en-IN" sz="1013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68BA112F-D749-47CD-8196-F14D98D7DC83}"/>
                </a:ext>
              </a:extLst>
            </p:cNvPr>
            <p:cNvSpPr/>
            <p:nvPr/>
          </p:nvSpPr>
          <p:spPr bwMode="auto">
            <a:xfrm>
              <a:off x="76200" y="4827470"/>
              <a:ext cx="2235200" cy="182680"/>
            </a:xfrm>
            <a:prstGeom prst="rect">
              <a:avLst/>
            </a:prstGeom>
            <a:solidFill>
              <a:srgbClr val="00206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en-IN" sz="1013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D4016A87-96B5-4034-8E84-06B9C380A90B}"/>
                </a:ext>
              </a:extLst>
            </p:cNvPr>
            <p:cNvSpPr/>
            <p:nvPr/>
          </p:nvSpPr>
          <p:spPr bwMode="auto">
            <a:xfrm>
              <a:off x="6832600" y="4827470"/>
              <a:ext cx="2235200" cy="182680"/>
            </a:xfrm>
            <a:prstGeom prst="rect">
              <a:avLst/>
            </a:prstGeom>
            <a:solidFill>
              <a:srgbClr val="FFCC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en-IN" sz="1013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6EAADF73-D41D-4D2D-8C30-FFCBCB826CD2}"/>
                </a:ext>
              </a:extLst>
            </p:cNvPr>
            <p:cNvSpPr/>
            <p:nvPr/>
          </p:nvSpPr>
          <p:spPr bwMode="auto">
            <a:xfrm>
              <a:off x="2324100" y="4827470"/>
              <a:ext cx="2235200" cy="182680"/>
            </a:xfrm>
            <a:prstGeom prst="rect">
              <a:avLst/>
            </a:prstGeom>
            <a:solidFill>
              <a:srgbClr val="FFCC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en-IN" sz="1013" dirty="0"/>
            </a:p>
          </p:txBody>
        </p:sp>
      </p:grpSp>
      <p:sp>
        <p:nvSpPr>
          <p:cNvPr id="11" name="Inhaltsplatzhalter 4">
            <a:extLst>
              <a:ext uri="{FF2B5EF4-FFF2-40B4-BE49-F238E27FC236}">
                <a16:creationId xmlns:a16="http://schemas.microsoft.com/office/drawing/2014/main" id="{7D80F4E0-502C-4D49-85AC-4E84CA18DCC7}"/>
              </a:ext>
            </a:extLst>
          </p:cNvPr>
          <p:cNvSpPr txBox="1">
            <a:spLocks/>
          </p:cNvSpPr>
          <p:nvPr/>
        </p:nvSpPr>
        <p:spPr>
          <a:xfrm>
            <a:off x="1986979" y="300707"/>
            <a:ext cx="5170043" cy="38728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marL="272967" indent="-272967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Wingdings" panose="05000000000000000000" pitchFamily="2" charset="2"/>
              <a:buChar char="§"/>
              <a:defRPr sz="23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1pPr>
            <a:lvl2pPr marL="807798" indent="-272967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20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2pPr>
            <a:lvl3pPr marL="1080764" indent="-177748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9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3pPr>
            <a:lvl4pPr marL="1436256" indent="-177748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6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4pPr>
            <a:lvl5pPr marL="1793335" indent="-179335" algn="l" defTabSz="914127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1000"/>
              </a:spcAft>
              <a:buFont typeface="Symbol" panose="05050102010706020507" pitchFamily="18" charset="2"/>
              <a:buChar char="-"/>
              <a:defRPr sz="1600" kern="1200">
                <a:solidFill>
                  <a:schemeClr val="bg1"/>
                </a:solidFill>
                <a:latin typeface="Calibri Light" panose="020F0302020204030204" pitchFamily="34" charset="0"/>
                <a:ea typeface="+mn-ea"/>
                <a:cs typeface="+mn-cs"/>
              </a:defRPr>
            </a:lvl5pPr>
            <a:lvl6pPr marL="2513847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0910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7972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5034" indent="-228532" algn="l" defTabSz="914127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100000"/>
              </a:lnSpc>
              <a:spcAft>
                <a:spcPts val="450"/>
              </a:spcAft>
              <a:buNone/>
            </a:pPr>
            <a:r>
              <a:rPr lang="en-US" sz="1200" b="1">
                <a:solidFill>
                  <a:srgbClr val="262626">
                    <a:lumMod val="75000"/>
                    <a:lumOff val="25000"/>
                  </a:srgbClr>
                </a:solidFill>
                <a:latin typeface="Roboto"/>
              </a:rPr>
              <a:t>Appendix </a:t>
            </a:r>
            <a:r>
              <a:rPr lang="en-US" sz="1200" b="1" dirty="0">
                <a:solidFill>
                  <a:srgbClr val="262626">
                    <a:lumMod val="75000"/>
                    <a:lumOff val="25000"/>
                  </a:srgbClr>
                </a:solidFill>
                <a:latin typeface="Roboto"/>
              </a:rPr>
              <a:t>3: Quantification method of phenolic compounds.</a:t>
            </a:r>
          </a:p>
          <a:p>
            <a:pPr marL="0" indent="0">
              <a:lnSpc>
                <a:spcPct val="100000"/>
              </a:lnSpc>
              <a:spcAft>
                <a:spcPts val="450"/>
              </a:spcAft>
              <a:buNone/>
            </a:pPr>
            <a:endParaRPr lang="en-US" sz="900" b="1" dirty="0">
              <a:solidFill>
                <a:srgbClr val="262626">
                  <a:lumMod val="75000"/>
                  <a:lumOff val="25000"/>
                </a:srgbClr>
              </a:solidFill>
              <a:latin typeface="Roboto"/>
            </a:endParaRPr>
          </a:p>
        </p:txBody>
      </p:sp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id="{24870EB8-A193-932B-9A24-02C1753FA34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1779378"/>
              </p:ext>
            </p:extLst>
          </p:nvPr>
        </p:nvGraphicFramePr>
        <p:xfrm>
          <a:off x="1146641" y="939251"/>
          <a:ext cx="6850718" cy="3187298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438154">
                  <a:extLst>
                    <a:ext uri="{9D8B030D-6E8A-4147-A177-3AD203B41FA5}">
                      <a16:colId xmlns:a16="http://schemas.microsoft.com/office/drawing/2014/main" val="3831895969"/>
                    </a:ext>
                  </a:extLst>
                </a:gridCol>
                <a:gridCol w="1707045">
                  <a:extLst>
                    <a:ext uri="{9D8B030D-6E8A-4147-A177-3AD203B41FA5}">
                      <a16:colId xmlns:a16="http://schemas.microsoft.com/office/drawing/2014/main" val="1755012435"/>
                    </a:ext>
                  </a:extLst>
                </a:gridCol>
                <a:gridCol w="531647">
                  <a:extLst>
                    <a:ext uri="{9D8B030D-6E8A-4147-A177-3AD203B41FA5}">
                      <a16:colId xmlns:a16="http://schemas.microsoft.com/office/drawing/2014/main" val="2162583529"/>
                    </a:ext>
                  </a:extLst>
                </a:gridCol>
                <a:gridCol w="985846">
                  <a:extLst>
                    <a:ext uri="{9D8B030D-6E8A-4147-A177-3AD203B41FA5}">
                      <a16:colId xmlns:a16="http://schemas.microsoft.com/office/drawing/2014/main" val="283565469"/>
                    </a:ext>
                  </a:extLst>
                </a:gridCol>
                <a:gridCol w="620718">
                  <a:extLst>
                    <a:ext uri="{9D8B030D-6E8A-4147-A177-3AD203B41FA5}">
                      <a16:colId xmlns:a16="http://schemas.microsoft.com/office/drawing/2014/main" val="143600746"/>
                    </a:ext>
                  </a:extLst>
                </a:gridCol>
                <a:gridCol w="911966">
                  <a:extLst>
                    <a:ext uri="{9D8B030D-6E8A-4147-A177-3AD203B41FA5}">
                      <a16:colId xmlns:a16="http://schemas.microsoft.com/office/drawing/2014/main" val="1151193654"/>
                    </a:ext>
                  </a:extLst>
                </a:gridCol>
                <a:gridCol w="1217188">
                  <a:extLst>
                    <a:ext uri="{9D8B030D-6E8A-4147-A177-3AD203B41FA5}">
                      <a16:colId xmlns:a16="http://schemas.microsoft.com/office/drawing/2014/main" val="1441047023"/>
                    </a:ext>
                  </a:extLst>
                </a:gridCol>
                <a:gridCol w="438154">
                  <a:extLst>
                    <a:ext uri="{9D8B030D-6E8A-4147-A177-3AD203B41FA5}">
                      <a16:colId xmlns:a16="http://schemas.microsoft.com/office/drawing/2014/main" val="3074786520"/>
                    </a:ext>
                  </a:extLst>
                </a:gridCol>
              </a:tblGrid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b="1" u="none" strike="noStrike" dirty="0">
                          <a:effectLst/>
                        </a:rPr>
                        <a:t>Number</a:t>
                      </a:r>
                      <a:endParaRPr lang="en-NZ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b="1" u="none" strike="noStrike" dirty="0">
                          <a:effectLst/>
                        </a:rPr>
                        <a:t>Product Name </a:t>
                      </a:r>
                      <a:endParaRPr lang="en-NZ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b="1" u="none" strike="noStrike" dirty="0">
                          <a:effectLst/>
                        </a:rPr>
                        <a:t>Precursor</a:t>
                      </a:r>
                      <a:endParaRPr lang="en-NZ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b="1" u="none" strike="noStrike" dirty="0">
                          <a:effectLst/>
                        </a:rPr>
                        <a:t>Product</a:t>
                      </a:r>
                      <a:endParaRPr lang="en-NZ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b="1" u="none" strike="noStrike" dirty="0">
                          <a:effectLst/>
                        </a:rPr>
                        <a:t>Polarity</a:t>
                      </a:r>
                      <a:endParaRPr lang="en-NZ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b="1" u="none" strike="noStrike" dirty="0">
                          <a:effectLst/>
                        </a:rPr>
                        <a:t>RT</a:t>
                      </a:r>
                      <a:endParaRPr lang="en-NZ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b="1" u="none" strike="noStrike" dirty="0">
                          <a:effectLst/>
                        </a:rPr>
                        <a:t>Regression equation</a:t>
                      </a:r>
                      <a:endParaRPr lang="en-NZ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b="1" u="none" strike="noStrike" dirty="0">
                          <a:effectLst/>
                        </a:rPr>
                        <a:t>R²</a:t>
                      </a:r>
                      <a:endParaRPr lang="en-NZ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753012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1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Gallic Acid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169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125/79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 dirty="0">
                          <a:effectLst/>
                        </a:rPr>
                        <a:t>Negative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0.651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baseline="0">
                          <a:effectLst/>
                        </a:rPr>
                        <a:t>y = 1795.5x + 1489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baseline="0">
                          <a:effectLst/>
                        </a:rPr>
                        <a:t>0.992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939309262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2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Catechin hydrat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289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245/20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Nega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3.131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977.35x + 53700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32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2211375666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2,4-Dihydroxybenzoic acid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5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09/108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Nega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4.35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1424.4x + 14678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01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2833536754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4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3-Hydrobenzoic acid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37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37/9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Nega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4.77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4905.8x + 362676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1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918758163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5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Ellagic acid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301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301/284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Nega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1.251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5105.7x + 72270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77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1889183746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6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Epigallocatechin (EGC)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307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39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Posi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.205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7386.2x + 74710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04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3477214777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7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Epicatechin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291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123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Nega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6.899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4036.8x + 48044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65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3839335207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8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Epigallocatechin gallat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291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2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Posi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7.222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4912.2x + 23504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75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3780086920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9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Epicatechin gallate(ECG)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44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2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Posi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1.194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8538x + 24229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95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2980913770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0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Quercitin-3-glucosid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462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301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Nega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2.005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6680.7x + 1E+06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22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4038262903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1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Quercetin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301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51/179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Nega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1.57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51.544x + 287.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9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1236319066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2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Quercitrin 3-D galactoside 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46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463/441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Nega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1.69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387.53x + 486.18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85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4227102333"/>
                  </a:ext>
                </a:extLst>
              </a:tr>
              <a:tr h="172990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13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Isoquercetin (Quercetin 3- glucoside)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462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462/300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 dirty="0">
                          <a:effectLst/>
                        </a:rPr>
                        <a:t>Negative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11.8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 dirty="0">
                          <a:effectLst/>
                        </a:rPr>
                        <a:t>y = 301.25x + 42146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0.9904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3217634998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4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Myricetin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317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79/151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Nega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13.26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157.75x + 14649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9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704773773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5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Myricetin-3-O-glucosid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479</a:t>
                      </a:r>
                      <a:endParaRPr lang="en-NZ" sz="800" b="0" i="0" u="none" strike="noStrike">
                        <a:solidFill>
                          <a:srgbClr val="2E2E2E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316/271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Nega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9.67</a:t>
                      </a:r>
                      <a:endParaRPr lang="en-NZ" sz="800" b="0" i="0" u="none" strike="noStrike">
                        <a:solidFill>
                          <a:srgbClr val="2E2E2E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9.3169x + 85.928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49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2505147343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6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Flavon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22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21/77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Posi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32.346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212.17x + 2150.7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79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3951293864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7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Procyanidin B1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577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289/245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Negative 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518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 dirty="0">
                          <a:effectLst/>
                        </a:rPr>
                        <a:t>y = 186.55x + 6218.8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5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2830087105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8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2,5 - Dihydrobenzoic acid 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5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09/65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Nega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3.1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159.68x + 415.79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66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927069493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9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Procyanidin B2 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577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287/407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Nega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6.28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 dirty="0">
                          <a:effectLst/>
                        </a:rPr>
                        <a:t>y = 326.43x + 2606.7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0.9977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3535908543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20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Protocatechuic acid 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5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09/108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Negative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.15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 dirty="0">
                          <a:effectLst/>
                        </a:rPr>
                        <a:t>y = 348.37x + 4918.7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0.9966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3681465449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21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Rutin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609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300/254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Negative 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1.72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259.24x + 3770.5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0.9958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2677390734"/>
                  </a:ext>
                </a:extLst>
              </a:tr>
              <a:tr h="137014"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22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4-hydroxybenzoic acid 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37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137/9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800" u="none" strike="noStrike">
                          <a:effectLst/>
                        </a:rPr>
                        <a:t>Negative 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>
                          <a:effectLst/>
                        </a:rPr>
                        <a:t>2.83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NZ" sz="800" u="none" strike="noStrike">
                          <a:effectLst/>
                        </a:rPr>
                        <a:t>y = 63.948x + 3493.5</a:t>
                      </a:r>
                      <a:endParaRPr lang="en-NZ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NZ" sz="800" u="none" strike="noStrike" dirty="0">
                          <a:effectLst/>
                        </a:rPr>
                        <a:t>0.9999</a:t>
                      </a:r>
                      <a:endParaRPr lang="en-NZ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851" marR="6851" marT="6851" marB="0" anchor="ctr"/>
                </a:tc>
                <a:extLst>
                  <a:ext uri="{0D108BD9-81ED-4DB2-BD59-A6C34878D82A}">
                    <a16:rowId xmlns:a16="http://schemas.microsoft.com/office/drawing/2014/main" val="90932574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17210217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08_Key">
      <a:dk1>
        <a:srgbClr val="262626"/>
      </a:dk1>
      <a:lt1>
        <a:srgbClr val="FFFFFF"/>
      </a:lt1>
      <a:dk2>
        <a:srgbClr val="262626"/>
      </a:dk2>
      <a:lt2>
        <a:srgbClr val="FFFFFF"/>
      </a:lt2>
      <a:accent1>
        <a:srgbClr val="494B69"/>
      </a:accent1>
      <a:accent2>
        <a:srgbClr val="695D7A"/>
      </a:accent2>
      <a:accent3>
        <a:srgbClr val="9F5B72"/>
      </a:accent3>
      <a:accent4>
        <a:srgbClr val="D8707C"/>
      </a:accent4>
      <a:accent5>
        <a:srgbClr val="FDA85A"/>
      </a:accent5>
      <a:accent6>
        <a:srgbClr val="FDCD5A"/>
      </a:accent6>
      <a:hlink>
        <a:srgbClr val="FFFFFF"/>
      </a:hlink>
      <a:folHlink>
        <a:srgbClr val="595959"/>
      </a:folHlink>
    </a:clrScheme>
    <a:fontScheme name="Custom 84">
      <a:majorFont>
        <a:latin typeface="Roboto"/>
        <a:ea typeface=""/>
        <a:cs typeface=""/>
      </a:majorFont>
      <a:minorFont>
        <a:latin typeface="Roboto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tx1"/>
        </a:solidFill>
        <a:ln w="9525">
          <a:noFill/>
          <a:round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>
          <a:defRPr/>
        </a:defPPr>
      </a:lstStyle>
    </a:spDef>
  </a:objectDefaults>
  <a:extraClrSchemeLst/>
</a:theme>
</file>

<file path=ppt/theme/theme2.xml><?xml version="1.0" encoding="utf-8"?>
<a:theme xmlns:a="http://schemas.openxmlformats.org/drawingml/2006/main" name="Custom Design">
  <a:themeElements>
    <a:clrScheme name="08_Key">
      <a:dk1>
        <a:srgbClr val="262626"/>
      </a:dk1>
      <a:lt1>
        <a:srgbClr val="FFFFFF"/>
      </a:lt1>
      <a:dk2>
        <a:srgbClr val="262626"/>
      </a:dk2>
      <a:lt2>
        <a:srgbClr val="FFFFFF"/>
      </a:lt2>
      <a:accent1>
        <a:srgbClr val="494B69"/>
      </a:accent1>
      <a:accent2>
        <a:srgbClr val="695D7A"/>
      </a:accent2>
      <a:accent3>
        <a:srgbClr val="9F5B72"/>
      </a:accent3>
      <a:accent4>
        <a:srgbClr val="D8707C"/>
      </a:accent4>
      <a:accent5>
        <a:srgbClr val="FDA85A"/>
      </a:accent5>
      <a:accent6>
        <a:srgbClr val="FDCD5A"/>
      </a:accent6>
      <a:hlink>
        <a:srgbClr val="FFFFFF"/>
      </a:hlink>
      <a:folHlink>
        <a:srgbClr val="595959"/>
      </a:folHlink>
    </a:clrScheme>
    <a:fontScheme name="Custom 76">
      <a:majorFont>
        <a:latin typeface="Roboto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gram positive and negative cell wall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Manasweeta Mohan PYR</Template>
  <TotalTime>26138</TotalTime>
  <Words>526</Words>
  <Application>Microsoft Office PowerPoint</Application>
  <PresentationFormat>On-screen Show (16:9)</PresentationFormat>
  <Paragraphs>20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3</vt:i4>
      </vt:variant>
    </vt:vector>
  </HeadingPairs>
  <TitlesOfParts>
    <vt:vector size="14" baseType="lpstr">
      <vt:lpstr>Adobe Devanagari</vt:lpstr>
      <vt:lpstr>Arial</vt:lpstr>
      <vt:lpstr>Arial</vt:lpstr>
      <vt:lpstr>Calibri</vt:lpstr>
      <vt:lpstr>Calibri Light</vt:lpstr>
      <vt:lpstr>Roboto</vt:lpstr>
      <vt:lpstr>Times New Roman</vt:lpstr>
      <vt:lpstr>Wingdings</vt:lpstr>
      <vt:lpstr>Default Theme</vt:lpstr>
      <vt:lpstr>Custom Design</vt:lpstr>
      <vt:lpstr>gram positive and negative cell wall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asweeta</dc:creator>
  <cp:lastModifiedBy>Manasweeta Angane</cp:lastModifiedBy>
  <cp:revision>75</cp:revision>
  <dcterms:created xsi:type="dcterms:W3CDTF">2020-04-05T03:43:35Z</dcterms:created>
  <dcterms:modified xsi:type="dcterms:W3CDTF">2023-06-11T14:20:48Z</dcterms:modified>
</cp:coreProperties>
</file>